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5" r:id="rId2"/>
  </p:sldIdLst>
  <p:sldSz cx="12192000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63994"/>
    <a:srgbClr val="1590BF"/>
    <a:srgbClr val="E50012"/>
    <a:srgbClr val="1D2088"/>
    <a:srgbClr val="45B035"/>
    <a:srgbClr val="C9D4B7"/>
    <a:srgbClr val="70AD47"/>
    <a:srgbClr val="D5DEC5"/>
    <a:srgbClr val="B9B080"/>
    <a:srgbClr val="BF9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DA37D80-6434-44D0-A028-1B22A696006F}" styleName="浅色样式 3 - 强调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5BE263C-DBD7-4A20-BB59-AAB30ACAA65A}" styleName="中度样式 3 - 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E25E649-3F16-4E02-A733-19D2CDBF48F0}" styleName="中度样式 3 - 强调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中度样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12" autoAdjust="0"/>
    <p:restoredTop sz="82847" autoAdjust="0"/>
  </p:normalViewPr>
  <p:slideViewPr>
    <p:cSldViewPr snapToGrid="0">
      <p:cViewPr>
        <p:scale>
          <a:sx n="66" d="100"/>
          <a:sy n="66" d="100"/>
        </p:scale>
        <p:origin x="2154" y="-9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AC1F3B-175B-4A89-8FBE-AC2D9C78DD99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84425" y="1143000"/>
            <a:ext cx="2089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01D8CC-32EE-46DD-88B6-1C6FD43B7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8120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84425" y="1143000"/>
            <a:ext cx="208915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01D8CC-32EE-46DD-88B6-1C6FD43B716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20601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945943"/>
            <a:ext cx="10363200" cy="626689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9454516"/>
            <a:ext cx="9144000" cy="434599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6427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1233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958369"/>
            <a:ext cx="2628900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958369"/>
            <a:ext cx="7734300" cy="15254730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7318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6765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487671"/>
            <a:ext cx="10515600" cy="74877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2046282"/>
            <a:ext cx="10515600" cy="393764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4872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791843"/>
            <a:ext cx="5181600" cy="1142125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791843"/>
            <a:ext cx="5181600" cy="1142125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8585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58373"/>
            <a:ext cx="10515600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4412664"/>
            <a:ext cx="5157787" cy="216257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6575242"/>
            <a:ext cx="5157787" cy="967119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4412664"/>
            <a:ext cx="5183188" cy="216257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6575242"/>
            <a:ext cx="5183188" cy="967119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9277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802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5308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00044"/>
            <a:ext cx="3932237" cy="420015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591766"/>
            <a:ext cx="6172200" cy="12792138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400199"/>
            <a:ext cx="3932237" cy="1000453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49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00044"/>
            <a:ext cx="3932237" cy="420015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591766"/>
            <a:ext cx="6172200" cy="12792138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400199"/>
            <a:ext cx="3932237" cy="1000453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6935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958373"/>
            <a:ext cx="10515600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791843"/>
            <a:ext cx="10515600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6683952"/>
            <a:ext cx="27432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EECE8A-85DC-42F3-A1AC-AF051D6C79C1}" type="datetimeFigureOut">
              <a:rPr lang="zh-CN" altLang="en-US" smtClean="0"/>
              <a:t>2022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6683952"/>
            <a:ext cx="41148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6683952"/>
            <a:ext cx="27432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80CCE-1CAA-4909-8A66-CA4EC7F2A2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708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2.jp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立方体 329">
            <a:extLst>
              <a:ext uri="{FF2B5EF4-FFF2-40B4-BE49-F238E27FC236}">
                <a16:creationId xmlns:a16="http://schemas.microsoft.com/office/drawing/2014/main" id="{1662E485-3138-4949-ABA3-4DB62830F918}"/>
              </a:ext>
            </a:extLst>
          </p:cNvPr>
          <p:cNvSpPr/>
          <p:nvPr/>
        </p:nvSpPr>
        <p:spPr>
          <a:xfrm>
            <a:off x="6638049" y="9687858"/>
            <a:ext cx="3297147" cy="224927"/>
          </a:xfrm>
          <a:prstGeom prst="cube">
            <a:avLst>
              <a:gd name="adj" fmla="val 58011"/>
            </a:avLst>
          </a:prstGeom>
          <a:solidFill>
            <a:schemeClr val="bg2">
              <a:lumMod val="5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4" name="立方体 333">
            <a:extLst>
              <a:ext uri="{FF2B5EF4-FFF2-40B4-BE49-F238E27FC236}">
                <a16:creationId xmlns:a16="http://schemas.microsoft.com/office/drawing/2014/main" id="{CEFBC1AF-1286-462F-991C-574BAC1D2817}"/>
              </a:ext>
            </a:extLst>
          </p:cNvPr>
          <p:cNvSpPr/>
          <p:nvPr/>
        </p:nvSpPr>
        <p:spPr>
          <a:xfrm>
            <a:off x="6295410" y="10054072"/>
            <a:ext cx="3297153" cy="227201"/>
          </a:xfrm>
          <a:prstGeom prst="cube">
            <a:avLst>
              <a:gd name="adj" fmla="val 58011"/>
            </a:avLst>
          </a:prstGeom>
          <a:solidFill>
            <a:schemeClr val="bg2">
              <a:lumMod val="5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5" name="箭头: 下 414">
            <a:extLst>
              <a:ext uri="{FF2B5EF4-FFF2-40B4-BE49-F238E27FC236}">
                <a16:creationId xmlns:a16="http://schemas.microsoft.com/office/drawing/2014/main" id="{1C764EC7-DF40-44A5-8930-7930B2DE71F1}"/>
              </a:ext>
            </a:extLst>
          </p:cNvPr>
          <p:cNvSpPr/>
          <p:nvPr/>
        </p:nvSpPr>
        <p:spPr>
          <a:xfrm rot="16200000">
            <a:off x="9492971" y="9555279"/>
            <a:ext cx="334374" cy="1123661"/>
          </a:xfrm>
          <a:prstGeom prst="downArrow">
            <a:avLst/>
          </a:prstGeom>
          <a:solidFill>
            <a:schemeClr val="accent6">
              <a:lumMod val="75000"/>
              <a:alpha val="50000"/>
            </a:schemeClr>
          </a:solidFill>
          <a:ln w="9525">
            <a:noFill/>
          </a:ln>
          <a:scene3d>
            <a:camera prst="isometricLeftDown"/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83BDFF6B-4780-4E78-8CFD-8FBF22380F02}"/>
              </a:ext>
            </a:extLst>
          </p:cNvPr>
          <p:cNvCxnSpPr>
            <a:cxnSpLocks/>
            <a:stCxn id="335" idx="5"/>
            <a:endCxn id="7" idx="1"/>
          </p:cNvCxnSpPr>
          <p:nvPr/>
        </p:nvCxnSpPr>
        <p:spPr>
          <a:xfrm>
            <a:off x="4235276" y="9865668"/>
            <a:ext cx="3867873" cy="367891"/>
          </a:xfrm>
          <a:prstGeom prst="straightConnector1">
            <a:avLst/>
          </a:prstGeom>
          <a:ln w="9525">
            <a:solidFill>
              <a:schemeClr val="accent3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9" name="图片 268">
            <a:extLst>
              <a:ext uri="{FF2B5EF4-FFF2-40B4-BE49-F238E27FC236}">
                <a16:creationId xmlns:a16="http://schemas.microsoft.com/office/drawing/2014/main" id="{A43DB738-5664-463A-A6C1-D6CD9D3FC7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6891" y="9821330"/>
            <a:ext cx="254210" cy="327410"/>
          </a:xfrm>
          <a:prstGeom prst="rect">
            <a:avLst/>
          </a:prstGeom>
        </p:spPr>
      </p:pic>
      <p:pic>
        <p:nvPicPr>
          <p:cNvPr id="271" name="图片 270">
            <a:extLst>
              <a:ext uri="{FF2B5EF4-FFF2-40B4-BE49-F238E27FC236}">
                <a16:creationId xmlns:a16="http://schemas.microsoft.com/office/drawing/2014/main" id="{3927501D-680F-4F53-AE93-E36C3A7B2E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98377" y="9848378"/>
            <a:ext cx="254210" cy="327410"/>
          </a:xfrm>
          <a:prstGeom prst="rect">
            <a:avLst/>
          </a:prstGeom>
        </p:spPr>
      </p:pic>
      <p:pic>
        <p:nvPicPr>
          <p:cNvPr id="272" name="图片 271">
            <a:extLst>
              <a:ext uri="{FF2B5EF4-FFF2-40B4-BE49-F238E27FC236}">
                <a16:creationId xmlns:a16="http://schemas.microsoft.com/office/drawing/2014/main" id="{000EA22F-03A2-4FB4-9FA8-9D9052800B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72391" y="9852781"/>
            <a:ext cx="254210" cy="327410"/>
          </a:xfrm>
          <a:prstGeom prst="rect">
            <a:avLst/>
          </a:prstGeom>
        </p:spPr>
      </p:pic>
      <p:sp>
        <p:nvSpPr>
          <p:cNvPr id="351" name="文本框 350">
            <a:extLst>
              <a:ext uri="{FF2B5EF4-FFF2-40B4-BE49-F238E27FC236}">
                <a16:creationId xmlns:a16="http://schemas.microsoft.com/office/drawing/2014/main" id="{45487274-30EE-4EB7-965A-0317A54A9D10}"/>
              </a:ext>
            </a:extLst>
          </p:cNvPr>
          <p:cNvSpPr txBox="1"/>
          <p:nvPr/>
        </p:nvSpPr>
        <p:spPr>
          <a:xfrm rot="10800000" flipH="1" flipV="1">
            <a:off x="667364" y="2223621"/>
            <a:ext cx="69978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文本框 351">
            <a:extLst>
              <a:ext uri="{FF2B5EF4-FFF2-40B4-BE49-F238E27FC236}">
                <a16:creationId xmlns:a16="http://schemas.microsoft.com/office/drawing/2014/main" id="{47EA1021-2B96-4BB8-9A26-B64E5028C6E6}"/>
              </a:ext>
            </a:extLst>
          </p:cNvPr>
          <p:cNvSpPr txBox="1"/>
          <p:nvPr/>
        </p:nvSpPr>
        <p:spPr>
          <a:xfrm>
            <a:off x="5630146" y="5672508"/>
            <a:ext cx="873624" cy="369332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9" name="文本框 528">
            <a:extLst>
              <a:ext uri="{FF2B5EF4-FFF2-40B4-BE49-F238E27FC236}">
                <a16:creationId xmlns:a16="http://schemas.microsoft.com/office/drawing/2014/main" id="{9649269A-E61E-4469-8011-B751CF07921E}"/>
              </a:ext>
            </a:extLst>
          </p:cNvPr>
          <p:cNvSpPr txBox="1"/>
          <p:nvPr/>
        </p:nvSpPr>
        <p:spPr>
          <a:xfrm>
            <a:off x="667364" y="5672508"/>
            <a:ext cx="932536" cy="369332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0" name="直接连接符 249">
            <a:extLst>
              <a:ext uri="{FF2B5EF4-FFF2-40B4-BE49-F238E27FC236}">
                <a16:creationId xmlns:a16="http://schemas.microsoft.com/office/drawing/2014/main" id="{3F05D972-66BB-4413-9ED0-B4734A5A4978}"/>
              </a:ext>
            </a:extLst>
          </p:cNvPr>
          <p:cNvCxnSpPr>
            <a:cxnSpLocks/>
          </p:cNvCxnSpPr>
          <p:nvPr/>
        </p:nvCxnSpPr>
        <p:spPr>
          <a:xfrm rot="10800000" flipH="1" flipV="1">
            <a:off x="8416956" y="5375078"/>
            <a:ext cx="1098883" cy="0"/>
          </a:xfrm>
          <a:prstGeom prst="line">
            <a:avLst/>
          </a:prstGeom>
          <a:ln w="28575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1" name="椭圆 250">
            <a:extLst>
              <a:ext uri="{FF2B5EF4-FFF2-40B4-BE49-F238E27FC236}">
                <a16:creationId xmlns:a16="http://schemas.microsoft.com/office/drawing/2014/main" id="{8709ED58-888A-45D7-94A1-5AD870525B6E}"/>
              </a:ext>
            </a:extLst>
          </p:cNvPr>
          <p:cNvSpPr/>
          <p:nvPr/>
        </p:nvSpPr>
        <p:spPr>
          <a:xfrm rot="10800000" flipH="1" flipV="1">
            <a:off x="9337430" y="5213318"/>
            <a:ext cx="350696" cy="350696"/>
          </a:xfrm>
          <a:prstGeom prst="ellipse">
            <a:avLst/>
          </a:prstGeom>
          <a:solidFill>
            <a:schemeClr val="accent3"/>
          </a:solidFill>
          <a:ln w="9525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252" name="椭圆 251">
            <a:extLst>
              <a:ext uri="{FF2B5EF4-FFF2-40B4-BE49-F238E27FC236}">
                <a16:creationId xmlns:a16="http://schemas.microsoft.com/office/drawing/2014/main" id="{0EDE80A1-B0A2-45A6-AB11-066E443EB31C}"/>
              </a:ext>
            </a:extLst>
          </p:cNvPr>
          <p:cNvSpPr/>
          <p:nvPr/>
        </p:nvSpPr>
        <p:spPr>
          <a:xfrm rot="10800000" flipH="1" flipV="1">
            <a:off x="9323638" y="4485612"/>
            <a:ext cx="350696" cy="350696"/>
          </a:xfrm>
          <a:prstGeom prst="ellipse">
            <a:avLst/>
          </a:prstGeom>
          <a:solidFill>
            <a:schemeClr val="accent2"/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cxnSp>
        <p:nvCxnSpPr>
          <p:cNvPr id="253" name="直接连接符 252">
            <a:extLst>
              <a:ext uri="{FF2B5EF4-FFF2-40B4-BE49-F238E27FC236}">
                <a16:creationId xmlns:a16="http://schemas.microsoft.com/office/drawing/2014/main" id="{5A028A82-5DC9-4856-8D5F-736459A5E831}"/>
              </a:ext>
            </a:extLst>
          </p:cNvPr>
          <p:cNvCxnSpPr>
            <a:cxnSpLocks/>
          </p:cNvCxnSpPr>
          <p:nvPr/>
        </p:nvCxnSpPr>
        <p:spPr>
          <a:xfrm rot="10800000" flipH="1" flipV="1">
            <a:off x="8416956" y="4647374"/>
            <a:ext cx="1092098" cy="0"/>
          </a:xfrm>
          <a:prstGeom prst="line">
            <a:avLst/>
          </a:prstGeom>
          <a:ln w="285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直接连接符 253">
            <a:extLst>
              <a:ext uri="{FF2B5EF4-FFF2-40B4-BE49-F238E27FC236}">
                <a16:creationId xmlns:a16="http://schemas.microsoft.com/office/drawing/2014/main" id="{D65F5D82-C6DE-44C3-B121-002F05ED4779}"/>
              </a:ext>
            </a:extLst>
          </p:cNvPr>
          <p:cNvCxnSpPr>
            <a:cxnSpLocks/>
          </p:cNvCxnSpPr>
          <p:nvPr/>
        </p:nvCxnSpPr>
        <p:spPr>
          <a:xfrm rot="10800000" flipH="1" flipV="1">
            <a:off x="8416956" y="3944897"/>
            <a:ext cx="1098883" cy="0"/>
          </a:xfrm>
          <a:prstGeom prst="line">
            <a:avLst/>
          </a:prstGeom>
          <a:ln w="28575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5" name="椭圆 254">
            <a:extLst>
              <a:ext uri="{FF2B5EF4-FFF2-40B4-BE49-F238E27FC236}">
                <a16:creationId xmlns:a16="http://schemas.microsoft.com/office/drawing/2014/main" id="{498D0349-2E6E-4483-9521-F14C957F7F95}"/>
              </a:ext>
            </a:extLst>
          </p:cNvPr>
          <p:cNvSpPr/>
          <p:nvPr/>
        </p:nvSpPr>
        <p:spPr>
          <a:xfrm rot="10800000" flipH="1" flipV="1">
            <a:off x="9337430" y="3783137"/>
            <a:ext cx="350696" cy="350696"/>
          </a:xfrm>
          <a:prstGeom prst="ellipse">
            <a:avLst/>
          </a:prstGeom>
          <a:solidFill>
            <a:schemeClr val="accent6"/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56" name="文本框 255">
                <a:extLst>
                  <a:ext uri="{FF2B5EF4-FFF2-40B4-BE49-F238E27FC236}">
                    <a16:creationId xmlns:a16="http://schemas.microsoft.com/office/drawing/2014/main" id="{A2C4C2FD-55C5-4773-AFD5-E88C7702B5F5}"/>
                  </a:ext>
                </a:extLst>
              </p:cNvPr>
              <p:cNvSpPr txBox="1"/>
              <p:nvPr/>
            </p:nvSpPr>
            <p:spPr>
              <a:xfrm rot="10800000" flipH="1" flipV="1">
                <a:off x="9933204" y="5303856"/>
                <a:ext cx="398891" cy="31258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𝟎</m:t>
                          </m:r>
                        </m:e>
                        <m:sup>
                          <m: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m:t>°</m:t>
                          </m:r>
                        </m:sup>
                      </m:sSup>
                    </m:oMath>
                  </m:oMathPara>
                </a14:m>
                <a:endParaRPr lang="zh-CN" altLang="en-US" sz="14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56" name="文本框 255">
                <a:extLst>
                  <a:ext uri="{FF2B5EF4-FFF2-40B4-BE49-F238E27FC236}">
                    <a16:creationId xmlns:a16="http://schemas.microsoft.com/office/drawing/2014/main" id="{A2C4C2FD-55C5-4773-AFD5-E88C7702B5F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0800000" flipH="1" flipV="1">
                <a:off x="9933204" y="5303856"/>
                <a:ext cx="398891" cy="312586"/>
              </a:xfrm>
              <a:prstGeom prst="rect">
                <a:avLst/>
              </a:prstGeom>
              <a:blipFill>
                <a:blip r:embed="rId4"/>
                <a:stretch>
                  <a:fillRect/>
                </a:stretch>
              </a:blipFill>
              <a:ln w="9525">
                <a:noFill/>
              </a:ln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57" name="文本框 256">
                <a:extLst>
                  <a:ext uri="{FF2B5EF4-FFF2-40B4-BE49-F238E27FC236}">
                    <a16:creationId xmlns:a16="http://schemas.microsoft.com/office/drawing/2014/main" id="{82B91851-7E57-483D-9136-1210CC78D050}"/>
                  </a:ext>
                </a:extLst>
              </p:cNvPr>
              <p:cNvSpPr txBox="1"/>
              <p:nvPr/>
            </p:nvSpPr>
            <p:spPr>
              <a:xfrm rot="10800000" flipH="1" flipV="1">
                <a:off x="9891551" y="4601644"/>
                <a:ext cx="506292" cy="31258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𝟗𝟎</m:t>
                          </m:r>
                        </m:e>
                        <m:sup>
                          <m: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m:t>°</m:t>
                          </m:r>
                        </m:sup>
                      </m:sSup>
                    </m:oMath>
                  </m:oMathPara>
                </a14:m>
                <a:endParaRPr lang="zh-CN" altLang="en-US" sz="14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57" name="文本框 256">
                <a:extLst>
                  <a:ext uri="{FF2B5EF4-FFF2-40B4-BE49-F238E27FC236}">
                    <a16:creationId xmlns:a16="http://schemas.microsoft.com/office/drawing/2014/main" id="{82B91851-7E57-483D-9136-1210CC78D05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0800000" flipH="1" flipV="1">
                <a:off x="9891551" y="4601644"/>
                <a:ext cx="506292" cy="312586"/>
              </a:xfrm>
              <a:prstGeom prst="rect">
                <a:avLst/>
              </a:prstGeom>
              <a:blipFill>
                <a:blip r:embed="rId5"/>
                <a:stretch>
                  <a:fillRect/>
                </a:stretch>
              </a:blipFill>
              <a:ln w="9525">
                <a:noFill/>
              </a:ln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58" name="文本框 257">
                <a:extLst>
                  <a:ext uri="{FF2B5EF4-FFF2-40B4-BE49-F238E27FC236}">
                    <a16:creationId xmlns:a16="http://schemas.microsoft.com/office/drawing/2014/main" id="{DA2A56F8-B9C5-4451-AA2D-342C6BAA0B85}"/>
                  </a:ext>
                </a:extLst>
              </p:cNvPr>
              <p:cNvSpPr txBox="1"/>
              <p:nvPr/>
            </p:nvSpPr>
            <p:spPr>
              <a:xfrm rot="10800000" flipH="1" flipV="1">
                <a:off x="9415908" y="3912910"/>
                <a:ext cx="1313015" cy="31258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−</m:t>
                          </m:r>
                          <m: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𝟗𝟎</m:t>
                          </m:r>
                        </m:e>
                        <m:sup>
                          <m:r>
                            <a:rPr lang="en-US" altLang="zh-CN" sz="1400" b="1" i="1" dirty="0">
                              <a:solidFill>
                                <a:schemeClr val="accent3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m:t>°</m:t>
                          </m:r>
                        </m:sup>
                      </m:sSup>
                    </m:oMath>
                  </m:oMathPara>
                </a14:m>
                <a:endParaRPr lang="zh-CN" altLang="en-US" sz="14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58" name="文本框 257">
                <a:extLst>
                  <a:ext uri="{FF2B5EF4-FFF2-40B4-BE49-F238E27FC236}">
                    <a16:creationId xmlns:a16="http://schemas.microsoft.com/office/drawing/2014/main" id="{DA2A56F8-B9C5-4451-AA2D-342C6BAA0B8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0800000" flipH="1" flipV="1">
                <a:off x="9415908" y="3912910"/>
                <a:ext cx="1313015" cy="312586"/>
              </a:xfrm>
              <a:prstGeom prst="rect">
                <a:avLst/>
              </a:prstGeom>
              <a:blipFill>
                <a:blip r:embed="rId6"/>
                <a:stretch>
                  <a:fillRect/>
                </a:stretch>
              </a:blipFill>
              <a:ln w="9525">
                <a:noFill/>
              </a:ln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59" name="立方体 258">
            <a:extLst>
              <a:ext uri="{FF2B5EF4-FFF2-40B4-BE49-F238E27FC236}">
                <a16:creationId xmlns:a16="http://schemas.microsoft.com/office/drawing/2014/main" id="{F7380A3C-2B1F-46B1-95FE-EFD6B2E77A65}"/>
              </a:ext>
            </a:extLst>
          </p:cNvPr>
          <p:cNvSpPr/>
          <p:nvPr/>
        </p:nvSpPr>
        <p:spPr>
          <a:xfrm rot="16200000" flipH="1">
            <a:off x="6701681" y="4072378"/>
            <a:ext cx="2201257" cy="1207652"/>
          </a:xfrm>
          <a:prstGeom prst="cube">
            <a:avLst>
              <a:gd name="adj" fmla="val 7096"/>
            </a:avLst>
          </a:prstGeom>
          <a:gradFill flip="none" rotWithShape="1">
            <a:gsLst>
              <a:gs pos="0">
                <a:schemeClr val="accent3">
                  <a:shade val="30000"/>
                  <a:satMod val="115000"/>
                </a:schemeClr>
              </a:gs>
              <a:gs pos="50000">
                <a:schemeClr val="accent3">
                  <a:shade val="67500"/>
                  <a:satMod val="115000"/>
                </a:schemeClr>
              </a:gs>
              <a:gs pos="100000">
                <a:schemeClr val="accent3">
                  <a:shade val="100000"/>
                  <a:satMod val="115000"/>
                </a:schemeClr>
              </a:gs>
            </a:gsLst>
            <a:path path="circle">
              <a:fillToRect l="50000" t="50000" r="50000" b="50000"/>
            </a:path>
            <a:tileRect/>
          </a:gradFill>
          <a:ln w="9525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ime Delay</a:t>
            </a:r>
          </a:p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60" name="文本框 259">
                <a:extLst>
                  <a:ext uri="{FF2B5EF4-FFF2-40B4-BE49-F238E27FC236}">
                    <a16:creationId xmlns:a16="http://schemas.microsoft.com/office/drawing/2014/main" id="{9FA56B27-01A5-4AD6-BFE1-40E70BE8F0DD}"/>
                  </a:ext>
                </a:extLst>
              </p:cNvPr>
              <p:cNvSpPr txBox="1"/>
              <p:nvPr/>
            </p:nvSpPr>
            <p:spPr>
              <a:xfrm rot="10800000" flipH="1" flipV="1">
                <a:off x="8611035" y="5102032"/>
                <a:ext cx="795795" cy="30777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∆</m:t>
                      </m:r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𝑻</m:t>
                      </m:r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=</m:t>
                      </m:r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𝟎</m:t>
                      </m:r>
                    </m:oMath>
                  </m:oMathPara>
                </a14:m>
                <a:endParaRPr lang="zh-CN" altLang="en-US" sz="14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60" name="文本框 259">
                <a:extLst>
                  <a:ext uri="{FF2B5EF4-FFF2-40B4-BE49-F238E27FC236}">
                    <a16:creationId xmlns:a16="http://schemas.microsoft.com/office/drawing/2014/main" id="{9FA56B27-01A5-4AD6-BFE1-40E70BE8F0D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0800000" flipH="1" flipV="1">
                <a:off x="8611035" y="5102032"/>
                <a:ext cx="795795" cy="307777"/>
              </a:xfrm>
              <a:prstGeom prst="rect">
                <a:avLst/>
              </a:prstGeom>
              <a:blipFill>
                <a:blip r:embed="rId7"/>
                <a:stretch>
                  <a:fillRect/>
                </a:stretch>
              </a:blipFill>
              <a:ln w="9525">
                <a:noFill/>
              </a:ln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61" name="矩形 260">
                <a:extLst>
                  <a:ext uri="{FF2B5EF4-FFF2-40B4-BE49-F238E27FC236}">
                    <a16:creationId xmlns:a16="http://schemas.microsoft.com/office/drawing/2014/main" id="{900F84B0-E0C6-4426-810D-C5E4D15FADA7}"/>
                  </a:ext>
                </a:extLst>
              </p:cNvPr>
              <p:cNvSpPr/>
              <p:nvPr/>
            </p:nvSpPr>
            <p:spPr>
              <a:xfrm rot="10800000" flipH="1" flipV="1">
                <a:off x="8611035" y="4268953"/>
                <a:ext cx="795795" cy="307777"/>
              </a:xfrm>
              <a:prstGeom prst="rect">
                <a:avLst/>
              </a:prstGeom>
              <a:ln w="9525">
                <a:noFill/>
              </a:ln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∆</m:t>
                      </m:r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𝑻</m:t>
                      </m:r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&gt;</m:t>
                      </m:r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𝟎</m:t>
                      </m:r>
                    </m:oMath>
                  </m:oMathPara>
                </a14:m>
                <a:endParaRPr lang="zh-CN" altLang="en-US" sz="14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61" name="矩形 260">
                <a:extLst>
                  <a:ext uri="{FF2B5EF4-FFF2-40B4-BE49-F238E27FC236}">
                    <a16:creationId xmlns:a16="http://schemas.microsoft.com/office/drawing/2014/main" id="{900F84B0-E0C6-4426-810D-C5E4D15FADA7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0800000" flipH="1" flipV="1">
                <a:off x="8611035" y="4268953"/>
                <a:ext cx="795795" cy="307777"/>
              </a:xfrm>
              <a:prstGeom prst="rect">
                <a:avLst/>
              </a:prstGeom>
              <a:blipFill>
                <a:blip r:embed="rId8"/>
                <a:stretch>
                  <a:fillRect/>
                </a:stretch>
              </a:blipFill>
              <a:ln w="9525">
                <a:noFill/>
              </a:ln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62" name="矩形 261">
                <a:extLst>
                  <a:ext uri="{FF2B5EF4-FFF2-40B4-BE49-F238E27FC236}">
                    <a16:creationId xmlns:a16="http://schemas.microsoft.com/office/drawing/2014/main" id="{18001AB0-C4E5-4D27-91C1-7414A720F030}"/>
                  </a:ext>
                </a:extLst>
              </p:cNvPr>
              <p:cNvSpPr/>
              <p:nvPr/>
            </p:nvSpPr>
            <p:spPr>
              <a:xfrm rot="10800000" flipH="1" flipV="1">
                <a:off x="8621769" y="3563558"/>
                <a:ext cx="795795" cy="307777"/>
              </a:xfrm>
              <a:prstGeom prst="rect">
                <a:avLst/>
              </a:prstGeom>
              <a:ln w="9525">
                <a:noFill/>
              </a:ln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∆</m:t>
                      </m:r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𝑻</m:t>
                      </m:r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&lt;</m:t>
                      </m:r>
                      <m:r>
                        <a:rPr lang="en-US" altLang="zh-CN" sz="1400" b="1" i="1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Arial" panose="020B0604020202020204" pitchFamily="34" charset="0"/>
                        </a:rPr>
                        <m:t>𝟎</m:t>
                      </m:r>
                    </m:oMath>
                  </m:oMathPara>
                </a14:m>
                <a:endParaRPr lang="zh-CN" altLang="en-US" sz="14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62" name="矩形 261">
                <a:extLst>
                  <a:ext uri="{FF2B5EF4-FFF2-40B4-BE49-F238E27FC236}">
                    <a16:creationId xmlns:a16="http://schemas.microsoft.com/office/drawing/2014/main" id="{18001AB0-C4E5-4D27-91C1-7414A720F030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0800000" flipH="1" flipV="1">
                <a:off x="8621769" y="3563558"/>
                <a:ext cx="795795" cy="307777"/>
              </a:xfrm>
              <a:prstGeom prst="rect">
                <a:avLst/>
              </a:prstGeom>
              <a:blipFill>
                <a:blip r:embed="rId9"/>
                <a:stretch>
                  <a:fillRect/>
                </a:stretch>
              </a:blipFill>
              <a:ln w="9525">
                <a:noFill/>
              </a:ln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16" name="箭头: 下 315">
            <a:extLst>
              <a:ext uri="{FF2B5EF4-FFF2-40B4-BE49-F238E27FC236}">
                <a16:creationId xmlns:a16="http://schemas.microsoft.com/office/drawing/2014/main" id="{E7F5371B-E94D-4E73-8019-03C7D19B4F03}"/>
              </a:ext>
            </a:extLst>
          </p:cNvPr>
          <p:cNvSpPr/>
          <p:nvPr/>
        </p:nvSpPr>
        <p:spPr>
          <a:xfrm rot="5400000" flipH="1" flipV="1">
            <a:off x="4484756" y="2216721"/>
            <a:ext cx="430093" cy="4934756"/>
          </a:xfrm>
          <a:prstGeom prst="downArrow">
            <a:avLst/>
          </a:prstGeom>
          <a:solidFill>
            <a:srgbClr val="F8CBAD">
              <a:alpha val="69804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474" name="组合 473">
            <a:extLst>
              <a:ext uri="{FF2B5EF4-FFF2-40B4-BE49-F238E27FC236}">
                <a16:creationId xmlns:a16="http://schemas.microsoft.com/office/drawing/2014/main" id="{8ECD10D0-B40E-4DA3-B5E0-4563EF1F7433}"/>
              </a:ext>
            </a:extLst>
          </p:cNvPr>
          <p:cNvGrpSpPr/>
          <p:nvPr/>
        </p:nvGrpSpPr>
        <p:grpSpPr>
          <a:xfrm flipH="1">
            <a:off x="2137114" y="2001739"/>
            <a:ext cx="4328808" cy="3013108"/>
            <a:chOff x="1004935" y="167319"/>
            <a:chExt cx="2738099" cy="1905879"/>
          </a:xfrm>
        </p:grpSpPr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B0D43814-BB4C-4CD2-A0CC-87A07003F9F4}"/>
                </a:ext>
              </a:extLst>
            </p:cNvPr>
            <p:cNvGrpSpPr/>
            <p:nvPr/>
          </p:nvGrpSpPr>
          <p:grpSpPr>
            <a:xfrm rot="5400000" flipH="1" flipV="1">
              <a:off x="2797001" y="1403018"/>
              <a:ext cx="739983" cy="549684"/>
              <a:chOff x="7541984" y="1247779"/>
              <a:chExt cx="1707588" cy="1268450"/>
            </a:xfrm>
          </p:grpSpPr>
          <p:sp>
            <p:nvSpPr>
              <p:cNvPr id="233" name="任意多边形: 形状 232">
                <a:extLst>
                  <a:ext uri="{FF2B5EF4-FFF2-40B4-BE49-F238E27FC236}">
                    <a16:creationId xmlns:a16="http://schemas.microsoft.com/office/drawing/2014/main" id="{0781A285-0446-4A21-B25E-42DBB415D3A8}"/>
                  </a:ext>
                </a:extLst>
              </p:cNvPr>
              <p:cNvSpPr/>
              <p:nvPr/>
            </p:nvSpPr>
            <p:spPr>
              <a:xfrm>
                <a:off x="8099447" y="1247779"/>
                <a:ext cx="863602" cy="1268450"/>
              </a:xfrm>
              <a:custGeom>
                <a:avLst/>
                <a:gdLst>
                  <a:gd name="connsiteX0" fmla="*/ 0 w 863600"/>
                  <a:gd name="connsiteY0" fmla="*/ 1018641 h 1543725"/>
                  <a:gd name="connsiteX1" fmla="*/ 101600 w 863600"/>
                  <a:gd name="connsiteY1" fmla="*/ 383641 h 1543725"/>
                  <a:gd name="connsiteX2" fmla="*/ 139700 w 863600"/>
                  <a:gd name="connsiteY2" fmla="*/ 53441 h 1543725"/>
                  <a:gd name="connsiteX3" fmla="*/ 190500 w 863600"/>
                  <a:gd name="connsiteY3" fmla="*/ 1513941 h 1543725"/>
                  <a:gd name="connsiteX4" fmla="*/ 266700 w 863600"/>
                  <a:gd name="connsiteY4" fmla="*/ 993241 h 1543725"/>
                  <a:gd name="connsiteX5" fmla="*/ 317500 w 863600"/>
                  <a:gd name="connsiteY5" fmla="*/ 472541 h 1543725"/>
                  <a:gd name="connsiteX6" fmla="*/ 355600 w 863600"/>
                  <a:gd name="connsiteY6" fmla="*/ 701141 h 1543725"/>
                  <a:gd name="connsiteX7" fmla="*/ 342900 w 863600"/>
                  <a:gd name="connsiteY7" fmla="*/ 1285341 h 1543725"/>
                  <a:gd name="connsiteX8" fmla="*/ 342900 w 863600"/>
                  <a:gd name="connsiteY8" fmla="*/ 1374241 h 1543725"/>
                  <a:gd name="connsiteX9" fmla="*/ 419100 w 863600"/>
                  <a:gd name="connsiteY9" fmla="*/ 802741 h 1543725"/>
                  <a:gd name="connsiteX10" fmla="*/ 419100 w 863600"/>
                  <a:gd name="connsiteY10" fmla="*/ 536041 h 1543725"/>
                  <a:gd name="connsiteX11" fmla="*/ 469900 w 863600"/>
                  <a:gd name="connsiteY11" fmla="*/ 320141 h 1543725"/>
                  <a:gd name="connsiteX12" fmla="*/ 469900 w 863600"/>
                  <a:gd name="connsiteY12" fmla="*/ 1196441 h 1543725"/>
                  <a:gd name="connsiteX13" fmla="*/ 622300 w 863600"/>
                  <a:gd name="connsiteY13" fmla="*/ 650341 h 1543725"/>
                  <a:gd name="connsiteX14" fmla="*/ 711200 w 863600"/>
                  <a:gd name="connsiteY14" fmla="*/ 1221841 h 1543725"/>
                  <a:gd name="connsiteX15" fmla="*/ 787400 w 863600"/>
                  <a:gd name="connsiteY15" fmla="*/ 878941 h 1543725"/>
                  <a:gd name="connsiteX16" fmla="*/ 863600 w 863600"/>
                  <a:gd name="connsiteY16" fmla="*/ 1069441 h 1543725"/>
                  <a:gd name="connsiteX0" fmla="*/ 0 w 863600"/>
                  <a:gd name="connsiteY0" fmla="*/ 1018641 h 1543725"/>
                  <a:gd name="connsiteX1" fmla="*/ 101600 w 863600"/>
                  <a:gd name="connsiteY1" fmla="*/ 383641 h 1543725"/>
                  <a:gd name="connsiteX2" fmla="*/ 139700 w 863600"/>
                  <a:gd name="connsiteY2" fmla="*/ 53441 h 1543725"/>
                  <a:gd name="connsiteX3" fmla="*/ 190500 w 863600"/>
                  <a:gd name="connsiteY3" fmla="*/ 1513941 h 1543725"/>
                  <a:gd name="connsiteX4" fmla="*/ 266700 w 863600"/>
                  <a:gd name="connsiteY4" fmla="*/ 993241 h 1543725"/>
                  <a:gd name="connsiteX5" fmla="*/ 317500 w 863600"/>
                  <a:gd name="connsiteY5" fmla="*/ 472541 h 1543725"/>
                  <a:gd name="connsiteX6" fmla="*/ 355600 w 863600"/>
                  <a:gd name="connsiteY6" fmla="*/ 701141 h 1543725"/>
                  <a:gd name="connsiteX7" fmla="*/ 342900 w 863600"/>
                  <a:gd name="connsiteY7" fmla="*/ 1285341 h 1543725"/>
                  <a:gd name="connsiteX8" fmla="*/ 342900 w 863600"/>
                  <a:gd name="connsiteY8" fmla="*/ 1374241 h 1543725"/>
                  <a:gd name="connsiteX9" fmla="*/ 419100 w 863600"/>
                  <a:gd name="connsiteY9" fmla="*/ 802741 h 1543725"/>
                  <a:gd name="connsiteX10" fmla="*/ 442913 w 863600"/>
                  <a:gd name="connsiteY10" fmla="*/ 536041 h 1543725"/>
                  <a:gd name="connsiteX11" fmla="*/ 469900 w 863600"/>
                  <a:gd name="connsiteY11" fmla="*/ 320141 h 1543725"/>
                  <a:gd name="connsiteX12" fmla="*/ 469900 w 863600"/>
                  <a:gd name="connsiteY12" fmla="*/ 1196441 h 1543725"/>
                  <a:gd name="connsiteX13" fmla="*/ 622300 w 863600"/>
                  <a:gd name="connsiteY13" fmla="*/ 650341 h 1543725"/>
                  <a:gd name="connsiteX14" fmla="*/ 711200 w 863600"/>
                  <a:gd name="connsiteY14" fmla="*/ 1221841 h 1543725"/>
                  <a:gd name="connsiteX15" fmla="*/ 787400 w 863600"/>
                  <a:gd name="connsiteY15" fmla="*/ 878941 h 1543725"/>
                  <a:gd name="connsiteX16" fmla="*/ 863600 w 863600"/>
                  <a:gd name="connsiteY16" fmla="*/ 1069441 h 1543725"/>
                  <a:gd name="connsiteX0" fmla="*/ 0 w 863600"/>
                  <a:gd name="connsiteY0" fmla="*/ 1019042 h 1544126"/>
                  <a:gd name="connsiteX1" fmla="*/ 89694 w 863600"/>
                  <a:gd name="connsiteY1" fmla="*/ 381661 h 1544126"/>
                  <a:gd name="connsiteX2" fmla="*/ 139700 w 863600"/>
                  <a:gd name="connsiteY2" fmla="*/ 53842 h 1544126"/>
                  <a:gd name="connsiteX3" fmla="*/ 190500 w 863600"/>
                  <a:gd name="connsiteY3" fmla="*/ 1514342 h 1544126"/>
                  <a:gd name="connsiteX4" fmla="*/ 266700 w 863600"/>
                  <a:gd name="connsiteY4" fmla="*/ 993642 h 1544126"/>
                  <a:gd name="connsiteX5" fmla="*/ 317500 w 863600"/>
                  <a:gd name="connsiteY5" fmla="*/ 472942 h 1544126"/>
                  <a:gd name="connsiteX6" fmla="*/ 355600 w 863600"/>
                  <a:gd name="connsiteY6" fmla="*/ 701542 h 1544126"/>
                  <a:gd name="connsiteX7" fmla="*/ 342900 w 863600"/>
                  <a:gd name="connsiteY7" fmla="*/ 1285742 h 1544126"/>
                  <a:gd name="connsiteX8" fmla="*/ 342900 w 863600"/>
                  <a:gd name="connsiteY8" fmla="*/ 1374642 h 1544126"/>
                  <a:gd name="connsiteX9" fmla="*/ 419100 w 863600"/>
                  <a:gd name="connsiteY9" fmla="*/ 803142 h 1544126"/>
                  <a:gd name="connsiteX10" fmla="*/ 442913 w 863600"/>
                  <a:gd name="connsiteY10" fmla="*/ 536442 h 1544126"/>
                  <a:gd name="connsiteX11" fmla="*/ 469900 w 863600"/>
                  <a:gd name="connsiteY11" fmla="*/ 320542 h 1544126"/>
                  <a:gd name="connsiteX12" fmla="*/ 469900 w 863600"/>
                  <a:gd name="connsiteY12" fmla="*/ 1196842 h 1544126"/>
                  <a:gd name="connsiteX13" fmla="*/ 622300 w 863600"/>
                  <a:gd name="connsiteY13" fmla="*/ 650742 h 1544126"/>
                  <a:gd name="connsiteX14" fmla="*/ 711200 w 863600"/>
                  <a:gd name="connsiteY14" fmla="*/ 1222242 h 1544126"/>
                  <a:gd name="connsiteX15" fmla="*/ 787400 w 863600"/>
                  <a:gd name="connsiteY15" fmla="*/ 879342 h 1544126"/>
                  <a:gd name="connsiteX16" fmla="*/ 863600 w 863600"/>
                  <a:gd name="connsiteY16" fmla="*/ 1069842 h 1544126"/>
                  <a:gd name="connsiteX0" fmla="*/ 0 w 863600"/>
                  <a:gd name="connsiteY0" fmla="*/ 1019445 h 1544529"/>
                  <a:gd name="connsiteX1" fmla="*/ 70644 w 863600"/>
                  <a:gd name="connsiteY1" fmla="*/ 379683 h 1544529"/>
                  <a:gd name="connsiteX2" fmla="*/ 139700 w 863600"/>
                  <a:gd name="connsiteY2" fmla="*/ 54245 h 1544529"/>
                  <a:gd name="connsiteX3" fmla="*/ 190500 w 863600"/>
                  <a:gd name="connsiteY3" fmla="*/ 1514745 h 1544529"/>
                  <a:gd name="connsiteX4" fmla="*/ 266700 w 863600"/>
                  <a:gd name="connsiteY4" fmla="*/ 994045 h 1544529"/>
                  <a:gd name="connsiteX5" fmla="*/ 317500 w 863600"/>
                  <a:gd name="connsiteY5" fmla="*/ 473345 h 1544529"/>
                  <a:gd name="connsiteX6" fmla="*/ 355600 w 863600"/>
                  <a:gd name="connsiteY6" fmla="*/ 701945 h 1544529"/>
                  <a:gd name="connsiteX7" fmla="*/ 342900 w 863600"/>
                  <a:gd name="connsiteY7" fmla="*/ 1286145 h 1544529"/>
                  <a:gd name="connsiteX8" fmla="*/ 342900 w 863600"/>
                  <a:gd name="connsiteY8" fmla="*/ 1375045 h 1544529"/>
                  <a:gd name="connsiteX9" fmla="*/ 419100 w 863600"/>
                  <a:gd name="connsiteY9" fmla="*/ 803545 h 1544529"/>
                  <a:gd name="connsiteX10" fmla="*/ 442913 w 863600"/>
                  <a:gd name="connsiteY10" fmla="*/ 536845 h 1544529"/>
                  <a:gd name="connsiteX11" fmla="*/ 469900 w 863600"/>
                  <a:gd name="connsiteY11" fmla="*/ 320945 h 1544529"/>
                  <a:gd name="connsiteX12" fmla="*/ 469900 w 863600"/>
                  <a:gd name="connsiteY12" fmla="*/ 1197245 h 1544529"/>
                  <a:gd name="connsiteX13" fmla="*/ 622300 w 863600"/>
                  <a:gd name="connsiteY13" fmla="*/ 651145 h 1544529"/>
                  <a:gd name="connsiteX14" fmla="*/ 711200 w 863600"/>
                  <a:gd name="connsiteY14" fmla="*/ 1222645 h 1544529"/>
                  <a:gd name="connsiteX15" fmla="*/ 787400 w 863600"/>
                  <a:gd name="connsiteY15" fmla="*/ 879745 h 1544529"/>
                  <a:gd name="connsiteX16" fmla="*/ 863600 w 863600"/>
                  <a:gd name="connsiteY16" fmla="*/ 1070245 h 1544529"/>
                  <a:gd name="connsiteX0" fmla="*/ 0 w 863600"/>
                  <a:gd name="connsiteY0" fmla="*/ 1019445 h 1544529"/>
                  <a:gd name="connsiteX1" fmla="*/ 84932 w 863600"/>
                  <a:gd name="connsiteY1" fmla="*/ 379683 h 1544529"/>
                  <a:gd name="connsiteX2" fmla="*/ 139700 w 863600"/>
                  <a:gd name="connsiteY2" fmla="*/ 54245 h 1544529"/>
                  <a:gd name="connsiteX3" fmla="*/ 190500 w 863600"/>
                  <a:gd name="connsiteY3" fmla="*/ 1514745 h 1544529"/>
                  <a:gd name="connsiteX4" fmla="*/ 266700 w 863600"/>
                  <a:gd name="connsiteY4" fmla="*/ 994045 h 1544529"/>
                  <a:gd name="connsiteX5" fmla="*/ 317500 w 863600"/>
                  <a:gd name="connsiteY5" fmla="*/ 473345 h 1544529"/>
                  <a:gd name="connsiteX6" fmla="*/ 355600 w 863600"/>
                  <a:gd name="connsiteY6" fmla="*/ 701945 h 1544529"/>
                  <a:gd name="connsiteX7" fmla="*/ 342900 w 863600"/>
                  <a:gd name="connsiteY7" fmla="*/ 1286145 h 1544529"/>
                  <a:gd name="connsiteX8" fmla="*/ 342900 w 863600"/>
                  <a:gd name="connsiteY8" fmla="*/ 1375045 h 1544529"/>
                  <a:gd name="connsiteX9" fmla="*/ 419100 w 863600"/>
                  <a:gd name="connsiteY9" fmla="*/ 803545 h 1544529"/>
                  <a:gd name="connsiteX10" fmla="*/ 442913 w 863600"/>
                  <a:gd name="connsiteY10" fmla="*/ 536845 h 1544529"/>
                  <a:gd name="connsiteX11" fmla="*/ 469900 w 863600"/>
                  <a:gd name="connsiteY11" fmla="*/ 320945 h 1544529"/>
                  <a:gd name="connsiteX12" fmla="*/ 469900 w 863600"/>
                  <a:gd name="connsiteY12" fmla="*/ 1197245 h 1544529"/>
                  <a:gd name="connsiteX13" fmla="*/ 622300 w 863600"/>
                  <a:gd name="connsiteY13" fmla="*/ 651145 h 1544529"/>
                  <a:gd name="connsiteX14" fmla="*/ 711200 w 863600"/>
                  <a:gd name="connsiteY14" fmla="*/ 1222645 h 1544529"/>
                  <a:gd name="connsiteX15" fmla="*/ 787400 w 863600"/>
                  <a:gd name="connsiteY15" fmla="*/ 879745 h 1544529"/>
                  <a:gd name="connsiteX16" fmla="*/ 863600 w 863600"/>
                  <a:gd name="connsiteY16" fmla="*/ 1070245 h 1544529"/>
                  <a:gd name="connsiteX0" fmla="*/ 0 w 863600"/>
                  <a:gd name="connsiteY0" fmla="*/ 1019678 h 1544762"/>
                  <a:gd name="connsiteX1" fmla="*/ 84932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419100 w 863600"/>
                  <a:gd name="connsiteY9" fmla="*/ 803778 h 1544762"/>
                  <a:gd name="connsiteX10" fmla="*/ 442913 w 863600"/>
                  <a:gd name="connsiteY10" fmla="*/ 537078 h 1544762"/>
                  <a:gd name="connsiteX11" fmla="*/ 469900 w 863600"/>
                  <a:gd name="connsiteY11" fmla="*/ 321178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419100 w 863600"/>
                  <a:gd name="connsiteY9" fmla="*/ 803778 h 1544762"/>
                  <a:gd name="connsiteX10" fmla="*/ 442913 w 863600"/>
                  <a:gd name="connsiteY10" fmla="*/ 537078 h 1544762"/>
                  <a:gd name="connsiteX11" fmla="*/ 469900 w 863600"/>
                  <a:gd name="connsiteY11" fmla="*/ 321178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419100 w 863600"/>
                  <a:gd name="connsiteY9" fmla="*/ 803778 h 1544762"/>
                  <a:gd name="connsiteX10" fmla="*/ 442913 w 863600"/>
                  <a:gd name="connsiteY10" fmla="*/ 537078 h 1544762"/>
                  <a:gd name="connsiteX11" fmla="*/ 457994 w 863600"/>
                  <a:gd name="connsiteY11" fmla="*/ 483103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419100 w 863600"/>
                  <a:gd name="connsiteY9" fmla="*/ 803778 h 1544762"/>
                  <a:gd name="connsiteX10" fmla="*/ 423863 w 863600"/>
                  <a:gd name="connsiteY10" fmla="*/ 537078 h 1544762"/>
                  <a:gd name="connsiteX11" fmla="*/ 457994 w 863600"/>
                  <a:gd name="connsiteY11" fmla="*/ 483103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57994 w 863600"/>
                  <a:gd name="connsiteY11" fmla="*/ 483103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53231 w 863600"/>
                  <a:gd name="connsiteY12" fmla="*/ 470404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31800 w 863600"/>
                  <a:gd name="connsiteY12" fmla="*/ 453735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65137 w 863600"/>
                  <a:gd name="connsiteY12" fmla="*/ 491835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31800 w 863600"/>
                  <a:gd name="connsiteY11" fmla="*/ 402140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31800 w 863600"/>
                  <a:gd name="connsiteY11" fmla="*/ 402140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24656 w 863600"/>
                  <a:gd name="connsiteY11" fmla="*/ 364040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19893 w 863600"/>
                  <a:gd name="connsiteY11" fmla="*/ 421190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17512 w 863600"/>
                  <a:gd name="connsiteY11" fmla="*/ 464053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22275 w 863600"/>
                  <a:gd name="connsiteY11" fmla="*/ 283078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36563 w 863600"/>
                  <a:gd name="connsiteY11" fmla="*/ 278315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863600" h="1544762">
                    <a:moveTo>
                      <a:pt x="0" y="1019678"/>
                    </a:moveTo>
                    <a:cubicBezTo>
                      <a:pt x="38100" y="781553"/>
                      <a:pt x="59268" y="543164"/>
                      <a:pt x="73026" y="379916"/>
                    </a:cubicBezTo>
                    <a:cubicBezTo>
                      <a:pt x="86784" y="216668"/>
                      <a:pt x="120121" y="-134699"/>
                      <a:pt x="139700" y="54478"/>
                    </a:cubicBezTo>
                    <a:cubicBezTo>
                      <a:pt x="159279" y="243655"/>
                      <a:pt x="169333" y="1358345"/>
                      <a:pt x="190500" y="1514978"/>
                    </a:cubicBezTo>
                    <a:cubicBezTo>
                      <a:pt x="211667" y="1671611"/>
                      <a:pt x="245533" y="1167845"/>
                      <a:pt x="266700" y="994278"/>
                    </a:cubicBezTo>
                    <a:cubicBezTo>
                      <a:pt x="287867" y="820711"/>
                      <a:pt x="302683" y="522261"/>
                      <a:pt x="317500" y="473578"/>
                    </a:cubicBezTo>
                    <a:cubicBezTo>
                      <a:pt x="332317" y="424895"/>
                      <a:pt x="351367" y="566712"/>
                      <a:pt x="355600" y="702178"/>
                    </a:cubicBezTo>
                    <a:cubicBezTo>
                      <a:pt x="359833" y="837644"/>
                      <a:pt x="345017" y="1174195"/>
                      <a:pt x="342900" y="1286378"/>
                    </a:cubicBezTo>
                    <a:cubicBezTo>
                      <a:pt x="340783" y="1398561"/>
                      <a:pt x="334566" y="1454521"/>
                      <a:pt x="342900" y="1375278"/>
                    </a:cubicBezTo>
                    <a:cubicBezTo>
                      <a:pt x="351234" y="1296035"/>
                      <a:pt x="380603" y="951019"/>
                      <a:pt x="392906" y="810922"/>
                    </a:cubicBezTo>
                    <a:cubicBezTo>
                      <a:pt x="405209" y="670825"/>
                      <a:pt x="409443" y="623465"/>
                      <a:pt x="416719" y="534697"/>
                    </a:cubicBezTo>
                    <a:cubicBezTo>
                      <a:pt x="423995" y="445929"/>
                      <a:pt x="431272" y="296968"/>
                      <a:pt x="436563" y="278315"/>
                    </a:cubicBezTo>
                    <a:cubicBezTo>
                      <a:pt x="441854" y="259662"/>
                      <a:pt x="444896" y="301335"/>
                      <a:pt x="448468" y="422779"/>
                    </a:cubicBezTo>
                    <a:cubicBezTo>
                      <a:pt x="452040" y="544223"/>
                      <a:pt x="440928" y="1159378"/>
                      <a:pt x="469900" y="1197478"/>
                    </a:cubicBezTo>
                    <a:cubicBezTo>
                      <a:pt x="498872" y="1235578"/>
                      <a:pt x="582083" y="647145"/>
                      <a:pt x="622300" y="651378"/>
                    </a:cubicBezTo>
                    <a:cubicBezTo>
                      <a:pt x="662517" y="655611"/>
                      <a:pt x="683683" y="1184778"/>
                      <a:pt x="711200" y="1222878"/>
                    </a:cubicBezTo>
                    <a:cubicBezTo>
                      <a:pt x="738717" y="1260978"/>
                      <a:pt x="762000" y="905378"/>
                      <a:pt x="787400" y="879978"/>
                    </a:cubicBezTo>
                    <a:cubicBezTo>
                      <a:pt x="812800" y="854578"/>
                      <a:pt x="838200" y="962528"/>
                      <a:pt x="863600" y="1070478"/>
                    </a:cubicBezTo>
                  </a:path>
                </a:pathLst>
              </a:custGeom>
              <a:noFill/>
              <a:ln w="952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234" name="直接连接符 233">
                <a:extLst>
                  <a:ext uri="{FF2B5EF4-FFF2-40B4-BE49-F238E27FC236}">
                    <a16:creationId xmlns:a16="http://schemas.microsoft.com/office/drawing/2014/main" id="{5E39964C-04BF-4B9F-97D5-923F578B3C3A}"/>
                  </a:ext>
                </a:extLst>
              </p:cNvPr>
              <p:cNvCxnSpPr>
                <a:cxnSpLocks/>
                <a:stCxn id="233" idx="0"/>
              </p:cNvCxnSpPr>
              <p:nvPr/>
            </p:nvCxnSpPr>
            <p:spPr>
              <a:xfrm flipH="1">
                <a:off x="7541984" y="2085067"/>
                <a:ext cx="557472" cy="5746"/>
              </a:xfrm>
              <a:prstGeom prst="line">
                <a:avLst/>
              </a:prstGeom>
              <a:ln w="95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直接连接符 234">
                <a:extLst>
                  <a:ext uri="{FF2B5EF4-FFF2-40B4-BE49-F238E27FC236}">
                    <a16:creationId xmlns:a16="http://schemas.microsoft.com/office/drawing/2014/main" id="{1E472DA5-950C-48DA-9CE9-EB7A144C1203}"/>
                  </a:ext>
                </a:extLst>
              </p:cNvPr>
              <p:cNvCxnSpPr/>
              <p:nvPr/>
            </p:nvCxnSpPr>
            <p:spPr>
              <a:xfrm flipH="1">
                <a:off x="8963052" y="2103551"/>
                <a:ext cx="286520" cy="7938"/>
              </a:xfrm>
              <a:prstGeom prst="line">
                <a:avLst/>
              </a:prstGeom>
              <a:ln w="95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0" name="组合 239">
              <a:extLst>
                <a:ext uri="{FF2B5EF4-FFF2-40B4-BE49-F238E27FC236}">
                  <a16:creationId xmlns:a16="http://schemas.microsoft.com/office/drawing/2014/main" id="{301AC15E-BFAC-499E-AC76-8F8D39709682}"/>
                </a:ext>
              </a:extLst>
            </p:cNvPr>
            <p:cNvGrpSpPr/>
            <p:nvPr/>
          </p:nvGrpSpPr>
          <p:grpSpPr>
            <a:xfrm rot="5400000" flipH="1" flipV="1">
              <a:off x="1034031" y="1270930"/>
              <a:ext cx="773172" cy="831364"/>
              <a:chOff x="4958582" y="1025021"/>
              <a:chExt cx="1436637" cy="1544762"/>
            </a:xfrm>
          </p:grpSpPr>
          <p:sp>
            <p:nvSpPr>
              <p:cNvPr id="241" name="任意多边形: 形状 240">
                <a:extLst>
                  <a:ext uri="{FF2B5EF4-FFF2-40B4-BE49-F238E27FC236}">
                    <a16:creationId xmlns:a16="http://schemas.microsoft.com/office/drawing/2014/main" id="{41AA7040-09D5-4443-B5BD-03E15C70E0FA}"/>
                  </a:ext>
                </a:extLst>
              </p:cNvPr>
              <p:cNvSpPr/>
              <p:nvPr/>
            </p:nvSpPr>
            <p:spPr>
              <a:xfrm>
                <a:off x="5245100" y="1025021"/>
                <a:ext cx="863600" cy="1544762"/>
              </a:xfrm>
              <a:custGeom>
                <a:avLst/>
                <a:gdLst>
                  <a:gd name="connsiteX0" fmla="*/ 0 w 863600"/>
                  <a:gd name="connsiteY0" fmla="*/ 1018641 h 1543725"/>
                  <a:gd name="connsiteX1" fmla="*/ 101600 w 863600"/>
                  <a:gd name="connsiteY1" fmla="*/ 383641 h 1543725"/>
                  <a:gd name="connsiteX2" fmla="*/ 139700 w 863600"/>
                  <a:gd name="connsiteY2" fmla="*/ 53441 h 1543725"/>
                  <a:gd name="connsiteX3" fmla="*/ 190500 w 863600"/>
                  <a:gd name="connsiteY3" fmla="*/ 1513941 h 1543725"/>
                  <a:gd name="connsiteX4" fmla="*/ 266700 w 863600"/>
                  <a:gd name="connsiteY4" fmla="*/ 993241 h 1543725"/>
                  <a:gd name="connsiteX5" fmla="*/ 317500 w 863600"/>
                  <a:gd name="connsiteY5" fmla="*/ 472541 h 1543725"/>
                  <a:gd name="connsiteX6" fmla="*/ 355600 w 863600"/>
                  <a:gd name="connsiteY6" fmla="*/ 701141 h 1543725"/>
                  <a:gd name="connsiteX7" fmla="*/ 342900 w 863600"/>
                  <a:gd name="connsiteY7" fmla="*/ 1285341 h 1543725"/>
                  <a:gd name="connsiteX8" fmla="*/ 342900 w 863600"/>
                  <a:gd name="connsiteY8" fmla="*/ 1374241 h 1543725"/>
                  <a:gd name="connsiteX9" fmla="*/ 419100 w 863600"/>
                  <a:gd name="connsiteY9" fmla="*/ 802741 h 1543725"/>
                  <a:gd name="connsiteX10" fmla="*/ 419100 w 863600"/>
                  <a:gd name="connsiteY10" fmla="*/ 536041 h 1543725"/>
                  <a:gd name="connsiteX11" fmla="*/ 469900 w 863600"/>
                  <a:gd name="connsiteY11" fmla="*/ 320141 h 1543725"/>
                  <a:gd name="connsiteX12" fmla="*/ 469900 w 863600"/>
                  <a:gd name="connsiteY12" fmla="*/ 1196441 h 1543725"/>
                  <a:gd name="connsiteX13" fmla="*/ 622300 w 863600"/>
                  <a:gd name="connsiteY13" fmla="*/ 650341 h 1543725"/>
                  <a:gd name="connsiteX14" fmla="*/ 711200 w 863600"/>
                  <a:gd name="connsiteY14" fmla="*/ 1221841 h 1543725"/>
                  <a:gd name="connsiteX15" fmla="*/ 787400 w 863600"/>
                  <a:gd name="connsiteY15" fmla="*/ 878941 h 1543725"/>
                  <a:gd name="connsiteX16" fmla="*/ 863600 w 863600"/>
                  <a:gd name="connsiteY16" fmla="*/ 1069441 h 1543725"/>
                  <a:gd name="connsiteX0" fmla="*/ 0 w 863600"/>
                  <a:gd name="connsiteY0" fmla="*/ 1018641 h 1543725"/>
                  <a:gd name="connsiteX1" fmla="*/ 101600 w 863600"/>
                  <a:gd name="connsiteY1" fmla="*/ 383641 h 1543725"/>
                  <a:gd name="connsiteX2" fmla="*/ 139700 w 863600"/>
                  <a:gd name="connsiteY2" fmla="*/ 53441 h 1543725"/>
                  <a:gd name="connsiteX3" fmla="*/ 190500 w 863600"/>
                  <a:gd name="connsiteY3" fmla="*/ 1513941 h 1543725"/>
                  <a:gd name="connsiteX4" fmla="*/ 266700 w 863600"/>
                  <a:gd name="connsiteY4" fmla="*/ 993241 h 1543725"/>
                  <a:gd name="connsiteX5" fmla="*/ 317500 w 863600"/>
                  <a:gd name="connsiteY5" fmla="*/ 472541 h 1543725"/>
                  <a:gd name="connsiteX6" fmla="*/ 355600 w 863600"/>
                  <a:gd name="connsiteY6" fmla="*/ 701141 h 1543725"/>
                  <a:gd name="connsiteX7" fmla="*/ 342900 w 863600"/>
                  <a:gd name="connsiteY7" fmla="*/ 1285341 h 1543725"/>
                  <a:gd name="connsiteX8" fmla="*/ 342900 w 863600"/>
                  <a:gd name="connsiteY8" fmla="*/ 1374241 h 1543725"/>
                  <a:gd name="connsiteX9" fmla="*/ 419100 w 863600"/>
                  <a:gd name="connsiteY9" fmla="*/ 802741 h 1543725"/>
                  <a:gd name="connsiteX10" fmla="*/ 442913 w 863600"/>
                  <a:gd name="connsiteY10" fmla="*/ 536041 h 1543725"/>
                  <a:gd name="connsiteX11" fmla="*/ 469900 w 863600"/>
                  <a:gd name="connsiteY11" fmla="*/ 320141 h 1543725"/>
                  <a:gd name="connsiteX12" fmla="*/ 469900 w 863600"/>
                  <a:gd name="connsiteY12" fmla="*/ 1196441 h 1543725"/>
                  <a:gd name="connsiteX13" fmla="*/ 622300 w 863600"/>
                  <a:gd name="connsiteY13" fmla="*/ 650341 h 1543725"/>
                  <a:gd name="connsiteX14" fmla="*/ 711200 w 863600"/>
                  <a:gd name="connsiteY14" fmla="*/ 1221841 h 1543725"/>
                  <a:gd name="connsiteX15" fmla="*/ 787400 w 863600"/>
                  <a:gd name="connsiteY15" fmla="*/ 878941 h 1543725"/>
                  <a:gd name="connsiteX16" fmla="*/ 863600 w 863600"/>
                  <a:gd name="connsiteY16" fmla="*/ 1069441 h 1543725"/>
                  <a:gd name="connsiteX0" fmla="*/ 0 w 863600"/>
                  <a:gd name="connsiteY0" fmla="*/ 1019042 h 1544126"/>
                  <a:gd name="connsiteX1" fmla="*/ 89694 w 863600"/>
                  <a:gd name="connsiteY1" fmla="*/ 381661 h 1544126"/>
                  <a:gd name="connsiteX2" fmla="*/ 139700 w 863600"/>
                  <a:gd name="connsiteY2" fmla="*/ 53842 h 1544126"/>
                  <a:gd name="connsiteX3" fmla="*/ 190500 w 863600"/>
                  <a:gd name="connsiteY3" fmla="*/ 1514342 h 1544126"/>
                  <a:gd name="connsiteX4" fmla="*/ 266700 w 863600"/>
                  <a:gd name="connsiteY4" fmla="*/ 993642 h 1544126"/>
                  <a:gd name="connsiteX5" fmla="*/ 317500 w 863600"/>
                  <a:gd name="connsiteY5" fmla="*/ 472942 h 1544126"/>
                  <a:gd name="connsiteX6" fmla="*/ 355600 w 863600"/>
                  <a:gd name="connsiteY6" fmla="*/ 701542 h 1544126"/>
                  <a:gd name="connsiteX7" fmla="*/ 342900 w 863600"/>
                  <a:gd name="connsiteY7" fmla="*/ 1285742 h 1544126"/>
                  <a:gd name="connsiteX8" fmla="*/ 342900 w 863600"/>
                  <a:gd name="connsiteY8" fmla="*/ 1374642 h 1544126"/>
                  <a:gd name="connsiteX9" fmla="*/ 419100 w 863600"/>
                  <a:gd name="connsiteY9" fmla="*/ 803142 h 1544126"/>
                  <a:gd name="connsiteX10" fmla="*/ 442913 w 863600"/>
                  <a:gd name="connsiteY10" fmla="*/ 536442 h 1544126"/>
                  <a:gd name="connsiteX11" fmla="*/ 469900 w 863600"/>
                  <a:gd name="connsiteY11" fmla="*/ 320542 h 1544126"/>
                  <a:gd name="connsiteX12" fmla="*/ 469900 w 863600"/>
                  <a:gd name="connsiteY12" fmla="*/ 1196842 h 1544126"/>
                  <a:gd name="connsiteX13" fmla="*/ 622300 w 863600"/>
                  <a:gd name="connsiteY13" fmla="*/ 650742 h 1544126"/>
                  <a:gd name="connsiteX14" fmla="*/ 711200 w 863600"/>
                  <a:gd name="connsiteY14" fmla="*/ 1222242 h 1544126"/>
                  <a:gd name="connsiteX15" fmla="*/ 787400 w 863600"/>
                  <a:gd name="connsiteY15" fmla="*/ 879342 h 1544126"/>
                  <a:gd name="connsiteX16" fmla="*/ 863600 w 863600"/>
                  <a:gd name="connsiteY16" fmla="*/ 1069842 h 1544126"/>
                  <a:gd name="connsiteX0" fmla="*/ 0 w 863600"/>
                  <a:gd name="connsiteY0" fmla="*/ 1019445 h 1544529"/>
                  <a:gd name="connsiteX1" fmla="*/ 70644 w 863600"/>
                  <a:gd name="connsiteY1" fmla="*/ 379683 h 1544529"/>
                  <a:gd name="connsiteX2" fmla="*/ 139700 w 863600"/>
                  <a:gd name="connsiteY2" fmla="*/ 54245 h 1544529"/>
                  <a:gd name="connsiteX3" fmla="*/ 190500 w 863600"/>
                  <a:gd name="connsiteY3" fmla="*/ 1514745 h 1544529"/>
                  <a:gd name="connsiteX4" fmla="*/ 266700 w 863600"/>
                  <a:gd name="connsiteY4" fmla="*/ 994045 h 1544529"/>
                  <a:gd name="connsiteX5" fmla="*/ 317500 w 863600"/>
                  <a:gd name="connsiteY5" fmla="*/ 473345 h 1544529"/>
                  <a:gd name="connsiteX6" fmla="*/ 355600 w 863600"/>
                  <a:gd name="connsiteY6" fmla="*/ 701945 h 1544529"/>
                  <a:gd name="connsiteX7" fmla="*/ 342900 w 863600"/>
                  <a:gd name="connsiteY7" fmla="*/ 1286145 h 1544529"/>
                  <a:gd name="connsiteX8" fmla="*/ 342900 w 863600"/>
                  <a:gd name="connsiteY8" fmla="*/ 1375045 h 1544529"/>
                  <a:gd name="connsiteX9" fmla="*/ 419100 w 863600"/>
                  <a:gd name="connsiteY9" fmla="*/ 803545 h 1544529"/>
                  <a:gd name="connsiteX10" fmla="*/ 442913 w 863600"/>
                  <a:gd name="connsiteY10" fmla="*/ 536845 h 1544529"/>
                  <a:gd name="connsiteX11" fmla="*/ 469900 w 863600"/>
                  <a:gd name="connsiteY11" fmla="*/ 320945 h 1544529"/>
                  <a:gd name="connsiteX12" fmla="*/ 469900 w 863600"/>
                  <a:gd name="connsiteY12" fmla="*/ 1197245 h 1544529"/>
                  <a:gd name="connsiteX13" fmla="*/ 622300 w 863600"/>
                  <a:gd name="connsiteY13" fmla="*/ 651145 h 1544529"/>
                  <a:gd name="connsiteX14" fmla="*/ 711200 w 863600"/>
                  <a:gd name="connsiteY14" fmla="*/ 1222645 h 1544529"/>
                  <a:gd name="connsiteX15" fmla="*/ 787400 w 863600"/>
                  <a:gd name="connsiteY15" fmla="*/ 879745 h 1544529"/>
                  <a:gd name="connsiteX16" fmla="*/ 863600 w 863600"/>
                  <a:gd name="connsiteY16" fmla="*/ 1070245 h 1544529"/>
                  <a:gd name="connsiteX0" fmla="*/ 0 w 863600"/>
                  <a:gd name="connsiteY0" fmla="*/ 1019445 h 1544529"/>
                  <a:gd name="connsiteX1" fmla="*/ 84932 w 863600"/>
                  <a:gd name="connsiteY1" fmla="*/ 379683 h 1544529"/>
                  <a:gd name="connsiteX2" fmla="*/ 139700 w 863600"/>
                  <a:gd name="connsiteY2" fmla="*/ 54245 h 1544529"/>
                  <a:gd name="connsiteX3" fmla="*/ 190500 w 863600"/>
                  <a:gd name="connsiteY3" fmla="*/ 1514745 h 1544529"/>
                  <a:gd name="connsiteX4" fmla="*/ 266700 w 863600"/>
                  <a:gd name="connsiteY4" fmla="*/ 994045 h 1544529"/>
                  <a:gd name="connsiteX5" fmla="*/ 317500 w 863600"/>
                  <a:gd name="connsiteY5" fmla="*/ 473345 h 1544529"/>
                  <a:gd name="connsiteX6" fmla="*/ 355600 w 863600"/>
                  <a:gd name="connsiteY6" fmla="*/ 701945 h 1544529"/>
                  <a:gd name="connsiteX7" fmla="*/ 342900 w 863600"/>
                  <a:gd name="connsiteY7" fmla="*/ 1286145 h 1544529"/>
                  <a:gd name="connsiteX8" fmla="*/ 342900 w 863600"/>
                  <a:gd name="connsiteY8" fmla="*/ 1375045 h 1544529"/>
                  <a:gd name="connsiteX9" fmla="*/ 419100 w 863600"/>
                  <a:gd name="connsiteY9" fmla="*/ 803545 h 1544529"/>
                  <a:gd name="connsiteX10" fmla="*/ 442913 w 863600"/>
                  <a:gd name="connsiteY10" fmla="*/ 536845 h 1544529"/>
                  <a:gd name="connsiteX11" fmla="*/ 469900 w 863600"/>
                  <a:gd name="connsiteY11" fmla="*/ 320945 h 1544529"/>
                  <a:gd name="connsiteX12" fmla="*/ 469900 w 863600"/>
                  <a:gd name="connsiteY12" fmla="*/ 1197245 h 1544529"/>
                  <a:gd name="connsiteX13" fmla="*/ 622300 w 863600"/>
                  <a:gd name="connsiteY13" fmla="*/ 651145 h 1544529"/>
                  <a:gd name="connsiteX14" fmla="*/ 711200 w 863600"/>
                  <a:gd name="connsiteY14" fmla="*/ 1222645 h 1544529"/>
                  <a:gd name="connsiteX15" fmla="*/ 787400 w 863600"/>
                  <a:gd name="connsiteY15" fmla="*/ 879745 h 1544529"/>
                  <a:gd name="connsiteX16" fmla="*/ 863600 w 863600"/>
                  <a:gd name="connsiteY16" fmla="*/ 1070245 h 1544529"/>
                  <a:gd name="connsiteX0" fmla="*/ 0 w 863600"/>
                  <a:gd name="connsiteY0" fmla="*/ 1019678 h 1544762"/>
                  <a:gd name="connsiteX1" fmla="*/ 84932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419100 w 863600"/>
                  <a:gd name="connsiteY9" fmla="*/ 803778 h 1544762"/>
                  <a:gd name="connsiteX10" fmla="*/ 442913 w 863600"/>
                  <a:gd name="connsiteY10" fmla="*/ 537078 h 1544762"/>
                  <a:gd name="connsiteX11" fmla="*/ 469900 w 863600"/>
                  <a:gd name="connsiteY11" fmla="*/ 321178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419100 w 863600"/>
                  <a:gd name="connsiteY9" fmla="*/ 803778 h 1544762"/>
                  <a:gd name="connsiteX10" fmla="*/ 442913 w 863600"/>
                  <a:gd name="connsiteY10" fmla="*/ 537078 h 1544762"/>
                  <a:gd name="connsiteX11" fmla="*/ 469900 w 863600"/>
                  <a:gd name="connsiteY11" fmla="*/ 321178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419100 w 863600"/>
                  <a:gd name="connsiteY9" fmla="*/ 803778 h 1544762"/>
                  <a:gd name="connsiteX10" fmla="*/ 442913 w 863600"/>
                  <a:gd name="connsiteY10" fmla="*/ 537078 h 1544762"/>
                  <a:gd name="connsiteX11" fmla="*/ 457994 w 863600"/>
                  <a:gd name="connsiteY11" fmla="*/ 483103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419100 w 863600"/>
                  <a:gd name="connsiteY9" fmla="*/ 803778 h 1544762"/>
                  <a:gd name="connsiteX10" fmla="*/ 423863 w 863600"/>
                  <a:gd name="connsiteY10" fmla="*/ 537078 h 1544762"/>
                  <a:gd name="connsiteX11" fmla="*/ 457994 w 863600"/>
                  <a:gd name="connsiteY11" fmla="*/ 483103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57994 w 863600"/>
                  <a:gd name="connsiteY11" fmla="*/ 483103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69900 w 863600"/>
                  <a:gd name="connsiteY12" fmla="*/ 1197478 h 1544762"/>
                  <a:gd name="connsiteX13" fmla="*/ 622300 w 863600"/>
                  <a:gd name="connsiteY13" fmla="*/ 651378 h 1544762"/>
                  <a:gd name="connsiteX14" fmla="*/ 711200 w 863600"/>
                  <a:gd name="connsiteY14" fmla="*/ 1222878 h 1544762"/>
                  <a:gd name="connsiteX15" fmla="*/ 787400 w 863600"/>
                  <a:gd name="connsiteY15" fmla="*/ 879978 h 1544762"/>
                  <a:gd name="connsiteX16" fmla="*/ 863600 w 863600"/>
                  <a:gd name="connsiteY16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53231 w 863600"/>
                  <a:gd name="connsiteY12" fmla="*/ 470404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31800 w 863600"/>
                  <a:gd name="connsiteY12" fmla="*/ 453735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65137 w 863600"/>
                  <a:gd name="connsiteY12" fmla="*/ 491835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48469 w 863600"/>
                  <a:gd name="connsiteY11" fmla="*/ 468815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23863 w 863600"/>
                  <a:gd name="connsiteY10" fmla="*/ 537078 h 1544762"/>
                  <a:gd name="connsiteX11" fmla="*/ 431800 w 863600"/>
                  <a:gd name="connsiteY11" fmla="*/ 402140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31800 w 863600"/>
                  <a:gd name="connsiteY11" fmla="*/ 402140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24656 w 863600"/>
                  <a:gd name="connsiteY11" fmla="*/ 364040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19893 w 863600"/>
                  <a:gd name="connsiteY11" fmla="*/ 421190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17512 w 863600"/>
                  <a:gd name="connsiteY11" fmla="*/ 464053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22275 w 863600"/>
                  <a:gd name="connsiteY11" fmla="*/ 283078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  <a:gd name="connsiteX0" fmla="*/ 0 w 863600"/>
                  <a:gd name="connsiteY0" fmla="*/ 1019678 h 1544762"/>
                  <a:gd name="connsiteX1" fmla="*/ 73026 w 863600"/>
                  <a:gd name="connsiteY1" fmla="*/ 379916 h 1544762"/>
                  <a:gd name="connsiteX2" fmla="*/ 139700 w 863600"/>
                  <a:gd name="connsiteY2" fmla="*/ 54478 h 1544762"/>
                  <a:gd name="connsiteX3" fmla="*/ 190500 w 863600"/>
                  <a:gd name="connsiteY3" fmla="*/ 1514978 h 1544762"/>
                  <a:gd name="connsiteX4" fmla="*/ 266700 w 863600"/>
                  <a:gd name="connsiteY4" fmla="*/ 994278 h 1544762"/>
                  <a:gd name="connsiteX5" fmla="*/ 317500 w 863600"/>
                  <a:gd name="connsiteY5" fmla="*/ 473578 h 1544762"/>
                  <a:gd name="connsiteX6" fmla="*/ 355600 w 863600"/>
                  <a:gd name="connsiteY6" fmla="*/ 702178 h 1544762"/>
                  <a:gd name="connsiteX7" fmla="*/ 342900 w 863600"/>
                  <a:gd name="connsiteY7" fmla="*/ 1286378 h 1544762"/>
                  <a:gd name="connsiteX8" fmla="*/ 342900 w 863600"/>
                  <a:gd name="connsiteY8" fmla="*/ 1375278 h 1544762"/>
                  <a:gd name="connsiteX9" fmla="*/ 392906 w 863600"/>
                  <a:gd name="connsiteY9" fmla="*/ 810922 h 1544762"/>
                  <a:gd name="connsiteX10" fmla="*/ 416719 w 863600"/>
                  <a:gd name="connsiteY10" fmla="*/ 534697 h 1544762"/>
                  <a:gd name="connsiteX11" fmla="*/ 436563 w 863600"/>
                  <a:gd name="connsiteY11" fmla="*/ 278315 h 1544762"/>
                  <a:gd name="connsiteX12" fmla="*/ 448468 w 863600"/>
                  <a:gd name="connsiteY12" fmla="*/ 422779 h 1544762"/>
                  <a:gd name="connsiteX13" fmla="*/ 469900 w 863600"/>
                  <a:gd name="connsiteY13" fmla="*/ 1197478 h 1544762"/>
                  <a:gd name="connsiteX14" fmla="*/ 622300 w 863600"/>
                  <a:gd name="connsiteY14" fmla="*/ 651378 h 1544762"/>
                  <a:gd name="connsiteX15" fmla="*/ 711200 w 863600"/>
                  <a:gd name="connsiteY15" fmla="*/ 1222878 h 1544762"/>
                  <a:gd name="connsiteX16" fmla="*/ 787400 w 863600"/>
                  <a:gd name="connsiteY16" fmla="*/ 879978 h 1544762"/>
                  <a:gd name="connsiteX17" fmla="*/ 863600 w 863600"/>
                  <a:gd name="connsiteY17" fmla="*/ 1070478 h 15447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863600" h="1544762">
                    <a:moveTo>
                      <a:pt x="0" y="1019678"/>
                    </a:moveTo>
                    <a:cubicBezTo>
                      <a:pt x="38100" y="781553"/>
                      <a:pt x="59268" y="543164"/>
                      <a:pt x="73026" y="379916"/>
                    </a:cubicBezTo>
                    <a:cubicBezTo>
                      <a:pt x="86784" y="216668"/>
                      <a:pt x="120121" y="-134699"/>
                      <a:pt x="139700" y="54478"/>
                    </a:cubicBezTo>
                    <a:cubicBezTo>
                      <a:pt x="159279" y="243655"/>
                      <a:pt x="169333" y="1358345"/>
                      <a:pt x="190500" y="1514978"/>
                    </a:cubicBezTo>
                    <a:cubicBezTo>
                      <a:pt x="211667" y="1671611"/>
                      <a:pt x="245533" y="1167845"/>
                      <a:pt x="266700" y="994278"/>
                    </a:cubicBezTo>
                    <a:cubicBezTo>
                      <a:pt x="287867" y="820711"/>
                      <a:pt x="302683" y="522261"/>
                      <a:pt x="317500" y="473578"/>
                    </a:cubicBezTo>
                    <a:cubicBezTo>
                      <a:pt x="332317" y="424895"/>
                      <a:pt x="351367" y="566712"/>
                      <a:pt x="355600" y="702178"/>
                    </a:cubicBezTo>
                    <a:cubicBezTo>
                      <a:pt x="359833" y="837644"/>
                      <a:pt x="345017" y="1174195"/>
                      <a:pt x="342900" y="1286378"/>
                    </a:cubicBezTo>
                    <a:cubicBezTo>
                      <a:pt x="340783" y="1398561"/>
                      <a:pt x="334566" y="1454521"/>
                      <a:pt x="342900" y="1375278"/>
                    </a:cubicBezTo>
                    <a:cubicBezTo>
                      <a:pt x="351234" y="1296035"/>
                      <a:pt x="380603" y="951019"/>
                      <a:pt x="392906" y="810922"/>
                    </a:cubicBezTo>
                    <a:cubicBezTo>
                      <a:pt x="405209" y="670825"/>
                      <a:pt x="409443" y="623465"/>
                      <a:pt x="416719" y="534697"/>
                    </a:cubicBezTo>
                    <a:cubicBezTo>
                      <a:pt x="423995" y="445929"/>
                      <a:pt x="431272" y="296968"/>
                      <a:pt x="436563" y="278315"/>
                    </a:cubicBezTo>
                    <a:cubicBezTo>
                      <a:pt x="441854" y="259662"/>
                      <a:pt x="444896" y="301335"/>
                      <a:pt x="448468" y="422779"/>
                    </a:cubicBezTo>
                    <a:cubicBezTo>
                      <a:pt x="452040" y="544223"/>
                      <a:pt x="440928" y="1159378"/>
                      <a:pt x="469900" y="1197478"/>
                    </a:cubicBezTo>
                    <a:cubicBezTo>
                      <a:pt x="498872" y="1235578"/>
                      <a:pt x="582083" y="647145"/>
                      <a:pt x="622300" y="651378"/>
                    </a:cubicBezTo>
                    <a:cubicBezTo>
                      <a:pt x="662517" y="655611"/>
                      <a:pt x="683683" y="1184778"/>
                      <a:pt x="711200" y="1222878"/>
                    </a:cubicBezTo>
                    <a:cubicBezTo>
                      <a:pt x="738717" y="1260978"/>
                      <a:pt x="762000" y="905378"/>
                      <a:pt x="787400" y="879978"/>
                    </a:cubicBezTo>
                    <a:cubicBezTo>
                      <a:pt x="812800" y="854578"/>
                      <a:pt x="838200" y="962528"/>
                      <a:pt x="863600" y="1070478"/>
                    </a:cubicBezTo>
                  </a:path>
                </a:pathLst>
              </a:custGeom>
              <a:noFill/>
              <a:ln w="952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242" name="直接连接符 241">
                <a:extLst>
                  <a:ext uri="{FF2B5EF4-FFF2-40B4-BE49-F238E27FC236}">
                    <a16:creationId xmlns:a16="http://schemas.microsoft.com/office/drawing/2014/main" id="{3CB55846-1BA3-4E92-BA7F-9C38BB3AC638}"/>
                  </a:ext>
                </a:extLst>
              </p:cNvPr>
              <p:cNvCxnSpPr>
                <a:cxnSpLocks/>
                <a:stCxn id="241" idx="0"/>
              </p:cNvCxnSpPr>
              <p:nvPr/>
            </p:nvCxnSpPr>
            <p:spPr>
              <a:xfrm flipH="1">
                <a:off x="4958582" y="2044699"/>
                <a:ext cx="286518" cy="7939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直接连接符 242">
                <a:extLst>
                  <a:ext uri="{FF2B5EF4-FFF2-40B4-BE49-F238E27FC236}">
                    <a16:creationId xmlns:a16="http://schemas.microsoft.com/office/drawing/2014/main" id="{40AEEEF4-38E9-4C20-8C89-40E9948589AD}"/>
                  </a:ext>
                </a:extLst>
              </p:cNvPr>
              <p:cNvCxnSpPr/>
              <p:nvPr/>
            </p:nvCxnSpPr>
            <p:spPr>
              <a:xfrm flipH="1">
                <a:off x="6108700" y="2087911"/>
                <a:ext cx="286519" cy="7939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6" name="组合 305">
              <a:extLst>
                <a:ext uri="{FF2B5EF4-FFF2-40B4-BE49-F238E27FC236}">
                  <a16:creationId xmlns:a16="http://schemas.microsoft.com/office/drawing/2014/main" id="{8012F865-9939-41E1-B0FB-ED9DBBFA6A0A}"/>
                </a:ext>
              </a:extLst>
            </p:cNvPr>
            <p:cNvGrpSpPr/>
            <p:nvPr/>
          </p:nvGrpSpPr>
          <p:grpSpPr>
            <a:xfrm rot="9578617" flipH="1" flipV="1">
              <a:off x="1909116" y="167319"/>
              <a:ext cx="335413" cy="388424"/>
              <a:chOff x="5258633" y="775855"/>
              <a:chExt cx="583340" cy="675535"/>
            </a:xfrm>
          </p:grpSpPr>
          <p:sp>
            <p:nvSpPr>
              <p:cNvPr id="307" name="矩形 306">
                <a:extLst>
                  <a:ext uri="{FF2B5EF4-FFF2-40B4-BE49-F238E27FC236}">
                    <a16:creationId xmlns:a16="http://schemas.microsoft.com/office/drawing/2014/main" id="{158394FF-382D-4A65-B910-4056F0189234}"/>
                  </a:ext>
                </a:extLst>
              </p:cNvPr>
              <p:cNvSpPr/>
              <p:nvPr/>
            </p:nvSpPr>
            <p:spPr>
              <a:xfrm>
                <a:off x="5393823" y="775855"/>
                <a:ext cx="313989" cy="85725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08" name="梯形 307">
                <a:extLst>
                  <a:ext uri="{FF2B5EF4-FFF2-40B4-BE49-F238E27FC236}">
                    <a16:creationId xmlns:a16="http://schemas.microsoft.com/office/drawing/2014/main" id="{250B68D0-948B-4B09-95A9-688C7064440B}"/>
                  </a:ext>
                </a:extLst>
              </p:cNvPr>
              <p:cNvSpPr/>
              <p:nvPr/>
            </p:nvSpPr>
            <p:spPr>
              <a:xfrm>
                <a:off x="5290988" y="861580"/>
                <a:ext cx="519112" cy="205813"/>
              </a:xfrm>
              <a:prstGeom prst="trapezoid">
                <a:avLst>
                  <a:gd name="adj" fmla="val 50000"/>
                </a:avLst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310" name="组合 309">
                <a:extLst>
                  <a:ext uri="{FF2B5EF4-FFF2-40B4-BE49-F238E27FC236}">
                    <a16:creationId xmlns:a16="http://schemas.microsoft.com/office/drawing/2014/main" id="{94BA8559-66CA-4EC0-8581-0234C0895EFB}"/>
                  </a:ext>
                </a:extLst>
              </p:cNvPr>
              <p:cNvGrpSpPr/>
              <p:nvPr/>
            </p:nvGrpSpPr>
            <p:grpSpPr>
              <a:xfrm rot="5610853">
                <a:off x="5255889" y="865307"/>
                <a:ext cx="588827" cy="583340"/>
                <a:chOff x="6035483" y="2426275"/>
                <a:chExt cx="923001" cy="914400"/>
              </a:xfrm>
            </p:grpSpPr>
            <p:sp>
              <p:nvSpPr>
                <p:cNvPr id="312" name="弧形 311">
                  <a:extLst>
                    <a:ext uri="{FF2B5EF4-FFF2-40B4-BE49-F238E27FC236}">
                      <a16:creationId xmlns:a16="http://schemas.microsoft.com/office/drawing/2014/main" id="{A1E431CE-BAEC-4D87-858E-6163B24021FB}"/>
                    </a:ext>
                  </a:extLst>
                </p:cNvPr>
                <p:cNvSpPr/>
                <p:nvPr/>
              </p:nvSpPr>
              <p:spPr>
                <a:xfrm rot="2563549">
                  <a:off x="6044084" y="2426275"/>
                  <a:ext cx="914400" cy="914400"/>
                </a:xfrm>
                <a:prstGeom prst="arc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13" name="弧形 312">
                  <a:extLst>
                    <a:ext uri="{FF2B5EF4-FFF2-40B4-BE49-F238E27FC236}">
                      <a16:creationId xmlns:a16="http://schemas.microsoft.com/office/drawing/2014/main" id="{396A7372-D910-4A71-8152-E771536CDF63}"/>
                    </a:ext>
                  </a:extLst>
                </p:cNvPr>
                <p:cNvSpPr/>
                <p:nvPr/>
              </p:nvSpPr>
              <p:spPr>
                <a:xfrm rot="2563549">
                  <a:off x="6035483" y="2530211"/>
                  <a:ext cx="724355" cy="724355"/>
                </a:xfrm>
                <a:prstGeom prst="arc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14" name="弧形 313">
                  <a:extLst>
                    <a:ext uri="{FF2B5EF4-FFF2-40B4-BE49-F238E27FC236}">
                      <a16:creationId xmlns:a16="http://schemas.microsoft.com/office/drawing/2014/main" id="{77AD3787-ED45-42AF-BA74-1C724AB56258}"/>
                    </a:ext>
                  </a:extLst>
                </p:cNvPr>
                <p:cNvSpPr/>
                <p:nvPr/>
              </p:nvSpPr>
              <p:spPr>
                <a:xfrm rot="2563549">
                  <a:off x="6076435" y="2651188"/>
                  <a:ext cx="482399" cy="482399"/>
                </a:xfrm>
                <a:prstGeom prst="arc">
                  <a:avLst/>
                </a:prstGeom>
                <a:ln w="9525">
                  <a:solidFill>
                    <a:schemeClr val="tx1">
                      <a:lumMod val="85000"/>
                      <a:lumOff val="1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62" name="右中括号 61">
              <a:extLst>
                <a:ext uri="{FF2B5EF4-FFF2-40B4-BE49-F238E27FC236}">
                  <a16:creationId xmlns:a16="http://schemas.microsoft.com/office/drawing/2014/main" id="{1DEB0987-1112-4CFB-A839-AAC1FED4F392}"/>
                </a:ext>
              </a:extLst>
            </p:cNvPr>
            <p:cNvSpPr/>
            <p:nvPr/>
          </p:nvSpPr>
          <p:spPr>
            <a:xfrm rot="1787113" flipH="1">
              <a:off x="1777386" y="283566"/>
              <a:ext cx="55971" cy="971842"/>
            </a:xfrm>
            <a:prstGeom prst="rightBracket">
              <a:avLst>
                <a:gd name="adj" fmla="val 107675"/>
              </a:avLst>
            </a:prstGeom>
            <a:ln w="9525">
              <a:solidFill>
                <a:srgbClr val="ADB9C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265" name="直接连接符 264">
              <a:extLst>
                <a:ext uri="{FF2B5EF4-FFF2-40B4-BE49-F238E27FC236}">
                  <a16:creationId xmlns:a16="http://schemas.microsoft.com/office/drawing/2014/main" id="{C40F6350-59E6-41DE-958C-33A115E96F4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72915" y="1288773"/>
              <a:ext cx="1676546" cy="0"/>
            </a:xfrm>
            <a:prstGeom prst="line">
              <a:avLst/>
            </a:prstGeom>
            <a:ln w="9525">
              <a:solidFill>
                <a:schemeClr val="tx2">
                  <a:lumMod val="40000"/>
                  <a:lumOff val="6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直接连接符 265">
              <a:extLst>
                <a:ext uri="{FF2B5EF4-FFF2-40B4-BE49-F238E27FC236}">
                  <a16:creationId xmlns:a16="http://schemas.microsoft.com/office/drawing/2014/main" id="{3DB07C0B-00FA-4A8C-AC2A-39E0D5D57D9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77193" y="381185"/>
              <a:ext cx="1159965" cy="892393"/>
            </a:xfrm>
            <a:prstGeom prst="line">
              <a:avLst/>
            </a:prstGeom>
            <a:ln w="9525">
              <a:solidFill>
                <a:schemeClr val="tx2">
                  <a:lumMod val="40000"/>
                  <a:lumOff val="6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直接连接符 267">
              <a:extLst>
                <a:ext uri="{FF2B5EF4-FFF2-40B4-BE49-F238E27FC236}">
                  <a16:creationId xmlns:a16="http://schemas.microsoft.com/office/drawing/2014/main" id="{A671D08F-3DA1-471E-996E-C2AAEAADCB4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72915" y="387920"/>
              <a:ext cx="491975" cy="885658"/>
            </a:xfrm>
            <a:prstGeom prst="line">
              <a:avLst/>
            </a:prstGeom>
            <a:ln w="9525">
              <a:solidFill>
                <a:schemeClr val="tx2">
                  <a:lumMod val="40000"/>
                  <a:lumOff val="6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5" name="文本框 284">
              <a:extLst>
                <a:ext uri="{FF2B5EF4-FFF2-40B4-BE49-F238E27FC236}">
                  <a16:creationId xmlns:a16="http://schemas.microsoft.com/office/drawing/2014/main" id="{6A8CCE4F-0244-42E5-A7C2-31AA2044E694}"/>
                </a:ext>
              </a:extLst>
            </p:cNvPr>
            <p:cNvSpPr txBox="1"/>
            <p:nvPr/>
          </p:nvSpPr>
          <p:spPr>
            <a:xfrm flipH="1">
              <a:off x="1032574" y="1110485"/>
              <a:ext cx="405782" cy="19467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ight</a:t>
              </a:r>
              <a:endParaRPr lang="zh-CN" altLang="en-US" sz="1400" b="1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文本框 300">
              <a:extLst>
                <a:ext uri="{FF2B5EF4-FFF2-40B4-BE49-F238E27FC236}">
                  <a16:creationId xmlns:a16="http://schemas.microsoft.com/office/drawing/2014/main" id="{A17F8DBE-8F51-4A81-8BDE-E043E859226D}"/>
                </a:ext>
              </a:extLst>
            </p:cNvPr>
            <p:cNvSpPr txBox="1"/>
            <p:nvPr/>
          </p:nvSpPr>
          <p:spPr>
            <a:xfrm flipH="1">
              <a:off x="3419382" y="1119567"/>
              <a:ext cx="323652" cy="19467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solidFill>
                    <a:srgbClr val="EB292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ft</a:t>
              </a:r>
              <a:endParaRPr lang="zh-CN" altLang="en-US" sz="1400" b="1" dirty="0">
                <a:solidFill>
                  <a:srgbClr val="EB292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椭圆 29">
              <a:extLst>
                <a:ext uri="{FF2B5EF4-FFF2-40B4-BE49-F238E27FC236}">
                  <a16:creationId xmlns:a16="http://schemas.microsoft.com/office/drawing/2014/main" id="{2294F98C-513E-4811-85D9-A32CC7DC8E16}"/>
                </a:ext>
              </a:extLst>
            </p:cNvPr>
            <p:cNvSpPr/>
            <p:nvPr/>
          </p:nvSpPr>
          <p:spPr>
            <a:xfrm rot="16200000" flipH="1">
              <a:off x="1498847" y="1194672"/>
              <a:ext cx="186029" cy="186029"/>
            </a:xfrm>
            <a:prstGeom prst="ellipse">
              <a:avLst/>
            </a:prstGeom>
            <a:solidFill>
              <a:schemeClr val="accent5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2" name="椭圆 301">
              <a:extLst>
                <a:ext uri="{FF2B5EF4-FFF2-40B4-BE49-F238E27FC236}">
                  <a16:creationId xmlns:a16="http://schemas.microsoft.com/office/drawing/2014/main" id="{17E9EAB2-2783-4FE6-A742-622071A857F6}"/>
                </a:ext>
              </a:extLst>
            </p:cNvPr>
            <p:cNvSpPr/>
            <p:nvPr/>
          </p:nvSpPr>
          <p:spPr>
            <a:xfrm rot="16200000" flipH="1">
              <a:off x="3141889" y="1215319"/>
              <a:ext cx="186029" cy="186029"/>
            </a:xfrm>
            <a:prstGeom prst="ellipse">
              <a:avLst/>
            </a:prstGeom>
            <a:solidFill>
              <a:srgbClr val="EB292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15" name="文本框 314">
                  <a:extLst>
                    <a:ext uri="{FF2B5EF4-FFF2-40B4-BE49-F238E27FC236}">
                      <a16:creationId xmlns:a16="http://schemas.microsoft.com/office/drawing/2014/main" id="{614E3C8A-D6AF-417F-96C6-4A3B29E01EB3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2009806" y="969986"/>
                  <a:ext cx="248619" cy="233613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zh-CN" altLang="en-US" b="1" i="1" dirty="0"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  <m:t>𝜽</m:t>
                        </m:r>
                      </m:oMath>
                    </m:oMathPara>
                  </a14:m>
                  <a:endParaRPr lang="zh-CN" alt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315" name="文本框 314">
                  <a:extLst>
                    <a:ext uri="{FF2B5EF4-FFF2-40B4-BE49-F238E27FC236}">
                      <a16:creationId xmlns:a16="http://schemas.microsoft.com/office/drawing/2014/main" id="{614E3C8A-D6AF-417F-96C6-4A3B29E01EB3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 rot="16200000" flipH="1">
                  <a:off x="2009806" y="969986"/>
                  <a:ext cx="248619" cy="233613"/>
                </a:xfrm>
                <a:prstGeom prst="rect">
                  <a:avLst/>
                </a:prstGeom>
                <a:blipFill>
                  <a:blip r:embed="rId10"/>
                  <a:stretch>
                    <a:fillRect/>
                  </a:stretch>
                </a:blipFill>
                <a:ln w="9525">
                  <a:noFill/>
                </a:ln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36" name="弧形 35">
              <a:extLst>
                <a:ext uri="{FF2B5EF4-FFF2-40B4-BE49-F238E27FC236}">
                  <a16:creationId xmlns:a16="http://schemas.microsoft.com/office/drawing/2014/main" id="{41A7FC20-AD4F-4E12-9FD3-8CABF2137346}"/>
                </a:ext>
              </a:extLst>
            </p:cNvPr>
            <p:cNvSpPr/>
            <p:nvPr/>
          </p:nvSpPr>
          <p:spPr>
            <a:xfrm rot="18012775" flipH="1">
              <a:off x="2192197" y="1141420"/>
              <a:ext cx="235438" cy="138026"/>
            </a:xfrm>
            <a:prstGeom prst="arc">
              <a:avLst>
                <a:gd name="adj1" fmla="val 12230240"/>
                <a:gd name="adj2" fmla="val 20505769"/>
              </a:avLst>
            </a:prstGeom>
            <a:ln w="9525">
              <a:solidFill>
                <a:schemeClr val="accent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5" name="右中括号 404">
              <a:extLst>
                <a:ext uri="{FF2B5EF4-FFF2-40B4-BE49-F238E27FC236}">
                  <a16:creationId xmlns:a16="http://schemas.microsoft.com/office/drawing/2014/main" id="{0D852DFF-2CC6-48F9-9D2D-A60D2E85F67D}"/>
                </a:ext>
              </a:extLst>
            </p:cNvPr>
            <p:cNvSpPr/>
            <p:nvPr/>
          </p:nvSpPr>
          <p:spPr>
            <a:xfrm rot="7663947" flipH="1">
              <a:off x="2645471" y="39799"/>
              <a:ext cx="55971" cy="1442547"/>
            </a:xfrm>
            <a:prstGeom prst="rightBracket">
              <a:avLst>
                <a:gd name="adj" fmla="val 107675"/>
              </a:avLst>
            </a:prstGeom>
            <a:ln w="9525">
              <a:solidFill>
                <a:srgbClr val="ADB9C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9" name="文本框 248">
              <a:extLst>
                <a:ext uri="{FF2B5EF4-FFF2-40B4-BE49-F238E27FC236}">
                  <a16:creationId xmlns:a16="http://schemas.microsoft.com/office/drawing/2014/main" id="{BB88F77C-805A-4CB7-88C8-36456A1B2B71}"/>
                </a:ext>
              </a:extLst>
            </p:cNvPr>
            <p:cNvSpPr txBox="1"/>
            <p:nvPr/>
          </p:nvSpPr>
          <p:spPr>
            <a:xfrm rot="10800000" flipH="1" flipV="1">
              <a:off x="2216710" y="1758604"/>
              <a:ext cx="352043" cy="2336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TD</a:t>
              </a:r>
              <a:endParaRPr lang="zh-CN" altLang="en-US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3" name="直接连接符 382">
              <a:extLst>
                <a:ext uri="{FF2B5EF4-FFF2-40B4-BE49-F238E27FC236}">
                  <a16:creationId xmlns:a16="http://schemas.microsoft.com/office/drawing/2014/main" id="{2CD3AC68-B3B6-4BF6-8B43-EBF7103DD404}"/>
                </a:ext>
              </a:extLst>
            </p:cNvPr>
            <p:cNvCxnSpPr>
              <a:cxnSpLocks/>
              <a:endCxn id="62" idx="0"/>
            </p:cNvCxnSpPr>
            <p:nvPr/>
          </p:nvCxnSpPr>
          <p:spPr>
            <a:xfrm flipH="1" flipV="1">
              <a:off x="2071041" y="361661"/>
              <a:ext cx="336178" cy="906822"/>
            </a:xfrm>
            <a:prstGeom prst="line">
              <a:avLst/>
            </a:prstGeom>
            <a:ln w="9525">
              <a:solidFill>
                <a:schemeClr val="tx2">
                  <a:lumMod val="40000"/>
                  <a:lumOff val="6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3288540A-ACFE-4A35-902B-0512FFB397B8}"/>
              </a:ext>
            </a:extLst>
          </p:cNvPr>
          <p:cNvSpPr txBox="1"/>
          <p:nvPr/>
        </p:nvSpPr>
        <p:spPr>
          <a:xfrm>
            <a:off x="7083926" y="2911932"/>
            <a:ext cx="135838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S</a:t>
            </a:r>
          </a:p>
          <a:p>
            <a:pPr algn="ctr"/>
            <a:r>
              <a:rPr lang="en-US" altLang="zh-CN" sz="14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rcuit</a:t>
            </a:r>
            <a:endParaRPr lang="zh-CN" altLang="en-US" sz="1400" b="1" dirty="0">
              <a:solidFill>
                <a:schemeClr val="bg2">
                  <a:lumMod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7" name="图片 376">
            <a:extLst>
              <a:ext uri="{FF2B5EF4-FFF2-40B4-BE49-F238E27FC236}">
                <a16:creationId xmlns:a16="http://schemas.microsoft.com/office/drawing/2014/main" id="{2CB88692-E8BF-46F4-9D34-49BE5F70D34E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duotone>
              <a:schemeClr val="bg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3" t="24138" r="77229" b="46508"/>
          <a:stretch/>
        </p:blipFill>
        <p:spPr>
          <a:xfrm>
            <a:off x="2407026" y="5837989"/>
            <a:ext cx="768157" cy="1679725"/>
          </a:xfrm>
          <a:prstGeom prst="rect">
            <a:avLst/>
          </a:prstGeom>
          <a:ln w="9525">
            <a:noFill/>
          </a:ln>
        </p:spPr>
      </p:pic>
      <p:pic>
        <p:nvPicPr>
          <p:cNvPr id="378" name="图片 377">
            <a:extLst>
              <a:ext uri="{FF2B5EF4-FFF2-40B4-BE49-F238E27FC236}">
                <a16:creationId xmlns:a16="http://schemas.microsoft.com/office/drawing/2014/main" id="{D8F7E88A-BC5E-4E37-A620-26186A299B7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duotone>
              <a:schemeClr val="bg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3" t="24138" r="77229" b="46508"/>
          <a:stretch/>
        </p:blipFill>
        <p:spPr>
          <a:xfrm flipH="1">
            <a:off x="3170541" y="5837987"/>
            <a:ext cx="768157" cy="1679725"/>
          </a:xfrm>
          <a:prstGeom prst="rect">
            <a:avLst/>
          </a:prstGeom>
          <a:ln w="9525">
            <a:noFill/>
          </a:ln>
        </p:spPr>
      </p:pic>
      <p:cxnSp>
        <p:nvCxnSpPr>
          <p:cNvPr id="379" name="直接连接符 378">
            <a:extLst>
              <a:ext uri="{FF2B5EF4-FFF2-40B4-BE49-F238E27FC236}">
                <a16:creationId xmlns:a16="http://schemas.microsoft.com/office/drawing/2014/main" id="{549A46F8-5823-4AA5-B295-9100AC81A543}"/>
              </a:ext>
            </a:extLst>
          </p:cNvPr>
          <p:cNvCxnSpPr>
            <a:cxnSpLocks/>
          </p:cNvCxnSpPr>
          <p:nvPr/>
        </p:nvCxnSpPr>
        <p:spPr>
          <a:xfrm flipV="1">
            <a:off x="3168643" y="6048404"/>
            <a:ext cx="0" cy="1322671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立方体 330">
            <a:extLst>
              <a:ext uri="{FF2B5EF4-FFF2-40B4-BE49-F238E27FC236}">
                <a16:creationId xmlns:a16="http://schemas.microsoft.com/office/drawing/2014/main" id="{6B86BF84-DEF0-4E7E-89ED-FFDA759A1772}"/>
              </a:ext>
            </a:extLst>
          </p:cNvPr>
          <p:cNvSpPr/>
          <p:nvPr/>
        </p:nvSpPr>
        <p:spPr>
          <a:xfrm>
            <a:off x="5703620" y="10683514"/>
            <a:ext cx="3297148" cy="191878"/>
          </a:xfrm>
          <a:prstGeom prst="cube">
            <a:avLst>
              <a:gd name="adj" fmla="val 58011"/>
            </a:avLst>
          </a:prstGeom>
          <a:solidFill>
            <a:schemeClr val="bg2">
              <a:lumMod val="5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2" name="立方体 321">
            <a:extLst>
              <a:ext uri="{FF2B5EF4-FFF2-40B4-BE49-F238E27FC236}">
                <a16:creationId xmlns:a16="http://schemas.microsoft.com/office/drawing/2014/main" id="{F5DBE17B-AA7A-4D5C-95B9-7F3CC67229E6}"/>
              </a:ext>
            </a:extLst>
          </p:cNvPr>
          <p:cNvSpPr/>
          <p:nvPr/>
        </p:nvSpPr>
        <p:spPr>
          <a:xfrm>
            <a:off x="5852477" y="10245838"/>
            <a:ext cx="335113" cy="227204"/>
          </a:xfrm>
          <a:prstGeom prst="cube">
            <a:avLst/>
          </a:prstGeom>
          <a:solidFill>
            <a:schemeClr val="accent2">
              <a:lumMod val="40000"/>
              <a:lumOff val="60000"/>
              <a:alpha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3" name="立方体 322">
            <a:extLst>
              <a:ext uri="{FF2B5EF4-FFF2-40B4-BE49-F238E27FC236}">
                <a16:creationId xmlns:a16="http://schemas.microsoft.com/office/drawing/2014/main" id="{B4A46AE8-817B-4C74-92ED-F03B6C3CDABA}"/>
              </a:ext>
            </a:extLst>
          </p:cNvPr>
          <p:cNvSpPr/>
          <p:nvPr/>
        </p:nvSpPr>
        <p:spPr>
          <a:xfrm>
            <a:off x="6611580" y="10253079"/>
            <a:ext cx="335113" cy="227204"/>
          </a:xfrm>
          <a:prstGeom prst="cube">
            <a:avLst/>
          </a:prstGeom>
          <a:solidFill>
            <a:schemeClr val="accent2">
              <a:lumMod val="40000"/>
              <a:lumOff val="60000"/>
              <a:alpha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4" name="立方体 323">
            <a:extLst>
              <a:ext uri="{FF2B5EF4-FFF2-40B4-BE49-F238E27FC236}">
                <a16:creationId xmlns:a16="http://schemas.microsoft.com/office/drawing/2014/main" id="{5A251C7A-E6DC-4D79-A480-49041724637C}"/>
              </a:ext>
            </a:extLst>
          </p:cNvPr>
          <p:cNvSpPr/>
          <p:nvPr/>
        </p:nvSpPr>
        <p:spPr>
          <a:xfrm>
            <a:off x="8196508" y="10261212"/>
            <a:ext cx="364655" cy="227204"/>
          </a:xfrm>
          <a:prstGeom prst="cube">
            <a:avLst/>
          </a:prstGeom>
          <a:solidFill>
            <a:schemeClr val="accent2">
              <a:lumMod val="40000"/>
              <a:lumOff val="60000"/>
              <a:alpha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5" name="立方体 324">
            <a:extLst>
              <a:ext uri="{FF2B5EF4-FFF2-40B4-BE49-F238E27FC236}">
                <a16:creationId xmlns:a16="http://schemas.microsoft.com/office/drawing/2014/main" id="{80A3C833-7ED8-4814-88F4-D9D2AE67FDB8}"/>
              </a:ext>
            </a:extLst>
          </p:cNvPr>
          <p:cNvSpPr/>
          <p:nvPr/>
        </p:nvSpPr>
        <p:spPr>
          <a:xfrm>
            <a:off x="6475908" y="9620047"/>
            <a:ext cx="335113" cy="227204"/>
          </a:xfrm>
          <a:prstGeom prst="cube">
            <a:avLst/>
          </a:prstGeom>
          <a:solidFill>
            <a:schemeClr val="accent2">
              <a:lumMod val="40000"/>
              <a:lumOff val="60000"/>
              <a:alpha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6" name="立方体 325">
            <a:extLst>
              <a:ext uri="{FF2B5EF4-FFF2-40B4-BE49-F238E27FC236}">
                <a16:creationId xmlns:a16="http://schemas.microsoft.com/office/drawing/2014/main" id="{B0D6B171-1FC4-416B-8940-FC1671E3C5A2}"/>
              </a:ext>
            </a:extLst>
          </p:cNvPr>
          <p:cNvSpPr/>
          <p:nvPr/>
        </p:nvSpPr>
        <p:spPr>
          <a:xfrm>
            <a:off x="6820397" y="9230671"/>
            <a:ext cx="361619" cy="227204"/>
          </a:xfrm>
          <a:prstGeom prst="cube">
            <a:avLst/>
          </a:prstGeom>
          <a:solidFill>
            <a:schemeClr val="accent2">
              <a:lumMod val="40000"/>
              <a:lumOff val="60000"/>
              <a:alpha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7" name="立方体 326">
            <a:extLst>
              <a:ext uri="{FF2B5EF4-FFF2-40B4-BE49-F238E27FC236}">
                <a16:creationId xmlns:a16="http://schemas.microsoft.com/office/drawing/2014/main" id="{7DE68A3F-D06D-45E8-979D-F1FEA2B572B2}"/>
              </a:ext>
            </a:extLst>
          </p:cNvPr>
          <p:cNvSpPr/>
          <p:nvPr/>
        </p:nvSpPr>
        <p:spPr>
          <a:xfrm>
            <a:off x="7579305" y="9264089"/>
            <a:ext cx="335113" cy="227204"/>
          </a:xfrm>
          <a:prstGeom prst="cube">
            <a:avLst/>
          </a:prstGeom>
          <a:solidFill>
            <a:schemeClr val="accent2">
              <a:lumMod val="40000"/>
              <a:lumOff val="60000"/>
              <a:alpha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8" name="立方体 327">
            <a:extLst>
              <a:ext uri="{FF2B5EF4-FFF2-40B4-BE49-F238E27FC236}">
                <a16:creationId xmlns:a16="http://schemas.microsoft.com/office/drawing/2014/main" id="{223D84A9-4DA9-4181-838B-E49CB2C23D0B}"/>
              </a:ext>
            </a:extLst>
          </p:cNvPr>
          <p:cNvSpPr/>
          <p:nvPr/>
        </p:nvSpPr>
        <p:spPr>
          <a:xfrm>
            <a:off x="9180272" y="9288891"/>
            <a:ext cx="335113" cy="227204"/>
          </a:xfrm>
          <a:prstGeom prst="cube">
            <a:avLst/>
          </a:prstGeom>
          <a:solidFill>
            <a:schemeClr val="accent2">
              <a:lumMod val="40000"/>
              <a:lumOff val="60000"/>
              <a:alpha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2" name="立方体 331">
            <a:extLst>
              <a:ext uri="{FF2B5EF4-FFF2-40B4-BE49-F238E27FC236}">
                <a16:creationId xmlns:a16="http://schemas.microsoft.com/office/drawing/2014/main" id="{80CFEAF2-3D32-429A-A4FB-3D94B3D05316}"/>
              </a:ext>
            </a:extLst>
          </p:cNvPr>
          <p:cNvSpPr/>
          <p:nvPr/>
        </p:nvSpPr>
        <p:spPr>
          <a:xfrm>
            <a:off x="7192629" y="9651461"/>
            <a:ext cx="389735" cy="227204"/>
          </a:xfrm>
          <a:prstGeom prst="cube">
            <a:avLst/>
          </a:prstGeom>
          <a:solidFill>
            <a:schemeClr val="accent2">
              <a:lumMod val="40000"/>
              <a:lumOff val="60000"/>
              <a:alpha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3" name="立方体 332">
            <a:extLst>
              <a:ext uri="{FF2B5EF4-FFF2-40B4-BE49-F238E27FC236}">
                <a16:creationId xmlns:a16="http://schemas.microsoft.com/office/drawing/2014/main" id="{E7B4C960-F2B7-438C-81D5-D2319F2AA96B}"/>
              </a:ext>
            </a:extLst>
          </p:cNvPr>
          <p:cNvSpPr/>
          <p:nvPr/>
        </p:nvSpPr>
        <p:spPr>
          <a:xfrm>
            <a:off x="8868003" y="9635427"/>
            <a:ext cx="335113" cy="227204"/>
          </a:xfrm>
          <a:prstGeom prst="cube">
            <a:avLst/>
          </a:prstGeom>
          <a:solidFill>
            <a:schemeClr val="accent2">
              <a:lumMod val="40000"/>
              <a:lumOff val="60000"/>
              <a:alpha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矩形: 圆角 102">
            <a:extLst>
              <a:ext uri="{FF2B5EF4-FFF2-40B4-BE49-F238E27FC236}">
                <a16:creationId xmlns:a16="http://schemas.microsoft.com/office/drawing/2014/main" id="{C1A1E8A1-24F7-440C-B54B-981FBDF20419}"/>
              </a:ext>
            </a:extLst>
          </p:cNvPr>
          <p:cNvSpPr/>
          <p:nvPr/>
        </p:nvSpPr>
        <p:spPr>
          <a:xfrm>
            <a:off x="5547342" y="8601474"/>
            <a:ext cx="4942280" cy="2447729"/>
          </a:xfrm>
          <a:prstGeom prst="roundRect">
            <a:avLst/>
          </a:prstGeom>
          <a:noFill/>
          <a:ln w="9525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3" name="文本框 492">
            <a:extLst>
              <a:ext uri="{FF2B5EF4-FFF2-40B4-BE49-F238E27FC236}">
                <a16:creationId xmlns:a16="http://schemas.microsoft.com/office/drawing/2014/main" id="{7CB0E574-83D4-4017-B526-01F9DE5DA95F}"/>
              </a:ext>
            </a:extLst>
          </p:cNvPr>
          <p:cNvSpPr txBox="1"/>
          <p:nvPr/>
        </p:nvSpPr>
        <p:spPr>
          <a:xfrm>
            <a:off x="6590975" y="6559231"/>
            <a:ext cx="511679" cy="307777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solidFill>
                  <a:srgbClr val="EB29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endParaRPr lang="zh-CN" altLang="en-US" sz="1400" b="1" dirty="0">
              <a:solidFill>
                <a:srgbClr val="EB292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文本框 493">
            <a:extLst>
              <a:ext uri="{FF2B5EF4-FFF2-40B4-BE49-F238E27FC236}">
                <a16:creationId xmlns:a16="http://schemas.microsoft.com/office/drawing/2014/main" id="{3027EDDF-99EA-4423-A9A4-160819CC4C7A}"/>
              </a:ext>
            </a:extLst>
          </p:cNvPr>
          <p:cNvSpPr txBox="1"/>
          <p:nvPr/>
        </p:nvSpPr>
        <p:spPr>
          <a:xfrm>
            <a:off x="9287641" y="6490886"/>
            <a:ext cx="641522" cy="307777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endParaRPr lang="zh-CN" altLang="en-US" sz="1400" b="1" dirty="0">
              <a:solidFill>
                <a:schemeClr val="accent5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5" name="文本框 534">
            <a:extLst>
              <a:ext uri="{FF2B5EF4-FFF2-40B4-BE49-F238E27FC236}">
                <a16:creationId xmlns:a16="http://schemas.microsoft.com/office/drawing/2014/main" id="{2D56531D-F0D5-481D-96E3-5CD0C0C5B9B0}"/>
              </a:ext>
            </a:extLst>
          </p:cNvPr>
          <p:cNvSpPr txBox="1"/>
          <p:nvPr/>
        </p:nvSpPr>
        <p:spPr>
          <a:xfrm>
            <a:off x="8179115" y="8787938"/>
            <a:ext cx="1050259" cy="400110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……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82" name="组合 481">
            <a:extLst>
              <a:ext uri="{FF2B5EF4-FFF2-40B4-BE49-F238E27FC236}">
                <a16:creationId xmlns:a16="http://schemas.microsoft.com/office/drawing/2014/main" id="{CAEE81D0-3C6C-41AF-B6CF-92838E4480AC}"/>
              </a:ext>
            </a:extLst>
          </p:cNvPr>
          <p:cNvGrpSpPr/>
          <p:nvPr/>
        </p:nvGrpSpPr>
        <p:grpSpPr>
          <a:xfrm flipH="1">
            <a:off x="8249610" y="6815161"/>
            <a:ext cx="1033329" cy="1111102"/>
            <a:chOff x="5060788" y="3384171"/>
            <a:chExt cx="685113" cy="736677"/>
          </a:xfrm>
        </p:grpSpPr>
        <p:sp>
          <p:nvSpPr>
            <p:cNvPr id="276" name="任意多边形: 形状 275">
              <a:extLst>
                <a:ext uri="{FF2B5EF4-FFF2-40B4-BE49-F238E27FC236}">
                  <a16:creationId xmlns:a16="http://schemas.microsoft.com/office/drawing/2014/main" id="{3C5CE3F4-2D15-4AEA-91D8-EC2918F6845F}"/>
                </a:ext>
              </a:extLst>
            </p:cNvPr>
            <p:cNvSpPr/>
            <p:nvPr/>
          </p:nvSpPr>
          <p:spPr>
            <a:xfrm>
              <a:off x="5197424" y="3384171"/>
              <a:ext cx="411839" cy="736677"/>
            </a:xfrm>
            <a:custGeom>
              <a:avLst/>
              <a:gdLst>
                <a:gd name="connsiteX0" fmla="*/ 0 w 863600"/>
                <a:gd name="connsiteY0" fmla="*/ 1018641 h 1543725"/>
                <a:gd name="connsiteX1" fmla="*/ 101600 w 863600"/>
                <a:gd name="connsiteY1" fmla="*/ 383641 h 1543725"/>
                <a:gd name="connsiteX2" fmla="*/ 139700 w 863600"/>
                <a:gd name="connsiteY2" fmla="*/ 53441 h 1543725"/>
                <a:gd name="connsiteX3" fmla="*/ 190500 w 863600"/>
                <a:gd name="connsiteY3" fmla="*/ 1513941 h 1543725"/>
                <a:gd name="connsiteX4" fmla="*/ 266700 w 863600"/>
                <a:gd name="connsiteY4" fmla="*/ 993241 h 1543725"/>
                <a:gd name="connsiteX5" fmla="*/ 317500 w 863600"/>
                <a:gd name="connsiteY5" fmla="*/ 472541 h 1543725"/>
                <a:gd name="connsiteX6" fmla="*/ 355600 w 863600"/>
                <a:gd name="connsiteY6" fmla="*/ 701141 h 1543725"/>
                <a:gd name="connsiteX7" fmla="*/ 342900 w 863600"/>
                <a:gd name="connsiteY7" fmla="*/ 1285341 h 1543725"/>
                <a:gd name="connsiteX8" fmla="*/ 342900 w 863600"/>
                <a:gd name="connsiteY8" fmla="*/ 1374241 h 1543725"/>
                <a:gd name="connsiteX9" fmla="*/ 419100 w 863600"/>
                <a:gd name="connsiteY9" fmla="*/ 802741 h 1543725"/>
                <a:gd name="connsiteX10" fmla="*/ 419100 w 863600"/>
                <a:gd name="connsiteY10" fmla="*/ 536041 h 1543725"/>
                <a:gd name="connsiteX11" fmla="*/ 469900 w 863600"/>
                <a:gd name="connsiteY11" fmla="*/ 320141 h 1543725"/>
                <a:gd name="connsiteX12" fmla="*/ 469900 w 863600"/>
                <a:gd name="connsiteY12" fmla="*/ 1196441 h 1543725"/>
                <a:gd name="connsiteX13" fmla="*/ 622300 w 863600"/>
                <a:gd name="connsiteY13" fmla="*/ 650341 h 1543725"/>
                <a:gd name="connsiteX14" fmla="*/ 711200 w 863600"/>
                <a:gd name="connsiteY14" fmla="*/ 1221841 h 1543725"/>
                <a:gd name="connsiteX15" fmla="*/ 787400 w 863600"/>
                <a:gd name="connsiteY15" fmla="*/ 878941 h 1543725"/>
                <a:gd name="connsiteX16" fmla="*/ 863600 w 863600"/>
                <a:gd name="connsiteY16" fmla="*/ 1069441 h 1543725"/>
                <a:gd name="connsiteX0" fmla="*/ 0 w 863600"/>
                <a:gd name="connsiteY0" fmla="*/ 1018641 h 1543725"/>
                <a:gd name="connsiteX1" fmla="*/ 101600 w 863600"/>
                <a:gd name="connsiteY1" fmla="*/ 383641 h 1543725"/>
                <a:gd name="connsiteX2" fmla="*/ 139700 w 863600"/>
                <a:gd name="connsiteY2" fmla="*/ 53441 h 1543725"/>
                <a:gd name="connsiteX3" fmla="*/ 190500 w 863600"/>
                <a:gd name="connsiteY3" fmla="*/ 1513941 h 1543725"/>
                <a:gd name="connsiteX4" fmla="*/ 266700 w 863600"/>
                <a:gd name="connsiteY4" fmla="*/ 993241 h 1543725"/>
                <a:gd name="connsiteX5" fmla="*/ 317500 w 863600"/>
                <a:gd name="connsiteY5" fmla="*/ 472541 h 1543725"/>
                <a:gd name="connsiteX6" fmla="*/ 355600 w 863600"/>
                <a:gd name="connsiteY6" fmla="*/ 701141 h 1543725"/>
                <a:gd name="connsiteX7" fmla="*/ 342900 w 863600"/>
                <a:gd name="connsiteY7" fmla="*/ 1285341 h 1543725"/>
                <a:gd name="connsiteX8" fmla="*/ 342900 w 863600"/>
                <a:gd name="connsiteY8" fmla="*/ 1374241 h 1543725"/>
                <a:gd name="connsiteX9" fmla="*/ 419100 w 863600"/>
                <a:gd name="connsiteY9" fmla="*/ 802741 h 1543725"/>
                <a:gd name="connsiteX10" fmla="*/ 442913 w 863600"/>
                <a:gd name="connsiteY10" fmla="*/ 536041 h 1543725"/>
                <a:gd name="connsiteX11" fmla="*/ 469900 w 863600"/>
                <a:gd name="connsiteY11" fmla="*/ 320141 h 1543725"/>
                <a:gd name="connsiteX12" fmla="*/ 469900 w 863600"/>
                <a:gd name="connsiteY12" fmla="*/ 1196441 h 1543725"/>
                <a:gd name="connsiteX13" fmla="*/ 622300 w 863600"/>
                <a:gd name="connsiteY13" fmla="*/ 650341 h 1543725"/>
                <a:gd name="connsiteX14" fmla="*/ 711200 w 863600"/>
                <a:gd name="connsiteY14" fmla="*/ 1221841 h 1543725"/>
                <a:gd name="connsiteX15" fmla="*/ 787400 w 863600"/>
                <a:gd name="connsiteY15" fmla="*/ 878941 h 1543725"/>
                <a:gd name="connsiteX16" fmla="*/ 863600 w 863600"/>
                <a:gd name="connsiteY16" fmla="*/ 1069441 h 1543725"/>
                <a:gd name="connsiteX0" fmla="*/ 0 w 863600"/>
                <a:gd name="connsiteY0" fmla="*/ 1019042 h 1544126"/>
                <a:gd name="connsiteX1" fmla="*/ 89694 w 863600"/>
                <a:gd name="connsiteY1" fmla="*/ 381661 h 1544126"/>
                <a:gd name="connsiteX2" fmla="*/ 139700 w 863600"/>
                <a:gd name="connsiteY2" fmla="*/ 53842 h 1544126"/>
                <a:gd name="connsiteX3" fmla="*/ 190500 w 863600"/>
                <a:gd name="connsiteY3" fmla="*/ 1514342 h 1544126"/>
                <a:gd name="connsiteX4" fmla="*/ 266700 w 863600"/>
                <a:gd name="connsiteY4" fmla="*/ 993642 h 1544126"/>
                <a:gd name="connsiteX5" fmla="*/ 317500 w 863600"/>
                <a:gd name="connsiteY5" fmla="*/ 472942 h 1544126"/>
                <a:gd name="connsiteX6" fmla="*/ 355600 w 863600"/>
                <a:gd name="connsiteY6" fmla="*/ 701542 h 1544126"/>
                <a:gd name="connsiteX7" fmla="*/ 342900 w 863600"/>
                <a:gd name="connsiteY7" fmla="*/ 1285742 h 1544126"/>
                <a:gd name="connsiteX8" fmla="*/ 342900 w 863600"/>
                <a:gd name="connsiteY8" fmla="*/ 1374642 h 1544126"/>
                <a:gd name="connsiteX9" fmla="*/ 419100 w 863600"/>
                <a:gd name="connsiteY9" fmla="*/ 803142 h 1544126"/>
                <a:gd name="connsiteX10" fmla="*/ 442913 w 863600"/>
                <a:gd name="connsiteY10" fmla="*/ 536442 h 1544126"/>
                <a:gd name="connsiteX11" fmla="*/ 469900 w 863600"/>
                <a:gd name="connsiteY11" fmla="*/ 320542 h 1544126"/>
                <a:gd name="connsiteX12" fmla="*/ 469900 w 863600"/>
                <a:gd name="connsiteY12" fmla="*/ 1196842 h 1544126"/>
                <a:gd name="connsiteX13" fmla="*/ 622300 w 863600"/>
                <a:gd name="connsiteY13" fmla="*/ 650742 h 1544126"/>
                <a:gd name="connsiteX14" fmla="*/ 711200 w 863600"/>
                <a:gd name="connsiteY14" fmla="*/ 1222242 h 1544126"/>
                <a:gd name="connsiteX15" fmla="*/ 787400 w 863600"/>
                <a:gd name="connsiteY15" fmla="*/ 879342 h 1544126"/>
                <a:gd name="connsiteX16" fmla="*/ 863600 w 863600"/>
                <a:gd name="connsiteY16" fmla="*/ 1069842 h 1544126"/>
                <a:gd name="connsiteX0" fmla="*/ 0 w 863600"/>
                <a:gd name="connsiteY0" fmla="*/ 1019445 h 1544529"/>
                <a:gd name="connsiteX1" fmla="*/ 70644 w 863600"/>
                <a:gd name="connsiteY1" fmla="*/ 379683 h 1544529"/>
                <a:gd name="connsiteX2" fmla="*/ 139700 w 863600"/>
                <a:gd name="connsiteY2" fmla="*/ 54245 h 1544529"/>
                <a:gd name="connsiteX3" fmla="*/ 190500 w 863600"/>
                <a:gd name="connsiteY3" fmla="*/ 1514745 h 1544529"/>
                <a:gd name="connsiteX4" fmla="*/ 266700 w 863600"/>
                <a:gd name="connsiteY4" fmla="*/ 994045 h 1544529"/>
                <a:gd name="connsiteX5" fmla="*/ 317500 w 863600"/>
                <a:gd name="connsiteY5" fmla="*/ 473345 h 1544529"/>
                <a:gd name="connsiteX6" fmla="*/ 355600 w 863600"/>
                <a:gd name="connsiteY6" fmla="*/ 701945 h 1544529"/>
                <a:gd name="connsiteX7" fmla="*/ 342900 w 863600"/>
                <a:gd name="connsiteY7" fmla="*/ 1286145 h 1544529"/>
                <a:gd name="connsiteX8" fmla="*/ 342900 w 863600"/>
                <a:gd name="connsiteY8" fmla="*/ 1375045 h 1544529"/>
                <a:gd name="connsiteX9" fmla="*/ 419100 w 863600"/>
                <a:gd name="connsiteY9" fmla="*/ 803545 h 1544529"/>
                <a:gd name="connsiteX10" fmla="*/ 442913 w 863600"/>
                <a:gd name="connsiteY10" fmla="*/ 536845 h 1544529"/>
                <a:gd name="connsiteX11" fmla="*/ 469900 w 863600"/>
                <a:gd name="connsiteY11" fmla="*/ 320945 h 1544529"/>
                <a:gd name="connsiteX12" fmla="*/ 469900 w 863600"/>
                <a:gd name="connsiteY12" fmla="*/ 1197245 h 1544529"/>
                <a:gd name="connsiteX13" fmla="*/ 622300 w 863600"/>
                <a:gd name="connsiteY13" fmla="*/ 651145 h 1544529"/>
                <a:gd name="connsiteX14" fmla="*/ 711200 w 863600"/>
                <a:gd name="connsiteY14" fmla="*/ 1222645 h 1544529"/>
                <a:gd name="connsiteX15" fmla="*/ 787400 w 863600"/>
                <a:gd name="connsiteY15" fmla="*/ 879745 h 1544529"/>
                <a:gd name="connsiteX16" fmla="*/ 863600 w 863600"/>
                <a:gd name="connsiteY16" fmla="*/ 1070245 h 1544529"/>
                <a:gd name="connsiteX0" fmla="*/ 0 w 863600"/>
                <a:gd name="connsiteY0" fmla="*/ 1019445 h 1544529"/>
                <a:gd name="connsiteX1" fmla="*/ 84932 w 863600"/>
                <a:gd name="connsiteY1" fmla="*/ 379683 h 1544529"/>
                <a:gd name="connsiteX2" fmla="*/ 139700 w 863600"/>
                <a:gd name="connsiteY2" fmla="*/ 54245 h 1544529"/>
                <a:gd name="connsiteX3" fmla="*/ 190500 w 863600"/>
                <a:gd name="connsiteY3" fmla="*/ 1514745 h 1544529"/>
                <a:gd name="connsiteX4" fmla="*/ 266700 w 863600"/>
                <a:gd name="connsiteY4" fmla="*/ 994045 h 1544529"/>
                <a:gd name="connsiteX5" fmla="*/ 317500 w 863600"/>
                <a:gd name="connsiteY5" fmla="*/ 473345 h 1544529"/>
                <a:gd name="connsiteX6" fmla="*/ 355600 w 863600"/>
                <a:gd name="connsiteY6" fmla="*/ 701945 h 1544529"/>
                <a:gd name="connsiteX7" fmla="*/ 342900 w 863600"/>
                <a:gd name="connsiteY7" fmla="*/ 1286145 h 1544529"/>
                <a:gd name="connsiteX8" fmla="*/ 342900 w 863600"/>
                <a:gd name="connsiteY8" fmla="*/ 1375045 h 1544529"/>
                <a:gd name="connsiteX9" fmla="*/ 419100 w 863600"/>
                <a:gd name="connsiteY9" fmla="*/ 803545 h 1544529"/>
                <a:gd name="connsiteX10" fmla="*/ 442913 w 863600"/>
                <a:gd name="connsiteY10" fmla="*/ 536845 h 1544529"/>
                <a:gd name="connsiteX11" fmla="*/ 469900 w 863600"/>
                <a:gd name="connsiteY11" fmla="*/ 320945 h 1544529"/>
                <a:gd name="connsiteX12" fmla="*/ 469900 w 863600"/>
                <a:gd name="connsiteY12" fmla="*/ 1197245 h 1544529"/>
                <a:gd name="connsiteX13" fmla="*/ 622300 w 863600"/>
                <a:gd name="connsiteY13" fmla="*/ 651145 h 1544529"/>
                <a:gd name="connsiteX14" fmla="*/ 711200 w 863600"/>
                <a:gd name="connsiteY14" fmla="*/ 1222645 h 1544529"/>
                <a:gd name="connsiteX15" fmla="*/ 787400 w 863600"/>
                <a:gd name="connsiteY15" fmla="*/ 879745 h 1544529"/>
                <a:gd name="connsiteX16" fmla="*/ 863600 w 863600"/>
                <a:gd name="connsiteY16" fmla="*/ 1070245 h 1544529"/>
                <a:gd name="connsiteX0" fmla="*/ 0 w 863600"/>
                <a:gd name="connsiteY0" fmla="*/ 1019678 h 1544762"/>
                <a:gd name="connsiteX1" fmla="*/ 84932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42913 w 863600"/>
                <a:gd name="connsiteY10" fmla="*/ 537078 h 1544762"/>
                <a:gd name="connsiteX11" fmla="*/ 469900 w 863600"/>
                <a:gd name="connsiteY11" fmla="*/ 321178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42913 w 863600"/>
                <a:gd name="connsiteY10" fmla="*/ 537078 h 1544762"/>
                <a:gd name="connsiteX11" fmla="*/ 469900 w 863600"/>
                <a:gd name="connsiteY11" fmla="*/ 321178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42913 w 863600"/>
                <a:gd name="connsiteY10" fmla="*/ 537078 h 1544762"/>
                <a:gd name="connsiteX11" fmla="*/ 457994 w 863600"/>
                <a:gd name="connsiteY11" fmla="*/ 483103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23863 w 863600"/>
                <a:gd name="connsiteY10" fmla="*/ 537078 h 1544762"/>
                <a:gd name="connsiteX11" fmla="*/ 457994 w 863600"/>
                <a:gd name="connsiteY11" fmla="*/ 483103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57994 w 863600"/>
                <a:gd name="connsiteY11" fmla="*/ 483103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53231 w 863600"/>
                <a:gd name="connsiteY12" fmla="*/ 470404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31800 w 863600"/>
                <a:gd name="connsiteY12" fmla="*/ 453735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65137 w 863600"/>
                <a:gd name="connsiteY12" fmla="*/ 491835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31800 w 863600"/>
                <a:gd name="connsiteY11" fmla="*/ 40214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31800 w 863600"/>
                <a:gd name="connsiteY11" fmla="*/ 40214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24656 w 863600"/>
                <a:gd name="connsiteY11" fmla="*/ 36404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19893 w 863600"/>
                <a:gd name="connsiteY11" fmla="*/ 42119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17512 w 863600"/>
                <a:gd name="connsiteY11" fmla="*/ 464053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22275 w 863600"/>
                <a:gd name="connsiteY11" fmla="*/ 283078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36563 w 863600"/>
                <a:gd name="connsiteY11" fmla="*/ 278315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863600" h="1544762">
                  <a:moveTo>
                    <a:pt x="0" y="1019678"/>
                  </a:moveTo>
                  <a:cubicBezTo>
                    <a:pt x="38100" y="781553"/>
                    <a:pt x="59268" y="543164"/>
                    <a:pt x="73026" y="379916"/>
                  </a:cubicBezTo>
                  <a:cubicBezTo>
                    <a:pt x="86784" y="216668"/>
                    <a:pt x="120121" y="-134699"/>
                    <a:pt x="139700" y="54478"/>
                  </a:cubicBezTo>
                  <a:cubicBezTo>
                    <a:pt x="159279" y="243655"/>
                    <a:pt x="169333" y="1358345"/>
                    <a:pt x="190500" y="1514978"/>
                  </a:cubicBezTo>
                  <a:cubicBezTo>
                    <a:pt x="211667" y="1671611"/>
                    <a:pt x="245533" y="1167845"/>
                    <a:pt x="266700" y="994278"/>
                  </a:cubicBezTo>
                  <a:cubicBezTo>
                    <a:pt x="287867" y="820711"/>
                    <a:pt x="302683" y="522261"/>
                    <a:pt x="317500" y="473578"/>
                  </a:cubicBezTo>
                  <a:cubicBezTo>
                    <a:pt x="332317" y="424895"/>
                    <a:pt x="351367" y="566712"/>
                    <a:pt x="355600" y="702178"/>
                  </a:cubicBezTo>
                  <a:cubicBezTo>
                    <a:pt x="359833" y="837644"/>
                    <a:pt x="345017" y="1174195"/>
                    <a:pt x="342900" y="1286378"/>
                  </a:cubicBezTo>
                  <a:cubicBezTo>
                    <a:pt x="340783" y="1398561"/>
                    <a:pt x="334566" y="1454521"/>
                    <a:pt x="342900" y="1375278"/>
                  </a:cubicBezTo>
                  <a:cubicBezTo>
                    <a:pt x="351234" y="1296035"/>
                    <a:pt x="380603" y="951019"/>
                    <a:pt x="392906" y="810922"/>
                  </a:cubicBezTo>
                  <a:cubicBezTo>
                    <a:pt x="405209" y="670825"/>
                    <a:pt x="409443" y="623465"/>
                    <a:pt x="416719" y="534697"/>
                  </a:cubicBezTo>
                  <a:cubicBezTo>
                    <a:pt x="423995" y="445929"/>
                    <a:pt x="431272" y="296968"/>
                    <a:pt x="436563" y="278315"/>
                  </a:cubicBezTo>
                  <a:cubicBezTo>
                    <a:pt x="441854" y="259662"/>
                    <a:pt x="444896" y="301335"/>
                    <a:pt x="448468" y="422779"/>
                  </a:cubicBezTo>
                  <a:cubicBezTo>
                    <a:pt x="452040" y="544223"/>
                    <a:pt x="440928" y="1159378"/>
                    <a:pt x="469900" y="1197478"/>
                  </a:cubicBezTo>
                  <a:cubicBezTo>
                    <a:pt x="498872" y="1235578"/>
                    <a:pt x="582083" y="647145"/>
                    <a:pt x="622300" y="651378"/>
                  </a:cubicBezTo>
                  <a:cubicBezTo>
                    <a:pt x="662517" y="655611"/>
                    <a:pt x="683683" y="1184778"/>
                    <a:pt x="711200" y="1222878"/>
                  </a:cubicBezTo>
                  <a:cubicBezTo>
                    <a:pt x="738717" y="1260978"/>
                    <a:pt x="762000" y="905378"/>
                    <a:pt x="787400" y="879978"/>
                  </a:cubicBezTo>
                  <a:cubicBezTo>
                    <a:pt x="812800" y="854578"/>
                    <a:pt x="838200" y="962528"/>
                    <a:pt x="863600" y="1070478"/>
                  </a:cubicBezTo>
                </a:path>
              </a:pathLst>
            </a:custGeom>
            <a:noFill/>
            <a:ln w="9525"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277" name="直接连接符 276">
              <a:extLst>
                <a:ext uri="{FF2B5EF4-FFF2-40B4-BE49-F238E27FC236}">
                  <a16:creationId xmlns:a16="http://schemas.microsoft.com/office/drawing/2014/main" id="{9E20ACDE-3F84-4F48-8DFB-0FF3EECD334D}"/>
                </a:ext>
              </a:extLst>
            </p:cNvPr>
            <p:cNvCxnSpPr>
              <a:cxnSpLocks/>
              <a:stCxn id="276" idx="0"/>
            </p:cNvCxnSpPr>
            <p:nvPr/>
          </p:nvCxnSpPr>
          <p:spPr>
            <a:xfrm flipH="1">
              <a:off x="5060788" y="3870442"/>
              <a:ext cx="136636" cy="3786"/>
            </a:xfrm>
            <a:prstGeom prst="line">
              <a:avLst/>
            </a:prstGeom>
            <a:ln w="9525">
              <a:solidFill>
                <a:schemeClr val="accent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直接连接符 277">
              <a:extLst>
                <a:ext uri="{FF2B5EF4-FFF2-40B4-BE49-F238E27FC236}">
                  <a16:creationId xmlns:a16="http://schemas.microsoft.com/office/drawing/2014/main" id="{5BCDC9D1-ACB8-4B33-B13F-BA5E618590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09264" y="3891050"/>
              <a:ext cx="136637" cy="0"/>
            </a:xfrm>
            <a:prstGeom prst="line">
              <a:avLst/>
            </a:prstGeom>
            <a:ln w="9525">
              <a:solidFill>
                <a:schemeClr val="accent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0" name="任意多边形: 形状 279">
            <a:extLst>
              <a:ext uri="{FF2B5EF4-FFF2-40B4-BE49-F238E27FC236}">
                <a16:creationId xmlns:a16="http://schemas.microsoft.com/office/drawing/2014/main" id="{78C25D4D-5A32-44DC-9E03-9A2CC2FB3DA0}"/>
              </a:ext>
            </a:extLst>
          </p:cNvPr>
          <p:cNvSpPr/>
          <p:nvPr/>
        </p:nvSpPr>
        <p:spPr>
          <a:xfrm>
            <a:off x="7632728" y="7045467"/>
            <a:ext cx="514605" cy="740933"/>
          </a:xfrm>
          <a:custGeom>
            <a:avLst/>
            <a:gdLst>
              <a:gd name="connsiteX0" fmla="*/ 0 w 863600"/>
              <a:gd name="connsiteY0" fmla="*/ 1018641 h 1543725"/>
              <a:gd name="connsiteX1" fmla="*/ 101600 w 863600"/>
              <a:gd name="connsiteY1" fmla="*/ 383641 h 1543725"/>
              <a:gd name="connsiteX2" fmla="*/ 139700 w 863600"/>
              <a:gd name="connsiteY2" fmla="*/ 53441 h 1543725"/>
              <a:gd name="connsiteX3" fmla="*/ 190500 w 863600"/>
              <a:gd name="connsiteY3" fmla="*/ 1513941 h 1543725"/>
              <a:gd name="connsiteX4" fmla="*/ 266700 w 863600"/>
              <a:gd name="connsiteY4" fmla="*/ 993241 h 1543725"/>
              <a:gd name="connsiteX5" fmla="*/ 317500 w 863600"/>
              <a:gd name="connsiteY5" fmla="*/ 472541 h 1543725"/>
              <a:gd name="connsiteX6" fmla="*/ 355600 w 863600"/>
              <a:gd name="connsiteY6" fmla="*/ 701141 h 1543725"/>
              <a:gd name="connsiteX7" fmla="*/ 342900 w 863600"/>
              <a:gd name="connsiteY7" fmla="*/ 1285341 h 1543725"/>
              <a:gd name="connsiteX8" fmla="*/ 342900 w 863600"/>
              <a:gd name="connsiteY8" fmla="*/ 1374241 h 1543725"/>
              <a:gd name="connsiteX9" fmla="*/ 419100 w 863600"/>
              <a:gd name="connsiteY9" fmla="*/ 802741 h 1543725"/>
              <a:gd name="connsiteX10" fmla="*/ 419100 w 863600"/>
              <a:gd name="connsiteY10" fmla="*/ 536041 h 1543725"/>
              <a:gd name="connsiteX11" fmla="*/ 469900 w 863600"/>
              <a:gd name="connsiteY11" fmla="*/ 320141 h 1543725"/>
              <a:gd name="connsiteX12" fmla="*/ 469900 w 863600"/>
              <a:gd name="connsiteY12" fmla="*/ 1196441 h 1543725"/>
              <a:gd name="connsiteX13" fmla="*/ 622300 w 863600"/>
              <a:gd name="connsiteY13" fmla="*/ 650341 h 1543725"/>
              <a:gd name="connsiteX14" fmla="*/ 711200 w 863600"/>
              <a:gd name="connsiteY14" fmla="*/ 1221841 h 1543725"/>
              <a:gd name="connsiteX15" fmla="*/ 787400 w 863600"/>
              <a:gd name="connsiteY15" fmla="*/ 878941 h 1543725"/>
              <a:gd name="connsiteX16" fmla="*/ 863600 w 863600"/>
              <a:gd name="connsiteY16" fmla="*/ 1069441 h 1543725"/>
              <a:gd name="connsiteX0" fmla="*/ 0 w 863600"/>
              <a:gd name="connsiteY0" fmla="*/ 1018641 h 1543725"/>
              <a:gd name="connsiteX1" fmla="*/ 101600 w 863600"/>
              <a:gd name="connsiteY1" fmla="*/ 383641 h 1543725"/>
              <a:gd name="connsiteX2" fmla="*/ 139700 w 863600"/>
              <a:gd name="connsiteY2" fmla="*/ 53441 h 1543725"/>
              <a:gd name="connsiteX3" fmla="*/ 190500 w 863600"/>
              <a:gd name="connsiteY3" fmla="*/ 1513941 h 1543725"/>
              <a:gd name="connsiteX4" fmla="*/ 266700 w 863600"/>
              <a:gd name="connsiteY4" fmla="*/ 993241 h 1543725"/>
              <a:gd name="connsiteX5" fmla="*/ 317500 w 863600"/>
              <a:gd name="connsiteY5" fmla="*/ 472541 h 1543725"/>
              <a:gd name="connsiteX6" fmla="*/ 355600 w 863600"/>
              <a:gd name="connsiteY6" fmla="*/ 701141 h 1543725"/>
              <a:gd name="connsiteX7" fmla="*/ 342900 w 863600"/>
              <a:gd name="connsiteY7" fmla="*/ 1285341 h 1543725"/>
              <a:gd name="connsiteX8" fmla="*/ 342900 w 863600"/>
              <a:gd name="connsiteY8" fmla="*/ 1374241 h 1543725"/>
              <a:gd name="connsiteX9" fmla="*/ 419100 w 863600"/>
              <a:gd name="connsiteY9" fmla="*/ 802741 h 1543725"/>
              <a:gd name="connsiteX10" fmla="*/ 442913 w 863600"/>
              <a:gd name="connsiteY10" fmla="*/ 536041 h 1543725"/>
              <a:gd name="connsiteX11" fmla="*/ 469900 w 863600"/>
              <a:gd name="connsiteY11" fmla="*/ 320141 h 1543725"/>
              <a:gd name="connsiteX12" fmla="*/ 469900 w 863600"/>
              <a:gd name="connsiteY12" fmla="*/ 1196441 h 1543725"/>
              <a:gd name="connsiteX13" fmla="*/ 622300 w 863600"/>
              <a:gd name="connsiteY13" fmla="*/ 650341 h 1543725"/>
              <a:gd name="connsiteX14" fmla="*/ 711200 w 863600"/>
              <a:gd name="connsiteY14" fmla="*/ 1221841 h 1543725"/>
              <a:gd name="connsiteX15" fmla="*/ 787400 w 863600"/>
              <a:gd name="connsiteY15" fmla="*/ 878941 h 1543725"/>
              <a:gd name="connsiteX16" fmla="*/ 863600 w 863600"/>
              <a:gd name="connsiteY16" fmla="*/ 1069441 h 1543725"/>
              <a:gd name="connsiteX0" fmla="*/ 0 w 863600"/>
              <a:gd name="connsiteY0" fmla="*/ 1019042 h 1544126"/>
              <a:gd name="connsiteX1" fmla="*/ 89694 w 863600"/>
              <a:gd name="connsiteY1" fmla="*/ 381661 h 1544126"/>
              <a:gd name="connsiteX2" fmla="*/ 139700 w 863600"/>
              <a:gd name="connsiteY2" fmla="*/ 53842 h 1544126"/>
              <a:gd name="connsiteX3" fmla="*/ 190500 w 863600"/>
              <a:gd name="connsiteY3" fmla="*/ 1514342 h 1544126"/>
              <a:gd name="connsiteX4" fmla="*/ 266700 w 863600"/>
              <a:gd name="connsiteY4" fmla="*/ 993642 h 1544126"/>
              <a:gd name="connsiteX5" fmla="*/ 317500 w 863600"/>
              <a:gd name="connsiteY5" fmla="*/ 472942 h 1544126"/>
              <a:gd name="connsiteX6" fmla="*/ 355600 w 863600"/>
              <a:gd name="connsiteY6" fmla="*/ 701542 h 1544126"/>
              <a:gd name="connsiteX7" fmla="*/ 342900 w 863600"/>
              <a:gd name="connsiteY7" fmla="*/ 1285742 h 1544126"/>
              <a:gd name="connsiteX8" fmla="*/ 342900 w 863600"/>
              <a:gd name="connsiteY8" fmla="*/ 1374642 h 1544126"/>
              <a:gd name="connsiteX9" fmla="*/ 419100 w 863600"/>
              <a:gd name="connsiteY9" fmla="*/ 803142 h 1544126"/>
              <a:gd name="connsiteX10" fmla="*/ 442913 w 863600"/>
              <a:gd name="connsiteY10" fmla="*/ 536442 h 1544126"/>
              <a:gd name="connsiteX11" fmla="*/ 469900 w 863600"/>
              <a:gd name="connsiteY11" fmla="*/ 320542 h 1544126"/>
              <a:gd name="connsiteX12" fmla="*/ 469900 w 863600"/>
              <a:gd name="connsiteY12" fmla="*/ 1196842 h 1544126"/>
              <a:gd name="connsiteX13" fmla="*/ 622300 w 863600"/>
              <a:gd name="connsiteY13" fmla="*/ 650742 h 1544126"/>
              <a:gd name="connsiteX14" fmla="*/ 711200 w 863600"/>
              <a:gd name="connsiteY14" fmla="*/ 1222242 h 1544126"/>
              <a:gd name="connsiteX15" fmla="*/ 787400 w 863600"/>
              <a:gd name="connsiteY15" fmla="*/ 879342 h 1544126"/>
              <a:gd name="connsiteX16" fmla="*/ 863600 w 863600"/>
              <a:gd name="connsiteY16" fmla="*/ 1069842 h 1544126"/>
              <a:gd name="connsiteX0" fmla="*/ 0 w 863600"/>
              <a:gd name="connsiteY0" fmla="*/ 1019445 h 1544529"/>
              <a:gd name="connsiteX1" fmla="*/ 70644 w 863600"/>
              <a:gd name="connsiteY1" fmla="*/ 379683 h 1544529"/>
              <a:gd name="connsiteX2" fmla="*/ 139700 w 863600"/>
              <a:gd name="connsiteY2" fmla="*/ 54245 h 1544529"/>
              <a:gd name="connsiteX3" fmla="*/ 190500 w 863600"/>
              <a:gd name="connsiteY3" fmla="*/ 1514745 h 1544529"/>
              <a:gd name="connsiteX4" fmla="*/ 266700 w 863600"/>
              <a:gd name="connsiteY4" fmla="*/ 994045 h 1544529"/>
              <a:gd name="connsiteX5" fmla="*/ 317500 w 863600"/>
              <a:gd name="connsiteY5" fmla="*/ 473345 h 1544529"/>
              <a:gd name="connsiteX6" fmla="*/ 355600 w 863600"/>
              <a:gd name="connsiteY6" fmla="*/ 701945 h 1544529"/>
              <a:gd name="connsiteX7" fmla="*/ 342900 w 863600"/>
              <a:gd name="connsiteY7" fmla="*/ 1286145 h 1544529"/>
              <a:gd name="connsiteX8" fmla="*/ 342900 w 863600"/>
              <a:gd name="connsiteY8" fmla="*/ 1375045 h 1544529"/>
              <a:gd name="connsiteX9" fmla="*/ 419100 w 863600"/>
              <a:gd name="connsiteY9" fmla="*/ 803545 h 1544529"/>
              <a:gd name="connsiteX10" fmla="*/ 442913 w 863600"/>
              <a:gd name="connsiteY10" fmla="*/ 536845 h 1544529"/>
              <a:gd name="connsiteX11" fmla="*/ 469900 w 863600"/>
              <a:gd name="connsiteY11" fmla="*/ 320945 h 1544529"/>
              <a:gd name="connsiteX12" fmla="*/ 469900 w 863600"/>
              <a:gd name="connsiteY12" fmla="*/ 1197245 h 1544529"/>
              <a:gd name="connsiteX13" fmla="*/ 622300 w 863600"/>
              <a:gd name="connsiteY13" fmla="*/ 651145 h 1544529"/>
              <a:gd name="connsiteX14" fmla="*/ 711200 w 863600"/>
              <a:gd name="connsiteY14" fmla="*/ 1222645 h 1544529"/>
              <a:gd name="connsiteX15" fmla="*/ 787400 w 863600"/>
              <a:gd name="connsiteY15" fmla="*/ 879745 h 1544529"/>
              <a:gd name="connsiteX16" fmla="*/ 863600 w 863600"/>
              <a:gd name="connsiteY16" fmla="*/ 1070245 h 1544529"/>
              <a:gd name="connsiteX0" fmla="*/ 0 w 863600"/>
              <a:gd name="connsiteY0" fmla="*/ 1019445 h 1544529"/>
              <a:gd name="connsiteX1" fmla="*/ 84932 w 863600"/>
              <a:gd name="connsiteY1" fmla="*/ 379683 h 1544529"/>
              <a:gd name="connsiteX2" fmla="*/ 139700 w 863600"/>
              <a:gd name="connsiteY2" fmla="*/ 54245 h 1544529"/>
              <a:gd name="connsiteX3" fmla="*/ 190500 w 863600"/>
              <a:gd name="connsiteY3" fmla="*/ 1514745 h 1544529"/>
              <a:gd name="connsiteX4" fmla="*/ 266700 w 863600"/>
              <a:gd name="connsiteY4" fmla="*/ 994045 h 1544529"/>
              <a:gd name="connsiteX5" fmla="*/ 317500 w 863600"/>
              <a:gd name="connsiteY5" fmla="*/ 473345 h 1544529"/>
              <a:gd name="connsiteX6" fmla="*/ 355600 w 863600"/>
              <a:gd name="connsiteY6" fmla="*/ 701945 h 1544529"/>
              <a:gd name="connsiteX7" fmla="*/ 342900 w 863600"/>
              <a:gd name="connsiteY7" fmla="*/ 1286145 h 1544529"/>
              <a:gd name="connsiteX8" fmla="*/ 342900 w 863600"/>
              <a:gd name="connsiteY8" fmla="*/ 1375045 h 1544529"/>
              <a:gd name="connsiteX9" fmla="*/ 419100 w 863600"/>
              <a:gd name="connsiteY9" fmla="*/ 803545 h 1544529"/>
              <a:gd name="connsiteX10" fmla="*/ 442913 w 863600"/>
              <a:gd name="connsiteY10" fmla="*/ 536845 h 1544529"/>
              <a:gd name="connsiteX11" fmla="*/ 469900 w 863600"/>
              <a:gd name="connsiteY11" fmla="*/ 320945 h 1544529"/>
              <a:gd name="connsiteX12" fmla="*/ 469900 w 863600"/>
              <a:gd name="connsiteY12" fmla="*/ 1197245 h 1544529"/>
              <a:gd name="connsiteX13" fmla="*/ 622300 w 863600"/>
              <a:gd name="connsiteY13" fmla="*/ 651145 h 1544529"/>
              <a:gd name="connsiteX14" fmla="*/ 711200 w 863600"/>
              <a:gd name="connsiteY14" fmla="*/ 1222645 h 1544529"/>
              <a:gd name="connsiteX15" fmla="*/ 787400 w 863600"/>
              <a:gd name="connsiteY15" fmla="*/ 879745 h 1544529"/>
              <a:gd name="connsiteX16" fmla="*/ 863600 w 863600"/>
              <a:gd name="connsiteY16" fmla="*/ 1070245 h 1544529"/>
              <a:gd name="connsiteX0" fmla="*/ 0 w 863600"/>
              <a:gd name="connsiteY0" fmla="*/ 1019678 h 1544762"/>
              <a:gd name="connsiteX1" fmla="*/ 84932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419100 w 863600"/>
              <a:gd name="connsiteY9" fmla="*/ 803778 h 1544762"/>
              <a:gd name="connsiteX10" fmla="*/ 442913 w 863600"/>
              <a:gd name="connsiteY10" fmla="*/ 537078 h 1544762"/>
              <a:gd name="connsiteX11" fmla="*/ 469900 w 863600"/>
              <a:gd name="connsiteY11" fmla="*/ 321178 h 1544762"/>
              <a:gd name="connsiteX12" fmla="*/ 469900 w 863600"/>
              <a:gd name="connsiteY12" fmla="*/ 1197478 h 1544762"/>
              <a:gd name="connsiteX13" fmla="*/ 622300 w 863600"/>
              <a:gd name="connsiteY13" fmla="*/ 651378 h 1544762"/>
              <a:gd name="connsiteX14" fmla="*/ 711200 w 863600"/>
              <a:gd name="connsiteY14" fmla="*/ 1222878 h 1544762"/>
              <a:gd name="connsiteX15" fmla="*/ 787400 w 863600"/>
              <a:gd name="connsiteY15" fmla="*/ 879978 h 1544762"/>
              <a:gd name="connsiteX16" fmla="*/ 863600 w 863600"/>
              <a:gd name="connsiteY16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419100 w 863600"/>
              <a:gd name="connsiteY9" fmla="*/ 803778 h 1544762"/>
              <a:gd name="connsiteX10" fmla="*/ 442913 w 863600"/>
              <a:gd name="connsiteY10" fmla="*/ 537078 h 1544762"/>
              <a:gd name="connsiteX11" fmla="*/ 469900 w 863600"/>
              <a:gd name="connsiteY11" fmla="*/ 321178 h 1544762"/>
              <a:gd name="connsiteX12" fmla="*/ 469900 w 863600"/>
              <a:gd name="connsiteY12" fmla="*/ 1197478 h 1544762"/>
              <a:gd name="connsiteX13" fmla="*/ 622300 w 863600"/>
              <a:gd name="connsiteY13" fmla="*/ 651378 h 1544762"/>
              <a:gd name="connsiteX14" fmla="*/ 711200 w 863600"/>
              <a:gd name="connsiteY14" fmla="*/ 1222878 h 1544762"/>
              <a:gd name="connsiteX15" fmla="*/ 787400 w 863600"/>
              <a:gd name="connsiteY15" fmla="*/ 879978 h 1544762"/>
              <a:gd name="connsiteX16" fmla="*/ 863600 w 863600"/>
              <a:gd name="connsiteY16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419100 w 863600"/>
              <a:gd name="connsiteY9" fmla="*/ 803778 h 1544762"/>
              <a:gd name="connsiteX10" fmla="*/ 442913 w 863600"/>
              <a:gd name="connsiteY10" fmla="*/ 537078 h 1544762"/>
              <a:gd name="connsiteX11" fmla="*/ 457994 w 863600"/>
              <a:gd name="connsiteY11" fmla="*/ 483103 h 1544762"/>
              <a:gd name="connsiteX12" fmla="*/ 469900 w 863600"/>
              <a:gd name="connsiteY12" fmla="*/ 1197478 h 1544762"/>
              <a:gd name="connsiteX13" fmla="*/ 622300 w 863600"/>
              <a:gd name="connsiteY13" fmla="*/ 651378 h 1544762"/>
              <a:gd name="connsiteX14" fmla="*/ 711200 w 863600"/>
              <a:gd name="connsiteY14" fmla="*/ 1222878 h 1544762"/>
              <a:gd name="connsiteX15" fmla="*/ 787400 w 863600"/>
              <a:gd name="connsiteY15" fmla="*/ 879978 h 1544762"/>
              <a:gd name="connsiteX16" fmla="*/ 863600 w 863600"/>
              <a:gd name="connsiteY16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419100 w 863600"/>
              <a:gd name="connsiteY9" fmla="*/ 803778 h 1544762"/>
              <a:gd name="connsiteX10" fmla="*/ 423863 w 863600"/>
              <a:gd name="connsiteY10" fmla="*/ 537078 h 1544762"/>
              <a:gd name="connsiteX11" fmla="*/ 457994 w 863600"/>
              <a:gd name="connsiteY11" fmla="*/ 483103 h 1544762"/>
              <a:gd name="connsiteX12" fmla="*/ 469900 w 863600"/>
              <a:gd name="connsiteY12" fmla="*/ 1197478 h 1544762"/>
              <a:gd name="connsiteX13" fmla="*/ 622300 w 863600"/>
              <a:gd name="connsiteY13" fmla="*/ 651378 h 1544762"/>
              <a:gd name="connsiteX14" fmla="*/ 711200 w 863600"/>
              <a:gd name="connsiteY14" fmla="*/ 1222878 h 1544762"/>
              <a:gd name="connsiteX15" fmla="*/ 787400 w 863600"/>
              <a:gd name="connsiteY15" fmla="*/ 879978 h 1544762"/>
              <a:gd name="connsiteX16" fmla="*/ 863600 w 863600"/>
              <a:gd name="connsiteY16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23863 w 863600"/>
              <a:gd name="connsiteY10" fmla="*/ 537078 h 1544762"/>
              <a:gd name="connsiteX11" fmla="*/ 457994 w 863600"/>
              <a:gd name="connsiteY11" fmla="*/ 483103 h 1544762"/>
              <a:gd name="connsiteX12" fmla="*/ 469900 w 863600"/>
              <a:gd name="connsiteY12" fmla="*/ 1197478 h 1544762"/>
              <a:gd name="connsiteX13" fmla="*/ 622300 w 863600"/>
              <a:gd name="connsiteY13" fmla="*/ 651378 h 1544762"/>
              <a:gd name="connsiteX14" fmla="*/ 711200 w 863600"/>
              <a:gd name="connsiteY14" fmla="*/ 1222878 h 1544762"/>
              <a:gd name="connsiteX15" fmla="*/ 787400 w 863600"/>
              <a:gd name="connsiteY15" fmla="*/ 879978 h 1544762"/>
              <a:gd name="connsiteX16" fmla="*/ 863600 w 863600"/>
              <a:gd name="connsiteY16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23863 w 863600"/>
              <a:gd name="connsiteY10" fmla="*/ 537078 h 1544762"/>
              <a:gd name="connsiteX11" fmla="*/ 448469 w 863600"/>
              <a:gd name="connsiteY11" fmla="*/ 468815 h 1544762"/>
              <a:gd name="connsiteX12" fmla="*/ 469900 w 863600"/>
              <a:gd name="connsiteY12" fmla="*/ 1197478 h 1544762"/>
              <a:gd name="connsiteX13" fmla="*/ 622300 w 863600"/>
              <a:gd name="connsiteY13" fmla="*/ 651378 h 1544762"/>
              <a:gd name="connsiteX14" fmla="*/ 711200 w 863600"/>
              <a:gd name="connsiteY14" fmla="*/ 1222878 h 1544762"/>
              <a:gd name="connsiteX15" fmla="*/ 787400 w 863600"/>
              <a:gd name="connsiteY15" fmla="*/ 879978 h 1544762"/>
              <a:gd name="connsiteX16" fmla="*/ 863600 w 863600"/>
              <a:gd name="connsiteY16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23863 w 863600"/>
              <a:gd name="connsiteY10" fmla="*/ 537078 h 1544762"/>
              <a:gd name="connsiteX11" fmla="*/ 448469 w 863600"/>
              <a:gd name="connsiteY11" fmla="*/ 468815 h 1544762"/>
              <a:gd name="connsiteX12" fmla="*/ 453231 w 863600"/>
              <a:gd name="connsiteY12" fmla="*/ 470404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23863 w 863600"/>
              <a:gd name="connsiteY10" fmla="*/ 537078 h 1544762"/>
              <a:gd name="connsiteX11" fmla="*/ 448469 w 863600"/>
              <a:gd name="connsiteY11" fmla="*/ 468815 h 1544762"/>
              <a:gd name="connsiteX12" fmla="*/ 431800 w 863600"/>
              <a:gd name="connsiteY12" fmla="*/ 453735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23863 w 863600"/>
              <a:gd name="connsiteY10" fmla="*/ 537078 h 1544762"/>
              <a:gd name="connsiteX11" fmla="*/ 448469 w 863600"/>
              <a:gd name="connsiteY11" fmla="*/ 468815 h 1544762"/>
              <a:gd name="connsiteX12" fmla="*/ 465137 w 863600"/>
              <a:gd name="connsiteY12" fmla="*/ 491835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23863 w 863600"/>
              <a:gd name="connsiteY10" fmla="*/ 537078 h 1544762"/>
              <a:gd name="connsiteX11" fmla="*/ 448469 w 863600"/>
              <a:gd name="connsiteY11" fmla="*/ 468815 h 1544762"/>
              <a:gd name="connsiteX12" fmla="*/ 448468 w 863600"/>
              <a:gd name="connsiteY12" fmla="*/ 422779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23863 w 863600"/>
              <a:gd name="connsiteY10" fmla="*/ 537078 h 1544762"/>
              <a:gd name="connsiteX11" fmla="*/ 431800 w 863600"/>
              <a:gd name="connsiteY11" fmla="*/ 402140 h 1544762"/>
              <a:gd name="connsiteX12" fmla="*/ 448468 w 863600"/>
              <a:gd name="connsiteY12" fmla="*/ 422779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16719 w 863600"/>
              <a:gd name="connsiteY10" fmla="*/ 534697 h 1544762"/>
              <a:gd name="connsiteX11" fmla="*/ 431800 w 863600"/>
              <a:gd name="connsiteY11" fmla="*/ 402140 h 1544762"/>
              <a:gd name="connsiteX12" fmla="*/ 448468 w 863600"/>
              <a:gd name="connsiteY12" fmla="*/ 422779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16719 w 863600"/>
              <a:gd name="connsiteY10" fmla="*/ 534697 h 1544762"/>
              <a:gd name="connsiteX11" fmla="*/ 424656 w 863600"/>
              <a:gd name="connsiteY11" fmla="*/ 364040 h 1544762"/>
              <a:gd name="connsiteX12" fmla="*/ 448468 w 863600"/>
              <a:gd name="connsiteY12" fmla="*/ 422779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16719 w 863600"/>
              <a:gd name="connsiteY10" fmla="*/ 534697 h 1544762"/>
              <a:gd name="connsiteX11" fmla="*/ 419893 w 863600"/>
              <a:gd name="connsiteY11" fmla="*/ 421190 h 1544762"/>
              <a:gd name="connsiteX12" fmla="*/ 448468 w 863600"/>
              <a:gd name="connsiteY12" fmla="*/ 422779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16719 w 863600"/>
              <a:gd name="connsiteY10" fmla="*/ 534697 h 1544762"/>
              <a:gd name="connsiteX11" fmla="*/ 417512 w 863600"/>
              <a:gd name="connsiteY11" fmla="*/ 464053 h 1544762"/>
              <a:gd name="connsiteX12" fmla="*/ 448468 w 863600"/>
              <a:gd name="connsiteY12" fmla="*/ 422779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16719 w 863600"/>
              <a:gd name="connsiteY10" fmla="*/ 534697 h 1544762"/>
              <a:gd name="connsiteX11" fmla="*/ 422275 w 863600"/>
              <a:gd name="connsiteY11" fmla="*/ 283078 h 1544762"/>
              <a:gd name="connsiteX12" fmla="*/ 448468 w 863600"/>
              <a:gd name="connsiteY12" fmla="*/ 422779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63600"/>
              <a:gd name="connsiteY0" fmla="*/ 1019678 h 1544762"/>
              <a:gd name="connsiteX1" fmla="*/ 73026 w 863600"/>
              <a:gd name="connsiteY1" fmla="*/ 379916 h 1544762"/>
              <a:gd name="connsiteX2" fmla="*/ 139700 w 863600"/>
              <a:gd name="connsiteY2" fmla="*/ 54478 h 1544762"/>
              <a:gd name="connsiteX3" fmla="*/ 190500 w 863600"/>
              <a:gd name="connsiteY3" fmla="*/ 1514978 h 1544762"/>
              <a:gd name="connsiteX4" fmla="*/ 266700 w 863600"/>
              <a:gd name="connsiteY4" fmla="*/ 994278 h 1544762"/>
              <a:gd name="connsiteX5" fmla="*/ 317500 w 863600"/>
              <a:gd name="connsiteY5" fmla="*/ 473578 h 1544762"/>
              <a:gd name="connsiteX6" fmla="*/ 355600 w 863600"/>
              <a:gd name="connsiteY6" fmla="*/ 702178 h 1544762"/>
              <a:gd name="connsiteX7" fmla="*/ 342900 w 863600"/>
              <a:gd name="connsiteY7" fmla="*/ 1286378 h 1544762"/>
              <a:gd name="connsiteX8" fmla="*/ 342900 w 863600"/>
              <a:gd name="connsiteY8" fmla="*/ 1375278 h 1544762"/>
              <a:gd name="connsiteX9" fmla="*/ 392906 w 863600"/>
              <a:gd name="connsiteY9" fmla="*/ 810922 h 1544762"/>
              <a:gd name="connsiteX10" fmla="*/ 416719 w 863600"/>
              <a:gd name="connsiteY10" fmla="*/ 534697 h 1544762"/>
              <a:gd name="connsiteX11" fmla="*/ 436563 w 863600"/>
              <a:gd name="connsiteY11" fmla="*/ 278315 h 1544762"/>
              <a:gd name="connsiteX12" fmla="*/ 448468 w 863600"/>
              <a:gd name="connsiteY12" fmla="*/ 422779 h 1544762"/>
              <a:gd name="connsiteX13" fmla="*/ 469900 w 863600"/>
              <a:gd name="connsiteY13" fmla="*/ 1197478 h 1544762"/>
              <a:gd name="connsiteX14" fmla="*/ 622300 w 863600"/>
              <a:gd name="connsiteY14" fmla="*/ 651378 h 1544762"/>
              <a:gd name="connsiteX15" fmla="*/ 711200 w 863600"/>
              <a:gd name="connsiteY15" fmla="*/ 1222878 h 1544762"/>
              <a:gd name="connsiteX16" fmla="*/ 787400 w 863600"/>
              <a:gd name="connsiteY16" fmla="*/ 879978 h 1544762"/>
              <a:gd name="connsiteX17" fmla="*/ 863600 w 863600"/>
              <a:gd name="connsiteY17" fmla="*/ 1070478 h 1544762"/>
              <a:gd name="connsiteX0" fmla="*/ 0 w 880983"/>
              <a:gd name="connsiteY0" fmla="*/ 1019678 h 1544762"/>
              <a:gd name="connsiteX1" fmla="*/ 73026 w 880983"/>
              <a:gd name="connsiteY1" fmla="*/ 379916 h 1544762"/>
              <a:gd name="connsiteX2" fmla="*/ 139700 w 880983"/>
              <a:gd name="connsiteY2" fmla="*/ 54478 h 1544762"/>
              <a:gd name="connsiteX3" fmla="*/ 190500 w 880983"/>
              <a:gd name="connsiteY3" fmla="*/ 1514978 h 1544762"/>
              <a:gd name="connsiteX4" fmla="*/ 266700 w 880983"/>
              <a:gd name="connsiteY4" fmla="*/ 994278 h 1544762"/>
              <a:gd name="connsiteX5" fmla="*/ 317500 w 880983"/>
              <a:gd name="connsiteY5" fmla="*/ 473578 h 1544762"/>
              <a:gd name="connsiteX6" fmla="*/ 355600 w 880983"/>
              <a:gd name="connsiteY6" fmla="*/ 702178 h 1544762"/>
              <a:gd name="connsiteX7" fmla="*/ 342900 w 880983"/>
              <a:gd name="connsiteY7" fmla="*/ 1286378 h 1544762"/>
              <a:gd name="connsiteX8" fmla="*/ 342900 w 880983"/>
              <a:gd name="connsiteY8" fmla="*/ 1375278 h 1544762"/>
              <a:gd name="connsiteX9" fmla="*/ 392906 w 880983"/>
              <a:gd name="connsiteY9" fmla="*/ 810922 h 1544762"/>
              <a:gd name="connsiteX10" fmla="*/ 416719 w 880983"/>
              <a:gd name="connsiteY10" fmla="*/ 534697 h 1544762"/>
              <a:gd name="connsiteX11" fmla="*/ 436563 w 880983"/>
              <a:gd name="connsiteY11" fmla="*/ 278315 h 1544762"/>
              <a:gd name="connsiteX12" fmla="*/ 448468 w 880983"/>
              <a:gd name="connsiteY12" fmla="*/ 422779 h 1544762"/>
              <a:gd name="connsiteX13" fmla="*/ 469900 w 880983"/>
              <a:gd name="connsiteY13" fmla="*/ 1197478 h 1544762"/>
              <a:gd name="connsiteX14" fmla="*/ 622300 w 880983"/>
              <a:gd name="connsiteY14" fmla="*/ 651378 h 1544762"/>
              <a:gd name="connsiteX15" fmla="*/ 711200 w 880983"/>
              <a:gd name="connsiteY15" fmla="*/ 1222878 h 1544762"/>
              <a:gd name="connsiteX16" fmla="*/ 787400 w 880983"/>
              <a:gd name="connsiteY16" fmla="*/ 879978 h 1544762"/>
              <a:gd name="connsiteX17" fmla="*/ 880983 w 880983"/>
              <a:gd name="connsiteY17" fmla="*/ 1122225 h 15447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</a:cxnLst>
            <a:rect l="l" t="t" r="r" b="b"/>
            <a:pathLst>
              <a:path w="880983" h="1544762">
                <a:moveTo>
                  <a:pt x="0" y="1019678"/>
                </a:moveTo>
                <a:cubicBezTo>
                  <a:pt x="38100" y="781553"/>
                  <a:pt x="59268" y="543164"/>
                  <a:pt x="73026" y="379916"/>
                </a:cubicBezTo>
                <a:cubicBezTo>
                  <a:pt x="86784" y="216668"/>
                  <a:pt x="120121" y="-134699"/>
                  <a:pt x="139700" y="54478"/>
                </a:cubicBezTo>
                <a:cubicBezTo>
                  <a:pt x="159279" y="243655"/>
                  <a:pt x="169333" y="1358345"/>
                  <a:pt x="190500" y="1514978"/>
                </a:cubicBezTo>
                <a:cubicBezTo>
                  <a:pt x="211667" y="1671611"/>
                  <a:pt x="245533" y="1167845"/>
                  <a:pt x="266700" y="994278"/>
                </a:cubicBezTo>
                <a:cubicBezTo>
                  <a:pt x="287867" y="820711"/>
                  <a:pt x="302683" y="522261"/>
                  <a:pt x="317500" y="473578"/>
                </a:cubicBezTo>
                <a:cubicBezTo>
                  <a:pt x="332317" y="424895"/>
                  <a:pt x="351367" y="566712"/>
                  <a:pt x="355600" y="702178"/>
                </a:cubicBezTo>
                <a:cubicBezTo>
                  <a:pt x="359833" y="837644"/>
                  <a:pt x="345017" y="1174195"/>
                  <a:pt x="342900" y="1286378"/>
                </a:cubicBezTo>
                <a:cubicBezTo>
                  <a:pt x="340783" y="1398561"/>
                  <a:pt x="334566" y="1454521"/>
                  <a:pt x="342900" y="1375278"/>
                </a:cubicBezTo>
                <a:cubicBezTo>
                  <a:pt x="351234" y="1296035"/>
                  <a:pt x="380603" y="951019"/>
                  <a:pt x="392906" y="810922"/>
                </a:cubicBezTo>
                <a:cubicBezTo>
                  <a:pt x="405209" y="670825"/>
                  <a:pt x="409443" y="623465"/>
                  <a:pt x="416719" y="534697"/>
                </a:cubicBezTo>
                <a:cubicBezTo>
                  <a:pt x="423995" y="445929"/>
                  <a:pt x="431272" y="296968"/>
                  <a:pt x="436563" y="278315"/>
                </a:cubicBezTo>
                <a:cubicBezTo>
                  <a:pt x="441854" y="259662"/>
                  <a:pt x="444896" y="301335"/>
                  <a:pt x="448468" y="422779"/>
                </a:cubicBezTo>
                <a:cubicBezTo>
                  <a:pt x="452040" y="544223"/>
                  <a:pt x="440928" y="1159378"/>
                  <a:pt x="469900" y="1197478"/>
                </a:cubicBezTo>
                <a:cubicBezTo>
                  <a:pt x="498872" y="1235578"/>
                  <a:pt x="582083" y="647145"/>
                  <a:pt x="622300" y="651378"/>
                </a:cubicBezTo>
                <a:cubicBezTo>
                  <a:pt x="662517" y="655611"/>
                  <a:pt x="683683" y="1184778"/>
                  <a:pt x="711200" y="1222878"/>
                </a:cubicBezTo>
                <a:cubicBezTo>
                  <a:pt x="738717" y="1260978"/>
                  <a:pt x="759103" y="896753"/>
                  <a:pt x="787400" y="879978"/>
                </a:cubicBezTo>
                <a:cubicBezTo>
                  <a:pt x="815697" y="863203"/>
                  <a:pt x="855583" y="1014275"/>
                  <a:pt x="880983" y="1122225"/>
                </a:cubicBezTo>
              </a:path>
            </a:pathLst>
          </a:custGeom>
          <a:noFill/>
          <a:ln w="9525">
            <a:solidFill>
              <a:srgbClr val="EB292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81" name="直接连接符 280">
            <a:extLst>
              <a:ext uri="{FF2B5EF4-FFF2-40B4-BE49-F238E27FC236}">
                <a16:creationId xmlns:a16="http://schemas.microsoft.com/office/drawing/2014/main" id="{DDD3920F-F808-499D-ACE8-642801DA7651}"/>
              </a:ext>
            </a:extLst>
          </p:cNvPr>
          <p:cNvCxnSpPr>
            <a:cxnSpLocks/>
          </p:cNvCxnSpPr>
          <p:nvPr/>
        </p:nvCxnSpPr>
        <p:spPr>
          <a:xfrm flipH="1">
            <a:off x="7279468" y="7537023"/>
            <a:ext cx="364629" cy="13409"/>
          </a:xfrm>
          <a:prstGeom prst="line">
            <a:avLst/>
          </a:prstGeom>
          <a:ln w="9525">
            <a:solidFill>
              <a:srgbClr val="EB292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直接连接符 281">
            <a:extLst>
              <a:ext uri="{FF2B5EF4-FFF2-40B4-BE49-F238E27FC236}">
                <a16:creationId xmlns:a16="http://schemas.microsoft.com/office/drawing/2014/main" id="{70674603-EF72-40BA-97F7-AA502C041F1F}"/>
              </a:ext>
            </a:extLst>
          </p:cNvPr>
          <p:cNvCxnSpPr/>
          <p:nvPr/>
        </p:nvCxnSpPr>
        <p:spPr>
          <a:xfrm flipH="1">
            <a:off x="8137350" y="7574502"/>
            <a:ext cx="167362" cy="4637"/>
          </a:xfrm>
          <a:prstGeom prst="line">
            <a:avLst/>
          </a:prstGeom>
          <a:ln w="9525">
            <a:solidFill>
              <a:srgbClr val="EB292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9" name="立方体 318">
            <a:extLst>
              <a:ext uri="{FF2B5EF4-FFF2-40B4-BE49-F238E27FC236}">
                <a16:creationId xmlns:a16="http://schemas.microsoft.com/office/drawing/2014/main" id="{DDC71E5D-C5F9-46DA-892D-4E2F4C66509A}"/>
              </a:ext>
            </a:extLst>
          </p:cNvPr>
          <p:cNvSpPr/>
          <p:nvPr/>
        </p:nvSpPr>
        <p:spPr>
          <a:xfrm>
            <a:off x="5792717" y="8905984"/>
            <a:ext cx="1686833" cy="1478011"/>
          </a:xfrm>
          <a:prstGeom prst="cube">
            <a:avLst>
              <a:gd name="adj" fmla="val 94212"/>
            </a:avLst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3"/>
              </a:gs>
            </a:gsLst>
            <a:lin ang="5400000" scaled="1"/>
          </a:gra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0" name="立方体 319">
            <a:extLst>
              <a:ext uri="{FF2B5EF4-FFF2-40B4-BE49-F238E27FC236}">
                <a16:creationId xmlns:a16="http://schemas.microsoft.com/office/drawing/2014/main" id="{C3D273EE-3403-4E34-B6BF-A996C857EA5D}"/>
              </a:ext>
            </a:extLst>
          </p:cNvPr>
          <p:cNvSpPr/>
          <p:nvPr/>
        </p:nvSpPr>
        <p:spPr>
          <a:xfrm>
            <a:off x="6571001" y="8908393"/>
            <a:ext cx="1666769" cy="1478011"/>
          </a:xfrm>
          <a:prstGeom prst="cube">
            <a:avLst>
              <a:gd name="adj" fmla="val 94212"/>
            </a:avLst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3"/>
              </a:gs>
            </a:gsLst>
            <a:lin ang="5400000" scaled="1"/>
          </a:gra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1" name="立方体 320">
            <a:extLst>
              <a:ext uri="{FF2B5EF4-FFF2-40B4-BE49-F238E27FC236}">
                <a16:creationId xmlns:a16="http://schemas.microsoft.com/office/drawing/2014/main" id="{662B5648-4F13-41AB-B1F1-41926F2E8C94}"/>
              </a:ext>
            </a:extLst>
          </p:cNvPr>
          <p:cNvSpPr/>
          <p:nvPr/>
        </p:nvSpPr>
        <p:spPr>
          <a:xfrm>
            <a:off x="8135439" y="8913992"/>
            <a:ext cx="1672526" cy="1478011"/>
          </a:xfrm>
          <a:prstGeom prst="cube">
            <a:avLst>
              <a:gd name="adj" fmla="val 94212"/>
            </a:avLst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3"/>
              </a:gs>
            </a:gsLst>
            <a:lin ang="5400000" scaled="1"/>
          </a:gra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70" name="组合 169">
            <a:extLst>
              <a:ext uri="{FF2B5EF4-FFF2-40B4-BE49-F238E27FC236}">
                <a16:creationId xmlns:a16="http://schemas.microsoft.com/office/drawing/2014/main" id="{B04D1A40-F271-4000-ABD2-9B1D1CC2540D}"/>
              </a:ext>
            </a:extLst>
          </p:cNvPr>
          <p:cNvGrpSpPr/>
          <p:nvPr/>
        </p:nvGrpSpPr>
        <p:grpSpPr>
          <a:xfrm flipH="1">
            <a:off x="1323531" y="7102872"/>
            <a:ext cx="651269" cy="1085072"/>
            <a:chOff x="8582434" y="4065623"/>
            <a:chExt cx="709203" cy="1181595"/>
          </a:xfrm>
        </p:grpSpPr>
        <p:sp>
          <p:nvSpPr>
            <p:cNvPr id="171" name="任意多边形: 形状 170">
              <a:extLst>
                <a:ext uri="{FF2B5EF4-FFF2-40B4-BE49-F238E27FC236}">
                  <a16:creationId xmlns:a16="http://schemas.microsoft.com/office/drawing/2014/main" id="{FA0FBF51-A3D0-4D3B-ABC1-F1CFE3C072B4}"/>
                </a:ext>
              </a:extLst>
            </p:cNvPr>
            <p:cNvSpPr/>
            <p:nvPr/>
          </p:nvSpPr>
          <p:spPr>
            <a:xfrm>
              <a:off x="8582434" y="4065623"/>
              <a:ext cx="696467" cy="1181595"/>
            </a:xfrm>
            <a:custGeom>
              <a:avLst/>
              <a:gdLst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197857 w 2783758"/>
                <a:gd name="connsiteY22" fmla="*/ 1544904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289297 w 2783758"/>
                <a:gd name="connsiteY22" fmla="*/ 1636344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2783758" h="4722803">
                  <a:moveTo>
                    <a:pt x="197857" y="1544904"/>
                  </a:moveTo>
                  <a:cubicBezTo>
                    <a:pt x="212605" y="1330233"/>
                    <a:pt x="240463" y="982826"/>
                    <a:pt x="335508" y="768155"/>
                  </a:cubicBezTo>
                  <a:cubicBezTo>
                    <a:pt x="430553" y="553484"/>
                    <a:pt x="623920" y="379781"/>
                    <a:pt x="768127" y="256878"/>
                  </a:cubicBezTo>
                  <a:cubicBezTo>
                    <a:pt x="912334" y="133975"/>
                    <a:pt x="1036876" y="66788"/>
                    <a:pt x="1200747" y="30736"/>
                  </a:cubicBezTo>
                  <a:cubicBezTo>
                    <a:pt x="1364618" y="-5316"/>
                    <a:pt x="1569456" y="-18425"/>
                    <a:pt x="1751353" y="40568"/>
                  </a:cubicBezTo>
                  <a:cubicBezTo>
                    <a:pt x="1933250" y="99561"/>
                    <a:pt x="2151198" y="224103"/>
                    <a:pt x="2292127" y="384697"/>
                  </a:cubicBezTo>
                  <a:cubicBezTo>
                    <a:pt x="2433056" y="545291"/>
                    <a:pt x="2514992" y="773072"/>
                    <a:pt x="2596927" y="1004130"/>
                  </a:cubicBezTo>
                  <a:cubicBezTo>
                    <a:pt x="2678862" y="1235188"/>
                    <a:pt x="2782101" y="1503936"/>
                    <a:pt x="2783740" y="1771046"/>
                  </a:cubicBezTo>
                  <a:cubicBezTo>
                    <a:pt x="2785379" y="2038156"/>
                    <a:pt x="2678863" y="2380646"/>
                    <a:pt x="2606760" y="2606788"/>
                  </a:cubicBezTo>
                  <a:cubicBezTo>
                    <a:pt x="2534657" y="2832930"/>
                    <a:pt x="2446166" y="2954194"/>
                    <a:pt x="2351121" y="3127897"/>
                  </a:cubicBezTo>
                  <a:cubicBezTo>
                    <a:pt x="2256076" y="3301600"/>
                    <a:pt x="2146282" y="3512994"/>
                    <a:pt x="2036489" y="3649007"/>
                  </a:cubicBezTo>
                  <a:cubicBezTo>
                    <a:pt x="1926696" y="3785020"/>
                    <a:pt x="1816902" y="3840736"/>
                    <a:pt x="1692360" y="3943975"/>
                  </a:cubicBezTo>
                  <a:cubicBezTo>
                    <a:pt x="1567818" y="4047214"/>
                    <a:pt x="1431805" y="4142258"/>
                    <a:pt x="1289237" y="4268439"/>
                  </a:cubicBezTo>
                  <a:cubicBezTo>
                    <a:pt x="1146669" y="4394620"/>
                    <a:pt x="982798" y="4640427"/>
                    <a:pt x="836953" y="4701059"/>
                  </a:cubicBezTo>
                  <a:cubicBezTo>
                    <a:pt x="691108" y="4761691"/>
                    <a:pt x="522321" y="4681394"/>
                    <a:pt x="414166" y="4632233"/>
                  </a:cubicBezTo>
                  <a:cubicBezTo>
                    <a:pt x="306011" y="4583072"/>
                    <a:pt x="230630" y="4517523"/>
                    <a:pt x="188024" y="4406091"/>
                  </a:cubicBezTo>
                  <a:cubicBezTo>
                    <a:pt x="145418" y="4294659"/>
                    <a:pt x="178192" y="4084904"/>
                    <a:pt x="158527" y="3963639"/>
                  </a:cubicBezTo>
                  <a:cubicBezTo>
                    <a:pt x="138862" y="3842374"/>
                    <a:pt x="96256" y="3770272"/>
                    <a:pt x="70037" y="3678504"/>
                  </a:cubicBezTo>
                  <a:cubicBezTo>
                    <a:pt x="43818" y="3586736"/>
                    <a:pt x="-8621" y="3491691"/>
                    <a:pt x="1211" y="3413033"/>
                  </a:cubicBezTo>
                  <a:cubicBezTo>
                    <a:pt x="11043" y="3334375"/>
                    <a:pt x="89702" y="3306516"/>
                    <a:pt x="129031" y="3206555"/>
                  </a:cubicBezTo>
                  <a:cubicBezTo>
                    <a:pt x="168360" y="3106594"/>
                    <a:pt x="217521" y="3004994"/>
                    <a:pt x="237186" y="2813265"/>
                  </a:cubicBezTo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2" name="任意多边形: 形状 171">
              <a:extLst>
                <a:ext uri="{FF2B5EF4-FFF2-40B4-BE49-F238E27FC236}">
                  <a16:creationId xmlns:a16="http://schemas.microsoft.com/office/drawing/2014/main" id="{98D04732-A2A8-4BF6-B76E-7EB5383BB5A6}"/>
                </a:ext>
              </a:extLst>
            </p:cNvPr>
            <p:cNvSpPr/>
            <p:nvPr/>
          </p:nvSpPr>
          <p:spPr>
            <a:xfrm>
              <a:off x="8612693" y="4065623"/>
              <a:ext cx="678944" cy="1181595"/>
            </a:xfrm>
            <a:custGeom>
              <a:avLst/>
              <a:gdLst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197857 w 2783758"/>
                <a:gd name="connsiteY22" fmla="*/ 1544904 h 4722803"/>
                <a:gd name="connsiteX0" fmla="*/ 247018 w 2783758"/>
                <a:gd name="connsiteY0" fmla="*/ 2056181 h 4722803"/>
                <a:gd name="connsiteX1" fmla="*/ 197857 w 2783758"/>
                <a:gd name="connsiteY1" fmla="*/ 1544904 h 4722803"/>
                <a:gd name="connsiteX2" fmla="*/ 335508 w 2783758"/>
                <a:gd name="connsiteY2" fmla="*/ 768155 h 4722803"/>
                <a:gd name="connsiteX3" fmla="*/ 768127 w 2783758"/>
                <a:gd name="connsiteY3" fmla="*/ 256878 h 4722803"/>
                <a:gd name="connsiteX4" fmla="*/ 1200747 w 2783758"/>
                <a:gd name="connsiteY4" fmla="*/ 30736 h 4722803"/>
                <a:gd name="connsiteX5" fmla="*/ 1751353 w 2783758"/>
                <a:gd name="connsiteY5" fmla="*/ 40568 h 4722803"/>
                <a:gd name="connsiteX6" fmla="*/ 2292127 w 2783758"/>
                <a:gd name="connsiteY6" fmla="*/ 384697 h 4722803"/>
                <a:gd name="connsiteX7" fmla="*/ 2596927 w 2783758"/>
                <a:gd name="connsiteY7" fmla="*/ 1004130 h 4722803"/>
                <a:gd name="connsiteX8" fmla="*/ 2783740 w 2783758"/>
                <a:gd name="connsiteY8" fmla="*/ 1771046 h 4722803"/>
                <a:gd name="connsiteX9" fmla="*/ 2606760 w 2783758"/>
                <a:gd name="connsiteY9" fmla="*/ 2606788 h 4722803"/>
                <a:gd name="connsiteX10" fmla="*/ 2351121 w 2783758"/>
                <a:gd name="connsiteY10" fmla="*/ 3127897 h 4722803"/>
                <a:gd name="connsiteX11" fmla="*/ 2036489 w 2783758"/>
                <a:gd name="connsiteY11" fmla="*/ 3649007 h 4722803"/>
                <a:gd name="connsiteX12" fmla="*/ 1692360 w 2783758"/>
                <a:gd name="connsiteY12" fmla="*/ 3943975 h 4722803"/>
                <a:gd name="connsiteX13" fmla="*/ 1289237 w 2783758"/>
                <a:gd name="connsiteY13" fmla="*/ 4268439 h 4722803"/>
                <a:gd name="connsiteX14" fmla="*/ 836953 w 2783758"/>
                <a:gd name="connsiteY14" fmla="*/ 4701059 h 4722803"/>
                <a:gd name="connsiteX15" fmla="*/ 414166 w 2783758"/>
                <a:gd name="connsiteY15" fmla="*/ 4632233 h 4722803"/>
                <a:gd name="connsiteX16" fmla="*/ 188024 w 2783758"/>
                <a:gd name="connsiteY16" fmla="*/ 4406091 h 4722803"/>
                <a:gd name="connsiteX17" fmla="*/ 158527 w 2783758"/>
                <a:gd name="connsiteY17" fmla="*/ 3963639 h 4722803"/>
                <a:gd name="connsiteX18" fmla="*/ 70037 w 2783758"/>
                <a:gd name="connsiteY18" fmla="*/ 3678504 h 4722803"/>
                <a:gd name="connsiteX19" fmla="*/ 1211 w 2783758"/>
                <a:gd name="connsiteY19" fmla="*/ 3413033 h 4722803"/>
                <a:gd name="connsiteX20" fmla="*/ 129031 w 2783758"/>
                <a:gd name="connsiteY20" fmla="*/ 3206555 h 4722803"/>
                <a:gd name="connsiteX21" fmla="*/ 237186 w 2783758"/>
                <a:gd name="connsiteY21" fmla="*/ 2813265 h 4722803"/>
                <a:gd name="connsiteX22" fmla="*/ 338458 w 2783758"/>
                <a:gd name="connsiteY22" fmla="*/ 2147621 h 4722803"/>
                <a:gd name="connsiteX0" fmla="*/ 247018 w 2783758"/>
                <a:gd name="connsiteY0" fmla="*/ 2056181 h 4722803"/>
                <a:gd name="connsiteX1" fmla="*/ 197857 w 2783758"/>
                <a:gd name="connsiteY1" fmla="*/ 1544904 h 4722803"/>
                <a:gd name="connsiteX2" fmla="*/ 335508 w 2783758"/>
                <a:gd name="connsiteY2" fmla="*/ 768155 h 4722803"/>
                <a:gd name="connsiteX3" fmla="*/ 768127 w 2783758"/>
                <a:gd name="connsiteY3" fmla="*/ 256878 h 4722803"/>
                <a:gd name="connsiteX4" fmla="*/ 1200747 w 2783758"/>
                <a:gd name="connsiteY4" fmla="*/ 30736 h 4722803"/>
                <a:gd name="connsiteX5" fmla="*/ 1751353 w 2783758"/>
                <a:gd name="connsiteY5" fmla="*/ 40568 h 4722803"/>
                <a:gd name="connsiteX6" fmla="*/ 2292127 w 2783758"/>
                <a:gd name="connsiteY6" fmla="*/ 384697 h 4722803"/>
                <a:gd name="connsiteX7" fmla="*/ 2596927 w 2783758"/>
                <a:gd name="connsiteY7" fmla="*/ 1004130 h 4722803"/>
                <a:gd name="connsiteX8" fmla="*/ 2783740 w 2783758"/>
                <a:gd name="connsiteY8" fmla="*/ 1771046 h 4722803"/>
                <a:gd name="connsiteX9" fmla="*/ 2606760 w 2783758"/>
                <a:gd name="connsiteY9" fmla="*/ 2606788 h 4722803"/>
                <a:gd name="connsiteX10" fmla="*/ 2351121 w 2783758"/>
                <a:gd name="connsiteY10" fmla="*/ 3127897 h 4722803"/>
                <a:gd name="connsiteX11" fmla="*/ 2036489 w 2783758"/>
                <a:gd name="connsiteY11" fmla="*/ 3649007 h 4722803"/>
                <a:gd name="connsiteX12" fmla="*/ 1692360 w 2783758"/>
                <a:gd name="connsiteY12" fmla="*/ 3943975 h 4722803"/>
                <a:gd name="connsiteX13" fmla="*/ 1289237 w 2783758"/>
                <a:gd name="connsiteY13" fmla="*/ 4268439 h 4722803"/>
                <a:gd name="connsiteX14" fmla="*/ 836953 w 2783758"/>
                <a:gd name="connsiteY14" fmla="*/ 4701059 h 4722803"/>
                <a:gd name="connsiteX15" fmla="*/ 414166 w 2783758"/>
                <a:gd name="connsiteY15" fmla="*/ 4632233 h 4722803"/>
                <a:gd name="connsiteX16" fmla="*/ 188024 w 2783758"/>
                <a:gd name="connsiteY16" fmla="*/ 4406091 h 4722803"/>
                <a:gd name="connsiteX17" fmla="*/ 158527 w 2783758"/>
                <a:gd name="connsiteY17" fmla="*/ 3963639 h 4722803"/>
                <a:gd name="connsiteX18" fmla="*/ 70037 w 2783758"/>
                <a:gd name="connsiteY18" fmla="*/ 3678504 h 4722803"/>
                <a:gd name="connsiteX19" fmla="*/ 1211 w 2783758"/>
                <a:gd name="connsiteY19" fmla="*/ 3413033 h 4722803"/>
                <a:gd name="connsiteX20" fmla="*/ 129031 w 2783758"/>
                <a:gd name="connsiteY20" fmla="*/ 3206555 h 4722803"/>
                <a:gd name="connsiteX21" fmla="*/ 237186 w 2783758"/>
                <a:gd name="connsiteY21" fmla="*/ 281326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0" fmla="*/ 127820 w 2713721"/>
                <a:gd name="connsiteY0" fmla="*/ 1544904 h 4722803"/>
                <a:gd name="connsiteX1" fmla="*/ 265471 w 2713721"/>
                <a:gd name="connsiteY1" fmla="*/ 768155 h 4722803"/>
                <a:gd name="connsiteX2" fmla="*/ 698090 w 2713721"/>
                <a:gd name="connsiteY2" fmla="*/ 256878 h 4722803"/>
                <a:gd name="connsiteX3" fmla="*/ 1130710 w 2713721"/>
                <a:gd name="connsiteY3" fmla="*/ 30736 h 4722803"/>
                <a:gd name="connsiteX4" fmla="*/ 1681316 w 2713721"/>
                <a:gd name="connsiteY4" fmla="*/ 40568 h 4722803"/>
                <a:gd name="connsiteX5" fmla="*/ 2222090 w 2713721"/>
                <a:gd name="connsiteY5" fmla="*/ 384697 h 4722803"/>
                <a:gd name="connsiteX6" fmla="*/ 2526890 w 2713721"/>
                <a:gd name="connsiteY6" fmla="*/ 1004130 h 4722803"/>
                <a:gd name="connsiteX7" fmla="*/ 2713703 w 2713721"/>
                <a:gd name="connsiteY7" fmla="*/ 1771046 h 4722803"/>
                <a:gd name="connsiteX8" fmla="*/ 2536723 w 2713721"/>
                <a:gd name="connsiteY8" fmla="*/ 2606788 h 4722803"/>
                <a:gd name="connsiteX9" fmla="*/ 2281084 w 2713721"/>
                <a:gd name="connsiteY9" fmla="*/ 3127897 h 4722803"/>
                <a:gd name="connsiteX10" fmla="*/ 1966452 w 2713721"/>
                <a:gd name="connsiteY10" fmla="*/ 3649007 h 4722803"/>
                <a:gd name="connsiteX11" fmla="*/ 1622323 w 2713721"/>
                <a:gd name="connsiteY11" fmla="*/ 3943975 h 4722803"/>
                <a:gd name="connsiteX12" fmla="*/ 1219200 w 2713721"/>
                <a:gd name="connsiteY12" fmla="*/ 4268439 h 4722803"/>
                <a:gd name="connsiteX13" fmla="*/ 766916 w 2713721"/>
                <a:gd name="connsiteY13" fmla="*/ 4701059 h 4722803"/>
                <a:gd name="connsiteX14" fmla="*/ 344129 w 2713721"/>
                <a:gd name="connsiteY14" fmla="*/ 4632233 h 4722803"/>
                <a:gd name="connsiteX15" fmla="*/ 117987 w 2713721"/>
                <a:gd name="connsiteY15" fmla="*/ 4406091 h 4722803"/>
                <a:gd name="connsiteX16" fmla="*/ 88490 w 2713721"/>
                <a:gd name="connsiteY16" fmla="*/ 3963639 h 4722803"/>
                <a:gd name="connsiteX17" fmla="*/ 0 w 2713721"/>
                <a:gd name="connsiteY17" fmla="*/ 3678504 h 47228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2713721" h="4722803">
                  <a:moveTo>
                    <a:pt x="127820" y="1544904"/>
                  </a:moveTo>
                  <a:cubicBezTo>
                    <a:pt x="142568" y="1330233"/>
                    <a:pt x="170426" y="982826"/>
                    <a:pt x="265471" y="768155"/>
                  </a:cubicBezTo>
                  <a:cubicBezTo>
                    <a:pt x="360516" y="553484"/>
                    <a:pt x="553883" y="379781"/>
                    <a:pt x="698090" y="256878"/>
                  </a:cubicBezTo>
                  <a:cubicBezTo>
                    <a:pt x="842297" y="133975"/>
                    <a:pt x="966839" y="66788"/>
                    <a:pt x="1130710" y="30736"/>
                  </a:cubicBezTo>
                  <a:cubicBezTo>
                    <a:pt x="1294581" y="-5316"/>
                    <a:pt x="1499419" y="-18425"/>
                    <a:pt x="1681316" y="40568"/>
                  </a:cubicBezTo>
                  <a:cubicBezTo>
                    <a:pt x="1863213" y="99561"/>
                    <a:pt x="2081161" y="224103"/>
                    <a:pt x="2222090" y="384697"/>
                  </a:cubicBezTo>
                  <a:cubicBezTo>
                    <a:pt x="2363019" y="545291"/>
                    <a:pt x="2444955" y="773072"/>
                    <a:pt x="2526890" y="1004130"/>
                  </a:cubicBezTo>
                  <a:cubicBezTo>
                    <a:pt x="2608825" y="1235188"/>
                    <a:pt x="2712064" y="1503936"/>
                    <a:pt x="2713703" y="1771046"/>
                  </a:cubicBezTo>
                  <a:cubicBezTo>
                    <a:pt x="2715342" y="2038156"/>
                    <a:pt x="2608826" y="2380646"/>
                    <a:pt x="2536723" y="2606788"/>
                  </a:cubicBezTo>
                  <a:cubicBezTo>
                    <a:pt x="2464620" y="2832930"/>
                    <a:pt x="2376129" y="2954194"/>
                    <a:pt x="2281084" y="3127897"/>
                  </a:cubicBezTo>
                  <a:cubicBezTo>
                    <a:pt x="2186039" y="3301600"/>
                    <a:pt x="2076245" y="3512994"/>
                    <a:pt x="1966452" y="3649007"/>
                  </a:cubicBezTo>
                  <a:cubicBezTo>
                    <a:pt x="1856659" y="3785020"/>
                    <a:pt x="1746865" y="3840736"/>
                    <a:pt x="1622323" y="3943975"/>
                  </a:cubicBezTo>
                  <a:cubicBezTo>
                    <a:pt x="1497781" y="4047214"/>
                    <a:pt x="1361768" y="4142258"/>
                    <a:pt x="1219200" y="4268439"/>
                  </a:cubicBezTo>
                  <a:cubicBezTo>
                    <a:pt x="1076632" y="4394620"/>
                    <a:pt x="912761" y="4640427"/>
                    <a:pt x="766916" y="4701059"/>
                  </a:cubicBezTo>
                  <a:cubicBezTo>
                    <a:pt x="621071" y="4761691"/>
                    <a:pt x="452284" y="4681394"/>
                    <a:pt x="344129" y="4632233"/>
                  </a:cubicBezTo>
                  <a:cubicBezTo>
                    <a:pt x="235974" y="4583072"/>
                    <a:pt x="160593" y="4517523"/>
                    <a:pt x="117987" y="4406091"/>
                  </a:cubicBezTo>
                  <a:cubicBezTo>
                    <a:pt x="75381" y="4294659"/>
                    <a:pt x="108155" y="4084904"/>
                    <a:pt x="88490" y="3963639"/>
                  </a:cubicBezTo>
                  <a:cubicBezTo>
                    <a:pt x="68825" y="3842374"/>
                    <a:pt x="26219" y="3770272"/>
                    <a:pt x="0" y="3678504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3" name="任意多边形: 形状 172">
              <a:extLst>
                <a:ext uri="{FF2B5EF4-FFF2-40B4-BE49-F238E27FC236}">
                  <a16:creationId xmlns:a16="http://schemas.microsoft.com/office/drawing/2014/main" id="{877BDABF-9896-4B59-80E6-6FA692F3EEA0}"/>
                </a:ext>
              </a:extLst>
            </p:cNvPr>
            <p:cNvSpPr/>
            <p:nvPr/>
          </p:nvSpPr>
          <p:spPr>
            <a:xfrm>
              <a:off x="8739933" y="4587190"/>
              <a:ext cx="108237" cy="108237"/>
            </a:xfrm>
            <a:custGeom>
              <a:avLst/>
              <a:gdLst>
                <a:gd name="connsiteX0" fmla="*/ 0 w 1101213"/>
                <a:gd name="connsiteY0" fmla="*/ 0 h 865238"/>
                <a:gd name="connsiteX1" fmla="*/ 98323 w 1101213"/>
                <a:gd name="connsiteY1" fmla="*/ 206477 h 865238"/>
                <a:gd name="connsiteX2" fmla="*/ 265471 w 1101213"/>
                <a:gd name="connsiteY2" fmla="*/ 373625 h 865238"/>
                <a:gd name="connsiteX3" fmla="*/ 432619 w 1101213"/>
                <a:gd name="connsiteY3" fmla="*/ 432619 h 865238"/>
                <a:gd name="connsiteX4" fmla="*/ 786581 w 1101213"/>
                <a:gd name="connsiteY4" fmla="*/ 550606 h 865238"/>
                <a:gd name="connsiteX5" fmla="*/ 1002890 w 1101213"/>
                <a:gd name="connsiteY5" fmla="*/ 639096 h 865238"/>
                <a:gd name="connsiteX6" fmla="*/ 1081548 w 1101213"/>
                <a:gd name="connsiteY6" fmla="*/ 786580 h 865238"/>
                <a:gd name="connsiteX7" fmla="*/ 1101213 w 1101213"/>
                <a:gd name="connsiteY7" fmla="*/ 865238 h 865238"/>
                <a:gd name="connsiteX0" fmla="*/ 0 w 1082429"/>
                <a:gd name="connsiteY0" fmla="*/ 0 h 941438"/>
                <a:gd name="connsiteX1" fmla="*/ 98323 w 1082429"/>
                <a:gd name="connsiteY1" fmla="*/ 206477 h 941438"/>
                <a:gd name="connsiteX2" fmla="*/ 265471 w 1082429"/>
                <a:gd name="connsiteY2" fmla="*/ 373625 h 941438"/>
                <a:gd name="connsiteX3" fmla="*/ 432619 w 1082429"/>
                <a:gd name="connsiteY3" fmla="*/ 432619 h 941438"/>
                <a:gd name="connsiteX4" fmla="*/ 786581 w 1082429"/>
                <a:gd name="connsiteY4" fmla="*/ 550606 h 941438"/>
                <a:gd name="connsiteX5" fmla="*/ 1002890 w 1082429"/>
                <a:gd name="connsiteY5" fmla="*/ 639096 h 941438"/>
                <a:gd name="connsiteX6" fmla="*/ 1081548 w 1082429"/>
                <a:gd name="connsiteY6" fmla="*/ 786580 h 941438"/>
                <a:gd name="connsiteX7" fmla="*/ 1047873 w 1082429"/>
                <a:gd name="connsiteY7" fmla="*/ 941438 h 941438"/>
                <a:gd name="connsiteX0" fmla="*/ 0 w 1081550"/>
                <a:gd name="connsiteY0" fmla="*/ 0 h 786579"/>
                <a:gd name="connsiteX1" fmla="*/ 98323 w 1081550"/>
                <a:gd name="connsiteY1" fmla="*/ 206477 h 786579"/>
                <a:gd name="connsiteX2" fmla="*/ 265471 w 1081550"/>
                <a:gd name="connsiteY2" fmla="*/ 373625 h 786579"/>
                <a:gd name="connsiteX3" fmla="*/ 432619 w 1081550"/>
                <a:gd name="connsiteY3" fmla="*/ 432619 h 786579"/>
                <a:gd name="connsiteX4" fmla="*/ 786581 w 1081550"/>
                <a:gd name="connsiteY4" fmla="*/ 550606 h 786579"/>
                <a:gd name="connsiteX5" fmla="*/ 1002890 w 1081550"/>
                <a:gd name="connsiteY5" fmla="*/ 639096 h 786579"/>
                <a:gd name="connsiteX6" fmla="*/ 1081548 w 1081550"/>
                <a:gd name="connsiteY6" fmla="*/ 786580 h 786579"/>
                <a:gd name="connsiteX0" fmla="*/ 0 w 1002889"/>
                <a:gd name="connsiteY0" fmla="*/ 0 h 639095"/>
                <a:gd name="connsiteX1" fmla="*/ 98323 w 1002889"/>
                <a:gd name="connsiteY1" fmla="*/ 206477 h 639095"/>
                <a:gd name="connsiteX2" fmla="*/ 265471 w 1002889"/>
                <a:gd name="connsiteY2" fmla="*/ 373625 h 639095"/>
                <a:gd name="connsiteX3" fmla="*/ 432619 w 1002889"/>
                <a:gd name="connsiteY3" fmla="*/ 432619 h 639095"/>
                <a:gd name="connsiteX4" fmla="*/ 786581 w 1002889"/>
                <a:gd name="connsiteY4" fmla="*/ 550606 h 639095"/>
                <a:gd name="connsiteX5" fmla="*/ 1002890 w 1002889"/>
                <a:gd name="connsiteY5" fmla="*/ 639096 h 639095"/>
                <a:gd name="connsiteX0" fmla="*/ 0 w 786581"/>
                <a:gd name="connsiteY0" fmla="*/ 0 h 550606"/>
                <a:gd name="connsiteX1" fmla="*/ 98323 w 786581"/>
                <a:gd name="connsiteY1" fmla="*/ 206477 h 550606"/>
                <a:gd name="connsiteX2" fmla="*/ 265471 w 786581"/>
                <a:gd name="connsiteY2" fmla="*/ 373625 h 550606"/>
                <a:gd name="connsiteX3" fmla="*/ 432619 w 786581"/>
                <a:gd name="connsiteY3" fmla="*/ 432619 h 550606"/>
                <a:gd name="connsiteX4" fmla="*/ 786581 w 786581"/>
                <a:gd name="connsiteY4" fmla="*/ 550606 h 550606"/>
                <a:gd name="connsiteX0" fmla="*/ 0 w 432621"/>
                <a:gd name="connsiteY0" fmla="*/ 0 h 432620"/>
                <a:gd name="connsiteX1" fmla="*/ 98323 w 432621"/>
                <a:gd name="connsiteY1" fmla="*/ 206477 h 432620"/>
                <a:gd name="connsiteX2" fmla="*/ 265471 w 432621"/>
                <a:gd name="connsiteY2" fmla="*/ 373625 h 432620"/>
                <a:gd name="connsiteX3" fmla="*/ 432619 w 432621"/>
                <a:gd name="connsiteY3" fmla="*/ 432619 h 4326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2621" h="432620">
                  <a:moveTo>
                    <a:pt x="0" y="0"/>
                  </a:moveTo>
                  <a:cubicBezTo>
                    <a:pt x="27039" y="72103"/>
                    <a:pt x="54078" y="144206"/>
                    <a:pt x="98323" y="206477"/>
                  </a:cubicBezTo>
                  <a:cubicBezTo>
                    <a:pt x="142568" y="268748"/>
                    <a:pt x="209755" y="335935"/>
                    <a:pt x="265471" y="373625"/>
                  </a:cubicBezTo>
                  <a:cubicBezTo>
                    <a:pt x="321187" y="411315"/>
                    <a:pt x="432619" y="432619"/>
                    <a:pt x="432619" y="43261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4" name="任意多边形: 形状 173">
              <a:extLst>
                <a:ext uri="{FF2B5EF4-FFF2-40B4-BE49-F238E27FC236}">
                  <a16:creationId xmlns:a16="http://schemas.microsoft.com/office/drawing/2014/main" id="{338A1BDB-0A88-4727-8904-8FCC88DE4E3F}"/>
                </a:ext>
              </a:extLst>
            </p:cNvPr>
            <p:cNvSpPr/>
            <p:nvPr/>
          </p:nvSpPr>
          <p:spPr>
            <a:xfrm>
              <a:off x="8676250" y="4687911"/>
              <a:ext cx="330999" cy="296865"/>
            </a:xfrm>
            <a:custGeom>
              <a:avLst/>
              <a:gdLst>
                <a:gd name="connsiteX0" fmla="*/ 506751 w 1322993"/>
                <a:gd name="connsiteY0" fmla="*/ 1530 h 1186562"/>
                <a:gd name="connsiteX1" fmla="*/ 880376 w 1322993"/>
                <a:gd name="connsiteY1" fmla="*/ 149013 h 1186562"/>
                <a:gd name="connsiteX2" fmla="*/ 1214673 w 1322993"/>
                <a:gd name="connsiteY2" fmla="*/ 267001 h 1186562"/>
                <a:gd name="connsiteX3" fmla="*/ 1322828 w 1322993"/>
                <a:gd name="connsiteY3" fmla="*/ 384988 h 1186562"/>
                <a:gd name="connsiteX4" fmla="*/ 1234338 w 1322993"/>
                <a:gd name="connsiteY4" fmla="*/ 670123 h 1186562"/>
                <a:gd name="connsiteX5" fmla="*/ 1047525 w 1322993"/>
                <a:gd name="connsiteY5" fmla="*/ 738949 h 1186562"/>
                <a:gd name="connsiteX6" fmla="*/ 801718 w 1322993"/>
                <a:gd name="connsiteY6" fmla="*/ 738949 h 1186562"/>
                <a:gd name="connsiteX7" fmla="*/ 644402 w 1322993"/>
                <a:gd name="connsiteY7" fmla="*/ 817607 h 1186562"/>
                <a:gd name="connsiteX8" fmla="*/ 457589 w 1322993"/>
                <a:gd name="connsiteY8" fmla="*/ 955259 h 1186562"/>
                <a:gd name="connsiteX9" fmla="*/ 310105 w 1322993"/>
                <a:gd name="connsiteY9" fmla="*/ 1132239 h 1186562"/>
                <a:gd name="connsiteX10" fmla="*/ 74131 w 1322993"/>
                <a:gd name="connsiteY10" fmla="*/ 1171568 h 1186562"/>
                <a:gd name="connsiteX11" fmla="*/ 5305 w 1322993"/>
                <a:gd name="connsiteY11" fmla="*/ 906097 h 1186562"/>
                <a:gd name="connsiteX12" fmla="*/ 192118 w 1322993"/>
                <a:gd name="connsiteY12" fmla="*/ 689788 h 1186562"/>
                <a:gd name="connsiteX13" fmla="*/ 359267 w 1322993"/>
                <a:gd name="connsiteY13" fmla="*/ 424317 h 1186562"/>
                <a:gd name="connsiteX14" fmla="*/ 369099 w 1322993"/>
                <a:gd name="connsiteY14" fmla="*/ 247336 h 1186562"/>
                <a:gd name="connsiteX15" fmla="*/ 506751 w 1322993"/>
                <a:gd name="connsiteY15" fmla="*/ 1530 h 11865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1322993" h="1186562">
                  <a:moveTo>
                    <a:pt x="506751" y="1530"/>
                  </a:moveTo>
                  <a:cubicBezTo>
                    <a:pt x="591964" y="-14857"/>
                    <a:pt x="762389" y="104768"/>
                    <a:pt x="880376" y="149013"/>
                  </a:cubicBezTo>
                  <a:cubicBezTo>
                    <a:pt x="998363" y="193258"/>
                    <a:pt x="1140931" y="227672"/>
                    <a:pt x="1214673" y="267001"/>
                  </a:cubicBezTo>
                  <a:cubicBezTo>
                    <a:pt x="1288415" y="306330"/>
                    <a:pt x="1319551" y="317801"/>
                    <a:pt x="1322828" y="384988"/>
                  </a:cubicBezTo>
                  <a:cubicBezTo>
                    <a:pt x="1326106" y="452175"/>
                    <a:pt x="1280222" y="611130"/>
                    <a:pt x="1234338" y="670123"/>
                  </a:cubicBezTo>
                  <a:cubicBezTo>
                    <a:pt x="1188454" y="729116"/>
                    <a:pt x="1119628" y="727478"/>
                    <a:pt x="1047525" y="738949"/>
                  </a:cubicBezTo>
                  <a:cubicBezTo>
                    <a:pt x="975422" y="750420"/>
                    <a:pt x="868905" y="725839"/>
                    <a:pt x="801718" y="738949"/>
                  </a:cubicBezTo>
                  <a:cubicBezTo>
                    <a:pt x="734531" y="752059"/>
                    <a:pt x="701757" y="781555"/>
                    <a:pt x="644402" y="817607"/>
                  </a:cubicBezTo>
                  <a:cubicBezTo>
                    <a:pt x="587047" y="853659"/>
                    <a:pt x="513305" y="902820"/>
                    <a:pt x="457589" y="955259"/>
                  </a:cubicBezTo>
                  <a:cubicBezTo>
                    <a:pt x="401873" y="1007698"/>
                    <a:pt x="374015" y="1096188"/>
                    <a:pt x="310105" y="1132239"/>
                  </a:cubicBezTo>
                  <a:cubicBezTo>
                    <a:pt x="246195" y="1168290"/>
                    <a:pt x="124931" y="1209258"/>
                    <a:pt x="74131" y="1171568"/>
                  </a:cubicBezTo>
                  <a:cubicBezTo>
                    <a:pt x="23331" y="1133878"/>
                    <a:pt x="-14360" y="986394"/>
                    <a:pt x="5305" y="906097"/>
                  </a:cubicBezTo>
                  <a:cubicBezTo>
                    <a:pt x="24970" y="825800"/>
                    <a:pt x="133124" y="770085"/>
                    <a:pt x="192118" y="689788"/>
                  </a:cubicBezTo>
                  <a:cubicBezTo>
                    <a:pt x="251112" y="609491"/>
                    <a:pt x="329770" y="498059"/>
                    <a:pt x="359267" y="424317"/>
                  </a:cubicBezTo>
                  <a:cubicBezTo>
                    <a:pt x="388764" y="350575"/>
                    <a:pt x="344518" y="312884"/>
                    <a:pt x="369099" y="247336"/>
                  </a:cubicBezTo>
                  <a:cubicBezTo>
                    <a:pt x="393680" y="181788"/>
                    <a:pt x="421538" y="17917"/>
                    <a:pt x="506751" y="1530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5" name="任意多边形: 形状 174">
              <a:extLst>
                <a:ext uri="{FF2B5EF4-FFF2-40B4-BE49-F238E27FC236}">
                  <a16:creationId xmlns:a16="http://schemas.microsoft.com/office/drawing/2014/main" id="{00C68A07-6C5C-4CA5-81CE-313CF0C75E73}"/>
                </a:ext>
              </a:extLst>
            </p:cNvPr>
            <p:cNvSpPr/>
            <p:nvPr/>
          </p:nvSpPr>
          <p:spPr>
            <a:xfrm>
              <a:off x="8803644" y="4428075"/>
              <a:ext cx="205414" cy="204666"/>
            </a:xfrm>
            <a:custGeom>
              <a:avLst/>
              <a:gdLst>
                <a:gd name="connsiteX0" fmla="*/ 3396 w 205414"/>
                <a:gd name="connsiteY0" fmla="*/ 257 h 204666"/>
                <a:gd name="connsiteX1" fmla="*/ 22446 w 205414"/>
                <a:gd name="connsiteY1" fmla="*/ 81220 h 204666"/>
                <a:gd name="connsiteX2" fmla="*/ 12921 w 205414"/>
                <a:gd name="connsiteY2" fmla="*/ 138370 h 204666"/>
                <a:gd name="connsiteX3" fmla="*/ 112933 w 205414"/>
                <a:gd name="connsiteY3" fmla="*/ 195520 h 204666"/>
                <a:gd name="connsiteX4" fmla="*/ 198658 w 205414"/>
                <a:gd name="connsiteY4" fmla="*/ 200282 h 204666"/>
                <a:gd name="connsiteX5" fmla="*/ 189133 w 205414"/>
                <a:gd name="connsiteY5" fmla="*/ 152657 h 204666"/>
                <a:gd name="connsiteX6" fmla="*/ 103408 w 205414"/>
                <a:gd name="connsiteY6" fmla="*/ 109795 h 204666"/>
                <a:gd name="connsiteX7" fmla="*/ 3396 w 205414"/>
                <a:gd name="connsiteY7" fmla="*/ 257 h 2046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05414" h="204666">
                  <a:moveTo>
                    <a:pt x="3396" y="257"/>
                  </a:moveTo>
                  <a:cubicBezTo>
                    <a:pt x="-10098" y="-4506"/>
                    <a:pt x="20859" y="58201"/>
                    <a:pt x="22446" y="81220"/>
                  </a:cubicBezTo>
                  <a:cubicBezTo>
                    <a:pt x="24033" y="104239"/>
                    <a:pt x="-2160" y="119320"/>
                    <a:pt x="12921" y="138370"/>
                  </a:cubicBezTo>
                  <a:cubicBezTo>
                    <a:pt x="28002" y="157420"/>
                    <a:pt x="81977" y="185201"/>
                    <a:pt x="112933" y="195520"/>
                  </a:cubicBezTo>
                  <a:cubicBezTo>
                    <a:pt x="143889" y="205839"/>
                    <a:pt x="185958" y="207426"/>
                    <a:pt x="198658" y="200282"/>
                  </a:cubicBezTo>
                  <a:cubicBezTo>
                    <a:pt x="211358" y="193138"/>
                    <a:pt x="205008" y="167738"/>
                    <a:pt x="189133" y="152657"/>
                  </a:cubicBezTo>
                  <a:cubicBezTo>
                    <a:pt x="173258" y="137576"/>
                    <a:pt x="129602" y="131226"/>
                    <a:pt x="103408" y="109795"/>
                  </a:cubicBezTo>
                  <a:cubicBezTo>
                    <a:pt x="77214" y="88364"/>
                    <a:pt x="16890" y="5020"/>
                    <a:pt x="3396" y="257"/>
                  </a:cubicBez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6" name="任意多边形: 形状 175">
              <a:extLst>
                <a:ext uri="{FF2B5EF4-FFF2-40B4-BE49-F238E27FC236}">
                  <a16:creationId xmlns:a16="http://schemas.microsoft.com/office/drawing/2014/main" id="{B936A98C-D9AD-447D-9F60-F987D2385393}"/>
                </a:ext>
              </a:extLst>
            </p:cNvPr>
            <p:cNvSpPr/>
            <p:nvPr/>
          </p:nvSpPr>
          <p:spPr>
            <a:xfrm>
              <a:off x="8766575" y="4208881"/>
              <a:ext cx="301356" cy="427866"/>
            </a:xfrm>
            <a:custGeom>
              <a:avLst/>
              <a:gdLst>
                <a:gd name="connsiteX0" fmla="*/ 301344 w 301394"/>
                <a:gd name="connsiteY0" fmla="*/ 48032 h 410775"/>
                <a:gd name="connsiteX1" fmla="*/ 199744 w 301394"/>
                <a:gd name="connsiteY1" fmla="*/ 28982 h 410775"/>
                <a:gd name="connsiteX2" fmla="*/ 98144 w 301394"/>
                <a:gd name="connsiteY2" fmla="*/ 28982 h 410775"/>
                <a:gd name="connsiteX3" fmla="*/ 98144 w 301394"/>
                <a:gd name="connsiteY3" fmla="*/ 73432 h 410775"/>
                <a:gd name="connsiteX4" fmla="*/ 98144 w 301394"/>
                <a:gd name="connsiteY4" fmla="*/ 162332 h 410775"/>
                <a:gd name="connsiteX5" fmla="*/ 79094 w 301394"/>
                <a:gd name="connsiteY5" fmla="*/ 200432 h 410775"/>
                <a:gd name="connsiteX6" fmla="*/ 91794 w 301394"/>
                <a:gd name="connsiteY6" fmla="*/ 270282 h 410775"/>
                <a:gd name="connsiteX7" fmla="*/ 155294 w 301394"/>
                <a:gd name="connsiteY7" fmla="*/ 289332 h 410775"/>
                <a:gd name="connsiteX8" fmla="*/ 212444 w 301394"/>
                <a:gd name="connsiteY8" fmla="*/ 346482 h 410775"/>
                <a:gd name="connsiteX9" fmla="*/ 237844 w 301394"/>
                <a:gd name="connsiteY9" fmla="*/ 403632 h 410775"/>
                <a:gd name="connsiteX10" fmla="*/ 161644 w 301394"/>
                <a:gd name="connsiteY10" fmla="*/ 403632 h 410775"/>
                <a:gd name="connsiteX11" fmla="*/ 40994 w 301394"/>
                <a:gd name="connsiteY11" fmla="*/ 346482 h 410775"/>
                <a:gd name="connsiteX12" fmla="*/ 40994 w 301394"/>
                <a:gd name="connsiteY12" fmla="*/ 276632 h 410775"/>
                <a:gd name="connsiteX13" fmla="*/ 40994 w 301394"/>
                <a:gd name="connsiteY13" fmla="*/ 143282 h 410775"/>
                <a:gd name="connsiteX14" fmla="*/ 2894 w 301394"/>
                <a:gd name="connsiteY14" fmla="*/ 35332 h 410775"/>
                <a:gd name="connsiteX15" fmla="*/ 129894 w 301394"/>
                <a:gd name="connsiteY15" fmla="*/ 3582 h 410775"/>
                <a:gd name="connsiteX16" fmla="*/ 212444 w 301394"/>
                <a:gd name="connsiteY16" fmla="*/ 3582 h 410775"/>
                <a:gd name="connsiteX17" fmla="*/ 301344 w 301394"/>
                <a:gd name="connsiteY17" fmla="*/ 48032 h 410775"/>
                <a:gd name="connsiteX0" fmla="*/ 301225 w 301277"/>
                <a:gd name="connsiteY0" fmla="*/ 64670 h 427413"/>
                <a:gd name="connsiteX1" fmla="*/ 199625 w 301277"/>
                <a:gd name="connsiteY1" fmla="*/ 45620 h 427413"/>
                <a:gd name="connsiteX2" fmla="*/ 98025 w 301277"/>
                <a:gd name="connsiteY2" fmla="*/ 45620 h 427413"/>
                <a:gd name="connsiteX3" fmla="*/ 98025 w 301277"/>
                <a:gd name="connsiteY3" fmla="*/ 90070 h 427413"/>
                <a:gd name="connsiteX4" fmla="*/ 98025 w 301277"/>
                <a:gd name="connsiteY4" fmla="*/ 178970 h 427413"/>
                <a:gd name="connsiteX5" fmla="*/ 78975 w 301277"/>
                <a:gd name="connsiteY5" fmla="*/ 217070 h 427413"/>
                <a:gd name="connsiteX6" fmla="*/ 91675 w 301277"/>
                <a:gd name="connsiteY6" fmla="*/ 286920 h 427413"/>
                <a:gd name="connsiteX7" fmla="*/ 155175 w 301277"/>
                <a:gd name="connsiteY7" fmla="*/ 305970 h 427413"/>
                <a:gd name="connsiteX8" fmla="*/ 212325 w 301277"/>
                <a:gd name="connsiteY8" fmla="*/ 363120 h 427413"/>
                <a:gd name="connsiteX9" fmla="*/ 237725 w 301277"/>
                <a:gd name="connsiteY9" fmla="*/ 420270 h 427413"/>
                <a:gd name="connsiteX10" fmla="*/ 161525 w 301277"/>
                <a:gd name="connsiteY10" fmla="*/ 420270 h 427413"/>
                <a:gd name="connsiteX11" fmla="*/ 40875 w 301277"/>
                <a:gd name="connsiteY11" fmla="*/ 363120 h 427413"/>
                <a:gd name="connsiteX12" fmla="*/ 40875 w 301277"/>
                <a:gd name="connsiteY12" fmla="*/ 293270 h 427413"/>
                <a:gd name="connsiteX13" fmla="*/ 40875 w 301277"/>
                <a:gd name="connsiteY13" fmla="*/ 159920 h 427413"/>
                <a:gd name="connsiteX14" fmla="*/ 2775 w 301277"/>
                <a:gd name="connsiteY14" fmla="*/ 51970 h 427413"/>
                <a:gd name="connsiteX15" fmla="*/ 127394 w 301277"/>
                <a:gd name="connsiteY15" fmla="*/ 1170 h 427413"/>
                <a:gd name="connsiteX16" fmla="*/ 212325 w 301277"/>
                <a:gd name="connsiteY16" fmla="*/ 20220 h 427413"/>
                <a:gd name="connsiteX17" fmla="*/ 301225 w 301277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98025 w 301571"/>
                <a:gd name="connsiteY2" fmla="*/ 45620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126600 w 301571"/>
                <a:gd name="connsiteY2" fmla="*/ 59907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150413 w 301571"/>
                <a:gd name="connsiteY2" fmla="*/ 74195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98025 w 301392"/>
                <a:gd name="connsiteY3" fmla="*/ 90070 h 427413"/>
                <a:gd name="connsiteX4" fmla="*/ 98025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121838 w 301392"/>
                <a:gd name="connsiteY3" fmla="*/ 106739 h 427413"/>
                <a:gd name="connsiteX4" fmla="*/ 98025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121838 w 301392"/>
                <a:gd name="connsiteY3" fmla="*/ 106739 h 427413"/>
                <a:gd name="connsiteX4" fmla="*/ 102787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866"/>
                <a:gd name="connsiteX1" fmla="*/ 209150 w 301392"/>
                <a:gd name="connsiteY1" fmla="*/ 69432 h 427866"/>
                <a:gd name="connsiteX2" fmla="*/ 150413 w 301392"/>
                <a:gd name="connsiteY2" fmla="*/ 74195 h 427866"/>
                <a:gd name="connsiteX3" fmla="*/ 121838 w 301392"/>
                <a:gd name="connsiteY3" fmla="*/ 106739 h 427866"/>
                <a:gd name="connsiteX4" fmla="*/ 102787 w 301392"/>
                <a:gd name="connsiteY4" fmla="*/ 178970 h 427866"/>
                <a:gd name="connsiteX5" fmla="*/ 78975 w 301392"/>
                <a:gd name="connsiteY5" fmla="*/ 217070 h 427866"/>
                <a:gd name="connsiteX6" fmla="*/ 91675 w 301392"/>
                <a:gd name="connsiteY6" fmla="*/ 286920 h 427866"/>
                <a:gd name="connsiteX7" fmla="*/ 155175 w 301392"/>
                <a:gd name="connsiteY7" fmla="*/ 305970 h 427866"/>
                <a:gd name="connsiteX8" fmla="*/ 212325 w 301392"/>
                <a:gd name="connsiteY8" fmla="*/ 363120 h 427866"/>
                <a:gd name="connsiteX9" fmla="*/ 237725 w 301392"/>
                <a:gd name="connsiteY9" fmla="*/ 420270 h 427866"/>
                <a:gd name="connsiteX10" fmla="*/ 161525 w 301392"/>
                <a:gd name="connsiteY10" fmla="*/ 420270 h 427866"/>
                <a:gd name="connsiteX11" fmla="*/ 55163 w 301392"/>
                <a:gd name="connsiteY11" fmla="*/ 355976 h 427866"/>
                <a:gd name="connsiteX12" fmla="*/ 40875 w 301392"/>
                <a:gd name="connsiteY12" fmla="*/ 293270 h 427866"/>
                <a:gd name="connsiteX13" fmla="*/ 40875 w 301392"/>
                <a:gd name="connsiteY13" fmla="*/ 159920 h 427866"/>
                <a:gd name="connsiteX14" fmla="*/ 2775 w 301392"/>
                <a:gd name="connsiteY14" fmla="*/ 51970 h 427866"/>
                <a:gd name="connsiteX15" fmla="*/ 127394 w 301392"/>
                <a:gd name="connsiteY15" fmla="*/ 1170 h 427866"/>
                <a:gd name="connsiteX16" fmla="*/ 228994 w 301392"/>
                <a:gd name="connsiteY16" fmla="*/ 20220 h 427866"/>
                <a:gd name="connsiteX17" fmla="*/ 301225 w 301392"/>
                <a:gd name="connsiteY17" fmla="*/ 64670 h 427866"/>
                <a:gd name="connsiteX0" fmla="*/ 301225 w 301392"/>
                <a:gd name="connsiteY0" fmla="*/ 64670 h 427866"/>
                <a:gd name="connsiteX1" fmla="*/ 209150 w 301392"/>
                <a:gd name="connsiteY1" fmla="*/ 69432 h 427866"/>
                <a:gd name="connsiteX2" fmla="*/ 124219 w 301392"/>
                <a:gd name="connsiteY2" fmla="*/ 52764 h 427866"/>
                <a:gd name="connsiteX3" fmla="*/ 121838 w 301392"/>
                <a:gd name="connsiteY3" fmla="*/ 106739 h 427866"/>
                <a:gd name="connsiteX4" fmla="*/ 102787 w 301392"/>
                <a:gd name="connsiteY4" fmla="*/ 178970 h 427866"/>
                <a:gd name="connsiteX5" fmla="*/ 78975 w 301392"/>
                <a:gd name="connsiteY5" fmla="*/ 217070 h 427866"/>
                <a:gd name="connsiteX6" fmla="*/ 91675 w 301392"/>
                <a:gd name="connsiteY6" fmla="*/ 286920 h 427866"/>
                <a:gd name="connsiteX7" fmla="*/ 155175 w 301392"/>
                <a:gd name="connsiteY7" fmla="*/ 305970 h 427866"/>
                <a:gd name="connsiteX8" fmla="*/ 212325 w 301392"/>
                <a:gd name="connsiteY8" fmla="*/ 363120 h 427866"/>
                <a:gd name="connsiteX9" fmla="*/ 237725 w 301392"/>
                <a:gd name="connsiteY9" fmla="*/ 420270 h 427866"/>
                <a:gd name="connsiteX10" fmla="*/ 161525 w 301392"/>
                <a:gd name="connsiteY10" fmla="*/ 420270 h 427866"/>
                <a:gd name="connsiteX11" fmla="*/ 55163 w 301392"/>
                <a:gd name="connsiteY11" fmla="*/ 355976 h 427866"/>
                <a:gd name="connsiteX12" fmla="*/ 40875 w 301392"/>
                <a:gd name="connsiteY12" fmla="*/ 293270 h 427866"/>
                <a:gd name="connsiteX13" fmla="*/ 40875 w 301392"/>
                <a:gd name="connsiteY13" fmla="*/ 159920 h 427866"/>
                <a:gd name="connsiteX14" fmla="*/ 2775 w 301392"/>
                <a:gd name="connsiteY14" fmla="*/ 51970 h 427866"/>
                <a:gd name="connsiteX15" fmla="*/ 127394 w 301392"/>
                <a:gd name="connsiteY15" fmla="*/ 1170 h 427866"/>
                <a:gd name="connsiteX16" fmla="*/ 228994 w 301392"/>
                <a:gd name="connsiteY16" fmla="*/ 20220 h 427866"/>
                <a:gd name="connsiteX17" fmla="*/ 301225 w 301392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121838 w 301356"/>
                <a:gd name="connsiteY3" fmla="*/ 106739 h 427866"/>
                <a:gd name="connsiteX4" fmla="*/ 102787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83738 w 301356"/>
                <a:gd name="connsiteY3" fmla="*/ 101976 h 427866"/>
                <a:gd name="connsiteX4" fmla="*/ 102787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83738 w 301356"/>
                <a:gd name="connsiteY3" fmla="*/ 101976 h 427866"/>
                <a:gd name="connsiteX4" fmla="*/ 78975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301356" h="427866">
                  <a:moveTo>
                    <a:pt x="301225" y="64670"/>
                  </a:moveTo>
                  <a:cubicBezTo>
                    <a:pt x="298315" y="70491"/>
                    <a:pt x="241032" y="57129"/>
                    <a:pt x="211531" y="55145"/>
                  </a:cubicBezTo>
                  <a:cubicBezTo>
                    <a:pt x="182030" y="53161"/>
                    <a:pt x="145518" y="44959"/>
                    <a:pt x="124219" y="52764"/>
                  </a:cubicBezTo>
                  <a:cubicBezTo>
                    <a:pt x="102920" y="60569"/>
                    <a:pt x="91279" y="80942"/>
                    <a:pt x="83738" y="101976"/>
                  </a:cubicBezTo>
                  <a:cubicBezTo>
                    <a:pt x="76197" y="123010"/>
                    <a:pt x="79769" y="159788"/>
                    <a:pt x="78975" y="178970"/>
                  </a:cubicBezTo>
                  <a:cubicBezTo>
                    <a:pt x="78181" y="198152"/>
                    <a:pt x="76858" y="199078"/>
                    <a:pt x="78975" y="217070"/>
                  </a:cubicBezTo>
                  <a:cubicBezTo>
                    <a:pt x="81092" y="235062"/>
                    <a:pt x="78975" y="272103"/>
                    <a:pt x="91675" y="286920"/>
                  </a:cubicBezTo>
                  <a:cubicBezTo>
                    <a:pt x="104375" y="301737"/>
                    <a:pt x="135067" y="293270"/>
                    <a:pt x="155175" y="305970"/>
                  </a:cubicBezTo>
                  <a:cubicBezTo>
                    <a:pt x="175283" y="318670"/>
                    <a:pt x="198567" y="344070"/>
                    <a:pt x="212325" y="363120"/>
                  </a:cubicBezTo>
                  <a:cubicBezTo>
                    <a:pt x="226083" y="382170"/>
                    <a:pt x="246192" y="410745"/>
                    <a:pt x="237725" y="420270"/>
                  </a:cubicBezTo>
                  <a:cubicBezTo>
                    <a:pt x="229258" y="429795"/>
                    <a:pt x="191952" y="430986"/>
                    <a:pt x="161525" y="420270"/>
                  </a:cubicBezTo>
                  <a:cubicBezTo>
                    <a:pt x="131098" y="409554"/>
                    <a:pt x="75271" y="377143"/>
                    <a:pt x="55163" y="355976"/>
                  </a:cubicBezTo>
                  <a:cubicBezTo>
                    <a:pt x="35055" y="334809"/>
                    <a:pt x="43256" y="325946"/>
                    <a:pt x="40875" y="293270"/>
                  </a:cubicBezTo>
                  <a:cubicBezTo>
                    <a:pt x="38494" y="260594"/>
                    <a:pt x="47225" y="200137"/>
                    <a:pt x="40875" y="159920"/>
                  </a:cubicBezTo>
                  <a:cubicBezTo>
                    <a:pt x="34525" y="119703"/>
                    <a:pt x="-11645" y="78428"/>
                    <a:pt x="2775" y="51970"/>
                  </a:cubicBezTo>
                  <a:cubicBezTo>
                    <a:pt x="17195" y="25512"/>
                    <a:pt x="92469" y="6462"/>
                    <a:pt x="127394" y="1170"/>
                  </a:cubicBezTo>
                  <a:cubicBezTo>
                    <a:pt x="162319" y="-4122"/>
                    <a:pt x="200022" y="9637"/>
                    <a:pt x="228994" y="20220"/>
                  </a:cubicBezTo>
                  <a:cubicBezTo>
                    <a:pt x="257966" y="30803"/>
                    <a:pt x="304136" y="58849"/>
                    <a:pt x="301225" y="64670"/>
                  </a:cubicBez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7" name="任意多边形: 形状 176">
              <a:extLst>
                <a:ext uri="{FF2B5EF4-FFF2-40B4-BE49-F238E27FC236}">
                  <a16:creationId xmlns:a16="http://schemas.microsoft.com/office/drawing/2014/main" id="{93F46582-0505-43AB-BAE5-5564050C098D}"/>
                </a:ext>
              </a:extLst>
            </p:cNvPr>
            <p:cNvSpPr/>
            <p:nvPr/>
          </p:nvSpPr>
          <p:spPr>
            <a:xfrm>
              <a:off x="8778654" y="4210860"/>
              <a:ext cx="387726" cy="773916"/>
            </a:xfrm>
            <a:custGeom>
              <a:avLst/>
              <a:gdLst>
                <a:gd name="connsiteX0" fmla="*/ 791928 w 1549729"/>
                <a:gd name="connsiteY0" fmla="*/ 3093321 h 3093321"/>
                <a:gd name="connsiteX1" fmla="*/ 1165554 w 1549729"/>
                <a:gd name="connsiteY1" fmla="*/ 2532882 h 3093321"/>
                <a:gd name="connsiteX2" fmla="*/ 1401528 w 1549729"/>
                <a:gd name="connsiteY2" fmla="*/ 1942947 h 3093321"/>
                <a:gd name="connsiteX3" fmla="*/ 1549012 w 1549729"/>
                <a:gd name="connsiteY3" fmla="*/ 1166199 h 3093321"/>
                <a:gd name="connsiteX4" fmla="*/ 1342535 w 1549729"/>
                <a:gd name="connsiteY4" fmla="*/ 586095 h 3093321"/>
                <a:gd name="connsiteX5" fmla="*/ 1027902 w 1549729"/>
                <a:gd name="connsiteY5" fmla="*/ 94482 h 3093321"/>
                <a:gd name="connsiteX6" fmla="*/ 408470 w 1549729"/>
                <a:gd name="connsiteY6" fmla="*/ 5992 h 3093321"/>
                <a:gd name="connsiteX7" fmla="*/ 15180 w 1549729"/>
                <a:gd name="connsiteY7" fmla="*/ 182973 h 3093321"/>
                <a:gd name="connsiteX8" fmla="*/ 84006 w 1549729"/>
                <a:gd name="connsiteY8" fmla="*/ 586095 h 3093321"/>
                <a:gd name="connsiteX9" fmla="*/ 113502 w 1549729"/>
                <a:gd name="connsiteY9" fmla="*/ 979386 h 3093321"/>
                <a:gd name="connsiteX10" fmla="*/ 201993 w 1549729"/>
                <a:gd name="connsiteY10" fmla="*/ 1441502 h 3093321"/>
                <a:gd name="connsiteX11" fmla="*/ 536289 w 1549729"/>
                <a:gd name="connsiteY11" fmla="*/ 1647979 h 3093321"/>
                <a:gd name="connsiteX12" fmla="*/ 870586 w 1549729"/>
                <a:gd name="connsiteY12" fmla="*/ 1657811 h 3093321"/>
                <a:gd name="connsiteX13" fmla="*/ 949244 w 1549729"/>
                <a:gd name="connsiteY13" fmla="*/ 1647979 h 30933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1549729" h="3093321">
                  <a:moveTo>
                    <a:pt x="791928" y="3093321"/>
                  </a:moveTo>
                  <a:cubicBezTo>
                    <a:pt x="927941" y="2908966"/>
                    <a:pt x="1063954" y="2724611"/>
                    <a:pt x="1165554" y="2532882"/>
                  </a:cubicBezTo>
                  <a:cubicBezTo>
                    <a:pt x="1267154" y="2341153"/>
                    <a:pt x="1337618" y="2170727"/>
                    <a:pt x="1401528" y="1942947"/>
                  </a:cubicBezTo>
                  <a:cubicBezTo>
                    <a:pt x="1465438" y="1715166"/>
                    <a:pt x="1558844" y="1392341"/>
                    <a:pt x="1549012" y="1166199"/>
                  </a:cubicBezTo>
                  <a:cubicBezTo>
                    <a:pt x="1539180" y="940057"/>
                    <a:pt x="1429387" y="764714"/>
                    <a:pt x="1342535" y="586095"/>
                  </a:cubicBezTo>
                  <a:cubicBezTo>
                    <a:pt x="1255683" y="407476"/>
                    <a:pt x="1183580" y="191166"/>
                    <a:pt x="1027902" y="94482"/>
                  </a:cubicBezTo>
                  <a:cubicBezTo>
                    <a:pt x="872225" y="-2202"/>
                    <a:pt x="577257" y="-8756"/>
                    <a:pt x="408470" y="5992"/>
                  </a:cubicBezTo>
                  <a:cubicBezTo>
                    <a:pt x="239683" y="20740"/>
                    <a:pt x="69257" y="86289"/>
                    <a:pt x="15180" y="182973"/>
                  </a:cubicBezTo>
                  <a:cubicBezTo>
                    <a:pt x="-38897" y="279657"/>
                    <a:pt x="67619" y="453360"/>
                    <a:pt x="84006" y="586095"/>
                  </a:cubicBezTo>
                  <a:cubicBezTo>
                    <a:pt x="100393" y="718830"/>
                    <a:pt x="93837" y="836818"/>
                    <a:pt x="113502" y="979386"/>
                  </a:cubicBezTo>
                  <a:cubicBezTo>
                    <a:pt x="133166" y="1121954"/>
                    <a:pt x="131529" y="1330070"/>
                    <a:pt x="201993" y="1441502"/>
                  </a:cubicBezTo>
                  <a:cubicBezTo>
                    <a:pt x="272457" y="1552934"/>
                    <a:pt x="424857" y="1611928"/>
                    <a:pt x="536289" y="1647979"/>
                  </a:cubicBezTo>
                  <a:cubicBezTo>
                    <a:pt x="647721" y="1684030"/>
                    <a:pt x="801760" y="1657811"/>
                    <a:pt x="870586" y="1657811"/>
                  </a:cubicBezTo>
                  <a:cubicBezTo>
                    <a:pt x="939412" y="1657811"/>
                    <a:pt x="944328" y="1652895"/>
                    <a:pt x="949244" y="164797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8" name="任意多边形: 形状 177">
              <a:extLst>
                <a:ext uri="{FF2B5EF4-FFF2-40B4-BE49-F238E27FC236}">
                  <a16:creationId xmlns:a16="http://schemas.microsoft.com/office/drawing/2014/main" id="{0FB72DF0-C083-40F0-9401-89D811AB7165}"/>
                </a:ext>
              </a:extLst>
            </p:cNvPr>
            <p:cNvSpPr/>
            <p:nvPr/>
          </p:nvSpPr>
          <p:spPr>
            <a:xfrm>
              <a:off x="8832218" y="4435732"/>
              <a:ext cx="196898" cy="370087"/>
            </a:xfrm>
            <a:custGeom>
              <a:avLst/>
              <a:gdLst>
                <a:gd name="connsiteX0" fmla="*/ 0 w 786995"/>
                <a:gd name="connsiteY0" fmla="*/ 0 h 1479227"/>
                <a:gd name="connsiteX1" fmla="*/ 98322 w 786995"/>
                <a:gd name="connsiteY1" fmla="*/ 226142 h 1479227"/>
                <a:gd name="connsiteX2" fmla="*/ 373626 w 786995"/>
                <a:gd name="connsiteY2" fmla="*/ 373626 h 1479227"/>
                <a:gd name="connsiteX3" fmla="*/ 629264 w 786995"/>
                <a:gd name="connsiteY3" fmla="*/ 570271 h 1479227"/>
                <a:gd name="connsiteX4" fmla="*/ 747251 w 786995"/>
                <a:gd name="connsiteY4" fmla="*/ 884903 h 1479227"/>
                <a:gd name="connsiteX5" fmla="*/ 786580 w 786995"/>
                <a:gd name="connsiteY5" fmla="*/ 1179871 h 1479227"/>
                <a:gd name="connsiteX6" fmla="*/ 727587 w 786995"/>
                <a:gd name="connsiteY6" fmla="*/ 1376516 h 1479227"/>
                <a:gd name="connsiteX7" fmla="*/ 678426 w 786995"/>
                <a:gd name="connsiteY7" fmla="*/ 1474839 h 14792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786995" h="1479227">
                  <a:moveTo>
                    <a:pt x="0" y="0"/>
                  </a:moveTo>
                  <a:cubicBezTo>
                    <a:pt x="18025" y="81935"/>
                    <a:pt x="36051" y="163871"/>
                    <a:pt x="98322" y="226142"/>
                  </a:cubicBezTo>
                  <a:cubicBezTo>
                    <a:pt x="160593" y="288413"/>
                    <a:pt x="285136" y="316271"/>
                    <a:pt x="373626" y="373626"/>
                  </a:cubicBezTo>
                  <a:cubicBezTo>
                    <a:pt x="462116" y="430981"/>
                    <a:pt x="566993" y="485058"/>
                    <a:pt x="629264" y="570271"/>
                  </a:cubicBezTo>
                  <a:cubicBezTo>
                    <a:pt x="691535" y="655484"/>
                    <a:pt x="721032" y="783303"/>
                    <a:pt x="747251" y="884903"/>
                  </a:cubicBezTo>
                  <a:cubicBezTo>
                    <a:pt x="773470" y="986503"/>
                    <a:pt x="789857" y="1097936"/>
                    <a:pt x="786580" y="1179871"/>
                  </a:cubicBezTo>
                  <a:cubicBezTo>
                    <a:pt x="783303" y="1261806"/>
                    <a:pt x="745613" y="1327355"/>
                    <a:pt x="727587" y="1376516"/>
                  </a:cubicBezTo>
                  <a:cubicBezTo>
                    <a:pt x="709561" y="1425677"/>
                    <a:pt x="683342" y="1497781"/>
                    <a:pt x="678426" y="147483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79" name="组合 178">
            <a:extLst>
              <a:ext uri="{FF2B5EF4-FFF2-40B4-BE49-F238E27FC236}">
                <a16:creationId xmlns:a16="http://schemas.microsoft.com/office/drawing/2014/main" id="{416F65E9-BBA0-4205-B6AA-AFB8630E16C2}"/>
              </a:ext>
            </a:extLst>
          </p:cNvPr>
          <p:cNvGrpSpPr/>
          <p:nvPr/>
        </p:nvGrpSpPr>
        <p:grpSpPr>
          <a:xfrm>
            <a:off x="4363105" y="7072867"/>
            <a:ext cx="651269" cy="1085072"/>
            <a:chOff x="8582434" y="4065623"/>
            <a:chExt cx="709203" cy="1181595"/>
          </a:xfrm>
        </p:grpSpPr>
        <p:sp>
          <p:nvSpPr>
            <p:cNvPr id="180" name="任意多边形: 形状 179">
              <a:extLst>
                <a:ext uri="{FF2B5EF4-FFF2-40B4-BE49-F238E27FC236}">
                  <a16:creationId xmlns:a16="http://schemas.microsoft.com/office/drawing/2014/main" id="{833A787A-91DD-4CB9-85CE-F4A0B15077DE}"/>
                </a:ext>
              </a:extLst>
            </p:cNvPr>
            <p:cNvSpPr/>
            <p:nvPr/>
          </p:nvSpPr>
          <p:spPr>
            <a:xfrm>
              <a:off x="8582434" y="4065623"/>
              <a:ext cx="696467" cy="1181595"/>
            </a:xfrm>
            <a:custGeom>
              <a:avLst/>
              <a:gdLst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197857 w 2783758"/>
                <a:gd name="connsiteY22" fmla="*/ 1544904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289297 w 2783758"/>
                <a:gd name="connsiteY22" fmla="*/ 1636344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2783758" h="4722803">
                  <a:moveTo>
                    <a:pt x="197857" y="1544904"/>
                  </a:moveTo>
                  <a:cubicBezTo>
                    <a:pt x="212605" y="1330233"/>
                    <a:pt x="240463" y="982826"/>
                    <a:pt x="335508" y="768155"/>
                  </a:cubicBezTo>
                  <a:cubicBezTo>
                    <a:pt x="430553" y="553484"/>
                    <a:pt x="623920" y="379781"/>
                    <a:pt x="768127" y="256878"/>
                  </a:cubicBezTo>
                  <a:cubicBezTo>
                    <a:pt x="912334" y="133975"/>
                    <a:pt x="1036876" y="66788"/>
                    <a:pt x="1200747" y="30736"/>
                  </a:cubicBezTo>
                  <a:cubicBezTo>
                    <a:pt x="1364618" y="-5316"/>
                    <a:pt x="1569456" y="-18425"/>
                    <a:pt x="1751353" y="40568"/>
                  </a:cubicBezTo>
                  <a:cubicBezTo>
                    <a:pt x="1933250" y="99561"/>
                    <a:pt x="2151198" y="224103"/>
                    <a:pt x="2292127" y="384697"/>
                  </a:cubicBezTo>
                  <a:cubicBezTo>
                    <a:pt x="2433056" y="545291"/>
                    <a:pt x="2514992" y="773072"/>
                    <a:pt x="2596927" y="1004130"/>
                  </a:cubicBezTo>
                  <a:cubicBezTo>
                    <a:pt x="2678862" y="1235188"/>
                    <a:pt x="2782101" y="1503936"/>
                    <a:pt x="2783740" y="1771046"/>
                  </a:cubicBezTo>
                  <a:cubicBezTo>
                    <a:pt x="2785379" y="2038156"/>
                    <a:pt x="2678863" y="2380646"/>
                    <a:pt x="2606760" y="2606788"/>
                  </a:cubicBezTo>
                  <a:cubicBezTo>
                    <a:pt x="2534657" y="2832930"/>
                    <a:pt x="2446166" y="2954194"/>
                    <a:pt x="2351121" y="3127897"/>
                  </a:cubicBezTo>
                  <a:cubicBezTo>
                    <a:pt x="2256076" y="3301600"/>
                    <a:pt x="2146282" y="3512994"/>
                    <a:pt x="2036489" y="3649007"/>
                  </a:cubicBezTo>
                  <a:cubicBezTo>
                    <a:pt x="1926696" y="3785020"/>
                    <a:pt x="1816902" y="3840736"/>
                    <a:pt x="1692360" y="3943975"/>
                  </a:cubicBezTo>
                  <a:cubicBezTo>
                    <a:pt x="1567818" y="4047214"/>
                    <a:pt x="1431805" y="4142258"/>
                    <a:pt x="1289237" y="4268439"/>
                  </a:cubicBezTo>
                  <a:cubicBezTo>
                    <a:pt x="1146669" y="4394620"/>
                    <a:pt x="982798" y="4640427"/>
                    <a:pt x="836953" y="4701059"/>
                  </a:cubicBezTo>
                  <a:cubicBezTo>
                    <a:pt x="691108" y="4761691"/>
                    <a:pt x="522321" y="4681394"/>
                    <a:pt x="414166" y="4632233"/>
                  </a:cubicBezTo>
                  <a:cubicBezTo>
                    <a:pt x="306011" y="4583072"/>
                    <a:pt x="230630" y="4517523"/>
                    <a:pt x="188024" y="4406091"/>
                  </a:cubicBezTo>
                  <a:cubicBezTo>
                    <a:pt x="145418" y="4294659"/>
                    <a:pt x="178192" y="4084904"/>
                    <a:pt x="158527" y="3963639"/>
                  </a:cubicBezTo>
                  <a:cubicBezTo>
                    <a:pt x="138862" y="3842374"/>
                    <a:pt x="96256" y="3770272"/>
                    <a:pt x="70037" y="3678504"/>
                  </a:cubicBezTo>
                  <a:cubicBezTo>
                    <a:pt x="43818" y="3586736"/>
                    <a:pt x="-8621" y="3491691"/>
                    <a:pt x="1211" y="3413033"/>
                  </a:cubicBezTo>
                  <a:cubicBezTo>
                    <a:pt x="11043" y="3334375"/>
                    <a:pt x="89702" y="3306516"/>
                    <a:pt x="129031" y="3206555"/>
                  </a:cubicBezTo>
                  <a:cubicBezTo>
                    <a:pt x="168360" y="3106594"/>
                    <a:pt x="217521" y="3004994"/>
                    <a:pt x="237186" y="2813265"/>
                  </a:cubicBezTo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81" name="任意多边形: 形状 180">
              <a:extLst>
                <a:ext uri="{FF2B5EF4-FFF2-40B4-BE49-F238E27FC236}">
                  <a16:creationId xmlns:a16="http://schemas.microsoft.com/office/drawing/2014/main" id="{60DA5D8B-6495-42F4-8A1A-D468C8A2ECE2}"/>
                </a:ext>
              </a:extLst>
            </p:cNvPr>
            <p:cNvSpPr/>
            <p:nvPr/>
          </p:nvSpPr>
          <p:spPr>
            <a:xfrm>
              <a:off x="8612693" y="4065623"/>
              <a:ext cx="678944" cy="1181595"/>
            </a:xfrm>
            <a:custGeom>
              <a:avLst/>
              <a:gdLst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197857 w 2783758"/>
                <a:gd name="connsiteY22" fmla="*/ 1544904 h 4722803"/>
                <a:gd name="connsiteX0" fmla="*/ 247018 w 2783758"/>
                <a:gd name="connsiteY0" fmla="*/ 2056181 h 4722803"/>
                <a:gd name="connsiteX1" fmla="*/ 197857 w 2783758"/>
                <a:gd name="connsiteY1" fmla="*/ 1544904 h 4722803"/>
                <a:gd name="connsiteX2" fmla="*/ 335508 w 2783758"/>
                <a:gd name="connsiteY2" fmla="*/ 768155 h 4722803"/>
                <a:gd name="connsiteX3" fmla="*/ 768127 w 2783758"/>
                <a:gd name="connsiteY3" fmla="*/ 256878 h 4722803"/>
                <a:gd name="connsiteX4" fmla="*/ 1200747 w 2783758"/>
                <a:gd name="connsiteY4" fmla="*/ 30736 h 4722803"/>
                <a:gd name="connsiteX5" fmla="*/ 1751353 w 2783758"/>
                <a:gd name="connsiteY5" fmla="*/ 40568 h 4722803"/>
                <a:gd name="connsiteX6" fmla="*/ 2292127 w 2783758"/>
                <a:gd name="connsiteY6" fmla="*/ 384697 h 4722803"/>
                <a:gd name="connsiteX7" fmla="*/ 2596927 w 2783758"/>
                <a:gd name="connsiteY7" fmla="*/ 1004130 h 4722803"/>
                <a:gd name="connsiteX8" fmla="*/ 2783740 w 2783758"/>
                <a:gd name="connsiteY8" fmla="*/ 1771046 h 4722803"/>
                <a:gd name="connsiteX9" fmla="*/ 2606760 w 2783758"/>
                <a:gd name="connsiteY9" fmla="*/ 2606788 h 4722803"/>
                <a:gd name="connsiteX10" fmla="*/ 2351121 w 2783758"/>
                <a:gd name="connsiteY10" fmla="*/ 3127897 h 4722803"/>
                <a:gd name="connsiteX11" fmla="*/ 2036489 w 2783758"/>
                <a:gd name="connsiteY11" fmla="*/ 3649007 h 4722803"/>
                <a:gd name="connsiteX12" fmla="*/ 1692360 w 2783758"/>
                <a:gd name="connsiteY12" fmla="*/ 3943975 h 4722803"/>
                <a:gd name="connsiteX13" fmla="*/ 1289237 w 2783758"/>
                <a:gd name="connsiteY13" fmla="*/ 4268439 h 4722803"/>
                <a:gd name="connsiteX14" fmla="*/ 836953 w 2783758"/>
                <a:gd name="connsiteY14" fmla="*/ 4701059 h 4722803"/>
                <a:gd name="connsiteX15" fmla="*/ 414166 w 2783758"/>
                <a:gd name="connsiteY15" fmla="*/ 4632233 h 4722803"/>
                <a:gd name="connsiteX16" fmla="*/ 188024 w 2783758"/>
                <a:gd name="connsiteY16" fmla="*/ 4406091 h 4722803"/>
                <a:gd name="connsiteX17" fmla="*/ 158527 w 2783758"/>
                <a:gd name="connsiteY17" fmla="*/ 3963639 h 4722803"/>
                <a:gd name="connsiteX18" fmla="*/ 70037 w 2783758"/>
                <a:gd name="connsiteY18" fmla="*/ 3678504 h 4722803"/>
                <a:gd name="connsiteX19" fmla="*/ 1211 w 2783758"/>
                <a:gd name="connsiteY19" fmla="*/ 3413033 h 4722803"/>
                <a:gd name="connsiteX20" fmla="*/ 129031 w 2783758"/>
                <a:gd name="connsiteY20" fmla="*/ 3206555 h 4722803"/>
                <a:gd name="connsiteX21" fmla="*/ 237186 w 2783758"/>
                <a:gd name="connsiteY21" fmla="*/ 2813265 h 4722803"/>
                <a:gd name="connsiteX22" fmla="*/ 338458 w 2783758"/>
                <a:gd name="connsiteY22" fmla="*/ 2147621 h 4722803"/>
                <a:gd name="connsiteX0" fmla="*/ 247018 w 2783758"/>
                <a:gd name="connsiteY0" fmla="*/ 2056181 h 4722803"/>
                <a:gd name="connsiteX1" fmla="*/ 197857 w 2783758"/>
                <a:gd name="connsiteY1" fmla="*/ 1544904 h 4722803"/>
                <a:gd name="connsiteX2" fmla="*/ 335508 w 2783758"/>
                <a:gd name="connsiteY2" fmla="*/ 768155 h 4722803"/>
                <a:gd name="connsiteX3" fmla="*/ 768127 w 2783758"/>
                <a:gd name="connsiteY3" fmla="*/ 256878 h 4722803"/>
                <a:gd name="connsiteX4" fmla="*/ 1200747 w 2783758"/>
                <a:gd name="connsiteY4" fmla="*/ 30736 h 4722803"/>
                <a:gd name="connsiteX5" fmla="*/ 1751353 w 2783758"/>
                <a:gd name="connsiteY5" fmla="*/ 40568 h 4722803"/>
                <a:gd name="connsiteX6" fmla="*/ 2292127 w 2783758"/>
                <a:gd name="connsiteY6" fmla="*/ 384697 h 4722803"/>
                <a:gd name="connsiteX7" fmla="*/ 2596927 w 2783758"/>
                <a:gd name="connsiteY7" fmla="*/ 1004130 h 4722803"/>
                <a:gd name="connsiteX8" fmla="*/ 2783740 w 2783758"/>
                <a:gd name="connsiteY8" fmla="*/ 1771046 h 4722803"/>
                <a:gd name="connsiteX9" fmla="*/ 2606760 w 2783758"/>
                <a:gd name="connsiteY9" fmla="*/ 2606788 h 4722803"/>
                <a:gd name="connsiteX10" fmla="*/ 2351121 w 2783758"/>
                <a:gd name="connsiteY10" fmla="*/ 3127897 h 4722803"/>
                <a:gd name="connsiteX11" fmla="*/ 2036489 w 2783758"/>
                <a:gd name="connsiteY11" fmla="*/ 3649007 h 4722803"/>
                <a:gd name="connsiteX12" fmla="*/ 1692360 w 2783758"/>
                <a:gd name="connsiteY12" fmla="*/ 3943975 h 4722803"/>
                <a:gd name="connsiteX13" fmla="*/ 1289237 w 2783758"/>
                <a:gd name="connsiteY13" fmla="*/ 4268439 h 4722803"/>
                <a:gd name="connsiteX14" fmla="*/ 836953 w 2783758"/>
                <a:gd name="connsiteY14" fmla="*/ 4701059 h 4722803"/>
                <a:gd name="connsiteX15" fmla="*/ 414166 w 2783758"/>
                <a:gd name="connsiteY15" fmla="*/ 4632233 h 4722803"/>
                <a:gd name="connsiteX16" fmla="*/ 188024 w 2783758"/>
                <a:gd name="connsiteY16" fmla="*/ 4406091 h 4722803"/>
                <a:gd name="connsiteX17" fmla="*/ 158527 w 2783758"/>
                <a:gd name="connsiteY17" fmla="*/ 3963639 h 4722803"/>
                <a:gd name="connsiteX18" fmla="*/ 70037 w 2783758"/>
                <a:gd name="connsiteY18" fmla="*/ 3678504 h 4722803"/>
                <a:gd name="connsiteX19" fmla="*/ 1211 w 2783758"/>
                <a:gd name="connsiteY19" fmla="*/ 3413033 h 4722803"/>
                <a:gd name="connsiteX20" fmla="*/ 129031 w 2783758"/>
                <a:gd name="connsiteY20" fmla="*/ 3206555 h 4722803"/>
                <a:gd name="connsiteX21" fmla="*/ 237186 w 2783758"/>
                <a:gd name="connsiteY21" fmla="*/ 281326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0" fmla="*/ 127820 w 2713721"/>
                <a:gd name="connsiteY0" fmla="*/ 1544904 h 4722803"/>
                <a:gd name="connsiteX1" fmla="*/ 265471 w 2713721"/>
                <a:gd name="connsiteY1" fmla="*/ 768155 h 4722803"/>
                <a:gd name="connsiteX2" fmla="*/ 698090 w 2713721"/>
                <a:gd name="connsiteY2" fmla="*/ 256878 h 4722803"/>
                <a:gd name="connsiteX3" fmla="*/ 1130710 w 2713721"/>
                <a:gd name="connsiteY3" fmla="*/ 30736 h 4722803"/>
                <a:gd name="connsiteX4" fmla="*/ 1681316 w 2713721"/>
                <a:gd name="connsiteY4" fmla="*/ 40568 h 4722803"/>
                <a:gd name="connsiteX5" fmla="*/ 2222090 w 2713721"/>
                <a:gd name="connsiteY5" fmla="*/ 384697 h 4722803"/>
                <a:gd name="connsiteX6" fmla="*/ 2526890 w 2713721"/>
                <a:gd name="connsiteY6" fmla="*/ 1004130 h 4722803"/>
                <a:gd name="connsiteX7" fmla="*/ 2713703 w 2713721"/>
                <a:gd name="connsiteY7" fmla="*/ 1771046 h 4722803"/>
                <a:gd name="connsiteX8" fmla="*/ 2536723 w 2713721"/>
                <a:gd name="connsiteY8" fmla="*/ 2606788 h 4722803"/>
                <a:gd name="connsiteX9" fmla="*/ 2281084 w 2713721"/>
                <a:gd name="connsiteY9" fmla="*/ 3127897 h 4722803"/>
                <a:gd name="connsiteX10" fmla="*/ 1966452 w 2713721"/>
                <a:gd name="connsiteY10" fmla="*/ 3649007 h 4722803"/>
                <a:gd name="connsiteX11" fmla="*/ 1622323 w 2713721"/>
                <a:gd name="connsiteY11" fmla="*/ 3943975 h 4722803"/>
                <a:gd name="connsiteX12" fmla="*/ 1219200 w 2713721"/>
                <a:gd name="connsiteY12" fmla="*/ 4268439 h 4722803"/>
                <a:gd name="connsiteX13" fmla="*/ 766916 w 2713721"/>
                <a:gd name="connsiteY13" fmla="*/ 4701059 h 4722803"/>
                <a:gd name="connsiteX14" fmla="*/ 344129 w 2713721"/>
                <a:gd name="connsiteY14" fmla="*/ 4632233 h 4722803"/>
                <a:gd name="connsiteX15" fmla="*/ 117987 w 2713721"/>
                <a:gd name="connsiteY15" fmla="*/ 4406091 h 4722803"/>
                <a:gd name="connsiteX16" fmla="*/ 88490 w 2713721"/>
                <a:gd name="connsiteY16" fmla="*/ 3963639 h 4722803"/>
                <a:gd name="connsiteX17" fmla="*/ 0 w 2713721"/>
                <a:gd name="connsiteY17" fmla="*/ 3678504 h 47228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2713721" h="4722803">
                  <a:moveTo>
                    <a:pt x="127820" y="1544904"/>
                  </a:moveTo>
                  <a:cubicBezTo>
                    <a:pt x="142568" y="1330233"/>
                    <a:pt x="170426" y="982826"/>
                    <a:pt x="265471" y="768155"/>
                  </a:cubicBezTo>
                  <a:cubicBezTo>
                    <a:pt x="360516" y="553484"/>
                    <a:pt x="553883" y="379781"/>
                    <a:pt x="698090" y="256878"/>
                  </a:cubicBezTo>
                  <a:cubicBezTo>
                    <a:pt x="842297" y="133975"/>
                    <a:pt x="966839" y="66788"/>
                    <a:pt x="1130710" y="30736"/>
                  </a:cubicBezTo>
                  <a:cubicBezTo>
                    <a:pt x="1294581" y="-5316"/>
                    <a:pt x="1499419" y="-18425"/>
                    <a:pt x="1681316" y="40568"/>
                  </a:cubicBezTo>
                  <a:cubicBezTo>
                    <a:pt x="1863213" y="99561"/>
                    <a:pt x="2081161" y="224103"/>
                    <a:pt x="2222090" y="384697"/>
                  </a:cubicBezTo>
                  <a:cubicBezTo>
                    <a:pt x="2363019" y="545291"/>
                    <a:pt x="2444955" y="773072"/>
                    <a:pt x="2526890" y="1004130"/>
                  </a:cubicBezTo>
                  <a:cubicBezTo>
                    <a:pt x="2608825" y="1235188"/>
                    <a:pt x="2712064" y="1503936"/>
                    <a:pt x="2713703" y="1771046"/>
                  </a:cubicBezTo>
                  <a:cubicBezTo>
                    <a:pt x="2715342" y="2038156"/>
                    <a:pt x="2608826" y="2380646"/>
                    <a:pt x="2536723" y="2606788"/>
                  </a:cubicBezTo>
                  <a:cubicBezTo>
                    <a:pt x="2464620" y="2832930"/>
                    <a:pt x="2376129" y="2954194"/>
                    <a:pt x="2281084" y="3127897"/>
                  </a:cubicBezTo>
                  <a:cubicBezTo>
                    <a:pt x="2186039" y="3301600"/>
                    <a:pt x="2076245" y="3512994"/>
                    <a:pt x="1966452" y="3649007"/>
                  </a:cubicBezTo>
                  <a:cubicBezTo>
                    <a:pt x="1856659" y="3785020"/>
                    <a:pt x="1746865" y="3840736"/>
                    <a:pt x="1622323" y="3943975"/>
                  </a:cubicBezTo>
                  <a:cubicBezTo>
                    <a:pt x="1497781" y="4047214"/>
                    <a:pt x="1361768" y="4142258"/>
                    <a:pt x="1219200" y="4268439"/>
                  </a:cubicBezTo>
                  <a:cubicBezTo>
                    <a:pt x="1076632" y="4394620"/>
                    <a:pt x="912761" y="4640427"/>
                    <a:pt x="766916" y="4701059"/>
                  </a:cubicBezTo>
                  <a:cubicBezTo>
                    <a:pt x="621071" y="4761691"/>
                    <a:pt x="452284" y="4681394"/>
                    <a:pt x="344129" y="4632233"/>
                  </a:cubicBezTo>
                  <a:cubicBezTo>
                    <a:pt x="235974" y="4583072"/>
                    <a:pt x="160593" y="4517523"/>
                    <a:pt x="117987" y="4406091"/>
                  </a:cubicBezTo>
                  <a:cubicBezTo>
                    <a:pt x="75381" y="4294659"/>
                    <a:pt x="108155" y="4084904"/>
                    <a:pt x="88490" y="3963639"/>
                  </a:cubicBezTo>
                  <a:cubicBezTo>
                    <a:pt x="68825" y="3842374"/>
                    <a:pt x="26219" y="3770272"/>
                    <a:pt x="0" y="3678504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2" name="任意多边形: 形状 181">
              <a:extLst>
                <a:ext uri="{FF2B5EF4-FFF2-40B4-BE49-F238E27FC236}">
                  <a16:creationId xmlns:a16="http://schemas.microsoft.com/office/drawing/2014/main" id="{C2D03BB1-81F8-4781-A625-36BDC12DB6A2}"/>
                </a:ext>
              </a:extLst>
            </p:cNvPr>
            <p:cNvSpPr/>
            <p:nvPr/>
          </p:nvSpPr>
          <p:spPr>
            <a:xfrm>
              <a:off x="8739933" y="4587190"/>
              <a:ext cx="108237" cy="108237"/>
            </a:xfrm>
            <a:custGeom>
              <a:avLst/>
              <a:gdLst>
                <a:gd name="connsiteX0" fmla="*/ 0 w 1101213"/>
                <a:gd name="connsiteY0" fmla="*/ 0 h 865238"/>
                <a:gd name="connsiteX1" fmla="*/ 98323 w 1101213"/>
                <a:gd name="connsiteY1" fmla="*/ 206477 h 865238"/>
                <a:gd name="connsiteX2" fmla="*/ 265471 w 1101213"/>
                <a:gd name="connsiteY2" fmla="*/ 373625 h 865238"/>
                <a:gd name="connsiteX3" fmla="*/ 432619 w 1101213"/>
                <a:gd name="connsiteY3" fmla="*/ 432619 h 865238"/>
                <a:gd name="connsiteX4" fmla="*/ 786581 w 1101213"/>
                <a:gd name="connsiteY4" fmla="*/ 550606 h 865238"/>
                <a:gd name="connsiteX5" fmla="*/ 1002890 w 1101213"/>
                <a:gd name="connsiteY5" fmla="*/ 639096 h 865238"/>
                <a:gd name="connsiteX6" fmla="*/ 1081548 w 1101213"/>
                <a:gd name="connsiteY6" fmla="*/ 786580 h 865238"/>
                <a:gd name="connsiteX7" fmla="*/ 1101213 w 1101213"/>
                <a:gd name="connsiteY7" fmla="*/ 865238 h 865238"/>
                <a:gd name="connsiteX0" fmla="*/ 0 w 1082429"/>
                <a:gd name="connsiteY0" fmla="*/ 0 h 941438"/>
                <a:gd name="connsiteX1" fmla="*/ 98323 w 1082429"/>
                <a:gd name="connsiteY1" fmla="*/ 206477 h 941438"/>
                <a:gd name="connsiteX2" fmla="*/ 265471 w 1082429"/>
                <a:gd name="connsiteY2" fmla="*/ 373625 h 941438"/>
                <a:gd name="connsiteX3" fmla="*/ 432619 w 1082429"/>
                <a:gd name="connsiteY3" fmla="*/ 432619 h 941438"/>
                <a:gd name="connsiteX4" fmla="*/ 786581 w 1082429"/>
                <a:gd name="connsiteY4" fmla="*/ 550606 h 941438"/>
                <a:gd name="connsiteX5" fmla="*/ 1002890 w 1082429"/>
                <a:gd name="connsiteY5" fmla="*/ 639096 h 941438"/>
                <a:gd name="connsiteX6" fmla="*/ 1081548 w 1082429"/>
                <a:gd name="connsiteY6" fmla="*/ 786580 h 941438"/>
                <a:gd name="connsiteX7" fmla="*/ 1047873 w 1082429"/>
                <a:gd name="connsiteY7" fmla="*/ 941438 h 941438"/>
                <a:gd name="connsiteX0" fmla="*/ 0 w 1081550"/>
                <a:gd name="connsiteY0" fmla="*/ 0 h 786579"/>
                <a:gd name="connsiteX1" fmla="*/ 98323 w 1081550"/>
                <a:gd name="connsiteY1" fmla="*/ 206477 h 786579"/>
                <a:gd name="connsiteX2" fmla="*/ 265471 w 1081550"/>
                <a:gd name="connsiteY2" fmla="*/ 373625 h 786579"/>
                <a:gd name="connsiteX3" fmla="*/ 432619 w 1081550"/>
                <a:gd name="connsiteY3" fmla="*/ 432619 h 786579"/>
                <a:gd name="connsiteX4" fmla="*/ 786581 w 1081550"/>
                <a:gd name="connsiteY4" fmla="*/ 550606 h 786579"/>
                <a:gd name="connsiteX5" fmla="*/ 1002890 w 1081550"/>
                <a:gd name="connsiteY5" fmla="*/ 639096 h 786579"/>
                <a:gd name="connsiteX6" fmla="*/ 1081548 w 1081550"/>
                <a:gd name="connsiteY6" fmla="*/ 786580 h 786579"/>
                <a:gd name="connsiteX0" fmla="*/ 0 w 1002889"/>
                <a:gd name="connsiteY0" fmla="*/ 0 h 639095"/>
                <a:gd name="connsiteX1" fmla="*/ 98323 w 1002889"/>
                <a:gd name="connsiteY1" fmla="*/ 206477 h 639095"/>
                <a:gd name="connsiteX2" fmla="*/ 265471 w 1002889"/>
                <a:gd name="connsiteY2" fmla="*/ 373625 h 639095"/>
                <a:gd name="connsiteX3" fmla="*/ 432619 w 1002889"/>
                <a:gd name="connsiteY3" fmla="*/ 432619 h 639095"/>
                <a:gd name="connsiteX4" fmla="*/ 786581 w 1002889"/>
                <a:gd name="connsiteY4" fmla="*/ 550606 h 639095"/>
                <a:gd name="connsiteX5" fmla="*/ 1002890 w 1002889"/>
                <a:gd name="connsiteY5" fmla="*/ 639096 h 639095"/>
                <a:gd name="connsiteX0" fmla="*/ 0 w 786581"/>
                <a:gd name="connsiteY0" fmla="*/ 0 h 550606"/>
                <a:gd name="connsiteX1" fmla="*/ 98323 w 786581"/>
                <a:gd name="connsiteY1" fmla="*/ 206477 h 550606"/>
                <a:gd name="connsiteX2" fmla="*/ 265471 w 786581"/>
                <a:gd name="connsiteY2" fmla="*/ 373625 h 550606"/>
                <a:gd name="connsiteX3" fmla="*/ 432619 w 786581"/>
                <a:gd name="connsiteY3" fmla="*/ 432619 h 550606"/>
                <a:gd name="connsiteX4" fmla="*/ 786581 w 786581"/>
                <a:gd name="connsiteY4" fmla="*/ 550606 h 550606"/>
                <a:gd name="connsiteX0" fmla="*/ 0 w 432621"/>
                <a:gd name="connsiteY0" fmla="*/ 0 h 432620"/>
                <a:gd name="connsiteX1" fmla="*/ 98323 w 432621"/>
                <a:gd name="connsiteY1" fmla="*/ 206477 h 432620"/>
                <a:gd name="connsiteX2" fmla="*/ 265471 w 432621"/>
                <a:gd name="connsiteY2" fmla="*/ 373625 h 432620"/>
                <a:gd name="connsiteX3" fmla="*/ 432619 w 432621"/>
                <a:gd name="connsiteY3" fmla="*/ 432619 h 4326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2621" h="432620">
                  <a:moveTo>
                    <a:pt x="0" y="0"/>
                  </a:moveTo>
                  <a:cubicBezTo>
                    <a:pt x="27039" y="72103"/>
                    <a:pt x="54078" y="144206"/>
                    <a:pt x="98323" y="206477"/>
                  </a:cubicBezTo>
                  <a:cubicBezTo>
                    <a:pt x="142568" y="268748"/>
                    <a:pt x="209755" y="335935"/>
                    <a:pt x="265471" y="373625"/>
                  </a:cubicBezTo>
                  <a:cubicBezTo>
                    <a:pt x="321187" y="411315"/>
                    <a:pt x="432619" y="432619"/>
                    <a:pt x="432619" y="43261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3" name="任意多边形: 形状 182">
              <a:extLst>
                <a:ext uri="{FF2B5EF4-FFF2-40B4-BE49-F238E27FC236}">
                  <a16:creationId xmlns:a16="http://schemas.microsoft.com/office/drawing/2014/main" id="{2608FE0E-11B0-47AC-959B-BF70E7814E36}"/>
                </a:ext>
              </a:extLst>
            </p:cNvPr>
            <p:cNvSpPr/>
            <p:nvPr/>
          </p:nvSpPr>
          <p:spPr>
            <a:xfrm>
              <a:off x="8676250" y="4687911"/>
              <a:ext cx="330999" cy="296865"/>
            </a:xfrm>
            <a:custGeom>
              <a:avLst/>
              <a:gdLst>
                <a:gd name="connsiteX0" fmla="*/ 506751 w 1322993"/>
                <a:gd name="connsiteY0" fmla="*/ 1530 h 1186562"/>
                <a:gd name="connsiteX1" fmla="*/ 880376 w 1322993"/>
                <a:gd name="connsiteY1" fmla="*/ 149013 h 1186562"/>
                <a:gd name="connsiteX2" fmla="*/ 1214673 w 1322993"/>
                <a:gd name="connsiteY2" fmla="*/ 267001 h 1186562"/>
                <a:gd name="connsiteX3" fmla="*/ 1322828 w 1322993"/>
                <a:gd name="connsiteY3" fmla="*/ 384988 h 1186562"/>
                <a:gd name="connsiteX4" fmla="*/ 1234338 w 1322993"/>
                <a:gd name="connsiteY4" fmla="*/ 670123 h 1186562"/>
                <a:gd name="connsiteX5" fmla="*/ 1047525 w 1322993"/>
                <a:gd name="connsiteY5" fmla="*/ 738949 h 1186562"/>
                <a:gd name="connsiteX6" fmla="*/ 801718 w 1322993"/>
                <a:gd name="connsiteY6" fmla="*/ 738949 h 1186562"/>
                <a:gd name="connsiteX7" fmla="*/ 644402 w 1322993"/>
                <a:gd name="connsiteY7" fmla="*/ 817607 h 1186562"/>
                <a:gd name="connsiteX8" fmla="*/ 457589 w 1322993"/>
                <a:gd name="connsiteY8" fmla="*/ 955259 h 1186562"/>
                <a:gd name="connsiteX9" fmla="*/ 310105 w 1322993"/>
                <a:gd name="connsiteY9" fmla="*/ 1132239 h 1186562"/>
                <a:gd name="connsiteX10" fmla="*/ 74131 w 1322993"/>
                <a:gd name="connsiteY10" fmla="*/ 1171568 h 1186562"/>
                <a:gd name="connsiteX11" fmla="*/ 5305 w 1322993"/>
                <a:gd name="connsiteY11" fmla="*/ 906097 h 1186562"/>
                <a:gd name="connsiteX12" fmla="*/ 192118 w 1322993"/>
                <a:gd name="connsiteY12" fmla="*/ 689788 h 1186562"/>
                <a:gd name="connsiteX13" fmla="*/ 359267 w 1322993"/>
                <a:gd name="connsiteY13" fmla="*/ 424317 h 1186562"/>
                <a:gd name="connsiteX14" fmla="*/ 369099 w 1322993"/>
                <a:gd name="connsiteY14" fmla="*/ 247336 h 1186562"/>
                <a:gd name="connsiteX15" fmla="*/ 506751 w 1322993"/>
                <a:gd name="connsiteY15" fmla="*/ 1530 h 11865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1322993" h="1186562">
                  <a:moveTo>
                    <a:pt x="506751" y="1530"/>
                  </a:moveTo>
                  <a:cubicBezTo>
                    <a:pt x="591964" y="-14857"/>
                    <a:pt x="762389" y="104768"/>
                    <a:pt x="880376" y="149013"/>
                  </a:cubicBezTo>
                  <a:cubicBezTo>
                    <a:pt x="998363" y="193258"/>
                    <a:pt x="1140931" y="227672"/>
                    <a:pt x="1214673" y="267001"/>
                  </a:cubicBezTo>
                  <a:cubicBezTo>
                    <a:pt x="1288415" y="306330"/>
                    <a:pt x="1319551" y="317801"/>
                    <a:pt x="1322828" y="384988"/>
                  </a:cubicBezTo>
                  <a:cubicBezTo>
                    <a:pt x="1326106" y="452175"/>
                    <a:pt x="1280222" y="611130"/>
                    <a:pt x="1234338" y="670123"/>
                  </a:cubicBezTo>
                  <a:cubicBezTo>
                    <a:pt x="1188454" y="729116"/>
                    <a:pt x="1119628" y="727478"/>
                    <a:pt x="1047525" y="738949"/>
                  </a:cubicBezTo>
                  <a:cubicBezTo>
                    <a:pt x="975422" y="750420"/>
                    <a:pt x="868905" y="725839"/>
                    <a:pt x="801718" y="738949"/>
                  </a:cubicBezTo>
                  <a:cubicBezTo>
                    <a:pt x="734531" y="752059"/>
                    <a:pt x="701757" y="781555"/>
                    <a:pt x="644402" y="817607"/>
                  </a:cubicBezTo>
                  <a:cubicBezTo>
                    <a:pt x="587047" y="853659"/>
                    <a:pt x="513305" y="902820"/>
                    <a:pt x="457589" y="955259"/>
                  </a:cubicBezTo>
                  <a:cubicBezTo>
                    <a:pt x="401873" y="1007698"/>
                    <a:pt x="374015" y="1096188"/>
                    <a:pt x="310105" y="1132239"/>
                  </a:cubicBezTo>
                  <a:cubicBezTo>
                    <a:pt x="246195" y="1168290"/>
                    <a:pt x="124931" y="1209258"/>
                    <a:pt x="74131" y="1171568"/>
                  </a:cubicBezTo>
                  <a:cubicBezTo>
                    <a:pt x="23331" y="1133878"/>
                    <a:pt x="-14360" y="986394"/>
                    <a:pt x="5305" y="906097"/>
                  </a:cubicBezTo>
                  <a:cubicBezTo>
                    <a:pt x="24970" y="825800"/>
                    <a:pt x="133124" y="770085"/>
                    <a:pt x="192118" y="689788"/>
                  </a:cubicBezTo>
                  <a:cubicBezTo>
                    <a:pt x="251112" y="609491"/>
                    <a:pt x="329770" y="498059"/>
                    <a:pt x="359267" y="424317"/>
                  </a:cubicBezTo>
                  <a:cubicBezTo>
                    <a:pt x="388764" y="350575"/>
                    <a:pt x="344518" y="312884"/>
                    <a:pt x="369099" y="247336"/>
                  </a:cubicBezTo>
                  <a:cubicBezTo>
                    <a:pt x="393680" y="181788"/>
                    <a:pt x="421538" y="17917"/>
                    <a:pt x="506751" y="1530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4" name="任意多边形: 形状 183">
              <a:extLst>
                <a:ext uri="{FF2B5EF4-FFF2-40B4-BE49-F238E27FC236}">
                  <a16:creationId xmlns:a16="http://schemas.microsoft.com/office/drawing/2014/main" id="{5CFB229E-6DFD-4018-A7F7-7CAAF107FA57}"/>
                </a:ext>
              </a:extLst>
            </p:cNvPr>
            <p:cNvSpPr/>
            <p:nvPr/>
          </p:nvSpPr>
          <p:spPr>
            <a:xfrm>
              <a:off x="8803644" y="4428075"/>
              <a:ext cx="205414" cy="204666"/>
            </a:xfrm>
            <a:custGeom>
              <a:avLst/>
              <a:gdLst>
                <a:gd name="connsiteX0" fmla="*/ 3396 w 205414"/>
                <a:gd name="connsiteY0" fmla="*/ 257 h 204666"/>
                <a:gd name="connsiteX1" fmla="*/ 22446 w 205414"/>
                <a:gd name="connsiteY1" fmla="*/ 81220 h 204666"/>
                <a:gd name="connsiteX2" fmla="*/ 12921 w 205414"/>
                <a:gd name="connsiteY2" fmla="*/ 138370 h 204666"/>
                <a:gd name="connsiteX3" fmla="*/ 112933 w 205414"/>
                <a:gd name="connsiteY3" fmla="*/ 195520 h 204666"/>
                <a:gd name="connsiteX4" fmla="*/ 198658 w 205414"/>
                <a:gd name="connsiteY4" fmla="*/ 200282 h 204666"/>
                <a:gd name="connsiteX5" fmla="*/ 189133 w 205414"/>
                <a:gd name="connsiteY5" fmla="*/ 152657 h 204666"/>
                <a:gd name="connsiteX6" fmla="*/ 103408 w 205414"/>
                <a:gd name="connsiteY6" fmla="*/ 109795 h 204666"/>
                <a:gd name="connsiteX7" fmla="*/ 3396 w 205414"/>
                <a:gd name="connsiteY7" fmla="*/ 257 h 2046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05414" h="204666">
                  <a:moveTo>
                    <a:pt x="3396" y="257"/>
                  </a:moveTo>
                  <a:cubicBezTo>
                    <a:pt x="-10098" y="-4506"/>
                    <a:pt x="20859" y="58201"/>
                    <a:pt x="22446" y="81220"/>
                  </a:cubicBezTo>
                  <a:cubicBezTo>
                    <a:pt x="24033" y="104239"/>
                    <a:pt x="-2160" y="119320"/>
                    <a:pt x="12921" y="138370"/>
                  </a:cubicBezTo>
                  <a:cubicBezTo>
                    <a:pt x="28002" y="157420"/>
                    <a:pt x="81977" y="185201"/>
                    <a:pt x="112933" y="195520"/>
                  </a:cubicBezTo>
                  <a:cubicBezTo>
                    <a:pt x="143889" y="205839"/>
                    <a:pt x="185958" y="207426"/>
                    <a:pt x="198658" y="200282"/>
                  </a:cubicBezTo>
                  <a:cubicBezTo>
                    <a:pt x="211358" y="193138"/>
                    <a:pt x="205008" y="167738"/>
                    <a:pt x="189133" y="152657"/>
                  </a:cubicBezTo>
                  <a:cubicBezTo>
                    <a:pt x="173258" y="137576"/>
                    <a:pt x="129602" y="131226"/>
                    <a:pt x="103408" y="109795"/>
                  </a:cubicBezTo>
                  <a:cubicBezTo>
                    <a:pt x="77214" y="88364"/>
                    <a:pt x="16890" y="5020"/>
                    <a:pt x="3396" y="257"/>
                  </a:cubicBez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5" name="任意多边形: 形状 184">
              <a:extLst>
                <a:ext uri="{FF2B5EF4-FFF2-40B4-BE49-F238E27FC236}">
                  <a16:creationId xmlns:a16="http://schemas.microsoft.com/office/drawing/2014/main" id="{6011A301-596A-44ED-A60C-F2EA8E2A8EBB}"/>
                </a:ext>
              </a:extLst>
            </p:cNvPr>
            <p:cNvSpPr/>
            <p:nvPr/>
          </p:nvSpPr>
          <p:spPr>
            <a:xfrm>
              <a:off x="8766575" y="4208881"/>
              <a:ext cx="301356" cy="427866"/>
            </a:xfrm>
            <a:custGeom>
              <a:avLst/>
              <a:gdLst>
                <a:gd name="connsiteX0" fmla="*/ 301344 w 301394"/>
                <a:gd name="connsiteY0" fmla="*/ 48032 h 410775"/>
                <a:gd name="connsiteX1" fmla="*/ 199744 w 301394"/>
                <a:gd name="connsiteY1" fmla="*/ 28982 h 410775"/>
                <a:gd name="connsiteX2" fmla="*/ 98144 w 301394"/>
                <a:gd name="connsiteY2" fmla="*/ 28982 h 410775"/>
                <a:gd name="connsiteX3" fmla="*/ 98144 w 301394"/>
                <a:gd name="connsiteY3" fmla="*/ 73432 h 410775"/>
                <a:gd name="connsiteX4" fmla="*/ 98144 w 301394"/>
                <a:gd name="connsiteY4" fmla="*/ 162332 h 410775"/>
                <a:gd name="connsiteX5" fmla="*/ 79094 w 301394"/>
                <a:gd name="connsiteY5" fmla="*/ 200432 h 410775"/>
                <a:gd name="connsiteX6" fmla="*/ 91794 w 301394"/>
                <a:gd name="connsiteY6" fmla="*/ 270282 h 410775"/>
                <a:gd name="connsiteX7" fmla="*/ 155294 w 301394"/>
                <a:gd name="connsiteY7" fmla="*/ 289332 h 410775"/>
                <a:gd name="connsiteX8" fmla="*/ 212444 w 301394"/>
                <a:gd name="connsiteY8" fmla="*/ 346482 h 410775"/>
                <a:gd name="connsiteX9" fmla="*/ 237844 w 301394"/>
                <a:gd name="connsiteY9" fmla="*/ 403632 h 410775"/>
                <a:gd name="connsiteX10" fmla="*/ 161644 w 301394"/>
                <a:gd name="connsiteY10" fmla="*/ 403632 h 410775"/>
                <a:gd name="connsiteX11" fmla="*/ 40994 w 301394"/>
                <a:gd name="connsiteY11" fmla="*/ 346482 h 410775"/>
                <a:gd name="connsiteX12" fmla="*/ 40994 w 301394"/>
                <a:gd name="connsiteY12" fmla="*/ 276632 h 410775"/>
                <a:gd name="connsiteX13" fmla="*/ 40994 w 301394"/>
                <a:gd name="connsiteY13" fmla="*/ 143282 h 410775"/>
                <a:gd name="connsiteX14" fmla="*/ 2894 w 301394"/>
                <a:gd name="connsiteY14" fmla="*/ 35332 h 410775"/>
                <a:gd name="connsiteX15" fmla="*/ 129894 w 301394"/>
                <a:gd name="connsiteY15" fmla="*/ 3582 h 410775"/>
                <a:gd name="connsiteX16" fmla="*/ 212444 w 301394"/>
                <a:gd name="connsiteY16" fmla="*/ 3582 h 410775"/>
                <a:gd name="connsiteX17" fmla="*/ 301344 w 301394"/>
                <a:gd name="connsiteY17" fmla="*/ 48032 h 410775"/>
                <a:gd name="connsiteX0" fmla="*/ 301225 w 301277"/>
                <a:gd name="connsiteY0" fmla="*/ 64670 h 427413"/>
                <a:gd name="connsiteX1" fmla="*/ 199625 w 301277"/>
                <a:gd name="connsiteY1" fmla="*/ 45620 h 427413"/>
                <a:gd name="connsiteX2" fmla="*/ 98025 w 301277"/>
                <a:gd name="connsiteY2" fmla="*/ 45620 h 427413"/>
                <a:gd name="connsiteX3" fmla="*/ 98025 w 301277"/>
                <a:gd name="connsiteY3" fmla="*/ 90070 h 427413"/>
                <a:gd name="connsiteX4" fmla="*/ 98025 w 301277"/>
                <a:gd name="connsiteY4" fmla="*/ 178970 h 427413"/>
                <a:gd name="connsiteX5" fmla="*/ 78975 w 301277"/>
                <a:gd name="connsiteY5" fmla="*/ 217070 h 427413"/>
                <a:gd name="connsiteX6" fmla="*/ 91675 w 301277"/>
                <a:gd name="connsiteY6" fmla="*/ 286920 h 427413"/>
                <a:gd name="connsiteX7" fmla="*/ 155175 w 301277"/>
                <a:gd name="connsiteY7" fmla="*/ 305970 h 427413"/>
                <a:gd name="connsiteX8" fmla="*/ 212325 w 301277"/>
                <a:gd name="connsiteY8" fmla="*/ 363120 h 427413"/>
                <a:gd name="connsiteX9" fmla="*/ 237725 w 301277"/>
                <a:gd name="connsiteY9" fmla="*/ 420270 h 427413"/>
                <a:gd name="connsiteX10" fmla="*/ 161525 w 301277"/>
                <a:gd name="connsiteY10" fmla="*/ 420270 h 427413"/>
                <a:gd name="connsiteX11" fmla="*/ 40875 w 301277"/>
                <a:gd name="connsiteY11" fmla="*/ 363120 h 427413"/>
                <a:gd name="connsiteX12" fmla="*/ 40875 w 301277"/>
                <a:gd name="connsiteY12" fmla="*/ 293270 h 427413"/>
                <a:gd name="connsiteX13" fmla="*/ 40875 w 301277"/>
                <a:gd name="connsiteY13" fmla="*/ 159920 h 427413"/>
                <a:gd name="connsiteX14" fmla="*/ 2775 w 301277"/>
                <a:gd name="connsiteY14" fmla="*/ 51970 h 427413"/>
                <a:gd name="connsiteX15" fmla="*/ 127394 w 301277"/>
                <a:gd name="connsiteY15" fmla="*/ 1170 h 427413"/>
                <a:gd name="connsiteX16" fmla="*/ 212325 w 301277"/>
                <a:gd name="connsiteY16" fmla="*/ 20220 h 427413"/>
                <a:gd name="connsiteX17" fmla="*/ 301225 w 301277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98025 w 301571"/>
                <a:gd name="connsiteY2" fmla="*/ 45620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126600 w 301571"/>
                <a:gd name="connsiteY2" fmla="*/ 59907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150413 w 301571"/>
                <a:gd name="connsiteY2" fmla="*/ 74195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98025 w 301392"/>
                <a:gd name="connsiteY3" fmla="*/ 90070 h 427413"/>
                <a:gd name="connsiteX4" fmla="*/ 98025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121838 w 301392"/>
                <a:gd name="connsiteY3" fmla="*/ 106739 h 427413"/>
                <a:gd name="connsiteX4" fmla="*/ 98025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121838 w 301392"/>
                <a:gd name="connsiteY3" fmla="*/ 106739 h 427413"/>
                <a:gd name="connsiteX4" fmla="*/ 102787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866"/>
                <a:gd name="connsiteX1" fmla="*/ 209150 w 301392"/>
                <a:gd name="connsiteY1" fmla="*/ 69432 h 427866"/>
                <a:gd name="connsiteX2" fmla="*/ 150413 w 301392"/>
                <a:gd name="connsiteY2" fmla="*/ 74195 h 427866"/>
                <a:gd name="connsiteX3" fmla="*/ 121838 w 301392"/>
                <a:gd name="connsiteY3" fmla="*/ 106739 h 427866"/>
                <a:gd name="connsiteX4" fmla="*/ 102787 w 301392"/>
                <a:gd name="connsiteY4" fmla="*/ 178970 h 427866"/>
                <a:gd name="connsiteX5" fmla="*/ 78975 w 301392"/>
                <a:gd name="connsiteY5" fmla="*/ 217070 h 427866"/>
                <a:gd name="connsiteX6" fmla="*/ 91675 w 301392"/>
                <a:gd name="connsiteY6" fmla="*/ 286920 h 427866"/>
                <a:gd name="connsiteX7" fmla="*/ 155175 w 301392"/>
                <a:gd name="connsiteY7" fmla="*/ 305970 h 427866"/>
                <a:gd name="connsiteX8" fmla="*/ 212325 w 301392"/>
                <a:gd name="connsiteY8" fmla="*/ 363120 h 427866"/>
                <a:gd name="connsiteX9" fmla="*/ 237725 w 301392"/>
                <a:gd name="connsiteY9" fmla="*/ 420270 h 427866"/>
                <a:gd name="connsiteX10" fmla="*/ 161525 w 301392"/>
                <a:gd name="connsiteY10" fmla="*/ 420270 h 427866"/>
                <a:gd name="connsiteX11" fmla="*/ 55163 w 301392"/>
                <a:gd name="connsiteY11" fmla="*/ 355976 h 427866"/>
                <a:gd name="connsiteX12" fmla="*/ 40875 w 301392"/>
                <a:gd name="connsiteY12" fmla="*/ 293270 h 427866"/>
                <a:gd name="connsiteX13" fmla="*/ 40875 w 301392"/>
                <a:gd name="connsiteY13" fmla="*/ 159920 h 427866"/>
                <a:gd name="connsiteX14" fmla="*/ 2775 w 301392"/>
                <a:gd name="connsiteY14" fmla="*/ 51970 h 427866"/>
                <a:gd name="connsiteX15" fmla="*/ 127394 w 301392"/>
                <a:gd name="connsiteY15" fmla="*/ 1170 h 427866"/>
                <a:gd name="connsiteX16" fmla="*/ 228994 w 301392"/>
                <a:gd name="connsiteY16" fmla="*/ 20220 h 427866"/>
                <a:gd name="connsiteX17" fmla="*/ 301225 w 301392"/>
                <a:gd name="connsiteY17" fmla="*/ 64670 h 427866"/>
                <a:gd name="connsiteX0" fmla="*/ 301225 w 301392"/>
                <a:gd name="connsiteY0" fmla="*/ 64670 h 427866"/>
                <a:gd name="connsiteX1" fmla="*/ 209150 w 301392"/>
                <a:gd name="connsiteY1" fmla="*/ 69432 h 427866"/>
                <a:gd name="connsiteX2" fmla="*/ 124219 w 301392"/>
                <a:gd name="connsiteY2" fmla="*/ 52764 h 427866"/>
                <a:gd name="connsiteX3" fmla="*/ 121838 w 301392"/>
                <a:gd name="connsiteY3" fmla="*/ 106739 h 427866"/>
                <a:gd name="connsiteX4" fmla="*/ 102787 w 301392"/>
                <a:gd name="connsiteY4" fmla="*/ 178970 h 427866"/>
                <a:gd name="connsiteX5" fmla="*/ 78975 w 301392"/>
                <a:gd name="connsiteY5" fmla="*/ 217070 h 427866"/>
                <a:gd name="connsiteX6" fmla="*/ 91675 w 301392"/>
                <a:gd name="connsiteY6" fmla="*/ 286920 h 427866"/>
                <a:gd name="connsiteX7" fmla="*/ 155175 w 301392"/>
                <a:gd name="connsiteY7" fmla="*/ 305970 h 427866"/>
                <a:gd name="connsiteX8" fmla="*/ 212325 w 301392"/>
                <a:gd name="connsiteY8" fmla="*/ 363120 h 427866"/>
                <a:gd name="connsiteX9" fmla="*/ 237725 w 301392"/>
                <a:gd name="connsiteY9" fmla="*/ 420270 h 427866"/>
                <a:gd name="connsiteX10" fmla="*/ 161525 w 301392"/>
                <a:gd name="connsiteY10" fmla="*/ 420270 h 427866"/>
                <a:gd name="connsiteX11" fmla="*/ 55163 w 301392"/>
                <a:gd name="connsiteY11" fmla="*/ 355976 h 427866"/>
                <a:gd name="connsiteX12" fmla="*/ 40875 w 301392"/>
                <a:gd name="connsiteY12" fmla="*/ 293270 h 427866"/>
                <a:gd name="connsiteX13" fmla="*/ 40875 w 301392"/>
                <a:gd name="connsiteY13" fmla="*/ 159920 h 427866"/>
                <a:gd name="connsiteX14" fmla="*/ 2775 w 301392"/>
                <a:gd name="connsiteY14" fmla="*/ 51970 h 427866"/>
                <a:gd name="connsiteX15" fmla="*/ 127394 w 301392"/>
                <a:gd name="connsiteY15" fmla="*/ 1170 h 427866"/>
                <a:gd name="connsiteX16" fmla="*/ 228994 w 301392"/>
                <a:gd name="connsiteY16" fmla="*/ 20220 h 427866"/>
                <a:gd name="connsiteX17" fmla="*/ 301225 w 301392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121838 w 301356"/>
                <a:gd name="connsiteY3" fmla="*/ 106739 h 427866"/>
                <a:gd name="connsiteX4" fmla="*/ 102787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83738 w 301356"/>
                <a:gd name="connsiteY3" fmla="*/ 101976 h 427866"/>
                <a:gd name="connsiteX4" fmla="*/ 102787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83738 w 301356"/>
                <a:gd name="connsiteY3" fmla="*/ 101976 h 427866"/>
                <a:gd name="connsiteX4" fmla="*/ 78975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301356" h="427866">
                  <a:moveTo>
                    <a:pt x="301225" y="64670"/>
                  </a:moveTo>
                  <a:cubicBezTo>
                    <a:pt x="298315" y="70491"/>
                    <a:pt x="241032" y="57129"/>
                    <a:pt x="211531" y="55145"/>
                  </a:cubicBezTo>
                  <a:cubicBezTo>
                    <a:pt x="182030" y="53161"/>
                    <a:pt x="145518" y="44959"/>
                    <a:pt x="124219" y="52764"/>
                  </a:cubicBezTo>
                  <a:cubicBezTo>
                    <a:pt x="102920" y="60569"/>
                    <a:pt x="91279" y="80942"/>
                    <a:pt x="83738" y="101976"/>
                  </a:cubicBezTo>
                  <a:cubicBezTo>
                    <a:pt x="76197" y="123010"/>
                    <a:pt x="79769" y="159788"/>
                    <a:pt x="78975" y="178970"/>
                  </a:cubicBezTo>
                  <a:cubicBezTo>
                    <a:pt x="78181" y="198152"/>
                    <a:pt x="76858" y="199078"/>
                    <a:pt x="78975" y="217070"/>
                  </a:cubicBezTo>
                  <a:cubicBezTo>
                    <a:pt x="81092" y="235062"/>
                    <a:pt x="78975" y="272103"/>
                    <a:pt x="91675" y="286920"/>
                  </a:cubicBezTo>
                  <a:cubicBezTo>
                    <a:pt x="104375" y="301737"/>
                    <a:pt x="135067" y="293270"/>
                    <a:pt x="155175" y="305970"/>
                  </a:cubicBezTo>
                  <a:cubicBezTo>
                    <a:pt x="175283" y="318670"/>
                    <a:pt x="198567" y="344070"/>
                    <a:pt x="212325" y="363120"/>
                  </a:cubicBezTo>
                  <a:cubicBezTo>
                    <a:pt x="226083" y="382170"/>
                    <a:pt x="246192" y="410745"/>
                    <a:pt x="237725" y="420270"/>
                  </a:cubicBezTo>
                  <a:cubicBezTo>
                    <a:pt x="229258" y="429795"/>
                    <a:pt x="191952" y="430986"/>
                    <a:pt x="161525" y="420270"/>
                  </a:cubicBezTo>
                  <a:cubicBezTo>
                    <a:pt x="131098" y="409554"/>
                    <a:pt x="75271" y="377143"/>
                    <a:pt x="55163" y="355976"/>
                  </a:cubicBezTo>
                  <a:cubicBezTo>
                    <a:pt x="35055" y="334809"/>
                    <a:pt x="43256" y="325946"/>
                    <a:pt x="40875" y="293270"/>
                  </a:cubicBezTo>
                  <a:cubicBezTo>
                    <a:pt x="38494" y="260594"/>
                    <a:pt x="47225" y="200137"/>
                    <a:pt x="40875" y="159920"/>
                  </a:cubicBezTo>
                  <a:cubicBezTo>
                    <a:pt x="34525" y="119703"/>
                    <a:pt x="-11645" y="78428"/>
                    <a:pt x="2775" y="51970"/>
                  </a:cubicBezTo>
                  <a:cubicBezTo>
                    <a:pt x="17195" y="25512"/>
                    <a:pt x="92469" y="6462"/>
                    <a:pt x="127394" y="1170"/>
                  </a:cubicBezTo>
                  <a:cubicBezTo>
                    <a:pt x="162319" y="-4122"/>
                    <a:pt x="200022" y="9637"/>
                    <a:pt x="228994" y="20220"/>
                  </a:cubicBezTo>
                  <a:cubicBezTo>
                    <a:pt x="257966" y="30803"/>
                    <a:pt x="304136" y="58849"/>
                    <a:pt x="301225" y="64670"/>
                  </a:cubicBez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6" name="任意多边形: 形状 185">
              <a:extLst>
                <a:ext uri="{FF2B5EF4-FFF2-40B4-BE49-F238E27FC236}">
                  <a16:creationId xmlns:a16="http://schemas.microsoft.com/office/drawing/2014/main" id="{9C01352C-9D2F-4416-BA5E-3686CB81EC89}"/>
                </a:ext>
              </a:extLst>
            </p:cNvPr>
            <p:cNvSpPr/>
            <p:nvPr/>
          </p:nvSpPr>
          <p:spPr>
            <a:xfrm>
              <a:off x="8778654" y="4210860"/>
              <a:ext cx="387726" cy="773916"/>
            </a:xfrm>
            <a:custGeom>
              <a:avLst/>
              <a:gdLst>
                <a:gd name="connsiteX0" fmla="*/ 791928 w 1549729"/>
                <a:gd name="connsiteY0" fmla="*/ 3093321 h 3093321"/>
                <a:gd name="connsiteX1" fmla="*/ 1165554 w 1549729"/>
                <a:gd name="connsiteY1" fmla="*/ 2532882 h 3093321"/>
                <a:gd name="connsiteX2" fmla="*/ 1401528 w 1549729"/>
                <a:gd name="connsiteY2" fmla="*/ 1942947 h 3093321"/>
                <a:gd name="connsiteX3" fmla="*/ 1549012 w 1549729"/>
                <a:gd name="connsiteY3" fmla="*/ 1166199 h 3093321"/>
                <a:gd name="connsiteX4" fmla="*/ 1342535 w 1549729"/>
                <a:gd name="connsiteY4" fmla="*/ 586095 h 3093321"/>
                <a:gd name="connsiteX5" fmla="*/ 1027902 w 1549729"/>
                <a:gd name="connsiteY5" fmla="*/ 94482 h 3093321"/>
                <a:gd name="connsiteX6" fmla="*/ 408470 w 1549729"/>
                <a:gd name="connsiteY6" fmla="*/ 5992 h 3093321"/>
                <a:gd name="connsiteX7" fmla="*/ 15180 w 1549729"/>
                <a:gd name="connsiteY7" fmla="*/ 182973 h 3093321"/>
                <a:gd name="connsiteX8" fmla="*/ 84006 w 1549729"/>
                <a:gd name="connsiteY8" fmla="*/ 586095 h 3093321"/>
                <a:gd name="connsiteX9" fmla="*/ 113502 w 1549729"/>
                <a:gd name="connsiteY9" fmla="*/ 979386 h 3093321"/>
                <a:gd name="connsiteX10" fmla="*/ 201993 w 1549729"/>
                <a:gd name="connsiteY10" fmla="*/ 1441502 h 3093321"/>
                <a:gd name="connsiteX11" fmla="*/ 536289 w 1549729"/>
                <a:gd name="connsiteY11" fmla="*/ 1647979 h 3093321"/>
                <a:gd name="connsiteX12" fmla="*/ 870586 w 1549729"/>
                <a:gd name="connsiteY12" fmla="*/ 1657811 h 3093321"/>
                <a:gd name="connsiteX13" fmla="*/ 949244 w 1549729"/>
                <a:gd name="connsiteY13" fmla="*/ 1647979 h 30933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1549729" h="3093321">
                  <a:moveTo>
                    <a:pt x="791928" y="3093321"/>
                  </a:moveTo>
                  <a:cubicBezTo>
                    <a:pt x="927941" y="2908966"/>
                    <a:pt x="1063954" y="2724611"/>
                    <a:pt x="1165554" y="2532882"/>
                  </a:cubicBezTo>
                  <a:cubicBezTo>
                    <a:pt x="1267154" y="2341153"/>
                    <a:pt x="1337618" y="2170727"/>
                    <a:pt x="1401528" y="1942947"/>
                  </a:cubicBezTo>
                  <a:cubicBezTo>
                    <a:pt x="1465438" y="1715166"/>
                    <a:pt x="1558844" y="1392341"/>
                    <a:pt x="1549012" y="1166199"/>
                  </a:cubicBezTo>
                  <a:cubicBezTo>
                    <a:pt x="1539180" y="940057"/>
                    <a:pt x="1429387" y="764714"/>
                    <a:pt x="1342535" y="586095"/>
                  </a:cubicBezTo>
                  <a:cubicBezTo>
                    <a:pt x="1255683" y="407476"/>
                    <a:pt x="1183580" y="191166"/>
                    <a:pt x="1027902" y="94482"/>
                  </a:cubicBezTo>
                  <a:cubicBezTo>
                    <a:pt x="872225" y="-2202"/>
                    <a:pt x="577257" y="-8756"/>
                    <a:pt x="408470" y="5992"/>
                  </a:cubicBezTo>
                  <a:cubicBezTo>
                    <a:pt x="239683" y="20740"/>
                    <a:pt x="69257" y="86289"/>
                    <a:pt x="15180" y="182973"/>
                  </a:cubicBezTo>
                  <a:cubicBezTo>
                    <a:pt x="-38897" y="279657"/>
                    <a:pt x="67619" y="453360"/>
                    <a:pt x="84006" y="586095"/>
                  </a:cubicBezTo>
                  <a:cubicBezTo>
                    <a:pt x="100393" y="718830"/>
                    <a:pt x="93837" y="836818"/>
                    <a:pt x="113502" y="979386"/>
                  </a:cubicBezTo>
                  <a:cubicBezTo>
                    <a:pt x="133166" y="1121954"/>
                    <a:pt x="131529" y="1330070"/>
                    <a:pt x="201993" y="1441502"/>
                  </a:cubicBezTo>
                  <a:cubicBezTo>
                    <a:pt x="272457" y="1552934"/>
                    <a:pt x="424857" y="1611928"/>
                    <a:pt x="536289" y="1647979"/>
                  </a:cubicBezTo>
                  <a:cubicBezTo>
                    <a:pt x="647721" y="1684030"/>
                    <a:pt x="801760" y="1657811"/>
                    <a:pt x="870586" y="1657811"/>
                  </a:cubicBezTo>
                  <a:cubicBezTo>
                    <a:pt x="939412" y="1657811"/>
                    <a:pt x="944328" y="1652895"/>
                    <a:pt x="949244" y="164797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7" name="任意多边形: 形状 186">
              <a:extLst>
                <a:ext uri="{FF2B5EF4-FFF2-40B4-BE49-F238E27FC236}">
                  <a16:creationId xmlns:a16="http://schemas.microsoft.com/office/drawing/2014/main" id="{DA486427-E374-40DF-99D3-3078811105B5}"/>
                </a:ext>
              </a:extLst>
            </p:cNvPr>
            <p:cNvSpPr/>
            <p:nvPr/>
          </p:nvSpPr>
          <p:spPr>
            <a:xfrm>
              <a:off x="8832218" y="4435732"/>
              <a:ext cx="196898" cy="370087"/>
            </a:xfrm>
            <a:custGeom>
              <a:avLst/>
              <a:gdLst>
                <a:gd name="connsiteX0" fmla="*/ 0 w 786995"/>
                <a:gd name="connsiteY0" fmla="*/ 0 h 1479227"/>
                <a:gd name="connsiteX1" fmla="*/ 98322 w 786995"/>
                <a:gd name="connsiteY1" fmla="*/ 226142 h 1479227"/>
                <a:gd name="connsiteX2" fmla="*/ 373626 w 786995"/>
                <a:gd name="connsiteY2" fmla="*/ 373626 h 1479227"/>
                <a:gd name="connsiteX3" fmla="*/ 629264 w 786995"/>
                <a:gd name="connsiteY3" fmla="*/ 570271 h 1479227"/>
                <a:gd name="connsiteX4" fmla="*/ 747251 w 786995"/>
                <a:gd name="connsiteY4" fmla="*/ 884903 h 1479227"/>
                <a:gd name="connsiteX5" fmla="*/ 786580 w 786995"/>
                <a:gd name="connsiteY5" fmla="*/ 1179871 h 1479227"/>
                <a:gd name="connsiteX6" fmla="*/ 727587 w 786995"/>
                <a:gd name="connsiteY6" fmla="*/ 1376516 h 1479227"/>
                <a:gd name="connsiteX7" fmla="*/ 678426 w 786995"/>
                <a:gd name="connsiteY7" fmla="*/ 1474839 h 14792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786995" h="1479227">
                  <a:moveTo>
                    <a:pt x="0" y="0"/>
                  </a:moveTo>
                  <a:cubicBezTo>
                    <a:pt x="18025" y="81935"/>
                    <a:pt x="36051" y="163871"/>
                    <a:pt x="98322" y="226142"/>
                  </a:cubicBezTo>
                  <a:cubicBezTo>
                    <a:pt x="160593" y="288413"/>
                    <a:pt x="285136" y="316271"/>
                    <a:pt x="373626" y="373626"/>
                  </a:cubicBezTo>
                  <a:cubicBezTo>
                    <a:pt x="462116" y="430981"/>
                    <a:pt x="566993" y="485058"/>
                    <a:pt x="629264" y="570271"/>
                  </a:cubicBezTo>
                  <a:cubicBezTo>
                    <a:pt x="691535" y="655484"/>
                    <a:pt x="721032" y="783303"/>
                    <a:pt x="747251" y="884903"/>
                  </a:cubicBezTo>
                  <a:cubicBezTo>
                    <a:pt x="773470" y="986503"/>
                    <a:pt x="789857" y="1097936"/>
                    <a:pt x="786580" y="1179871"/>
                  </a:cubicBezTo>
                  <a:cubicBezTo>
                    <a:pt x="783303" y="1261806"/>
                    <a:pt x="745613" y="1327355"/>
                    <a:pt x="727587" y="1376516"/>
                  </a:cubicBezTo>
                  <a:cubicBezTo>
                    <a:pt x="709561" y="1425677"/>
                    <a:pt x="683342" y="1497781"/>
                    <a:pt x="678426" y="147483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97" name="组合 196">
            <a:extLst>
              <a:ext uri="{FF2B5EF4-FFF2-40B4-BE49-F238E27FC236}">
                <a16:creationId xmlns:a16="http://schemas.microsoft.com/office/drawing/2014/main" id="{C7F83FE1-DB76-472A-962B-9022322445FF}"/>
              </a:ext>
            </a:extLst>
          </p:cNvPr>
          <p:cNvGrpSpPr/>
          <p:nvPr/>
        </p:nvGrpSpPr>
        <p:grpSpPr>
          <a:xfrm rot="1773924">
            <a:off x="4055152" y="5429904"/>
            <a:ext cx="535687" cy="620352"/>
            <a:chOff x="5258633" y="775855"/>
            <a:chExt cx="583340" cy="675535"/>
          </a:xfrm>
        </p:grpSpPr>
        <p:sp>
          <p:nvSpPr>
            <p:cNvPr id="198" name="矩形 197">
              <a:extLst>
                <a:ext uri="{FF2B5EF4-FFF2-40B4-BE49-F238E27FC236}">
                  <a16:creationId xmlns:a16="http://schemas.microsoft.com/office/drawing/2014/main" id="{A1915362-83F3-47D4-AB00-B8B4002CFFD2}"/>
                </a:ext>
              </a:extLst>
            </p:cNvPr>
            <p:cNvSpPr/>
            <p:nvPr/>
          </p:nvSpPr>
          <p:spPr>
            <a:xfrm>
              <a:off x="5393823" y="775855"/>
              <a:ext cx="313989" cy="857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9" name="梯形 198">
              <a:extLst>
                <a:ext uri="{FF2B5EF4-FFF2-40B4-BE49-F238E27FC236}">
                  <a16:creationId xmlns:a16="http://schemas.microsoft.com/office/drawing/2014/main" id="{1D16CE7C-4156-45B8-B37A-245CD9BCEEBE}"/>
                </a:ext>
              </a:extLst>
            </p:cNvPr>
            <p:cNvSpPr/>
            <p:nvPr/>
          </p:nvSpPr>
          <p:spPr>
            <a:xfrm>
              <a:off x="5290988" y="861580"/>
              <a:ext cx="519112" cy="205813"/>
            </a:xfrm>
            <a:prstGeom prst="trapezoid">
              <a:avLst>
                <a:gd name="adj" fmla="val 50000"/>
              </a:avLst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200" name="组合 199">
              <a:extLst>
                <a:ext uri="{FF2B5EF4-FFF2-40B4-BE49-F238E27FC236}">
                  <a16:creationId xmlns:a16="http://schemas.microsoft.com/office/drawing/2014/main" id="{9FB26B89-0904-42F1-8915-688346062DA8}"/>
                </a:ext>
              </a:extLst>
            </p:cNvPr>
            <p:cNvGrpSpPr/>
            <p:nvPr/>
          </p:nvGrpSpPr>
          <p:grpSpPr>
            <a:xfrm rot="5610853">
              <a:off x="5255889" y="865307"/>
              <a:ext cx="588827" cy="583340"/>
              <a:chOff x="6035483" y="2426275"/>
              <a:chExt cx="923001" cy="914400"/>
            </a:xfrm>
          </p:grpSpPr>
          <p:sp>
            <p:nvSpPr>
              <p:cNvPr id="201" name="弧形 200">
                <a:extLst>
                  <a:ext uri="{FF2B5EF4-FFF2-40B4-BE49-F238E27FC236}">
                    <a16:creationId xmlns:a16="http://schemas.microsoft.com/office/drawing/2014/main" id="{33BE6465-09AA-44B0-8EFE-D6673223C42A}"/>
                  </a:ext>
                </a:extLst>
              </p:cNvPr>
              <p:cNvSpPr/>
              <p:nvPr/>
            </p:nvSpPr>
            <p:spPr>
              <a:xfrm rot="2563549">
                <a:off x="6044084" y="2426275"/>
                <a:ext cx="914400" cy="914400"/>
              </a:xfrm>
              <a:prstGeom prst="arc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2" name="弧形 201">
                <a:extLst>
                  <a:ext uri="{FF2B5EF4-FFF2-40B4-BE49-F238E27FC236}">
                    <a16:creationId xmlns:a16="http://schemas.microsoft.com/office/drawing/2014/main" id="{17CE4FC0-4E3F-4ADF-BD25-E71CA76D7CBC}"/>
                  </a:ext>
                </a:extLst>
              </p:cNvPr>
              <p:cNvSpPr/>
              <p:nvPr/>
            </p:nvSpPr>
            <p:spPr>
              <a:xfrm rot="2563549">
                <a:off x="6035483" y="2530211"/>
                <a:ext cx="724355" cy="724355"/>
              </a:xfrm>
              <a:prstGeom prst="arc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3" name="弧形 202">
                <a:extLst>
                  <a:ext uri="{FF2B5EF4-FFF2-40B4-BE49-F238E27FC236}">
                    <a16:creationId xmlns:a16="http://schemas.microsoft.com/office/drawing/2014/main" id="{A43A482E-071C-436F-BD10-D3FBA9AE80D2}"/>
                  </a:ext>
                </a:extLst>
              </p:cNvPr>
              <p:cNvSpPr/>
              <p:nvPr/>
            </p:nvSpPr>
            <p:spPr>
              <a:xfrm rot="2563549">
                <a:off x="6076435" y="2651188"/>
                <a:ext cx="482399" cy="482399"/>
              </a:xfrm>
              <a:prstGeom prst="arc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sp>
        <p:nvSpPr>
          <p:cNvPr id="23" name="矩形: 圆角 22">
            <a:extLst>
              <a:ext uri="{FF2B5EF4-FFF2-40B4-BE49-F238E27FC236}">
                <a16:creationId xmlns:a16="http://schemas.microsoft.com/office/drawing/2014/main" id="{AECFFA04-72F1-4DFC-A438-C365046B4558}"/>
              </a:ext>
            </a:extLst>
          </p:cNvPr>
          <p:cNvSpPr/>
          <p:nvPr/>
        </p:nvSpPr>
        <p:spPr>
          <a:xfrm>
            <a:off x="1024006" y="8601474"/>
            <a:ext cx="4277373" cy="2500741"/>
          </a:xfrm>
          <a:prstGeom prst="roundRect">
            <a:avLst/>
          </a:prstGeom>
          <a:noFill/>
          <a:ln w="9525">
            <a:solidFill>
              <a:schemeClr val="accent2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52" name="任意多边形: 形状 151">
            <a:extLst>
              <a:ext uri="{FF2B5EF4-FFF2-40B4-BE49-F238E27FC236}">
                <a16:creationId xmlns:a16="http://schemas.microsoft.com/office/drawing/2014/main" id="{F6506E39-69A8-4332-B5F8-4BCBDBB7AD68}"/>
              </a:ext>
            </a:extLst>
          </p:cNvPr>
          <p:cNvSpPr/>
          <p:nvPr/>
        </p:nvSpPr>
        <p:spPr>
          <a:xfrm rot="10454383">
            <a:off x="1116094" y="8660467"/>
            <a:ext cx="1229215" cy="1066328"/>
          </a:xfrm>
          <a:custGeom>
            <a:avLst/>
            <a:gdLst>
              <a:gd name="connsiteX0" fmla="*/ 925897 w 2970711"/>
              <a:gd name="connsiteY0" fmla="*/ 743139 h 3086327"/>
              <a:gd name="connsiteX1" fmla="*/ 1173547 w 2970711"/>
              <a:gd name="connsiteY1" fmla="*/ 774889 h 3086327"/>
              <a:gd name="connsiteX2" fmla="*/ 1275147 w 2970711"/>
              <a:gd name="connsiteY2" fmla="*/ 501839 h 3086327"/>
              <a:gd name="connsiteX3" fmla="*/ 1186247 w 2970711"/>
              <a:gd name="connsiteY3" fmla="*/ 285939 h 3086327"/>
              <a:gd name="connsiteX4" fmla="*/ 862397 w 2970711"/>
              <a:gd name="connsiteY4" fmla="*/ 158939 h 3086327"/>
              <a:gd name="connsiteX5" fmla="*/ 786197 w 2970711"/>
              <a:gd name="connsiteY5" fmla="*/ 189 h 3086327"/>
              <a:gd name="connsiteX6" fmla="*/ 849697 w 2970711"/>
              <a:gd name="connsiteY6" fmla="*/ 127189 h 3086327"/>
              <a:gd name="connsiteX7" fmla="*/ 938597 w 2970711"/>
              <a:gd name="connsiteY7" fmla="*/ 152589 h 3086327"/>
              <a:gd name="connsiteX8" fmla="*/ 1110047 w 2970711"/>
              <a:gd name="connsiteY8" fmla="*/ 209739 h 3086327"/>
              <a:gd name="connsiteX9" fmla="*/ 1230697 w 2970711"/>
              <a:gd name="connsiteY9" fmla="*/ 209739 h 3086327"/>
              <a:gd name="connsiteX10" fmla="*/ 1167197 w 2970711"/>
              <a:gd name="connsiteY10" fmla="*/ 63689 h 3086327"/>
              <a:gd name="connsiteX11" fmla="*/ 1173547 w 2970711"/>
              <a:gd name="connsiteY11" fmla="*/ 19239 h 3086327"/>
              <a:gd name="connsiteX12" fmla="*/ 1256097 w 2970711"/>
              <a:gd name="connsiteY12" fmla="*/ 171639 h 3086327"/>
              <a:gd name="connsiteX13" fmla="*/ 1300547 w 2970711"/>
              <a:gd name="connsiteY13" fmla="*/ 241489 h 3086327"/>
              <a:gd name="connsiteX14" fmla="*/ 1294197 w 2970711"/>
              <a:gd name="connsiteY14" fmla="*/ 355789 h 3086327"/>
              <a:gd name="connsiteX15" fmla="*/ 1300547 w 2970711"/>
              <a:gd name="connsiteY15" fmla="*/ 533589 h 3086327"/>
              <a:gd name="connsiteX16" fmla="*/ 1275147 w 2970711"/>
              <a:gd name="connsiteY16" fmla="*/ 698689 h 3086327"/>
              <a:gd name="connsiteX17" fmla="*/ 1433897 w 2970711"/>
              <a:gd name="connsiteY17" fmla="*/ 774889 h 3086327"/>
              <a:gd name="connsiteX18" fmla="*/ 1618047 w 2970711"/>
              <a:gd name="connsiteY18" fmla="*/ 635189 h 3086327"/>
              <a:gd name="connsiteX19" fmla="*/ 1618047 w 2970711"/>
              <a:gd name="connsiteY19" fmla="*/ 419289 h 3086327"/>
              <a:gd name="connsiteX20" fmla="*/ 1548197 w 2970711"/>
              <a:gd name="connsiteY20" fmla="*/ 292289 h 3086327"/>
              <a:gd name="connsiteX21" fmla="*/ 1605347 w 2970711"/>
              <a:gd name="connsiteY21" fmla="*/ 336739 h 3086327"/>
              <a:gd name="connsiteX22" fmla="*/ 1668847 w 2970711"/>
              <a:gd name="connsiteY22" fmla="*/ 501839 h 3086327"/>
              <a:gd name="connsiteX23" fmla="*/ 1656147 w 2970711"/>
              <a:gd name="connsiteY23" fmla="*/ 660589 h 3086327"/>
              <a:gd name="connsiteX24" fmla="*/ 1611697 w 2970711"/>
              <a:gd name="connsiteY24" fmla="*/ 736789 h 3086327"/>
              <a:gd name="connsiteX25" fmla="*/ 1706947 w 2970711"/>
              <a:gd name="connsiteY25" fmla="*/ 571689 h 3086327"/>
              <a:gd name="connsiteX26" fmla="*/ 1802197 w 2970711"/>
              <a:gd name="connsiteY26" fmla="*/ 438339 h 3086327"/>
              <a:gd name="connsiteX27" fmla="*/ 1719647 w 2970711"/>
              <a:gd name="connsiteY27" fmla="*/ 584389 h 3086327"/>
              <a:gd name="connsiteX28" fmla="*/ 1643447 w 2970711"/>
              <a:gd name="connsiteY28" fmla="*/ 730439 h 3086327"/>
              <a:gd name="connsiteX29" fmla="*/ 1522797 w 2970711"/>
              <a:gd name="connsiteY29" fmla="*/ 806639 h 3086327"/>
              <a:gd name="connsiteX30" fmla="*/ 1446597 w 2970711"/>
              <a:gd name="connsiteY30" fmla="*/ 1136839 h 3086327"/>
              <a:gd name="connsiteX31" fmla="*/ 1637097 w 2970711"/>
              <a:gd name="connsiteY31" fmla="*/ 1301939 h 3086327"/>
              <a:gd name="connsiteX32" fmla="*/ 1846647 w 2970711"/>
              <a:gd name="connsiteY32" fmla="*/ 1301939 h 3086327"/>
              <a:gd name="connsiteX33" fmla="*/ 2119697 w 2970711"/>
              <a:gd name="connsiteY33" fmla="*/ 1308289 h 3086327"/>
              <a:gd name="connsiteX34" fmla="*/ 2164147 w 2970711"/>
              <a:gd name="connsiteY34" fmla="*/ 1124139 h 3086327"/>
              <a:gd name="connsiteX35" fmla="*/ 2081597 w 2970711"/>
              <a:gd name="connsiteY35" fmla="*/ 939989 h 3086327"/>
              <a:gd name="connsiteX36" fmla="*/ 2183197 w 2970711"/>
              <a:gd name="connsiteY36" fmla="*/ 1098739 h 3086327"/>
              <a:gd name="connsiteX37" fmla="*/ 2208597 w 2970711"/>
              <a:gd name="connsiteY37" fmla="*/ 1232089 h 3086327"/>
              <a:gd name="connsiteX38" fmla="*/ 2284797 w 2970711"/>
              <a:gd name="connsiteY38" fmla="*/ 800289 h 3086327"/>
              <a:gd name="connsiteX39" fmla="*/ 2373697 w 2970711"/>
              <a:gd name="connsiteY39" fmla="*/ 711389 h 3086327"/>
              <a:gd name="connsiteX40" fmla="*/ 2303847 w 2970711"/>
              <a:gd name="connsiteY40" fmla="*/ 793939 h 3086327"/>
              <a:gd name="connsiteX41" fmla="*/ 2284797 w 2970711"/>
              <a:gd name="connsiteY41" fmla="*/ 959039 h 3086327"/>
              <a:gd name="connsiteX42" fmla="*/ 2272097 w 2970711"/>
              <a:gd name="connsiteY42" fmla="*/ 1155889 h 3086327"/>
              <a:gd name="connsiteX43" fmla="*/ 2278447 w 2970711"/>
              <a:gd name="connsiteY43" fmla="*/ 1270189 h 3086327"/>
              <a:gd name="connsiteX44" fmla="*/ 2284797 w 2970711"/>
              <a:gd name="connsiteY44" fmla="*/ 1301939 h 3086327"/>
              <a:gd name="connsiteX45" fmla="*/ 2373697 w 2970711"/>
              <a:gd name="connsiteY45" fmla="*/ 1346389 h 3086327"/>
              <a:gd name="connsiteX46" fmla="*/ 2500697 w 2970711"/>
              <a:gd name="connsiteY46" fmla="*/ 1320989 h 3086327"/>
              <a:gd name="connsiteX47" fmla="*/ 2741997 w 2970711"/>
              <a:gd name="connsiteY47" fmla="*/ 1308289 h 3086327"/>
              <a:gd name="connsiteX48" fmla="*/ 2907097 w 2970711"/>
              <a:gd name="connsiteY48" fmla="*/ 1371789 h 3086327"/>
              <a:gd name="connsiteX49" fmla="*/ 2970597 w 2970711"/>
              <a:gd name="connsiteY49" fmla="*/ 1498789 h 3086327"/>
              <a:gd name="connsiteX50" fmla="*/ 2894397 w 2970711"/>
              <a:gd name="connsiteY50" fmla="*/ 1409889 h 3086327"/>
              <a:gd name="connsiteX51" fmla="*/ 2691197 w 2970711"/>
              <a:gd name="connsiteY51" fmla="*/ 1340039 h 3086327"/>
              <a:gd name="connsiteX52" fmla="*/ 2513397 w 2970711"/>
              <a:gd name="connsiteY52" fmla="*/ 1378139 h 3086327"/>
              <a:gd name="connsiteX53" fmla="*/ 2545147 w 2970711"/>
              <a:gd name="connsiteY53" fmla="*/ 1498789 h 3086327"/>
              <a:gd name="connsiteX54" fmla="*/ 2583247 w 2970711"/>
              <a:gd name="connsiteY54" fmla="*/ 1536889 h 3086327"/>
              <a:gd name="connsiteX55" fmla="*/ 2710247 w 2970711"/>
              <a:gd name="connsiteY55" fmla="*/ 1644839 h 3086327"/>
              <a:gd name="connsiteX56" fmla="*/ 2608647 w 2970711"/>
              <a:gd name="connsiteY56" fmla="*/ 1587689 h 3086327"/>
              <a:gd name="connsiteX57" fmla="*/ 2481647 w 2970711"/>
              <a:gd name="connsiteY57" fmla="*/ 1479739 h 3086327"/>
              <a:gd name="connsiteX58" fmla="*/ 2411797 w 2970711"/>
              <a:gd name="connsiteY58" fmla="*/ 1378139 h 3086327"/>
              <a:gd name="connsiteX59" fmla="*/ 2284797 w 2970711"/>
              <a:gd name="connsiteY59" fmla="*/ 1359089 h 3086327"/>
              <a:gd name="connsiteX60" fmla="*/ 2145097 w 2970711"/>
              <a:gd name="connsiteY60" fmla="*/ 1340039 h 3086327"/>
              <a:gd name="connsiteX61" fmla="*/ 1872047 w 2970711"/>
              <a:gd name="connsiteY61" fmla="*/ 1340039 h 3086327"/>
              <a:gd name="connsiteX62" fmla="*/ 1573597 w 2970711"/>
              <a:gd name="connsiteY62" fmla="*/ 1352739 h 3086327"/>
              <a:gd name="connsiteX63" fmla="*/ 1376747 w 2970711"/>
              <a:gd name="connsiteY63" fmla="*/ 1251139 h 3086327"/>
              <a:gd name="connsiteX64" fmla="*/ 1198947 w 2970711"/>
              <a:gd name="connsiteY64" fmla="*/ 1206689 h 3086327"/>
              <a:gd name="connsiteX65" fmla="*/ 970347 w 2970711"/>
              <a:gd name="connsiteY65" fmla="*/ 1282889 h 3086327"/>
              <a:gd name="connsiteX66" fmla="*/ 944947 w 2970711"/>
              <a:gd name="connsiteY66" fmla="*/ 1447989 h 3086327"/>
              <a:gd name="connsiteX67" fmla="*/ 913197 w 2970711"/>
              <a:gd name="connsiteY67" fmla="*/ 1568639 h 3086327"/>
              <a:gd name="connsiteX68" fmla="*/ 900497 w 2970711"/>
              <a:gd name="connsiteY68" fmla="*/ 1714689 h 3086327"/>
              <a:gd name="connsiteX69" fmla="*/ 1002097 w 2970711"/>
              <a:gd name="connsiteY69" fmla="*/ 1879789 h 3086327"/>
              <a:gd name="connsiteX70" fmla="*/ 944947 w 2970711"/>
              <a:gd name="connsiteY70" fmla="*/ 1835339 h 3086327"/>
              <a:gd name="connsiteX71" fmla="*/ 881447 w 2970711"/>
              <a:gd name="connsiteY71" fmla="*/ 1746439 h 3086327"/>
              <a:gd name="connsiteX72" fmla="*/ 951297 w 2970711"/>
              <a:gd name="connsiteY72" fmla="*/ 2051239 h 3086327"/>
              <a:gd name="connsiteX73" fmla="*/ 951297 w 2970711"/>
              <a:gd name="connsiteY73" fmla="*/ 2121089 h 3086327"/>
              <a:gd name="connsiteX74" fmla="*/ 913197 w 2970711"/>
              <a:gd name="connsiteY74" fmla="*/ 1987739 h 3086327"/>
              <a:gd name="connsiteX75" fmla="*/ 868747 w 2970711"/>
              <a:gd name="connsiteY75" fmla="*/ 1803589 h 3086327"/>
              <a:gd name="connsiteX76" fmla="*/ 862397 w 2970711"/>
              <a:gd name="connsiteY76" fmla="*/ 1746439 h 3086327"/>
              <a:gd name="connsiteX77" fmla="*/ 875097 w 2970711"/>
              <a:gd name="connsiteY77" fmla="*/ 2025839 h 3086327"/>
              <a:gd name="connsiteX78" fmla="*/ 995747 w 2970711"/>
              <a:gd name="connsiteY78" fmla="*/ 2387789 h 3086327"/>
              <a:gd name="connsiteX79" fmla="*/ 1110047 w 2970711"/>
              <a:gd name="connsiteY79" fmla="*/ 2476689 h 3086327"/>
              <a:gd name="connsiteX80" fmla="*/ 1287847 w 2970711"/>
              <a:gd name="connsiteY80" fmla="*/ 2381439 h 3086327"/>
              <a:gd name="connsiteX81" fmla="*/ 1319597 w 2970711"/>
              <a:gd name="connsiteY81" fmla="*/ 2229039 h 3086327"/>
              <a:gd name="connsiteX82" fmla="*/ 1383097 w 2970711"/>
              <a:gd name="connsiteY82" fmla="*/ 2216339 h 3086327"/>
              <a:gd name="connsiteX83" fmla="*/ 1332297 w 2970711"/>
              <a:gd name="connsiteY83" fmla="*/ 2254439 h 3086327"/>
              <a:gd name="connsiteX84" fmla="*/ 1338647 w 2970711"/>
              <a:gd name="connsiteY84" fmla="*/ 2387789 h 3086327"/>
              <a:gd name="connsiteX85" fmla="*/ 1268797 w 2970711"/>
              <a:gd name="connsiteY85" fmla="*/ 2438589 h 3086327"/>
              <a:gd name="connsiteX86" fmla="*/ 1465647 w 2970711"/>
              <a:gd name="connsiteY86" fmla="*/ 2432239 h 3086327"/>
              <a:gd name="connsiteX87" fmla="*/ 1618047 w 2970711"/>
              <a:gd name="connsiteY87" fmla="*/ 2508439 h 3086327"/>
              <a:gd name="connsiteX88" fmla="*/ 1522797 w 2970711"/>
              <a:gd name="connsiteY88" fmla="*/ 2476689 h 3086327"/>
              <a:gd name="connsiteX89" fmla="*/ 1414847 w 2970711"/>
              <a:gd name="connsiteY89" fmla="*/ 2457639 h 3086327"/>
              <a:gd name="connsiteX90" fmla="*/ 1300547 w 2970711"/>
              <a:gd name="connsiteY90" fmla="*/ 2457639 h 3086327"/>
              <a:gd name="connsiteX91" fmla="*/ 1205297 w 2970711"/>
              <a:gd name="connsiteY91" fmla="*/ 2489389 h 3086327"/>
              <a:gd name="connsiteX92" fmla="*/ 1084647 w 2970711"/>
              <a:gd name="connsiteY92" fmla="*/ 2514789 h 3086327"/>
              <a:gd name="connsiteX93" fmla="*/ 1135447 w 2970711"/>
              <a:gd name="connsiteY93" fmla="*/ 2730689 h 3086327"/>
              <a:gd name="connsiteX94" fmla="*/ 1008447 w 2970711"/>
              <a:gd name="connsiteY94" fmla="*/ 2952939 h 3086327"/>
              <a:gd name="connsiteX95" fmla="*/ 843347 w 2970711"/>
              <a:gd name="connsiteY95" fmla="*/ 3086289 h 3086327"/>
              <a:gd name="connsiteX96" fmla="*/ 957647 w 2970711"/>
              <a:gd name="connsiteY96" fmla="*/ 2965639 h 3086327"/>
              <a:gd name="connsiteX97" fmla="*/ 1040197 w 2970711"/>
              <a:gd name="connsiteY97" fmla="*/ 2870389 h 3086327"/>
              <a:gd name="connsiteX98" fmla="*/ 1065597 w 2970711"/>
              <a:gd name="connsiteY98" fmla="*/ 2749739 h 3086327"/>
              <a:gd name="connsiteX99" fmla="*/ 1027497 w 2970711"/>
              <a:gd name="connsiteY99" fmla="*/ 2590989 h 3086327"/>
              <a:gd name="connsiteX100" fmla="*/ 963997 w 2970711"/>
              <a:gd name="connsiteY100" fmla="*/ 2552889 h 3086327"/>
              <a:gd name="connsiteX101" fmla="*/ 938597 w 2970711"/>
              <a:gd name="connsiteY101" fmla="*/ 2717989 h 3086327"/>
              <a:gd name="connsiteX102" fmla="*/ 836997 w 2970711"/>
              <a:gd name="connsiteY102" fmla="*/ 2781489 h 3086327"/>
              <a:gd name="connsiteX103" fmla="*/ 906847 w 2970711"/>
              <a:gd name="connsiteY103" fmla="*/ 2724339 h 3086327"/>
              <a:gd name="connsiteX104" fmla="*/ 925897 w 2970711"/>
              <a:gd name="connsiteY104" fmla="*/ 2584639 h 3086327"/>
              <a:gd name="connsiteX105" fmla="*/ 932247 w 2970711"/>
              <a:gd name="connsiteY105" fmla="*/ 2495739 h 3086327"/>
              <a:gd name="connsiteX106" fmla="*/ 906847 w 2970711"/>
              <a:gd name="connsiteY106" fmla="*/ 2381439 h 3086327"/>
              <a:gd name="connsiteX107" fmla="*/ 894147 w 2970711"/>
              <a:gd name="connsiteY107" fmla="*/ 2197289 h 3086327"/>
              <a:gd name="connsiteX108" fmla="*/ 767147 w 2970711"/>
              <a:gd name="connsiteY108" fmla="*/ 1809939 h 3086327"/>
              <a:gd name="connsiteX109" fmla="*/ 836997 w 2970711"/>
              <a:gd name="connsiteY109" fmla="*/ 1524189 h 3086327"/>
              <a:gd name="connsiteX110" fmla="*/ 843347 w 2970711"/>
              <a:gd name="connsiteY110" fmla="*/ 1384489 h 3086327"/>
              <a:gd name="connsiteX111" fmla="*/ 811597 w 2970711"/>
              <a:gd name="connsiteY111" fmla="*/ 1105089 h 3086327"/>
              <a:gd name="connsiteX112" fmla="*/ 665547 w 2970711"/>
              <a:gd name="connsiteY112" fmla="*/ 1047939 h 3086327"/>
              <a:gd name="connsiteX113" fmla="*/ 563947 w 2970711"/>
              <a:gd name="connsiteY113" fmla="*/ 1251139 h 3086327"/>
              <a:gd name="connsiteX114" fmla="*/ 449647 w 2970711"/>
              <a:gd name="connsiteY114" fmla="*/ 1320989 h 3086327"/>
              <a:gd name="connsiteX115" fmla="*/ 462347 w 2970711"/>
              <a:gd name="connsiteY115" fmla="*/ 1454339 h 3086327"/>
              <a:gd name="connsiteX116" fmla="*/ 455997 w 2970711"/>
              <a:gd name="connsiteY116" fmla="*/ 1314639 h 3086327"/>
              <a:gd name="connsiteX117" fmla="*/ 525847 w 2970711"/>
              <a:gd name="connsiteY117" fmla="*/ 1206689 h 3086327"/>
              <a:gd name="connsiteX118" fmla="*/ 538547 w 2970711"/>
              <a:gd name="connsiteY118" fmla="*/ 1124139 h 3086327"/>
              <a:gd name="connsiteX119" fmla="*/ 354397 w 2970711"/>
              <a:gd name="connsiteY119" fmla="*/ 1086039 h 3086327"/>
              <a:gd name="connsiteX120" fmla="*/ 233747 w 2970711"/>
              <a:gd name="connsiteY120" fmla="*/ 1054289 h 3086327"/>
              <a:gd name="connsiteX121" fmla="*/ 138497 w 2970711"/>
              <a:gd name="connsiteY121" fmla="*/ 1213039 h 3086327"/>
              <a:gd name="connsiteX122" fmla="*/ 5147 w 2970711"/>
              <a:gd name="connsiteY122" fmla="*/ 1346389 h 3086327"/>
              <a:gd name="connsiteX123" fmla="*/ 36897 w 2970711"/>
              <a:gd name="connsiteY123" fmla="*/ 1276539 h 3086327"/>
              <a:gd name="connsiteX124" fmla="*/ 125797 w 2970711"/>
              <a:gd name="connsiteY124" fmla="*/ 1168589 h 3086327"/>
              <a:gd name="connsiteX125" fmla="*/ 208347 w 2970711"/>
              <a:gd name="connsiteY125" fmla="*/ 1022539 h 3086327"/>
              <a:gd name="connsiteX126" fmla="*/ 367097 w 2970711"/>
              <a:gd name="connsiteY126" fmla="*/ 1009839 h 3086327"/>
              <a:gd name="connsiteX127" fmla="*/ 246447 w 2970711"/>
              <a:gd name="connsiteY127" fmla="*/ 914589 h 3086327"/>
              <a:gd name="connsiteX128" fmla="*/ 113097 w 2970711"/>
              <a:gd name="connsiteY128" fmla="*/ 838389 h 3086327"/>
              <a:gd name="connsiteX129" fmla="*/ 113097 w 2970711"/>
              <a:gd name="connsiteY129" fmla="*/ 685989 h 3086327"/>
              <a:gd name="connsiteX130" fmla="*/ 182947 w 2970711"/>
              <a:gd name="connsiteY130" fmla="*/ 838389 h 3086327"/>
              <a:gd name="connsiteX131" fmla="*/ 284547 w 2970711"/>
              <a:gd name="connsiteY131" fmla="*/ 863789 h 3086327"/>
              <a:gd name="connsiteX132" fmla="*/ 424247 w 2970711"/>
              <a:gd name="connsiteY132" fmla="*/ 971739 h 3086327"/>
              <a:gd name="connsiteX133" fmla="*/ 551247 w 2970711"/>
              <a:gd name="connsiteY133" fmla="*/ 1041589 h 3086327"/>
              <a:gd name="connsiteX134" fmla="*/ 697297 w 2970711"/>
              <a:gd name="connsiteY134" fmla="*/ 997139 h 3086327"/>
              <a:gd name="connsiteX135" fmla="*/ 843347 w 2970711"/>
              <a:gd name="connsiteY135" fmla="*/ 984439 h 3086327"/>
              <a:gd name="connsiteX136" fmla="*/ 856047 w 2970711"/>
              <a:gd name="connsiteY136" fmla="*/ 825689 h 3086327"/>
              <a:gd name="connsiteX137" fmla="*/ 557597 w 2970711"/>
              <a:gd name="connsiteY137" fmla="*/ 438339 h 3086327"/>
              <a:gd name="connsiteX138" fmla="*/ 709997 w 2970711"/>
              <a:gd name="connsiteY138" fmla="*/ 584389 h 3086327"/>
              <a:gd name="connsiteX139" fmla="*/ 843347 w 2970711"/>
              <a:gd name="connsiteY139" fmla="*/ 724089 h 3086327"/>
              <a:gd name="connsiteX140" fmla="*/ 925897 w 2970711"/>
              <a:gd name="connsiteY140" fmla="*/ 743139 h 3086327"/>
              <a:gd name="connsiteX0" fmla="*/ 925897 w 2970711"/>
              <a:gd name="connsiteY0" fmla="*/ 743139 h 3086327"/>
              <a:gd name="connsiteX1" fmla="*/ 1173547 w 2970711"/>
              <a:gd name="connsiteY1" fmla="*/ 774889 h 3086327"/>
              <a:gd name="connsiteX2" fmla="*/ 1275147 w 2970711"/>
              <a:gd name="connsiteY2" fmla="*/ 501839 h 3086327"/>
              <a:gd name="connsiteX3" fmla="*/ 1186247 w 2970711"/>
              <a:gd name="connsiteY3" fmla="*/ 285939 h 3086327"/>
              <a:gd name="connsiteX4" fmla="*/ 862397 w 2970711"/>
              <a:gd name="connsiteY4" fmla="*/ 158939 h 3086327"/>
              <a:gd name="connsiteX5" fmla="*/ 786197 w 2970711"/>
              <a:gd name="connsiteY5" fmla="*/ 189 h 3086327"/>
              <a:gd name="connsiteX6" fmla="*/ 849697 w 2970711"/>
              <a:gd name="connsiteY6" fmla="*/ 127189 h 3086327"/>
              <a:gd name="connsiteX7" fmla="*/ 938597 w 2970711"/>
              <a:gd name="connsiteY7" fmla="*/ 152589 h 3086327"/>
              <a:gd name="connsiteX8" fmla="*/ 1110047 w 2970711"/>
              <a:gd name="connsiteY8" fmla="*/ 209739 h 3086327"/>
              <a:gd name="connsiteX9" fmla="*/ 1230697 w 2970711"/>
              <a:gd name="connsiteY9" fmla="*/ 209739 h 3086327"/>
              <a:gd name="connsiteX10" fmla="*/ 1167197 w 2970711"/>
              <a:gd name="connsiteY10" fmla="*/ 63689 h 3086327"/>
              <a:gd name="connsiteX11" fmla="*/ 1173547 w 2970711"/>
              <a:gd name="connsiteY11" fmla="*/ 19239 h 3086327"/>
              <a:gd name="connsiteX12" fmla="*/ 1256097 w 2970711"/>
              <a:gd name="connsiteY12" fmla="*/ 171639 h 3086327"/>
              <a:gd name="connsiteX13" fmla="*/ 1300547 w 2970711"/>
              <a:gd name="connsiteY13" fmla="*/ 241489 h 3086327"/>
              <a:gd name="connsiteX14" fmla="*/ 1294197 w 2970711"/>
              <a:gd name="connsiteY14" fmla="*/ 355789 h 3086327"/>
              <a:gd name="connsiteX15" fmla="*/ 1300547 w 2970711"/>
              <a:gd name="connsiteY15" fmla="*/ 533589 h 3086327"/>
              <a:gd name="connsiteX16" fmla="*/ 1275147 w 2970711"/>
              <a:gd name="connsiteY16" fmla="*/ 698689 h 3086327"/>
              <a:gd name="connsiteX17" fmla="*/ 1433897 w 2970711"/>
              <a:gd name="connsiteY17" fmla="*/ 774889 h 3086327"/>
              <a:gd name="connsiteX18" fmla="*/ 1618047 w 2970711"/>
              <a:gd name="connsiteY18" fmla="*/ 635189 h 3086327"/>
              <a:gd name="connsiteX19" fmla="*/ 1618047 w 2970711"/>
              <a:gd name="connsiteY19" fmla="*/ 419289 h 3086327"/>
              <a:gd name="connsiteX20" fmla="*/ 1548197 w 2970711"/>
              <a:gd name="connsiteY20" fmla="*/ 292289 h 3086327"/>
              <a:gd name="connsiteX21" fmla="*/ 1605347 w 2970711"/>
              <a:gd name="connsiteY21" fmla="*/ 336739 h 3086327"/>
              <a:gd name="connsiteX22" fmla="*/ 1668847 w 2970711"/>
              <a:gd name="connsiteY22" fmla="*/ 501839 h 3086327"/>
              <a:gd name="connsiteX23" fmla="*/ 1656147 w 2970711"/>
              <a:gd name="connsiteY23" fmla="*/ 660589 h 3086327"/>
              <a:gd name="connsiteX24" fmla="*/ 1611697 w 2970711"/>
              <a:gd name="connsiteY24" fmla="*/ 736789 h 3086327"/>
              <a:gd name="connsiteX25" fmla="*/ 1706947 w 2970711"/>
              <a:gd name="connsiteY25" fmla="*/ 571689 h 3086327"/>
              <a:gd name="connsiteX26" fmla="*/ 1802197 w 2970711"/>
              <a:gd name="connsiteY26" fmla="*/ 438339 h 3086327"/>
              <a:gd name="connsiteX27" fmla="*/ 1719647 w 2970711"/>
              <a:gd name="connsiteY27" fmla="*/ 584389 h 3086327"/>
              <a:gd name="connsiteX28" fmla="*/ 1643447 w 2970711"/>
              <a:gd name="connsiteY28" fmla="*/ 730439 h 3086327"/>
              <a:gd name="connsiteX29" fmla="*/ 1522797 w 2970711"/>
              <a:gd name="connsiteY29" fmla="*/ 806639 h 3086327"/>
              <a:gd name="connsiteX30" fmla="*/ 1446597 w 2970711"/>
              <a:gd name="connsiteY30" fmla="*/ 1136839 h 3086327"/>
              <a:gd name="connsiteX31" fmla="*/ 1637097 w 2970711"/>
              <a:gd name="connsiteY31" fmla="*/ 1301939 h 3086327"/>
              <a:gd name="connsiteX32" fmla="*/ 1846647 w 2970711"/>
              <a:gd name="connsiteY32" fmla="*/ 1301939 h 3086327"/>
              <a:gd name="connsiteX33" fmla="*/ 2119697 w 2970711"/>
              <a:gd name="connsiteY33" fmla="*/ 1308289 h 3086327"/>
              <a:gd name="connsiteX34" fmla="*/ 2164147 w 2970711"/>
              <a:gd name="connsiteY34" fmla="*/ 1124139 h 3086327"/>
              <a:gd name="connsiteX35" fmla="*/ 2081597 w 2970711"/>
              <a:gd name="connsiteY35" fmla="*/ 939989 h 3086327"/>
              <a:gd name="connsiteX36" fmla="*/ 2183197 w 2970711"/>
              <a:gd name="connsiteY36" fmla="*/ 1098739 h 3086327"/>
              <a:gd name="connsiteX37" fmla="*/ 2208597 w 2970711"/>
              <a:gd name="connsiteY37" fmla="*/ 1232089 h 3086327"/>
              <a:gd name="connsiteX38" fmla="*/ 2284797 w 2970711"/>
              <a:gd name="connsiteY38" fmla="*/ 800289 h 3086327"/>
              <a:gd name="connsiteX39" fmla="*/ 2373697 w 2970711"/>
              <a:gd name="connsiteY39" fmla="*/ 711389 h 3086327"/>
              <a:gd name="connsiteX40" fmla="*/ 2303847 w 2970711"/>
              <a:gd name="connsiteY40" fmla="*/ 793939 h 3086327"/>
              <a:gd name="connsiteX41" fmla="*/ 2284797 w 2970711"/>
              <a:gd name="connsiteY41" fmla="*/ 959039 h 3086327"/>
              <a:gd name="connsiteX42" fmla="*/ 2272097 w 2970711"/>
              <a:gd name="connsiteY42" fmla="*/ 1155889 h 3086327"/>
              <a:gd name="connsiteX43" fmla="*/ 2278447 w 2970711"/>
              <a:gd name="connsiteY43" fmla="*/ 1270189 h 3086327"/>
              <a:gd name="connsiteX44" fmla="*/ 2284797 w 2970711"/>
              <a:gd name="connsiteY44" fmla="*/ 1301939 h 3086327"/>
              <a:gd name="connsiteX45" fmla="*/ 2373697 w 2970711"/>
              <a:gd name="connsiteY45" fmla="*/ 1346389 h 3086327"/>
              <a:gd name="connsiteX46" fmla="*/ 2500697 w 2970711"/>
              <a:gd name="connsiteY46" fmla="*/ 1320989 h 3086327"/>
              <a:gd name="connsiteX47" fmla="*/ 2741997 w 2970711"/>
              <a:gd name="connsiteY47" fmla="*/ 1308289 h 3086327"/>
              <a:gd name="connsiteX48" fmla="*/ 2907097 w 2970711"/>
              <a:gd name="connsiteY48" fmla="*/ 1371789 h 3086327"/>
              <a:gd name="connsiteX49" fmla="*/ 2970597 w 2970711"/>
              <a:gd name="connsiteY49" fmla="*/ 1498789 h 3086327"/>
              <a:gd name="connsiteX50" fmla="*/ 2894397 w 2970711"/>
              <a:gd name="connsiteY50" fmla="*/ 1409889 h 3086327"/>
              <a:gd name="connsiteX51" fmla="*/ 2691197 w 2970711"/>
              <a:gd name="connsiteY51" fmla="*/ 1340039 h 3086327"/>
              <a:gd name="connsiteX52" fmla="*/ 2513397 w 2970711"/>
              <a:gd name="connsiteY52" fmla="*/ 1378139 h 3086327"/>
              <a:gd name="connsiteX53" fmla="*/ 2545147 w 2970711"/>
              <a:gd name="connsiteY53" fmla="*/ 1498789 h 3086327"/>
              <a:gd name="connsiteX54" fmla="*/ 2583247 w 2970711"/>
              <a:gd name="connsiteY54" fmla="*/ 1536889 h 3086327"/>
              <a:gd name="connsiteX55" fmla="*/ 2710247 w 2970711"/>
              <a:gd name="connsiteY55" fmla="*/ 1644839 h 3086327"/>
              <a:gd name="connsiteX56" fmla="*/ 2608647 w 2970711"/>
              <a:gd name="connsiteY56" fmla="*/ 1587689 h 3086327"/>
              <a:gd name="connsiteX57" fmla="*/ 2481647 w 2970711"/>
              <a:gd name="connsiteY57" fmla="*/ 1479739 h 3086327"/>
              <a:gd name="connsiteX58" fmla="*/ 2411797 w 2970711"/>
              <a:gd name="connsiteY58" fmla="*/ 1378139 h 3086327"/>
              <a:gd name="connsiteX59" fmla="*/ 2284797 w 2970711"/>
              <a:gd name="connsiteY59" fmla="*/ 1359089 h 3086327"/>
              <a:gd name="connsiteX60" fmla="*/ 2145097 w 2970711"/>
              <a:gd name="connsiteY60" fmla="*/ 1340039 h 3086327"/>
              <a:gd name="connsiteX61" fmla="*/ 1872047 w 2970711"/>
              <a:gd name="connsiteY61" fmla="*/ 1340039 h 3086327"/>
              <a:gd name="connsiteX62" fmla="*/ 1573597 w 2970711"/>
              <a:gd name="connsiteY62" fmla="*/ 1352739 h 3086327"/>
              <a:gd name="connsiteX63" fmla="*/ 1376747 w 2970711"/>
              <a:gd name="connsiteY63" fmla="*/ 1251139 h 3086327"/>
              <a:gd name="connsiteX64" fmla="*/ 1198947 w 2970711"/>
              <a:gd name="connsiteY64" fmla="*/ 1206689 h 3086327"/>
              <a:gd name="connsiteX65" fmla="*/ 970347 w 2970711"/>
              <a:gd name="connsiteY65" fmla="*/ 1282889 h 3086327"/>
              <a:gd name="connsiteX66" fmla="*/ 944947 w 2970711"/>
              <a:gd name="connsiteY66" fmla="*/ 1447989 h 3086327"/>
              <a:gd name="connsiteX67" fmla="*/ 913197 w 2970711"/>
              <a:gd name="connsiteY67" fmla="*/ 1568639 h 3086327"/>
              <a:gd name="connsiteX68" fmla="*/ 900497 w 2970711"/>
              <a:gd name="connsiteY68" fmla="*/ 1714689 h 3086327"/>
              <a:gd name="connsiteX69" fmla="*/ 1002097 w 2970711"/>
              <a:gd name="connsiteY69" fmla="*/ 1879789 h 3086327"/>
              <a:gd name="connsiteX70" fmla="*/ 944947 w 2970711"/>
              <a:gd name="connsiteY70" fmla="*/ 1835339 h 3086327"/>
              <a:gd name="connsiteX71" fmla="*/ 929072 w 2970711"/>
              <a:gd name="connsiteY71" fmla="*/ 1898839 h 3086327"/>
              <a:gd name="connsiteX72" fmla="*/ 951297 w 2970711"/>
              <a:gd name="connsiteY72" fmla="*/ 2051239 h 3086327"/>
              <a:gd name="connsiteX73" fmla="*/ 951297 w 2970711"/>
              <a:gd name="connsiteY73" fmla="*/ 2121089 h 3086327"/>
              <a:gd name="connsiteX74" fmla="*/ 913197 w 2970711"/>
              <a:gd name="connsiteY74" fmla="*/ 1987739 h 3086327"/>
              <a:gd name="connsiteX75" fmla="*/ 868747 w 2970711"/>
              <a:gd name="connsiteY75" fmla="*/ 1803589 h 3086327"/>
              <a:gd name="connsiteX76" fmla="*/ 862397 w 2970711"/>
              <a:gd name="connsiteY76" fmla="*/ 1746439 h 3086327"/>
              <a:gd name="connsiteX77" fmla="*/ 875097 w 2970711"/>
              <a:gd name="connsiteY77" fmla="*/ 2025839 h 3086327"/>
              <a:gd name="connsiteX78" fmla="*/ 995747 w 2970711"/>
              <a:gd name="connsiteY78" fmla="*/ 2387789 h 3086327"/>
              <a:gd name="connsiteX79" fmla="*/ 1110047 w 2970711"/>
              <a:gd name="connsiteY79" fmla="*/ 2476689 h 3086327"/>
              <a:gd name="connsiteX80" fmla="*/ 1287847 w 2970711"/>
              <a:gd name="connsiteY80" fmla="*/ 2381439 h 3086327"/>
              <a:gd name="connsiteX81" fmla="*/ 1319597 w 2970711"/>
              <a:gd name="connsiteY81" fmla="*/ 2229039 h 3086327"/>
              <a:gd name="connsiteX82" fmla="*/ 1383097 w 2970711"/>
              <a:gd name="connsiteY82" fmla="*/ 2216339 h 3086327"/>
              <a:gd name="connsiteX83" fmla="*/ 1332297 w 2970711"/>
              <a:gd name="connsiteY83" fmla="*/ 2254439 h 3086327"/>
              <a:gd name="connsiteX84" fmla="*/ 1338647 w 2970711"/>
              <a:gd name="connsiteY84" fmla="*/ 2387789 h 3086327"/>
              <a:gd name="connsiteX85" fmla="*/ 1268797 w 2970711"/>
              <a:gd name="connsiteY85" fmla="*/ 2438589 h 3086327"/>
              <a:gd name="connsiteX86" fmla="*/ 1465647 w 2970711"/>
              <a:gd name="connsiteY86" fmla="*/ 2432239 h 3086327"/>
              <a:gd name="connsiteX87" fmla="*/ 1618047 w 2970711"/>
              <a:gd name="connsiteY87" fmla="*/ 2508439 h 3086327"/>
              <a:gd name="connsiteX88" fmla="*/ 1522797 w 2970711"/>
              <a:gd name="connsiteY88" fmla="*/ 2476689 h 3086327"/>
              <a:gd name="connsiteX89" fmla="*/ 1414847 w 2970711"/>
              <a:gd name="connsiteY89" fmla="*/ 2457639 h 3086327"/>
              <a:gd name="connsiteX90" fmla="*/ 1300547 w 2970711"/>
              <a:gd name="connsiteY90" fmla="*/ 2457639 h 3086327"/>
              <a:gd name="connsiteX91" fmla="*/ 1205297 w 2970711"/>
              <a:gd name="connsiteY91" fmla="*/ 2489389 h 3086327"/>
              <a:gd name="connsiteX92" fmla="*/ 1084647 w 2970711"/>
              <a:gd name="connsiteY92" fmla="*/ 2514789 h 3086327"/>
              <a:gd name="connsiteX93" fmla="*/ 1135447 w 2970711"/>
              <a:gd name="connsiteY93" fmla="*/ 2730689 h 3086327"/>
              <a:gd name="connsiteX94" fmla="*/ 1008447 w 2970711"/>
              <a:gd name="connsiteY94" fmla="*/ 2952939 h 3086327"/>
              <a:gd name="connsiteX95" fmla="*/ 843347 w 2970711"/>
              <a:gd name="connsiteY95" fmla="*/ 3086289 h 3086327"/>
              <a:gd name="connsiteX96" fmla="*/ 957647 w 2970711"/>
              <a:gd name="connsiteY96" fmla="*/ 2965639 h 3086327"/>
              <a:gd name="connsiteX97" fmla="*/ 1040197 w 2970711"/>
              <a:gd name="connsiteY97" fmla="*/ 2870389 h 3086327"/>
              <a:gd name="connsiteX98" fmla="*/ 1065597 w 2970711"/>
              <a:gd name="connsiteY98" fmla="*/ 2749739 h 3086327"/>
              <a:gd name="connsiteX99" fmla="*/ 1027497 w 2970711"/>
              <a:gd name="connsiteY99" fmla="*/ 2590989 h 3086327"/>
              <a:gd name="connsiteX100" fmla="*/ 963997 w 2970711"/>
              <a:gd name="connsiteY100" fmla="*/ 2552889 h 3086327"/>
              <a:gd name="connsiteX101" fmla="*/ 938597 w 2970711"/>
              <a:gd name="connsiteY101" fmla="*/ 2717989 h 3086327"/>
              <a:gd name="connsiteX102" fmla="*/ 836997 w 2970711"/>
              <a:gd name="connsiteY102" fmla="*/ 2781489 h 3086327"/>
              <a:gd name="connsiteX103" fmla="*/ 906847 w 2970711"/>
              <a:gd name="connsiteY103" fmla="*/ 2724339 h 3086327"/>
              <a:gd name="connsiteX104" fmla="*/ 925897 w 2970711"/>
              <a:gd name="connsiteY104" fmla="*/ 2584639 h 3086327"/>
              <a:gd name="connsiteX105" fmla="*/ 932247 w 2970711"/>
              <a:gd name="connsiteY105" fmla="*/ 2495739 h 3086327"/>
              <a:gd name="connsiteX106" fmla="*/ 906847 w 2970711"/>
              <a:gd name="connsiteY106" fmla="*/ 2381439 h 3086327"/>
              <a:gd name="connsiteX107" fmla="*/ 894147 w 2970711"/>
              <a:gd name="connsiteY107" fmla="*/ 2197289 h 3086327"/>
              <a:gd name="connsiteX108" fmla="*/ 767147 w 2970711"/>
              <a:gd name="connsiteY108" fmla="*/ 1809939 h 3086327"/>
              <a:gd name="connsiteX109" fmla="*/ 836997 w 2970711"/>
              <a:gd name="connsiteY109" fmla="*/ 1524189 h 3086327"/>
              <a:gd name="connsiteX110" fmla="*/ 843347 w 2970711"/>
              <a:gd name="connsiteY110" fmla="*/ 1384489 h 3086327"/>
              <a:gd name="connsiteX111" fmla="*/ 811597 w 2970711"/>
              <a:gd name="connsiteY111" fmla="*/ 1105089 h 3086327"/>
              <a:gd name="connsiteX112" fmla="*/ 665547 w 2970711"/>
              <a:gd name="connsiteY112" fmla="*/ 1047939 h 3086327"/>
              <a:gd name="connsiteX113" fmla="*/ 563947 w 2970711"/>
              <a:gd name="connsiteY113" fmla="*/ 1251139 h 3086327"/>
              <a:gd name="connsiteX114" fmla="*/ 449647 w 2970711"/>
              <a:gd name="connsiteY114" fmla="*/ 1320989 h 3086327"/>
              <a:gd name="connsiteX115" fmla="*/ 462347 w 2970711"/>
              <a:gd name="connsiteY115" fmla="*/ 1454339 h 3086327"/>
              <a:gd name="connsiteX116" fmla="*/ 455997 w 2970711"/>
              <a:gd name="connsiteY116" fmla="*/ 1314639 h 3086327"/>
              <a:gd name="connsiteX117" fmla="*/ 525847 w 2970711"/>
              <a:gd name="connsiteY117" fmla="*/ 1206689 h 3086327"/>
              <a:gd name="connsiteX118" fmla="*/ 538547 w 2970711"/>
              <a:gd name="connsiteY118" fmla="*/ 1124139 h 3086327"/>
              <a:gd name="connsiteX119" fmla="*/ 354397 w 2970711"/>
              <a:gd name="connsiteY119" fmla="*/ 1086039 h 3086327"/>
              <a:gd name="connsiteX120" fmla="*/ 233747 w 2970711"/>
              <a:gd name="connsiteY120" fmla="*/ 1054289 h 3086327"/>
              <a:gd name="connsiteX121" fmla="*/ 138497 w 2970711"/>
              <a:gd name="connsiteY121" fmla="*/ 1213039 h 3086327"/>
              <a:gd name="connsiteX122" fmla="*/ 5147 w 2970711"/>
              <a:gd name="connsiteY122" fmla="*/ 1346389 h 3086327"/>
              <a:gd name="connsiteX123" fmla="*/ 36897 w 2970711"/>
              <a:gd name="connsiteY123" fmla="*/ 1276539 h 3086327"/>
              <a:gd name="connsiteX124" fmla="*/ 125797 w 2970711"/>
              <a:gd name="connsiteY124" fmla="*/ 1168589 h 3086327"/>
              <a:gd name="connsiteX125" fmla="*/ 208347 w 2970711"/>
              <a:gd name="connsiteY125" fmla="*/ 1022539 h 3086327"/>
              <a:gd name="connsiteX126" fmla="*/ 367097 w 2970711"/>
              <a:gd name="connsiteY126" fmla="*/ 1009839 h 3086327"/>
              <a:gd name="connsiteX127" fmla="*/ 246447 w 2970711"/>
              <a:gd name="connsiteY127" fmla="*/ 914589 h 3086327"/>
              <a:gd name="connsiteX128" fmla="*/ 113097 w 2970711"/>
              <a:gd name="connsiteY128" fmla="*/ 838389 h 3086327"/>
              <a:gd name="connsiteX129" fmla="*/ 113097 w 2970711"/>
              <a:gd name="connsiteY129" fmla="*/ 685989 h 3086327"/>
              <a:gd name="connsiteX130" fmla="*/ 182947 w 2970711"/>
              <a:gd name="connsiteY130" fmla="*/ 838389 h 3086327"/>
              <a:gd name="connsiteX131" fmla="*/ 284547 w 2970711"/>
              <a:gd name="connsiteY131" fmla="*/ 863789 h 3086327"/>
              <a:gd name="connsiteX132" fmla="*/ 424247 w 2970711"/>
              <a:gd name="connsiteY132" fmla="*/ 971739 h 3086327"/>
              <a:gd name="connsiteX133" fmla="*/ 551247 w 2970711"/>
              <a:gd name="connsiteY133" fmla="*/ 1041589 h 3086327"/>
              <a:gd name="connsiteX134" fmla="*/ 697297 w 2970711"/>
              <a:gd name="connsiteY134" fmla="*/ 997139 h 3086327"/>
              <a:gd name="connsiteX135" fmla="*/ 843347 w 2970711"/>
              <a:gd name="connsiteY135" fmla="*/ 984439 h 3086327"/>
              <a:gd name="connsiteX136" fmla="*/ 856047 w 2970711"/>
              <a:gd name="connsiteY136" fmla="*/ 825689 h 3086327"/>
              <a:gd name="connsiteX137" fmla="*/ 557597 w 2970711"/>
              <a:gd name="connsiteY137" fmla="*/ 438339 h 3086327"/>
              <a:gd name="connsiteX138" fmla="*/ 709997 w 2970711"/>
              <a:gd name="connsiteY138" fmla="*/ 584389 h 3086327"/>
              <a:gd name="connsiteX139" fmla="*/ 843347 w 2970711"/>
              <a:gd name="connsiteY139" fmla="*/ 724089 h 3086327"/>
              <a:gd name="connsiteX140" fmla="*/ 925897 w 2970711"/>
              <a:gd name="connsiteY140" fmla="*/ 743139 h 3086327"/>
              <a:gd name="connsiteX0" fmla="*/ 923703 w 2968517"/>
              <a:gd name="connsiteY0" fmla="*/ 743139 h 3086327"/>
              <a:gd name="connsiteX1" fmla="*/ 1171353 w 2968517"/>
              <a:gd name="connsiteY1" fmla="*/ 774889 h 3086327"/>
              <a:gd name="connsiteX2" fmla="*/ 1272953 w 2968517"/>
              <a:gd name="connsiteY2" fmla="*/ 501839 h 3086327"/>
              <a:gd name="connsiteX3" fmla="*/ 1184053 w 2968517"/>
              <a:gd name="connsiteY3" fmla="*/ 285939 h 3086327"/>
              <a:gd name="connsiteX4" fmla="*/ 860203 w 2968517"/>
              <a:gd name="connsiteY4" fmla="*/ 158939 h 3086327"/>
              <a:gd name="connsiteX5" fmla="*/ 784003 w 2968517"/>
              <a:gd name="connsiteY5" fmla="*/ 189 h 3086327"/>
              <a:gd name="connsiteX6" fmla="*/ 847503 w 2968517"/>
              <a:gd name="connsiteY6" fmla="*/ 127189 h 3086327"/>
              <a:gd name="connsiteX7" fmla="*/ 936403 w 2968517"/>
              <a:gd name="connsiteY7" fmla="*/ 152589 h 3086327"/>
              <a:gd name="connsiteX8" fmla="*/ 1107853 w 2968517"/>
              <a:gd name="connsiteY8" fmla="*/ 209739 h 3086327"/>
              <a:gd name="connsiteX9" fmla="*/ 1228503 w 2968517"/>
              <a:gd name="connsiteY9" fmla="*/ 209739 h 3086327"/>
              <a:gd name="connsiteX10" fmla="*/ 1165003 w 2968517"/>
              <a:gd name="connsiteY10" fmla="*/ 63689 h 3086327"/>
              <a:gd name="connsiteX11" fmla="*/ 1171353 w 2968517"/>
              <a:gd name="connsiteY11" fmla="*/ 19239 h 3086327"/>
              <a:gd name="connsiteX12" fmla="*/ 1253903 w 2968517"/>
              <a:gd name="connsiteY12" fmla="*/ 171639 h 3086327"/>
              <a:gd name="connsiteX13" fmla="*/ 1298353 w 2968517"/>
              <a:gd name="connsiteY13" fmla="*/ 241489 h 3086327"/>
              <a:gd name="connsiteX14" fmla="*/ 1292003 w 2968517"/>
              <a:gd name="connsiteY14" fmla="*/ 355789 h 3086327"/>
              <a:gd name="connsiteX15" fmla="*/ 1298353 w 2968517"/>
              <a:gd name="connsiteY15" fmla="*/ 533589 h 3086327"/>
              <a:gd name="connsiteX16" fmla="*/ 1272953 w 2968517"/>
              <a:gd name="connsiteY16" fmla="*/ 698689 h 3086327"/>
              <a:gd name="connsiteX17" fmla="*/ 1431703 w 2968517"/>
              <a:gd name="connsiteY17" fmla="*/ 774889 h 3086327"/>
              <a:gd name="connsiteX18" fmla="*/ 1615853 w 2968517"/>
              <a:gd name="connsiteY18" fmla="*/ 635189 h 3086327"/>
              <a:gd name="connsiteX19" fmla="*/ 1615853 w 2968517"/>
              <a:gd name="connsiteY19" fmla="*/ 419289 h 3086327"/>
              <a:gd name="connsiteX20" fmla="*/ 1546003 w 2968517"/>
              <a:gd name="connsiteY20" fmla="*/ 292289 h 3086327"/>
              <a:gd name="connsiteX21" fmla="*/ 1603153 w 2968517"/>
              <a:gd name="connsiteY21" fmla="*/ 336739 h 3086327"/>
              <a:gd name="connsiteX22" fmla="*/ 1666653 w 2968517"/>
              <a:gd name="connsiteY22" fmla="*/ 501839 h 3086327"/>
              <a:gd name="connsiteX23" fmla="*/ 1653953 w 2968517"/>
              <a:gd name="connsiteY23" fmla="*/ 660589 h 3086327"/>
              <a:gd name="connsiteX24" fmla="*/ 1609503 w 2968517"/>
              <a:gd name="connsiteY24" fmla="*/ 736789 h 3086327"/>
              <a:gd name="connsiteX25" fmla="*/ 1704753 w 2968517"/>
              <a:gd name="connsiteY25" fmla="*/ 571689 h 3086327"/>
              <a:gd name="connsiteX26" fmla="*/ 1800003 w 2968517"/>
              <a:gd name="connsiteY26" fmla="*/ 438339 h 3086327"/>
              <a:gd name="connsiteX27" fmla="*/ 1717453 w 2968517"/>
              <a:gd name="connsiteY27" fmla="*/ 584389 h 3086327"/>
              <a:gd name="connsiteX28" fmla="*/ 1641253 w 2968517"/>
              <a:gd name="connsiteY28" fmla="*/ 730439 h 3086327"/>
              <a:gd name="connsiteX29" fmla="*/ 1520603 w 2968517"/>
              <a:gd name="connsiteY29" fmla="*/ 806639 h 3086327"/>
              <a:gd name="connsiteX30" fmla="*/ 1444403 w 2968517"/>
              <a:gd name="connsiteY30" fmla="*/ 1136839 h 3086327"/>
              <a:gd name="connsiteX31" fmla="*/ 1634903 w 2968517"/>
              <a:gd name="connsiteY31" fmla="*/ 1301939 h 3086327"/>
              <a:gd name="connsiteX32" fmla="*/ 1844453 w 2968517"/>
              <a:gd name="connsiteY32" fmla="*/ 1301939 h 3086327"/>
              <a:gd name="connsiteX33" fmla="*/ 2117503 w 2968517"/>
              <a:gd name="connsiteY33" fmla="*/ 1308289 h 3086327"/>
              <a:gd name="connsiteX34" fmla="*/ 2161953 w 2968517"/>
              <a:gd name="connsiteY34" fmla="*/ 1124139 h 3086327"/>
              <a:gd name="connsiteX35" fmla="*/ 2079403 w 2968517"/>
              <a:gd name="connsiteY35" fmla="*/ 939989 h 3086327"/>
              <a:gd name="connsiteX36" fmla="*/ 2181003 w 2968517"/>
              <a:gd name="connsiteY36" fmla="*/ 1098739 h 3086327"/>
              <a:gd name="connsiteX37" fmla="*/ 2206403 w 2968517"/>
              <a:gd name="connsiteY37" fmla="*/ 1232089 h 3086327"/>
              <a:gd name="connsiteX38" fmla="*/ 2282603 w 2968517"/>
              <a:gd name="connsiteY38" fmla="*/ 800289 h 3086327"/>
              <a:gd name="connsiteX39" fmla="*/ 2371503 w 2968517"/>
              <a:gd name="connsiteY39" fmla="*/ 711389 h 3086327"/>
              <a:gd name="connsiteX40" fmla="*/ 2301653 w 2968517"/>
              <a:gd name="connsiteY40" fmla="*/ 793939 h 3086327"/>
              <a:gd name="connsiteX41" fmla="*/ 2282603 w 2968517"/>
              <a:gd name="connsiteY41" fmla="*/ 959039 h 3086327"/>
              <a:gd name="connsiteX42" fmla="*/ 2269903 w 2968517"/>
              <a:gd name="connsiteY42" fmla="*/ 1155889 h 3086327"/>
              <a:gd name="connsiteX43" fmla="*/ 2276253 w 2968517"/>
              <a:gd name="connsiteY43" fmla="*/ 1270189 h 3086327"/>
              <a:gd name="connsiteX44" fmla="*/ 2282603 w 2968517"/>
              <a:gd name="connsiteY44" fmla="*/ 1301939 h 3086327"/>
              <a:gd name="connsiteX45" fmla="*/ 2371503 w 2968517"/>
              <a:gd name="connsiteY45" fmla="*/ 1346389 h 3086327"/>
              <a:gd name="connsiteX46" fmla="*/ 2498503 w 2968517"/>
              <a:gd name="connsiteY46" fmla="*/ 1320989 h 3086327"/>
              <a:gd name="connsiteX47" fmla="*/ 2739803 w 2968517"/>
              <a:gd name="connsiteY47" fmla="*/ 1308289 h 3086327"/>
              <a:gd name="connsiteX48" fmla="*/ 2904903 w 2968517"/>
              <a:gd name="connsiteY48" fmla="*/ 1371789 h 3086327"/>
              <a:gd name="connsiteX49" fmla="*/ 2968403 w 2968517"/>
              <a:gd name="connsiteY49" fmla="*/ 1498789 h 3086327"/>
              <a:gd name="connsiteX50" fmla="*/ 2892203 w 2968517"/>
              <a:gd name="connsiteY50" fmla="*/ 1409889 h 3086327"/>
              <a:gd name="connsiteX51" fmla="*/ 2689003 w 2968517"/>
              <a:gd name="connsiteY51" fmla="*/ 1340039 h 3086327"/>
              <a:gd name="connsiteX52" fmla="*/ 2511203 w 2968517"/>
              <a:gd name="connsiteY52" fmla="*/ 1378139 h 3086327"/>
              <a:gd name="connsiteX53" fmla="*/ 2542953 w 2968517"/>
              <a:gd name="connsiteY53" fmla="*/ 1498789 h 3086327"/>
              <a:gd name="connsiteX54" fmla="*/ 2581053 w 2968517"/>
              <a:gd name="connsiteY54" fmla="*/ 1536889 h 3086327"/>
              <a:gd name="connsiteX55" fmla="*/ 2708053 w 2968517"/>
              <a:gd name="connsiteY55" fmla="*/ 1644839 h 3086327"/>
              <a:gd name="connsiteX56" fmla="*/ 2606453 w 2968517"/>
              <a:gd name="connsiteY56" fmla="*/ 1587689 h 3086327"/>
              <a:gd name="connsiteX57" fmla="*/ 2479453 w 2968517"/>
              <a:gd name="connsiteY57" fmla="*/ 1479739 h 3086327"/>
              <a:gd name="connsiteX58" fmla="*/ 2409603 w 2968517"/>
              <a:gd name="connsiteY58" fmla="*/ 1378139 h 3086327"/>
              <a:gd name="connsiteX59" fmla="*/ 2282603 w 2968517"/>
              <a:gd name="connsiteY59" fmla="*/ 1359089 h 3086327"/>
              <a:gd name="connsiteX60" fmla="*/ 2142903 w 2968517"/>
              <a:gd name="connsiteY60" fmla="*/ 1340039 h 3086327"/>
              <a:gd name="connsiteX61" fmla="*/ 1869853 w 2968517"/>
              <a:gd name="connsiteY61" fmla="*/ 1340039 h 3086327"/>
              <a:gd name="connsiteX62" fmla="*/ 1571403 w 2968517"/>
              <a:gd name="connsiteY62" fmla="*/ 1352739 h 3086327"/>
              <a:gd name="connsiteX63" fmla="*/ 1374553 w 2968517"/>
              <a:gd name="connsiteY63" fmla="*/ 1251139 h 3086327"/>
              <a:gd name="connsiteX64" fmla="*/ 1196753 w 2968517"/>
              <a:gd name="connsiteY64" fmla="*/ 1206689 h 3086327"/>
              <a:gd name="connsiteX65" fmla="*/ 968153 w 2968517"/>
              <a:gd name="connsiteY65" fmla="*/ 1282889 h 3086327"/>
              <a:gd name="connsiteX66" fmla="*/ 942753 w 2968517"/>
              <a:gd name="connsiteY66" fmla="*/ 1447989 h 3086327"/>
              <a:gd name="connsiteX67" fmla="*/ 911003 w 2968517"/>
              <a:gd name="connsiteY67" fmla="*/ 1568639 h 3086327"/>
              <a:gd name="connsiteX68" fmla="*/ 898303 w 2968517"/>
              <a:gd name="connsiteY68" fmla="*/ 1714689 h 3086327"/>
              <a:gd name="connsiteX69" fmla="*/ 999903 w 2968517"/>
              <a:gd name="connsiteY69" fmla="*/ 1879789 h 3086327"/>
              <a:gd name="connsiteX70" fmla="*/ 942753 w 2968517"/>
              <a:gd name="connsiteY70" fmla="*/ 1835339 h 3086327"/>
              <a:gd name="connsiteX71" fmla="*/ 926878 w 2968517"/>
              <a:gd name="connsiteY71" fmla="*/ 1898839 h 3086327"/>
              <a:gd name="connsiteX72" fmla="*/ 949103 w 2968517"/>
              <a:gd name="connsiteY72" fmla="*/ 2051239 h 3086327"/>
              <a:gd name="connsiteX73" fmla="*/ 949103 w 2968517"/>
              <a:gd name="connsiteY73" fmla="*/ 2121089 h 3086327"/>
              <a:gd name="connsiteX74" fmla="*/ 911003 w 2968517"/>
              <a:gd name="connsiteY74" fmla="*/ 1987739 h 3086327"/>
              <a:gd name="connsiteX75" fmla="*/ 866553 w 2968517"/>
              <a:gd name="connsiteY75" fmla="*/ 1803589 h 3086327"/>
              <a:gd name="connsiteX76" fmla="*/ 860203 w 2968517"/>
              <a:gd name="connsiteY76" fmla="*/ 1746439 h 3086327"/>
              <a:gd name="connsiteX77" fmla="*/ 872903 w 2968517"/>
              <a:gd name="connsiteY77" fmla="*/ 2025839 h 3086327"/>
              <a:gd name="connsiteX78" fmla="*/ 993553 w 2968517"/>
              <a:gd name="connsiteY78" fmla="*/ 2387789 h 3086327"/>
              <a:gd name="connsiteX79" fmla="*/ 1107853 w 2968517"/>
              <a:gd name="connsiteY79" fmla="*/ 2476689 h 3086327"/>
              <a:gd name="connsiteX80" fmla="*/ 1285653 w 2968517"/>
              <a:gd name="connsiteY80" fmla="*/ 2381439 h 3086327"/>
              <a:gd name="connsiteX81" fmla="*/ 1317403 w 2968517"/>
              <a:gd name="connsiteY81" fmla="*/ 2229039 h 3086327"/>
              <a:gd name="connsiteX82" fmla="*/ 1380903 w 2968517"/>
              <a:gd name="connsiteY82" fmla="*/ 2216339 h 3086327"/>
              <a:gd name="connsiteX83" fmla="*/ 1330103 w 2968517"/>
              <a:gd name="connsiteY83" fmla="*/ 2254439 h 3086327"/>
              <a:gd name="connsiteX84" fmla="*/ 1336453 w 2968517"/>
              <a:gd name="connsiteY84" fmla="*/ 2387789 h 3086327"/>
              <a:gd name="connsiteX85" fmla="*/ 1266603 w 2968517"/>
              <a:gd name="connsiteY85" fmla="*/ 2438589 h 3086327"/>
              <a:gd name="connsiteX86" fmla="*/ 1463453 w 2968517"/>
              <a:gd name="connsiteY86" fmla="*/ 2432239 h 3086327"/>
              <a:gd name="connsiteX87" fmla="*/ 1615853 w 2968517"/>
              <a:gd name="connsiteY87" fmla="*/ 2508439 h 3086327"/>
              <a:gd name="connsiteX88" fmla="*/ 1520603 w 2968517"/>
              <a:gd name="connsiteY88" fmla="*/ 2476689 h 3086327"/>
              <a:gd name="connsiteX89" fmla="*/ 1412653 w 2968517"/>
              <a:gd name="connsiteY89" fmla="*/ 2457639 h 3086327"/>
              <a:gd name="connsiteX90" fmla="*/ 1298353 w 2968517"/>
              <a:gd name="connsiteY90" fmla="*/ 2457639 h 3086327"/>
              <a:gd name="connsiteX91" fmla="*/ 1203103 w 2968517"/>
              <a:gd name="connsiteY91" fmla="*/ 2489389 h 3086327"/>
              <a:gd name="connsiteX92" fmla="*/ 1082453 w 2968517"/>
              <a:gd name="connsiteY92" fmla="*/ 2514789 h 3086327"/>
              <a:gd name="connsiteX93" fmla="*/ 1133253 w 2968517"/>
              <a:gd name="connsiteY93" fmla="*/ 2730689 h 3086327"/>
              <a:gd name="connsiteX94" fmla="*/ 1006253 w 2968517"/>
              <a:gd name="connsiteY94" fmla="*/ 2952939 h 3086327"/>
              <a:gd name="connsiteX95" fmla="*/ 841153 w 2968517"/>
              <a:gd name="connsiteY95" fmla="*/ 3086289 h 3086327"/>
              <a:gd name="connsiteX96" fmla="*/ 955453 w 2968517"/>
              <a:gd name="connsiteY96" fmla="*/ 2965639 h 3086327"/>
              <a:gd name="connsiteX97" fmla="*/ 1038003 w 2968517"/>
              <a:gd name="connsiteY97" fmla="*/ 2870389 h 3086327"/>
              <a:gd name="connsiteX98" fmla="*/ 1063403 w 2968517"/>
              <a:gd name="connsiteY98" fmla="*/ 2749739 h 3086327"/>
              <a:gd name="connsiteX99" fmla="*/ 1025303 w 2968517"/>
              <a:gd name="connsiteY99" fmla="*/ 2590989 h 3086327"/>
              <a:gd name="connsiteX100" fmla="*/ 961803 w 2968517"/>
              <a:gd name="connsiteY100" fmla="*/ 2552889 h 3086327"/>
              <a:gd name="connsiteX101" fmla="*/ 936403 w 2968517"/>
              <a:gd name="connsiteY101" fmla="*/ 2717989 h 3086327"/>
              <a:gd name="connsiteX102" fmla="*/ 834803 w 2968517"/>
              <a:gd name="connsiteY102" fmla="*/ 2781489 h 3086327"/>
              <a:gd name="connsiteX103" fmla="*/ 904653 w 2968517"/>
              <a:gd name="connsiteY103" fmla="*/ 2724339 h 3086327"/>
              <a:gd name="connsiteX104" fmla="*/ 923703 w 2968517"/>
              <a:gd name="connsiteY104" fmla="*/ 2584639 h 3086327"/>
              <a:gd name="connsiteX105" fmla="*/ 930053 w 2968517"/>
              <a:gd name="connsiteY105" fmla="*/ 2495739 h 3086327"/>
              <a:gd name="connsiteX106" fmla="*/ 904653 w 2968517"/>
              <a:gd name="connsiteY106" fmla="*/ 2381439 h 3086327"/>
              <a:gd name="connsiteX107" fmla="*/ 891953 w 2968517"/>
              <a:gd name="connsiteY107" fmla="*/ 2197289 h 3086327"/>
              <a:gd name="connsiteX108" fmla="*/ 764953 w 2968517"/>
              <a:gd name="connsiteY108" fmla="*/ 1809939 h 3086327"/>
              <a:gd name="connsiteX109" fmla="*/ 834803 w 2968517"/>
              <a:gd name="connsiteY109" fmla="*/ 1524189 h 3086327"/>
              <a:gd name="connsiteX110" fmla="*/ 841153 w 2968517"/>
              <a:gd name="connsiteY110" fmla="*/ 1384489 h 3086327"/>
              <a:gd name="connsiteX111" fmla="*/ 809403 w 2968517"/>
              <a:gd name="connsiteY111" fmla="*/ 1105089 h 3086327"/>
              <a:gd name="connsiteX112" fmla="*/ 663353 w 2968517"/>
              <a:gd name="connsiteY112" fmla="*/ 1047939 h 3086327"/>
              <a:gd name="connsiteX113" fmla="*/ 561753 w 2968517"/>
              <a:gd name="connsiteY113" fmla="*/ 1251139 h 3086327"/>
              <a:gd name="connsiteX114" fmla="*/ 447453 w 2968517"/>
              <a:gd name="connsiteY114" fmla="*/ 1320989 h 3086327"/>
              <a:gd name="connsiteX115" fmla="*/ 460153 w 2968517"/>
              <a:gd name="connsiteY115" fmla="*/ 1454339 h 3086327"/>
              <a:gd name="connsiteX116" fmla="*/ 453803 w 2968517"/>
              <a:gd name="connsiteY116" fmla="*/ 1314639 h 3086327"/>
              <a:gd name="connsiteX117" fmla="*/ 523653 w 2968517"/>
              <a:gd name="connsiteY117" fmla="*/ 1206689 h 3086327"/>
              <a:gd name="connsiteX118" fmla="*/ 536353 w 2968517"/>
              <a:gd name="connsiteY118" fmla="*/ 1124139 h 3086327"/>
              <a:gd name="connsiteX119" fmla="*/ 352203 w 2968517"/>
              <a:gd name="connsiteY119" fmla="*/ 1086039 h 3086327"/>
              <a:gd name="connsiteX120" fmla="*/ 231553 w 2968517"/>
              <a:gd name="connsiteY120" fmla="*/ 1054289 h 3086327"/>
              <a:gd name="connsiteX121" fmla="*/ 136303 w 2968517"/>
              <a:gd name="connsiteY121" fmla="*/ 1213039 h 3086327"/>
              <a:gd name="connsiteX122" fmla="*/ 2953 w 2968517"/>
              <a:gd name="connsiteY122" fmla="*/ 1346389 h 3086327"/>
              <a:gd name="connsiteX123" fmla="*/ 50242 w 2968517"/>
              <a:gd name="connsiteY123" fmla="*/ 1280241 h 3086327"/>
              <a:gd name="connsiteX124" fmla="*/ 123603 w 2968517"/>
              <a:gd name="connsiteY124" fmla="*/ 1168589 h 3086327"/>
              <a:gd name="connsiteX125" fmla="*/ 206153 w 2968517"/>
              <a:gd name="connsiteY125" fmla="*/ 1022539 h 3086327"/>
              <a:gd name="connsiteX126" fmla="*/ 364903 w 2968517"/>
              <a:gd name="connsiteY126" fmla="*/ 1009839 h 3086327"/>
              <a:gd name="connsiteX127" fmla="*/ 244253 w 2968517"/>
              <a:gd name="connsiteY127" fmla="*/ 914589 h 3086327"/>
              <a:gd name="connsiteX128" fmla="*/ 110903 w 2968517"/>
              <a:gd name="connsiteY128" fmla="*/ 838389 h 3086327"/>
              <a:gd name="connsiteX129" fmla="*/ 110903 w 2968517"/>
              <a:gd name="connsiteY129" fmla="*/ 685989 h 3086327"/>
              <a:gd name="connsiteX130" fmla="*/ 180753 w 2968517"/>
              <a:gd name="connsiteY130" fmla="*/ 838389 h 3086327"/>
              <a:gd name="connsiteX131" fmla="*/ 282353 w 2968517"/>
              <a:gd name="connsiteY131" fmla="*/ 863789 h 3086327"/>
              <a:gd name="connsiteX132" fmla="*/ 422053 w 2968517"/>
              <a:gd name="connsiteY132" fmla="*/ 971739 h 3086327"/>
              <a:gd name="connsiteX133" fmla="*/ 549053 w 2968517"/>
              <a:gd name="connsiteY133" fmla="*/ 1041589 h 3086327"/>
              <a:gd name="connsiteX134" fmla="*/ 695103 w 2968517"/>
              <a:gd name="connsiteY134" fmla="*/ 997139 h 3086327"/>
              <a:gd name="connsiteX135" fmla="*/ 841153 w 2968517"/>
              <a:gd name="connsiteY135" fmla="*/ 984439 h 3086327"/>
              <a:gd name="connsiteX136" fmla="*/ 853853 w 2968517"/>
              <a:gd name="connsiteY136" fmla="*/ 825689 h 3086327"/>
              <a:gd name="connsiteX137" fmla="*/ 555403 w 2968517"/>
              <a:gd name="connsiteY137" fmla="*/ 438339 h 3086327"/>
              <a:gd name="connsiteX138" fmla="*/ 707803 w 2968517"/>
              <a:gd name="connsiteY138" fmla="*/ 584389 h 3086327"/>
              <a:gd name="connsiteX139" fmla="*/ 841153 w 2968517"/>
              <a:gd name="connsiteY139" fmla="*/ 724089 h 3086327"/>
              <a:gd name="connsiteX140" fmla="*/ 923703 w 2968517"/>
              <a:gd name="connsiteY140" fmla="*/ 743139 h 3086327"/>
              <a:gd name="connsiteX0" fmla="*/ 923813 w 2968627"/>
              <a:gd name="connsiteY0" fmla="*/ 743139 h 3086327"/>
              <a:gd name="connsiteX1" fmla="*/ 1171463 w 2968627"/>
              <a:gd name="connsiteY1" fmla="*/ 774889 h 3086327"/>
              <a:gd name="connsiteX2" fmla="*/ 1273063 w 2968627"/>
              <a:gd name="connsiteY2" fmla="*/ 501839 h 3086327"/>
              <a:gd name="connsiteX3" fmla="*/ 1184163 w 2968627"/>
              <a:gd name="connsiteY3" fmla="*/ 285939 h 3086327"/>
              <a:gd name="connsiteX4" fmla="*/ 860313 w 2968627"/>
              <a:gd name="connsiteY4" fmla="*/ 158939 h 3086327"/>
              <a:gd name="connsiteX5" fmla="*/ 784113 w 2968627"/>
              <a:gd name="connsiteY5" fmla="*/ 189 h 3086327"/>
              <a:gd name="connsiteX6" fmla="*/ 847613 w 2968627"/>
              <a:gd name="connsiteY6" fmla="*/ 127189 h 3086327"/>
              <a:gd name="connsiteX7" fmla="*/ 936513 w 2968627"/>
              <a:gd name="connsiteY7" fmla="*/ 152589 h 3086327"/>
              <a:gd name="connsiteX8" fmla="*/ 1107963 w 2968627"/>
              <a:gd name="connsiteY8" fmla="*/ 209739 h 3086327"/>
              <a:gd name="connsiteX9" fmla="*/ 1228613 w 2968627"/>
              <a:gd name="connsiteY9" fmla="*/ 209739 h 3086327"/>
              <a:gd name="connsiteX10" fmla="*/ 1165113 w 2968627"/>
              <a:gd name="connsiteY10" fmla="*/ 63689 h 3086327"/>
              <a:gd name="connsiteX11" fmla="*/ 1171463 w 2968627"/>
              <a:gd name="connsiteY11" fmla="*/ 19239 h 3086327"/>
              <a:gd name="connsiteX12" fmla="*/ 1254013 w 2968627"/>
              <a:gd name="connsiteY12" fmla="*/ 171639 h 3086327"/>
              <a:gd name="connsiteX13" fmla="*/ 1298463 w 2968627"/>
              <a:gd name="connsiteY13" fmla="*/ 241489 h 3086327"/>
              <a:gd name="connsiteX14" fmla="*/ 1292113 w 2968627"/>
              <a:gd name="connsiteY14" fmla="*/ 355789 h 3086327"/>
              <a:gd name="connsiteX15" fmla="*/ 1298463 w 2968627"/>
              <a:gd name="connsiteY15" fmla="*/ 533589 h 3086327"/>
              <a:gd name="connsiteX16" fmla="*/ 1273063 w 2968627"/>
              <a:gd name="connsiteY16" fmla="*/ 698689 h 3086327"/>
              <a:gd name="connsiteX17" fmla="*/ 1431813 w 2968627"/>
              <a:gd name="connsiteY17" fmla="*/ 774889 h 3086327"/>
              <a:gd name="connsiteX18" fmla="*/ 1615963 w 2968627"/>
              <a:gd name="connsiteY18" fmla="*/ 635189 h 3086327"/>
              <a:gd name="connsiteX19" fmla="*/ 1615963 w 2968627"/>
              <a:gd name="connsiteY19" fmla="*/ 419289 h 3086327"/>
              <a:gd name="connsiteX20" fmla="*/ 1546113 w 2968627"/>
              <a:gd name="connsiteY20" fmla="*/ 292289 h 3086327"/>
              <a:gd name="connsiteX21" fmla="*/ 1603263 w 2968627"/>
              <a:gd name="connsiteY21" fmla="*/ 336739 h 3086327"/>
              <a:gd name="connsiteX22" fmla="*/ 1666763 w 2968627"/>
              <a:gd name="connsiteY22" fmla="*/ 501839 h 3086327"/>
              <a:gd name="connsiteX23" fmla="*/ 1654063 w 2968627"/>
              <a:gd name="connsiteY23" fmla="*/ 660589 h 3086327"/>
              <a:gd name="connsiteX24" fmla="*/ 1609613 w 2968627"/>
              <a:gd name="connsiteY24" fmla="*/ 736789 h 3086327"/>
              <a:gd name="connsiteX25" fmla="*/ 1704863 w 2968627"/>
              <a:gd name="connsiteY25" fmla="*/ 571689 h 3086327"/>
              <a:gd name="connsiteX26" fmla="*/ 1800113 w 2968627"/>
              <a:gd name="connsiteY26" fmla="*/ 438339 h 3086327"/>
              <a:gd name="connsiteX27" fmla="*/ 1717563 w 2968627"/>
              <a:gd name="connsiteY27" fmla="*/ 584389 h 3086327"/>
              <a:gd name="connsiteX28" fmla="*/ 1641363 w 2968627"/>
              <a:gd name="connsiteY28" fmla="*/ 730439 h 3086327"/>
              <a:gd name="connsiteX29" fmla="*/ 1520713 w 2968627"/>
              <a:gd name="connsiteY29" fmla="*/ 806639 h 3086327"/>
              <a:gd name="connsiteX30" fmla="*/ 1444513 w 2968627"/>
              <a:gd name="connsiteY30" fmla="*/ 1136839 h 3086327"/>
              <a:gd name="connsiteX31" fmla="*/ 1635013 w 2968627"/>
              <a:gd name="connsiteY31" fmla="*/ 1301939 h 3086327"/>
              <a:gd name="connsiteX32" fmla="*/ 1844563 w 2968627"/>
              <a:gd name="connsiteY32" fmla="*/ 1301939 h 3086327"/>
              <a:gd name="connsiteX33" fmla="*/ 2117613 w 2968627"/>
              <a:gd name="connsiteY33" fmla="*/ 1308289 h 3086327"/>
              <a:gd name="connsiteX34" fmla="*/ 2162063 w 2968627"/>
              <a:gd name="connsiteY34" fmla="*/ 1124139 h 3086327"/>
              <a:gd name="connsiteX35" fmla="*/ 2079513 w 2968627"/>
              <a:gd name="connsiteY35" fmla="*/ 939989 h 3086327"/>
              <a:gd name="connsiteX36" fmla="*/ 2181113 w 2968627"/>
              <a:gd name="connsiteY36" fmla="*/ 1098739 h 3086327"/>
              <a:gd name="connsiteX37" fmla="*/ 2206513 w 2968627"/>
              <a:gd name="connsiteY37" fmla="*/ 1232089 h 3086327"/>
              <a:gd name="connsiteX38" fmla="*/ 2282713 w 2968627"/>
              <a:gd name="connsiteY38" fmla="*/ 800289 h 3086327"/>
              <a:gd name="connsiteX39" fmla="*/ 2371613 w 2968627"/>
              <a:gd name="connsiteY39" fmla="*/ 711389 h 3086327"/>
              <a:gd name="connsiteX40" fmla="*/ 2301763 w 2968627"/>
              <a:gd name="connsiteY40" fmla="*/ 793939 h 3086327"/>
              <a:gd name="connsiteX41" fmla="*/ 2282713 w 2968627"/>
              <a:gd name="connsiteY41" fmla="*/ 959039 h 3086327"/>
              <a:gd name="connsiteX42" fmla="*/ 2270013 w 2968627"/>
              <a:gd name="connsiteY42" fmla="*/ 1155889 h 3086327"/>
              <a:gd name="connsiteX43" fmla="*/ 2276363 w 2968627"/>
              <a:gd name="connsiteY43" fmla="*/ 1270189 h 3086327"/>
              <a:gd name="connsiteX44" fmla="*/ 2282713 w 2968627"/>
              <a:gd name="connsiteY44" fmla="*/ 1301939 h 3086327"/>
              <a:gd name="connsiteX45" fmla="*/ 2371613 w 2968627"/>
              <a:gd name="connsiteY45" fmla="*/ 1346389 h 3086327"/>
              <a:gd name="connsiteX46" fmla="*/ 2498613 w 2968627"/>
              <a:gd name="connsiteY46" fmla="*/ 1320989 h 3086327"/>
              <a:gd name="connsiteX47" fmla="*/ 2739913 w 2968627"/>
              <a:gd name="connsiteY47" fmla="*/ 1308289 h 3086327"/>
              <a:gd name="connsiteX48" fmla="*/ 2905013 w 2968627"/>
              <a:gd name="connsiteY48" fmla="*/ 1371789 h 3086327"/>
              <a:gd name="connsiteX49" fmla="*/ 2968513 w 2968627"/>
              <a:gd name="connsiteY49" fmla="*/ 1498789 h 3086327"/>
              <a:gd name="connsiteX50" fmla="*/ 2892313 w 2968627"/>
              <a:gd name="connsiteY50" fmla="*/ 1409889 h 3086327"/>
              <a:gd name="connsiteX51" fmla="*/ 2689113 w 2968627"/>
              <a:gd name="connsiteY51" fmla="*/ 1340039 h 3086327"/>
              <a:gd name="connsiteX52" fmla="*/ 2511313 w 2968627"/>
              <a:gd name="connsiteY52" fmla="*/ 1378139 h 3086327"/>
              <a:gd name="connsiteX53" fmla="*/ 2543063 w 2968627"/>
              <a:gd name="connsiteY53" fmla="*/ 1498789 h 3086327"/>
              <a:gd name="connsiteX54" fmla="*/ 2581163 w 2968627"/>
              <a:gd name="connsiteY54" fmla="*/ 1536889 h 3086327"/>
              <a:gd name="connsiteX55" fmla="*/ 2708163 w 2968627"/>
              <a:gd name="connsiteY55" fmla="*/ 1644839 h 3086327"/>
              <a:gd name="connsiteX56" fmla="*/ 2606563 w 2968627"/>
              <a:gd name="connsiteY56" fmla="*/ 1587689 h 3086327"/>
              <a:gd name="connsiteX57" fmla="*/ 2479563 w 2968627"/>
              <a:gd name="connsiteY57" fmla="*/ 1479739 h 3086327"/>
              <a:gd name="connsiteX58" fmla="*/ 2409713 w 2968627"/>
              <a:gd name="connsiteY58" fmla="*/ 1378139 h 3086327"/>
              <a:gd name="connsiteX59" fmla="*/ 2282713 w 2968627"/>
              <a:gd name="connsiteY59" fmla="*/ 1359089 h 3086327"/>
              <a:gd name="connsiteX60" fmla="*/ 2143013 w 2968627"/>
              <a:gd name="connsiteY60" fmla="*/ 1340039 h 3086327"/>
              <a:gd name="connsiteX61" fmla="*/ 1869963 w 2968627"/>
              <a:gd name="connsiteY61" fmla="*/ 1340039 h 3086327"/>
              <a:gd name="connsiteX62" fmla="*/ 1571513 w 2968627"/>
              <a:gd name="connsiteY62" fmla="*/ 1352739 h 3086327"/>
              <a:gd name="connsiteX63" fmla="*/ 1374663 w 2968627"/>
              <a:gd name="connsiteY63" fmla="*/ 1251139 h 3086327"/>
              <a:gd name="connsiteX64" fmla="*/ 1196863 w 2968627"/>
              <a:gd name="connsiteY64" fmla="*/ 1206689 h 3086327"/>
              <a:gd name="connsiteX65" fmla="*/ 968263 w 2968627"/>
              <a:gd name="connsiteY65" fmla="*/ 1282889 h 3086327"/>
              <a:gd name="connsiteX66" fmla="*/ 942863 w 2968627"/>
              <a:gd name="connsiteY66" fmla="*/ 1447989 h 3086327"/>
              <a:gd name="connsiteX67" fmla="*/ 911113 w 2968627"/>
              <a:gd name="connsiteY67" fmla="*/ 1568639 h 3086327"/>
              <a:gd name="connsiteX68" fmla="*/ 898413 w 2968627"/>
              <a:gd name="connsiteY68" fmla="*/ 1714689 h 3086327"/>
              <a:gd name="connsiteX69" fmla="*/ 1000013 w 2968627"/>
              <a:gd name="connsiteY69" fmla="*/ 1879789 h 3086327"/>
              <a:gd name="connsiteX70" fmla="*/ 942863 w 2968627"/>
              <a:gd name="connsiteY70" fmla="*/ 1835339 h 3086327"/>
              <a:gd name="connsiteX71" fmla="*/ 926988 w 2968627"/>
              <a:gd name="connsiteY71" fmla="*/ 1898839 h 3086327"/>
              <a:gd name="connsiteX72" fmla="*/ 949213 w 2968627"/>
              <a:gd name="connsiteY72" fmla="*/ 2051239 h 3086327"/>
              <a:gd name="connsiteX73" fmla="*/ 949213 w 2968627"/>
              <a:gd name="connsiteY73" fmla="*/ 2121089 h 3086327"/>
              <a:gd name="connsiteX74" fmla="*/ 911113 w 2968627"/>
              <a:gd name="connsiteY74" fmla="*/ 1987739 h 3086327"/>
              <a:gd name="connsiteX75" fmla="*/ 866663 w 2968627"/>
              <a:gd name="connsiteY75" fmla="*/ 1803589 h 3086327"/>
              <a:gd name="connsiteX76" fmla="*/ 860313 w 2968627"/>
              <a:gd name="connsiteY76" fmla="*/ 1746439 h 3086327"/>
              <a:gd name="connsiteX77" fmla="*/ 873013 w 2968627"/>
              <a:gd name="connsiteY77" fmla="*/ 2025839 h 3086327"/>
              <a:gd name="connsiteX78" fmla="*/ 993663 w 2968627"/>
              <a:gd name="connsiteY78" fmla="*/ 2387789 h 3086327"/>
              <a:gd name="connsiteX79" fmla="*/ 1107963 w 2968627"/>
              <a:gd name="connsiteY79" fmla="*/ 2476689 h 3086327"/>
              <a:gd name="connsiteX80" fmla="*/ 1285763 w 2968627"/>
              <a:gd name="connsiteY80" fmla="*/ 2381439 h 3086327"/>
              <a:gd name="connsiteX81" fmla="*/ 1317513 w 2968627"/>
              <a:gd name="connsiteY81" fmla="*/ 2229039 h 3086327"/>
              <a:gd name="connsiteX82" fmla="*/ 1381013 w 2968627"/>
              <a:gd name="connsiteY82" fmla="*/ 2216339 h 3086327"/>
              <a:gd name="connsiteX83" fmla="*/ 1330213 w 2968627"/>
              <a:gd name="connsiteY83" fmla="*/ 2254439 h 3086327"/>
              <a:gd name="connsiteX84" fmla="*/ 1336563 w 2968627"/>
              <a:gd name="connsiteY84" fmla="*/ 2387789 h 3086327"/>
              <a:gd name="connsiteX85" fmla="*/ 1266713 w 2968627"/>
              <a:gd name="connsiteY85" fmla="*/ 2438589 h 3086327"/>
              <a:gd name="connsiteX86" fmla="*/ 1463563 w 2968627"/>
              <a:gd name="connsiteY86" fmla="*/ 2432239 h 3086327"/>
              <a:gd name="connsiteX87" fmla="*/ 1615963 w 2968627"/>
              <a:gd name="connsiteY87" fmla="*/ 2508439 h 3086327"/>
              <a:gd name="connsiteX88" fmla="*/ 1520713 w 2968627"/>
              <a:gd name="connsiteY88" fmla="*/ 2476689 h 3086327"/>
              <a:gd name="connsiteX89" fmla="*/ 1412763 w 2968627"/>
              <a:gd name="connsiteY89" fmla="*/ 2457639 h 3086327"/>
              <a:gd name="connsiteX90" fmla="*/ 1298463 w 2968627"/>
              <a:gd name="connsiteY90" fmla="*/ 2457639 h 3086327"/>
              <a:gd name="connsiteX91" fmla="*/ 1203213 w 2968627"/>
              <a:gd name="connsiteY91" fmla="*/ 2489389 h 3086327"/>
              <a:gd name="connsiteX92" fmla="*/ 1082563 w 2968627"/>
              <a:gd name="connsiteY92" fmla="*/ 2514789 h 3086327"/>
              <a:gd name="connsiteX93" fmla="*/ 1133363 w 2968627"/>
              <a:gd name="connsiteY93" fmla="*/ 2730689 h 3086327"/>
              <a:gd name="connsiteX94" fmla="*/ 1006363 w 2968627"/>
              <a:gd name="connsiteY94" fmla="*/ 2952939 h 3086327"/>
              <a:gd name="connsiteX95" fmla="*/ 841263 w 2968627"/>
              <a:gd name="connsiteY95" fmla="*/ 3086289 h 3086327"/>
              <a:gd name="connsiteX96" fmla="*/ 955563 w 2968627"/>
              <a:gd name="connsiteY96" fmla="*/ 2965639 h 3086327"/>
              <a:gd name="connsiteX97" fmla="*/ 1038113 w 2968627"/>
              <a:gd name="connsiteY97" fmla="*/ 2870389 h 3086327"/>
              <a:gd name="connsiteX98" fmla="*/ 1063513 w 2968627"/>
              <a:gd name="connsiteY98" fmla="*/ 2749739 h 3086327"/>
              <a:gd name="connsiteX99" fmla="*/ 1025413 w 2968627"/>
              <a:gd name="connsiteY99" fmla="*/ 2590989 h 3086327"/>
              <a:gd name="connsiteX100" fmla="*/ 961913 w 2968627"/>
              <a:gd name="connsiteY100" fmla="*/ 2552889 h 3086327"/>
              <a:gd name="connsiteX101" fmla="*/ 936513 w 2968627"/>
              <a:gd name="connsiteY101" fmla="*/ 2717989 h 3086327"/>
              <a:gd name="connsiteX102" fmla="*/ 834913 w 2968627"/>
              <a:gd name="connsiteY102" fmla="*/ 2781489 h 3086327"/>
              <a:gd name="connsiteX103" fmla="*/ 904763 w 2968627"/>
              <a:gd name="connsiteY103" fmla="*/ 2724339 h 3086327"/>
              <a:gd name="connsiteX104" fmla="*/ 923813 w 2968627"/>
              <a:gd name="connsiteY104" fmla="*/ 2584639 h 3086327"/>
              <a:gd name="connsiteX105" fmla="*/ 930163 w 2968627"/>
              <a:gd name="connsiteY105" fmla="*/ 2495739 h 3086327"/>
              <a:gd name="connsiteX106" fmla="*/ 904763 w 2968627"/>
              <a:gd name="connsiteY106" fmla="*/ 2381439 h 3086327"/>
              <a:gd name="connsiteX107" fmla="*/ 892063 w 2968627"/>
              <a:gd name="connsiteY107" fmla="*/ 2197289 h 3086327"/>
              <a:gd name="connsiteX108" fmla="*/ 765063 w 2968627"/>
              <a:gd name="connsiteY108" fmla="*/ 1809939 h 3086327"/>
              <a:gd name="connsiteX109" fmla="*/ 834913 w 2968627"/>
              <a:gd name="connsiteY109" fmla="*/ 1524189 h 3086327"/>
              <a:gd name="connsiteX110" fmla="*/ 841263 w 2968627"/>
              <a:gd name="connsiteY110" fmla="*/ 1384489 h 3086327"/>
              <a:gd name="connsiteX111" fmla="*/ 809513 w 2968627"/>
              <a:gd name="connsiteY111" fmla="*/ 1105089 h 3086327"/>
              <a:gd name="connsiteX112" fmla="*/ 663463 w 2968627"/>
              <a:gd name="connsiteY112" fmla="*/ 1047939 h 3086327"/>
              <a:gd name="connsiteX113" fmla="*/ 561863 w 2968627"/>
              <a:gd name="connsiteY113" fmla="*/ 1251139 h 3086327"/>
              <a:gd name="connsiteX114" fmla="*/ 447563 w 2968627"/>
              <a:gd name="connsiteY114" fmla="*/ 1320989 h 3086327"/>
              <a:gd name="connsiteX115" fmla="*/ 460263 w 2968627"/>
              <a:gd name="connsiteY115" fmla="*/ 1454339 h 3086327"/>
              <a:gd name="connsiteX116" fmla="*/ 453913 w 2968627"/>
              <a:gd name="connsiteY116" fmla="*/ 1314639 h 3086327"/>
              <a:gd name="connsiteX117" fmla="*/ 523763 w 2968627"/>
              <a:gd name="connsiteY117" fmla="*/ 1206689 h 3086327"/>
              <a:gd name="connsiteX118" fmla="*/ 536463 w 2968627"/>
              <a:gd name="connsiteY118" fmla="*/ 1124139 h 3086327"/>
              <a:gd name="connsiteX119" fmla="*/ 352313 w 2968627"/>
              <a:gd name="connsiteY119" fmla="*/ 1086039 h 3086327"/>
              <a:gd name="connsiteX120" fmla="*/ 231663 w 2968627"/>
              <a:gd name="connsiteY120" fmla="*/ 1054289 h 3086327"/>
              <a:gd name="connsiteX121" fmla="*/ 136413 w 2968627"/>
              <a:gd name="connsiteY121" fmla="*/ 1213039 h 3086327"/>
              <a:gd name="connsiteX122" fmla="*/ 3063 w 2968627"/>
              <a:gd name="connsiteY122" fmla="*/ 1346389 h 3086327"/>
              <a:gd name="connsiteX123" fmla="*/ 50352 w 2968627"/>
              <a:gd name="connsiteY123" fmla="*/ 1280241 h 3086327"/>
              <a:gd name="connsiteX124" fmla="*/ 136093 w 2968627"/>
              <a:gd name="connsiteY124" fmla="*/ 1190147 h 3086327"/>
              <a:gd name="connsiteX125" fmla="*/ 206263 w 2968627"/>
              <a:gd name="connsiteY125" fmla="*/ 1022539 h 3086327"/>
              <a:gd name="connsiteX126" fmla="*/ 365013 w 2968627"/>
              <a:gd name="connsiteY126" fmla="*/ 1009839 h 3086327"/>
              <a:gd name="connsiteX127" fmla="*/ 244363 w 2968627"/>
              <a:gd name="connsiteY127" fmla="*/ 914589 h 3086327"/>
              <a:gd name="connsiteX128" fmla="*/ 111013 w 2968627"/>
              <a:gd name="connsiteY128" fmla="*/ 838389 h 3086327"/>
              <a:gd name="connsiteX129" fmla="*/ 111013 w 2968627"/>
              <a:gd name="connsiteY129" fmla="*/ 685989 h 3086327"/>
              <a:gd name="connsiteX130" fmla="*/ 180863 w 2968627"/>
              <a:gd name="connsiteY130" fmla="*/ 838389 h 3086327"/>
              <a:gd name="connsiteX131" fmla="*/ 282463 w 2968627"/>
              <a:gd name="connsiteY131" fmla="*/ 863789 h 3086327"/>
              <a:gd name="connsiteX132" fmla="*/ 422163 w 2968627"/>
              <a:gd name="connsiteY132" fmla="*/ 971739 h 3086327"/>
              <a:gd name="connsiteX133" fmla="*/ 549163 w 2968627"/>
              <a:gd name="connsiteY133" fmla="*/ 1041589 h 3086327"/>
              <a:gd name="connsiteX134" fmla="*/ 695213 w 2968627"/>
              <a:gd name="connsiteY134" fmla="*/ 997139 h 3086327"/>
              <a:gd name="connsiteX135" fmla="*/ 841263 w 2968627"/>
              <a:gd name="connsiteY135" fmla="*/ 984439 h 3086327"/>
              <a:gd name="connsiteX136" fmla="*/ 853963 w 2968627"/>
              <a:gd name="connsiteY136" fmla="*/ 825689 h 3086327"/>
              <a:gd name="connsiteX137" fmla="*/ 555513 w 2968627"/>
              <a:gd name="connsiteY137" fmla="*/ 438339 h 3086327"/>
              <a:gd name="connsiteX138" fmla="*/ 707913 w 2968627"/>
              <a:gd name="connsiteY138" fmla="*/ 584389 h 3086327"/>
              <a:gd name="connsiteX139" fmla="*/ 841263 w 2968627"/>
              <a:gd name="connsiteY139" fmla="*/ 724089 h 3086327"/>
              <a:gd name="connsiteX140" fmla="*/ 923813 w 2968627"/>
              <a:gd name="connsiteY140" fmla="*/ 743139 h 3086327"/>
              <a:gd name="connsiteX0" fmla="*/ 923813 w 2968627"/>
              <a:gd name="connsiteY0" fmla="*/ 743139 h 3086327"/>
              <a:gd name="connsiteX1" fmla="*/ 1171463 w 2968627"/>
              <a:gd name="connsiteY1" fmla="*/ 774889 h 3086327"/>
              <a:gd name="connsiteX2" fmla="*/ 1273063 w 2968627"/>
              <a:gd name="connsiteY2" fmla="*/ 501839 h 3086327"/>
              <a:gd name="connsiteX3" fmla="*/ 1184163 w 2968627"/>
              <a:gd name="connsiteY3" fmla="*/ 285939 h 3086327"/>
              <a:gd name="connsiteX4" fmla="*/ 860313 w 2968627"/>
              <a:gd name="connsiteY4" fmla="*/ 158939 h 3086327"/>
              <a:gd name="connsiteX5" fmla="*/ 784113 w 2968627"/>
              <a:gd name="connsiteY5" fmla="*/ 189 h 3086327"/>
              <a:gd name="connsiteX6" fmla="*/ 847613 w 2968627"/>
              <a:gd name="connsiteY6" fmla="*/ 127189 h 3086327"/>
              <a:gd name="connsiteX7" fmla="*/ 936513 w 2968627"/>
              <a:gd name="connsiteY7" fmla="*/ 152589 h 3086327"/>
              <a:gd name="connsiteX8" fmla="*/ 1107963 w 2968627"/>
              <a:gd name="connsiteY8" fmla="*/ 209739 h 3086327"/>
              <a:gd name="connsiteX9" fmla="*/ 1228613 w 2968627"/>
              <a:gd name="connsiteY9" fmla="*/ 209739 h 3086327"/>
              <a:gd name="connsiteX10" fmla="*/ 1165113 w 2968627"/>
              <a:gd name="connsiteY10" fmla="*/ 63689 h 3086327"/>
              <a:gd name="connsiteX11" fmla="*/ 1171463 w 2968627"/>
              <a:gd name="connsiteY11" fmla="*/ 19239 h 3086327"/>
              <a:gd name="connsiteX12" fmla="*/ 1254013 w 2968627"/>
              <a:gd name="connsiteY12" fmla="*/ 171639 h 3086327"/>
              <a:gd name="connsiteX13" fmla="*/ 1298463 w 2968627"/>
              <a:gd name="connsiteY13" fmla="*/ 241489 h 3086327"/>
              <a:gd name="connsiteX14" fmla="*/ 1292113 w 2968627"/>
              <a:gd name="connsiteY14" fmla="*/ 355789 h 3086327"/>
              <a:gd name="connsiteX15" fmla="*/ 1298463 w 2968627"/>
              <a:gd name="connsiteY15" fmla="*/ 533589 h 3086327"/>
              <a:gd name="connsiteX16" fmla="*/ 1273063 w 2968627"/>
              <a:gd name="connsiteY16" fmla="*/ 698689 h 3086327"/>
              <a:gd name="connsiteX17" fmla="*/ 1431813 w 2968627"/>
              <a:gd name="connsiteY17" fmla="*/ 774889 h 3086327"/>
              <a:gd name="connsiteX18" fmla="*/ 1615963 w 2968627"/>
              <a:gd name="connsiteY18" fmla="*/ 635189 h 3086327"/>
              <a:gd name="connsiteX19" fmla="*/ 1615963 w 2968627"/>
              <a:gd name="connsiteY19" fmla="*/ 419289 h 3086327"/>
              <a:gd name="connsiteX20" fmla="*/ 1546113 w 2968627"/>
              <a:gd name="connsiteY20" fmla="*/ 292289 h 3086327"/>
              <a:gd name="connsiteX21" fmla="*/ 1603263 w 2968627"/>
              <a:gd name="connsiteY21" fmla="*/ 336739 h 3086327"/>
              <a:gd name="connsiteX22" fmla="*/ 1666763 w 2968627"/>
              <a:gd name="connsiteY22" fmla="*/ 501839 h 3086327"/>
              <a:gd name="connsiteX23" fmla="*/ 1654063 w 2968627"/>
              <a:gd name="connsiteY23" fmla="*/ 660589 h 3086327"/>
              <a:gd name="connsiteX24" fmla="*/ 1609613 w 2968627"/>
              <a:gd name="connsiteY24" fmla="*/ 736789 h 3086327"/>
              <a:gd name="connsiteX25" fmla="*/ 1704863 w 2968627"/>
              <a:gd name="connsiteY25" fmla="*/ 571689 h 3086327"/>
              <a:gd name="connsiteX26" fmla="*/ 1800113 w 2968627"/>
              <a:gd name="connsiteY26" fmla="*/ 438339 h 3086327"/>
              <a:gd name="connsiteX27" fmla="*/ 1717563 w 2968627"/>
              <a:gd name="connsiteY27" fmla="*/ 584389 h 3086327"/>
              <a:gd name="connsiteX28" fmla="*/ 1641363 w 2968627"/>
              <a:gd name="connsiteY28" fmla="*/ 730439 h 3086327"/>
              <a:gd name="connsiteX29" fmla="*/ 1520713 w 2968627"/>
              <a:gd name="connsiteY29" fmla="*/ 806639 h 3086327"/>
              <a:gd name="connsiteX30" fmla="*/ 1444513 w 2968627"/>
              <a:gd name="connsiteY30" fmla="*/ 1136839 h 3086327"/>
              <a:gd name="connsiteX31" fmla="*/ 1635013 w 2968627"/>
              <a:gd name="connsiteY31" fmla="*/ 1301939 h 3086327"/>
              <a:gd name="connsiteX32" fmla="*/ 1844563 w 2968627"/>
              <a:gd name="connsiteY32" fmla="*/ 1301939 h 3086327"/>
              <a:gd name="connsiteX33" fmla="*/ 2117613 w 2968627"/>
              <a:gd name="connsiteY33" fmla="*/ 1308289 h 3086327"/>
              <a:gd name="connsiteX34" fmla="*/ 2162063 w 2968627"/>
              <a:gd name="connsiteY34" fmla="*/ 1124139 h 3086327"/>
              <a:gd name="connsiteX35" fmla="*/ 2079513 w 2968627"/>
              <a:gd name="connsiteY35" fmla="*/ 939989 h 3086327"/>
              <a:gd name="connsiteX36" fmla="*/ 2181113 w 2968627"/>
              <a:gd name="connsiteY36" fmla="*/ 1098739 h 3086327"/>
              <a:gd name="connsiteX37" fmla="*/ 2206513 w 2968627"/>
              <a:gd name="connsiteY37" fmla="*/ 1232089 h 3086327"/>
              <a:gd name="connsiteX38" fmla="*/ 2282713 w 2968627"/>
              <a:gd name="connsiteY38" fmla="*/ 800289 h 3086327"/>
              <a:gd name="connsiteX39" fmla="*/ 2371613 w 2968627"/>
              <a:gd name="connsiteY39" fmla="*/ 711389 h 3086327"/>
              <a:gd name="connsiteX40" fmla="*/ 2301763 w 2968627"/>
              <a:gd name="connsiteY40" fmla="*/ 793939 h 3086327"/>
              <a:gd name="connsiteX41" fmla="*/ 2282713 w 2968627"/>
              <a:gd name="connsiteY41" fmla="*/ 959039 h 3086327"/>
              <a:gd name="connsiteX42" fmla="*/ 2270013 w 2968627"/>
              <a:gd name="connsiteY42" fmla="*/ 1155889 h 3086327"/>
              <a:gd name="connsiteX43" fmla="*/ 2276363 w 2968627"/>
              <a:gd name="connsiteY43" fmla="*/ 1270189 h 3086327"/>
              <a:gd name="connsiteX44" fmla="*/ 2282713 w 2968627"/>
              <a:gd name="connsiteY44" fmla="*/ 1301939 h 3086327"/>
              <a:gd name="connsiteX45" fmla="*/ 2371613 w 2968627"/>
              <a:gd name="connsiteY45" fmla="*/ 1346389 h 3086327"/>
              <a:gd name="connsiteX46" fmla="*/ 2498613 w 2968627"/>
              <a:gd name="connsiteY46" fmla="*/ 1320989 h 3086327"/>
              <a:gd name="connsiteX47" fmla="*/ 2739913 w 2968627"/>
              <a:gd name="connsiteY47" fmla="*/ 1308289 h 3086327"/>
              <a:gd name="connsiteX48" fmla="*/ 2905013 w 2968627"/>
              <a:gd name="connsiteY48" fmla="*/ 1371789 h 3086327"/>
              <a:gd name="connsiteX49" fmla="*/ 2968513 w 2968627"/>
              <a:gd name="connsiteY49" fmla="*/ 1498789 h 3086327"/>
              <a:gd name="connsiteX50" fmla="*/ 2892313 w 2968627"/>
              <a:gd name="connsiteY50" fmla="*/ 1409889 h 3086327"/>
              <a:gd name="connsiteX51" fmla="*/ 2689113 w 2968627"/>
              <a:gd name="connsiteY51" fmla="*/ 1340039 h 3086327"/>
              <a:gd name="connsiteX52" fmla="*/ 2511313 w 2968627"/>
              <a:gd name="connsiteY52" fmla="*/ 1378139 h 3086327"/>
              <a:gd name="connsiteX53" fmla="*/ 2543063 w 2968627"/>
              <a:gd name="connsiteY53" fmla="*/ 1498789 h 3086327"/>
              <a:gd name="connsiteX54" fmla="*/ 2581163 w 2968627"/>
              <a:gd name="connsiteY54" fmla="*/ 1536889 h 3086327"/>
              <a:gd name="connsiteX55" fmla="*/ 2708163 w 2968627"/>
              <a:gd name="connsiteY55" fmla="*/ 1644839 h 3086327"/>
              <a:gd name="connsiteX56" fmla="*/ 2606563 w 2968627"/>
              <a:gd name="connsiteY56" fmla="*/ 1587689 h 3086327"/>
              <a:gd name="connsiteX57" fmla="*/ 2479563 w 2968627"/>
              <a:gd name="connsiteY57" fmla="*/ 1479739 h 3086327"/>
              <a:gd name="connsiteX58" fmla="*/ 2409713 w 2968627"/>
              <a:gd name="connsiteY58" fmla="*/ 1378139 h 3086327"/>
              <a:gd name="connsiteX59" fmla="*/ 2282713 w 2968627"/>
              <a:gd name="connsiteY59" fmla="*/ 1359089 h 3086327"/>
              <a:gd name="connsiteX60" fmla="*/ 2143013 w 2968627"/>
              <a:gd name="connsiteY60" fmla="*/ 1340039 h 3086327"/>
              <a:gd name="connsiteX61" fmla="*/ 1869963 w 2968627"/>
              <a:gd name="connsiteY61" fmla="*/ 1340039 h 3086327"/>
              <a:gd name="connsiteX62" fmla="*/ 1571513 w 2968627"/>
              <a:gd name="connsiteY62" fmla="*/ 1352739 h 3086327"/>
              <a:gd name="connsiteX63" fmla="*/ 1374663 w 2968627"/>
              <a:gd name="connsiteY63" fmla="*/ 1251139 h 3086327"/>
              <a:gd name="connsiteX64" fmla="*/ 1196863 w 2968627"/>
              <a:gd name="connsiteY64" fmla="*/ 1206689 h 3086327"/>
              <a:gd name="connsiteX65" fmla="*/ 968263 w 2968627"/>
              <a:gd name="connsiteY65" fmla="*/ 1282889 h 3086327"/>
              <a:gd name="connsiteX66" fmla="*/ 942863 w 2968627"/>
              <a:gd name="connsiteY66" fmla="*/ 1447989 h 3086327"/>
              <a:gd name="connsiteX67" fmla="*/ 911113 w 2968627"/>
              <a:gd name="connsiteY67" fmla="*/ 1568639 h 3086327"/>
              <a:gd name="connsiteX68" fmla="*/ 898413 w 2968627"/>
              <a:gd name="connsiteY68" fmla="*/ 1714689 h 3086327"/>
              <a:gd name="connsiteX69" fmla="*/ 1000013 w 2968627"/>
              <a:gd name="connsiteY69" fmla="*/ 1879789 h 3086327"/>
              <a:gd name="connsiteX70" fmla="*/ 942863 w 2968627"/>
              <a:gd name="connsiteY70" fmla="*/ 1835339 h 3086327"/>
              <a:gd name="connsiteX71" fmla="*/ 926988 w 2968627"/>
              <a:gd name="connsiteY71" fmla="*/ 1898839 h 3086327"/>
              <a:gd name="connsiteX72" fmla="*/ 949213 w 2968627"/>
              <a:gd name="connsiteY72" fmla="*/ 2051239 h 3086327"/>
              <a:gd name="connsiteX73" fmla="*/ 949213 w 2968627"/>
              <a:gd name="connsiteY73" fmla="*/ 2121089 h 3086327"/>
              <a:gd name="connsiteX74" fmla="*/ 911113 w 2968627"/>
              <a:gd name="connsiteY74" fmla="*/ 1987739 h 3086327"/>
              <a:gd name="connsiteX75" fmla="*/ 866663 w 2968627"/>
              <a:gd name="connsiteY75" fmla="*/ 1803589 h 3086327"/>
              <a:gd name="connsiteX76" fmla="*/ 860313 w 2968627"/>
              <a:gd name="connsiteY76" fmla="*/ 1746439 h 3086327"/>
              <a:gd name="connsiteX77" fmla="*/ 873013 w 2968627"/>
              <a:gd name="connsiteY77" fmla="*/ 2025839 h 3086327"/>
              <a:gd name="connsiteX78" fmla="*/ 993663 w 2968627"/>
              <a:gd name="connsiteY78" fmla="*/ 2387789 h 3086327"/>
              <a:gd name="connsiteX79" fmla="*/ 1107963 w 2968627"/>
              <a:gd name="connsiteY79" fmla="*/ 2476689 h 3086327"/>
              <a:gd name="connsiteX80" fmla="*/ 1285763 w 2968627"/>
              <a:gd name="connsiteY80" fmla="*/ 2381439 h 3086327"/>
              <a:gd name="connsiteX81" fmla="*/ 1317513 w 2968627"/>
              <a:gd name="connsiteY81" fmla="*/ 2229039 h 3086327"/>
              <a:gd name="connsiteX82" fmla="*/ 1381013 w 2968627"/>
              <a:gd name="connsiteY82" fmla="*/ 2216339 h 3086327"/>
              <a:gd name="connsiteX83" fmla="*/ 1330213 w 2968627"/>
              <a:gd name="connsiteY83" fmla="*/ 2254439 h 3086327"/>
              <a:gd name="connsiteX84" fmla="*/ 1336563 w 2968627"/>
              <a:gd name="connsiteY84" fmla="*/ 2387789 h 3086327"/>
              <a:gd name="connsiteX85" fmla="*/ 1266713 w 2968627"/>
              <a:gd name="connsiteY85" fmla="*/ 2438589 h 3086327"/>
              <a:gd name="connsiteX86" fmla="*/ 1463563 w 2968627"/>
              <a:gd name="connsiteY86" fmla="*/ 2432239 h 3086327"/>
              <a:gd name="connsiteX87" fmla="*/ 1615963 w 2968627"/>
              <a:gd name="connsiteY87" fmla="*/ 2508439 h 3086327"/>
              <a:gd name="connsiteX88" fmla="*/ 1520713 w 2968627"/>
              <a:gd name="connsiteY88" fmla="*/ 2476689 h 3086327"/>
              <a:gd name="connsiteX89" fmla="*/ 1412763 w 2968627"/>
              <a:gd name="connsiteY89" fmla="*/ 2457639 h 3086327"/>
              <a:gd name="connsiteX90" fmla="*/ 1298463 w 2968627"/>
              <a:gd name="connsiteY90" fmla="*/ 2457639 h 3086327"/>
              <a:gd name="connsiteX91" fmla="*/ 1203213 w 2968627"/>
              <a:gd name="connsiteY91" fmla="*/ 2489389 h 3086327"/>
              <a:gd name="connsiteX92" fmla="*/ 1082563 w 2968627"/>
              <a:gd name="connsiteY92" fmla="*/ 2514789 h 3086327"/>
              <a:gd name="connsiteX93" fmla="*/ 1133363 w 2968627"/>
              <a:gd name="connsiteY93" fmla="*/ 2730689 h 3086327"/>
              <a:gd name="connsiteX94" fmla="*/ 1006363 w 2968627"/>
              <a:gd name="connsiteY94" fmla="*/ 2952939 h 3086327"/>
              <a:gd name="connsiteX95" fmla="*/ 841263 w 2968627"/>
              <a:gd name="connsiteY95" fmla="*/ 3086289 h 3086327"/>
              <a:gd name="connsiteX96" fmla="*/ 955563 w 2968627"/>
              <a:gd name="connsiteY96" fmla="*/ 2965639 h 3086327"/>
              <a:gd name="connsiteX97" fmla="*/ 1038113 w 2968627"/>
              <a:gd name="connsiteY97" fmla="*/ 2870389 h 3086327"/>
              <a:gd name="connsiteX98" fmla="*/ 1063513 w 2968627"/>
              <a:gd name="connsiteY98" fmla="*/ 2749739 h 3086327"/>
              <a:gd name="connsiteX99" fmla="*/ 1025413 w 2968627"/>
              <a:gd name="connsiteY99" fmla="*/ 2590989 h 3086327"/>
              <a:gd name="connsiteX100" fmla="*/ 961913 w 2968627"/>
              <a:gd name="connsiteY100" fmla="*/ 2552889 h 3086327"/>
              <a:gd name="connsiteX101" fmla="*/ 936513 w 2968627"/>
              <a:gd name="connsiteY101" fmla="*/ 2717989 h 3086327"/>
              <a:gd name="connsiteX102" fmla="*/ 834913 w 2968627"/>
              <a:gd name="connsiteY102" fmla="*/ 2781489 h 3086327"/>
              <a:gd name="connsiteX103" fmla="*/ 904763 w 2968627"/>
              <a:gd name="connsiteY103" fmla="*/ 2724339 h 3086327"/>
              <a:gd name="connsiteX104" fmla="*/ 923813 w 2968627"/>
              <a:gd name="connsiteY104" fmla="*/ 2584639 h 3086327"/>
              <a:gd name="connsiteX105" fmla="*/ 930163 w 2968627"/>
              <a:gd name="connsiteY105" fmla="*/ 2495739 h 3086327"/>
              <a:gd name="connsiteX106" fmla="*/ 904763 w 2968627"/>
              <a:gd name="connsiteY106" fmla="*/ 2381439 h 3086327"/>
              <a:gd name="connsiteX107" fmla="*/ 892063 w 2968627"/>
              <a:gd name="connsiteY107" fmla="*/ 2197289 h 3086327"/>
              <a:gd name="connsiteX108" fmla="*/ 765063 w 2968627"/>
              <a:gd name="connsiteY108" fmla="*/ 1809939 h 3086327"/>
              <a:gd name="connsiteX109" fmla="*/ 834913 w 2968627"/>
              <a:gd name="connsiteY109" fmla="*/ 1524189 h 3086327"/>
              <a:gd name="connsiteX110" fmla="*/ 841263 w 2968627"/>
              <a:gd name="connsiteY110" fmla="*/ 1384489 h 3086327"/>
              <a:gd name="connsiteX111" fmla="*/ 809513 w 2968627"/>
              <a:gd name="connsiteY111" fmla="*/ 1105089 h 3086327"/>
              <a:gd name="connsiteX112" fmla="*/ 663463 w 2968627"/>
              <a:gd name="connsiteY112" fmla="*/ 1047939 h 3086327"/>
              <a:gd name="connsiteX113" fmla="*/ 561863 w 2968627"/>
              <a:gd name="connsiteY113" fmla="*/ 1251139 h 3086327"/>
              <a:gd name="connsiteX114" fmla="*/ 447563 w 2968627"/>
              <a:gd name="connsiteY114" fmla="*/ 1320989 h 3086327"/>
              <a:gd name="connsiteX115" fmla="*/ 460263 w 2968627"/>
              <a:gd name="connsiteY115" fmla="*/ 1454339 h 3086327"/>
              <a:gd name="connsiteX116" fmla="*/ 453913 w 2968627"/>
              <a:gd name="connsiteY116" fmla="*/ 1314639 h 3086327"/>
              <a:gd name="connsiteX117" fmla="*/ 523763 w 2968627"/>
              <a:gd name="connsiteY117" fmla="*/ 1206689 h 3086327"/>
              <a:gd name="connsiteX118" fmla="*/ 536463 w 2968627"/>
              <a:gd name="connsiteY118" fmla="*/ 1124139 h 3086327"/>
              <a:gd name="connsiteX119" fmla="*/ 352313 w 2968627"/>
              <a:gd name="connsiteY119" fmla="*/ 1086039 h 3086327"/>
              <a:gd name="connsiteX120" fmla="*/ 231663 w 2968627"/>
              <a:gd name="connsiteY120" fmla="*/ 1054289 h 3086327"/>
              <a:gd name="connsiteX121" fmla="*/ 136413 w 2968627"/>
              <a:gd name="connsiteY121" fmla="*/ 1213039 h 3086327"/>
              <a:gd name="connsiteX122" fmla="*/ 3063 w 2968627"/>
              <a:gd name="connsiteY122" fmla="*/ 1346389 h 3086327"/>
              <a:gd name="connsiteX123" fmla="*/ 50352 w 2968627"/>
              <a:gd name="connsiteY123" fmla="*/ 1280241 h 3086327"/>
              <a:gd name="connsiteX124" fmla="*/ 136093 w 2968627"/>
              <a:gd name="connsiteY124" fmla="*/ 1190147 h 3086327"/>
              <a:gd name="connsiteX125" fmla="*/ 206263 w 2968627"/>
              <a:gd name="connsiteY125" fmla="*/ 1022539 h 3086327"/>
              <a:gd name="connsiteX126" fmla="*/ 365013 w 2968627"/>
              <a:gd name="connsiteY126" fmla="*/ 1009839 h 3086327"/>
              <a:gd name="connsiteX127" fmla="*/ 244363 w 2968627"/>
              <a:gd name="connsiteY127" fmla="*/ 914589 h 3086327"/>
              <a:gd name="connsiteX128" fmla="*/ 125074 w 2968627"/>
              <a:gd name="connsiteY128" fmla="*/ 825317 h 3086327"/>
              <a:gd name="connsiteX129" fmla="*/ 111013 w 2968627"/>
              <a:gd name="connsiteY129" fmla="*/ 685989 h 3086327"/>
              <a:gd name="connsiteX130" fmla="*/ 180863 w 2968627"/>
              <a:gd name="connsiteY130" fmla="*/ 838389 h 3086327"/>
              <a:gd name="connsiteX131" fmla="*/ 282463 w 2968627"/>
              <a:gd name="connsiteY131" fmla="*/ 863789 h 3086327"/>
              <a:gd name="connsiteX132" fmla="*/ 422163 w 2968627"/>
              <a:gd name="connsiteY132" fmla="*/ 971739 h 3086327"/>
              <a:gd name="connsiteX133" fmla="*/ 549163 w 2968627"/>
              <a:gd name="connsiteY133" fmla="*/ 1041589 h 3086327"/>
              <a:gd name="connsiteX134" fmla="*/ 695213 w 2968627"/>
              <a:gd name="connsiteY134" fmla="*/ 997139 h 3086327"/>
              <a:gd name="connsiteX135" fmla="*/ 841263 w 2968627"/>
              <a:gd name="connsiteY135" fmla="*/ 984439 h 3086327"/>
              <a:gd name="connsiteX136" fmla="*/ 853963 w 2968627"/>
              <a:gd name="connsiteY136" fmla="*/ 825689 h 3086327"/>
              <a:gd name="connsiteX137" fmla="*/ 555513 w 2968627"/>
              <a:gd name="connsiteY137" fmla="*/ 438339 h 3086327"/>
              <a:gd name="connsiteX138" fmla="*/ 707913 w 2968627"/>
              <a:gd name="connsiteY138" fmla="*/ 584389 h 3086327"/>
              <a:gd name="connsiteX139" fmla="*/ 841263 w 2968627"/>
              <a:gd name="connsiteY139" fmla="*/ 724089 h 3086327"/>
              <a:gd name="connsiteX140" fmla="*/ 923813 w 2968627"/>
              <a:gd name="connsiteY140" fmla="*/ 743139 h 3086327"/>
              <a:gd name="connsiteX0" fmla="*/ 923813 w 2968627"/>
              <a:gd name="connsiteY0" fmla="*/ 743139 h 3086327"/>
              <a:gd name="connsiteX1" fmla="*/ 1171463 w 2968627"/>
              <a:gd name="connsiteY1" fmla="*/ 774889 h 3086327"/>
              <a:gd name="connsiteX2" fmla="*/ 1273063 w 2968627"/>
              <a:gd name="connsiteY2" fmla="*/ 501839 h 3086327"/>
              <a:gd name="connsiteX3" fmla="*/ 1184163 w 2968627"/>
              <a:gd name="connsiteY3" fmla="*/ 285939 h 3086327"/>
              <a:gd name="connsiteX4" fmla="*/ 860313 w 2968627"/>
              <a:gd name="connsiteY4" fmla="*/ 158939 h 3086327"/>
              <a:gd name="connsiteX5" fmla="*/ 784113 w 2968627"/>
              <a:gd name="connsiteY5" fmla="*/ 189 h 3086327"/>
              <a:gd name="connsiteX6" fmla="*/ 847613 w 2968627"/>
              <a:gd name="connsiteY6" fmla="*/ 127189 h 3086327"/>
              <a:gd name="connsiteX7" fmla="*/ 936513 w 2968627"/>
              <a:gd name="connsiteY7" fmla="*/ 152589 h 3086327"/>
              <a:gd name="connsiteX8" fmla="*/ 1107963 w 2968627"/>
              <a:gd name="connsiteY8" fmla="*/ 209739 h 3086327"/>
              <a:gd name="connsiteX9" fmla="*/ 1228613 w 2968627"/>
              <a:gd name="connsiteY9" fmla="*/ 209739 h 3086327"/>
              <a:gd name="connsiteX10" fmla="*/ 1165113 w 2968627"/>
              <a:gd name="connsiteY10" fmla="*/ 63689 h 3086327"/>
              <a:gd name="connsiteX11" fmla="*/ 1171463 w 2968627"/>
              <a:gd name="connsiteY11" fmla="*/ 19239 h 3086327"/>
              <a:gd name="connsiteX12" fmla="*/ 1254013 w 2968627"/>
              <a:gd name="connsiteY12" fmla="*/ 171639 h 3086327"/>
              <a:gd name="connsiteX13" fmla="*/ 1298463 w 2968627"/>
              <a:gd name="connsiteY13" fmla="*/ 241489 h 3086327"/>
              <a:gd name="connsiteX14" fmla="*/ 1292113 w 2968627"/>
              <a:gd name="connsiteY14" fmla="*/ 355789 h 3086327"/>
              <a:gd name="connsiteX15" fmla="*/ 1298463 w 2968627"/>
              <a:gd name="connsiteY15" fmla="*/ 533589 h 3086327"/>
              <a:gd name="connsiteX16" fmla="*/ 1273063 w 2968627"/>
              <a:gd name="connsiteY16" fmla="*/ 698689 h 3086327"/>
              <a:gd name="connsiteX17" fmla="*/ 1431813 w 2968627"/>
              <a:gd name="connsiteY17" fmla="*/ 774889 h 3086327"/>
              <a:gd name="connsiteX18" fmla="*/ 1615963 w 2968627"/>
              <a:gd name="connsiteY18" fmla="*/ 635189 h 3086327"/>
              <a:gd name="connsiteX19" fmla="*/ 1615963 w 2968627"/>
              <a:gd name="connsiteY19" fmla="*/ 419289 h 3086327"/>
              <a:gd name="connsiteX20" fmla="*/ 1546113 w 2968627"/>
              <a:gd name="connsiteY20" fmla="*/ 292289 h 3086327"/>
              <a:gd name="connsiteX21" fmla="*/ 1603263 w 2968627"/>
              <a:gd name="connsiteY21" fmla="*/ 336739 h 3086327"/>
              <a:gd name="connsiteX22" fmla="*/ 1666763 w 2968627"/>
              <a:gd name="connsiteY22" fmla="*/ 501839 h 3086327"/>
              <a:gd name="connsiteX23" fmla="*/ 1654063 w 2968627"/>
              <a:gd name="connsiteY23" fmla="*/ 660589 h 3086327"/>
              <a:gd name="connsiteX24" fmla="*/ 1609613 w 2968627"/>
              <a:gd name="connsiteY24" fmla="*/ 736789 h 3086327"/>
              <a:gd name="connsiteX25" fmla="*/ 1704863 w 2968627"/>
              <a:gd name="connsiteY25" fmla="*/ 571689 h 3086327"/>
              <a:gd name="connsiteX26" fmla="*/ 1800113 w 2968627"/>
              <a:gd name="connsiteY26" fmla="*/ 438339 h 3086327"/>
              <a:gd name="connsiteX27" fmla="*/ 1717563 w 2968627"/>
              <a:gd name="connsiteY27" fmla="*/ 584389 h 3086327"/>
              <a:gd name="connsiteX28" fmla="*/ 1641363 w 2968627"/>
              <a:gd name="connsiteY28" fmla="*/ 730439 h 3086327"/>
              <a:gd name="connsiteX29" fmla="*/ 1520713 w 2968627"/>
              <a:gd name="connsiteY29" fmla="*/ 806639 h 3086327"/>
              <a:gd name="connsiteX30" fmla="*/ 1444513 w 2968627"/>
              <a:gd name="connsiteY30" fmla="*/ 1136839 h 3086327"/>
              <a:gd name="connsiteX31" fmla="*/ 1635013 w 2968627"/>
              <a:gd name="connsiteY31" fmla="*/ 1301939 h 3086327"/>
              <a:gd name="connsiteX32" fmla="*/ 1844563 w 2968627"/>
              <a:gd name="connsiteY32" fmla="*/ 1301939 h 3086327"/>
              <a:gd name="connsiteX33" fmla="*/ 2117613 w 2968627"/>
              <a:gd name="connsiteY33" fmla="*/ 1308289 h 3086327"/>
              <a:gd name="connsiteX34" fmla="*/ 2162063 w 2968627"/>
              <a:gd name="connsiteY34" fmla="*/ 1124139 h 3086327"/>
              <a:gd name="connsiteX35" fmla="*/ 2079513 w 2968627"/>
              <a:gd name="connsiteY35" fmla="*/ 939989 h 3086327"/>
              <a:gd name="connsiteX36" fmla="*/ 2181113 w 2968627"/>
              <a:gd name="connsiteY36" fmla="*/ 1098739 h 3086327"/>
              <a:gd name="connsiteX37" fmla="*/ 2206513 w 2968627"/>
              <a:gd name="connsiteY37" fmla="*/ 1232089 h 3086327"/>
              <a:gd name="connsiteX38" fmla="*/ 2282713 w 2968627"/>
              <a:gd name="connsiteY38" fmla="*/ 800289 h 3086327"/>
              <a:gd name="connsiteX39" fmla="*/ 2371613 w 2968627"/>
              <a:gd name="connsiteY39" fmla="*/ 711389 h 3086327"/>
              <a:gd name="connsiteX40" fmla="*/ 2301763 w 2968627"/>
              <a:gd name="connsiteY40" fmla="*/ 793939 h 3086327"/>
              <a:gd name="connsiteX41" fmla="*/ 2282713 w 2968627"/>
              <a:gd name="connsiteY41" fmla="*/ 959039 h 3086327"/>
              <a:gd name="connsiteX42" fmla="*/ 2270013 w 2968627"/>
              <a:gd name="connsiteY42" fmla="*/ 1155889 h 3086327"/>
              <a:gd name="connsiteX43" fmla="*/ 2276363 w 2968627"/>
              <a:gd name="connsiteY43" fmla="*/ 1270189 h 3086327"/>
              <a:gd name="connsiteX44" fmla="*/ 2282713 w 2968627"/>
              <a:gd name="connsiteY44" fmla="*/ 1301939 h 3086327"/>
              <a:gd name="connsiteX45" fmla="*/ 2371613 w 2968627"/>
              <a:gd name="connsiteY45" fmla="*/ 1346389 h 3086327"/>
              <a:gd name="connsiteX46" fmla="*/ 2498613 w 2968627"/>
              <a:gd name="connsiteY46" fmla="*/ 1320989 h 3086327"/>
              <a:gd name="connsiteX47" fmla="*/ 2739913 w 2968627"/>
              <a:gd name="connsiteY47" fmla="*/ 1308289 h 3086327"/>
              <a:gd name="connsiteX48" fmla="*/ 2905013 w 2968627"/>
              <a:gd name="connsiteY48" fmla="*/ 1371789 h 3086327"/>
              <a:gd name="connsiteX49" fmla="*/ 2968513 w 2968627"/>
              <a:gd name="connsiteY49" fmla="*/ 1498789 h 3086327"/>
              <a:gd name="connsiteX50" fmla="*/ 2892313 w 2968627"/>
              <a:gd name="connsiteY50" fmla="*/ 1409889 h 3086327"/>
              <a:gd name="connsiteX51" fmla="*/ 2689113 w 2968627"/>
              <a:gd name="connsiteY51" fmla="*/ 1340039 h 3086327"/>
              <a:gd name="connsiteX52" fmla="*/ 2511313 w 2968627"/>
              <a:gd name="connsiteY52" fmla="*/ 1378139 h 3086327"/>
              <a:gd name="connsiteX53" fmla="*/ 2543063 w 2968627"/>
              <a:gd name="connsiteY53" fmla="*/ 1498789 h 3086327"/>
              <a:gd name="connsiteX54" fmla="*/ 2581163 w 2968627"/>
              <a:gd name="connsiteY54" fmla="*/ 1536889 h 3086327"/>
              <a:gd name="connsiteX55" fmla="*/ 2708163 w 2968627"/>
              <a:gd name="connsiteY55" fmla="*/ 1644839 h 3086327"/>
              <a:gd name="connsiteX56" fmla="*/ 2606563 w 2968627"/>
              <a:gd name="connsiteY56" fmla="*/ 1587689 h 3086327"/>
              <a:gd name="connsiteX57" fmla="*/ 2479563 w 2968627"/>
              <a:gd name="connsiteY57" fmla="*/ 1479739 h 3086327"/>
              <a:gd name="connsiteX58" fmla="*/ 2409713 w 2968627"/>
              <a:gd name="connsiteY58" fmla="*/ 1378139 h 3086327"/>
              <a:gd name="connsiteX59" fmla="*/ 2282713 w 2968627"/>
              <a:gd name="connsiteY59" fmla="*/ 1359089 h 3086327"/>
              <a:gd name="connsiteX60" fmla="*/ 2143013 w 2968627"/>
              <a:gd name="connsiteY60" fmla="*/ 1340039 h 3086327"/>
              <a:gd name="connsiteX61" fmla="*/ 1869963 w 2968627"/>
              <a:gd name="connsiteY61" fmla="*/ 1340039 h 3086327"/>
              <a:gd name="connsiteX62" fmla="*/ 1571513 w 2968627"/>
              <a:gd name="connsiteY62" fmla="*/ 1352739 h 3086327"/>
              <a:gd name="connsiteX63" fmla="*/ 1374663 w 2968627"/>
              <a:gd name="connsiteY63" fmla="*/ 1251139 h 3086327"/>
              <a:gd name="connsiteX64" fmla="*/ 1196863 w 2968627"/>
              <a:gd name="connsiteY64" fmla="*/ 1206689 h 3086327"/>
              <a:gd name="connsiteX65" fmla="*/ 968263 w 2968627"/>
              <a:gd name="connsiteY65" fmla="*/ 1282889 h 3086327"/>
              <a:gd name="connsiteX66" fmla="*/ 942863 w 2968627"/>
              <a:gd name="connsiteY66" fmla="*/ 1447989 h 3086327"/>
              <a:gd name="connsiteX67" fmla="*/ 911113 w 2968627"/>
              <a:gd name="connsiteY67" fmla="*/ 1568639 h 3086327"/>
              <a:gd name="connsiteX68" fmla="*/ 898413 w 2968627"/>
              <a:gd name="connsiteY68" fmla="*/ 1714689 h 3086327"/>
              <a:gd name="connsiteX69" fmla="*/ 1000013 w 2968627"/>
              <a:gd name="connsiteY69" fmla="*/ 1879789 h 3086327"/>
              <a:gd name="connsiteX70" fmla="*/ 942863 w 2968627"/>
              <a:gd name="connsiteY70" fmla="*/ 1835339 h 3086327"/>
              <a:gd name="connsiteX71" fmla="*/ 926988 w 2968627"/>
              <a:gd name="connsiteY71" fmla="*/ 1898839 h 3086327"/>
              <a:gd name="connsiteX72" fmla="*/ 949213 w 2968627"/>
              <a:gd name="connsiteY72" fmla="*/ 2051239 h 3086327"/>
              <a:gd name="connsiteX73" fmla="*/ 949213 w 2968627"/>
              <a:gd name="connsiteY73" fmla="*/ 2121089 h 3086327"/>
              <a:gd name="connsiteX74" fmla="*/ 911113 w 2968627"/>
              <a:gd name="connsiteY74" fmla="*/ 1987739 h 3086327"/>
              <a:gd name="connsiteX75" fmla="*/ 866663 w 2968627"/>
              <a:gd name="connsiteY75" fmla="*/ 1803589 h 3086327"/>
              <a:gd name="connsiteX76" fmla="*/ 860313 w 2968627"/>
              <a:gd name="connsiteY76" fmla="*/ 1746439 h 3086327"/>
              <a:gd name="connsiteX77" fmla="*/ 873013 w 2968627"/>
              <a:gd name="connsiteY77" fmla="*/ 2025839 h 3086327"/>
              <a:gd name="connsiteX78" fmla="*/ 993663 w 2968627"/>
              <a:gd name="connsiteY78" fmla="*/ 2387789 h 3086327"/>
              <a:gd name="connsiteX79" fmla="*/ 1107963 w 2968627"/>
              <a:gd name="connsiteY79" fmla="*/ 2476689 h 3086327"/>
              <a:gd name="connsiteX80" fmla="*/ 1285763 w 2968627"/>
              <a:gd name="connsiteY80" fmla="*/ 2381439 h 3086327"/>
              <a:gd name="connsiteX81" fmla="*/ 1317513 w 2968627"/>
              <a:gd name="connsiteY81" fmla="*/ 2229039 h 3086327"/>
              <a:gd name="connsiteX82" fmla="*/ 1381013 w 2968627"/>
              <a:gd name="connsiteY82" fmla="*/ 2216339 h 3086327"/>
              <a:gd name="connsiteX83" fmla="*/ 1330213 w 2968627"/>
              <a:gd name="connsiteY83" fmla="*/ 2254439 h 3086327"/>
              <a:gd name="connsiteX84" fmla="*/ 1336563 w 2968627"/>
              <a:gd name="connsiteY84" fmla="*/ 2387789 h 3086327"/>
              <a:gd name="connsiteX85" fmla="*/ 1266713 w 2968627"/>
              <a:gd name="connsiteY85" fmla="*/ 2438589 h 3086327"/>
              <a:gd name="connsiteX86" fmla="*/ 1463563 w 2968627"/>
              <a:gd name="connsiteY86" fmla="*/ 2432239 h 3086327"/>
              <a:gd name="connsiteX87" fmla="*/ 1615963 w 2968627"/>
              <a:gd name="connsiteY87" fmla="*/ 2508439 h 3086327"/>
              <a:gd name="connsiteX88" fmla="*/ 1520713 w 2968627"/>
              <a:gd name="connsiteY88" fmla="*/ 2476689 h 3086327"/>
              <a:gd name="connsiteX89" fmla="*/ 1412763 w 2968627"/>
              <a:gd name="connsiteY89" fmla="*/ 2457639 h 3086327"/>
              <a:gd name="connsiteX90" fmla="*/ 1298463 w 2968627"/>
              <a:gd name="connsiteY90" fmla="*/ 2457639 h 3086327"/>
              <a:gd name="connsiteX91" fmla="*/ 1203213 w 2968627"/>
              <a:gd name="connsiteY91" fmla="*/ 2489389 h 3086327"/>
              <a:gd name="connsiteX92" fmla="*/ 1082563 w 2968627"/>
              <a:gd name="connsiteY92" fmla="*/ 2514789 h 3086327"/>
              <a:gd name="connsiteX93" fmla="*/ 1133363 w 2968627"/>
              <a:gd name="connsiteY93" fmla="*/ 2730689 h 3086327"/>
              <a:gd name="connsiteX94" fmla="*/ 1006363 w 2968627"/>
              <a:gd name="connsiteY94" fmla="*/ 2952939 h 3086327"/>
              <a:gd name="connsiteX95" fmla="*/ 841263 w 2968627"/>
              <a:gd name="connsiteY95" fmla="*/ 3086289 h 3086327"/>
              <a:gd name="connsiteX96" fmla="*/ 955563 w 2968627"/>
              <a:gd name="connsiteY96" fmla="*/ 2965639 h 3086327"/>
              <a:gd name="connsiteX97" fmla="*/ 1038113 w 2968627"/>
              <a:gd name="connsiteY97" fmla="*/ 2870389 h 3086327"/>
              <a:gd name="connsiteX98" fmla="*/ 1063513 w 2968627"/>
              <a:gd name="connsiteY98" fmla="*/ 2749739 h 3086327"/>
              <a:gd name="connsiteX99" fmla="*/ 1025413 w 2968627"/>
              <a:gd name="connsiteY99" fmla="*/ 2590989 h 3086327"/>
              <a:gd name="connsiteX100" fmla="*/ 961913 w 2968627"/>
              <a:gd name="connsiteY100" fmla="*/ 2552889 h 3086327"/>
              <a:gd name="connsiteX101" fmla="*/ 936513 w 2968627"/>
              <a:gd name="connsiteY101" fmla="*/ 2717989 h 3086327"/>
              <a:gd name="connsiteX102" fmla="*/ 834913 w 2968627"/>
              <a:gd name="connsiteY102" fmla="*/ 2781489 h 3086327"/>
              <a:gd name="connsiteX103" fmla="*/ 904763 w 2968627"/>
              <a:gd name="connsiteY103" fmla="*/ 2724339 h 3086327"/>
              <a:gd name="connsiteX104" fmla="*/ 923813 w 2968627"/>
              <a:gd name="connsiteY104" fmla="*/ 2584639 h 3086327"/>
              <a:gd name="connsiteX105" fmla="*/ 930163 w 2968627"/>
              <a:gd name="connsiteY105" fmla="*/ 2495739 h 3086327"/>
              <a:gd name="connsiteX106" fmla="*/ 904763 w 2968627"/>
              <a:gd name="connsiteY106" fmla="*/ 2381439 h 3086327"/>
              <a:gd name="connsiteX107" fmla="*/ 892063 w 2968627"/>
              <a:gd name="connsiteY107" fmla="*/ 2197289 h 3086327"/>
              <a:gd name="connsiteX108" fmla="*/ 765063 w 2968627"/>
              <a:gd name="connsiteY108" fmla="*/ 1809939 h 3086327"/>
              <a:gd name="connsiteX109" fmla="*/ 834913 w 2968627"/>
              <a:gd name="connsiteY109" fmla="*/ 1524189 h 3086327"/>
              <a:gd name="connsiteX110" fmla="*/ 841263 w 2968627"/>
              <a:gd name="connsiteY110" fmla="*/ 1384489 h 3086327"/>
              <a:gd name="connsiteX111" fmla="*/ 809513 w 2968627"/>
              <a:gd name="connsiteY111" fmla="*/ 1105089 h 3086327"/>
              <a:gd name="connsiteX112" fmla="*/ 663463 w 2968627"/>
              <a:gd name="connsiteY112" fmla="*/ 1047939 h 3086327"/>
              <a:gd name="connsiteX113" fmla="*/ 561863 w 2968627"/>
              <a:gd name="connsiteY113" fmla="*/ 1251139 h 3086327"/>
              <a:gd name="connsiteX114" fmla="*/ 447563 w 2968627"/>
              <a:gd name="connsiteY114" fmla="*/ 1320989 h 3086327"/>
              <a:gd name="connsiteX115" fmla="*/ 460263 w 2968627"/>
              <a:gd name="connsiteY115" fmla="*/ 1454339 h 3086327"/>
              <a:gd name="connsiteX116" fmla="*/ 453913 w 2968627"/>
              <a:gd name="connsiteY116" fmla="*/ 1314639 h 3086327"/>
              <a:gd name="connsiteX117" fmla="*/ 523763 w 2968627"/>
              <a:gd name="connsiteY117" fmla="*/ 1206689 h 3086327"/>
              <a:gd name="connsiteX118" fmla="*/ 536463 w 2968627"/>
              <a:gd name="connsiteY118" fmla="*/ 1124139 h 3086327"/>
              <a:gd name="connsiteX119" fmla="*/ 352313 w 2968627"/>
              <a:gd name="connsiteY119" fmla="*/ 1086039 h 3086327"/>
              <a:gd name="connsiteX120" fmla="*/ 231663 w 2968627"/>
              <a:gd name="connsiteY120" fmla="*/ 1054289 h 3086327"/>
              <a:gd name="connsiteX121" fmla="*/ 136413 w 2968627"/>
              <a:gd name="connsiteY121" fmla="*/ 1213039 h 3086327"/>
              <a:gd name="connsiteX122" fmla="*/ 3063 w 2968627"/>
              <a:gd name="connsiteY122" fmla="*/ 1346389 h 3086327"/>
              <a:gd name="connsiteX123" fmla="*/ 50352 w 2968627"/>
              <a:gd name="connsiteY123" fmla="*/ 1280241 h 3086327"/>
              <a:gd name="connsiteX124" fmla="*/ 136093 w 2968627"/>
              <a:gd name="connsiteY124" fmla="*/ 1190147 h 3086327"/>
              <a:gd name="connsiteX125" fmla="*/ 206263 w 2968627"/>
              <a:gd name="connsiteY125" fmla="*/ 1022539 h 3086327"/>
              <a:gd name="connsiteX126" fmla="*/ 365013 w 2968627"/>
              <a:gd name="connsiteY126" fmla="*/ 1009839 h 3086327"/>
              <a:gd name="connsiteX127" fmla="*/ 244363 w 2968627"/>
              <a:gd name="connsiteY127" fmla="*/ 914589 h 3086327"/>
              <a:gd name="connsiteX128" fmla="*/ 125074 w 2968627"/>
              <a:gd name="connsiteY128" fmla="*/ 825317 h 3086327"/>
              <a:gd name="connsiteX129" fmla="*/ 111013 w 2968627"/>
              <a:gd name="connsiteY129" fmla="*/ 685989 h 3086327"/>
              <a:gd name="connsiteX130" fmla="*/ 151710 w 2968627"/>
              <a:gd name="connsiteY130" fmla="*/ 818307 h 3086327"/>
              <a:gd name="connsiteX131" fmla="*/ 282463 w 2968627"/>
              <a:gd name="connsiteY131" fmla="*/ 863789 h 3086327"/>
              <a:gd name="connsiteX132" fmla="*/ 422163 w 2968627"/>
              <a:gd name="connsiteY132" fmla="*/ 971739 h 3086327"/>
              <a:gd name="connsiteX133" fmla="*/ 549163 w 2968627"/>
              <a:gd name="connsiteY133" fmla="*/ 1041589 h 3086327"/>
              <a:gd name="connsiteX134" fmla="*/ 695213 w 2968627"/>
              <a:gd name="connsiteY134" fmla="*/ 997139 h 3086327"/>
              <a:gd name="connsiteX135" fmla="*/ 841263 w 2968627"/>
              <a:gd name="connsiteY135" fmla="*/ 984439 h 3086327"/>
              <a:gd name="connsiteX136" fmla="*/ 853963 w 2968627"/>
              <a:gd name="connsiteY136" fmla="*/ 825689 h 3086327"/>
              <a:gd name="connsiteX137" fmla="*/ 555513 w 2968627"/>
              <a:gd name="connsiteY137" fmla="*/ 438339 h 3086327"/>
              <a:gd name="connsiteX138" fmla="*/ 707913 w 2968627"/>
              <a:gd name="connsiteY138" fmla="*/ 584389 h 3086327"/>
              <a:gd name="connsiteX139" fmla="*/ 841263 w 2968627"/>
              <a:gd name="connsiteY139" fmla="*/ 724089 h 3086327"/>
              <a:gd name="connsiteX140" fmla="*/ 923813 w 2968627"/>
              <a:gd name="connsiteY140" fmla="*/ 743139 h 3086327"/>
              <a:gd name="connsiteX0" fmla="*/ 923813 w 2968627"/>
              <a:gd name="connsiteY0" fmla="*/ 743139 h 3086327"/>
              <a:gd name="connsiteX1" fmla="*/ 1171463 w 2968627"/>
              <a:gd name="connsiteY1" fmla="*/ 774889 h 3086327"/>
              <a:gd name="connsiteX2" fmla="*/ 1273063 w 2968627"/>
              <a:gd name="connsiteY2" fmla="*/ 501839 h 3086327"/>
              <a:gd name="connsiteX3" fmla="*/ 1184163 w 2968627"/>
              <a:gd name="connsiteY3" fmla="*/ 285939 h 3086327"/>
              <a:gd name="connsiteX4" fmla="*/ 860313 w 2968627"/>
              <a:gd name="connsiteY4" fmla="*/ 158939 h 3086327"/>
              <a:gd name="connsiteX5" fmla="*/ 784113 w 2968627"/>
              <a:gd name="connsiteY5" fmla="*/ 189 h 3086327"/>
              <a:gd name="connsiteX6" fmla="*/ 847613 w 2968627"/>
              <a:gd name="connsiteY6" fmla="*/ 127189 h 3086327"/>
              <a:gd name="connsiteX7" fmla="*/ 936513 w 2968627"/>
              <a:gd name="connsiteY7" fmla="*/ 152589 h 3086327"/>
              <a:gd name="connsiteX8" fmla="*/ 1107963 w 2968627"/>
              <a:gd name="connsiteY8" fmla="*/ 209739 h 3086327"/>
              <a:gd name="connsiteX9" fmla="*/ 1228613 w 2968627"/>
              <a:gd name="connsiteY9" fmla="*/ 209739 h 3086327"/>
              <a:gd name="connsiteX10" fmla="*/ 1165113 w 2968627"/>
              <a:gd name="connsiteY10" fmla="*/ 63689 h 3086327"/>
              <a:gd name="connsiteX11" fmla="*/ 1171463 w 2968627"/>
              <a:gd name="connsiteY11" fmla="*/ 19239 h 3086327"/>
              <a:gd name="connsiteX12" fmla="*/ 1254013 w 2968627"/>
              <a:gd name="connsiteY12" fmla="*/ 171639 h 3086327"/>
              <a:gd name="connsiteX13" fmla="*/ 1298463 w 2968627"/>
              <a:gd name="connsiteY13" fmla="*/ 241489 h 3086327"/>
              <a:gd name="connsiteX14" fmla="*/ 1292113 w 2968627"/>
              <a:gd name="connsiteY14" fmla="*/ 355789 h 3086327"/>
              <a:gd name="connsiteX15" fmla="*/ 1298463 w 2968627"/>
              <a:gd name="connsiteY15" fmla="*/ 533589 h 3086327"/>
              <a:gd name="connsiteX16" fmla="*/ 1273063 w 2968627"/>
              <a:gd name="connsiteY16" fmla="*/ 698689 h 3086327"/>
              <a:gd name="connsiteX17" fmla="*/ 1431813 w 2968627"/>
              <a:gd name="connsiteY17" fmla="*/ 774889 h 3086327"/>
              <a:gd name="connsiteX18" fmla="*/ 1615963 w 2968627"/>
              <a:gd name="connsiteY18" fmla="*/ 635189 h 3086327"/>
              <a:gd name="connsiteX19" fmla="*/ 1615963 w 2968627"/>
              <a:gd name="connsiteY19" fmla="*/ 419289 h 3086327"/>
              <a:gd name="connsiteX20" fmla="*/ 1546113 w 2968627"/>
              <a:gd name="connsiteY20" fmla="*/ 292289 h 3086327"/>
              <a:gd name="connsiteX21" fmla="*/ 1603263 w 2968627"/>
              <a:gd name="connsiteY21" fmla="*/ 336739 h 3086327"/>
              <a:gd name="connsiteX22" fmla="*/ 1666763 w 2968627"/>
              <a:gd name="connsiteY22" fmla="*/ 501839 h 3086327"/>
              <a:gd name="connsiteX23" fmla="*/ 1654063 w 2968627"/>
              <a:gd name="connsiteY23" fmla="*/ 660589 h 3086327"/>
              <a:gd name="connsiteX24" fmla="*/ 1609613 w 2968627"/>
              <a:gd name="connsiteY24" fmla="*/ 736789 h 3086327"/>
              <a:gd name="connsiteX25" fmla="*/ 1704863 w 2968627"/>
              <a:gd name="connsiteY25" fmla="*/ 571689 h 3086327"/>
              <a:gd name="connsiteX26" fmla="*/ 1800113 w 2968627"/>
              <a:gd name="connsiteY26" fmla="*/ 438339 h 3086327"/>
              <a:gd name="connsiteX27" fmla="*/ 1717563 w 2968627"/>
              <a:gd name="connsiteY27" fmla="*/ 584389 h 3086327"/>
              <a:gd name="connsiteX28" fmla="*/ 1641363 w 2968627"/>
              <a:gd name="connsiteY28" fmla="*/ 730439 h 3086327"/>
              <a:gd name="connsiteX29" fmla="*/ 1520713 w 2968627"/>
              <a:gd name="connsiteY29" fmla="*/ 806639 h 3086327"/>
              <a:gd name="connsiteX30" fmla="*/ 1444513 w 2968627"/>
              <a:gd name="connsiteY30" fmla="*/ 1136839 h 3086327"/>
              <a:gd name="connsiteX31" fmla="*/ 1635013 w 2968627"/>
              <a:gd name="connsiteY31" fmla="*/ 1301939 h 3086327"/>
              <a:gd name="connsiteX32" fmla="*/ 1844563 w 2968627"/>
              <a:gd name="connsiteY32" fmla="*/ 1301939 h 3086327"/>
              <a:gd name="connsiteX33" fmla="*/ 2117613 w 2968627"/>
              <a:gd name="connsiteY33" fmla="*/ 1308289 h 3086327"/>
              <a:gd name="connsiteX34" fmla="*/ 2162063 w 2968627"/>
              <a:gd name="connsiteY34" fmla="*/ 1124139 h 3086327"/>
              <a:gd name="connsiteX35" fmla="*/ 2079513 w 2968627"/>
              <a:gd name="connsiteY35" fmla="*/ 939989 h 3086327"/>
              <a:gd name="connsiteX36" fmla="*/ 2181113 w 2968627"/>
              <a:gd name="connsiteY36" fmla="*/ 1098739 h 3086327"/>
              <a:gd name="connsiteX37" fmla="*/ 2206513 w 2968627"/>
              <a:gd name="connsiteY37" fmla="*/ 1232089 h 3086327"/>
              <a:gd name="connsiteX38" fmla="*/ 2282713 w 2968627"/>
              <a:gd name="connsiteY38" fmla="*/ 800289 h 3086327"/>
              <a:gd name="connsiteX39" fmla="*/ 2371613 w 2968627"/>
              <a:gd name="connsiteY39" fmla="*/ 711389 h 3086327"/>
              <a:gd name="connsiteX40" fmla="*/ 2301763 w 2968627"/>
              <a:gd name="connsiteY40" fmla="*/ 793939 h 3086327"/>
              <a:gd name="connsiteX41" fmla="*/ 2282713 w 2968627"/>
              <a:gd name="connsiteY41" fmla="*/ 959039 h 3086327"/>
              <a:gd name="connsiteX42" fmla="*/ 2270013 w 2968627"/>
              <a:gd name="connsiteY42" fmla="*/ 1155889 h 3086327"/>
              <a:gd name="connsiteX43" fmla="*/ 2276363 w 2968627"/>
              <a:gd name="connsiteY43" fmla="*/ 1270189 h 3086327"/>
              <a:gd name="connsiteX44" fmla="*/ 2282713 w 2968627"/>
              <a:gd name="connsiteY44" fmla="*/ 1301939 h 3086327"/>
              <a:gd name="connsiteX45" fmla="*/ 2371613 w 2968627"/>
              <a:gd name="connsiteY45" fmla="*/ 1346389 h 3086327"/>
              <a:gd name="connsiteX46" fmla="*/ 2498613 w 2968627"/>
              <a:gd name="connsiteY46" fmla="*/ 1320989 h 3086327"/>
              <a:gd name="connsiteX47" fmla="*/ 2739913 w 2968627"/>
              <a:gd name="connsiteY47" fmla="*/ 1308289 h 3086327"/>
              <a:gd name="connsiteX48" fmla="*/ 2905013 w 2968627"/>
              <a:gd name="connsiteY48" fmla="*/ 1371789 h 3086327"/>
              <a:gd name="connsiteX49" fmla="*/ 2968513 w 2968627"/>
              <a:gd name="connsiteY49" fmla="*/ 1498789 h 3086327"/>
              <a:gd name="connsiteX50" fmla="*/ 2892313 w 2968627"/>
              <a:gd name="connsiteY50" fmla="*/ 1409889 h 3086327"/>
              <a:gd name="connsiteX51" fmla="*/ 2689113 w 2968627"/>
              <a:gd name="connsiteY51" fmla="*/ 1340039 h 3086327"/>
              <a:gd name="connsiteX52" fmla="*/ 2511313 w 2968627"/>
              <a:gd name="connsiteY52" fmla="*/ 1378139 h 3086327"/>
              <a:gd name="connsiteX53" fmla="*/ 2543063 w 2968627"/>
              <a:gd name="connsiteY53" fmla="*/ 1498789 h 3086327"/>
              <a:gd name="connsiteX54" fmla="*/ 2581163 w 2968627"/>
              <a:gd name="connsiteY54" fmla="*/ 1536889 h 3086327"/>
              <a:gd name="connsiteX55" fmla="*/ 2708163 w 2968627"/>
              <a:gd name="connsiteY55" fmla="*/ 1644839 h 3086327"/>
              <a:gd name="connsiteX56" fmla="*/ 2606563 w 2968627"/>
              <a:gd name="connsiteY56" fmla="*/ 1587689 h 3086327"/>
              <a:gd name="connsiteX57" fmla="*/ 2479563 w 2968627"/>
              <a:gd name="connsiteY57" fmla="*/ 1479739 h 3086327"/>
              <a:gd name="connsiteX58" fmla="*/ 2409713 w 2968627"/>
              <a:gd name="connsiteY58" fmla="*/ 1378139 h 3086327"/>
              <a:gd name="connsiteX59" fmla="*/ 2282713 w 2968627"/>
              <a:gd name="connsiteY59" fmla="*/ 1359089 h 3086327"/>
              <a:gd name="connsiteX60" fmla="*/ 2143013 w 2968627"/>
              <a:gd name="connsiteY60" fmla="*/ 1340039 h 3086327"/>
              <a:gd name="connsiteX61" fmla="*/ 1869963 w 2968627"/>
              <a:gd name="connsiteY61" fmla="*/ 1340039 h 3086327"/>
              <a:gd name="connsiteX62" fmla="*/ 1571513 w 2968627"/>
              <a:gd name="connsiteY62" fmla="*/ 1352739 h 3086327"/>
              <a:gd name="connsiteX63" fmla="*/ 1374663 w 2968627"/>
              <a:gd name="connsiteY63" fmla="*/ 1251139 h 3086327"/>
              <a:gd name="connsiteX64" fmla="*/ 1196863 w 2968627"/>
              <a:gd name="connsiteY64" fmla="*/ 1206689 h 3086327"/>
              <a:gd name="connsiteX65" fmla="*/ 968263 w 2968627"/>
              <a:gd name="connsiteY65" fmla="*/ 1282889 h 3086327"/>
              <a:gd name="connsiteX66" fmla="*/ 942863 w 2968627"/>
              <a:gd name="connsiteY66" fmla="*/ 1447989 h 3086327"/>
              <a:gd name="connsiteX67" fmla="*/ 911113 w 2968627"/>
              <a:gd name="connsiteY67" fmla="*/ 1568639 h 3086327"/>
              <a:gd name="connsiteX68" fmla="*/ 898413 w 2968627"/>
              <a:gd name="connsiteY68" fmla="*/ 1714689 h 3086327"/>
              <a:gd name="connsiteX69" fmla="*/ 1000013 w 2968627"/>
              <a:gd name="connsiteY69" fmla="*/ 1879789 h 3086327"/>
              <a:gd name="connsiteX70" fmla="*/ 942863 w 2968627"/>
              <a:gd name="connsiteY70" fmla="*/ 1835339 h 3086327"/>
              <a:gd name="connsiteX71" fmla="*/ 926988 w 2968627"/>
              <a:gd name="connsiteY71" fmla="*/ 1898839 h 3086327"/>
              <a:gd name="connsiteX72" fmla="*/ 949213 w 2968627"/>
              <a:gd name="connsiteY72" fmla="*/ 2051239 h 3086327"/>
              <a:gd name="connsiteX73" fmla="*/ 949213 w 2968627"/>
              <a:gd name="connsiteY73" fmla="*/ 2121089 h 3086327"/>
              <a:gd name="connsiteX74" fmla="*/ 911113 w 2968627"/>
              <a:gd name="connsiteY74" fmla="*/ 1987739 h 3086327"/>
              <a:gd name="connsiteX75" fmla="*/ 866663 w 2968627"/>
              <a:gd name="connsiteY75" fmla="*/ 1803589 h 3086327"/>
              <a:gd name="connsiteX76" fmla="*/ 860313 w 2968627"/>
              <a:gd name="connsiteY76" fmla="*/ 1746439 h 3086327"/>
              <a:gd name="connsiteX77" fmla="*/ 873013 w 2968627"/>
              <a:gd name="connsiteY77" fmla="*/ 2025839 h 3086327"/>
              <a:gd name="connsiteX78" fmla="*/ 993663 w 2968627"/>
              <a:gd name="connsiteY78" fmla="*/ 2387789 h 3086327"/>
              <a:gd name="connsiteX79" fmla="*/ 1107963 w 2968627"/>
              <a:gd name="connsiteY79" fmla="*/ 2476689 h 3086327"/>
              <a:gd name="connsiteX80" fmla="*/ 1285763 w 2968627"/>
              <a:gd name="connsiteY80" fmla="*/ 2381439 h 3086327"/>
              <a:gd name="connsiteX81" fmla="*/ 1317513 w 2968627"/>
              <a:gd name="connsiteY81" fmla="*/ 2229039 h 3086327"/>
              <a:gd name="connsiteX82" fmla="*/ 1381013 w 2968627"/>
              <a:gd name="connsiteY82" fmla="*/ 2216339 h 3086327"/>
              <a:gd name="connsiteX83" fmla="*/ 1330213 w 2968627"/>
              <a:gd name="connsiteY83" fmla="*/ 2254439 h 3086327"/>
              <a:gd name="connsiteX84" fmla="*/ 1336563 w 2968627"/>
              <a:gd name="connsiteY84" fmla="*/ 2387789 h 3086327"/>
              <a:gd name="connsiteX85" fmla="*/ 1266713 w 2968627"/>
              <a:gd name="connsiteY85" fmla="*/ 2438589 h 3086327"/>
              <a:gd name="connsiteX86" fmla="*/ 1463563 w 2968627"/>
              <a:gd name="connsiteY86" fmla="*/ 2432239 h 3086327"/>
              <a:gd name="connsiteX87" fmla="*/ 1615963 w 2968627"/>
              <a:gd name="connsiteY87" fmla="*/ 2508439 h 3086327"/>
              <a:gd name="connsiteX88" fmla="*/ 1520713 w 2968627"/>
              <a:gd name="connsiteY88" fmla="*/ 2476689 h 3086327"/>
              <a:gd name="connsiteX89" fmla="*/ 1412763 w 2968627"/>
              <a:gd name="connsiteY89" fmla="*/ 2457639 h 3086327"/>
              <a:gd name="connsiteX90" fmla="*/ 1298463 w 2968627"/>
              <a:gd name="connsiteY90" fmla="*/ 2457639 h 3086327"/>
              <a:gd name="connsiteX91" fmla="*/ 1203213 w 2968627"/>
              <a:gd name="connsiteY91" fmla="*/ 2489389 h 3086327"/>
              <a:gd name="connsiteX92" fmla="*/ 1082563 w 2968627"/>
              <a:gd name="connsiteY92" fmla="*/ 2514789 h 3086327"/>
              <a:gd name="connsiteX93" fmla="*/ 1133363 w 2968627"/>
              <a:gd name="connsiteY93" fmla="*/ 2730689 h 3086327"/>
              <a:gd name="connsiteX94" fmla="*/ 1006363 w 2968627"/>
              <a:gd name="connsiteY94" fmla="*/ 2952939 h 3086327"/>
              <a:gd name="connsiteX95" fmla="*/ 841263 w 2968627"/>
              <a:gd name="connsiteY95" fmla="*/ 3086289 h 3086327"/>
              <a:gd name="connsiteX96" fmla="*/ 955563 w 2968627"/>
              <a:gd name="connsiteY96" fmla="*/ 2965639 h 3086327"/>
              <a:gd name="connsiteX97" fmla="*/ 1038113 w 2968627"/>
              <a:gd name="connsiteY97" fmla="*/ 2870389 h 3086327"/>
              <a:gd name="connsiteX98" fmla="*/ 1063513 w 2968627"/>
              <a:gd name="connsiteY98" fmla="*/ 2749739 h 3086327"/>
              <a:gd name="connsiteX99" fmla="*/ 1025413 w 2968627"/>
              <a:gd name="connsiteY99" fmla="*/ 2590989 h 3086327"/>
              <a:gd name="connsiteX100" fmla="*/ 961913 w 2968627"/>
              <a:gd name="connsiteY100" fmla="*/ 2552889 h 3086327"/>
              <a:gd name="connsiteX101" fmla="*/ 936513 w 2968627"/>
              <a:gd name="connsiteY101" fmla="*/ 2717989 h 3086327"/>
              <a:gd name="connsiteX102" fmla="*/ 834913 w 2968627"/>
              <a:gd name="connsiteY102" fmla="*/ 2781489 h 3086327"/>
              <a:gd name="connsiteX103" fmla="*/ 904763 w 2968627"/>
              <a:gd name="connsiteY103" fmla="*/ 2724339 h 3086327"/>
              <a:gd name="connsiteX104" fmla="*/ 923813 w 2968627"/>
              <a:gd name="connsiteY104" fmla="*/ 2584639 h 3086327"/>
              <a:gd name="connsiteX105" fmla="*/ 930163 w 2968627"/>
              <a:gd name="connsiteY105" fmla="*/ 2495739 h 3086327"/>
              <a:gd name="connsiteX106" fmla="*/ 904763 w 2968627"/>
              <a:gd name="connsiteY106" fmla="*/ 2381439 h 3086327"/>
              <a:gd name="connsiteX107" fmla="*/ 892063 w 2968627"/>
              <a:gd name="connsiteY107" fmla="*/ 2197289 h 3086327"/>
              <a:gd name="connsiteX108" fmla="*/ 765063 w 2968627"/>
              <a:gd name="connsiteY108" fmla="*/ 1809939 h 3086327"/>
              <a:gd name="connsiteX109" fmla="*/ 834913 w 2968627"/>
              <a:gd name="connsiteY109" fmla="*/ 1524189 h 3086327"/>
              <a:gd name="connsiteX110" fmla="*/ 841263 w 2968627"/>
              <a:gd name="connsiteY110" fmla="*/ 1384489 h 3086327"/>
              <a:gd name="connsiteX111" fmla="*/ 809513 w 2968627"/>
              <a:gd name="connsiteY111" fmla="*/ 1105089 h 3086327"/>
              <a:gd name="connsiteX112" fmla="*/ 663463 w 2968627"/>
              <a:gd name="connsiteY112" fmla="*/ 1047939 h 3086327"/>
              <a:gd name="connsiteX113" fmla="*/ 561863 w 2968627"/>
              <a:gd name="connsiteY113" fmla="*/ 1251139 h 3086327"/>
              <a:gd name="connsiteX114" fmla="*/ 447563 w 2968627"/>
              <a:gd name="connsiteY114" fmla="*/ 1320989 h 3086327"/>
              <a:gd name="connsiteX115" fmla="*/ 460263 w 2968627"/>
              <a:gd name="connsiteY115" fmla="*/ 1454339 h 3086327"/>
              <a:gd name="connsiteX116" fmla="*/ 453913 w 2968627"/>
              <a:gd name="connsiteY116" fmla="*/ 1314639 h 3086327"/>
              <a:gd name="connsiteX117" fmla="*/ 523763 w 2968627"/>
              <a:gd name="connsiteY117" fmla="*/ 1206689 h 3086327"/>
              <a:gd name="connsiteX118" fmla="*/ 536463 w 2968627"/>
              <a:gd name="connsiteY118" fmla="*/ 1124139 h 3086327"/>
              <a:gd name="connsiteX119" fmla="*/ 352313 w 2968627"/>
              <a:gd name="connsiteY119" fmla="*/ 1086039 h 3086327"/>
              <a:gd name="connsiteX120" fmla="*/ 231663 w 2968627"/>
              <a:gd name="connsiteY120" fmla="*/ 1054289 h 3086327"/>
              <a:gd name="connsiteX121" fmla="*/ 136413 w 2968627"/>
              <a:gd name="connsiteY121" fmla="*/ 1213039 h 3086327"/>
              <a:gd name="connsiteX122" fmla="*/ 3063 w 2968627"/>
              <a:gd name="connsiteY122" fmla="*/ 1346389 h 3086327"/>
              <a:gd name="connsiteX123" fmla="*/ 50352 w 2968627"/>
              <a:gd name="connsiteY123" fmla="*/ 1280241 h 3086327"/>
              <a:gd name="connsiteX124" fmla="*/ 136093 w 2968627"/>
              <a:gd name="connsiteY124" fmla="*/ 1190147 h 3086327"/>
              <a:gd name="connsiteX125" fmla="*/ 206263 w 2968627"/>
              <a:gd name="connsiteY125" fmla="*/ 1022539 h 3086327"/>
              <a:gd name="connsiteX126" fmla="*/ 365013 w 2968627"/>
              <a:gd name="connsiteY126" fmla="*/ 1009839 h 3086327"/>
              <a:gd name="connsiteX127" fmla="*/ 244363 w 2968627"/>
              <a:gd name="connsiteY127" fmla="*/ 914589 h 3086327"/>
              <a:gd name="connsiteX128" fmla="*/ 125074 w 2968627"/>
              <a:gd name="connsiteY128" fmla="*/ 825317 h 3086327"/>
              <a:gd name="connsiteX129" fmla="*/ 111013 w 2968627"/>
              <a:gd name="connsiteY129" fmla="*/ 685989 h 3086327"/>
              <a:gd name="connsiteX130" fmla="*/ 151710 w 2968627"/>
              <a:gd name="connsiteY130" fmla="*/ 818307 h 3086327"/>
              <a:gd name="connsiteX131" fmla="*/ 254341 w 2968627"/>
              <a:gd name="connsiteY131" fmla="*/ 889932 h 3086327"/>
              <a:gd name="connsiteX132" fmla="*/ 422163 w 2968627"/>
              <a:gd name="connsiteY132" fmla="*/ 971739 h 3086327"/>
              <a:gd name="connsiteX133" fmla="*/ 549163 w 2968627"/>
              <a:gd name="connsiteY133" fmla="*/ 1041589 h 3086327"/>
              <a:gd name="connsiteX134" fmla="*/ 695213 w 2968627"/>
              <a:gd name="connsiteY134" fmla="*/ 997139 h 3086327"/>
              <a:gd name="connsiteX135" fmla="*/ 841263 w 2968627"/>
              <a:gd name="connsiteY135" fmla="*/ 984439 h 3086327"/>
              <a:gd name="connsiteX136" fmla="*/ 853963 w 2968627"/>
              <a:gd name="connsiteY136" fmla="*/ 825689 h 3086327"/>
              <a:gd name="connsiteX137" fmla="*/ 555513 w 2968627"/>
              <a:gd name="connsiteY137" fmla="*/ 438339 h 3086327"/>
              <a:gd name="connsiteX138" fmla="*/ 707913 w 2968627"/>
              <a:gd name="connsiteY138" fmla="*/ 584389 h 3086327"/>
              <a:gd name="connsiteX139" fmla="*/ 841263 w 2968627"/>
              <a:gd name="connsiteY139" fmla="*/ 724089 h 3086327"/>
              <a:gd name="connsiteX140" fmla="*/ 923813 w 2968627"/>
              <a:gd name="connsiteY140" fmla="*/ 743139 h 3086327"/>
              <a:gd name="connsiteX0" fmla="*/ 923813 w 2968627"/>
              <a:gd name="connsiteY0" fmla="*/ 743139 h 3086327"/>
              <a:gd name="connsiteX1" fmla="*/ 1171463 w 2968627"/>
              <a:gd name="connsiteY1" fmla="*/ 774889 h 3086327"/>
              <a:gd name="connsiteX2" fmla="*/ 1273063 w 2968627"/>
              <a:gd name="connsiteY2" fmla="*/ 501839 h 3086327"/>
              <a:gd name="connsiteX3" fmla="*/ 1184163 w 2968627"/>
              <a:gd name="connsiteY3" fmla="*/ 285939 h 3086327"/>
              <a:gd name="connsiteX4" fmla="*/ 860313 w 2968627"/>
              <a:gd name="connsiteY4" fmla="*/ 158939 h 3086327"/>
              <a:gd name="connsiteX5" fmla="*/ 784113 w 2968627"/>
              <a:gd name="connsiteY5" fmla="*/ 189 h 3086327"/>
              <a:gd name="connsiteX6" fmla="*/ 847613 w 2968627"/>
              <a:gd name="connsiteY6" fmla="*/ 127189 h 3086327"/>
              <a:gd name="connsiteX7" fmla="*/ 936513 w 2968627"/>
              <a:gd name="connsiteY7" fmla="*/ 152589 h 3086327"/>
              <a:gd name="connsiteX8" fmla="*/ 1107963 w 2968627"/>
              <a:gd name="connsiteY8" fmla="*/ 209739 h 3086327"/>
              <a:gd name="connsiteX9" fmla="*/ 1228613 w 2968627"/>
              <a:gd name="connsiteY9" fmla="*/ 209739 h 3086327"/>
              <a:gd name="connsiteX10" fmla="*/ 1165113 w 2968627"/>
              <a:gd name="connsiteY10" fmla="*/ 63689 h 3086327"/>
              <a:gd name="connsiteX11" fmla="*/ 1171463 w 2968627"/>
              <a:gd name="connsiteY11" fmla="*/ 19239 h 3086327"/>
              <a:gd name="connsiteX12" fmla="*/ 1254013 w 2968627"/>
              <a:gd name="connsiteY12" fmla="*/ 171639 h 3086327"/>
              <a:gd name="connsiteX13" fmla="*/ 1298463 w 2968627"/>
              <a:gd name="connsiteY13" fmla="*/ 241489 h 3086327"/>
              <a:gd name="connsiteX14" fmla="*/ 1292113 w 2968627"/>
              <a:gd name="connsiteY14" fmla="*/ 355789 h 3086327"/>
              <a:gd name="connsiteX15" fmla="*/ 1298463 w 2968627"/>
              <a:gd name="connsiteY15" fmla="*/ 533589 h 3086327"/>
              <a:gd name="connsiteX16" fmla="*/ 1273063 w 2968627"/>
              <a:gd name="connsiteY16" fmla="*/ 698689 h 3086327"/>
              <a:gd name="connsiteX17" fmla="*/ 1431813 w 2968627"/>
              <a:gd name="connsiteY17" fmla="*/ 774889 h 3086327"/>
              <a:gd name="connsiteX18" fmla="*/ 1615963 w 2968627"/>
              <a:gd name="connsiteY18" fmla="*/ 635189 h 3086327"/>
              <a:gd name="connsiteX19" fmla="*/ 1615963 w 2968627"/>
              <a:gd name="connsiteY19" fmla="*/ 419289 h 3086327"/>
              <a:gd name="connsiteX20" fmla="*/ 1546113 w 2968627"/>
              <a:gd name="connsiteY20" fmla="*/ 292289 h 3086327"/>
              <a:gd name="connsiteX21" fmla="*/ 1603263 w 2968627"/>
              <a:gd name="connsiteY21" fmla="*/ 336739 h 3086327"/>
              <a:gd name="connsiteX22" fmla="*/ 1666763 w 2968627"/>
              <a:gd name="connsiteY22" fmla="*/ 501839 h 3086327"/>
              <a:gd name="connsiteX23" fmla="*/ 1654063 w 2968627"/>
              <a:gd name="connsiteY23" fmla="*/ 660589 h 3086327"/>
              <a:gd name="connsiteX24" fmla="*/ 1609613 w 2968627"/>
              <a:gd name="connsiteY24" fmla="*/ 736789 h 3086327"/>
              <a:gd name="connsiteX25" fmla="*/ 1704863 w 2968627"/>
              <a:gd name="connsiteY25" fmla="*/ 571689 h 3086327"/>
              <a:gd name="connsiteX26" fmla="*/ 1800113 w 2968627"/>
              <a:gd name="connsiteY26" fmla="*/ 438339 h 3086327"/>
              <a:gd name="connsiteX27" fmla="*/ 1717563 w 2968627"/>
              <a:gd name="connsiteY27" fmla="*/ 584389 h 3086327"/>
              <a:gd name="connsiteX28" fmla="*/ 1641363 w 2968627"/>
              <a:gd name="connsiteY28" fmla="*/ 730439 h 3086327"/>
              <a:gd name="connsiteX29" fmla="*/ 1520713 w 2968627"/>
              <a:gd name="connsiteY29" fmla="*/ 806639 h 3086327"/>
              <a:gd name="connsiteX30" fmla="*/ 1444513 w 2968627"/>
              <a:gd name="connsiteY30" fmla="*/ 1136839 h 3086327"/>
              <a:gd name="connsiteX31" fmla="*/ 1635013 w 2968627"/>
              <a:gd name="connsiteY31" fmla="*/ 1301939 h 3086327"/>
              <a:gd name="connsiteX32" fmla="*/ 1844563 w 2968627"/>
              <a:gd name="connsiteY32" fmla="*/ 1301939 h 3086327"/>
              <a:gd name="connsiteX33" fmla="*/ 2117613 w 2968627"/>
              <a:gd name="connsiteY33" fmla="*/ 1308289 h 3086327"/>
              <a:gd name="connsiteX34" fmla="*/ 2162063 w 2968627"/>
              <a:gd name="connsiteY34" fmla="*/ 1124139 h 3086327"/>
              <a:gd name="connsiteX35" fmla="*/ 2079513 w 2968627"/>
              <a:gd name="connsiteY35" fmla="*/ 939989 h 3086327"/>
              <a:gd name="connsiteX36" fmla="*/ 2181113 w 2968627"/>
              <a:gd name="connsiteY36" fmla="*/ 1098739 h 3086327"/>
              <a:gd name="connsiteX37" fmla="*/ 2206513 w 2968627"/>
              <a:gd name="connsiteY37" fmla="*/ 1232089 h 3086327"/>
              <a:gd name="connsiteX38" fmla="*/ 2282713 w 2968627"/>
              <a:gd name="connsiteY38" fmla="*/ 800289 h 3086327"/>
              <a:gd name="connsiteX39" fmla="*/ 2371613 w 2968627"/>
              <a:gd name="connsiteY39" fmla="*/ 711389 h 3086327"/>
              <a:gd name="connsiteX40" fmla="*/ 2301763 w 2968627"/>
              <a:gd name="connsiteY40" fmla="*/ 793939 h 3086327"/>
              <a:gd name="connsiteX41" fmla="*/ 2282713 w 2968627"/>
              <a:gd name="connsiteY41" fmla="*/ 959039 h 3086327"/>
              <a:gd name="connsiteX42" fmla="*/ 2270013 w 2968627"/>
              <a:gd name="connsiteY42" fmla="*/ 1155889 h 3086327"/>
              <a:gd name="connsiteX43" fmla="*/ 2276363 w 2968627"/>
              <a:gd name="connsiteY43" fmla="*/ 1270189 h 3086327"/>
              <a:gd name="connsiteX44" fmla="*/ 2282713 w 2968627"/>
              <a:gd name="connsiteY44" fmla="*/ 1301939 h 3086327"/>
              <a:gd name="connsiteX45" fmla="*/ 2371613 w 2968627"/>
              <a:gd name="connsiteY45" fmla="*/ 1346389 h 3086327"/>
              <a:gd name="connsiteX46" fmla="*/ 2498613 w 2968627"/>
              <a:gd name="connsiteY46" fmla="*/ 1320989 h 3086327"/>
              <a:gd name="connsiteX47" fmla="*/ 2739913 w 2968627"/>
              <a:gd name="connsiteY47" fmla="*/ 1308289 h 3086327"/>
              <a:gd name="connsiteX48" fmla="*/ 2905013 w 2968627"/>
              <a:gd name="connsiteY48" fmla="*/ 1371789 h 3086327"/>
              <a:gd name="connsiteX49" fmla="*/ 2968513 w 2968627"/>
              <a:gd name="connsiteY49" fmla="*/ 1498789 h 3086327"/>
              <a:gd name="connsiteX50" fmla="*/ 2892313 w 2968627"/>
              <a:gd name="connsiteY50" fmla="*/ 1409889 h 3086327"/>
              <a:gd name="connsiteX51" fmla="*/ 2689113 w 2968627"/>
              <a:gd name="connsiteY51" fmla="*/ 1340039 h 3086327"/>
              <a:gd name="connsiteX52" fmla="*/ 2511313 w 2968627"/>
              <a:gd name="connsiteY52" fmla="*/ 1378139 h 3086327"/>
              <a:gd name="connsiteX53" fmla="*/ 2543063 w 2968627"/>
              <a:gd name="connsiteY53" fmla="*/ 1498789 h 3086327"/>
              <a:gd name="connsiteX54" fmla="*/ 2581163 w 2968627"/>
              <a:gd name="connsiteY54" fmla="*/ 1536889 h 3086327"/>
              <a:gd name="connsiteX55" fmla="*/ 2708163 w 2968627"/>
              <a:gd name="connsiteY55" fmla="*/ 1644839 h 3086327"/>
              <a:gd name="connsiteX56" fmla="*/ 2606563 w 2968627"/>
              <a:gd name="connsiteY56" fmla="*/ 1587689 h 3086327"/>
              <a:gd name="connsiteX57" fmla="*/ 2479563 w 2968627"/>
              <a:gd name="connsiteY57" fmla="*/ 1479739 h 3086327"/>
              <a:gd name="connsiteX58" fmla="*/ 2409713 w 2968627"/>
              <a:gd name="connsiteY58" fmla="*/ 1378139 h 3086327"/>
              <a:gd name="connsiteX59" fmla="*/ 2282713 w 2968627"/>
              <a:gd name="connsiteY59" fmla="*/ 1359089 h 3086327"/>
              <a:gd name="connsiteX60" fmla="*/ 2143013 w 2968627"/>
              <a:gd name="connsiteY60" fmla="*/ 1340039 h 3086327"/>
              <a:gd name="connsiteX61" fmla="*/ 1869963 w 2968627"/>
              <a:gd name="connsiteY61" fmla="*/ 1340039 h 3086327"/>
              <a:gd name="connsiteX62" fmla="*/ 1571513 w 2968627"/>
              <a:gd name="connsiteY62" fmla="*/ 1352739 h 3086327"/>
              <a:gd name="connsiteX63" fmla="*/ 1374663 w 2968627"/>
              <a:gd name="connsiteY63" fmla="*/ 1251139 h 3086327"/>
              <a:gd name="connsiteX64" fmla="*/ 1196863 w 2968627"/>
              <a:gd name="connsiteY64" fmla="*/ 1206689 h 3086327"/>
              <a:gd name="connsiteX65" fmla="*/ 968263 w 2968627"/>
              <a:gd name="connsiteY65" fmla="*/ 1282889 h 3086327"/>
              <a:gd name="connsiteX66" fmla="*/ 942863 w 2968627"/>
              <a:gd name="connsiteY66" fmla="*/ 1447989 h 3086327"/>
              <a:gd name="connsiteX67" fmla="*/ 911113 w 2968627"/>
              <a:gd name="connsiteY67" fmla="*/ 1568639 h 3086327"/>
              <a:gd name="connsiteX68" fmla="*/ 898413 w 2968627"/>
              <a:gd name="connsiteY68" fmla="*/ 1714689 h 3086327"/>
              <a:gd name="connsiteX69" fmla="*/ 1000013 w 2968627"/>
              <a:gd name="connsiteY69" fmla="*/ 1879789 h 3086327"/>
              <a:gd name="connsiteX70" fmla="*/ 942863 w 2968627"/>
              <a:gd name="connsiteY70" fmla="*/ 1835339 h 3086327"/>
              <a:gd name="connsiteX71" fmla="*/ 926988 w 2968627"/>
              <a:gd name="connsiteY71" fmla="*/ 1898839 h 3086327"/>
              <a:gd name="connsiteX72" fmla="*/ 949213 w 2968627"/>
              <a:gd name="connsiteY72" fmla="*/ 2051239 h 3086327"/>
              <a:gd name="connsiteX73" fmla="*/ 949213 w 2968627"/>
              <a:gd name="connsiteY73" fmla="*/ 2121089 h 3086327"/>
              <a:gd name="connsiteX74" fmla="*/ 911113 w 2968627"/>
              <a:gd name="connsiteY74" fmla="*/ 1987739 h 3086327"/>
              <a:gd name="connsiteX75" fmla="*/ 866663 w 2968627"/>
              <a:gd name="connsiteY75" fmla="*/ 1803589 h 3086327"/>
              <a:gd name="connsiteX76" fmla="*/ 860313 w 2968627"/>
              <a:gd name="connsiteY76" fmla="*/ 1746439 h 3086327"/>
              <a:gd name="connsiteX77" fmla="*/ 873013 w 2968627"/>
              <a:gd name="connsiteY77" fmla="*/ 2025839 h 3086327"/>
              <a:gd name="connsiteX78" fmla="*/ 993663 w 2968627"/>
              <a:gd name="connsiteY78" fmla="*/ 2387789 h 3086327"/>
              <a:gd name="connsiteX79" fmla="*/ 1107963 w 2968627"/>
              <a:gd name="connsiteY79" fmla="*/ 2476689 h 3086327"/>
              <a:gd name="connsiteX80" fmla="*/ 1285763 w 2968627"/>
              <a:gd name="connsiteY80" fmla="*/ 2381439 h 3086327"/>
              <a:gd name="connsiteX81" fmla="*/ 1317513 w 2968627"/>
              <a:gd name="connsiteY81" fmla="*/ 2229039 h 3086327"/>
              <a:gd name="connsiteX82" fmla="*/ 1381013 w 2968627"/>
              <a:gd name="connsiteY82" fmla="*/ 2216339 h 3086327"/>
              <a:gd name="connsiteX83" fmla="*/ 1330213 w 2968627"/>
              <a:gd name="connsiteY83" fmla="*/ 2254439 h 3086327"/>
              <a:gd name="connsiteX84" fmla="*/ 1336563 w 2968627"/>
              <a:gd name="connsiteY84" fmla="*/ 2387789 h 3086327"/>
              <a:gd name="connsiteX85" fmla="*/ 1266713 w 2968627"/>
              <a:gd name="connsiteY85" fmla="*/ 2438589 h 3086327"/>
              <a:gd name="connsiteX86" fmla="*/ 1463563 w 2968627"/>
              <a:gd name="connsiteY86" fmla="*/ 2432239 h 3086327"/>
              <a:gd name="connsiteX87" fmla="*/ 1615963 w 2968627"/>
              <a:gd name="connsiteY87" fmla="*/ 2508439 h 3086327"/>
              <a:gd name="connsiteX88" fmla="*/ 1520713 w 2968627"/>
              <a:gd name="connsiteY88" fmla="*/ 2476689 h 3086327"/>
              <a:gd name="connsiteX89" fmla="*/ 1412763 w 2968627"/>
              <a:gd name="connsiteY89" fmla="*/ 2457639 h 3086327"/>
              <a:gd name="connsiteX90" fmla="*/ 1298463 w 2968627"/>
              <a:gd name="connsiteY90" fmla="*/ 2457639 h 3086327"/>
              <a:gd name="connsiteX91" fmla="*/ 1203213 w 2968627"/>
              <a:gd name="connsiteY91" fmla="*/ 2489389 h 3086327"/>
              <a:gd name="connsiteX92" fmla="*/ 1082563 w 2968627"/>
              <a:gd name="connsiteY92" fmla="*/ 2514789 h 3086327"/>
              <a:gd name="connsiteX93" fmla="*/ 1133363 w 2968627"/>
              <a:gd name="connsiteY93" fmla="*/ 2730689 h 3086327"/>
              <a:gd name="connsiteX94" fmla="*/ 1006363 w 2968627"/>
              <a:gd name="connsiteY94" fmla="*/ 2952939 h 3086327"/>
              <a:gd name="connsiteX95" fmla="*/ 841263 w 2968627"/>
              <a:gd name="connsiteY95" fmla="*/ 3086289 h 3086327"/>
              <a:gd name="connsiteX96" fmla="*/ 955563 w 2968627"/>
              <a:gd name="connsiteY96" fmla="*/ 2965639 h 3086327"/>
              <a:gd name="connsiteX97" fmla="*/ 1038113 w 2968627"/>
              <a:gd name="connsiteY97" fmla="*/ 2870389 h 3086327"/>
              <a:gd name="connsiteX98" fmla="*/ 1063513 w 2968627"/>
              <a:gd name="connsiteY98" fmla="*/ 2749739 h 3086327"/>
              <a:gd name="connsiteX99" fmla="*/ 1025413 w 2968627"/>
              <a:gd name="connsiteY99" fmla="*/ 2590989 h 3086327"/>
              <a:gd name="connsiteX100" fmla="*/ 961913 w 2968627"/>
              <a:gd name="connsiteY100" fmla="*/ 2552889 h 3086327"/>
              <a:gd name="connsiteX101" fmla="*/ 936513 w 2968627"/>
              <a:gd name="connsiteY101" fmla="*/ 2717989 h 3086327"/>
              <a:gd name="connsiteX102" fmla="*/ 834913 w 2968627"/>
              <a:gd name="connsiteY102" fmla="*/ 2781489 h 3086327"/>
              <a:gd name="connsiteX103" fmla="*/ 904763 w 2968627"/>
              <a:gd name="connsiteY103" fmla="*/ 2724339 h 3086327"/>
              <a:gd name="connsiteX104" fmla="*/ 923813 w 2968627"/>
              <a:gd name="connsiteY104" fmla="*/ 2584639 h 3086327"/>
              <a:gd name="connsiteX105" fmla="*/ 930163 w 2968627"/>
              <a:gd name="connsiteY105" fmla="*/ 2495739 h 3086327"/>
              <a:gd name="connsiteX106" fmla="*/ 904763 w 2968627"/>
              <a:gd name="connsiteY106" fmla="*/ 2381439 h 3086327"/>
              <a:gd name="connsiteX107" fmla="*/ 892063 w 2968627"/>
              <a:gd name="connsiteY107" fmla="*/ 2197289 h 3086327"/>
              <a:gd name="connsiteX108" fmla="*/ 765063 w 2968627"/>
              <a:gd name="connsiteY108" fmla="*/ 1809939 h 3086327"/>
              <a:gd name="connsiteX109" fmla="*/ 834913 w 2968627"/>
              <a:gd name="connsiteY109" fmla="*/ 1524189 h 3086327"/>
              <a:gd name="connsiteX110" fmla="*/ 841263 w 2968627"/>
              <a:gd name="connsiteY110" fmla="*/ 1384489 h 3086327"/>
              <a:gd name="connsiteX111" fmla="*/ 809513 w 2968627"/>
              <a:gd name="connsiteY111" fmla="*/ 1105089 h 3086327"/>
              <a:gd name="connsiteX112" fmla="*/ 663463 w 2968627"/>
              <a:gd name="connsiteY112" fmla="*/ 1047939 h 3086327"/>
              <a:gd name="connsiteX113" fmla="*/ 561863 w 2968627"/>
              <a:gd name="connsiteY113" fmla="*/ 1251139 h 3086327"/>
              <a:gd name="connsiteX114" fmla="*/ 447563 w 2968627"/>
              <a:gd name="connsiteY114" fmla="*/ 1320989 h 3086327"/>
              <a:gd name="connsiteX115" fmla="*/ 460263 w 2968627"/>
              <a:gd name="connsiteY115" fmla="*/ 1454339 h 3086327"/>
              <a:gd name="connsiteX116" fmla="*/ 453913 w 2968627"/>
              <a:gd name="connsiteY116" fmla="*/ 1314639 h 3086327"/>
              <a:gd name="connsiteX117" fmla="*/ 523763 w 2968627"/>
              <a:gd name="connsiteY117" fmla="*/ 1206689 h 3086327"/>
              <a:gd name="connsiteX118" fmla="*/ 536463 w 2968627"/>
              <a:gd name="connsiteY118" fmla="*/ 1124139 h 3086327"/>
              <a:gd name="connsiteX119" fmla="*/ 352313 w 2968627"/>
              <a:gd name="connsiteY119" fmla="*/ 1086039 h 3086327"/>
              <a:gd name="connsiteX120" fmla="*/ 231663 w 2968627"/>
              <a:gd name="connsiteY120" fmla="*/ 1054289 h 3086327"/>
              <a:gd name="connsiteX121" fmla="*/ 136413 w 2968627"/>
              <a:gd name="connsiteY121" fmla="*/ 1213039 h 3086327"/>
              <a:gd name="connsiteX122" fmla="*/ 3063 w 2968627"/>
              <a:gd name="connsiteY122" fmla="*/ 1346389 h 3086327"/>
              <a:gd name="connsiteX123" fmla="*/ 50352 w 2968627"/>
              <a:gd name="connsiteY123" fmla="*/ 1280241 h 3086327"/>
              <a:gd name="connsiteX124" fmla="*/ 136093 w 2968627"/>
              <a:gd name="connsiteY124" fmla="*/ 1190147 h 3086327"/>
              <a:gd name="connsiteX125" fmla="*/ 206263 w 2968627"/>
              <a:gd name="connsiteY125" fmla="*/ 1022539 h 3086327"/>
              <a:gd name="connsiteX126" fmla="*/ 365013 w 2968627"/>
              <a:gd name="connsiteY126" fmla="*/ 1009839 h 3086327"/>
              <a:gd name="connsiteX127" fmla="*/ 244363 w 2968627"/>
              <a:gd name="connsiteY127" fmla="*/ 914589 h 3086327"/>
              <a:gd name="connsiteX128" fmla="*/ 125074 w 2968627"/>
              <a:gd name="connsiteY128" fmla="*/ 825317 h 3086327"/>
              <a:gd name="connsiteX129" fmla="*/ 111013 w 2968627"/>
              <a:gd name="connsiteY129" fmla="*/ 685989 h 3086327"/>
              <a:gd name="connsiteX130" fmla="*/ 151710 w 2968627"/>
              <a:gd name="connsiteY130" fmla="*/ 818307 h 3086327"/>
              <a:gd name="connsiteX131" fmla="*/ 254341 w 2968627"/>
              <a:gd name="connsiteY131" fmla="*/ 889932 h 3086327"/>
              <a:gd name="connsiteX132" fmla="*/ 422163 w 2968627"/>
              <a:gd name="connsiteY132" fmla="*/ 971739 h 3086327"/>
              <a:gd name="connsiteX133" fmla="*/ 549163 w 2968627"/>
              <a:gd name="connsiteY133" fmla="*/ 1041589 h 3086327"/>
              <a:gd name="connsiteX134" fmla="*/ 695213 w 2968627"/>
              <a:gd name="connsiteY134" fmla="*/ 997139 h 3086327"/>
              <a:gd name="connsiteX135" fmla="*/ 841263 w 2968627"/>
              <a:gd name="connsiteY135" fmla="*/ 984439 h 3086327"/>
              <a:gd name="connsiteX136" fmla="*/ 853963 w 2968627"/>
              <a:gd name="connsiteY136" fmla="*/ 825689 h 3086327"/>
              <a:gd name="connsiteX137" fmla="*/ 555513 w 2968627"/>
              <a:gd name="connsiteY137" fmla="*/ 438339 h 3086327"/>
              <a:gd name="connsiteX138" fmla="*/ 707913 w 2968627"/>
              <a:gd name="connsiteY138" fmla="*/ 584389 h 3086327"/>
              <a:gd name="connsiteX139" fmla="*/ 841263 w 2968627"/>
              <a:gd name="connsiteY139" fmla="*/ 724089 h 3086327"/>
              <a:gd name="connsiteX140" fmla="*/ 923813 w 2968627"/>
              <a:gd name="connsiteY140" fmla="*/ 743139 h 3086327"/>
              <a:gd name="connsiteX0" fmla="*/ 923813 w 2968627"/>
              <a:gd name="connsiteY0" fmla="*/ 743139 h 3086327"/>
              <a:gd name="connsiteX1" fmla="*/ 1171463 w 2968627"/>
              <a:gd name="connsiteY1" fmla="*/ 774889 h 3086327"/>
              <a:gd name="connsiteX2" fmla="*/ 1273063 w 2968627"/>
              <a:gd name="connsiteY2" fmla="*/ 501839 h 3086327"/>
              <a:gd name="connsiteX3" fmla="*/ 1184163 w 2968627"/>
              <a:gd name="connsiteY3" fmla="*/ 285939 h 3086327"/>
              <a:gd name="connsiteX4" fmla="*/ 860313 w 2968627"/>
              <a:gd name="connsiteY4" fmla="*/ 158939 h 3086327"/>
              <a:gd name="connsiteX5" fmla="*/ 784113 w 2968627"/>
              <a:gd name="connsiteY5" fmla="*/ 189 h 3086327"/>
              <a:gd name="connsiteX6" fmla="*/ 847613 w 2968627"/>
              <a:gd name="connsiteY6" fmla="*/ 127189 h 3086327"/>
              <a:gd name="connsiteX7" fmla="*/ 936513 w 2968627"/>
              <a:gd name="connsiteY7" fmla="*/ 152589 h 3086327"/>
              <a:gd name="connsiteX8" fmla="*/ 1107963 w 2968627"/>
              <a:gd name="connsiteY8" fmla="*/ 209739 h 3086327"/>
              <a:gd name="connsiteX9" fmla="*/ 1228613 w 2968627"/>
              <a:gd name="connsiteY9" fmla="*/ 209739 h 3086327"/>
              <a:gd name="connsiteX10" fmla="*/ 1165113 w 2968627"/>
              <a:gd name="connsiteY10" fmla="*/ 63689 h 3086327"/>
              <a:gd name="connsiteX11" fmla="*/ 1171463 w 2968627"/>
              <a:gd name="connsiteY11" fmla="*/ 19239 h 3086327"/>
              <a:gd name="connsiteX12" fmla="*/ 1254013 w 2968627"/>
              <a:gd name="connsiteY12" fmla="*/ 171639 h 3086327"/>
              <a:gd name="connsiteX13" fmla="*/ 1298463 w 2968627"/>
              <a:gd name="connsiteY13" fmla="*/ 241489 h 3086327"/>
              <a:gd name="connsiteX14" fmla="*/ 1292113 w 2968627"/>
              <a:gd name="connsiteY14" fmla="*/ 355789 h 3086327"/>
              <a:gd name="connsiteX15" fmla="*/ 1298463 w 2968627"/>
              <a:gd name="connsiteY15" fmla="*/ 533589 h 3086327"/>
              <a:gd name="connsiteX16" fmla="*/ 1273063 w 2968627"/>
              <a:gd name="connsiteY16" fmla="*/ 698689 h 3086327"/>
              <a:gd name="connsiteX17" fmla="*/ 1431813 w 2968627"/>
              <a:gd name="connsiteY17" fmla="*/ 774889 h 3086327"/>
              <a:gd name="connsiteX18" fmla="*/ 1615963 w 2968627"/>
              <a:gd name="connsiteY18" fmla="*/ 635189 h 3086327"/>
              <a:gd name="connsiteX19" fmla="*/ 1615963 w 2968627"/>
              <a:gd name="connsiteY19" fmla="*/ 419289 h 3086327"/>
              <a:gd name="connsiteX20" fmla="*/ 1546113 w 2968627"/>
              <a:gd name="connsiteY20" fmla="*/ 292289 h 3086327"/>
              <a:gd name="connsiteX21" fmla="*/ 1603263 w 2968627"/>
              <a:gd name="connsiteY21" fmla="*/ 336739 h 3086327"/>
              <a:gd name="connsiteX22" fmla="*/ 1666763 w 2968627"/>
              <a:gd name="connsiteY22" fmla="*/ 501839 h 3086327"/>
              <a:gd name="connsiteX23" fmla="*/ 1654063 w 2968627"/>
              <a:gd name="connsiteY23" fmla="*/ 660589 h 3086327"/>
              <a:gd name="connsiteX24" fmla="*/ 1609613 w 2968627"/>
              <a:gd name="connsiteY24" fmla="*/ 736789 h 3086327"/>
              <a:gd name="connsiteX25" fmla="*/ 1704863 w 2968627"/>
              <a:gd name="connsiteY25" fmla="*/ 571689 h 3086327"/>
              <a:gd name="connsiteX26" fmla="*/ 1800113 w 2968627"/>
              <a:gd name="connsiteY26" fmla="*/ 438339 h 3086327"/>
              <a:gd name="connsiteX27" fmla="*/ 1717563 w 2968627"/>
              <a:gd name="connsiteY27" fmla="*/ 584389 h 3086327"/>
              <a:gd name="connsiteX28" fmla="*/ 1641363 w 2968627"/>
              <a:gd name="connsiteY28" fmla="*/ 730439 h 3086327"/>
              <a:gd name="connsiteX29" fmla="*/ 1520713 w 2968627"/>
              <a:gd name="connsiteY29" fmla="*/ 806639 h 3086327"/>
              <a:gd name="connsiteX30" fmla="*/ 1444513 w 2968627"/>
              <a:gd name="connsiteY30" fmla="*/ 1136839 h 3086327"/>
              <a:gd name="connsiteX31" fmla="*/ 1635013 w 2968627"/>
              <a:gd name="connsiteY31" fmla="*/ 1301939 h 3086327"/>
              <a:gd name="connsiteX32" fmla="*/ 1844563 w 2968627"/>
              <a:gd name="connsiteY32" fmla="*/ 1301939 h 3086327"/>
              <a:gd name="connsiteX33" fmla="*/ 2117613 w 2968627"/>
              <a:gd name="connsiteY33" fmla="*/ 1308289 h 3086327"/>
              <a:gd name="connsiteX34" fmla="*/ 2162063 w 2968627"/>
              <a:gd name="connsiteY34" fmla="*/ 1124139 h 3086327"/>
              <a:gd name="connsiteX35" fmla="*/ 2079513 w 2968627"/>
              <a:gd name="connsiteY35" fmla="*/ 939989 h 3086327"/>
              <a:gd name="connsiteX36" fmla="*/ 2181113 w 2968627"/>
              <a:gd name="connsiteY36" fmla="*/ 1098739 h 3086327"/>
              <a:gd name="connsiteX37" fmla="*/ 2206513 w 2968627"/>
              <a:gd name="connsiteY37" fmla="*/ 1232089 h 3086327"/>
              <a:gd name="connsiteX38" fmla="*/ 2282713 w 2968627"/>
              <a:gd name="connsiteY38" fmla="*/ 800289 h 3086327"/>
              <a:gd name="connsiteX39" fmla="*/ 2371613 w 2968627"/>
              <a:gd name="connsiteY39" fmla="*/ 711389 h 3086327"/>
              <a:gd name="connsiteX40" fmla="*/ 2301763 w 2968627"/>
              <a:gd name="connsiteY40" fmla="*/ 793939 h 3086327"/>
              <a:gd name="connsiteX41" fmla="*/ 2282713 w 2968627"/>
              <a:gd name="connsiteY41" fmla="*/ 959039 h 3086327"/>
              <a:gd name="connsiteX42" fmla="*/ 2270013 w 2968627"/>
              <a:gd name="connsiteY42" fmla="*/ 1155889 h 3086327"/>
              <a:gd name="connsiteX43" fmla="*/ 2276363 w 2968627"/>
              <a:gd name="connsiteY43" fmla="*/ 1270189 h 3086327"/>
              <a:gd name="connsiteX44" fmla="*/ 2282713 w 2968627"/>
              <a:gd name="connsiteY44" fmla="*/ 1301939 h 3086327"/>
              <a:gd name="connsiteX45" fmla="*/ 2371613 w 2968627"/>
              <a:gd name="connsiteY45" fmla="*/ 1346389 h 3086327"/>
              <a:gd name="connsiteX46" fmla="*/ 2498613 w 2968627"/>
              <a:gd name="connsiteY46" fmla="*/ 1320989 h 3086327"/>
              <a:gd name="connsiteX47" fmla="*/ 2739913 w 2968627"/>
              <a:gd name="connsiteY47" fmla="*/ 1308289 h 3086327"/>
              <a:gd name="connsiteX48" fmla="*/ 2905013 w 2968627"/>
              <a:gd name="connsiteY48" fmla="*/ 1371789 h 3086327"/>
              <a:gd name="connsiteX49" fmla="*/ 2968513 w 2968627"/>
              <a:gd name="connsiteY49" fmla="*/ 1498789 h 3086327"/>
              <a:gd name="connsiteX50" fmla="*/ 2892313 w 2968627"/>
              <a:gd name="connsiteY50" fmla="*/ 1409889 h 3086327"/>
              <a:gd name="connsiteX51" fmla="*/ 2689113 w 2968627"/>
              <a:gd name="connsiteY51" fmla="*/ 1340039 h 3086327"/>
              <a:gd name="connsiteX52" fmla="*/ 2511313 w 2968627"/>
              <a:gd name="connsiteY52" fmla="*/ 1378139 h 3086327"/>
              <a:gd name="connsiteX53" fmla="*/ 2543063 w 2968627"/>
              <a:gd name="connsiteY53" fmla="*/ 1498789 h 3086327"/>
              <a:gd name="connsiteX54" fmla="*/ 2581163 w 2968627"/>
              <a:gd name="connsiteY54" fmla="*/ 1536889 h 3086327"/>
              <a:gd name="connsiteX55" fmla="*/ 2708163 w 2968627"/>
              <a:gd name="connsiteY55" fmla="*/ 1644839 h 3086327"/>
              <a:gd name="connsiteX56" fmla="*/ 2606563 w 2968627"/>
              <a:gd name="connsiteY56" fmla="*/ 1587689 h 3086327"/>
              <a:gd name="connsiteX57" fmla="*/ 2479563 w 2968627"/>
              <a:gd name="connsiteY57" fmla="*/ 1479739 h 3086327"/>
              <a:gd name="connsiteX58" fmla="*/ 2409713 w 2968627"/>
              <a:gd name="connsiteY58" fmla="*/ 1378139 h 3086327"/>
              <a:gd name="connsiteX59" fmla="*/ 2282713 w 2968627"/>
              <a:gd name="connsiteY59" fmla="*/ 1359089 h 3086327"/>
              <a:gd name="connsiteX60" fmla="*/ 2143013 w 2968627"/>
              <a:gd name="connsiteY60" fmla="*/ 1340039 h 3086327"/>
              <a:gd name="connsiteX61" fmla="*/ 1869963 w 2968627"/>
              <a:gd name="connsiteY61" fmla="*/ 1340039 h 3086327"/>
              <a:gd name="connsiteX62" fmla="*/ 1571513 w 2968627"/>
              <a:gd name="connsiteY62" fmla="*/ 1352739 h 3086327"/>
              <a:gd name="connsiteX63" fmla="*/ 1374663 w 2968627"/>
              <a:gd name="connsiteY63" fmla="*/ 1251139 h 3086327"/>
              <a:gd name="connsiteX64" fmla="*/ 1196863 w 2968627"/>
              <a:gd name="connsiteY64" fmla="*/ 1206689 h 3086327"/>
              <a:gd name="connsiteX65" fmla="*/ 968263 w 2968627"/>
              <a:gd name="connsiteY65" fmla="*/ 1282889 h 3086327"/>
              <a:gd name="connsiteX66" fmla="*/ 942863 w 2968627"/>
              <a:gd name="connsiteY66" fmla="*/ 1447989 h 3086327"/>
              <a:gd name="connsiteX67" fmla="*/ 911113 w 2968627"/>
              <a:gd name="connsiteY67" fmla="*/ 1568639 h 3086327"/>
              <a:gd name="connsiteX68" fmla="*/ 898413 w 2968627"/>
              <a:gd name="connsiteY68" fmla="*/ 1714689 h 3086327"/>
              <a:gd name="connsiteX69" fmla="*/ 1000013 w 2968627"/>
              <a:gd name="connsiteY69" fmla="*/ 1879789 h 3086327"/>
              <a:gd name="connsiteX70" fmla="*/ 942863 w 2968627"/>
              <a:gd name="connsiteY70" fmla="*/ 1835339 h 3086327"/>
              <a:gd name="connsiteX71" fmla="*/ 926988 w 2968627"/>
              <a:gd name="connsiteY71" fmla="*/ 1898839 h 3086327"/>
              <a:gd name="connsiteX72" fmla="*/ 949213 w 2968627"/>
              <a:gd name="connsiteY72" fmla="*/ 2051239 h 3086327"/>
              <a:gd name="connsiteX73" fmla="*/ 949213 w 2968627"/>
              <a:gd name="connsiteY73" fmla="*/ 2121089 h 3086327"/>
              <a:gd name="connsiteX74" fmla="*/ 911113 w 2968627"/>
              <a:gd name="connsiteY74" fmla="*/ 1987739 h 3086327"/>
              <a:gd name="connsiteX75" fmla="*/ 866663 w 2968627"/>
              <a:gd name="connsiteY75" fmla="*/ 1803589 h 3086327"/>
              <a:gd name="connsiteX76" fmla="*/ 860313 w 2968627"/>
              <a:gd name="connsiteY76" fmla="*/ 1746439 h 3086327"/>
              <a:gd name="connsiteX77" fmla="*/ 873013 w 2968627"/>
              <a:gd name="connsiteY77" fmla="*/ 2025839 h 3086327"/>
              <a:gd name="connsiteX78" fmla="*/ 993663 w 2968627"/>
              <a:gd name="connsiteY78" fmla="*/ 2387789 h 3086327"/>
              <a:gd name="connsiteX79" fmla="*/ 1107963 w 2968627"/>
              <a:gd name="connsiteY79" fmla="*/ 2476689 h 3086327"/>
              <a:gd name="connsiteX80" fmla="*/ 1285763 w 2968627"/>
              <a:gd name="connsiteY80" fmla="*/ 2381439 h 3086327"/>
              <a:gd name="connsiteX81" fmla="*/ 1317513 w 2968627"/>
              <a:gd name="connsiteY81" fmla="*/ 2229039 h 3086327"/>
              <a:gd name="connsiteX82" fmla="*/ 1381013 w 2968627"/>
              <a:gd name="connsiteY82" fmla="*/ 2216339 h 3086327"/>
              <a:gd name="connsiteX83" fmla="*/ 1330213 w 2968627"/>
              <a:gd name="connsiteY83" fmla="*/ 2254439 h 3086327"/>
              <a:gd name="connsiteX84" fmla="*/ 1336563 w 2968627"/>
              <a:gd name="connsiteY84" fmla="*/ 2387789 h 3086327"/>
              <a:gd name="connsiteX85" fmla="*/ 1266713 w 2968627"/>
              <a:gd name="connsiteY85" fmla="*/ 2438589 h 3086327"/>
              <a:gd name="connsiteX86" fmla="*/ 1463563 w 2968627"/>
              <a:gd name="connsiteY86" fmla="*/ 2432239 h 3086327"/>
              <a:gd name="connsiteX87" fmla="*/ 1615963 w 2968627"/>
              <a:gd name="connsiteY87" fmla="*/ 2508439 h 3086327"/>
              <a:gd name="connsiteX88" fmla="*/ 1520713 w 2968627"/>
              <a:gd name="connsiteY88" fmla="*/ 2476689 h 3086327"/>
              <a:gd name="connsiteX89" fmla="*/ 1412763 w 2968627"/>
              <a:gd name="connsiteY89" fmla="*/ 2457639 h 3086327"/>
              <a:gd name="connsiteX90" fmla="*/ 1298463 w 2968627"/>
              <a:gd name="connsiteY90" fmla="*/ 2457639 h 3086327"/>
              <a:gd name="connsiteX91" fmla="*/ 1203213 w 2968627"/>
              <a:gd name="connsiteY91" fmla="*/ 2489389 h 3086327"/>
              <a:gd name="connsiteX92" fmla="*/ 1082563 w 2968627"/>
              <a:gd name="connsiteY92" fmla="*/ 2514789 h 3086327"/>
              <a:gd name="connsiteX93" fmla="*/ 1133363 w 2968627"/>
              <a:gd name="connsiteY93" fmla="*/ 2730689 h 3086327"/>
              <a:gd name="connsiteX94" fmla="*/ 1006363 w 2968627"/>
              <a:gd name="connsiteY94" fmla="*/ 2952939 h 3086327"/>
              <a:gd name="connsiteX95" fmla="*/ 841263 w 2968627"/>
              <a:gd name="connsiteY95" fmla="*/ 3086289 h 3086327"/>
              <a:gd name="connsiteX96" fmla="*/ 955563 w 2968627"/>
              <a:gd name="connsiteY96" fmla="*/ 2965639 h 3086327"/>
              <a:gd name="connsiteX97" fmla="*/ 1038113 w 2968627"/>
              <a:gd name="connsiteY97" fmla="*/ 2870389 h 3086327"/>
              <a:gd name="connsiteX98" fmla="*/ 1063513 w 2968627"/>
              <a:gd name="connsiteY98" fmla="*/ 2749739 h 3086327"/>
              <a:gd name="connsiteX99" fmla="*/ 1025413 w 2968627"/>
              <a:gd name="connsiteY99" fmla="*/ 2590989 h 3086327"/>
              <a:gd name="connsiteX100" fmla="*/ 961913 w 2968627"/>
              <a:gd name="connsiteY100" fmla="*/ 2552889 h 3086327"/>
              <a:gd name="connsiteX101" fmla="*/ 936513 w 2968627"/>
              <a:gd name="connsiteY101" fmla="*/ 2717989 h 3086327"/>
              <a:gd name="connsiteX102" fmla="*/ 834913 w 2968627"/>
              <a:gd name="connsiteY102" fmla="*/ 2781489 h 3086327"/>
              <a:gd name="connsiteX103" fmla="*/ 904763 w 2968627"/>
              <a:gd name="connsiteY103" fmla="*/ 2724339 h 3086327"/>
              <a:gd name="connsiteX104" fmla="*/ 923813 w 2968627"/>
              <a:gd name="connsiteY104" fmla="*/ 2584639 h 3086327"/>
              <a:gd name="connsiteX105" fmla="*/ 930163 w 2968627"/>
              <a:gd name="connsiteY105" fmla="*/ 2495739 h 3086327"/>
              <a:gd name="connsiteX106" fmla="*/ 904763 w 2968627"/>
              <a:gd name="connsiteY106" fmla="*/ 2381439 h 3086327"/>
              <a:gd name="connsiteX107" fmla="*/ 892063 w 2968627"/>
              <a:gd name="connsiteY107" fmla="*/ 2197289 h 3086327"/>
              <a:gd name="connsiteX108" fmla="*/ 765063 w 2968627"/>
              <a:gd name="connsiteY108" fmla="*/ 1809939 h 3086327"/>
              <a:gd name="connsiteX109" fmla="*/ 834913 w 2968627"/>
              <a:gd name="connsiteY109" fmla="*/ 1524189 h 3086327"/>
              <a:gd name="connsiteX110" fmla="*/ 841263 w 2968627"/>
              <a:gd name="connsiteY110" fmla="*/ 1384489 h 3086327"/>
              <a:gd name="connsiteX111" fmla="*/ 809513 w 2968627"/>
              <a:gd name="connsiteY111" fmla="*/ 1105089 h 3086327"/>
              <a:gd name="connsiteX112" fmla="*/ 663463 w 2968627"/>
              <a:gd name="connsiteY112" fmla="*/ 1047939 h 3086327"/>
              <a:gd name="connsiteX113" fmla="*/ 561863 w 2968627"/>
              <a:gd name="connsiteY113" fmla="*/ 1251139 h 3086327"/>
              <a:gd name="connsiteX114" fmla="*/ 447563 w 2968627"/>
              <a:gd name="connsiteY114" fmla="*/ 1320989 h 3086327"/>
              <a:gd name="connsiteX115" fmla="*/ 460263 w 2968627"/>
              <a:gd name="connsiteY115" fmla="*/ 1454339 h 3086327"/>
              <a:gd name="connsiteX116" fmla="*/ 453913 w 2968627"/>
              <a:gd name="connsiteY116" fmla="*/ 1314639 h 3086327"/>
              <a:gd name="connsiteX117" fmla="*/ 523763 w 2968627"/>
              <a:gd name="connsiteY117" fmla="*/ 1206689 h 3086327"/>
              <a:gd name="connsiteX118" fmla="*/ 536463 w 2968627"/>
              <a:gd name="connsiteY118" fmla="*/ 1124139 h 3086327"/>
              <a:gd name="connsiteX119" fmla="*/ 352313 w 2968627"/>
              <a:gd name="connsiteY119" fmla="*/ 1086039 h 3086327"/>
              <a:gd name="connsiteX120" fmla="*/ 231663 w 2968627"/>
              <a:gd name="connsiteY120" fmla="*/ 1054289 h 3086327"/>
              <a:gd name="connsiteX121" fmla="*/ 136413 w 2968627"/>
              <a:gd name="connsiteY121" fmla="*/ 1213039 h 3086327"/>
              <a:gd name="connsiteX122" fmla="*/ 3063 w 2968627"/>
              <a:gd name="connsiteY122" fmla="*/ 1346389 h 3086327"/>
              <a:gd name="connsiteX123" fmla="*/ 50352 w 2968627"/>
              <a:gd name="connsiteY123" fmla="*/ 1280241 h 3086327"/>
              <a:gd name="connsiteX124" fmla="*/ 136093 w 2968627"/>
              <a:gd name="connsiteY124" fmla="*/ 1190147 h 3086327"/>
              <a:gd name="connsiteX125" fmla="*/ 206263 w 2968627"/>
              <a:gd name="connsiteY125" fmla="*/ 1022539 h 3086327"/>
              <a:gd name="connsiteX126" fmla="*/ 365013 w 2968627"/>
              <a:gd name="connsiteY126" fmla="*/ 1009839 h 3086327"/>
              <a:gd name="connsiteX127" fmla="*/ 244363 w 2968627"/>
              <a:gd name="connsiteY127" fmla="*/ 914589 h 3086327"/>
              <a:gd name="connsiteX128" fmla="*/ 125074 w 2968627"/>
              <a:gd name="connsiteY128" fmla="*/ 825317 h 3086327"/>
              <a:gd name="connsiteX129" fmla="*/ 111013 w 2968627"/>
              <a:gd name="connsiteY129" fmla="*/ 685989 h 3086327"/>
              <a:gd name="connsiteX130" fmla="*/ 140116 w 2968627"/>
              <a:gd name="connsiteY130" fmla="*/ 821019 h 3086327"/>
              <a:gd name="connsiteX131" fmla="*/ 254341 w 2968627"/>
              <a:gd name="connsiteY131" fmla="*/ 889932 h 3086327"/>
              <a:gd name="connsiteX132" fmla="*/ 422163 w 2968627"/>
              <a:gd name="connsiteY132" fmla="*/ 971739 h 3086327"/>
              <a:gd name="connsiteX133" fmla="*/ 549163 w 2968627"/>
              <a:gd name="connsiteY133" fmla="*/ 1041589 h 3086327"/>
              <a:gd name="connsiteX134" fmla="*/ 695213 w 2968627"/>
              <a:gd name="connsiteY134" fmla="*/ 997139 h 3086327"/>
              <a:gd name="connsiteX135" fmla="*/ 841263 w 2968627"/>
              <a:gd name="connsiteY135" fmla="*/ 984439 h 3086327"/>
              <a:gd name="connsiteX136" fmla="*/ 853963 w 2968627"/>
              <a:gd name="connsiteY136" fmla="*/ 825689 h 3086327"/>
              <a:gd name="connsiteX137" fmla="*/ 555513 w 2968627"/>
              <a:gd name="connsiteY137" fmla="*/ 438339 h 3086327"/>
              <a:gd name="connsiteX138" fmla="*/ 707913 w 2968627"/>
              <a:gd name="connsiteY138" fmla="*/ 584389 h 3086327"/>
              <a:gd name="connsiteX139" fmla="*/ 841263 w 2968627"/>
              <a:gd name="connsiteY139" fmla="*/ 724089 h 3086327"/>
              <a:gd name="connsiteX140" fmla="*/ 923813 w 2968627"/>
              <a:gd name="connsiteY140" fmla="*/ 743139 h 30863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</a:cxnLst>
            <a:rect l="l" t="t" r="r" b="b"/>
            <a:pathLst>
              <a:path w="2968627" h="3086327">
                <a:moveTo>
                  <a:pt x="923813" y="743139"/>
                </a:moveTo>
                <a:cubicBezTo>
                  <a:pt x="978846" y="751606"/>
                  <a:pt x="1113255" y="815106"/>
                  <a:pt x="1171463" y="774889"/>
                </a:cubicBezTo>
                <a:cubicBezTo>
                  <a:pt x="1229671" y="734672"/>
                  <a:pt x="1270946" y="583331"/>
                  <a:pt x="1273063" y="501839"/>
                </a:cubicBezTo>
                <a:cubicBezTo>
                  <a:pt x="1275180" y="420347"/>
                  <a:pt x="1252955" y="343089"/>
                  <a:pt x="1184163" y="285939"/>
                </a:cubicBezTo>
                <a:cubicBezTo>
                  <a:pt x="1115371" y="228789"/>
                  <a:pt x="926988" y="206564"/>
                  <a:pt x="860313" y="158939"/>
                </a:cubicBezTo>
                <a:cubicBezTo>
                  <a:pt x="793638" y="111314"/>
                  <a:pt x="786230" y="5481"/>
                  <a:pt x="784113" y="189"/>
                </a:cubicBezTo>
                <a:cubicBezTo>
                  <a:pt x="781996" y="-5103"/>
                  <a:pt x="822213" y="101789"/>
                  <a:pt x="847613" y="127189"/>
                </a:cubicBezTo>
                <a:cubicBezTo>
                  <a:pt x="873013" y="152589"/>
                  <a:pt x="893121" y="138831"/>
                  <a:pt x="936513" y="152589"/>
                </a:cubicBezTo>
                <a:cubicBezTo>
                  <a:pt x="979905" y="166347"/>
                  <a:pt x="1059280" y="200214"/>
                  <a:pt x="1107963" y="209739"/>
                </a:cubicBezTo>
                <a:cubicBezTo>
                  <a:pt x="1156646" y="219264"/>
                  <a:pt x="1219088" y="234081"/>
                  <a:pt x="1228613" y="209739"/>
                </a:cubicBezTo>
                <a:cubicBezTo>
                  <a:pt x="1238138" y="185397"/>
                  <a:pt x="1174638" y="95439"/>
                  <a:pt x="1165113" y="63689"/>
                </a:cubicBezTo>
                <a:cubicBezTo>
                  <a:pt x="1155588" y="31939"/>
                  <a:pt x="1156646" y="1247"/>
                  <a:pt x="1171463" y="19239"/>
                </a:cubicBezTo>
                <a:cubicBezTo>
                  <a:pt x="1186280" y="37231"/>
                  <a:pt x="1232846" y="134597"/>
                  <a:pt x="1254013" y="171639"/>
                </a:cubicBezTo>
                <a:cubicBezTo>
                  <a:pt x="1275180" y="208681"/>
                  <a:pt x="1292113" y="210797"/>
                  <a:pt x="1298463" y="241489"/>
                </a:cubicBezTo>
                <a:cubicBezTo>
                  <a:pt x="1304813" y="272181"/>
                  <a:pt x="1292113" y="307106"/>
                  <a:pt x="1292113" y="355789"/>
                </a:cubicBezTo>
                <a:cubicBezTo>
                  <a:pt x="1292113" y="404472"/>
                  <a:pt x="1301638" y="476439"/>
                  <a:pt x="1298463" y="533589"/>
                </a:cubicBezTo>
                <a:cubicBezTo>
                  <a:pt x="1295288" y="590739"/>
                  <a:pt x="1250838" y="658472"/>
                  <a:pt x="1273063" y="698689"/>
                </a:cubicBezTo>
                <a:cubicBezTo>
                  <a:pt x="1295288" y="738906"/>
                  <a:pt x="1374663" y="785472"/>
                  <a:pt x="1431813" y="774889"/>
                </a:cubicBezTo>
                <a:cubicBezTo>
                  <a:pt x="1488963" y="764306"/>
                  <a:pt x="1585271" y="694456"/>
                  <a:pt x="1615963" y="635189"/>
                </a:cubicBezTo>
                <a:cubicBezTo>
                  <a:pt x="1646655" y="575922"/>
                  <a:pt x="1627605" y="476439"/>
                  <a:pt x="1615963" y="419289"/>
                </a:cubicBezTo>
                <a:cubicBezTo>
                  <a:pt x="1604321" y="362139"/>
                  <a:pt x="1548230" y="306047"/>
                  <a:pt x="1546113" y="292289"/>
                </a:cubicBezTo>
                <a:cubicBezTo>
                  <a:pt x="1543996" y="278531"/>
                  <a:pt x="1583155" y="301814"/>
                  <a:pt x="1603263" y="336739"/>
                </a:cubicBezTo>
                <a:cubicBezTo>
                  <a:pt x="1623371" y="371664"/>
                  <a:pt x="1658296" y="447864"/>
                  <a:pt x="1666763" y="501839"/>
                </a:cubicBezTo>
                <a:cubicBezTo>
                  <a:pt x="1675230" y="555814"/>
                  <a:pt x="1663588" y="621431"/>
                  <a:pt x="1654063" y="660589"/>
                </a:cubicBezTo>
                <a:cubicBezTo>
                  <a:pt x="1644538" y="699747"/>
                  <a:pt x="1601146" y="751606"/>
                  <a:pt x="1609613" y="736789"/>
                </a:cubicBezTo>
                <a:cubicBezTo>
                  <a:pt x="1618080" y="721972"/>
                  <a:pt x="1673113" y="621431"/>
                  <a:pt x="1704863" y="571689"/>
                </a:cubicBezTo>
                <a:cubicBezTo>
                  <a:pt x="1736613" y="521947"/>
                  <a:pt x="1797996" y="436222"/>
                  <a:pt x="1800113" y="438339"/>
                </a:cubicBezTo>
                <a:cubicBezTo>
                  <a:pt x="1802230" y="440456"/>
                  <a:pt x="1744021" y="535706"/>
                  <a:pt x="1717563" y="584389"/>
                </a:cubicBezTo>
                <a:cubicBezTo>
                  <a:pt x="1691105" y="633072"/>
                  <a:pt x="1674171" y="693397"/>
                  <a:pt x="1641363" y="730439"/>
                </a:cubicBezTo>
                <a:cubicBezTo>
                  <a:pt x="1608555" y="767481"/>
                  <a:pt x="1553521" y="738906"/>
                  <a:pt x="1520713" y="806639"/>
                </a:cubicBezTo>
                <a:cubicBezTo>
                  <a:pt x="1487905" y="874372"/>
                  <a:pt x="1425463" y="1054289"/>
                  <a:pt x="1444513" y="1136839"/>
                </a:cubicBezTo>
                <a:cubicBezTo>
                  <a:pt x="1463563" y="1219389"/>
                  <a:pt x="1568338" y="1274422"/>
                  <a:pt x="1635013" y="1301939"/>
                </a:cubicBezTo>
                <a:cubicBezTo>
                  <a:pt x="1701688" y="1329456"/>
                  <a:pt x="1764130" y="1300881"/>
                  <a:pt x="1844563" y="1301939"/>
                </a:cubicBezTo>
                <a:cubicBezTo>
                  <a:pt x="1924996" y="1302997"/>
                  <a:pt x="2064696" y="1337922"/>
                  <a:pt x="2117613" y="1308289"/>
                </a:cubicBezTo>
                <a:cubicBezTo>
                  <a:pt x="2170530" y="1278656"/>
                  <a:pt x="2168413" y="1185522"/>
                  <a:pt x="2162063" y="1124139"/>
                </a:cubicBezTo>
                <a:cubicBezTo>
                  <a:pt x="2155713" y="1062756"/>
                  <a:pt x="2076338" y="944222"/>
                  <a:pt x="2079513" y="939989"/>
                </a:cubicBezTo>
                <a:cubicBezTo>
                  <a:pt x="2082688" y="935756"/>
                  <a:pt x="2159946" y="1050056"/>
                  <a:pt x="2181113" y="1098739"/>
                </a:cubicBezTo>
                <a:cubicBezTo>
                  <a:pt x="2202280" y="1147422"/>
                  <a:pt x="2189580" y="1281831"/>
                  <a:pt x="2206513" y="1232089"/>
                </a:cubicBezTo>
                <a:cubicBezTo>
                  <a:pt x="2223446" y="1182347"/>
                  <a:pt x="2255196" y="887072"/>
                  <a:pt x="2282713" y="800289"/>
                </a:cubicBezTo>
                <a:cubicBezTo>
                  <a:pt x="2310230" y="713506"/>
                  <a:pt x="2368438" y="712447"/>
                  <a:pt x="2371613" y="711389"/>
                </a:cubicBezTo>
                <a:cubicBezTo>
                  <a:pt x="2374788" y="710331"/>
                  <a:pt x="2316580" y="752664"/>
                  <a:pt x="2301763" y="793939"/>
                </a:cubicBezTo>
                <a:cubicBezTo>
                  <a:pt x="2286946" y="835214"/>
                  <a:pt x="2288005" y="898714"/>
                  <a:pt x="2282713" y="959039"/>
                </a:cubicBezTo>
                <a:cubicBezTo>
                  <a:pt x="2277421" y="1019364"/>
                  <a:pt x="2271071" y="1104031"/>
                  <a:pt x="2270013" y="1155889"/>
                </a:cubicBezTo>
                <a:cubicBezTo>
                  <a:pt x="2268955" y="1207747"/>
                  <a:pt x="2274246" y="1245847"/>
                  <a:pt x="2276363" y="1270189"/>
                </a:cubicBezTo>
                <a:cubicBezTo>
                  <a:pt x="2278480" y="1294531"/>
                  <a:pt x="2266838" y="1289239"/>
                  <a:pt x="2282713" y="1301939"/>
                </a:cubicBezTo>
                <a:cubicBezTo>
                  <a:pt x="2298588" y="1314639"/>
                  <a:pt x="2335630" y="1343214"/>
                  <a:pt x="2371613" y="1346389"/>
                </a:cubicBezTo>
                <a:cubicBezTo>
                  <a:pt x="2407596" y="1349564"/>
                  <a:pt x="2437230" y="1327339"/>
                  <a:pt x="2498613" y="1320989"/>
                </a:cubicBezTo>
                <a:cubicBezTo>
                  <a:pt x="2559996" y="1314639"/>
                  <a:pt x="2672180" y="1299822"/>
                  <a:pt x="2739913" y="1308289"/>
                </a:cubicBezTo>
                <a:cubicBezTo>
                  <a:pt x="2807646" y="1316756"/>
                  <a:pt x="2866913" y="1340039"/>
                  <a:pt x="2905013" y="1371789"/>
                </a:cubicBezTo>
                <a:cubicBezTo>
                  <a:pt x="2943113" y="1403539"/>
                  <a:pt x="2970630" y="1492439"/>
                  <a:pt x="2968513" y="1498789"/>
                </a:cubicBezTo>
                <a:cubicBezTo>
                  <a:pt x="2966396" y="1505139"/>
                  <a:pt x="2938880" y="1436347"/>
                  <a:pt x="2892313" y="1409889"/>
                </a:cubicBezTo>
                <a:cubicBezTo>
                  <a:pt x="2845746" y="1383431"/>
                  <a:pt x="2752613" y="1345331"/>
                  <a:pt x="2689113" y="1340039"/>
                </a:cubicBezTo>
                <a:cubicBezTo>
                  <a:pt x="2625613" y="1334747"/>
                  <a:pt x="2535655" y="1351681"/>
                  <a:pt x="2511313" y="1378139"/>
                </a:cubicBezTo>
                <a:cubicBezTo>
                  <a:pt x="2486971" y="1404597"/>
                  <a:pt x="2531421" y="1472331"/>
                  <a:pt x="2543063" y="1498789"/>
                </a:cubicBezTo>
                <a:cubicBezTo>
                  <a:pt x="2554705" y="1525247"/>
                  <a:pt x="2553646" y="1512547"/>
                  <a:pt x="2581163" y="1536889"/>
                </a:cubicBezTo>
                <a:cubicBezTo>
                  <a:pt x="2608680" y="1561231"/>
                  <a:pt x="2703930" y="1636372"/>
                  <a:pt x="2708163" y="1644839"/>
                </a:cubicBezTo>
                <a:cubicBezTo>
                  <a:pt x="2712396" y="1653306"/>
                  <a:pt x="2644663" y="1615206"/>
                  <a:pt x="2606563" y="1587689"/>
                </a:cubicBezTo>
                <a:cubicBezTo>
                  <a:pt x="2568463" y="1560172"/>
                  <a:pt x="2512371" y="1514664"/>
                  <a:pt x="2479563" y="1479739"/>
                </a:cubicBezTo>
                <a:cubicBezTo>
                  <a:pt x="2446755" y="1444814"/>
                  <a:pt x="2442521" y="1398247"/>
                  <a:pt x="2409713" y="1378139"/>
                </a:cubicBezTo>
                <a:cubicBezTo>
                  <a:pt x="2376905" y="1358031"/>
                  <a:pt x="2282713" y="1359089"/>
                  <a:pt x="2282713" y="1359089"/>
                </a:cubicBezTo>
                <a:cubicBezTo>
                  <a:pt x="2238263" y="1352739"/>
                  <a:pt x="2211805" y="1343214"/>
                  <a:pt x="2143013" y="1340039"/>
                </a:cubicBezTo>
                <a:cubicBezTo>
                  <a:pt x="2074221" y="1336864"/>
                  <a:pt x="1965213" y="1337922"/>
                  <a:pt x="1869963" y="1340039"/>
                </a:cubicBezTo>
                <a:cubicBezTo>
                  <a:pt x="1774713" y="1342156"/>
                  <a:pt x="1654063" y="1367556"/>
                  <a:pt x="1571513" y="1352739"/>
                </a:cubicBezTo>
                <a:cubicBezTo>
                  <a:pt x="1488963" y="1337922"/>
                  <a:pt x="1437105" y="1275481"/>
                  <a:pt x="1374663" y="1251139"/>
                </a:cubicBezTo>
                <a:cubicBezTo>
                  <a:pt x="1312221" y="1226797"/>
                  <a:pt x="1264596" y="1201397"/>
                  <a:pt x="1196863" y="1206689"/>
                </a:cubicBezTo>
                <a:cubicBezTo>
                  <a:pt x="1129130" y="1211981"/>
                  <a:pt x="1010596" y="1242672"/>
                  <a:pt x="968263" y="1282889"/>
                </a:cubicBezTo>
                <a:cubicBezTo>
                  <a:pt x="925930" y="1323106"/>
                  <a:pt x="952388" y="1400364"/>
                  <a:pt x="942863" y="1447989"/>
                </a:cubicBezTo>
                <a:cubicBezTo>
                  <a:pt x="933338" y="1495614"/>
                  <a:pt x="918521" y="1524189"/>
                  <a:pt x="911113" y="1568639"/>
                </a:cubicBezTo>
                <a:cubicBezTo>
                  <a:pt x="903705" y="1613089"/>
                  <a:pt x="883596" y="1662831"/>
                  <a:pt x="898413" y="1714689"/>
                </a:cubicBezTo>
                <a:cubicBezTo>
                  <a:pt x="913230" y="1766547"/>
                  <a:pt x="992605" y="1859681"/>
                  <a:pt x="1000013" y="1879789"/>
                </a:cubicBezTo>
                <a:cubicBezTo>
                  <a:pt x="1007421" y="1899897"/>
                  <a:pt x="955034" y="1832164"/>
                  <a:pt x="942863" y="1835339"/>
                </a:cubicBezTo>
                <a:cubicBezTo>
                  <a:pt x="930692" y="1838514"/>
                  <a:pt x="925930" y="1862856"/>
                  <a:pt x="926988" y="1898839"/>
                </a:cubicBezTo>
                <a:cubicBezTo>
                  <a:pt x="928046" y="1934822"/>
                  <a:pt x="945509" y="2014197"/>
                  <a:pt x="949213" y="2051239"/>
                </a:cubicBezTo>
                <a:cubicBezTo>
                  <a:pt x="952917" y="2088281"/>
                  <a:pt x="955563" y="2131672"/>
                  <a:pt x="949213" y="2121089"/>
                </a:cubicBezTo>
                <a:cubicBezTo>
                  <a:pt x="942863" y="2110506"/>
                  <a:pt x="924871" y="2040656"/>
                  <a:pt x="911113" y="1987739"/>
                </a:cubicBezTo>
                <a:cubicBezTo>
                  <a:pt x="897355" y="1934822"/>
                  <a:pt x="875130" y="1843805"/>
                  <a:pt x="866663" y="1803589"/>
                </a:cubicBezTo>
                <a:cubicBezTo>
                  <a:pt x="858196" y="1763373"/>
                  <a:pt x="859255" y="1709397"/>
                  <a:pt x="860313" y="1746439"/>
                </a:cubicBezTo>
                <a:cubicBezTo>
                  <a:pt x="861371" y="1783481"/>
                  <a:pt x="850788" y="1918947"/>
                  <a:pt x="873013" y="2025839"/>
                </a:cubicBezTo>
                <a:cubicBezTo>
                  <a:pt x="895238" y="2132731"/>
                  <a:pt x="954505" y="2312647"/>
                  <a:pt x="993663" y="2387789"/>
                </a:cubicBezTo>
                <a:cubicBezTo>
                  <a:pt x="1032821" y="2462931"/>
                  <a:pt x="1059280" y="2477747"/>
                  <a:pt x="1107963" y="2476689"/>
                </a:cubicBezTo>
                <a:cubicBezTo>
                  <a:pt x="1156646" y="2475631"/>
                  <a:pt x="1250838" y="2422714"/>
                  <a:pt x="1285763" y="2381439"/>
                </a:cubicBezTo>
                <a:cubicBezTo>
                  <a:pt x="1320688" y="2340164"/>
                  <a:pt x="1301638" y="2256556"/>
                  <a:pt x="1317513" y="2229039"/>
                </a:cubicBezTo>
                <a:cubicBezTo>
                  <a:pt x="1333388" y="2201522"/>
                  <a:pt x="1378896" y="2212106"/>
                  <a:pt x="1381013" y="2216339"/>
                </a:cubicBezTo>
                <a:cubicBezTo>
                  <a:pt x="1383130" y="2220572"/>
                  <a:pt x="1337621" y="2225864"/>
                  <a:pt x="1330213" y="2254439"/>
                </a:cubicBezTo>
                <a:cubicBezTo>
                  <a:pt x="1322805" y="2283014"/>
                  <a:pt x="1347146" y="2357097"/>
                  <a:pt x="1336563" y="2387789"/>
                </a:cubicBezTo>
                <a:cubicBezTo>
                  <a:pt x="1325980" y="2418481"/>
                  <a:pt x="1245546" y="2431181"/>
                  <a:pt x="1266713" y="2438589"/>
                </a:cubicBezTo>
                <a:cubicBezTo>
                  <a:pt x="1287880" y="2445997"/>
                  <a:pt x="1405355" y="2420597"/>
                  <a:pt x="1463563" y="2432239"/>
                </a:cubicBezTo>
                <a:cubicBezTo>
                  <a:pt x="1521771" y="2443881"/>
                  <a:pt x="1606438" y="2501031"/>
                  <a:pt x="1615963" y="2508439"/>
                </a:cubicBezTo>
                <a:cubicBezTo>
                  <a:pt x="1625488" y="2515847"/>
                  <a:pt x="1554580" y="2485156"/>
                  <a:pt x="1520713" y="2476689"/>
                </a:cubicBezTo>
                <a:cubicBezTo>
                  <a:pt x="1486846" y="2468222"/>
                  <a:pt x="1449805" y="2460814"/>
                  <a:pt x="1412763" y="2457639"/>
                </a:cubicBezTo>
                <a:cubicBezTo>
                  <a:pt x="1375721" y="2454464"/>
                  <a:pt x="1333388" y="2452347"/>
                  <a:pt x="1298463" y="2457639"/>
                </a:cubicBezTo>
                <a:cubicBezTo>
                  <a:pt x="1263538" y="2462931"/>
                  <a:pt x="1239196" y="2479864"/>
                  <a:pt x="1203213" y="2489389"/>
                </a:cubicBezTo>
                <a:cubicBezTo>
                  <a:pt x="1167230" y="2498914"/>
                  <a:pt x="1094205" y="2474572"/>
                  <a:pt x="1082563" y="2514789"/>
                </a:cubicBezTo>
                <a:cubicBezTo>
                  <a:pt x="1070921" y="2555006"/>
                  <a:pt x="1146063" y="2657664"/>
                  <a:pt x="1133363" y="2730689"/>
                </a:cubicBezTo>
                <a:cubicBezTo>
                  <a:pt x="1120663" y="2803714"/>
                  <a:pt x="1055046" y="2893672"/>
                  <a:pt x="1006363" y="2952939"/>
                </a:cubicBezTo>
                <a:cubicBezTo>
                  <a:pt x="957680" y="3012206"/>
                  <a:pt x="849730" y="3084172"/>
                  <a:pt x="841263" y="3086289"/>
                </a:cubicBezTo>
                <a:cubicBezTo>
                  <a:pt x="832796" y="3088406"/>
                  <a:pt x="922755" y="3001622"/>
                  <a:pt x="955563" y="2965639"/>
                </a:cubicBezTo>
                <a:cubicBezTo>
                  <a:pt x="988371" y="2929656"/>
                  <a:pt x="1020121" y="2906372"/>
                  <a:pt x="1038113" y="2870389"/>
                </a:cubicBezTo>
                <a:cubicBezTo>
                  <a:pt x="1056105" y="2834406"/>
                  <a:pt x="1065630" y="2796306"/>
                  <a:pt x="1063513" y="2749739"/>
                </a:cubicBezTo>
                <a:cubicBezTo>
                  <a:pt x="1061396" y="2703172"/>
                  <a:pt x="1042346" y="2623797"/>
                  <a:pt x="1025413" y="2590989"/>
                </a:cubicBezTo>
                <a:cubicBezTo>
                  <a:pt x="1008480" y="2558181"/>
                  <a:pt x="976730" y="2531722"/>
                  <a:pt x="961913" y="2552889"/>
                </a:cubicBezTo>
                <a:cubicBezTo>
                  <a:pt x="947096" y="2574056"/>
                  <a:pt x="957680" y="2679889"/>
                  <a:pt x="936513" y="2717989"/>
                </a:cubicBezTo>
                <a:cubicBezTo>
                  <a:pt x="915346" y="2756089"/>
                  <a:pt x="840204" y="2780431"/>
                  <a:pt x="834913" y="2781489"/>
                </a:cubicBezTo>
                <a:cubicBezTo>
                  <a:pt x="829622" y="2782547"/>
                  <a:pt x="889946" y="2757147"/>
                  <a:pt x="904763" y="2724339"/>
                </a:cubicBezTo>
                <a:cubicBezTo>
                  <a:pt x="919580" y="2691531"/>
                  <a:pt x="919580" y="2622739"/>
                  <a:pt x="923813" y="2584639"/>
                </a:cubicBezTo>
                <a:cubicBezTo>
                  <a:pt x="928046" y="2546539"/>
                  <a:pt x="933338" y="2529606"/>
                  <a:pt x="930163" y="2495739"/>
                </a:cubicBezTo>
                <a:cubicBezTo>
                  <a:pt x="926988" y="2461872"/>
                  <a:pt x="911113" y="2431181"/>
                  <a:pt x="904763" y="2381439"/>
                </a:cubicBezTo>
                <a:cubicBezTo>
                  <a:pt x="898413" y="2331697"/>
                  <a:pt x="915346" y="2292539"/>
                  <a:pt x="892063" y="2197289"/>
                </a:cubicBezTo>
                <a:cubicBezTo>
                  <a:pt x="868780" y="2102039"/>
                  <a:pt x="774588" y="1922122"/>
                  <a:pt x="765063" y="1809939"/>
                </a:cubicBezTo>
                <a:cubicBezTo>
                  <a:pt x="755538" y="1697756"/>
                  <a:pt x="822213" y="1595097"/>
                  <a:pt x="834913" y="1524189"/>
                </a:cubicBezTo>
                <a:cubicBezTo>
                  <a:pt x="847613" y="1453281"/>
                  <a:pt x="845496" y="1454339"/>
                  <a:pt x="841263" y="1384489"/>
                </a:cubicBezTo>
                <a:cubicBezTo>
                  <a:pt x="837030" y="1314639"/>
                  <a:pt x="839146" y="1161181"/>
                  <a:pt x="809513" y="1105089"/>
                </a:cubicBezTo>
                <a:cubicBezTo>
                  <a:pt x="779880" y="1048997"/>
                  <a:pt x="704738" y="1023597"/>
                  <a:pt x="663463" y="1047939"/>
                </a:cubicBezTo>
                <a:cubicBezTo>
                  <a:pt x="622188" y="1072281"/>
                  <a:pt x="597846" y="1205631"/>
                  <a:pt x="561863" y="1251139"/>
                </a:cubicBezTo>
                <a:cubicBezTo>
                  <a:pt x="525880" y="1296647"/>
                  <a:pt x="464496" y="1287122"/>
                  <a:pt x="447563" y="1320989"/>
                </a:cubicBezTo>
                <a:cubicBezTo>
                  <a:pt x="430630" y="1354856"/>
                  <a:pt x="459205" y="1455397"/>
                  <a:pt x="460263" y="1454339"/>
                </a:cubicBezTo>
                <a:cubicBezTo>
                  <a:pt x="461321" y="1453281"/>
                  <a:pt x="443330" y="1355914"/>
                  <a:pt x="453913" y="1314639"/>
                </a:cubicBezTo>
                <a:cubicBezTo>
                  <a:pt x="464496" y="1273364"/>
                  <a:pt x="510005" y="1238439"/>
                  <a:pt x="523763" y="1206689"/>
                </a:cubicBezTo>
                <a:cubicBezTo>
                  <a:pt x="537521" y="1174939"/>
                  <a:pt x="565038" y="1144247"/>
                  <a:pt x="536463" y="1124139"/>
                </a:cubicBezTo>
                <a:cubicBezTo>
                  <a:pt x="507888" y="1104031"/>
                  <a:pt x="403113" y="1097681"/>
                  <a:pt x="352313" y="1086039"/>
                </a:cubicBezTo>
                <a:cubicBezTo>
                  <a:pt x="301513" y="1074397"/>
                  <a:pt x="267646" y="1033122"/>
                  <a:pt x="231663" y="1054289"/>
                </a:cubicBezTo>
                <a:cubicBezTo>
                  <a:pt x="195680" y="1075456"/>
                  <a:pt x="174513" y="1164356"/>
                  <a:pt x="136413" y="1213039"/>
                </a:cubicBezTo>
                <a:cubicBezTo>
                  <a:pt x="98313" y="1261722"/>
                  <a:pt x="17407" y="1335189"/>
                  <a:pt x="3063" y="1346389"/>
                </a:cubicBezTo>
                <a:cubicBezTo>
                  <a:pt x="-11281" y="1357589"/>
                  <a:pt x="28180" y="1306281"/>
                  <a:pt x="50352" y="1280241"/>
                </a:cubicBezTo>
                <a:cubicBezTo>
                  <a:pt x="72524" y="1254201"/>
                  <a:pt x="110108" y="1233097"/>
                  <a:pt x="136093" y="1190147"/>
                </a:cubicBezTo>
                <a:cubicBezTo>
                  <a:pt x="162078" y="1147197"/>
                  <a:pt x="168110" y="1052590"/>
                  <a:pt x="206263" y="1022539"/>
                </a:cubicBezTo>
                <a:cubicBezTo>
                  <a:pt x="244416" y="992488"/>
                  <a:pt x="358663" y="1027831"/>
                  <a:pt x="365013" y="1009839"/>
                </a:cubicBezTo>
                <a:cubicBezTo>
                  <a:pt x="371363" y="991847"/>
                  <a:pt x="284353" y="945343"/>
                  <a:pt x="244363" y="914589"/>
                </a:cubicBezTo>
                <a:cubicBezTo>
                  <a:pt x="204373" y="883835"/>
                  <a:pt x="147299" y="863417"/>
                  <a:pt x="125074" y="825317"/>
                </a:cubicBezTo>
                <a:cubicBezTo>
                  <a:pt x="102849" y="787217"/>
                  <a:pt x="108506" y="686705"/>
                  <a:pt x="111013" y="685989"/>
                </a:cubicBezTo>
                <a:cubicBezTo>
                  <a:pt x="113520" y="685273"/>
                  <a:pt x="116228" y="787029"/>
                  <a:pt x="140116" y="821019"/>
                </a:cubicBezTo>
                <a:cubicBezTo>
                  <a:pt x="164004" y="855010"/>
                  <a:pt x="207333" y="864812"/>
                  <a:pt x="254341" y="889932"/>
                </a:cubicBezTo>
                <a:cubicBezTo>
                  <a:pt x="301349" y="915052"/>
                  <a:pt x="373026" y="946463"/>
                  <a:pt x="422163" y="971739"/>
                </a:cubicBezTo>
                <a:cubicBezTo>
                  <a:pt x="471300" y="997015"/>
                  <a:pt x="503655" y="1037356"/>
                  <a:pt x="549163" y="1041589"/>
                </a:cubicBezTo>
                <a:cubicBezTo>
                  <a:pt x="594671" y="1045822"/>
                  <a:pt x="646530" y="1006664"/>
                  <a:pt x="695213" y="997139"/>
                </a:cubicBezTo>
                <a:cubicBezTo>
                  <a:pt x="743896" y="987614"/>
                  <a:pt x="814805" y="1013014"/>
                  <a:pt x="841263" y="984439"/>
                </a:cubicBezTo>
                <a:cubicBezTo>
                  <a:pt x="867721" y="955864"/>
                  <a:pt x="901588" y="916706"/>
                  <a:pt x="853963" y="825689"/>
                </a:cubicBezTo>
                <a:cubicBezTo>
                  <a:pt x="806338" y="734672"/>
                  <a:pt x="579855" y="478556"/>
                  <a:pt x="555513" y="438339"/>
                </a:cubicBezTo>
                <a:cubicBezTo>
                  <a:pt x="531171" y="398122"/>
                  <a:pt x="660288" y="536764"/>
                  <a:pt x="707913" y="584389"/>
                </a:cubicBezTo>
                <a:cubicBezTo>
                  <a:pt x="755538" y="632014"/>
                  <a:pt x="803163" y="697631"/>
                  <a:pt x="841263" y="724089"/>
                </a:cubicBezTo>
                <a:cubicBezTo>
                  <a:pt x="879363" y="750547"/>
                  <a:pt x="868780" y="734672"/>
                  <a:pt x="923813" y="743139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任意多边形: 形状 9">
            <a:extLst>
              <a:ext uri="{FF2B5EF4-FFF2-40B4-BE49-F238E27FC236}">
                <a16:creationId xmlns:a16="http://schemas.microsoft.com/office/drawing/2014/main" id="{0647D1B8-6A9B-46B1-B460-76086916D79E}"/>
              </a:ext>
            </a:extLst>
          </p:cNvPr>
          <p:cNvSpPr/>
          <p:nvPr/>
        </p:nvSpPr>
        <p:spPr>
          <a:xfrm>
            <a:off x="3395967" y="9402645"/>
            <a:ext cx="771315" cy="738649"/>
          </a:xfrm>
          <a:custGeom>
            <a:avLst/>
            <a:gdLst>
              <a:gd name="connsiteX0" fmla="*/ 12831 w 1281989"/>
              <a:gd name="connsiteY0" fmla="*/ 514559 h 1232334"/>
              <a:gd name="connsiteX1" fmla="*/ 229141 w 1281989"/>
              <a:gd name="connsiteY1" fmla="*/ 445734 h 1232334"/>
              <a:gd name="connsiteX2" fmla="*/ 347128 w 1281989"/>
              <a:gd name="connsiteY2" fmla="*/ 278585 h 1232334"/>
              <a:gd name="connsiteX3" fmla="*/ 327463 w 1281989"/>
              <a:gd name="connsiteY3" fmla="*/ 160598 h 1232334"/>
              <a:gd name="connsiteX4" fmla="*/ 386457 w 1281989"/>
              <a:gd name="connsiteY4" fmla="*/ 258921 h 1232334"/>
              <a:gd name="connsiteX5" fmla="*/ 337295 w 1281989"/>
              <a:gd name="connsiteY5" fmla="*/ 386740 h 1232334"/>
              <a:gd name="connsiteX6" fmla="*/ 288134 w 1281989"/>
              <a:gd name="connsiteY6" fmla="*/ 455566 h 1232334"/>
              <a:gd name="connsiteX7" fmla="*/ 406121 w 1281989"/>
              <a:gd name="connsiteY7" fmla="*/ 475230 h 1232334"/>
              <a:gd name="connsiteX8" fmla="*/ 592934 w 1281989"/>
              <a:gd name="connsiteY8" fmla="*/ 327746 h 1232334"/>
              <a:gd name="connsiteX9" fmla="*/ 730586 w 1281989"/>
              <a:gd name="connsiteY9" fmla="*/ 22946 h 1232334"/>
              <a:gd name="connsiteX10" fmla="*/ 976392 w 1281989"/>
              <a:gd name="connsiteY10" fmla="*/ 22946 h 1232334"/>
              <a:gd name="connsiteX11" fmla="*/ 799412 w 1281989"/>
              <a:gd name="connsiteY11" fmla="*/ 32779 h 1232334"/>
              <a:gd name="connsiteX12" fmla="*/ 671592 w 1281989"/>
              <a:gd name="connsiteY12" fmla="*/ 239256 h 1232334"/>
              <a:gd name="connsiteX13" fmla="*/ 553605 w 1281989"/>
              <a:gd name="connsiteY13" fmla="*/ 465398 h 1232334"/>
              <a:gd name="connsiteX14" fmla="*/ 288134 w 1281989"/>
              <a:gd name="connsiteY14" fmla="*/ 504727 h 1232334"/>
              <a:gd name="connsiteX15" fmla="*/ 288134 w 1281989"/>
              <a:gd name="connsiteY15" fmla="*/ 524392 h 1232334"/>
              <a:gd name="connsiteX16" fmla="*/ 691257 w 1281989"/>
              <a:gd name="connsiteY16" fmla="*/ 544056 h 1232334"/>
              <a:gd name="connsiteX17" fmla="*/ 1025553 w 1281989"/>
              <a:gd name="connsiteY17" fmla="*/ 681708 h 1232334"/>
              <a:gd name="connsiteX18" fmla="*/ 1281192 w 1281989"/>
              <a:gd name="connsiteY18" fmla="*/ 593217 h 1232334"/>
              <a:gd name="connsiteX19" fmla="*/ 1094379 w 1281989"/>
              <a:gd name="connsiteY19" fmla="*/ 711205 h 1232334"/>
              <a:gd name="connsiteX20" fmla="*/ 779747 w 1281989"/>
              <a:gd name="connsiteY20" fmla="*/ 652211 h 1232334"/>
              <a:gd name="connsiteX21" fmla="*/ 671592 w 1281989"/>
              <a:gd name="connsiteY21" fmla="*/ 603050 h 1232334"/>
              <a:gd name="connsiteX22" fmla="*/ 671592 w 1281989"/>
              <a:gd name="connsiteY22" fmla="*/ 691540 h 1232334"/>
              <a:gd name="connsiteX23" fmla="*/ 838741 w 1281989"/>
              <a:gd name="connsiteY23" fmla="*/ 750534 h 1232334"/>
              <a:gd name="connsiteX24" fmla="*/ 937063 w 1281989"/>
              <a:gd name="connsiteY24" fmla="*/ 888185 h 1232334"/>
              <a:gd name="connsiteX25" fmla="*/ 1015721 w 1281989"/>
              <a:gd name="connsiteY25" fmla="*/ 1006172 h 1232334"/>
              <a:gd name="connsiteX26" fmla="*/ 878070 w 1281989"/>
              <a:gd name="connsiteY26" fmla="*/ 868521 h 1232334"/>
              <a:gd name="connsiteX27" fmla="*/ 828908 w 1281989"/>
              <a:gd name="connsiteY27" fmla="*/ 770198 h 1232334"/>
              <a:gd name="connsiteX28" fmla="*/ 651928 w 1281989"/>
              <a:gd name="connsiteY28" fmla="*/ 711205 h 1232334"/>
              <a:gd name="connsiteX29" fmla="*/ 602766 w 1281989"/>
              <a:gd name="connsiteY29" fmla="*/ 622714 h 1232334"/>
              <a:gd name="connsiteX30" fmla="*/ 386457 w 1281989"/>
              <a:gd name="connsiteY30" fmla="*/ 583385 h 1232334"/>
              <a:gd name="connsiteX31" fmla="*/ 642095 w 1281989"/>
              <a:gd name="connsiteY31" fmla="*/ 878353 h 1232334"/>
              <a:gd name="connsiteX32" fmla="*/ 760082 w 1281989"/>
              <a:gd name="connsiteY32" fmla="*/ 1183153 h 1232334"/>
              <a:gd name="connsiteX33" fmla="*/ 642095 w 1281989"/>
              <a:gd name="connsiteY33" fmla="*/ 937346 h 1232334"/>
              <a:gd name="connsiteX34" fmla="*/ 533941 w 1281989"/>
              <a:gd name="connsiteY34" fmla="*/ 799695 h 1232334"/>
              <a:gd name="connsiteX35" fmla="*/ 396289 w 1281989"/>
              <a:gd name="connsiteY35" fmla="*/ 671875 h 1232334"/>
              <a:gd name="connsiteX36" fmla="*/ 268470 w 1281989"/>
              <a:gd name="connsiteY36" fmla="*/ 593217 h 1232334"/>
              <a:gd name="connsiteX37" fmla="*/ 101321 w 1281989"/>
              <a:gd name="connsiteY37" fmla="*/ 593217 h 1232334"/>
              <a:gd name="connsiteX38" fmla="*/ 179979 w 1281989"/>
              <a:gd name="connsiteY38" fmla="*/ 799695 h 1232334"/>
              <a:gd name="connsiteX39" fmla="*/ 435618 w 1281989"/>
              <a:gd name="connsiteY39" fmla="*/ 957011 h 1232334"/>
              <a:gd name="connsiteX40" fmla="*/ 494612 w 1281989"/>
              <a:gd name="connsiteY40" fmla="*/ 1016005 h 1232334"/>
              <a:gd name="connsiteX41" fmla="*/ 258637 w 1281989"/>
              <a:gd name="connsiteY41" fmla="*/ 888185 h 1232334"/>
              <a:gd name="connsiteX42" fmla="*/ 219308 w 1281989"/>
              <a:gd name="connsiteY42" fmla="*/ 907850 h 1232334"/>
              <a:gd name="connsiteX43" fmla="*/ 356960 w 1281989"/>
              <a:gd name="connsiteY43" fmla="*/ 1084830 h 1232334"/>
              <a:gd name="connsiteX44" fmla="*/ 602766 w 1281989"/>
              <a:gd name="connsiteY44" fmla="*/ 1232314 h 1232334"/>
              <a:gd name="connsiteX45" fmla="*/ 268470 w 1281989"/>
              <a:gd name="connsiteY45" fmla="*/ 1074998 h 1232334"/>
              <a:gd name="connsiteX46" fmla="*/ 209476 w 1281989"/>
              <a:gd name="connsiteY46" fmla="*/ 917682 h 1232334"/>
              <a:gd name="connsiteX47" fmla="*/ 81657 w 1281989"/>
              <a:gd name="connsiteY47" fmla="*/ 760366 h 1232334"/>
              <a:gd name="connsiteX48" fmla="*/ 81657 w 1281989"/>
              <a:gd name="connsiteY48" fmla="*/ 917682 h 1232334"/>
              <a:gd name="connsiteX49" fmla="*/ 91489 w 1281989"/>
              <a:gd name="connsiteY49" fmla="*/ 1084830 h 1232334"/>
              <a:gd name="connsiteX50" fmla="*/ 32495 w 1281989"/>
              <a:gd name="connsiteY50" fmla="*/ 829192 h 1232334"/>
              <a:gd name="connsiteX51" fmla="*/ 22663 w 1281989"/>
              <a:gd name="connsiteY51" fmla="*/ 632546 h 1232334"/>
              <a:gd name="connsiteX52" fmla="*/ 12831 w 1281989"/>
              <a:gd name="connsiteY52" fmla="*/ 514559 h 1232334"/>
              <a:gd name="connsiteX0" fmla="*/ 12831 w 1281989"/>
              <a:gd name="connsiteY0" fmla="*/ 514559 h 1232334"/>
              <a:gd name="connsiteX1" fmla="*/ 229141 w 1281989"/>
              <a:gd name="connsiteY1" fmla="*/ 445734 h 1232334"/>
              <a:gd name="connsiteX2" fmla="*/ 347128 w 1281989"/>
              <a:gd name="connsiteY2" fmla="*/ 278585 h 1232334"/>
              <a:gd name="connsiteX3" fmla="*/ 327463 w 1281989"/>
              <a:gd name="connsiteY3" fmla="*/ 160598 h 1232334"/>
              <a:gd name="connsiteX4" fmla="*/ 386457 w 1281989"/>
              <a:gd name="connsiteY4" fmla="*/ 258921 h 1232334"/>
              <a:gd name="connsiteX5" fmla="*/ 337295 w 1281989"/>
              <a:gd name="connsiteY5" fmla="*/ 386740 h 1232334"/>
              <a:gd name="connsiteX6" fmla="*/ 288134 w 1281989"/>
              <a:gd name="connsiteY6" fmla="*/ 455566 h 1232334"/>
              <a:gd name="connsiteX7" fmla="*/ 406121 w 1281989"/>
              <a:gd name="connsiteY7" fmla="*/ 475230 h 1232334"/>
              <a:gd name="connsiteX8" fmla="*/ 592934 w 1281989"/>
              <a:gd name="connsiteY8" fmla="*/ 327746 h 1232334"/>
              <a:gd name="connsiteX9" fmla="*/ 730586 w 1281989"/>
              <a:gd name="connsiteY9" fmla="*/ 22946 h 1232334"/>
              <a:gd name="connsiteX10" fmla="*/ 976392 w 1281989"/>
              <a:gd name="connsiteY10" fmla="*/ 22946 h 1232334"/>
              <a:gd name="connsiteX11" fmla="*/ 799412 w 1281989"/>
              <a:gd name="connsiteY11" fmla="*/ 32779 h 1232334"/>
              <a:gd name="connsiteX12" fmla="*/ 671592 w 1281989"/>
              <a:gd name="connsiteY12" fmla="*/ 239256 h 1232334"/>
              <a:gd name="connsiteX13" fmla="*/ 553605 w 1281989"/>
              <a:gd name="connsiteY13" fmla="*/ 465398 h 1232334"/>
              <a:gd name="connsiteX14" fmla="*/ 288134 w 1281989"/>
              <a:gd name="connsiteY14" fmla="*/ 504727 h 1232334"/>
              <a:gd name="connsiteX15" fmla="*/ 288134 w 1281989"/>
              <a:gd name="connsiteY15" fmla="*/ 524392 h 1232334"/>
              <a:gd name="connsiteX16" fmla="*/ 691257 w 1281989"/>
              <a:gd name="connsiteY16" fmla="*/ 544056 h 1232334"/>
              <a:gd name="connsiteX17" fmla="*/ 1025553 w 1281989"/>
              <a:gd name="connsiteY17" fmla="*/ 681708 h 1232334"/>
              <a:gd name="connsiteX18" fmla="*/ 1281192 w 1281989"/>
              <a:gd name="connsiteY18" fmla="*/ 593217 h 1232334"/>
              <a:gd name="connsiteX19" fmla="*/ 1094379 w 1281989"/>
              <a:gd name="connsiteY19" fmla="*/ 711205 h 1232334"/>
              <a:gd name="connsiteX20" fmla="*/ 779747 w 1281989"/>
              <a:gd name="connsiteY20" fmla="*/ 652211 h 1232334"/>
              <a:gd name="connsiteX21" fmla="*/ 671592 w 1281989"/>
              <a:gd name="connsiteY21" fmla="*/ 603050 h 1232334"/>
              <a:gd name="connsiteX22" fmla="*/ 671592 w 1281989"/>
              <a:gd name="connsiteY22" fmla="*/ 691540 h 1232334"/>
              <a:gd name="connsiteX23" fmla="*/ 838741 w 1281989"/>
              <a:gd name="connsiteY23" fmla="*/ 750534 h 1232334"/>
              <a:gd name="connsiteX24" fmla="*/ 937063 w 1281989"/>
              <a:gd name="connsiteY24" fmla="*/ 888185 h 1232334"/>
              <a:gd name="connsiteX25" fmla="*/ 1015721 w 1281989"/>
              <a:gd name="connsiteY25" fmla="*/ 1006172 h 1232334"/>
              <a:gd name="connsiteX26" fmla="*/ 878070 w 1281989"/>
              <a:gd name="connsiteY26" fmla="*/ 868521 h 1232334"/>
              <a:gd name="connsiteX27" fmla="*/ 828908 w 1281989"/>
              <a:gd name="connsiteY27" fmla="*/ 770198 h 1232334"/>
              <a:gd name="connsiteX28" fmla="*/ 651928 w 1281989"/>
              <a:gd name="connsiteY28" fmla="*/ 711205 h 1232334"/>
              <a:gd name="connsiteX29" fmla="*/ 602766 w 1281989"/>
              <a:gd name="connsiteY29" fmla="*/ 622714 h 1232334"/>
              <a:gd name="connsiteX30" fmla="*/ 386457 w 1281989"/>
              <a:gd name="connsiteY30" fmla="*/ 583385 h 1232334"/>
              <a:gd name="connsiteX31" fmla="*/ 642095 w 1281989"/>
              <a:gd name="connsiteY31" fmla="*/ 878353 h 1232334"/>
              <a:gd name="connsiteX32" fmla="*/ 760082 w 1281989"/>
              <a:gd name="connsiteY32" fmla="*/ 1183153 h 1232334"/>
              <a:gd name="connsiteX33" fmla="*/ 642095 w 1281989"/>
              <a:gd name="connsiteY33" fmla="*/ 937346 h 1232334"/>
              <a:gd name="connsiteX34" fmla="*/ 533941 w 1281989"/>
              <a:gd name="connsiteY34" fmla="*/ 799695 h 1232334"/>
              <a:gd name="connsiteX35" fmla="*/ 396289 w 1281989"/>
              <a:gd name="connsiteY35" fmla="*/ 671875 h 1232334"/>
              <a:gd name="connsiteX36" fmla="*/ 268470 w 1281989"/>
              <a:gd name="connsiteY36" fmla="*/ 593217 h 1232334"/>
              <a:gd name="connsiteX37" fmla="*/ 101321 w 1281989"/>
              <a:gd name="connsiteY37" fmla="*/ 593217 h 1232334"/>
              <a:gd name="connsiteX38" fmla="*/ 179979 w 1281989"/>
              <a:gd name="connsiteY38" fmla="*/ 799695 h 1232334"/>
              <a:gd name="connsiteX39" fmla="*/ 435618 w 1281989"/>
              <a:gd name="connsiteY39" fmla="*/ 957011 h 1232334"/>
              <a:gd name="connsiteX40" fmla="*/ 494612 w 1281989"/>
              <a:gd name="connsiteY40" fmla="*/ 1016005 h 1232334"/>
              <a:gd name="connsiteX41" fmla="*/ 258637 w 1281989"/>
              <a:gd name="connsiteY41" fmla="*/ 888185 h 1232334"/>
              <a:gd name="connsiteX42" fmla="*/ 219308 w 1281989"/>
              <a:gd name="connsiteY42" fmla="*/ 907850 h 1232334"/>
              <a:gd name="connsiteX43" fmla="*/ 356960 w 1281989"/>
              <a:gd name="connsiteY43" fmla="*/ 1084830 h 1232334"/>
              <a:gd name="connsiteX44" fmla="*/ 602766 w 1281989"/>
              <a:gd name="connsiteY44" fmla="*/ 1232314 h 1232334"/>
              <a:gd name="connsiteX45" fmla="*/ 316095 w 1281989"/>
              <a:gd name="connsiteY45" fmla="*/ 1074998 h 1232334"/>
              <a:gd name="connsiteX46" fmla="*/ 209476 w 1281989"/>
              <a:gd name="connsiteY46" fmla="*/ 917682 h 1232334"/>
              <a:gd name="connsiteX47" fmla="*/ 81657 w 1281989"/>
              <a:gd name="connsiteY47" fmla="*/ 760366 h 1232334"/>
              <a:gd name="connsiteX48" fmla="*/ 81657 w 1281989"/>
              <a:gd name="connsiteY48" fmla="*/ 917682 h 1232334"/>
              <a:gd name="connsiteX49" fmla="*/ 91489 w 1281989"/>
              <a:gd name="connsiteY49" fmla="*/ 1084830 h 1232334"/>
              <a:gd name="connsiteX50" fmla="*/ 32495 w 1281989"/>
              <a:gd name="connsiteY50" fmla="*/ 829192 h 1232334"/>
              <a:gd name="connsiteX51" fmla="*/ 22663 w 1281989"/>
              <a:gd name="connsiteY51" fmla="*/ 632546 h 1232334"/>
              <a:gd name="connsiteX52" fmla="*/ 12831 w 1281989"/>
              <a:gd name="connsiteY52" fmla="*/ 514559 h 1232334"/>
              <a:gd name="connsiteX0" fmla="*/ 12831 w 1281989"/>
              <a:gd name="connsiteY0" fmla="*/ 514559 h 1232334"/>
              <a:gd name="connsiteX1" fmla="*/ 229141 w 1281989"/>
              <a:gd name="connsiteY1" fmla="*/ 445734 h 1232334"/>
              <a:gd name="connsiteX2" fmla="*/ 347128 w 1281989"/>
              <a:gd name="connsiteY2" fmla="*/ 278585 h 1232334"/>
              <a:gd name="connsiteX3" fmla="*/ 327463 w 1281989"/>
              <a:gd name="connsiteY3" fmla="*/ 160598 h 1232334"/>
              <a:gd name="connsiteX4" fmla="*/ 386457 w 1281989"/>
              <a:gd name="connsiteY4" fmla="*/ 258921 h 1232334"/>
              <a:gd name="connsiteX5" fmla="*/ 337295 w 1281989"/>
              <a:gd name="connsiteY5" fmla="*/ 386740 h 1232334"/>
              <a:gd name="connsiteX6" fmla="*/ 288134 w 1281989"/>
              <a:gd name="connsiteY6" fmla="*/ 455566 h 1232334"/>
              <a:gd name="connsiteX7" fmla="*/ 406121 w 1281989"/>
              <a:gd name="connsiteY7" fmla="*/ 475230 h 1232334"/>
              <a:gd name="connsiteX8" fmla="*/ 592934 w 1281989"/>
              <a:gd name="connsiteY8" fmla="*/ 327746 h 1232334"/>
              <a:gd name="connsiteX9" fmla="*/ 730586 w 1281989"/>
              <a:gd name="connsiteY9" fmla="*/ 22946 h 1232334"/>
              <a:gd name="connsiteX10" fmla="*/ 976392 w 1281989"/>
              <a:gd name="connsiteY10" fmla="*/ 22946 h 1232334"/>
              <a:gd name="connsiteX11" fmla="*/ 799412 w 1281989"/>
              <a:gd name="connsiteY11" fmla="*/ 32779 h 1232334"/>
              <a:gd name="connsiteX12" fmla="*/ 671592 w 1281989"/>
              <a:gd name="connsiteY12" fmla="*/ 239256 h 1232334"/>
              <a:gd name="connsiteX13" fmla="*/ 553605 w 1281989"/>
              <a:gd name="connsiteY13" fmla="*/ 465398 h 1232334"/>
              <a:gd name="connsiteX14" fmla="*/ 288134 w 1281989"/>
              <a:gd name="connsiteY14" fmla="*/ 504727 h 1232334"/>
              <a:gd name="connsiteX15" fmla="*/ 288134 w 1281989"/>
              <a:gd name="connsiteY15" fmla="*/ 524392 h 1232334"/>
              <a:gd name="connsiteX16" fmla="*/ 691257 w 1281989"/>
              <a:gd name="connsiteY16" fmla="*/ 544056 h 1232334"/>
              <a:gd name="connsiteX17" fmla="*/ 1025553 w 1281989"/>
              <a:gd name="connsiteY17" fmla="*/ 681708 h 1232334"/>
              <a:gd name="connsiteX18" fmla="*/ 1281192 w 1281989"/>
              <a:gd name="connsiteY18" fmla="*/ 593217 h 1232334"/>
              <a:gd name="connsiteX19" fmla="*/ 1094379 w 1281989"/>
              <a:gd name="connsiteY19" fmla="*/ 711205 h 1232334"/>
              <a:gd name="connsiteX20" fmla="*/ 779747 w 1281989"/>
              <a:gd name="connsiteY20" fmla="*/ 652211 h 1232334"/>
              <a:gd name="connsiteX21" fmla="*/ 671592 w 1281989"/>
              <a:gd name="connsiteY21" fmla="*/ 603050 h 1232334"/>
              <a:gd name="connsiteX22" fmla="*/ 671592 w 1281989"/>
              <a:gd name="connsiteY22" fmla="*/ 691540 h 1232334"/>
              <a:gd name="connsiteX23" fmla="*/ 838741 w 1281989"/>
              <a:gd name="connsiteY23" fmla="*/ 750534 h 1232334"/>
              <a:gd name="connsiteX24" fmla="*/ 937063 w 1281989"/>
              <a:gd name="connsiteY24" fmla="*/ 888185 h 1232334"/>
              <a:gd name="connsiteX25" fmla="*/ 1015721 w 1281989"/>
              <a:gd name="connsiteY25" fmla="*/ 1006172 h 1232334"/>
              <a:gd name="connsiteX26" fmla="*/ 893945 w 1281989"/>
              <a:gd name="connsiteY26" fmla="*/ 858996 h 1232334"/>
              <a:gd name="connsiteX27" fmla="*/ 828908 w 1281989"/>
              <a:gd name="connsiteY27" fmla="*/ 770198 h 1232334"/>
              <a:gd name="connsiteX28" fmla="*/ 651928 w 1281989"/>
              <a:gd name="connsiteY28" fmla="*/ 711205 h 1232334"/>
              <a:gd name="connsiteX29" fmla="*/ 602766 w 1281989"/>
              <a:gd name="connsiteY29" fmla="*/ 622714 h 1232334"/>
              <a:gd name="connsiteX30" fmla="*/ 386457 w 1281989"/>
              <a:gd name="connsiteY30" fmla="*/ 583385 h 1232334"/>
              <a:gd name="connsiteX31" fmla="*/ 642095 w 1281989"/>
              <a:gd name="connsiteY31" fmla="*/ 878353 h 1232334"/>
              <a:gd name="connsiteX32" fmla="*/ 760082 w 1281989"/>
              <a:gd name="connsiteY32" fmla="*/ 1183153 h 1232334"/>
              <a:gd name="connsiteX33" fmla="*/ 642095 w 1281989"/>
              <a:gd name="connsiteY33" fmla="*/ 937346 h 1232334"/>
              <a:gd name="connsiteX34" fmla="*/ 533941 w 1281989"/>
              <a:gd name="connsiteY34" fmla="*/ 799695 h 1232334"/>
              <a:gd name="connsiteX35" fmla="*/ 396289 w 1281989"/>
              <a:gd name="connsiteY35" fmla="*/ 671875 h 1232334"/>
              <a:gd name="connsiteX36" fmla="*/ 268470 w 1281989"/>
              <a:gd name="connsiteY36" fmla="*/ 593217 h 1232334"/>
              <a:gd name="connsiteX37" fmla="*/ 101321 w 1281989"/>
              <a:gd name="connsiteY37" fmla="*/ 593217 h 1232334"/>
              <a:gd name="connsiteX38" fmla="*/ 179979 w 1281989"/>
              <a:gd name="connsiteY38" fmla="*/ 799695 h 1232334"/>
              <a:gd name="connsiteX39" fmla="*/ 435618 w 1281989"/>
              <a:gd name="connsiteY39" fmla="*/ 957011 h 1232334"/>
              <a:gd name="connsiteX40" fmla="*/ 494612 w 1281989"/>
              <a:gd name="connsiteY40" fmla="*/ 1016005 h 1232334"/>
              <a:gd name="connsiteX41" fmla="*/ 258637 w 1281989"/>
              <a:gd name="connsiteY41" fmla="*/ 888185 h 1232334"/>
              <a:gd name="connsiteX42" fmla="*/ 219308 w 1281989"/>
              <a:gd name="connsiteY42" fmla="*/ 907850 h 1232334"/>
              <a:gd name="connsiteX43" fmla="*/ 356960 w 1281989"/>
              <a:gd name="connsiteY43" fmla="*/ 1084830 h 1232334"/>
              <a:gd name="connsiteX44" fmla="*/ 602766 w 1281989"/>
              <a:gd name="connsiteY44" fmla="*/ 1232314 h 1232334"/>
              <a:gd name="connsiteX45" fmla="*/ 316095 w 1281989"/>
              <a:gd name="connsiteY45" fmla="*/ 1074998 h 1232334"/>
              <a:gd name="connsiteX46" fmla="*/ 209476 w 1281989"/>
              <a:gd name="connsiteY46" fmla="*/ 917682 h 1232334"/>
              <a:gd name="connsiteX47" fmla="*/ 81657 w 1281989"/>
              <a:gd name="connsiteY47" fmla="*/ 760366 h 1232334"/>
              <a:gd name="connsiteX48" fmla="*/ 81657 w 1281989"/>
              <a:gd name="connsiteY48" fmla="*/ 917682 h 1232334"/>
              <a:gd name="connsiteX49" fmla="*/ 91489 w 1281989"/>
              <a:gd name="connsiteY49" fmla="*/ 1084830 h 1232334"/>
              <a:gd name="connsiteX50" fmla="*/ 32495 w 1281989"/>
              <a:gd name="connsiteY50" fmla="*/ 829192 h 1232334"/>
              <a:gd name="connsiteX51" fmla="*/ 22663 w 1281989"/>
              <a:gd name="connsiteY51" fmla="*/ 632546 h 1232334"/>
              <a:gd name="connsiteX52" fmla="*/ 12831 w 1281989"/>
              <a:gd name="connsiteY52" fmla="*/ 514559 h 1232334"/>
              <a:gd name="connsiteX0" fmla="*/ 12831 w 1281982"/>
              <a:gd name="connsiteY0" fmla="*/ 514559 h 1232334"/>
              <a:gd name="connsiteX1" fmla="*/ 229141 w 1281982"/>
              <a:gd name="connsiteY1" fmla="*/ 445734 h 1232334"/>
              <a:gd name="connsiteX2" fmla="*/ 347128 w 1281982"/>
              <a:gd name="connsiteY2" fmla="*/ 278585 h 1232334"/>
              <a:gd name="connsiteX3" fmla="*/ 327463 w 1281982"/>
              <a:gd name="connsiteY3" fmla="*/ 160598 h 1232334"/>
              <a:gd name="connsiteX4" fmla="*/ 386457 w 1281982"/>
              <a:gd name="connsiteY4" fmla="*/ 258921 h 1232334"/>
              <a:gd name="connsiteX5" fmla="*/ 337295 w 1281982"/>
              <a:gd name="connsiteY5" fmla="*/ 386740 h 1232334"/>
              <a:gd name="connsiteX6" fmla="*/ 288134 w 1281982"/>
              <a:gd name="connsiteY6" fmla="*/ 455566 h 1232334"/>
              <a:gd name="connsiteX7" fmla="*/ 406121 w 1281982"/>
              <a:gd name="connsiteY7" fmla="*/ 475230 h 1232334"/>
              <a:gd name="connsiteX8" fmla="*/ 592934 w 1281982"/>
              <a:gd name="connsiteY8" fmla="*/ 327746 h 1232334"/>
              <a:gd name="connsiteX9" fmla="*/ 730586 w 1281982"/>
              <a:gd name="connsiteY9" fmla="*/ 22946 h 1232334"/>
              <a:gd name="connsiteX10" fmla="*/ 976392 w 1281982"/>
              <a:gd name="connsiteY10" fmla="*/ 22946 h 1232334"/>
              <a:gd name="connsiteX11" fmla="*/ 799412 w 1281982"/>
              <a:gd name="connsiteY11" fmla="*/ 32779 h 1232334"/>
              <a:gd name="connsiteX12" fmla="*/ 671592 w 1281982"/>
              <a:gd name="connsiteY12" fmla="*/ 239256 h 1232334"/>
              <a:gd name="connsiteX13" fmla="*/ 553605 w 1281982"/>
              <a:gd name="connsiteY13" fmla="*/ 465398 h 1232334"/>
              <a:gd name="connsiteX14" fmla="*/ 288134 w 1281982"/>
              <a:gd name="connsiteY14" fmla="*/ 504727 h 1232334"/>
              <a:gd name="connsiteX15" fmla="*/ 288134 w 1281982"/>
              <a:gd name="connsiteY15" fmla="*/ 524392 h 1232334"/>
              <a:gd name="connsiteX16" fmla="*/ 691257 w 1281982"/>
              <a:gd name="connsiteY16" fmla="*/ 544056 h 1232334"/>
              <a:gd name="connsiteX17" fmla="*/ 1025553 w 1281982"/>
              <a:gd name="connsiteY17" fmla="*/ 681708 h 1232334"/>
              <a:gd name="connsiteX18" fmla="*/ 1281192 w 1281982"/>
              <a:gd name="connsiteY18" fmla="*/ 593217 h 1232334"/>
              <a:gd name="connsiteX19" fmla="*/ 1094379 w 1281982"/>
              <a:gd name="connsiteY19" fmla="*/ 711205 h 1232334"/>
              <a:gd name="connsiteX20" fmla="*/ 786097 w 1281982"/>
              <a:gd name="connsiteY20" fmla="*/ 614111 h 1232334"/>
              <a:gd name="connsiteX21" fmla="*/ 671592 w 1281982"/>
              <a:gd name="connsiteY21" fmla="*/ 603050 h 1232334"/>
              <a:gd name="connsiteX22" fmla="*/ 671592 w 1281982"/>
              <a:gd name="connsiteY22" fmla="*/ 691540 h 1232334"/>
              <a:gd name="connsiteX23" fmla="*/ 838741 w 1281982"/>
              <a:gd name="connsiteY23" fmla="*/ 750534 h 1232334"/>
              <a:gd name="connsiteX24" fmla="*/ 937063 w 1281982"/>
              <a:gd name="connsiteY24" fmla="*/ 888185 h 1232334"/>
              <a:gd name="connsiteX25" fmla="*/ 1015721 w 1281982"/>
              <a:gd name="connsiteY25" fmla="*/ 1006172 h 1232334"/>
              <a:gd name="connsiteX26" fmla="*/ 893945 w 1281982"/>
              <a:gd name="connsiteY26" fmla="*/ 858996 h 1232334"/>
              <a:gd name="connsiteX27" fmla="*/ 828908 w 1281982"/>
              <a:gd name="connsiteY27" fmla="*/ 770198 h 1232334"/>
              <a:gd name="connsiteX28" fmla="*/ 651928 w 1281982"/>
              <a:gd name="connsiteY28" fmla="*/ 711205 h 1232334"/>
              <a:gd name="connsiteX29" fmla="*/ 602766 w 1281982"/>
              <a:gd name="connsiteY29" fmla="*/ 622714 h 1232334"/>
              <a:gd name="connsiteX30" fmla="*/ 386457 w 1281982"/>
              <a:gd name="connsiteY30" fmla="*/ 583385 h 1232334"/>
              <a:gd name="connsiteX31" fmla="*/ 642095 w 1281982"/>
              <a:gd name="connsiteY31" fmla="*/ 878353 h 1232334"/>
              <a:gd name="connsiteX32" fmla="*/ 760082 w 1281982"/>
              <a:gd name="connsiteY32" fmla="*/ 1183153 h 1232334"/>
              <a:gd name="connsiteX33" fmla="*/ 642095 w 1281982"/>
              <a:gd name="connsiteY33" fmla="*/ 937346 h 1232334"/>
              <a:gd name="connsiteX34" fmla="*/ 533941 w 1281982"/>
              <a:gd name="connsiteY34" fmla="*/ 799695 h 1232334"/>
              <a:gd name="connsiteX35" fmla="*/ 396289 w 1281982"/>
              <a:gd name="connsiteY35" fmla="*/ 671875 h 1232334"/>
              <a:gd name="connsiteX36" fmla="*/ 268470 w 1281982"/>
              <a:gd name="connsiteY36" fmla="*/ 593217 h 1232334"/>
              <a:gd name="connsiteX37" fmla="*/ 101321 w 1281982"/>
              <a:gd name="connsiteY37" fmla="*/ 593217 h 1232334"/>
              <a:gd name="connsiteX38" fmla="*/ 179979 w 1281982"/>
              <a:gd name="connsiteY38" fmla="*/ 799695 h 1232334"/>
              <a:gd name="connsiteX39" fmla="*/ 435618 w 1281982"/>
              <a:gd name="connsiteY39" fmla="*/ 957011 h 1232334"/>
              <a:gd name="connsiteX40" fmla="*/ 494612 w 1281982"/>
              <a:gd name="connsiteY40" fmla="*/ 1016005 h 1232334"/>
              <a:gd name="connsiteX41" fmla="*/ 258637 w 1281982"/>
              <a:gd name="connsiteY41" fmla="*/ 888185 h 1232334"/>
              <a:gd name="connsiteX42" fmla="*/ 219308 w 1281982"/>
              <a:gd name="connsiteY42" fmla="*/ 907850 h 1232334"/>
              <a:gd name="connsiteX43" fmla="*/ 356960 w 1281982"/>
              <a:gd name="connsiteY43" fmla="*/ 1084830 h 1232334"/>
              <a:gd name="connsiteX44" fmla="*/ 602766 w 1281982"/>
              <a:gd name="connsiteY44" fmla="*/ 1232314 h 1232334"/>
              <a:gd name="connsiteX45" fmla="*/ 316095 w 1281982"/>
              <a:gd name="connsiteY45" fmla="*/ 1074998 h 1232334"/>
              <a:gd name="connsiteX46" fmla="*/ 209476 w 1281982"/>
              <a:gd name="connsiteY46" fmla="*/ 917682 h 1232334"/>
              <a:gd name="connsiteX47" fmla="*/ 81657 w 1281982"/>
              <a:gd name="connsiteY47" fmla="*/ 760366 h 1232334"/>
              <a:gd name="connsiteX48" fmla="*/ 81657 w 1281982"/>
              <a:gd name="connsiteY48" fmla="*/ 917682 h 1232334"/>
              <a:gd name="connsiteX49" fmla="*/ 91489 w 1281982"/>
              <a:gd name="connsiteY49" fmla="*/ 1084830 h 1232334"/>
              <a:gd name="connsiteX50" fmla="*/ 32495 w 1281982"/>
              <a:gd name="connsiteY50" fmla="*/ 829192 h 1232334"/>
              <a:gd name="connsiteX51" fmla="*/ 22663 w 1281982"/>
              <a:gd name="connsiteY51" fmla="*/ 632546 h 1232334"/>
              <a:gd name="connsiteX52" fmla="*/ 12831 w 1281982"/>
              <a:gd name="connsiteY52" fmla="*/ 514559 h 1232334"/>
              <a:gd name="connsiteX0" fmla="*/ 12831 w 1282073"/>
              <a:gd name="connsiteY0" fmla="*/ 514559 h 1232334"/>
              <a:gd name="connsiteX1" fmla="*/ 229141 w 1282073"/>
              <a:gd name="connsiteY1" fmla="*/ 445734 h 1232334"/>
              <a:gd name="connsiteX2" fmla="*/ 347128 w 1282073"/>
              <a:gd name="connsiteY2" fmla="*/ 278585 h 1232334"/>
              <a:gd name="connsiteX3" fmla="*/ 327463 w 1282073"/>
              <a:gd name="connsiteY3" fmla="*/ 160598 h 1232334"/>
              <a:gd name="connsiteX4" fmla="*/ 386457 w 1282073"/>
              <a:gd name="connsiteY4" fmla="*/ 258921 h 1232334"/>
              <a:gd name="connsiteX5" fmla="*/ 337295 w 1282073"/>
              <a:gd name="connsiteY5" fmla="*/ 386740 h 1232334"/>
              <a:gd name="connsiteX6" fmla="*/ 288134 w 1282073"/>
              <a:gd name="connsiteY6" fmla="*/ 455566 h 1232334"/>
              <a:gd name="connsiteX7" fmla="*/ 406121 w 1282073"/>
              <a:gd name="connsiteY7" fmla="*/ 475230 h 1232334"/>
              <a:gd name="connsiteX8" fmla="*/ 592934 w 1282073"/>
              <a:gd name="connsiteY8" fmla="*/ 327746 h 1232334"/>
              <a:gd name="connsiteX9" fmla="*/ 730586 w 1282073"/>
              <a:gd name="connsiteY9" fmla="*/ 22946 h 1232334"/>
              <a:gd name="connsiteX10" fmla="*/ 976392 w 1282073"/>
              <a:gd name="connsiteY10" fmla="*/ 22946 h 1232334"/>
              <a:gd name="connsiteX11" fmla="*/ 799412 w 1282073"/>
              <a:gd name="connsiteY11" fmla="*/ 32779 h 1232334"/>
              <a:gd name="connsiteX12" fmla="*/ 671592 w 1282073"/>
              <a:gd name="connsiteY12" fmla="*/ 239256 h 1232334"/>
              <a:gd name="connsiteX13" fmla="*/ 553605 w 1282073"/>
              <a:gd name="connsiteY13" fmla="*/ 465398 h 1232334"/>
              <a:gd name="connsiteX14" fmla="*/ 288134 w 1282073"/>
              <a:gd name="connsiteY14" fmla="*/ 504727 h 1232334"/>
              <a:gd name="connsiteX15" fmla="*/ 288134 w 1282073"/>
              <a:gd name="connsiteY15" fmla="*/ 524392 h 1232334"/>
              <a:gd name="connsiteX16" fmla="*/ 691257 w 1282073"/>
              <a:gd name="connsiteY16" fmla="*/ 544056 h 1232334"/>
              <a:gd name="connsiteX17" fmla="*/ 1025553 w 1282073"/>
              <a:gd name="connsiteY17" fmla="*/ 681708 h 1232334"/>
              <a:gd name="connsiteX18" fmla="*/ 1281192 w 1282073"/>
              <a:gd name="connsiteY18" fmla="*/ 593217 h 1232334"/>
              <a:gd name="connsiteX19" fmla="*/ 1097554 w 1282073"/>
              <a:gd name="connsiteY19" fmla="*/ 688980 h 1232334"/>
              <a:gd name="connsiteX20" fmla="*/ 786097 w 1282073"/>
              <a:gd name="connsiteY20" fmla="*/ 614111 h 1232334"/>
              <a:gd name="connsiteX21" fmla="*/ 671592 w 1282073"/>
              <a:gd name="connsiteY21" fmla="*/ 603050 h 1232334"/>
              <a:gd name="connsiteX22" fmla="*/ 671592 w 1282073"/>
              <a:gd name="connsiteY22" fmla="*/ 691540 h 1232334"/>
              <a:gd name="connsiteX23" fmla="*/ 838741 w 1282073"/>
              <a:gd name="connsiteY23" fmla="*/ 750534 h 1232334"/>
              <a:gd name="connsiteX24" fmla="*/ 937063 w 1282073"/>
              <a:gd name="connsiteY24" fmla="*/ 888185 h 1232334"/>
              <a:gd name="connsiteX25" fmla="*/ 1015721 w 1282073"/>
              <a:gd name="connsiteY25" fmla="*/ 1006172 h 1232334"/>
              <a:gd name="connsiteX26" fmla="*/ 893945 w 1282073"/>
              <a:gd name="connsiteY26" fmla="*/ 858996 h 1232334"/>
              <a:gd name="connsiteX27" fmla="*/ 828908 w 1282073"/>
              <a:gd name="connsiteY27" fmla="*/ 770198 h 1232334"/>
              <a:gd name="connsiteX28" fmla="*/ 651928 w 1282073"/>
              <a:gd name="connsiteY28" fmla="*/ 711205 h 1232334"/>
              <a:gd name="connsiteX29" fmla="*/ 602766 w 1282073"/>
              <a:gd name="connsiteY29" fmla="*/ 622714 h 1232334"/>
              <a:gd name="connsiteX30" fmla="*/ 386457 w 1282073"/>
              <a:gd name="connsiteY30" fmla="*/ 583385 h 1232334"/>
              <a:gd name="connsiteX31" fmla="*/ 642095 w 1282073"/>
              <a:gd name="connsiteY31" fmla="*/ 878353 h 1232334"/>
              <a:gd name="connsiteX32" fmla="*/ 760082 w 1282073"/>
              <a:gd name="connsiteY32" fmla="*/ 1183153 h 1232334"/>
              <a:gd name="connsiteX33" fmla="*/ 642095 w 1282073"/>
              <a:gd name="connsiteY33" fmla="*/ 937346 h 1232334"/>
              <a:gd name="connsiteX34" fmla="*/ 533941 w 1282073"/>
              <a:gd name="connsiteY34" fmla="*/ 799695 h 1232334"/>
              <a:gd name="connsiteX35" fmla="*/ 396289 w 1282073"/>
              <a:gd name="connsiteY35" fmla="*/ 671875 h 1232334"/>
              <a:gd name="connsiteX36" fmla="*/ 268470 w 1282073"/>
              <a:gd name="connsiteY36" fmla="*/ 593217 h 1232334"/>
              <a:gd name="connsiteX37" fmla="*/ 101321 w 1282073"/>
              <a:gd name="connsiteY37" fmla="*/ 593217 h 1232334"/>
              <a:gd name="connsiteX38" fmla="*/ 179979 w 1282073"/>
              <a:gd name="connsiteY38" fmla="*/ 799695 h 1232334"/>
              <a:gd name="connsiteX39" fmla="*/ 435618 w 1282073"/>
              <a:gd name="connsiteY39" fmla="*/ 957011 h 1232334"/>
              <a:gd name="connsiteX40" fmla="*/ 494612 w 1282073"/>
              <a:gd name="connsiteY40" fmla="*/ 1016005 h 1232334"/>
              <a:gd name="connsiteX41" fmla="*/ 258637 w 1282073"/>
              <a:gd name="connsiteY41" fmla="*/ 888185 h 1232334"/>
              <a:gd name="connsiteX42" fmla="*/ 219308 w 1282073"/>
              <a:gd name="connsiteY42" fmla="*/ 907850 h 1232334"/>
              <a:gd name="connsiteX43" fmla="*/ 356960 w 1282073"/>
              <a:gd name="connsiteY43" fmla="*/ 1084830 h 1232334"/>
              <a:gd name="connsiteX44" fmla="*/ 602766 w 1282073"/>
              <a:gd name="connsiteY44" fmla="*/ 1232314 h 1232334"/>
              <a:gd name="connsiteX45" fmla="*/ 316095 w 1282073"/>
              <a:gd name="connsiteY45" fmla="*/ 1074998 h 1232334"/>
              <a:gd name="connsiteX46" fmla="*/ 209476 w 1282073"/>
              <a:gd name="connsiteY46" fmla="*/ 917682 h 1232334"/>
              <a:gd name="connsiteX47" fmla="*/ 81657 w 1282073"/>
              <a:gd name="connsiteY47" fmla="*/ 760366 h 1232334"/>
              <a:gd name="connsiteX48" fmla="*/ 81657 w 1282073"/>
              <a:gd name="connsiteY48" fmla="*/ 917682 h 1232334"/>
              <a:gd name="connsiteX49" fmla="*/ 91489 w 1282073"/>
              <a:gd name="connsiteY49" fmla="*/ 1084830 h 1232334"/>
              <a:gd name="connsiteX50" fmla="*/ 32495 w 1282073"/>
              <a:gd name="connsiteY50" fmla="*/ 829192 h 1232334"/>
              <a:gd name="connsiteX51" fmla="*/ 22663 w 1282073"/>
              <a:gd name="connsiteY51" fmla="*/ 632546 h 1232334"/>
              <a:gd name="connsiteX52" fmla="*/ 12831 w 1282073"/>
              <a:gd name="connsiteY52" fmla="*/ 514559 h 1232334"/>
              <a:gd name="connsiteX0" fmla="*/ 12831 w 1282073"/>
              <a:gd name="connsiteY0" fmla="*/ 514559 h 1232334"/>
              <a:gd name="connsiteX1" fmla="*/ 229141 w 1282073"/>
              <a:gd name="connsiteY1" fmla="*/ 445734 h 1232334"/>
              <a:gd name="connsiteX2" fmla="*/ 347128 w 1282073"/>
              <a:gd name="connsiteY2" fmla="*/ 278585 h 1232334"/>
              <a:gd name="connsiteX3" fmla="*/ 327463 w 1282073"/>
              <a:gd name="connsiteY3" fmla="*/ 160598 h 1232334"/>
              <a:gd name="connsiteX4" fmla="*/ 386457 w 1282073"/>
              <a:gd name="connsiteY4" fmla="*/ 258921 h 1232334"/>
              <a:gd name="connsiteX5" fmla="*/ 337295 w 1282073"/>
              <a:gd name="connsiteY5" fmla="*/ 386740 h 1232334"/>
              <a:gd name="connsiteX6" fmla="*/ 288134 w 1282073"/>
              <a:gd name="connsiteY6" fmla="*/ 455566 h 1232334"/>
              <a:gd name="connsiteX7" fmla="*/ 406121 w 1282073"/>
              <a:gd name="connsiteY7" fmla="*/ 475230 h 1232334"/>
              <a:gd name="connsiteX8" fmla="*/ 592934 w 1282073"/>
              <a:gd name="connsiteY8" fmla="*/ 327746 h 1232334"/>
              <a:gd name="connsiteX9" fmla="*/ 730586 w 1282073"/>
              <a:gd name="connsiteY9" fmla="*/ 22946 h 1232334"/>
              <a:gd name="connsiteX10" fmla="*/ 976392 w 1282073"/>
              <a:gd name="connsiteY10" fmla="*/ 22946 h 1232334"/>
              <a:gd name="connsiteX11" fmla="*/ 799412 w 1282073"/>
              <a:gd name="connsiteY11" fmla="*/ 32779 h 1232334"/>
              <a:gd name="connsiteX12" fmla="*/ 671592 w 1282073"/>
              <a:gd name="connsiteY12" fmla="*/ 239256 h 1232334"/>
              <a:gd name="connsiteX13" fmla="*/ 531380 w 1282073"/>
              <a:gd name="connsiteY13" fmla="*/ 433648 h 1232334"/>
              <a:gd name="connsiteX14" fmla="*/ 288134 w 1282073"/>
              <a:gd name="connsiteY14" fmla="*/ 504727 h 1232334"/>
              <a:gd name="connsiteX15" fmla="*/ 288134 w 1282073"/>
              <a:gd name="connsiteY15" fmla="*/ 524392 h 1232334"/>
              <a:gd name="connsiteX16" fmla="*/ 691257 w 1282073"/>
              <a:gd name="connsiteY16" fmla="*/ 544056 h 1232334"/>
              <a:gd name="connsiteX17" fmla="*/ 1025553 w 1282073"/>
              <a:gd name="connsiteY17" fmla="*/ 681708 h 1232334"/>
              <a:gd name="connsiteX18" fmla="*/ 1281192 w 1282073"/>
              <a:gd name="connsiteY18" fmla="*/ 593217 h 1232334"/>
              <a:gd name="connsiteX19" fmla="*/ 1097554 w 1282073"/>
              <a:gd name="connsiteY19" fmla="*/ 688980 h 1232334"/>
              <a:gd name="connsiteX20" fmla="*/ 786097 w 1282073"/>
              <a:gd name="connsiteY20" fmla="*/ 614111 h 1232334"/>
              <a:gd name="connsiteX21" fmla="*/ 671592 w 1282073"/>
              <a:gd name="connsiteY21" fmla="*/ 603050 h 1232334"/>
              <a:gd name="connsiteX22" fmla="*/ 671592 w 1282073"/>
              <a:gd name="connsiteY22" fmla="*/ 691540 h 1232334"/>
              <a:gd name="connsiteX23" fmla="*/ 838741 w 1282073"/>
              <a:gd name="connsiteY23" fmla="*/ 750534 h 1232334"/>
              <a:gd name="connsiteX24" fmla="*/ 937063 w 1282073"/>
              <a:gd name="connsiteY24" fmla="*/ 888185 h 1232334"/>
              <a:gd name="connsiteX25" fmla="*/ 1015721 w 1282073"/>
              <a:gd name="connsiteY25" fmla="*/ 1006172 h 1232334"/>
              <a:gd name="connsiteX26" fmla="*/ 893945 w 1282073"/>
              <a:gd name="connsiteY26" fmla="*/ 858996 h 1232334"/>
              <a:gd name="connsiteX27" fmla="*/ 828908 w 1282073"/>
              <a:gd name="connsiteY27" fmla="*/ 770198 h 1232334"/>
              <a:gd name="connsiteX28" fmla="*/ 651928 w 1282073"/>
              <a:gd name="connsiteY28" fmla="*/ 711205 h 1232334"/>
              <a:gd name="connsiteX29" fmla="*/ 602766 w 1282073"/>
              <a:gd name="connsiteY29" fmla="*/ 622714 h 1232334"/>
              <a:gd name="connsiteX30" fmla="*/ 386457 w 1282073"/>
              <a:gd name="connsiteY30" fmla="*/ 583385 h 1232334"/>
              <a:gd name="connsiteX31" fmla="*/ 642095 w 1282073"/>
              <a:gd name="connsiteY31" fmla="*/ 878353 h 1232334"/>
              <a:gd name="connsiteX32" fmla="*/ 760082 w 1282073"/>
              <a:gd name="connsiteY32" fmla="*/ 1183153 h 1232334"/>
              <a:gd name="connsiteX33" fmla="*/ 642095 w 1282073"/>
              <a:gd name="connsiteY33" fmla="*/ 937346 h 1232334"/>
              <a:gd name="connsiteX34" fmla="*/ 533941 w 1282073"/>
              <a:gd name="connsiteY34" fmla="*/ 799695 h 1232334"/>
              <a:gd name="connsiteX35" fmla="*/ 396289 w 1282073"/>
              <a:gd name="connsiteY35" fmla="*/ 671875 h 1232334"/>
              <a:gd name="connsiteX36" fmla="*/ 268470 w 1282073"/>
              <a:gd name="connsiteY36" fmla="*/ 593217 h 1232334"/>
              <a:gd name="connsiteX37" fmla="*/ 101321 w 1282073"/>
              <a:gd name="connsiteY37" fmla="*/ 593217 h 1232334"/>
              <a:gd name="connsiteX38" fmla="*/ 179979 w 1282073"/>
              <a:gd name="connsiteY38" fmla="*/ 799695 h 1232334"/>
              <a:gd name="connsiteX39" fmla="*/ 435618 w 1282073"/>
              <a:gd name="connsiteY39" fmla="*/ 957011 h 1232334"/>
              <a:gd name="connsiteX40" fmla="*/ 494612 w 1282073"/>
              <a:gd name="connsiteY40" fmla="*/ 1016005 h 1232334"/>
              <a:gd name="connsiteX41" fmla="*/ 258637 w 1282073"/>
              <a:gd name="connsiteY41" fmla="*/ 888185 h 1232334"/>
              <a:gd name="connsiteX42" fmla="*/ 219308 w 1282073"/>
              <a:gd name="connsiteY42" fmla="*/ 907850 h 1232334"/>
              <a:gd name="connsiteX43" fmla="*/ 356960 w 1282073"/>
              <a:gd name="connsiteY43" fmla="*/ 1084830 h 1232334"/>
              <a:gd name="connsiteX44" fmla="*/ 602766 w 1282073"/>
              <a:gd name="connsiteY44" fmla="*/ 1232314 h 1232334"/>
              <a:gd name="connsiteX45" fmla="*/ 316095 w 1282073"/>
              <a:gd name="connsiteY45" fmla="*/ 1074998 h 1232334"/>
              <a:gd name="connsiteX46" fmla="*/ 209476 w 1282073"/>
              <a:gd name="connsiteY46" fmla="*/ 917682 h 1232334"/>
              <a:gd name="connsiteX47" fmla="*/ 81657 w 1282073"/>
              <a:gd name="connsiteY47" fmla="*/ 760366 h 1232334"/>
              <a:gd name="connsiteX48" fmla="*/ 81657 w 1282073"/>
              <a:gd name="connsiteY48" fmla="*/ 917682 h 1232334"/>
              <a:gd name="connsiteX49" fmla="*/ 91489 w 1282073"/>
              <a:gd name="connsiteY49" fmla="*/ 1084830 h 1232334"/>
              <a:gd name="connsiteX50" fmla="*/ 32495 w 1282073"/>
              <a:gd name="connsiteY50" fmla="*/ 829192 h 1232334"/>
              <a:gd name="connsiteX51" fmla="*/ 22663 w 1282073"/>
              <a:gd name="connsiteY51" fmla="*/ 632546 h 1232334"/>
              <a:gd name="connsiteX52" fmla="*/ 12831 w 1282073"/>
              <a:gd name="connsiteY52" fmla="*/ 514559 h 1232334"/>
              <a:gd name="connsiteX0" fmla="*/ 12831 w 1282073"/>
              <a:gd name="connsiteY0" fmla="*/ 509761 h 1227536"/>
              <a:gd name="connsiteX1" fmla="*/ 229141 w 1282073"/>
              <a:gd name="connsiteY1" fmla="*/ 440936 h 1227536"/>
              <a:gd name="connsiteX2" fmla="*/ 347128 w 1282073"/>
              <a:gd name="connsiteY2" fmla="*/ 273787 h 1227536"/>
              <a:gd name="connsiteX3" fmla="*/ 327463 w 1282073"/>
              <a:gd name="connsiteY3" fmla="*/ 155800 h 1227536"/>
              <a:gd name="connsiteX4" fmla="*/ 386457 w 1282073"/>
              <a:gd name="connsiteY4" fmla="*/ 254123 h 1227536"/>
              <a:gd name="connsiteX5" fmla="*/ 337295 w 1282073"/>
              <a:gd name="connsiteY5" fmla="*/ 381942 h 1227536"/>
              <a:gd name="connsiteX6" fmla="*/ 288134 w 1282073"/>
              <a:gd name="connsiteY6" fmla="*/ 450768 h 1227536"/>
              <a:gd name="connsiteX7" fmla="*/ 406121 w 1282073"/>
              <a:gd name="connsiteY7" fmla="*/ 470432 h 1227536"/>
              <a:gd name="connsiteX8" fmla="*/ 592934 w 1282073"/>
              <a:gd name="connsiteY8" fmla="*/ 322948 h 1227536"/>
              <a:gd name="connsiteX9" fmla="*/ 752811 w 1282073"/>
              <a:gd name="connsiteY9" fmla="*/ 24498 h 1227536"/>
              <a:gd name="connsiteX10" fmla="*/ 976392 w 1282073"/>
              <a:gd name="connsiteY10" fmla="*/ 18148 h 1227536"/>
              <a:gd name="connsiteX11" fmla="*/ 799412 w 1282073"/>
              <a:gd name="connsiteY11" fmla="*/ 27981 h 1227536"/>
              <a:gd name="connsiteX12" fmla="*/ 671592 w 1282073"/>
              <a:gd name="connsiteY12" fmla="*/ 234458 h 1227536"/>
              <a:gd name="connsiteX13" fmla="*/ 531380 w 1282073"/>
              <a:gd name="connsiteY13" fmla="*/ 428850 h 1227536"/>
              <a:gd name="connsiteX14" fmla="*/ 288134 w 1282073"/>
              <a:gd name="connsiteY14" fmla="*/ 499929 h 1227536"/>
              <a:gd name="connsiteX15" fmla="*/ 288134 w 1282073"/>
              <a:gd name="connsiteY15" fmla="*/ 519594 h 1227536"/>
              <a:gd name="connsiteX16" fmla="*/ 691257 w 1282073"/>
              <a:gd name="connsiteY16" fmla="*/ 539258 h 1227536"/>
              <a:gd name="connsiteX17" fmla="*/ 1025553 w 1282073"/>
              <a:gd name="connsiteY17" fmla="*/ 676910 h 1227536"/>
              <a:gd name="connsiteX18" fmla="*/ 1281192 w 1282073"/>
              <a:gd name="connsiteY18" fmla="*/ 588419 h 1227536"/>
              <a:gd name="connsiteX19" fmla="*/ 1097554 w 1282073"/>
              <a:gd name="connsiteY19" fmla="*/ 684182 h 1227536"/>
              <a:gd name="connsiteX20" fmla="*/ 786097 w 1282073"/>
              <a:gd name="connsiteY20" fmla="*/ 609313 h 1227536"/>
              <a:gd name="connsiteX21" fmla="*/ 671592 w 1282073"/>
              <a:gd name="connsiteY21" fmla="*/ 598252 h 1227536"/>
              <a:gd name="connsiteX22" fmla="*/ 671592 w 1282073"/>
              <a:gd name="connsiteY22" fmla="*/ 686742 h 1227536"/>
              <a:gd name="connsiteX23" fmla="*/ 838741 w 1282073"/>
              <a:gd name="connsiteY23" fmla="*/ 745736 h 1227536"/>
              <a:gd name="connsiteX24" fmla="*/ 937063 w 1282073"/>
              <a:gd name="connsiteY24" fmla="*/ 883387 h 1227536"/>
              <a:gd name="connsiteX25" fmla="*/ 1015721 w 1282073"/>
              <a:gd name="connsiteY25" fmla="*/ 1001374 h 1227536"/>
              <a:gd name="connsiteX26" fmla="*/ 893945 w 1282073"/>
              <a:gd name="connsiteY26" fmla="*/ 854198 h 1227536"/>
              <a:gd name="connsiteX27" fmla="*/ 828908 w 1282073"/>
              <a:gd name="connsiteY27" fmla="*/ 765400 h 1227536"/>
              <a:gd name="connsiteX28" fmla="*/ 651928 w 1282073"/>
              <a:gd name="connsiteY28" fmla="*/ 706407 h 1227536"/>
              <a:gd name="connsiteX29" fmla="*/ 602766 w 1282073"/>
              <a:gd name="connsiteY29" fmla="*/ 617916 h 1227536"/>
              <a:gd name="connsiteX30" fmla="*/ 386457 w 1282073"/>
              <a:gd name="connsiteY30" fmla="*/ 578587 h 1227536"/>
              <a:gd name="connsiteX31" fmla="*/ 642095 w 1282073"/>
              <a:gd name="connsiteY31" fmla="*/ 873555 h 1227536"/>
              <a:gd name="connsiteX32" fmla="*/ 760082 w 1282073"/>
              <a:gd name="connsiteY32" fmla="*/ 1178355 h 1227536"/>
              <a:gd name="connsiteX33" fmla="*/ 642095 w 1282073"/>
              <a:gd name="connsiteY33" fmla="*/ 932548 h 1227536"/>
              <a:gd name="connsiteX34" fmla="*/ 533941 w 1282073"/>
              <a:gd name="connsiteY34" fmla="*/ 794897 h 1227536"/>
              <a:gd name="connsiteX35" fmla="*/ 396289 w 1282073"/>
              <a:gd name="connsiteY35" fmla="*/ 667077 h 1227536"/>
              <a:gd name="connsiteX36" fmla="*/ 268470 w 1282073"/>
              <a:gd name="connsiteY36" fmla="*/ 588419 h 1227536"/>
              <a:gd name="connsiteX37" fmla="*/ 101321 w 1282073"/>
              <a:gd name="connsiteY37" fmla="*/ 588419 h 1227536"/>
              <a:gd name="connsiteX38" fmla="*/ 179979 w 1282073"/>
              <a:gd name="connsiteY38" fmla="*/ 794897 h 1227536"/>
              <a:gd name="connsiteX39" fmla="*/ 435618 w 1282073"/>
              <a:gd name="connsiteY39" fmla="*/ 952213 h 1227536"/>
              <a:gd name="connsiteX40" fmla="*/ 494612 w 1282073"/>
              <a:gd name="connsiteY40" fmla="*/ 1011207 h 1227536"/>
              <a:gd name="connsiteX41" fmla="*/ 258637 w 1282073"/>
              <a:gd name="connsiteY41" fmla="*/ 883387 h 1227536"/>
              <a:gd name="connsiteX42" fmla="*/ 219308 w 1282073"/>
              <a:gd name="connsiteY42" fmla="*/ 903052 h 1227536"/>
              <a:gd name="connsiteX43" fmla="*/ 356960 w 1282073"/>
              <a:gd name="connsiteY43" fmla="*/ 1080032 h 1227536"/>
              <a:gd name="connsiteX44" fmla="*/ 602766 w 1282073"/>
              <a:gd name="connsiteY44" fmla="*/ 1227516 h 1227536"/>
              <a:gd name="connsiteX45" fmla="*/ 316095 w 1282073"/>
              <a:gd name="connsiteY45" fmla="*/ 1070200 h 1227536"/>
              <a:gd name="connsiteX46" fmla="*/ 209476 w 1282073"/>
              <a:gd name="connsiteY46" fmla="*/ 912884 h 1227536"/>
              <a:gd name="connsiteX47" fmla="*/ 81657 w 1282073"/>
              <a:gd name="connsiteY47" fmla="*/ 755568 h 1227536"/>
              <a:gd name="connsiteX48" fmla="*/ 81657 w 1282073"/>
              <a:gd name="connsiteY48" fmla="*/ 912884 h 1227536"/>
              <a:gd name="connsiteX49" fmla="*/ 91489 w 1282073"/>
              <a:gd name="connsiteY49" fmla="*/ 1080032 h 1227536"/>
              <a:gd name="connsiteX50" fmla="*/ 32495 w 1282073"/>
              <a:gd name="connsiteY50" fmla="*/ 824394 h 1227536"/>
              <a:gd name="connsiteX51" fmla="*/ 22663 w 1282073"/>
              <a:gd name="connsiteY51" fmla="*/ 627748 h 1227536"/>
              <a:gd name="connsiteX52" fmla="*/ 12831 w 1282073"/>
              <a:gd name="connsiteY52" fmla="*/ 509761 h 1227536"/>
              <a:gd name="connsiteX0" fmla="*/ 12831 w 1282073"/>
              <a:gd name="connsiteY0" fmla="*/ 509761 h 1227536"/>
              <a:gd name="connsiteX1" fmla="*/ 229141 w 1282073"/>
              <a:gd name="connsiteY1" fmla="*/ 440936 h 1227536"/>
              <a:gd name="connsiteX2" fmla="*/ 347128 w 1282073"/>
              <a:gd name="connsiteY2" fmla="*/ 273787 h 1227536"/>
              <a:gd name="connsiteX3" fmla="*/ 327463 w 1282073"/>
              <a:gd name="connsiteY3" fmla="*/ 155800 h 1227536"/>
              <a:gd name="connsiteX4" fmla="*/ 386457 w 1282073"/>
              <a:gd name="connsiteY4" fmla="*/ 254123 h 1227536"/>
              <a:gd name="connsiteX5" fmla="*/ 337295 w 1282073"/>
              <a:gd name="connsiteY5" fmla="*/ 381942 h 1227536"/>
              <a:gd name="connsiteX6" fmla="*/ 288134 w 1282073"/>
              <a:gd name="connsiteY6" fmla="*/ 450768 h 1227536"/>
              <a:gd name="connsiteX7" fmla="*/ 406121 w 1282073"/>
              <a:gd name="connsiteY7" fmla="*/ 470432 h 1227536"/>
              <a:gd name="connsiteX8" fmla="*/ 592934 w 1282073"/>
              <a:gd name="connsiteY8" fmla="*/ 322948 h 1227536"/>
              <a:gd name="connsiteX9" fmla="*/ 752811 w 1282073"/>
              <a:gd name="connsiteY9" fmla="*/ 24498 h 1227536"/>
              <a:gd name="connsiteX10" fmla="*/ 976392 w 1282073"/>
              <a:gd name="connsiteY10" fmla="*/ 18148 h 1227536"/>
              <a:gd name="connsiteX11" fmla="*/ 799412 w 1282073"/>
              <a:gd name="connsiteY11" fmla="*/ 27981 h 1227536"/>
              <a:gd name="connsiteX12" fmla="*/ 671592 w 1282073"/>
              <a:gd name="connsiteY12" fmla="*/ 234458 h 1227536"/>
              <a:gd name="connsiteX13" fmla="*/ 531380 w 1282073"/>
              <a:gd name="connsiteY13" fmla="*/ 428850 h 1227536"/>
              <a:gd name="connsiteX14" fmla="*/ 288134 w 1282073"/>
              <a:gd name="connsiteY14" fmla="*/ 499929 h 1227536"/>
              <a:gd name="connsiteX15" fmla="*/ 288134 w 1282073"/>
              <a:gd name="connsiteY15" fmla="*/ 519594 h 1227536"/>
              <a:gd name="connsiteX16" fmla="*/ 691257 w 1282073"/>
              <a:gd name="connsiteY16" fmla="*/ 539258 h 1227536"/>
              <a:gd name="connsiteX17" fmla="*/ 1025553 w 1282073"/>
              <a:gd name="connsiteY17" fmla="*/ 676910 h 1227536"/>
              <a:gd name="connsiteX18" fmla="*/ 1281192 w 1282073"/>
              <a:gd name="connsiteY18" fmla="*/ 588419 h 1227536"/>
              <a:gd name="connsiteX19" fmla="*/ 1097554 w 1282073"/>
              <a:gd name="connsiteY19" fmla="*/ 684182 h 1227536"/>
              <a:gd name="connsiteX20" fmla="*/ 786097 w 1282073"/>
              <a:gd name="connsiteY20" fmla="*/ 609313 h 1227536"/>
              <a:gd name="connsiteX21" fmla="*/ 671592 w 1282073"/>
              <a:gd name="connsiteY21" fmla="*/ 598252 h 1227536"/>
              <a:gd name="connsiteX22" fmla="*/ 671592 w 1282073"/>
              <a:gd name="connsiteY22" fmla="*/ 686742 h 1227536"/>
              <a:gd name="connsiteX23" fmla="*/ 838741 w 1282073"/>
              <a:gd name="connsiteY23" fmla="*/ 745736 h 1227536"/>
              <a:gd name="connsiteX24" fmla="*/ 937063 w 1282073"/>
              <a:gd name="connsiteY24" fmla="*/ 883387 h 1227536"/>
              <a:gd name="connsiteX25" fmla="*/ 1015721 w 1282073"/>
              <a:gd name="connsiteY25" fmla="*/ 1001374 h 1227536"/>
              <a:gd name="connsiteX26" fmla="*/ 893945 w 1282073"/>
              <a:gd name="connsiteY26" fmla="*/ 854198 h 1227536"/>
              <a:gd name="connsiteX27" fmla="*/ 828908 w 1282073"/>
              <a:gd name="connsiteY27" fmla="*/ 765400 h 1227536"/>
              <a:gd name="connsiteX28" fmla="*/ 651928 w 1282073"/>
              <a:gd name="connsiteY28" fmla="*/ 706407 h 1227536"/>
              <a:gd name="connsiteX29" fmla="*/ 602766 w 1282073"/>
              <a:gd name="connsiteY29" fmla="*/ 617916 h 1227536"/>
              <a:gd name="connsiteX30" fmla="*/ 386457 w 1282073"/>
              <a:gd name="connsiteY30" fmla="*/ 578587 h 1227536"/>
              <a:gd name="connsiteX31" fmla="*/ 642095 w 1282073"/>
              <a:gd name="connsiteY31" fmla="*/ 873555 h 1227536"/>
              <a:gd name="connsiteX32" fmla="*/ 760082 w 1282073"/>
              <a:gd name="connsiteY32" fmla="*/ 1178355 h 1227536"/>
              <a:gd name="connsiteX33" fmla="*/ 642095 w 1282073"/>
              <a:gd name="connsiteY33" fmla="*/ 932548 h 1227536"/>
              <a:gd name="connsiteX34" fmla="*/ 533941 w 1282073"/>
              <a:gd name="connsiteY34" fmla="*/ 794897 h 1227536"/>
              <a:gd name="connsiteX35" fmla="*/ 396289 w 1282073"/>
              <a:gd name="connsiteY35" fmla="*/ 667077 h 1227536"/>
              <a:gd name="connsiteX36" fmla="*/ 268470 w 1282073"/>
              <a:gd name="connsiteY36" fmla="*/ 588419 h 1227536"/>
              <a:gd name="connsiteX37" fmla="*/ 101321 w 1282073"/>
              <a:gd name="connsiteY37" fmla="*/ 588419 h 1227536"/>
              <a:gd name="connsiteX38" fmla="*/ 179979 w 1282073"/>
              <a:gd name="connsiteY38" fmla="*/ 794897 h 1227536"/>
              <a:gd name="connsiteX39" fmla="*/ 435618 w 1282073"/>
              <a:gd name="connsiteY39" fmla="*/ 952213 h 1227536"/>
              <a:gd name="connsiteX40" fmla="*/ 516837 w 1282073"/>
              <a:gd name="connsiteY40" fmla="*/ 1036607 h 1227536"/>
              <a:gd name="connsiteX41" fmla="*/ 258637 w 1282073"/>
              <a:gd name="connsiteY41" fmla="*/ 883387 h 1227536"/>
              <a:gd name="connsiteX42" fmla="*/ 219308 w 1282073"/>
              <a:gd name="connsiteY42" fmla="*/ 903052 h 1227536"/>
              <a:gd name="connsiteX43" fmla="*/ 356960 w 1282073"/>
              <a:gd name="connsiteY43" fmla="*/ 1080032 h 1227536"/>
              <a:gd name="connsiteX44" fmla="*/ 602766 w 1282073"/>
              <a:gd name="connsiteY44" fmla="*/ 1227516 h 1227536"/>
              <a:gd name="connsiteX45" fmla="*/ 316095 w 1282073"/>
              <a:gd name="connsiteY45" fmla="*/ 1070200 h 1227536"/>
              <a:gd name="connsiteX46" fmla="*/ 209476 w 1282073"/>
              <a:gd name="connsiteY46" fmla="*/ 912884 h 1227536"/>
              <a:gd name="connsiteX47" fmla="*/ 81657 w 1282073"/>
              <a:gd name="connsiteY47" fmla="*/ 755568 h 1227536"/>
              <a:gd name="connsiteX48" fmla="*/ 81657 w 1282073"/>
              <a:gd name="connsiteY48" fmla="*/ 912884 h 1227536"/>
              <a:gd name="connsiteX49" fmla="*/ 91489 w 1282073"/>
              <a:gd name="connsiteY49" fmla="*/ 1080032 h 1227536"/>
              <a:gd name="connsiteX50" fmla="*/ 32495 w 1282073"/>
              <a:gd name="connsiteY50" fmla="*/ 824394 h 1227536"/>
              <a:gd name="connsiteX51" fmla="*/ 22663 w 1282073"/>
              <a:gd name="connsiteY51" fmla="*/ 627748 h 1227536"/>
              <a:gd name="connsiteX52" fmla="*/ 12831 w 1282073"/>
              <a:gd name="connsiteY52" fmla="*/ 509761 h 1227536"/>
              <a:gd name="connsiteX0" fmla="*/ 12831 w 1282073"/>
              <a:gd name="connsiteY0" fmla="*/ 509761 h 1227536"/>
              <a:gd name="connsiteX1" fmla="*/ 229141 w 1282073"/>
              <a:gd name="connsiteY1" fmla="*/ 440936 h 1227536"/>
              <a:gd name="connsiteX2" fmla="*/ 347128 w 1282073"/>
              <a:gd name="connsiteY2" fmla="*/ 273787 h 1227536"/>
              <a:gd name="connsiteX3" fmla="*/ 327463 w 1282073"/>
              <a:gd name="connsiteY3" fmla="*/ 155800 h 1227536"/>
              <a:gd name="connsiteX4" fmla="*/ 386457 w 1282073"/>
              <a:gd name="connsiteY4" fmla="*/ 254123 h 1227536"/>
              <a:gd name="connsiteX5" fmla="*/ 337295 w 1282073"/>
              <a:gd name="connsiteY5" fmla="*/ 381942 h 1227536"/>
              <a:gd name="connsiteX6" fmla="*/ 288134 w 1282073"/>
              <a:gd name="connsiteY6" fmla="*/ 450768 h 1227536"/>
              <a:gd name="connsiteX7" fmla="*/ 406121 w 1282073"/>
              <a:gd name="connsiteY7" fmla="*/ 470432 h 1227536"/>
              <a:gd name="connsiteX8" fmla="*/ 592934 w 1282073"/>
              <a:gd name="connsiteY8" fmla="*/ 322948 h 1227536"/>
              <a:gd name="connsiteX9" fmla="*/ 752811 w 1282073"/>
              <a:gd name="connsiteY9" fmla="*/ 24498 h 1227536"/>
              <a:gd name="connsiteX10" fmla="*/ 976392 w 1282073"/>
              <a:gd name="connsiteY10" fmla="*/ 18148 h 1227536"/>
              <a:gd name="connsiteX11" fmla="*/ 799412 w 1282073"/>
              <a:gd name="connsiteY11" fmla="*/ 27981 h 1227536"/>
              <a:gd name="connsiteX12" fmla="*/ 671592 w 1282073"/>
              <a:gd name="connsiteY12" fmla="*/ 234458 h 1227536"/>
              <a:gd name="connsiteX13" fmla="*/ 531380 w 1282073"/>
              <a:gd name="connsiteY13" fmla="*/ 428850 h 1227536"/>
              <a:gd name="connsiteX14" fmla="*/ 288134 w 1282073"/>
              <a:gd name="connsiteY14" fmla="*/ 499929 h 1227536"/>
              <a:gd name="connsiteX15" fmla="*/ 288134 w 1282073"/>
              <a:gd name="connsiteY15" fmla="*/ 519594 h 1227536"/>
              <a:gd name="connsiteX16" fmla="*/ 691257 w 1282073"/>
              <a:gd name="connsiteY16" fmla="*/ 539258 h 1227536"/>
              <a:gd name="connsiteX17" fmla="*/ 1025553 w 1282073"/>
              <a:gd name="connsiteY17" fmla="*/ 676910 h 1227536"/>
              <a:gd name="connsiteX18" fmla="*/ 1281192 w 1282073"/>
              <a:gd name="connsiteY18" fmla="*/ 588419 h 1227536"/>
              <a:gd name="connsiteX19" fmla="*/ 1097554 w 1282073"/>
              <a:gd name="connsiteY19" fmla="*/ 684182 h 1227536"/>
              <a:gd name="connsiteX20" fmla="*/ 786097 w 1282073"/>
              <a:gd name="connsiteY20" fmla="*/ 609313 h 1227536"/>
              <a:gd name="connsiteX21" fmla="*/ 671592 w 1282073"/>
              <a:gd name="connsiteY21" fmla="*/ 598252 h 1227536"/>
              <a:gd name="connsiteX22" fmla="*/ 671592 w 1282073"/>
              <a:gd name="connsiteY22" fmla="*/ 686742 h 1227536"/>
              <a:gd name="connsiteX23" fmla="*/ 838741 w 1282073"/>
              <a:gd name="connsiteY23" fmla="*/ 745736 h 1227536"/>
              <a:gd name="connsiteX24" fmla="*/ 937063 w 1282073"/>
              <a:gd name="connsiteY24" fmla="*/ 883387 h 1227536"/>
              <a:gd name="connsiteX25" fmla="*/ 1015721 w 1282073"/>
              <a:gd name="connsiteY25" fmla="*/ 1001374 h 1227536"/>
              <a:gd name="connsiteX26" fmla="*/ 893945 w 1282073"/>
              <a:gd name="connsiteY26" fmla="*/ 854198 h 1227536"/>
              <a:gd name="connsiteX27" fmla="*/ 828908 w 1282073"/>
              <a:gd name="connsiteY27" fmla="*/ 765400 h 1227536"/>
              <a:gd name="connsiteX28" fmla="*/ 651928 w 1282073"/>
              <a:gd name="connsiteY28" fmla="*/ 706407 h 1227536"/>
              <a:gd name="connsiteX29" fmla="*/ 602766 w 1282073"/>
              <a:gd name="connsiteY29" fmla="*/ 617916 h 1227536"/>
              <a:gd name="connsiteX30" fmla="*/ 386457 w 1282073"/>
              <a:gd name="connsiteY30" fmla="*/ 578587 h 1227536"/>
              <a:gd name="connsiteX31" fmla="*/ 642095 w 1282073"/>
              <a:gd name="connsiteY31" fmla="*/ 873555 h 1227536"/>
              <a:gd name="connsiteX32" fmla="*/ 760082 w 1282073"/>
              <a:gd name="connsiteY32" fmla="*/ 1178355 h 1227536"/>
              <a:gd name="connsiteX33" fmla="*/ 642095 w 1282073"/>
              <a:gd name="connsiteY33" fmla="*/ 932548 h 1227536"/>
              <a:gd name="connsiteX34" fmla="*/ 533941 w 1282073"/>
              <a:gd name="connsiteY34" fmla="*/ 794897 h 1227536"/>
              <a:gd name="connsiteX35" fmla="*/ 396289 w 1282073"/>
              <a:gd name="connsiteY35" fmla="*/ 667077 h 1227536"/>
              <a:gd name="connsiteX36" fmla="*/ 268470 w 1282073"/>
              <a:gd name="connsiteY36" fmla="*/ 588419 h 1227536"/>
              <a:gd name="connsiteX37" fmla="*/ 101321 w 1282073"/>
              <a:gd name="connsiteY37" fmla="*/ 588419 h 1227536"/>
              <a:gd name="connsiteX38" fmla="*/ 179979 w 1282073"/>
              <a:gd name="connsiteY38" fmla="*/ 794897 h 1227536"/>
              <a:gd name="connsiteX39" fmla="*/ 435618 w 1282073"/>
              <a:gd name="connsiteY39" fmla="*/ 952213 h 1227536"/>
              <a:gd name="connsiteX40" fmla="*/ 516837 w 1282073"/>
              <a:gd name="connsiteY40" fmla="*/ 1036607 h 1227536"/>
              <a:gd name="connsiteX41" fmla="*/ 258637 w 1282073"/>
              <a:gd name="connsiteY41" fmla="*/ 883387 h 1227536"/>
              <a:gd name="connsiteX42" fmla="*/ 219308 w 1282073"/>
              <a:gd name="connsiteY42" fmla="*/ 903052 h 1227536"/>
              <a:gd name="connsiteX43" fmla="*/ 356960 w 1282073"/>
              <a:gd name="connsiteY43" fmla="*/ 1080032 h 1227536"/>
              <a:gd name="connsiteX44" fmla="*/ 602766 w 1282073"/>
              <a:gd name="connsiteY44" fmla="*/ 1227516 h 1227536"/>
              <a:gd name="connsiteX45" fmla="*/ 316095 w 1282073"/>
              <a:gd name="connsiteY45" fmla="*/ 1070200 h 1227536"/>
              <a:gd name="connsiteX46" fmla="*/ 209476 w 1282073"/>
              <a:gd name="connsiteY46" fmla="*/ 912884 h 1227536"/>
              <a:gd name="connsiteX47" fmla="*/ 81657 w 1282073"/>
              <a:gd name="connsiteY47" fmla="*/ 755568 h 1227536"/>
              <a:gd name="connsiteX48" fmla="*/ 81657 w 1282073"/>
              <a:gd name="connsiteY48" fmla="*/ 912884 h 1227536"/>
              <a:gd name="connsiteX49" fmla="*/ 91489 w 1282073"/>
              <a:gd name="connsiteY49" fmla="*/ 1080032 h 1227536"/>
              <a:gd name="connsiteX50" fmla="*/ 32495 w 1282073"/>
              <a:gd name="connsiteY50" fmla="*/ 824394 h 1227536"/>
              <a:gd name="connsiteX51" fmla="*/ 22663 w 1282073"/>
              <a:gd name="connsiteY51" fmla="*/ 627748 h 1227536"/>
              <a:gd name="connsiteX52" fmla="*/ 12831 w 1282073"/>
              <a:gd name="connsiteY52" fmla="*/ 509761 h 1227536"/>
              <a:gd name="connsiteX0" fmla="*/ 12831 w 1282073"/>
              <a:gd name="connsiteY0" fmla="*/ 509761 h 1227536"/>
              <a:gd name="connsiteX1" fmla="*/ 229141 w 1282073"/>
              <a:gd name="connsiteY1" fmla="*/ 440936 h 1227536"/>
              <a:gd name="connsiteX2" fmla="*/ 347128 w 1282073"/>
              <a:gd name="connsiteY2" fmla="*/ 273787 h 1227536"/>
              <a:gd name="connsiteX3" fmla="*/ 327463 w 1282073"/>
              <a:gd name="connsiteY3" fmla="*/ 155800 h 1227536"/>
              <a:gd name="connsiteX4" fmla="*/ 386457 w 1282073"/>
              <a:gd name="connsiteY4" fmla="*/ 254123 h 1227536"/>
              <a:gd name="connsiteX5" fmla="*/ 337295 w 1282073"/>
              <a:gd name="connsiteY5" fmla="*/ 381942 h 1227536"/>
              <a:gd name="connsiteX6" fmla="*/ 288134 w 1282073"/>
              <a:gd name="connsiteY6" fmla="*/ 450768 h 1227536"/>
              <a:gd name="connsiteX7" fmla="*/ 406121 w 1282073"/>
              <a:gd name="connsiteY7" fmla="*/ 470432 h 1227536"/>
              <a:gd name="connsiteX8" fmla="*/ 592934 w 1282073"/>
              <a:gd name="connsiteY8" fmla="*/ 322948 h 1227536"/>
              <a:gd name="connsiteX9" fmla="*/ 752811 w 1282073"/>
              <a:gd name="connsiteY9" fmla="*/ 24498 h 1227536"/>
              <a:gd name="connsiteX10" fmla="*/ 976392 w 1282073"/>
              <a:gd name="connsiteY10" fmla="*/ 18148 h 1227536"/>
              <a:gd name="connsiteX11" fmla="*/ 799412 w 1282073"/>
              <a:gd name="connsiteY11" fmla="*/ 27981 h 1227536"/>
              <a:gd name="connsiteX12" fmla="*/ 671592 w 1282073"/>
              <a:gd name="connsiteY12" fmla="*/ 234458 h 1227536"/>
              <a:gd name="connsiteX13" fmla="*/ 531380 w 1282073"/>
              <a:gd name="connsiteY13" fmla="*/ 428850 h 1227536"/>
              <a:gd name="connsiteX14" fmla="*/ 288134 w 1282073"/>
              <a:gd name="connsiteY14" fmla="*/ 499929 h 1227536"/>
              <a:gd name="connsiteX15" fmla="*/ 288134 w 1282073"/>
              <a:gd name="connsiteY15" fmla="*/ 519594 h 1227536"/>
              <a:gd name="connsiteX16" fmla="*/ 691257 w 1282073"/>
              <a:gd name="connsiteY16" fmla="*/ 539258 h 1227536"/>
              <a:gd name="connsiteX17" fmla="*/ 1025553 w 1282073"/>
              <a:gd name="connsiteY17" fmla="*/ 706094 h 1227536"/>
              <a:gd name="connsiteX18" fmla="*/ 1281192 w 1282073"/>
              <a:gd name="connsiteY18" fmla="*/ 588419 h 1227536"/>
              <a:gd name="connsiteX19" fmla="*/ 1097554 w 1282073"/>
              <a:gd name="connsiteY19" fmla="*/ 684182 h 1227536"/>
              <a:gd name="connsiteX20" fmla="*/ 786097 w 1282073"/>
              <a:gd name="connsiteY20" fmla="*/ 609313 h 1227536"/>
              <a:gd name="connsiteX21" fmla="*/ 671592 w 1282073"/>
              <a:gd name="connsiteY21" fmla="*/ 598252 h 1227536"/>
              <a:gd name="connsiteX22" fmla="*/ 671592 w 1282073"/>
              <a:gd name="connsiteY22" fmla="*/ 686742 h 1227536"/>
              <a:gd name="connsiteX23" fmla="*/ 838741 w 1282073"/>
              <a:gd name="connsiteY23" fmla="*/ 745736 h 1227536"/>
              <a:gd name="connsiteX24" fmla="*/ 937063 w 1282073"/>
              <a:gd name="connsiteY24" fmla="*/ 883387 h 1227536"/>
              <a:gd name="connsiteX25" fmla="*/ 1015721 w 1282073"/>
              <a:gd name="connsiteY25" fmla="*/ 1001374 h 1227536"/>
              <a:gd name="connsiteX26" fmla="*/ 893945 w 1282073"/>
              <a:gd name="connsiteY26" fmla="*/ 854198 h 1227536"/>
              <a:gd name="connsiteX27" fmla="*/ 828908 w 1282073"/>
              <a:gd name="connsiteY27" fmla="*/ 765400 h 1227536"/>
              <a:gd name="connsiteX28" fmla="*/ 651928 w 1282073"/>
              <a:gd name="connsiteY28" fmla="*/ 706407 h 1227536"/>
              <a:gd name="connsiteX29" fmla="*/ 602766 w 1282073"/>
              <a:gd name="connsiteY29" fmla="*/ 617916 h 1227536"/>
              <a:gd name="connsiteX30" fmla="*/ 386457 w 1282073"/>
              <a:gd name="connsiteY30" fmla="*/ 578587 h 1227536"/>
              <a:gd name="connsiteX31" fmla="*/ 642095 w 1282073"/>
              <a:gd name="connsiteY31" fmla="*/ 873555 h 1227536"/>
              <a:gd name="connsiteX32" fmla="*/ 760082 w 1282073"/>
              <a:gd name="connsiteY32" fmla="*/ 1178355 h 1227536"/>
              <a:gd name="connsiteX33" fmla="*/ 642095 w 1282073"/>
              <a:gd name="connsiteY33" fmla="*/ 932548 h 1227536"/>
              <a:gd name="connsiteX34" fmla="*/ 533941 w 1282073"/>
              <a:gd name="connsiteY34" fmla="*/ 794897 h 1227536"/>
              <a:gd name="connsiteX35" fmla="*/ 396289 w 1282073"/>
              <a:gd name="connsiteY35" fmla="*/ 667077 h 1227536"/>
              <a:gd name="connsiteX36" fmla="*/ 268470 w 1282073"/>
              <a:gd name="connsiteY36" fmla="*/ 588419 h 1227536"/>
              <a:gd name="connsiteX37" fmla="*/ 101321 w 1282073"/>
              <a:gd name="connsiteY37" fmla="*/ 588419 h 1227536"/>
              <a:gd name="connsiteX38" fmla="*/ 179979 w 1282073"/>
              <a:gd name="connsiteY38" fmla="*/ 794897 h 1227536"/>
              <a:gd name="connsiteX39" fmla="*/ 435618 w 1282073"/>
              <a:gd name="connsiteY39" fmla="*/ 952213 h 1227536"/>
              <a:gd name="connsiteX40" fmla="*/ 516837 w 1282073"/>
              <a:gd name="connsiteY40" fmla="*/ 1036607 h 1227536"/>
              <a:gd name="connsiteX41" fmla="*/ 258637 w 1282073"/>
              <a:gd name="connsiteY41" fmla="*/ 883387 h 1227536"/>
              <a:gd name="connsiteX42" fmla="*/ 219308 w 1282073"/>
              <a:gd name="connsiteY42" fmla="*/ 903052 h 1227536"/>
              <a:gd name="connsiteX43" fmla="*/ 356960 w 1282073"/>
              <a:gd name="connsiteY43" fmla="*/ 1080032 h 1227536"/>
              <a:gd name="connsiteX44" fmla="*/ 602766 w 1282073"/>
              <a:gd name="connsiteY44" fmla="*/ 1227516 h 1227536"/>
              <a:gd name="connsiteX45" fmla="*/ 316095 w 1282073"/>
              <a:gd name="connsiteY45" fmla="*/ 1070200 h 1227536"/>
              <a:gd name="connsiteX46" fmla="*/ 209476 w 1282073"/>
              <a:gd name="connsiteY46" fmla="*/ 912884 h 1227536"/>
              <a:gd name="connsiteX47" fmla="*/ 81657 w 1282073"/>
              <a:gd name="connsiteY47" fmla="*/ 755568 h 1227536"/>
              <a:gd name="connsiteX48" fmla="*/ 81657 w 1282073"/>
              <a:gd name="connsiteY48" fmla="*/ 912884 h 1227536"/>
              <a:gd name="connsiteX49" fmla="*/ 91489 w 1282073"/>
              <a:gd name="connsiteY49" fmla="*/ 1080032 h 1227536"/>
              <a:gd name="connsiteX50" fmla="*/ 32495 w 1282073"/>
              <a:gd name="connsiteY50" fmla="*/ 824394 h 1227536"/>
              <a:gd name="connsiteX51" fmla="*/ 22663 w 1282073"/>
              <a:gd name="connsiteY51" fmla="*/ 627748 h 1227536"/>
              <a:gd name="connsiteX52" fmla="*/ 12831 w 1282073"/>
              <a:gd name="connsiteY52" fmla="*/ 509761 h 1227536"/>
              <a:gd name="connsiteX0" fmla="*/ 12831 w 1281601"/>
              <a:gd name="connsiteY0" fmla="*/ 509761 h 1227536"/>
              <a:gd name="connsiteX1" fmla="*/ 229141 w 1281601"/>
              <a:gd name="connsiteY1" fmla="*/ 440936 h 1227536"/>
              <a:gd name="connsiteX2" fmla="*/ 347128 w 1281601"/>
              <a:gd name="connsiteY2" fmla="*/ 273787 h 1227536"/>
              <a:gd name="connsiteX3" fmla="*/ 327463 w 1281601"/>
              <a:gd name="connsiteY3" fmla="*/ 155800 h 1227536"/>
              <a:gd name="connsiteX4" fmla="*/ 386457 w 1281601"/>
              <a:gd name="connsiteY4" fmla="*/ 254123 h 1227536"/>
              <a:gd name="connsiteX5" fmla="*/ 337295 w 1281601"/>
              <a:gd name="connsiteY5" fmla="*/ 381942 h 1227536"/>
              <a:gd name="connsiteX6" fmla="*/ 288134 w 1281601"/>
              <a:gd name="connsiteY6" fmla="*/ 450768 h 1227536"/>
              <a:gd name="connsiteX7" fmla="*/ 406121 w 1281601"/>
              <a:gd name="connsiteY7" fmla="*/ 470432 h 1227536"/>
              <a:gd name="connsiteX8" fmla="*/ 592934 w 1281601"/>
              <a:gd name="connsiteY8" fmla="*/ 322948 h 1227536"/>
              <a:gd name="connsiteX9" fmla="*/ 752811 w 1281601"/>
              <a:gd name="connsiteY9" fmla="*/ 24498 h 1227536"/>
              <a:gd name="connsiteX10" fmla="*/ 976392 w 1281601"/>
              <a:gd name="connsiteY10" fmla="*/ 18148 h 1227536"/>
              <a:gd name="connsiteX11" fmla="*/ 799412 w 1281601"/>
              <a:gd name="connsiteY11" fmla="*/ 27981 h 1227536"/>
              <a:gd name="connsiteX12" fmla="*/ 671592 w 1281601"/>
              <a:gd name="connsiteY12" fmla="*/ 234458 h 1227536"/>
              <a:gd name="connsiteX13" fmla="*/ 531380 w 1281601"/>
              <a:gd name="connsiteY13" fmla="*/ 428850 h 1227536"/>
              <a:gd name="connsiteX14" fmla="*/ 288134 w 1281601"/>
              <a:gd name="connsiteY14" fmla="*/ 499929 h 1227536"/>
              <a:gd name="connsiteX15" fmla="*/ 288134 w 1281601"/>
              <a:gd name="connsiteY15" fmla="*/ 519594 h 1227536"/>
              <a:gd name="connsiteX16" fmla="*/ 691257 w 1281601"/>
              <a:gd name="connsiteY16" fmla="*/ 539258 h 1227536"/>
              <a:gd name="connsiteX17" fmla="*/ 1049872 w 1281601"/>
              <a:gd name="connsiteY17" fmla="*/ 642863 h 1227536"/>
              <a:gd name="connsiteX18" fmla="*/ 1281192 w 1281601"/>
              <a:gd name="connsiteY18" fmla="*/ 588419 h 1227536"/>
              <a:gd name="connsiteX19" fmla="*/ 1097554 w 1281601"/>
              <a:gd name="connsiteY19" fmla="*/ 684182 h 1227536"/>
              <a:gd name="connsiteX20" fmla="*/ 786097 w 1281601"/>
              <a:gd name="connsiteY20" fmla="*/ 609313 h 1227536"/>
              <a:gd name="connsiteX21" fmla="*/ 671592 w 1281601"/>
              <a:gd name="connsiteY21" fmla="*/ 598252 h 1227536"/>
              <a:gd name="connsiteX22" fmla="*/ 671592 w 1281601"/>
              <a:gd name="connsiteY22" fmla="*/ 686742 h 1227536"/>
              <a:gd name="connsiteX23" fmla="*/ 838741 w 1281601"/>
              <a:gd name="connsiteY23" fmla="*/ 745736 h 1227536"/>
              <a:gd name="connsiteX24" fmla="*/ 937063 w 1281601"/>
              <a:gd name="connsiteY24" fmla="*/ 883387 h 1227536"/>
              <a:gd name="connsiteX25" fmla="*/ 1015721 w 1281601"/>
              <a:gd name="connsiteY25" fmla="*/ 1001374 h 1227536"/>
              <a:gd name="connsiteX26" fmla="*/ 893945 w 1281601"/>
              <a:gd name="connsiteY26" fmla="*/ 854198 h 1227536"/>
              <a:gd name="connsiteX27" fmla="*/ 828908 w 1281601"/>
              <a:gd name="connsiteY27" fmla="*/ 765400 h 1227536"/>
              <a:gd name="connsiteX28" fmla="*/ 651928 w 1281601"/>
              <a:gd name="connsiteY28" fmla="*/ 706407 h 1227536"/>
              <a:gd name="connsiteX29" fmla="*/ 602766 w 1281601"/>
              <a:gd name="connsiteY29" fmla="*/ 617916 h 1227536"/>
              <a:gd name="connsiteX30" fmla="*/ 386457 w 1281601"/>
              <a:gd name="connsiteY30" fmla="*/ 578587 h 1227536"/>
              <a:gd name="connsiteX31" fmla="*/ 642095 w 1281601"/>
              <a:gd name="connsiteY31" fmla="*/ 873555 h 1227536"/>
              <a:gd name="connsiteX32" fmla="*/ 760082 w 1281601"/>
              <a:gd name="connsiteY32" fmla="*/ 1178355 h 1227536"/>
              <a:gd name="connsiteX33" fmla="*/ 642095 w 1281601"/>
              <a:gd name="connsiteY33" fmla="*/ 932548 h 1227536"/>
              <a:gd name="connsiteX34" fmla="*/ 533941 w 1281601"/>
              <a:gd name="connsiteY34" fmla="*/ 794897 h 1227536"/>
              <a:gd name="connsiteX35" fmla="*/ 396289 w 1281601"/>
              <a:gd name="connsiteY35" fmla="*/ 667077 h 1227536"/>
              <a:gd name="connsiteX36" fmla="*/ 268470 w 1281601"/>
              <a:gd name="connsiteY36" fmla="*/ 588419 h 1227536"/>
              <a:gd name="connsiteX37" fmla="*/ 101321 w 1281601"/>
              <a:gd name="connsiteY37" fmla="*/ 588419 h 1227536"/>
              <a:gd name="connsiteX38" fmla="*/ 179979 w 1281601"/>
              <a:gd name="connsiteY38" fmla="*/ 794897 h 1227536"/>
              <a:gd name="connsiteX39" fmla="*/ 435618 w 1281601"/>
              <a:gd name="connsiteY39" fmla="*/ 952213 h 1227536"/>
              <a:gd name="connsiteX40" fmla="*/ 516837 w 1281601"/>
              <a:gd name="connsiteY40" fmla="*/ 1036607 h 1227536"/>
              <a:gd name="connsiteX41" fmla="*/ 258637 w 1281601"/>
              <a:gd name="connsiteY41" fmla="*/ 883387 h 1227536"/>
              <a:gd name="connsiteX42" fmla="*/ 219308 w 1281601"/>
              <a:gd name="connsiteY42" fmla="*/ 903052 h 1227536"/>
              <a:gd name="connsiteX43" fmla="*/ 356960 w 1281601"/>
              <a:gd name="connsiteY43" fmla="*/ 1080032 h 1227536"/>
              <a:gd name="connsiteX44" fmla="*/ 602766 w 1281601"/>
              <a:gd name="connsiteY44" fmla="*/ 1227516 h 1227536"/>
              <a:gd name="connsiteX45" fmla="*/ 316095 w 1281601"/>
              <a:gd name="connsiteY45" fmla="*/ 1070200 h 1227536"/>
              <a:gd name="connsiteX46" fmla="*/ 209476 w 1281601"/>
              <a:gd name="connsiteY46" fmla="*/ 912884 h 1227536"/>
              <a:gd name="connsiteX47" fmla="*/ 81657 w 1281601"/>
              <a:gd name="connsiteY47" fmla="*/ 755568 h 1227536"/>
              <a:gd name="connsiteX48" fmla="*/ 81657 w 1281601"/>
              <a:gd name="connsiteY48" fmla="*/ 912884 h 1227536"/>
              <a:gd name="connsiteX49" fmla="*/ 91489 w 1281601"/>
              <a:gd name="connsiteY49" fmla="*/ 1080032 h 1227536"/>
              <a:gd name="connsiteX50" fmla="*/ 32495 w 1281601"/>
              <a:gd name="connsiteY50" fmla="*/ 824394 h 1227536"/>
              <a:gd name="connsiteX51" fmla="*/ 22663 w 1281601"/>
              <a:gd name="connsiteY51" fmla="*/ 627748 h 1227536"/>
              <a:gd name="connsiteX52" fmla="*/ 12831 w 1281601"/>
              <a:gd name="connsiteY52" fmla="*/ 509761 h 1227536"/>
              <a:gd name="connsiteX0" fmla="*/ 12831 w 1281824"/>
              <a:gd name="connsiteY0" fmla="*/ 509761 h 1227536"/>
              <a:gd name="connsiteX1" fmla="*/ 229141 w 1281824"/>
              <a:gd name="connsiteY1" fmla="*/ 440936 h 1227536"/>
              <a:gd name="connsiteX2" fmla="*/ 347128 w 1281824"/>
              <a:gd name="connsiteY2" fmla="*/ 273787 h 1227536"/>
              <a:gd name="connsiteX3" fmla="*/ 327463 w 1281824"/>
              <a:gd name="connsiteY3" fmla="*/ 155800 h 1227536"/>
              <a:gd name="connsiteX4" fmla="*/ 386457 w 1281824"/>
              <a:gd name="connsiteY4" fmla="*/ 254123 h 1227536"/>
              <a:gd name="connsiteX5" fmla="*/ 337295 w 1281824"/>
              <a:gd name="connsiteY5" fmla="*/ 381942 h 1227536"/>
              <a:gd name="connsiteX6" fmla="*/ 288134 w 1281824"/>
              <a:gd name="connsiteY6" fmla="*/ 450768 h 1227536"/>
              <a:gd name="connsiteX7" fmla="*/ 406121 w 1281824"/>
              <a:gd name="connsiteY7" fmla="*/ 470432 h 1227536"/>
              <a:gd name="connsiteX8" fmla="*/ 592934 w 1281824"/>
              <a:gd name="connsiteY8" fmla="*/ 322948 h 1227536"/>
              <a:gd name="connsiteX9" fmla="*/ 752811 w 1281824"/>
              <a:gd name="connsiteY9" fmla="*/ 24498 h 1227536"/>
              <a:gd name="connsiteX10" fmla="*/ 976392 w 1281824"/>
              <a:gd name="connsiteY10" fmla="*/ 18148 h 1227536"/>
              <a:gd name="connsiteX11" fmla="*/ 799412 w 1281824"/>
              <a:gd name="connsiteY11" fmla="*/ 27981 h 1227536"/>
              <a:gd name="connsiteX12" fmla="*/ 671592 w 1281824"/>
              <a:gd name="connsiteY12" fmla="*/ 234458 h 1227536"/>
              <a:gd name="connsiteX13" fmla="*/ 531380 w 1281824"/>
              <a:gd name="connsiteY13" fmla="*/ 428850 h 1227536"/>
              <a:gd name="connsiteX14" fmla="*/ 288134 w 1281824"/>
              <a:gd name="connsiteY14" fmla="*/ 499929 h 1227536"/>
              <a:gd name="connsiteX15" fmla="*/ 288134 w 1281824"/>
              <a:gd name="connsiteY15" fmla="*/ 519594 h 1227536"/>
              <a:gd name="connsiteX16" fmla="*/ 691257 w 1281824"/>
              <a:gd name="connsiteY16" fmla="*/ 539258 h 1227536"/>
              <a:gd name="connsiteX17" fmla="*/ 1049872 w 1281824"/>
              <a:gd name="connsiteY17" fmla="*/ 642863 h 1227536"/>
              <a:gd name="connsiteX18" fmla="*/ 1281192 w 1281824"/>
              <a:gd name="connsiteY18" fmla="*/ 588419 h 1227536"/>
              <a:gd name="connsiteX19" fmla="*/ 1107282 w 1281824"/>
              <a:gd name="connsiteY19" fmla="*/ 659860 h 1227536"/>
              <a:gd name="connsiteX20" fmla="*/ 786097 w 1281824"/>
              <a:gd name="connsiteY20" fmla="*/ 609313 h 1227536"/>
              <a:gd name="connsiteX21" fmla="*/ 671592 w 1281824"/>
              <a:gd name="connsiteY21" fmla="*/ 598252 h 1227536"/>
              <a:gd name="connsiteX22" fmla="*/ 671592 w 1281824"/>
              <a:gd name="connsiteY22" fmla="*/ 686742 h 1227536"/>
              <a:gd name="connsiteX23" fmla="*/ 838741 w 1281824"/>
              <a:gd name="connsiteY23" fmla="*/ 745736 h 1227536"/>
              <a:gd name="connsiteX24" fmla="*/ 937063 w 1281824"/>
              <a:gd name="connsiteY24" fmla="*/ 883387 h 1227536"/>
              <a:gd name="connsiteX25" fmla="*/ 1015721 w 1281824"/>
              <a:gd name="connsiteY25" fmla="*/ 1001374 h 1227536"/>
              <a:gd name="connsiteX26" fmla="*/ 893945 w 1281824"/>
              <a:gd name="connsiteY26" fmla="*/ 854198 h 1227536"/>
              <a:gd name="connsiteX27" fmla="*/ 828908 w 1281824"/>
              <a:gd name="connsiteY27" fmla="*/ 765400 h 1227536"/>
              <a:gd name="connsiteX28" fmla="*/ 651928 w 1281824"/>
              <a:gd name="connsiteY28" fmla="*/ 706407 h 1227536"/>
              <a:gd name="connsiteX29" fmla="*/ 602766 w 1281824"/>
              <a:gd name="connsiteY29" fmla="*/ 617916 h 1227536"/>
              <a:gd name="connsiteX30" fmla="*/ 386457 w 1281824"/>
              <a:gd name="connsiteY30" fmla="*/ 578587 h 1227536"/>
              <a:gd name="connsiteX31" fmla="*/ 642095 w 1281824"/>
              <a:gd name="connsiteY31" fmla="*/ 873555 h 1227536"/>
              <a:gd name="connsiteX32" fmla="*/ 760082 w 1281824"/>
              <a:gd name="connsiteY32" fmla="*/ 1178355 h 1227536"/>
              <a:gd name="connsiteX33" fmla="*/ 642095 w 1281824"/>
              <a:gd name="connsiteY33" fmla="*/ 932548 h 1227536"/>
              <a:gd name="connsiteX34" fmla="*/ 533941 w 1281824"/>
              <a:gd name="connsiteY34" fmla="*/ 794897 h 1227536"/>
              <a:gd name="connsiteX35" fmla="*/ 396289 w 1281824"/>
              <a:gd name="connsiteY35" fmla="*/ 667077 h 1227536"/>
              <a:gd name="connsiteX36" fmla="*/ 268470 w 1281824"/>
              <a:gd name="connsiteY36" fmla="*/ 588419 h 1227536"/>
              <a:gd name="connsiteX37" fmla="*/ 101321 w 1281824"/>
              <a:gd name="connsiteY37" fmla="*/ 588419 h 1227536"/>
              <a:gd name="connsiteX38" fmla="*/ 179979 w 1281824"/>
              <a:gd name="connsiteY38" fmla="*/ 794897 h 1227536"/>
              <a:gd name="connsiteX39" fmla="*/ 435618 w 1281824"/>
              <a:gd name="connsiteY39" fmla="*/ 952213 h 1227536"/>
              <a:gd name="connsiteX40" fmla="*/ 516837 w 1281824"/>
              <a:gd name="connsiteY40" fmla="*/ 1036607 h 1227536"/>
              <a:gd name="connsiteX41" fmla="*/ 258637 w 1281824"/>
              <a:gd name="connsiteY41" fmla="*/ 883387 h 1227536"/>
              <a:gd name="connsiteX42" fmla="*/ 219308 w 1281824"/>
              <a:gd name="connsiteY42" fmla="*/ 903052 h 1227536"/>
              <a:gd name="connsiteX43" fmla="*/ 356960 w 1281824"/>
              <a:gd name="connsiteY43" fmla="*/ 1080032 h 1227536"/>
              <a:gd name="connsiteX44" fmla="*/ 602766 w 1281824"/>
              <a:gd name="connsiteY44" fmla="*/ 1227516 h 1227536"/>
              <a:gd name="connsiteX45" fmla="*/ 316095 w 1281824"/>
              <a:gd name="connsiteY45" fmla="*/ 1070200 h 1227536"/>
              <a:gd name="connsiteX46" fmla="*/ 209476 w 1281824"/>
              <a:gd name="connsiteY46" fmla="*/ 912884 h 1227536"/>
              <a:gd name="connsiteX47" fmla="*/ 81657 w 1281824"/>
              <a:gd name="connsiteY47" fmla="*/ 755568 h 1227536"/>
              <a:gd name="connsiteX48" fmla="*/ 81657 w 1281824"/>
              <a:gd name="connsiteY48" fmla="*/ 912884 h 1227536"/>
              <a:gd name="connsiteX49" fmla="*/ 91489 w 1281824"/>
              <a:gd name="connsiteY49" fmla="*/ 1080032 h 1227536"/>
              <a:gd name="connsiteX50" fmla="*/ 32495 w 1281824"/>
              <a:gd name="connsiteY50" fmla="*/ 824394 h 1227536"/>
              <a:gd name="connsiteX51" fmla="*/ 22663 w 1281824"/>
              <a:gd name="connsiteY51" fmla="*/ 627748 h 1227536"/>
              <a:gd name="connsiteX52" fmla="*/ 12831 w 1281824"/>
              <a:gd name="connsiteY52" fmla="*/ 509761 h 12275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</a:cxnLst>
            <a:rect l="l" t="t" r="r" b="b"/>
            <a:pathLst>
              <a:path w="1281824" h="1227536">
                <a:moveTo>
                  <a:pt x="12831" y="509761"/>
                </a:moveTo>
                <a:cubicBezTo>
                  <a:pt x="47244" y="478626"/>
                  <a:pt x="173425" y="480265"/>
                  <a:pt x="229141" y="440936"/>
                </a:cubicBezTo>
                <a:cubicBezTo>
                  <a:pt x="284857" y="401607"/>
                  <a:pt x="330741" y="321310"/>
                  <a:pt x="347128" y="273787"/>
                </a:cubicBezTo>
                <a:cubicBezTo>
                  <a:pt x="363515" y="226264"/>
                  <a:pt x="320908" y="159077"/>
                  <a:pt x="327463" y="155800"/>
                </a:cubicBezTo>
                <a:cubicBezTo>
                  <a:pt x="334018" y="152523"/>
                  <a:pt x="384818" y="216433"/>
                  <a:pt x="386457" y="254123"/>
                </a:cubicBezTo>
                <a:cubicBezTo>
                  <a:pt x="388096" y="291813"/>
                  <a:pt x="353682" y="349168"/>
                  <a:pt x="337295" y="381942"/>
                </a:cubicBezTo>
                <a:cubicBezTo>
                  <a:pt x="320908" y="414716"/>
                  <a:pt x="276663" y="436020"/>
                  <a:pt x="288134" y="450768"/>
                </a:cubicBezTo>
                <a:cubicBezTo>
                  <a:pt x="299605" y="465516"/>
                  <a:pt x="355321" y="491735"/>
                  <a:pt x="406121" y="470432"/>
                </a:cubicBezTo>
                <a:cubicBezTo>
                  <a:pt x="456921" y="449129"/>
                  <a:pt x="535152" y="397270"/>
                  <a:pt x="592934" y="322948"/>
                </a:cubicBezTo>
                <a:cubicBezTo>
                  <a:pt x="650716" y="248626"/>
                  <a:pt x="688901" y="75298"/>
                  <a:pt x="752811" y="24498"/>
                </a:cubicBezTo>
                <a:cubicBezTo>
                  <a:pt x="816721" y="-26302"/>
                  <a:pt x="968625" y="17568"/>
                  <a:pt x="976392" y="18148"/>
                </a:cubicBezTo>
                <a:cubicBezTo>
                  <a:pt x="984159" y="18728"/>
                  <a:pt x="850212" y="-8071"/>
                  <a:pt x="799412" y="27981"/>
                </a:cubicBezTo>
                <a:cubicBezTo>
                  <a:pt x="748612" y="64033"/>
                  <a:pt x="716264" y="167647"/>
                  <a:pt x="671592" y="234458"/>
                </a:cubicBezTo>
                <a:cubicBezTo>
                  <a:pt x="626920" y="301269"/>
                  <a:pt x="595290" y="384605"/>
                  <a:pt x="531380" y="428850"/>
                </a:cubicBezTo>
                <a:cubicBezTo>
                  <a:pt x="467470" y="473095"/>
                  <a:pt x="328675" y="484805"/>
                  <a:pt x="288134" y="499929"/>
                </a:cubicBezTo>
                <a:cubicBezTo>
                  <a:pt x="247593" y="515053"/>
                  <a:pt x="220947" y="513039"/>
                  <a:pt x="288134" y="519594"/>
                </a:cubicBezTo>
                <a:cubicBezTo>
                  <a:pt x="355321" y="526149"/>
                  <a:pt x="564301" y="518713"/>
                  <a:pt x="691257" y="539258"/>
                </a:cubicBezTo>
                <a:cubicBezTo>
                  <a:pt x="818213" y="559803"/>
                  <a:pt x="951550" y="634670"/>
                  <a:pt x="1049872" y="642863"/>
                </a:cubicBezTo>
                <a:cubicBezTo>
                  <a:pt x="1148194" y="651056"/>
                  <a:pt x="1271624" y="585586"/>
                  <a:pt x="1281192" y="588419"/>
                </a:cubicBezTo>
                <a:cubicBezTo>
                  <a:pt x="1290760" y="591252"/>
                  <a:pt x="1189798" y="656378"/>
                  <a:pt x="1107282" y="659860"/>
                </a:cubicBezTo>
                <a:cubicBezTo>
                  <a:pt x="1024766" y="663342"/>
                  <a:pt x="858712" y="619581"/>
                  <a:pt x="786097" y="609313"/>
                </a:cubicBezTo>
                <a:cubicBezTo>
                  <a:pt x="713482" y="599045"/>
                  <a:pt x="690676" y="585347"/>
                  <a:pt x="671592" y="598252"/>
                </a:cubicBezTo>
                <a:cubicBezTo>
                  <a:pt x="652508" y="611157"/>
                  <a:pt x="643734" y="662161"/>
                  <a:pt x="671592" y="686742"/>
                </a:cubicBezTo>
                <a:cubicBezTo>
                  <a:pt x="699450" y="711323"/>
                  <a:pt x="794496" y="712962"/>
                  <a:pt x="838741" y="745736"/>
                </a:cubicBezTo>
                <a:cubicBezTo>
                  <a:pt x="882986" y="778510"/>
                  <a:pt x="907566" y="840781"/>
                  <a:pt x="937063" y="883387"/>
                </a:cubicBezTo>
                <a:cubicBezTo>
                  <a:pt x="966560" y="925993"/>
                  <a:pt x="1022907" y="1006239"/>
                  <a:pt x="1015721" y="1001374"/>
                </a:cubicBezTo>
                <a:cubicBezTo>
                  <a:pt x="1008535" y="996509"/>
                  <a:pt x="925080" y="893527"/>
                  <a:pt x="893945" y="854198"/>
                </a:cubicBezTo>
                <a:cubicBezTo>
                  <a:pt x="862810" y="814869"/>
                  <a:pt x="869244" y="790032"/>
                  <a:pt x="828908" y="765400"/>
                </a:cubicBezTo>
                <a:cubicBezTo>
                  <a:pt x="788572" y="740768"/>
                  <a:pt x="689618" y="730988"/>
                  <a:pt x="651928" y="706407"/>
                </a:cubicBezTo>
                <a:cubicBezTo>
                  <a:pt x="614238" y="681826"/>
                  <a:pt x="647011" y="639219"/>
                  <a:pt x="602766" y="617916"/>
                </a:cubicBezTo>
                <a:cubicBezTo>
                  <a:pt x="558521" y="596613"/>
                  <a:pt x="379902" y="535981"/>
                  <a:pt x="386457" y="578587"/>
                </a:cubicBezTo>
                <a:cubicBezTo>
                  <a:pt x="393012" y="621193"/>
                  <a:pt x="579824" y="773594"/>
                  <a:pt x="642095" y="873555"/>
                </a:cubicBezTo>
                <a:cubicBezTo>
                  <a:pt x="704366" y="973516"/>
                  <a:pt x="760082" y="1168523"/>
                  <a:pt x="760082" y="1178355"/>
                </a:cubicBezTo>
                <a:cubicBezTo>
                  <a:pt x="760082" y="1188187"/>
                  <a:pt x="679785" y="996458"/>
                  <a:pt x="642095" y="932548"/>
                </a:cubicBezTo>
                <a:cubicBezTo>
                  <a:pt x="604405" y="868638"/>
                  <a:pt x="574909" y="839142"/>
                  <a:pt x="533941" y="794897"/>
                </a:cubicBezTo>
                <a:cubicBezTo>
                  <a:pt x="492973" y="750652"/>
                  <a:pt x="440534" y="701490"/>
                  <a:pt x="396289" y="667077"/>
                </a:cubicBezTo>
                <a:cubicBezTo>
                  <a:pt x="352044" y="632664"/>
                  <a:pt x="317631" y="601529"/>
                  <a:pt x="268470" y="588419"/>
                </a:cubicBezTo>
                <a:cubicBezTo>
                  <a:pt x="219309" y="575309"/>
                  <a:pt x="116069" y="554006"/>
                  <a:pt x="101321" y="588419"/>
                </a:cubicBezTo>
                <a:cubicBezTo>
                  <a:pt x="86573" y="622832"/>
                  <a:pt x="124263" y="734265"/>
                  <a:pt x="179979" y="794897"/>
                </a:cubicBezTo>
                <a:cubicBezTo>
                  <a:pt x="235695" y="855529"/>
                  <a:pt x="379475" y="911928"/>
                  <a:pt x="435618" y="952213"/>
                </a:cubicBezTo>
                <a:cubicBezTo>
                  <a:pt x="491761" y="992498"/>
                  <a:pt x="527284" y="1079828"/>
                  <a:pt x="516837" y="1036607"/>
                </a:cubicBezTo>
                <a:cubicBezTo>
                  <a:pt x="506390" y="993386"/>
                  <a:pt x="308225" y="905646"/>
                  <a:pt x="258637" y="883387"/>
                </a:cubicBezTo>
                <a:cubicBezTo>
                  <a:pt x="209049" y="861128"/>
                  <a:pt x="202921" y="870278"/>
                  <a:pt x="219308" y="903052"/>
                </a:cubicBezTo>
                <a:cubicBezTo>
                  <a:pt x="235695" y="935826"/>
                  <a:pt x="293050" y="1025955"/>
                  <a:pt x="356960" y="1080032"/>
                </a:cubicBezTo>
                <a:cubicBezTo>
                  <a:pt x="420870" y="1134109"/>
                  <a:pt x="609577" y="1229155"/>
                  <a:pt x="602766" y="1227516"/>
                </a:cubicBezTo>
                <a:cubicBezTo>
                  <a:pt x="595955" y="1225877"/>
                  <a:pt x="381643" y="1122639"/>
                  <a:pt x="316095" y="1070200"/>
                </a:cubicBezTo>
                <a:cubicBezTo>
                  <a:pt x="250547" y="1017761"/>
                  <a:pt x="248549" y="965323"/>
                  <a:pt x="209476" y="912884"/>
                </a:cubicBezTo>
                <a:cubicBezTo>
                  <a:pt x="170403" y="860445"/>
                  <a:pt x="102960" y="755568"/>
                  <a:pt x="81657" y="755568"/>
                </a:cubicBezTo>
                <a:cubicBezTo>
                  <a:pt x="60354" y="755568"/>
                  <a:pt x="80018" y="858807"/>
                  <a:pt x="81657" y="912884"/>
                </a:cubicBezTo>
                <a:cubicBezTo>
                  <a:pt x="83296" y="966961"/>
                  <a:pt x="99683" y="1094780"/>
                  <a:pt x="91489" y="1080032"/>
                </a:cubicBezTo>
                <a:cubicBezTo>
                  <a:pt x="83295" y="1065284"/>
                  <a:pt x="43966" y="899775"/>
                  <a:pt x="32495" y="824394"/>
                </a:cubicBezTo>
                <a:cubicBezTo>
                  <a:pt x="21024" y="749013"/>
                  <a:pt x="21024" y="680187"/>
                  <a:pt x="22663" y="627748"/>
                </a:cubicBezTo>
                <a:cubicBezTo>
                  <a:pt x="24302" y="575309"/>
                  <a:pt x="-21582" y="540896"/>
                  <a:pt x="12831" y="50976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33135FBD-B53A-48C0-ABBA-9D1ABA00FD3B}"/>
              </a:ext>
            </a:extLst>
          </p:cNvPr>
          <p:cNvGrpSpPr/>
          <p:nvPr/>
        </p:nvGrpSpPr>
        <p:grpSpPr>
          <a:xfrm>
            <a:off x="1896149" y="9344946"/>
            <a:ext cx="1548829" cy="417869"/>
            <a:chOff x="1927279" y="1083125"/>
            <a:chExt cx="1260123" cy="339978"/>
          </a:xfrm>
          <a:solidFill>
            <a:schemeClr val="accent2">
              <a:lumMod val="60000"/>
              <a:lumOff val="40000"/>
            </a:schemeClr>
          </a:solidFill>
        </p:grpSpPr>
        <p:sp>
          <p:nvSpPr>
            <p:cNvPr id="8" name="任意多边形: 形状 7">
              <a:extLst>
                <a:ext uri="{FF2B5EF4-FFF2-40B4-BE49-F238E27FC236}">
                  <a16:creationId xmlns:a16="http://schemas.microsoft.com/office/drawing/2014/main" id="{93080334-CBC3-448B-8A3B-83C0FC074B3B}"/>
                </a:ext>
              </a:extLst>
            </p:cNvPr>
            <p:cNvSpPr/>
            <p:nvPr/>
          </p:nvSpPr>
          <p:spPr>
            <a:xfrm>
              <a:off x="2032659" y="1174071"/>
              <a:ext cx="1154743" cy="221338"/>
            </a:xfrm>
            <a:custGeom>
              <a:avLst/>
              <a:gdLst>
                <a:gd name="connsiteX0" fmla="*/ 10605 w 2358367"/>
                <a:gd name="connsiteY0" fmla="*/ 265 h 468400"/>
                <a:gd name="connsiteX1" fmla="*/ 820230 w 2358367"/>
                <a:gd name="connsiteY1" fmla="*/ 371740 h 468400"/>
                <a:gd name="connsiteX2" fmla="*/ 2268030 w 2358367"/>
                <a:gd name="connsiteY2" fmla="*/ 438415 h 468400"/>
                <a:gd name="connsiteX3" fmla="*/ 2087055 w 2358367"/>
                <a:gd name="connsiteY3" fmla="*/ 466990 h 468400"/>
                <a:gd name="connsiteX4" fmla="*/ 1115505 w 2358367"/>
                <a:gd name="connsiteY4" fmla="*/ 447940 h 468400"/>
                <a:gd name="connsiteX5" fmla="*/ 410655 w 2358367"/>
                <a:gd name="connsiteY5" fmla="*/ 314590 h 468400"/>
                <a:gd name="connsiteX6" fmla="*/ 10605 w 2358367"/>
                <a:gd name="connsiteY6" fmla="*/ 265 h 468400"/>
                <a:gd name="connsiteX0" fmla="*/ 7359 w 2355121"/>
                <a:gd name="connsiteY0" fmla="*/ 705 h 468840"/>
                <a:gd name="connsiteX1" fmla="*/ 816984 w 2355121"/>
                <a:gd name="connsiteY1" fmla="*/ 372180 h 468840"/>
                <a:gd name="connsiteX2" fmla="*/ 2264784 w 2355121"/>
                <a:gd name="connsiteY2" fmla="*/ 438855 h 468840"/>
                <a:gd name="connsiteX3" fmla="*/ 2083809 w 2355121"/>
                <a:gd name="connsiteY3" fmla="*/ 467430 h 468840"/>
                <a:gd name="connsiteX4" fmla="*/ 1112259 w 2355121"/>
                <a:gd name="connsiteY4" fmla="*/ 448380 h 468840"/>
                <a:gd name="connsiteX5" fmla="*/ 458209 w 2355121"/>
                <a:gd name="connsiteY5" fmla="*/ 283280 h 468840"/>
                <a:gd name="connsiteX6" fmla="*/ 7359 w 2355121"/>
                <a:gd name="connsiteY6" fmla="*/ 705 h 468840"/>
                <a:gd name="connsiteX0" fmla="*/ 7359 w 2359922"/>
                <a:gd name="connsiteY0" fmla="*/ 705 h 460965"/>
                <a:gd name="connsiteX1" fmla="*/ 816984 w 2359922"/>
                <a:gd name="connsiteY1" fmla="*/ 372180 h 460965"/>
                <a:gd name="connsiteX2" fmla="*/ 2264784 w 2359922"/>
                <a:gd name="connsiteY2" fmla="*/ 438855 h 460965"/>
                <a:gd name="connsiteX3" fmla="*/ 2099684 w 2359922"/>
                <a:gd name="connsiteY3" fmla="*/ 451555 h 460965"/>
                <a:gd name="connsiteX4" fmla="*/ 1112259 w 2359922"/>
                <a:gd name="connsiteY4" fmla="*/ 448380 h 460965"/>
                <a:gd name="connsiteX5" fmla="*/ 458209 w 2359922"/>
                <a:gd name="connsiteY5" fmla="*/ 283280 h 460965"/>
                <a:gd name="connsiteX6" fmla="*/ 7359 w 2359922"/>
                <a:gd name="connsiteY6" fmla="*/ 705 h 460965"/>
                <a:gd name="connsiteX0" fmla="*/ 7319 w 2358699"/>
                <a:gd name="connsiteY0" fmla="*/ 696 h 452108"/>
                <a:gd name="connsiteX1" fmla="*/ 816944 w 2358699"/>
                <a:gd name="connsiteY1" fmla="*/ 372171 h 452108"/>
                <a:gd name="connsiteX2" fmla="*/ 2264744 w 2358699"/>
                <a:gd name="connsiteY2" fmla="*/ 438846 h 452108"/>
                <a:gd name="connsiteX3" fmla="*/ 2099644 w 2358699"/>
                <a:gd name="connsiteY3" fmla="*/ 451546 h 452108"/>
                <a:gd name="connsiteX4" fmla="*/ 1147144 w 2358699"/>
                <a:gd name="connsiteY4" fmla="*/ 429321 h 452108"/>
                <a:gd name="connsiteX5" fmla="*/ 458169 w 2358699"/>
                <a:gd name="connsiteY5" fmla="*/ 283271 h 452108"/>
                <a:gd name="connsiteX6" fmla="*/ 7319 w 2358699"/>
                <a:gd name="connsiteY6" fmla="*/ 696 h 4521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358699" h="452108">
                  <a:moveTo>
                    <a:pt x="7319" y="696"/>
                  </a:moveTo>
                  <a:cubicBezTo>
                    <a:pt x="67115" y="15513"/>
                    <a:pt x="440707" y="299146"/>
                    <a:pt x="816944" y="372171"/>
                  </a:cubicBezTo>
                  <a:cubicBezTo>
                    <a:pt x="1193181" y="445196"/>
                    <a:pt x="2050961" y="425617"/>
                    <a:pt x="2264744" y="438846"/>
                  </a:cubicBezTo>
                  <a:cubicBezTo>
                    <a:pt x="2478527" y="452075"/>
                    <a:pt x="2285911" y="453134"/>
                    <a:pt x="2099644" y="451546"/>
                  </a:cubicBezTo>
                  <a:cubicBezTo>
                    <a:pt x="1913377" y="449959"/>
                    <a:pt x="1426544" y="454721"/>
                    <a:pt x="1147144" y="429321"/>
                  </a:cubicBezTo>
                  <a:cubicBezTo>
                    <a:pt x="867744" y="403921"/>
                    <a:pt x="648140" y="354708"/>
                    <a:pt x="458169" y="283271"/>
                  </a:cubicBezTo>
                  <a:cubicBezTo>
                    <a:pt x="268198" y="211834"/>
                    <a:pt x="-52477" y="-14121"/>
                    <a:pt x="7319" y="696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" name="任意多边形: 形状 100">
              <a:extLst>
                <a:ext uri="{FF2B5EF4-FFF2-40B4-BE49-F238E27FC236}">
                  <a16:creationId xmlns:a16="http://schemas.microsoft.com/office/drawing/2014/main" id="{9CCB68D7-6A8E-446A-AAD2-AFF7F3CFF4CA}"/>
                </a:ext>
              </a:extLst>
            </p:cNvPr>
            <p:cNvSpPr/>
            <p:nvPr/>
          </p:nvSpPr>
          <p:spPr>
            <a:xfrm>
              <a:off x="2075215" y="1193132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" name="任意多边形: 形状 101">
              <a:extLst>
                <a:ext uri="{FF2B5EF4-FFF2-40B4-BE49-F238E27FC236}">
                  <a16:creationId xmlns:a16="http://schemas.microsoft.com/office/drawing/2014/main" id="{FFAB9343-66EB-4F1C-A279-EEED59E3B03C}"/>
                </a:ext>
              </a:extLst>
            </p:cNvPr>
            <p:cNvSpPr/>
            <p:nvPr/>
          </p:nvSpPr>
          <p:spPr>
            <a:xfrm rot="21101213">
              <a:off x="2151354" y="1232118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" name="任意多边形: 形状 103">
              <a:extLst>
                <a:ext uri="{FF2B5EF4-FFF2-40B4-BE49-F238E27FC236}">
                  <a16:creationId xmlns:a16="http://schemas.microsoft.com/office/drawing/2014/main" id="{941FCDFC-AC96-4C65-AC65-F9F7ABD12ECD}"/>
                </a:ext>
              </a:extLst>
            </p:cNvPr>
            <p:cNvSpPr/>
            <p:nvPr/>
          </p:nvSpPr>
          <p:spPr>
            <a:xfrm rot="21079912">
              <a:off x="2235102" y="1273777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" name="任意多边形: 形状 105">
              <a:extLst>
                <a:ext uri="{FF2B5EF4-FFF2-40B4-BE49-F238E27FC236}">
                  <a16:creationId xmlns:a16="http://schemas.microsoft.com/office/drawing/2014/main" id="{ADE7EC37-0D30-4AE7-863D-3382F6648844}"/>
                </a:ext>
              </a:extLst>
            </p:cNvPr>
            <p:cNvSpPr/>
            <p:nvPr/>
          </p:nvSpPr>
          <p:spPr>
            <a:xfrm rot="20623611">
              <a:off x="2323311" y="1303658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" name="任意多边形: 形状 106">
              <a:extLst>
                <a:ext uri="{FF2B5EF4-FFF2-40B4-BE49-F238E27FC236}">
                  <a16:creationId xmlns:a16="http://schemas.microsoft.com/office/drawing/2014/main" id="{0017C178-51A2-4554-A45A-445FCEAB22F5}"/>
                </a:ext>
              </a:extLst>
            </p:cNvPr>
            <p:cNvSpPr/>
            <p:nvPr/>
          </p:nvSpPr>
          <p:spPr>
            <a:xfrm rot="20512159">
              <a:off x="2416092" y="1328019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" name="任意多边形: 形状 109">
              <a:extLst>
                <a:ext uri="{FF2B5EF4-FFF2-40B4-BE49-F238E27FC236}">
                  <a16:creationId xmlns:a16="http://schemas.microsoft.com/office/drawing/2014/main" id="{0C5D0EDC-F6A7-46C6-B583-8FA4D211EB73}"/>
                </a:ext>
              </a:extLst>
            </p:cNvPr>
            <p:cNvSpPr/>
            <p:nvPr/>
          </p:nvSpPr>
          <p:spPr>
            <a:xfrm rot="20001958">
              <a:off x="2510875" y="1347580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" name="任意多边形: 形状 111">
              <a:extLst>
                <a:ext uri="{FF2B5EF4-FFF2-40B4-BE49-F238E27FC236}">
                  <a16:creationId xmlns:a16="http://schemas.microsoft.com/office/drawing/2014/main" id="{DACF89F9-B808-4104-A2BE-8A3CB52346E4}"/>
                </a:ext>
              </a:extLst>
            </p:cNvPr>
            <p:cNvSpPr/>
            <p:nvPr/>
          </p:nvSpPr>
          <p:spPr>
            <a:xfrm rot="19740256">
              <a:off x="2605739" y="1351084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" name="任意多边形: 形状 113">
              <a:extLst>
                <a:ext uri="{FF2B5EF4-FFF2-40B4-BE49-F238E27FC236}">
                  <a16:creationId xmlns:a16="http://schemas.microsoft.com/office/drawing/2014/main" id="{3C1133A6-FA1E-46F0-B2CC-FD1CF4A83CE7}"/>
                </a:ext>
              </a:extLst>
            </p:cNvPr>
            <p:cNvSpPr/>
            <p:nvPr/>
          </p:nvSpPr>
          <p:spPr>
            <a:xfrm rot="19740256">
              <a:off x="2702094" y="1351085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" name="任意多边形: 形状 114">
              <a:extLst>
                <a:ext uri="{FF2B5EF4-FFF2-40B4-BE49-F238E27FC236}">
                  <a16:creationId xmlns:a16="http://schemas.microsoft.com/office/drawing/2014/main" id="{A480C0AC-37FA-43BC-B32F-4CBBFE729B5F}"/>
                </a:ext>
              </a:extLst>
            </p:cNvPr>
            <p:cNvSpPr/>
            <p:nvPr/>
          </p:nvSpPr>
          <p:spPr>
            <a:xfrm rot="19530412">
              <a:off x="2794729" y="1351084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6" name="任意多边形: 形状 115">
              <a:extLst>
                <a:ext uri="{FF2B5EF4-FFF2-40B4-BE49-F238E27FC236}">
                  <a16:creationId xmlns:a16="http://schemas.microsoft.com/office/drawing/2014/main" id="{818B4993-F0F4-4EDF-A221-92EB63050BFC}"/>
                </a:ext>
              </a:extLst>
            </p:cNvPr>
            <p:cNvSpPr/>
            <p:nvPr/>
          </p:nvSpPr>
          <p:spPr>
            <a:xfrm rot="19675566">
              <a:off x="2884636" y="1350053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" name="任意多边形: 形状 122">
              <a:extLst>
                <a:ext uri="{FF2B5EF4-FFF2-40B4-BE49-F238E27FC236}">
                  <a16:creationId xmlns:a16="http://schemas.microsoft.com/office/drawing/2014/main" id="{D0DF9676-BBD5-4865-B5CF-86FC165E483B}"/>
                </a:ext>
              </a:extLst>
            </p:cNvPr>
            <p:cNvSpPr/>
            <p:nvPr/>
          </p:nvSpPr>
          <p:spPr>
            <a:xfrm rot="19875844">
              <a:off x="2975994" y="1355309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" name="任意多边形: 形状 127">
              <a:extLst>
                <a:ext uri="{FF2B5EF4-FFF2-40B4-BE49-F238E27FC236}">
                  <a16:creationId xmlns:a16="http://schemas.microsoft.com/office/drawing/2014/main" id="{70BA66F4-203F-4736-A1B5-7793260F0D9B}"/>
                </a:ext>
              </a:extLst>
            </p:cNvPr>
            <p:cNvSpPr/>
            <p:nvPr/>
          </p:nvSpPr>
          <p:spPr>
            <a:xfrm rot="19894656">
              <a:off x="3065071" y="1355309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" name="任意多边形: 形状 129">
              <a:extLst>
                <a:ext uri="{FF2B5EF4-FFF2-40B4-BE49-F238E27FC236}">
                  <a16:creationId xmlns:a16="http://schemas.microsoft.com/office/drawing/2014/main" id="{0E5824AF-FCC0-44AC-88D9-9A041A37678F}"/>
                </a:ext>
              </a:extLst>
            </p:cNvPr>
            <p:cNvSpPr/>
            <p:nvPr/>
          </p:nvSpPr>
          <p:spPr>
            <a:xfrm rot="656223">
              <a:off x="1927279" y="1083125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" name="任意多边形: 形状 128">
              <a:extLst>
                <a:ext uri="{FF2B5EF4-FFF2-40B4-BE49-F238E27FC236}">
                  <a16:creationId xmlns:a16="http://schemas.microsoft.com/office/drawing/2014/main" id="{7BA9F315-C442-46D3-AA4F-8CB1487243AA}"/>
                </a:ext>
              </a:extLst>
            </p:cNvPr>
            <p:cNvSpPr/>
            <p:nvPr/>
          </p:nvSpPr>
          <p:spPr>
            <a:xfrm>
              <a:off x="1999077" y="1140308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53" name="椭圆 152">
            <a:extLst>
              <a:ext uri="{FF2B5EF4-FFF2-40B4-BE49-F238E27FC236}">
                <a16:creationId xmlns:a16="http://schemas.microsoft.com/office/drawing/2014/main" id="{C724EBC7-EA9A-46E7-80E9-50CD2EDA4987}"/>
              </a:ext>
            </a:extLst>
          </p:cNvPr>
          <p:cNvSpPr/>
          <p:nvPr/>
        </p:nvSpPr>
        <p:spPr>
          <a:xfrm rot="20672102">
            <a:off x="1784592" y="9344512"/>
            <a:ext cx="148139" cy="64544"/>
          </a:xfrm>
          <a:prstGeom prst="ellipse">
            <a:avLst/>
          </a:prstGeom>
          <a:solidFill>
            <a:schemeClr val="accent2">
              <a:lumMod val="20000"/>
              <a:lumOff val="8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任意多边形: 形状 12">
            <a:extLst>
              <a:ext uri="{FF2B5EF4-FFF2-40B4-BE49-F238E27FC236}">
                <a16:creationId xmlns:a16="http://schemas.microsoft.com/office/drawing/2014/main" id="{2F7FA6B7-C942-4471-ABBE-5A7106A22080}"/>
              </a:ext>
            </a:extLst>
          </p:cNvPr>
          <p:cNvSpPr/>
          <p:nvPr/>
        </p:nvSpPr>
        <p:spPr>
          <a:xfrm rot="20981025">
            <a:off x="3647551" y="9613385"/>
            <a:ext cx="1286235" cy="1055812"/>
          </a:xfrm>
          <a:custGeom>
            <a:avLst/>
            <a:gdLst>
              <a:gd name="connsiteX0" fmla="*/ 990631 w 2865682"/>
              <a:gd name="connsiteY0" fmla="*/ 455657 h 2355636"/>
              <a:gd name="connsiteX1" fmla="*/ 1181131 w 2865682"/>
              <a:gd name="connsiteY1" fmla="*/ 436607 h 2355636"/>
              <a:gd name="connsiteX2" fmla="*/ 1282731 w 2865682"/>
              <a:gd name="connsiteY2" fmla="*/ 487407 h 2355636"/>
              <a:gd name="connsiteX3" fmla="*/ 1308131 w 2865682"/>
              <a:gd name="connsiteY3" fmla="*/ 442957 h 2355636"/>
              <a:gd name="connsiteX4" fmla="*/ 1289081 w 2865682"/>
              <a:gd name="connsiteY4" fmla="*/ 322307 h 2355636"/>
              <a:gd name="connsiteX5" fmla="*/ 1333531 w 2865682"/>
              <a:gd name="connsiteY5" fmla="*/ 208007 h 2355636"/>
              <a:gd name="connsiteX6" fmla="*/ 1308131 w 2865682"/>
              <a:gd name="connsiteY6" fmla="*/ 335007 h 2355636"/>
              <a:gd name="connsiteX7" fmla="*/ 1333531 w 2865682"/>
              <a:gd name="connsiteY7" fmla="*/ 417557 h 2355636"/>
              <a:gd name="connsiteX8" fmla="*/ 1384331 w 2865682"/>
              <a:gd name="connsiteY8" fmla="*/ 296907 h 2355636"/>
              <a:gd name="connsiteX9" fmla="*/ 1339881 w 2865682"/>
              <a:gd name="connsiteY9" fmla="*/ 468357 h 2355636"/>
              <a:gd name="connsiteX10" fmla="*/ 1339881 w 2865682"/>
              <a:gd name="connsiteY10" fmla="*/ 506457 h 2355636"/>
              <a:gd name="connsiteX11" fmla="*/ 1308131 w 2865682"/>
              <a:gd name="connsiteY11" fmla="*/ 500107 h 2355636"/>
              <a:gd name="connsiteX12" fmla="*/ 1358931 w 2865682"/>
              <a:gd name="connsiteY12" fmla="*/ 817607 h 2355636"/>
              <a:gd name="connsiteX13" fmla="*/ 1428781 w 2865682"/>
              <a:gd name="connsiteY13" fmla="*/ 1020807 h 2355636"/>
              <a:gd name="connsiteX14" fmla="*/ 1689131 w 2865682"/>
              <a:gd name="connsiteY14" fmla="*/ 868407 h 2355636"/>
              <a:gd name="connsiteX15" fmla="*/ 1689131 w 2865682"/>
              <a:gd name="connsiteY15" fmla="*/ 487407 h 2355636"/>
              <a:gd name="connsiteX16" fmla="*/ 1739931 w 2865682"/>
              <a:gd name="connsiteY16" fmla="*/ 277857 h 2355636"/>
              <a:gd name="connsiteX17" fmla="*/ 1822481 w 2865682"/>
              <a:gd name="connsiteY17" fmla="*/ 119107 h 2355636"/>
              <a:gd name="connsiteX18" fmla="*/ 1733581 w 2865682"/>
              <a:gd name="connsiteY18" fmla="*/ 379457 h 2355636"/>
              <a:gd name="connsiteX19" fmla="*/ 1835181 w 2865682"/>
              <a:gd name="connsiteY19" fmla="*/ 373107 h 2355636"/>
              <a:gd name="connsiteX20" fmla="*/ 1917731 w 2865682"/>
              <a:gd name="connsiteY20" fmla="*/ 188957 h 2355636"/>
              <a:gd name="connsiteX21" fmla="*/ 1866931 w 2865682"/>
              <a:gd name="connsiteY21" fmla="*/ 417557 h 2355636"/>
              <a:gd name="connsiteX22" fmla="*/ 1720881 w 2865682"/>
              <a:gd name="connsiteY22" fmla="*/ 455657 h 2355636"/>
              <a:gd name="connsiteX23" fmla="*/ 1733581 w 2865682"/>
              <a:gd name="connsiteY23" fmla="*/ 646157 h 2355636"/>
              <a:gd name="connsiteX24" fmla="*/ 1936781 w 2865682"/>
              <a:gd name="connsiteY24" fmla="*/ 544557 h 2355636"/>
              <a:gd name="connsiteX25" fmla="*/ 1968531 w 2865682"/>
              <a:gd name="connsiteY25" fmla="*/ 119107 h 2355636"/>
              <a:gd name="connsiteX26" fmla="*/ 1981231 w 2865682"/>
              <a:gd name="connsiteY26" fmla="*/ 11157 h 2355636"/>
              <a:gd name="connsiteX27" fmla="*/ 1993931 w 2865682"/>
              <a:gd name="connsiteY27" fmla="*/ 335007 h 2355636"/>
              <a:gd name="connsiteX28" fmla="*/ 1968531 w 2865682"/>
              <a:gd name="connsiteY28" fmla="*/ 589007 h 2355636"/>
              <a:gd name="connsiteX29" fmla="*/ 1860581 w 2865682"/>
              <a:gd name="connsiteY29" fmla="*/ 665207 h 2355636"/>
              <a:gd name="connsiteX30" fmla="*/ 2057431 w 2865682"/>
              <a:gd name="connsiteY30" fmla="*/ 696957 h 2355636"/>
              <a:gd name="connsiteX31" fmla="*/ 2228881 w 2865682"/>
              <a:gd name="connsiteY31" fmla="*/ 652507 h 2355636"/>
              <a:gd name="connsiteX32" fmla="*/ 2089181 w 2865682"/>
              <a:gd name="connsiteY32" fmla="*/ 735057 h 2355636"/>
              <a:gd name="connsiteX33" fmla="*/ 1879631 w 2865682"/>
              <a:gd name="connsiteY33" fmla="*/ 722357 h 2355636"/>
              <a:gd name="connsiteX34" fmla="*/ 1784381 w 2865682"/>
              <a:gd name="connsiteY34" fmla="*/ 703307 h 2355636"/>
              <a:gd name="connsiteX35" fmla="*/ 1733581 w 2865682"/>
              <a:gd name="connsiteY35" fmla="*/ 868407 h 2355636"/>
              <a:gd name="connsiteX36" fmla="*/ 1574831 w 2865682"/>
              <a:gd name="connsiteY36" fmla="*/ 1052557 h 2355636"/>
              <a:gd name="connsiteX37" fmla="*/ 1536731 w 2865682"/>
              <a:gd name="connsiteY37" fmla="*/ 1306557 h 2355636"/>
              <a:gd name="connsiteX38" fmla="*/ 1828831 w 2865682"/>
              <a:gd name="connsiteY38" fmla="*/ 1351007 h 2355636"/>
              <a:gd name="connsiteX39" fmla="*/ 2139981 w 2865682"/>
              <a:gd name="connsiteY39" fmla="*/ 1071607 h 2355636"/>
              <a:gd name="connsiteX40" fmla="*/ 2101881 w 2865682"/>
              <a:gd name="connsiteY40" fmla="*/ 925557 h 2355636"/>
              <a:gd name="connsiteX41" fmla="*/ 2171731 w 2865682"/>
              <a:gd name="connsiteY41" fmla="*/ 792207 h 2355636"/>
              <a:gd name="connsiteX42" fmla="*/ 2139981 w 2865682"/>
              <a:gd name="connsiteY42" fmla="*/ 995407 h 2355636"/>
              <a:gd name="connsiteX43" fmla="*/ 2165381 w 2865682"/>
              <a:gd name="connsiteY43" fmla="*/ 1097007 h 2355636"/>
              <a:gd name="connsiteX44" fmla="*/ 1962181 w 2865682"/>
              <a:gd name="connsiteY44" fmla="*/ 1300207 h 2355636"/>
              <a:gd name="connsiteX45" fmla="*/ 2292381 w 2865682"/>
              <a:gd name="connsiteY45" fmla="*/ 1185907 h 2355636"/>
              <a:gd name="connsiteX46" fmla="*/ 2324131 w 2865682"/>
              <a:gd name="connsiteY46" fmla="*/ 735057 h 2355636"/>
              <a:gd name="connsiteX47" fmla="*/ 2362231 w 2865682"/>
              <a:gd name="connsiteY47" fmla="*/ 1001757 h 2355636"/>
              <a:gd name="connsiteX48" fmla="*/ 2349531 w 2865682"/>
              <a:gd name="connsiteY48" fmla="*/ 1185907 h 2355636"/>
              <a:gd name="connsiteX49" fmla="*/ 2540031 w 2865682"/>
              <a:gd name="connsiteY49" fmla="*/ 627107 h 2355636"/>
              <a:gd name="connsiteX50" fmla="*/ 2863881 w 2865682"/>
              <a:gd name="connsiteY50" fmla="*/ 411207 h 2355636"/>
              <a:gd name="connsiteX51" fmla="*/ 2667031 w 2865682"/>
              <a:gd name="connsiteY51" fmla="*/ 550907 h 2355636"/>
              <a:gd name="connsiteX52" fmla="*/ 2584481 w 2865682"/>
              <a:gd name="connsiteY52" fmla="*/ 633457 h 2355636"/>
              <a:gd name="connsiteX53" fmla="*/ 2533681 w 2865682"/>
              <a:gd name="connsiteY53" fmla="*/ 741407 h 2355636"/>
              <a:gd name="connsiteX54" fmla="*/ 2476531 w 2865682"/>
              <a:gd name="connsiteY54" fmla="*/ 919207 h 2355636"/>
              <a:gd name="connsiteX55" fmla="*/ 2673381 w 2865682"/>
              <a:gd name="connsiteY55" fmla="*/ 766807 h 2355636"/>
              <a:gd name="connsiteX56" fmla="*/ 2711481 w 2865682"/>
              <a:gd name="connsiteY56" fmla="*/ 639807 h 2355636"/>
              <a:gd name="connsiteX57" fmla="*/ 2717831 w 2865682"/>
              <a:gd name="connsiteY57" fmla="*/ 804907 h 2355636"/>
              <a:gd name="connsiteX58" fmla="*/ 2533681 w 2865682"/>
              <a:gd name="connsiteY58" fmla="*/ 950957 h 2355636"/>
              <a:gd name="connsiteX59" fmla="*/ 2438431 w 2865682"/>
              <a:gd name="connsiteY59" fmla="*/ 1109707 h 2355636"/>
              <a:gd name="connsiteX60" fmla="*/ 2381281 w 2865682"/>
              <a:gd name="connsiteY60" fmla="*/ 1274807 h 2355636"/>
              <a:gd name="connsiteX61" fmla="*/ 1993931 w 2865682"/>
              <a:gd name="connsiteY61" fmla="*/ 1401807 h 2355636"/>
              <a:gd name="connsiteX62" fmla="*/ 1854231 w 2865682"/>
              <a:gd name="connsiteY62" fmla="*/ 1401807 h 2355636"/>
              <a:gd name="connsiteX63" fmla="*/ 1581181 w 2865682"/>
              <a:gd name="connsiteY63" fmla="*/ 1458957 h 2355636"/>
              <a:gd name="connsiteX64" fmla="*/ 1339881 w 2865682"/>
              <a:gd name="connsiteY64" fmla="*/ 1611357 h 2355636"/>
              <a:gd name="connsiteX65" fmla="*/ 1377981 w 2865682"/>
              <a:gd name="connsiteY65" fmla="*/ 1782807 h 2355636"/>
              <a:gd name="connsiteX66" fmla="*/ 1803431 w 2865682"/>
              <a:gd name="connsiteY66" fmla="*/ 2036807 h 2355636"/>
              <a:gd name="connsiteX67" fmla="*/ 1365281 w 2865682"/>
              <a:gd name="connsiteY67" fmla="*/ 1865357 h 2355636"/>
              <a:gd name="connsiteX68" fmla="*/ 1225581 w 2865682"/>
              <a:gd name="connsiteY68" fmla="*/ 1687557 h 2355636"/>
              <a:gd name="connsiteX69" fmla="*/ 895381 w 2865682"/>
              <a:gd name="connsiteY69" fmla="*/ 1738357 h 2355636"/>
              <a:gd name="connsiteX70" fmla="*/ 704881 w 2865682"/>
              <a:gd name="connsiteY70" fmla="*/ 1973307 h 2355636"/>
              <a:gd name="connsiteX71" fmla="*/ 533431 w 2865682"/>
              <a:gd name="connsiteY71" fmla="*/ 2252707 h 2355636"/>
              <a:gd name="connsiteX72" fmla="*/ 190531 w 2865682"/>
              <a:gd name="connsiteY72" fmla="*/ 2354307 h 2355636"/>
              <a:gd name="connsiteX73" fmla="*/ 31 w 2865682"/>
              <a:gd name="connsiteY73" fmla="*/ 2309857 h 2355636"/>
              <a:gd name="connsiteX74" fmla="*/ 203231 w 2865682"/>
              <a:gd name="connsiteY74" fmla="*/ 2297157 h 2355636"/>
              <a:gd name="connsiteX75" fmla="*/ 457231 w 2865682"/>
              <a:gd name="connsiteY75" fmla="*/ 2227307 h 2355636"/>
              <a:gd name="connsiteX76" fmla="*/ 539781 w 2865682"/>
              <a:gd name="connsiteY76" fmla="*/ 2049507 h 2355636"/>
              <a:gd name="connsiteX77" fmla="*/ 488981 w 2865682"/>
              <a:gd name="connsiteY77" fmla="*/ 1871707 h 2355636"/>
              <a:gd name="connsiteX78" fmla="*/ 273081 w 2865682"/>
              <a:gd name="connsiteY78" fmla="*/ 2125707 h 2355636"/>
              <a:gd name="connsiteX79" fmla="*/ 114331 w 2865682"/>
              <a:gd name="connsiteY79" fmla="*/ 2132057 h 2355636"/>
              <a:gd name="connsiteX80" fmla="*/ 222281 w 2865682"/>
              <a:gd name="connsiteY80" fmla="*/ 2119357 h 2355636"/>
              <a:gd name="connsiteX81" fmla="*/ 355631 w 2865682"/>
              <a:gd name="connsiteY81" fmla="*/ 1960607 h 2355636"/>
              <a:gd name="connsiteX82" fmla="*/ 501681 w 2865682"/>
              <a:gd name="connsiteY82" fmla="*/ 1814557 h 2355636"/>
              <a:gd name="connsiteX83" fmla="*/ 819181 w 2865682"/>
              <a:gd name="connsiteY83" fmla="*/ 1636757 h 2355636"/>
              <a:gd name="connsiteX84" fmla="*/ 901731 w 2865682"/>
              <a:gd name="connsiteY84" fmla="*/ 1306557 h 2355636"/>
              <a:gd name="connsiteX85" fmla="*/ 641381 w 2865682"/>
              <a:gd name="connsiteY85" fmla="*/ 1179557 h 2355636"/>
              <a:gd name="connsiteX86" fmla="*/ 482631 w 2865682"/>
              <a:gd name="connsiteY86" fmla="*/ 1090657 h 2355636"/>
              <a:gd name="connsiteX87" fmla="*/ 717581 w 2865682"/>
              <a:gd name="connsiteY87" fmla="*/ 1173207 h 2355636"/>
              <a:gd name="connsiteX88" fmla="*/ 692181 w 2865682"/>
              <a:gd name="connsiteY88" fmla="*/ 950957 h 2355636"/>
              <a:gd name="connsiteX89" fmla="*/ 584231 w 2865682"/>
              <a:gd name="connsiteY89" fmla="*/ 830307 h 2355636"/>
              <a:gd name="connsiteX90" fmla="*/ 711231 w 2865682"/>
              <a:gd name="connsiteY90" fmla="*/ 931907 h 2355636"/>
              <a:gd name="connsiteX91" fmla="*/ 749331 w 2865682"/>
              <a:gd name="connsiteY91" fmla="*/ 1109707 h 2355636"/>
              <a:gd name="connsiteX92" fmla="*/ 781081 w 2865682"/>
              <a:gd name="connsiteY92" fmla="*/ 1058907 h 2355636"/>
              <a:gd name="connsiteX93" fmla="*/ 800131 w 2865682"/>
              <a:gd name="connsiteY93" fmla="*/ 912857 h 2355636"/>
              <a:gd name="connsiteX94" fmla="*/ 723931 w 2865682"/>
              <a:gd name="connsiteY94" fmla="*/ 722357 h 2355636"/>
              <a:gd name="connsiteX95" fmla="*/ 812831 w 2865682"/>
              <a:gd name="connsiteY95" fmla="*/ 862057 h 2355636"/>
              <a:gd name="connsiteX96" fmla="*/ 857281 w 2865682"/>
              <a:gd name="connsiteY96" fmla="*/ 1033507 h 2355636"/>
              <a:gd name="connsiteX97" fmla="*/ 812831 w 2865682"/>
              <a:gd name="connsiteY97" fmla="*/ 1204957 h 2355636"/>
              <a:gd name="connsiteX98" fmla="*/ 939831 w 2865682"/>
              <a:gd name="connsiteY98" fmla="*/ 1312907 h 2355636"/>
              <a:gd name="connsiteX99" fmla="*/ 1016031 w 2865682"/>
              <a:gd name="connsiteY99" fmla="*/ 1046207 h 2355636"/>
              <a:gd name="connsiteX100" fmla="*/ 1009681 w 2865682"/>
              <a:gd name="connsiteY100" fmla="*/ 1198607 h 2355636"/>
              <a:gd name="connsiteX101" fmla="*/ 1009681 w 2865682"/>
              <a:gd name="connsiteY101" fmla="*/ 1287507 h 2355636"/>
              <a:gd name="connsiteX102" fmla="*/ 1130331 w 2865682"/>
              <a:gd name="connsiteY102" fmla="*/ 1274807 h 2355636"/>
              <a:gd name="connsiteX103" fmla="*/ 1263681 w 2865682"/>
              <a:gd name="connsiteY103" fmla="*/ 1046207 h 2355636"/>
              <a:gd name="connsiteX104" fmla="*/ 1301781 w 2865682"/>
              <a:gd name="connsiteY104" fmla="*/ 665207 h 2355636"/>
              <a:gd name="connsiteX105" fmla="*/ 1289081 w 2865682"/>
              <a:gd name="connsiteY105" fmla="*/ 538207 h 2355636"/>
              <a:gd name="connsiteX106" fmla="*/ 990631 w 2865682"/>
              <a:gd name="connsiteY106" fmla="*/ 455657 h 2355636"/>
              <a:gd name="connsiteX0" fmla="*/ 990631 w 2865682"/>
              <a:gd name="connsiteY0" fmla="*/ 455657 h 2355636"/>
              <a:gd name="connsiteX1" fmla="*/ 1181131 w 2865682"/>
              <a:gd name="connsiteY1" fmla="*/ 436607 h 2355636"/>
              <a:gd name="connsiteX2" fmla="*/ 1282731 w 2865682"/>
              <a:gd name="connsiteY2" fmla="*/ 487407 h 2355636"/>
              <a:gd name="connsiteX3" fmla="*/ 1308131 w 2865682"/>
              <a:gd name="connsiteY3" fmla="*/ 442957 h 2355636"/>
              <a:gd name="connsiteX4" fmla="*/ 1289081 w 2865682"/>
              <a:gd name="connsiteY4" fmla="*/ 322307 h 2355636"/>
              <a:gd name="connsiteX5" fmla="*/ 1333531 w 2865682"/>
              <a:gd name="connsiteY5" fmla="*/ 208007 h 2355636"/>
              <a:gd name="connsiteX6" fmla="*/ 1308131 w 2865682"/>
              <a:gd name="connsiteY6" fmla="*/ 335007 h 2355636"/>
              <a:gd name="connsiteX7" fmla="*/ 1333531 w 2865682"/>
              <a:gd name="connsiteY7" fmla="*/ 417557 h 2355636"/>
              <a:gd name="connsiteX8" fmla="*/ 1384331 w 2865682"/>
              <a:gd name="connsiteY8" fmla="*/ 296907 h 2355636"/>
              <a:gd name="connsiteX9" fmla="*/ 1339881 w 2865682"/>
              <a:gd name="connsiteY9" fmla="*/ 468357 h 2355636"/>
              <a:gd name="connsiteX10" fmla="*/ 1339881 w 2865682"/>
              <a:gd name="connsiteY10" fmla="*/ 506457 h 2355636"/>
              <a:gd name="connsiteX11" fmla="*/ 1308131 w 2865682"/>
              <a:gd name="connsiteY11" fmla="*/ 500107 h 2355636"/>
              <a:gd name="connsiteX12" fmla="*/ 1358931 w 2865682"/>
              <a:gd name="connsiteY12" fmla="*/ 817607 h 2355636"/>
              <a:gd name="connsiteX13" fmla="*/ 1428781 w 2865682"/>
              <a:gd name="connsiteY13" fmla="*/ 1020807 h 2355636"/>
              <a:gd name="connsiteX14" fmla="*/ 1689131 w 2865682"/>
              <a:gd name="connsiteY14" fmla="*/ 868407 h 2355636"/>
              <a:gd name="connsiteX15" fmla="*/ 1689131 w 2865682"/>
              <a:gd name="connsiteY15" fmla="*/ 487407 h 2355636"/>
              <a:gd name="connsiteX16" fmla="*/ 1739931 w 2865682"/>
              <a:gd name="connsiteY16" fmla="*/ 277857 h 2355636"/>
              <a:gd name="connsiteX17" fmla="*/ 1822481 w 2865682"/>
              <a:gd name="connsiteY17" fmla="*/ 119107 h 2355636"/>
              <a:gd name="connsiteX18" fmla="*/ 1733581 w 2865682"/>
              <a:gd name="connsiteY18" fmla="*/ 379457 h 2355636"/>
              <a:gd name="connsiteX19" fmla="*/ 1835181 w 2865682"/>
              <a:gd name="connsiteY19" fmla="*/ 373107 h 2355636"/>
              <a:gd name="connsiteX20" fmla="*/ 1917731 w 2865682"/>
              <a:gd name="connsiteY20" fmla="*/ 188957 h 2355636"/>
              <a:gd name="connsiteX21" fmla="*/ 1866931 w 2865682"/>
              <a:gd name="connsiteY21" fmla="*/ 417557 h 2355636"/>
              <a:gd name="connsiteX22" fmla="*/ 1720881 w 2865682"/>
              <a:gd name="connsiteY22" fmla="*/ 455657 h 2355636"/>
              <a:gd name="connsiteX23" fmla="*/ 1733581 w 2865682"/>
              <a:gd name="connsiteY23" fmla="*/ 646157 h 2355636"/>
              <a:gd name="connsiteX24" fmla="*/ 1936781 w 2865682"/>
              <a:gd name="connsiteY24" fmla="*/ 544557 h 2355636"/>
              <a:gd name="connsiteX25" fmla="*/ 1968531 w 2865682"/>
              <a:gd name="connsiteY25" fmla="*/ 119107 h 2355636"/>
              <a:gd name="connsiteX26" fmla="*/ 1981231 w 2865682"/>
              <a:gd name="connsiteY26" fmla="*/ 11157 h 2355636"/>
              <a:gd name="connsiteX27" fmla="*/ 1993931 w 2865682"/>
              <a:gd name="connsiteY27" fmla="*/ 335007 h 2355636"/>
              <a:gd name="connsiteX28" fmla="*/ 1968531 w 2865682"/>
              <a:gd name="connsiteY28" fmla="*/ 589007 h 2355636"/>
              <a:gd name="connsiteX29" fmla="*/ 1860581 w 2865682"/>
              <a:gd name="connsiteY29" fmla="*/ 665207 h 2355636"/>
              <a:gd name="connsiteX30" fmla="*/ 2057431 w 2865682"/>
              <a:gd name="connsiteY30" fmla="*/ 696957 h 2355636"/>
              <a:gd name="connsiteX31" fmla="*/ 2228881 w 2865682"/>
              <a:gd name="connsiteY31" fmla="*/ 652507 h 2355636"/>
              <a:gd name="connsiteX32" fmla="*/ 2089181 w 2865682"/>
              <a:gd name="connsiteY32" fmla="*/ 735057 h 2355636"/>
              <a:gd name="connsiteX33" fmla="*/ 1879631 w 2865682"/>
              <a:gd name="connsiteY33" fmla="*/ 722357 h 2355636"/>
              <a:gd name="connsiteX34" fmla="*/ 1784381 w 2865682"/>
              <a:gd name="connsiteY34" fmla="*/ 703307 h 2355636"/>
              <a:gd name="connsiteX35" fmla="*/ 1733581 w 2865682"/>
              <a:gd name="connsiteY35" fmla="*/ 868407 h 2355636"/>
              <a:gd name="connsiteX36" fmla="*/ 1574831 w 2865682"/>
              <a:gd name="connsiteY36" fmla="*/ 1052557 h 2355636"/>
              <a:gd name="connsiteX37" fmla="*/ 1536731 w 2865682"/>
              <a:gd name="connsiteY37" fmla="*/ 1306557 h 2355636"/>
              <a:gd name="connsiteX38" fmla="*/ 1828831 w 2865682"/>
              <a:gd name="connsiteY38" fmla="*/ 1351007 h 2355636"/>
              <a:gd name="connsiteX39" fmla="*/ 2139981 w 2865682"/>
              <a:gd name="connsiteY39" fmla="*/ 1071607 h 2355636"/>
              <a:gd name="connsiteX40" fmla="*/ 2101881 w 2865682"/>
              <a:gd name="connsiteY40" fmla="*/ 925557 h 2355636"/>
              <a:gd name="connsiteX41" fmla="*/ 2171731 w 2865682"/>
              <a:gd name="connsiteY41" fmla="*/ 792207 h 2355636"/>
              <a:gd name="connsiteX42" fmla="*/ 2139981 w 2865682"/>
              <a:gd name="connsiteY42" fmla="*/ 995407 h 2355636"/>
              <a:gd name="connsiteX43" fmla="*/ 2165381 w 2865682"/>
              <a:gd name="connsiteY43" fmla="*/ 1097007 h 2355636"/>
              <a:gd name="connsiteX44" fmla="*/ 1962181 w 2865682"/>
              <a:gd name="connsiteY44" fmla="*/ 1300207 h 2355636"/>
              <a:gd name="connsiteX45" fmla="*/ 2292381 w 2865682"/>
              <a:gd name="connsiteY45" fmla="*/ 1185907 h 2355636"/>
              <a:gd name="connsiteX46" fmla="*/ 2324131 w 2865682"/>
              <a:gd name="connsiteY46" fmla="*/ 735057 h 2355636"/>
              <a:gd name="connsiteX47" fmla="*/ 2362231 w 2865682"/>
              <a:gd name="connsiteY47" fmla="*/ 1001757 h 2355636"/>
              <a:gd name="connsiteX48" fmla="*/ 2349531 w 2865682"/>
              <a:gd name="connsiteY48" fmla="*/ 1185907 h 2355636"/>
              <a:gd name="connsiteX49" fmla="*/ 2540031 w 2865682"/>
              <a:gd name="connsiteY49" fmla="*/ 627107 h 2355636"/>
              <a:gd name="connsiteX50" fmla="*/ 2863881 w 2865682"/>
              <a:gd name="connsiteY50" fmla="*/ 411207 h 2355636"/>
              <a:gd name="connsiteX51" fmla="*/ 2667031 w 2865682"/>
              <a:gd name="connsiteY51" fmla="*/ 550907 h 2355636"/>
              <a:gd name="connsiteX52" fmla="*/ 2584481 w 2865682"/>
              <a:gd name="connsiteY52" fmla="*/ 633457 h 2355636"/>
              <a:gd name="connsiteX53" fmla="*/ 2533681 w 2865682"/>
              <a:gd name="connsiteY53" fmla="*/ 741407 h 2355636"/>
              <a:gd name="connsiteX54" fmla="*/ 2476531 w 2865682"/>
              <a:gd name="connsiteY54" fmla="*/ 919207 h 2355636"/>
              <a:gd name="connsiteX55" fmla="*/ 2673381 w 2865682"/>
              <a:gd name="connsiteY55" fmla="*/ 766807 h 2355636"/>
              <a:gd name="connsiteX56" fmla="*/ 2711481 w 2865682"/>
              <a:gd name="connsiteY56" fmla="*/ 639807 h 2355636"/>
              <a:gd name="connsiteX57" fmla="*/ 2717831 w 2865682"/>
              <a:gd name="connsiteY57" fmla="*/ 804907 h 2355636"/>
              <a:gd name="connsiteX58" fmla="*/ 2533681 w 2865682"/>
              <a:gd name="connsiteY58" fmla="*/ 950957 h 2355636"/>
              <a:gd name="connsiteX59" fmla="*/ 2438431 w 2865682"/>
              <a:gd name="connsiteY59" fmla="*/ 1109707 h 2355636"/>
              <a:gd name="connsiteX60" fmla="*/ 2381281 w 2865682"/>
              <a:gd name="connsiteY60" fmla="*/ 1274807 h 2355636"/>
              <a:gd name="connsiteX61" fmla="*/ 1993931 w 2865682"/>
              <a:gd name="connsiteY61" fmla="*/ 1401807 h 2355636"/>
              <a:gd name="connsiteX62" fmla="*/ 1854231 w 2865682"/>
              <a:gd name="connsiteY62" fmla="*/ 1401807 h 2355636"/>
              <a:gd name="connsiteX63" fmla="*/ 1581181 w 2865682"/>
              <a:gd name="connsiteY63" fmla="*/ 1458957 h 2355636"/>
              <a:gd name="connsiteX64" fmla="*/ 1339881 w 2865682"/>
              <a:gd name="connsiteY64" fmla="*/ 1611357 h 2355636"/>
              <a:gd name="connsiteX65" fmla="*/ 1377981 w 2865682"/>
              <a:gd name="connsiteY65" fmla="*/ 1782807 h 2355636"/>
              <a:gd name="connsiteX66" fmla="*/ 1803431 w 2865682"/>
              <a:gd name="connsiteY66" fmla="*/ 2036807 h 2355636"/>
              <a:gd name="connsiteX67" fmla="*/ 1365281 w 2865682"/>
              <a:gd name="connsiteY67" fmla="*/ 1865357 h 2355636"/>
              <a:gd name="connsiteX68" fmla="*/ 1225581 w 2865682"/>
              <a:gd name="connsiteY68" fmla="*/ 1687557 h 2355636"/>
              <a:gd name="connsiteX69" fmla="*/ 895381 w 2865682"/>
              <a:gd name="connsiteY69" fmla="*/ 1738357 h 2355636"/>
              <a:gd name="connsiteX70" fmla="*/ 704881 w 2865682"/>
              <a:gd name="connsiteY70" fmla="*/ 1973307 h 2355636"/>
              <a:gd name="connsiteX71" fmla="*/ 533431 w 2865682"/>
              <a:gd name="connsiteY71" fmla="*/ 2252707 h 2355636"/>
              <a:gd name="connsiteX72" fmla="*/ 190531 w 2865682"/>
              <a:gd name="connsiteY72" fmla="*/ 2354307 h 2355636"/>
              <a:gd name="connsiteX73" fmla="*/ 31 w 2865682"/>
              <a:gd name="connsiteY73" fmla="*/ 2309857 h 2355636"/>
              <a:gd name="connsiteX74" fmla="*/ 203231 w 2865682"/>
              <a:gd name="connsiteY74" fmla="*/ 2297157 h 2355636"/>
              <a:gd name="connsiteX75" fmla="*/ 457231 w 2865682"/>
              <a:gd name="connsiteY75" fmla="*/ 2227307 h 2355636"/>
              <a:gd name="connsiteX76" fmla="*/ 539781 w 2865682"/>
              <a:gd name="connsiteY76" fmla="*/ 2049507 h 2355636"/>
              <a:gd name="connsiteX77" fmla="*/ 673131 w 2865682"/>
              <a:gd name="connsiteY77" fmla="*/ 1808207 h 2355636"/>
              <a:gd name="connsiteX78" fmla="*/ 273081 w 2865682"/>
              <a:gd name="connsiteY78" fmla="*/ 2125707 h 2355636"/>
              <a:gd name="connsiteX79" fmla="*/ 114331 w 2865682"/>
              <a:gd name="connsiteY79" fmla="*/ 2132057 h 2355636"/>
              <a:gd name="connsiteX80" fmla="*/ 222281 w 2865682"/>
              <a:gd name="connsiteY80" fmla="*/ 2119357 h 2355636"/>
              <a:gd name="connsiteX81" fmla="*/ 355631 w 2865682"/>
              <a:gd name="connsiteY81" fmla="*/ 1960607 h 2355636"/>
              <a:gd name="connsiteX82" fmla="*/ 501681 w 2865682"/>
              <a:gd name="connsiteY82" fmla="*/ 1814557 h 2355636"/>
              <a:gd name="connsiteX83" fmla="*/ 819181 w 2865682"/>
              <a:gd name="connsiteY83" fmla="*/ 1636757 h 2355636"/>
              <a:gd name="connsiteX84" fmla="*/ 901731 w 2865682"/>
              <a:gd name="connsiteY84" fmla="*/ 1306557 h 2355636"/>
              <a:gd name="connsiteX85" fmla="*/ 641381 w 2865682"/>
              <a:gd name="connsiteY85" fmla="*/ 1179557 h 2355636"/>
              <a:gd name="connsiteX86" fmla="*/ 482631 w 2865682"/>
              <a:gd name="connsiteY86" fmla="*/ 1090657 h 2355636"/>
              <a:gd name="connsiteX87" fmla="*/ 717581 w 2865682"/>
              <a:gd name="connsiteY87" fmla="*/ 1173207 h 2355636"/>
              <a:gd name="connsiteX88" fmla="*/ 692181 w 2865682"/>
              <a:gd name="connsiteY88" fmla="*/ 950957 h 2355636"/>
              <a:gd name="connsiteX89" fmla="*/ 584231 w 2865682"/>
              <a:gd name="connsiteY89" fmla="*/ 830307 h 2355636"/>
              <a:gd name="connsiteX90" fmla="*/ 711231 w 2865682"/>
              <a:gd name="connsiteY90" fmla="*/ 931907 h 2355636"/>
              <a:gd name="connsiteX91" fmla="*/ 749331 w 2865682"/>
              <a:gd name="connsiteY91" fmla="*/ 1109707 h 2355636"/>
              <a:gd name="connsiteX92" fmla="*/ 781081 w 2865682"/>
              <a:gd name="connsiteY92" fmla="*/ 1058907 h 2355636"/>
              <a:gd name="connsiteX93" fmla="*/ 800131 w 2865682"/>
              <a:gd name="connsiteY93" fmla="*/ 912857 h 2355636"/>
              <a:gd name="connsiteX94" fmla="*/ 723931 w 2865682"/>
              <a:gd name="connsiteY94" fmla="*/ 722357 h 2355636"/>
              <a:gd name="connsiteX95" fmla="*/ 812831 w 2865682"/>
              <a:gd name="connsiteY95" fmla="*/ 862057 h 2355636"/>
              <a:gd name="connsiteX96" fmla="*/ 857281 w 2865682"/>
              <a:gd name="connsiteY96" fmla="*/ 1033507 h 2355636"/>
              <a:gd name="connsiteX97" fmla="*/ 812831 w 2865682"/>
              <a:gd name="connsiteY97" fmla="*/ 1204957 h 2355636"/>
              <a:gd name="connsiteX98" fmla="*/ 939831 w 2865682"/>
              <a:gd name="connsiteY98" fmla="*/ 1312907 h 2355636"/>
              <a:gd name="connsiteX99" fmla="*/ 1016031 w 2865682"/>
              <a:gd name="connsiteY99" fmla="*/ 1046207 h 2355636"/>
              <a:gd name="connsiteX100" fmla="*/ 1009681 w 2865682"/>
              <a:gd name="connsiteY100" fmla="*/ 1198607 h 2355636"/>
              <a:gd name="connsiteX101" fmla="*/ 1009681 w 2865682"/>
              <a:gd name="connsiteY101" fmla="*/ 1287507 h 2355636"/>
              <a:gd name="connsiteX102" fmla="*/ 1130331 w 2865682"/>
              <a:gd name="connsiteY102" fmla="*/ 1274807 h 2355636"/>
              <a:gd name="connsiteX103" fmla="*/ 1263681 w 2865682"/>
              <a:gd name="connsiteY103" fmla="*/ 1046207 h 2355636"/>
              <a:gd name="connsiteX104" fmla="*/ 1301781 w 2865682"/>
              <a:gd name="connsiteY104" fmla="*/ 665207 h 2355636"/>
              <a:gd name="connsiteX105" fmla="*/ 1289081 w 2865682"/>
              <a:gd name="connsiteY105" fmla="*/ 538207 h 2355636"/>
              <a:gd name="connsiteX106" fmla="*/ 990631 w 2865682"/>
              <a:gd name="connsiteY106" fmla="*/ 455657 h 2355636"/>
              <a:gd name="connsiteX0" fmla="*/ 990631 w 2865682"/>
              <a:gd name="connsiteY0" fmla="*/ 455657 h 2355636"/>
              <a:gd name="connsiteX1" fmla="*/ 1181131 w 2865682"/>
              <a:gd name="connsiteY1" fmla="*/ 436607 h 2355636"/>
              <a:gd name="connsiteX2" fmla="*/ 1282731 w 2865682"/>
              <a:gd name="connsiteY2" fmla="*/ 487407 h 2355636"/>
              <a:gd name="connsiteX3" fmla="*/ 1308131 w 2865682"/>
              <a:gd name="connsiteY3" fmla="*/ 442957 h 2355636"/>
              <a:gd name="connsiteX4" fmla="*/ 1289081 w 2865682"/>
              <a:gd name="connsiteY4" fmla="*/ 322307 h 2355636"/>
              <a:gd name="connsiteX5" fmla="*/ 1333531 w 2865682"/>
              <a:gd name="connsiteY5" fmla="*/ 208007 h 2355636"/>
              <a:gd name="connsiteX6" fmla="*/ 1308131 w 2865682"/>
              <a:gd name="connsiteY6" fmla="*/ 335007 h 2355636"/>
              <a:gd name="connsiteX7" fmla="*/ 1333531 w 2865682"/>
              <a:gd name="connsiteY7" fmla="*/ 417557 h 2355636"/>
              <a:gd name="connsiteX8" fmla="*/ 1384331 w 2865682"/>
              <a:gd name="connsiteY8" fmla="*/ 296907 h 2355636"/>
              <a:gd name="connsiteX9" fmla="*/ 1339881 w 2865682"/>
              <a:gd name="connsiteY9" fmla="*/ 468357 h 2355636"/>
              <a:gd name="connsiteX10" fmla="*/ 1339881 w 2865682"/>
              <a:gd name="connsiteY10" fmla="*/ 506457 h 2355636"/>
              <a:gd name="connsiteX11" fmla="*/ 1308131 w 2865682"/>
              <a:gd name="connsiteY11" fmla="*/ 500107 h 2355636"/>
              <a:gd name="connsiteX12" fmla="*/ 1358931 w 2865682"/>
              <a:gd name="connsiteY12" fmla="*/ 817607 h 2355636"/>
              <a:gd name="connsiteX13" fmla="*/ 1428781 w 2865682"/>
              <a:gd name="connsiteY13" fmla="*/ 1020807 h 2355636"/>
              <a:gd name="connsiteX14" fmla="*/ 1689131 w 2865682"/>
              <a:gd name="connsiteY14" fmla="*/ 868407 h 2355636"/>
              <a:gd name="connsiteX15" fmla="*/ 1689131 w 2865682"/>
              <a:gd name="connsiteY15" fmla="*/ 487407 h 2355636"/>
              <a:gd name="connsiteX16" fmla="*/ 1739931 w 2865682"/>
              <a:gd name="connsiteY16" fmla="*/ 277857 h 2355636"/>
              <a:gd name="connsiteX17" fmla="*/ 1822481 w 2865682"/>
              <a:gd name="connsiteY17" fmla="*/ 119107 h 2355636"/>
              <a:gd name="connsiteX18" fmla="*/ 1733581 w 2865682"/>
              <a:gd name="connsiteY18" fmla="*/ 379457 h 2355636"/>
              <a:gd name="connsiteX19" fmla="*/ 1835181 w 2865682"/>
              <a:gd name="connsiteY19" fmla="*/ 373107 h 2355636"/>
              <a:gd name="connsiteX20" fmla="*/ 1917731 w 2865682"/>
              <a:gd name="connsiteY20" fmla="*/ 188957 h 2355636"/>
              <a:gd name="connsiteX21" fmla="*/ 1866931 w 2865682"/>
              <a:gd name="connsiteY21" fmla="*/ 417557 h 2355636"/>
              <a:gd name="connsiteX22" fmla="*/ 1720881 w 2865682"/>
              <a:gd name="connsiteY22" fmla="*/ 455657 h 2355636"/>
              <a:gd name="connsiteX23" fmla="*/ 1733581 w 2865682"/>
              <a:gd name="connsiteY23" fmla="*/ 646157 h 2355636"/>
              <a:gd name="connsiteX24" fmla="*/ 1936781 w 2865682"/>
              <a:gd name="connsiteY24" fmla="*/ 544557 h 2355636"/>
              <a:gd name="connsiteX25" fmla="*/ 1968531 w 2865682"/>
              <a:gd name="connsiteY25" fmla="*/ 119107 h 2355636"/>
              <a:gd name="connsiteX26" fmla="*/ 1981231 w 2865682"/>
              <a:gd name="connsiteY26" fmla="*/ 11157 h 2355636"/>
              <a:gd name="connsiteX27" fmla="*/ 1993931 w 2865682"/>
              <a:gd name="connsiteY27" fmla="*/ 335007 h 2355636"/>
              <a:gd name="connsiteX28" fmla="*/ 1968531 w 2865682"/>
              <a:gd name="connsiteY28" fmla="*/ 589007 h 2355636"/>
              <a:gd name="connsiteX29" fmla="*/ 1860581 w 2865682"/>
              <a:gd name="connsiteY29" fmla="*/ 665207 h 2355636"/>
              <a:gd name="connsiteX30" fmla="*/ 2057431 w 2865682"/>
              <a:gd name="connsiteY30" fmla="*/ 696957 h 2355636"/>
              <a:gd name="connsiteX31" fmla="*/ 2228881 w 2865682"/>
              <a:gd name="connsiteY31" fmla="*/ 652507 h 2355636"/>
              <a:gd name="connsiteX32" fmla="*/ 2089181 w 2865682"/>
              <a:gd name="connsiteY32" fmla="*/ 735057 h 2355636"/>
              <a:gd name="connsiteX33" fmla="*/ 1879631 w 2865682"/>
              <a:gd name="connsiteY33" fmla="*/ 722357 h 2355636"/>
              <a:gd name="connsiteX34" fmla="*/ 1784381 w 2865682"/>
              <a:gd name="connsiteY34" fmla="*/ 703307 h 2355636"/>
              <a:gd name="connsiteX35" fmla="*/ 1733581 w 2865682"/>
              <a:gd name="connsiteY35" fmla="*/ 868407 h 2355636"/>
              <a:gd name="connsiteX36" fmla="*/ 1574831 w 2865682"/>
              <a:gd name="connsiteY36" fmla="*/ 1052557 h 2355636"/>
              <a:gd name="connsiteX37" fmla="*/ 1536731 w 2865682"/>
              <a:gd name="connsiteY37" fmla="*/ 1306557 h 2355636"/>
              <a:gd name="connsiteX38" fmla="*/ 1828831 w 2865682"/>
              <a:gd name="connsiteY38" fmla="*/ 1351007 h 2355636"/>
              <a:gd name="connsiteX39" fmla="*/ 2139981 w 2865682"/>
              <a:gd name="connsiteY39" fmla="*/ 1071607 h 2355636"/>
              <a:gd name="connsiteX40" fmla="*/ 2101881 w 2865682"/>
              <a:gd name="connsiteY40" fmla="*/ 925557 h 2355636"/>
              <a:gd name="connsiteX41" fmla="*/ 2171731 w 2865682"/>
              <a:gd name="connsiteY41" fmla="*/ 792207 h 2355636"/>
              <a:gd name="connsiteX42" fmla="*/ 2139981 w 2865682"/>
              <a:gd name="connsiteY42" fmla="*/ 995407 h 2355636"/>
              <a:gd name="connsiteX43" fmla="*/ 2165381 w 2865682"/>
              <a:gd name="connsiteY43" fmla="*/ 1097007 h 2355636"/>
              <a:gd name="connsiteX44" fmla="*/ 1962181 w 2865682"/>
              <a:gd name="connsiteY44" fmla="*/ 1300207 h 2355636"/>
              <a:gd name="connsiteX45" fmla="*/ 2292381 w 2865682"/>
              <a:gd name="connsiteY45" fmla="*/ 1185907 h 2355636"/>
              <a:gd name="connsiteX46" fmla="*/ 2324131 w 2865682"/>
              <a:gd name="connsiteY46" fmla="*/ 735057 h 2355636"/>
              <a:gd name="connsiteX47" fmla="*/ 2362231 w 2865682"/>
              <a:gd name="connsiteY47" fmla="*/ 1001757 h 2355636"/>
              <a:gd name="connsiteX48" fmla="*/ 2349531 w 2865682"/>
              <a:gd name="connsiteY48" fmla="*/ 1185907 h 2355636"/>
              <a:gd name="connsiteX49" fmla="*/ 2540031 w 2865682"/>
              <a:gd name="connsiteY49" fmla="*/ 627107 h 2355636"/>
              <a:gd name="connsiteX50" fmla="*/ 2863881 w 2865682"/>
              <a:gd name="connsiteY50" fmla="*/ 411207 h 2355636"/>
              <a:gd name="connsiteX51" fmla="*/ 2667031 w 2865682"/>
              <a:gd name="connsiteY51" fmla="*/ 550907 h 2355636"/>
              <a:gd name="connsiteX52" fmla="*/ 2584481 w 2865682"/>
              <a:gd name="connsiteY52" fmla="*/ 633457 h 2355636"/>
              <a:gd name="connsiteX53" fmla="*/ 2533681 w 2865682"/>
              <a:gd name="connsiteY53" fmla="*/ 741407 h 2355636"/>
              <a:gd name="connsiteX54" fmla="*/ 2476531 w 2865682"/>
              <a:gd name="connsiteY54" fmla="*/ 919207 h 2355636"/>
              <a:gd name="connsiteX55" fmla="*/ 2673381 w 2865682"/>
              <a:gd name="connsiteY55" fmla="*/ 766807 h 2355636"/>
              <a:gd name="connsiteX56" fmla="*/ 2711481 w 2865682"/>
              <a:gd name="connsiteY56" fmla="*/ 639807 h 2355636"/>
              <a:gd name="connsiteX57" fmla="*/ 2717831 w 2865682"/>
              <a:gd name="connsiteY57" fmla="*/ 804907 h 2355636"/>
              <a:gd name="connsiteX58" fmla="*/ 2533681 w 2865682"/>
              <a:gd name="connsiteY58" fmla="*/ 950957 h 2355636"/>
              <a:gd name="connsiteX59" fmla="*/ 2438431 w 2865682"/>
              <a:gd name="connsiteY59" fmla="*/ 1109707 h 2355636"/>
              <a:gd name="connsiteX60" fmla="*/ 2381281 w 2865682"/>
              <a:gd name="connsiteY60" fmla="*/ 1274807 h 2355636"/>
              <a:gd name="connsiteX61" fmla="*/ 1993931 w 2865682"/>
              <a:gd name="connsiteY61" fmla="*/ 1401807 h 2355636"/>
              <a:gd name="connsiteX62" fmla="*/ 1854231 w 2865682"/>
              <a:gd name="connsiteY62" fmla="*/ 1401807 h 2355636"/>
              <a:gd name="connsiteX63" fmla="*/ 1581181 w 2865682"/>
              <a:gd name="connsiteY63" fmla="*/ 1458957 h 2355636"/>
              <a:gd name="connsiteX64" fmla="*/ 1339881 w 2865682"/>
              <a:gd name="connsiteY64" fmla="*/ 1611357 h 2355636"/>
              <a:gd name="connsiteX65" fmla="*/ 1377981 w 2865682"/>
              <a:gd name="connsiteY65" fmla="*/ 1782807 h 2355636"/>
              <a:gd name="connsiteX66" fmla="*/ 1803431 w 2865682"/>
              <a:gd name="connsiteY66" fmla="*/ 2036807 h 2355636"/>
              <a:gd name="connsiteX67" fmla="*/ 1365281 w 2865682"/>
              <a:gd name="connsiteY67" fmla="*/ 1865357 h 2355636"/>
              <a:gd name="connsiteX68" fmla="*/ 1225581 w 2865682"/>
              <a:gd name="connsiteY68" fmla="*/ 1687557 h 2355636"/>
              <a:gd name="connsiteX69" fmla="*/ 895381 w 2865682"/>
              <a:gd name="connsiteY69" fmla="*/ 1738357 h 2355636"/>
              <a:gd name="connsiteX70" fmla="*/ 704881 w 2865682"/>
              <a:gd name="connsiteY70" fmla="*/ 1973307 h 2355636"/>
              <a:gd name="connsiteX71" fmla="*/ 533431 w 2865682"/>
              <a:gd name="connsiteY71" fmla="*/ 2252707 h 2355636"/>
              <a:gd name="connsiteX72" fmla="*/ 190531 w 2865682"/>
              <a:gd name="connsiteY72" fmla="*/ 2354307 h 2355636"/>
              <a:gd name="connsiteX73" fmla="*/ 31 w 2865682"/>
              <a:gd name="connsiteY73" fmla="*/ 2309857 h 2355636"/>
              <a:gd name="connsiteX74" fmla="*/ 203231 w 2865682"/>
              <a:gd name="connsiteY74" fmla="*/ 2297157 h 2355636"/>
              <a:gd name="connsiteX75" fmla="*/ 457231 w 2865682"/>
              <a:gd name="connsiteY75" fmla="*/ 2227307 h 2355636"/>
              <a:gd name="connsiteX76" fmla="*/ 539781 w 2865682"/>
              <a:gd name="connsiteY76" fmla="*/ 2049507 h 2355636"/>
              <a:gd name="connsiteX77" fmla="*/ 673131 w 2865682"/>
              <a:gd name="connsiteY77" fmla="*/ 1808207 h 2355636"/>
              <a:gd name="connsiteX78" fmla="*/ 273081 w 2865682"/>
              <a:gd name="connsiteY78" fmla="*/ 2125707 h 2355636"/>
              <a:gd name="connsiteX79" fmla="*/ 114331 w 2865682"/>
              <a:gd name="connsiteY79" fmla="*/ 2132057 h 2355636"/>
              <a:gd name="connsiteX80" fmla="*/ 222281 w 2865682"/>
              <a:gd name="connsiteY80" fmla="*/ 2119357 h 2355636"/>
              <a:gd name="connsiteX81" fmla="*/ 355631 w 2865682"/>
              <a:gd name="connsiteY81" fmla="*/ 1960607 h 2355636"/>
              <a:gd name="connsiteX82" fmla="*/ 527081 w 2865682"/>
              <a:gd name="connsiteY82" fmla="*/ 1852657 h 2355636"/>
              <a:gd name="connsiteX83" fmla="*/ 819181 w 2865682"/>
              <a:gd name="connsiteY83" fmla="*/ 1636757 h 2355636"/>
              <a:gd name="connsiteX84" fmla="*/ 901731 w 2865682"/>
              <a:gd name="connsiteY84" fmla="*/ 1306557 h 2355636"/>
              <a:gd name="connsiteX85" fmla="*/ 641381 w 2865682"/>
              <a:gd name="connsiteY85" fmla="*/ 1179557 h 2355636"/>
              <a:gd name="connsiteX86" fmla="*/ 482631 w 2865682"/>
              <a:gd name="connsiteY86" fmla="*/ 1090657 h 2355636"/>
              <a:gd name="connsiteX87" fmla="*/ 717581 w 2865682"/>
              <a:gd name="connsiteY87" fmla="*/ 1173207 h 2355636"/>
              <a:gd name="connsiteX88" fmla="*/ 692181 w 2865682"/>
              <a:gd name="connsiteY88" fmla="*/ 950957 h 2355636"/>
              <a:gd name="connsiteX89" fmla="*/ 584231 w 2865682"/>
              <a:gd name="connsiteY89" fmla="*/ 830307 h 2355636"/>
              <a:gd name="connsiteX90" fmla="*/ 711231 w 2865682"/>
              <a:gd name="connsiteY90" fmla="*/ 931907 h 2355636"/>
              <a:gd name="connsiteX91" fmla="*/ 749331 w 2865682"/>
              <a:gd name="connsiteY91" fmla="*/ 1109707 h 2355636"/>
              <a:gd name="connsiteX92" fmla="*/ 781081 w 2865682"/>
              <a:gd name="connsiteY92" fmla="*/ 1058907 h 2355636"/>
              <a:gd name="connsiteX93" fmla="*/ 800131 w 2865682"/>
              <a:gd name="connsiteY93" fmla="*/ 912857 h 2355636"/>
              <a:gd name="connsiteX94" fmla="*/ 723931 w 2865682"/>
              <a:gd name="connsiteY94" fmla="*/ 722357 h 2355636"/>
              <a:gd name="connsiteX95" fmla="*/ 812831 w 2865682"/>
              <a:gd name="connsiteY95" fmla="*/ 862057 h 2355636"/>
              <a:gd name="connsiteX96" fmla="*/ 857281 w 2865682"/>
              <a:gd name="connsiteY96" fmla="*/ 1033507 h 2355636"/>
              <a:gd name="connsiteX97" fmla="*/ 812831 w 2865682"/>
              <a:gd name="connsiteY97" fmla="*/ 1204957 h 2355636"/>
              <a:gd name="connsiteX98" fmla="*/ 939831 w 2865682"/>
              <a:gd name="connsiteY98" fmla="*/ 1312907 h 2355636"/>
              <a:gd name="connsiteX99" fmla="*/ 1016031 w 2865682"/>
              <a:gd name="connsiteY99" fmla="*/ 1046207 h 2355636"/>
              <a:gd name="connsiteX100" fmla="*/ 1009681 w 2865682"/>
              <a:gd name="connsiteY100" fmla="*/ 1198607 h 2355636"/>
              <a:gd name="connsiteX101" fmla="*/ 1009681 w 2865682"/>
              <a:gd name="connsiteY101" fmla="*/ 1287507 h 2355636"/>
              <a:gd name="connsiteX102" fmla="*/ 1130331 w 2865682"/>
              <a:gd name="connsiteY102" fmla="*/ 1274807 h 2355636"/>
              <a:gd name="connsiteX103" fmla="*/ 1263681 w 2865682"/>
              <a:gd name="connsiteY103" fmla="*/ 1046207 h 2355636"/>
              <a:gd name="connsiteX104" fmla="*/ 1301781 w 2865682"/>
              <a:gd name="connsiteY104" fmla="*/ 665207 h 2355636"/>
              <a:gd name="connsiteX105" fmla="*/ 1289081 w 2865682"/>
              <a:gd name="connsiteY105" fmla="*/ 538207 h 2355636"/>
              <a:gd name="connsiteX106" fmla="*/ 990631 w 2865682"/>
              <a:gd name="connsiteY106" fmla="*/ 455657 h 2355636"/>
              <a:gd name="connsiteX0" fmla="*/ 990631 w 2865682"/>
              <a:gd name="connsiteY0" fmla="*/ 455657 h 2355636"/>
              <a:gd name="connsiteX1" fmla="*/ 1181131 w 2865682"/>
              <a:gd name="connsiteY1" fmla="*/ 436607 h 2355636"/>
              <a:gd name="connsiteX2" fmla="*/ 1282731 w 2865682"/>
              <a:gd name="connsiteY2" fmla="*/ 487407 h 2355636"/>
              <a:gd name="connsiteX3" fmla="*/ 1308131 w 2865682"/>
              <a:gd name="connsiteY3" fmla="*/ 442957 h 2355636"/>
              <a:gd name="connsiteX4" fmla="*/ 1289081 w 2865682"/>
              <a:gd name="connsiteY4" fmla="*/ 322307 h 2355636"/>
              <a:gd name="connsiteX5" fmla="*/ 1333531 w 2865682"/>
              <a:gd name="connsiteY5" fmla="*/ 208007 h 2355636"/>
              <a:gd name="connsiteX6" fmla="*/ 1308131 w 2865682"/>
              <a:gd name="connsiteY6" fmla="*/ 335007 h 2355636"/>
              <a:gd name="connsiteX7" fmla="*/ 1333531 w 2865682"/>
              <a:gd name="connsiteY7" fmla="*/ 417557 h 2355636"/>
              <a:gd name="connsiteX8" fmla="*/ 1384331 w 2865682"/>
              <a:gd name="connsiteY8" fmla="*/ 296907 h 2355636"/>
              <a:gd name="connsiteX9" fmla="*/ 1339881 w 2865682"/>
              <a:gd name="connsiteY9" fmla="*/ 468357 h 2355636"/>
              <a:gd name="connsiteX10" fmla="*/ 1339881 w 2865682"/>
              <a:gd name="connsiteY10" fmla="*/ 506457 h 2355636"/>
              <a:gd name="connsiteX11" fmla="*/ 1308131 w 2865682"/>
              <a:gd name="connsiteY11" fmla="*/ 500107 h 2355636"/>
              <a:gd name="connsiteX12" fmla="*/ 1358931 w 2865682"/>
              <a:gd name="connsiteY12" fmla="*/ 817607 h 2355636"/>
              <a:gd name="connsiteX13" fmla="*/ 1428781 w 2865682"/>
              <a:gd name="connsiteY13" fmla="*/ 1020807 h 2355636"/>
              <a:gd name="connsiteX14" fmla="*/ 1689131 w 2865682"/>
              <a:gd name="connsiteY14" fmla="*/ 868407 h 2355636"/>
              <a:gd name="connsiteX15" fmla="*/ 1689131 w 2865682"/>
              <a:gd name="connsiteY15" fmla="*/ 487407 h 2355636"/>
              <a:gd name="connsiteX16" fmla="*/ 1739931 w 2865682"/>
              <a:gd name="connsiteY16" fmla="*/ 277857 h 2355636"/>
              <a:gd name="connsiteX17" fmla="*/ 1822481 w 2865682"/>
              <a:gd name="connsiteY17" fmla="*/ 119107 h 2355636"/>
              <a:gd name="connsiteX18" fmla="*/ 1733581 w 2865682"/>
              <a:gd name="connsiteY18" fmla="*/ 379457 h 2355636"/>
              <a:gd name="connsiteX19" fmla="*/ 1835181 w 2865682"/>
              <a:gd name="connsiteY19" fmla="*/ 373107 h 2355636"/>
              <a:gd name="connsiteX20" fmla="*/ 1917731 w 2865682"/>
              <a:gd name="connsiteY20" fmla="*/ 188957 h 2355636"/>
              <a:gd name="connsiteX21" fmla="*/ 1866931 w 2865682"/>
              <a:gd name="connsiteY21" fmla="*/ 417557 h 2355636"/>
              <a:gd name="connsiteX22" fmla="*/ 1720881 w 2865682"/>
              <a:gd name="connsiteY22" fmla="*/ 455657 h 2355636"/>
              <a:gd name="connsiteX23" fmla="*/ 1733581 w 2865682"/>
              <a:gd name="connsiteY23" fmla="*/ 646157 h 2355636"/>
              <a:gd name="connsiteX24" fmla="*/ 1936781 w 2865682"/>
              <a:gd name="connsiteY24" fmla="*/ 544557 h 2355636"/>
              <a:gd name="connsiteX25" fmla="*/ 1968531 w 2865682"/>
              <a:gd name="connsiteY25" fmla="*/ 119107 h 2355636"/>
              <a:gd name="connsiteX26" fmla="*/ 1981231 w 2865682"/>
              <a:gd name="connsiteY26" fmla="*/ 11157 h 2355636"/>
              <a:gd name="connsiteX27" fmla="*/ 1993931 w 2865682"/>
              <a:gd name="connsiteY27" fmla="*/ 335007 h 2355636"/>
              <a:gd name="connsiteX28" fmla="*/ 1968531 w 2865682"/>
              <a:gd name="connsiteY28" fmla="*/ 589007 h 2355636"/>
              <a:gd name="connsiteX29" fmla="*/ 1860581 w 2865682"/>
              <a:gd name="connsiteY29" fmla="*/ 665207 h 2355636"/>
              <a:gd name="connsiteX30" fmla="*/ 2057431 w 2865682"/>
              <a:gd name="connsiteY30" fmla="*/ 696957 h 2355636"/>
              <a:gd name="connsiteX31" fmla="*/ 2228881 w 2865682"/>
              <a:gd name="connsiteY31" fmla="*/ 652507 h 2355636"/>
              <a:gd name="connsiteX32" fmla="*/ 2089181 w 2865682"/>
              <a:gd name="connsiteY32" fmla="*/ 735057 h 2355636"/>
              <a:gd name="connsiteX33" fmla="*/ 1879631 w 2865682"/>
              <a:gd name="connsiteY33" fmla="*/ 722357 h 2355636"/>
              <a:gd name="connsiteX34" fmla="*/ 1784381 w 2865682"/>
              <a:gd name="connsiteY34" fmla="*/ 703307 h 2355636"/>
              <a:gd name="connsiteX35" fmla="*/ 1733581 w 2865682"/>
              <a:gd name="connsiteY35" fmla="*/ 868407 h 2355636"/>
              <a:gd name="connsiteX36" fmla="*/ 1574831 w 2865682"/>
              <a:gd name="connsiteY36" fmla="*/ 1052557 h 2355636"/>
              <a:gd name="connsiteX37" fmla="*/ 1536731 w 2865682"/>
              <a:gd name="connsiteY37" fmla="*/ 1306557 h 2355636"/>
              <a:gd name="connsiteX38" fmla="*/ 1828831 w 2865682"/>
              <a:gd name="connsiteY38" fmla="*/ 1351007 h 2355636"/>
              <a:gd name="connsiteX39" fmla="*/ 2139981 w 2865682"/>
              <a:gd name="connsiteY39" fmla="*/ 1071607 h 2355636"/>
              <a:gd name="connsiteX40" fmla="*/ 2101881 w 2865682"/>
              <a:gd name="connsiteY40" fmla="*/ 925557 h 2355636"/>
              <a:gd name="connsiteX41" fmla="*/ 2171731 w 2865682"/>
              <a:gd name="connsiteY41" fmla="*/ 792207 h 2355636"/>
              <a:gd name="connsiteX42" fmla="*/ 2139981 w 2865682"/>
              <a:gd name="connsiteY42" fmla="*/ 995407 h 2355636"/>
              <a:gd name="connsiteX43" fmla="*/ 2165381 w 2865682"/>
              <a:gd name="connsiteY43" fmla="*/ 1097007 h 2355636"/>
              <a:gd name="connsiteX44" fmla="*/ 1962181 w 2865682"/>
              <a:gd name="connsiteY44" fmla="*/ 1300207 h 2355636"/>
              <a:gd name="connsiteX45" fmla="*/ 2292381 w 2865682"/>
              <a:gd name="connsiteY45" fmla="*/ 1185907 h 2355636"/>
              <a:gd name="connsiteX46" fmla="*/ 2324131 w 2865682"/>
              <a:gd name="connsiteY46" fmla="*/ 735057 h 2355636"/>
              <a:gd name="connsiteX47" fmla="*/ 2362231 w 2865682"/>
              <a:gd name="connsiteY47" fmla="*/ 1001757 h 2355636"/>
              <a:gd name="connsiteX48" fmla="*/ 2349531 w 2865682"/>
              <a:gd name="connsiteY48" fmla="*/ 1185907 h 2355636"/>
              <a:gd name="connsiteX49" fmla="*/ 2540031 w 2865682"/>
              <a:gd name="connsiteY49" fmla="*/ 627107 h 2355636"/>
              <a:gd name="connsiteX50" fmla="*/ 2863881 w 2865682"/>
              <a:gd name="connsiteY50" fmla="*/ 411207 h 2355636"/>
              <a:gd name="connsiteX51" fmla="*/ 2667031 w 2865682"/>
              <a:gd name="connsiteY51" fmla="*/ 550907 h 2355636"/>
              <a:gd name="connsiteX52" fmla="*/ 2584481 w 2865682"/>
              <a:gd name="connsiteY52" fmla="*/ 633457 h 2355636"/>
              <a:gd name="connsiteX53" fmla="*/ 2533681 w 2865682"/>
              <a:gd name="connsiteY53" fmla="*/ 741407 h 2355636"/>
              <a:gd name="connsiteX54" fmla="*/ 2476531 w 2865682"/>
              <a:gd name="connsiteY54" fmla="*/ 919207 h 2355636"/>
              <a:gd name="connsiteX55" fmla="*/ 2673381 w 2865682"/>
              <a:gd name="connsiteY55" fmla="*/ 766807 h 2355636"/>
              <a:gd name="connsiteX56" fmla="*/ 2711481 w 2865682"/>
              <a:gd name="connsiteY56" fmla="*/ 639807 h 2355636"/>
              <a:gd name="connsiteX57" fmla="*/ 2717831 w 2865682"/>
              <a:gd name="connsiteY57" fmla="*/ 804907 h 2355636"/>
              <a:gd name="connsiteX58" fmla="*/ 2533681 w 2865682"/>
              <a:gd name="connsiteY58" fmla="*/ 950957 h 2355636"/>
              <a:gd name="connsiteX59" fmla="*/ 2438431 w 2865682"/>
              <a:gd name="connsiteY59" fmla="*/ 1109707 h 2355636"/>
              <a:gd name="connsiteX60" fmla="*/ 2381281 w 2865682"/>
              <a:gd name="connsiteY60" fmla="*/ 1274807 h 2355636"/>
              <a:gd name="connsiteX61" fmla="*/ 1993931 w 2865682"/>
              <a:gd name="connsiteY61" fmla="*/ 1401807 h 2355636"/>
              <a:gd name="connsiteX62" fmla="*/ 1854231 w 2865682"/>
              <a:gd name="connsiteY62" fmla="*/ 1401807 h 2355636"/>
              <a:gd name="connsiteX63" fmla="*/ 1581181 w 2865682"/>
              <a:gd name="connsiteY63" fmla="*/ 1458957 h 2355636"/>
              <a:gd name="connsiteX64" fmla="*/ 1339881 w 2865682"/>
              <a:gd name="connsiteY64" fmla="*/ 1611357 h 2355636"/>
              <a:gd name="connsiteX65" fmla="*/ 1377981 w 2865682"/>
              <a:gd name="connsiteY65" fmla="*/ 1782807 h 2355636"/>
              <a:gd name="connsiteX66" fmla="*/ 1803431 w 2865682"/>
              <a:gd name="connsiteY66" fmla="*/ 2036807 h 2355636"/>
              <a:gd name="connsiteX67" fmla="*/ 1365281 w 2865682"/>
              <a:gd name="connsiteY67" fmla="*/ 1865357 h 2355636"/>
              <a:gd name="connsiteX68" fmla="*/ 1225581 w 2865682"/>
              <a:gd name="connsiteY68" fmla="*/ 1687557 h 2355636"/>
              <a:gd name="connsiteX69" fmla="*/ 895381 w 2865682"/>
              <a:gd name="connsiteY69" fmla="*/ 1738357 h 2355636"/>
              <a:gd name="connsiteX70" fmla="*/ 704881 w 2865682"/>
              <a:gd name="connsiteY70" fmla="*/ 1973307 h 2355636"/>
              <a:gd name="connsiteX71" fmla="*/ 533431 w 2865682"/>
              <a:gd name="connsiteY71" fmla="*/ 2252707 h 2355636"/>
              <a:gd name="connsiteX72" fmla="*/ 190531 w 2865682"/>
              <a:gd name="connsiteY72" fmla="*/ 2354307 h 2355636"/>
              <a:gd name="connsiteX73" fmla="*/ 31 w 2865682"/>
              <a:gd name="connsiteY73" fmla="*/ 2309857 h 2355636"/>
              <a:gd name="connsiteX74" fmla="*/ 203231 w 2865682"/>
              <a:gd name="connsiteY74" fmla="*/ 2297157 h 2355636"/>
              <a:gd name="connsiteX75" fmla="*/ 457231 w 2865682"/>
              <a:gd name="connsiteY75" fmla="*/ 2227307 h 2355636"/>
              <a:gd name="connsiteX76" fmla="*/ 539781 w 2865682"/>
              <a:gd name="connsiteY76" fmla="*/ 2049507 h 2355636"/>
              <a:gd name="connsiteX77" fmla="*/ 673131 w 2865682"/>
              <a:gd name="connsiteY77" fmla="*/ 1808207 h 2355636"/>
              <a:gd name="connsiteX78" fmla="*/ 273081 w 2865682"/>
              <a:gd name="connsiteY78" fmla="*/ 2125707 h 2355636"/>
              <a:gd name="connsiteX79" fmla="*/ 114331 w 2865682"/>
              <a:gd name="connsiteY79" fmla="*/ 2132057 h 2355636"/>
              <a:gd name="connsiteX80" fmla="*/ 222281 w 2865682"/>
              <a:gd name="connsiteY80" fmla="*/ 2119357 h 2355636"/>
              <a:gd name="connsiteX81" fmla="*/ 393731 w 2865682"/>
              <a:gd name="connsiteY81" fmla="*/ 1998707 h 2355636"/>
              <a:gd name="connsiteX82" fmla="*/ 527081 w 2865682"/>
              <a:gd name="connsiteY82" fmla="*/ 1852657 h 2355636"/>
              <a:gd name="connsiteX83" fmla="*/ 819181 w 2865682"/>
              <a:gd name="connsiteY83" fmla="*/ 1636757 h 2355636"/>
              <a:gd name="connsiteX84" fmla="*/ 901731 w 2865682"/>
              <a:gd name="connsiteY84" fmla="*/ 1306557 h 2355636"/>
              <a:gd name="connsiteX85" fmla="*/ 641381 w 2865682"/>
              <a:gd name="connsiteY85" fmla="*/ 1179557 h 2355636"/>
              <a:gd name="connsiteX86" fmla="*/ 482631 w 2865682"/>
              <a:gd name="connsiteY86" fmla="*/ 1090657 h 2355636"/>
              <a:gd name="connsiteX87" fmla="*/ 717581 w 2865682"/>
              <a:gd name="connsiteY87" fmla="*/ 1173207 h 2355636"/>
              <a:gd name="connsiteX88" fmla="*/ 692181 w 2865682"/>
              <a:gd name="connsiteY88" fmla="*/ 950957 h 2355636"/>
              <a:gd name="connsiteX89" fmla="*/ 584231 w 2865682"/>
              <a:gd name="connsiteY89" fmla="*/ 830307 h 2355636"/>
              <a:gd name="connsiteX90" fmla="*/ 711231 w 2865682"/>
              <a:gd name="connsiteY90" fmla="*/ 931907 h 2355636"/>
              <a:gd name="connsiteX91" fmla="*/ 749331 w 2865682"/>
              <a:gd name="connsiteY91" fmla="*/ 1109707 h 2355636"/>
              <a:gd name="connsiteX92" fmla="*/ 781081 w 2865682"/>
              <a:gd name="connsiteY92" fmla="*/ 1058907 h 2355636"/>
              <a:gd name="connsiteX93" fmla="*/ 800131 w 2865682"/>
              <a:gd name="connsiteY93" fmla="*/ 912857 h 2355636"/>
              <a:gd name="connsiteX94" fmla="*/ 723931 w 2865682"/>
              <a:gd name="connsiteY94" fmla="*/ 722357 h 2355636"/>
              <a:gd name="connsiteX95" fmla="*/ 812831 w 2865682"/>
              <a:gd name="connsiteY95" fmla="*/ 862057 h 2355636"/>
              <a:gd name="connsiteX96" fmla="*/ 857281 w 2865682"/>
              <a:gd name="connsiteY96" fmla="*/ 1033507 h 2355636"/>
              <a:gd name="connsiteX97" fmla="*/ 812831 w 2865682"/>
              <a:gd name="connsiteY97" fmla="*/ 1204957 h 2355636"/>
              <a:gd name="connsiteX98" fmla="*/ 939831 w 2865682"/>
              <a:gd name="connsiteY98" fmla="*/ 1312907 h 2355636"/>
              <a:gd name="connsiteX99" fmla="*/ 1016031 w 2865682"/>
              <a:gd name="connsiteY99" fmla="*/ 1046207 h 2355636"/>
              <a:gd name="connsiteX100" fmla="*/ 1009681 w 2865682"/>
              <a:gd name="connsiteY100" fmla="*/ 1198607 h 2355636"/>
              <a:gd name="connsiteX101" fmla="*/ 1009681 w 2865682"/>
              <a:gd name="connsiteY101" fmla="*/ 1287507 h 2355636"/>
              <a:gd name="connsiteX102" fmla="*/ 1130331 w 2865682"/>
              <a:gd name="connsiteY102" fmla="*/ 1274807 h 2355636"/>
              <a:gd name="connsiteX103" fmla="*/ 1263681 w 2865682"/>
              <a:gd name="connsiteY103" fmla="*/ 1046207 h 2355636"/>
              <a:gd name="connsiteX104" fmla="*/ 1301781 w 2865682"/>
              <a:gd name="connsiteY104" fmla="*/ 665207 h 2355636"/>
              <a:gd name="connsiteX105" fmla="*/ 1289081 w 2865682"/>
              <a:gd name="connsiteY105" fmla="*/ 538207 h 2355636"/>
              <a:gd name="connsiteX106" fmla="*/ 990631 w 2865682"/>
              <a:gd name="connsiteY106" fmla="*/ 455657 h 2355636"/>
              <a:gd name="connsiteX0" fmla="*/ 990631 w 2865682"/>
              <a:gd name="connsiteY0" fmla="*/ 455657 h 2355636"/>
              <a:gd name="connsiteX1" fmla="*/ 1181131 w 2865682"/>
              <a:gd name="connsiteY1" fmla="*/ 436607 h 2355636"/>
              <a:gd name="connsiteX2" fmla="*/ 1282731 w 2865682"/>
              <a:gd name="connsiteY2" fmla="*/ 487407 h 2355636"/>
              <a:gd name="connsiteX3" fmla="*/ 1308131 w 2865682"/>
              <a:gd name="connsiteY3" fmla="*/ 442957 h 2355636"/>
              <a:gd name="connsiteX4" fmla="*/ 1289081 w 2865682"/>
              <a:gd name="connsiteY4" fmla="*/ 322307 h 2355636"/>
              <a:gd name="connsiteX5" fmla="*/ 1333531 w 2865682"/>
              <a:gd name="connsiteY5" fmla="*/ 208007 h 2355636"/>
              <a:gd name="connsiteX6" fmla="*/ 1308131 w 2865682"/>
              <a:gd name="connsiteY6" fmla="*/ 335007 h 2355636"/>
              <a:gd name="connsiteX7" fmla="*/ 1333531 w 2865682"/>
              <a:gd name="connsiteY7" fmla="*/ 417557 h 2355636"/>
              <a:gd name="connsiteX8" fmla="*/ 1384331 w 2865682"/>
              <a:gd name="connsiteY8" fmla="*/ 296907 h 2355636"/>
              <a:gd name="connsiteX9" fmla="*/ 1339881 w 2865682"/>
              <a:gd name="connsiteY9" fmla="*/ 468357 h 2355636"/>
              <a:gd name="connsiteX10" fmla="*/ 1339881 w 2865682"/>
              <a:gd name="connsiteY10" fmla="*/ 506457 h 2355636"/>
              <a:gd name="connsiteX11" fmla="*/ 1308131 w 2865682"/>
              <a:gd name="connsiteY11" fmla="*/ 500107 h 2355636"/>
              <a:gd name="connsiteX12" fmla="*/ 1358931 w 2865682"/>
              <a:gd name="connsiteY12" fmla="*/ 817607 h 2355636"/>
              <a:gd name="connsiteX13" fmla="*/ 1428781 w 2865682"/>
              <a:gd name="connsiteY13" fmla="*/ 1020807 h 2355636"/>
              <a:gd name="connsiteX14" fmla="*/ 1689131 w 2865682"/>
              <a:gd name="connsiteY14" fmla="*/ 868407 h 2355636"/>
              <a:gd name="connsiteX15" fmla="*/ 1689131 w 2865682"/>
              <a:gd name="connsiteY15" fmla="*/ 487407 h 2355636"/>
              <a:gd name="connsiteX16" fmla="*/ 1739931 w 2865682"/>
              <a:gd name="connsiteY16" fmla="*/ 277857 h 2355636"/>
              <a:gd name="connsiteX17" fmla="*/ 1822481 w 2865682"/>
              <a:gd name="connsiteY17" fmla="*/ 119107 h 2355636"/>
              <a:gd name="connsiteX18" fmla="*/ 1733581 w 2865682"/>
              <a:gd name="connsiteY18" fmla="*/ 379457 h 2355636"/>
              <a:gd name="connsiteX19" fmla="*/ 1835181 w 2865682"/>
              <a:gd name="connsiteY19" fmla="*/ 373107 h 2355636"/>
              <a:gd name="connsiteX20" fmla="*/ 1917731 w 2865682"/>
              <a:gd name="connsiteY20" fmla="*/ 188957 h 2355636"/>
              <a:gd name="connsiteX21" fmla="*/ 1866931 w 2865682"/>
              <a:gd name="connsiteY21" fmla="*/ 417557 h 2355636"/>
              <a:gd name="connsiteX22" fmla="*/ 1720881 w 2865682"/>
              <a:gd name="connsiteY22" fmla="*/ 455657 h 2355636"/>
              <a:gd name="connsiteX23" fmla="*/ 1733581 w 2865682"/>
              <a:gd name="connsiteY23" fmla="*/ 646157 h 2355636"/>
              <a:gd name="connsiteX24" fmla="*/ 1936781 w 2865682"/>
              <a:gd name="connsiteY24" fmla="*/ 544557 h 2355636"/>
              <a:gd name="connsiteX25" fmla="*/ 1968531 w 2865682"/>
              <a:gd name="connsiteY25" fmla="*/ 119107 h 2355636"/>
              <a:gd name="connsiteX26" fmla="*/ 1981231 w 2865682"/>
              <a:gd name="connsiteY26" fmla="*/ 11157 h 2355636"/>
              <a:gd name="connsiteX27" fmla="*/ 1993931 w 2865682"/>
              <a:gd name="connsiteY27" fmla="*/ 335007 h 2355636"/>
              <a:gd name="connsiteX28" fmla="*/ 1968531 w 2865682"/>
              <a:gd name="connsiteY28" fmla="*/ 589007 h 2355636"/>
              <a:gd name="connsiteX29" fmla="*/ 1860581 w 2865682"/>
              <a:gd name="connsiteY29" fmla="*/ 665207 h 2355636"/>
              <a:gd name="connsiteX30" fmla="*/ 2057431 w 2865682"/>
              <a:gd name="connsiteY30" fmla="*/ 696957 h 2355636"/>
              <a:gd name="connsiteX31" fmla="*/ 2228881 w 2865682"/>
              <a:gd name="connsiteY31" fmla="*/ 652507 h 2355636"/>
              <a:gd name="connsiteX32" fmla="*/ 2089181 w 2865682"/>
              <a:gd name="connsiteY32" fmla="*/ 735057 h 2355636"/>
              <a:gd name="connsiteX33" fmla="*/ 1879631 w 2865682"/>
              <a:gd name="connsiteY33" fmla="*/ 722357 h 2355636"/>
              <a:gd name="connsiteX34" fmla="*/ 1784381 w 2865682"/>
              <a:gd name="connsiteY34" fmla="*/ 703307 h 2355636"/>
              <a:gd name="connsiteX35" fmla="*/ 1733581 w 2865682"/>
              <a:gd name="connsiteY35" fmla="*/ 868407 h 2355636"/>
              <a:gd name="connsiteX36" fmla="*/ 1574831 w 2865682"/>
              <a:gd name="connsiteY36" fmla="*/ 1052557 h 2355636"/>
              <a:gd name="connsiteX37" fmla="*/ 1536731 w 2865682"/>
              <a:gd name="connsiteY37" fmla="*/ 1306557 h 2355636"/>
              <a:gd name="connsiteX38" fmla="*/ 1828831 w 2865682"/>
              <a:gd name="connsiteY38" fmla="*/ 1351007 h 2355636"/>
              <a:gd name="connsiteX39" fmla="*/ 2139981 w 2865682"/>
              <a:gd name="connsiteY39" fmla="*/ 1071607 h 2355636"/>
              <a:gd name="connsiteX40" fmla="*/ 2101881 w 2865682"/>
              <a:gd name="connsiteY40" fmla="*/ 925557 h 2355636"/>
              <a:gd name="connsiteX41" fmla="*/ 2171731 w 2865682"/>
              <a:gd name="connsiteY41" fmla="*/ 792207 h 2355636"/>
              <a:gd name="connsiteX42" fmla="*/ 2139981 w 2865682"/>
              <a:gd name="connsiteY42" fmla="*/ 995407 h 2355636"/>
              <a:gd name="connsiteX43" fmla="*/ 2165381 w 2865682"/>
              <a:gd name="connsiteY43" fmla="*/ 1097007 h 2355636"/>
              <a:gd name="connsiteX44" fmla="*/ 1962181 w 2865682"/>
              <a:gd name="connsiteY44" fmla="*/ 1300207 h 2355636"/>
              <a:gd name="connsiteX45" fmla="*/ 2292381 w 2865682"/>
              <a:gd name="connsiteY45" fmla="*/ 1185907 h 2355636"/>
              <a:gd name="connsiteX46" fmla="*/ 2324131 w 2865682"/>
              <a:gd name="connsiteY46" fmla="*/ 735057 h 2355636"/>
              <a:gd name="connsiteX47" fmla="*/ 2362231 w 2865682"/>
              <a:gd name="connsiteY47" fmla="*/ 1001757 h 2355636"/>
              <a:gd name="connsiteX48" fmla="*/ 2349531 w 2865682"/>
              <a:gd name="connsiteY48" fmla="*/ 1185907 h 2355636"/>
              <a:gd name="connsiteX49" fmla="*/ 2540031 w 2865682"/>
              <a:gd name="connsiteY49" fmla="*/ 627107 h 2355636"/>
              <a:gd name="connsiteX50" fmla="*/ 2863881 w 2865682"/>
              <a:gd name="connsiteY50" fmla="*/ 411207 h 2355636"/>
              <a:gd name="connsiteX51" fmla="*/ 2667031 w 2865682"/>
              <a:gd name="connsiteY51" fmla="*/ 550907 h 2355636"/>
              <a:gd name="connsiteX52" fmla="*/ 2584481 w 2865682"/>
              <a:gd name="connsiteY52" fmla="*/ 633457 h 2355636"/>
              <a:gd name="connsiteX53" fmla="*/ 2533681 w 2865682"/>
              <a:gd name="connsiteY53" fmla="*/ 741407 h 2355636"/>
              <a:gd name="connsiteX54" fmla="*/ 2476531 w 2865682"/>
              <a:gd name="connsiteY54" fmla="*/ 919207 h 2355636"/>
              <a:gd name="connsiteX55" fmla="*/ 2673381 w 2865682"/>
              <a:gd name="connsiteY55" fmla="*/ 766807 h 2355636"/>
              <a:gd name="connsiteX56" fmla="*/ 2711481 w 2865682"/>
              <a:gd name="connsiteY56" fmla="*/ 639807 h 2355636"/>
              <a:gd name="connsiteX57" fmla="*/ 2717831 w 2865682"/>
              <a:gd name="connsiteY57" fmla="*/ 804907 h 2355636"/>
              <a:gd name="connsiteX58" fmla="*/ 2533681 w 2865682"/>
              <a:gd name="connsiteY58" fmla="*/ 950957 h 2355636"/>
              <a:gd name="connsiteX59" fmla="*/ 2438431 w 2865682"/>
              <a:gd name="connsiteY59" fmla="*/ 1109707 h 2355636"/>
              <a:gd name="connsiteX60" fmla="*/ 2381281 w 2865682"/>
              <a:gd name="connsiteY60" fmla="*/ 1274807 h 2355636"/>
              <a:gd name="connsiteX61" fmla="*/ 1993931 w 2865682"/>
              <a:gd name="connsiteY61" fmla="*/ 1401807 h 2355636"/>
              <a:gd name="connsiteX62" fmla="*/ 1854231 w 2865682"/>
              <a:gd name="connsiteY62" fmla="*/ 1401807 h 2355636"/>
              <a:gd name="connsiteX63" fmla="*/ 1581181 w 2865682"/>
              <a:gd name="connsiteY63" fmla="*/ 1458957 h 2355636"/>
              <a:gd name="connsiteX64" fmla="*/ 1339881 w 2865682"/>
              <a:gd name="connsiteY64" fmla="*/ 1611357 h 2355636"/>
              <a:gd name="connsiteX65" fmla="*/ 1377981 w 2865682"/>
              <a:gd name="connsiteY65" fmla="*/ 1782807 h 2355636"/>
              <a:gd name="connsiteX66" fmla="*/ 1803431 w 2865682"/>
              <a:gd name="connsiteY66" fmla="*/ 2036807 h 2355636"/>
              <a:gd name="connsiteX67" fmla="*/ 1365281 w 2865682"/>
              <a:gd name="connsiteY67" fmla="*/ 1865357 h 2355636"/>
              <a:gd name="connsiteX68" fmla="*/ 1225581 w 2865682"/>
              <a:gd name="connsiteY68" fmla="*/ 1687557 h 2355636"/>
              <a:gd name="connsiteX69" fmla="*/ 895381 w 2865682"/>
              <a:gd name="connsiteY69" fmla="*/ 1738357 h 2355636"/>
              <a:gd name="connsiteX70" fmla="*/ 704881 w 2865682"/>
              <a:gd name="connsiteY70" fmla="*/ 1973307 h 2355636"/>
              <a:gd name="connsiteX71" fmla="*/ 533431 w 2865682"/>
              <a:gd name="connsiteY71" fmla="*/ 2252707 h 2355636"/>
              <a:gd name="connsiteX72" fmla="*/ 190531 w 2865682"/>
              <a:gd name="connsiteY72" fmla="*/ 2354307 h 2355636"/>
              <a:gd name="connsiteX73" fmla="*/ 31 w 2865682"/>
              <a:gd name="connsiteY73" fmla="*/ 2309857 h 2355636"/>
              <a:gd name="connsiteX74" fmla="*/ 203231 w 2865682"/>
              <a:gd name="connsiteY74" fmla="*/ 2297157 h 2355636"/>
              <a:gd name="connsiteX75" fmla="*/ 457231 w 2865682"/>
              <a:gd name="connsiteY75" fmla="*/ 2227307 h 2355636"/>
              <a:gd name="connsiteX76" fmla="*/ 622331 w 2865682"/>
              <a:gd name="connsiteY76" fmla="*/ 2036807 h 2355636"/>
              <a:gd name="connsiteX77" fmla="*/ 673131 w 2865682"/>
              <a:gd name="connsiteY77" fmla="*/ 1808207 h 2355636"/>
              <a:gd name="connsiteX78" fmla="*/ 273081 w 2865682"/>
              <a:gd name="connsiteY78" fmla="*/ 2125707 h 2355636"/>
              <a:gd name="connsiteX79" fmla="*/ 114331 w 2865682"/>
              <a:gd name="connsiteY79" fmla="*/ 2132057 h 2355636"/>
              <a:gd name="connsiteX80" fmla="*/ 222281 w 2865682"/>
              <a:gd name="connsiteY80" fmla="*/ 2119357 h 2355636"/>
              <a:gd name="connsiteX81" fmla="*/ 393731 w 2865682"/>
              <a:gd name="connsiteY81" fmla="*/ 1998707 h 2355636"/>
              <a:gd name="connsiteX82" fmla="*/ 527081 w 2865682"/>
              <a:gd name="connsiteY82" fmla="*/ 1852657 h 2355636"/>
              <a:gd name="connsiteX83" fmla="*/ 819181 w 2865682"/>
              <a:gd name="connsiteY83" fmla="*/ 1636757 h 2355636"/>
              <a:gd name="connsiteX84" fmla="*/ 901731 w 2865682"/>
              <a:gd name="connsiteY84" fmla="*/ 1306557 h 2355636"/>
              <a:gd name="connsiteX85" fmla="*/ 641381 w 2865682"/>
              <a:gd name="connsiteY85" fmla="*/ 1179557 h 2355636"/>
              <a:gd name="connsiteX86" fmla="*/ 482631 w 2865682"/>
              <a:gd name="connsiteY86" fmla="*/ 1090657 h 2355636"/>
              <a:gd name="connsiteX87" fmla="*/ 717581 w 2865682"/>
              <a:gd name="connsiteY87" fmla="*/ 1173207 h 2355636"/>
              <a:gd name="connsiteX88" fmla="*/ 692181 w 2865682"/>
              <a:gd name="connsiteY88" fmla="*/ 950957 h 2355636"/>
              <a:gd name="connsiteX89" fmla="*/ 584231 w 2865682"/>
              <a:gd name="connsiteY89" fmla="*/ 830307 h 2355636"/>
              <a:gd name="connsiteX90" fmla="*/ 711231 w 2865682"/>
              <a:gd name="connsiteY90" fmla="*/ 931907 h 2355636"/>
              <a:gd name="connsiteX91" fmla="*/ 749331 w 2865682"/>
              <a:gd name="connsiteY91" fmla="*/ 1109707 h 2355636"/>
              <a:gd name="connsiteX92" fmla="*/ 781081 w 2865682"/>
              <a:gd name="connsiteY92" fmla="*/ 1058907 h 2355636"/>
              <a:gd name="connsiteX93" fmla="*/ 800131 w 2865682"/>
              <a:gd name="connsiteY93" fmla="*/ 912857 h 2355636"/>
              <a:gd name="connsiteX94" fmla="*/ 723931 w 2865682"/>
              <a:gd name="connsiteY94" fmla="*/ 722357 h 2355636"/>
              <a:gd name="connsiteX95" fmla="*/ 812831 w 2865682"/>
              <a:gd name="connsiteY95" fmla="*/ 862057 h 2355636"/>
              <a:gd name="connsiteX96" fmla="*/ 857281 w 2865682"/>
              <a:gd name="connsiteY96" fmla="*/ 1033507 h 2355636"/>
              <a:gd name="connsiteX97" fmla="*/ 812831 w 2865682"/>
              <a:gd name="connsiteY97" fmla="*/ 1204957 h 2355636"/>
              <a:gd name="connsiteX98" fmla="*/ 939831 w 2865682"/>
              <a:gd name="connsiteY98" fmla="*/ 1312907 h 2355636"/>
              <a:gd name="connsiteX99" fmla="*/ 1016031 w 2865682"/>
              <a:gd name="connsiteY99" fmla="*/ 1046207 h 2355636"/>
              <a:gd name="connsiteX100" fmla="*/ 1009681 w 2865682"/>
              <a:gd name="connsiteY100" fmla="*/ 1198607 h 2355636"/>
              <a:gd name="connsiteX101" fmla="*/ 1009681 w 2865682"/>
              <a:gd name="connsiteY101" fmla="*/ 1287507 h 2355636"/>
              <a:gd name="connsiteX102" fmla="*/ 1130331 w 2865682"/>
              <a:gd name="connsiteY102" fmla="*/ 1274807 h 2355636"/>
              <a:gd name="connsiteX103" fmla="*/ 1263681 w 2865682"/>
              <a:gd name="connsiteY103" fmla="*/ 1046207 h 2355636"/>
              <a:gd name="connsiteX104" fmla="*/ 1301781 w 2865682"/>
              <a:gd name="connsiteY104" fmla="*/ 665207 h 2355636"/>
              <a:gd name="connsiteX105" fmla="*/ 1289081 w 2865682"/>
              <a:gd name="connsiteY105" fmla="*/ 538207 h 2355636"/>
              <a:gd name="connsiteX106" fmla="*/ 990631 w 2865682"/>
              <a:gd name="connsiteY106" fmla="*/ 455657 h 2355636"/>
              <a:gd name="connsiteX0" fmla="*/ 990867 w 2865918"/>
              <a:gd name="connsiteY0" fmla="*/ 455657 h 2355494"/>
              <a:gd name="connsiteX1" fmla="*/ 1181367 w 2865918"/>
              <a:gd name="connsiteY1" fmla="*/ 4366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0117 w 2865918"/>
              <a:gd name="connsiteY10" fmla="*/ 506457 h 2355494"/>
              <a:gd name="connsiteX11" fmla="*/ 1308367 w 2865918"/>
              <a:gd name="connsiteY11" fmla="*/ 500107 h 2355494"/>
              <a:gd name="connsiteX12" fmla="*/ 1359167 w 2865918"/>
              <a:gd name="connsiteY12" fmla="*/ 817607 h 2355494"/>
              <a:gd name="connsiteX13" fmla="*/ 1429017 w 2865918"/>
              <a:gd name="connsiteY13" fmla="*/ 1020807 h 2355494"/>
              <a:gd name="connsiteX14" fmla="*/ 1689367 w 2865918"/>
              <a:gd name="connsiteY14" fmla="*/ 868407 h 2355494"/>
              <a:gd name="connsiteX15" fmla="*/ 1689367 w 2865918"/>
              <a:gd name="connsiteY15" fmla="*/ 487407 h 2355494"/>
              <a:gd name="connsiteX16" fmla="*/ 1740167 w 2865918"/>
              <a:gd name="connsiteY16" fmla="*/ 277857 h 2355494"/>
              <a:gd name="connsiteX17" fmla="*/ 1822717 w 2865918"/>
              <a:gd name="connsiteY17" fmla="*/ 119107 h 2355494"/>
              <a:gd name="connsiteX18" fmla="*/ 1733817 w 2865918"/>
              <a:gd name="connsiteY18" fmla="*/ 379457 h 2355494"/>
              <a:gd name="connsiteX19" fmla="*/ 1835417 w 2865918"/>
              <a:gd name="connsiteY19" fmla="*/ 373107 h 2355494"/>
              <a:gd name="connsiteX20" fmla="*/ 1917967 w 2865918"/>
              <a:gd name="connsiteY20" fmla="*/ 188957 h 2355494"/>
              <a:gd name="connsiteX21" fmla="*/ 1867167 w 2865918"/>
              <a:gd name="connsiteY21" fmla="*/ 417557 h 2355494"/>
              <a:gd name="connsiteX22" fmla="*/ 1721117 w 2865918"/>
              <a:gd name="connsiteY22" fmla="*/ 455657 h 2355494"/>
              <a:gd name="connsiteX23" fmla="*/ 1733817 w 2865918"/>
              <a:gd name="connsiteY23" fmla="*/ 646157 h 2355494"/>
              <a:gd name="connsiteX24" fmla="*/ 1937017 w 2865918"/>
              <a:gd name="connsiteY24" fmla="*/ 544557 h 2355494"/>
              <a:gd name="connsiteX25" fmla="*/ 1968767 w 2865918"/>
              <a:gd name="connsiteY25" fmla="*/ 119107 h 2355494"/>
              <a:gd name="connsiteX26" fmla="*/ 1981467 w 2865918"/>
              <a:gd name="connsiteY26" fmla="*/ 11157 h 2355494"/>
              <a:gd name="connsiteX27" fmla="*/ 1994167 w 2865918"/>
              <a:gd name="connsiteY27" fmla="*/ 335007 h 2355494"/>
              <a:gd name="connsiteX28" fmla="*/ 1968767 w 2865918"/>
              <a:gd name="connsiteY28" fmla="*/ 589007 h 2355494"/>
              <a:gd name="connsiteX29" fmla="*/ 1860817 w 2865918"/>
              <a:gd name="connsiteY29" fmla="*/ 665207 h 2355494"/>
              <a:gd name="connsiteX30" fmla="*/ 2057667 w 2865918"/>
              <a:gd name="connsiteY30" fmla="*/ 696957 h 2355494"/>
              <a:gd name="connsiteX31" fmla="*/ 2229117 w 2865918"/>
              <a:gd name="connsiteY31" fmla="*/ 652507 h 2355494"/>
              <a:gd name="connsiteX32" fmla="*/ 2089417 w 2865918"/>
              <a:gd name="connsiteY32" fmla="*/ 735057 h 2355494"/>
              <a:gd name="connsiteX33" fmla="*/ 1879867 w 2865918"/>
              <a:gd name="connsiteY33" fmla="*/ 722357 h 2355494"/>
              <a:gd name="connsiteX34" fmla="*/ 1784617 w 2865918"/>
              <a:gd name="connsiteY34" fmla="*/ 703307 h 2355494"/>
              <a:gd name="connsiteX35" fmla="*/ 1733817 w 2865918"/>
              <a:gd name="connsiteY35" fmla="*/ 868407 h 2355494"/>
              <a:gd name="connsiteX36" fmla="*/ 1575067 w 2865918"/>
              <a:gd name="connsiteY36" fmla="*/ 1052557 h 2355494"/>
              <a:gd name="connsiteX37" fmla="*/ 1536967 w 2865918"/>
              <a:gd name="connsiteY37" fmla="*/ 1306557 h 2355494"/>
              <a:gd name="connsiteX38" fmla="*/ 1829067 w 2865918"/>
              <a:gd name="connsiteY38" fmla="*/ 1351007 h 2355494"/>
              <a:gd name="connsiteX39" fmla="*/ 2140217 w 2865918"/>
              <a:gd name="connsiteY39" fmla="*/ 1071607 h 2355494"/>
              <a:gd name="connsiteX40" fmla="*/ 2102117 w 2865918"/>
              <a:gd name="connsiteY40" fmla="*/ 925557 h 2355494"/>
              <a:gd name="connsiteX41" fmla="*/ 2171967 w 2865918"/>
              <a:gd name="connsiteY41" fmla="*/ 792207 h 2355494"/>
              <a:gd name="connsiteX42" fmla="*/ 2140217 w 2865918"/>
              <a:gd name="connsiteY42" fmla="*/ 995407 h 2355494"/>
              <a:gd name="connsiteX43" fmla="*/ 2165617 w 2865918"/>
              <a:gd name="connsiteY43" fmla="*/ 1097007 h 2355494"/>
              <a:gd name="connsiteX44" fmla="*/ 1962417 w 2865918"/>
              <a:gd name="connsiteY44" fmla="*/ 1300207 h 2355494"/>
              <a:gd name="connsiteX45" fmla="*/ 2292617 w 2865918"/>
              <a:gd name="connsiteY45" fmla="*/ 1185907 h 2355494"/>
              <a:gd name="connsiteX46" fmla="*/ 2324367 w 2865918"/>
              <a:gd name="connsiteY46" fmla="*/ 735057 h 2355494"/>
              <a:gd name="connsiteX47" fmla="*/ 2362467 w 2865918"/>
              <a:gd name="connsiteY47" fmla="*/ 1001757 h 2355494"/>
              <a:gd name="connsiteX48" fmla="*/ 2349767 w 2865918"/>
              <a:gd name="connsiteY48" fmla="*/ 1185907 h 2355494"/>
              <a:gd name="connsiteX49" fmla="*/ 2540267 w 2865918"/>
              <a:gd name="connsiteY49" fmla="*/ 627107 h 2355494"/>
              <a:gd name="connsiteX50" fmla="*/ 2864117 w 2865918"/>
              <a:gd name="connsiteY50" fmla="*/ 411207 h 2355494"/>
              <a:gd name="connsiteX51" fmla="*/ 2667267 w 2865918"/>
              <a:gd name="connsiteY51" fmla="*/ 550907 h 2355494"/>
              <a:gd name="connsiteX52" fmla="*/ 2584717 w 2865918"/>
              <a:gd name="connsiteY52" fmla="*/ 633457 h 2355494"/>
              <a:gd name="connsiteX53" fmla="*/ 2533917 w 2865918"/>
              <a:gd name="connsiteY53" fmla="*/ 741407 h 2355494"/>
              <a:gd name="connsiteX54" fmla="*/ 2476767 w 2865918"/>
              <a:gd name="connsiteY54" fmla="*/ 919207 h 2355494"/>
              <a:gd name="connsiteX55" fmla="*/ 2673617 w 2865918"/>
              <a:gd name="connsiteY55" fmla="*/ 766807 h 2355494"/>
              <a:gd name="connsiteX56" fmla="*/ 2711717 w 2865918"/>
              <a:gd name="connsiteY56" fmla="*/ 639807 h 2355494"/>
              <a:gd name="connsiteX57" fmla="*/ 2718067 w 2865918"/>
              <a:gd name="connsiteY57" fmla="*/ 804907 h 2355494"/>
              <a:gd name="connsiteX58" fmla="*/ 2533917 w 2865918"/>
              <a:gd name="connsiteY58" fmla="*/ 950957 h 2355494"/>
              <a:gd name="connsiteX59" fmla="*/ 2438667 w 2865918"/>
              <a:gd name="connsiteY59" fmla="*/ 1109707 h 2355494"/>
              <a:gd name="connsiteX60" fmla="*/ 2381517 w 2865918"/>
              <a:gd name="connsiteY60" fmla="*/ 1274807 h 2355494"/>
              <a:gd name="connsiteX61" fmla="*/ 1994167 w 2865918"/>
              <a:gd name="connsiteY61" fmla="*/ 1401807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365517 w 2865918"/>
              <a:gd name="connsiteY67" fmla="*/ 1865357 h 2355494"/>
              <a:gd name="connsiteX68" fmla="*/ 1225817 w 2865918"/>
              <a:gd name="connsiteY68" fmla="*/ 1687557 h 2355494"/>
              <a:gd name="connsiteX69" fmla="*/ 895617 w 2865918"/>
              <a:gd name="connsiteY69" fmla="*/ 173835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57467 w 2865918"/>
              <a:gd name="connsiteY75" fmla="*/ 22273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27317 w 2865918"/>
              <a:gd name="connsiteY82" fmla="*/ 1852657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575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89317 w 2865918"/>
              <a:gd name="connsiteY105" fmla="*/ 538207 h 2355494"/>
              <a:gd name="connsiteX106" fmla="*/ 990867 w 2865918"/>
              <a:gd name="connsiteY106" fmla="*/ 455657 h 2355494"/>
              <a:gd name="connsiteX0" fmla="*/ 990867 w 2865918"/>
              <a:gd name="connsiteY0" fmla="*/ 455657 h 2355494"/>
              <a:gd name="connsiteX1" fmla="*/ 1181367 w 2865918"/>
              <a:gd name="connsiteY1" fmla="*/ 4366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0117 w 2865918"/>
              <a:gd name="connsiteY10" fmla="*/ 506457 h 2355494"/>
              <a:gd name="connsiteX11" fmla="*/ 1308367 w 2865918"/>
              <a:gd name="connsiteY11" fmla="*/ 500107 h 2355494"/>
              <a:gd name="connsiteX12" fmla="*/ 1359167 w 2865918"/>
              <a:gd name="connsiteY12" fmla="*/ 817607 h 2355494"/>
              <a:gd name="connsiteX13" fmla="*/ 1429017 w 2865918"/>
              <a:gd name="connsiteY13" fmla="*/ 1020807 h 2355494"/>
              <a:gd name="connsiteX14" fmla="*/ 1689367 w 2865918"/>
              <a:gd name="connsiteY14" fmla="*/ 868407 h 2355494"/>
              <a:gd name="connsiteX15" fmla="*/ 1689367 w 2865918"/>
              <a:gd name="connsiteY15" fmla="*/ 487407 h 2355494"/>
              <a:gd name="connsiteX16" fmla="*/ 1740167 w 2865918"/>
              <a:gd name="connsiteY16" fmla="*/ 277857 h 2355494"/>
              <a:gd name="connsiteX17" fmla="*/ 1822717 w 2865918"/>
              <a:gd name="connsiteY17" fmla="*/ 119107 h 2355494"/>
              <a:gd name="connsiteX18" fmla="*/ 1733817 w 2865918"/>
              <a:gd name="connsiteY18" fmla="*/ 379457 h 2355494"/>
              <a:gd name="connsiteX19" fmla="*/ 1835417 w 2865918"/>
              <a:gd name="connsiteY19" fmla="*/ 373107 h 2355494"/>
              <a:gd name="connsiteX20" fmla="*/ 1917967 w 2865918"/>
              <a:gd name="connsiteY20" fmla="*/ 188957 h 2355494"/>
              <a:gd name="connsiteX21" fmla="*/ 1867167 w 2865918"/>
              <a:gd name="connsiteY21" fmla="*/ 417557 h 2355494"/>
              <a:gd name="connsiteX22" fmla="*/ 1721117 w 2865918"/>
              <a:gd name="connsiteY22" fmla="*/ 455657 h 2355494"/>
              <a:gd name="connsiteX23" fmla="*/ 1733817 w 2865918"/>
              <a:gd name="connsiteY23" fmla="*/ 646157 h 2355494"/>
              <a:gd name="connsiteX24" fmla="*/ 1937017 w 2865918"/>
              <a:gd name="connsiteY24" fmla="*/ 544557 h 2355494"/>
              <a:gd name="connsiteX25" fmla="*/ 1968767 w 2865918"/>
              <a:gd name="connsiteY25" fmla="*/ 119107 h 2355494"/>
              <a:gd name="connsiteX26" fmla="*/ 1981467 w 2865918"/>
              <a:gd name="connsiteY26" fmla="*/ 11157 h 2355494"/>
              <a:gd name="connsiteX27" fmla="*/ 1994167 w 2865918"/>
              <a:gd name="connsiteY27" fmla="*/ 335007 h 2355494"/>
              <a:gd name="connsiteX28" fmla="*/ 1968767 w 2865918"/>
              <a:gd name="connsiteY28" fmla="*/ 589007 h 2355494"/>
              <a:gd name="connsiteX29" fmla="*/ 1860817 w 2865918"/>
              <a:gd name="connsiteY29" fmla="*/ 665207 h 2355494"/>
              <a:gd name="connsiteX30" fmla="*/ 2057667 w 2865918"/>
              <a:gd name="connsiteY30" fmla="*/ 696957 h 2355494"/>
              <a:gd name="connsiteX31" fmla="*/ 2229117 w 2865918"/>
              <a:gd name="connsiteY31" fmla="*/ 652507 h 2355494"/>
              <a:gd name="connsiteX32" fmla="*/ 2089417 w 2865918"/>
              <a:gd name="connsiteY32" fmla="*/ 735057 h 2355494"/>
              <a:gd name="connsiteX33" fmla="*/ 1879867 w 2865918"/>
              <a:gd name="connsiteY33" fmla="*/ 722357 h 2355494"/>
              <a:gd name="connsiteX34" fmla="*/ 1784617 w 2865918"/>
              <a:gd name="connsiteY34" fmla="*/ 703307 h 2355494"/>
              <a:gd name="connsiteX35" fmla="*/ 1733817 w 2865918"/>
              <a:gd name="connsiteY35" fmla="*/ 868407 h 2355494"/>
              <a:gd name="connsiteX36" fmla="*/ 1575067 w 2865918"/>
              <a:gd name="connsiteY36" fmla="*/ 1052557 h 2355494"/>
              <a:gd name="connsiteX37" fmla="*/ 1536967 w 2865918"/>
              <a:gd name="connsiteY37" fmla="*/ 1306557 h 2355494"/>
              <a:gd name="connsiteX38" fmla="*/ 1829067 w 2865918"/>
              <a:gd name="connsiteY38" fmla="*/ 1351007 h 2355494"/>
              <a:gd name="connsiteX39" fmla="*/ 2140217 w 2865918"/>
              <a:gd name="connsiteY39" fmla="*/ 1071607 h 2355494"/>
              <a:gd name="connsiteX40" fmla="*/ 2102117 w 2865918"/>
              <a:gd name="connsiteY40" fmla="*/ 925557 h 2355494"/>
              <a:gd name="connsiteX41" fmla="*/ 2171967 w 2865918"/>
              <a:gd name="connsiteY41" fmla="*/ 792207 h 2355494"/>
              <a:gd name="connsiteX42" fmla="*/ 2140217 w 2865918"/>
              <a:gd name="connsiteY42" fmla="*/ 995407 h 2355494"/>
              <a:gd name="connsiteX43" fmla="*/ 2165617 w 2865918"/>
              <a:gd name="connsiteY43" fmla="*/ 1097007 h 2355494"/>
              <a:gd name="connsiteX44" fmla="*/ 1962417 w 2865918"/>
              <a:gd name="connsiteY44" fmla="*/ 1300207 h 2355494"/>
              <a:gd name="connsiteX45" fmla="*/ 2292617 w 2865918"/>
              <a:gd name="connsiteY45" fmla="*/ 1185907 h 2355494"/>
              <a:gd name="connsiteX46" fmla="*/ 2324367 w 2865918"/>
              <a:gd name="connsiteY46" fmla="*/ 735057 h 2355494"/>
              <a:gd name="connsiteX47" fmla="*/ 2362467 w 2865918"/>
              <a:gd name="connsiteY47" fmla="*/ 1001757 h 2355494"/>
              <a:gd name="connsiteX48" fmla="*/ 2349767 w 2865918"/>
              <a:gd name="connsiteY48" fmla="*/ 1185907 h 2355494"/>
              <a:gd name="connsiteX49" fmla="*/ 2540267 w 2865918"/>
              <a:gd name="connsiteY49" fmla="*/ 627107 h 2355494"/>
              <a:gd name="connsiteX50" fmla="*/ 2864117 w 2865918"/>
              <a:gd name="connsiteY50" fmla="*/ 411207 h 2355494"/>
              <a:gd name="connsiteX51" fmla="*/ 2667267 w 2865918"/>
              <a:gd name="connsiteY51" fmla="*/ 550907 h 2355494"/>
              <a:gd name="connsiteX52" fmla="*/ 2584717 w 2865918"/>
              <a:gd name="connsiteY52" fmla="*/ 633457 h 2355494"/>
              <a:gd name="connsiteX53" fmla="*/ 2533917 w 2865918"/>
              <a:gd name="connsiteY53" fmla="*/ 741407 h 2355494"/>
              <a:gd name="connsiteX54" fmla="*/ 2476767 w 2865918"/>
              <a:gd name="connsiteY54" fmla="*/ 919207 h 2355494"/>
              <a:gd name="connsiteX55" fmla="*/ 2673617 w 2865918"/>
              <a:gd name="connsiteY55" fmla="*/ 766807 h 2355494"/>
              <a:gd name="connsiteX56" fmla="*/ 2711717 w 2865918"/>
              <a:gd name="connsiteY56" fmla="*/ 639807 h 2355494"/>
              <a:gd name="connsiteX57" fmla="*/ 2718067 w 2865918"/>
              <a:gd name="connsiteY57" fmla="*/ 804907 h 2355494"/>
              <a:gd name="connsiteX58" fmla="*/ 2533917 w 2865918"/>
              <a:gd name="connsiteY58" fmla="*/ 950957 h 2355494"/>
              <a:gd name="connsiteX59" fmla="*/ 2438667 w 2865918"/>
              <a:gd name="connsiteY59" fmla="*/ 1109707 h 2355494"/>
              <a:gd name="connsiteX60" fmla="*/ 2381517 w 2865918"/>
              <a:gd name="connsiteY60" fmla="*/ 1274807 h 2355494"/>
              <a:gd name="connsiteX61" fmla="*/ 1994167 w 2865918"/>
              <a:gd name="connsiteY61" fmla="*/ 1401807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365517 w 2865918"/>
              <a:gd name="connsiteY67" fmla="*/ 1865357 h 2355494"/>
              <a:gd name="connsiteX68" fmla="*/ 1225817 w 2865918"/>
              <a:gd name="connsiteY68" fmla="*/ 1687557 h 2355494"/>
              <a:gd name="connsiteX69" fmla="*/ 895617 w 2865918"/>
              <a:gd name="connsiteY69" fmla="*/ 173835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57467 w 2865918"/>
              <a:gd name="connsiteY75" fmla="*/ 22273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27317 w 2865918"/>
              <a:gd name="connsiteY82" fmla="*/ 1852657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89317 w 2865918"/>
              <a:gd name="connsiteY105" fmla="*/ 538207 h 2355494"/>
              <a:gd name="connsiteX106" fmla="*/ 990867 w 2865918"/>
              <a:gd name="connsiteY106" fmla="*/ 455657 h 2355494"/>
              <a:gd name="connsiteX0" fmla="*/ 990867 w 2865918"/>
              <a:gd name="connsiteY0" fmla="*/ 45565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0117 w 2865918"/>
              <a:gd name="connsiteY10" fmla="*/ 506457 h 2355494"/>
              <a:gd name="connsiteX11" fmla="*/ 1308367 w 2865918"/>
              <a:gd name="connsiteY11" fmla="*/ 500107 h 2355494"/>
              <a:gd name="connsiteX12" fmla="*/ 1359167 w 2865918"/>
              <a:gd name="connsiteY12" fmla="*/ 817607 h 2355494"/>
              <a:gd name="connsiteX13" fmla="*/ 1429017 w 2865918"/>
              <a:gd name="connsiteY13" fmla="*/ 1020807 h 2355494"/>
              <a:gd name="connsiteX14" fmla="*/ 1689367 w 2865918"/>
              <a:gd name="connsiteY14" fmla="*/ 868407 h 2355494"/>
              <a:gd name="connsiteX15" fmla="*/ 1689367 w 2865918"/>
              <a:gd name="connsiteY15" fmla="*/ 487407 h 2355494"/>
              <a:gd name="connsiteX16" fmla="*/ 1740167 w 2865918"/>
              <a:gd name="connsiteY16" fmla="*/ 277857 h 2355494"/>
              <a:gd name="connsiteX17" fmla="*/ 1822717 w 2865918"/>
              <a:gd name="connsiteY17" fmla="*/ 119107 h 2355494"/>
              <a:gd name="connsiteX18" fmla="*/ 1733817 w 2865918"/>
              <a:gd name="connsiteY18" fmla="*/ 379457 h 2355494"/>
              <a:gd name="connsiteX19" fmla="*/ 1835417 w 2865918"/>
              <a:gd name="connsiteY19" fmla="*/ 373107 h 2355494"/>
              <a:gd name="connsiteX20" fmla="*/ 1917967 w 2865918"/>
              <a:gd name="connsiteY20" fmla="*/ 188957 h 2355494"/>
              <a:gd name="connsiteX21" fmla="*/ 1867167 w 2865918"/>
              <a:gd name="connsiteY21" fmla="*/ 417557 h 2355494"/>
              <a:gd name="connsiteX22" fmla="*/ 1721117 w 2865918"/>
              <a:gd name="connsiteY22" fmla="*/ 455657 h 2355494"/>
              <a:gd name="connsiteX23" fmla="*/ 1733817 w 2865918"/>
              <a:gd name="connsiteY23" fmla="*/ 646157 h 2355494"/>
              <a:gd name="connsiteX24" fmla="*/ 1937017 w 2865918"/>
              <a:gd name="connsiteY24" fmla="*/ 544557 h 2355494"/>
              <a:gd name="connsiteX25" fmla="*/ 1968767 w 2865918"/>
              <a:gd name="connsiteY25" fmla="*/ 119107 h 2355494"/>
              <a:gd name="connsiteX26" fmla="*/ 1981467 w 2865918"/>
              <a:gd name="connsiteY26" fmla="*/ 11157 h 2355494"/>
              <a:gd name="connsiteX27" fmla="*/ 1994167 w 2865918"/>
              <a:gd name="connsiteY27" fmla="*/ 335007 h 2355494"/>
              <a:gd name="connsiteX28" fmla="*/ 1968767 w 2865918"/>
              <a:gd name="connsiteY28" fmla="*/ 589007 h 2355494"/>
              <a:gd name="connsiteX29" fmla="*/ 1860817 w 2865918"/>
              <a:gd name="connsiteY29" fmla="*/ 665207 h 2355494"/>
              <a:gd name="connsiteX30" fmla="*/ 2057667 w 2865918"/>
              <a:gd name="connsiteY30" fmla="*/ 696957 h 2355494"/>
              <a:gd name="connsiteX31" fmla="*/ 2229117 w 2865918"/>
              <a:gd name="connsiteY31" fmla="*/ 652507 h 2355494"/>
              <a:gd name="connsiteX32" fmla="*/ 2089417 w 2865918"/>
              <a:gd name="connsiteY32" fmla="*/ 735057 h 2355494"/>
              <a:gd name="connsiteX33" fmla="*/ 1879867 w 2865918"/>
              <a:gd name="connsiteY33" fmla="*/ 722357 h 2355494"/>
              <a:gd name="connsiteX34" fmla="*/ 1784617 w 2865918"/>
              <a:gd name="connsiteY34" fmla="*/ 703307 h 2355494"/>
              <a:gd name="connsiteX35" fmla="*/ 1733817 w 2865918"/>
              <a:gd name="connsiteY35" fmla="*/ 868407 h 2355494"/>
              <a:gd name="connsiteX36" fmla="*/ 1575067 w 2865918"/>
              <a:gd name="connsiteY36" fmla="*/ 1052557 h 2355494"/>
              <a:gd name="connsiteX37" fmla="*/ 1536967 w 2865918"/>
              <a:gd name="connsiteY37" fmla="*/ 1306557 h 2355494"/>
              <a:gd name="connsiteX38" fmla="*/ 1829067 w 2865918"/>
              <a:gd name="connsiteY38" fmla="*/ 1351007 h 2355494"/>
              <a:gd name="connsiteX39" fmla="*/ 2140217 w 2865918"/>
              <a:gd name="connsiteY39" fmla="*/ 1071607 h 2355494"/>
              <a:gd name="connsiteX40" fmla="*/ 2102117 w 2865918"/>
              <a:gd name="connsiteY40" fmla="*/ 925557 h 2355494"/>
              <a:gd name="connsiteX41" fmla="*/ 2171967 w 2865918"/>
              <a:gd name="connsiteY41" fmla="*/ 792207 h 2355494"/>
              <a:gd name="connsiteX42" fmla="*/ 2140217 w 2865918"/>
              <a:gd name="connsiteY42" fmla="*/ 995407 h 2355494"/>
              <a:gd name="connsiteX43" fmla="*/ 2165617 w 2865918"/>
              <a:gd name="connsiteY43" fmla="*/ 1097007 h 2355494"/>
              <a:gd name="connsiteX44" fmla="*/ 1962417 w 2865918"/>
              <a:gd name="connsiteY44" fmla="*/ 1300207 h 2355494"/>
              <a:gd name="connsiteX45" fmla="*/ 2292617 w 2865918"/>
              <a:gd name="connsiteY45" fmla="*/ 1185907 h 2355494"/>
              <a:gd name="connsiteX46" fmla="*/ 2324367 w 2865918"/>
              <a:gd name="connsiteY46" fmla="*/ 735057 h 2355494"/>
              <a:gd name="connsiteX47" fmla="*/ 2362467 w 2865918"/>
              <a:gd name="connsiteY47" fmla="*/ 1001757 h 2355494"/>
              <a:gd name="connsiteX48" fmla="*/ 2349767 w 2865918"/>
              <a:gd name="connsiteY48" fmla="*/ 1185907 h 2355494"/>
              <a:gd name="connsiteX49" fmla="*/ 2540267 w 2865918"/>
              <a:gd name="connsiteY49" fmla="*/ 627107 h 2355494"/>
              <a:gd name="connsiteX50" fmla="*/ 2864117 w 2865918"/>
              <a:gd name="connsiteY50" fmla="*/ 411207 h 2355494"/>
              <a:gd name="connsiteX51" fmla="*/ 2667267 w 2865918"/>
              <a:gd name="connsiteY51" fmla="*/ 550907 h 2355494"/>
              <a:gd name="connsiteX52" fmla="*/ 2584717 w 2865918"/>
              <a:gd name="connsiteY52" fmla="*/ 633457 h 2355494"/>
              <a:gd name="connsiteX53" fmla="*/ 2533917 w 2865918"/>
              <a:gd name="connsiteY53" fmla="*/ 741407 h 2355494"/>
              <a:gd name="connsiteX54" fmla="*/ 2476767 w 2865918"/>
              <a:gd name="connsiteY54" fmla="*/ 919207 h 2355494"/>
              <a:gd name="connsiteX55" fmla="*/ 2673617 w 2865918"/>
              <a:gd name="connsiteY55" fmla="*/ 766807 h 2355494"/>
              <a:gd name="connsiteX56" fmla="*/ 2711717 w 2865918"/>
              <a:gd name="connsiteY56" fmla="*/ 639807 h 2355494"/>
              <a:gd name="connsiteX57" fmla="*/ 2718067 w 2865918"/>
              <a:gd name="connsiteY57" fmla="*/ 804907 h 2355494"/>
              <a:gd name="connsiteX58" fmla="*/ 2533917 w 2865918"/>
              <a:gd name="connsiteY58" fmla="*/ 950957 h 2355494"/>
              <a:gd name="connsiteX59" fmla="*/ 2438667 w 2865918"/>
              <a:gd name="connsiteY59" fmla="*/ 1109707 h 2355494"/>
              <a:gd name="connsiteX60" fmla="*/ 2381517 w 2865918"/>
              <a:gd name="connsiteY60" fmla="*/ 1274807 h 2355494"/>
              <a:gd name="connsiteX61" fmla="*/ 1994167 w 2865918"/>
              <a:gd name="connsiteY61" fmla="*/ 1401807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365517 w 2865918"/>
              <a:gd name="connsiteY67" fmla="*/ 1865357 h 2355494"/>
              <a:gd name="connsiteX68" fmla="*/ 1225817 w 2865918"/>
              <a:gd name="connsiteY68" fmla="*/ 1687557 h 2355494"/>
              <a:gd name="connsiteX69" fmla="*/ 895617 w 2865918"/>
              <a:gd name="connsiteY69" fmla="*/ 173835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57467 w 2865918"/>
              <a:gd name="connsiteY75" fmla="*/ 22273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27317 w 2865918"/>
              <a:gd name="connsiteY82" fmla="*/ 1852657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89317 w 2865918"/>
              <a:gd name="connsiteY105" fmla="*/ 538207 h 2355494"/>
              <a:gd name="connsiteX106" fmla="*/ 990867 w 2865918"/>
              <a:gd name="connsiteY106" fmla="*/ 455657 h 2355494"/>
              <a:gd name="connsiteX0" fmla="*/ 990867 w 2865918"/>
              <a:gd name="connsiteY0" fmla="*/ 45565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0117 w 2865918"/>
              <a:gd name="connsiteY10" fmla="*/ 506457 h 2355494"/>
              <a:gd name="connsiteX11" fmla="*/ 1308367 w 2865918"/>
              <a:gd name="connsiteY11" fmla="*/ 500107 h 2355494"/>
              <a:gd name="connsiteX12" fmla="*/ 1359167 w 2865918"/>
              <a:gd name="connsiteY12" fmla="*/ 817607 h 2355494"/>
              <a:gd name="connsiteX13" fmla="*/ 1429017 w 2865918"/>
              <a:gd name="connsiteY13" fmla="*/ 1020807 h 2355494"/>
              <a:gd name="connsiteX14" fmla="*/ 1689367 w 2865918"/>
              <a:gd name="connsiteY14" fmla="*/ 868407 h 2355494"/>
              <a:gd name="connsiteX15" fmla="*/ 1689367 w 2865918"/>
              <a:gd name="connsiteY15" fmla="*/ 487407 h 2355494"/>
              <a:gd name="connsiteX16" fmla="*/ 1740167 w 2865918"/>
              <a:gd name="connsiteY16" fmla="*/ 277857 h 2355494"/>
              <a:gd name="connsiteX17" fmla="*/ 1822717 w 2865918"/>
              <a:gd name="connsiteY17" fmla="*/ 119107 h 2355494"/>
              <a:gd name="connsiteX18" fmla="*/ 1733817 w 2865918"/>
              <a:gd name="connsiteY18" fmla="*/ 379457 h 2355494"/>
              <a:gd name="connsiteX19" fmla="*/ 1835417 w 2865918"/>
              <a:gd name="connsiteY19" fmla="*/ 373107 h 2355494"/>
              <a:gd name="connsiteX20" fmla="*/ 1917967 w 2865918"/>
              <a:gd name="connsiteY20" fmla="*/ 188957 h 2355494"/>
              <a:gd name="connsiteX21" fmla="*/ 1867167 w 2865918"/>
              <a:gd name="connsiteY21" fmla="*/ 417557 h 2355494"/>
              <a:gd name="connsiteX22" fmla="*/ 1721117 w 2865918"/>
              <a:gd name="connsiteY22" fmla="*/ 455657 h 2355494"/>
              <a:gd name="connsiteX23" fmla="*/ 1733817 w 2865918"/>
              <a:gd name="connsiteY23" fmla="*/ 646157 h 2355494"/>
              <a:gd name="connsiteX24" fmla="*/ 1937017 w 2865918"/>
              <a:gd name="connsiteY24" fmla="*/ 544557 h 2355494"/>
              <a:gd name="connsiteX25" fmla="*/ 1968767 w 2865918"/>
              <a:gd name="connsiteY25" fmla="*/ 119107 h 2355494"/>
              <a:gd name="connsiteX26" fmla="*/ 1981467 w 2865918"/>
              <a:gd name="connsiteY26" fmla="*/ 11157 h 2355494"/>
              <a:gd name="connsiteX27" fmla="*/ 1994167 w 2865918"/>
              <a:gd name="connsiteY27" fmla="*/ 335007 h 2355494"/>
              <a:gd name="connsiteX28" fmla="*/ 1968767 w 2865918"/>
              <a:gd name="connsiteY28" fmla="*/ 589007 h 2355494"/>
              <a:gd name="connsiteX29" fmla="*/ 1860817 w 2865918"/>
              <a:gd name="connsiteY29" fmla="*/ 665207 h 2355494"/>
              <a:gd name="connsiteX30" fmla="*/ 2057667 w 2865918"/>
              <a:gd name="connsiteY30" fmla="*/ 696957 h 2355494"/>
              <a:gd name="connsiteX31" fmla="*/ 2229117 w 2865918"/>
              <a:gd name="connsiteY31" fmla="*/ 652507 h 2355494"/>
              <a:gd name="connsiteX32" fmla="*/ 2089417 w 2865918"/>
              <a:gd name="connsiteY32" fmla="*/ 735057 h 2355494"/>
              <a:gd name="connsiteX33" fmla="*/ 1879867 w 2865918"/>
              <a:gd name="connsiteY33" fmla="*/ 722357 h 2355494"/>
              <a:gd name="connsiteX34" fmla="*/ 1784617 w 2865918"/>
              <a:gd name="connsiteY34" fmla="*/ 703307 h 2355494"/>
              <a:gd name="connsiteX35" fmla="*/ 1733817 w 2865918"/>
              <a:gd name="connsiteY35" fmla="*/ 868407 h 2355494"/>
              <a:gd name="connsiteX36" fmla="*/ 1575067 w 2865918"/>
              <a:gd name="connsiteY36" fmla="*/ 1052557 h 2355494"/>
              <a:gd name="connsiteX37" fmla="*/ 1536967 w 2865918"/>
              <a:gd name="connsiteY37" fmla="*/ 1306557 h 2355494"/>
              <a:gd name="connsiteX38" fmla="*/ 1829067 w 2865918"/>
              <a:gd name="connsiteY38" fmla="*/ 1351007 h 2355494"/>
              <a:gd name="connsiteX39" fmla="*/ 2140217 w 2865918"/>
              <a:gd name="connsiteY39" fmla="*/ 1071607 h 2355494"/>
              <a:gd name="connsiteX40" fmla="*/ 2102117 w 2865918"/>
              <a:gd name="connsiteY40" fmla="*/ 925557 h 2355494"/>
              <a:gd name="connsiteX41" fmla="*/ 2171967 w 2865918"/>
              <a:gd name="connsiteY41" fmla="*/ 792207 h 2355494"/>
              <a:gd name="connsiteX42" fmla="*/ 2140217 w 2865918"/>
              <a:gd name="connsiteY42" fmla="*/ 995407 h 2355494"/>
              <a:gd name="connsiteX43" fmla="*/ 2165617 w 2865918"/>
              <a:gd name="connsiteY43" fmla="*/ 1097007 h 2355494"/>
              <a:gd name="connsiteX44" fmla="*/ 1962417 w 2865918"/>
              <a:gd name="connsiteY44" fmla="*/ 1300207 h 2355494"/>
              <a:gd name="connsiteX45" fmla="*/ 2292617 w 2865918"/>
              <a:gd name="connsiteY45" fmla="*/ 1185907 h 2355494"/>
              <a:gd name="connsiteX46" fmla="*/ 2324367 w 2865918"/>
              <a:gd name="connsiteY46" fmla="*/ 735057 h 2355494"/>
              <a:gd name="connsiteX47" fmla="*/ 2362467 w 2865918"/>
              <a:gd name="connsiteY47" fmla="*/ 1001757 h 2355494"/>
              <a:gd name="connsiteX48" fmla="*/ 2349767 w 2865918"/>
              <a:gd name="connsiteY48" fmla="*/ 1185907 h 2355494"/>
              <a:gd name="connsiteX49" fmla="*/ 2540267 w 2865918"/>
              <a:gd name="connsiteY49" fmla="*/ 627107 h 2355494"/>
              <a:gd name="connsiteX50" fmla="*/ 2864117 w 2865918"/>
              <a:gd name="connsiteY50" fmla="*/ 411207 h 2355494"/>
              <a:gd name="connsiteX51" fmla="*/ 2667267 w 2865918"/>
              <a:gd name="connsiteY51" fmla="*/ 550907 h 2355494"/>
              <a:gd name="connsiteX52" fmla="*/ 2584717 w 2865918"/>
              <a:gd name="connsiteY52" fmla="*/ 633457 h 2355494"/>
              <a:gd name="connsiteX53" fmla="*/ 2533917 w 2865918"/>
              <a:gd name="connsiteY53" fmla="*/ 741407 h 2355494"/>
              <a:gd name="connsiteX54" fmla="*/ 2476767 w 2865918"/>
              <a:gd name="connsiteY54" fmla="*/ 919207 h 2355494"/>
              <a:gd name="connsiteX55" fmla="*/ 2673617 w 2865918"/>
              <a:gd name="connsiteY55" fmla="*/ 766807 h 2355494"/>
              <a:gd name="connsiteX56" fmla="*/ 2711717 w 2865918"/>
              <a:gd name="connsiteY56" fmla="*/ 639807 h 2355494"/>
              <a:gd name="connsiteX57" fmla="*/ 2718067 w 2865918"/>
              <a:gd name="connsiteY57" fmla="*/ 804907 h 2355494"/>
              <a:gd name="connsiteX58" fmla="*/ 2533917 w 2865918"/>
              <a:gd name="connsiteY58" fmla="*/ 950957 h 2355494"/>
              <a:gd name="connsiteX59" fmla="*/ 2438667 w 2865918"/>
              <a:gd name="connsiteY59" fmla="*/ 1109707 h 2355494"/>
              <a:gd name="connsiteX60" fmla="*/ 2381517 w 2865918"/>
              <a:gd name="connsiteY60" fmla="*/ 1274807 h 2355494"/>
              <a:gd name="connsiteX61" fmla="*/ 1994167 w 2865918"/>
              <a:gd name="connsiteY61" fmla="*/ 1401807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365517 w 2865918"/>
              <a:gd name="connsiteY67" fmla="*/ 1865357 h 2355494"/>
              <a:gd name="connsiteX68" fmla="*/ 1225817 w 2865918"/>
              <a:gd name="connsiteY68" fmla="*/ 1687557 h 2355494"/>
              <a:gd name="connsiteX69" fmla="*/ 895617 w 2865918"/>
              <a:gd name="connsiteY69" fmla="*/ 173835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57467 w 2865918"/>
              <a:gd name="connsiteY75" fmla="*/ 22273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27317 w 2865918"/>
              <a:gd name="connsiteY82" fmla="*/ 1852657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5505 w 2865918"/>
              <a:gd name="connsiteY105" fmla="*/ 547732 h 2355494"/>
              <a:gd name="connsiteX106" fmla="*/ 990867 w 2865918"/>
              <a:gd name="connsiteY106" fmla="*/ 455657 h 2355494"/>
              <a:gd name="connsiteX0" fmla="*/ 990867 w 2865918"/>
              <a:gd name="connsiteY0" fmla="*/ 45565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0117 w 2865918"/>
              <a:gd name="connsiteY10" fmla="*/ 506457 h 2355494"/>
              <a:gd name="connsiteX11" fmla="*/ 1308367 w 2865918"/>
              <a:gd name="connsiteY11" fmla="*/ 500107 h 2355494"/>
              <a:gd name="connsiteX12" fmla="*/ 1359167 w 2865918"/>
              <a:gd name="connsiteY12" fmla="*/ 817607 h 2355494"/>
              <a:gd name="connsiteX13" fmla="*/ 1429017 w 2865918"/>
              <a:gd name="connsiteY13" fmla="*/ 1020807 h 2355494"/>
              <a:gd name="connsiteX14" fmla="*/ 1689367 w 2865918"/>
              <a:gd name="connsiteY14" fmla="*/ 868407 h 2355494"/>
              <a:gd name="connsiteX15" fmla="*/ 1689367 w 2865918"/>
              <a:gd name="connsiteY15" fmla="*/ 487407 h 2355494"/>
              <a:gd name="connsiteX16" fmla="*/ 1740167 w 2865918"/>
              <a:gd name="connsiteY16" fmla="*/ 277857 h 2355494"/>
              <a:gd name="connsiteX17" fmla="*/ 1822717 w 2865918"/>
              <a:gd name="connsiteY17" fmla="*/ 119107 h 2355494"/>
              <a:gd name="connsiteX18" fmla="*/ 1733817 w 2865918"/>
              <a:gd name="connsiteY18" fmla="*/ 379457 h 2355494"/>
              <a:gd name="connsiteX19" fmla="*/ 1835417 w 2865918"/>
              <a:gd name="connsiteY19" fmla="*/ 373107 h 2355494"/>
              <a:gd name="connsiteX20" fmla="*/ 1917967 w 2865918"/>
              <a:gd name="connsiteY20" fmla="*/ 188957 h 2355494"/>
              <a:gd name="connsiteX21" fmla="*/ 1867167 w 2865918"/>
              <a:gd name="connsiteY21" fmla="*/ 417557 h 2355494"/>
              <a:gd name="connsiteX22" fmla="*/ 1721117 w 2865918"/>
              <a:gd name="connsiteY22" fmla="*/ 455657 h 2355494"/>
              <a:gd name="connsiteX23" fmla="*/ 1733817 w 2865918"/>
              <a:gd name="connsiteY23" fmla="*/ 646157 h 2355494"/>
              <a:gd name="connsiteX24" fmla="*/ 1937017 w 2865918"/>
              <a:gd name="connsiteY24" fmla="*/ 544557 h 2355494"/>
              <a:gd name="connsiteX25" fmla="*/ 1968767 w 2865918"/>
              <a:gd name="connsiteY25" fmla="*/ 119107 h 2355494"/>
              <a:gd name="connsiteX26" fmla="*/ 1981467 w 2865918"/>
              <a:gd name="connsiteY26" fmla="*/ 11157 h 2355494"/>
              <a:gd name="connsiteX27" fmla="*/ 1994167 w 2865918"/>
              <a:gd name="connsiteY27" fmla="*/ 335007 h 2355494"/>
              <a:gd name="connsiteX28" fmla="*/ 1968767 w 2865918"/>
              <a:gd name="connsiteY28" fmla="*/ 589007 h 2355494"/>
              <a:gd name="connsiteX29" fmla="*/ 1860817 w 2865918"/>
              <a:gd name="connsiteY29" fmla="*/ 665207 h 2355494"/>
              <a:gd name="connsiteX30" fmla="*/ 2057667 w 2865918"/>
              <a:gd name="connsiteY30" fmla="*/ 696957 h 2355494"/>
              <a:gd name="connsiteX31" fmla="*/ 2229117 w 2865918"/>
              <a:gd name="connsiteY31" fmla="*/ 652507 h 2355494"/>
              <a:gd name="connsiteX32" fmla="*/ 2089417 w 2865918"/>
              <a:gd name="connsiteY32" fmla="*/ 735057 h 2355494"/>
              <a:gd name="connsiteX33" fmla="*/ 1879867 w 2865918"/>
              <a:gd name="connsiteY33" fmla="*/ 722357 h 2355494"/>
              <a:gd name="connsiteX34" fmla="*/ 1784617 w 2865918"/>
              <a:gd name="connsiteY34" fmla="*/ 703307 h 2355494"/>
              <a:gd name="connsiteX35" fmla="*/ 1733817 w 2865918"/>
              <a:gd name="connsiteY35" fmla="*/ 868407 h 2355494"/>
              <a:gd name="connsiteX36" fmla="*/ 1575067 w 2865918"/>
              <a:gd name="connsiteY36" fmla="*/ 1052557 h 2355494"/>
              <a:gd name="connsiteX37" fmla="*/ 1536967 w 2865918"/>
              <a:gd name="connsiteY37" fmla="*/ 1306557 h 2355494"/>
              <a:gd name="connsiteX38" fmla="*/ 1829067 w 2865918"/>
              <a:gd name="connsiteY38" fmla="*/ 1351007 h 2355494"/>
              <a:gd name="connsiteX39" fmla="*/ 2140217 w 2865918"/>
              <a:gd name="connsiteY39" fmla="*/ 1071607 h 2355494"/>
              <a:gd name="connsiteX40" fmla="*/ 2102117 w 2865918"/>
              <a:gd name="connsiteY40" fmla="*/ 925557 h 2355494"/>
              <a:gd name="connsiteX41" fmla="*/ 2171967 w 2865918"/>
              <a:gd name="connsiteY41" fmla="*/ 792207 h 2355494"/>
              <a:gd name="connsiteX42" fmla="*/ 2140217 w 2865918"/>
              <a:gd name="connsiteY42" fmla="*/ 995407 h 2355494"/>
              <a:gd name="connsiteX43" fmla="*/ 2165617 w 2865918"/>
              <a:gd name="connsiteY43" fmla="*/ 1097007 h 2355494"/>
              <a:gd name="connsiteX44" fmla="*/ 1962417 w 2865918"/>
              <a:gd name="connsiteY44" fmla="*/ 1300207 h 2355494"/>
              <a:gd name="connsiteX45" fmla="*/ 2292617 w 2865918"/>
              <a:gd name="connsiteY45" fmla="*/ 1185907 h 2355494"/>
              <a:gd name="connsiteX46" fmla="*/ 2324367 w 2865918"/>
              <a:gd name="connsiteY46" fmla="*/ 735057 h 2355494"/>
              <a:gd name="connsiteX47" fmla="*/ 2362467 w 2865918"/>
              <a:gd name="connsiteY47" fmla="*/ 1001757 h 2355494"/>
              <a:gd name="connsiteX48" fmla="*/ 2349767 w 2865918"/>
              <a:gd name="connsiteY48" fmla="*/ 1185907 h 2355494"/>
              <a:gd name="connsiteX49" fmla="*/ 2540267 w 2865918"/>
              <a:gd name="connsiteY49" fmla="*/ 627107 h 2355494"/>
              <a:gd name="connsiteX50" fmla="*/ 2864117 w 2865918"/>
              <a:gd name="connsiteY50" fmla="*/ 411207 h 2355494"/>
              <a:gd name="connsiteX51" fmla="*/ 2667267 w 2865918"/>
              <a:gd name="connsiteY51" fmla="*/ 550907 h 2355494"/>
              <a:gd name="connsiteX52" fmla="*/ 2584717 w 2865918"/>
              <a:gd name="connsiteY52" fmla="*/ 633457 h 2355494"/>
              <a:gd name="connsiteX53" fmla="*/ 2533917 w 2865918"/>
              <a:gd name="connsiteY53" fmla="*/ 741407 h 2355494"/>
              <a:gd name="connsiteX54" fmla="*/ 2476767 w 2865918"/>
              <a:gd name="connsiteY54" fmla="*/ 919207 h 2355494"/>
              <a:gd name="connsiteX55" fmla="*/ 2673617 w 2865918"/>
              <a:gd name="connsiteY55" fmla="*/ 766807 h 2355494"/>
              <a:gd name="connsiteX56" fmla="*/ 2711717 w 2865918"/>
              <a:gd name="connsiteY56" fmla="*/ 639807 h 2355494"/>
              <a:gd name="connsiteX57" fmla="*/ 2718067 w 2865918"/>
              <a:gd name="connsiteY57" fmla="*/ 804907 h 2355494"/>
              <a:gd name="connsiteX58" fmla="*/ 2533917 w 2865918"/>
              <a:gd name="connsiteY58" fmla="*/ 950957 h 2355494"/>
              <a:gd name="connsiteX59" fmla="*/ 2438667 w 2865918"/>
              <a:gd name="connsiteY59" fmla="*/ 1109707 h 2355494"/>
              <a:gd name="connsiteX60" fmla="*/ 2381517 w 2865918"/>
              <a:gd name="connsiteY60" fmla="*/ 1274807 h 2355494"/>
              <a:gd name="connsiteX61" fmla="*/ 1994167 w 2865918"/>
              <a:gd name="connsiteY61" fmla="*/ 1401807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365517 w 2865918"/>
              <a:gd name="connsiteY67" fmla="*/ 1865357 h 2355494"/>
              <a:gd name="connsiteX68" fmla="*/ 1225817 w 2865918"/>
              <a:gd name="connsiteY68" fmla="*/ 1687557 h 2355494"/>
              <a:gd name="connsiteX69" fmla="*/ 895617 w 2865918"/>
              <a:gd name="connsiteY69" fmla="*/ 173835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57467 w 2865918"/>
              <a:gd name="connsiteY75" fmla="*/ 22273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27317 w 2865918"/>
              <a:gd name="connsiteY82" fmla="*/ 1852657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990867 w 2865918"/>
              <a:gd name="connsiteY106" fmla="*/ 45565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0117 w 2865918"/>
              <a:gd name="connsiteY10" fmla="*/ 506457 h 2355494"/>
              <a:gd name="connsiteX11" fmla="*/ 1308367 w 2865918"/>
              <a:gd name="connsiteY11" fmla="*/ 500107 h 2355494"/>
              <a:gd name="connsiteX12" fmla="*/ 1359167 w 2865918"/>
              <a:gd name="connsiteY12" fmla="*/ 817607 h 2355494"/>
              <a:gd name="connsiteX13" fmla="*/ 1429017 w 2865918"/>
              <a:gd name="connsiteY13" fmla="*/ 1020807 h 2355494"/>
              <a:gd name="connsiteX14" fmla="*/ 1689367 w 2865918"/>
              <a:gd name="connsiteY14" fmla="*/ 868407 h 2355494"/>
              <a:gd name="connsiteX15" fmla="*/ 1689367 w 2865918"/>
              <a:gd name="connsiteY15" fmla="*/ 487407 h 2355494"/>
              <a:gd name="connsiteX16" fmla="*/ 1740167 w 2865918"/>
              <a:gd name="connsiteY16" fmla="*/ 277857 h 2355494"/>
              <a:gd name="connsiteX17" fmla="*/ 1822717 w 2865918"/>
              <a:gd name="connsiteY17" fmla="*/ 119107 h 2355494"/>
              <a:gd name="connsiteX18" fmla="*/ 1733817 w 2865918"/>
              <a:gd name="connsiteY18" fmla="*/ 379457 h 2355494"/>
              <a:gd name="connsiteX19" fmla="*/ 1835417 w 2865918"/>
              <a:gd name="connsiteY19" fmla="*/ 373107 h 2355494"/>
              <a:gd name="connsiteX20" fmla="*/ 1917967 w 2865918"/>
              <a:gd name="connsiteY20" fmla="*/ 188957 h 2355494"/>
              <a:gd name="connsiteX21" fmla="*/ 1867167 w 2865918"/>
              <a:gd name="connsiteY21" fmla="*/ 417557 h 2355494"/>
              <a:gd name="connsiteX22" fmla="*/ 1721117 w 2865918"/>
              <a:gd name="connsiteY22" fmla="*/ 455657 h 2355494"/>
              <a:gd name="connsiteX23" fmla="*/ 1733817 w 2865918"/>
              <a:gd name="connsiteY23" fmla="*/ 646157 h 2355494"/>
              <a:gd name="connsiteX24" fmla="*/ 1937017 w 2865918"/>
              <a:gd name="connsiteY24" fmla="*/ 544557 h 2355494"/>
              <a:gd name="connsiteX25" fmla="*/ 1968767 w 2865918"/>
              <a:gd name="connsiteY25" fmla="*/ 119107 h 2355494"/>
              <a:gd name="connsiteX26" fmla="*/ 1981467 w 2865918"/>
              <a:gd name="connsiteY26" fmla="*/ 11157 h 2355494"/>
              <a:gd name="connsiteX27" fmla="*/ 1994167 w 2865918"/>
              <a:gd name="connsiteY27" fmla="*/ 335007 h 2355494"/>
              <a:gd name="connsiteX28" fmla="*/ 1968767 w 2865918"/>
              <a:gd name="connsiteY28" fmla="*/ 589007 h 2355494"/>
              <a:gd name="connsiteX29" fmla="*/ 1860817 w 2865918"/>
              <a:gd name="connsiteY29" fmla="*/ 665207 h 2355494"/>
              <a:gd name="connsiteX30" fmla="*/ 2057667 w 2865918"/>
              <a:gd name="connsiteY30" fmla="*/ 696957 h 2355494"/>
              <a:gd name="connsiteX31" fmla="*/ 2229117 w 2865918"/>
              <a:gd name="connsiteY31" fmla="*/ 652507 h 2355494"/>
              <a:gd name="connsiteX32" fmla="*/ 2089417 w 2865918"/>
              <a:gd name="connsiteY32" fmla="*/ 735057 h 2355494"/>
              <a:gd name="connsiteX33" fmla="*/ 1879867 w 2865918"/>
              <a:gd name="connsiteY33" fmla="*/ 722357 h 2355494"/>
              <a:gd name="connsiteX34" fmla="*/ 1784617 w 2865918"/>
              <a:gd name="connsiteY34" fmla="*/ 703307 h 2355494"/>
              <a:gd name="connsiteX35" fmla="*/ 1733817 w 2865918"/>
              <a:gd name="connsiteY35" fmla="*/ 868407 h 2355494"/>
              <a:gd name="connsiteX36" fmla="*/ 1575067 w 2865918"/>
              <a:gd name="connsiteY36" fmla="*/ 1052557 h 2355494"/>
              <a:gd name="connsiteX37" fmla="*/ 1536967 w 2865918"/>
              <a:gd name="connsiteY37" fmla="*/ 1306557 h 2355494"/>
              <a:gd name="connsiteX38" fmla="*/ 1829067 w 2865918"/>
              <a:gd name="connsiteY38" fmla="*/ 1351007 h 2355494"/>
              <a:gd name="connsiteX39" fmla="*/ 2140217 w 2865918"/>
              <a:gd name="connsiteY39" fmla="*/ 1071607 h 2355494"/>
              <a:gd name="connsiteX40" fmla="*/ 2102117 w 2865918"/>
              <a:gd name="connsiteY40" fmla="*/ 925557 h 2355494"/>
              <a:gd name="connsiteX41" fmla="*/ 2171967 w 2865918"/>
              <a:gd name="connsiteY41" fmla="*/ 792207 h 2355494"/>
              <a:gd name="connsiteX42" fmla="*/ 2140217 w 2865918"/>
              <a:gd name="connsiteY42" fmla="*/ 995407 h 2355494"/>
              <a:gd name="connsiteX43" fmla="*/ 2165617 w 2865918"/>
              <a:gd name="connsiteY43" fmla="*/ 1097007 h 2355494"/>
              <a:gd name="connsiteX44" fmla="*/ 1962417 w 2865918"/>
              <a:gd name="connsiteY44" fmla="*/ 1300207 h 2355494"/>
              <a:gd name="connsiteX45" fmla="*/ 2292617 w 2865918"/>
              <a:gd name="connsiteY45" fmla="*/ 1185907 h 2355494"/>
              <a:gd name="connsiteX46" fmla="*/ 2324367 w 2865918"/>
              <a:gd name="connsiteY46" fmla="*/ 735057 h 2355494"/>
              <a:gd name="connsiteX47" fmla="*/ 2362467 w 2865918"/>
              <a:gd name="connsiteY47" fmla="*/ 1001757 h 2355494"/>
              <a:gd name="connsiteX48" fmla="*/ 2349767 w 2865918"/>
              <a:gd name="connsiteY48" fmla="*/ 1185907 h 2355494"/>
              <a:gd name="connsiteX49" fmla="*/ 2540267 w 2865918"/>
              <a:gd name="connsiteY49" fmla="*/ 627107 h 2355494"/>
              <a:gd name="connsiteX50" fmla="*/ 2864117 w 2865918"/>
              <a:gd name="connsiteY50" fmla="*/ 411207 h 2355494"/>
              <a:gd name="connsiteX51" fmla="*/ 2667267 w 2865918"/>
              <a:gd name="connsiteY51" fmla="*/ 550907 h 2355494"/>
              <a:gd name="connsiteX52" fmla="*/ 2584717 w 2865918"/>
              <a:gd name="connsiteY52" fmla="*/ 633457 h 2355494"/>
              <a:gd name="connsiteX53" fmla="*/ 2533917 w 2865918"/>
              <a:gd name="connsiteY53" fmla="*/ 741407 h 2355494"/>
              <a:gd name="connsiteX54" fmla="*/ 2476767 w 2865918"/>
              <a:gd name="connsiteY54" fmla="*/ 919207 h 2355494"/>
              <a:gd name="connsiteX55" fmla="*/ 2673617 w 2865918"/>
              <a:gd name="connsiteY55" fmla="*/ 766807 h 2355494"/>
              <a:gd name="connsiteX56" fmla="*/ 2711717 w 2865918"/>
              <a:gd name="connsiteY56" fmla="*/ 639807 h 2355494"/>
              <a:gd name="connsiteX57" fmla="*/ 2718067 w 2865918"/>
              <a:gd name="connsiteY57" fmla="*/ 804907 h 2355494"/>
              <a:gd name="connsiteX58" fmla="*/ 2533917 w 2865918"/>
              <a:gd name="connsiteY58" fmla="*/ 950957 h 2355494"/>
              <a:gd name="connsiteX59" fmla="*/ 2438667 w 2865918"/>
              <a:gd name="connsiteY59" fmla="*/ 1109707 h 2355494"/>
              <a:gd name="connsiteX60" fmla="*/ 2381517 w 2865918"/>
              <a:gd name="connsiteY60" fmla="*/ 1274807 h 2355494"/>
              <a:gd name="connsiteX61" fmla="*/ 1994167 w 2865918"/>
              <a:gd name="connsiteY61" fmla="*/ 1401807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365517 w 2865918"/>
              <a:gd name="connsiteY67" fmla="*/ 1865357 h 2355494"/>
              <a:gd name="connsiteX68" fmla="*/ 1225817 w 2865918"/>
              <a:gd name="connsiteY68" fmla="*/ 1687557 h 2355494"/>
              <a:gd name="connsiteX69" fmla="*/ 895617 w 2865918"/>
              <a:gd name="connsiteY69" fmla="*/ 173835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57467 w 2865918"/>
              <a:gd name="connsiteY75" fmla="*/ 22273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27317 w 2865918"/>
              <a:gd name="connsiteY82" fmla="*/ 1852657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0117 w 2865918"/>
              <a:gd name="connsiteY10" fmla="*/ 506457 h 2355494"/>
              <a:gd name="connsiteX11" fmla="*/ 1308367 w 2865918"/>
              <a:gd name="connsiteY11" fmla="*/ 500107 h 2355494"/>
              <a:gd name="connsiteX12" fmla="*/ 1359167 w 2865918"/>
              <a:gd name="connsiteY12" fmla="*/ 817607 h 2355494"/>
              <a:gd name="connsiteX13" fmla="*/ 1429017 w 2865918"/>
              <a:gd name="connsiteY13" fmla="*/ 1020807 h 2355494"/>
              <a:gd name="connsiteX14" fmla="*/ 1689367 w 2865918"/>
              <a:gd name="connsiteY14" fmla="*/ 868407 h 2355494"/>
              <a:gd name="connsiteX15" fmla="*/ 1689367 w 2865918"/>
              <a:gd name="connsiteY15" fmla="*/ 487407 h 2355494"/>
              <a:gd name="connsiteX16" fmla="*/ 1740167 w 2865918"/>
              <a:gd name="connsiteY16" fmla="*/ 277857 h 2355494"/>
              <a:gd name="connsiteX17" fmla="*/ 1822717 w 2865918"/>
              <a:gd name="connsiteY17" fmla="*/ 119107 h 2355494"/>
              <a:gd name="connsiteX18" fmla="*/ 1733817 w 2865918"/>
              <a:gd name="connsiteY18" fmla="*/ 379457 h 2355494"/>
              <a:gd name="connsiteX19" fmla="*/ 1835417 w 2865918"/>
              <a:gd name="connsiteY19" fmla="*/ 373107 h 2355494"/>
              <a:gd name="connsiteX20" fmla="*/ 1917967 w 2865918"/>
              <a:gd name="connsiteY20" fmla="*/ 188957 h 2355494"/>
              <a:gd name="connsiteX21" fmla="*/ 1867167 w 2865918"/>
              <a:gd name="connsiteY21" fmla="*/ 417557 h 2355494"/>
              <a:gd name="connsiteX22" fmla="*/ 1721117 w 2865918"/>
              <a:gd name="connsiteY22" fmla="*/ 455657 h 2355494"/>
              <a:gd name="connsiteX23" fmla="*/ 1733817 w 2865918"/>
              <a:gd name="connsiteY23" fmla="*/ 646157 h 2355494"/>
              <a:gd name="connsiteX24" fmla="*/ 1937017 w 2865918"/>
              <a:gd name="connsiteY24" fmla="*/ 544557 h 2355494"/>
              <a:gd name="connsiteX25" fmla="*/ 1968767 w 2865918"/>
              <a:gd name="connsiteY25" fmla="*/ 119107 h 2355494"/>
              <a:gd name="connsiteX26" fmla="*/ 1981467 w 2865918"/>
              <a:gd name="connsiteY26" fmla="*/ 11157 h 2355494"/>
              <a:gd name="connsiteX27" fmla="*/ 1994167 w 2865918"/>
              <a:gd name="connsiteY27" fmla="*/ 335007 h 2355494"/>
              <a:gd name="connsiteX28" fmla="*/ 1968767 w 2865918"/>
              <a:gd name="connsiteY28" fmla="*/ 589007 h 2355494"/>
              <a:gd name="connsiteX29" fmla="*/ 1860817 w 2865918"/>
              <a:gd name="connsiteY29" fmla="*/ 665207 h 2355494"/>
              <a:gd name="connsiteX30" fmla="*/ 2057667 w 2865918"/>
              <a:gd name="connsiteY30" fmla="*/ 696957 h 2355494"/>
              <a:gd name="connsiteX31" fmla="*/ 2229117 w 2865918"/>
              <a:gd name="connsiteY31" fmla="*/ 652507 h 2355494"/>
              <a:gd name="connsiteX32" fmla="*/ 2089417 w 2865918"/>
              <a:gd name="connsiteY32" fmla="*/ 735057 h 2355494"/>
              <a:gd name="connsiteX33" fmla="*/ 1879867 w 2865918"/>
              <a:gd name="connsiteY33" fmla="*/ 722357 h 2355494"/>
              <a:gd name="connsiteX34" fmla="*/ 1784617 w 2865918"/>
              <a:gd name="connsiteY34" fmla="*/ 703307 h 2355494"/>
              <a:gd name="connsiteX35" fmla="*/ 1733817 w 2865918"/>
              <a:gd name="connsiteY35" fmla="*/ 868407 h 2355494"/>
              <a:gd name="connsiteX36" fmla="*/ 1575067 w 2865918"/>
              <a:gd name="connsiteY36" fmla="*/ 1052557 h 2355494"/>
              <a:gd name="connsiteX37" fmla="*/ 1536967 w 2865918"/>
              <a:gd name="connsiteY37" fmla="*/ 1306557 h 2355494"/>
              <a:gd name="connsiteX38" fmla="*/ 1829067 w 2865918"/>
              <a:gd name="connsiteY38" fmla="*/ 1351007 h 2355494"/>
              <a:gd name="connsiteX39" fmla="*/ 2140217 w 2865918"/>
              <a:gd name="connsiteY39" fmla="*/ 1071607 h 2355494"/>
              <a:gd name="connsiteX40" fmla="*/ 2102117 w 2865918"/>
              <a:gd name="connsiteY40" fmla="*/ 925557 h 2355494"/>
              <a:gd name="connsiteX41" fmla="*/ 2171967 w 2865918"/>
              <a:gd name="connsiteY41" fmla="*/ 792207 h 2355494"/>
              <a:gd name="connsiteX42" fmla="*/ 2140217 w 2865918"/>
              <a:gd name="connsiteY42" fmla="*/ 995407 h 2355494"/>
              <a:gd name="connsiteX43" fmla="*/ 2165617 w 2865918"/>
              <a:gd name="connsiteY43" fmla="*/ 1097007 h 2355494"/>
              <a:gd name="connsiteX44" fmla="*/ 1962417 w 2865918"/>
              <a:gd name="connsiteY44" fmla="*/ 1300207 h 2355494"/>
              <a:gd name="connsiteX45" fmla="*/ 2292617 w 2865918"/>
              <a:gd name="connsiteY45" fmla="*/ 1185907 h 2355494"/>
              <a:gd name="connsiteX46" fmla="*/ 2324367 w 2865918"/>
              <a:gd name="connsiteY46" fmla="*/ 735057 h 2355494"/>
              <a:gd name="connsiteX47" fmla="*/ 2362467 w 2865918"/>
              <a:gd name="connsiteY47" fmla="*/ 1001757 h 2355494"/>
              <a:gd name="connsiteX48" fmla="*/ 2349767 w 2865918"/>
              <a:gd name="connsiteY48" fmla="*/ 1185907 h 2355494"/>
              <a:gd name="connsiteX49" fmla="*/ 2540267 w 2865918"/>
              <a:gd name="connsiteY49" fmla="*/ 627107 h 2355494"/>
              <a:gd name="connsiteX50" fmla="*/ 2864117 w 2865918"/>
              <a:gd name="connsiteY50" fmla="*/ 411207 h 2355494"/>
              <a:gd name="connsiteX51" fmla="*/ 2667267 w 2865918"/>
              <a:gd name="connsiteY51" fmla="*/ 550907 h 2355494"/>
              <a:gd name="connsiteX52" fmla="*/ 2584717 w 2865918"/>
              <a:gd name="connsiteY52" fmla="*/ 633457 h 2355494"/>
              <a:gd name="connsiteX53" fmla="*/ 2533917 w 2865918"/>
              <a:gd name="connsiteY53" fmla="*/ 741407 h 2355494"/>
              <a:gd name="connsiteX54" fmla="*/ 2476767 w 2865918"/>
              <a:gd name="connsiteY54" fmla="*/ 919207 h 2355494"/>
              <a:gd name="connsiteX55" fmla="*/ 2673617 w 2865918"/>
              <a:gd name="connsiteY55" fmla="*/ 766807 h 2355494"/>
              <a:gd name="connsiteX56" fmla="*/ 2711717 w 2865918"/>
              <a:gd name="connsiteY56" fmla="*/ 639807 h 2355494"/>
              <a:gd name="connsiteX57" fmla="*/ 2718067 w 2865918"/>
              <a:gd name="connsiteY57" fmla="*/ 804907 h 2355494"/>
              <a:gd name="connsiteX58" fmla="*/ 2533917 w 2865918"/>
              <a:gd name="connsiteY58" fmla="*/ 950957 h 2355494"/>
              <a:gd name="connsiteX59" fmla="*/ 2438667 w 2865918"/>
              <a:gd name="connsiteY59" fmla="*/ 1109707 h 2355494"/>
              <a:gd name="connsiteX60" fmla="*/ 2381517 w 2865918"/>
              <a:gd name="connsiteY60" fmla="*/ 1274807 h 2355494"/>
              <a:gd name="connsiteX61" fmla="*/ 1994167 w 2865918"/>
              <a:gd name="connsiteY61" fmla="*/ 1401807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365517 w 2865918"/>
              <a:gd name="connsiteY67" fmla="*/ 1865357 h 2355494"/>
              <a:gd name="connsiteX68" fmla="*/ 1225817 w 2865918"/>
              <a:gd name="connsiteY68" fmla="*/ 1687557 h 2355494"/>
              <a:gd name="connsiteX69" fmla="*/ 895617 w 2865918"/>
              <a:gd name="connsiteY69" fmla="*/ 173835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57467 w 2865918"/>
              <a:gd name="connsiteY75" fmla="*/ 22273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27317 w 2865918"/>
              <a:gd name="connsiteY82" fmla="*/ 1852657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963445 w 2865918"/>
              <a:gd name="connsiteY106" fmla="*/ 443249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0117 w 2865918"/>
              <a:gd name="connsiteY10" fmla="*/ 506457 h 2355494"/>
              <a:gd name="connsiteX11" fmla="*/ 1308367 w 2865918"/>
              <a:gd name="connsiteY11" fmla="*/ 500107 h 2355494"/>
              <a:gd name="connsiteX12" fmla="*/ 1359167 w 2865918"/>
              <a:gd name="connsiteY12" fmla="*/ 817607 h 2355494"/>
              <a:gd name="connsiteX13" fmla="*/ 1429017 w 2865918"/>
              <a:gd name="connsiteY13" fmla="*/ 1020807 h 2355494"/>
              <a:gd name="connsiteX14" fmla="*/ 1689367 w 2865918"/>
              <a:gd name="connsiteY14" fmla="*/ 868407 h 2355494"/>
              <a:gd name="connsiteX15" fmla="*/ 1689367 w 2865918"/>
              <a:gd name="connsiteY15" fmla="*/ 487407 h 2355494"/>
              <a:gd name="connsiteX16" fmla="*/ 1740167 w 2865918"/>
              <a:gd name="connsiteY16" fmla="*/ 277857 h 2355494"/>
              <a:gd name="connsiteX17" fmla="*/ 1822717 w 2865918"/>
              <a:gd name="connsiteY17" fmla="*/ 119107 h 2355494"/>
              <a:gd name="connsiteX18" fmla="*/ 1733817 w 2865918"/>
              <a:gd name="connsiteY18" fmla="*/ 379457 h 2355494"/>
              <a:gd name="connsiteX19" fmla="*/ 1835417 w 2865918"/>
              <a:gd name="connsiteY19" fmla="*/ 373107 h 2355494"/>
              <a:gd name="connsiteX20" fmla="*/ 1917967 w 2865918"/>
              <a:gd name="connsiteY20" fmla="*/ 188957 h 2355494"/>
              <a:gd name="connsiteX21" fmla="*/ 1867167 w 2865918"/>
              <a:gd name="connsiteY21" fmla="*/ 417557 h 2355494"/>
              <a:gd name="connsiteX22" fmla="*/ 1721117 w 2865918"/>
              <a:gd name="connsiteY22" fmla="*/ 455657 h 2355494"/>
              <a:gd name="connsiteX23" fmla="*/ 1733817 w 2865918"/>
              <a:gd name="connsiteY23" fmla="*/ 646157 h 2355494"/>
              <a:gd name="connsiteX24" fmla="*/ 1937017 w 2865918"/>
              <a:gd name="connsiteY24" fmla="*/ 544557 h 2355494"/>
              <a:gd name="connsiteX25" fmla="*/ 1968767 w 2865918"/>
              <a:gd name="connsiteY25" fmla="*/ 119107 h 2355494"/>
              <a:gd name="connsiteX26" fmla="*/ 1981467 w 2865918"/>
              <a:gd name="connsiteY26" fmla="*/ 11157 h 2355494"/>
              <a:gd name="connsiteX27" fmla="*/ 1994167 w 2865918"/>
              <a:gd name="connsiteY27" fmla="*/ 335007 h 2355494"/>
              <a:gd name="connsiteX28" fmla="*/ 1968767 w 2865918"/>
              <a:gd name="connsiteY28" fmla="*/ 589007 h 2355494"/>
              <a:gd name="connsiteX29" fmla="*/ 1860817 w 2865918"/>
              <a:gd name="connsiteY29" fmla="*/ 665207 h 2355494"/>
              <a:gd name="connsiteX30" fmla="*/ 2057667 w 2865918"/>
              <a:gd name="connsiteY30" fmla="*/ 696957 h 2355494"/>
              <a:gd name="connsiteX31" fmla="*/ 2229117 w 2865918"/>
              <a:gd name="connsiteY31" fmla="*/ 652507 h 2355494"/>
              <a:gd name="connsiteX32" fmla="*/ 2089417 w 2865918"/>
              <a:gd name="connsiteY32" fmla="*/ 735057 h 2355494"/>
              <a:gd name="connsiteX33" fmla="*/ 1879867 w 2865918"/>
              <a:gd name="connsiteY33" fmla="*/ 722357 h 2355494"/>
              <a:gd name="connsiteX34" fmla="*/ 1784617 w 2865918"/>
              <a:gd name="connsiteY34" fmla="*/ 703307 h 2355494"/>
              <a:gd name="connsiteX35" fmla="*/ 1733817 w 2865918"/>
              <a:gd name="connsiteY35" fmla="*/ 868407 h 2355494"/>
              <a:gd name="connsiteX36" fmla="*/ 1575067 w 2865918"/>
              <a:gd name="connsiteY36" fmla="*/ 1052557 h 2355494"/>
              <a:gd name="connsiteX37" fmla="*/ 1536967 w 2865918"/>
              <a:gd name="connsiteY37" fmla="*/ 1306557 h 2355494"/>
              <a:gd name="connsiteX38" fmla="*/ 1829067 w 2865918"/>
              <a:gd name="connsiteY38" fmla="*/ 1351007 h 2355494"/>
              <a:gd name="connsiteX39" fmla="*/ 2140217 w 2865918"/>
              <a:gd name="connsiteY39" fmla="*/ 1071607 h 2355494"/>
              <a:gd name="connsiteX40" fmla="*/ 2102117 w 2865918"/>
              <a:gd name="connsiteY40" fmla="*/ 925557 h 2355494"/>
              <a:gd name="connsiteX41" fmla="*/ 2171967 w 2865918"/>
              <a:gd name="connsiteY41" fmla="*/ 792207 h 2355494"/>
              <a:gd name="connsiteX42" fmla="*/ 2140217 w 2865918"/>
              <a:gd name="connsiteY42" fmla="*/ 995407 h 2355494"/>
              <a:gd name="connsiteX43" fmla="*/ 2165617 w 2865918"/>
              <a:gd name="connsiteY43" fmla="*/ 1097007 h 2355494"/>
              <a:gd name="connsiteX44" fmla="*/ 1962417 w 2865918"/>
              <a:gd name="connsiteY44" fmla="*/ 1300207 h 2355494"/>
              <a:gd name="connsiteX45" fmla="*/ 2292617 w 2865918"/>
              <a:gd name="connsiteY45" fmla="*/ 1185907 h 2355494"/>
              <a:gd name="connsiteX46" fmla="*/ 2324367 w 2865918"/>
              <a:gd name="connsiteY46" fmla="*/ 735057 h 2355494"/>
              <a:gd name="connsiteX47" fmla="*/ 2362467 w 2865918"/>
              <a:gd name="connsiteY47" fmla="*/ 1001757 h 2355494"/>
              <a:gd name="connsiteX48" fmla="*/ 2349767 w 2865918"/>
              <a:gd name="connsiteY48" fmla="*/ 1185907 h 2355494"/>
              <a:gd name="connsiteX49" fmla="*/ 2540267 w 2865918"/>
              <a:gd name="connsiteY49" fmla="*/ 627107 h 2355494"/>
              <a:gd name="connsiteX50" fmla="*/ 2864117 w 2865918"/>
              <a:gd name="connsiteY50" fmla="*/ 411207 h 2355494"/>
              <a:gd name="connsiteX51" fmla="*/ 2667267 w 2865918"/>
              <a:gd name="connsiteY51" fmla="*/ 550907 h 2355494"/>
              <a:gd name="connsiteX52" fmla="*/ 2584717 w 2865918"/>
              <a:gd name="connsiteY52" fmla="*/ 633457 h 2355494"/>
              <a:gd name="connsiteX53" fmla="*/ 2533917 w 2865918"/>
              <a:gd name="connsiteY53" fmla="*/ 741407 h 2355494"/>
              <a:gd name="connsiteX54" fmla="*/ 2476767 w 2865918"/>
              <a:gd name="connsiteY54" fmla="*/ 919207 h 2355494"/>
              <a:gd name="connsiteX55" fmla="*/ 2673617 w 2865918"/>
              <a:gd name="connsiteY55" fmla="*/ 766807 h 2355494"/>
              <a:gd name="connsiteX56" fmla="*/ 2711717 w 2865918"/>
              <a:gd name="connsiteY56" fmla="*/ 639807 h 2355494"/>
              <a:gd name="connsiteX57" fmla="*/ 2718067 w 2865918"/>
              <a:gd name="connsiteY57" fmla="*/ 804907 h 2355494"/>
              <a:gd name="connsiteX58" fmla="*/ 2533917 w 2865918"/>
              <a:gd name="connsiteY58" fmla="*/ 950957 h 2355494"/>
              <a:gd name="connsiteX59" fmla="*/ 2438667 w 2865918"/>
              <a:gd name="connsiteY59" fmla="*/ 1109707 h 2355494"/>
              <a:gd name="connsiteX60" fmla="*/ 2381517 w 2865918"/>
              <a:gd name="connsiteY60" fmla="*/ 1274807 h 2355494"/>
              <a:gd name="connsiteX61" fmla="*/ 1994167 w 2865918"/>
              <a:gd name="connsiteY61" fmla="*/ 1401807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365517 w 2865918"/>
              <a:gd name="connsiteY67" fmla="*/ 1865357 h 2355494"/>
              <a:gd name="connsiteX68" fmla="*/ 1225817 w 2865918"/>
              <a:gd name="connsiteY68" fmla="*/ 1687557 h 2355494"/>
              <a:gd name="connsiteX69" fmla="*/ 895617 w 2865918"/>
              <a:gd name="connsiteY69" fmla="*/ 173835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57467 w 2865918"/>
              <a:gd name="connsiteY75" fmla="*/ 22273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27317 w 2865918"/>
              <a:gd name="connsiteY82" fmla="*/ 1852657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30592 w 2865918"/>
              <a:gd name="connsiteY10" fmla="*/ 485025 h 2355494"/>
              <a:gd name="connsiteX11" fmla="*/ 1308367 w 2865918"/>
              <a:gd name="connsiteY11" fmla="*/ 500107 h 2355494"/>
              <a:gd name="connsiteX12" fmla="*/ 1359167 w 2865918"/>
              <a:gd name="connsiteY12" fmla="*/ 817607 h 2355494"/>
              <a:gd name="connsiteX13" fmla="*/ 1429017 w 2865918"/>
              <a:gd name="connsiteY13" fmla="*/ 1020807 h 2355494"/>
              <a:gd name="connsiteX14" fmla="*/ 1689367 w 2865918"/>
              <a:gd name="connsiteY14" fmla="*/ 868407 h 2355494"/>
              <a:gd name="connsiteX15" fmla="*/ 1689367 w 2865918"/>
              <a:gd name="connsiteY15" fmla="*/ 487407 h 2355494"/>
              <a:gd name="connsiteX16" fmla="*/ 1740167 w 2865918"/>
              <a:gd name="connsiteY16" fmla="*/ 277857 h 2355494"/>
              <a:gd name="connsiteX17" fmla="*/ 1822717 w 2865918"/>
              <a:gd name="connsiteY17" fmla="*/ 119107 h 2355494"/>
              <a:gd name="connsiteX18" fmla="*/ 1733817 w 2865918"/>
              <a:gd name="connsiteY18" fmla="*/ 379457 h 2355494"/>
              <a:gd name="connsiteX19" fmla="*/ 1835417 w 2865918"/>
              <a:gd name="connsiteY19" fmla="*/ 373107 h 2355494"/>
              <a:gd name="connsiteX20" fmla="*/ 1917967 w 2865918"/>
              <a:gd name="connsiteY20" fmla="*/ 188957 h 2355494"/>
              <a:gd name="connsiteX21" fmla="*/ 1867167 w 2865918"/>
              <a:gd name="connsiteY21" fmla="*/ 417557 h 2355494"/>
              <a:gd name="connsiteX22" fmla="*/ 1721117 w 2865918"/>
              <a:gd name="connsiteY22" fmla="*/ 455657 h 2355494"/>
              <a:gd name="connsiteX23" fmla="*/ 1733817 w 2865918"/>
              <a:gd name="connsiteY23" fmla="*/ 646157 h 2355494"/>
              <a:gd name="connsiteX24" fmla="*/ 1937017 w 2865918"/>
              <a:gd name="connsiteY24" fmla="*/ 544557 h 2355494"/>
              <a:gd name="connsiteX25" fmla="*/ 1968767 w 2865918"/>
              <a:gd name="connsiteY25" fmla="*/ 119107 h 2355494"/>
              <a:gd name="connsiteX26" fmla="*/ 1981467 w 2865918"/>
              <a:gd name="connsiteY26" fmla="*/ 11157 h 2355494"/>
              <a:gd name="connsiteX27" fmla="*/ 1994167 w 2865918"/>
              <a:gd name="connsiteY27" fmla="*/ 335007 h 2355494"/>
              <a:gd name="connsiteX28" fmla="*/ 1968767 w 2865918"/>
              <a:gd name="connsiteY28" fmla="*/ 589007 h 2355494"/>
              <a:gd name="connsiteX29" fmla="*/ 1860817 w 2865918"/>
              <a:gd name="connsiteY29" fmla="*/ 665207 h 2355494"/>
              <a:gd name="connsiteX30" fmla="*/ 2057667 w 2865918"/>
              <a:gd name="connsiteY30" fmla="*/ 696957 h 2355494"/>
              <a:gd name="connsiteX31" fmla="*/ 2229117 w 2865918"/>
              <a:gd name="connsiteY31" fmla="*/ 652507 h 2355494"/>
              <a:gd name="connsiteX32" fmla="*/ 2089417 w 2865918"/>
              <a:gd name="connsiteY32" fmla="*/ 735057 h 2355494"/>
              <a:gd name="connsiteX33" fmla="*/ 1879867 w 2865918"/>
              <a:gd name="connsiteY33" fmla="*/ 722357 h 2355494"/>
              <a:gd name="connsiteX34" fmla="*/ 1784617 w 2865918"/>
              <a:gd name="connsiteY34" fmla="*/ 703307 h 2355494"/>
              <a:gd name="connsiteX35" fmla="*/ 1733817 w 2865918"/>
              <a:gd name="connsiteY35" fmla="*/ 868407 h 2355494"/>
              <a:gd name="connsiteX36" fmla="*/ 1575067 w 2865918"/>
              <a:gd name="connsiteY36" fmla="*/ 1052557 h 2355494"/>
              <a:gd name="connsiteX37" fmla="*/ 1536967 w 2865918"/>
              <a:gd name="connsiteY37" fmla="*/ 1306557 h 2355494"/>
              <a:gd name="connsiteX38" fmla="*/ 1829067 w 2865918"/>
              <a:gd name="connsiteY38" fmla="*/ 1351007 h 2355494"/>
              <a:gd name="connsiteX39" fmla="*/ 2140217 w 2865918"/>
              <a:gd name="connsiteY39" fmla="*/ 1071607 h 2355494"/>
              <a:gd name="connsiteX40" fmla="*/ 2102117 w 2865918"/>
              <a:gd name="connsiteY40" fmla="*/ 925557 h 2355494"/>
              <a:gd name="connsiteX41" fmla="*/ 2171967 w 2865918"/>
              <a:gd name="connsiteY41" fmla="*/ 792207 h 2355494"/>
              <a:gd name="connsiteX42" fmla="*/ 2140217 w 2865918"/>
              <a:gd name="connsiteY42" fmla="*/ 995407 h 2355494"/>
              <a:gd name="connsiteX43" fmla="*/ 2165617 w 2865918"/>
              <a:gd name="connsiteY43" fmla="*/ 1097007 h 2355494"/>
              <a:gd name="connsiteX44" fmla="*/ 1962417 w 2865918"/>
              <a:gd name="connsiteY44" fmla="*/ 1300207 h 2355494"/>
              <a:gd name="connsiteX45" fmla="*/ 2292617 w 2865918"/>
              <a:gd name="connsiteY45" fmla="*/ 1185907 h 2355494"/>
              <a:gd name="connsiteX46" fmla="*/ 2324367 w 2865918"/>
              <a:gd name="connsiteY46" fmla="*/ 735057 h 2355494"/>
              <a:gd name="connsiteX47" fmla="*/ 2362467 w 2865918"/>
              <a:gd name="connsiteY47" fmla="*/ 1001757 h 2355494"/>
              <a:gd name="connsiteX48" fmla="*/ 2349767 w 2865918"/>
              <a:gd name="connsiteY48" fmla="*/ 1185907 h 2355494"/>
              <a:gd name="connsiteX49" fmla="*/ 2540267 w 2865918"/>
              <a:gd name="connsiteY49" fmla="*/ 627107 h 2355494"/>
              <a:gd name="connsiteX50" fmla="*/ 2864117 w 2865918"/>
              <a:gd name="connsiteY50" fmla="*/ 411207 h 2355494"/>
              <a:gd name="connsiteX51" fmla="*/ 2667267 w 2865918"/>
              <a:gd name="connsiteY51" fmla="*/ 550907 h 2355494"/>
              <a:gd name="connsiteX52" fmla="*/ 2584717 w 2865918"/>
              <a:gd name="connsiteY52" fmla="*/ 633457 h 2355494"/>
              <a:gd name="connsiteX53" fmla="*/ 2533917 w 2865918"/>
              <a:gd name="connsiteY53" fmla="*/ 741407 h 2355494"/>
              <a:gd name="connsiteX54" fmla="*/ 2476767 w 2865918"/>
              <a:gd name="connsiteY54" fmla="*/ 919207 h 2355494"/>
              <a:gd name="connsiteX55" fmla="*/ 2673617 w 2865918"/>
              <a:gd name="connsiteY55" fmla="*/ 766807 h 2355494"/>
              <a:gd name="connsiteX56" fmla="*/ 2711717 w 2865918"/>
              <a:gd name="connsiteY56" fmla="*/ 639807 h 2355494"/>
              <a:gd name="connsiteX57" fmla="*/ 2718067 w 2865918"/>
              <a:gd name="connsiteY57" fmla="*/ 804907 h 2355494"/>
              <a:gd name="connsiteX58" fmla="*/ 2533917 w 2865918"/>
              <a:gd name="connsiteY58" fmla="*/ 950957 h 2355494"/>
              <a:gd name="connsiteX59" fmla="*/ 2438667 w 2865918"/>
              <a:gd name="connsiteY59" fmla="*/ 1109707 h 2355494"/>
              <a:gd name="connsiteX60" fmla="*/ 2381517 w 2865918"/>
              <a:gd name="connsiteY60" fmla="*/ 1274807 h 2355494"/>
              <a:gd name="connsiteX61" fmla="*/ 1994167 w 2865918"/>
              <a:gd name="connsiteY61" fmla="*/ 1401807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365517 w 2865918"/>
              <a:gd name="connsiteY67" fmla="*/ 1865357 h 2355494"/>
              <a:gd name="connsiteX68" fmla="*/ 1225817 w 2865918"/>
              <a:gd name="connsiteY68" fmla="*/ 1687557 h 2355494"/>
              <a:gd name="connsiteX69" fmla="*/ 895617 w 2865918"/>
              <a:gd name="connsiteY69" fmla="*/ 173835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57467 w 2865918"/>
              <a:gd name="connsiteY75" fmla="*/ 22273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27317 w 2865918"/>
              <a:gd name="connsiteY82" fmla="*/ 1852657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08367 w 2865918"/>
              <a:gd name="connsiteY10" fmla="*/ 500107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67167 w 2865918"/>
              <a:gd name="connsiteY20" fmla="*/ 417557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81517 w 2865918"/>
              <a:gd name="connsiteY59" fmla="*/ 127480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65517 w 2865918"/>
              <a:gd name="connsiteY66" fmla="*/ 1865357 h 2355494"/>
              <a:gd name="connsiteX67" fmla="*/ 1225817 w 2865918"/>
              <a:gd name="connsiteY67" fmla="*/ 1687557 h 2355494"/>
              <a:gd name="connsiteX68" fmla="*/ 895617 w 2865918"/>
              <a:gd name="connsiteY68" fmla="*/ 173835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57467 w 2865918"/>
              <a:gd name="connsiteY74" fmla="*/ 22273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27317 w 2865918"/>
              <a:gd name="connsiteY81" fmla="*/ 1852657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2265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67167 w 2865918"/>
              <a:gd name="connsiteY20" fmla="*/ 417557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81517 w 2865918"/>
              <a:gd name="connsiteY59" fmla="*/ 127480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65517 w 2865918"/>
              <a:gd name="connsiteY66" fmla="*/ 1865357 h 2355494"/>
              <a:gd name="connsiteX67" fmla="*/ 1225817 w 2865918"/>
              <a:gd name="connsiteY67" fmla="*/ 1687557 h 2355494"/>
              <a:gd name="connsiteX68" fmla="*/ 895617 w 2865918"/>
              <a:gd name="connsiteY68" fmla="*/ 173835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57467 w 2865918"/>
              <a:gd name="connsiteY74" fmla="*/ 22273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27317 w 2865918"/>
              <a:gd name="connsiteY81" fmla="*/ 1852657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67167 w 2865918"/>
              <a:gd name="connsiteY20" fmla="*/ 417557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81517 w 2865918"/>
              <a:gd name="connsiteY59" fmla="*/ 127480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65517 w 2865918"/>
              <a:gd name="connsiteY66" fmla="*/ 1865357 h 2355494"/>
              <a:gd name="connsiteX67" fmla="*/ 1225817 w 2865918"/>
              <a:gd name="connsiteY67" fmla="*/ 1687557 h 2355494"/>
              <a:gd name="connsiteX68" fmla="*/ 895617 w 2865918"/>
              <a:gd name="connsiteY68" fmla="*/ 173835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57467 w 2865918"/>
              <a:gd name="connsiteY74" fmla="*/ 22273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27317 w 2865918"/>
              <a:gd name="connsiteY81" fmla="*/ 1852657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67167 w 2865918"/>
              <a:gd name="connsiteY20" fmla="*/ 417557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12937 w 2865918"/>
              <a:gd name="connsiteY59" fmla="*/ 125956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65517 w 2865918"/>
              <a:gd name="connsiteY66" fmla="*/ 1865357 h 2355494"/>
              <a:gd name="connsiteX67" fmla="*/ 1225817 w 2865918"/>
              <a:gd name="connsiteY67" fmla="*/ 1687557 h 2355494"/>
              <a:gd name="connsiteX68" fmla="*/ 895617 w 2865918"/>
              <a:gd name="connsiteY68" fmla="*/ 173835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57467 w 2865918"/>
              <a:gd name="connsiteY74" fmla="*/ 22273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27317 w 2865918"/>
              <a:gd name="connsiteY81" fmla="*/ 1852657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74787 w 2865918"/>
              <a:gd name="connsiteY20" fmla="*/ 402317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12937 w 2865918"/>
              <a:gd name="connsiteY59" fmla="*/ 125956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65517 w 2865918"/>
              <a:gd name="connsiteY66" fmla="*/ 1865357 h 2355494"/>
              <a:gd name="connsiteX67" fmla="*/ 1225817 w 2865918"/>
              <a:gd name="connsiteY67" fmla="*/ 1687557 h 2355494"/>
              <a:gd name="connsiteX68" fmla="*/ 895617 w 2865918"/>
              <a:gd name="connsiteY68" fmla="*/ 173835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57467 w 2865918"/>
              <a:gd name="connsiteY74" fmla="*/ 22273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27317 w 2865918"/>
              <a:gd name="connsiteY81" fmla="*/ 1852657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12937 w 2865918"/>
              <a:gd name="connsiteY59" fmla="*/ 125956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65517 w 2865918"/>
              <a:gd name="connsiteY66" fmla="*/ 1865357 h 2355494"/>
              <a:gd name="connsiteX67" fmla="*/ 1225817 w 2865918"/>
              <a:gd name="connsiteY67" fmla="*/ 1687557 h 2355494"/>
              <a:gd name="connsiteX68" fmla="*/ 895617 w 2865918"/>
              <a:gd name="connsiteY68" fmla="*/ 173835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57467 w 2865918"/>
              <a:gd name="connsiteY74" fmla="*/ 22273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27317 w 2865918"/>
              <a:gd name="connsiteY81" fmla="*/ 1852657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12937 w 2865918"/>
              <a:gd name="connsiteY59" fmla="*/ 125956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65517 w 2865918"/>
              <a:gd name="connsiteY66" fmla="*/ 1865357 h 2355494"/>
              <a:gd name="connsiteX67" fmla="*/ 1225817 w 2865918"/>
              <a:gd name="connsiteY67" fmla="*/ 1687557 h 2355494"/>
              <a:gd name="connsiteX68" fmla="*/ 895617 w 2865918"/>
              <a:gd name="connsiteY68" fmla="*/ 173835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89217 w 2865918"/>
              <a:gd name="connsiteY74" fmla="*/ 22400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27317 w 2865918"/>
              <a:gd name="connsiteY81" fmla="*/ 1852657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12937 w 2865918"/>
              <a:gd name="connsiteY59" fmla="*/ 125956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65517 w 2865918"/>
              <a:gd name="connsiteY66" fmla="*/ 1865357 h 2355494"/>
              <a:gd name="connsiteX67" fmla="*/ 1225817 w 2865918"/>
              <a:gd name="connsiteY67" fmla="*/ 1687557 h 2355494"/>
              <a:gd name="connsiteX68" fmla="*/ 895617 w 2865918"/>
              <a:gd name="connsiteY68" fmla="*/ 173835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89217 w 2865918"/>
              <a:gd name="connsiteY74" fmla="*/ 22400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52717 w 2865918"/>
              <a:gd name="connsiteY81" fmla="*/ 1855832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12937 w 2865918"/>
              <a:gd name="connsiteY59" fmla="*/ 125956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65517 w 2865918"/>
              <a:gd name="connsiteY66" fmla="*/ 1865357 h 2355494"/>
              <a:gd name="connsiteX67" fmla="*/ 1225817 w 2865918"/>
              <a:gd name="connsiteY67" fmla="*/ 1687557 h 2355494"/>
              <a:gd name="connsiteX68" fmla="*/ 924192 w 2865918"/>
              <a:gd name="connsiteY68" fmla="*/ 168120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89217 w 2865918"/>
              <a:gd name="connsiteY74" fmla="*/ 22400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52717 w 2865918"/>
              <a:gd name="connsiteY81" fmla="*/ 1855832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12937 w 2865918"/>
              <a:gd name="connsiteY59" fmla="*/ 125956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394092 w 2865918"/>
              <a:gd name="connsiteY66" fmla="*/ 1862182 h 2355494"/>
              <a:gd name="connsiteX67" fmla="*/ 1225817 w 2865918"/>
              <a:gd name="connsiteY67" fmla="*/ 1687557 h 2355494"/>
              <a:gd name="connsiteX68" fmla="*/ 924192 w 2865918"/>
              <a:gd name="connsiteY68" fmla="*/ 168120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89217 w 2865918"/>
              <a:gd name="connsiteY74" fmla="*/ 22400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52717 w 2865918"/>
              <a:gd name="connsiteY81" fmla="*/ 1855832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12937 w 2865918"/>
              <a:gd name="connsiteY59" fmla="*/ 1259567 h 2355494"/>
              <a:gd name="connsiteX60" fmla="*/ 1994167 w 2865918"/>
              <a:gd name="connsiteY60" fmla="*/ 1401807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416317 w 2865918"/>
              <a:gd name="connsiteY66" fmla="*/ 1859007 h 2355494"/>
              <a:gd name="connsiteX67" fmla="*/ 1225817 w 2865918"/>
              <a:gd name="connsiteY67" fmla="*/ 1687557 h 2355494"/>
              <a:gd name="connsiteX68" fmla="*/ 924192 w 2865918"/>
              <a:gd name="connsiteY68" fmla="*/ 168120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89217 w 2865918"/>
              <a:gd name="connsiteY74" fmla="*/ 22400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52717 w 2865918"/>
              <a:gd name="connsiteY81" fmla="*/ 1855832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12937 w 2865918"/>
              <a:gd name="connsiteY59" fmla="*/ 1259567 h 2355494"/>
              <a:gd name="connsiteX60" fmla="*/ 2022742 w 2865918"/>
              <a:gd name="connsiteY60" fmla="*/ 1347832 h 2355494"/>
              <a:gd name="connsiteX61" fmla="*/ 1854467 w 2865918"/>
              <a:gd name="connsiteY61" fmla="*/ 1401807 h 2355494"/>
              <a:gd name="connsiteX62" fmla="*/ 1581417 w 2865918"/>
              <a:gd name="connsiteY62" fmla="*/ 1458957 h 2355494"/>
              <a:gd name="connsiteX63" fmla="*/ 1340117 w 2865918"/>
              <a:gd name="connsiteY63" fmla="*/ 1611357 h 2355494"/>
              <a:gd name="connsiteX64" fmla="*/ 1378217 w 2865918"/>
              <a:gd name="connsiteY64" fmla="*/ 1782807 h 2355494"/>
              <a:gd name="connsiteX65" fmla="*/ 1803667 w 2865918"/>
              <a:gd name="connsiteY65" fmla="*/ 2036807 h 2355494"/>
              <a:gd name="connsiteX66" fmla="*/ 1416317 w 2865918"/>
              <a:gd name="connsiteY66" fmla="*/ 1859007 h 2355494"/>
              <a:gd name="connsiteX67" fmla="*/ 1225817 w 2865918"/>
              <a:gd name="connsiteY67" fmla="*/ 1687557 h 2355494"/>
              <a:gd name="connsiteX68" fmla="*/ 924192 w 2865918"/>
              <a:gd name="connsiteY68" fmla="*/ 1681207 h 2355494"/>
              <a:gd name="connsiteX69" fmla="*/ 705117 w 2865918"/>
              <a:gd name="connsiteY69" fmla="*/ 1973307 h 2355494"/>
              <a:gd name="connsiteX70" fmla="*/ 533667 w 2865918"/>
              <a:gd name="connsiteY70" fmla="*/ 2252707 h 2355494"/>
              <a:gd name="connsiteX71" fmla="*/ 190767 w 2865918"/>
              <a:gd name="connsiteY71" fmla="*/ 2354307 h 2355494"/>
              <a:gd name="connsiteX72" fmla="*/ 267 w 2865918"/>
              <a:gd name="connsiteY72" fmla="*/ 2309857 h 2355494"/>
              <a:gd name="connsiteX73" fmla="*/ 228867 w 2865918"/>
              <a:gd name="connsiteY73" fmla="*/ 2335257 h 2355494"/>
              <a:gd name="connsiteX74" fmla="*/ 489217 w 2865918"/>
              <a:gd name="connsiteY74" fmla="*/ 2240007 h 2355494"/>
              <a:gd name="connsiteX75" fmla="*/ 622567 w 2865918"/>
              <a:gd name="connsiteY75" fmla="*/ 2036807 h 2355494"/>
              <a:gd name="connsiteX76" fmla="*/ 673367 w 2865918"/>
              <a:gd name="connsiteY76" fmla="*/ 1808207 h 2355494"/>
              <a:gd name="connsiteX77" fmla="*/ 273317 w 2865918"/>
              <a:gd name="connsiteY77" fmla="*/ 2125707 h 2355494"/>
              <a:gd name="connsiteX78" fmla="*/ 114567 w 2865918"/>
              <a:gd name="connsiteY78" fmla="*/ 2132057 h 2355494"/>
              <a:gd name="connsiteX79" fmla="*/ 222517 w 2865918"/>
              <a:gd name="connsiteY79" fmla="*/ 2119357 h 2355494"/>
              <a:gd name="connsiteX80" fmla="*/ 393967 w 2865918"/>
              <a:gd name="connsiteY80" fmla="*/ 1998707 h 2355494"/>
              <a:gd name="connsiteX81" fmla="*/ 552717 w 2865918"/>
              <a:gd name="connsiteY81" fmla="*/ 1855832 h 2355494"/>
              <a:gd name="connsiteX82" fmla="*/ 819417 w 2865918"/>
              <a:gd name="connsiteY82" fmla="*/ 1636757 h 2355494"/>
              <a:gd name="connsiteX83" fmla="*/ 901967 w 2865918"/>
              <a:gd name="connsiteY83" fmla="*/ 1306557 h 2355494"/>
              <a:gd name="connsiteX84" fmla="*/ 641617 w 2865918"/>
              <a:gd name="connsiteY84" fmla="*/ 1179557 h 2355494"/>
              <a:gd name="connsiteX85" fmla="*/ 482867 w 2865918"/>
              <a:gd name="connsiteY85" fmla="*/ 1090657 h 2355494"/>
              <a:gd name="connsiteX86" fmla="*/ 717817 w 2865918"/>
              <a:gd name="connsiteY86" fmla="*/ 1173207 h 2355494"/>
              <a:gd name="connsiteX87" fmla="*/ 692417 w 2865918"/>
              <a:gd name="connsiteY87" fmla="*/ 950957 h 2355494"/>
              <a:gd name="connsiteX88" fmla="*/ 584467 w 2865918"/>
              <a:gd name="connsiteY88" fmla="*/ 830307 h 2355494"/>
              <a:gd name="connsiteX89" fmla="*/ 711467 w 2865918"/>
              <a:gd name="connsiteY89" fmla="*/ 931907 h 2355494"/>
              <a:gd name="connsiteX90" fmla="*/ 749567 w 2865918"/>
              <a:gd name="connsiteY90" fmla="*/ 1109707 h 2355494"/>
              <a:gd name="connsiteX91" fmla="*/ 781317 w 2865918"/>
              <a:gd name="connsiteY91" fmla="*/ 1058907 h 2355494"/>
              <a:gd name="connsiteX92" fmla="*/ 800367 w 2865918"/>
              <a:gd name="connsiteY92" fmla="*/ 912857 h 2355494"/>
              <a:gd name="connsiteX93" fmla="*/ 724167 w 2865918"/>
              <a:gd name="connsiteY93" fmla="*/ 722357 h 2355494"/>
              <a:gd name="connsiteX94" fmla="*/ 813067 w 2865918"/>
              <a:gd name="connsiteY94" fmla="*/ 862057 h 2355494"/>
              <a:gd name="connsiteX95" fmla="*/ 806717 w 2865918"/>
              <a:gd name="connsiteY95" fmla="*/ 1033507 h 2355494"/>
              <a:gd name="connsiteX96" fmla="*/ 813067 w 2865918"/>
              <a:gd name="connsiteY96" fmla="*/ 1204957 h 2355494"/>
              <a:gd name="connsiteX97" fmla="*/ 940067 w 2865918"/>
              <a:gd name="connsiteY97" fmla="*/ 1312907 h 2355494"/>
              <a:gd name="connsiteX98" fmla="*/ 1016267 w 2865918"/>
              <a:gd name="connsiteY98" fmla="*/ 1046207 h 2355494"/>
              <a:gd name="connsiteX99" fmla="*/ 1009917 w 2865918"/>
              <a:gd name="connsiteY99" fmla="*/ 1198607 h 2355494"/>
              <a:gd name="connsiteX100" fmla="*/ 1009917 w 2865918"/>
              <a:gd name="connsiteY100" fmla="*/ 1287507 h 2355494"/>
              <a:gd name="connsiteX101" fmla="*/ 1130567 w 2865918"/>
              <a:gd name="connsiteY101" fmla="*/ 1274807 h 2355494"/>
              <a:gd name="connsiteX102" fmla="*/ 1263917 w 2865918"/>
              <a:gd name="connsiteY102" fmla="*/ 1046207 h 2355494"/>
              <a:gd name="connsiteX103" fmla="*/ 1302017 w 2865918"/>
              <a:gd name="connsiteY103" fmla="*/ 665207 h 2355494"/>
              <a:gd name="connsiteX104" fmla="*/ 1263123 w 2865918"/>
              <a:gd name="connsiteY104" fmla="*/ 519157 h 2355494"/>
              <a:gd name="connsiteX105" fmla="*/ 1042026 w 2865918"/>
              <a:gd name="connsiteY105" fmla="*/ 455155 h 2355494"/>
              <a:gd name="connsiteX106" fmla="*/ 909905 w 2865918"/>
              <a:gd name="connsiteY106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85907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48703 w 2865918"/>
              <a:gd name="connsiteY59" fmla="*/ 1233883 h 2355494"/>
              <a:gd name="connsiteX60" fmla="*/ 2312937 w 2865918"/>
              <a:gd name="connsiteY60" fmla="*/ 1259567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6368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48703 w 2865918"/>
              <a:gd name="connsiteY59" fmla="*/ 1233883 h 2355494"/>
              <a:gd name="connsiteX60" fmla="*/ 2312937 w 2865918"/>
              <a:gd name="connsiteY60" fmla="*/ 1259567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533917 w 2865918"/>
              <a:gd name="connsiteY57" fmla="*/ 950957 h 2355494"/>
              <a:gd name="connsiteX58" fmla="*/ 2438667 w 2865918"/>
              <a:gd name="connsiteY58" fmla="*/ 1109707 h 2355494"/>
              <a:gd name="connsiteX59" fmla="*/ 2348703 w 2865918"/>
              <a:gd name="connsiteY59" fmla="*/ 1233883 h 2355494"/>
              <a:gd name="connsiteX60" fmla="*/ 2312937 w 2865918"/>
              <a:gd name="connsiteY60" fmla="*/ 1259567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718067 w 2865918"/>
              <a:gd name="connsiteY56" fmla="*/ 804907 h 2355494"/>
              <a:gd name="connsiteX57" fmla="*/ 2495817 w 2865918"/>
              <a:gd name="connsiteY57" fmla="*/ 944607 h 2355494"/>
              <a:gd name="connsiteX58" fmla="*/ 2438667 w 2865918"/>
              <a:gd name="connsiteY58" fmla="*/ 1109707 h 2355494"/>
              <a:gd name="connsiteX59" fmla="*/ 2348703 w 2865918"/>
              <a:gd name="connsiteY59" fmla="*/ 1233883 h 2355494"/>
              <a:gd name="connsiteX60" fmla="*/ 2312937 w 2865918"/>
              <a:gd name="connsiteY60" fmla="*/ 1259567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38667 w 2865918"/>
              <a:gd name="connsiteY58" fmla="*/ 1109707 h 2355494"/>
              <a:gd name="connsiteX59" fmla="*/ 2348703 w 2865918"/>
              <a:gd name="connsiteY59" fmla="*/ 1233883 h 2355494"/>
              <a:gd name="connsiteX60" fmla="*/ 2312937 w 2865918"/>
              <a:gd name="connsiteY60" fmla="*/ 1259567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48703 w 2865918"/>
              <a:gd name="connsiteY59" fmla="*/ 1233883 h 2355494"/>
              <a:gd name="connsiteX60" fmla="*/ 2312937 w 2865918"/>
              <a:gd name="connsiteY60" fmla="*/ 1259567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20128 w 2865918"/>
              <a:gd name="connsiteY59" fmla="*/ 1214833 h 2355494"/>
              <a:gd name="connsiteX60" fmla="*/ 2312937 w 2865918"/>
              <a:gd name="connsiteY60" fmla="*/ 1259567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20128 w 2865918"/>
              <a:gd name="connsiteY59" fmla="*/ 1214833 h 2355494"/>
              <a:gd name="connsiteX60" fmla="*/ 2284362 w 2865918"/>
              <a:gd name="connsiteY60" fmla="*/ 1250042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021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20128 w 2865918"/>
              <a:gd name="connsiteY59" fmla="*/ 1214833 h 2355494"/>
              <a:gd name="connsiteX60" fmla="*/ 2265312 w 2865918"/>
              <a:gd name="connsiteY60" fmla="*/ 1243692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089417 w 2865918"/>
              <a:gd name="connsiteY39" fmla="*/ 925557 h 2355494"/>
              <a:gd name="connsiteX40" fmla="*/ 2171967 w 2865918"/>
              <a:gd name="connsiteY40" fmla="*/ 792207 h 2355494"/>
              <a:gd name="connsiteX41" fmla="*/ 2140217 w 2865918"/>
              <a:gd name="connsiteY41" fmla="*/ 995407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20128 w 2865918"/>
              <a:gd name="connsiteY59" fmla="*/ 1214833 h 2355494"/>
              <a:gd name="connsiteX60" fmla="*/ 2265312 w 2865918"/>
              <a:gd name="connsiteY60" fmla="*/ 1243692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089417 w 2865918"/>
              <a:gd name="connsiteY39" fmla="*/ 925557 h 2355494"/>
              <a:gd name="connsiteX40" fmla="*/ 2171967 w 2865918"/>
              <a:gd name="connsiteY40" fmla="*/ 792207 h 2355494"/>
              <a:gd name="connsiteX41" fmla="*/ 2191017 w 2865918"/>
              <a:gd name="connsiteY41" fmla="*/ 992232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20128 w 2865918"/>
              <a:gd name="connsiteY59" fmla="*/ 1214833 h 2355494"/>
              <a:gd name="connsiteX60" fmla="*/ 2265312 w 2865918"/>
              <a:gd name="connsiteY60" fmla="*/ 1243692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65617 w 2865918"/>
              <a:gd name="connsiteY39" fmla="*/ 909682 h 2355494"/>
              <a:gd name="connsiteX40" fmla="*/ 2171967 w 2865918"/>
              <a:gd name="connsiteY40" fmla="*/ 792207 h 2355494"/>
              <a:gd name="connsiteX41" fmla="*/ 2191017 w 2865918"/>
              <a:gd name="connsiteY41" fmla="*/ 992232 h 2355494"/>
              <a:gd name="connsiteX42" fmla="*/ 2165617 w 2865918"/>
              <a:gd name="connsiteY42" fmla="*/ 1097007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20128 w 2865918"/>
              <a:gd name="connsiteY59" fmla="*/ 1214833 h 2355494"/>
              <a:gd name="connsiteX60" fmla="*/ 2265312 w 2865918"/>
              <a:gd name="connsiteY60" fmla="*/ 1243692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65617 w 2865918"/>
              <a:gd name="connsiteY39" fmla="*/ 909682 h 2355494"/>
              <a:gd name="connsiteX40" fmla="*/ 2171967 w 2865918"/>
              <a:gd name="connsiteY40" fmla="*/ 792207 h 2355494"/>
              <a:gd name="connsiteX41" fmla="*/ 2191017 w 2865918"/>
              <a:gd name="connsiteY41" fmla="*/ 992232 h 2355494"/>
              <a:gd name="connsiteX42" fmla="*/ 2144185 w 2865918"/>
              <a:gd name="connsiteY42" fmla="*/ 1101769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62467 w 2865918"/>
              <a:gd name="connsiteY46" fmla="*/ 1001757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20128 w 2865918"/>
              <a:gd name="connsiteY59" fmla="*/ 1214833 h 2355494"/>
              <a:gd name="connsiteX60" fmla="*/ 2265312 w 2865918"/>
              <a:gd name="connsiteY60" fmla="*/ 1243692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65617 w 2865918"/>
              <a:gd name="connsiteY39" fmla="*/ 909682 h 2355494"/>
              <a:gd name="connsiteX40" fmla="*/ 2171967 w 2865918"/>
              <a:gd name="connsiteY40" fmla="*/ 792207 h 2355494"/>
              <a:gd name="connsiteX41" fmla="*/ 2191017 w 2865918"/>
              <a:gd name="connsiteY41" fmla="*/ 992232 h 2355494"/>
              <a:gd name="connsiteX42" fmla="*/ 2144185 w 2865918"/>
              <a:gd name="connsiteY42" fmla="*/ 1101769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52942 w 2865918"/>
              <a:gd name="connsiteY46" fmla="*/ 1016044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76767 w 2865918"/>
              <a:gd name="connsiteY53" fmla="*/ 919207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20128 w 2865918"/>
              <a:gd name="connsiteY59" fmla="*/ 1214833 h 2355494"/>
              <a:gd name="connsiteX60" fmla="*/ 2265312 w 2865918"/>
              <a:gd name="connsiteY60" fmla="*/ 1243692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18"/>
              <a:gd name="connsiteY0" fmla="*/ 436607 h 2355494"/>
              <a:gd name="connsiteX1" fmla="*/ 1219467 w 2865918"/>
              <a:gd name="connsiteY1" fmla="*/ 474707 h 2355494"/>
              <a:gd name="connsiteX2" fmla="*/ 1282967 w 2865918"/>
              <a:gd name="connsiteY2" fmla="*/ 487407 h 2355494"/>
              <a:gd name="connsiteX3" fmla="*/ 1308367 w 2865918"/>
              <a:gd name="connsiteY3" fmla="*/ 442957 h 2355494"/>
              <a:gd name="connsiteX4" fmla="*/ 1289317 w 2865918"/>
              <a:gd name="connsiteY4" fmla="*/ 322307 h 2355494"/>
              <a:gd name="connsiteX5" fmla="*/ 1333767 w 2865918"/>
              <a:gd name="connsiteY5" fmla="*/ 208007 h 2355494"/>
              <a:gd name="connsiteX6" fmla="*/ 1308367 w 2865918"/>
              <a:gd name="connsiteY6" fmla="*/ 335007 h 2355494"/>
              <a:gd name="connsiteX7" fmla="*/ 1333767 w 2865918"/>
              <a:gd name="connsiteY7" fmla="*/ 417557 h 2355494"/>
              <a:gd name="connsiteX8" fmla="*/ 1384567 w 2865918"/>
              <a:gd name="connsiteY8" fmla="*/ 296907 h 2355494"/>
              <a:gd name="connsiteX9" fmla="*/ 1340117 w 2865918"/>
              <a:gd name="connsiteY9" fmla="*/ 468357 h 2355494"/>
              <a:gd name="connsiteX10" fmla="*/ 1341704 w 2865918"/>
              <a:gd name="connsiteY10" fmla="*/ 504869 h 2355494"/>
              <a:gd name="connsiteX11" fmla="*/ 1359167 w 2865918"/>
              <a:gd name="connsiteY11" fmla="*/ 817607 h 2355494"/>
              <a:gd name="connsiteX12" fmla="*/ 1429017 w 2865918"/>
              <a:gd name="connsiteY12" fmla="*/ 1020807 h 2355494"/>
              <a:gd name="connsiteX13" fmla="*/ 1689367 w 2865918"/>
              <a:gd name="connsiteY13" fmla="*/ 868407 h 2355494"/>
              <a:gd name="connsiteX14" fmla="*/ 1689367 w 2865918"/>
              <a:gd name="connsiteY14" fmla="*/ 487407 h 2355494"/>
              <a:gd name="connsiteX15" fmla="*/ 1740167 w 2865918"/>
              <a:gd name="connsiteY15" fmla="*/ 277857 h 2355494"/>
              <a:gd name="connsiteX16" fmla="*/ 1822717 w 2865918"/>
              <a:gd name="connsiteY16" fmla="*/ 119107 h 2355494"/>
              <a:gd name="connsiteX17" fmla="*/ 1733817 w 2865918"/>
              <a:gd name="connsiteY17" fmla="*/ 379457 h 2355494"/>
              <a:gd name="connsiteX18" fmla="*/ 1835417 w 2865918"/>
              <a:gd name="connsiteY18" fmla="*/ 373107 h 2355494"/>
              <a:gd name="connsiteX19" fmla="*/ 1917967 w 2865918"/>
              <a:gd name="connsiteY19" fmla="*/ 188957 h 2355494"/>
              <a:gd name="connsiteX20" fmla="*/ 1836687 w 2865918"/>
              <a:gd name="connsiteY20" fmla="*/ 399142 h 2355494"/>
              <a:gd name="connsiteX21" fmla="*/ 1721117 w 2865918"/>
              <a:gd name="connsiteY21" fmla="*/ 455657 h 2355494"/>
              <a:gd name="connsiteX22" fmla="*/ 1733817 w 2865918"/>
              <a:gd name="connsiteY22" fmla="*/ 646157 h 2355494"/>
              <a:gd name="connsiteX23" fmla="*/ 1937017 w 2865918"/>
              <a:gd name="connsiteY23" fmla="*/ 544557 h 2355494"/>
              <a:gd name="connsiteX24" fmla="*/ 1968767 w 2865918"/>
              <a:gd name="connsiteY24" fmla="*/ 119107 h 2355494"/>
              <a:gd name="connsiteX25" fmla="*/ 1981467 w 2865918"/>
              <a:gd name="connsiteY25" fmla="*/ 11157 h 2355494"/>
              <a:gd name="connsiteX26" fmla="*/ 1994167 w 2865918"/>
              <a:gd name="connsiteY26" fmla="*/ 335007 h 2355494"/>
              <a:gd name="connsiteX27" fmla="*/ 1968767 w 2865918"/>
              <a:gd name="connsiteY27" fmla="*/ 589007 h 2355494"/>
              <a:gd name="connsiteX28" fmla="*/ 1860817 w 2865918"/>
              <a:gd name="connsiteY28" fmla="*/ 665207 h 2355494"/>
              <a:gd name="connsiteX29" fmla="*/ 2057667 w 2865918"/>
              <a:gd name="connsiteY29" fmla="*/ 696957 h 2355494"/>
              <a:gd name="connsiteX30" fmla="*/ 2229117 w 2865918"/>
              <a:gd name="connsiteY30" fmla="*/ 652507 h 2355494"/>
              <a:gd name="connsiteX31" fmla="*/ 2089417 w 2865918"/>
              <a:gd name="connsiteY31" fmla="*/ 735057 h 2355494"/>
              <a:gd name="connsiteX32" fmla="*/ 1879867 w 2865918"/>
              <a:gd name="connsiteY32" fmla="*/ 722357 h 2355494"/>
              <a:gd name="connsiteX33" fmla="*/ 1784617 w 2865918"/>
              <a:gd name="connsiteY33" fmla="*/ 703307 h 2355494"/>
              <a:gd name="connsiteX34" fmla="*/ 1733817 w 2865918"/>
              <a:gd name="connsiteY34" fmla="*/ 868407 h 2355494"/>
              <a:gd name="connsiteX35" fmla="*/ 1575067 w 2865918"/>
              <a:gd name="connsiteY35" fmla="*/ 1052557 h 2355494"/>
              <a:gd name="connsiteX36" fmla="*/ 1536967 w 2865918"/>
              <a:gd name="connsiteY36" fmla="*/ 1306557 h 2355494"/>
              <a:gd name="connsiteX37" fmla="*/ 1829067 w 2865918"/>
              <a:gd name="connsiteY37" fmla="*/ 1351007 h 2355494"/>
              <a:gd name="connsiteX38" fmla="*/ 2140217 w 2865918"/>
              <a:gd name="connsiteY38" fmla="*/ 1071607 h 2355494"/>
              <a:gd name="connsiteX39" fmla="*/ 2165617 w 2865918"/>
              <a:gd name="connsiteY39" fmla="*/ 909682 h 2355494"/>
              <a:gd name="connsiteX40" fmla="*/ 2171967 w 2865918"/>
              <a:gd name="connsiteY40" fmla="*/ 792207 h 2355494"/>
              <a:gd name="connsiteX41" fmla="*/ 2191017 w 2865918"/>
              <a:gd name="connsiteY41" fmla="*/ 992232 h 2355494"/>
              <a:gd name="connsiteX42" fmla="*/ 2144185 w 2865918"/>
              <a:gd name="connsiteY42" fmla="*/ 1101769 h 2355494"/>
              <a:gd name="connsiteX43" fmla="*/ 1962417 w 2865918"/>
              <a:gd name="connsiteY43" fmla="*/ 1300207 h 2355494"/>
              <a:gd name="connsiteX44" fmla="*/ 2292617 w 2865918"/>
              <a:gd name="connsiteY44" fmla="*/ 1185907 h 2355494"/>
              <a:gd name="connsiteX45" fmla="*/ 2324367 w 2865918"/>
              <a:gd name="connsiteY45" fmla="*/ 735057 h 2355494"/>
              <a:gd name="connsiteX46" fmla="*/ 2352942 w 2865918"/>
              <a:gd name="connsiteY46" fmla="*/ 1016044 h 2355494"/>
              <a:gd name="connsiteX47" fmla="*/ 2349767 w 2865918"/>
              <a:gd name="connsiteY47" fmla="*/ 1131932 h 2355494"/>
              <a:gd name="connsiteX48" fmla="*/ 2540267 w 2865918"/>
              <a:gd name="connsiteY48" fmla="*/ 627107 h 2355494"/>
              <a:gd name="connsiteX49" fmla="*/ 2864117 w 2865918"/>
              <a:gd name="connsiteY49" fmla="*/ 411207 h 2355494"/>
              <a:gd name="connsiteX50" fmla="*/ 2667267 w 2865918"/>
              <a:gd name="connsiteY50" fmla="*/ 550907 h 2355494"/>
              <a:gd name="connsiteX51" fmla="*/ 2584717 w 2865918"/>
              <a:gd name="connsiteY51" fmla="*/ 633457 h 2355494"/>
              <a:gd name="connsiteX52" fmla="*/ 2533917 w 2865918"/>
              <a:gd name="connsiteY52" fmla="*/ 741407 h 2355494"/>
              <a:gd name="connsiteX53" fmla="*/ 2450573 w 2865918"/>
              <a:gd name="connsiteY53" fmla="*/ 943019 h 2355494"/>
              <a:gd name="connsiteX54" fmla="*/ 2673617 w 2865918"/>
              <a:gd name="connsiteY54" fmla="*/ 766807 h 2355494"/>
              <a:gd name="connsiteX55" fmla="*/ 2711717 w 2865918"/>
              <a:gd name="connsiteY55" fmla="*/ 639807 h 2355494"/>
              <a:gd name="connsiteX56" fmla="*/ 2676792 w 2865918"/>
              <a:gd name="connsiteY56" fmla="*/ 782682 h 2355494"/>
              <a:gd name="connsiteX57" fmla="*/ 2495817 w 2865918"/>
              <a:gd name="connsiteY57" fmla="*/ 944607 h 2355494"/>
              <a:gd name="connsiteX58" fmla="*/ 2413267 w 2865918"/>
              <a:gd name="connsiteY58" fmla="*/ 1100182 h 2355494"/>
              <a:gd name="connsiteX59" fmla="*/ 2320128 w 2865918"/>
              <a:gd name="connsiteY59" fmla="*/ 1214833 h 2355494"/>
              <a:gd name="connsiteX60" fmla="*/ 2265312 w 2865918"/>
              <a:gd name="connsiteY60" fmla="*/ 1243692 h 2355494"/>
              <a:gd name="connsiteX61" fmla="*/ 2022742 w 2865918"/>
              <a:gd name="connsiteY61" fmla="*/ 1347832 h 2355494"/>
              <a:gd name="connsiteX62" fmla="*/ 1854467 w 2865918"/>
              <a:gd name="connsiteY62" fmla="*/ 1401807 h 2355494"/>
              <a:gd name="connsiteX63" fmla="*/ 1581417 w 2865918"/>
              <a:gd name="connsiteY63" fmla="*/ 1458957 h 2355494"/>
              <a:gd name="connsiteX64" fmla="*/ 1340117 w 2865918"/>
              <a:gd name="connsiteY64" fmla="*/ 1611357 h 2355494"/>
              <a:gd name="connsiteX65" fmla="*/ 1378217 w 2865918"/>
              <a:gd name="connsiteY65" fmla="*/ 1782807 h 2355494"/>
              <a:gd name="connsiteX66" fmla="*/ 1803667 w 2865918"/>
              <a:gd name="connsiteY66" fmla="*/ 2036807 h 2355494"/>
              <a:gd name="connsiteX67" fmla="*/ 1416317 w 2865918"/>
              <a:gd name="connsiteY67" fmla="*/ 1859007 h 2355494"/>
              <a:gd name="connsiteX68" fmla="*/ 1225817 w 2865918"/>
              <a:gd name="connsiteY68" fmla="*/ 1687557 h 2355494"/>
              <a:gd name="connsiteX69" fmla="*/ 924192 w 2865918"/>
              <a:gd name="connsiteY69" fmla="*/ 1681207 h 2355494"/>
              <a:gd name="connsiteX70" fmla="*/ 705117 w 2865918"/>
              <a:gd name="connsiteY70" fmla="*/ 1973307 h 2355494"/>
              <a:gd name="connsiteX71" fmla="*/ 533667 w 2865918"/>
              <a:gd name="connsiteY71" fmla="*/ 2252707 h 2355494"/>
              <a:gd name="connsiteX72" fmla="*/ 190767 w 2865918"/>
              <a:gd name="connsiteY72" fmla="*/ 2354307 h 2355494"/>
              <a:gd name="connsiteX73" fmla="*/ 267 w 2865918"/>
              <a:gd name="connsiteY73" fmla="*/ 2309857 h 2355494"/>
              <a:gd name="connsiteX74" fmla="*/ 228867 w 2865918"/>
              <a:gd name="connsiteY74" fmla="*/ 2335257 h 2355494"/>
              <a:gd name="connsiteX75" fmla="*/ 489217 w 2865918"/>
              <a:gd name="connsiteY75" fmla="*/ 2240007 h 2355494"/>
              <a:gd name="connsiteX76" fmla="*/ 622567 w 2865918"/>
              <a:gd name="connsiteY76" fmla="*/ 2036807 h 2355494"/>
              <a:gd name="connsiteX77" fmla="*/ 673367 w 2865918"/>
              <a:gd name="connsiteY77" fmla="*/ 1808207 h 2355494"/>
              <a:gd name="connsiteX78" fmla="*/ 273317 w 2865918"/>
              <a:gd name="connsiteY78" fmla="*/ 2125707 h 2355494"/>
              <a:gd name="connsiteX79" fmla="*/ 114567 w 2865918"/>
              <a:gd name="connsiteY79" fmla="*/ 2132057 h 2355494"/>
              <a:gd name="connsiteX80" fmla="*/ 222517 w 2865918"/>
              <a:gd name="connsiteY80" fmla="*/ 2119357 h 2355494"/>
              <a:gd name="connsiteX81" fmla="*/ 393967 w 2865918"/>
              <a:gd name="connsiteY81" fmla="*/ 1998707 h 2355494"/>
              <a:gd name="connsiteX82" fmla="*/ 552717 w 2865918"/>
              <a:gd name="connsiteY82" fmla="*/ 1855832 h 2355494"/>
              <a:gd name="connsiteX83" fmla="*/ 819417 w 2865918"/>
              <a:gd name="connsiteY83" fmla="*/ 1636757 h 2355494"/>
              <a:gd name="connsiteX84" fmla="*/ 901967 w 2865918"/>
              <a:gd name="connsiteY84" fmla="*/ 1306557 h 2355494"/>
              <a:gd name="connsiteX85" fmla="*/ 641617 w 2865918"/>
              <a:gd name="connsiteY85" fmla="*/ 1179557 h 2355494"/>
              <a:gd name="connsiteX86" fmla="*/ 482867 w 2865918"/>
              <a:gd name="connsiteY86" fmla="*/ 1090657 h 2355494"/>
              <a:gd name="connsiteX87" fmla="*/ 717817 w 2865918"/>
              <a:gd name="connsiteY87" fmla="*/ 1173207 h 2355494"/>
              <a:gd name="connsiteX88" fmla="*/ 692417 w 2865918"/>
              <a:gd name="connsiteY88" fmla="*/ 950957 h 2355494"/>
              <a:gd name="connsiteX89" fmla="*/ 584467 w 2865918"/>
              <a:gd name="connsiteY89" fmla="*/ 830307 h 2355494"/>
              <a:gd name="connsiteX90" fmla="*/ 711467 w 2865918"/>
              <a:gd name="connsiteY90" fmla="*/ 931907 h 2355494"/>
              <a:gd name="connsiteX91" fmla="*/ 749567 w 2865918"/>
              <a:gd name="connsiteY91" fmla="*/ 1109707 h 2355494"/>
              <a:gd name="connsiteX92" fmla="*/ 781317 w 2865918"/>
              <a:gd name="connsiteY92" fmla="*/ 1058907 h 2355494"/>
              <a:gd name="connsiteX93" fmla="*/ 800367 w 2865918"/>
              <a:gd name="connsiteY93" fmla="*/ 912857 h 2355494"/>
              <a:gd name="connsiteX94" fmla="*/ 724167 w 2865918"/>
              <a:gd name="connsiteY94" fmla="*/ 722357 h 2355494"/>
              <a:gd name="connsiteX95" fmla="*/ 813067 w 2865918"/>
              <a:gd name="connsiteY95" fmla="*/ 862057 h 2355494"/>
              <a:gd name="connsiteX96" fmla="*/ 806717 w 2865918"/>
              <a:gd name="connsiteY96" fmla="*/ 1033507 h 2355494"/>
              <a:gd name="connsiteX97" fmla="*/ 813067 w 2865918"/>
              <a:gd name="connsiteY97" fmla="*/ 1204957 h 2355494"/>
              <a:gd name="connsiteX98" fmla="*/ 940067 w 2865918"/>
              <a:gd name="connsiteY98" fmla="*/ 1312907 h 2355494"/>
              <a:gd name="connsiteX99" fmla="*/ 1016267 w 2865918"/>
              <a:gd name="connsiteY99" fmla="*/ 1046207 h 2355494"/>
              <a:gd name="connsiteX100" fmla="*/ 1009917 w 2865918"/>
              <a:gd name="connsiteY100" fmla="*/ 1198607 h 2355494"/>
              <a:gd name="connsiteX101" fmla="*/ 1009917 w 2865918"/>
              <a:gd name="connsiteY101" fmla="*/ 1287507 h 2355494"/>
              <a:gd name="connsiteX102" fmla="*/ 1130567 w 2865918"/>
              <a:gd name="connsiteY102" fmla="*/ 1274807 h 2355494"/>
              <a:gd name="connsiteX103" fmla="*/ 1263917 w 2865918"/>
              <a:gd name="connsiteY103" fmla="*/ 1046207 h 2355494"/>
              <a:gd name="connsiteX104" fmla="*/ 1302017 w 2865918"/>
              <a:gd name="connsiteY104" fmla="*/ 665207 h 2355494"/>
              <a:gd name="connsiteX105" fmla="*/ 1263123 w 2865918"/>
              <a:gd name="connsiteY105" fmla="*/ 519157 h 2355494"/>
              <a:gd name="connsiteX106" fmla="*/ 1042026 w 2865918"/>
              <a:gd name="connsiteY106" fmla="*/ 455155 h 2355494"/>
              <a:gd name="connsiteX107" fmla="*/ 909905 w 2865918"/>
              <a:gd name="connsiteY107" fmla="*/ 436607 h 2355494"/>
              <a:gd name="connsiteX0" fmla="*/ 909905 w 2865944"/>
              <a:gd name="connsiteY0" fmla="*/ 436607 h 2355494"/>
              <a:gd name="connsiteX1" fmla="*/ 1219467 w 2865944"/>
              <a:gd name="connsiteY1" fmla="*/ 474707 h 2355494"/>
              <a:gd name="connsiteX2" fmla="*/ 1282967 w 2865944"/>
              <a:gd name="connsiteY2" fmla="*/ 487407 h 2355494"/>
              <a:gd name="connsiteX3" fmla="*/ 1308367 w 2865944"/>
              <a:gd name="connsiteY3" fmla="*/ 442957 h 2355494"/>
              <a:gd name="connsiteX4" fmla="*/ 1289317 w 2865944"/>
              <a:gd name="connsiteY4" fmla="*/ 322307 h 2355494"/>
              <a:gd name="connsiteX5" fmla="*/ 1333767 w 2865944"/>
              <a:gd name="connsiteY5" fmla="*/ 208007 h 2355494"/>
              <a:gd name="connsiteX6" fmla="*/ 1308367 w 2865944"/>
              <a:gd name="connsiteY6" fmla="*/ 335007 h 2355494"/>
              <a:gd name="connsiteX7" fmla="*/ 1333767 w 2865944"/>
              <a:gd name="connsiteY7" fmla="*/ 417557 h 2355494"/>
              <a:gd name="connsiteX8" fmla="*/ 1384567 w 2865944"/>
              <a:gd name="connsiteY8" fmla="*/ 296907 h 2355494"/>
              <a:gd name="connsiteX9" fmla="*/ 1340117 w 2865944"/>
              <a:gd name="connsiteY9" fmla="*/ 468357 h 2355494"/>
              <a:gd name="connsiteX10" fmla="*/ 1341704 w 2865944"/>
              <a:gd name="connsiteY10" fmla="*/ 504869 h 2355494"/>
              <a:gd name="connsiteX11" fmla="*/ 1359167 w 2865944"/>
              <a:gd name="connsiteY11" fmla="*/ 817607 h 2355494"/>
              <a:gd name="connsiteX12" fmla="*/ 1429017 w 2865944"/>
              <a:gd name="connsiteY12" fmla="*/ 1020807 h 2355494"/>
              <a:gd name="connsiteX13" fmla="*/ 1689367 w 2865944"/>
              <a:gd name="connsiteY13" fmla="*/ 868407 h 2355494"/>
              <a:gd name="connsiteX14" fmla="*/ 1689367 w 2865944"/>
              <a:gd name="connsiteY14" fmla="*/ 487407 h 2355494"/>
              <a:gd name="connsiteX15" fmla="*/ 1740167 w 2865944"/>
              <a:gd name="connsiteY15" fmla="*/ 277857 h 2355494"/>
              <a:gd name="connsiteX16" fmla="*/ 1822717 w 2865944"/>
              <a:gd name="connsiteY16" fmla="*/ 119107 h 2355494"/>
              <a:gd name="connsiteX17" fmla="*/ 1733817 w 2865944"/>
              <a:gd name="connsiteY17" fmla="*/ 379457 h 2355494"/>
              <a:gd name="connsiteX18" fmla="*/ 1835417 w 2865944"/>
              <a:gd name="connsiteY18" fmla="*/ 373107 h 2355494"/>
              <a:gd name="connsiteX19" fmla="*/ 1917967 w 2865944"/>
              <a:gd name="connsiteY19" fmla="*/ 188957 h 2355494"/>
              <a:gd name="connsiteX20" fmla="*/ 1836687 w 2865944"/>
              <a:gd name="connsiteY20" fmla="*/ 399142 h 2355494"/>
              <a:gd name="connsiteX21" fmla="*/ 1721117 w 2865944"/>
              <a:gd name="connsiteY21" fmla="*/ 455657 h 2355494"/>
              <a:gd name="connsiteX22" fmla="*/ 1733817 w 2865944"/>
              <a:gd name="connsiteY22" fmla="*/ 646157 h 2355494"/>
              <a:gd name="connsiteX23" fmla="*/ 1937017 w 2865944"/>
              <a:gd name="connsiteY23" fmla="*/ 544557 h 2355494"/>
              <a:gd name="connsiteX24" fmla="*/ 1968767 w 2865944"/>
              <a:gd name="connsiteY24" fmla="*/ 119107 h 2355494"/>
              <a:gd name="connsiteX25" fmla="*/ 1981467 w 2865944"/>
              <a:gd name="connsiteY25" fmla="*/ 11157 h 2355494"/>
              <a:gd name="connsiteX26" fmla="*/ 1994167 w 2865944"/>
              <a:gd name="connsiteY26" fmla="*/ 335007 h 2355494"/>
              <a:gd name="connsiteX27" fmla="*/ 1968767 w 2865944"/>
              <a:gd name="connsiteY27" fmla="*/ 589007 h 2355494"/>
              <a:gd name="connsiteX28" fmla="*/ 1860817 w 2865944"/>
              <a:gd name="connsiteY28" fmla="*/ 665207 h 2355494"/>
              <a:gd name="connsiteX29" fmla="*/ 2057667 w 2865944"/>
              <a:gd name="connsiteY29" fmla="*/ 696957 h 2355494"/>
              <a:gd name="connsiteX30" fmla="*/ 2229117 w 2865944"/>
              <a:gd name="connsiteY30" fmla="*/ 652507 h 2355494"/>
              <a:gd name="connsiteX31" fmla="*/ 2089417 w 2865944"/>
              <a:gd name="connsiteY31" fmla="*/ 735057 h 2355494"/>
              <a:gd name="connsiteX32" fmla="*/ 1879867 w 2865944"/>
              <a:gd name="connsiteY32" fmla="*/ 722357 h 2355494"/>
              <a:gd name="connsiteX33" fmla="*/ 1784617 w 2865944"/>
              <a:gd name="connsiteY33" fmla="*/ 703307 h 2355494"/>
              <a:gd name="connsiteX34" fmla="*/ 1733817 w 2865944"/>
              <a:gd name="connsiteY34" fmla="*/ 868407 h 2355494"/>
              <a:gd name="connsiteX35" fmla="*/ 1575067 w 2865944"/>
              <a:gd name="connsiteY35" fmla="*/ 1052557 h 2355494"/>
              <a:gd name="connsiteX36" fmla="*/ 1536967 w 2865944"/>
              <a:gd name="connsiteY36" fmla="*/ 1306557 h 2355494"/>
              <a:gd name="connsiteX37" fmla="*/ 1829067 w 2865944"/>
              <a:gd name="connsiteY37" fmla="*/ 1351007 h 2355494"/>
              <a:gd name="connsiteX38" fmla="*/ 2140217 w 2865944"/>
              <a:gd name="connsiteY38" fmla="*/ 1071607 h 2355494"/>
              <a:gd name="connsiteX39" fmla="*/ 2165617 w 2865944"/>
              <a:gd name="connsiteY39" fmla="*/ 909682 h 2355494"/>
              <a:gd name="connsiteX40" fmla="*/ 2171967 w 2865944"/>
              <a:gd name="connsiteY40" fmla="*/ 792207 h 2355494"/>
              <a:gd name="connsiteX41" fmla="*/ 2191017 w 2865944"/>
              <a:gd name="connsiteY41" fmla="*/ 992232 h 2355494"/>
              <a:gd name="connsiteX42" fmla="*/ 2144185 w 2865944"/>
              <a:gd name="connsiteY42" fmla="*/ 1101769 h 2355494"/>
              <a:gd name="connsiteX43" fmla="*/ 1962417 w 2865944"/>
              <a:gd name="connsiteY43" fmla="*/ 1300207 h 2355494"/>
              <a:gd name="connsiteX44" fmla="*/ 2292617 w 2865944"/>
              <a:gd name="connsiteY44" fmla="*/ 1185907 h 2355494"/>
              <a:gd name="connsiteX45" fmla="*/ 2324367 w 2865944"/>
              <a:gd name="connsiteY45" fmla="*/ 735057 h 2355494"/>
              <a:gd name="connsiteX46" fmla="*/ 2352942 w 2865944"/>
              <a:gd name="connsiteY46" fmla="*/ 1016044 h 2355494"/>
              <a:gd name="connsiteX47" fmla="*/ 2349767 w 2865944"/>
              <a:gd name="connsiteY47" fmla="*/ 1131932 h 2355494"/>
              <a:gd name="connsiteX48" fmla="*/ 2540267 w 2865944"/>
              <a:gd name="connsiteY48" fmla="*/ 627107 h 2355494"/>
              <a:gd name="connsiteX49" fmla="*/ 2864117 w 2865944"/>
              <a:gd name="connsiteY49" fmla="*/ 411207 h 2355494"/>
              <a:gd name="connsiteX50" fmla="*/ 2667267 w 2865944"/>
              <a:gd name="connsiteY50" fmla="*/ 550907 h 2355494"/>
              <a:gd name="connsiteX51" fmla="*/ 2568048 w 2865944"/>
              <a:gd name="connsiteY51" fmla="*/ 628695 h 2355494"/>
              <a:gd name="connsiteX52" fmla="*/ 2533917 w 2865944"/>
              <a:gd name="connsiteY52" fmla="*/ 741407 h 2355494"/>
              <a:gd name="connsiteX53" fmla="*/ 2450573 w 2865944"/>
              <a:gd name="connsiteY53" fmla="*/ 943019 h 2355494"/>
              <a:gd name="connsiteX54" fmla="*/ 2673617 w 2865944"/>
              <a:gd name="connsiteY54" fmla="*/ 766807 h 2355494"/>
              <a:gd name="connsiteX55" fmla="*/ 2711717 w 2865944"/>
              <a:gd name="connsiteY55" fmla="*/ 639807 h 2355494"/>
              <a:gd name="connsiteX56" fmla="*/ 2676792 w 2865944"/>
              <a:gd name="connsiteY56" fmla="*/ 782682 h 2355494"/>
              <a:gd name="connsiteX57" fmla="*/ 2495817 w 2865944"/>
              <a:gd name="connsiteY57" fmla="*/ 944607 h 2355494"/>
              <a:gd name="connsiteX58" fmla="*/ 2413267 w 2865944"/>
              <a:gd name="connsiteY58" fmla="*/ 1100182 h 2355494"/>
              <a:gd name="connsiteX59" fmla="*/ 2320128 w 2865944"/>
              <a:gd name="connsiteY59" fmla="*/ 1214833 h 2355494"/>
              <a:gd name="connsiteX60" fmla="*/ 2265312 w 2865944"/>
              <a:gd name="connsiteY60" fmla="*/ 1243692 h 2355494"/>
              <a:gd name="connsiteX61" fmla="*/ 2022742 w 2865944"/>
              <a:gd name="connsiteY61" fmla="*/ 1347832 h 2355494"/>
              <a:gd name="connsiteX62" fmla="*/ 1854467 w 2865944"/>
              <a:gd name="connsiteY62" fmla="*/ 1401807 h 2355494"/>
              <a:gd name="connsiteX63" fmla="*/ 1581417 w 2865944"/>
              <a:gd name="connsiteY63" fmla="*/ 1458957 h 2355494"/>
              <a:gd name="connsiteX64" fmla="*/ 1340117 w 2865944"/>
              <a:gd name="connsiteY64" fmla="*/ 1611357 h 2355494"/>
              <a:gd name="connsiteX65" fmla="*/ 1378217 w 2865944"/>
              <a:gd name="connsiteY65" fmla="*/ 1782807 h 2355494"/>
              <a:gd name="connsiteX66" fmla="*/ 1803667 w 2865944"/>
              <a:gd name="connsiteY66" fmla="*/ 2036807 h 2355494"/>
              <a:gd name="connsiteX67" fmla="*/ 1416317 w 2865944"/>
              <a:gd name="connsiteY67" fmla="*/ 1859007 h 2355494"/>
              <a:gd name="connsiteX68" fmla="*/ 1225817 w 2865944"/>
              <a:gd name="connsiteY68" fmla="*/ 1687557 h 2355494"/>
              <a:gd name="connsiteX69" fmla="*/ 924192 w 2865944"/>
              <a:gd name="connsiteY69" fmla="*/ 1681207 h 2355494"/>
              <a:gd name="connsiteX70" fmla="*/ 705117 w 2865944"/>
              <a:gd name="connsiteY70" fmla="*/ 1973307 h 2355494"/>
              <a:gd name="connsiteX71" fmla="*/ 533667 w 2865944"/>
              <a:gd name="connsiteY71" fmla="*/ 2252707 h 2355494"/>
              <a:gd name="connsiteX72" fmla="*/ 190767 w 2865944"/>
              <a:gd name="connsiteY72" fmla="*/ 2354307 h 2355494"/>
              <a:gd name="connsiteX73" fmla="*/ 267 w 2865944"/>
              <a:gd name="connsiteY73" fmla="*/ 2309857 h 2355494"/>
              <a:gd name="connsiteX74" fmla="*/ 228867 w 2865944"/>
              <a:gd name="connsiteY74" fmla="*/ 2335257 h 2355494"/>
              <a:gd name="connsiteX75" fmla="*/ 489217 w 2865944"/>
              <a:gd name="connsiteY75" fmla="*/ 2240007 h 2355494"/>
              <a:gd name="connsiteX76" fmla="*/ 622567 w 2865944"/>
              <a:gd name="connsiteY76" fmla="*/ 2036807 h 2355494"/>
              <a:gd name="connsiteX77" fmla="*/ 673367 w 2865944"/>
              <a:gd name="connsiteY77" fmla="*/ 1808207 h 2355494"/>
              <a:gd name="connsiteX78" fmla="*/ 273317 w 2865944"/>
              <a:gd name="connsiteY78" fmla="*/ 2125707 h 2355494"/>
              <a:gd name="connsiteX79" fmla="*/ 114567 w 2865944"/>
              <a:gd name="connsiteY79" fmla="*/ 2132057 h 2355494"/>
              <a:gd name="connsiteX80" fmla="*/ 222517 w 2865944"/>
              <a:gd name="connsiteY80" fmla="*/ 2119357 h 2355494"/>
              <a:gd name="connsiteX81" fmla="*/ 393967 w 2865944"/>
              <a:gd name="connsiteY81" fmla="*/ 1998707 h 2355494"/>
              <a:gd name="connsiteX82" fmla="*/ 552717 w 2865944"/>
              <a:gd name="connsiteY82" fmla="*/ 1855832 h 2355494"/>
              <a:gd name="connsiteX83" fmla="*/ 819417 w 2865944"/>
              <a:gd name="connsiteY83" fmla="*/ 1636757 h 2355494"/>
              <a:gd name="connsiteX84" fmla="*/ 901967 w 2865944"/>
              <a:gd name="connsiteY84" fmla="*/ 1306557 h 2355494"/>
              <a:gd name="connsiteX85" fmla="*/ 641617 w 2865944"/>
              <a:gd name="connsiteY85" fmla="*/ 1179557 h 2355494"/>
              <a:gd name="connsiteX86" fmla="*/ 482867 w 2865944"/>
              <a:gd name="connsiteY86" fmla="*/ 1090657 h 2355494"/>
              <a:gd name="connsiteX87" fmla="*/ 717817 w 2865944"/>
              <a:gd name="connsiteY87" fmla="*/ 1173207 h 2355494"/>
              <a:gd name="connsiteX88" fmla="*/ 692417 w 2865944"/>
              <a:gd name="connsiteY88" fmla="*/ 950957 h 2355494"/>
              <a:gd name="connsiteX89" fmla="*/ 584467 w 2865944"/>
              <a:gd name="connsiteY89" fmla="*/ 830307 h 2355494"/>
              <a:gd name="connsiteX90" fmla="*/ 711467 w 2865944"/>
              <a:gd name="connsiteY90" fmla="*/ 931907 h 2355494"/>
              <a:gd name="connsiteX91" fmla="*/ 749567 w 2865944"/>
              <a:gd name="connsiteY91" fmla="*/ 1109707 h 2355494"/>
              <a:gd name="connsiteX92" fmla="*/ 781317 w 2865944"/>
              <a:gd name="connsiteY92" fmla="*/ 1058907 h 2355494"/>
              <a:gd name="connsiteX93" fmla="*/ 800367 w 2865944"/>
              <a:gd name="connsiteY93" fmla="*/ 912857 h 2355494"/>
              <a:gd name="connsiteX94" fmla="*/ 724167 w 2865944"/>
              <a:gd name="connsiteY94" fmla="*/ 722357 h 2355494"/>
              <a:gd name="connsiteX95" fmla="*/ 813067 w 2865944"/>
              <a:gd name="connsiteY95" fmla="*/ 862057 h 2355494"/>
              <a:gd name="connsiteX96" fmla="*/ 806717 w 2865944"/>
              <a:gd name="connsiteY96" fmla="*/ 1033507 h 2355494"/>
              <a:gd name="connsiteX97" fmla="*/ 813067 w 2865944"/>
              <a:gd name="connsiteY97" fmla="*/ 1204957 h 2355494"/>
              <a:gd name="connsiteX98" fmla="*/ 940067 w 2865944"/>
              <a:gd name="connsiteY98" fmla="*/ 1312907 h 2355494"/>
              <a:gd name="connsiteX99" fmla="*/ 1016267 w 2865944"/>
              <a:gd name="connsiteY99" fmla="*/ 1046207 h 2355494"/>
              <a:gd name="connsiteX100" fmla="*/ 1009917 w 2865944"/>
              <a:gd name="connsiteY100" fmla="*/ 1198607 h 2355494"/>
              <a:gd name="connsiteX101" fmla="*/ 1009917 w 2865944"/>
              <a:gd name="connsiteY101" fmla="*/ 1287507 h 2355494"/>
              <a:gd name="connsiteX102" fmla="*/ 1130567 w 2865944"/>
              <a:gd name="connsiteY102" fmla="*/ 1274807 h 2355494"/>
              <a:gd name="connsiteX103" fmla="*/ 1263917 w 2865944"/>
              <a:gd name="connsiteY103" fmla="*/ 1046207 h 2355494"/>
              <a:gd name="connsiteX104" fmla="*/ 1302017 w 2865944"/>
              <a:gd name="connsiteY104" fmla="*/ 665207 h 2355494"/>
              <a:gd name="connsiteX105" fmla="*/ 1263123 w 2865944"/>
              <a:gd name="connsiteY105" fmla="*/ 519157 h 2355494"/>
              <a:gd name="connsiteX106" fmla="*/ 1042026 w 2865944"/>
              <a:gd name="connsiteY106" fmla="*/ 455155 h 2355494"/>
              <a:gd name="connsiteX107" fmla="*/ 909905 w 2865944"/>
              <a:gd name="connsiteY107" fmla="*/ 436607 h 2355494"/>
              <a:gd name="connsiteX0" fmla="*/ 909905 w 2865944"/>
              <a:gd name="connsiteY0" fmla="*/ 436607 h 2355494"/>
              <a:gd name="connsiteX1" fmla="*/ 1219467 w 2865944"/>
              <a:gd name="connsiteY1" fmla="*/ 474707 h 2355494"/>
              <a:gd name="connsiteX2" fmla="*/ 1282967 w 2865944"/>
              <a:gd name="connsiteY2" fmla="*/ 487407 h 2355494"/>
              <a:gd name="connsiteX3" fmla="*/ 1308367 w 2865944"/>
              <a:gd name="connsiteY3" fmla="*/ 442957 h 2355494"/>
              <a:gd name="connsiteX4" fmla="*/ 1289317 w 2865944"/>
              <a:gd name="connsiteY4" fmla="*/ 322307 h 2355494"/>
              <a:gd name="connsiteX5" fmla="*/ 1333767 w 2865944"/>
              <a:gd name="connsiteY5" fmla="*/ 208007 h 2355494"/>
              <a:gd name="connsiteX6" fmla="*/ 1308367 w 2865944"/>
              <a:gd name="connsiteY6" fmla="*/ 335007 h 2355494"/>
              <a:gd name="connsiteX7" fmla="*/ 1333767 w 2865944"/>
              <a:gd name="connsiteY7" fmla="*/ 417557 h 2355494"/>
              <a:gd name="connsiteX8" fmla="*/ 1384567 w 2865944"/>
              <a:gd name="connsiteY8" fmla="*/ 296907 h 2355494"/>
              <a:gd name="connsiteX9" fmla="*/ 1340117 w 2865944"/>
              <a:gd name="connsiteY9" fmla="*/ 468357 h 2355494"/>
              <a:gd name="connsiteX10" fmla="*/ 1341704 w 2865944"/>
              <a:gd name="connsiteY10" fmla="*/ 504869 h 2355494"/>
              <a:gd name="connsiteX11" fmla="*/ 1359167 w 2865944"/>
              <a:gd name="connsiteY11" fmla="*/ 817607 h 2355494"/>
              <a:gd name="connsiteX12" fmla="*/ 1429017 w 2865944"/>
              <a:gd name="connsiteY12" fmla="*/ 1020807 h 2355494"/>
              <a:gd name="connsiteX13" fmla="*/ 1689367 w 2865944"/>
              <a:gd name="connsiteY13" fmla="*/ 868407 h 2355494"/>
              <a:gd name="connsiteX14" fmla="*/ 1689367 w 2865944"/>
              <a:gd name="connsiteY14" fmla="*/ 487407 h 2355494"/>
              <a:gd name="connsiteX15" fmla="*/ 1740167 w 2865944"/>
              <a:gd name="connsiteY15" fmla="*/ 277857 h 2355494"/>
              <a:gd name="connsiteX16" fmla="*/ 1822717 w 2865944"/>
              <a:gd name="connsiteY16" fmla="*/ 119107 h 2355494"/>
              <a:gd name="connsiteX17" fmla="*/ 1733817 w 2865944"/>
              <a:gd name="connsiteY17" fmla="*/ 379457 h 2355494"/>
              <a:gd name="connsiteX18" fmla="*/ 1835417 w 2865944"/>
              <a:gd name="connsiteY18" fmla="*/ 373107 h 2355494"/>
              <a:gd name="connsiteX19" fmla="*/ 1917967 w 2865944"/>
              <a:gd name="connsiteY19" fmla="*/ 188957 h 2355494"/>
              <a:gd name="connsiteX20" fmla="*/ 1836687 w 2865944"/>
              <a:gd name="connsiteY20" fmla="*/ 399142 h 2355494"/>
              <a:gd name="connsiteX21" fmla="*/ 1721117 w 2865944"/>
              <a:gd name="connsiteY21" fmla="*/ 455657 h 2355494"/>
              <a:gd name="connsiteX22" fmla="*/ 1733817 w 2865944"/>
              <a:gd name="connsiteY22" fmla="*/ 646157 h 2355494"/>
              <a:gd name="connsiteX23" fmla="*/ 1937017 w 2865944"/>
              <a:gd name="connsiteY23" fmla="*/ 544557 h 2355494"/>
              <a:gd name="connsiteX24" fmla="*/ 1968767 w 2865944"/>
              <a:gd name="connsiteY24" fmla="*/ 119107 h 2355494"/>
              <a:gd name="connsiteX25" fmla="*/ 1981467 w 2865944"/>
              <a:gd name="connsiteY25" fmla="*/ 11157 h 2355494"/>
              <a:gd name="connsiteX26" fmla="*/ 1994167 w 2865944"/>
              <a:gd name="connsiteY26" fmla="*/ 335007 h 2355494"/>
              <a:gd name="connsiteX27" fmla="*/ 1968767 w 2865944"/>
              <a:gd name="connsiteY27" fmla="*/ 589007 h 2355494"/>
              <a:gd name="connsiteX28" fmla="*/ 1860817 w 2865944"/>
              <a:gd name="connsiteY28" fmla="*/ 665207 h 2355494"/>
              <a:gd name="connsiteX29" fmla="*/ 2057667 w 2865944"/>
              <a:gd name="connsiteY29" fmla="*/ 696957 h 2355494"/>
              <a:gd name="connsiteX30" fmla="*/ 2229117 w 2865944"/>
              <a:gd name="connsiteY30" fmla="*/ 652507 h 2355494"/>
              <a:gd name="connsiteX31" fmla="*/ 2089417 w 2865944"/>
              <a:gd name="connsiteY31" fmla="*/ 735057 h 2355494"/>
              <a:gd name="connsiteX32" fmla="*/ 1879867 w 2865944"/>
              <a:gd name="connsiteY32" fmla="*/ 722357 h 2355494"/>
              <a:gd name="connsiteX33" fmla="*/ 1784617 w 2865944"/>
              <a:gd name="connsiteY33" fmla="*/ 703307 h 2355494"/>
              <a:gd name="connsiteX34" fmla="*/ 1733817 w 2865944"/>
              <a:gd name="connsiteY34" fmla="*/ 868407 h 2355494"/>
              <a:gd name="connsiteX35" fmla="*/ 1575067 w 2865944"/>
              <a:gd name="connsiteY35" fmla="*/ 1052557 h 2355494"/>
              <a:gd name="connsiteX36" fmla="*/ 1536967 w 2865944"/>
              <a:gd name="connsiteY36" fmla="*/ 1306557 h 2355494"/>
              <a:gd name="connsiteX37" fmla="*/ 1829067 w 2865944"/>
              <a:gd name="connsiteY37" fmla="*/ 1351007 h 2355494"/>
              <a:gd name="connsiteX38" fmla="*/ 2140217 w 2865944"/>
              <a:gd name="connsiteY38" fmla="*/ 1071607 h 2355494"/>
              <a:gd name="connsiteX39" fmla="*/ 2165617 w 2865944"/>
              <a:gd name="connsiteY39" fmla="*/ 909682 h 2355494"/>
              <a:gd name="connsiteX40" fmla="*/ 2171967 w 2865944"/>
              <a:gd name="connsiteY40" fmla="*/ 792207 h 2355494"/>
              <a:gd name="connsiteX41" fmla="*/ 2191017 w 2865944"/>
              <a:gd name="connsiteY41" fmla="*/ 992232 h 2355494"/>
              <a:gd name="connsiteX42" fmla="*/ 2144185 w 2865944"/>
              <a:gd name="connsiteY42" fmla="*/ 1101769 h 2355494"/>
              <a:gd name="connsiteX43" fmla="*/ 1962417 w 2865944"/>
              <a:gd name="connsiteY43" fmla="*/ 1300207 h 2355494"/>
              <a:gd name="connsiteX44" fmla="*/ 2292617 w 2865944"/>
              <a:gd name="connsiteY44" fmla="*/ 1185907 h 2355494"/>
              <a:gd name="connsiteX45" fmla="*/ 2324367 w 2865944"/>
              <a:gd name="connsiteY45" fmla="*/ 735057 h 2355494"/>
              <a:gd name="connsiteX46" fmla="*/ 2352942 w 2865944"/>
              <a:gd name="connsiteY46" fmla="*/ 1016044 h 2355494"/>
              <a:gd name="connsiteX47" fmla="*/ 2349767 w 2865944"/>
              <a:gd name="connsiteY47" fmla="*/ 1131932 h 2355494"/>
              <a:gd name="connsiteX48" fmla="*/ 2540267 w 2865944"/>
              <a:gd name="connsiteY48" fmla="*/ 627107 h 2355494"/>
              <a:gd name="connsiteX49" fmla="*/ 2864117 w 2865944"/>
              <a:gd name="connsiteY49" fmla="*/ 411207 h 2355494"/>
              <a:gd name="connsiteX50" fmla="*/ 2667267 w 2865944"/>
              <a:gd name="connsiteY50" fmla="*/ 550907 h 2355494"/>
              <a:gd name="connsiteX51" fmla="*/ 2568048 w 2865944"/>
              <a:gd name="connsiteY51" fmla="*/ 628695 h 2355494"/>
              <a:gd name="connsiteX52" fmla="*/ 2517772 w 2865944"/>
              <a:gd name="connsiteY52" fmla="*/ 714771 h 2355494"/>
              <a:gd name="connsiteX53" fmla="*/ 2533917 w 2865944"/>
              <a:gd name="connsiteY53" fmla="*/ 741407 h 2355494"/>
              <a:gd name="connsiteX54" fmla="*/ 2450573 w 2865944"/>
              <a:gd name="connsiteY54" fmla="*/ 943019 h 2355494"/>
              <a:gd name="connsiteX55" fmla="*/ 2673617 w 2865944"/>
              <a:gd name="connsiteY55" fmla="*/ 766807 h 2355494"/>
              <a:gd name="connsiteX56" fmla="*/ 2711717 w 2865944"/>
              <a:gd name="connsiteY56" fmla="*/ 639807 h 2355494"/>
              <a:gd name="connsiteX57" fmla="*/ 2676792 w 2865944"/>
              <a:gd name="connsiteY57" fmla="*/ 782682 h 2355494"/>
              <a:gd name="connsiteX58" fmla="*/ 2495817 w 2865944"/>
              <a:gd name="connsiteY58" fmla="*/ 944607 h 2355494"/>
              <a:gd name="connsiteX59" fmla="*/ 2413267 w 2865944"/>
              <a:gd name="connsiteY59" fmla="*/ 1100182 h 2355494"/>
              <a:gd name="connsiteX60" fmla="*/ 2320128 w 2865944"/>
              <a:gd name="connsiteY60" fmla="*/ 1214833 h 2355494"/>
              <a:gd name="connsiteX61" fmla="*/ 2265312 w 2865944"/>
              <a:gd name="connsiteY61" fmla="*/ 1243692 h 2355494"/>
              <a:gd name="connsiteX62" fmla="*/ 2022742 w 2865944"/>
              <a:gd name="connsiteY62" fmla="*/ 1347832 h 2355494"/>
              <a:gd name="connsiteX63" fmla="*/ 1854467 w 2865944"/>
              <a:gd name="connsiteY63" fmla="*/ 1401807 h 2355494"/>
              <a:gd name="connsiteX64" fmla="*/ 1581417 w 2865944"/>
              <a:gd name="connsiteY64" fmla="*/ 1458957 h 2355494"/>
              <a:gd name="connsiteX65" fmla="*/ 1340117 w 2865944"/>
              <a:gd name="connsiteY65" fmla="*/ 1611357 h 2355494"/>
              <a:gd name="connsiteX66" fmla="*/ 1378217 w 2865944"/>
              <a:gd name="connsiteY66" fmla="*/ 1782807 h 2355494"/>
              <a:gd name="connsiteX67" fmla="*/ 1803667 w 2865944"/>
              <a:gd name="connsiteY67" fmla="*/ 2036807 h 2355494"/>
              <a:gd name="connsiteX68" fmla="*/ 1416317 w 2865944"/>
              <a:gd name="connsiteY68" fmla="*/ 1859007 h 2355494"/>
              <a:gd name="connsiteX69" fmla="*/ 1225817 w 2865944"/>
              <a:gd name="connsiteY69" fmla="*/ 1687557 h 2355494"/>
              <a:gd name="connsiteX70" fmla="*/ 924192 w 2865944"/>
              <a:gd name="connsiteY70" fmla="*/ 1681207 h 2355494"/>
              <a:gd name="connsiteX71" fmla="*/ 705117 w 2865944"/>
              <a:gd name="connsiteY71" fmla="*/ 1973307 h 2355494"/>
              <a:gd name="connsiteX72" fmla="*/ 533667 w 2865944"/>
              <a:gd name="connsiteY72" fmla="*/ 2252707 h 2355494"/>
              <a:gd name="connsiteX73" fmla="*/ 190767 w 2865944"/>
              <a:gd name="connsiteY73" fmla="*/ 2354307 h 2355494"/>
              <a:gd name="connsiteX74" fmla="*/ 267 w 2865944"/>
              <a:gd name="connsiteY74" fmla="*/ 2309857 h 2355494"/>
              <a:gd name="connsiteX75" fmla="*/ 228867 w 2865944"/>
              <a:gd name="connsiteY75" fmla="*/ 2335257 h 2355494"/>
              <a:gd name="connsiteX76" fmla="*/ 489217 w 2865944"/>
              <a:gd name="connsiteY76" fmla="*/ 2240007 h 2355494"/>
              <a:gd name="connsiteX77" fmla="*/ 622567 w 2865944"/>
              <a:gd name="connsiteY77" fmla="*/ 2036807 h 2355494"/>
              <a:gd name="connsiteX78" fmla="*/ 673367 w 2865944"/>
              <a:gd name="connsiteY78" fmla="*/ 1808207 h 2355494"/>
              <a:gd name="connsiteX79" fmla="*/ 273317 w 2865944"/>
              <a:gd name="connsiteY79" fmla="*/ 2125707 h 2355494"/>
              <a:gd name="connsiteX80" fmla="*/ 114567 w 2865944"/>
              <a:gd name="connsiteY80" fmla="*/ 2132057 h 2355494"/>
              <a:gd name="connsiteX81" fmla="*/ 222517 w 2865944"/>
              <a:gd name="connsiteY81" fmla="*/ 2119357 h 2355494"/>
              <a:gd name="connsiteX82" fmla="*/ 393967 w 2865944"/>
              <a:gd name="connsiteY82" fmla="*/ 1998707 h 2355494"/>
              <a:gd name="connsiteX83" fmla="*/ 552717 w 2865944"/>
              <a:gd name="connsiteY83" fmla="*/ 1855832 h 2355494"/>
              <a:gd name="connsiteX84" fmla="*/ 819417 w 2865944"/>
              <a:gd name="connsiteY84" fmla="*/ 1636757 h 2355494"/>
              <a:gd name="connsiteX85" fmla="*/ 901967 w 2865944"/>
              <a:gd name="connsiteY85" fmla="*/ 1306557 h 2355494"/>
              <a:gd name="connsiteX86" fmla="*/ 641617 w 2865944"/>
              <a:gd name="connsiteY86" fmla="*/ 1179557 h 2355494"/>
              <a:gd name="connsiteX87" fmla="*/ 482867 w 2865944"/>
              <a:gd name="connsiteY87" fmla="*/ 1090657 h 2355494"/>
              <a:gd name="connsiteX88" fmla="*/ 717817 w 2865944"/>
              <a:gd name="connsiteY88" fmla="*/ 1173207 h 2355494"/>
              <a:gd name="connsiteX89" fmla="*/ 692417 w 2865944"/>
              <a:gd name="connsiteY89" fmla="*/ 950957 h 2355494"/>
              <a:gd name="connsiteX90" fmla="*/ 584467 w 2865944"/>
              <a:gd name="connsiteY90" fmla="*/ 830307 h 2355494"/>
              <a:gd name="connsiteX91" fmla="*/ 711467 w 2865944"/>
              <a:gd name="connsiteY91" fmla="*/ 931907 h 2355494"/>
              <a:gd name="connsiteX92" fmla="*/ 749567 w 2865944"/>
              <a:gd name="connsiteY92" fmla="*/ 1109707 h 2355494"/>
              <a:gd name="connsiteX93" fmla="*/ 781317 w 2865944"/>
              <a:gd name="connsiteY93" fmla="*/ 1058907 h 2355494"/>
              <a:gd name="connsiteX94" fmla="*/ 800367 w 2865944"/>
              <a:gd name="connsiteY94" fmla="*/ 912857 h 2355494"/>
              <a:gd name="connsiteX95" fmla="*/ 724167 w 2865944"/>
              <a:gd name="connsiteY95" fmla="*/ 722357 h 2355494"/>
              <a:gd name="connsiteX96" fmla="*/ 813067 w 2865944"/>
              <a:gd name="connsiteY96" fmla="*/ 862057 h 2355494"/>
              <a:gd name="connsiteX97" fmla="*/ 806717 w 2865944"/>
              <a:gd name="connsiteY97" fmla="*/ 1033507 h 2355494"/>
              <a:gd name="connsiteX98" fmla="*/ 813067 w 2865944"/>
              <a:gd name="connsiteY98" fmla="*/ 1204957 h 2355494"/>
              <a:gd name="connsiteX99" fmla="*/ 940067 w 2865944"/>
              <a:gd name="connsiteY99" fmla="*/ 1312907 h 2355494"/>
              <a:gd name="connsiteX100" fmla="*/ 1016267 w 2865944"/>
              <a:gd name="connsiteY100" fmla="*/ 1046207 h 2355494"/>
              <a:gd name="connsiteX101" fmla="*/ 1009917 w 2865944"/>
              <a:gd name="connsiteY101" fmla="*/ 1198607 h 2355494"/>
              <a:gd name="connsiteX102" fmla="*/ 1009917 w 2865944"/>
              <a:gd name="connsiteY102" fmla="*/ 1287507 h 2355494"/>
              <a:gd name="connsiteX103" fmla="*/ 1130567 w 2865944"/>
              <a:gd name="connsiteY103" fmla="*/ 1274807 h 2355494"/>
              <a:gd name="connsiteX104" fmla="*/ 1263917 w 2865944"/>
              <a:gd name="connsiteY104" fmla="*/ 1046207 h 2355494"/>
              <a:gd name="connsiteX105" fmla="*/ 1302017 w 2865944"/>
              <a:gd name="connsiteY105" fmla="*/ 665207 h 2355494"/>
              <a:gd name="connsiteX106" fmla="*/ 1263123 w 2865944"/>
              <a:gd name="connsiteY106" fmla="*/ 519157 h 2355494"/>
              <a:gd name="connsiteX107" fmla="*/ 1042026 w 2865944"/>
              <a:gd name="connsiteY107" fmla="*/ 455155 h 2355494"/>
              <a:gd name="connsiteX108" fmla="*/ 909905 w 2865944"/>
              <a:gd name="connsiteY108" fmla="*/ 436607 h 2355494"/>
              <a:gd name="connsiteX0" fmla="*/ 909905 w 2865944"/>
              <a:gd name="connsiteY0" fmla="*/ 436607 h 2355494"/>
              <a:gd name="connsiteX1" fmla="*/ 1219467 w 2865944"/>
              <a:gd name="connsiteY1" fmla="*/ 474707 h 2355494"/>
              <a:gd name="connsiteX2" fmla="*/ 1282967 w 2865944"/>
              <a:gd name="connsiteY2" fmla="*/ 487407 h 2355494"/>
              <a:gd name="connsiteX3" fmla="*/ 1308367 w 2865944"/>
              <a:gd name="connsiteY3" fmla="*/ 442957 h 2355494"/>
              <a:gd name="connsiteX4" fmla="*/ 1289317 w 2865944"/>
              <a:gd name="connsiteY4" fmla="*/ 322307 h 2355494"/>
              <a:gd name="connsiteX5" fmla="*/ 1333767 w 2865944"/>
              <a:gd name="connsiteY5" fmla="*/ 208007 h 2355494"/>
              <a:gd name="connsiteX6" fmla="*/ 1308367 w 2865944"/>
              <a:gd name="connsiteY6" fmla="*/ 335007 h 2355494"/>
              <a:gd name="connsiteX7" fmla="*/ 1333767 w 2865944"/>
              <a:gd name="connsiteY7" fmla="*/ 417557 h 2355494"/>
              <a:gd name="connsiteX8" fmla="*/ 1384567 w 2865944"/>
              <a:gd name="connsiteY8" fmla="*/ 296907 h 2355494"/>
              <a:gd name="connsiteX9" fmla="*/ 1340117 w 2865944"/>
              <a:gd name="connsiteY9" fmla="*/ 468357 h 2355494"/>
              <a:gd name="connsiteX10" fmla="*/ 1341704 w 2865944"/>
              <a:gd name="connsiteY10" fmla="*/ 504869 h 2355494"/>
              <a:gd name="connsiteX11" fmla="*/ 1359167 w 2865944"/>
              <a:gd name="connsiteY11" fmla="*/ 817607 h 2355494"/>
              <a:gd name="connsiteX12" fmla="*/ 1429017 w 2865944"/>
              <a:gd name="connsiteY12" fmla="*/ 1020807 h 2355494"/>
              <a:gd name="connsiteX13" fmla="*/ 1689367 w 2865944"/>
              <a:gd name="connsiteY13" fmla="*/ 868407 h 2355494"/>
              <a:gd name="connsiteX14" fmla="*/ 1689367 w 2865944"/>
              <a:gd name="connsiteY14" fmla="*/ 487407 h 2355494"/>
              <a:gd name="connsiteX15" fmla="*/ 1740167 w 2865944"/>
              <a:gd name="connsiteY15" fmla="*/ 277857 h 2355494"/>
              <a:gd name="connsiteX16" fmla="*/ 1822717 w 2865944"/>
              <a:gd name="connsiteY16" fmla="*/ 119107 h 2355494"/>
              <a:gd name="connsiteX17" fmla="*/ 1733817 w 2865944"/>
              <a:gd name="connsiteY17" fmla="*/ 379457 h 2355494"/>
              <a:gd name="connsiteX18" fmla="*/ 1835417 w 2865944"/>
              <a:gd name="connsiteY18" fmla="*/ 373107 h 2355494"/>
              <a:gd name="connsiteX19" fmla="*/ 1917967 w 2865944"/>
              <a:gd name="connsiteY19" fmla="*/ 188957 h 2355494"/>
              <a:gd name="connsiteX20" fmla="*/ 1836687 w 2865944"/>
              <a:gd name="connsiteY20" fmla="*/ 399142 h 2355494"/>
              <a:gd name="connsiteX21" fmla="*/ 1721117 w 2865944"/>
              <a:gd name="connsiteY21" fmla="*/ 455657 h 2355494"/>
              <a:gd name="connsiteX22" fmla="*/ 1733817 w 2865944"/>
              <a:gd name="connsiteY22" fmla="*/ 646157 h 2355494"/>
              <a:gd name="connsiteX23" fmla="*/ 1937017 w 2865944"/>
              <a:gd name="connsiteY23" fmla="*/ 544557 h 2355494"/>
              <a:gd name="connsiteX24" fmla="*/ 1968767 w 2865944"/>
              <a:gd name="connsiteY24" fmla="*/ 119107 h 2355494"/>
              <a:gd name="connsiteX25" fmla="*/ 1981467 w 2865944"/>
              <a:gd name="connsiteY25" fmla="*/ 11157 h 2355494"/>
              <a:gd name="connsiteX26" fmla="*/ 1994167 w 2865944"/>
              <a:gd name="connsiteY26" fmla="*/ 335007 h 2355494"/>
              <a:gd name="connsiteX27" fmla="*/ 1968767 w 2865944"/>
              <a:gd name="connsiteY27" fmla="*/ 589007 h 2355494"/>
              <a:gd name="connsiteX28" fmla="*/ 1860817 w 2865944"/>
              <a:gd name="connsiteY28" fmla="*/ 665207 h 2355494"/>
              <a:gd name="connsiteX29" fmla="*/ 2057667 w 2865944"/>
              <a:gd name="connsiteY29" fmla="*/ 696957 h 2355494"/>
              <a:gd name="connsiteX30" fmla="*/ 2229117 w 2865944"/>
              <a:gd name="connsiteY30" fmla="*/ 652507 h 2355494"/>
              <a:gd name="connsiteX31" fmla="*/ 2089417 w 2865944"/>
              <a:gd name="connsiteY31" fmla="*/ 735057 h 2355494"/>
              <a:gd name="connsiteX32" fmla="*/ 1879867 w 2865944"/>
              <a:gd name="connsiteY32" fmla="*/ 722357 h 2355494"/>
              <a:gd name="connsiteX33" fmla="*/ 1784617 w 2865944"/>
              <a:gd name="connsiteY33" fmla="*/ 703307 h 2355494"/>
              <a:gd name="connsiteX34" fmla="*/ 1733817 w 2865944"/>
              <a:gd name="connsiteY34" fmla="*/ 868407 h 2355494"/>
              <a:gd name="connsiteX35" fmla="*/ 1575067 w 2865944"/>
              <a:gd name="connsiteY35" fmla="*/ 1052557 h 2355494"/>
              <a:gd name="connsiteX36" fmla="*/ 1536967 w 2865944"/>
              <a:gd name="connsiteY36" fmla="*/ 1306557 h 2355494"/>
              <a:gd name="connsiteX37" fmla="*/ 1829067 w 2865944"/>
              <a:gd name="connsiteY37" fmla="*/ 1351007 h 2355494"/>
              <a:gd name="connsiteX38" fmla="*/ 2140217 w 2865944"/>
              <a:gd name="connsiteY38" fmla="*/ 1071607 h 2355494"/>
              <a:gd name="connsiteX39" fmla="*/ 2165617 w 2865944"/>
              <a:gd name="connsiteY39" fmla="*/ 909682 h 2355494"/>
              <a:gd name="connsiteX40" fmla="*/ 2171967 w 2865944"/>
              <a:gd name="connsiteY40" fmla="*/ 792207 h 2355494"/>
              <a:gd name="connsiteX41" fmla="*/ 2191017 w 2865944"/>
              <a:gd name="connsiteY41" fmla="*/ 992232 h 2355494"/>
              <a:gd name="connsiteX42" fmla="*/ 2144185 w 2865944"/>
              <a:gd name="connsiteY42" fmla="*/ 1101769 h 2355494"/>
              <a:gd name="connsiteX43" fmla="*/ 1962417 w 2865944"/>
              <a:gd name="connsiteY43" fmla="*/ 1300207 h 2355494"/>
              <a:gd name="connsiteX44" fmla="*/ 2292617 w 2865944"/>
              <a:gd name="connsiteY44" fmla="*/ 1185907 h 2355494"/>
              <a:gd name="connsiteX45" fmla="*/ 2324367 w 2865944"/>
              <a:gd name="connsiteY45" fmla="*/ 735057 h 2355494"/>
              <a:gd name="connsiteX46" fmla="*/ 2352942 w 2865944"/>
              <a:gd name="connsiteY46" fmla="*/ 1016044 h 2355494"/>
              <a:gd name="connsiteX47" fmla="*/ 2349767 w 2865944"/>
              <a:gd name="connsiteY47" fmla="*/ 1131932 h 2355494"/>
              <a:gd name="connsiteX48" fmla="*/ 2540267 w 2865944"/>
              <a:gd name="connsiteY48" fmla="*/ 627107 h 2355494"/>
              <a:gd name="connsiteX49" fmla="*/ 2864117 w 2865944"/>
              <a:gd name="connsiteY49" fmla="*/ 411207 h 2355494"/>
              <a:gd name="connsiteX50" fmla="*/ 2667267 w 2865944"/>
              <a:gd name="connsiteY50" fmla="*/ 550907 h 2355494"/>
              <a:gd name="connsiteX51" fmla="*/ 2568048 w 2865944"/>
              <a:gd name="connsiteY51" fmla="*/ 628695 h 2355494"/>
              <a:gd name="connsiteX52" fmla="*/ 2517772 w 2865944"/>
              <a:gd name="connsiteY52" fmla="*/ 714771 h 2355494"/>
              <a:gd name="connsiteX53" fmla="*/ 2500580 w 2865944"/>
              <a:gd name="connsiteY53" fmla="*/ 748551 h 2355494"/>
              <a:gd name="connsiteX54" fmla="*/ 2450573 w 2865944"/>
              <a:gd name="connsiteY54" fmla="*/ 943019 h 2355494"/>
              <a:gd name="connsiteX55" fmla="*/ 2673617 w 2865944"/>
              <a:gd name="connsiteY55" fmla="*/ 766807 h 2355494"/>
              <a:gd name="connsiteX56" fmla="*/ 2711717 w 2865944"/>
              <a:gd name="connsiteY56" fmla="*/ 639807 h 2355494"/>
              <a:gd name="connsiteX57" fmla="*/ 2676792 w 2865944"/>
              <a:gd name="connsiteY57" fmla="*/ 782682 h 2355494"/>
              <a:gd name="connsiteX58" fmla="*/ 2495817 w 2865944"/>
              <a:gd name="connsiteY58" fmla="*/ 944607 h 2355494"/>
              <a:gd name="connsiteX59" fmla="*/ 2413267 w 2865944"/>
              <a:gd name="connsiteY59" fmla="*/ 1100182 h 2355494"/>
              <a:gd name="connsiteX60" fmla="*/ 2320128 w 2865944"/>
              <a:gd name="connsiteY60" fmla="*/ 1214833 h 2355494"/>
              <a:gd name="connsiteX61" fmla="*/ 2265312 w 2865944"/>
              <a:gd name="connsiteY61" fmla="*/ 1243692 h 2355494"/>
              <a:gd name="connsiteX62" fmla="*/ 2022742 w 2865944"/>
              <a:gd name="connsiteY62" fmla="*/ 1347832 h 2355494"/>
              <a:gd name="connsiteX63" fmla="*/ 1854467 w 2865944"/>
              <a:gd name="connsiteY63" fmla="*/ 1401807 h 2355494"/>
              <a:gd name="connsiteX64" fmla="*/ 1581417 w 2865944"/>
              <a:gd name="connsiteY64" fmla="*/ 1458957 h 2355494"/>
              <a:gd name="connsiteX65" fmla="*/ 1340117 w 2865944"/>
              <a:gd name="connsiteY65" fmla="*/ 1611357 h 2355494"/>
              <a:gd name="connsiteX66" fmla="*/ 1378217 w 2865944"/>
              <a:gd name="connsiteY66" fmla="*/ 1782807 h 2355494"/>
              <a:gd name="connsiteX67" fmla="*/ 1803667 w 2865944"/>
              <a:gd name="connsiteY67" fmla="*/ 2036807 h 2355494"/>
              <a:gd name="connsiteX68" fmla="*/ 1416317 w 2865944"/>
              <a:gd name="connsiteY68" fmla="*/ 1859007 h 2355494"/>
              <a:gd name="connsiteX69" fmla="*/ 1225817 w 2865944"/>
              <a:gd name="connsiteY69" fmla="*/ 1687557 h 2355494"/>
              <a:gd name="connsiteX70" fmla="*/ 924192 w 2865944"/>
              <a:gd name="connsiteY70" fmla="*/ 1681207 h 2355494"/>
              <a:gd name="connsiteX71" fmla="*/ 705117 w 2865944"/>
              <a:gd name="connsiteY71" fmla="*/ 1973307 h 2355494"/>
              <a:gd name="connsiteX72" fmla="*/ 533667 w 2865944"/>
              <a:gd name="connsiteY72" fmla="*/ 2252707 h 2355494"/>
              <a:gd name="connsiteX73" fmla="*/ 190767 w 2865944"/>
              <a:gd name="connsiteY73" fmla="*/ 2354307 h 2355494"/>
              <a:gd name="connsiteX74" fmla="*/ 267 w 2865944"/>
              <a:gd name="connsiteY74" fmla="*/ 2309857 h 2355494"/>
              <a:gd name="connsiteX75" fmla="*/ 228867 w 2865944"/>
              <a:gd name="connsiteY75" fmla="*/ 2335257 h 2355494"/>
              <a:gd name="connsiteX76" fmla="*/ 489217 w 2865944"/>
              <a:gd name="connsiteY76" fmla="*/ 2240007 h 2355494"/>
              <a:gd name="connsiteX77" fmla="*/ 622567 w 2865944"/>
              <a:gd name="connsiteY77" fmla="*/ 2036807 h 2355494"/>
              <a:gd name="connsiteX78" fmla="*/ 673367 w 2865944"/>
              <a:gd name="connsiteY78" fmla="*/ 1808207 h 2355494"/>
              <a:gd name="connsiteX79" fmla="*/ 273317 w 2865944"/>
              <a:gd name="connsiteY79" fmla="*/ 2125707 h 2355494"/>
              <a:gd name="connsiteX80" fmla="*/ 114567 w 2865944"/>
              <a:gd name="connsiteY80" fmla="*/ 2132057 h 2355494"/>
              <a:gd name="connsiteX81" fmla="*/ 222517 w 2865944"/>
              <a:gd name="connsiteY81" fmla="*/ 2119357 h 2355494"/>
              <a:gd name="connsiteX82" fmla="*/ 393967 w 2865944"/>
              <a:gd name="connsiteY82" fmla="*/ 1998707 h 2355494"/>
              <a:gd name="connsiteX83" fmla="*/ 552717 w 2865944"/>
              <a:gd name="connsiteY83" fmla="*/ 1855832 h 2355494"/>
              <a:gd name="connsiteX84" fmla="*/ 819417 w 2865944"/>
              <a:gd name="connsiteY84" fmla="*/ 1636757 h 2355494"/>
              <a:gd name="connsiteX85" fmla="*/ 901967 w 2865944"/>
              <a:gd name="connsiteY85" fmla="*/ 1306557 h 2355494"/>
              <a:gd name="connsiteX86" fmla="*/ 641617 w 2865944"/>
              <a:gd name="connsiteY86" fmla="*/ 1179557 h 2355494"/>
              <a:gd name="connsiteX87" fmla="*/ 482867 w 2865944"/>
              <a:gd name="connsiteY87" fmla="*/ 1090657 h 2355494"/>
              <a:gd name="connsiteX88" fmla="*/ 717817 w 2865944"/>
              <a:gd name="connsiteY88" fmla="*/ 1173207 h 2355494"/>
              <a:gd name="connsiteX89" fmla="*/ 692417 w 2865944"/>
              <a:gd name="connsiteY89" fmla="*/ 950957 h 2355494"/>
              <a:gd name="connsiteX90" fmla="*/ 584467 w 2865944"/>
              <a:gd name="connsiteY90" fmla="*/ 830307 h 2355494"/>
              <a:gd name="connsiteX91" fmla="*/ 711467 w 2865944"/>
              <a:gd name="connsiteY91" fmla="*/ 931907 h 2355494"/>
              <a:gd name="connsiteX92" fmla="*/ 749567 w 2865944"/>
              <a:gd name="connsiteY92" fmla="*/ 1109707 h 2355494"/>
              <a:gd name="connsiteX93" fmla="*/ 781317 w 2865944"/>
              <a:gd name="connsiteY93" fmla="*/ 1058907 h 2355494"/>
              <a:gd name="connsiteX94" fmla="*/ 800367 w 2865944"/>
              <a:gd name="connsiteY94" fmla="*/ 912857 h 2355494"/>
              <a:gd name="connsiteX95" fmla="*/ 724167 w 2865944"/>
              <a:gd name="connsiteY95" fmla="*/ 722357 h 2355494"/>
              <a:gd name="connsiteX96" fmla="*/ 813067 w 2865944"/>
              <a:gd name="connsiteY96" fmla="*/ 862057 h 2355494"/>
              <a:gd name="connsiteX97" fmla="*/ 806717 w 2865944"/>
              <a:gd name="connsiteY97" fmla="*/ 1033507 h 2355494"/>
              <a:gd name="connsiteX98" fmla="*/ 813067 w 2865944"/>
              <a:gd name="connsiteY98" fmla="*/ 1204957 h 2355494"/>
              <a:gd name="connsiteX99" fmla="*/ 940067 w 2865944"/>
              <a:gd name="connsiteY99" fmla="*/ 1312907 h 2355494"/>
              <a:gd name="connsiteX100" fmla="*/ 1016267 w 2865944"/>
              <a:gd name="connsiteY100" fmla="*/ 1046207 h 2355494"/>
              <a:gd name="connsiteX101" fmla="*/ 1009917 w 2865944"/>
              <a:gd name="connsiteY101" fmla="*/ 1198607 h 2355494"/>
              <a:gd name="connsiteX102" fmla="*/ 1009917 w 2865944"/>
              <a:gd name="connsiteY102" fmla="*/ 1287507 h 2355494"/>
              <a:gd name="connsiteX103" fmla="*/ 1130567 w 2865944"/>
              <a:gd name="connsiteY103" fmla="*/ 1274807 h 2355494"/>
              <a:gd name="connsiteX104" fmla="*/ 1263917 w 2865944"/>
              <a:gd name="connsiteY104" fmla="*/ 1046207 h 2355494"/>
              <a:gd name="connsiteX105" fmla="*/ 1302017 w 2865944"/>
              <a:gd name="connsiteY105" fmla="*/ 665207 h 2355494"/>
              <a:gd name="connsiteX106" fmla="*/ 1263123 w 2865944"/>
              <a:gd name="connsiteY106" fmla="*/ 519157 h 2355494"/>
              <a:gd name="connsiteX107" fmla="*/ 1042026 w 2865944"/>
              <a:gd name="connsiteY107" fmla="*/ 455155 h 2355494"/>
              <a:gd name="connsiteX108" fmla="*/ 909905 w 2865944"/>
              <a:gd name="connsiteY108" fmla="*/ 436607 h 2355494"/>
              <a:gd name="connsiteX0" fmla="*/ 909905 w 2866309"/>
              <a:gd name="connsiteY0" fmla="*/ 436607 h 2355494"/>
              <a:gd name="connsiteX1" fmla="*/ 1219467 w 2866309"/>
              <a:gd name="connsiteY1" fmla="*/ 474707 h 2355494"/>
              <a:gd name="connsiteX2" fmla="*/ 1282967 w 2866309"/>
              <a:gd name="connsiteY2" fmla="*/ 487407 h 2355494"/>
              <a:gd name="connsiteX3" fmla="*/ 1308367 w 2866309"/>
              <a:gd name="connsiteY3" fmla="*/ 442957 h 2355494"/>
              <a:gd name="connsiteX4" fmla="*/ 1289317 w 2866309"/>
              <a:gd name="connsiteY4" fmla="*/ 322307 h 2355494"/>
              <a:gd name="connsiteX5" fmla="*/ 1333767 w 2866309"/>
              <a:gd name="connsiteY5" fmla="*/ 208007 h 2355494"/>
              <a:gd name="connsiteX6" fmla="*/ 1308367 w 2866309"/>
              <a:gd name="connsiteY6" fmla="*/ 335007 h 2355494"/>
              <a:gd name="connsiteX7" fmla="*/ 1333767 w 2866309"/>
              <a:gd name="connsiteY7" fmla="*/ 417557 h 2355494"/>
              <a:gd name="connsiteX8" fmla="*/ 1384567 w 2866309"/>
              <a:gd name="connsiteY8" fmla="*/ 296907 h 2355494"/>
              <a:gd name="connsiteX9" fmla="*/ 1340117 w 2866309"/>
              <a:gd name="connsiteY9" fmla="*/ 468357 h 2355494"/>
              <a:gd name="connsiteX10" fmla="*/ 1341704 w 2866309"/>
              <a:gd name="connsiteY10" fmla="*/ 504869 h 2355494"/>
              <a:gd name="connsiteX11" fmla="*/ 1359167 w 2866309"/>
              <a:gd name="connsiteY11" fmla="*/ 817607 h 2355494"/>
              <a:gd name="connsiteX12" fmla="*/ 1429017 w 2866309"/>
              <a:gd name="connsiteY12" fmla="*/ 1020807 h 2355494"/>
              <a:gd name="connsiteX13" fmla="*/ 1689367 w 2866309"/>
              <a:gd name="connsiteY13" fmla="*/ 868407 h 2355494"/>
              <a:gd name="connsiteX14" fmla="*/ 1689367 w 2866309"/>
              <a:gd name="connsiteY14" fmla="*/ 487407 h 2355494"/>
              <a:gd name="connsiteX15" fmla="*/ 1740167 w 2866309"/>
              <a:gd name="connsiteY15" fmla="*/ 277857 h 2355494"/>
              <a:gd name="connsiteX16" fmla="*/ 1822717 w 2866309"/>
              <a:gd name="connsiteY16" fmla="*/ 119107 h 2355494"/>
              <a:gd name="connsiteX17" fmla="*/ 1733817 w 2866309"/>
              <a:gd name="connsiteY17" fmla="*/ 379457 h 2355494"/>
              <a:gd name="connsiteX18" fmla="*/ 1835417 w 2866309"/>
              <a:gd name="connsiteY18" fmla="*/ 373107 h 2355494"/>
              <a:gd name="connsiteX19" fmla="*/ 1917967 w 2866309"/>
              <a:gd name="connsiteY19" fmla="*/ 188957 h 2355494"/>
              <a:gd name="connsiteX20" fmla="*/ 1836687 w 2866309"/>
              <a:gd name="connsiteY20" fmla="*/ 399142 h 2355494"/>
              <a:gd name="connsiteX21" fmla="*/ 1721117 w 2866309"/>
              <a:gd name="connsiteY21" fmla="*/ 455657 h 2355494"/>
              <a:gd name="connsiteX22" fmla="*/ 1733817 w 2866309"/>
              <a:gd name="connsiteY22" fmla="*/ 646157 h 2355494"/>
              <a:gd name="connsiteX23" fmla="*/ 1937017 w 2866309"/>
              <a:gd name="connsiteY23" fmla="*/ 544557 h 2355494"/>
              <a:gd name="connsiteX24" fmla="*/ 1968767 w 2866309"/>
              <a:gd name="connsiteY24" fmla="*/ 119107 h 2355494"/>
              <a:gd name="connsiteX25" fmla="*/ 1981467 w 2866309"/>
              <a:gd name="connsiteY25" fmla="*/ 11157 h 2355494"/>
              <a:gd name="connsiteX26" fmla="*/ 1994167 w 2866309"/>
              <a:gd name="connsiteY26" fmla="*/ 335007 h 2355494"/>
              <a:gd name="connsiteX27" fmla="*/ 1968767 w 2866309"/>
              <a:gd name="connsiteY27" fmla="*/ 589007 h 2355494"/>
              <a:gd name="connsiteX28" fmla="*/ 1860817 w 2866309"/>
              <a:gd name="connsiteY28" fmla="*/ 665207 h 2355494"/>
              <a:gd name="connsiteX29" fmla="*/ 2057667 w 2866309"/>
              <a:gd name="connsiteY29" fmla="*/ 696957 h 2355494"/>
              <a:gd name="connsiteX30" fmla="*/ 2229117 w 2866309"/>
              <a:gd name="connsiteY30" fmla="*/ 652507 h 2355494"/>
              <a:gd name="connsiteX31" fmla="*/ 2089417 w 2866309"/>
              <a:gd name="connsiteY31" fmla="*/ 735057 h 2355494"/>
              <a:gd name="connsiteX32" fmla="*/ 1879867 w 2866309"/>
              <a:gd name="connsiteY32" fmla="*/ 722357 h 2355494"/>
              <a:gd name="connsiteX33" fmla="*/ 1784617 w 2866309"/>
              <a:gd name="connsiteY33" fmla="*/ 703307 h 2355494"/>
              <a:gd name="connsiteX34" fmla="*/ 1733817 w 2866309"/>
              <a:gd name="connsiteY34" fmla="*/ 868407 h 2355494"/>
              <a:gd name="connsiteX35" fmla="*/ 1575067 w 2866309"/>
              <a:gd name="connsiteY35" fmla="*/ 1052557 h 2355494"/>
              <a:gd name="connsiteX36" fmla="*/ 1536967 w 2866309"/>
              <a:gd name="connsiteY36" fmla="*/ 1306557 h 2355494"/>
              <a:gd name="connsiteX37" fmla="*/ 1829067 w 2866309"/>
              <a:gd name="connsiteY37" fmla="*/ 1351007 h 2355494"/>
              <a:gd name="connsiteX38" fmla="*/ 2140217 w 2866309"/>
              <a:gd name="connsiteY38" fmla="*/ 1071607 h 2355494"/>
              <a:gd name="connsiteX39" fmla="*/ 2165617 w 2866309"/>
              <a:gd name="connsiteY39" fmla="*/ 909682 h 2355494"/>
              <a:gd name="connsiteX40" fmla="*/ 2171967 w 2866309"/>
              <a:gd name="connsiteY40" fmla="*/ 792207 h 2355494"/>
              <a:gd name="connsiteX41" fmla="*/ 2191017 w 2866309"/>
              <a:gd name="connsiteY41" fmla="*/ 992232 h 2355494"/>
              <a:gd name="connsiteX42" fmla="*/ 2144185 w 2866309"/>
              <a:gd name="connsiteY42" fmla="*/ 1101769 h 2355494"/>
              <a:gd name="connsiteX43" fmla="*/ 1962417 w 2866309"/>
              <a:gd name="connsiteY43" fmla="*/ 1300207 h 2355494"/>
              <a:gd name="connsiteX44" fmla="*/ 2292617 w 2866309"/>
              <a:gd name="connsiteY44" fmla="*/ 1185907 h 2355494"/>
              <a:gd name="connsiteX45" fmla="*/ 2324367 w 2866309"/>
              <a:gd name="connsiteY45" fmla="*/ 735057 h 2355494"/>
              <a:gd name="connsiteX46" fmla="*/ 2352942 w 2866309"/>
              <a:gd name="connsiteY46" fmla="*/ 1016044 h 2355494"/>
              <a:gd name="connsiteX47" fmla="*/ 2349767 w 2866309"/>
              <a:gd name="connsiteY47" fmla="*/ 1131932 h 2355494"/>
              <a:gd name="connsiteX48" fmla="*/ 2540267 w 2866309"/>
              <a:gd name="connsiteY48" fmla="*/ 627107 h 2355494"/>
              <a:gd name="connsiteX49" fmla="*/ 2864117 w 2866309"/>
              <a:gd name="connsiteY49" fmla="*/ 411207 h 2355494"/>
              <a:gd name="connsiteX50" fmla="*/ 2676792 w 2866309"/>
              <a:gd name="connsiteY50" fmla="*/ 527094 h 2355494"/>
              <a:gd name="connsiteX51" fmla="*/ 2568048 w 2866309"/>
              <a:gd name="connsiteY51" fmla="*/ 628695 h 2355494"/>
              <a:gd name="connsiteX52" fmla="*/ 2517772 w 2866309"/>
              <a:gd name="connsiteY52" fmla="*/ 714771 h 2355494"/>
              <a:gd name="connsiteX53" fmla="*/ 2500580 w 2866309"/>
              <a:gd name="connsiteY53" fmla="*/ 748551 h 2355494"/>
              <a:gd name="connsiteX54" fmla="*/ 2450573 w 2866309"/>
              <a:gd name="connsiteY54" fmla="*/ 943019 h 2355494"/>
              <a:gd name="connsiteX55" fmla="*/ 2673617 w 2866309"/>
              <a:gd name="connsiteY55" fmla="*/ 766807 h 2355494"/>
              <a:gd name="connsiteX56" fmla="*/ 2711717 w 2866309"/>
              <a:gd name="connsiteY56" fmla="*/ 639807 h 2355494"/>
              <a:gd name="connsiteX57" fmla="*/ 2676792 w 2866309"/>
              <a:gd name="connsiteY57" fmla="*/ 782682 h 2355494"/>
              <a:gd name="connsiteX58" fmla="*/ 2495817 w 2866309"/>
              <a:gd name="connsiteY58" fmla="*/ 944607 h 2355494"/>
              <a:gd name="connsiteX59" fmla="*/ 2413267 w 2866309"/>
              <a:gd name="connsiteY59" fmla="*/ 1100182 h 2355494"/>
              <a:gd name="connsiteX60" fmla="*/ 2320128 w 2866309"/>
              <a:gd name="connsiteY60" fmla="*/ 1214833 h 2355494"/>
              <a:gd name="connsiteX61" fmla="*/ 2265312 w 2866309"/>
              <a:gd name="connsiteY61" fmla="*/ 1243692 h 2355494"/>
              <a:gd name="connsiteX62" fmla="*/ 2022742 w 2866309"/>
              <a:gd name="connsiteY62" fmla="*/ 1347832 h 2355494"/>
              <a:gd name="connsiteX63" fmla="*/ 1854467 w 2866309"/>
              <a:gd name="connsiteY63" fmla="*/ 1401807 h 2355494"/>
              <a:gd name="connsiteX64" fmla="*/ 1581417 w 2866309"/>
              <a:gd name="connsiteY64" fmla="*/ 1458957 h 2355494"/>
              <a:gd name="connsiteX65" fmla="*/ 1340117 w 2866309"/>
              <a:gd name="connsiteY65" fmla="*/ 1611357 h 2355494"/>
              <a:gd name="connsiteX66" fmla="*/ 1378217 w 2866309"/>
              <a:gd name="connsiteY66" fmla="*/ 1782807 h 2355494"/>
              <a:gd name="connsiteX67" fmla="*/ 1803667 w 2866309"/>
              <a:gd name="connsiteY67" fmla="*/ 2036807 h 2355494"/>
              <a:gd name="connsiteX68" fmla="*/ 1416317 w 2866309"/>
              <a:gd name="connsiteY68" fmla="*/ 1859007 h 2355494"/>
              <a:gd name="connsiteX69" fmla="*/ 1225817 w 2866309"/>
              <a:gd name="connsiteY69" fmla="*/ 1687557 h 2355494"/>
              <a:gd name="connsiteX70" fmla="*/ 924192 w 2866309"/>
              <a:gd name="connsiteY70" fmla="*/ 1681207 h 2355494"/>
              <a:gd name="connsiteX71" fmla="*/ 705117 w 2866309"/>
              <a:gd name="connsiteY71" fmla="*/ 1973307 h 2355494"/>
              <a:gd name="connsiteX72" fmla="*/ 533667 w 2866309"/>
              <a:gd name="connsiteY72" fmla="*/ 2252707 h 2355494"/>
              <a:gd name="connsiteX73" fmla="*/ 190767 w 2866309"/>
              <a:gd name="connsiteY73" fmla="*/ 2354307 h 2355494"/>
              <a:gd name="connsiteX74" fmla="*/ 267 w 2866309"/>
              <a:gd name="connsiteY74" fmla="*/ 2309857 h 2355494"/>
              <a:gd name="connsiteX75" fmla="*/ 228867 w 2866309"/>
              <a:gd name="connsiteY75" fmla="*/ 2335257 h 2355494"/>
              <a:gd name="connsiteX76" fmla="*/ 489217 w 2866309"/>
              <a:gd name="connsiteY76" fmla="*/ 2240007 h 2355494"/>
              <a:gd name="connsiteX77" fmla="*/ 622567 w 2866309"/>
              <a:gd name="connsiteY77" fmla="*/ 2036807 h 2355494"/>
              <a:gd name="connsiteX78" fmla="*/ 673367 w 2866309"/>
              <a:gd name="connsiteY78" fmla="*/ 1808207 h 2355494"/>
              <a:gd name="connsiteX79" fmla="*/ 273317 w 2866309"/>
              <a:gd name="connsiteY79" fmla="*/ 2125707 h 2355494"/>
              <a:gd name="connsiteX80" fmla="*/ 114567 w 2866309"/>
              <a:gd name="connsiteY80" fmla="*/ 2132057 h 2355494"/>
              <a:gd name="connsiteX81" fmla="*/ 222517 w 2866309"/>
              <a:gd name="connsiteY81" fmla="*/ 2119357 h 2355494"/>
              <a:gd name="connsiteX82" fmla="*/ 393967 w 2866309"/>
              <a:gd name="connsiteY82" fmla="*/ 1998707 h 2355494"/>
              <a:gd name="connsiteX83" fmla="*/ 552717 w 2866309"/>
              <a:gd name="connsiteY83" fmla="*/ 1855832 h 2355494"/>
              <a:gd name="connsiteX84" fmla="*/ 819417 w 2866309"/>
              <a:gd name="connsiteY84" fmla="*/ 1636757 h 2355494"/>
              <a:gd name="connsiteX85" fmla="*/ 901967 w 2866309"/>
              <a:gd name="connsiteY85" fmla="*/ 1306557 h 2355494"/>
              <a:gd name="connsiteX86" fmla="*/ 641617 w 2866309"/>
              <a:gd name="connsiteY86" fmla="*/ 1179557 h 2355494"/>
              <a:gd name="connsiteX87" fmla="*/ 482867 w 2866309"/>
              <a:gd name="connsiteY87" fmla="*/ 1090657 h 2355494"/>
              <a:gd name="connsiteX88" fmla="*/ 717817 w 2866309"/>
              <a:gd name="connsiteY88" fmla="*/ 1173207 h 2355494"/>
              <a:gd name="connsiteX89" fmla="*/ 692417 w 2866309"/>
              <a:gd name="connsiteY89" fmla="*/ 950957 h 2355494"/>
              <a:gd name="connsiteX90" fmla="*/ 584467 w 2866309"/>
              <a:gd name="connsiteY90" fmla="*/ 830307 h 2355494"/>
              <a:gd name="connsiteX91" fmla="*/ 711467 w 2866309"/>
              <a:gd name="connsiteY91" fmla="*/ 931907 h 2355494"/>
              <a:gd name="connsiteX92" fmla="*/ 749567 w 2866309"/>
              <a:gd name="connsiteY92" fmla="*/ 1109707 h 2355494"/>
              <a:gd name="connsiteX93" fmla="*/ 781317 w 2866309"/>
              <a:gd name="connsiteY93" fmla="*/ 1058907 h 2355494"/>
              <a:gd name="connsiteX94" fmla="*/ 800367 w 2866309"/>
              <a:gd name="connsiteY94" fmla="*/ 912857 h 2355494"/>
              <a:gd name="connsiteX95" fmla="*/ 724167 w 2866309"/>
              <a:gd name="connsiteY95" fmla="*/ 722357 h 2355494"/>
              <a:gd name="connsiteX96" fmla="*/ 813067 w 2866309"/>
              <a:gd name="connsiteY96" fmla="*/ 862057 h 2355494"/>
              <a:gd name="connsiteX97" fmla="*/ 806717 w 2866309"/>
              <a:gd name="connsiteY97" fmla="*/ 1033507 h 2355494"/>
              <a:gd name="connsiteX98" fmla="*/ 813067 w 2866309"/>
              <a:gd name="connsiteY98" fmla="*/ 1204957 h 2355494"/>
              <a:gd name="connsiteX99" fmla="*/ 940067 w 2866309"/>
              <a:gd name="connsiteY99" fmla="*/ 1312907 h 2355494"/>
              <a:gd name="connsiteX100" fmla="*/ 1016267 w 2866309"/>
              <a:gd name="connsiteY100" fmla="*/ 1046207 h 2355494"/>
              <a:gd name="connsiteX101" fmla="*/ 1009917 w 2866309"/>
              <a:gd name="connsiteY101" fmla="*/ 1198607 h 2355494"/>
              <a:gd name="connsiteX102" fmla="*/ 1009917 w 2866309"/>
              <a:gd name="connsiteY102" fmla="*/ 1287507 h 2355494"/>
              <a:gd name="connsiteX103" fmla="*/ 1130567 w 2866309"/>
              <a:gd name="connsiteY103" fmla="*/ 1274807 h 2355494"/>
              <a:gd name="connsiteX104" fmla="*/ 1263917 w 2866309"/>
              <a:gd name="connsiteY104" fmla="*/ 1046207 h 2355494"/>
              <a:gd name="connsiteX105" fmla="*/ 1302017 w 2866309"/>
              <a:gd name="connsiteY105" fmla="*/ 665207 h 2355494"/>
              <a:gd name="connsiteX106" fmla="*/ 1263123 w 2866309"/>
              <a:gd name="connsiteY106" fmla="*/ 519157 h 2355494"/>
              <a:gd name="connsiteX107" fmla="*/ 1042026 w 2866309"/>
              <a:gd name="connsiteY107" fmla="*/ 455155 h 2355494"/>
              <a:gd name="connsiteX108" fmla="*/ 909905 w 2866309"/>
              <a:gd name="connsiteY108" fmla="*/ 436607 h 2355494"/>
              <a:gd name="connsiteX0" fmla="*/ 909905 w 2866309"/>
              <a:gd name="connsiteY0" fmla="*/ 436607 h 2355494"/>
              <a:gd name="connsiteX1" fmla="*/ 1219467 w 2866309"/>
              <a:gd name="connsiteY1" fmla="*/ 474707 h 2355494"/>
              <a:gd name="connsiteX2" fmla="*/ 1282967 w 2866309"/>
              <a:gd name="connsiteY2" fmla="*/ 487407 h 2355494"/>
              <a:gd name="connsiteX3" fmla="*/ 1308367 w 2866309"/>
              <a:gd name="connsiteY3" fmla="*/ 442957 h 2355494"/>
              <a:gd name="connsiteX4" fmla="*/ 1289317 w 2866309"/>
              <a:gd name="connsiteY4" fmla="*/ 322307 h 2355494"/>
              <a:gd name="connsiteX5" fmla="*/ 1333767 w 2866309"/>
              <a:gd name="connsiteY5" fmla="*/ 208007 h 2355494"/>
              <a:gd name="connsiteX6" fmla="*/ 1308367 w 2866309"/>
              <a:gd name="connsiteY6" fmla="*/ 335007 h 2355494"/>
              <a:gd name="connsiteX7" fmla="*/ 1333767 w 2866309"/>
              <a:gd name="connsiteY7" fmla="*/ 417557 h 2355494"/>
              <a:gd name="connsiteX8" fmla="*/ 1384567 w 2866309"/>
              <a:gd name="connsiteY8" fmla="*/ 296907 h 2355494"/>
              <a:gd name="connsiteX9" fmla="*/ 1340117 w 2866309"/>
              <a:gd name="connsiteY9" fmla="*/ 468357 h 2355494"/>
              <a:gd name="connsiteX10" fmla="*/ 1341704 w 2866309"/>
              <a:gd name="connsiteY10" fmla="*/ 504869 h 2355494"/>
              <a:gd name="connsiteX11" fmla="*/ 1359167 w 2866309"/>
              <a:gd name="connsiteY11" fmla="*/ 817607 h 2355494"/>
              <a:gd name="connsiteX12" fmla="*/ 1429017 w 2866309"/>
              <a:gd name="connsiteY12" fmla="*/ 1020807 h 2355494"/>
              <a:gd name="connsiteX13" fmla="*/ 1689367 w 2866309"/>
              <a:gd name="connsiteY13" fmla="*/ 868407 h 2355494"/>
              <a:gd name="connsiteX14" fmla="*/ 1689367 w 2866309"/>
              <a:gd name="connsiteY14" fmla="*/ 487407 h 2355494"/>
              <a:gd name="connsiteX15" fmla="*/ 1740167 w 2866309"/>
              <a:gd name="connsiteY15" fmla="*/ 277857 h 2355494"/>
              <a:gd name="connsiteX16" fmla="*/ 1822717 w 2866309"/>
              <a:gd name="connsiteY16" fmla="*/ 119107 h 2355494"/>
              <a:gd name="connsiteX17" fmla="*/ 1733817 w 2866309"/>
              <a:gd name="connsiteY17" fmla="*/ 379457 h 2355494"/>
              <a:gd name="connsiteX18" fmla="*/ 1835417 w 2866309"/>
              <a:gd name="connsiteY18" fmla="*/ 373107 h 2355494"/>
              <a:gd name="connsiteX19" fmla="*/ 1917967 w 2866309"/>
              <a:gd name="connsiteY19" fmla="*/ 188957 h 2355494"/>
              <a:gd name="connsiteX20" fmla="*/ 1836687 w 2866309"/>
              <a:gd name="connsiteY20" fmla="*/ 399142 h 2355494"/>
              <a:gd name="connsiteX21" fmla="*/ 1721117 w 2866309"/>
              <a:gd name="connsiteY21" fmla="*/ 455657 h 2355494"/>
              <a:gd name="connsiteX22" fmla="*/ 1733817 w 2866309"/>
              <a:gd name="connsiteY22" fmla="*/ 646157 h 2355494"/>
              <a:gd name="connsiteX23" fmla="*/ 1937017 w 2866309"/>
              <a:gd name="connsiteY23" fmla="*/ 544557 h 2355494"/>
              <a:gd name="connsiteX24" fmla="*/ 1968767 w 2866309"/>
              <a:gd name="connsiteY24" fmla="*/ 119107 h 2355494"/>
              <a:gd name="connsiteX25" fmla="*/ 1981467 w 2866309"/>
              <a:gd name="connsiteY25" fmla="*/ 11157 h 2355494"/>
              <a:gd name="connsiteX26" fmla="*/ 1994167 w 2866309"/>
              <a:gd name="connsiteY26" fmla="*/ 335007 h 2355494"/>
              <a:gd name="connsiteX27" fmla="*/ 1968767 w 2866309"/>
              <a:gd name="connsiteY27" fmla="*/ 589007 h 2355494"/>
              <a:gd name="connsiteX28" fmla="*/ 1860817 w 2866309"/>
              <a:gd name="connsiteY28" fmla="*/ 665207 h 2355494"/>
              <a:gd name="connsiteX29" fmla="*/ 2057667 w 2866309"/>
              <a:gd name="connsiteY29" fmla="*/ 696957 h 2355494"/>
              <a:gd name="connsiteX30" fmla="*/ 2096291 w 2866309"/>
              <a:gd name="connsiteY30" fmla="*/ 702864 h 2355494"/>
              <a:gd name="connsiteX31" fmla="*/ 2229117 w 2866309"/>
              <a:gd name="connsiteY31" fmla="*/ 652507 h 2355494"/>
              <a:gd name="connsiteX32" fmla="*/ 2089417 w 2866309"/>
              <a:gd name="connsiteY32" fmla="*/ 735057 h 2355494"/>
              <a:gd name="connsiteX33" fmla="*/ 1879867 w 2866309"/>
              <a:gd name="connsiteY33" fmla="*/ 722357 h 2355494"/>
              <a:gd name="connsiteX34" fmla="*/ 1784617 w 2866309"/>
              <a:gd name="connsiteY34" fmla="*/ 703307 h 2355494"/>
              <a:gd name="connsiteX35" fmla="*/ 1733817 w 2866309"/>
              <a:gd name="connsiteY35" fmla="*/ 868407 h 2355494"/>
              <a:gd name="connsiteX36" fmla="*/ 1575067 w 2866309"/>
              <a:gd name="connsiteY36" fmla="*/ 1052557 h 2355494"/>
              <a:gd name="connsiteX37" fmla="*/ 1536967 w 2866309"/>
              <a:gd name="connsiteY37" fmla="*/ 1306557 h 2355494"/>
              <a:gd name="connsiteX38" fmla="*/ 1829067 w 2866309"/>
              <a:gd name="connsiteY38" fmla="*/ 1351007 h 2355494"/>
              <a:gd name="connsiteX39" fmla="*/ 2140217 w 2866309"/>
              <a:gd name="connsiteY39" fmla="*/ 1071607 h 2355494"/>
              <a:gd name="connsiteX40" fmla="*/ 2165617 w 2866309"/>
              <a:gd name="connsiteY40" fmla="*/ 909682 h 2355494"/>
              <a:gd name="connsiteX41" fmla="*/ 2171967 w 2866309"/>
              <a:gd name="connsiteY41" fmla="*/ 792207 h 2355494"/>
              <a:gd name="connsiteX42" fmla="*/ 2191017 w 2866309"/>
              <a:gd name="connsiteY42" fmla="*/ 992232 h 2355494"/>
              <a:gd name="connsiteX43" fmla="*/ 2144185 w 2866309"/>
              <a:gd name="connsiteY43" fmla="*/ 1101769 h 2355494"/>
              <a:gd name="connsiteX44" fmla="*/ 1962417 w 2866309"/>
              <a:gd name="connsiteY44" fmla="*/ 1300207 h 2355494"/>
              <a:gd name="connsiteX45" fmla="*/ 2292617 w 2866309"/>
              <a:gd name="connsiteY45" fmla="*/ 1185907 h 2355494"/>
              <a:gd name="connsiteX46" fmla="*/ 2324367 w 2866309"/>
              <a:gd name="connsiteY46" fmla="*/ 735057 h 2355494"/>
              <a:gd name="connsiteX47" fmla="*/ 2352942 w 2866309"/>
              <a:gd name="connsiteY47" fmla="*/ 1016044 h 2355494"/>
              <a:gd name="connsiteX48" fmla="*/ 2349767 w 2866309"/>
              <a:gd name="connsiteY48" fmla="*/ 1131932 h 2355494"/>
              <a:gd name="connsiteX49" fmla="*/ 2540267 w 2866309"/>
              <a:gd name="connsiteY49" fmla="*/ 627107 h 2355494"/>
              <a:gd name="connsiteX50" fmla="*/ 2864117 w 2866309"/>
              <a:gd name="connsiteY50" fmla="*/ 411207 h 2355494"/>
              <a:gd name="connsiteX51" fmla="*/ 2676792 w 2866309"/>
              <a:gd name="connsiteY51" fmla="*/ 527094 h 2355494"/>
              <a:gd name="connsiteX52" fmla="*/ 2568048 w 2866309"/>
              <a:gd name="connsiteY52" fmla="*/ 628695 h 2355494"/>
              <a:gd name="connsiteX53" fmla="*/ 2517772 w 2866309"/>
              <a:gd name="connsiteY53" fmla="*/ 714771 h 2355494"/>
              <a:gd name="connsiteX54" fmla="*/ 2500580 w 2866309"/>
              <a:gd name="connsiteY54" fmla="*/ 748551 h 2355494"/>
              <a:gd name="connsiteX55" fmla="*/ 2450573 w 2866309"/>
              <a:gd name="connsiteY55" fmla="*/ 943019 h 2355494"/>
              <a:gd name="connsiteX56" fmla="*/ 2673617 w 2866309"/>
              <a:gd name="connsiteY56" fmla="*/ 766807 h 2355494"/>
              <a:gd name="connsiteX57" fmla="*/ 2711717 w 2866309"/>
              <a:gd name="connsiteY57" fmla="*/ 639807 h 2355494"/>
              <a:gd name="connsiteX58" fmla="*/ 2676792 w 2866309"/>
              <a:gd name="connsiteY58" fmla="*/ 782682 h 2355494"/>
              <a:gd name="connsiteX59" fmla="*/ 2495817 w 2866309"/>
              <a:gd name="connsiteY59" fmla="*/ 944607 h 2355494"/>
              <a:gd name="connsiteX60" fmla="*/ 2413267 w 2866309"/>
              <a:gd name="connsiteY60" fmla="*/ 1100182 h 2355494"/>
              <a:gd name="connsiteX61" fmla="*/ 2320128 w 2866309"/>
              <a:gd name="connsiteY61" fmla="*/ 1214833 h 2355494"/>
              <a:gd name="connsiteX62" fmla="*/ 2265312 w 2866309"/>
              <a:gd name="connsiteY62" fmla="*/ 1243692 h 2355494"/>
              <a:gd name="connsiteX63" fmla="*/ 2022742 w 2866309"/>
              <a:gd name="connsiteY63" fmla="*/ 1347832 h 2355494"/>
              <a:gd name="connsiteX64" fmla="*/ 1854467 w 2866309"/>
              <a:gd name="connsiteY64" fmla="*/ 1401807 h 2355494"/>
              <a:gd name="connsiteX65" fmla="*/ 1581417 w 2866309"/>
              <a:gd name="connsiteY65" fmla="*/ 1458957 h 2355494"/>
              <a:gd name="connsiteX66" fmla="*/ 1340117 w 2866309"/>
              <a:gd name="connsiteY66" fmla="*/ 1611357 h 2355494"/>
              <a:gd name="connsiteX67" fmla="*/ 1378217 w 2866309"/>
              <a:gd name="connsiteY67" fmla="*/ 1782807 h 2355494"/>
              <a:gd name="connsiteX68" fmla="*/ 1803667 w 2866309"/>
              <a:gd name="connsiteY68" fmla="*/ 2036807 h 2355494"/>
              <a:gd name="connsiteX69" fmla="*/ 1416317 w 2866309"/>
              <a:gd name="connsiteY69" fmla="*/ 1859007 h 2355494"/>
              <a:gd name="connsiteX70" fmla="*/ 1225817 w 2866309"/>
              <a:gd name="connsiteY70" fmla="*/ 1687557 h 2355494"/>
              <a:gd name="connsiteX71" fmla="*/ 924192 w 2866309"/>
              <a:gd name="connsiteY71" fmla="*/ 1681207 h 2355494"/>
              <a:gd name="connsiteX72" fmla="*/ 705117 w 2866309"/>
              <a:gd name="connsiteY72" fmla="*/ 1973307 h 2355494"/>
              <a:gd name="connsiteX73" fmla="*/ 533667 w 2866309"/>
              <a:gd name="connsiteY73" fmla="*/ 2252707 h 2355494"/>
              <a:gd name="connsiteX74" fmla="*/ 190767 w 2866309"/>
              <a:gd name="connsiteY74" fmla="*/ 2354307 h 2355494"/>
              <a:gd name="connsiteX75" fmla="*/ 267 w 2866309"/>
              <a:gd name="connsiteY75" fmla="*/ 2309857 h 2355494"/>
              <a:gd name="connsiteX76" fmla="*/ 228867 w 2866309"/>
              <a:gd name="connsiteY76" fmla="*/ 2335257 h 2355494"/>
              <a:gd name="connsiteX77" fmla="*/ 489217 w 2866309"/>
              <a:gd name="connsiteY77" fmla="*/ 2240007 h 2355494"/>
              <a:gd name="connsiteX78" fmla="*/ 622567 w 2866309"/>
              <a:gd name="connsiteY78" fmla="*/ 2036807 h 2355494"/>
              <a:gd name="connsiteX79" fmla="*/ 673367 w 2866309"/>
              <a:gd name="connsiteY79" fmla="*/ 1808207 h 2355494"/>
              <a:gd name="connsiteX80" fmla="*/ 273317 w 2866309"/>
              <a:gd name="connsiteY80" fmla="*/ 2125707 h 2355494"/>
              <a:gd name="connsiteX81" fmla="*/ 114567 w 2866309"/>
              <a:gd name="connsiteY81" fmla="*/ 2132057 h 2355494"/>
              <a:gd name="connsiteX82" fmla="*/ 222517 w 2866309"/>
              <a:gd name="connsiteY82" fmla="*/ 2119357 h 2355494"/>
              <a:gd name="connsiteX83" fmla="*/ 393967 w 2866309"/>
              <a:gd name="connsiteY83" fmla="*/ 1998707 h 2355494"/>
              <a:gd name="connsiteX84" fmla="*/ 552717 w 2866309"/>
              <a:gd name="connsiteY84" fmla="*/ 1855832 h 2355494"/>
              <a:gd name="connsiteX85" fmla="*/ 819417 w 2866309"/>
              <a:gd name="connsiteY85" fmla="*/ 1636757 h 2355494"/>
              <a:gd name="connsiteX86" fmla="*/ 901967 w 2866309"/>
              <a:gd name="connsiteY86" fmla="*/ 1306557 h 2355494"/>
              <a:gd name="connsiteX87" fmla="*/ 641617 w 2866309"/>
              <a:gd name="connsiteY87" fmla="*/ 1179557 h 2355494"/>
              <a:gd name="connsiteX88" fmla="*/ 482867 w 2866309"/>
              <a:gd name="connsiteY88" fmla="*/ 1090657 h 2355494"/>
              <a:gd name="connsiteX89" fmla="*/ 717817 w 2866309"/>
              <a:gd name="connsiteY89" fmla="*/ 1173207 h 2355494"/>
              <a:gd name="connsiteX90" fmla="*/ 692417 w 2866309"/>
              <a:gd name="connsiteY90" fmla="*/ 950957 h 2355494"/>
              <a:gd name="connsiteX91" fmla="*/ 584467 w 2866309"/>
              <a:gd name="connsiteY91" fmla="*/ 830307 h 2355494"/>
              <a:gd name="connsiteX92" fmla="*/ 711467 w 2866309"/>
              <a:gd name="connsiteY92" fmla="*/ 931907 h 2355494"/>
              <a:gd name="connsiteX93" fmla="*/ 749567 w 2866309"/>
              <a:gd name="connsiteY93" fmla="*/ 1109707 h 2355494"/>
              <a:gd name="connsiteX94" fmla="*/ 781317 w 2866309"/>
              <a:gd name="connsiteY94" fmla="*/ 1058907 h 2355494"/>
              <a:gd name="connsiteX95" fmla="*/ 800367 w 2866309"/>
              <a:gd name="connsiteY95" fmla="*/ 912857 h 2355494"/>
              <a:gd name="connsiteX96" fmla="*/ 724167 w 2866309"/>
              <a:gd name="connsiteY96" fmla="*/ 722357 h 2355494"/>
              <a:gd name="connsiteX97" fmla="*/ 813067 w 2866309"/>
              <a:gd name="connsiteY97" fmla="*/ 862057 h 2355494"/>
              <a:gd name="connsiteX98" fmla="*/ 806717 w 2866309"/>
              <a:gd name="connsiteY98" fmla="*/ 1033507 h 2355494"/>
              <a:gd name="connsiteX99" fmla="*/ 813067 w 2866309"/>
              <a:gd name="connsiteY99" fmla="*/ 1204957 h 2355494"/>
              <a:gd name="connsiteX100" fmla="*/ 940067 w 2866309"/>
              <a:gd name="connsiteY100" fmla="*/ 1312907 h 2355494"/>
              <a:gd name="connsiteX101" fmla="*/ 1016267 w 2866309"/>
              <a:gd name="connsiteY101" fmla="*/ 1046207 h 2355494"/>
              <a:gd name="connsiteX102" fmla="*/ 1009917 w 2866309"/>
              <a:gd name="connsiteY102" fmla="*/ 1198607 h 2355494"/>
              <a:gd name="connsiteX103" fmla="*/ 1009917 w 2866309"/>
              <a:gd name="connsiteY103" fmla="*/ 1287507 h 2355494"/>
              <a:gd name="connsiteX104" fmla="*/ 1130567 w 2866309"/>
              <a:gd name="connsiteY104" fmla="*/ 1274807 h 2355494"/>
              <a:gd name="connsiteX105" fmla="*/ 1263917 w 2866309"/>
              <a:gd name="connsiteY105" fmla="*/ 1046207 h 2355494"/>
              <a:gd name="connsiteX106" fmla="*/ 1302017 w 2866309"/>
              <a:gd name="connsiteY106" fmla="*/ 665207 h 2355494"/>
              <a:gd name="connsiteX107" fmla="*/ 1263123 w 2866309"/>
              <a:gd name="connsiteY107" fmla="*/ 519157 h 2355494"/>
              <a:gd name="connsiteX108" fmla="*/ 1042026 w 2866309"/>
              <a:gd name="connsiteY108" fmla="*/ 455155 h 2355494"/>
              <a:gd name="connsiteX109" fmla="*/ 909905 w 2866309"/>
              <a:gd name="connsiteY109" fmla="*/ 436607 h 2355494"/>
              <a:gd name="connsiteX0" fmla="*/ 909905 w 2866309"/>
              <a:gd name="connsiteY0" fmla="*/ 436607 h 2355494"/>
              <a:gd name="connsiteX1" fmla="*/ 1219467 w 2866309"/>
              <a:gd name="connsiteY1" fmla="*/ 474707 h 2355494"/>
              <a:gd name="connsiteX2" fmla="*/ 1282967 w 2866309"/>
              <a:gd name="connsiteY2" fmla="*/ 487407 h 2355494"/>
              <a:gd name="connsiteX3" fmla="*/ 1308367 w 2866309"/>
              <a:gd name="connsiteY3" fmla="*/ 442957 h 2355494"/>
              <a:gd name="connsiteX4" fmla="*/ 1289317 w 2866309"/>
              <a:gd name="connsiteY4" fmla="*/ 322307 h 2355494"/>
              <a:gd name="connsiteX5" fmla="*/ 1333767 w 2866309"/>
              <a:gd name="connsiteY5" fmla="*/ 208007 h 2355494"/>
              <a:gd name="connsiteX6" fmla="*/ 1308367 w 2866309"/>
              <a:gd name="connsiteY6" fmla="*/ 335007 h 2355494"/>
              <a:gd name="connsiteX7" fmla="*/ 1333767 w 2866309"/>
              <a:gd name="connsiteY7" fmla="*/ 417557 h 2355494"/>
              <a:gd name="connsiteX8" fmla="*/ 1384567 w 2866309"/>
              <a:gd name="connsiteY8" fmla="*/ 296907 h 2355494"/>
              <a:gd name="connsiteX9" fmla="*/ 1340117 w 2866309"/>
              <a:gd name="connsiteY9" fmla="*/ 468357 h 2355494"/>
              <a:gd name="connsiteX10" fmla="*/ 1341704 w 2866309"/>
              <a:gd name="connsiteY10" fmla="*/ 504869 h 2355494"/>
              <a:gd name="connsiteX11" fmla="*/ 1359167 w 2866309"/>
              <a:gd name="connsiteY11" fmla="*/ 817607 h 2355494"/>
              <a:gd name="connsiteX12" fmla="*/ 1429017 w 2866309"/>
              <a:gd name="connsiteY12" fmla="*/ 1020807 h 2355494"/>
              <a:gd name="connsiteX13" fmla="*/ 1689367 w 2866309"/>
              <a:gd name="connsiteY13" fmla="*/ 868407 h 2355494"/>
              <a:gd name="connsiteX14" fmla="*/ 1689367 w 2866309"/>
              <a:gd name="connsiteY14" fmla="*/ 487407 h 2355494"/>
              <a:gd name="connsiteX15" fmla="*/ 1740167 w 2866309"/>
              <a:gd name="connsiteY15" fmla="*/ 277857 h 2355494"/>
              <a:gd name="connsiteX16" fmla="*/ 1822717 w 2866309"/>
              <a:gd name="connsiteY16" fmla="*/ 119107 h 2355494"/>
              <a:gd name="connsiteX17" fmla="*/ 1733817 w 2866309"/>
              <a:gd name="connsiteY17" fmla="*/ 379457 h 2355494"/>
              <a:gd name="connsiteX18" fmla="*/ 1835417 w 2866309"/>
              <a:gd name="connsiteY18" fmla="*/ 373107 h 2355494"/>
              <a:gd name="connsiteX19" fmla="*/ 1917967 w 2866309"/>
              <a:gd name="connsiteY19" fmla="*/ 188957 h 2355494"/>
              <a:gd name="connsiteX20" fmla="*/ 1836687 w 2866309"/>
              <a:gd name="connsiteY20" fmla="*/ 399142 h 2355494"/>
              <a:gd name="connsiteX21" fmla="*/ 1721117 w 2866309"/>
              <a:gd name="connsiteY21" fmla="*/ 455657 h 2355494"/>
              <a:gd name="connsiteX22" fmla="*/ 1733817 w 2866309"/>
              <a:gd name="connsiteY22" fmla="*/ 646157 h 2355494"/>
              <a:gd name="connsiteX23" fmla="*/ 1937017 w 2866309"/>
              <a:gd name="connsiteY23" fmla="*/ 544557 h 2355494"/>
              <a:gd name="connsiteX24" fmla="*/ 1968767 w 2866309"/>
              <a:gd name="connsiteY24" fmla="*/ 119107 h 2355494"/>
              <a:gd name="connsiteX25" fmla="*/ 1981467 w 2866309"/>
              <a:gd name="connsiteY25" fmla="*/ 11157 h 2355494"/>
              <a:gd name="connsiteX26" fmla="*/ 1994167 w 2866309"/>
              <a:gd name="connsiteY26" fmla="*/ 335007 h 2355494"/>
              <a:gd name="connsiteX27" fmla="*/ 1968767 w 2866309"/>
              <a:gd name="connsiteY27" fmla="*/ 589007 h 2355494"/>
              <a:gd name="connsiteX28" fmla="*/ 1860817 w 2866309"/>
              <a:gd name="connsiteY28" fmla="*/ 665207 h 2355494"/>
              <a:gd name="connsiteX29" fmla="*/ 2057667 w 2866309"/>
              <a:gd name="connsiteY29" fmla="*/ 713626 h 2355494"/>
              <a:gd name="connsiteX30" fmla="*/ 2096291 w 2866309"/>
              <a:gd name="connsiteY30" fmla="*/ 702864 h 2355494"/>
              <a:gd name="connsiteX31" fmla="*/ 2229117 w 2866309"/>
              <a:gd name="connsiteY31" fmla="*/ 652507 h 2355494"/>
              <a:gd name="connsiteX32" fmla="*/ 2089417 w 2866309"/>
              <a:gd name="connsiteY32" fmla="*/ 735057 h 2355494"/>
              <a:gd name="connsiteX33" fmla="*/ 1879867 w 2866309"/>
              <a:gd name="connsiteY33" fmla="*/ 722357 h 2355494"/>
              <a:gd name="connsiteX34" fmla="*/ 1784617 w 2866309"/>
              <a:gd name="connsiteY34" fmla="*/ 703307 h 2355494"/>
              <a:gd name="connsiteX35" fmla="*/ 1733817 w 2866309"/>
              <a:gd name="connsiteY35" fmla="*/ 868407 h 2355494"/>
              <a:gd name="connsiteX36" fmla="*/ 1575067 w 2866309"/>
              <a:gd name="connsiteY36" fmla="*/ 1052557 h 2355494"/>
              <a:gd name="connsiteX37" fmla="*/ 1536967 w 2866309"/>
              <a:gd name="connsiteY37" fmla="*/ 1306557 h 2355494"/>
              <a:gd name="connsiteX38" fmla="*/ 1829067 w 2866309"/>
              <a:gd name="connsiteY38" fmla="*/ 1351007 h 2355494"/>
              <a:gd name="connsiteX39" fmla="*/ 2140217 w 2866309"/>
              <a:gd name="connsiteY39" fmla="*/ 1071607 h 2355494"/>
              <a:gd name="connsiteX40" fmla="*/ 2165617 w 2866309"/>
              <a:gd name="connsiteY40" fmla="*/ 909682 h 2355494"/>
              <a:gd name="connsiteX41" fmla="*/ 2171967 w 2866309"/>
              <a:gd name="connsiteY41" fmla="*/ 792207 h 2355494"/>
              <a:gd name="connsiteX42" fmla="*/ 2191017 w 2866309"/>
              <a:gd name="connsiteY42" fmla="*/ 992232 h 2355494"/>
              <a:gd name="connsiteX43" fmla="*/ 2144185 w 2866309"/>
              <a:gd name="connsiteY43" fmla="*/ 1101769 h 2355494"/>
              <a:gd name="connsiteX44" fmla="*/ 1962417 w 2866309"/>
              <a:gd name="connsiteY44" fmla="*/ 1300207 h 2355494"/>
              <a:gd name="connsiteX45" fmla="*/ 2292617 w 2866309"/>
              <a:gd name="connsiteY45" fmla="*/ 1185907 h 2355494"/>
              <a:gd name="connsiteX46" fmla="*/ 2324367 w 2866309"/>
              <a:gd name="connsiteY46" fmla="*/ 735057 h 2355494"/>
              <a:gd name="connsiteX47" fmla="*/ 2352942 w 2866309"/>
              <a:gd name="connsiteY47" fmla="*/ 1016044 h 2355494"/>
              <a:gd name="connsiteX48" fmla="*/ 2349767 w 2866309"/>
              <a:gd name="connsiteY48" fmla="*/ 1131932 h 2355494"/>
              <a:gd name="connsiteX49" fmla="*/ 2540267 w 2866309"/>
              <a:gd name="connsiteY49" fmla="*/ 627107 h 2355494"/>
              <a:gd name="connsiteX50" fmla="*/ 2864117 w 2866309"/>
              <a:gd name="connsiteY50" fmla="*/ 411207 h 2355494"/>
              <a:gd name="connsiteX51" fmla="*/ 2676792 w 2866309"/>
              <a:gd name="connsiteY51" fmla="*/ 527094 h 2355494"/>
              <a:gd name="connsiteX52" fmla="*/ 2568048 w 2866309"/>
              <a:gd name="connsiteY52" fmla="*/ 628695 h 2355494"/>
              <a:gd name="connsiteX53" fmla="*/ 2517772 w 2866309"/>
              <a:gd name="connsiteY53" fmla="*/ 714771 h 2355494"/>
              <a:gd name="connsiteX54" fmla="*/ 2500580 w 2866309"/>
              <a:gd name="connsiteY54" fmla="*/ 748551 h 2355494"/>
              <a:gd name="connsiteX55" fmla="*/ 2450573 w 2866309"/>
              <a:gd name="connsiteY55" fmla="*/ 943019 h 2355494"/>
              <a:gd name="connsiteX56" fmla="*/ 2673617 w 2866309"/>
              <a:gd name="connsiteY56" fmla="*/ 766807 h 2355494"/>
              <a:gd name="connsiteX57" fmla="*/ 2711717 w 2866309"/>
              <a:gd name="connsiteY57" fmla="*/ 639807 h 2355494"/>
              <a:gd name="connsiteX58" fmla="*/ 2676792 w 2866309"/>
              <a:gd name="connsiteY58" fmla="*/ 782682 h 2355494"/>
              <a:gd name="connsiteX59" fmla="*/ 2495817 w 2866309"/>
              <a:gd name="connsiteY59" fmla="*/ 944607 h 2355494"/>
              <a:gd name="connsiteX60" fmla="*/ 2413267 w 2866309"/>
              <a:gd name="connsiteY60" fmla="*/ 1100182 h 2355494"/>
              <a:gd name="connsiteX61" fmla="*/ 2320128 w 2866309"/>
              <a:gd name="connsiteY61" fmla="*/ 1214833 h 2355494"/>
              <a:gd name="connsiteX62" fmla="*/ 2265312 w 2866309"/>
              <a:gd name="connsiteY62" fmla="*/ 1243692 h 2355494"/>
              <a:gd name="connsiteX63" fmla="*/ 2022742 w 2866309"/>
              <a:gd name="connsiteY63" fmla="*/ 1347832 h 2355494"/>
              <a:gd name="connsiteX64" fmla="*/ 1854467 w 2866309"/>
              <a:gd name="connsiteY64" fmla="*/ 1401807 h 2355494"/>
              <a:gd name="connsiteX65" fmla="*/ 1581417 w 2866309"/>
              <a:gd name="connsiteY65" fmla="*/ 1458957 h 2355494"/>
              <a:gd name="connsiteX66" fmla="*/ 1340117 w 2866309"/>
              <a:gd name="connsiteY66" fmla="*/ 1611357 h 2355494"/>
              <a:gd name="connsiteX67" fmla="*/ 1378217 w 2866309"/>
              <a:gd name="connsiteY67" fmla="*/ 1782807 h 2355494"/>
              <a:gd name="connsiteX68" fmla="*/ 1803667 w 2866309"/>
              <a:gd name="connsiteY68" fmla="*/ 2036807 h 2355494"/>
              <a:gd name="connsiteX69" fmla="*/ 1416317 w 2866309"/>
              <a:gd name="connsiteY69" fmla="*/ 1859007 h 2355494"/>
              <a:gd name="connsiteX70" fmla="*/ 1225817 w 2866309"/>
              <a:gd name="connsiteY70" fmla="*/ 1687557 h 2355494"/>
              <a:gd name="connsiteX71" fmla="*/ 924192 w 2866309"/>
              <a:gd name="connsiteY71" fmla="*/ 1681207 h 2355494"/>
              <a:gd name="connsiteX72" fmla="*/ 705117 w 2866309"/>
              <a:gd name="connsiteY72" fmla="*/ 1973307 h 2355494"/>
              <a:gd name="connsiteX73" fmla="*/ 533667 w 2866309"/>
              <a:gd name="connsiteY73" fmla="*/ 2252707 h 2355494"/>
              <a:gd name="connsiteX74" fmla="*/ 190767 w 2866309"/>
              <a:gd name="connsiteY74" fmla="*/ 2354307 h 2355494"/>
              <a:gd name="connsiteX75" fmla="*/ 267 w 2866309"/>
              <a:gd name="connsiteY75" fmla="*/ 2309857 h 2355494"/>
              <a:gd name="connsiteX76" fmla="*/ 228867 w 2866309"/>
              <a:gd name="connsiteY76" fmla="*/ 2335257 h 2355494"/>
              <a:gd name="connsiteX77" fmla="*/ 489217 w 2866309"/>
              <a:gd name="connsiteY77" fmla="*/ 2240007 h 2355494"/>
              <a:gd name="connsiteX78" fmla="*/ 622567 w 2866309"/>
              <a:gd name="connsiteY78" fmla="*/ 2036807 h 2355494"/>
              <a:gd name="connsiteX79" fmla="*/ 673367 w 2866309"/>
              <a:gd name="connsiteY79" fmla="*/ 1808207 h 2355494"/>
              <a:gd name="connsiteX80" fmla="*/ 273317 w 2866309"/>
              <a:gd name="connsiteY80" fmla="*/ 2125707 h 2355494"/>
              <a:gd name="connsiteX81" fmla="*/ 114567 w 2866309"/>
              <a:gd name="connsiteY81" fmla="*/ 2132057 h 2355494"/>
              <a:gd name="connsiteX82" fmla="*/ 222517 w 2866309"/>
              <a:gd name="connsiteY82" fmla="*/ 2119357 h 2355494"/>
              <a:gd name="connsiteX83" fmla="*/ 393967 w 2866309"/>
              <a:gd name="connsiteY83" fmla="*/ 1998707 h 2355494"/>
              <a:gd name="connsiteX84" fmla="*/ 552717 w 2866309"/>
              <a:gd name="connsiteY84" fmla="*/ 1855832 h 2355494"/>
              <a:gd name="connsiteX85" fmla="*/ 819417 w 2866309"/>
              <a:gd name="connsiteY85" fmla="*/ 1636757 h 2355494"/>
              <a:gd name="connsiteX86" fmla="*/ 901967 w 2866309"/>
              <a:gd name="connsiteY86" fmla="*/ 1306557 h 2355494"/>
              <a:gd name="connsiteX87" fmla="*/ 641617 w 2866309"/>
              <a:gd name="connsiteY87" fmla="*/ 1179557 h 2355494"/>
              <a:gd name="connsiteX88" fmla="*/ 482867 w 2866309"/>
              <a:gd name="connsiteY88" fmla="*/ 1090657 h 2355494"/>
              <a:gd name="connsiteX89" fmla="*/ 717817 w 2866309"/>
              <a:gd name="connsiteY89" fmla="*/ 1173207 h 2355494"/>
              <a:gd name="connsiteX90" fmla="*/ 692417 w 2866309"/>
              <a:gd name="connsiteY90" fmla="*/ 950957 h 2355494"/>
              <a:gd name="connsiteX91" fmla="*/ 584467 w 2866309"/>
              <a:gd name="connsiteY91" fmla="*/ 830307 h 2355494"/>
              <a:gd name="connsiteX92" fmla="*/ 711467 w 2866309"/>
              <a:gd name="connsiteY92" fmla="*/ 931907 h 2355494"/>
              <a:gd name="connsiteX93" fmla="*/ 749567 w 2866309"/>
              <a:gd name="connsiteY93" fmla="*/ 1109707 h 2355494"/>
              <a:gd name="connsiteX94" fmla="*/ 781317 w 2866309"/>
              <a:gd name="connsiteY94" fmla="*/ 1058907 h 2355494"/>
              <a:gd name="connsiteX95" fmla="*/ 800367 w 2866309"/>
              <a:gd name="connsiteY95" fmla="*/ 912857 h 2355494"/>
              <a:gd name="connsiteX96" fmla="*/ 724167 w 2866309"/>
              <a:gd name="connsiteY96" fmla="*/ 722357 h 2355494"/>
              <a:gd name="connsiteX97" fmla="*/ 813067 w 2866309"/>
              <a:gd name="connsiteY97" fmla="*/ 862057 h 2355494"/>
              <a:gd name="connsiteX98" fmla="*/ 806717 w 2866309"/>
              <a:gd name="connsiteY98" fmla="*/ 1033507 h 2355494"/>
              <a:gd name="connsiteX99" fmla="*/ 813067 w 2866309"/>
              <a:gd name="connsiteY99" fmla="*/ 1204957 h 2355494"/>
              <a:gd name="connsiteX100" fmla="*/ 940067 w 2866309"/>
              <a:gd name="connsiteY100" fmla="*/ 1312907 h 2355494"/>
              <a:gd name="connsiteX101" fmla="*/ 1016267 w 2866309"/>
              <a:gd name="connsiteY101" fmla="*/ 1046207 h 2355494"/>
              <a:gd name="connsiteX102" fmla="*/ 1009917 w 2866309"/>
              <a:gd name="connsiteY102" fmla="*/ 1198607 h 2355494"/>
              <a:gd name="connsiteX103" fmla="*/ 1009917 w 2866309"/>
              <a:gd name="connsiteY103" fmla="*/ 1287507 h 2355494"/>
              <a:gd name="connsiteX104" fmla="*/ 1130567 w 2866309"/>
              <a:gd name="connsiteY104" fmla="*/ 1274807 h 2355494"/>
              <a:gd name="connsiteX105" fmla="*/ 1263917 w 2866309"/>
              <a:gd name="connsiteY105" fmla="*/ 1046207 h 2355494"/>
              <a:gd name="connsiteX106" fmla="*/ 1302017 w 2866309"/>
              <a:gd name="connsiteY106" fmla="*/ 665207 h 2355494"/>
              <a:gd name="connsiteX107" fmla="*/ 1263123 w 2866309"/>
              <a:gd name="connsiteY107" fmla="*/ 519157 h 2355494"/>
              <a:gd name="connsiteX108" fmla="*/ 1042026 w 2866309"/>
              <a:gd name="connsiteY108" fmla="*/ 455155 h 2355494"/>
              <a:gd name="connsiteX109" fmla="*/ 909905 w 2866309"/>
              <a:gd name="connsiteY109" fmla="*/ 436607 h 2355494"/>
              <a:gd name="connsiteX0" fmla="*/ 909905 w 2866309"/>
              <a:gd name="connsiteY0" fmla="*/ 436607 h 2355494"/>
              <a:gd name="connsiteX1" fmla="*/ 1219467 w 2866309"/>
              <a:gd name="connsiteY1" fmla="*/ 474707 h 2355494"/>
              <a:gd name="connsiteX2" fmla="*/ 1282967 w 2866309"/>
              <a:gd name="connsiteY2" fmla="*/ 487407 h 2355494"/>
              <a:gd name="connsiteX3" fmla="*/ 1308367 w 2866309"/>
              <a:gd name="connsiteY3" fmla="*/ 442957 h 2355494"/>
              <a:gd name="connsiteX4" fmla="*/ 1289317 w 2866309"/>
              <a:gd name="connsiteY4" fmla="*/ 322307 h 2355494"/>
              <a:gd name="connsiteX5" fmla="*/ 1333767 w 2866309"/>
              <a:gd name="connsiteY5" fmla="*/ 208007 h 2355494"/>
              <a:gd name="connsiteX6" fmla="*/ 1308367 w 2866309"/>
              <a:gd name="connsiteY6" fmla="*/ 335007 h 2355494"/>
              <a:gd name="connsiteX7" fmla="*/ 1333767 w 2866309"/>
              <a:gd name="connsiteY7" fmla="*/ 417557 h 2355494"/>
              <a:gd name="connsiteX8" fmla="*/ 1384567 w 2866309"/>
              <a:gd name="connsiteY8" fmla="*/ 296907 h 2355494"/>
              <a:gd name="connsiteX9" fmla="*/ 1340117 w 2866309"/>
              <a:gd name="connsiteY9" fmla="*/ 468357 h 2355494"/>
              <a:gd name="connsiteX10" fmla="*/ 1341704 w 2866309"/>
              <a:gd name="connsiteY10" fmla="*/ 504869 h 2355494"/>
              <a:gd name="connsiteX11" fmla="*/ 1359167 w 2866309"/>
              <a:gd name="connsiteY11" fmla="*/ 817607 h 2355494"/>
              <a:gd name="connsiteX12" fmla="*/ 1429017 w 2866309"/>
              <a:gd name="connsiteY12" fmla="*/ 1020807 h 2355494"/>
              <a:gd name="connsiteX13" fmla="*/ 1689367 w 2866309"/>
              <a:gd name="connsiteY13" fmla="*/ 868407 h 2355494"/>
              <a:gd name="connsiteX14" fmla="*/ 1689367 w 2866309"/>
              <a:gd name="connsiteY14" fmla="*/ 487407 h 2355494"/>
              <a:gd name="connsiteX15" fmla="*/ 1740167 w 2866309"/>
              <a:gd name="connsiteY15" fmla="*/ 277857 h 2355494"/>
              <a:gd name="connsiteX16" fmla="*/ 1822717 w 2866309"/>
              <a:gd name="connsiteY16" fmla="*/ 119107 h 2355494"/>
              <a:gd name="connsiteX17" fmla="*/ 1733817 w 2866309"/>
              <a:gd name="connsiteY17" fmla="*/ 379457 h 2355494"/>
              <a:gd name="connsiteX18" fmla="*/ 1835417 w 2866309"/>
              <a:gd name="connsiteY18" fmla="*/ 373107 h 2355494"/>
              <a:gd name="connsiteX19" fmla="*/ 1917967 w 2866309"/>
              <a:gd name="connsiteY19" fmla="*/ 188957 h 2355494"/>
              <a:gd name="connsiteX20" fmla="*/ 1836687 w 2866309"/>
              <a:gd name="connsiteY20" fmla="*/ 399142 h 2355494"/>
              <a:gd name="connsiteX21" fmla="*/ 1721117 w 2866309"/>
              <a:gd name="connsiteY21" fmla="*/ 455657 h 2355494"/>
              <a:gd name="connsiteX22" fmla="*/ 1733817 w 2866309"/>
              <a:gd name="connsiteY22" fmla="*/ 646157 h 2355494"/>
              <a:gd name="connsiteX23" fmla="*/ 1937017 w 2866309"/>
              <a:gd name="connsiteY23" fmla="*/ 544557 h 2355494"/>
              <a:gd name="connsiteX24" fmla="*/ 1968767 w 2866309"/>
              <a:gd name="connsiteY24" fmla="*/ 119107 h 2355494"/>
              <a:gd name="connsiteX25" fmla="*/ 1981467 w 2866309"/>
              <a:gd name="connsiteY25" fmla="*/ 11157 h 2355494"/>
              <a:gd name="connsiteX26" fmla="*/ 1994167 w 2866309"/>
              <a:gd name="connsiteY26" fmla="*/ 335007 h 2355494"/>
              <a:gd name="connsiteX27" fmla="*/ 1968767 w 2866309"/>
              <a:gd name="connsiteY27" fmla="*/ 589007 h 2355494"/>
              <a:gd name="connsiteX28" fmla="*/ 1860817 w 2866309"/>
              <a:gd name="connsiteY28" fmla="*/ 665207 h 2355494"/>
              <a:gd name="connsiteX29" fmla="*/ 2057667 w 2866309"/>
              <a:gd name="connsiteY29" fmla="*/ 713626 h 2355494"/>
              <a:gd name="connsiteX30" fmla="*/ 2115341 w 2866309"/>
              <a:gd name="connsiteY30" fmla="*/ 707626 h 2355494"/>
              <a:gd name="connsiteX31" fmla="*/ 2229117 w 2866309"/>
              <a:gd name="connsiteY31" fmla="*/ 652507 h 2355494"/>
              <a:gd name="connsiteX32" fmla="*/ 2089417 w 2866309"/>
              <a:gd name="connsiteY32" fmla="*/ 735057 h 2355494"/>
              <a:gd name="connsiteX33" fmla="*/ 1879867 w 2866309"/>
              <a:gd name="connsiteY33" fmla="*/ 722357 h 2355494"/>
              <a:gd name="connsiteX34" fmla="*/ 1784617 w 2866309"/>
              <a:gd name="connsiteY34" fmla="*/ 703307 h 2355494"/>
              <a:gd name="connsiteX35" fmla="*/ 1733817 w 2866309"/>
              <a:gd name="connsiteY35" fmla="*/ 868407 h 2355494"/>
              <a:gd name="connsiteX36" fmla="*/ 1575067 w 2866309"/>
              <a:gd name="connsiteY36" fmla="*/ 1052557 h 2355494"/>
              <a:gd name="connsiteX37" fmla="*/ 1536967 w 2866309"/>
              <a:gd name="connsiteY37" fmla="*/ 1306557 h 2355494"/>
              <a:gd name="connsiteX38" fmla="*/ 1829067 w 2866309"/>
              <a:gd name="connsiteY38" fmla="*/ 1351007 h 2355494"/>
              <a:gd name="connsiteX39" fmla="*/ 2140217 w 2866309"/>
              <a:gd name="connsiteY39" fmla="*/ 1071607 h 2355494"/>
              <a:gd name="connsiteX40" fmla="*/ 2165617 w 2866309"/>
              <a:gd name="connsiteY40" fmla="*/ 909682 h 2355494"/>
              <a:gd name="connsiteX41" fmla="*/ 2171967 w 2866309"/>
              <a:gd name="connsiteY41" fmla="*/ 792207 h 2355494"/>
              <a:gd name="connsiteX42" fmla="*/ 2191017 w 2866309"/>
              <a:gd name="connsiteY42" fmla="*/ 992232 h 2355494"/>
              <a:gd name="connsiteX43" fmla="*/ 2144185 w 2866309"/>
              <a:gd name="connsiteY43" fmla="*/ 1101769 h 2355494"/>
              <a:gd name="connsiteX44" fmla="*/ 1962417 w 2866309"/>
              <a:gd name="connsiteY44" fmla="*/ 1300207 h 2355494"/>
              <a:gd name="connsiteX45" fmla="*/ 2292617 w 2866309"/>
              <a:gd name="connsiteY45" fmla="*/ 1185907 h 2355494"/>
              <a:gd name="connsiteX46" fmla="*/ 2324367 w 2866309"/>
              <a:gd name="connsiteY46" fmla="*/ 735057 h 2355494"/>
              <a:gd name="connsiteX47" fmla="*/ 2352942 w 2866309"/>
              <a:gd name="connsiteY47" fmla="*/ 1016044 h 2355494"/>
              <a:gd name="connsiteX48" fmla="*/ 2349767 w 2866309"/>
              <a:gd name="connsiteY48" fmla="*/ 1131932 h 2355494"/>
              <a:gd name="connsiteX49" fmla="*/ 2540267 w 2866309"/>
              <a:gd name="connsiteY49" fmla="*/ 627107 h 2355494"/>
              <a:gd name="connsiteX50" fmla="*/ 2864117 w 2866309"/>
              <a:gd name="connsiteY50" fmla="*/ 411207 h 2355494"/>
              <a:gd name="connsiteX51" fmla="*/ 2676792 w 2866309"/>
              <a:gd name="connsiteY51" fmla="*/ 527094 h 2355494"/>
              <a:gd name="connsiteX52" fmla="*/ 2568048 w 2866309"/>
              <a:gd name="connsiteY52" fmla="*/ 628695 h 2355494"/>
              <a:gd name="connsiteX53" fmla="*/ 2517772 w 2866309"/>
              <a:gd name="connsiteY53" fmla="*/ 714771 h 2355494"/>
              <a:gd name="connsiteX54" fmla="*/ 2500580 w 2866309"/>
              <a:gd name="connsiteY54" fmla="*/ 748551 h 2355494"/>
              <a:gd name="connsiteX55" fmla="*/ 2450573 w 2866309"/>
              <a:gd name="connsiteY55" fmla="*/ 943019 h 2355494"/>
              <a:gd name="connsiteX56" fmla="*/ 2673617 w 2866309"/>
              <a:gd name="connsiteY56" fmla="*/ 766807 h 2355494"/>
              <a:gd name="connsiteX57" fmla="*/ 2711717 w 2866309"/>
              <a:gd name="connsiteY57" fmla="*/ 639807 h 2355494"/>
              <a:gd name="connsiteX58" fmla="*/ 2676792 w 2866309"/>
              <a:gd name="connsiteY58" fmla="*/ 782682 h 2355494"/>
              <a:gd name="connsiteX59" fmla="*/ 2495817 w 2866309"/>
              <a:gd name="connsiteY59" fmla="*/ 944607 h 2355494"/>
              <a:gd name="connsiteX60" fmla="*/ 2413267 w 2866309"/>
              <a:gd name="connsiteY60" fmla="*/ 1100182 h 2355494"/>
              <a:gd name="connsiteX61" fmla="*/ 2320128 w 2866309"/>
              <a:gd name="connsiteY61" fmla="*/ 1214833 h 2355494"/>
              <a:gd name="connsiteX62" fmla="*/ 2265312 w 2866309"/>
              <a:gd name="connsiteY62" fmla="*/ 1243692 h 2355494"/>
              <a:gd name="connsiteX63" fmla="*/ 2022742 w 2866309"/>
              <a:gd name="connsiteY63" fmla="*/ 1347832 h 2355494"/>
              <a:gd name="connsiteX64" fmla="*/ 1854467 w 2866309"/>
              <a:gd name="connsiteY64" fmla="*/ 1401807 h 2355494"/>
              <a:gd name="connsiteX65" fmla="*/ 1581417 w 2866309"/>
              <a:gd name="connsiteY65" fmla="*/ 1458957 h 2355494"/>
              <a:gd name="connsiteX66" fmla="*/ 1340117 w 2866309"/>
              <a:gd name="connsiteY66" fmla="*/ 1611357 h 2355494"/>
              <a:gd name="connsiteX67" fmla="*/ 1378217 w 2866309"/>
              <a:gd name="connsiteY67" fmla="*/ 1782807 h 2355494"/>
              <a:gd name="connsiteX68" fmla="*/ 1803667 w 2866309"/>
              <a:gd name="connsiteY68" fmla="*/ 2036807 h 2355494"/>
              <a:gd name="connsiteX69" fmla="*/ 1416317 w 2866309"/>
              <a:gd name="connsiteY69" fmla="*/ 1859007 h 2355494"/>
              <a:gd name="connsiteX70" fmla="*/ 1225817 w 2866309"/>
              <a:gd name="connsiteY70" fmla="*/ 1687557 h 2355494"/>
              <a:gd name="connsiteX71" fmla="*/ 924192 w 2866309"/>
              <a:gd name="connsiteY71" fmla="*/ 1681207 h 2355494"/>
              <a:gd name="connsiteX72" fmla="*/ 705117 w 2866309"/>
              <a:gd name="connsiteY72" fmla="*/ 1973307 h 2355494"/>
              <a:gd name="connsiteX73" fmla="*/ 533667 w 2866309"/>
              <a:gd name="connsiteY73" fmla="*/ 2252707 h 2355494"/>
              <a:gd name="connsiteX74" fmla="*/ 190767 w 2866309"/>
              <a:gd name="connsiteY74" fmla="*/ 2354307 h 2355494"/>
              <a:gd name="connsiteX75" fmla="*/ 267 w 2866309"/>
              <a:gd name="connsiteY75" fmla="*/ 2309857 h 2355494"/>
              <a:gd name="connsiteX76" fmla="*/ 228867 w 2866309"/>
              <a:gd name="connsiteY76" fmla="*/ 2335257 h 2355494"/>
              <a:gd name="connsiteX77" fmla="*/ 489217 w 2866309"/>
              <a:gd name="connsiteY77" fmla="*/ 2240007 h 2355494"/>
              <a:gd name="connsiteX78" fmla="*/ 622567 w 2866309"/>
              <a:gd name="connsiteY78" fmla="*/ 2036807 h 2355494"/>
              <a:gd name="connsiteX79" fmla="*/ 673367 w 2866309"/>
              <a:gd name="connsiteY79" fmla="*/ 1808207 h 2355494"/>
              <a:gd name="connsiteX80" fmla="*/ 273317 w 2866309"/>
              <a:gd name="connsiteY80" fmla="*/ 2125707 h 2355494"/>
              <a:gd name="connsiteX81" fmla="*/ 114567 w 2866309"/>
              <a:gd name="connsiteY81" fmla="*/ 2132057 h 2355494"/>
              <a:gd name="connsiteX82" fmla="*/ 222517 w 2866309"/>
              <a:gd name="connsiteY82" fmla="*/ 2119357 h 2355494"/>
              <a:gd name="connsiteX83" fmla="*/ 393967 w 2866309"/>
              <a:gd name="connsiteY83" fmla="*/ 1998707 h 2355494"/>
              <a:gd name="connsiteX84" fmla="*/ 552717 w 2866309"/>
              <a:gd name="connsiteY84" fmla="*/ 1855832 h 2355494"/>
              <a:gd name="connsiteX85" fmla="*/ 819417 w 2866309"/>
              <a:gd name="connsiteY85" fmla="*/ 1636757 h 2355494"/>
              <a:gd name="connsiteX86" fmla="*/ 901967 w 2866309"/>
              <a:gd name="connsiteY86" fmla="*/ 1306557 h 2355494"/>
              <a:gd name="connsiteX87" fmla="*/ 641617 w 2866309"/>
              <a:gd name="connsiteY87" fmla="*/ 1179557 h 2355494"/>
              <a:gd name="connsiteX88" fmla="*/ 482867 w 2866309"/>
              <a:gd name="connsiteY88" fmla="*/ 1090657 h 2355494"/>
              <a:gd name="connsiteX89" fmla="*/ 717817 w 2866309"/>
              <a:gd name="connsiteY89" fmla="*/ 1173207 h 2355494"/>
              <a:gd name="connsiteX90" fmla="*/ 692417 w 2866309"/>
              <a:gd name="connsiteY90" fmla="*/ 950957 h 2355494"/>
              <a:gd name="connsiteX91" fmla="*/ 584467 w 2866309"/>
              <a:gd name="connsiteY91" fmla="*/ 830307 h 2355494"/>
              <a:gd name="connsiteX92" fmla="*/ 711467 w 2866309"/>
              <a:gd name="connsiteY92" fmla="*/ 931907 h 2355494"/>
              <a:gd name="connsiteX93" fmla="*/ 749567 w 2866309"/>
              <a:gd name="connsiteY93" fmla="*/ 1109707 h 2355494"/>
              <a:gd name="connsiteX94" fmla="*/ 781317 w 2866309"/>
              <a:gd name="connsiteY94" fmla="*/ 1058907 h 2355494"/>
              <a:gd name="connsiteX95" fmla="*/ 800367 w 2866309"/>
              <a:gd name="connsiteY95" fmla="*/ 912857 h 2355494"/>
              <a:gd name="connsiteX96" fmla="*/ 724167 w 2866309"/>
              <a:gd name="connsiteY96" fmla="*/ 722357 h 2355494"/>
              <a:gd name="connsiteX97" fmla="*/ 813067 w 2866309"/>
              <a:gd name="connsiteY97" fmla="*/ 862057 h 2355494"/>
              <a:gd name="connsiteX98" fmla="*/ 806717 w 2866309"/>
              <a:gd name="connsiteY98" fmla="*/ 1033507 h 2355494"/>
              <a:gd name="connsiteX99" fmla="*/ 813067 w 2866309"/>
              <a:gd name="connsiteY99" fmla="*/ 1204957 h 2355494"/>
              <a:gd name="connsiteX100" fmla="*/ 940067 w 2866309"/>
              <a:gd name="connsiteY100" fmla="*/ 1312907 h 2355494"/>
              <a:gd name="connsiteX101" fmla="*/ 1016267 w 2866309"/>
              <a:gd name="connsiteY101" fmla="*/ 1046207 h 2355494"/>
              <a:gd name="connsiteX102" fmla="*/ 1009917 w 2866309"/>
              <a:gd name="connsiteY102" fmla="*/ 1198607 h 2355494"/>
              <a:gd name="connsiteX103" fmla="*/ 1009917 w 2866309"/>
              <a:gd name="connsiteY103" fmla="*/ 1287507 h 2355494"/>
              <a:gd name="connsiteX104" fmla="*/ 1130567 w 2866309"/>
              <a:gd name="connsiteY104" fmla="*/ 1274807 h 2355494"/>
              <a:gd name="connsiteX105" fmla="*/ 1263917 w 2866309"/>
              <a:gd name="connsiteY105" fmla="*/ 1046207 h 2355494"/>
              <a:gd name="connsiteX106" fmla="*/ 1302017 w 2866309"/>
              <a:gd name="connsiteY106" fmla="*/ 665207 h 2355494"/>
              <a:gd name="connsiteX107" fmla="*/ 1263123 w 2866309"/>
              <a:gd name="connsiteY107" fmla="*/ 519157 h 2355494"/>
              <a:gd name="connsiteX108" fmla="*/ 1042026 w 2866309"/>
              <a:gd name="connsiteY108" fmla="*/ 455155 h 2355494"/>
              <a:gd name="connsiteX109" fmla="*/ 909905 w 2866309"/>
              <a:gd name="connsiteY109" fmla="*/ 436607 h 2355494"/>
              <a:gd name="connsiteX0" fmla="*/ 909905 w 2866309"/>
              <a:gd name="connsiteY0" fmla="*/ 436607 h 2355494"/>
              <a:gd name="connsiteX1" fmla="*/ 1219467 w 2866309"/>
              <a:gd name="connsiteY1" fmla="*/ 474707 h 2355494"/>
              <a:gd name="connsiteX2" fmla="*/ 1282967 w 2866309"/>
              <a:gd name="connsiteY2" fmla="*/ 487407 h 2355494"/>
              <a:gd name="connsiteX3" fmla="*/ 1308367 w 2866309"/>
              <a:gd name="connsiteY3" fmla="*/ 442957 h 2355494"/>
              <a:gd name="connsiteX4" fmla="*/ 1289317 w 2866309"/>
              <a:gd name="connsiteY4" fmla="*/ 322307 h 2355494"/>
              <a:gd name="connsiteX5" fmla="*/ 1333767 w 2866309"/>
              <a:gd name="connsiteY5" fmla="*/ 208007 h 2355494"/>
              <a:gd name="connsiteX6" fmla="*/ 1308367 w 2866309"/>
              <a:gd name="connsiteY6" fmla="*/ 335007 h 2355494"/>
              <a:gd name="connsiteX7" fmla="*/ 1333767 w 2866309"/>
              <a:gd name="connsiteY7" fmla="*/ 417557 h 2355494"/>
              <a:gd name="connsiteX8" fmla="*/ 1384567 w 2866309"/>
              <a:gd name="connsiteY8" fmla="*/ 296907 h 2355494"/>
              <a:gd name="connsiteX9" fmla="*/ 1340117 w 2866309"/>
              <a:gd name="connsiteY9" fmla="*/ 468357 h 2355494"/>
              <a:gd name="connsiteX10" fmla="*/ 1341704 w 2866309"/>
              <a:gd name="connsiteY10" fmla="*/ 504869 h 2355494"/>
              <a:gd name="connsiteX11" fmla="*/ 1359167 w 2866309"/>
              <a:gd name="connsiteY11" fmla="*/ 817607 h 2355494"/>
              <a:gd name="connsiteX12" fmla="*/ 1429017 w 2866309"/>
              <a:gd name="connsiteY12" fmla="*/ 1020807 h 2355494"/>
              <a:gd name="connsiteX13" fmla="*/ 1689367 w 2866309"/>
              <a:gd name="connsiteY13" fmla="*/ 868407 h 2355494"/>
              <a:gd name="connsiteX14" fmla="*/ 1689367 w 2866309"/>
              <a:gd name="connsiteY14" fmla="*/ 487407 h 2355494"/>
              <a:gd name="connsiteX15" fmla="*/ 1740167 w 2866309"/>
              <a:gd name="connsiteY15" fmla="*/ 277857 h 2355494"/>
              <a:gd name="connsiteX16" fmla="*/ 1822717 w 2866309"/>
              <a:gd name="connsiteY16" fmla="*/ 119107 h 2355494"/>
              <a:gd name="connsiteX17" fmla="*/ 1733817 w 2866309"/>
              <a:gd name="connsiteY17" fmla="*/ 379457 h 2355494"/>
              <a:gd name="connsiteX18" fmla="*/ 1835417 w 2866309"/>
              <a:gd name="connsiteY18" fmla="*/ 373107 h 2355494"/>
              <a:gd name="connsiteX19" fmla="*/ 1917967 w 2866309"/>
              <a:gd name="connsiteY19" fmla="*/ 188957 h 2355494"/>
              <a:gd name="connsiteX20" fmla="*/ 1836687 w 2866309"/>
              <a:gd name="connsiteY20" fmla="*/ 399142 h 2355494"/>
              <a:gd name="connsiteX21" fmla="*/ 1721117 w 2866309"/>
              <a:gd name="connsiteY21" fmla="*/ 455657 h 2355494"/>
              <a:gd name="connsiteX22" fmla="*/ 1733817 w 2866309"/>
              <a:gd name="connsiteY22" fmla="*/ 646157 h 2355494"/>
              <a:gd name="connsiteX23" fmla="*/ 1937017 w 2866309"/>
              <a:gd name="connsiteY23" fmla="*/ 544557 h 2355494"/>
              <a:gd name="connsiteX24" fmla="*/ 1968767 w 2866309"/>
              <a:gd name="connsiteY24" fmla="*/ 119107 h 2355494"/>
              <a:gd name="connsiteX25" fmla="*/ 1981467 w 2866309"/>
              <a:gd name="connsiteY25" fmla="*/ 11157 h 2355494"/>
              <a:gd name="connsiteX26" fmla="*/ 1994167 w 2866309"/>
              <a:gd name="connsiteY26" fmla="*/ 335007 h 2355494"/>
              <a:gd name="connsiteX27" fmla="*/ 1947335 w 2866309"/>
              <a:gd name="connsiteY27" fmla="*/ 572338 h 2355494"/>
              <a:gd name="connsiteX28" fmla="*/ 1860817 w 2866309"/>
              <a:gd name="connsiteY28" fmla="*/ 665207 h 2355494"/>
              <a:gd name="connsiteX29" fmla="*/ 2057667 w 2866309"/>
              <a:gd name="connsiteY29" fmla="*/ 713626 h 2355494"/>
              <a:gd name="connsiteX30" fmla="*/ 2115341 w 2866309"/>
              <a:gd name="connsiteY30" fmla="*/ 707626 h 2355494"/>
              <a:gd name="connsiteX31" fmla="*/ 2229117 w 2866309"/>
              <a:gd name="connsiteY31" fmla="*/ 652507 h 2355494"/>
              <a:gd name="connsiteX32" fmla="*/ 2089417 w 2866309"/>
              <a:gd name="connsiteY32" fmla="*/ 735057 h 2355494"/>
              <a:gd name="connsiteX33" fmla="*/ 1879867 w 2866309"/>
              <a:gd name="connsiteY33" fmla="*/ 722357 h 2355494"/>
              <a:gd name="connsiteX34" fmla="*/ 1784617 w 2866309"/>
              <a:gd name="connsiteY34" fmla="*/ 703307 h 2355494"/>
              <a:gd name="connsiteX35" fmla="*/ 1733817 w 2866309"/>
              <a:gd name="connsiteY35" fmla="*/ 868407 h 2355494"/>
              <a:gd name="connsiteX36" fmla="*/ 1575067 w 2866309"/>
              <a:gd name="connsiteY36" fmla="*/ 1052557 h 2355494"/>
              <a:gd name="connsiteX37" fmla="*/ 1536967 w 2866309"/>
              <a:gd name="connsiteY37" fmla="*/ 1306557 h 2355494"/>
              <a:gd name="connsiteX38" fmla="*/ 1829067 w 2866309"/>
              <a:gd name="connsiteY38" fmla="*/ 1351007 h 2355494"/>
              <a:gd name="connsiteX39" fmla="*/ 2140217 w 2866309"/>
              <a:gd name="connsiteY39" fmla="*/ 1071607 h 2355494"/>
              <a:gd name="connsiteX40" fmla="*/ 2165617 w 2866309"/>
              <a:gd name="connsiteY40" fmla="*/ 909682 h 2355494"/>
              <a:gd name="connsiteX41" fmla="*/ 2171967 w 2866309"/>
              <a:gd name="connsiteY41" fmla="*/ 792207 h 2355494"/>
              <a:gd name="connsiteX42" fmla="*/ 2191017 w 2866309"/>
              <a:gd name="connsiteY42" fmla="*/ 992232 h 2355494"/>
              <a:gd name="connsiteX43" fmla="*/ 2144185 w 2866309"/>
              <a:gd name="connsiteY43" fmla="*/ 1101769 h 2355494"/>
              <a:gd name="connsiteX44" fmla="*/ 1962417 w 2866309"/>
              <a:gd name="connsiteY44" fmla="*/ 1300207 h 2355494"/>
              <a:gd name="connsiteX45" fmla="*/ 2292617 w 2866309"/>
              <a:gd name="connsiteY45" fmla="*/ 1185907 h 2355494"/>
              <a:gd name="connsiteX46" fmla="*/ 2324367 w 2866309"/>
              <a:gd name="connsiteY46" fmla="*/ 735057 h 2355494"/>
              <a:gd name="connsiteX47" fmla="*/ 2352942 w 2866309"/>
              <a:gd name="connsiteY47" fmla="*/ 1016044 h 2355494"/>
              <a:gd name="connsiteX48" fmla="*/ 2349767 w 2866309"/>
              <a:gd name="connsiteY48" fmla="*/ 1131932 h 2355494"/>
              <a:gd name="connsiteX49" fmla="*/ 2540267 w 2866309"/>
              <a:gd name="connsiteY49" fmla="*/ 627107 h 2355494"/>
              <a:gd name="connsiteX50" fmla="*/ 2864117 w 2866309"/>
              <a:gd name="connsiteY50" fmla="*/ 411207 h 2355494"/>
              <a:gd name="connsiteX51" fmla="*/ 2676792 w 2866309"/>
              <a:gd name="connsiteY51" fmla="*/ 527094 h 2355494"/>
              <a:gd name="connsiteX52" fmla="*/ 2568048 w 2866309"/>
              <a:gd name="connsiteY52" fmla="*/ 628695 h 2355494"/>
              <a:gd name="connsiteX53" fmla="*/ 2517772 w 2866309"/>
              <a:gd name="connsiteY53" fmla="*/ 714771 h 2355494"/>
              <a:gd name="connsiteX54" fmla="*/ 2500580 w 2866309"/>
              <a:gd name="connsiteY54" fmla="*/ 748551 h 2355494"/>
              <a:gd name="connsiteX55" fmla="*/ 2450573 w 2866309"/>
              <a:gd name="connsiteY55" fmla="*/ 943019 h 2355494"/>
              <a:gd name="connsiteX56" fmla="*/ 2673617 w 2866309"/>
              <a:gd name="connsiteY56" fmla="*/ 766807 h 2355494"/>
              <a:gd name="connsiteX57" fmla="*/ 2711717 w 2866309"/>
              <a:gd name="connsiteY57" fmla="*/ 639807 h 2355494"/>
              <a:gd name="connsiteX58" fmla="*/ 2676792 w 2866309"/>
              <a:gd name="connsiteY58" fmla="*/ 782682 h 2355494"/>
              <a:gd name="connsiteX59" fmla="*/ 2495817 w 2866309"/>
              <a:gd name="connsiteY59" fmla="*/ 944607 h 2355494"/>
              <a:gd name="connsiteX60" fmla="*/ 2413267 w 2866309"/>
              <a:gd name="connsiteY60" fmla="*/ 1100182 h 2355494"/>
              <a:gd name="connsiteX61" fmla="*/ 2320128 w 2866309"/>
              <a:gd name="connsiteY61" fmla="*/ 1214833 h 2355494"/>
              <a:gd name="connsiteX62" fmla="*/ 2265312 w 2866309"/>
              <a:gd name="connsiteY62" fmla="*/ 1243692 h 2355494"/>
              <a:gd name="connsiteX63" fmla="*/ 2022742 w 2866309"/>
              <a:gd name="connsiteY63" fmla="*/ 1347832 h 2355494"/>
              <a:gd name="connsiteX64" fmla="*/ 1854467 w 2866309"/>
              <a:gd name="connsiteY64" fmla="*/ 1401807 h 2355494"/>
              <a:gd name="connsiteX65" fmla="*/ 1581417 w 2866309"/>
              <a:gd name="connsiteY65" fmla="*/ 1458957 h 2355494"/>
              <a:gd name="connsiteX66" fmla="*/ 1340117 w 2866309"/>
              <a:gd name="connsiteY66" fmla="*/ 1611357 h 2355494"/>
              <a:gd name="connsiteX67" fmla="*/ 1378217 w 2866309"/>
              <a:gd name="connsiteY67" fmla="*/ 1782807 h 2355494"/>
              <a:gd name="connsiteX68" fmla="*/ 1803667 w 2866309"/>
              <a:gd name="connsiteY68" fmla="*/ 2036807 h 2355494"/>
              <a:gd name="connsiteX69" fmla="*/ 1416317 w 2866309"/>
              <a:gd name="connsiteY69" fmla="*/ 1859007 h 2355494"/>
              <a:gd name="connsiteX70" fmla="*/ 1225817 w 2866309"/>
              <a:gd name="connsiteY70" fmla="*/ 1687557 h 2355494"/>
              <a:gd name="connsiteX71" fmla="*/ 924192 w 2866309"/>
              <a:gd name="connsiteY71" fmla="*/ 1681207 h 2355494"/>
              <a:gd name="connsiteX72" fmla="*/ 705117 w 2866309"/>
              <a:gd name="connsiteY72" fmla="*/ 1973307 h 2355494"/>
              <a:gd name="connsiteX73" fmla="*/ 533667 w 2866309"/>
              <a:gd name="connsiteY73" fmla="*/ 2252707 h 2355494"/>
              <a:gd name="connsiteX74" fmla="*/ 190767 w 2866309"/>
              <a:gd name="connsiteY74" fmla="*/ 2354307 h 2355494"/>
              <a:gd name="connsiteX75" fmla="*/ 267 w 2866309"/>
              <a:gd name="connsiteY75" fmla="*/ 2309857 h 2355494"/>
              <a:gd name="connsiteX76" fmla="*/ 228867 w 2866309"/>
              <a:gd name="connsiteY76" fmla="*/ 2335257 h 2355494"/>
              <a:gd name="connsiteX77" fmla="*/ 489217 w 2866309"/>
              <a:gd name="connsiteY77" fmla="*/ 2240007 h 2355494"/>
              <a:gd name="connsiteX78" fmla="*/ 622567 w 2866309"/>
              <a:gd name="connsiteY78" fmla="*/ 2036807 h 2355494"/>
              <a:gd name="connsiteX79" fmla="*/ 673367 w 2866309"/>
              <a:gd name="connsiteY79" fmla="*/ 1808207 h 2355494"/>
              <a:gd name="connsiteX80" fmla="*/ 273317 w 2866309"/>
              <a:gd name="connsiteY80" fmla="*/ 2125707 h 2355494"/>
              <a:gd name="connsiteX81" fmla="*/ 114567 w 2866309"/>
              <a:gd name="connsiteY81" fmla="*/ 2132057 h 2355494"/>
              <a:gd name="connsiteX82" fmla="*/ 222517 w 2866309"/>
              <a:gd name="connsiteY82" fmla="*/ 2119357 h 2355494"/>
              <a:gd name="connsiteX83" fmla="*/ 393967 w 2866309"/>
              <a:gd name="connsiteY83" fmla="*/ 1998707 h 2355494"/>
              <a:gd name="connsiteX84" fmla="*/ 552717 w 2866309"/>
              <a:gd name="connsiteY84" fmla="*/ 1855832 h 2355494"/>
              <a:gd name="connsiteX85" fmla="*/ 819417 w 2866309"/>
              <a:gd name="connsiteY85" fmla="*/ 1636757 h 2355494"/>
              <a:gd name="connsiteX86" fmla="*/ 901967 w 2866309"/>
              <a:gd name="connsiteY86" fmla="*/ 1306557 h 2355494"/>
              <a:gd name="connsiteX87" fmla="*/ 641617 w 2866309"/>
              <a:gd name="connsiteY87" fmla="*/ 1179557 h 2355494"/>
              <a:gd name="connsiteX88" fmla="*/ 482867 w 2866309"/>
              <a:gd name="connsiteY88" fmla="*/ 1090657 h 2355494"/>
              <a:gd name="connsiteX89" fmla="*/ 717817 w 2866309"/>
              <a:gd name="connsiteY89" fmla="*/ 1173207 h 2355494"/>
              <a:gd name="connsiteX90" fmla="*/ 692417 w 2866309"/>
              <a:gd name="connsiteY90" fmla="*/ 950957 h 2355494"/>
              <a:gd name="connsiteX91" fmla="*/ 584467 w 2866309"/>
              <a:gd name="connsiteY91" fmla="*/ 830307 h 2355494"/>
              <a:gd name="connsiteX92" fmla="*/ 711467 w 2866309"/>
              <a:gd name="connsiteY92" fmla="*/ 931907 h 2355494"/>
              <a:gd name="connsiteX93" fmla="*/ 749567 w 2866309"/>
              <a:gd name="connsiteY93" fmla="*/ 1109707 h 2355494"/>
              <a:gd name="connsiteX94" fmla="*/ 781317 w 2866309"/>
              <a:gd name="connsiteY94" fmla="*/ 1058907 h 2355494"/>
              <a:gd name="connsiteX95" fmla="*/ 800367 w 2866309"/>
              <a:gd name="connsiteY95" fmla="*/ 912857 h 2355494"/>
              <a:gd name="connsiteX96" fmla="*/ 724167 w 2866309"/>
              <a:gd name="connsiteY96" fmla="*/ 722357 h 2355494"/>
              <a:gd name="connsiteX97" fmla="*/ 813067 w 2866309"/>
              <a:gd name="connsiteY97" fmla="*/ 862057 h 2355494"/>
              <a:gd name="connsiteX98" fmla="*/ 806717 w 2866309"/>
              <a:gd name="connsiteY98" fmla="*/ 1033507 h 2355494"/>
              <a:gd name="connsiteX99" fmla="*/ 813067 w 2866309"/>
              <a:gd name="connsiteY99" fmla="*/ 1204957 h 2355494"/>
              <a:gd name="connsiteX100" fmla="*/ 940067 w 2866309"/>
              <a:gd name="connsiteY100" fmla="*/ 1312907 h 2355494"/>
              <a:gd name="connsiteX101" fmla="*/ 1016267 w 2866309"/>
              <a:gd name="connsiteY101" fmla="*/ 1046207 h 2355494"/>
              <a:gd name="connsiteX102" fmla="*/ 1009917 w 2866309"/>
              <a:gd name="connsiteY102" fmla="*/ 1198607 h 2355494"/>
              <a:gd name="connsiteX103" fmla="*/ 1009917 w 2866309"/>
              <a:gd name="connsiteY103" fmla="*/ 1287507 h 2355494"/>
              <a:gd name="connsiteX104" fmla="*/ 1130567 w 2866309"/>
              <a:gd name="connsiteY104" fmla="*/ 1274807 h 2355494"/>
              <a:gd name="connsiteX105" fmla="*/ 1263917 w 2866309"/>
              <a:gd name="connsiteY105" fmla="*/ 1046207 h 2355494"/>
              <a:gd name="connsiteX106" fmla="*/ 1302017 w 2866309"/>
              <a:gd name="connsiteY106" fmla="*/ 665207 h 2355494"/>
              <a:gd name="connsiteX107" fmla="*/ 1263123 w 2866309"/>
              <a:gd name="connsiteY107" fmla="*/ 519157 h 2355494"/>
              <a:gd name="connsiteX108" fmla="*/ 1042026 w 2866309"/>
              <a:gd name="connsiteY108" fmla="*/ 455155 h 2355494"/>
              <a:gd name="connsiteX109" fmla="*/ 909905 w 2866309"/>
              <a:gd name="connsiteY109" fmla="*/ 436607 h 2355494"/>
              <a:gd name="connsiteX0" fmla="*/ 909905 w 2866309"/>
              <a:gd name="connsiteY0" fmla="*/ 433935 h 2352822"/>
              <a:gd name="connsiteX1" fmla="*/ 1219467 w 2866309"/>
              <a:gd name="connsiteY1" fmla="*/ 472035 h 2352822"/>
              <a:gd name="connsiteX2" fmla="*/ 1282967 w 2866309"/>
              <a:gd name="connsiteY2" fmla="*/ 484735 h 2352822"/>
              <a:gd name="connsiteX3" fmla="*/ 1308367 w 2866309"/>
              <a:gd name="connsiteY3" fmla="*/ 440285 h 2352822"/>
              <a:gd name="connsiteX4" fmla="*/ 1289317 w 2866309"/>
              <a:gd name="connsiteY4" fmla="*/ 319635 h 2352822"/>
              <a:gd name="connsiteX5" fmla="*/ 1333767 w 2866309"/>
              <a:gd name="connsiteY5" fmla="*/ 205335 h 2352822"/>
              <a:gd name="connsiteX6" fmla="*/ 1308367 w 2866309"/>
              <a:gd name="connsiteY6" fmla="*/ 332335 h 2352822"/>
              <a:gd name="connsiteX7" fmla="*/ 1333767 w 2866309"/>
              <a:gd name="connsiteY7" fmla="*/ 414885 h 2352822"/>
              <a:gd name="connsiteX8" fmla="*/ 1384567 w 2866309"/>
              <a:gd name="connsiteY8" fmla="*/ 294235 h 2352822"/>
              <a:gd name="connsiteX9" fmla="*/ 1340117 w 2866309"/>
              <a:gd name="connsiteY9" fmla="*/ 465685 h 2352822"/>
              <a:gd name="connsiteX10" fmla="*/ 1341704 w 2866309"/>
              <a:gd name="connsiteY10" fmla="*/ 502197 h 2352822"/>
              <a:gd name="connsiteX11" fmla="*/ 1359167 w 2866309"/>
              <a:gd name="connsiteY11" fmla="*/ 814935 h 2352822"/>
              <a:gd name="connsiteX12" fmla="*/ 1429017 w 2866309"/>
              <a:gd name="connsiteY12" fmla="*/ 1018135 h 2352822"/>
              <a:gd name="connsiteX13" fmla="*/ 1689367 w 2866309"/>
              <a:gd name="connsiteY13" fmla="*/ 865735 h 2352822"/>
              <a:gd name="connsiteX14" fmla="*/ 1689367 w 2866309"/>
              <a:gd name="connsiteY14" fmla="*/ 484735 h 2352822"/>
              <a:gd name="connsiteX15" fmla="*/ 1740167 w 2866309"/>
              <a:gd name="connsiteY15" fmla="*/ 275185 h 2352822"/>
              <a:gd name="connsiteX16" fmla="*/ 1822717 w 2866309"/>
              <a:gd name="connsiteY16" fmla="*/ 116435 h 2352822"/>
              <a:gd name="connsiteX17" fmla="*/ 1733817 w 2866309"/>
              <a:gd name="connsiteY17" fmla="*/ 376785 h 2352822"/>
              <a:gd name="connsiteX18" fmla="*/ 1835417 w 2866309"/>
              <a:gd name="connsiteY18" fmla="*/ 370435 h 2352822"/>
              <a:gd name="connsiteX19" fmla="*/ 1917967 w 2866309"/>
              <a:gd name="connsiteY19" fmla="*/ 186285 h 2352822"/>
              <a:gd name="connsiteX20" fmla="*/ 1836687 w 2866309"/>
              <a:gd name="connsiteY20" fmla="*/ 396470 h 2352822"/>
              <a:gd name="connsiteX21" fmla="*/ 1721117 w 2866309"/>
              <a:gd name="connsiteY21" fmla="*/ 452985 h 2352822"/>
              <a:gd name="connsiteX22" fmla="*/ 1733817 w 2866309"/>
              <a:gd name="connsiteY22" fmla="*/ 643485 h 2352822"/>
              <a:gd name="connsiteX23" fmla="*/ 1937017 w 2866309"/>
              <a:gd name="connsiteY23" fmla="*/ 541885 h 2352822"/>
              <a:gd name="connsiteX24" fmla="*/ 1968767 w 2866309"/>
              <a:gd name="connsiteY24" fmla="*/ 116435 h 2352822"/>
              <a:gd name="connsiteX25" fmla="*/ 1981467 w 2866309"/>
              <a:gd name="connsiteY25" fmla="*/ 8485 h 2352822"/>
              <a:gd name="connsiteX26" fmla="*/ 1987817 w 2866309"/>
              <a:gd name="connsiteY26" fmla="*/ 291060 h 2352822"/>
              <a:gd name="connsiteX27" fmla="*/ 1947335 w 2866309"/>
              <a:gd name="connsiteY27" fmla="*/ 569666 h 2352822"/>
              <a:gd name="connsiteX28" fmla="*/ 1860817 w 2866309"/>
              <a:gd name="connsiteY28" fmla="*/ 662535 h 2352822"/>
              <a:gd name="connsiteX29" fmla="*/ 2057667 w 2866309"/>
              <a:gd name="connsiteY29" fmla="*/ 710954 h 2352822"/>
              <a:gd name="connsiteX30" fmla="*/ 2115341 w 2866309"/>
              <a:gd name="connsiteY30" fmla="*/ 704954 h 2352822"/>
              <a:gd name="connsiteX31" fmla="*/ 2229117 w 2866309"/>
              <a:gd name="connsiteY31" fmla="*/ 649835 h 2352822"/>
              <a:gd name="connsiteX32" fmla="*/ 2089417 w 2866309"/>
              <a:gd name="connsiteY32" fmla="*/ 732385 h 2352822"/>
              <a:gd name="connsiteX33" fmla="*/ 1879867 w 2866309"/>
              <a:gd name="connsiteY33" fmla="*/ 719685 h 2352822"/>
              <a:gd name="connsiteX34" fmla="*/ 1784617 w 2866309"/>
              <a:gd name="connsiteY34" fmla="*/ 700635 h 2352822"/>
              <a:gd name="connsiteX35" fmla="*/ 1733817 w 2866309"/>
              <a:gd name="connsiteY35" fmla="*/ 865735 h 2352822"/>
              <a:gd name="connsiteX36" fmla="*/ 1575067 w 2866309"/>
              <a:gd name="connsiteY36" fmla="*/ 1049885 h 2352822"/>
              <a:gd name="connsiteX37" fmla="*/ 1536967 w 2866309"/>
              <a:gd name="connsiteY37" fmla="*/ 1303885 h 2352822"/>
              <a:gd name="connsiteX38" fmla="*/ 1829067 w 2866309"/>
              <a:gd name="connsiteY38" fmla="*/ 1348335 h 2352822"/>
              <a:gd name="connsiteX39" fmla="*/ 2140217 w 2866309"/>
              <a:gd name="connsiteY39" fmla="*/ 1068935 h 2352822"/>
              <a:gd name="connsiteX40" fmla="*/ 2165617 w 2866309"/>
              <a:gd name="connsiteY40" fmla="*/ 907010 h 2352822"/>
              <a:gd name="connsiteX41" fmla="*/ 2171967 w 2866309"/>
              <a:gd name="connsiteY41" fmla="*/ 789535 h 2352822"/>
              <a:gd name="connsiteX42" fmla="*/ 2191017 w 2866309"/>
              <a:gd name="connsiteY42" fmla="*/ 989560 h 2352822"/>
              <a:gd name="connsiteX43" fmla="*/ 2144185 w 2866309"/>
              <a:gd name="connsiteY43" fmla="*/ 1099097 h 2352822"/>
              <a:gd name="connsiteX44" fmla="*/ 1962417 w 2866309"/>
              <a:gd name="connsiteY44" fmla="*/ 1297535 h 2352822"/>
              <a:gd name="connsiteX45" fmla="*/ 2292617 w 2866309"/>
              <a:gd name="connsiteY45" fmla="*/ 1183235 h 2352822"/>
              <a:gd name="connsiteX46" fmla="*/ 2324367 w 2866309"/>
              <a:gd name="connsiteY46" fmla="*/ 732385 h 2352822"/>
              <a:gd name="connsiteX47" fmla="*/ 2352942 w 2866309"/>
              <a:gd name="connsiteY47" fmla="*/ 1013372 h 2352822"/>
              <a:gd name="connsiteX48" fmla="*/ 2349767 w 2866309"/>
              <a:gd name="connsiteY48" fmla="*/ 1129260 h 2352822"/>
              <a:gd name="connsiteX49" fmla="*/ 2540267 w 2866309"/>
              <a:gd name="connsiteY49" fmla="*/ 624435 h 2352822"/>
              <a:gd name="connsiteX50" fmla="*/ 2864117 w 2866309"/>
              <a:gd name="connsiteY50" fmla="*/ 408535 h 2352822"/>
              <a:gd name="connsiteX51" fmla="*/ 2676792 w 2866309"/>
              <a:gd name="connsiteY51" fmla="*/ 524422 h 2352822"/>
              <a:gd name="connsiteX52" fmla="*/ 2568048 w 2866309"/>
              <a:gd name="connsiteY52" fmla="*/ 626023 h 2352822"/>
              <a:gd name="connsiteX53" fmla="*/ 2517772 w 2866309"/>
              <a:gd name="connsiteY53" fmla="*/ 712099 h 2352822"/>
              <a:gd name="connsiteX54" fmla="*/ 2500580 w 2866309"/>
              <a:gd name="connsiteY54" fmla="*/ 745879 h 2352822"/>
              <a:gd name="connsiteX55" fmla="*/ 2450573 w 2866309"/>
              <a:gd name="connsiteY55" fmla="*/ 940347 h 2352822"/>
              <a:gd name="connsiteX56" fmla="*/ 2673617 w 2866309"/>
              <a:gd name="connsiteY56" fmla="*/ 764135 h 2352822"/>
              <a:gd name="connsiteX57" fmla="*/ 2711717 w 2866309"/>
              <a:gd name="connsiteY57" fmla="*/ 637135 h 2352822"/>
              <a:gd name="connsiteX58" fmla="*/ 2676792 w 2866309"/>
              <a:gd name="connsiteY58" fmla="*/ 780010 h 2352822"/>
              <a:gd name="connsiteX59" fmla="*/ 2495817 w 2866309"/>
              <a:gd name="connsiteY59" fmla="*/ 941935 h 2352822"/>
              <a:gd name="connsiteX60" fmla="*/ 2413267 w 2866309"/>
              <a:gd name="connsiteY60" fmla="*/ 1097510 h 2352822"/>
              <a:gd name="connsiteX61" fmla="*/ 2320128 w 2866309"/>
              <a:gd name="connsiteY61" fmla="*/ 1212161 h 2352822"/>
              <a:gd name="connsiteX62" fmla="*/ 2265312 w 2866309"/>
              <a:gd name="connsiteY62" fmla="*/ 1241020 h 2352822"/>
              <a:gd name="connsiteX63" fmla="*/ 2022742 w 2866309"/>
              <a:gd name="connsiteY63" fmla="*/ 1345160 h 2352822"/>
              <a:gd name="connsiteX64" fmla="*/ 1854467 w 2866309"/>
              <a:gd name="connsiteY64" fmla="*/ 1399135 h 2352822"/>
              <a:gd name="connsiteX65" fmla="*/ 1581417 w 2866309"/>
              <a:gd name="connsiteY65" fmla="*/ 1456285 h 2352822"/>
              <a:gd name="connsiteX66" fmla="*/ 1340117 w 2866309"/>
              <a:gd name="connsiteY66" fmla="*/ 1608685 h 2352822"/>
              <a:gd name="connsiteX67" fmla="*/ 1378217 w 2866309"/>
              <a:gd name="connsiteY67" fmla="*/ 1780135 h 2352822"/>
              <a:gd name="connsiteX68" fmla="*/ 1803667 w 2866309"/>
              <a:gd name="connsiteY68" fmla="*/ 2034135 h 2352822"/>
              <a:gd name="connsiteX69" fmla="*/ 1416317 w 2866309"/>
              <a:gd name="connsiteY69" fmla="*/ 1856335 h 2352822"/>
              <a:gd name="connsiteX70" fmla="*/ 1225817 w 2866309"/>
              <a:gd name="connsiteY70" fmla="*/ 1684885 h 2352822"/>
              <a:gd name="connsiteX71" fmla="*/ 924192 w 2866309"/>
              <a:gd name="connsiteY71" fmla="*/ 1678535 h 2352822"/>
              <a:gd name="connsiteX72" fmla="*/ 705117 w 2866309"/>
              <a:gd name="connsiteY72" fmla="*/ 1970635 h 2352822"/>
              <a:gd name="connsiteX73" fmla="*/ 533667 w 2866309"/>
              <a:gd name="connsiteY73" fmla="*/ 2250035 h 2352822"/>
              <a:gd name="connsiteX74" fmla="*/ 190767 w 2866309"/>
              <a:gd name="connsiteY74" fmla="*/ 2351635 h 2352822"/>
              <a:gd name="connsiteX75" fmla="*/ 267 w 2866309"/>
              <a:gd name="connsiteY75" fmla="*/ 2307185 h 2352822"/>
              <a:gd name="connsiteX76" fmla="*/ 228867 w 2866309"/>
              <a:gd name="connsiteY76" fmla="*/ 2332585 h 2352822"/>
              <a:gd name="connsiteX77" fmla="*/ 489217 w 2866309"/>
              <a:gd name="connsiteY77" fmla="*/ 2237335 h 2352822"/>
              <a:gd name="connsiteX78" fmla="*/ 622567 w 2866309"/>
              <a:gd name="connsiteY78" fmla="*/ 2034135 h 2352822"/>
              <a:gd name="connsiteX79" fmla="*/ 673367 w 2866309"/>
              <a:gd name="connsiteY79" fmla="*/ 1805535 h 2352822"/>
              <a:gd name="connsiteX80" fmla="*/ 273317 w 2866309"/>
              <a:gd name="connsiteY80" fmla="*/ 2123035 h 2352822"/>
              <a:gd name="connsiteX81" fmla="*/ 114567 w 2866309"/>
              <a:gd name="connsiteY81" fmla="*/ 2129385 h 2352822"/>
              <a:gd name="connsiteX82" fmla="*/ 222517 w 2866309"/>
              <a:gd name="connsiteY82" fmla="*/ 2116685 h 2352822"/>
              <a:gd name="connsiteX83" fmla="*/ 393967 w 2866309"/>
              <a:gd name="connsiteY83" fmla="*/ 1996035 h 2352822"/>
              <a:gd name="connsiteX84" fmla="*/ 552717 w 2866309"/>
              <a:gd name="connsiteY84" fmla="*/ 1853160 h 2352822"/>
              <a:gd name="connsiteX85" fmla="*/ 819417 w 2866309"/>
              <a:gd name="connsiteY85" fmla="*/ 1634085 h 2352822"/>
              <a:gd name="connsiteX86" fmla="*/ 901967 w 2866309"/>
              <a:gd name="connsiteY86" fmla="*/ 1303885 h 2352822"/>
              <a:gd name="connsiteX87" fmla="*/ 641617 w 2866309"/>
              <a:gd name="connsiteY87" fmla="*/ 1176885 h 2352822"/>
              <a:gd name="connsiteX88" fmla="*/ 482867 w 2866309"/>
              <a:gd name="connsiteY88" fmla="*/ 1087985 h 2352822"/>
              <a:gd name="connsiteX89" fmla="*/ 717817 w 2866309"/>
              <a:gd name="connsiteY89" fmla="*/ 1170535 h 2352822"/>
              <a:gd name="connsiteX90" fmla="*/ 692417 w 2866309"/>
              <a:gd name="connsiteY90" fmla="*/ 948285 h 2352822"/>
              <a:gd name="connsiteX91" fmla="*/ 584467 w 2866309"/>
              <a:gd name="connsiteY91" fmla="*/ 827635 h 2352822"/>
              <a:gd name="connsiteX92" fmla="*/ 711467 w 2866309"/>
              <a:gd name="connsiteY92" fmla="*/ 929235 h 2352822"/>
              <a:gd name="connsiteX93" fmla="*/ 749567 w 2866309"/>
              <a:gd name="connsiteY93" fmla="*/ 1107035 h 2352822"/>
              <a:gd name="connsiteX94" fmla="*/ 781317 w 2866309"/>
              <a:gd name="connsiteY94" fmla="*/ 1056235 h 2352822"/>
              <a:gd name="connsiteX95" fmla="*/ 800367 w 2866309"/>
              <a:gd name="connsiteY95" fmla="*/ 910185 h 2352822"/>
              <a:gd name="connsiteX96" fmla="*/ 724167 w 2866309"/>
              <a:gd name="connsiteY96" fmla="*/ 719685 h 2352822"/>
              <a:gd name="connsiteX97" fmla="*/ 813067 w 2866309"/>
              <a:gd name="connsiteY97" fmla="*/ 859385 h 2352822"/>
              <a:gd name="connsiteX98" fmla="*/ 806717 w 2866309"/>
              <a:gd name="connsiteY98" fmla="*/ 1030835 h 2352822"/>
              <a:gd name="connsiteX99" fmla="*/ 813067 w 2866309"/>
              <a:gd name="connsiteY99" fmla="*/ 1202285 h 2352822"/>
              <a:gd name="connsiteX100" fmla="*/ 940067 w 2866309"/>
              <a:gd name="connsiteY100" fmla="*/ 1310235 h 2352822"/>
              <a:gd name="connsiteX101" fmla="*/ 1016267 w 2866309"/>
              <a:gd name="connsiteY101" fmla="*/ 1043535 h 2352822"/>
              <a:gd name="connsiteX102" fmla="*/ 1009917 w 2866309"/>
              <a:gd name="connsiteY102" fmla="*/ 1195935 h 2352822"/>
              <a:gd name="connsiteX103" fmla="*/ 1009917 w 2866309"/>
              <a:gd name="connsiteY103" fmla="*/ 1284835 h 2352822"/>
              <a:gd name="connsiteX104" fmla="*/ 1130567 w 2866309"/>
              <a:gd name="connsiteY104" fmla="*/ 1272135 h 2352822"/>
              <a:gd name="connsiteX105" fmla="*/ 1263917 w 2866309"/>
              <a:gd name="connsiteY105" fmla="*/ 1043535 h 2352822"/>
              <a:gd name="connsiteX106" fmla="*/ 1302017 w 2866309"/>
              <a:gd name="connsiteY106" fmla="*/ 662535 h 2352822"/>
              <a:gd name="connsiteX107" fmla="*/ 1263123 w 2866309"/>
              <a:gd name="connsiteY107" fmla="*/ 516485 h 2352822"/>
              <a:gd name="connsiteX108" fmla="*/ 1042026 w 2866309"/>
              <a:gd name="connsiteY108" fmla="*/ 452483 h 2352822"/>
              <a:gd name="connsiteX109" fmla="*/ 909905 w 2866309"/>
              <a:gd name="connsiteY109" fmla="*/ 433935 h 2352822"/>
              <a:gd name="connsiteX0" fmla="*/ 909905 w 2866309"/>
              <a:gd name="connsiteY0" fmla="*/ 433935 h 2352822"/>
              <a:gd name="connsiteX1" fmla="*/ 1219467 w 2866309"/>
              <a:gd name="connsiteY1" fmla="*/ 472035 h 2352822"/>
              <a:gd name="connsiteX2" fmla="*/ 1282967 w 2866309"/>
              <a:gd name="connsiteY2" fmla="*/ 484735 h 2352822"/>
              <a:gd name="connsiteX3" fmla="*/ 1308367 w 2866309"/>
              <a:gd name="connsiteY3" fmla="*/ 440285 h 2352822"/>
              <a:gd name="connsiteX4" fmla="*/ 1289317 w 2866309"/>
              <a:gd name="connsiteY4" fmla="*/ 319635 h 2352822"/>
              <a:gd name="connsiteX5" fmla="*/ 1333767 w 2866309"/>
              <a:gd name="connsiteY5" fmla="*/ 205335 h 2352822"/>
              <a:gd name="connsiteX6" fmla="*/ 1308367 w 2866309"/>
              <a:gd name="connsiteY6" fmla="*/ 332335 h 2352822"/>
              <a:gd name="connsiteX7" fmla="*/ 1333767 w 2866309"/>
              <a:gd name="connsiteY7" fmla="*/ 414885 h 2352822"/>
              <a:gd name="connsiteX8" fmla="*/ 1384567 w 2866309"/>
              <a:gd name="connsiteY8" fmla="*/ 294235 h 2352822"/>
              <a:gd name="connsiteX9" fmla="*/ 1340117 w 2866309"/>
              <a:gd name="connsiteY9" fmla="*/ 465685 h 2352822"/>
              <a:gd name="connsiteX10" fmla="*/ 1341704 w 2866309"/>
              <a:gd name="connsiteY10" fmla="*/ 502197 h 2352822"/>
              <a:gd name="connsiteX11" fmla="*/ 1359167 w 2866309"/>
              <a:gd name="connsiteY11" fmla="*/ 814935 h 2352822"/>
              <a:gd name="connsiteX12" fmla="*/ 1429017 w 2866309"/>
              <a:gd name="connsiteY12" fmla="*/ 1018135 h 2352822"/>
              <a:gd name="connsiteX13" fmla="*/ 1689367 w 2866309"/>
              <a:gd name="connsiteY13" fmla="*/ 865735 h 2352822"/>
              <a:gd name="connsiteX14" fmla="*/ 1689367 w 2866309"/>
              <a:gd name="connsiteY14" fmla="*/ 484735 h 2352822"/>
              <a:gd name="connsiteX15" fmla="*/ 1740167 w 2866309"/>
              <a:gd name="connsiteY15" fmla="*/ 275185 h 2352822"/>
              <a:gd name="connsiteX16" fmla="*/ 1822717 w 2866309"/>
              <a:gd name="connsiteY16" fmla="*/ 116435 h 2352822"/>
              <a:gd name="connsiteX17" fmla="*/ 1733817 w 2866309"/>
              <a:gd name="connsiteY17" fmla="*/ 376785 h 2352822"/>
              <a:gd name="connsiteX18" fmla="*/ 1835417 w 2866309"/>
              <a:gd name="connsiteY18" fmla="*/ 370435 h 2352822"/>
              <a:gd name="connsiteX19" fmla="*/ 1917967 w 2866309"/>
              <a:gd name="connsiteY19" fmla="*/ 186285 h 2352822"/>
              <a:gd name="connsiteX20" fmla="*/ 1836687 w 2866309"/>
              <a:gd name="connsiteY20" fmla="*/ 396470 h 2352822"/>
              <a:gd name="connsiteX21" fmla="*/ 1721117 w 2866309"/>
              <a:gd name="connsiteY21" fmla="*/ 452985 h 2352822"/>
              <a:gd name="connsiteX22" fmla="*/ 1733817 w 2866309"/>
              <a:gd name="connsiteY22" fmla="*/ 643485 h 2352822"/>
              <a:gd name="connsiteX23" fmla="*/ 1937017 w 2866309"/>
              <a:gd name="connsiteY23" fmla="*/ 541885 h 2352822"/>
              <a:gd name="connsiteX24" fmla="*/ 1968767 w 2866309"/>
              <a:gd name="connsiteY24" fmla="*/ 116435 h 2352822"/>
              <a:gd name="connsiteX25" fmla="*/ 1981467 w 2866309"/>
              <a:gd name="connsiteY25" fmla="*/ 8485 h 2352822"/>
              <a:gd name="connsiteX26" fmla="*/ 1987817 w 2866309"/>
              <a:gd name="connsiteY26" fmla="*/ 291060 h 2352822"/>
              <a:gd name="connsiteX27" fmla="*/ 1947335 w 2866309"/>
              <a:gd name="connsiteY27" fmla="*/ 569666 h 2352822"/>
              <a:gd name="connsiteX28" fmla="*/ 1860817 w 2866309"/>
              <a:gd name="connsiteY28" fmla="*/ 662535 h 2352822"/>
              <a:gd name="connsiteX29" fmla="*/ 2057667 w 2866309"/>
              <a:gd name="connsiteY29" fmla="*/ 710954 h 2352822"/>
              <a:gd name="connsiteX30" fmla="*/ 2115341 w 2866309"/>
              <a:gd name="connsiteY30" fmla="*/ 704954 h 2352822"/>
              <a:gd name="connsiteX31" fmla="*/ 2229117 w 2866309"/>
              <a:gd name="connsiteY31" fmla="*/ 649835 h 2352822"/>
              <a:gd name="connsiteX32" fmla="*/ 2089417 w 2866309"/>
              <a:gd name="connsiteY32" fmla="*/ 732385 h 2352822"/>
              <a:gd name="connsiteX33" fmla="*/ 1879867 w 2866309"/>
              <a:gd name="connsiteY33" fmla="*/ 719685 h 2352822"/>
              <a:gd name="connsiteX34" fmla="*/ 1784617 w 2866309"/>
              <a:gd name="connsiteY34" fmla="*/ 700635 h 2352822"/>
              <a:gd name="connsiteX35" fmla="*/ 1733817 w 2866309"/>
              <a:gd name="connsiteY35" fmla="*/ 865735 h 2352822"/>
              <a:gd name="connsiteX36" fmla="*/ 1575067 w 2866309"/>
              <a:gd name="connsiteY36" fmla="*/ 1049885 h 2352822"/>
              <a:gd name="connsiteX37" fmla="*/ 1536967 w 2866309"/>
              <a:gd name="connsiteY37" fmla="*/ 1303885 h 2352822"/>
              <a:gd name="connsiteX38" fmla="*/ 1829067 w 2866309"/>
              <a:gd name="connsiteY38" fmla="*/ 1348335 h 2352822"/>
              <a:gd name="connsiteX39" fmla="*/ 2140217 w 2866309"/>
              <a:gd name="connsiteY39" fmla="*/ 1068935 h 2352822"/>
              <a:gd name="connsiteX40" fmla="*/ 2165617 w 2866309"/>
              <a:gd name="connsiteY40" fmla="*/ 907010 h 2352822"/>
              <a:gd name="connsiteX41" fmla="*/ 2171967 w 2866309"/>
              <a:gd name="connsiteY41" fmla="*/ 789535 h 2352822"/>
              <a:gd name="connsiteX42" fmla="*/ 2191017 w 2866309"/>
              <a:gd name="connsiteY42" fmla="*/ 989560 h 2352822"/>
              <a:gd name="connsiteX43" fmla="*/ 2144185 w 2866309"/>
              <a:gd name="connsiteY43" fmla="*/ 1099097 h 2352822"/>
              <a:gd name="connsiteX44" fmla="*/ 1962417 w 2866309"/>
              <a:gd name="connsiteY44" fmla="*/ 1297535 h 2352822"/>
              <a:gd name="connsiteX45" fmla="*/ 2292617 w 2866309"/>
              <a:gd name="connsiteY45" fmla="*/ 1183235 h 2352822"/>
              <a:gd name="connsiteX46" fmla="*/ 2324367 w 2866309"/>
              <a:gd name="connsiteY46" fmla="*/ 732385 h 2352822"/>
              <a:gd name="connsiteX47" fmla="*/ 2352942 w 2866309"/>
              <a:gd name="connsiteY47" fmla="*/ 1013372 h 2352822"/>
              <a:gd name="connsiteX48" fmla="*/ 2349767 w 2866309"/>
              <a:gd name="connsiteY48" fmla="*/ 1129260 h 2352822"/>
              <a:gd name="connsiteX49" fmla="*/ 2540267 w 2866309"/>
              <a:gd name="connsiteY49" fmla="*/ 624435 h 2352822"/>
              <a:gd name="connsiteX50" fmla="*/ 2864117 w 2866309"/>
              <a:gd name="connsiteY50" fmla="*/ 408535 h 2352822"/>
              <a:gd name="connsiteX51" fmla="*/ 2676792 w 2866309"/>
              <a:gd name="connsiteY51" fmla="*/ 524422 h 2352822"/>
              <a:gd name="connsiteX52" fmla="*/ 2568048 w 2866309"/>
              <a:gd name="connsiteY52" fmla="*/ 626023 h 2352822"/>
              <a:gd name="connsiteX53" fmla="*/ 2517772 w 2866309"/>
              <a:gd name="connsiteY53" fmla="*/ 712099 h 2352822"/>
              <a:gd name="connsiteX54" fmla="*/ 2500580 w 2866309"/>
              <a:gd name="connsiteY54" fmla="*/ 745879 h 2352822"/>
              <a:gd name="connsiteX55" fmla="*/ 2450573 w 2866309"/>
              <a:gd name="connsiteY55" fmla="*/ 940347 h 2352822"/>
              <a:gd name="connsiteX56" fmla="*/ 2673617 w 2866309"/>
              <a:gd name="connsiteY56" fmla="*/ 764135 h 2352822"/>
              <a:gd name="connsiteX57" fmla="*/ 2711717 w 2866309"/>
              <a:gd name="connsiteY57" fmla="*/ 637135 h 2352822"/>
              <a:gd name="connsiteX58" fmla="*/ 2676792 w 2866309"/>
              <a:gd name="connsiteY58" fmla="*/ 780010 h 2352822"/>
              <a:gd name="connsiteX59" fmla="*/ 2495817 w 2866309"/>
              <a:gd name="connsiteY59" fmla="*/ 941935 h 2352822"/>
              <a:gd name="connsiteX60" fmla="*/ 2413267 w 2866309"/>
              <a:gd name="connsiteY60" fmla="*/ 1097510 h 2352822"/>
              <a:gd name="connsiteX61" fmla="*/ 2320128 w 2866309"/>
              <a:gd name="connsiteY61" fmla="*/ 1212161 h 2352822"/>
              <a:gd name="connsiteX62" fmla="*/ 2265312 w 2866309"/>
              <a:gd name="connsiteY62" fmla="*/ 1241020 h 2352822"/>
              <a:gd name="connsiteX63" fmla="*/ 2022742 w 2866309"/>
              <a:gd name="connsiteY63" fmla="*/ 1345160 h 2352822"/>
              <a:gd name="connsiteX64" fmla="*/ 1854467 w 2866309"/>
              <a:gd name="connsiteY64" fmla="*/ 1399135 h 2352822"/>
              <a:gd name="connsiteX65" fmla="*/ 1581417 w 2866309"/>
              <a:gd name="connsiteY65" fmla="*/ 1456285 h 2352822"/>
              <a:gd name="connsiteX66" fmla="*/ 1340117 w 2866309"/>
              <a:gd name="connsiteY66" fmla="*/ 1608685 h 2352822"/>
              <a:gd name="connsiteX67" fmla="*/ 1378217 w 2866309"/>
              <a:gd name="connsiteY67" fmla="*/ 1780135 h 2352822"/>
              <a:gd name="connsiteX68" fmla="*/ 1803667 w 2866309"/>
              <a:gd name="connsiteY68" fmla="*/ 2034135 h 2352822"/>
              <a:gd name="connsiteX69" fmla="*/ 1416317 w 2866309"/>
              <a:gd name="connsiteY69" fmla="*/ 1856335 h 2352822"/>
              <a:gd name="connsiteX70" fmla="*/ 1225817 w 2866309"/>
              <a:gd name="connsiteY70" fmla="*/ 1684885 h 2352822"/>
              <a:gd name="connsiteX71" fmla="*/ 924192 w 2866309"/>
              <a:gd name="connsiteY71" fmla="*/ 1678535 h 2352822"/>
              <a:gd name="connsiteX72" fmla="*/ 705117 w 2866309"/>
              <a:gd name="connsiteY72" fmla="*/ 1970635 h 2352822"/>
              <a:gd name="connsiteX73" fmla="*/ 533667 w 2866309"/>
              <a:gd name="connsiteY73" fmla="*/ 2250035 h 2352822"/>
              <a:gd name="connsiteX74" fmla="*/ 190767 w 2866309"/>
              <a:gd name="connsiteY74" fmla="*/ 2351635 h 2352822"/>
              <a:gd name="connsiteX75" fmla="*/ 267 w 2866309"/>
              <a:gd name="connsiteY75" fmla="*/ 2307185 h 2352822"/>
              <a:gd name="connsiteX76" fmla="*/ 228867 w 2866309"/>
              <a:gd name="connsiteY76" fmla="*/ 2332585 h 2352822"/>
              <a:gd name="connsiteX77" fmla="*/ 489217 w 2866309"/>
              <a:gd name="connsiteY77" fmla="*/ 2237335 h 2352822"/>
              <a:gd name="connsiteX78" fmla="*/ 622567 w 2866309"/>
              <a:gd name="connsiteY78" fmla="*/ 2034135 h 2352822"/>
              <a:gd name="connsiteX79" fmla="*/ 673367 w 2866309"/>
              <a:gd name="connsiteY79" fmla="*/ 1805535 h 2352822"/>
              <a:gd name="connsiteX80" fmla="*/ 273317 w 2866309"/>
              <a:gd name="connsiteY80" fmla="*/ 2123035 h 2352822"/>
              <a:gd name="connsiteX81" fmla="*/ 114567 w 2866309"/>
              <a:gd name="connsiteY81" fmla="*/ 2129385 h 2352822"/>
              <a:gd name="connsiteX82" fmla="*/ 222517 w 2866309"/>
              <a:gd name="connsiteY82" fmla="*/ 2116685 h 2352822"/>
              <a:gd name="connsiteX83" fmla="*/ 393967 w 2866309"/>
              <a:gd name="connsiteY83" fmla="*/ 1996035 h 2352822"/>
              <a:gd name="connsiteX84" fmla="*/ 552717 w 2866309"/>
              <a:gd name="connsiteY84" fmla="*/ 1853160 h 2352822"/>
              <a:gd name="connsiteX85" fmla="*/ 819417 w 2866309"/>
              <a:gd name="connsiteY85" fmla="*/ 1634085 h 2352822"/>
              <a:gd name="connsiteX86" fmla="*/ 867042 w 2866309"/>
              <a:gd name="connsiteY86" fmla="*/ 1348335 h 2352822"/>
              <a:gd name="connsiteX87" fmla="*/ 641617 w 2866309"/>
              <a:gd name="connsiteY87" fmla="*/ 1176885 h 2352822"/>
              <a:gd name="connsiteX88" fmla="*/ 482867 w 2866309"/>
              <a:gd name="connsiteY88" fmla="*/ 1087985 h 2352822"/>
              <a:gd name="connsiteX89" fmla="*/ 717817 w 2866309"/>
              <a:gd name="connsiteY89" fmla="*/ 1170535 h 2352822"/>
              <a:gd name="connsiteX90" fmla="*/ 692417 w 2866309"/>
              <a:gd name="connsiteY90" fmla="*/ 948285 h 2352822"/>
              <a:gd name="connsiteX91" fmla="*/ 584467 w 2866309"/>
              <a:gd name="connsiteY91" fmla="*/ 827635 h 2352822"/>
              <a:gd name="connsiteX92" fmla="*/ 711467 w 2866309"/>
              <a:gd name="connsiteY92" fmla="*/ 929235 h 2352822"/>
              <a:gd name="connsiteX93" fmla="*/ 749567 w 2866309"/>
              <a:gd name="connsiteY93" fmla="*/ 1107035 h 2352822"/>
              <a:gd name="connsiteX94" fmla="*/ 781317 w 2866309"/>
              <a:gd name="connsiteY94" fmla="*/ 1056235 h 2352822"/>
              <a:gd name="connsiteX95" fmla="*/ 800367 w 2866309"/>
              <a:gd name="connsiteY95" fmla="*/ 910185 h 2352822"/>
              <a:gd name="connsiteX96" fmla="*/ 724167 w 2866309"/>
              <a:gd name="connsiteY96" fmla="*/ 719685 h 2352822"/>
              <a:gd name="connsiteX97" fmla="*/ 813067 w 2866309"/>
              <a:gd name="connsiteY97" fmla="*/ 859385 h 2352822"/>
              <a:gd name="connsiteX98" fmla="*/ 806717 w 2866309"/>
              <a:gd name="connsiteY98" fmla="*/ 1030835 h 2352822"/>
              <a:gd name="connsiteX99" fmla="*/ 813067 w 2866309"/>
              <a:gd name="connsiteY99" fmla="*/ 1202285 h 2352822"/>
              <a:gd name="connsiteX100" fmla="*/ 940067 w 2866309"/>
              <a:gd name="connsiteY100" fmla="*/ 1310235 h 2352822"/>
              <a:gd name="connsiteX101" fmla="*/ 1016267 w 2866309"/>
              <a:gd name="connsiteY101" fmla="*/ 1043535 h 2352822"/>
              <a:gd name="connsiteX102" fmla="*/ 1009917 w 2866309"/>
              <a:gd name="connsiteY102" fmla="*/ 1195935 h 2352822"/>
              <a:gd name="connsiteX103" fmla="*/ 1009917 w 2866309"/>
              <a:gd name="connsiteY103" fmla="*/ 1284835 h 2352822"/>
              <a:gd name="connsiteX104" fmla="*/ 1130567 w 2866309"/>
              <a:gd name="connsiteY104" fmla="*/ 1272135 h 2352822"/>
              <a:gd name="connsiteX105" fmla="*/ 1263917 w 2866309"/>
              <a:gd name="connsiteY105" fmla="*/ 1043535 h 2352822"/>
              <a:gd name="connsiteX106" fmla="*/ 1302017 w 2866309"/>
              <a:gd name="connsiteY106" fmla="*/ 662535 h 2352822"/>
              <a:gd name="connsiteX107" fmla="*/ 1263123 w 2866309"/>
              <a:gd name="connsiteY107" fmla="*/ 516485 h 2352822"/>
              <a:gd name="connsiteX108" fmla="*/ 1042026 w 2866309"/>
              <a:gd name="connsiteY108" fmla="*/ 452483 h 2352822"/>
              <a:gd name="connsiteX109" fmla="*/ 909905 w 2866309"/>
              <a:gd name="connsiteY109" fmla="*/ 433935 h 2352822"/>
              <a:gd name="connsiteX0" fmla="*/ 909905 w 2866309"/>
              <a:gd name="connsiteY0" fmla="*/ 433935 h 2352822"/>
              <a:gd name="connsiteX1" fmla="*/ 1219467 w 2866309"/>
              <a:gd name="connsiteY1" fmla="*/ 472035 h 2352822"/>
              <a:gd name="connsiteX2" fmla="*/ 1282967 w 2866309"/>
              <a:gd name="connsiteY2" fmla="*/ 484735 h 2352822"/>
              <a:gd name="connsiteX3" fmla="*/ 1308367 w 2866309"/>
              <a:gd name="connsiteY3" fmla="*/ 440285 h 2352822"/>
              <a:gd name="connsiteX4" fmla="*/ 1289317 w 2866309"/>
              <a:gd name="connsiteY4" fmla="*/ 319635 h 2352822"/>
              <a:gd name="connsiteX5" fmla="*/ 1333767 w 2866309"/>
              <a:gd name="connsiteY5" fmla="*/ 205335 h 2352822"/>
              <a:gd name="connsiteX6" fmla="*/ 1308367 w 2866309"/>
              <a:gd name="connsiteY6" fmla="*/ 332335 h 2352822"/>
              <a:gd name="connsiteX7" fmla="*/ 1333767 w 2866309"/>
              <a:gd name="connsiteY7" fmla="*/ 414885 h 2352822"/>
              <a:gd name="connsiteX8" fmla="*/ 1384567 w 2866309"/>
              <a:gd name="connsiteY8" fmla="*/ 294235 h 2352822"/>
              <a:gd name="connsiteX9" fmla="*/ 1340117 w 2866309"/>
              <a:gd name="connsiteY9" fmla="*/ 465685 h 2352822"/>
              <a:gd name="connsiteX10" fmla="*/ 1341704 w 2866309"/>
              <a:gd name="connsiteY10" fmla="*/ 502197 h 2352822"/>
              <a:gd name="connsiteX11" fmla="*/ 1359167 w 2866309"/>
              <a:gd name="connsiteY11" fmla="*/ 814935 h 2352822"/>
              <a:gd name="connsiteX12" fmla="*/ 1429017 w 2866309"/>
              <a:gd name="connsiteY12" fmla="*/ 1018135 h 2352822"/>
              <a:gd name="connsiteX13" fmla="*/ 1689367 w 2866309"/>
              <a:gd name="connsiteY13" fmla="*/ 865735 h 2352822"/>
              <a:gd name="connsiteX14" fmla="*/ 1689367 w 2866309"/>
              <a:gd name="connsiteY14" fmla="*/ 484735 h 2352822"/>
              <a:gd name="connsiteX15" fmla="*/ 1740167 w 2866309"/>
              <a:gd name="connsiteY15" fmla="*/ 275185 h 2352822"/>
              <a:gd name="connsiteX16" fmla="*/ 1822717 w 2866309"/>
              <a:gd name="connsiteY16" fmla="*/ 116435 h 2352822"/>
              <a:gd name="connsiteX17" fmla="*/ 1733817 w 2866309"/>
              <a:gd name="connsiteY17" fmla="*/ 376785 h 2352822"/>
              <a:gd name="connsiteX18" fmla="*/ 1835417 w 2866309"/>
              <a:gd name="connsiteY18" fmla="*/ 370435 h 2352822"/>
              <a:gd name="connsiteX19" fmla="*/ 1917967 w 2866309"/>
              <a:gd name="connsiteY19" fmla="*/ 186285 h 2352822"/>
              <a:gd name="connsiteX20" fmla="*/ 1836687 w 2866309"/>
              <a:gd name="connsiteY20" fmla="*/ 396470 h 2352822"/>
              <a:gd name="connsiteX21" fmla="*/ 1721117 w 2866309"/>
              <a:gd name="connsiteY21" fmla="*/ 452985 h 2352822"/>
              <a:gd name="connsiteX22" fmla="*/ 1733817 w 2866309"/>
              <a:gd name="connsiteY22" fmla="*/ 643485 h 2352822"/>
              <a:gd name="connsiteX23" fmla="*/ 1937017 w 2866309"/>
              <a:gd name="connsiteY23" fmla="*/ 541885 h 2352822"/>
              <a:gd name="connsiteX24" fmla="*/ 1968767 w 2866309"/>
              <a:gd name="connsiteY24" fmla="*/ 116435 h 2352822"/>
              <a:gd name="connsiteX25" fmla="*/ 1981467 w 2866309"/>
              <a:gd name="connsiteY25" fmla="*/ 8485 h 2352822"/>
              <a:gd name="connsiteX26" fmla="*/ 1987817 w 2866309"/>
              <a:gd name="connsiteY26" fmla="*/ 291060 h 2352822"/>
              <a:gd name="connsiteX27" fmla="*/ 1947335 w 2866309"/>
              <a:gd name="connsiteY27" fmla="*/ 569666 h 2352822"/>
              <a:gd name="connsiteX28" fmla="*/ 1860817 w 2866309"/>
              <a:gd name="connsiteY28" fmla="*/ 662535 h 2352822"/>
              <a:gd name="connsiteX29" fmla="*/ 2057667 w 2866309"/>
              <a:gd name="connsiteY29" fmla="*/ 710954 h 2352822"/>
              <a:gd name="connsiteX30" fmla="*/ 2115341 w 2866309"/>
              <a:gd name="connsiteY30" fmla="*/ 704954 h 2352822"/>
              <a:gd name="connsiteX31" fmla="*/ 2229117 w 2866309"/>
              <a:gd name="connsiteY31" fmla="*/ 649835 h 2352822"/>
              <a:gd name="connsiteX32" fmla="*/ 2089417 w 2866309"/>
              <a:gd name="connsiteY32" fmla="*/ 732385 h 2352822"/>
              <a:gd name="connsiteX33" fmla="*/ 1879867 w 2866309"/>
              <a:gd name="connsiteY33" fmla="*/ 719685 h 2352822"/>
              <a:gd name="connsiteX34" fmla="*/ 1784617 w 2866309"/>
              <a:gd name="connsiteY34" fmla="*/ 700635 h 2352822"/>
              <a:gd name="connsiteX35" fmla="*/ 1733817 w 2866309"/>
              <a:gd name="connsiteY35" fmla="*/ 865735 h 2352822"/>
              <a:gd name="connsiteX36" fmla="*/ 1575067 w 2866309"/>
              <a:gd name="connsiteY36" fmla="*/ 1049885 h 2352822"/>
              <a:gd name="connsiteX37" fmla="*/ 1536967 w 2866309"/>
              <a:gd name="connsiteY37" fmla="*/ 1303885 h 2352822"/>
              <a:gd name="connsiteX38" fmla="*/ 1829067 w 2866309"/>
              <a:gd name="connsiteY38" fmla="*/ 1348335 h 2352822"/>
              <a:gd name="connsiteX39" fmla="*/ 2140217 w 2866309"/>
              <a:gd name="connsiteY39" fmla="*/ 1068935 h 2352822"/>
              <a:gd name="connsiteX40" fmla="*/ 2165617 w 2866309"/>
              <a:gd name="connsiteY40" fmla="*/ 907010 h 2352822"/>
              <a:gd name="connsiteX41" fmla="*/ 2171967 w 2866309"/>
              <a:gd name="connsiteY41" fmla="*/ 789535 h 2352822"/>
              <a:gd name="connsiteX42" fmla="*/ 2191017 w 2866309"/>
              <a:gd name="connsiteY42" fmla="*/ 989560 h 2352822"/>
              <a:gd name="connsiteX43" fmla="*/ 2144185 w 2866309"/>
              <a:gd name="connsiteY43" fmla="*/ 1099097 h 2352822"/>
              <a:gd name="connsiteX44" fmla="*/ 1962417 w 2866309"/>
              <a:gd name="connsiteY44" fmla="*/ 1297535 h 2352822"/>
              <a:gd name="connsiteX45" fmla="*/ 2292617 w 2866309"/>
              <a:gd name="connsiteY45" fmla="*/ 1183235 h 2352822"/>
              <a:gd name="connsiteX46" fmla="*/ 2324367 w 2866309"/>
              <a:gd name="connsiteY46" fmla="*/ 732385 h 2352822"/>
              <a:gd name="connsiteX47" fmla="*/ 2352942 w 2866309"/>
              <a:gd name="connsiteY47" fmla="*/ 1013372 h 2352822"/>
              <a:gd name="connsiteX48" fmla="*/ 2349767 w 2866309"/>
              <a:gd name="connsiteY48" fmla="*/ 1129260 h 2352822"/>
              <a:gd name="connsiteX49" fmla="*/ 2540267 w 2866309"/>
              <a:gd name="connsiteY49" fmla="*/ 624435 h 2352822"/>
              <a:gd name="connsiteX50" fmla="*/ 2864117 w 2866309"/>
              <a:gd name="connsiteY50" fmla="*/ 408535 h 2352822"/>
              <a:gd name="connsiteX51" fmla="*/ 2676792 w 2866309"/>
              <a:gd name="connsiteY51" fmla="*/ 524422 h 2352822"/>
              <a:gd name="connsiteX52" fmla="*/ 2568048 w 2866309"/>
              <a:gd name="connsiteY52" fmla="*/ 626023 h 2352822"/>
              <a:gd name="connsiteX53" fmla="*/ 2517772 w 2866309"/>
              <a:gd name="connsiteY53" fmla="*/ 712099 h 2352822"/>
              <a:gd name="connsiteX54" fmla="*/ 2500580 w 2866309"/>
              <a:gd name="connsiteY54" fmla="*/ 745879 h 2352822"/>
              <a:gd name="connsiteX55" fmla="*/ 2450573 w 2866309"/>
              <a:gd name="connsiteY55" fmla="*/ 940347 h 2352822"/>
              <a:gd name="connsiteX56" fmla="*/ 2673617 w 2866309"/>
              <a:gd name="connsiteY56" fmla="*/ 764135 h 2352822"/>
              <a:gd name="connsiteX57" fmla="*/ 2711717 w 2866309"/>
              <a:gd name="connsiteY57" fmla="*/ 637135 h 2352822"/>
              <a:gd name="connsiteX58" fmla="*/ 2676792 w 2866309"/>
              <a:gd name="connsiteY58" fmla="*/ 780010 h 2352822"/>
              <a:gd name="connsiteX59" fmla="*/ 2495817 w 2866309"/>
              <a:gd name="connsiteY59" fmla="*/ 941935 h 2352822"/>
              <a:gd name="connsiteX60" fmla="*/ 2413267 w 2866309"/>
              <a:gd name="connsiteY60" fmla="*/ 1097510 h 2352822"/>
              <a:gd name="connsiteX61" fmla="*/ 2320128 w 2866309"/>
              <a:gd name="connsiteY61" fmla="*/ 1212161 h 2352822"/>
              <a:gd name="connsiteX62" fmla="*/ 2265312 w 2866309"/>
              <a:gd name="connsiteY62" fmla="*/ 1241020 h 2352822"/>
              <a:gd name="connsiteX63" fmla="*/ 2022742 w 2866309"/>
              <a:gd name="connsiteY63" fmla="*/ 1345160 h 2352822"/>
              <a:gd name="connsiteX64" fmla="*/ 1854467 w 2866309"/>
              <a:gd name="connsiteY64" fmla="*/ 1399135 h 2352822"/>
              <a:gd name="connsiteX65" fmla="*/ 1581417 w 2866309"/>
              <a:gd name="connsiteY65" fmla="*/ 1456285 h 2352822"/>
              <a:gd name="connsiteX66" fmla="*/ 1340117 w 2866309"/>
              <a:gd name="connsiteY66" fmla="*/ 1608685 h 2352822"/>
              <a:gd name="connsiteX67" fmla="*/ 1378217 w 2866309"/>
              <a:gd name="connsiteY67" fmla="*/ 1780135 h 2352822"/>
              <a:gd name="connsiteX68" fmla="*/ 1803667 w 2866309"/>
              <a:gd name="connsiteY68" fmla="*/ 2034135 h 2352822"/>
              <a:gd name="connsiteX69" fmla="*/ 1416317 w 2866309"/>
              <a:gd name="connsiteY69" fmla="*/ 1856335 h 2352822"/>
              <a:gd name="connsiteX70" fmla="*/ 1225817 w 2866309"/>
              <a:gd name="connsiteY70" fmla="*/ 1684885 h 2352822"/>
              <a:gd name="connsiteX71" fmla="*/ 924192 w 2866309"/>
              <a:gd name="connsiteY71" fmla="*/ 1678535 h 2352822"/>
              <a:gd name="connsiteX72" fmla="*/ 705117 w 2866309"/>
              <a:gd name="connsiteY72" fmla="*/ 1970635 h 2352822"/>
              <a:gd name="connsiteX73" fmla="*/ 533667 w 2866309"/>
              <a:gd name="connsiteY73" fmla="*/ 2250035 h 2352822"/>
              <a:gd name="connsiteX74" fmla="*/ 190767 w 2866309"/>
              <a:gd name="connsiteY74" fmla="*/ 2351635 h 2352822"/>
              <a:gd name="connsiteX75" fmla="*/ 267 w 2866309"/>
              <a:gd name="connsiteY75" fmla="*/ 2307185 h 2352822"/>
              <a:gd name="connsiteX76" fmla="*/ 228867 w 2866309"/>
              <a:gd name="connsiteY76" fmla="*/ 2332585 h 2352822"/>
              <a:gd name="connsiteX77" fmla="*/ 489217 w 2866309"/>
              <a:gd name="connsiteY77" fmla="*/ 2237335 h 2352822"/>
              <a:gd name="connsiteX78" fmla="*/ 622567 w 2866309"/>
              <a:gd name="connsiteY78" fmla="*/ 2034135 h 2352822"/>
              <a:gd name="connsiteX79" fmla="*/ 673367 w 2866309"/>
              <a:gd name="connsiteY79" fmla="*/ 1805535 h 2352822"/>
              <a:gd name="connsiteX80" fmla="*/ 273317 w 2866309"/>
              <a:gd name="connsiteY80" fmla="*/ 2123035 h 2352822"/>
              <a:gd name="connsiteX81" fmla="*/ 114567 w 2866309"/>
              <a:gd name="connsiteY81" fmla="*/ 2129385 h 2352822"/>
              <a:gd name="connsiteX82" fmla="*/ 222517 w 2866309"/>
              <a:gd name="connsiteY82" fmla="*/ 2116685 h 2352822"/>
              <a:gd name="connsiteX83" fmla="*/ 393967 w 2866309"/>
              <a:gd name="connsiteY83" fmla="*/ 1996035 h 2352822"/>
              <a:gd name="connsiteX84" fmla="*/ 552717 w 2866309"/>
              <a:gd name="connsiteY84" fmla="*/ 1853160 h 2352822"/>
              <a:gd name="connsiteX85" fmla="*/ 819417 w 2866309"/>
              <a:gd name="connsiteY85" fmla="*/ 1634085 h 2352822"/>
              <a:gd name="connsiteX86" fmla="*/ 867042 w 2866309"/>
              <a:gd name="connsiteY86" fmla="*/ 1348335 h 2352822"/>
              <a:gd name="connsiteX87" fmla="*/ 641617 w 2866309"/>
              <a:gd name="connsiteY87" fmla="*/ 1176885 h 2352822"/>
              <a:gd name="connsiteX88" fmla="*/ 482867 w 2866309"/>
              <a:gd name="connsiteY88" fmla="*/ 1087985 h 2352822"/>
              <a:gd name="connsiteX89" fmla="*/ 717817 w 2866309"/>
              <a:gd name="connsiteY89" fmla="*/ 1170535 h 2352822"/>
              <a:gd name="connsiteX90" fmla="*/ 692417 w 2866309"/>
              <a:gd name="connsiteY90" fmla="*/ 948285 h 2352822"/>
              <a:gd name="connsiteX91" fmla="*/ 584467 w 2866309"/>
              <a:gd name="connsiteY91" fmla="*/ 827635 h 2352822"/>
              <a:gd name="connsiteX92" fmla="*/ 711467 w 2866309"/>
              <a:gd name="connsiteY92" fmla="*/ 929235 h 2352822"/>
              <a:gd name="connsiteX93" fmla="*/ 765442 w 2866309"/>
              <a:gd name="connsiteY93" fmla="*/ 1202285 h 2352822"/>
              <a:gd name="connsiteX94" fmla="*/ 781317 w 2866309"/>
              <a:gd name="connsiteY94" fmla="*/ 1056235 h 2352822"/>
              <a:gd name="connsiteX95" fmla="*/ 800367 w 2866309"/>
              <a:gd name="connsiteY95" fmla="*/ 910185 h 2352822"/>
              <a:gd name="connsiteX96" fmla="*/ 724167 w 2866309"/>
              <a:gd name="connsiteY96" fmla="*/ 719685 h 2352822"/>
              <a:gd name="connsiteX97" fmla="*/ 813067 w 2866309"/>
              <a:gd name="connsiteY97" fmla="*/ 859385 h 2352822"/>
              <a:gd name="connsiteX98" fmla="*/ 806717 w 2866309"/>
              <a:gd name="connsiteY98" fmla="*/ 1030835 h 2352822"/>
              <a:gd name="connsiteX99" fmla="*/ 813067 w 2866309"/>
              <a:gd name="connsiteY99" fmla="*/ 1202285 h 2352822"/>
              <a:gd name="connsiteX100" fmla="*/ 940067 w 2866309"/>
              <a:gd name="connsiteY100" fmla="*/ 1310235 h 2352822"/>
              <a:gd name="connsiteX101" fmla="*/ 1016267 w 2866309"/>
              <a:gd name="connsiteY101" fmla="*/ 1043535 h 2352822"/>
              <a:gd name="connsiteX102" fmla="*/ 1009917 w 2866309"/>
              <a:gd name="connsiteY102" fmla="*/ 1195935 h 2352822"/>
              <a:gd name="connsiteX103" fmla="*/ 1009917 w 2866309"/>
              <a:gd name="connsiteY103" fmla="*/ 1284835 h 2352822"/>
              <a:gd name="connsiteX104" fmla="*/ 1130567 w 2866309"/>
              <a:gd name="connsiteY104" fmla="*/ 1272135 h 2352822"/>
              <a:gd name="connsiteX105" fmla="*/ 1263917 w 2866309"/>
              <a:gd name="connsiteY105" fmla="*/ 1043535 h 2352822"/>
              <a:gd name="connsiteX106" fmla="*/ 1302017 w 2866309"/>
              <a:gd name="connsiteY106" fmla="*/ 662535 h 2352822"/>
              <a:gd name="connsiteX107" fmla="*/ 1263123 w 2866309"/>
              <a:gd name="connsiteY107" fmla="*/ 516485 h 2352822"/>
              <a:gd name="connsiteX108" fmla="*/ 1042026 w 2866309"/>
              <a:gd name="connsiteY108" fmla="*/ 452483 h 2352822"/>
              <a:gd name="connsiteX109" fmla="*/ 909905 w 2866309"/>
              <a:gd name="connsiteY109" fmla="*/ 433935 h 2352822"/>
              <a:gd name="connsiteX0" fmla="*/ 909905 w 2866309"/>
              <a:gd name="connsiteY0" fmla="*/ 433935 h 2352822"/>
              <a:gd name="connsiteX1" fmla="*/ 1219467 w 2866309"/>
              <a:gd name="connsiteY1" fmla="*/ 472035 h 2352822"/>
              <a:gd name="connsiteX2" fmla="*/ 1282967 w 2866309"/>
              <a:gd name="connsiteY2" fmla="*/ 484735 h 2352822"/>
              <a:gd name="connsiteX3" fmla="*/ 1308367 w 2866309"/>
              <a:gd name="connsiteY3" fmla="*/ 440285 h 2352822"/>
              <a:gd name="connsiteX4" fmla="*/ 1289317 w 2866309"/>
              <a:gd name="connsiteY4" fmla="*/ 319635 h 2352822"/>
              <a:gd name="connsiteX5" fmla="*/ 1333767 w 2866309"/>
              <a:gd name="connsiteY5" fmla="*/ 205335 h 2352822"/>
              <a:gd name="connsiteX6" fmla="*/ 1308367 w 2866309"/>
              <a:gd name="connsiteY6" fmla="*/ 332335 h 2352822"/>
              <a:gd name="connsiteX7" fmla="*/ 1333767 w 2866309"/>
              <a:gd name="connsiteY7" fmla="*/ 414885 h 2352822"/>
              <a:gd name="connsiteX8" fmla="*/ 1384567 w 2866309"/>
              <a:gd name="connsiteY8" fmla="*/ 294235 h 2352822"/>
              <a:gd name="connsiteX9" fmla="*/ 1340117 w 2866309"/>
              <a:gd name="connsiteY9" fmla="*/ 465685 h 2352822"/>
              <a:gd name="connsiteX10" fmla="*/ 1341704 w 2866309"/>
              <a:gd name="connsiteY10" fmla="*/ 502197 h 2352822"/>
              <a:gd name="connsiteX11" fmla="*/ 1359167 w 2866309"/>
              <a:gd name="connsiteY11" fmla="*/ 814935 h 2352822"/>
              <a:gd name="connsiteX12" fmla="*/ 1429017 w 2866309"/>
              <a:gd name="connsiteY12" fmla="*/ 1018135 h 2352822"/>
              <a:gd name="connsiteX13" fmla="*/ 1689367 w 2866309"/>
              <a:gd name="connsiteY13" fmla="*/ 865735 h 2352822"/>
              <a:gd name="connsiteX14" fmla="*/ 1689367 w 2866309"/>
              <a:gd name="connsiteY14" fmla="*/ 484735 h 2352822"/>
              <a:gd name="connsiteX15" fmla="*/ 1740167 w 2866309"/>
              <a:gd name="connsiteY15" fmla="*/ 275185 h 2352822"/>
              <a:gd name="connsiteX16" fmla="*/ 1822717 w 2866309"/>
              <a:gd name="connsiteY16" fmla="*/ 116435 h 2352822"/>
              <a:gd name="connsiteX17" fmla="*/ 1733817 w 2866309"/>
              <a:gd name="connsiteY17" fmla="*/ 376785 h 2352822"/>
              <a:gd name="connsiteX18" fmla="*/ 1835417 w 2866309"/>
              <a:gd name="connsiteY18" fmla="*/ 370435 h 2352822"/>
              <a:gd name="connsiteX19" fmla="*/ 1917967 w 2866309"/>
              <a:gd name="connsiteY19" fmla="*/ 186285 h 2352822"/>
              <a:gd name="connsiteX20" fmla="*/ 1836687 w 2866309"/>
              <a:gd name="connsiteY20" fmla="*/ 396470 h 2352822"/>
              <a:gd name="connsiteX21" fmla="*/ 1721117 w 2866309"/>
              <a:gd name="connsiteY21" fmla="*/ 452985 h 2352822"/>
              <a:gd name="connsiteX22" fmla="*/ 1733817 w 2866309"/>
              <a:gd name="connsiteY22" fmla="*/ 643485 h 2352822"/>
              <a:gd name="connsiteX23" fmla="*/ 1937017 w 2866309"/>
              <a:gd name="connsiteY23" fmla="*/ 541885 h 2352822"/>
              <a:gd name="connsiteX24" fmla="*/ 1968767 w 2866309"/>
              <a:gd name="connsiteY24" fmla="*/ 116435 h 2352822"/>
              <a:gd name="connsiteX25" fmla="*/ 1981467 w 2866309"/>
              <a:gd name="connsiteY25" fmla="*/ 8485 h 2352822"/>
              <a:gd name="connsiteX26" fmla="*/ 1987817 w 2866309"/>
              <a:gd name="connsiteY26" fmla="*/ 291060 h 2352822"/>
              <a:gd name="connsiteX27" fmla="*/ 1947335 w 2866309"/>
              <a:gd name="connsiteY27" fmla="*/ 569666 h 2352822"/>
              <a:gd name="connsiteX28" fmla="*/ 1860817 w 2866309"/>
              <a:gd name="connsiteY28" fmla="*/ 662535 h 2352822"/>
              <a:gd name="connsiteX29" fmla="*/ 2057667 w 2866309"/>
              <a:gd name="connsiteY29" fmla="*/ 710954 h 2352822"/>
              <a:gd name="connsiteX30" fmla="*/ 2115341 w 2866309"/>
              <a:gd name="connsiteY30" fmla="*/ 704954 h 2352822"/>
              <a:gd name="connsiteX31" fmla="*/ 2229117 w 2866309"/>
              <a:gd name="connsiteY31" fmla="*/ 649835 h 2352822"/>
              <a:gd name="connsiteX32" fmla="*/ 2089417 w 2866309"/>
              <a:gd name="connsiteY32" fmla="*/ 732385 h 2352822"/>
              <a:gd name="connsiteX33" fmla="*/ 1879867 w 2866309"/>
              <a:gd name="connsiteY33" fmla="*/ 719685 h 2352822"/>
              <a:gd name="connsiteX34" fmla="*/ 1784617 w 2866309"/>
              <a:gd name="connsiteY34" fmla="*/ 700635 h 2352822"/>
              <a:gd name="connsiteX35" fmla="*/ 1733817 w 2866309"/>
              <a:gd name="connsiteY35" fmla="*/ 865735 h 2352822"/>
              <a:gd name="connsiteX36" fmla="*/ 1575067 w 2866309"/>
              <a:gd name="connsiteY36" fmla="*/ 1049885 h 2352822"/>
              <a:gd name="connsiteX37" fmla="*/ 1536967 w 2866309"/>
              <a:gd name="connsiteY37" fmla="*/ 1303885 h 2352822"/>
              <a:gd name="connsiteX38" fmla="*/ 1829067 w 2866309"/>
              <a:gd name="connsiteY38" fmla="*/ 1348335 h 2352822"/>
              <a:gd name="connsiteX39" fmla="*/ 2140217 w 2866309"/>
              <a:gd name="connsiteY39" fmla="*/ 1068935 h 2352822"/>
              <a:gd name="connsiteX40" fmla="*/ 2165617 w 2866309"/>
              <a:gd name="connsiteY40" fmla="*/ 907010 h 2352822"/>
              <a:gd name="connsiteX41" fmla="*/ 2171967 w 2866309"/>
              <a:gd name="connsiteY41" fmla="*/ 789535 h 2352822"/>
              <a:gd name="connsiteX42" fmla="*/ 2191017 w 2866309"/>
              <a:gd name="connsiteY42" fmla="*/ 989560 h 2352822"/>
              <a:gd name="connsiteX43" fmla="*/ 2144185 w 2866309"/>
              <a:gd name="connsiteY43" fmla="*/ 1099097 h 2352822"/>
              <a:gd name="connsiteX44" fmla="*/ 1962417 w 2866309"/>
              <a:gd name="connsiteY44" fmla="*/ 1297535 h 2352822"/>
              <a:gd name="connsiteX45" fmla="*/ 2292617 w 2866309"/>
              <a:gd name="connsiteY45" fmla="*/ 1183235 h 2352822"/>
              <a:gd name="connsiteX46" fmla="*/ 2324367 w 2866309"/>
              <a:gd name="connsiteY46" fmla="*/ 732385 h 2352822"/>
              <a:gd name="connsiteX47" fmla="*/ 2352942 w 2866309"/>
              <a:gd name="connsiteY47" fmla="*/ 1013372 h 2352822"/>
              <a:gd name="connsiteX48" fmla="*/ 2349767 w 2866309"/>
              <a:gd name="connsiteY48" fmla="*/ 1129260 h 2352822"/>
              <a:gd name="connsiteX49" fmla="*/ 2540267 w 2866309"/>
              <a:gd name="connsiteY49" fmla="*/ 624435 h 2352822"/>
              <a:gd name="connsiteX50" fmla="*/ 2864117 w 2866309"/>
              <a:gd name="connsiteY50" fmla="*/ 408535 h 2352822"/>
              <a:gd name="connsiteX51" fmla="*/ 2676792 w 2866309"/>
              <a:gd name="connsiteY51" fmla="*/ 524422 h 2352822"/>
              <a:gd name="connsiteX52" fmla="*/ 2568048 w 2866309"/>
              <a:gd name="connsiteY52" fmla="*/ 626023 h 2352822"/>
              <a:gd name="connsiteX53" fmla="*/ 2517772 w 2866309"/>
              <a:gd name="connsiteY53" fmla="*/ 712099 h 2352822"/>
              <a:gd name="connsiteX54" fmla="*/ 2500580 w 2866309"/>
              <a:gd name="connsiteY54" fmla="*/ 745879 h 2352822"/>
              <a:gd name="connsiteX55" fmla="*/ 2450573 w 2866309"/>
              <a:gd name="connsiteY55" fmla="*/ 940347 h 2352822"/>
              <a:gd name="connsiteX56" fmla="*/ 2673617 w 2866309"/>
              <a:gd name="connsiteY56" fmla="*/ 764135 h 2352822"/>
              <a:gd name="connsiteX57" fmla="*/ 2711717 w 2866309"/>
              <a:gd name="connsiteY57" fmla="*/ 637135 h 2352822"/>
              <a:gd name="connsiteX58" fmla="*/ 2676792 w 2866309"/>
              <a:gd name="connsiteY58" fmla="*/ 780010 h 2352822"/>
              <a:gd name="connsiteX59" fmla="*/ 2495817 w 2866309"/>
              <a:gd name="connsiteY59" fmla="*/ 941935 h 2352822"/>
              <a:gd name="connsiteX60" fmla="*/ 2413267 w 2866309"/>
              <a:gd name="connsiteY60" fmla="*/ 1097510 h 2352822"/>
              <a:gd name="connsiteX61" fmla="*/ 2320128 w 2866309"/>
              <a:gd name="connsiteY61" fmla="*/ 1212161 h 2352822"/>
              <a:gd name="connsiteX62" fmla="*/ 2265312 w 2866309"/>
              <a:gd name="connsiteY62" fmla="*/ 1241020 h 2352822"/>
              <a:gd name="connsiteX63" fmla="*/ 2022742 w 2866309"/>
              <a:gd name="connsiteY63" fmla="*/ 1345160 h 2352822"/>
              <a:gd name="connsiteX64" fmla="*/ 1854467 w 2866309"/>
              <a:gd name="connsiteY64" fmla="*/ 1399135 h 2352822"/>
              <a:gd name="connsiteX65" fmla="*/ 1581417 w 2866309"/>
              <a:gd name="connsiteY65" fmla="*/ 1456285 h 2352822"/>
              <a:gd name="connsiteX66" fmla="*/ 1340117 w 2866309"/>
              <a:gd name="connsiteY66" fmla="*/ 1608685 h 2352822"/>
              <a:gd name="connsiteX67" fmla="*/ 1378217 w 2866309"/>
              <a:gd name="connsiteY67" fmla="*/ 1780135 h 2352822"/>
              <a:gd name="connsiteX68" fmla="*/ 1803667 w 2866309"/>
              <a:gd name="connsiteY68" fmla="*/ 2034135 h 2352822"/>
              <a:gd name="connsiteX69" fmla="*/ 1416317 w 2866309"/>
              <a:gd name="connsiteY69" fmla="*/ 1856335 h 2352822"/>
              <a:gd name="connsiteX70" fmla="*/ 1225817 w 2866309"/>
              <a:gd name="connsiteY70" fmla="*/ 1684885 h 2352822"/>
              <a:gd name="connsiteX71" fmla="*/ 924192 w 2866309"/>
              <a:gd name="connsiteY71" fmla="*/ 1678535 h 2352822"/>
              <a:gd name="connsiteX72" fmla="*/ 705117 w 2866309"/>
              <a:gd name="connsiteY72" fmla="*/ 1970635 h 2352822"/>
              <a:gd name="connsiteX73" fmla="*/ 533667 w 2866309"/>
              <a:gd name="connsiteY73" fmla="*/ 2250035 h 2352822"/>
              <a:gd name="connsiteX74" fmla="*/ 190767 w 2866309"/>
              <a:gd name="connsiteY74" fmla="*/ 2351635 h 2352822"/>
              <a:gd name="connsiteX75" fmla="*/ 267 w 2866309"/>
              <a:gd name="connsiteY75" fmla="*/ 2307185 h 2352822"/>
              <a:gd name="connsiteX76" fmla="*/ 228867 w 2866309"/>
              <a:gd name="connsiteY76" fmla="*/ 2332585 h 2352822"/>
              <a:gd name="connsiteX77" fmla="*/ 489217 w 2866309"/>
              <a:gd name="connsiteY77" fmla="*/ 2237335 h 2352822"/>
              <a:gd name="connsiteX78" fmla="*/ 622567 w 2866309"/>
              <a:gd name="connsiteY78" fmla="*/ 2034135 h 2352822"/>
              <a:gd name="connsiteX79" fmla="*/ 673367 w 2866309"/>
              <a:gd name="connsiteY79" fmla="*/ 1805535 h 2352822"/>
              <a:gd name="connsiteX80" fmla="*/ 273317 w 2866309"/>
              <a:gd name="connsiteY80" fmla="*/ 2123035 h 2352822"/>
              <a:gd name="connsiteX81" fmla="*/ 114567 w 2866309"/>
              <a:gd name="connsiteY81" fmla="*/ 2129385 h 2352822"/>
              <a:gd name="connsiteX82" fmla="*/ 222517 w 2866309"/>
              <a:gd name="connsiteY82" fmla="*/ 2116685 h 2352822"/>
              <a:gd name="connsiteX83" fmla="*/ 393967 w 2866309"/>
              <a:gd name="connsiteY83" fmla="*/ 1996035 h 2352822"/>
              <a:gd name="connsiteX84" fmla="*/ 552717 w 2866309"/>
              <a:gd name="connsiteY84" fmla="*/ 1853160 h 2352822"/>
              <a:gd name="connsiteX85" fmla="*/ 819417 w 2866309"/>
              <a:gd name="connsiteY85" fmla="*/ 1634085 h 2352822"/>
              <a:gd name="connsiteX86" fmla="*/ 867042 w 2866309"/>
              <a:gd name="connsiteY86" fmla="*/ 1348335 h 2352822"/>
              <a:gd name="connsiteX87" fmla="*/ 641617 w 2866309"/>
              <a:gd name="connsiteY87" fmla="*/ 1176885 h 2352822"/>
              <a:gd name="connsiteX88" fmla="*/ 482867 w 2866309"/>
              <a:gd name="connsiteY88" fmla="*/ 1087985 h 2352822"/>
              <a:gd name="connsiteX89" fmla="*/ 717817 w 2866309"/>
              <a:gd name="connsiteY89" fmla="*/ 1170535 h 2352822"/>
              <a:gd name="connsiteX90" fmla="*/ 692417 w 2866309"/>
              <a:gd name="connsiteY90" fmla="*/ 948285 h 2352822"/>
              <a:gd name="connsiteX91" fmla="*/ 584467 w 2866309"/>
              <a:gd name="connsiteY91" fmla="*/ 827635 h 2352822"/>
              <a:gd name="connsiteX92" fmla="*/ 711467 w 2866309"/>
              <a:gd name="connsiteY92" fmla="*/ 929235 h 2352822"/>
              <a:gd name="connsiteX93" fmla="*/ 765442 w 2866309"/>
              <a:gd name="connsiteY93" fmla="*/ 1202285 h 2352822"/>
              <a:gd name="connsiteX94" fmla="*/ 781317 w 2866309"/>
              <a:gd name="connsiteY94" fmla="*/ 1056235 h 2352822"/>
              <a:gd name="connsiteX95" fmla="*/ 800367 w 2866309"/>
              <a:gd name="connsiteY95" fmla="*/ 910185 h 2352822"/>
              <a:gd name="connsiteX96" fmla="*/ 724167 w 2866309"/>
              <a:gd name="connsiteY96" fmla="*/ 719685 h 2352822"/>
              <a:gd name="connsiteX97" fmla="*/ 824973 w 2866309"/>
              <a:gd name="connsiteY97" fmla="*/ 909391 h 2352822"/>
              <a:gd name="connsiteX98" fmla="*/ 806717 w 2866309"/>
              <a:gd name="connsiteY98" fmla="*/ 1030835 h 2352822"/>
              <a:gd name="connsiteX99" fmla="*/ 813067 w 2866309"/>
              <a:gd name="connsiteY99" fmla="*/ 1202285 h 2352822"/>
              <a:gd name="connsiteX100" fmla="*/ 940067 w 2866309"/>
              <a:gd name="connsiteY100" fmla="*/ 1310235 h 2352822"/>
              <a:gd name="connsiteX101" fmla="*/ 1016267 w 2866309"/>
              <a:gd name="connsiteY101" fmla="*/ 1043535 h 2352822"/>
              <a:gd name="connsiteX102" fmla="*/ 1009917 w 2866309"/>
              <a:gd name="connsiteY102" fmla="*/ 1195935 h 2352822"/>
              <a:gd name="connsiteX103" fmla="*/ 1009917 w 2866309"/>
              <a:gd name="connsiteY103" fmla="*/ 1284835 h 2352822"/>
              <a:gd name="connsiteX104" fmla="*/ 1130567 w 2866309"/>
              <a:gd name="connsiteY104" fmla="*/ 1272135 h 2352822"/>
              <a:gd name="connsiteX105" fmla="*/ 1263917 w 2866309"/>
              <a:gd name="connsiteY105" fmla="*/ 1043535 h 2352822"/>
              <a:gd name="connsiteX106" fmla="*/ 1302017 w 2866309"/>
              <a:gd name="connsiteY106" fmla="*/ 662535 h 2352822"/>
              <a:gd name="connsiteX107" fmla="*/ 1263123 w 2866309"/>
              <a:gd name="connsiteY107" fmla="*/ 516485 h 2352822"/>
              <a:gd name="connsiteX108" fmla="*/ 1042026 w 2866309"/>
              <a:gd name="connsiteY108" fmla="*/ 452483 h 2352822"/>
              <a:gd name="connsiteX109" fmla="*/ 909905 w 2866309"/>
              <a:gd name="connsiteY109" fmla="*/ 433935 h 2352822"/>
              <a:gd name="connsiteX0" fmla="*/ 909905 w 2866309"/>
              <a:gd name="connsiteY0" fmla="*/ 433935 h 2352822"/>
              <a:gd name="connsiteX1" fmla="*/ 1219467 w 2866309"/>
              <a:gd name="connsiteY1" fmla="*/ 472035 h 2352822"/>
              <a:gd name="connsiteX2" fmla="*/ 1282967 w 2866309"/>
              <a:gd name="connsiteY2" fmla="*/ 484735 h 2352822"/>
              <a:gd name="connsiteX3" fmla="*/ 1308367 w 2866309"/>
              <a:gd name="connsiteY3" fmla="*/ 440285 h 2352822"/>
              <a:gd name="connsiteX4" fmla="*/ 1289317 w 2866309"/>
              <a:gd name="connsiteY4" fmla="*/ 319635 h 2352822"/>
              <a:gd name="connsiteX5" fmla="*/ 1333767 w 2866309"/>
              <a:gd name="connsiteY5" fmla="*/ 205335 h 2352822"/>
              <a:gd name="connsiteX6" fmla="*/ 1308367 w 2866309"/>
              <a:gd name="connsiteY6" fmla="*/ 332335 h 2352822"/>
              <a:gd name="connsiteX7" fmla="*/ 1333767 w 2866309"/>
              <a:gd name="connsiteY7" fmla="*/ 414885 h 2352822"/>
              <a:gd name="connsiteX8" fmla="*/ 1384567 w 2866309"/>
              <a:gd name="connsiteY8" fmla="*/ 294235 h 2352822"/>
              <a:gd name="connsiteX9" fmla="*/ 1340117 w 2866309"/>
              <a:gd name="connsiteY9" fmla="*/ 465685 h 2352822"/>
              <a:gd name="connsiteX10" fmla="*/ 1341704 w 2866309"/>
              <a:gd name="connsiteY10" fmla="*/ 502197 h 2352822"/>
              <a:gd name="connsiteX11" fmla="*/ 1359167 w 2866309"/>
              <a:gd name="connsiteY11" fmla="*/ 814935 h 2352822"/>
              <a:gd name="connsiteX12" fmla="*/ 1429017 w 2866309"/>
              <a:gd name="connsiteY12" fmla="*/ 1018135 h 2352822"/>
              <a:gd name="connsiteX13" fmla="*/ 1689367 w 2866309"/>
              <a:gd name="connsiteY13" fmla="*/ 865735 h 2352822"/>
              <a:gd name="connsiteX14" fmla="*/ 1689367 w 2866309"/>
              <a:gd name="connsiteY14" fmla="*/ 484735 h 2352822"/>
              <a:gd name="connsiteX15" fmla="*/ 1740167 w 2866309"/>
              <a:gd name="connsiteY15" fmla="*/ 275185 h 2352822"/>
              <a:gd name="connsiteX16" fmla="*/ 1822717 w 2866309"/>
              <a:gd name="connsiteY16" fmla="*/ 116435 h 2352822"/>
              <a:gd name="connsiteX17" fmla="*/ 1733817 w 2866309"/>
              <a:gd name="connsiteY17" fmla="*/ 376785 h 2352822"/>
              <a:gd name="connsiteX18" fmla="*/ 1835417 w 2866309"/>
              <a:gd name="connsiteY18" fmla="*/ 370435 h 2352822"/>
              <a:gd name="connsiteX19" fmla="*/ 1917967 w 2866309"/>
              <a:gd name="connsiteY19" fmla="*/ 186285 h 2352822"/>
              <a:gd name="connsiteX20" fmla="*/ 1836687 w 2866309"/>
              <a:gd name="connsiteY20" fmla="*/ 396470 h 2352822"/>
              <a:gd name="connsiteX21" fmla="*/ 1721117 w 2866309"/>
              <a:gd name="connsiteY21" fmla="*/ 452985 h 2352822"/>
              <a:gd name="connsiteX22" fmla="*/ 1733817 w 2866309"/>
              <a:gd name="connsiteY22" fmla="*/ 643485 h 2352822"/>
              <a:gd name="connsiteX23" fmla="*/ 1937017 w 2866309"/>
              <a:gd name="connsiteY23" fmla="*/ 541885 h 2352822"/>
              <a:gd name="connsiteX24" fmla="*/ 1968767 w 2866309"/>
              <a:gd name="connsiteY24" fmla="*/ 116435 h 2352822"/>
              <a:gd name="connsiteX25" fmla="*/ 1981467 w 2866309"/>
              <a:gd name="connsiteY25" fmla="*/ 8485 h 2352822"/>
              <a:gd name="connsiteX26" fmla="*/ 1987817 w 2866309"/>
              <a:gd name="connsiteY26" fmla="*/ 291060 h 2352822"/>
              <a:gd name="connsiteX27" fmla="*/ 1947335 w 2866309"/>
              <a:gd name="connsiteY27" fmla="*/ 569666 h 2352822"/>
              <a:gd name="connsiteX28" fmla="*/ 1860817 w 2866309"/>
              <a:gd name="connsiteY28" fmla="*/ 662535 h 2352822"/>
              <a:gd name="connsiteX29" fmla="*/ 2057667 w 2866309"/>
              <a:gd name="connsiteY29" fmla="*/ 710954 h 2352822"/>
              <a:gd name="connsiteX30" fmla="*/ 2115341 w 2866309"/>
              <a:gd name="connsiteY30" fmla="*/ 704954 h 2352822"/>
              <a:gd name="connsiteX31" fmla="*/ 2229117 w 2866309"/>
              <a:gd name="connsiteY31" fmla="*/ 649835 h 2352822"/>
              <a:gd name="connsiteX32" fmla="*/ 2089417 w 2866309"/>
              <a:gd name="connsiteY32" fmla="*/ 732385 h 2352822"/>
              <a:gd name="connsiteX33" fmla="*/ 1879867 w 2866309"/>
              <a:gd name="connsiteY33" fmla="*/ 719685 h 2352822"/>
              <a:gd name="connsiteX34" fmla="*/ 1784617 w 2866309"/>
              <a:gd name="connsiteY34" fmla="*/ 700635 h 2352822"/>
              <a:gd name="connsiteX35" fmla="*/ 1733817 w 2866309"/>
              <a:gd name="connsiteY35" fmla="*/ 865735 h 2352822"/>
              <a:gd name="connsiteX36" fmla="*/ 1575067 w 2866309"/>
              <a:gd name="connsiteY36" fmla="*/ 1049885 h 2352822"/>
              <a:gd name="connsiteX37" fmla="*/ 1536967 w 2866309"/>
              <a:gd name="connsiteY37" fmla="*/ 1303885 h 2352822"/>
              <a:gd name="connsiteX38" fmla="*/ 1829067 w 2866309"/>
              <a:gd name="connsiteY38" fmla="*/ 1348335 h 2352822"/>
              <a:gd name="connsiteX39" fmla="*/ 2140217 w 2866309"/>
              <a:gd name="connsiteY39" fmla="*/ 1068935 h 2352822"/>
              <a:gd name="connsiteX40" fmla="*/ 2165617 w 2866309"/>
              <a:gd name="connsiteY40" fmla="*/ 907010 h 2352822"/>
              <a:gd name="connsiteX41" fmla="*/ 2171967 w 2866309"/>
              <a:gd name="connsiteY41" fmla="*/ 789535 h 2352822"/>
              <a:gd name="connsiteX42" fmla="*/ 2191017 w 2866309"/>
              <a:gd name="connsiteY42" fmla="*/ 989560 h 2352822"/>
              <a:gd name="connsiteX43" fmla="*/ 2144185 w 2866309"/>
              <a:gd name="connsiteY43" fmla="*/ 1099097 h 2352822"/>
              <a:gd name="connsiteX44" fmla="*/ 1962417 w 2866309"/>
              <a:gd name="connsiteY44" fmla="*/ 1297535 h 2352822"/>
              <a:gd name="connsiteX45" fmla="*/ 2292617 w 2866309"/>
              <a:gd name="connsiteY45" fmla="*/ 1183235 h 2352822"/>
              <a:gd name="connsiteX46" fmla="*/ 2324367 w 2866309"/>
              <a:gd name="connsiteY46" fmla="*/ 732385 h 2352822"/>
              <a:gd name="connsiteX47" fmla="*/ 2352942 w 2866309"/>
              <a:gd name="connsiteY47" fmla="*/ 1013372 h 2352822"/>
              <a:gd name="connsiteX48" fmla="*/ 2349767 w 2866309"/>
              <a:gd name="connsiteY48" fmla="*/ 1129260 h 2352822"/>
              <a:gd name="connsiteX49" fmla="*/ 2540267 w 2866309"/>
              <a:gd name="connsiteY49" fmla="*/ 624435 h 2352822"/>
              <a:gd name="connsiteX50" fmla="*/ 2864117 w 2866309"/>
              <a:gd name="connsiteY50" fmla="*/ 408535 h 2352822"/>
              <a:gd name="connsiteX51" fmla="*/ 2676792 w 2866309"/>
              <a:gd name="connsiteY51" fmla="*/ 524422 h 2352822"/>
              <a:gd name="connsiteX52" fmla="*/ 2568048 w 2866309"/>
              <a:gd name="connsiteY52" fmla="*/ 626023 h 2352822"/>
              <a:gd name="connsiteX53" fmla="*/ 2517772 w 2866309"/>
              <a:gd name="connsiteY53" fmla="*/ 712099 h 2352822"/>
              <a:gd name="connsiteX54" fmla="*/ 2500580 w 2866309"/>
              <a:gd name="connsiteY54" fmla="*/ 745879 h 2352822"/>
              <a:gd name="connsiteX55" fmla="*/ 2450573 w 2866309"/>
              <a:gd name="connsiteY55" fmla="*/ 940347 h 2352822"/>
              <a:gd name="connsiteX56" fmla="*/ 2673617 w 2866309"/>
              <a:gd name="connsiteY56" fmla="*/ 764135 h 2352822"/>
              <a:gd name="connsiteX57" fmla="*/ 2711717 w 2866309"/>
              <a:gd name="connsiteY57" fmla="*/ 637135 h 2352822"/>
              <a:gd name="connsiteX58" fmla="*/ 2676792 w 2866309"/>
              <a:gd name="connsiteY58" fmla="*/ 780010 h 2352822"/>
              <a:gd name="connsiteX59" fmla="*/ 2495817 w 2866309"/>
              <a:gd name="connsiteY59" fmla="*/ 941935 h 2352822"/>
              <a:gd name="connsiteX60" fmla="*/ 2420410 w 2866309"/>
              <a:gd name="connsiteY60" fmla="*/ 1042741 h 2352822"/>
              <a:gd name="connsiteX61" fmla="*/ 2320128 w 2866309"/>
              <a:gd name="connsiteY61" fmla="*/ 1212161 h 2352822"/>
              <a:gd name="connsiteX62" fmla="*/ 2265312 w 2866309"/>
              <a:gd name="connsiteY62" fmla="*/ 1241020 h 2352822"/>
              <a:gd name="connsiteX63" fmla="*/ 2022742 w 2866309"/>
              <a:gd name="connsiteY63" fmla="*/ 1345160 h 2352822"/>
              <a:gd name="connsiteX64" fmla="*/ 1854467 w 2866309"/>
              <a:gd name="connsiteY64" fmla="*/ 1399135 h 2352822"/>
              <a:gd name="connsiteX65" fmla="*/ 1581417 w 2866309"/>
              <a:gd name="connsiteY65" fmla="*/ 1456285 h 2352822"/>
              <a:gd name="connsiteX66" fmla="*/ 1340117 w 2866309"/>
              <a:gd name="connsiteY66" fmla="*/ 1608685 h 2352822"/>
              <a:gd name="connsiteX67" fmla="*/ 1378217 w 2866309"/>
              <a:gd name="connsiteY67" fmla="*/ 1780135 h 2352822"/>
              <a:gd name="connsiteX68" fmla="*/ 1803667 w 2866309"/>
              <a:gd name="connsiteY68" fmla="*/ 2034135 h 2352822"/>
              <a:gd name="connsiteX69" fmla="*/ 1416317 w 2866309"/>
              <a:gd name="connsiteY69" fmla="*/ 1856335 h 2352822"/>
              <a:gd name="connsiteX70" fmla="*/ 1225817 w 2866309"/>
              <a:gd name="connsiteY70" fmla="*/ 1684885 h 2352822"/>
              <a:gd name="connsiteX71" fmla="*/ 924192 w 2866309"/>
              <a:gd name="connsiteY71" fmla="*/ 1678535 h 2352822"/>
              <a:gd name="connsiteX72" fmla="*/ 705117 w 2866309"/>
              <a:gd name="connsiteY72" fmla="*/ 1970635 h 2352822"/>
              <a:gd name="connsiteX73" fmla="*/ 533667 w 2866309"/>
              <a:gd name="connsiteY73" fmla="*/ 2250035 h 2352822"/>
              <a:gd name="connsiteX74" fmla="*/ 190767 w 2866309"/>
              <a:gd name="connsiteY74" fmla="*/ 2351635 h 2352822"/>
              <a:gd name="connsiteX75" fmla="*/ 267 w 2866309"/>
              <a:gd name="connsiteY75" fmla="*/ 2307185 h 2352822"/>
              <a:gd name="connsiteX76" fmla="*/ 228867 w 2866309"/>
              <a:gd name="connsiteY76" fmla="*/ 2332585 h 2352822"/>
              <a:gd name="connsiteX77" fmla="*/ 489217 w 2866309"/>
              <a:gd name="connsiteY77" fmla="*/ 2237335 h 2352822"/>
              <a:gd name="connsiteX78" fmla="*/ 622567 w 2866309"/>
              <a:gd name="connsiteY78" fmla="*/ 2034135 h 2352822"/>
              <a:gd name="connsiteX79" fmla="*/ 673367 w 2866309"/>
              <a:gd name="connsiteY79" fmla="*/ 1805535 h 2352822"/>
              <a:gd name="connsiteX80" fmla="*/ 273317 w 2866309"/>
              <a:gd name="connsiteY80" fmla="*/ 2123035 h 2352822"/>
              <a:gd name="connsiteX81" fmla="*/ 114567 w 2866309"/>
              <a:gd name="connsiteY81" fmla="*/ 2129385 h 2352822"/>
              <a:gd name="connsiteX82" fmla="*/ 222517 w 2866309"/>
              <a:gd name="connsiteY82" fmla="*/ 2116685 h 2352822"/>
              <a:gd name="connsiteX83" fmla="*/ 393967 w 2866309"/>
              <a:gd name="connsiteY83" fmla="*/ 1996035 h 2352822"/>
              <a:gd name="connsiteX84" fmla="*/ 552717 w 2866309"/>
              <a:gd name="connsiteY84" fmla="*/ 1853160 h 2352822"/>
              <a:gd name="connsiteX85" fmla="*/ 819417 w 2866309"/>
              <a:gd name="connsiteY85" fmla="*/ 1634085 h 2352822"/>
              <a:gd name="connsiteX86" fmla="*/ 867042 w 2866309"/>
              <a:gd name="connsiteY86" fmla="*/ 1348335 h 2352822"/>
              <a:gd name="connsiteX87" fmla="*/ 641617 w 2866309"/>
              <a:gd name="connsiteY87" fmla="*/ 1176885 h 2352822"/>
              <a:gd name="connsiteX88" fmla="*/ 482867 w 2866309"/>
              <a:gd name="connsiteY88" fmla="*/ 1087985 h 2352822"/>
              <a:gd name="connsiteX89" fmla="*/ 717817 w 2866309"/>
              <a:gd name="connsiteY89" fmla="*/ 1170535 h 2352822"/>
              <a:gd name="connsiteX90" fmla="*/ 692417 w 2866309"/>
              <a:gd name="connsiteY90" fmla="*/ 948285 h 2352822"/>
              <a:gd name="connsiteX91" fmla="*/ 584467 w 2866309"/>
              <a:gd name="connsiteY91" fmla="*/ 827635 h 2352822"/>
              <a:gd name="connsiteX92" fmla="*/ 711467 w 2866309"/>
              <a:gd name="connsiteY92" fmla="*/ 929235 h 2352822"/>
              <a:gd name="connsiteX93" fmla="*/ 765442 w 2866309"/>
              <a:gd name="connsiteY93" fmla="*/ 1202285 h 2352822"/>
              <a:gd name="connsiteX94" fmla="*/ 781317 w 2866309"/>
              <a:gd name="connsiteY94" fmla="*/ 1056235 h 2352822"/>
              <a:gd name="connsiteX95" fmla="*/ 800367 w 2866309"/>
              <a:gd name="connsiteY95" fmla="*/ 910185 h 2352822"/>
              <a:gd name="connsiteX96" fmla="*/ 724167 w 2866309"/>
              <a:gd name="connsiteY96" fmla="*/ 719685 h 2352822"/>
              <a:gd name="connsiteX97" fmla="*/ 824973 w 2866309"/>
              <a:gd name="connsiteY97" fmla="*/ 909391 h 2352822"/>
              <a:gd name="connsiteX98" fmla="*/ 806717 w 2866309"/>
              <a:gd name="connsiteY98" fmla="*/ 1030835 h 2352822"/>
              <a:gd name="connsiteX99" fmla="*/ 813067 w 2866309"/>
              <a:gd name="connsiteY99" fmla="*/ 1202285 h 2352822"/>
              <a:gd name="connsiteX100" fmla="*/ 940067 w 2866309"/>
              <a:gd name="connsiteY100" fmla="*/ 1310235 h 2352822"/>
              <a:gd name="connsiteX101" fmla="*/ 1016267 w 2866309"/>
              <a:gd name="connsiteY101" fmla="*/ 1043535 h 2352822"/>
              <a:gd name="connsiteX102" fmla="*/ 1009917 w 2866309"/>
              <a:gd name="connsiteY102" fmla="*/ 1195935 h 2352822"/>
              <a:gd name="connsiteX103" fmla="*/ 1009917 w 2866309"/>
              <a:gd name="connsiteY103" fmla="*/ 1284835 h 2352822"/>
              <a:gd name="connsiteX104" fmla="*/ 1130567 w 2866309"/>
              <a:gd name="connsiteY104" fmla="*/ 1272135 h 2352822"/>
              <a:gd name="connsiteX105" fmla="*/ 1263917 w 2866309"/>
              <a:gd name="connsiteY105" fmla="*/ 1043535 h 2352822"/>
              <a:gd name="connsiteX106" fmla="*/ 1302017 w 2866309"/>
              <a:gd name="connsiteY106" fmla="*/ 662535 h 2352822"/>
              <a:gd name="connsiteX107" fmla="*/ 1263123 w 2866309"/>
              <a:gd name="connsiteY107" fmla="*/ 516485 h 2352822"/>
              <a:gd name="connsiteX108" fmla="*/ 1042026 w 2866309"/>
              <a:gd name="connsiteY108" fmla="*/ 452483 h 2352822"/>
              <a:gd name="connsiteX109" fmla="*/ 909905 w 2866309"/>
              <a:gd name="connsiteY109" fmla="*/ 433935 h 2352822"/>
              <a:gd name="connsiteX0" fmla="*/ 909905 w 2866309"/>
              <a:gd name="connsiteY0" fmla="*/ 433935 h 2352822"/>
              <a:gd name="connsiteX1" fmla="*/ 1219467 w 2866309"/>
              <a:gd name="connsiteY1" fmla="*/ 472035 h 2352822"/>
              <a:gd name="connsiteX2" fmla="*/ 1282967 w 2866309"/>
              <a:gd name="connsiteY2" fmla="*/ 484735 h 2352822"/>
              <a:gd name="connsiteX3" fmla="*/ 1308367 w 2866309"/>
              <a:gd name="connsiteY3" fmla="*/ 440285 h 2352822"/>
              <a:gd name="connsiteX4" fmla="*/ 1289317 w 2866309"/>
              <a:gd name="connsiteY4" fmla="*/ 319635 h 2352822"/>
              <a:gd name="connsiteX5" fmla="*/ 1333767 w 2866309"/>
              <a:gd name="connsiteY5" fmla="*/ 205335 h 2352822"/>
              <a:gd name="connsiteX6" fmla="*/ 1308367 w 2866309"/>
              <a:gd name="connsiteY6" fmla="*/ 332335 h 2352822"/>
              <a:gd name="connsiteX7" fmla="*/ 1333767 w 2866309"/>
              <a:gd name="connsiteY7" fmla="*/ 414885 h 2352822"/>
              <a:gd name="connsiteX8" fmla="*/ 1384567 w 2866309"/>
              <a:gd name="connsiteY8" fmla="*/ 294235 h 2352822"/>
              <a:gd name="connsiteX9" fmla="*/ 1340117 w 2866309"/>
              <a:gd name="connsiteY9" fmla="*/ 465685 h 2352822"/>
              <a:gd name="connsiteX10" fmla="*/ 1341704 w 2866309"/>
              <a:gd name="connsiteY10" fmla="*/ 502197 h 2352822"/>
              <a:gd name="connsiteX11" fmla="*/ 1359167 w 2866309"/>
              <a:gd name="connsiteY11" fmla="*/ 814935 h 2352822"/>
              <a:gd name="connsiteX12" fmla="*/ 1429017 w 2866309"/>
              <a:gd name="connsiteY12" fmla="*/ 1018135 h 2352822"/>
              <a:gd name="connsiteX13" fmla="*/ 1689367 w 2866309"/>
              <a:gd name="connsiteY13" fmla="*/ 865735 h 2352822"/>
              <a:gd name="connsiteX14" fmla="*/ 1689367 w 2866309"/>
              <a:gd name="connsiteY14" fmla="*/ 484735 h 2352822"/>
              <a:gd name="connsiteX15" fmla="*/ 1740167 w 2866309"/>
              <a:gd name="connsiteY15" fmla="*/ 275185 h 2352822"/>
              <a:gd name="connsiteX16" fmla="*/ 1822717 w 2866309"/>
              <a:gd name="connsiteY16" fmla="*/ 116435 h 2352822"/>
              <a:gd name="connsiteX17" fmla="*/ 1733817 w 2866309"/>
              <a:gd name="connsiteY17" fmla="*/ 376785 h 2352822"/>
              <a:gd name="connsiteX18" fmla="*/ 1835417 w 2866309"/>
              <a:gd name="connsiteY18" fmla="*/ 370435 h 2352822"/>
              <a:gd name="connsiteX19" fmla="*/ 1917967 w 2866309"/>
              <a:gd name="connsiteY19" fmla="*/ 186285 h 2352822"/>
              <a:gd name="connsiteX20" fmla="*/ 1836687 w 2866309"/>
              <a:gd name="connsiteY20" fmla="*/ 396470 h 2352822"/>
              <a:gd name="connsiteX21" fmla="*/ 1721117 w 2866309"/>
              <a:gd name="connsiteY21" fmla="*/ 452985 h 2352822"/>
              <a:gd name="connsiteX22" fmla="*/ 1733817 w 2866309"/>
              <a:gd name="connsiteY22" fmla="*/ 643485 h 2352822"/>
              <a:gd name="connsiteX23" fmla="*/ 1937017 w 2866309"/>
              <a:gd name="connsiteY23" fmla="*/ 541885 h 2352822"/>
              <a:gd name="connsiteX24" fmla="*/ 1968767 w 2866309"/>
              <a:gd name="connsiteY24" fmla="*/ 116435 h 2352822"/>
              <a:gd name="connsiteX25" fmla="*/ 1981467 w 2866309"/>
              <a:gd name="connsiteY25" fmla="*/ 8485 h 2352822"/>
              <a:gd name="connsiteX26" fmla="*/ 1987817 w 2866309"/>
              <a:gd name="connsiteY26" fmla="*/ 291060 h 2352822"/>
              <a:gd name="connsiteX27" fmla="*/ 1947335 w 2866309"/>
              <a:gd name="connsiteY27" fmla="*/ 569666 h 2352822"/>
              <a:gd name="connsiteX28" fmla="*/ 1860817 w 2866309"/>
              <a:gd name="connsiteY28" fmla="*/ 662535 h 2352822"/>
              <a:gd name="connsiteX29" fmla="*/ 2057667 w 2866309"/>
              <a:gd name="connsiteY29" fmla="*/ 710954 h 2352822"/>
              <a:gd name="connsiteX30" fmla="*/ 2115341 w 2866309"/>
              <a:gd name="connsiteY30" fmla="*/ 704954 h 2352822"/>
              <a:gd name="connsiteX31" fmla="*/ 2229117 w 2866309"/>
              <a:gd name="connsiteY31" fmla="*/ 649835 h 2352822"/>
              <a:gd name="connsiteX32" fmla="*/ 2089417 w 2866309"/>
              <a:gd name="connsiteY32" fmla="*/ 732385 h 2352822"/>
              <a:gd name="connsiteX33" fmla="*/ 1879867 w 2866309"/>
              <a:gd name="connsiteY33" fmla="*/ 719685 h 2352822"/>
              <a:gd name="connsiteX34" fmla="*/ 1784617 w 2866309"/>
              <a:gd name="connsiteY34" fmla="*/ 700635 h 2352822"/>
              <a:gd name="connsiteX35" fmla="*/ 1733817 w 2866309"/>
              <a:gd name="connsiteY35" fmla="*/ 865735 h 2352822"/>
              <a:gd name="connsiteX36" fmla="*/ 1575067 w 2866309"/>
              <a:gd name="connsiteY36" fmla="*/ 1049885 h 2352822"/>
              <a:gd name="connsiteX37" fmla="*/ 1536967 w 2866309"/>
              <a:gd name="connsiteY37" fmla="*/ 1303885 h 2352822"/>
              <a:gd name="connsiteX38" fmla="*/ 1829067 w 2866309"/>
              <a:gd name="connsiteY38" fmla="*/ 1348335 h 2352822"/>
              <a:gd name="connsiteX39" fmla="*/ 2140217 w 2866309"/>
              <a:gd name="connsiteY39" fmla="*/ 1068935 h 2352822"/>
              <a:gd name="connsiteX40" fmla="*/ 2165617 w 2866309"/>
              <a:gd name="connsiteY40" fmla="*/ 907010 h 2352822"/>
              <a:gd name="connsiteX41" fmla="*/ 2171967 w 2866309"/>
              <a:gd name="connsiteY41" fmla="*/ 789535 h 2352822"/>
              <a:gd name="connsiteX42" fmla="*/ 2191017 w 2866309"/>
              <a:gd name="connsiteY42" fmla="*/ 989560 h 2352822"/>
              <a:gd name="connsiteX43" fmla="*/ 2144185 w 2866309"/>
              <a:gd name="connsiteY43" fmla="*/ 1099097 h 2352822"/>
              <a:gd name="connsiteX44" fmla="*/ 1962417 w 2866309"/>
              <a:gd name="connsiteY44" fmla="*/ 1297535 h 2352822"/>
              <a:gd name="connsiteX45" fmla="*/ 2292617 w 2866309"/>
              <a:gd name="connsiteY45" fmla="*/ 1183235 h 2352822"/>
              <a:gd name="connsiteX46" fmla="*/ 2324367 w 2866309"/>
              <a:gd name="connsiteY46" fmla="*/ 732385 h 2352822"/>
              <a:gd name="connsiteX47" fmla="*/ 2352942 w 2866309"/>
              <a:gd name="connsiteY47" fmla="*/ 1013372 h 2352822"/>
              <a:gd name="connsiteX48" fmla="*/ 2349767 w 2866309"/>
              <a:gd name="connsiteY48" fmla="*/ 1129260 h 2352822"/>
              <a:gd name="connsiteX49" fmla="*/ 2540267 w 2866309"/>
              <a:gd name="connsiteY49" fmla="*/ 624435 h 2352822"/>
              <a:gd name="connsiteX50" fmla="*/ 2864117 w 2866309"/>
              <a:gd name="connsiteY50" fmla="*/ 408535 h 2352822"/>
              <a:gd name="connsiteX51" fmla="*/ 2676792 w 2866309"/>
              <a:gd name="connsiteY51" fmla="*/ 524422 h 2352822"/>
              <a:gd name="connsiteX52" fmla="*/ 2568048 w 2866309"/>
              <a:gd name="connsiteY52" fmla="*/ 626023 h 2352822"/>
              <a:gd name="connsiteX53" fmla="*/ 2517772 w 2866309"/>
              <a:gd name="connsiteY53" fmla="*/ 712099 h 2352822"/>
              <a:gd name="connsiteX54" fmla="*/ 2500580 w 2866309"/>
              <a:gd name="connsiteY54" fmla="*/ 745879 h 2352822"/>
              <a:gd name="connsiteX55" fmla="*/ 2450573 w 2866309"/>
              <a:gd name="connsiteY55" fmla="*/ 940347 h 2352822"/>
              <a:gd name="connsiteX56" fmla="*/ 2673617 w 2866309"/>
              <a:gd name="connsiteY56" fmla="*/ 764135 h 2352822"/>
              <a:gd name="connsiteX57" fmla="*/ 2711717 w 2866309"/>
              <a:gd name="connsiteY57" fmla="*/ 637135 h 2352822"/>
              <a:gd name="connsiteX58" fmla="*/ 2676792 w 2866309"/>
              <a:gd name="connsiteY58" fmla="*/ 780010 h 2352822"/>
              <a:gd name="connsiteX59" fmla="*/ 2495817 w 2866309"/>
              <a:gd name="connsiteY59" fmla="*/ 941935 h 2352822"/>
              <a:gd name="connsiteX60" fmla="*/ 2420410 w 2866309"/>
              <a:gd name="connsiteY60" fmla="*/ 1042741 h 2352822"/>
              <a:gd name="connsiteX61" fmla="*/ 2317747 w 2866309"/>
              <a:gd name="connsiteY61" fmla="*/ 1190729 h 2352822"/>
              <a:gd name="connsiteX62" fmla="*/ 2265312 w 2866309"/>
              <a:gd name="connsiteY62" fmla="*/ 1241020 h 2352822"/>
              <a:gd name="connsiteX63" fmla="*/ 2022742 w 2866309"/>
              <a:gd name="connsiteY63" fmla="*/ 1345160 h 2352822"/>
              <a:gd name="connsiteX64" fmla="*/ 1854467 w 2866309"/>
              <a:gd name="connsiteY64" fmla="*/ 1399135 h 2352822"/>
              <a:gd name="connsiteX65" fmla="*/ 1581417 w 2866309"/>
              <a:gd name="connsiteY65" fmla="*/ 1456285 h 2352822"/>
              <a:gd name="connsiteX66" fmla="*/ 1340117 w 2866309"/>
              <a:gd name="connsiteY66" fmla="*/ 1608685 h 2352822"/>
              <a:gd name="connsiteX67" fmla="*/ 1378217 w 2866309"/>
              <a:gd name="connsiteY67" fmla="*/ 1780135 h 2352822"/>
              <a:gd name="connsiteX68" fmla="*/ 1803667 w 2866309"/>
              <a:gd name="connsiteY68" fmla="*/ 2034135 h 2352822"/>
              <a:gd name="connsiteX69" fmla="*/ 1416317 w 2866309"/>
              <a:gd name="connsiteY69" fmla="*/ 1856335 h 2352822"/>
              <a:gd name="connsiteX70" fmla="*/ 1225817 w 2866309"/>
              <a:gd name="connsiteY70" fmla="*/ 1684885 h 2352822"/>
              <a:gd name="connsiteX71" fmla="*/ 924192 w 2866309"/>
              <a:gd name="connsiteY71" fmla="*/ 1678535 h 2352822"/>
              <a:gd name="connsiteX72" fmla="*/ 705117 w 2866309"/>
              <a:gd name="connsiteY72" fmla="*/ 1970635 h 2352822"/>
              <a:gd name="connsiteX73" fmla="*/ 533667 w 2866309"/>
              <a:gd name="connsiteY73" fmla="*/ 2250035 h 2352822"/>
              <a:gd name="connsiteX74" fmla="*/ 190767 w 2866309"/>
              <a:gd name="connsiteY74" fmla="*/ 2351635 h 2352822"/>
              <a:gd name="connsiteX75" fmla="*/ 267 w 2866309"/>
              <a:gd name="connsiteY75" fmla="*/ 2307185 h 2352822"/>
              <a:gd name="connsiteX76" fmla="*/ 228867 w 2866309"/>
              <a:gd name="connsiteY76" fmla="*/ 2332585 h 2352822"/>
              <a:gd name="connsiteX77" fmla="*/ 489217 w 2866309"/>
              <a:gd name="connsiteY77" fmla="*/ 2237335 h 2352822"/>
              <a:gd name="connsiteX78" fmla="*/ 622567 w 2866309"/>
              <a:gd name="connsiteY78" fmla="*/ 2034135 h 2352822"/>
              <a:gd name="connsiteX79" fmla="*/ 673367 w 2866309"/>
              <a:gd name="connsiteY79" fmla="*/ 1805535 h 2352822"/>
              <a:gd name="connsiteX80" fmla="*/ 273317 w 2866309"/>
              <a:gd name="connsiteY80" fmla="*/ 2123035 h 2352822"/>
              <a:gd name="connsiteX81" fmla="*/ 114567 w 2866309"/>
              <a:gd name="connsiteY81" fmla="*/ 2129385 h 2352822"/>
              <a:gd name="connsiteX82" fmla="*/ 222517 w 2866309"/>
              <a:gd name="connsiteY82" fmla="*/ 2116685 h 2352822"/>
              <a:gd name="connsiteX83" fmla="*/ 393967 w 2866309"/>
              <a:gd name="connsiteY83" fmla="*/ 1996035 h 2352822"/>
              <a:gd name="connsiteX84" fmla="*/ 552717 w 2866309"/>
              <a:gd name="connsiteY84" fmla="*/ 1853160 h 2352822"/>
              <a:gd name="connsiteX85" fmla="*/ 819417 w 2866309"/>
              <a:gd name="connsiteY85" fmla="*/ 1634085 h 2352822"/>
              <a:gd name="connsiteX86" fmla="*/ 867042 w 2866309"/>
              <a:gd name="connsiteY86" fmla="*/ 1348335 h 2352822"/>
              <a:gd name="connsiteX87" fmla="*/ 641617 w 2866309"/>
              <a:gd name="connsiteY87" fmla="*/ 1176885 h 2352822"/>
              <a:gd name="connsiteX88" fmla="*/ 482867 w 2866309"/>
              <a:gd name="connsiteY88" fmla="*/ 1087985 h 2352822"/>
              <a:gd name="connsiteX89" fmla="*/ 717817 w 2866309"/>
              <a:gd name="connsiteY89" fmla="*/ 1170535 h 2352822"/>
              <a:gd name="connsiteX90" fmla="*/ 692417 w 2866309"/>
              <a:gd name="connsiteY90" fmla="*/ 948285 h 2352822"/>
              <a:gd name="connsiteX91" fmla="*/ 584467 w 2866309"/>
              <a:gd name="connsiteY91" fmla="*/ 827635 h 2352822"/>
              <a:gd name="connsiteX92" fmla="*/ 711467 w 2866309"/>
              <a:gd name="connsiteY92" fmla="*/ 929235 h 2352822"/>
              <a:gd name="connsiteX93" fmla="*/ 765442 w 2866309"/>
              <a:gd name="connsiteY93" fmla="*/ 1202285 h 2352822"/>
              <a:gd name="connsiteX94" fmla="*/ 781317 w 2866309"/>
              <a:gd name="connsiteY94" fmla="*/ 1056235 h 2352822"/>
              <a:gd name="connsiteX95" fmla="*/ 800367 w 2866309"/>
              <a:gd name="connsiteY95" fmla="*/ 910185 h 2352822"/>
              <a:gd name="connsiteX96" fmla="*/ 724167 w 2866309"/>
              <a:gd name="connsiteY96" fmla="*/ 719685 h 2352822"/>
              <a:gd name="connsiteX97" fmla="*/ 824973 w 2866309"/>
              <a:gd name="connsiteY97" fmla="*/ 909391 h 2352822"/>
              <a:gd name="connsiteX98" fmla="*/ 806717 w 2866309"/>
              <a:gd name="connsiteY98" fmla="*/ 1030835 h 2352822"/>
              <a:gd name="connsiteX99" fmla="*/ 813067 w 2866309"/>
              <a:gd name="connsiteY99" fmla="*/ 1202285 h 2352822"/>
              <a:gd name="connsiteX100" fmla="*/ 940067 w 2866309"/>
              <a:gd name="connsiteY100" fmla="*/ 1310235 h 2352822"/>
              <a:gd name="connsiteX101" fmla="*/ 1016267 w 2866309"/>
              <a:gd name="connsiteY101" fmla="*/ 1043535 h 2352822"/>
              <a:gd name="connsiteX102" fmla="*/ 1009917 w 2866309"/>
              <a:gd name="connsiteY102" fmla="*/ 1195935 h 2352822"/>
              <a:gd name="connsiteX103" fmla="*/ 1009917 w 2866309"/>
              <a:gd name="connsiteY103" fmla="*/ 1284835 h 2352822"/>
              <a:gd name="connsiteX104" fmla="*/ 1130567 w 2866309"/>
              <a:gd name="connsiteY104" fmla="*/ 1272135 h 2352822"/>
              <a:gd name="connsiteX105" fmla="*/ 1263917 w 2866309"/>
              <a:gd name="connsiteY105" fmla="*/ 1043535 h 2352822"/>
              <a:gd name="connsiteX106" fmla="*/ 1302017 w 2866309"/>
              <a:gd name="connsiteY106" fmla="*/ 662535 h 2352822"/>
              <a:gd name="connsiteX107" fmla="*/ 1263123 w 2866309"/>
              <a:gd name="connsiteY107" fmla="*/ 516485 h 2352822"/>
              <a:gd name="connsiteX108" fmla="*/ 1042026 w 2866309"/>
              <a:gd name="connsiteY108" fmla="*/ 452483 h 2352822"/>
              <a:gd name="connsiteX109" fmla="*/ 909905 w 2866309"/>
              <a:gd name="connsiteY109" fmla="*/ 433935 h 23528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</a:cxnLst>
            <a:rect l="l" t="t" r="r" b="b"/>
            <a:pathLst>
              <a:path w="2866309" h="2352822">
                <a:moveTo>
                  <a:pt x="909905" y="433935"/>
                </a:moveTo>
                <a:cubicBezTo>
                  <a:pt x="939478" y="437194"/>
                  <a:pt x="1157290" y="463568"/>
                  <a:pt x="1219467" y="472035"/>
                </a:cubicBezTo>
                <a:cubicBezTo>
                  <a:pt x="1281644" y="480502"/>
                  <a:pt x="1268150" y="490027"/>
                  <a:pt x="1282967" y="484735"/>
                </a:cubicBezTo>
                <a:cubicBezTo>
                  <a:pt x="1297784" y="479443"/>
                  <a:pt x="1307309" y="467802"/>
                  <a:pt x="1308367" y="440285"/>
                </a:cubicBezTo>
                <a:cubicBezTo>
                  <a:pt x="1309425" y="412768"/>
                  <a:pt x="1285084" y="358793"/>
                  <a:pt x="1289317" y="319635"/>
                </a:cubicBezTo>
                <a:cubicBezTo>
                  <a:pt x="1293550" y="280477"/>
                  <a:pt x="1330592" y="203218"/>
                  <a:pt x="1333767" y="205335"/>
                </a:cubicBezTo>
                <a:cubicBezTo>
                  <a:pt x="1336942" y="207452"/>
                  <a:pt x="1308367" y="297410"/>
                  <a:pt x="1308367" y="332335"/>
                </a:cubicBezTo>
                <a:cubicBezTo>
                  <a:pt x="1308367" y="367260"/>
                  <a:pt x="1321067" y="421235"/>
                  <a:pt x="1333767" y="414885"/>
                </a:cubicBezTo>
                <a:cubicBezTo>
                  <a:pt x="1346467" y="408535"/>
                  <a:pt x="1383509" y="285768"/>
                  <a:pt x="1384567" y="294235"/>
                </a:cubicBezTo>
                <a:cubicBezTo>
                  <a:pt x="1385625" y="302702"/>
                  <a:pt x="1347261" y="431025"/>
                  <a:pt x="1340117" y="465685"/>
                </a:cubicBezTo>
                <a:cubicBezTo>
                  <a:pt x="1332973" y="500345"/>
                  <a:pt x="1338529" y="443989"/>
                  <a:pt x="1341704" y="502197"/>
                </a:cubicBezTo>
                <a:cubicBezTo>
                  <a:pt x="1344879" y="560405"/>
                  <a:pt x="1344615" y="728945"/>
                  <a:pt x="1359167" y="814935"/>
                </a:cubicBezTo>
                <a:cubicBezTo>
                  <a:pt x="1373719" y="900925"/>
                  <a:pt x="1373984" y="1009668"/>
                  <a:pt x="1429017" y="1018135"/>
                </a:cubicBezTo>
                <a:cubicBezTo>
                  <a:pt x="1484050" y="1026602"/>
                  <a:pt x="1645975" y="954635"/>
                  <a:pt x="1689367" y="865735"/>
                </a:cubicBezTo>
                <a:cubicBezTo>
                  <a:pt x="1732759" y="776835"/>
                  <a:pt x="1680900" y="583160"/>
                  <a:pt x="1689367" y="484735"/>
                </a:cubicBezTo>
                <a:cubicBezTo>
                  <a:pt x="1697834" y="386310"/>
                  <a:pt x="1717942" y="336568"/>
                  <a:pt x="1740167" y="275185"/>
                </a:cubicBezTo>
                <a:cubicBezTo>
                  <a:pt x="1762392" y="213802"/>
                  <a:pt x="1823775" y="99502"/>
                  <a:pt x="1822717" y="116435"/>
                </a:cubicBezTo>
                <a:cubicBezTo>
                  <a:pt x="1821659" y="133368"/>
                  <a:pt x="1731700" y="334452"/>
                  <a:pt x="1733817" y="376785"/>
                </a:cubicBezTo>
                <a:cubicBezTo>
                  <a:pt x="1735934" y="419118"/>
                  <a:pt x="1804725" y="402185"/>
                  <a:pt x="1835417" y="370435"/>
                </a:cubicBezTo>
                <a:cubicBezTo>
                  <a:pt x="1866109" y="338685"/>
                  <a:pt x="1917755" y="181946"/>
                  <a:pt x="1917967" y="186285"/>
                </a:cubicBezTo>
                <a:cubicBezTo>
                  <a:pt x="1918179" y="190624"/>
                  <a:pt x="1869495" y="352020"/>
                  <a:pt x="1836687" y="396470"/>
                </a:cubicBezTo>
                <a:cubicBezTo>
                  <a:pt x="1803879" y="440920"/>
                  <a:pt x="1738262" y="411816"/>
                  <a:pt x="1721117" y="452985"/>
                </a:cubicBezTo>
                <a:cubicBezTo>
                  <a:pt x="1703972" y="494154"/>
                  <a:pt x="1697834" y="628668"/>
                  <a:pt x="1733817" y="643485"/>
                </a:cubicBezTo>
                <a:cubicBezTo>
                  <a:pt x="1769800" y="658302"/>
                  <a:pt x="1897859" y="629727"/>
                  <a:pt x="1937017" y="541885"/>
                </a:cubicBezTo>
                <a:cubicBezTo>
                  <a:pt x="1976175" y="454043"/>
                  <a:pt x="1961359" y="205335"/>
                  <a:pt x="1968767" y="116435"/>
                </a:cubicBezTo>
                <a:cubicBezTo>
                  <a:pt x="1976175" y="27535"/>
                  <a:pt x="1978292" y="-20619"/>
                  <a:pt x="1981467" y="8485"/>
                </a:cubicBezTo>
                <a:cubicBezTo>
                  <a:pt x="1984642" y="37589"/>
                  <a:pt x="1993506" y="197530"/>
                  <a:pt x="1987817" y="291060"/>
                </a:cubicBezTo>
                <a:cubicBezTo>
                  <a:pt x="1982128" y="384590"/>
                  <a:pt x="1968502" y="507753"/>
                  <a:pt x="1947335" y="569666"/>
                </a:cubicBezTo>
                <a:cubicBezTo>
                  <a:pt x="1926168" y="631579"/>
                  <a:pt x="1842428" y="638987"/>
                  <a:pt x="1860817" y="662535"/>
                </a:cubicBezTo>
                <a:cubicBezTo>
                  <a:pt x="1879206" y="686083"/>
                  <a:pt x="2015246" y="703884"/>
                  <a:pt x="2057667" y="710954"/>
                </a:cubicBezTo>
                <a:cubicBezTo>
                  <a:pt x="2100088" y="718024"/>
                  <a:pt x="2086766" y="712362"/>
                  <a:pt x="2115341" y="704954"/>
                </a:cubicBezTo>
                <a:cubicBezTo>
                  <a:pt x="2143916" y="697546"/>
                  <a:pt x="2233438" y="645263"/>
                  <a:pt x="2229117" y="649835"/>
                </a:cubicBezTo>
                <a:cubicBezTo>
                  <a:pt x="2224796" y="654407"/>
                  <a:pt x="2147625" y="720743"/>
                  <a:pt x="2089417" y="732385"/>
                </a:cubicBezTo>
                <a:cubicBezTo>
                  <a:pt x="2031209" y="744027"/>
                  <a:pt x="1930667" y="724977"/>
                  <a:pt x="1879867" y="719685"/>
                </a:cubicBezTo>
                <a:cubicBezTo>
                  <a:pt x="1829067" y="714393"/>
                  <a:pt x="1808959" y="676293"/>
                  <a:pt x="1784617" y="700635"/>
                </a:cubicBezTo>
                <a:cubicBezTo>
                  <a:pt x="1760275" y="724977"/>
                  <a:pt x="1768742" y="807527"/>
                  <a:pt x="1733817" y="865735"/>
                </a:cubicBezTo>
                <a:cubicBezTo>
                  <a:pt x="1698892" y="923943"/>
                  <a:pt x="1607875" y="976860"/>
                  <a:pt x="1575067" y="1049885"/>
                </a:cubicBezTo>
                <a:cubicBezTo>
                  <a:pt x="1542259" y="1122910"/>
                  <a:pt x="1494634" y="1254144"/>
                  <a:pt x="1536967" y="1303885"/>
                </a:cubicBezTo>
                <a:cubicBezTo>
                  <a:pt x="1579300" y="1353626"/>
                  <a:pt x="1728525" y="1387493"/>
                  <a:pt x="1829067" y="1348335"/>
                </a:cubicBezTo>
                <a:cubicBezTo>
                  <a:pt x="1929609" y="1309177"/>
                  <a:pt x="2084125" y="1142489"/>
                  <a:pt x="2140217" y="1068935"/>
                </a:cubicBezTo>
                <a:cubicBezTo>
                  <a:pt x="2196309" y="995381"/>
                  <a:pt x="2160325" y="953577"/>
                  <a:pt x="2165617" y="907010"/>
                </a:cubicBezTo>
                <a:cubicBezTo>
                  <a:pt x="2170909" y="860443"/>
                  <a:pt x="2167734" y="775777"/>
                  <a:pt x="2171967" y="789535"/>
                </a:cubicBezTo>
                <a:cubicBezTo>
                  <a:pt x="2176200" y="803293"/>
                  <a:pt x="2195647" y="937966"/>
                  <a:pt x="2191017" y="989560"/>
                </a:cubicBezTo>
                <a:cubicBezTo>
                  <a:pt x="2186387" y="1041154"/>
                  <a:pt x="2182285" y="1047768"/>
                  <a:pt x="2144185" y="1099097"/>
                </a:cubicBezTo>
                <a:cubicBezTo>
                  <a:pt x="2106085" y="1150426"/>
                  <a:pt x="1937678" y="1283512"/>
                  <a:pt x="1962417" y="1297535"/>
                </a:cubicBezTo>
                <a:cubicBezTo>
                  <a:pt x="1987156" y="1311558"/>
                  <a:pt x="2232292" y="1277427"/>
                  <a:pt x="2292617" y="1183235"/>
                </a:cubicBezTo>
                <a:cubicBezTo>
                  <a:pt x="2352942" y="1089043"/>
                  <a:pt x="2314313" y="760695"/>
                  <a:pt x="2324367" y="732385"/>
                </a:cubicBezTo>
                <a:cubicBezTo>
                  <a:pt x="2334421" y="704075"/>
                  <a:pt x="2348709" y="947226"/>
                  <a:pt x="2352942" y="1013372"/>
                </a:cubicBezTo>
                <a:cubicBezTo>
                  <a:pt x="2357175" y="1079518"/>
                  <a:pt x="2318546" y="1194083"/>
                  <a:pt x="2349767" y="1129260"/>
                </a:cubicBezTo>
                <a:cubicBezTo>
                  <a:pt x="2380988" y="1064437"/>
                  <a:pt x="2454542" y="744556"/>
                  <a:pt x="2540267" y="624435"/>
                </a:cubicBezTo>
                <a:cubicBezTo>
                  <a:pt x="2625992" y="504314"/>
                  <a:pt x="2841363" y="425204"/>
                  <a:pt x="2864117" y="408535"/>
                </a:cubicBezTo>
                <a:cubicBezTo>
                  <a:pt x="2886871" y="391866"/>
                  <a:pt x="2726137" y="488174"/>
                  <a:pt x="2676792" y="524422"/>
                </a:cubicBezTo>
                <a:cubicBezTo>
                  <a:pt x="2627447" y="560670"/>
                  <a:pt x="2594551" y="594744"/>
                  <a:pt x="2568048" y="626023"/>
                </a:cubicBezTo>
                <a:cubicBezTo>
                  <a:pt x="2541545" y="657302"/>
                  <a:pt x="2523460" y="693314"/>
                  <a:pt x="2517772" y="712099"/>
                </a:cubicBezTo>
                <a:cubicBezTo>
                  <a:pt x="2512084" y="730884"/>
                  <a:pt x="2511780" y="707838"/>
                  <a:pt x="2500580" y="745879"/>
                </a:cubicBezTo>
                <a:cubicBezTo>
                  <a:pt x="2489380" y="783920"/>
                  <a:pt x="2421734" y="937304"/>
                  <a:pt x="2450573" y="940347"/>
                </a:cubicBezTo>
                <a:cubicBezTo>
                  <a:pt x="2479412" y="943390"/>
                  <a:pt x="2630093" y="814670"/>
                  <a:pt x="2673617" y="764135"/>
                </a:cubicBezTo>
                <a:cubicBezTo>
                  <a:pt x="2717141" y="713600"/>
                  <a:pt x="2711188" y="634489"/>
                  <a:pt x="2711717" y="637135"/>
                </a:cubicBezTo>
                <a:cubicBezTo>
                  <a:pt x="2712246" y="639781"/>
                  <a:pt x="2712775" y="729210"/>
                  <a:pt x="2676792" y="780010"/>
                </a:cubicBezTo>
                <a:cubicBezTo>
                  <a:pt x="2640809" y="830810"/>
                  <a:pt x="2538547" y="898147"/>
                  <a:pt x="2495817" y="941935"/>
                </a:cubicBezTo>
                <a:cubicBezTo>
                  <a:pt x="2453087" y="985723"/>
                  <a:pt x="2450088" y="1001275"/>
                  <a:pt x="2420410" y="1042741"/>
                </a:cubicBezTo>
                <a:cubicBezTo>
                  <a:pt x="2390732" y="1084207"/>
                  <a:pt x="2338702" y="1165752"/>
                  <a:pt x="2317747" y="1190729"/>
                </a:cubicBezTo>
                <a:cubicBezTo>
                  <a:pt x="2296792" y="1215706"/>
                  <a:pt x="2314479" y="1215282"/>
                  <a:pt x="2265312" y="1241020"/>
                </a:cubicBezTo>
                <a:cubicBezTo>
                  <a:pt x="2216145" y="1266758"/>
                  <a:pt x="2091216" y="1318808"/>
                  <a:pt x="2022742" y="1345160"/>
                </a:cubicBezTo>
                <a:cubicBezTo>
                  <a:pt x="1954268" y="1371513"/>
                  <a:pt x="1928021" y="1380614"/>
                  <a:pt x="1854467" y="1399135"/>
                </a:cubicBezTo>
                <a:cubicBezTo>
                  <a:pt x="1780913" y="1417656"/>
                  <a:pt x="1667142" y="1421360"/>
                  <a:pt x="1581417" y="1456285"/>
                </a:cubicBezTo>
                <a:cubicBezTo>
                  <a:pt x="1495692" y="1491210"/>
                  <a:pt x="1373984" y="1554710"/>
                  <a:pt x="1340117" y="1608685"/>
                </a:cubicBezTo>
                <a:cubicBezTo>
                  <a:pt x="1306250" y="1662660"/>
                  <a:pt x="1300959" y="1709227"/>
                  <a:pt x="1378217" y="1780135"/>
                </a:cubicBezTo>
                <a:cubicBezTo>
                  <a:pt x="1455475" y="1851043"/>
                  <a:pt x="1797317" y="2021435"/>
                  <a:pt x="1803667" y="2034135"/>
                </a:cubicBezTo>
                <a:cubicBezTo>
                  <a:pt x="1810017" y="2046835"/>
                  <a:pt x="1512625" y="1914543"/>
                  <a:pt x="1416317" y="1856335"/>
                </a:cubicBezTo>
                <a:cubicBezTo>
                  <a:pt x="1320009" y="1798127"/>
                  <a:pt x="1307838" y="1714518"/>
                  <a:pt x="1225817" y="1684885"/>
                </a:cubicBezTo>
                <a:cubicBezTo>
                  <a:pt x="1143796" y="1655252"/>
                  <a:pt x="1010975" y="1630910"/>
                  <a:pt x="924192" y="1678535"/>
                </a:cubicBezTo>
                <a:cubicBezTo>
                  <a:pt x="837409" y="1726160"/>
                  <a:pt x="770205" y="1875385"/>
                  <a:pt x="705117" y="1970635"/>
                </a:cubicBezTo>
                <a:cubicBezTo>
                  <a:pt x="640030" y="2065885"/>
                  <a:pt x="619392" y="2186535"/>
                  <a:pt x="533667" y="2250035"/>
                </a:cubicBezTo>
                <a:cubicBezTo>
                  <a:pt x="447942" y="2313535"/>
                  <a:pt x="279667" y="2342110"/>
                  <a:pt x="190767" y="2351635"/>
                </a:cubicBezTo>
                <a:cubicBezTo>
                  <a:pt x="101867" y="2361160"/>
                  <a:pt x="-6083" y="2310360"/>
                  <a:pt x="267" y="2307185"/>
                </a:cubicBezTo>
                <a:cubicBezTo>
                  <a:pt x="6617" y="2304010"/>
                  <a:pt x="147375" y="2344227"/>
                  <a:pt x="228867" y="2332585"/>
                </a:cubicBezTo>
                <a:cubicBezTo>
                  <a:pt x="310359" y="2320943"/>
                  <a:pt x="423600" y="2287077"/>
                  <a:pt x="489217" y="2237335"/>
                </a:cubicBezTo>
                <a:cubicBezTo>
                  <a:pt x="554834" y="2187593"/>
                  <a:pt x="591875" y="2106102"/>
                  <a:pt x="622567" y="2034135"/>
                </a:cubicBezTo>
                <a:cubicBezTo>
                  <a:pt x="653259" y="1962168"/>
                  <a:pt x="731575" y="1790718"/>
                  <a:pt x="673367" y="1805535"/>
                </a:cubicBezTo>
                <a:cubicBezTo>
                  <a:pt x="615159" y="1820352"/>
                  <a:pt x="366450" y="2069060"/>
                  <a:pt x="273317" y="2123035"/>
                </a:cubicBezTo>
                <a:cubicBezTo>
                  <a:pt x="180184" y="2177010"/>
                  <a:pt x="123034" y="2130443"/>
                  <a:pt x="114567" y="2129385"/>
                </a:cubicBezTo>
                <a:cubicBezTo>
                  <a:pt x="106100" y="2128327"/>
                  <a:pt x="175950" y="2138910"/>
                  <a:pt x="222517" y="2116685"/>
                </a:cubicBezTo>
                <a:cubicBezTo>
                  <a:pt x="269084" y="2094460"/>
                  <a:pt x="338934" y="2039956"/>
                  <a:pt x="393967" y="1996035"/>
                </a:cubicBezTo>
                <a:cubicBezTo>
                  <a:pt x="449000" y="1952114"/>
                  <a:pt x="481809" y="1913485"/>
                  <a:pt x="552717" y="1853160"/>
                </a:cubicBezTo>
                <a:cubicBezTo>
                  <a:pt x="623625" y="1792835"/>
                  <a:pt x="767030" y="1718223"/>
                  <a:pt x="819417" y="1634085"/>
                </a:cubicBezTo>
                <a:cubicBezTo>
                  <a:pt x="871805" y="1549948"/>
                  <a:pt x="896675" y="1424535"/>
                  <a:pt x="867042" y="1348335"/>
                </a:cubicBezTo>
                <a:cubicBezTo>
                  <a:pt x="837409" y="1272135"/>
                  <a:pt x="705646" y="1220277"/>
                  <a:pt x="641617" y="1176885"/>
                </a:cubicBezTo>
                <a:cubicBezTo>
                  <a:pt x="577588" y="1133493"/>
                  <a:pt x="470167" y="1089043"/>
                  <a:pt x="482867" y="1087985"/>
                </a:cubicBezTo>
                <a:cubicBezTo>
                  <a:pt x="495567" y="1086927"/>
                  <a:pt x="682892" y="1193818"/>
                  <a:pt x="717817" y="1170535"/>
                </a:cubicBezTo>
                <a:cubicBezTo>
                  <a:pt x="752742" y="1147252"/>
                  <a:pt x="714642" y="1005435"/>
                  <a:pt x="692417" y="948285"/>
                </a:cubicBezTo>
                <a:cubicBezTo>
                  <a:pt x="670192" y="891135"/>
                  <a:pt x="581292" y="830810"/>
                  <a:pt x="584467" y="827635"/>
                </a:cubicBezTo>
                <a:cubicBezTo>
                  <a:pt x="587642" y="824460"/>
                  <a:pt x="681305" y="866793"/>
                  <a:pt x="711467" y="929235"/>
                </a:cubicBezTo>
                <a:cubicBezTo>
                  <a:pt x="741629" y="991677"/>
                  <a:pt x="753800" y="1181118"/>
                  <a:pt x="765442" y="1202285"/>
                </a:cubicBezTo>
                <a:cubicBezTo>
                  <a:pt x="777084" y="1223452"/>
                  <a:pt x="775496" y="1104918"/>
                  <a:pt x="781317" y="1056235"/>
                </a:cubicBezTo>
                <a:cubicBezTo>
                  <a:pt x="787138" y="1007552"/>
                  <a:pt x="809892" y="966277"/>
                  <a:pt x="800367" y="910185"/>
                </a:cubicBezTo>
                <a:cubicBezTo>
                  <a:pt x="790842" y="854093"/>
                  <a:pt x="720066" y="719817"/>
                  <a:pt x="724167" y="719685"/>
                </a:cubicBezTo>
                <a:cubicBezTo>
                  <a:pt x="728268" y="719553"/>
                  <a:pt x="811215" y="857533"/>
                  <a:pt x="824973" y="909391"/>
                </a:cubicBezTo>
                <a:cubicBezTo>
                  <a:pt x="838731" y="961249"/>
                  <a:pt x="808701" y="982019"/>
                  <a:pt x="806717" y="1030835"/>
                </a:cubicBezTo>
                <a:cubicBezTo>
                  <a:pt x="804733" y="1079651"/>
                  <a:pt x="790842" y="1155718"/>
                  <a:pt x="813067" y="1202285"/>
                </a:cubicBezTo>
                <a:cubicBezTo>
                  <a:pt x="835292" y="1248852"/>
                  <a:pt x="906200" y="1336693"/>
                  <a:pt x="940067" y="1310235"/>
                </a:cubicBezTo>
                <a:cubicBezTo>
                  <a:pt x="973934" y="1283777"/>
                  <a:pt x="1004625" y="1062585"/>
                  <a:pt x="1016267" y="1043535"/>
                </a:cubicBezTo>
                <a:cubicBezTo>
                  <a:pt x="1027909" y="1024485"/>
                  <a:pt x="1010975" y="1155718"/>
                  <a:pt x="1009917" y="1195935"/>
                </a:cubicBezTo>
                <a:cubicBezTo>
                  <a:pt x="1008859" y="1236152"/>
                  <a:pt x="989809" y="1272135"/>
                  <a:pt x="1009917" y="1284835"/>
                </a:cubicBezTo>
                <a:cubicBezTo>
                  <a:pt x="1030025" y="1297535"/>
                  <a:pt x="1088234" y="1312352"/>
                  <a:pt x="1130567" y="1272135"/>
                </a:cubicBezTo>
                <a:cubicBezTo>
                  <a:pt x="1172900" y="1231918"/>
                  <a:pt x="1235342" y="1145135"/>
                  <a:pt x="1263917" y="1043535"/>
                </a:cubicBezTo>
                <a:cubicBezTo>
                  <a:pt x="1292492" y="941935"/>
                  <a:pt x="1297784" y="747202"/>
                  <a:pt x="1302017" y="662535"/>
                </a:cubicBezTo>
                <a:cubicBezTo>
                  <a:pt x="1306250" y="577868"/>
                  <a:pt x="1306455" y="551494"/>
                  <a:pt x="1263123" y="516485"/>
                </a:cubicBezTo>
                <a:cubicBezTo>
                  <a:pt x="1219791" y="481476"/>
                  <a:pt x="1100896" y="466241"/>
                  <a:pt x="1042026" y="452483"/>
                </a:cubicBezTo>
                <a:cubicBezTo>
                  <a:pt x="983156" y="438725"/>
                  <a:pt x="880332" y="430676"/>
                  <a:pt x="909905" y="433935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" name="椭圆 5">
            <a:extLst>
              <a:ext uri="{FF2B5EF4-FFF2-40B4-BE49-F238E27FC236}">
                <a16:creationId xmlns:a16="http://schemas.microsoft.com/office/drawing/2014/main" id="{F8C169A0-FADB-4B3C-9DFF-4AAE356FECE1}"/>
              </a:ext>
            </a:extLst>
          </p:cNvPr>
          <p:cNvSpPr/>
          <p:nvPr/>
        </p:nvSpPr>
        <p:spPr>
          <a:xfrm rot="20053127">
            <a:off x="4166826" y="10226273"/>
            <a:ext cx="110475" cy="48135"/>
          </a:xfrm>
          <a:prstGeom prst="ellipse">
            <a:avLst/>
          </a:prstGeom>
          <a:solidFill>
            <a:schemeClr val="accent2">
              <a:lumMod val="20000"/>
              <a:lumOff val="8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ABC330FD-FFAF-44F7-902C-E63FF7A3A07C}"/>
              </a:ext>
            </a:extLst>
          </p:cNvPr>
          <p:cNvGrpSpPr/>
          <p:nvPr/>
        </p:nvGrpSpPr>
        <p:grpSpPr>
          <a:xfrm>
            <a:off x="4368359" y="10347835"/>
            <a:ext cx="831082" cy="264458"/>
            <a:chOff x="3938665" y="1899074"/>
            <a:chExt cx="676166" cy="215163"/>
          </a:xfrm>
          <a:solidFill>
            <a:schemeClr val="accent2">
              <a:lumMod val="60000"/>
              <a:lumOff val="40000"/>
            </a:schemeClr>
          </a:solidFill>
        </p:grpSpPr>
        <p:sp>
          <p:nvSpPr>
            <p:cNvPr id="154" name="任意多边形: 形状 153">
              <a:extLst>
                <a:ext uri="{FF2B5EF4-FFF2-40B4-BE49-F238E27FC236}">
                  <a16:creationId xmlns:a16="http://schemas.microsoft.com/office/drawing/2014/main" id="{AFE1BB41-63EA-4170-BBC5-EB729B5945BB}"/>
                </a:ext>
              </a:extLst>
            </p:cNvPr>
            <p:cNvSpPr/>
            <p:nvPr/>
          </p:nvSpPr>
          <p:spPr>
            <a:xfrm rot="20528713">
              <a:off x="3990558" y="1899074"/>
              <a:ext cx="624273" cy="215163"/>
            </a:xfrm>
            <a:custGeom>
              <a:avLst/>
              <a:gdLst>
                <a:gd name="connsiteX0" fmla="*/ 10605 w 2358367"/>
                <a:gd name="connsiteY0" fmla="*/ 265 h 468400"/>
                <a:gd name="connsiteX1" fmla="*/ 820230 w 2358367"/>
                <a:gd name="connsiteY1" fmla="*/ 371740 h 468400"/>
                <a:gd name="connsiteX2" fmla="*/ 2268030 w 2358367"/>
                <a:gd name="connsiteY2" fmla="*/ 438415 h 468400"/>
                <a:gd name="connsiteX3" fmla="*/ 2087055 w 2358367"/>
                <a:gd name="connsiteY3" fmla="*/ 466990 h 468400"/>
                <a:gd name="connsiteX4" fmla="*/ 1115505 w 2358367"/>
                <a:gd name="connsiteY4" fmla="*/ 447940 h 468400"/>
                <a:gd name="connsiteX5" fmla="*/ 410655 w 2358367"/>
                <a:gd name="connsiteY5" fmla="*/ 314590 h 468400"/>
                <a:gd name="connsiteX6" fmla="*/ 10605 w 2358367"/>
                <a:gd name="connsiteY6" fmla="*/ 265 h 468400"/>
                <a:gd name="connsiteX0" fmla="*/ 7359 w 2355121"/>
                <a:gd name="connsiteY0" fmla="*/ 705 h 468840"/>
                <a:gd name="connsiteX1" fmla="*/ 816984 w 2355121"/>
                <a:gd name="connsiteY1" fmla="*/ 372180 h 468840"/>
                <a:gd name="connsiteX2" fmla="*/ 2264784 w 2355121"/>
                <a:gd name="connsiteY2" fmla="*/ 438855 h 468840"/>
                <a:gd name="connsiteX3" fmla="*/ 2083809 w 2355121"/>
                <a:gd name="connsiteY3" fmla="*/ 467430 h 468840"/>
                <a:gd name="connsiteX4" fmla="*/ 1112259 w 2355121"/>
                <a:gd name="connsiteY4" fmla="*/ 448380 h 468840"/>
                <a:gd name="connsiteX5" fmla="*/ 458209 w 2355121"/>
                <a:gd name="connsiteY5" fmla="*/ 283280 h 468840"/>
                <a:gd name="connsiteX6" fmla="*/ 7359 w 2355121"/>
                <a:gd name="connsiteY6" fmla="*/ 705 h 468840"/>
                <a:gd name="connsiteX0" fmla="*/ 7359 w 2359922"/>
                <a:gd name="connsiteY0" fmla="*/ 705 h 460965"/>
                <a:gd name="connsiteX1" fmla="*/ 816984 w 2359922"/>
                <a:gd name="connsiteY1" fmla="*/ 372180 h 460965"/>
                <a:gd name="connsiteX2" fmla="*/ 2264784 w 2359922"/>
                <a:gd name="connsiteY2" fmla="*/ 438855 h 460965"/>
                <a:gd name="connsiteX3" fmla="*/ 2099684 w 2359922"/>
                <a:gd name="connsiteY3" fmla="*/ 451555 h 460965"/>
                <a:gd name="connsiteX4" fmla="*/ 1112259 w 2359922"/>
                <a:gd name="connsiteY4" fmla="*/ 448380 h 460965"/>
                <a:gd name="connsiteX5" fmla="*/ 458209 w 2359922"/>
                <a:gd name="connsiteY5" fmla="*/ 283280 h 460965"/>
                <a:gd name="connsiteX6" fmla="*/ 7359 w 2359922"/>
                <a:gd name="connsiteY6" fmla="*/ 705 h 460965"/>
                <a:gd name="connsiteX0" fmla="*/ 7319 w 2358699"/>
                <a:gd name="connsiteY0" fmla="*/ 696 h 452108"/>
                <a:gd name="connsiteX1" fmla="*/ 816944 w 2358699"/>
                <a:gd name="connsiteY1" fmla="*/ 372171 h 452108"/>
                <a:gd name="connsiteX2" fmla="*/ 2264744 w 2358699"/>
                <a:gd name="connsiteY2" fmla="*/ 438846 h 452108"/>
                <a:gd name="connsiteX3" fmla="*/ 2099644 w 2358699"/>
                <a:gd name="connsiteY3" fmla="*/ 451546 h 452108"/>
                <a:gd name="connsiteX4" fmla="*/ 1147144 w 2358699"/>
                <a:gd name="connsiteY4" fmla="*/ 429321 h 452108"/>
                <a:gd name="connsiteX5" fmla="*/ 458169 w 2358699"/>
                <a:gd name="connsiteY5" fmla="*/ 283271 h 452108"/>
                <a:gd name="connsiteX6" fmla="*/ 7319 w 2358699"/>
                <a:gd name="connsiteY6" fmla="*/ 696 h 452108"/>
                <a:gd name="connsiteX0" fmla="*/ 7319 w 2102769"/>
                <a:gd name="connsiteY0" fmla="*/ 696 h 453125"/>
                <a:gd name="connsiteX1" fmla="*/ 816944 w 2102769"/>
                <a:gd name="connsiteY1" fmla="*/ 372171 h 453125"/>
                <a:gd name="connsiteX2" fmla="*/ 1430997 w 2102769"/>
                <a:gd name="connsiteY2" fmla="*/ 442469 h 453125"/>
                <a:gd name="connsiteX3" fmla="*/ 2099644 w 2102769"/>
                <a:gd name="connsiteY3" fmla="*/ 451546 h 453125"/>
                <a:gd name="connsiteX4" fmla="*/ 1147144 w 2102769"/>
                <a:gd name="connsiteY4" fmla="*/ 429321 h 453125"/>
                <a:gd name="connsiteX5" fmla="*/ 458169 w 2102769"/>
                <a:gd name="connsiteY5" fmla="*/ 283271 h 453125"/>
                <a:gd name="connsiteX6" fmla="*/ 7319 w 2102769"/>
                <a:gd name="connsiteY6" fmla="*/ 696 h 453125"/>
                <a:gd name="connsiteX0" fmla="*/ 7319 w 1493824"/>
                <a:gd name="connsiteY0" fmla="*/ 696 h 445374"/>
                <a:gd name="connsiteX1" fmla="*/ 816944 w 1493824"/>
                <a:gd name="connsiteY1" fmla="*/ 372171 h 445374"/>
                <a:gd name="connsiteX2" fmla="*/ 1430997 w 1493824"/>
                <a:gd name="connsiteY2" fmla="*/ 442469 h 445374"/>
                <a:gd name="connsiteX3" fmla="*/ 1441574 w 1493824"/>
                <a:gd name="connsiteY3" fmla="*/ 431702 h 445374"/>
                <a:gd name="connsiteX4" fmla="*/ 1147144 w 1493824"/>
                <a:gd name="connsiteY4" fmla="*/ 429321 h 445374"/>
                <a:gd name="connsiteX5" fmla="*/ 458169 w 1493824"/>
                <a:gd name="connsiteY5" fmla="*/ 283271 h 445374"/>
                <a:gd name="connsiteX6" fmla="*/ 7319 w 1493824"/>
                <a:gd name="connsiteY6" fmla="*/ 696 h 445374"/>
                <a:gd name="connsiteX0" fmla="*/ 7319 w 1438910"/>
                <a:gd name="connsiteY0" fmla="*/ 696 h 444117"/>
                <a:gd name="connsiteX1" fmla="*/ 816944 w 1438910"/>
                <a:gd name="connsiteY1" fmla="*/ 372171 h 444117"/>
                <a:gd name="connsiteX2" fmla="*/ 1430997 w 1438910"/>
                <a:gd name="connsiteY2" fmla="*/ 442469 h 444117"/>
                <a:gd name="connsiteX3" fmla="*/ 1164356 w 1438910"/>
                <a:gd name="connsiteY3" fmla="*/ 422461 h 444117"/>
                <a:gd name="connsiteX4" fmla="*/ 1147144 w 1438910"/>
                <a:gd name="connsiteY4" fmla="*/ 429321 h 444117"/>
                <a:gd name="connsiteX5" fmla="*/ 458169 w 1438910"/>
                <a:gd name="connsiteY5" fmla="*/ 283271 h 444117"/>
                <a:gd name="connsiteX6" fmla="*/ 7319 w 1438910"/>
                <a:gd name="connsiteY6" fmla="*/ 696 h 444117"/>
                <a:gd name="connsiteX0" fmla="*/ 7319 w 1275152"/>
                <a:gd name="connsiteY0" fmla="*/ 696 h 439496"/>
                <a:gd name="connsiteX1" fmla="*/ 816944 w 1275152"/>
                <a:gd name="connsiteY1" fmla="*/ 372171 h 439496"/>
                <a:gd name="connsiteX2" fmla="*/ 1167379 w 1275152"/>
                <a:gd name="connsiteY2" fmla="*/ 437608 h 439496"/>
                <a:gd name="connsiteX3" fmla="*/ 1164356 w 1275152"/>
                <a:gd name="connsiteY3" fmla="*/ 422461 h 439496"/>
                <a:gd name="connsiteX4" fmla="*/ 1147144 w 1275152"/>
                <a:gd name="connsiteY4" fmla="*/ 429321 h 439496"/>
                <a:gd name="connsiteX5" fmla="*/ 458169 w 1275152"/>
                <a:gd name="connsiteY5" fmla="*/ 283271 h 439496"/>
                <a:gd name="connsiteX6" fmla="*/ 7319 w 1275152"/>
                <a:gd name="connsiteY6" fmla="*/ 696 h 4394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275152" h="439496">
                  <a:moveTo>
                    <a:pt x="7319" y="696"/>
                  </a:moveTo>
                  <a:cubicBezTo>
                    <a:pt x="67115" y="15513"/>
                    <a:pt x="623601" y="299352"/>
                    <a:pt x="816944" y="372171"/>
                  </a:cubicBezTo>
                  <a:cubicBezTo>
                    <a:pt x="1010287" y="444990"/>
                    <a:pt x="1109477" y="429226"/>
                    <a:pt x="1167379" y="437608"/>
                  </a:cubicBezTo>
                  <a:cubicBezTo>
                    <a:pt x="1225281" y="445990"/>
                    <a:pt x="1167728" y="423842"/>
                    <a:pt x="1164356" y="422461"/>
                  </a:cubicBezTo>
                  <a:cubicBezTo>
                    <a:pt x="1160984" y="421080"/>
                    <a:pt x="1426544" y="454721"/>
                    <a:pt x="1147144" y="429321"/>
                  </a:cubicBezTo>
                  <a:cubicBezTo>
                    <a:pt x="867744" y="403921"/>
                    <a:pt x="648140" y="354708"/>
                    <a:pt x="458169" y="283271"/>
                  </a:cubicBezTo>
                  <a:cubicBezTo>
                    <a:pt x="268198" y="211834"/>
                    <a:pt x="-52477" y="-14121"/>
                    <a:pt x="7319" y="696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" name="任意多边形: 形状 154">
              <a:extLst>
                <a:ext uri="{FF2B5EF4-FFF2-40B4-BE49-F238E27FC236}">
                  <a16:creationId xmlns:a16="http://schemas.microsoft.com/office/drawing/2014/main" id="{5A7D1BFB-FEA9-496C-B238-6BA7C792CF80}"/>
                </a:ext>
              </a:extLst>
            </p:cNvPr>
            <p:cNvSpPr/>
            <p:nvPr/>
          </p:nvSpPr>
          <p:spPr>
            <a:xfrm rot="20528713">
              <a:off x="4027333" y="1990583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" name="任意多边形: 形状 155">
              <a:extLst>
                <a:ext uri="{FF2B5EF4-FFF2-40B4-BE49-F238E27FC236}">
                  <a16:creationId xmlns:a16="http://schemas.microsoft.com/office/drawing/2014/main" id="{92B8CC8D-D382-4AF5-825D-8FFF3B0D2A03}"/>
                </a:ext>
              </a:extLst>
            </p:cNvPr>
            <p:cNvSpPr/>
            <p:nvPr/>
          </p:nvSpPr>
          <p:spPr>
            <a:xfrm rot="20029926">
              <a:off x="4111758" y="2004346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" name="任意多边形: 形状 156">
              <a:extLst>
                <a:ext uri="{FF2B5EF4-FFF2-40B4-BE49-F238E27FC236}">
                  <a16:creationId xmlns:a16="http://schemas.microsoft.com/office/drawing/2014/main" id="{A417E50F-EAB1-4A62-8311-F3D3F49F3CF2}"/>
                </a:ext>
              </a:extLst>
            </p:cNvPr>
            <p:cNvSpPr/>
            <p:nvPr/>
          </p:nvSpPr>
          <p:spPr>
            <a:xfrm rot="20008625">
              <a:off x="4204246" y="2018321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" name="任意多边形: 形状 157">
              <a:extLst>
                <a:ext uri="{FF2B5EF4-FFF2-40B4-BE49-F238E27FC236}">
                  <a16:creationId xmlns:a16="http://schemas.microsoft.com/office/drawing/2014/main" id="{B19EEE47-CD1F-414F-9708-F15BAEAC2EF8}"/>
                </a:ext>
              </a:extLst>
            </p:cNvPr>
            <p:cNvSpPr/>
            <p:nvPr/>
          </p:nvSpPr>
          <p:spPr>
            <a:xfrm rot="19552324">
              <a:off x="4297368" y="2019717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" name="任意多边形: 形状 158">
              <a:extLst>
                <a:ext uri="{FF2B5EF4-FFF2-40B4-BE49-F238E27FC236}">
                  <a16:creationId xmlns:a16="http://schemas.microsoft.com/office/drawing/2014/main" id="{4ACBA722-B171-4BE3-B8B4-D93AC4F5D24B}"/>
                </a:ext>
              </a:extLst>
            </p:cNvPr>
            <p:cNvSpPr/>
            <p:nvPr/>
          </p:nvSpPr>
          <p:spPr>
            <a:xfrm rot="19440872">
              <a:off x="4393149" y="2014457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" name="任意多边形: 形状 159">
              <a:extLst>
                <a:ext uri="{FF2B5EF4-FFF2-40B4-BE49-F238E27FC236}">
                  <a16:creationId xmlns:a16="http://schemas.microsoft.com/office/drawing/2014/main" id="{48DBF6D8-844A-433B-AA15-37804A763F37}"/>
                </a:ext>
              </a:extLst>
            </p:cNvPr>
            <p:cNvSpPr/>
            <p:nvPr/>
          </p:nvSpPr>
          <p:spPr>
            <a:xfrm rot="18930671">
              <a:off x="4489365" y="2004016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" name="任意多边形: 形状 166">
              <a:extLst>
                <a:ext uri="{FF2B5EF4-FFF2-40B4-BE49-F238E27FC236}">
                  <a16:creationId xmlns:a16="http://schemas.microsoft.com/office/drawing/2014/main" id="{33974844-ECC8-48FF-A0AF-BC2AE195F374}"/>
                </a:ext>
              </a:extLst>
            </p:cNvPr>
            <p:cNvSpPr/>
            <p:nvPr/>
          </p:nvSpPr>
          <p:spPr>
            <a:xfrm rot="20528713">
              <a:off x="3938665" y="1963646"/>
              <a:ext cx="83748" cy="67794"/>
            </a:xfrm>
            <a:custGeom>
              <a:avLst/>
              <a:gdLst>
                <a:gd name="connsiteX0" fmla="*/ 19379 w 149865"/>
                <a:gd name="connsiteY0" fmla="*/ 405 h 138551"/>
                <a:gd name="connsiteX1" fmla="*/ 9547 w 149865"/>
                <a:gd name="connsiteY1" fmla="*/ 59398 h 138551"/>
                <a:gd name="connsiteX2" fmla="*/ 107870 w 149865"/>
                <a:gd name="connsiteY2" fmla="*/ 138056 h 138551"/>
                <a:gd name="connsiteX3" fmla="*/ 147199 w 149865"/>
                <a:gd name="connsiteY3" fmla="*/ 88895 h 138551"/>
                <a:gd name="connsiteX4" fmla="*/ 19379 w 149865"/>
                <a:gd name="connsiteY4" fmla="*/ 405 h 138551"/>
                <a:gd name="connsiteX0" fmla="*/ 40580 w 171066"/>
                <a:gd name="connsiteY0" fmla="*/ 331 h 138477"/>
                <a:gd name="connsiteX1" fmla="*/ 4555 w 171066"/>
                <a:gd name="connsiteY1" fmla="*/ 61706 h 138477"/>
                <a:gd name="connsiteX2" fmla="*/ 129071 w 171066"/>
                <a:gd name="connsiteY2" fmla="*/ 137982 h 138477"/>
                <a:gd name="connsiteX3" fmla="*/ 168400 w 171066"/>
                <a:gd name="connsiteY3" fmla="*/ 88821 h 138477"/>
                <a:gd name="connsiteX4" fmla="*/ 40580 w 171066"/>
                <a:gd name="connsiteY4" fmla="*/ 331 h 1384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1066" h="138477">
                  <a:moveTo>
                    <a:pt x="40580" y="331"/>
                  </a:moveTo>
                  <a:cubicBezTo>
                    <a:pt x="13273" y="-4188"/>
                    <a:pt x="-10194" y="38764"/>
                    <a:pt x="4555" y="61706"/>
                  </a:cubicBezTo>
                  <a:cubicBezTo>
                    <a:pt x="19304" y="84648"/>
                    <a:pt x="106129" y="133066"/>
                    <a:pt x="129071" y="137982"/>
                  </a:cubicBezTo>
                  <a:cubicBezTo>
                    <a:pt x="152013" y="142898"/>
                    <a:pt x="179871" y="110124"/>
                    <a:pt x="168400" y="88821"/>
                  </a:cubicBezTo>
                  <a:cubicBezTo>
                    <a:pt x="156929" y="67518"/>
                    <a:pt x="67887" y="4850"/>
                    <a:pt x="40580" y="331"/>
                  </a:cubicBezTo>
                  <a:close/>
                </a:path>
              </a:pathLst>
            </a:custGeom>
            <a:grp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33" name="任意多边形: 形状 32">
            <a:extLst>
              <a:ext uri="{FF2B5EF4-FFF2-40B4-BE49-F238E27FC236}">
                <a16:creationId xmlns:a16="http://schemas.microsoft.com/office/drawing/2014/main" id="{A2C05317-C6B1-494B-807E-2F9D10CEBA30}"/>
              </a:ext>
            </a:extLst>
          </p:cNvPr>
          <p:cNvSpPr/>
          <p:nvPr/>
        </p:nvSpPr>
        <p:spPr>
          <a:xfrm rot="15304263" flipV="1">
            <a:off x="1184523" y="10135709"/>
            <a:ext cx="1037183" cy="1048469"/>
          </a:xfrm>
          <a:custGeom>
            <a:avLst/>
            <a:gdLst>
              <a:gd name="connsiteX0" fmla="*/ 2273749 w 4449117"/>
              <a:gd name="connsiteY0" fmla="*/ 1194101 h 3581744"/>
              <a:gd name="connsiteX1" fmla="*/ 2515049 w 4449117"/>
              <a:gd name="connsiteY1" fmla="*/ 1410001 h 3581744"/>
              <a:gd name="connsiteX2" fmla="*/ 2870649 w 4449117"/>
              <a:gd name="connsiteY2" fmla="*/ 1410001 h 3581744"/>
              <a:gd name="connsiteX3" fmla="*/ 3010349 w 4449117"/>
              <a:gd name="connsiteY3" fmla="*/ 990901 h 3581744"/>
              <a:gd name="connsiteX4" fmla="*/ 2743649 w 4449117"/>
              <a:gd name="connsiteY4" fmla="*/ 406701 h 3581744"/>
              <a:gd name="connsiteX5" fmla="*/ 2946849 w 4449117"/>
              <a:gd name="connsiteY5" fmla="*/ 660701 h 3581744"/>
              <a:gd name="connsiteX6" fmla="*/ 3086549 w 4449117"/>
              <a:gd name="connsiteY6" fmla="*/ 965501 h 3581744"/>
              <a:gd name="connsiteX7" fmla="*/ 2984949 w 4449117"/>
              <a:gd name="connsiteY7" fmla="*/ 216201 h 3581744"/>
              <a:gd name="connsiteX8" fmla="*/ 3150049 w 4449117"/>
              <a:gd name="connsiteY8" fmla="*/ 301 h 3581744"/>
              <a:gd name="connsiteX9" fmla="*/ 3035749 w 4449117"/>
              <a:gd name="connsiteY9" fmla="*/ 178101 h 3581744"/>
              <a:gd name="connsiteX10" fmla="*/ 3086549 w 4449117"/>
              <a:gd name="connsiteY10" fmla="*/ 533701 h 3581744"/>
              <a:gd name="connsiteX11" fmla="*/ 3289749 w 4449117"/>
              <a:gd name="connsiteY11" fmla="*/ 228901 h 3581744"/>
              <a:gd name="connsiteX12" fmla="*/ 3162749 w 4449117"/>
              <a:gd name="connsiteY12" fmla="*/ 609901 h 3581744"/>
              <a:gd name="connsiteX13" fmla="*/ 3162749 w 4449117"/>
              <a:gd name="connsiteY13" fmla="*/ 876601 h 3581744"/>
              <a:gd name="connsiteX14" fmla="*/ 3099249 w 4449117"/>
              <a:gd name="connsiteY14" fmla="*/ 1206801 h 3581744"/>
              <a:gd name="connsiteX15" fmla="*/ 3048449 w 4449117"/>
              <a:gd name="connsiteY15" fmla="*/ 1384601 h 3581744"/>
              <a:gd name="connsiteX16" fmla="*/ 3048449 w 4449117"/>
              <a:gd name="connsiteY16" fmla="*/ 1676701 h 3581744"/>
              <a:gd name="connsiteX17" fmla="*/ 3048449 w 4449117"/>
              <a:gd name="connsiteY17" fmla="*/ 1803701 h 3581744"/>
              <a:gd name="connsiteX18" fmla="*/ 4013649 w 4449117"/>
              <a:gd name="connsiteY18" fmla="*/ 1981501 h 3581744"/>
              <a:gd name="connsiteX19" fmla="*/ 4445449 w 4449117"/>
              <a:gd name="connsiteY19" fmla="*/ 2070401 h 3581744"/>
              <a:gd name="connsiteX20" fmla="*/ 3797749 w 4449117"/>
              <a:gd name="connsiteY20" fmla="*/ 1994201 h 3581744"/>
              <a:gd name="connsiteX21" fmla="*/ 3505649 w 4449117"/>
              <a:gd name="connsiteY21" fmla="*/ 2006901 h 3581744"/>
              <a:gd name="connsiteX22" fmla="*/ 4039049 w 4449117"/>
              <a:gd name="connsiteY22" fmla="*/ 2362501 h 3581744"/>
              <a:gd name="connsiteX23" fmla="*/ 3531049 w 4449117"/>
              <a:gd name="connsiteY23" fmla="*/ 2121201 h 3581744"/>
              <a:gd name="connsiteX24" fmla="*/ 3823149 w 4449117"/>
              <a:gd name="connsiteY24" fmla="*/ 2629201 h 3581744"/>
              <a:gd name="connsiteX25" fmla="*/ 4242249 w 4449117"/>
              <a:gd name="connsiteY25" fmla="*/ 3149901 h 3581744"/>
              <a:gd name="connsiteX26" fmla="*/ 3785049 w 4449117"/>
              <a:gd name="connsiteY26" fmla="*/ 2692701 h 3581744"/>
              <a:gd name="connsiteX27" fmla="*/ 3454849 w 4449117"/>
              <a:gd name="connsiteY27" fmla="*/ 2172001 h 3581744"/>
              <a:gd name="connsiteX28" fmla="*/ 3035749 w 4449117"/>
              <a:gd name="connsiteY28" fmla="*/ 1879901 h 3581744"/>
              <a:gd name="connsiteX29" fmla="*/ 2464249 w 4449117"/>
              <a:gd name="connsiteY29" fmla="*/ 2032301 h 3581744"/>
              <a:gd name="connsiteX30" fmla="*/ 2451549 w 4449117"/>
              <a:gd name="connsiteY30" fmla="*/ 2527601 h 3581744"/>
              <a:gd name="connsiteX31" fmla="*/ 2883349 w 4449117"/>
              <a:gd name="connsiteY31" fmla="*/ 2781601 h 3581744"/>
              <a:gd name="connsiteX32" fmla="*/ 2426149 w 4449117"/>
              <a:gd name="connsiteY32" fmla="*/ 2641901 h 3581744"/>
              <a:gd name="connsiteX33" fmla="*/ 2972249 w 4449117"/>
              <a:gd name="connsiteY33" fmla="*/ 3124501 h 3581744"/>
              <a:gd name="connsiteX34" fmla="*/ 3086549 w 4449117"/>
              <a:gd name="connsiteY34" fmla="*/ 3581701 h 3581744"/>
              <a:gd name="connsiteX35" fmla="*/ 2870649 w 4449117"/>
              <a:gd name="connsiteY35" fmla="*/ 3099101 h 3581744"/>
              <a:gd name="connsiteX36" fmla="*/ 2476949 w 4449117"/>
              <a:gd name="connsiteY36" fmla="*/ 2819701 h 3581744"/>
              <a:gd name="connsiteX37" fmla="*/ 2349949 w 4449117"/>
              <a:gd name="connsiteY37" fmla="*/ 2730801 h 3581744"/>
              <a:gd name="connsiteX38" fmla="*/ 2324549 w 4449117"/>
              <a:gd name="connsiteY38" fmla="*/ 2413301 h 3581744"/>
              <a:gd name="connsiteX39" fmla="*/ 2210249 w 4449117"/>
              <a:gd name="connsiteY39" fmla="*/ 2311701 h 3581744"/>
              <a:gd name="connsiteX40" fmla="*/ 2057849 w 4449117"/>
              <a:gd name="connsiteY40" fmla="*/ 3111801 h 3581744"/>
              <a:gd name="connsiteX41" fmla="*/ 1727649 w 4449117"/>
              <a:gd name="connsiteY41" fmla="*/ 3238801 h 3581744"/>
              <a:gd name="connsiteX42" fmla="*/ 1956249 w 4449117"/>
              <a:gd name="connsiteY42" fmla="*/ 3073701 h 3581744"/>
              <a:gd name="connsiteX43" fmla="*/ 2095949 w 4449117"/>
              <a:gd name="connsiteY43" fmla="*/ 2680001 h 3581744"/>
              <a:gd name="connsiteX44" fmla="*/ 2032449 w 4449117"/>
              <a:gd name="connsiteY44" fmla="*/ 2337101 h 3581744"/>
              <a:gd name="connsiteX45" fmla="*/ 1943549 w 4449117"/>
              <a:gd name="connsiteY45" fmla="*/ 2832401 h 3581744"/>
              <a:gd name="connsiteX46" fmla="*/ 1905449 w 4449117"/>
              <a:gd name="connsiteY46" fmla="*/ 2426001 h 3581744"/>
              <a:gd name="connsiteX47" fmla="*/ 2121349 w 4449117"/>
              <a:gd name="connsiteY47" fmla="*/ 2197401 h 3581744"/>
              <a:gd name="connsiteX48" fmla="*/ 2311849 w 4449117"/>
              <a:gd name="connsiteY48" fmla="*/ 2045001 h 3581744"/>
              <a:gd name="connsiteX49" fmla="*/ 2248349 w 4449117"/>
              <a:gd name="connsiteY49" fmla="*/ 1664001 h 3581744"/>
              <a:gd name="connsiteX50" fmla="*/ 1841949 w 4449117"/>
              <a:gd name="connsiteY50" fmla="*/ 1778301 h 3581744"/>
              <a:gd name="connsiteX51" fmla="*/ 1702249 w 4449117"/>
              <a:gd name="connsiteY51" fmla="*/ 2032301 h 3581744"/>
              <a:gd name="connsiteX52" fmla="*/ 1346649 w 4449117"/>
              <a:gd name="connsiteY52" fmla="*/ 2527601 h 3581744"/>
              <a:gd name="connsiteX53" fmla="*/ 1511749 w 4449117"/>
              <a:gd name="connsiteY53" fmla="*/ 2172001 h 3581744"/>
              <a:gd name="connsiteX54" fmla="*/ 1664149 w 4449117"/>
              <a:gd name="connsiteY54" fmla="*/ 1918001 h 3581744"/>
              <a:gd name="connsiteX55" fmla="*/ 1308549 w 4449117"/>
              <a:gd name="connsiteY55" fmla="*/ 1943401 h 3581744"/>
              <a:gd name="connsiteX56" fmla="*/ 775149 w 4449117"/>
              <a:gd name="connsiteY56" fmla="*/ 2121201 h 3581744"/>
              <a:gd name="connsiteX57" fmla="*/ 406849 w 4449117"/>
              <a:gd name="connsiteY57" fmla="*/ 2591101 h 3581744"/>
              <a:gd name="connsiteX58" fmla="*/ 622749 w 4449117"/>
              <a:gd name="connsiteY58" fmla="*/ 2159301 h 3581744"/>
              <a:gd name="connsiteX59" fmla="*/ 444949 w 4449117"/>
              <a:gd name="connsiteY59" fmla="*/ 1752901 h 3581744"/>
              <a:gd name="connsiteX60" fmla="*/ 449 w 4449117"/>
              <a:gd name="connsiteY60" fmla="*/ 1537001 h 3581744"/>
              <a:gd name="connsiteX61" fmla="*/ 533849 w 4449117"/>
              <a:gd name="connsiteY61" fmla="*/ 1638601 h 3581744"/>
              <a:gd name="connsiteX62" fmla="*/ 775149 w 4449117"/>
              <a:gd name="connsiteY62" fmla="*/ 1905301 h 3581744"/>
              <a:gd name="connsiteX63" fmla="*/ 724349 w 4449117"/>
              <a:gd name="connsiteY63" fmla="*/ 1486201 h 3581744"/>
              <a:gd name="connsiteX64" fmla="*/ 559249 w 4449117"/>
              <a:gd name="connsiteY64" fmla="*/ 1194101 h 3581744"/>
              <a:gd name="connsiteX65" fmla="*/ 902149 w 4449117"/>
              <a:gd name="connsiteY65" fmla="*/ 1625901 h 3581744"/>
              <a:gd name="connsiteX66" fmla="*/ 1321249 w 4449117"/>
              <a:gd name="connsiteY66" fmla="*/ 1740201 h 3581744"/>
              <a:gd name="connsiteX67" fmla="*/ 1829249 w 4449117"/>
              <a:gd name="connsiteY67" fmla="*/ 1638601 h 3581744"/>
              <a:gd name="connsiteX68" fmla="*/ 2083249 w 4449117"/>
              <a:gd name="connsiteY68" fmla="*/ 1524301 h 3581744"/>
              <a:gd name="connsiteX69" fmla="*/ 2134049 w 4449117"/>
              <a:gd name="connsiteY69" fmla="*/ 1359201 h 3581744"/>
              <a:gd name="connsiteX70" fmla="*/ 1816549 w 4449117"/>
              <a:gd name="connsiteY70" fmla="*/ 775001 h 3581744"/>
              <a:gd name="connsiteX71" fmla="*/ 2273749 w 4449117"/>
              <a:gd name="connsiteY71" fmla="*/ 1194101 h 3581744"/>
              <a:gd name="connsiteX0" fmla="*/ 2273749 w 4449117"/>
              <a:gd name="connsiteY0" fmla="*/ 1194101 h 3581744"/>
              <a:gd name="connsiteX1" fmla="*/ 2515049 w 4449117"/>
              <a:gd name="connsiteY1" fmla="*/ 1410001 h 3581744"/>
              <a:gd name="connsiteX2" fmla="*/ 2870649 w 4449117"/>
              <a:gd name="connsiteY2" fmla="*/ 1410001 h 3581744"/>
              <a:gd name="connsiteX3" fmla="*/ 3010349 w 4449117"/>
              <a:gd name="connsiteY3" fmla="*/ 990901 h 3581744"/>
              <a:gd name="connsiteX4" fmla="*/ 2743649 w 4449117"/>
              <a:gd name="connsiteY4" fmla="*/ 406701 h 3581744"/>
              <a:gd name="connsiteX5" fmla="*/ 2946849 w 4449117"/>
              <a:gd name="connsiteY5" fmla="*/ 660701 h 3581744"/>
              <a:gd name="connsiteX6" fmla="*/ 3086549 w 4449117"/>
              <a:gd name="connsiteY6" fmla="*/ 965501 h 3581744"/>
              <a:gd name="connsiteX7" fmla="*/ 2984949 w 4449117"/>
              <a:gd name="connsiteY7" fmla="*/ 216201 h 3581744"/>
              <a:gd name="connsiteX8" fmla="*/ 3150049 w 4449117"/>
              <a:gd name="connsiteY8" fmla="*/ 301 h 3581744"/>
              <a:gd name="connsiteX9" fmla="*/ 3035749 w 4449117"/>
              <a:gd name="connsiteY9" fmla="*/ 178101 h 3581744"/>
              <a:gd name="connsiteX10" fmla="*/ 3086549 w 4449117"/>
              <a:gd name="connsiteY10" fmla="*/ 533701 h 3581744"/>
              <a:gd name="connsiteX11" fmla="*/ 3289749 w 4449117"/>
              <a:gd name="connsiteY11" fmla="*/ 228901 h 3581744"/>
              <a:gd name="connsiteX12" fmla="*/ 3162749 w 4449117"/>
              <a:gd name="connsiteY12" fmla="*/ 609901 h 3581744"/>
              <a:gd name="connsiteX13" fmla="*/ 3162749 w 4449117"/>
              <a:gd name="connsiteY13" fmla="*/ 876601 h 3581744"/>
              <a:gd name="connsiteX14" fmla="*/ 3099249 w 4449117"/>
              <a:gd name="connsiteY14" fmla="*/ 1206801 h 3581744"/>
              <a:gd name="connsiteX15" fmla="*/ 3048449 w 4449117"/>
              <a:gd name="connsiteY15" fmla="*/ 1384601 h 3581744"/>
              <a:gd name="connsiteX16" fmla="*/ 3048449 w 4449117"/>
              <a:gd name="connsiteY16" fmla="*/ 1676701 h 3581744"/>
              <a:gd name="connsiteX17" fmla="*/ 3048449 w 4449117"/>
              <a:gd name="connsiteY17" fmla="*/ 1803701 h 3581744"/>
              <a:gd name="connsiteX18" fmla="*/ 4013649 w 4449117"/>
              <a:gd name="connsiteY18" fmla="*/ 1981501 h 3581744"/>
              <a:gd name="connsiteX19" fmla="*/ 4445449 w 4449117"/>
              <a:gd name="connsiteY19" fmla="*/ 2070401 h 3581744"/>
              <a:gd name="connsiteX20" fmla="*/ 3797749 w 4449117"/>
              <a:gd name="connsiteY20" fmla="*/ 1994201 h 3581744"/>
              <a:gd name="connsiteX21" fmla="*/ 3505649 w 4449117"/>
              <a:gd name="connsiteY21" fmla="*/ 2006901 h 3581744"/>
              <a:gd name="connsiteX22" fmla="*/ 4039049 w 4449117"/>
              <a:gd name="connsiteY22" fmla="*/ 2362501 h 3581744"/>
              <a:gd name="connsiteX23" fmla="*/ 3531049 w 4449117"/>
              <a:gd name="connsiteY23" fmla="*/ 2121201 h 3581744"/>
              <a:gd name="connsiteX24" fmla="*/ 3823149 w 4449117"/>
              <a:gd name="connsiteY24" fmla="*/ 2629201 h 3581744"/>
              <a:gd name="connsiteX25" fmla="*/ 4242249 w 4449117"/>
              <a:gd name="connsiteY25" fmla="*/ 3149901 h 3581744"/>
              <a:gd name="connsiteX26" fmla="*/ 3785049 w 4449117"/>
              <a:gd name="connsiteY26" fmla="*/ 2692701 h 3581744"/>
              <a:gd name="connsiteX27" fmla="*/ 3454849 w 4449117"/>
              <a:gd name="connsiteY27" fmla="*/ 2172001 h 3581744"/>
              <a:gd name="connsiteX28" fmla="*/ 3035749 w 4449117"/>
              <a:gd name="connsiteY28" fmla="*/ 1879901 h 3581744"/>
              <a:gd name="connsiteX29" fmla="*/ 2464249 w 4449117"/>
              <a:gd name="connsiteY29" fmla="*/ 2032301 h 3581744"/>
              <a:gd name="connsiteX30" fmla="*/ 2451549 w 4449117"/>
              <a:gd name="connsiteY30" fmla="*/ 2527601 h 3581744"/>
              <a:gd name="connsiteX31" fmla="*/ 2883349 w 4449117"/>
              <a:gd name="connsiteY31" fmla="*/ 2781601 h 3581744"/>
              <a:gd name="connsiteX32" fmla="*/ 2426149 w 4449117"/>
              <a:gd name="connsiteY32" fmla="*/ 2641901 h 3581744"/>
              <a:gd name="connsiteX33" fmla="*/ 2972249 w 4449117"/>
              <a:gd name="connsiteY33" fmla="*/ 3124501 h 3581744"/>
              <a:gd name="connsiteX34" fmla="*/ 3086549 w 4449117"/>
              <a:gd name="connsiteY34" fmla="*/ 3581701 h 3581744"/>
              <a:gd name="connsiteX35" fmla="*/ 2870649 w 4449117"/>
              <a:gd name="connsiteY35" fmla="*/ 3099101 h 3581744"/>
              <a:gd name="connsiteX36" fmla="*/ 2476949 w 4449117"/>
              <a:gd name="connsiteY36" fmla="*/ 2819701 h 3581744"/>
              <a:gd name="connsiteX37" fmla="*/ 2349949 w 4449117"/>
              <a:gd name="connsiteY37" fmla="*/ 2730801 h 3581744"/>
              <a:gd name="connsiteX38" fmla="*/ 2324549 w 4449117"/>
              <a:gd name="connsiteY38" fmla="*/ 2413301 h 3581744"/>
              <a:gd name="connsiteX39" fmla="*/ 2210249 w 4449117"/>
              <a:gd name="connsiteY39" fmla="*/ 2311701 h 3581744"/>
              <a:gd name="connsiteX40" fmla="*/ 2057849 w 4449117"/>
              <a:gd name="connsiteY40" fmla="*/ 3111801 h 3581744"/>
              <a:gd name="connsiteX41" fmla="*/ 1727649 w 4449117"/>
              <a:gd name="connsiteY41" fmla="*/ 3238801 h 3581744"/>
              <a:gd name="connsiteX42" fmla="*/ 1956249 w 4449117"/>
              <a:gd name="connsiteY42" fmla="*/ 3073701 h 3581744"/>
              <a:gd name="connsiteX43" fmla="*/ 2095949 w 4449117"/>
              <a:gd name="connsiteY43" fmla="*/ 2680001 h 3581744"/>
              <a:gd name="connsiteX44" fmla="*/ 2032449 w 4449117"/>
              <a:gd name="connsiteY44" fmla="*/ 2337101 h 3581744"/>
              <a:gd name="connsiteX45" fmla="*/ 1943549 w 4449117"/>
              <a:gd name="connsiteY45" fmla="*/ 2832401 h 3581744"/>
              <a:gd name="connsiteX46" fmla="*/ 1905449 w 4449117"/>
              <a:gd name="connsiteY46" fmla="*/ 2426001 h 3581744"/>
              <a:gd name="connsiteX47" fmla="*/ 2121349 w 4449117"/>
              <a:gd name="connsiteY47" fmla="*/ 2197401 h 3581744"/>
              <a:gd name="connsiteX48" fmla="*/ 2311849 w 4449117"/>
              <a:gd name="connsiteY48" fmla="*/ 2045001 h 3581744"/>
              <a:gd name="connsiteX49" fmla="*/ 2248349 w 4449117"/>
              <a:gd name="connsiteY49" fmla="*/ 1664001 h 3581744"/>
              <a:gd name="connsiteX50" fmla="*/ 1841949 w 4449117"/>
              <a:gd name="connsiteY50" fmla="*/ 1778301 h 3581744"/>
              <a:gd name="connsiteX51" fmla="*/ 1702249 w 4449117"/>
              <a:gd name="connsiteY51" fmla="*/ 2032301 h 3581744"/>
              <a:gd name="connsiteX52" fmla="*/ 1346649 w 4449117"/>
              <a:gd name="connsiteY52" fmla="*/ 2527601 h 3581744"/>
              <a:gd name="connsiteX53" fmla="*/ 1511749 w 4449117"/>
              <a:gd name="connsiteY53" fmla="*/ 2172001 h 3581744"/>
              <a:gd name="connsiteX54" fmla="*/ 1664149 w 4449117"/>
              <a:gd name="connsiteY54" fmla="*/ 1918001 h 3581744"/>
              <a:gd name="connsiteX55" fmla="*/ 1308549 w 4449117"/>
              <a:gd name="connsiteY55" fmla="*/ 1943401 h 3581744"/>
              <a:gd name="connsiteX56" fmla="*/ 775149 w 4449117"/>
              <a:gd name="connsiteY56" fmla="*/ 2121201 h 3581744"/>
              <a:gd name="connsiteX57" fmla="*/ 406849 w 4449117"/>
              <a:gd name="connsiteY57" fmla="*/ 2591101 h 3581744"/>
              <a:gd name="connsiteX58" fmla="*/ 622749 w 4449117"/>
              <a:gd name="connsiteY58" fmla="*/ 2159301 h 3581744"/>
              <a:gd name="connsiteX59" fmla="*/ 444949 w 4449117"/>
              <a:gd name="connsiteY59" fmla="*/ 1752901 h 3581744"/>
              <a:gd name="connsiteX60" fmla="*/ 449 w 4449117"/>
              <a:gd name="connsiteY60" fmla="*/ 1537001 h 3581744"/>
              <a:gd name="connsiteX61" fmla="*/ 533849 w 4449117"/>
              <a:gd name="connsiteY61" fmla="*/ 1638601 h 3581744"/>
              <a:gd name="connsiteX62" fmla="*/ 980889 w 4449117"/>
              <a:gd name="connsiteY62" fmla="*/ 1821481 h 3581744"/>
              <a:gd name="connsiteX63" fmla="*/ 724349 w 4449117"/>
              <a:gd name="connsiteY63" fmla="*/ 1486201 h 3581744"/>
              <a:gd name="connsiteX64" fmla="*/ 559249 w 4449117"/>
              <a:gd name="connsiteY64" fmla="*/ 1194101 h 3581744"/>
              <a:gd name="connsiteX65" fmla="*/ 902149 w 4449117"/>
              <a:gd name="connsiteY65" fmla="*/ 1625901 h 3581744"/>
              <a:gd name="connsiteX66" fmla="*/ 1321249 w 4449117"/>
              <a:gd name="connsiteY66" fmla="*/ 1740201 h 3581744"/>
              <a:gd name="connsiteX67" fmla="*/ 1829249 w 4449117"/>
              <a:gd name="connsiteY67" fmla="*/ 1638601 h 3581744"/>
              <a:gd name="connsiteX68" fmla="*/ 2083249 w 4449117"/>
              <a:gd name="connsiteY68" fmla="*/ 1524301 h 3581744"/>
              <a:gd name="connsiteX69" fmla="*/ 2134049 w 4449117"/>
              <a:gd name="connsiteY69" fmla="*/ 1359201 h 3581744"/>
              <a:gd name="connsiteX70" fmla="*/ 1816549 w 4449117"/>
              <a:gd name="connsiteY70" fmla="*/ 775001 h 3581744"/>
              <a:gd name="connsiteX71" fmla="*/ 2273749 w 4449117"/>
              <a:gd name="connsiteY71" fmla="*/ 1194101 h 3581744"/>
              <a:gd name="connsiteX0" fmla="*/ 2274893 w 4450261"/>
              <a:gd name="connsiteY0" fmla="*/ 1194101 h 3581744"/>
              <a:gd name="connsiteX1" fmla="*/ 2516193 w 4450261"/>
              <a:gd name="connsiteY1" fmla="*/ 1410001 h 3581744"/>
              <a:gd name="connsiteX2" fmla="*/ 2871793 w 4450261"/>
              <a:gd name="connsiteY2" fmla="*/ 1410001 h 3581744"/>
              <a:gd name="connsiteX3" fmla="*/ 3011493 w 4450261"/>
              <a:gd name="connsiteY3" fmla="*/ 990901 h 3581744"/>
              <a:gd name="connsiteX4" fmla="*/ 2744793 w 4450261"/>
              <a:gd name="connsiteY4" fmla="*/ 406701 h 3581744"/>
              <a:gd name="connsiteX5" fmla="*/ 2947993 w 4450261"/>
              <a:gd name="connsiteY5" fmla="*/ 660701 h 3581744"/>
              <a:gd name="connsiteX6" fmla="*/ 3087693 w 4450261"/>
              <a:gd name="connsiteY6" fmla="*/ 965501 h 3581744"/>
              <a:gd name="connsiteX7" fmla="*/ 2986093 w 4450261"/>
              <a:gd name="connsiteY7" fmla="*/ 216201 h 3581744"/>
              <a:gd name="connsiteX8" fmla="*/ 3151193 w 4450261"/>
              <a:gd name="connsiteY8" fmla="*/ 301 h 3581744"/>
              <a:gd name="connsiteX9" fmla="*/ 3036893 w 4450261"/>
              <a:gd name="connsiteY9" fmla="*/ 178101 h 3581744"/>
              <a:gd name="connsiteX10" fmla="*/ 3087693 w 4450261"/>
              <a:gd name="connsiteY10" fmla="*/ 533701 h 3581744"/>
              <a:gd name="connsiteX11" fmla="*/ 3290893 w 4450261"/>
              <a:gd name="connsiteY11" fmla="*/ 228901 h 3581744"/>
              <a:gd name="connsiteX12" fmla="*/ 3163893 w 4450261"/>
              <a:gd name="connsiteY12" fmla="*/ 609901 h 3581744"/>
              <a:gd name="connsiteX13" fmla="*/ 3163893 w 4450261"/>
              <a:gd name="connsiteY13" fmla="*/ 876601 h 3581744"/>
              <a:gd name="connsiteX14" fmla="*/ 3100393 w 4450261"/>
              <a:gd name="connsiteY14" fmla="*/ 1206801 h 3581744"/>
              <a:gd name="connsiteX15" fmla="*/ 3049593 w 4450261"/>
              <a:gd name="connsiteY15" fmla="*/ 1384601 h 3581744"/>
              <a:gd name="connsiteX16" fmla="*/ 3049593 w 4450261"/>
              <a:gd name="connsiteY16" fmla="*/ 1676701 h 3581744"/>
              <a:gd name="connsiteX17" fmla="*/ 3049593 w 4450261"/>
              <a:gd name="connsiteY17" fmla="*/ 1803701 h 3581744"/>
              <a:gd name="connsiteX18" fmla="*/ 4014793 w 4450261"/>
              <a:gd name="connsiteY18" fmla="*/ 1981501 h 3581744"/>
              <a:gd name="connsiteX19" fmla="*/ 4446593 w 4450261"/>
              <a:gd name="connsiteY19" fmla="*/ 2070401 h 3581744"/>
              <a:gd name="connsiteX20" fmla="*/ 3798893 w 4450261"/>
              <a:gd name="connsiteY20" fmla="*/ 1994201 h 3581744"/>
              <a:gd name="connsiteX21" fmla="*/ 3506793 w 4450261"/>
              <a:gd name="connsiteY21" fmla="*/ 2006901 h 3581744"/>
              <a:gd name="connsiteX22" fmla="*/ 4040193 w 4450261"/>
              <a:gd name="connsiteY22" fmla="*/ 2362501 h 3581744"/>
              <a:gd name="connsiteX23" fmla="*/ 3532193 w 4450261"/>
              <a:gd name="connsiteY23" fmla="*/ 2121201 h 3581744"/>
              <a:gd name="connsiteX24" fmla="*/ 3824293 w 4450261"/>
              <a:gd name="connsiteY24" fmla="*/ 2629201 h 3581744"/>
              <a:gd name="connsiteX25" fmla="*/ 4243393 w 4450261"/>
              <a:gd name="connsiteY25" fmla="*/ 3149901 h 3581744"/>
              <a:gd name="connsiteX26" fmla="*/ 3786193 w 4450261"/>
              <a:gd name="connsiteY26" fmla="*/ 2692701 h 3581744"/>
              <a:gd name="connsiteX27" fmla="*/ 3455993 w 4450261"/>
              <a:gd name="connsiteY27" fmla="*/ 2172001 h 3581744"/>
              <a:gd name="connsiteX28" fmla="*/ 3036893 w 4450261"/>
              <a:gd name="connsiteY28" fmla="*/ 1879901 h 3581744"/>
              <a:gd name="connsiteX29" fmla="*/ 2465393 w 4450261"/>
              <a:gd name="connsiteY29" fmla="*/ 2032301 h 3581744"/>
              <a:gd name="connsiteX30" fmla="*/ 2452693 w 4450261"/>
              <a:gd name="connsiteY30" fmla="*/ 2527601 h 3581744"/>
              <a:gd name="connsiteX31" fmla="*/ 2884493 w 4450261"/>
              <a:gd name="connsiteY31" fmla="*/ 2781601 h 3581744"/>
              <a:gd name="connsiteX32" fmla="*/ 2427293 w 4450261"/>
              <a:gd name="connsiteY32" fmla="*/ 2641901 h 3581744"/>
              <a:gd name="connsiteX33" fmla="*/ 2973393 w 4450261"/>
              <a:gd name="connsiteY33" fmla="*/ 3124501 h 3581744"/>
              <a:gd name="connsiteX34" fmla="*/ 3087693 w 4450261"/>
              <a:gd name="connsiteY34" fmla="*/ 3581701 h 3581744"/>
              <a:gd name="connsiteX35" fmla="*/ 2871793 w 4450261"/>
              <a:gd name="connsiteY35" fmla="*/ 3099101 h 3581744"/>
              <a:gd name="connsiteX36" fmla="*/ 2478093 w 4450261"/>
              <a:gd name="connsiteY36" fmla="*/ 2819701 h 3581744"/>
              <a:gd name="connsiteX37" fmla="*/ 2351093 w 4450261"/>
              <a:gd name="connsiteY37" fmla="*/ 2730801 h 3581744"/>
              <a:gd name="connsiteX38" fmla="*/ 2325693 w 4450261"/>
              <a:gd name="connsiteY38" fmla="*/ 2413301 h 3581744"/>
              <a:gd name="connsiteX39" fmla="*/ 2211393 w 4450261"/>
              <a:gd name="connsiteY39" fmla="*/ 2311701 h 3581744"/>
              <a:gd name="connsiteX40" fmla="*/ 2058993 w 4450261"/>
              <a:gd name="connsiteY40" fmla="*/ 3111801 h 3581744"/>
              <a:gd name="connsiteX41" fmla="*/ 1728793 w 4450261"/>
              <a:gd name="connsiteY41" fmla="*/ 3238801 h 3581744"/>
              <a:gd name="connsiteX42" fmla="*/ 1957393 w 4450261"/>
              <a:gd name="connsiteY42" fmla="*/ 3073701 h 3581744"/>
              <a:gd name="connsiteX43" fmla="*/ 2097093 w 4450261"/>
              <a:gd name="connsiteY43" fmla="*/ 2680001 h 3581744"/>
              <a:gd name="connsiteX44" fmla="*/ 2033593 w 4450261"/>
              <a:gd name="connsiteY44" fmla="*/ 2337101 h 3581744"/>
              <a:gd name="connsiteX45" fmla="*/ 1944693 w 4450261"/>
              <a:gd name="connsiteY45" fmla="*/ 2832401 h 3581744"/>
              <a:gd name="connsiteX46" fmla="*/ 1906593 w 4450261"/>
              <a:gd name="connsiteY46" fmla="*/ 2426001 h 3581744"/>
              <a:gd name="connsiteX47" fmla="*/ 2122493 w 4450261"/>
              <a:gd name="connsiteY47" fmla="*/ 2197401 h 3581744"/>
              <a:gd name="connsiteX48" fmla="*/ 2312993 w 4450261"/>
              <a:gd name="connsiteY48" fmla="*/ 2045001 h 3581744"/>
              <a:gd name="connsiteX49" fmla="*/ 2249493 w 4450261"/>
              <a:gd name="connsiteY49" fmla="*/ 1664001 h 3581744"/>
              <a:gd name="connsiteX50" fmla="*/ 1843093 w 4450261"/>
              <a:gd name="connsiteY50" fmla="*/ 1778301 h 3581744"/>
              <a:gd name="connsiteX51" fmla="*/ 1703393 w 4450261"/>
              <a:gd name="connsiteY51" fmla="*/ 2032301 h 3581744"/>
              <a:gd name="connsiteX52" fmla="*/ 1347793 w 4450261"/>
              <a:gd name="connsiteY52" fmla="*/ 2527601 h 3581744"/>
              <a:gd name="connsiteX53" fmla="*/ 1512893 w 4450261"/>
              <a:gd name="connsiteY53" fmla="*/ 2172001 h 3581744"/>
              <a:gd name="connsiteX54" fmla="*/ 1665293 w 4450261"/>
              <a:gd name="connsiteY54" fmla="*/ 1918001 h 3581744"/>
              <a:gd name="connsiteX55" fmla="*/ 1309693 w 4450261"/>
              <a:gd name="connsiteY55" fmla="*/ 1943401 h 3581744"/>
              <a:gd name="connsiteX56" fmla="*/ 776293 w 4450261"/>
              <a:gd name="connsiteY56" fmla="*/ 2121201 h 3581744"/>
              <a:gd name="connsiteX57" fmla="*/ 407993 w 4450261"/>
              <a:gd name="connsiteY57" fmla="*/ 2591101 h 3581744"/>
              <a:gd name="connsiteX58" fmla="*/ 623893 w 4450261"/>
              <a:gd name="connsiteY58" fmla="*/ 2159301 h 3581744"/>
              <a:gd name="connsiteX59" fmla="*/ 446093 w 4450261"/>
              <a:gd name="connsiteY59" fmla="*/ 1752901 h 3581744"/>
              <a:gd name="connsiteX60" fmla="*/ 1593 w 4450261"/>
              <a:gd name="connsiteY60" fmla="*/ 1537001 h 3581744"/>
              <a:gd name="connsiteX61" fmla="*/ 618813 w 4450261"/>
              <a:gd name="connsiteY61" fmla="*/ 1775761 h 3581744"/>
              <a:gd name="connsiteX62" fmla="*/ 982033 w 4450261"/>
              <a:gd name="connsiteY62" fmla="*/ 1821481 h 3581744"/>
              <a:gd name="connsiteX63" fmla="*/ 725493 w 4450261"/>
              <a:gd name="connsiteY63" fmla="*/ 1486201 h 3581744"/>
              <a:gd name="connsiteX64" fmla="*/ 560393 w 4450261"/>
              <a:gd name="connsiteY64" fmla="*/ 1194101 h 3581744"/>
              <a:gd name="connsiteX65" fmla="*/ 903293 w 4450261"/>
              <a:gd name="connsiteY65" fmla="*/ 1625901 h 3581744"/>
              <a:gd name="connsiteX66" fmla="*/ 1322393 w 4450261"/>
              <a:gd name="connsiteY66" fmla="*/ 1740201 h 3581744"/>
              <a:gd name="connsiteX67" fmla="*/ 1830393 w 4450261"/>
              <a:gd name="connsiteY67" fmla="*/ 1638601 h 3581744"/>
              <a:gd name="connsiteX68" fmla="*/ 2084393 w 4450261"/>
              <a:gd name="connsiteY68" fmla="*/ 1524301 h 3581744"/>
              <a:gd name="connsiteX69" fmla="*/ 2135193 w 4450261"/>
              <a:gd name="connsiteY69" fmla="*/ 1359201 h 3581744"/>
              <a:gd name="connsiteX70" fmla="*/ 1817693 w 4450261"/>
              <a:gd name="connsiteY70" fmla="*/ 775001 h 3581744"/>
              <a:gd name="connsiteX71" fmla="*/ 2274893 w 4450261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1330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32325 w 4448993"/>
              <a:gd name="connsiteY44" fmla="*/ 2337101 h 3581744"/>
              <a:gd name="connsiteX45" fmla="*/ 1943425 w 4448993"/>
              <a:gd name="connsiteY45" fmla="*/ 2832401 h 3581744"/>
              <a:gd name="connsiteX46" fmla="*/ 1905325 w 4448993"/>
              <a:gd name="connsiteY46" fmla="*/ 242600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702125 w 4448993"/>
              <a:gd name="connsiteY51" fmla="*/ 203230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664025 w 4448993"/>
              <a:gd name="connsiteY54" fmla="*/ 1918001 h 3581744"/>
              <a:gd name="connsiteX55" fmla="*/ 1308425 w 4448993"/>
              <a:gd name="connsiteY55" fmla="*/ 19434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083125 w 4448993"/>
              <a:gd name="connsiteY68" fmla="*/ 1524301 h 3581744"/>
              <a:gd name="connsiteX69" fmla="*/ 2133925 w 4448993"/>
              <a:gd name="connsiteY69" fmla="*/ 13592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1330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32325 w 4448993"/>
              <a:gd name="connsiteY44" fmla="*/ 2337101 h 3581744"/>
              <a:gd name="connsiteX45" fmla="*/ 1943425 w 4448993"/>
              <a:gd name="connsiteY45" fmla="*/ 2832401 h 3581744"/>
              <a:gd name="connsiteX46" fmla="*/ 1905325 w 4448993"/>
              <a:gd name="connsiteY46" fmla="*/ 242600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702125 w 4448993"/>
              <a:gd name="connsiteY51" fmla="*/ 203230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664025 w 4448993"/>
              <a:gd name="connsiteY54" fmla="*/ 1918001 h 3581744"/>
              <a:gd name="connsiteX55" fmla="*/ 1308425 w 4448993"/>
              <a:gd name="connsiteY55" fmla="*/ 19434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083125 w 4448993"/>
              <a:gd name="connsiteY68" fmla="*/ 1524301 h 3581744"/>
              <a:gd name="connsiteX69" fmla="*/ 2133925 w 4448993"/>
              <a:gd name="connsiteY69" fmla="*/ 13592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1330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32325 w 4448993"/>
              <a:gd name="connsiteY44" fmla="*/ 2337101 h 3581744"/>
              <a:gd name="connsiteX45" fmla="*/ 1943425 w 4448993"/>
              <a:gd name="connsiteY45" fmla="*/ 2832401 h 3581744"/>
              <a:gd name="connsiteX46" fmla="*/ 1905325 w 4448993"/>
              <a:gd name="connsiteY46" fmla="*/ 242600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702125 w 4448993"/>
              <a:gd name="connsiteY51" fmla="*/ 203230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664025 w 4448993"/>
              <a:gd name="connsiteY54" fmla="*/ 191800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083125 w 4448993"/>
              <a:gd name="connsiteY68" fmla="*/ 1524301 h 3581744"/>
              <a:gd name="connsiteX69" fmla="*/ 2133925 w 4448993"/>
              <a:gd name="connsiteY69" fmla="*/ 13592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1330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32325 w 4448993"/>
              <a:gd name="connsiteY44" fmla="*/ 2337101 h 3581744"/>
              <a:gd name="connsiteX45" fmla="*/ 1943425 w 4448993"/>
              <a:gd name="connsiteY45" fmla="*/ 2832401 h 3581744"/>
              <a:gd name="connsiteX46" fmla="*/ 1905325 w 4448993"/>
              <a:gd name="connsiteY46" fmla="*/ 242600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702125 w 4448993"/>
              <a:gd name="connsiteY51" fmla="*/ 203230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083125 w 4448993"/>
              <a:gd name="connsiteY68" fmla="*/ 1524301 h 3581744"/>
              <a:gd name="connsiteX69" fmla="*/ 2133925 w 4448993"/>
              <a:gd name="connsiteY69" fmla="*/ 13592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1330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32325 w 4448993"/>
              <a:gd name="connsiteY44" fmla="*/ 2337101 h 3581744"/>
              <a:gd name="connsiteX45" fmla="*/ 1943425 w 4448993"/>
              <a:gd name="connsiteY45" fmla="*/ 2832401 h 3581744"/>
              <a:gd name="connsiteX46" fmla="*/ 1905325 w 4448993"/>
              <a:gd name="connsiteY46" fmla="*/ 242600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679265 w 4448993"/>
              <a:gd name="connsiteY51" fmla="*/ 202468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083125 w 4448993"/>
              <a:gd name="connsiteY68" fmla="*/ 1524301 h 3581744"/>
              <a:gd name="connsiteX69" fmla="*/ 2133925 w 4448993"/>
              <a:gd name="connsiteY69" fmla="*/ 13592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1330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32325 w 4448993"/>
              <a:gd name="connsiteY44" fmla="*/ 2337101 h 3581744"/>
              <a:gd name="connsiteX45" fmla="*/ 1943425 w 4448993"/>
              <a:gd name="connsiteY45" fmla="*/ 2832401 h 3581744"/>
              <a:gd name="connsiteX46" fmla="*/ 1905325 w 4448993"/>
              <a:gd name="connsiteY46" fmla="*/ 242600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679265 w 4448993"/>
              <a:gd name="connsiteY51" fmla="*/ 202468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083125 w 4448993"/>
              <a:gd name="connsiteY68" fmla="*/ 1524301 h 3581744"/>
              <a:gd name="connsiteX69" fmla="*/ 2232985 w 4448993"/>
              <a:gd name="connsiteY69" fmla="*/ 13973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1330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32325 w 4448993"/>
              <a:gd name="connsiteY44" fmla="*/ 2337101 h 3581744"/>
              <a:gd name="connsiteX45" fmla="*/ 1943425 w 4448993"/>
              <a:gd name="connsiteY45" fmla="*/ 2832401 h 3581744"/>
              <a:gd name="connsiteX46" fmla="*/ 1905325 w 4448993"/>
              <a:gd name="connsiteY46" fmla="*/ 242600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679265 w 4448993"/>
              <a:gd name="connsiteY51" fmla="*/ 202468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105985 w 4448993"/>
              <a:gd name="connsiteY68" fmla="*/ 1562401 h 3581744"/>
              <a:gd name="connsiteX69" fmla="*/ 2232985 w 4448993"/>
              <a:gd name="connsiteY69" fmla="*/ 13973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1330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85665 w 4448993"/>
              <a:gd name="connsiteY44" fmla="*/ 2352341 h 3581744"/>
              <a:gd name="connsiteX45" fmla="*/ 1943425 w 4448993"/>
              <a:gd name="connsiteY45" fmla="*/ 2832401 h 3581744"/>
              <a:gd name="connsiteX46" fmla="*/ 1905325 w 4448993"/>
              <a:gd name="connsiteY46" fmla="*/ 242600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679265 w 4448993"/>
              <a:gd name="connsiteY51" fmla="*/ 202468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105985 w 4448993"/>
              <a:gd name="connsiteY68" fmla="*/ 1562401 h 3581744"/>
              <a:gd name="connsiteX69" fmla="*/ 2232985 w 4448993"/>
              <a:gd name="connsiteY69" fmla="*/ 13973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1330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85665 w 4448993"/>
              <a:gd name="connsiteY44" fmla="*/ 2352341 h 3581744"/>
              <a:gd name="connsiteX45" fmla="*/ 1943425 w 4448993"/>
              <a:gd name="connsiteY45" fmla="*/ 2832401 h 3581744"/>
              <a:gd name="connsiteX46" fmla="*/ 1943425 w 4448993"/>
              <a:gd name="connsiteY46" fmla="*/ 254792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679265 w 4448993"/>
              <a:gd name="connsiteY51" fmla="*/ 202468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105985 w 4448993"/>
              <a:gd name="connsiteY68" fmla="*/ 1562401 h 3581744"/>
              <a:gd name="connsiteX69" fmla="*/ 2232985 w 4448993"/>
              <a:gd name="connsiteY69" fmla="*/ 13973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349825 w 4448993"/>
              <a:gd name="connsiteY37" fmla="*/ 2730801 h 3581744"/>
              <a:gd name="connsiteX38" fmla="*/ 2324425 w 4448993"/>
              <a:gd name="connsiteY38" fmla="*/ 246664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85665 w 4448993"/>
              <a:gd name="connsiteY44" fmla="*/ 2352341 h 3581744"/>
              <a:gd name="connsiteX45" fmla="*/ 1943425 w 4448993"/>
              <a:gd name="connsiteY45" fmla="*/ 2832401 h 3581744"/>
              <a:gd name="connsiteX46" fmla="*/ 1943425 w 4448993"/>
              <a:gd name="connsiteY46" fmla="*/ 254792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679265 w 4448993"/>
              <a:gd name="connsiteY51" fmla="*/ 202468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105985 w 4448993"/>
              <a:gd name="connsiteY68" fmla="*/ 1562401 h 3581744"/>
              <a:gd name="connsiteX69" fmla="*/ 2232985 w 4448993"/>
              <a:gd name="connsiteY69" fmla="*/ 13973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476825 w 4448993"/>
              <a:gd name="connsiteY36" fmla="*/ 2819701 h 3581744"/>
              <a:gd name="connsiteX37" fmla="*/ 2410785 w 4448993"/>
              <a:gd name="connsiteY37" fmla="*/ 2738421 h 3581744"/>
              <a:gd name="connsiteX38" fmla="*/ 2324425 w 4448993"/>
              <a:gd name="connsiteY38" fmla="*/ 246664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85665 w 4448993"/>
              <a:gd name="connsiteY44" fmla="*/ 2352341 h 3581744"/>
              <a:gd name="connsiteX45" fmla="*/ 1943425 w 4448993"/>
              <a:gd name="connsiteY45" fmla="*/ 2832401 h 3581744"/>
              <a:gd name="connsiteX46" fmla="*/ 1943425 w 4448993"/>
              <a:gd name="connsiteY46" fmla="*/ 254792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679265 w 4448993"/>
              <a:gd name="connsiteY51" fmla="*/ 202468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105985 w 4448993"/>
              <a:gd name="connsiteY68" fmla="*/ 1562401 h 3581744"/>
              <a:gd name="connsiteX69" fmla="*/ 2232985 w 4448993"/>
              <a:gd name="connsiteY69" fmla="*/ 13973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048325 w 4448993"/>
              <a:gd name="connsiteY16" fmla="*/ 167670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507305 w 4448993"/>
              <a:gd name="connsiteY36" fmla="*/ 2812081 h 3581744"/>
              <a:gd name="connsiteX37" fmla="*/ 2410785 w 4448993"/>
              <a:gd name="connsiteY37" fmla="*/ 2738421 h 3581744"/>
              <a:gd name="connsiteX38" fmla="*/ 2324425 w 4448993"/>
              <a:gd name="connsiteY38" fmla="*/ 246664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85665 w 4448993"/>
              <a:gd name="connsiteY44" fmla="*/ 2352341 h 3581744"/>
              <a:gd name="connsiteX45" fmla="*/ 1943425 w 4448993"/>
              <a:gd name="connsiteY45" fmla="*/ 2832401 h 3581744"/>
              <a:gd name="connsiteX46" fmla="*/ 1943425 w 4448993"/>
              <a:gd name="connsiteY46" fmla="*/ 254792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679265 w 4448993"/>
              <a:gd name="connsiteY51" fmla="*/ 202468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105985 w 4448993"/>
              <a:gd name="connsiteY68" fmla="*/ 1562401 h 3581744"/>
              <a:gd name="connsiteX69" fmla="*/ 2232985 w 4448993"/>
              <a:gd name="connsiteY69" fmla="*/ 13973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993"/>
              <a:gd name="connsiteY0" fmla="*/ 1194101 h 3581744"/>
              <a:gd name="connsiteX1" fmla="*/ 2514925 w 4448993"/>
              <a:gd name="connsiteY1" fmla="*/ 1410001 h 3581744"/>
              <a:gd name="connsiteX2" fmla="*/ 2870525 w 4448993"/>
              <a:gd name="connsiteY2" fmla="*/ 1410001 h 3581744"/>
              <a:gd name="connsiteX3" fmla="*/ 3010225 w 4448993"/>
              <a:gd name="connsiteY3" fmla="*/ 990901 h 3581744"/>
              <a:gd name="connsiteX4" fmla="*/ 2743525 w 4448993"/>
              <a:gd name="connsiteY4" fmla="*/ 406701 h 3581744"/>
              <a:gd name="connsiteX5" fmla="*/ 2946725 w 4448993"/>
              <a:gd name="connsiteY5" fmla="*/ 660701 h 3581744"/>
              <a:gd name="connsiteX6" fmla="*/ 3086425 w 4448993"/>
              <a:gd name="connsiteY6" fmla="*/ 965501 h 3581744"/>
              <a:gd name="connsiteX7" fmla="*/ 2984825 w 4448993"/>
              <a:gd name="connsiteY7" fmla="*/ 216201 h 3581744"/>
              <a:gd name="connsiteX8" fmla="*/ 3149925 w 4448993"/>
              <a:gd name="connsiteY8" fmla="*/ 301 h 3581744"/>
              <a:gd name="connsiteX9" fmla="*/ 3035625 w 4448993"/>
              <a:gd name="connsiteY9" fmla="*/ 178101 h 3581744"/>
              <a:gd name="connsiteX10" fmla="*/ 3086425 w 4448993"/>
              <a:gd name="connsiteY10" fmla="*/ 533701 h 3581744"/>
              <a:gd name="connsiteX11" fmla="*/ 3289625 w 4448993"/>
              <a:gd name="connsiteY11" fmla="*/ 228901 h 3581744"/>
              <a:gd name="connsiteX12" fmla="*/ 3162625 w 4448993"/>
              <a:gd name="connsiteY12" fmla="*/ 609901 h 3581744"/>
              <a:gd name="connsiteX13" fmla="*/ 3162625 w 4448993"/>
              <a:gd name="connsiteY13" fmla="*/ 876601 h 3581744"/>
              <a:gd name="connsiteX14" fmla="*/ 3099125 w 4448993"/>
              <a:gd name="connsiteY14" fmla="*/ 1206801 h 3581744"/>
              <a:gd name="connsiteX15" fmla="*/ 3048325 w 4448993"/>
              <a:gd name="connsiteY15" fmla="*/ 1384601 h 3581744"/>
              <a:gd name="connsiteX16" fmla="*/ 3101665 w 4448993"/>
              <a:gd name="connsiteY16" fmla="*/ 1585261 h 3581744"/>
              <a:gd name="connsiteX17" fmla="*/ 3048325 w 4448993"/>
              <a:gd name="connsiteY17" fmla="*/ 1803701 h 3581744"/>
              <a:gd name="connsiteX18" fmla="*/ 4013525 w 4448993"/>
              <a:gd name="connsiteY18" fmla="*/ 1981501 h 3581744"/>
              <a:gd name="connsiteX19" fmla="*/ 4445325 w 4448993"/>
              <a:gd name="connsiteY19" fmla="*/ 2070401 h 3581744"/>
              <a:gd name="connsiteX20" fmla="*/ 3797625 w 4448993"/>
              <a:gd name="connsiteY20" fmla="*/ 1994201 h 3581744"/>
              <a:gd name="connsiteX21" fmla="*/ 3505525 w 4448993"/>
              <a:gd name="connsiteY21" fmla="*/ 2006901 h 3581744"/>
              <a:gd name="connsiteX22" fmla="*/ 4038925 w 4448993"/>
              <a:gd name="connsiteY22" fmla="*/ 2362501 h 3581744"/>
              <a:gd name="connsiteX23" fmla="*/ 3530925 w 4448993"/>
              <a:gd name="connsiteY23" fmla="*/ 2121201 h 3581744"/>
              <a:gd name="connsiteX24" fmla="*/ 3823025 w 4448993"/>
              <a:gd name="connsiteY24" fmla="*/ 2629201 h 3581744"/>
              <a:gd name="connsiteX25" fmla="*/ 4242125 w 4448993"/>
              <a:gd name="connsiteY25" fmla="*/ 3149901 h 3581744"/>
              <a:gd name="connsiteX26" fmla="*/ 3784925 w 4448993"/>
              <a:gd name="connsiteY26" fmla="*/ 2692701 h 3581744"/>
              <a:gd name="connsiteX27" fmla="*/ 3454725 w 4448993"/>
              <a:gd name="connsiteY27" fmla="*/ 2172001 h 3581744"/>
              <a:gd name="connsiteX28" fmla="*/ 3035625 w 4448993"/>
              <a:gd name="connsiteY28" fmla="*/ 1879901 h 3581744"/>
              <a:gd name="connsiteX29" fmla="*/ 2464125 w 4448993"/>
              <a:gd name="connsiteY29" fmla="*/ 2032301 h 3581744"/>
              <a:gd name="connsiteX30" fmla="*/ 2451425 w 4448993"/>
              <a:gd name="connsiteY30" fmla="*/ 2527601 h 3581744"/>
              <a:gd name="connsiteX31" fmla="*/ 2883225 w 4448993"/>
              <a:gd name="connsiteY31" fmla="*/ 2781601 h 3581744"/>
              <a:gd name="connsiteX32" fmla="*/ 2426025 w 4448993"/>
              <a:gd name="connsiteY32" fmla="*/ 2641901 h 3581744"/>
              <a:gd name="connsiteX33" fmla="*/ 2972125 w 4448993"/>
              <a:gd name="connsiteY33" fmla="*/ 3124501 h 3581744"/>
              <a:gd name="connsiteX34" fmla="*/ 3086425 w 4448993"/>
              <a:gd name="connsiteY34" fmla="*/ 3581701 h 3581744"/>
              <a:gd name="connsiteX35" fmla="*/ 2870525 w 4448993"/>
              <a:gd name="connsiteY35" fmla="*/ 3099101 h 3581744"/>
              <a:gd name="connsiteX36" fmla="*/ 2507305 w 4448993"/>
              <a:gd name="connsiteY36" fmla="*/ 2812081 h 3581744"/>
              <a:gd name="connsiteX37" fmla="*/ 2410785 w 4448993"/>
              <a:gd name="connsiteY37" fmla="*/ 2738421 h 3581744"/>
              <a:gd name="connsiteX38" fmla="*/ 2324425 w 4448993"/>
              <a:gd name="connsiteY38" fmla="*/ 2466641 h 3581744"/>
              <a:gd name="connsiteX39" fmla="*/ 2210125 w 4448993"/>
              <a:gd name="connsiteY39" fmla="*/ 2311701 h 3581744"/>
              <a:gd name="connsiteX40" fmla="*/ 2057725 w 4448993"/>
              <a:gd name="connsiteY40" fmla="*/ 3111801 h 3581744"/>
              <a:gd name="connsiteX41" fmla="*/ 1727525 w 4448993"/>
              <a:gd name="connsiteY41" fmla="*/ 3238801 h 3581744"/>
              <a:gd name="connsiteX42" fmla="*/ 1956125 w 4448993"/>
              <a:gd name="connsiteY42" fmla="*/ 3073701 h 3581744"/>
              <a:gd name="connsiteX43" fmla="*/ 2095825 w 4448993"/>
              <a:gd name="connsiteY43" fmla="*/ 2680001 h 3581744"/>
              <a:gd name="connsiteX44" fmla="*/ 2085665 w 4448993"/>
              <a:gd name="connsiteY44" fmla="*/ 2352341 h 3581744"/>
              <a:gd name="connsiteX45" fmla="*/ 1943425 w 4448993"/>
              <a:gd name="connsiteY45" fmla="*/ 2832401 h 3581744"/>
              <a:gd name="connsiteX46" fmla="*/ 1943425 w 4448993"/>
              <a:gd name="connsiteY46" fmla="*/ 2547921 h 3581744"/>
              <a:gd name="connsiteX47" fmla="*/ 2121225 w 4448993"/>
              <a:gd name="connsiteY47" fmla="*/ 2197401 h 3581744"/>
              <a:gd name="connsiteX48" fmla="*/ 2311725 w 4448993"/>
              <a:gd name="connsiteY48" fmla="*/ 2045001 h 3581744"/>
              <a:gd name="connsiteX49" fmla="*/ 2248225 w 4448993"/>
              <a:gd name="connsiteY49" fmla="*/ 1664001 h 3581744"/>
              <a:gd name="connsiteX50" fmla="*/ 1841825 w 4448993"/>
              <a:gd name="connsiteY50" fmla="*/ 1778301 h 3581744"/>
              <a:gd name="connsiteX51" fmla="*/ 1679265 w 4448993"/>
              <a:gd name="connsiteY51" fmla="*/ 2024681 h 3581744"/>
              <a:gd name="connsiteX52" fmla="*/ 1346525 w 4448993"/>
              <a:gd name="connsiteY52" fmla="*/ 2527601 h 3581744"/>
              <a:gd name="connsiteX53" fmla="*/ 1511625 w 4448993"/>
              <a:gd name="connsiteY53" fmla="*/ 2172001 h 3581744"/>
              <a:gd name="connsiteX54" fmla="*/ 1709745 w 4448993"/>
              <a:gd name="connsiteY54" fmla="*/ 1796081 h 3581744"/>
              <a:gd name="connsiteX55" fmla="*/ 1308425 w 4448993"/>
              <a:gd name="connsiteY55" fmla="*/ 1829101 h 3581744"/>
              <a:gd name="connsiteX56" fmla="*/ 775025 w 4448993"/>
              <a:gd name="connsiteY56" fmla="*/ 2121201 h 3581744"/>
              <a:gd name="connsiteX57" fmla="*/ 406725 w 4448993"/>
              <a:gd name="connsiteY57" fmla="*/ 2591101 h 3581744"/>
              <a:gd name="connsiteX58" fmla="*/ 622625 w 4448993"/>
              <a:gd name="connsiteY58" fmla="*/ 2159301 h 3581744"/>
              <a:gd name="connsiteX59" fmla="*/ 703905 w 4448993"/>
              <a:gd name="connsiteY59" fmla="*/ 1890061 h 3581744"/>
              <a:gd name="connsiteX60" fmla="*/ 325 w 4448993"/>
              <a:gd name="connsiteY60" fmla="*/ 1537001 h 3581744"/>
              <a:gd name="connsiteX61" fmla="*/ 617545 w 4448993"/>
              <a:gd name="connsiteY61" fmla="*/ 1775761 h 3581744"/>
              <a:gd name="connsiteX62" fmla="*/ 980765 w 4448993"/>
              <a:gd name="connsiteY62" fmla="*/ 1821481 h 3581744"/>
              <a:gd name="connsiteX63" fmla="*/ 724225 w 4448993"/>
              <a:gd name="connsiteY63" fmla="*/ 1486201 h 3581744"/>
              <a:gd name="connsiteX64" fmla="*/ 559125 w 4448993"/>
              <a:gd name="connsiteY64" fmla="*/ 1194101 h 3581744"/>
              <a:gd name="connsiteX65" fmla="*/ 902025 w 4448993"/>
              <a:gd name="connsiteY65" fmla="*/ 1625901 h 3581744"/>
              <a:gd name="connsiteX66" fmla="*/ 1321125 w 4448993"/>
              <a:gd name="connsiteY66" fmla="*/ 1740201 h 3581744"/>
              <a:gd name="connsiteX67" fmla="*/ 1829125 w 4448993"/>
              <a:gd name="connsiteY67" fmla="*/ 1638601 h 3581744"/>
              <a:gd name="connsiteX68" fmla="*/ 2105985 w 4448993"/>
              <a:gd name="connsiteY68" fmla="*/ 1562401 h 3581744"/>
              <a:gd name="connsiteX69" fmla="*/ 2232985 w 4448993"/>
              <a:gd name="connsiteY69" fmla="*/ 1397301 h 3581744"/>
              <a:gd name="connsiteX70" fmla="*/ 1816425 w 4448993"/>
              <a:gd name="connsiteY70" fmla="*/ 775001 h 3581744"/>
              <a:gd name="connsiteX71" fmla="*/ 2273625 w 4448993"/>
              <a:gd name="connsiteY71" fmla="*/ 1194101 h 3581744"/>
              <a:gd name="connsiteX0" fmla="*/ 2273625 w 4448757"/>
              <a:gd name="connsiteY0" fmla="*/ 1194101 h 3581744"/>
              <a:gd name="connsiteX1" fmla="*/ 2514925 w 4448757"/>
              <a:gd name="connsiteY1" fmla="*/ 1410001 h 3581744"/>
              <a:gd name="connsiteX2" fmla="*/ 2870525 w 4448757"/>
              <a:gd name="connsiteY2" fmla="*/ 1410001 h 3581744"/>
              <a:gd name="connsiteX3" fmla="*/ 3010225 w 4448757"/>
              <a:gd name="connsiteY3" fmla="*/ 990901 h 3581744"/>
              <a:gd name="connsiteX4" fmla="*/ 2743525 w 4448757"/>
              <a:gd name="connsiteY4" fmla="*/ 406701 h 3581744"/>
              <a:gd name="connsiteX5" fmla="*/ 2946725 w 4448757"/>
              <a:gd name="connsiteY5" fmla="*/ 660701 h 3581744"/>
              <a:gd name="connsiteX6" fmla="*/ 3086425 w 4448757"/>
              <a:gd name="connsiteY6" fmla="*/ 965501 h 3581744"/>
              <a:gd name="connsiteX7" fmla="*/ 2984825 w 4448757"/>
              <a:gd name="connsiteY7" fmla="*/ 216201 h 3581744"/>
              <a:gd name="connsiteX8" fmla="*/ 3149925 w 4448757"/>
              <a:gd name="connsiteY8" fmla="*/ 301 h 3581744"/>
              <a:gd name="connsiteX9" fmla="*/ 3035625 w 4448757"/>
              <a:gd name="connsiteY9" fmla="*/ 178101 h 3581744"/>
              <a:gd name="connsiteX10" fmla="*/ 3086425 w 4448757"/>
              <a:gd name="connsiteY10" fmla="*/ 533701 h 3581744"/>
              <a:gd name="connsiteX11" fmla="*/ 3289625 w 4448757"/>
              <a:gd name="connsiteY11" fmla="*/ 228901 h 3581744"/>
              <a:gd name="connsiteX12" fmla="*/ 3162625 w 4448757"/>
              <a:gd name="connsiteY12" fmla="*/ 609901 h 3581744"/>
              <a:gd name="connsiteX13" fmla="*/ 3162625 w 4448757"/>
              <a:gd name="connsiteY13" fmla="*/ 876601 h 3581744"/>
              <a:gd name="connsiteX14" fmla="*/ 3099125 w 4448757"/>
              <a:gd name="connsiteY14" fmla="*/ 1206801 h 3581744"/>
              <a:gd name="connsiteX15" fmla="*/ 3048325 w 4448757"/>
              <a:gd name="connsiteY15" fmla="*/ 1384601 h 3581744"/>
              <a:gd name="connsiteX16" fmla="*/ 3101665 w 4448757"/>
              <a:gd name="connsiteY16" fmla="*/ 1585261 h 3581744"/>
              <a:gd name="connsiteX17" fmla="*/ 3162625 w 4448757"/>
              <a:gd name="connsiteY17" fmla="*/ 1811321 h 3581744"/>
              <a:gd name="connsiteX18" fmla="*/ 4013525 w 4448757"/>
              <a:gd name="connsiteY18" fmla="*/ 1981501 h 3581744"/>
              <a:gd name="connsiteX19" fmla="*/ 4445325 w 4448757"/>
              <a:gd name="connsiteY19" fmla="*/ 2070401 h 3581744"/>
              <a:gd name="connsiteX20" fmla="*/ 3797625 w 4448757"/>
              <a:gd name="connsiteY20" fmla="*/ 1994201 h 3581744"/>
              <a:gd name="connsiteX21" fmla="*/ 3505525 w 4448757"/>
              <a:gd name="connsiteY21" fmla="*/ 2006901 h 3581744"/>
              <a:gd name="connsiteX22" fmla="*/ 4038925 w 4448757"/>
              <a:gd name="connsiteY22" fmla="*/ 2362501 h 3581744"/>
              <a:gd name="connsiteX23" fmla="*/ 3530925 w 4448757"/>
              <a:gd name="connsiteY23" fmla="*/ 2121201 h 3581744"/>
              <a:gd name="connsiteX24" fmla="*/ 3823025 w 4448757"/>
              <a:gd name="connsiteY24" fmla="*/ 2629201 h 3581744"/>
              <a:gd name="connsiteX25" fmla="*/ 4242125 w 4448757"/>
              <a:gd name="connsiteY25" fmla="*/ 3149901 h 3581744"/>
              <a:gd name="connsiteX26" fmla="*/ 3784925 w 4448757"/>
              <a:gd name="connsiteY26" fmla="*/ 2692701 h 3581744"/>
              <a:gd name="connsiteX27" fmla="*/ 3454725 w 4448757"/>
              <a:gd name="connsiteY27" fmla="*/ 2172001 h 3581744"/>
              <a:gd name="connsiteX28" fmla="*/ 3035625 w 4448757"/>
              <a:gd name="connsiteY28" fmla="*/ 1879901 h 3581744"/>
              <a:gd name="connsiteX29" fmla="*/ 2464125 w 4448757"/>
              <a:gd name="connsiteY29" fmla="*/ 2032301 h 3581744"/>
              <a:gd name="connsiteX30" fmla="*/ 2451425 w 4448757"/>
              <a:gd name="connsiteY30" fmla="*/ 2527601 h 3581744"/>
              <a:gd name="connsiteX31" fmla="*/ 2883225 w 4448757"/>
              <a:gd name="connsiteY31" fmla="*/ 2781601 h 3581744"/>
              <a:gd name="connsiteX32" fmla="*/ 2426025 w 4448757"/>
              <a:gd name="connsiteY32" fmla="*/ 2641901 h 3581744"/>
              <a:gd name="connsiteX33" fmla="*/ 2972125 w 4448757"/>
              <a:gd name="connsiteY33" fmla="*/ 3124501 h 3581744"/>
              <a:gd name="connsiteX34" fmla="*/ 3086425 w 4448757"/>
              <a:gd name="connsiteY34" fmla="*/ 3581701 h 3581744"/>
              <a:gd name="connsiteX35" fmla="*/ 2870525 w 4448757"/>
              <a:gd name="connsiteY35" fmla="*/ 3099101 h 3581744"/>
              <a:gd name="connsiteX36" fmla="*/ 2507305 w 4448757"/>
              <a:gd name="connsiteY36" fmla="*/ 2812081 h 3581744"/>
              <a:gd name="connsiteX37" fmla="*/ 2410785 w 4448757"/>
              <a:gd name="connsiteY37" fmla="*/ 2738421 h 3581744"/>
              <a:gd name="connsiteX38" fmla="*/ 2324425 w 4448757"/>
              <a:gd name="connsiteY38" fmla="*/ 2466641 h 3581744"/>
              <a:gd name="connsiteX39" fmla="*/ 2210125 w 4448757"/>
              <a:gd name="connsiteY39" fmla="*/ 2311701 h 3581744"/>
              <a:gd name="connsiteX40" fmla="*/ 2057725 w 4448757"/>
              <a:gd name="connsiteY40" fmla="*/ 3111801 h 3581744"/>
              <a:gd name="connsiteX41" fmla="*/ 1727525 w 4448757"/>
              <a:gd name="connsiteY41" fmla="*/ 3238801 h 3581744"/>
              <a:gd name="connsiteX42" fmla="*/ 1956125 w 4448757"/>
              <a:gd name="connsiteY42" fmla="*/ 3073701 h 3581744"/>
              <a:gd name="connsiteX43" fmla="*/ 2095825 w 4448757"/>
              <a:gd name="connsiteY43" fmla="*/ 2680001 h 3581744"/>
              <a:gd name="connsiteX44" fmla="*/ 2085665 w 4448757"/>
              <a:gd name="connsiteY44" fmla="*/ 2352341 h 3581744"/>
              <a:gd name="connsiteX45" fmla="*/ 1943425 w 4448757"/>
              <a:gd name="connsiteY45" fmla="*/ 2832401 h 3581744"/>
              <a:gd name="connsiteX46" fmla="*/ 1943425 w 4448757"/>
              <a:gd name="connsiteY46" fmla="*/ 2547921 h 3581744"/>
              <a:gd name="connsiteX47" fmla="*/ 2121225 w 4448757"/>
              <a:gd name="connsiteY47" fmla="*/ 2197401 h 3581744"/>
              <a:gd name="connsiteX48" fmla="*/ 2311725 w 4448757"/>
              <a:gd name="connsiteY48" fmla="*/ 2045001 h 3581744"/>
              <a:gd name="connsiteX49" fmla="*/ 2248225 w 4448757"/>
              <a:gd name="connsiteY49" fmla="*/ 1664001 h 3581744"/>
              <a:gd name="connsiteX50" fmla="*/ 1841825 w 4448757"/>
              <a:gd name="connsiteY50" fmla="*/ 1778301 h 3581744"/>
              <a:gd name="connsiteX51" fmla="*/ 1679265 w 4448757"/>
              <a:gd name="connsiteY51" fmla="*/ 2024681 h 3581744"/>
              <a:gd name="connsiteX52" fmla="*/ 1346525 w 4448757"/>
              <a:gd name="connsiteY52" fmla="*/ 2527601 h 3581744"/>
              <a:gd name="connsiteX53" fmla="*/ 1511625 w 4448757"/>
              <a:gd name="connsiteY53" fmla="*/ 2172001 h 3581744"/>
              <a:gd name="connsiteX54" fmla="*/ 1709745 w 4448757"/>
              <a:gd name="connsiteY54" fmla="*/ 1796081 h 3581744"/>
              <a:gd name="connsiteX55" fmla="*/ 1308425 w 4448757"/>
              <a:gd name="connsiteY55" fmla="*/ 1829101 h 3581744"/>
              <a:gd name="connsiteX56" fmla="*/ 775025 w 4448757"/>
              <a:gd name="connsiteY56" fmla="*/ 2121201 h 3581744"/>
              <a:gd name="connsiteX57" fmla="*/ 406725 w 4448757"/>
              <a:gd name="connsiteY57" fmla="*/ 2591101 h 3581744"/>
              <a:gd name="connsiteX58" fmla="*/ 622625 w 4448757"/>
              <a:gd name="connsiteY58" fmla="*/ 2159301 h 3581744"/>
              <a:gd name="connsiteX59" fmla="*/ 703905 w 4448757"/>
              <a:gd name="connsiteY59" fmla="*/ 1890061 h 3581744"/>
              <a:gd name="connsiteX60" fmla="*/ 325 w 4448757"/>
              <a:gd name="connsiteY60" fmla="*/ 1537001 h 3581744"/>
              <a:gd name="connsiteX61" fmla="*/ 617545 w 4448757"/>
              <a:gd name="connsiteY61" fmla="*/ 1775761 h 3581744"/>
              <a:gd name="connsiteX62" fmla="*/ 980765 w 4448757"/>
              <a:gd name="connsiteY62" fmla="*/ 1821481 h 3581744"/>
              <a:gd name="connsiteX63" fmla="*/ 724225 w 4448757"/>
              <a:gd name="connsiteY63" fmla="*/ 1486201 h 3581744"/>
              <a:gd name="connsiteX64" fmla="*/ 559125 w 4448757"/>
              <a:gd name="connsiteY64" fmla="*/ 1194101 h 3581744"/>
              <a:gd name="connsiteX65" fmla="*/ 902025 w 4448757"/>
              <a:gd name="connsiteY65" fmla="*/ 1625901 h 3581744"/>
              <a:gd name="connsiteX66" fmla="*/ 1321125 w 4448757"/>
              <a:gd name="connsiteY66" fmla="*/ 1740201 h 3581744"/>
              <a:gd name="connsiteX67" fmla="*/ 1829125 w 4448757"/>
              <a:gd name="connsiteY67" fmla="*/ 1638601 h 3581744"/>
              <a:gd name="connsiteX68" fmla="*/ 2105985 w 4448757"/>
              <a:gd name="connsiteY68" fmla="*/ 1562401 h 3581744"/>
              <a:gd name="connsiteX69" fmla="*/ 2232985 w 4448757"/>
              <a:gd name="connsiteY69" fmla="*/ 1397301 h 3581744"/>
              <a:gd name="connsiteX70" fmla="*/ 1816425 w 4448757"/>
              <a:gd name="connsiteY70" fmla="*/ 775001 h 3581744"/>
              <a:gd name="connsiteX71" fmla="*/ 2273625 w 4448757"/>
              <a:gd name="connsiteY71" fmla="*/ 1194101 h 3581744"/>
              <a:gd name="connsiteX0" fmla="*/ 2273625 w 4448757"/>
              <a:gd name="connsiteY0" fmla="*/ 1194101 h 3581744"/>
              <a:gd name="connsiteX1" fmla="*/ 2514925 w 4448757"/>
              <a:gd name="connsiteY1" fmla="*/ 1410001 h 3581744"/>
              <a:gd name="connsiteX2" fmla="*/ 2870525 w 4448757"/>
              <a:gd name="connsiteY2" fmla="*/ 1410001 h 3581744"/>
              <a:gd name="connsiteX3" fmla="*/ 3010225 w 4448757"/>
              <a:gd name="connsiteY3" fmla="*/ 990901 h 3581744"/>
              <a:gd name="connsiteX4" fmla="*/ 2743525 w 4448757"/>
              <a:gd name="connsiteY4" fmla="*/ 406701 h 3581744"/>
              <a:gd name="connsiteX5" fmla="*/ 2946725 w 4448757"/>
              <a:gd name="connsiteY5" fmla="*/ 660701 h 3581744"/>
              <a:gd name="connsiteX6" fmla="*/ 3086425 w 4448757"/>
              <a:gd name="connsiteY6" fmla="*/ 965501 h 3581744"/>
              <a:gd name="connsiteX7" fmla="*/ 2984825 w 4448757"/>
              <a:gd name="connsiteY7" fmla="*/ 216201 h 3581744"/>
              <a:gd name="connsiteX8" fmla="*/ 3149925 w 4448757"/>
              <a:gd name="connsiteY8" fmla="*/ 301 h 3581744"/>
              <a:gd name="connsiteX9" fmla="*/ 3035625 w 4448757"/>
              <a:gd name="connsiteY9" fmla="*/ 178101 h 3581744"/>
              <a:gd name="connsiteX10" fmla="*/ 3086425 w 4448757"/>
              <a:gd name="connsiteY10" fmla="*/ 533701 h 3581744"/>
              <a:gd name="connsiteX11" fmla="*/ 3289625 w 4448757"/>
              <a:gd name="connsiteY11" fmla="*/ 228901 h 3581744"/>
              <a:gd name="connsiteX12" fmla="*/ 3162625 w 4448757"/>
              <a:gd name="connsiteY12" fmla="*/ 609901 h 3581744"/>
              <a:gd name="connsiteX13" fmla="*/ 3162625 w 4448757"/>
              <a:gd name="connsiteY13" fmla="*/ 876601 h 3581744"/>
              <a:gd name="connsiteX14" fmla="*/ 3099125 w 4448757"/>
              <a:gd name="connsiteY14" fmla="*/ 1206801 h 3581744"/>
              <a:gd name="connsiteX15" fmla="*/ 3048325 w 4448757"/>
              <a:gd name="connsiteY15" fmla="*/ 1384601 h 3581744"/>
              <a:gd name="connsiteX16" fmla="*/ 3048325 w 4448757"/>
              <a:gd name="connsiteY16" fmla="*/ 1585261 h 3581744"/>
              <a:gd name="connsiteX17" fmla="*/ 3162625 w 4448757"/>
              <a:gd name="connsiteY17" fmla="*/ 1811321 h 3581744"/>
              <a:gd name="connsiteX18" fmla="*/ 4013525 w 4448757"/>
              <a:gd name="connsiteY18" fmla="*/ 1981501 h 3581744"/>
              <a:gd name="connsiteX19" fmla="*/ 4445325 w 4448757"/>
              <a:gd name="connsiteY19" fmla="*/ 2070401 h 3581744"/>
              <a:gd name="connsiteX20" fmla="*/ 3797625 w 4448757"/>
              <a:gd name="connsiteY20" fmla="*/ 1994201 h 3581744"/>
              <a:gd name="connsiteX21" fmla="*/ 3505525 w 4448757"/>
              <a:gd name="connsiteY21" fmla="*/ 2006901 h 3581744"/>
              <a:gd name="connsiteX22" fmla="*/ 4038925 w 4448757"/>
              <a:gd name="connsiteY22" fmla="*/ 2362501 h 3581744"/>
              <a:gd name="connsiteX23" fmla="*/ 3530925 w 4448757"/>
              <a:gd name="connsiteY23" fmla="*/ 2121201 h 3581744"/>
              <a:gd name="connsiteX24" fmla="*/ 3823025 w 4448757"/>
              <a:gd name="connsiteY24" fmla="*/ 2629201 h 3581744"/>
              <a:gd name="connsiteX25" fmla="*/ 4242125 w 4448757"/>
              <a:gd name="connsiteY25" fmla="*/ 3149901 h 3581744"/>
              <a:gd name="connsiteX26" fmla="*/ 3784925 w 4448757"/>
              <a:gd name="connsiteY26" fmla="*/ 2692701 h 3581744"/>
              <a:gd name="connsiteX27" fmla="*/ 3454725 w 4448757"/>
              <a:gd name="connsiteY27" fmla="*/ 2172001 h 3581744"/>
              <a:gd name="connsiteX28" fmla="*/ 3035625 w 4448757"/>
              <a:gd name="connsiteY28" fmla="*/ 1879901 h 3581744"/>
              <a:gd name="connsiteX29" fmla="*/ 2464125 w 4448757"/>
              <a:gd name="connsiteY29" fmla="*/ 2032301 h 3581744"/>
              <a:gd name="connsiteX30" fmla="*/ 2451425 w 4448757"/>
              <a:gd name="connsiteY30" fmla="*/ 2527601 h 3581744"/>
              <a:gd name="connsiteX31" fmla="*/ 2883225 w 4448757"/>
              <a:gd name="connsiteY31" fmla="*/ 2781601 h 3581744"/>
              <a:gd name="connsiteX32" fmla="*/ 2426025 w 4448757"/>
              <a:gd name="connsiteY32" fmla="*/ 2641901 h 3581744"/>
              <a:gd name="connsiteX33" fmla="*/ 2972125 w 4448757"/>
              <a:gd name="connsiteY33" fmla="*/ 3124501 h 3581744"/>
              <a:gd name="connsiteX34" fmla="*/ 3086425 w 4448757"/>
              <a:gd name="connsiteY34" fmla="*/ 3581701 h 3581744"/>
              <a:gd name="connsiteX35" fmla="*/ 2870525 w 4448757"/>
              <a:gd name="connsiteY35" fmla="*/ 3099101 h 3581744"/>
              <a:gd name="connsiteX36" fmla="*/ 2507305 w 4448757"/>
              <a:gd name="connsiteY36" fmla="*/ 2812081 h 3581744"/>
              <a:gd name="connsiteX37" fmla="*/ 2410785 w 4448757"/>
              <a:gd name="connsiteY37" fmla="*/ 2738421 h 3581744"/>
              <a:gd name="connsiteX38" fmla="*/ 2324425 w 4448757"/>
              <a:gd name="connsiteY38" fmla="*/ 2466641 h 3581744"/>
              <a:gd name="connsiteX39" fmla="*/ 2210125 w 4448757"/>
              <a:gd name="connsiteY39" fmla="*/ 2311701 h 3581744"/>
              <a:gd name="connsiteX40" fmla="*/ 2057725 w 4448757"/>
              <a:gd name="connsiteY40" fmla="*/ 3111801 h 3581744"/>
              <a:gd name="connsiteX41" fmla="*/ 1727525 w 4448757"/>
              <a:gd name="connsiteY41" fmla="*/ 3238801 h 3581744"/>
              <a:gd name="connsiteX42" fmla="*/ 1956125 w 4448757"/>
              <a:gd name="connsiteY42" fmla="*/ 3073701 h 3581744"/>
              <a:gd name="connsiteX43" fmla="*/ 2095825 w 4448757"/>
              <a:gd name="connsiteY43" fmla="*/ 2680001 h 3581744"/>
              <a:gd name="connsiteX44" fmla="*/ 2085665 w 4448757"/>
              <a:gd name="connsiteY44" fmla="*/ 2352341 h 3581744"/>
              <a:gd name="connsiteX45" fmla="*/ 1943425 w 4448757"/>
              <a:gd name="connsiteY45" fmla="*/ 2832401 h 3581744"/>
              <a:gd name="connsiteX46" fmla="*/ 1943425 w 4448757"/>
              <a:gd name="connsiteY46" fmla="*/ 2547921 h 3581744"/>
              <a:gd name="connsiteX47" fmla="*/ 2121225 w 4448757"/>
              <a:gd name="connsiteY47" fmla="*/ 2197401 h 3581744"/>
              <a:gd name="connsiteX48" fmla="*/ 2311725 w 4448757"/>
              <a:gd name="connsiteY48" fmla="*/ 2045001 h 3581744"/>
              <a:gd name="connsiteX49" fmla="*/ 2248225 w 4448757"/>
              <a:gd name="connsiteY49" fmla="*/ 1664001 h 3581744"/>
              <a:gd name="connsiteX50" fmla="*/ 1841825 w 4448757"/>
              <a:gd name="connsiteY50" fmla="*/ 1778301 h 3581744"/>
              <a:gd name="connsiteX51" fmla="*/ 1679265 w 4448757"/>
              <a:gd name="connsiteY51" fmla="*/ 2024681 h 3581744"/>
              <a:gd name="connsiteX52" fmla="*/ 1346525 w 4448757"/>
              <a:gd name="connsiteY52" fmla="*/ 2527601 h 3581744"/>
              <a:gd name="connsiteX53" fmla="*/ 1511625 w 4448757"/>
              <a:gd name="connsiteY53" fmla="*/ 2172001 h 3581744"/>
              <a:gd name="connsiteX54" fmla="*/ 1709745 w 4448757"/>
              <a:gd name="connsiteY54" fmla="*/ 1796081 h 3581744"/>
              <a:gd name="connsiteX55" fmla="*/ 1308425 w 4448757"/>
              <a:gd name="connsiteY55" fmla="*/ 1829101 h 3581744"/>
              <a:gd name="connsiteX56" fmla="*/ 775025 w 4448757"/>
              <a:gd name="connsiteY56" fmla="*/ 2121201 h 3581744"/>
              <a:gd name="connsiteX57" fmla="*/ 406725 w 4448757"/>
              <a:gd name="connsiteY57" fmla="*/ 2591101 h 3581744"/>
              <a:gd name="connsiteX58" fmla="*/ 622625 w 4448757"/>
              <a:gd name="connsiteY58" fmla="*/ 2159301 h 3581744"/>
              <a:gd name="connsiteX59" fmla="*/ 703905 w 4448757"/>
              <a:gd name="connsiteY59" fmla="*/ 1890061 h 3581744"/>
              <a:gd name="connsiteX60" fmla="*/ 325 w 4448757"/>
              <a:gd name="connsiteY60" fmla="*/ 1537001 h 3581744"/>
              <a:gd name="connsiteX61" fmla="*/ 617545 w 4448757"/>
              <a:gd name="connsiteY61" fmla="*/ 1775761 h 3581744"/>
              <a:gd name="connsiteX62" fmla="*/ 980765 w 4448757"/>
              <a:gd name="connsiteY62" fmla="*/ 1821481 h 3581744"/>
              <a:gd name="connsiteX63" fmla="*/ 724225 w 4448757"/>
              <a:gd name="connsiteY63" fmla="*/ 1486201 h 3581744"/>
              <a:gd name="connsiteX64" fmla="*/ 559125 w 4448757"/>
              <a:gd name="connsiteY64" fmla="*/ 1194101 h 3581744"/>
              <a:gd name="connsiteX65" fmla="*/ 902025 w 4448757"/>
              <a:gd name="connsiteY65" fmla="*/ 1625901 h 3581744"/>
              <a:gd name="connsiteX66" fmla="*/ 1321125 w 4448757"/>
              <a:gd name="connsiteY66" fmla="*/ 1740201 h 3581744"/>
              <a:gd name="connsiteX67" fmla="*/ 1829125 w 4448757"/>
              <a:gd name="connsiteY67" fmla="*/ 1638601 h 3581744"/>
              <a:gd name="connsiteX68" fmla="*/ 2105985 w 4448757"/>
              <a:gd name="connsiteY68" fmla="*/ 1562401 h 3581744"/>
              <a:gd name="connsiteX69" fmla="*/ 2232985 w 4448757"/>
              <a:gd name="connsiteY69" fmla="*/ 1397301 h 3581744"/>
              <a:gd name="connsiteX70" fmla="*/ 1816425 w 4448757"/>
              <a:gd name="connsiteY70" fmla="*/ 775001 h 3581744"/>
              <a:gd name="connsiteX71" fmla="*/ 2273625 w 4448757"/>
              <a:gd name="connsiteY71" fmla="*/ 1194101 h 3581744"/>
              <a:gd name="connsiteX0" fmla="*/ 2273638 w 4448770"/>
              <a:gd name="connsiteY0" fmla="*/ 1194101 h 3581744"/>
              <a:gd name="connsiteX1" fmla="*/ 2514938 w 4448770"/>
              <a:gd name="connsiteY1" fmla="*/ 1410001 h 3581744"/>
              <a:gd name="connsiteX2" fmla="*/ 2870538 w 4448770"/>
              <a:gd name="connsiteY2" fmla="*/ 1410001 h 3581744"/>
              <a:gd name="connsiteX3" fmla="*/ 3010238 w 4448770"/>
              <a:gd name="connsiteY3" fmla="*/ 990901 h 3581744"/>
              <a:gd name="connsiteX4" fmla="*/ 2743538 w 4448770"/>
              <a:gd name="connsiteY4" fmla="*/ 406701 h 3581744"/>
              <a:gd name="connsiteX5" fmla="*/ 2946738 w 4448770"/>
              <a:gd name="connsiteY5" fmla="*/ 660701 h 3581744"/>
              <a:gd name="connsiteX6" fmla="*/ 3086438 w 4448770"/>
              <a:gd name="connsiteY6" fmla="*/ 965501 h 3581744"/>
              <a:gd name="connsiteX7" fmla="*/ 2984838 w 4448770"/>
              <a:gd name="connsiteY7" fmla="*/ 216201 h 3581744"/>
              <a:gd name="connsiteX8" fmla="*/ 3149938 w 4448770"/>
              <a:gd name="connsiteY8" fmla="*/ 301 h 3581744"/>
              <a:gd name="connsiteX9" fmla="*/ 3035638 w 4448770"/>
              <a:gd name="connsiteY9" fmla="*/ 178101 h 3581744"/>
              <a:gd name="connsiteX10" fmla="*/ 3086438 w 4448770"/>
              <a:gd name="connsiteY10" fmla="*/ 533701 h 3581744"/>
              <a:gd name="connsiteX11" fmla="*/ 3289638 w 4448770"/>
              <a:gd name="connsiteY11" fmla="*/ 228901 h 3581744"/>
              <a:gd name="connsiteX12" fmla="*/ 3162638 w 4448770"/>
              <a:gd name="connsiteY12" fmla="*/ 609901 h 3581744"/>
              <a:gd name="connsiteX13" fmla="*/ 3162638 w 4448770"/>
              <a:gd name="connsiteY13" fmla="*/ 876601 h 3581744"/>
              <a:gd name="connsiteX14" fmla="*/ 3099138 w 4448770"/>
              <a:gd name="connsiteY14" fmla="*/ 1206801 h 3581744"/>
              <a:gd name="connsiteX15" fmla="*/ 3048338 w 4448770"/>
              <a:gd name="connsiteY15" fmla="*/ 1384601 h 3581744"/>
              <a:gd name="connsiteX16" fmla="*/ 3048338 w 4448770"/>
              <a:gd name="connsiteY16" fmla="*/ 1585261 h 3581744"/>
              <a:gd name="connsiteX17" fmla="*/ 3162638 w 4448770"/>
              <a:gd name="connsiteY17" fmla="*/ 1811321 h 3581744"/>
              <a:gd name="connsiteX18" fmla="*/ 4013538 w 4448770"/>
              <a:gd name="connsiteY18" fmla="*/ 1981501 h 3581744"/>
              <a:gd name="connsiteX19" fmla="*/ 4445338 w 4448770"/>
              <a:gd name="connsiteY19" fmla="*/ 2070401 h 3581744"/>
              <a:gd name="connsiteX20" fmla="*/ 3797638 w 4448770"/>
              <a:gd name="connsiteY20" fmla="*/ 1994201 h 3581744"/>
              <a:gd name="connsiteX21" fmla="*/ 3505538 w 4448770"/>
              <a:gd name="connsiteY21" fmla="*/ 2006901 h 3581744"/>
              <a:gd name="connsiteX22" fmla="*/ 4038938 w 4448770"/>
              <a:gd name="connsiteY22" fmla="*/ 2362501 h 3581744"/>
              <a:gd name="connsiteX23" fmla="*/ 3530938 w 4448770"/>
              <a:gd name="connsiteY23" fmla="*/ 2121201 h 3581744"/>
              <a:gd name="connsiteX24" fmla="*/ 3823038 w 4448770"/>
              <a:gd name="connsiteY24" fmla="*/ 2629201 h 3581744"/>
              <a:gd name="connsiteX25" fmla="*/ 4242138 w 4448770"/>
              <a:gd name="connsiteY25" fmla="*/ 3149901 h 3581744"/>
              <a:gd name="connsiteX26" fmla="*/ 3784938 w 4448770"/>
              <a:gd name="connsiteY26" fmla="*/ 2692701 h 3581744"/>
              <a:gd name="connsiteX27" fmla="*/ 3454738 w 4448770"/>
              <a:gd name="connsiteY27" fmla="*/ 2172001 h 3581744"/>
              <a:gd name="connsiteX28" fmla="*/ 3035638 w 4448770"/>
              <a:gd name="connsiteY28" fmla="*/ 1879901 h 3581744"/>
              <a:gd name="connsiteX29" fmla="*/ 2464138 w 4448770"/>
              <a:gd name="connsiteY29" fmla="*/ 2032301 h 3581744"/>
              <a:gd name="connsiteX30" fmla="*/ 2451438 w 4448770"/>
              <a:gd name="connsiteY30" fmla="*/ 2527601 h 3581744"/>
              <a:gd name="connsiteX31" fmla="*/ 2883238 w 4448770"/>
              <a:gd name="connsiteY31" fmla="*/ 2781601 h 3581744"/>
              <a:gd name="connsiteX32" fmla="*/ 2426038 w 4448770"/>
              <a:gd name="connsiteY32" fmla="*/ 2641901 h 3581744"/>
              <a:gd name="connsiteX33" fmla="*/ 2972138 w 4448770"/>
              <a:gd name="connsiteY33" fmla="*/ 3124501 h 3581744"/>
              <a:gd name="connsiteX34" fmla="*/ 3086438 w 4448770"/>
              <a:gd name="connsiteY34" fmla="*/ 3581701 h 3581744"/>
              <a:gd name="connsiteX35" fmla="*/ 2870538 w 4448770"/>
              <a:gd name="connsiteY35" fmla="*/ 3099101 h 3581744"/>
              <a:gd name="connsiteX36" fmla="*/ 2507318 w 4448770"/>
              <a:gd name="connsiteY36" fmla="*/ 2812081 h 3581744"/>
              <a:gd name="connsiteX37" fmla="*/ 2410798 w 4448770"/>
              <a:gd name="connsiteY37" fmla="*/ 2738421 h 3581744"/>
              <a:gd name="connsiteX38" fmla="*/ 2324438 w 4448770"/>
              <a:gd name="connsiteY38" fmla="*/ 2466641 h 3581744"/>
              <a:gd name="connsiteX39" fmla="*/ 2210138 w 4448770"/>
              <a:gd name="connsiteY39" fmla="*/ 2311701 h 3581744"/>
              <a:gd name="connsiteX40" fmla="*/ 2057738 w 4448770"/>
              <a:gd name="connsiteY40" fmla="*/ 3111801 h 3581744"/>
              <a:gd name="connsiteX41" fmla="*/ 1727538 w 4448770"/>
              <a:gd name="connsiteY41" fmla="*/ 3238801 h 3581744"/>
              <a:gd name="connsiteX42" fmla="*/ 1956138 w 4448770"/>
              <a:gd name="connsiteY42" fmla="*/ 3073701 h 3581744"/>
              <a:gd name="connsiteX43" fmla="*/ 2095838 w 4448770"/>
              <a:gd name="connsiteY43" fmla="*/ 2680001 h 3581744"/>
              <a:gd name="connsiteX44" fmla="*/ 2085678 w 4448770"/>
              <a:gd name="connsiteY44" fmla="*/ 2352341 h 3581744"/>
              <a:gd name="connsiteX45" fmla="*/ 1943438 w 4448770"/>
              <a:gd name="connsiteY45" fmla="*/ 2832401 h 3581744"/>
              <a:gd name="connsiteX46" fmla="*/ 1943438 w 4448770"/>
              <a:gd name="connsiteY46" fmla="*/ 2547921 h 3581744"/>
              <a:gd name="connsiteX47" fmla="*/ 2121238 w 4448770"/>
              <a:gd name="connsiteY47" fmla="*/ 2197401 h 3581744"/>
              <a:gd name="connsiteX48" fmla="*/ 2311738 w 4448770"/>
              <a:gd name="connsiteY48" fmla="*/ 2045001 h 3581744"/>
              <a:gd name="connsiteX49" fmla="*/ 2248238 w 4448770"/>
              <a:gd name="connsiteY49" fmla="*/ 1664001 h 3581744"/>
              <a:gd name="connsiteX50" fmla="*/ 1841838 w 4448770"/>
              <a:gd name="connsiteY50" fmla="*/ 1778301 h 3581744"/>
              <a:gd name="connsiteX51" fmla="*/ 1679278 w 4448770"/>
              <a:gd name="connsiteY51" fmla="*/ 2024681 h 3581744"/>
              <a:gd name="connsiteX52" fmla="*/ 1346538 w 4448770"/>
              <a:gd name="connsiteY52" fmla="*/ 2527601 h 3581744"/>
              <a:gd name="connsiteX53" fmla="*/ 1511638 w 4448770"/>
              <a:gd name="connsiteY53" fmla="*/ 2172001 h 3581744"/>
              <a:gd name="connsiteX54" fmla="*/ 1709758 w 4448770"/>
              <a:gd name="connsiteY54" fmla="*/ 1796081 h 3581744"/>
              <a:gd name="connsiteX55" fmla="*/ 1308438 w 4448770"/>
              <a:gd name="connsiteY55" fmla="*/ 1829101 h 3581744"/>
              <a:gd name="connsiteX56" fmla="*/ 775038 w 4448770"/>
              <a:gd name="connsiteY56" fmla="*/ 2121201 h 3581744"/>
              <a:gd name="connsiteX57" fmla="*/ 406738 w 4448770"/>
              <a:gd name="connsiteY57" fmla="*/ 2591101 h 3581744"/>
              <a:gd name="connsiteX58" fmla="*/ 622638 w 4448770"/>
              <a:gd name="connsiteY58" fmla="*/ 2159301 h 3581744"/>
              <a:gd name="connsiteX59" fmla="*/ 703918 w 4448770"/>
              <a:gd name="connsiteY59" fmla="*/ 1890061 h 3581744"/>
              <a:gd name="connsiteX60" fmla="*/ 338 w 4448770"/>
              <a:gd name="connsiteY60" fmla="*/ 1537001 h 3581744"/>
              <a:gd name="connsiteX61" fmla="*/ 617558 w 4448770"/>
              <a:gd name="connsiteY61" fmla="*/ 1775761 h 3581744"/>
              <a:gd name="connsiteX62" fmla="*/ 1089272 w 4448770"/>
              <a:gd name="connsiteY62" fmla="*/ 1803511 h 3581744"/>
              <a:gd name="connsiteX63" fmla="*/ 724238 w 4448770"/>
              <a:gd name="connsiteY63" fmla="*/ 1486201 h 3581744"/>
              <a:gd name="connsiteX64" fmla="*/ 559138 w 4448770"/>
              <a:gd name="connsiteY64" fmla="*/ 1194101 h 3581744"/>
              <a:gd name="connsiteX65" fmla="*/ 902038 w 4448770"/>
              <a:gd name="connsiteY65" fmla="*/ 1625901 h 3581744"/>
              <a:gd name="connsiteX66" fmla="*/ 1321138 w 4448770"/>
              <a:gd name="connsiteY66" fmla="*/ 1740201 h 3581744"/>
              <a:gd name="connsiteX67" fmla="*/ 1829138 w 4448770"/>
              <a:gd name="connsiteY67" fmla="*/ 1638601 h 3581744"/>
              <a:gd name="connsiteX68" fmla="*/ 2105998 w 4448770"/>
              <a:gd name="connsiteY68" fmla="*/ 1562401 h 3581744"/>
              <a:gd name="connsiteX69" fmla="*/ 2232998 w 4448770"/>
              <a:gd name="connsiteY69" fmla="*/ 1397301 h 3581744"/>
              <a:gd name="connsiteX70" fmla="*/ 1816438 w 4448770"/>
              <a:gd name="connsiteY70" fmla="*/ 775001 h 3581744"/>
              <a:gd name="connsiteX71" fmla="*/ 2273638 w 4448770"/>
              <a:gd name="connsiteY71" fmla="*/ 1194101 h 3581744"/>
              <a:gd name="connsiteX0" fmla="*/ 2274433 w 4449565"/>
              <a:gd name="connsiteY0" fmla="*/ 1194101 h 3581744"/>
              <a:gd name="connsiteX1" fmla="*/ 2515733 w 4449565"/>
              <a:gd name="connsiteY1" fmla="*/ 1410001 h 3581744"/>
              <a:gd name="connsiteX2" fmla="*/ 2871333 w 4449565"/>
              <a:gd name="connsiteY2" fmla="*/ 1410001 h 3581744"/>
              <a:gd name="connsiteX3" fmla="*/ 3011033 w 4449565"/>
              <a:gd name="connsiteY3" fmla="*/ 990901 h 3581744"/>
              <a:gd name="connsiteX4" fmla="*/ 2744333 w 4449565"/>
              <a:gd name="connsiteY4" fmla="*/ 406701 h 3581744"/>
              <a:gd name="connsiteX5" fmla="*/ 2947533 w 4449565"/>
              <a:gd name="connsiteY5" fmla="*/ 660701 h 3581744"/>
              <a:gd name="connsiteX6" fmla="*/ 3087233 w 4449565"/>
              <a:gd name="connsiteY6" fmla="*/ 965501 h 3581744"/>
              <a:gd name="connsiteX7" fmla="*/ 2985633 w 4449565"/>
              <a:gd name="connsiteY7" fmla="*/ 216201 h 3581744"/>
              <a:gd name="connsiteX8" fmla="*/ 3150733 w 4449565"/>
              <a:gd name="connsiteY8" fmla="*/ 301 h 3581744"/>
              <a:gd name="connsiteX9" fmla="*/ 3036433 w 4449565"/>
              <a:gd name="connsiteY9" fmla="*/ 178101 h 3581744"/>
              <a:gd name="connsiteX10" fmla="*/ 3087233 w 4449565"/>
              <a:gd name="connsiteY10" fmla="*/ 533701 h 3581744"/>
              <a:gd name="connsiteX11" fmla="*/ 3290433 w 4449565"/>
              <a:gd name="connsiteY11" fmla="*/ 228901 h 3581744"/>
              <a:gd name="connsiteX12" fmla="*/ 3163433 w 4449565"/>
              <a:gd name="connsiteY12" fmla="*/ 609901 h 3581744"/>
              <a:gd name="connsiteX13" fmla="*/ 3163433 w 4449565"/>
              <a:gd name="connsiteY13" fmla="*/ 876601 h 3581744"/>
              <a:gd name="connsiteX14" fmla="*/ 3099933 w 4449565"/>
              <a:gd name="connsiteY14" fmla="*/ 1206801 h 3581744"/>
              <a:gd name="connsiteX15" fmla="*/ 3049133 w 4449565"/>
              <a:gd name="connsiteY15" fmla="*/ 1384601 h 3581744"/>
              <a:gd name="connsiteX16" fmla="*/ 3049133 w 4449565"/>
              <a:gd name="connsiteY16" fmla="*/ 1585261 h 3581744"/>
              <a:gd name="connsiteX17" fmla="*/ 3163433 w 4449565"/>
              <a:gd name="connsiteY17" fmla="*/ 1811321 h 3581744"/>
              <a:gd name="connsiteX18" fmla="*/ 4014333 w 4449565"/>
              <a:gd name="connsiteY18" fmla="*/ 1981501 h 3581744"/>
              <a:gd name="connsiteX19" fmla="*/ 4446133 w 4449565"/>
              <a:gd name="connsiteY19" fmla="*/ 2070401 h 3581744"/>
              <a:gd name="connsiteX20" fmla="*/ 3798433 w 4449565"/>
              <a:gd name="connsiteY20" fmla="*/ 1994201 h 3581744"/>
              <a:gd name="connsiteX21" fmla="*/ 3506333 w 4449565"/>
              <a:gd name="connsiteY21" fmla="*/ 2006901 h 3581744"/>
              <a:gd name="connsiteX22" fmla="*/ 4039733 w 4449565"/>
              <a:gd name="connsiteY22" fmla="*/ 2362501 h 3581744"/>
              <a:gd name="connsiteX23" fmla="*/ 3531733 w 4449565"/>
              <a:gd name="connsiteY23" fmla="*/ 2121201 h 3581744"/>
              <a:gd name="connsiteX24" fmla="*/ 3823833 w 4449565"/>
              <a:gd name="connsiteY24" fmla="*/ 2629201 h 3581744"/>
              <a:gd name="connsiteX25" fmla="*/ 4242933 w 4449565"/>
              <a:gd name="connsiteY25" fmla="*/ 3149901 h 3581744"/>
              <a:gd name="connsiteX26" fmla="*/ 3785733 w 4449565"/>
              <a:gd name="connsiteY26" fmla="*/ 2692701 h 3581744"/>
              <a:gd name="connsiteX27" fmla="*/ 3455533 w 4449565"/>
              <a:gd name="connsiteY27" fmla="*/ 2172001 h 3581744"/>
              <a:gd name="connsiteX28" fmla="*/ 3036433 w 4449565"/>
              <a:gd name="connsiteY28" fmla="*/ 1879901 h 3581744"/>
              <a:gd name="connsiteX29" fmla="*/ 2464933 w 4449565"/>
              <a:gd name="connsiteY29" fmla="*/ 2032301 h 3581744"/>
              <a:gd name="connsiteX30" fmla="*/ 2452233 w 4449565"/>
              <a:gd name="connsiteY30" fmla="*/ 2527601 h 3581744"/>
              <a:gd name="connsiteX31" fmla="*/ 2884033 w 4449565"/>
              <a:gd name="connsiteY31" fmla="*/ 2781601 h 3581744"/>
              <a:gd name="connsiteX32" fmla="*/ 2426833 w 4449565"/>
              <a:gd name="connsiteY32" fmla="*/ 2641901 h 3581744"/>
              <a:gd name="connsiteX33" fmla="*/ 2972933 w 4449565"/>
              <a:gd name="connsiteY33" fmla="*/ 3124501 h 3581744"/>
              <a:gd name="connsiteX34" fmla="*/ 3087233 w 4449565"/>
              <a:gd name="connsiteY34" fmla="*/ 3581701 h 3581744"/>
              <a:gd name="connsiteX35" fmla="*/ 2871333 w 4449565"/>
              <a:gd name="connsiteY35" fmla="*/ 3099101 h 3581744"/>
              <a:gd name="connsiteX36" fmla="*/ 2508113 w 4449565"/>
              <a:gd name="connsiteY36" fmla="*/ 2812081 h 3581744"/>
              <a:gd name="connsiteX37" fmla="*/ 2411593 w 4449565"/>
              <a:gd name="connsiteY37" fmla="*/ 2738421 h 3581744"/>
              <a:gd name="connsiteX38" fmla="*/ 2325233 w 4449565"/>
              <a:gd name="connsiteY38" fmla="*/ 2466641 h 3581744"/>
              <a:gd name="connsiteX39" fmla="*/ 2210933 w 4449565"/>
              <a:gd name="connsiteY39" fmla="*/ 2311701 h 3581744"/>
              <a:gd name="connsiteX40" fmla="*/ 2058533 w 4449565"/>
              <a:gd name="connsiteY40" fmla="*/ 3111801 h 3581744"/>
              <a:gd name="connsiteX41" fmla="*/ 1728333 w 4449565"/>
              <a:gd name="connsiteY41" fmla="*/ 3238801 h 3581744"/>
              <a:gd name="connsiteX42" fmla="*/ 1956933 w 4449565"/>
              <a:gd name="connsiteY42" fmla="*/ 3073701 h 3581744"/>
              <a:gd name="connsiteX43" fmla="*/ 2096633 w 4449565"/>
              <a:gd name="connsiteY43" fmla="*/ 2680001 h 3581744"/>
              <a:gd name="connsiteX44" fmla="*/ 2086473 w 4449565"/>
              <a:gd name="connsiteY44" fmla="*/ 2352341 h 3581744"/>
              <a:gd name="connsiteX45" fmla="*/ 1944233 w 4449565"/>
              <a:gd name="connsiteY45" fmla="*/ 2832401 h 3581744"/>
              <a:gd name="connsiteX46" fmla="*/ 1944233 w 4449565"/>
              <a:gd name="connsiteY46" fmla="*/ 2547921 h 3581744"/>
              <a:gd name="connsiteX47" fmla="*/ 2122033 w 4449565"/>
              <a:gd name="connsiteY47" fmla="*/ 2197401 h 3581744"/>
              <a:gd name="connsiteX48" fmla="*/ 2312533 w 4449565"/>
              <a:gd name="connsiteY48" fmla="*/ 2045001 h 3581744"/>
              <a:gd name="connsiteX49" fmla="*/ 2249033 w 4449565"/>
              <a:gd name="connsiteY49" fmla="*/ 1664001 h 3581744"/>
              <a:gd name="connsiteX50" fmla="*/ 1842633 w 4449565"/>
              <a:gd name="connsiteY50" fmla="*/ 1778301 h 3581744"/>
              <a:gd name="connsiteX51" fmla="*/ 1680073 w 4449565"/>
              <a:gd name="connsiteY51" fmla="*/ 2024681 h 3581744"/>
              <a:gd name="connsiteX52" fmla="*/ 1347333 w 4449565"/>
              <a:gd name="connsiteY52" fmla="*/ 2527601 h 3581744"/>
              <a:gd name="connsiteX53" fmla="*/ 1512433 w 4449565"/>
              <a:gd name="connsiteY53" fmla="*/ 2172001 h 3581744"/>
              <a:gd name="connsiteX54" fmla="*/ 1710553 w 4449565"/>
              <a:gd name="connsiteY54" fmla="*/ 1796081 h 3581744"/>
              <a:gd name="connsiteX55" fmla="*/ 1309233 w 4449565"/>
              <a:gd name="connsiteY55" fmla="*/ 1829101 h 3581744"/>
              <a:gd name="connsiteX56" fmla="*/ 775833 w 4449565"/>
              <a:gd name="connsiteY56" fmla="*/ 2121201 h 3581744"/>
              <a:gd name="connsiteX57" fmla="*/ 407533 w 4449565"/>
              <a:gd name="connsiteY57" fmla="*/ 2591101 h 3581744"/>
              <a:gd name="connsiteX58" fmla="*/ 623433 w 4449565"/>
              <a:gd name="connsiteY58" fmla="*/ 2159301 h 3581744"/>
              <a:gd name="connsiteX59" fmla="*/ 780342 w 4449565"/>
              <a:gd name="connsiteY59" fmla="*/ 1868939 h 3581744"/>
              <a:gd name="connsiteX60" fmla="*/ 1133 w 4449565"/>
              <a:gd name="connsiteY60" fmla="*/ 1537001 h 3581744"/>
              <a:gd name="connsiteX61" fmla="*/ 618353 w 4449565"/>
              <a:gd name="connsiteY61" fmla="*/ 1775761 h 3581744"/>
              <a:gd name="connsiteX62" fmla="*/ 1090067 w 4449565"/>
              <a:gd name="connsiteY62" fmla="*/ 1803511 h 3581744"/>
              <a:gd name="connsiteX63" fmla="*/ 725033 w 4449565"/>
              <a:gd name="connsiteY63" fmla="*/ 1486201 h 3581744"/>
              <a:gd name="connsiteX64" fmla="*/ 559933 w 4449565"/>
              <a:gd name="connsiteY64" fmla="*/ 1194101 h 3581744"/>
              <a:gd name="connsiteX65" fmla="*/ 902833 w 4449565"/>
              <a:gd name="connsiteY65" fmla="*/ 1625901 h 3581744"/>
              <a:gd name="connsiteX66" fmla="*/ 1321933 w 4449565"/>
              <a:gd name="connsiteY66" fmla="*/ 1740201 h 3581744"/>
              <a:gd name="connsiteX67" fmla="*/ 1829933 w 4449565"/>
              <a:gd name="connsiteY67" fmla="*/ 1638601 h 3581744"/>
              <a:gd name="connsiteX68" fmla="*/ 2106793 w 4449565"/>
              <a:gd name="connsiteY68" fmla="*/ 1562401 h 3581744"/>
              <a:gd name="connsiteX69" fmla="*/ 2233793 w 4449565"/>
              <a:gd name="connsiteY69" fmla="*/ 1397301 h 3581744"/>
              <a:gd name="connsiteX70" fmla="*/ 1817233 w 4449565"/>
              <a:gd name="connsiteY70" fmla="*/ 775001 h 3581744"/>
              <a:gd name="connsiteX71" fmla="*/ 2274433 w 4449565"/>
              <a:gd name="connsiteY71" fmla="*/ 1194101 h 35817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</a:cxnLst>
            <a:rect l="l" t="t" r="r" b="b"/>
            <a:pathLst>
              <a:path w="4449565" h="3581744">
                <a:moveTo>
                  <a:pt x="2274433" y="1194101"/>
                </a:moveTo>
                <a:cubicBezTo>
                  <a:pt x="2390850" y="1299934"/>
                  <a:pt x="2416250" y="1374018"/>
                  <a:pt x="2515733" y="1410001"/>
                </a:cubicBezTo>
                <a:cubicBezTo>
                  <a:pt x="2615216" y="1445984"/>
                  <a:pt x="2788783" y="1479851"/>
                  <a:pt x="2871333" y="1410001"/>
                </a:cubicBezTo>
                <a:cubicBezTo>
                  <a:pt x="2953883" y="1340151"/>
                  <a:pt x="3032200" y="1158118"/>
                  <a:pt x="3011033" y="990901"/>
                </a:cubicBezTo>
                <a:cubicBezTo>
                  <a:pt x="2989866" y="823684"/>
                  <a:pt x="2754916" y="461734"/>
                  <a:pt x="2744333" y="406701"/>
                </a:cubicBezTo>
                <a:cubicBezTo>
                  <a:pt x="2733750" y="351668"/>
                  <a:pt x="2890383" y="567568"/>
                  <a:pt x="2947533" y="660701"/>
                </a:cubicBezTo>
                <a:cubicBezTo>
                  <a:pt x="3004683" y="753834"/>
                  <a:pt x="3080883" y="1039584"/>
                  <a:pt x="3087233" y="965501"/>
                </a:cubicBezTo>
                <a:cubicBezTo>
                  <a:pt x="3093583" y="891418"/>
                  <a:pt x="2975050" y="377068"/>
                  <a:pt x="2985633" y="216201"/>
                </a:cubicBezTo>
                <a:cubicBezTo>
                  <a:pt x="2996216" y="55334"/>
                  <a:pt x="3142266" y="6651"/>
                  <a:pt x="3150733" y="301"/>
                </a:cubicBezTo>
                <a:cubicBezTo>
                  <a:pt x="3159200" y="-6049"/>
                  <a:pt x="3047016" y="89201"/>
                  <a:pt x="3036433" y="178101"/>
                </a:cubicBezTo>
                <a:cubicBezTo>
                  <a:pt x="3025850" y="267001"/>
                  <a:pt x="3044900" y="525234"/>
                  <a:pt x="3087233" y="533701"/>
                </a:cubicBezTo>
                <a:cubicBezTo>
                  <a:pt x="3129566" y="542168"/>
                  <a:pt x="3277733" y="216201"/>
                  <a:pt x="3290433" y="228901"/>
                </a:cubicBezTo>
                <a:cubicBezTo>
                  <a:pt x="3303133" y="241601"/>
                  <a:pt x="3184600" y="501951"/>
                  <a:pt x="3163433" y="609901"/>
                </a:cubicBezTo>
                <a:cubicBezTo>
                  <a:pt x="3142266" y="717851"/>
                  <a:pt x="3174016" y="777118"/>
                  <a:pt x="3163433" y="876601"/>
                </a:cubicBezTo>
                <a:cubicBezTo>
                  <a:pt x="3152850" y="976084"/>
                  <a:pt x="3118983" y="1122134"/>
                  <a:pt x="3099933" y="1206801"/>
                </a:cubicBezTo>
                <a:cubicBezTo>
                  <a:pt x="3080883" y="1291468"/>
                  <a:pt x="3057600" y="1321524"/>
                  <a:pt x="3049133" y="1384601"/>
                </a:cubicBezTo>
                <a:cubicBezTo>
                  <a:pt x="3040666" y="1447678"/>
                  <a:pt x="3030083" y="1514141"/>
                  <a:pt x="3049133" y="1585261"/>
                </a:cubicBezTo>
                <a:cubicBezTo>
                  <a:pt x="3068183" y="1656381"/>
                  <a:pt x="3002566" y="1745281"/>
                  <a:pt x="3163433" y="1811321"/>
                </a:cubicBezTo>
                <a:cubicBezTo>
                  <a:pt x="3324300" y="1877361"/>
                  <a:pt x="3800550" y="1938321"/>
                  <a:pt x="4014333" y="1981501"/>
                </a:cubicBezTo>
                <a:cubicBezTo>
                  <a:pt x="4228116" y="2024681"/>
                  <a:pt x="4482116" y="2068284"/>
                  <a:pt x="4446133" y="2070401"/>
                </a:cubicBezTo>
                <a:cubicBezTo>
                  <a:pt x="4410150" y="2072518"/>
                  <a:pt x="3955066" y="2004784"/>
                  <a:pt x="3798433" y="1994201"/>
                </a:cubicBezTo>
                <a:cubicBezTo>
                  <a:pt x="3641800" y="1983618"/>
                  <a:pt x="3466116" y="1945518"/>
                  <a:pt x="3506333" y="2006901"/>
                </a:cubicBezTo>
                <a:cubicBezTo>
                  <a:pt x="3546550" y="2068284"/>
                  <a:pt x="4035500" y="2343451"/>
                  <a:pt x="4039733" y="2362501"/>
                </a:cubicBezTo>
                <a:cubicBezTo>
                  <a:pt x="4043966" y="2381551"/>
                  <a:pt x="3567716" y="2076751"/>
                  <a:pt x="3531733" y="2121201"/>
                </a:cubicBezTo>
                <a:cubicBezTo>
                  <a:pt x="3495750" y="2165651"/>
                  <a:pt x="3705300" y="2457751"/>
                  <a:pt x="3823833" y="2629201"/>
                </a:cubicBezTo>
                <a:cubicBezTo>
                  <a:pt x="3942366" y="2800651"/>
                  <a:pt x="4249283" y="3139318"/>
                  <a:pt x="4242933" y="3149901"/>
                </a:cubicBezTo>
                <a:cubicBezTo>
                  <a:pt x="4236583" y="3160484"/>
                  <a:pt x="3916966" y="2855684"/>
                  <a:pt x="3785733" y="2692701"/>
                </a:cubicBezTo>
                <a:cubicBezTo>
                  <a:pt x="3654500" y="2529718"/>
                  <a:pt x="3580416" y="2307468"/>
                  <a:pt x="3455533" y="2172001"/>
                </a:cubicBezTo>
                <a:cubicBezTo>
                  <a:pt x="3330650" y="2036534"/>
                  <a:pt x="3201533" y="1903184"/>
                  <a:pt x="3036433" y="1879901"/>
                </a:cubicBezTo>
                <a:cubicBezTo>
                  <a:pt x="2871333" y="1856618"/>
                  <a:pt x="2562300" y="1924351"/>
                  <a:pt x="2464933" y="2032301"/>
                </a:cubicBezTo>
                <a:cubicBezTo>
                  <a:pt x="2367566" y="2140251"/>
                  <a:pt x="2382383" y="2402718"/>
                  <a:pt x="2452233" y="2527601"/>
                </a:cubicBezTo>
                <a:cubicBezTo>
                  <a:pt x="2522083" y="2652484"/>
                  <a:pt x="2888266" y="2762551"/>
                  <a:pt x="2884033" y="2781601"/>
                </a:cubicBezTo>
                <a:cubicBezTo>
                  <a:pt x="2879800" y="2800651"/>
                  <a:pt x="2412016" y="2584751"/>
                  <a:pt x="2426833" y="2641901"/>
                </a:cubicBezTo>
                <a:cubicBezTo>
                  <a:pt x="2441650" y="2699051"/>
                  <a:pt x="2862866" y="2967868"/>
                  <a:pt x="2972933" y="3124501"/>
                </a:cubicBezTo>
                <a:cubicBezTo>
                  <a:pt x="3083000" y="3281134"/>
                  <a:pt x="3104166" y="3585934"/>
                  <a:pt x="3087233" y="3581701"/>
                </a:cubicBezTo>
                <a:cubicBezTo>
                  <a:pt x="3070300" y="3577468"/>
                  <a:pt x="2967853" y="3227371"/>
                  <a:pt x="2871333" y="3099101"/>
                </a:cubicBezTo>
                <a:cubicBezTo>
                  <a:pt x="2774813" y="2970831"/>
                  <a:pt x="2584736" y="2872194"/>
                  <a:pt x="2508113" y="2812081"/>
                </a:cubicBezTo>
                <a:cubicBezTo>
                  <a:pt x="2431490" y="2751968"/>
                  <a:pt x="2442073" y="2795994"/>
                  <a:pt x="2411593" y="2738421"/>
                </a:cubicBezTo>
                <a:cubicBezTo>
                  <a:pt x="2381113" y="2680848"/>
                  <a:pt x="2358676" y="2537761"/>
                  <a:pt x="2325233" y="2466641"/>
                </a:cubicBezTo>
                <a:cubicBezTo>
                  <a:pt x="2291790" y="2395521"/>
                  <a:pt x="2255383" y="2204174"/>
                  <a:pt x="2210933" y="2311701"/>
                </a:cubicBezTo>
                <a:cubicBezTo>
                  <a:pt x="2166483" y="2419228"/>
                  <a:pt x="2138966" y="2957284"/>
                  <a:pt x="2058533" y="3111801"/>
                </a:cubicBezTo>
                <a:cubicBezTo>
                  <a:pt x="1978100" y="3266318"/>
                  <a:pt x="1745266" y="3245151"/>
                  <a:pt x="1728333" y="3238801"/>
                </a:cubicBezTo>
                <a:cubicBezTo>
                  <a:pt x="1711400" y="3232451"/>
                  <a:pt x="1895550" y="3166834"/>
                  <a:pt x="1956933" y="3073701"/>
                </a:cubicBezTo>
                <a:cubicBezTo>
                  <a:pt x="2018316" y="2980568"/>
                  <a:pt x="2075043" y="2800228"/>
                  <a:pt x="2096633" y="2680001"/>
                </a:cubicBezTo>
                <a:cubicBezTo>
                  <a:pt x="2118223" y="2559774"/>
                  <a:pt x="2111873" y="2326941"/>
                  <a:pt x="2086473" y="2352341"/>
                </a:cubicBezTo>
                <a:cubicBezTo>
                  <a:pt x="2061073" y="2377741"/>
                  <a:pt x="1967940" y="2799804"/>
                  <a:pt x="1944233" y="2832401"/>
                </a:cubicBezTo>
                <a:cubicBezTo>
                  <a:pt x="1920526" y="2864998"/>
                  <a:pt x="1914600" y="2653754"/>
                  <a:pt x="1944233" y="2547921"/>
                </a:cubicBezTo>
                <a:cubicBezTo>
                  <a:pt x="1973866" y="2442088"/>
                  <a:pt x="2060650" y="2281221"/>
                  <a:pt x="2122033" y="2197401"/>
                </a:cubicBezTo>
                <a:cubicBezTo>
                  <a:pt x="2183416" y="2113581"/>
                  <a:pt x="2291366" y="2133901"/>
                  <a:pt x="2312533" y="2045001"/>
                </a:cubicBezTo>
                <a:cubicBezTo>
                  <a:pt x="2333700" y="1956101"/>
                  <a:pt x="2327350" y="1708451"/>
                  <a:pt x="2249033" y="1664001"/>
                </a:cubicBezTo>
                <a:cubicBezTo>
                  <a:pt x="2170716" y="1619551"/>
                  <a:pt x="1937460" y="1718188"/>
                  <a:pt x="1842633" y="1778301"/>
                </a:cubicBezTo>
                <a:cubicBezTo>
                  <a:pt x="1747806" y="1838414"/>
                  <a:pt x="1762623" y="1899798"/>
                  <a:pt x="1680073" y="2024681"/>
                </a:cubicBezTo>
                <a:cubicBezTo>
                  <a:pt x="1597523" y="2149564"/>
                  <a:pt x="1375273" y="2503048"/>
                  <a:pt x="1347333" y="2527601"/>
                </a:cubicBezTo>
                <a:cubicBezTo>
                  <a:pt x="1319393" y="2552154"/>
                  <a:pt x="1451896" y="2293921"/>
                  <a:pt x="1512433" y="2172001"/>
                </a:cubicBezTo>
                <a:cubicBezTo>
                  <a:pt x="1572970" y="2050081"/>
                  <a:pt x="1744420" y="1853231"/>
                  <a:pt x="1710553" y="1796081"/>
                </a:cubicBezTo>
                <a:cubicBezTo>
                  <a:pt x="1676686" y="1738931"/>
                  <a:pt x="1465020" y="1774914"/>
                  <a:pt x="1309233" y="1829101"/>
                </a:cubicBezTo>
                <a:cubicBezTo>
                  <a:pt x="1153446" y="1883288"/>
                  <a:pt x="926116" y="1994201"/>
                  <a:pt x="775833" y="2121201"/>
                </a:cubicBezTo>
                <a:cubicBezTo>
                  <a:pt x="625550" y="2248201"/>
                  <a:pt x="432933" y="2584751"/>
                  <a:pt x="407533" y="2591101"/>
                </a:cubicBezTo>
                <a:cubicBezTo>
                  <a:pt x="382133" y="2597451"/>
                  <a:pt x="561298" y="2279661"/>
                  <a:pt x="623433" y="2159301"/>
                </a:cubicBezTo>
                <a:cubicBezTo>
                  <a:pt x="685568" y="2038941"/>
                  <a:pt x="1089799" y="1965036"/>
                  <a:pt x="780342" y="1868939"/>
                </a:cubicBezTo>
                <a:cubicBezTo>
                  <a:pt x="470885" y="1772842"/>
                  <a:pt x="28131" y="1552531"/>
                  <a:pt x="1133" y="1537001"/>
                </a:cubicBezTo>
                <a:cubicBezTo>
                  <a:pt x="-25865" y="1521471"/>
                  <a:pt x="436864" y="1731343"/>
                  <a:pt x="618353" y="1775761"/>
                </a:cubicBezTo>
                <a:cubicBezTo>
                  <a:pt x="799842" y="1820179"/>
                  <a:pt x="1072287" y="1851771"/>
                  <a:pt x="1090067" y="1803511"/>
                </a:cubicBezTo>
                <a:cubicBezTo>
                  <a:pt x="1107847" y="1755251"/>
                  <a:pt x="813389" y="1587769"/>
                  <a:pt x="725033" y="1486201"/>
                </a:cubicBezTo>
                <a:cubicBezTo>
                  <a:pt x="636677" y="1384633"/>
                  <a:pt x="530300" y="1170818"/>
                  <a:pt x="559933" y="1194101"/>
                </a:cubicBezTo>
                <a:cubicBezTo>
                  <a:pt x="589566" y="1217384"/>
                  <a:pt x="775833" y="1534884"/>
                  <a:pt x="902833" y="1625901"/>
                </a:cubicBezTo>
                <a:cubicBezTo>
                  <a:pt x="1029833" y="1716918"/>
                  <a:pt x="1167416" y="1738084"/>
                  <a:pt x="1321933" y="1740201"/>
                </a:cubicBezTo>
                <a:cubicBezTo>
                  <a:pt x="1476450" y="1742318"/>
                  <a:pt x="1699123" y="1668234"/>
                  <a:pt x="1829933" y="1638601"/>
                </a:cubicBezTo>
                <a:cubicBezTo>
                  <a:pt x="1960743" y="1608968"/>
                  <a:pt x="2039483" y="1602618"/>
                  <a:pt x="2106793" y="1562401"/>
                </a:cubicBezTo>
                <a:cubicBezTo>
                  <a:pt x="2174103" y="1522184"/>
                  <a:pt x="2278243" y="1522184"/>
                  <a:pt x="2233793" y="1397301"/>
                </a:cubicBezTo>
                <a:cubicBezTo>
                  <a:pt x="2189343" y="1272418"/>
                  <a:pt x="1810460" y="808868"/>
                  <a:pt x="1817233" y="775001"/>
                </a:cubicBezTo>
                <a:cubicBezTo>
                  <a:pt x="1824006" y="741134"/>
                  <a:pt x="2158016" y="1088268"/>
                  <a:pt x="2274433" y="119410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椭圆 30">
            <a:extLst>
              <a:ext uri="{FF2B5EF4-FFF2-40B4-BE49-F238E27FC236}">
                <a16:creationId xmlns:a16="http://schemas.microsoft.com/office/drawing/2014/main" id="{59B91EF4-E0F6-482E-9BCC-C7006591DB53}"/>
              </a:ext>
            </a:extLst>
          </p:cNvPr>
          <p:cNvSpPr/>
          <p:nvPr/>
        </p:nvSpPr>
        <p:spPr>
          <a:xfrm rot="15304263" flipV="1">
            <a:off x="1641264" y="10520224"/>
            <a:ext cx="119924" cy="72274"/>
          </a:xfrm>
          <a:prstGeom prst="ellipse">
            <a:avLst/>
          </a:prstGeom>
          <a:solidFill>
            <a:schemeClr val="accent2">
              <a:lumMod val="20000"/>
              <a:lumOff val="8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0" name="任意多边形: 形状 209">
            <a:extLst>
              <a:ext uri="{FF2B5EF4-FFF2-40B4-BE49-F238E27FC236}">
                <a16:creationId xmlns:a16="http://schemas.microsoft.com/office/drawing/2014/main" id="{11DE77AA-FADD-47A2-A1A8-7E12846CA7A1}"/>
              </a:ext>
            </a:extLst>
          </p:cNvPr>
          <p:cNvSpPr/>
          <p:nvPr/>
        </p:nvSpPr>
        <p:spPr>
          <a:xfrm rot="20343195">
            <a:off x="2042337" y="10412904"/>
            <a:ext cx="1419307" cy="272047"/>
          </a:xfrm>
          <a:custGeom>
            <a:avLst/>
            <a:gdLst>
              <a:gd name="connsiteX0" fmla="*/ 10605 w 2358367"/>
              <a:gd name="connsiteY0" fmla="*/ 265 h 468400"/>
              <a:gd name="connsiteX1" fmla="*/ 820230 w 2358367"/>
              <a:gd name="connsiteY1" fmla="*/ 371740 h 468400"/>
              <a:gd name="connsiteX2" fmla="*/ 2268030 w 2358367"/>
              <a:gd name="connsiteY2" fmla="*/ 438415 h 468400"/>
              <a:gd name="connsiteX3" fmla="*/ 2087055 w 2358367"/>
              <a:gd name="connsiteY3" fmla="*/ 466990 h 468400"/>
              <a:gd name="connsiteX4" fmla="*/ 1115505 w 2358367"/>
              <a:gd name="connsiteY4" fmla="*/ 447940 h 468400"/>
              <a:gd name="connsiteX5" fmla="*/ 410655 w 2358367"/>
              <a:gd name="connsiteY5" fmla="*/ 314590 h 468400"/>
              <a:gd name="connsiteX6" fmla="*/ 10605 w 2358367"/>
              <a:gd name="connsiteY6" fmla="*/ 265 h 468400"/>
              <a:gd name="connsiteX0" fmla="*/ 7359 w 2355121"/>
              <a:gd name="connsiteY0" fmla="*/ 705 h 468840"/>
              <a:gd name="connsiteX1" fmla="*/ 816984 w 2355121"/>
              <a:gd name="connsiteY1" fmla="*/ 372180 h 468840"/>
              <a:gd name="connsiteX2" fmla="*/ 2264784 w 2355121"/>
              <a:gd name="connsiteY2" fmla="*/ 438855 h 468840"/>
              <a:gd name="connsiteX3" fmla="*/ 2083809 w 2355121"/>
              <a:gd name="connsiteY3" fmla="*/ 467430 h 468840"/>
              <a:gd name="connsiteX4" fmla="*/ 1112259 w 2355121"/>
              <a:gd name="connsiteY4" fmla="*/ 448380 h 468840"/>
              <a:gd name="connsiteX5" fmla="*/ 458209 w 2355121"/>
              <a:gd name="connsiteY5" fmla="*/ 283280 h 468840"/>
              <a:gd name="connsiteX6" fmla="*/ 7359 w 2355121"/>
              <a:gd name="connsiteY6" fmla="*/ 705 h 468840"/>
              <a:gd name="connsiteX0" fmla="*/ 7359 w 2359922"/>
              <a:gd name="connsiteY0" fmla="*/ 705 h 460965"/>
              <a:gd name="connsiteX1" fmla="*/ 816984 w 2359922"/>
              <a:gd name="connsiteY1" fmla="*/ 372180 h 460965"/>
              <a:gd name="connsiteX2" fmla="*/ 2264784 w 2359922"/>
              <a:gd name="connsiteY2" fmla="*/ 438855 h 460965"/>
              <a:gd name="connsiteX3" fmla="*/ 2099684 w 2359922"/>
              <a:gd name="connsiteY3" fmla="*/ 451555 h 460965"/>
              <a:gd name="connsiteX4" fmla="*/ 1112259 w 2359922"/>
              <a:gd name="connsiteY4" fmla="*/ 448380 h 460965"/>
              <a:gd name="connsiteX5" fmla="*/ 458209 w 2359922"/>
              <a:gd name="connsiteY5" fmla="*/ 283280 h 460965"/>
              <a:gd name="connsiteX6" fmla="*/ 7359 w 2359922"/>
              <a:gd name="connsiteY6" fmla="*/ 705 h 460965"/>
              <a:gd name="connsiteX0" fmla="*/ 7319 w 2358699"/>
              <a:gd name="connsiteY0" fmla="*/ 696 h 452108"/>
              <a:gd name="connsiteX1" fmla="*/ 816944 w 2358699"/>
              <a:gd name="connsiteY1" fmla="*/ 372171 h 452108"/>
              <a:gd name="connsiteX2" fmla="*/ 2264744 w 2358699"/>
              <a:gd name="connsiteY2" fmla="*/ 438846 h 452108"/>
              <a:gd name="connsiteX3" fmla="*/ 2099644 w 2358699"/>
              <a:gd name="connsiteY3" fmla="*/ 451546 h 452108"/>
              <a:gd name="connsiteX4" fmla="*/ 1147144 w 2358699"/>
              <a:gd name="connsiteY4" fmla="*/ 429321 h 452108"/>
              <a:gd name="connsiteX5" fmla="*/ 458169 w 2358699"/>
              <a:gd name="connsiteY5" fmla="*/ 283271 h 452108"/>
              <a:gd name="connsiteX6" fmla="*/ 7319 w 2358699"/>
              <a:gd name="connsiteY6" fmla="*/ 696 h 4521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358699" h="452108">
                <a:moveTo>
                  <a:pt x="7319" y="696"/>
                </a:moveTo>
                <a:cubicBezTo>
                  <a:pt x="67115" y="15513"/>
                  <a:pt x="440707" y="299146"/>
                  <a:pt x="816944" y="372171"/>
                </a:cubicBezTo>
                <a:cubicBezTo>
                  <a:pt x="1193181" y="445196"/>
                  <a:pt x="2050961" y="425617"/>
                  <a:pt x="2264744" y="438846"/>
                </a:cubicBezTo>
                <a:cubicBezTo>
                  <a:pt x="2478527" y="452075"/>
                  <a:pt x="2285911" y="453134"/>
                  <a:pt x="2099644" y="451546"/>
                </a:cubicBezTo>
                <a:cubicBezTo>
                  <a:pt x="1913377" y="449959"/>
                  <a:pt x="1426544" y="454721"/>
                  <a:pt x="1147144" y="429321"/>
                </a:cubicBezTo>
                <a:cubicBezTo>
                  <a:pt x="867744" y="403921"/>
                  <a:pt x="648140" y="354708"/>
                  <a:pt x="458169" y="283271"/>
                </a:cubicBezTo>
                <a:cubicBezTo>
                  <a:pt x="268198" y="211834"/>
                  <a:pt x="-52477" y="-14121"/>
                  <a:pt x="7319" y="696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1" name="任意多边形: 形状 210">
            <a:extLst>
              <a:ext uri="{FF2B5EF4-FFF2-40B4-BE49-F238E27FC236}">
                <a16:creationId xmlns:a16="http://schemas.microsoft.com/office/drawing/2014/main" id="{E0D791F9-FA2C-4EFB-814A-31811BE2C128}"/>
              </a:ext>
            </a:extLst>
          </p:cNvPr>
          <p:cNvSpPr/>
          <p:nvPr/>
        </p:nvSpPr>
        <p:spPr>
          <a:xfrm rot="20343195">
            <a:off x="2109322" y="10657622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2" name="任意多边形: 形状 211">
            <a:extLst>
              <a:ext uri="{FF2B5EF4-FFF2-40B4-BE49-F238E27FC236}">
                <a16:creationId xmlns:a16="http://schemas.microsoft.com/office/drawing/2014/main" id="{331C1C4D-E498-4FC5-B5DB-B010BDB9E1D0}"/>
              </a:ext>
            </a:extLst>
          </p:cNvPr>
          <p:cNvSpPr/>
          <p:nvPr/>
        </p:nvSpPr>
        <p:spPr>
          <a:xfrm rot="19844408">
            <a:off x="2213851" y="10668916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3" name="任意多边形: 形状 212">
            <a:extLst>
              <a:ext uri="{FF2B5EF4-FFF2-40B4-BE49-F238E27FC236}">
                <a16:creationId xmlns:a16="http://schemas.microsoft.com/office/drawing/2014/main" id="{66636BCA-9CF7-4428-91AF-5091720A34AE}"/>
              </a:ext>
            </a:extLst>
          </p:cNvPr>
          <p:cNvSpPr/>
          <p:nvPr/>
        </p:nvSpPr>
        <p:spPr>
          <a:xfrm rot="19823107">
            <a:off x="2328292" y="10679937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4" name="任意多边形: 形状 213">
            <a:extLst>
              <a:ext uri="{FF2B5EF4-FFF2-40B4-BE49-F238E27FC236}">
                <a16:creationId xmlns:a16="http://schemas.microsoft.com/office/drawing/2014/main" id="{2337C1CC-D051-4C04-9CF3-06B14A83E64C}"/>
              </a:ext>
            </a:extLst>
          </p:cNvPr>
          <p:cNvSpPr/>
          <p:nvPr/>
        </p:nvSpPr>
        <p:spPr>
          <a:xfrm rot="19366806">
            <a:off x="2442673" y="10675477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5" name="任意多边形: 形状 214">
            <a:extLst>
              <a:ext uri="{FF2B5EF4-FFF2-40B4-BE49-F238E27FC236}">
                <a16:creationId xmlns:a16="http://schemas.microsoft.com/office/drawing/2014/main" id="{0332A868-8A89-442E-8DFB-EE737A366144}"/>
              </a:ext>
            </a:extLst>
          </p:cNvPr>
          <p:cNvSpPr/>
          <p:nvPr/>
        </p:nvSpPr>
        <p:spPr>
          <a:xfrm rot="19255354">
            <a:off x="2559878" y="10662670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6" name="任意多边形: 形状 215">
            <a:extLst>
              <a:ext uri="{FF2B5EF4-FFF2-40B4-BE49-F238E27FC236}">
                <a16:creationId xmlns:a16="http://schemas.microsoft.com/office/drawing/2014/main" id="{65634BA9-725E-4D5A-A156-F0A623158B7F}"/>
              </a:ext>
            </a:extLst>
          </p:cNvPr>
          <p:cNvSpPr/>
          <p:nvPr/>
        </p:nvSpPr>
        <p:spPr>
          <a:xfrm rot="18745153">
            <a:off x="2677274" y="10643478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7" name="任意多边形: 形状 216">
            <a:extLst>
              <a:ext uri="{FF2B5EF4-FFF2-40B4-BE49-F238E27FC236}">
                <a16:creationId xmlns:a16="http://schemas.microsoft.com/office/drawing/2014/main" id="{062B9A4D-BA71-4950-8A96-86F4C80680DF}"/>
              </a:ext>
            </a:extLst>
          </p:cNvPr>
          <p:cNvSpPr/>
          <p:nvPr/>
        </p:nvSpPr>
        <p:spPr>
          <a:xfrm rot="18483451">
            <a:off x="2787706" y="10605817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8" name="任意多边形: 形状 217">
            <a:extLst>
              <a:ext uri="{FF2B5EF4-FFF2-40B4-BE49-F238E27FC236}">
                <a16:creationId xmlns:a16="http://schemas.microsoft.com/office/drawing/2014/main" id="{325A4A0E-E216-4DE4-8161-04A1C9B98A10}"/>
              </a:ext>
            </a:extLst>
          </p:cNvPr>
          <p:cNvSpPr/>
          <p:nvPr/>
        </p:nvSpPr>
        <p:spPr>
          <a:xfrm rot="18483451">
            <a:off x="2898312" y="10563476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9" name="任意多边形: 形状 218">
            <a:extLst>
              <a:ext uri="{FF2B5EF4-FFF2-40B4-BE49-F238E27FC236}">
                <a16:creationId xmlns:a16="http://schemas.microsoft.com/office/drawing/2014/main" id="{F50FB9B4-A675-4D60-AB88-2FCDF4F82462}"/>
              </a:ext>
            </a:extLst>
          </p:cNvPr>
          <p:cNvSpPr/>
          <p:nvPr/>
        </p:nvSpPr>
        <p:spPr>
          <a:xfrm rot="18273607">
            <a:off x="3004644" y="10522771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0" name="任意多边形: 形状 219">
            <a:extLst>
              <a:ext uri="{FF2B5EF4-FFF2-40B4-BE49-F238E27FC236}">
                <a16:creationId xmlns:a16="http://schemas.microsoft.com/office/drawing/2014/main" id="{ACDBCB77-44EF-41C9-8B51-99C40001380F}"/>
              </a:ext>
            </a:extLst>
          </p:cNvPr>
          <p:cNvSpPr/>
          <p:nvPr/>
        </p:nvSpPr>
        <p:spPr>
          <a:xfrm rot="18418761">
            <a:off x="3107393" y="10482082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1" name="任意多边形: 形状 220">
            <a:extLst>
              <a:ext uri="{FF2B5EF4-FFF2-40B4-BE49-F238E27FC236}">
                <a16:creationId xmlns:a16="http://schemas.microsoft.com/office/drawing/2014/main" id="{16875432-E2F7-4957-AF56-C0F9539BBF08}"/>
              </a:ext>
            </a:extLst>
          </p:cNvPr>
          <p:cNvSpPr/>
          <p:nvPr/>
        </p:nvSpPr>
        <p:spPr>
          <a:xfrm rot="18619039">
            <a:off x="3214570" y="10447971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2" name="任意多边形: 形状 221">
            <a:extLst>
              <a:ext uri="{FF2B5EF4-FFF2-40B4-BE49-F238E27FC236}">
                <a16:creationId xmlns:a16="http://schemas.microsoft.com/office/drawing/2014/main" id="{30524BA3-9F7E-4C7D-831B-A8A3EF41BA09}"/>
              </a:ext>
            </a:extLst>
          </p:cNvPr>
          <p:cNvSpPr/>
          <p:nvPr/>
        </p:nvSpPr>
        <p:spPr>
          <a:xfrm rot="18637851">
            <a:off x="3316819" y="10408833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3" name="任意多边形: 形状 222">
            <a:extLst>
              <a:ext uri="{FF2B5EF4-FFF2-40B4-BE49-F238E27FC236}">
                <a16:creationId xmlns:a16="http://schemas.microsoft.com/office/drawing/2014/main" id="{FAAE208F-E58C-4ACC-8136-D827A2E59934}"/>
              </a:ext>
            </a:extLst>
          </p:cNvPr>
          <p:cNvSpPr/>
          <p:nvPr/>
        </p:nvSpPr>
        <p:spPr>
          <a:xfrm rot="20343195">
            <a:off x="1998713" y="10630439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4" name="任意多边形: 形状 223">
            <a:extLst>
              <a:ext uri="{FF2B5EF4-FFF2-40B4-BE49-F238E27FC236}">
                <a16:creationId xmlns:a16="http://schemas.microsoft.com/office/drawing/2014/main" id="{94867236-696F-492E-8AA5-CB2A856473D1}"/>
              </a:ext>
            </a:extLst>
          </p:cNvPr>
          <p:cNvSpPr/>
          <p:nvPr/>
        </p:nvSpPr>
        <p:spPr>
          <a:xfrm rot="20999418">
            <a:off x="1891172" y="10596350"/>
            <a:ext cx="102936" cy="83327"/>
          </a:xfrm>
          <a:custGeom>
            <a:avLst/>
            <a:gdLst>
              <a:gd name="connsiteX0" fmla="*/ 19379 w 149865"/>
              <a:gd name="connsiteY0" fmla="*/ 405 h 138551"/>
              <a:gd name="connsiteX1" fmla="*/ 9547 w 149865"/>
              <a:gd name="connsiteY1" fmla="*/ 59398 h 138551"/>
              <a:gd name="connsiteX2" fmla="*/ 107870 w 149865"/>
              <a:gd name="connsiteY2" fmla="*/ 138056 h 138551"/>
              <a:gd name="connsiteX3" fmla="*/ 147199 w 149865"/>
              <a:gd name="connsiteY3" fmla="*/ 88895 h 138551"/>
              <a:gd name="connsiteX4" fmla="*/ 19379 w 149865"/>
              <a:gd name="connsiteY4" fmla="*/ 405 h 138551"/>
              <a:gd name="connsiteX0" fmla="*/ 40580 w 171066"/>
              <a:gd name="connsiteY0" fmla="*/ 331 h 138477"/>
              <a:gd name="connsiteX1" fmla="*/ 4555 w 171066"/>
              <a:gd name="connsiteY1" fmla="*/ 61706 h 138477"/>
              <a:gd name="connsiteX2" fmla="*/ 129071 w 171066"/>
              <a:gd name="connsiteY2" fmla="*/ 137982 h 138477"/>
              <a:gd name="connsiteX3" fmla="*/ 168400 w 171066"/>
              <a:gd name="connsiteY3" fmla="*/ 88821 h 138477"/>
              <a:gd name="connsiteX4" fmla="*/ 40580 w 171066"/>
              <a:gd name="connsiteY4" fmla="*/ 331 h 138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066" h="138477">
                <a:moveTo>
                  <a:pt x="40580" y="331"/>
                </a:moveTo>
                <a:cubicBezTo>
                  <a:pt x="13273" y="-4188"/>
                  <a:pt x="-10194" y="38764"/>
                  <a:pt x="4555" y="61706"/>
                </a:cubicBezTo>
                <a:cubicBezTo>
                  <a:pt x="19304" y="84648"/>
                  <a:pt x="106129" y="133066"/>
                  <a:pt x="129071" y="137982"/>
                </a:cubicBezTo>
                <a:cubicBezTo>
                  <a:pt x="152013" y="142898"/>
                  <a:pt x="179871" y="110124"/>
                  <a:pt x="168400" y="88821"/>
                </a:cubicBezTo>
                <a:cubicBezTo>
                  <a:pt x="156929" y="67518"/>
                  <a:pt x="67887" y="4850"/>
                  <a:pt x="40580" y="33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任意多边形: 形状 37">
            <a:extLst>
              <a:ext uri="{FF2B5EF4-FFF2-40B4-BE49-F238E27FC236}">
                <a16:creationId xmlns:a16="http://schemas.microsoft.com/office/drawing/2014/main" id="{A4F0E574-16EC-4037-84DD-9D64C41EF36A}"/>
              </a:ext>
            </a:extLst>
          </p:cNvPr>
          <p:cNvSpPr/>
          <p:nvPr/>
        </p:nvSpPr>
        <p:spPr>
          <a:xfrm rot="21206442">
            <a:off x="3329457" y="10182792"/>
            <a:ext cx="584821" cy="593459"/>
          </a:xfrm>
          <a:custGeom>
            <a:avLst/>
            <a:gdLst>
              <a:gd name="connsiteX0" fmla="*/ 63520 w 1175567"/>
              <a:gd name="connsiteY0" fmla="*/ 432563 h 1195202"/>
              <a:gd name="connsiteX1" fmla="*/ 317520 w 1175567"/>
              <a:gd name="connsiteY1" fmla="*/ 330963 h 1195202"/>
              <a:gd name="connsiteX2" fmla="*/ 406420 w 1175567"/>
              <a:gd name="connsiteY2" fmla="*/ 96013 h 1195202"/>
              <a:gd name="connsiteX3" fmla="*/ 400070 w 1175567"/>
              <a:gd name="connsiteY3" fmla="*/ 51563 h 1195202"/>
              <a:gd name="connsiteX4" fmla="*/ 330220 w 1175567"/>
              <a:gd name="connsiteY4" fmla="*/ 356363 h 1195202"/>
              <a:gd name="connsiteX5" fmla="*/ 355620 w 1175567"/>
              <a:gd name="connsiteY5" fmla="*/ 369063 h 1195202"/>
              <a:gd name="connsiteX6" fmla="*/ 419120 w 1175567"/>
              <a:gd name="connsiteY6" fmla="*/ 375413 h 1195202"/>
              <a:gd name="connsiteX7" fmla="*/ 622320 w 1175567"/>
              <a:gd name="connsiteY7" fmla="*/ 318263 h 1195202"/>
              <a:gd name="connsiteX8" fmla="*/ 876320 w 1175567"/>
              <a:gd name="connsiteY8" fmla="*/ 26163 h 1195202"/>
              <a:gd name="connsiteX9" fmla="*/ 1085870 w 1175567"/>
              <a:gd name="connsiteY9" fmla="*/ 19813 h 1195202"/>
              <a:gd name="connsiteX10" fmla="*/ 857270 w 1175567"/>
              <a:gd name="connsiteY10" fmla="*/ 76963 h 1195202"/>
              <a:gd name="connsiteX11" fmla="*/ 736620 w 1175567"/>
              <a:gd name="connsiteY11" fmla="*/ 305563 h 1195202"/>
              <a:gd name="connsiteX12" fmla="*/ 482620 w 1175567"/>
              <a:gd name="connsiteY12" fmla="*/ 394463 h 1195202"/>
              <a:gd name="connsiteX13" fmla="*/ 298470 w 1175567"/>
              <a:gd name="connsiteY13" fmla="*/ 438913 h 1195202"/>
              <a:gd name="connsiteX14" fmla="*/ 527070 w 1175567"/>
              <a:gd name="connsiteY14" fmla="*/ 521463 h 1195202"/>
              <a:gd name="connsiteX15" fmla="*/ 749320 w 1175567"/>
              <a:gd name="connsiteY15" fmla="*/ 654813 h 1195202"/>
              <a:gd name="connsiteX16" fmla="*/ 996970 w 1175567"/>
              <a:gd name="connsiteY16" fmla="*/ 591313 h 1195202"/>
              <a:gd name="connsiteX17" fmla="*/ 1174770 w 1175567"/>
              <a:gd name="connsiteY17" fmla="*/ 731013 h 1195202"/>
              <a:gd name="connsiteX18" fmla="*/ 927120 w 1175567"/>
              <a:gd name="connsiteY18" fmla="*/ 642113 h 1195202"/>
              <a:gd name="connsiteX19" fmla="*/ 800120 w 1175567"/>
              <a:gd name="connsiteY19" fmla="*/ 705613 h 1195202"/>
              <a:gd name="connsiteX20" fmla="*/ 450870 w 1175567"/>
              <a:gd name="connsiteY20" fmla="*/ 591313 h 1195202"/>
              <a:gd name="connsiteX21" fmla="*/ 501670 w 1175567"/>
              <a:gd name="connsiteY21" fmla="*/ 737363 h 1195202"/>
              <a:gd name="connsiteX22" fmla="*/ 730270 w 1175567"/>
              <a:gd name="connsiteY22" fmla="*/ 1054863 h 1195202"/>
              <a:gd name="connsiteX23" fmla="*/ 577870 w 1175567"/>
              <a:gd name="connsiteY23" fmla="*/ 908813 h 1195202"/>
              <a:gd name="connsiteX24" fmla="*/ 387370 w 1175567"/>
              <a:gd name="connsiteY24" fmla="*/ 610363 h 1195202"/>
              <a:gd name="connsiteX25" fmla="*/ 241320 w 1175567"/>
              <a:gd name="connsiteY25" fmla="*/ 496063 h 1195202"/>
              <a:gd name="connsiteX26" fmla="*/ 228620 w 1175567"/>
              <a:gd name="connsiteY26" fmla="*/ 705613 h 1195202"/>
              <a:gd name="connsiteX27" fmla="*/ 317520 w 1175567"/>
              <a:gd name="connsiteY27" fmla="*/ 915163 h 1195202"/>
              <a:gd name="connsiteX28" fmla="*/ 222270 w 1175567"/>
              <a:gd name="connsiteY28" fmla="*/ 1143763 h 1195202"/>
              <a:gd name="connsiteX29" fmla="*/ 120670 w 1175567"/>
              <a:gd name="connsiteY29" fmla="*/ 1194563 h 1195202"/>
              <a:gd name="connsiteX30" fmla="*/ 190520 w 1175567"/>
              <a:gd name="connsiteY30" fmla="*/ 1124713 h 1195202"/>
              <a:gd name="connsiteX31" fmla="*/ 266720 w 1175567"/>
              <a:gd name="connsiteY31" fmla="*/ 940563 h 1195202"/>
              <a:gd name="connsiteX32" fmla="*/ 247670 w 1175567"/>
              <a:gd name="connsiteY32" fmla="*/ 826263 h 1195202"/>
              <a:gd name="connsiteX33" fmla="*/ 127020 w 1175567"/>
              <a:gd name="connsiteY33" fmla="*/ 921513 h 1195202"/>
              <a:gd name="connsiteX34" fmla="*/ 76220 w 1175567"/>
              <a:gd name="connsiteY34" fmla="*/ 1143763 h 1195202"/>
              <a:gd name="connsiteX35" fmla="*/ 20 w 1175567"/>
              <a:gd name="connsiteY35" fmla="*/ 1169163 h 1195202"/>
              <a:gd name="connsiteX36" fmla="*/ 69870 w 1175567"/>
              <a:gd name="connsiteY36" fmla="*/ 902463 h 1195202"/>
              <a:gd name="connsiteX37" fmla="*/ 184170 w 1175567"/>
              <a:gd name="connsiteY37" fmla="*/ 718313 h 1195202"/>
              <a:gd name="connsiteX38" fmla="*/ 101620 w 1175567"/>
              <a:gd name="connsiteY38" fmla="*/ 483363 h 1195202"/>
              <a:gd name="connsiteX39" fmla="*/ 63520 w 1175567"/>
              <a:gd name="connsiteY39" fmla="*/ 432563 h 1195202"/>
              <a:gd name="connsiteX0" fmla="*/ 63811 w 1175858"/>
              <a:gd name="connsiteY0" fmla="*/ 432563 h 1195202"/>
              <a:gd name="connsiteX1" fmla="*/ 317811 w 1175858"/>
              <a:gd name="connsiteY1" fmla="*/ 330963 h 1195202"/>
              <a:gd name="connsiteX2" fmla="*/ 406711 w 1175858"/>
              <a:gd name="connsiteY2" fmla="*/ 96013 h 1195202"/>
              <a:gd name="connsiteX3" fmla="*/ 400361 w 1175858"/>
              <a:gd name="connsiteY3" fmla="*/ 51563 h 1195202"/>
              <a:gd name="connsiteX4" fmla="*/ 330511 w 1175858"/>
              <a:gd name="connsiteY4" fmla="*/ 356363 h 1195202"/>
              <a:gd name="connsiteX5" fmla="*/ 355911 w 1175858"/>
              <a:gd name="connsiteY5" fmla="*/ 369063 h 1195202"/>
              <a:gd name="connsiteX6" fmla="*/ 419411 w 1175858"/>
              <a:gd name="connsiteY6" fmla="*/ 375413 h 1195202"/>
              <a:gd name="connsiteX7" fmla="*/ 622611 w 1175858"/>
              <a:gd name="connsiteY7" fmla="*/ 318263 h 1195202"/>
              <a:gd name="connsiteX8" fmla="*/ 876611 w 1175858"/>
              <a:gd name="connsiteY8" fmla="*/ 26163 h 1195202"/>
              <a:gd name="connsiteX9" fmla="*/ 1086161 w 1175858"/>
              <a:gd name="connsiteY9" fmla="*/ 19813 h 1195202"/>
              <a:gd name="connsiteX10" fmla="*/ 857561 w 1175858"/>
              <a:gd name="connsiteY10" fmla="*/ 76963 h 1195202"/>
              <a:gd name="connsiteX11" fmla="*/ 736911 w 1175858"/>
              <a:gd name="connsiteY11" fmla="*/ 305563 h 1195202"/>
              <a:gd name="connsiteX12" fmla="*/ 482911 w 1175858"/>
              <a:gd name="connsiteY12" fmla="*/ 394463 h 1195202"/>
              <a:gd name="connsiteX13" fmla="*/ 298761 w 1175858"/>
              <a:gd name="connsiteY13" fmla="*/ 438913 h 1195202"/>
              <a:gd name="connsiteX14" fmla="*/ 527361 w 1175858"/>
              <a:gd name="connsiteY14" fmla="*/ 521463 h 1195202"/>
              <a:gd name="connsiteX15" fmla="*/ 749611 w 1175858"/>
              <a:gd name="connsiteY15" fmla="*/ 654813 h 1195202"/>
              <a:gd name="connsiteX16" fmla="*/ 997261 w 1175858"/>
              <a:gd name="connsiteY16" fmla="*/ 591313 h 1195202"/>
              <a:gd name="connsiteX17" fmla="*/ 1175061 w 1175858"/>
              <a:gd name="connsiteY17" fmla="*/ 731013 h 1195202"/>
              <a:gd name="connsiteX18" fmla="*/ 927411 w 1175858"/>
              <a:gd name="connsiteY18" fmla="*/ 642113 h 1195202"/>
              <a:gd name="connsiteX19" fmla="*/ 800411 w 1175858"/>
              <a:gd name="connsiteY19" fmla="*/ 705613 h 1195202"/>
              <a:gd name="connsiteX20" fmla="*/ 451161 w 1175858"/>
              <a:gd name="connsiteY20" fmla="*/ 591313 h 1195202"/>
              <a:gd name="connsiteX21" fmla="*/ 501961 w 1175858"/>
              <a:gd name="connsiteY21" fmla="*/ 737363 h 1195202"/>
              <a:gd name="connsiteX22" fmla="*/ 730561 w 1175858"/>
              <a:gd name="connsiteY22" fmla="*/ 1054863 h 1195202"/>
              <a:gd name="connsiteX23" fmla="*/ 578161 w 1175858"/>
              <a:gd name="connsiteY23" fmla="*/ 908813 h 1195202"/>
              <a:gd name="connsiteX24" fmla="*/ 387661 w 1175858"/>
              <a:gd name="connsiteY24" fmla="*/ 610363 h 1195202"/>
              <a:gd name="connsiteX25" fmla="*/ 241611 w 1175858"/>
              <a:gd name="connsiteY25" fmla="*/ 496063 h 1195202"/>
              <a:gd name="connsiteX26" fmla="*/ 228911 w 1175858"/>
              <a:gd name="connsiteY26" fmla="*/ 705613 h 1195202"/>
              <a:gd name="connsiteX27" fmla="*/ 317811 w 1175858"/>
              <a:gd name="connsiteY27" fmla="*/ 915163 h 1195202"/>
              <a:gd name="connsiteX28" fmla="*/ 222561 w 1175858"/>
              <a:gd name="connsiteY28" fmla="*/ 1143763 h 1195202"/>
              <a:gd name="connsiteX29" fmla="*/ 120961 w 1175858"/>
              <a:gd name="connsiteY29" fmla="*/ 1194563 h 1195202"/>
              <a:gd name="connsiteX30" fmla="*/ 190811 w 1175858"/>
              <a:gd name="connsiteY30" fmla="*/ 1124713 h 1195202"/>
              <a:gd name="connsiteX31" fmla="*/ 267011 w 1175858"/>
              <a:gd name="connsiteY31" fmla="*/ 940563 h 1195202"/>
              <a:gd name="connsiteX32" fmla="*/ 247961 w 1175858"/>
              <a:gd name="connsiteY32" fmla="*/ 826263 h 1195202"/>
              <a:gd name="connsiteX33" fmla="*/ 127311 w 1175858"/>
              <a:gd name="connsiteY33" fmla="*/ 921513 h 1195202"/>
              <a:gd name="connsiteX34" fmla="*/ 47936 w 1175858"/>
              <a:gd name="connsiteY34" fmla="*/ 1091375 h 1195202"/>
              <a:gd name="connsiteX35" fmla="*/ 311 w 1175858"/>
              <a:gd name="connsiteY35" fmla="*/ 1169163 h 1195202"/>
              <a:gd name="connsiteX36" fmla="*/ 70161 w 1175858"/>
              <a:gd name="connsiteY36" fmla="*/ 902463 h 1195202"/>
              <a:gd name="connsiteX37" fmla="*/ 184461 w 1175858"/>
              <a:gd name="connsiteY37" fmla="*/ 718313 h 1195202"/>
              <a:gd name="connsiteX38" fmla="*/ 101911 w 1175858"/>
              <a:gd name="connsiteY38" fmla="*/ 483363 h 1195202"/>
              <a:gd name="connsiteX39" fmla="*/ 63811 w 1175858"/>
              <a:gd name="connsiteY39" fmla="*/ 432563 h 1195202"/>
              <a:gd name="connsiteX0" fmla="*/ 63861 w 1175908"/>
              <a:gd name="connsiteY0" fmla="*/ 432563 h 1195202"/>
              <a:gd name="connsiteX1" fmla="*/ 317861 w 1175908"/>
              <a:gd name="connsiteY1" fmla="*/ 330963 h 1195202"/>
              <a:gd name="connsiteX2" fmla="*/ 406761 w 1175908"/>
              <a:gd name="connsiteY2" fmla="*/ 96013 h 1195202"/>
              <a:gd name="connsiteX3" fmla="*/ 400411 w 1175908"/>
              <a:gd name="connsiteY3" fmla="*/ 51563 h 1195202"/>
              <a:gd name="connsiteX4" fmla="*/ 330561 w 1175908"/>
              <a:gd name="connsiteY4" fmla="*/ 356363 h 1195202"/>
              <a:gd name="connsiteX5" fmla="*/ 355961 w 1175908"/>
              <a:gd name="connsiteY5" fmla="*/ 369063 h 1195202"/>
              <a:gd name="connsiteX6" fmla="*/ 419461 w 1175908"/>
              <a:gd name="connsiteY6" fmla="*/ 375413 h 1195202"/>
              <a:gd name="connsiteX7" fmla="*/ 622661 w 1175908"/>
              <a:gd name="connsiteY7" fmla="*/ 318263 h 1195202"/>
              <a:gd name="connsiteX8" fmla="*/ 876661 w 1175908"/>
              <a:gd name="connsiteY8" fmla="*/ 26163 h 1195202"/>
              <a:gd name="connsiteX9" fmla="*/ 1086211 w 1175908"/>
              <a:gd name="connsiteY9" fmla="*/ 19813 h 1195202"/>
              <a:gd name="connsiteX10" fmla="*/ 857611 w 1175908"/>
              <a:gd name="connsiteY10" fmla="*/ 76963 h 1195202"/>
              <a:gd name="connsiteX11" fmla="*/ 736961 w 1175908"/>
              <a:gd name="connsiteY11" fmla="*/ 305563 h 1195202"/>
              <a:gd name="connsiteX12" fmla="*/ 482961 w 1175908"/>
              <a:gd name="connsiteY12" fmla="*/ 394463 h 1195202"/>
              <a:gd name="connsiteX13" fmla="*/ 298811 w 1175908"/>
              <a:gd name="connsiteY13" fmla="*/ 438913 h 1195202"/>
              <a:gd name="connsiteX14" fmla="*/ 527411 w 1175908"/>
              <a:gd name="connsiteY14" fmla="*/ 521463 h 1195202"/>
              <a:gd name="connsiteX15" fmla="*/ 749661 w 1175908"/>
              <a:gd name="connsiteY15" fmla="*/ 654813 h 1195202"/>
              <a:gd name="connsiteX16" fmla="*/ 997311 w 1175908"/>
              <a:gd name="connsiteY16" fmla="*/ 591313 h 1195202"/>
              <a:gd name="connsiteX17" fmla="*/ 1175111 w 1175908"/>
              <a:gd name="connsiteY17" fmla="*/ 731013 h 1195202"/>
              <a:gd name="connsiteX18" fmla="*/ 927461 w 1175908"/>
              <a:gd name="connsiteY18" fmla="*/ 642113 h 1195202"/>
              <a:gd name="connsiteX19" fmla="*/ 800461 w 1175908"/>
              <a:gd name="connsiteY19" fmla="*/ 705613 h 1195202"/>
              <a:gd name="connsiteX20" fmla="*/ 451211 w 1175908"/>
              <a:gd name="connsiteY20" fmla="*/ 591313 h 1195202"/>
              <a:gd name="connsiteX21" fmla="*/ 502011 w 1175908"/>
              <a:gd name="connsiteY21" fmla="*/ 737363 h 1195202"/>
              <a:gd name="connsiteX22" fmla="*/ 730611 w 1175908"/>
              <a:gd name="connsiteY22" fmla="*/ 1054863 h 1195202"/>
              <a:gd name="connsiteX23" fmla="*/ 578211 w 1175908"/>
              <a:gd name="connsiteY23" fmla="*/ 908813 h 1195202"/>
              <a:gd name="connsiteX24" fmla="*/ 387711 w 1175908"/>
              <a:gd name="connsiteY24" fmla="*/ 610363 h 1195202"/>
              <a:gd name="connsiteX25" fmla="*/ 241661 w 1175908"/>
              <a:gd name="connsiteY25" fmla="*/ 496063 h 1195202"/>
              <a:gd name="connsiteX26" fmla="*/ 228961 w 1175908"/>
              <a:gd name="connsiteY26" fmla="*/ 705613 h 1195202"/>
              <a:gd name="connsiteX27" fmla="*/ 317861 w 1175908"/>
              <a:gd name="connsiteY27" fmla="*/ 915163 h 1195202"/>
              <a:gd name="connsiteX28" fmla="*/ 222611 w 1175908"/>
              <a:gd name="connsiteY28" fmla="*/ 1143763 h 1195202"/>
              <a:gd name="connsiteX29" fmla="*/ 121011 w 1175908"/>
              <a:gd name="connsiteY29" fmla="*/ 1194563 h 1195202"/>
              <a:gd name="connsiteX30" fmla="*/ 190861 w 1175908"/>
              <a:gd name="connsiteY30" fmla="*/ 1124713 h 1195202"/>
              <a:gd name="connsiteX31" fmla="*/ 267061 w 1175908"/>
              <a:gd name="connsiteY31" fmla="*/ 940563 h 1195202"/>
              <a:gd name="connsiteX32" fmla="*/ 248011 w 1175908"/>
              <a:gd name="connsiteY32" fmla="*/ 826263 h 1195202"/>
              <a:gd name="connsiteX33" fmla="*/ 155936 w 1175908"/>
              <a:gd name="connsiteY33" fmla="*/ 888176 h 1195202"/>
              <a:gd name="connsiteX34" fmla="*/ 47986 w 1175908"/>
              <a:gd name="connsiteY34" fmla="*/ 1091375 h 1195202"/>
              <a:gd name="connsiteX35" fmla="*/ 361 w 1175908"/>
              <a:gd name="connsiteY35" fmla="*/ 1169163 h 1195202"/>
              <a:gd name="connsiteX36" fmla="*/ 70211 w 1175908"/>
              <a:gd name="connsiteY36" fmla="*/ 902463 h 1195202"/>
              <a:gd name="connsiteX37" fmla="*/ 184511 w 1175908"/>
              <a:gd name="connsiteY37" fmla="*/ 718313 h 1195202"/>
              <a:gd name="connsiteX38" fmla="*/ 101961 w 1175908"/>
              <a:gd name="connsiteY38" fmla="*/ 483363 h 1195202"/>
              <a:gd name="connsiteX39" fmla="*/ 63861 w 1175908"/>
              <a:gd name="connsiteY39" fmla="*/ 432563 h 1195202"/>
              <a:gd name="connsiteX0" fmla="*/ 65644 w 1177691"/>
              <a:gd name="connsiteY0" fmla="*/ 432563 h 1195202"/>
              <a:gd name="connsiteX1" fmla="*/ 319644 w 1177691"/>
              <a:gd name="connsiteY1" fmla="*/ 330963 h 1195202"/>
              <a:gd name="connsiteX2" fmla="*/ 408544 w 1177691"/>
              <a:gd name="connsiteY2" fmla="*/ 96013 h 1195202"/>
              <a:gd name="connsiteX3" fmla="*/ 402194 w 1177691"/>
              <a:gd name="connsiteY3" fmla="*/ 51563 h 1195202"/>
              <a:gd name="connsiteX4" fmla="*/ 332344 w 1177691"/>
              <a:gd name="connsiteY4" fmla="*/ 356363 h 1195202"/>
              <a:gd name="connsiteX5" fmla="*/ 357744 w 1177691"/>
              <a:gd name="connsiteY5" fmla="*/ 369063 h 1195202"/>
              <a:gd name="connsiteX6" fmla="*/ 421244 w 1177691"/>
              <a:gd name="connsiteY6" fmla="*/ 375413 h 1195202"/>
              <a:gd name="connsiteX7" fmla="*/ 624444 w 1177691"/>
              <a:gd name="connsiteY7" fmla="*/ 318263 h 1195202"/>
              <a:gd name="connsiteX8" fmla="*/ 878444 w 1177691"/>
              <a:gd name="connsiteY8" fmla="*/ 26163 h 1195202"/>
              <a:gd name="connsiteX9" fmla="*/ 1087994 w 1177691"/>
              <a:gd name="connsiteY9" fmla="*/ 19813 h 1195202"/>
              <a:gd name="connsiteX10" fmla="*/ 859394 w 1177691"/>
              <a:gd name="connsiteY10" fmla="*/ 76963 h 1195202"/>
              <a:gd name="connsiteX11" fmla="*/ 738744 w 1177691"/>
              <a:gd name="connsiteY11" fmla="*/ 305563 h 1195202"/>
              <a:gd name="connsiteX12" fmla="*/ 484744 w 1177691"/>
              <a:gd name="connsiteY12" fmla="*/ 394463 h 1195202"/>
              <a:gd name="connsiteX13" fmla="*/ 300594 w 1177691"/>
              <a:gd name="connsiteY13" fmla="*/ 438913 h 1195202"/>
              <a:gd name="connsiteX14" fmla="*/ 529194 w 1177691"/>
              <a:gd name="connsiteY14" fmla="*/ 521463 h 1195202"/>
              <a:gd name="connsiteX15" fmla="*/ 751444 w 1177691"/>
              <a:gd name="connsiteY15" fmla="*/ 654813 h 1195202"/>
              <a:gd name="connsiteX16" fmla="*/ 999094 w 1177691"/>
              <a:gd name="connsiteY16" fmla="*/ 591313 h 1195202"/>
              <a:gd name="connsiteX17" fmla="*/ 1176894 w 1177691"/>
              <a:gd name="connsiteY17" fmla="*/ 731013 h 1195202"/>
              <a:gd name="connsiteX18" fmla="*/ 929244 w 1177691"/>
              <a:gd name="connsiteY18" fmla="*/ 642113 h 1195202"/>
              <a:gd name="connsiteX19" fmla="*/ 802244 w 1177691"/>
              <a:gd name="connsiteY19" fmla="*/ 705613 h 1195202"/>
              <a:gd name="connsiteX20" fmla="*/ 452994 w 1177691"/>
              <a:gd name="connsiteY20" fmla="*/ 591313 h 1195202"/>
              <a:gd name="connsiteX21" fmla="*/ 503794 w 1177691"/>
              <a:gd name="connsiteY21" fmla="*/ 737363 h 1195202"/>
              <a:gd name="connsiteX22" fmla="*/ 732394 w 1177691"/>
              <a:gd name="connsiteY22" fmla="*/ 1054863 h 1195202"/>
              <a:gd name="connsiteX23" fmla="*/ 579994 w 1177691"/>
              <a:gd name="connsiteY23" fmla="*/ 908813 h 1195202"/>
              <a:gd name="connsiteX24" fmla="*/ 389494 w 1177691"/>
              <a:gd name="connsiteY24" fmla="*/ 610363 h 1195202"/>
              <a:gd name="connsiteX25" fmla="*/ 243444 w 1177691"/>
              <a:gd name="connsiteY25" fmla="*/ 496063 h 1195202"/>
              <a:gd name="connsiteX26" fmla="*/ 230744 w 1177691"/>
              <a:gd name="connsiteY26" fmla="*/ 705613 h 1195202"/>
              <a:gd name="connsiteX27" fmla="*/ 319644 w 1177691"/>
              <a:gd name="connsiteY27" fmla="*/ 915163 h 1195202"/>
              <a:gd name="connsiteX28" fmla="*/ 224394 w 1177691"/>
              <a:gd name="connsiteY28" fmla="*/ 1143763 h 1195202"/>
              <a:gd name="connsiteX29" fmla="*/ 122794 w 1177691"/>
              <a:gd name="connsiteY29" fmla="*/ 1194563 h 1195202"/>
              <a:gd name="connsiteX30" fmla="*/ 192644 w 1177691"/>
              <a:gd name="connsiteY30" fmla="*/ 1124713 h 1195202"/>
              <a:gd name="connsiteX31" fmla="*/ 268844 w 1177691"/>
              <a:gd name="connsiteY31" fmla="*/ 940563 h 1195202"/>
              <a:gd name="connsiteX32" fmla="*/ 249794 w 1177691"/>
              <a:gd name="connsiteY32" fmla="*/ 826263 h 1195202"/>
              <a:gd name="connsiteX33" fmla="*/ 157719 w 1177691"/>
              <a:gd name="connsiteY33" fmla="*/ 888176 h 1195202"/>
              <a:gd name="connsiteX34" fmla="*/ 49769 w 1177691"/>
              <a:gd name="connsiteY34" fmla="*/ 1091375 h 1195202"/>
              <a:gd name="connsiteX35" fmla="*/ 2144 w 1177691"/>
              <a:gd name="connsiteY35" fmla="*/ 1169163 h 1195202"/>
              <a:gd name="connsiteX36" fmla="*/ 114857 w 1177691"/>
              <a:gd name="connsiteY36" fmla="*/ 897700 h 1195202"/>
              <a:gd name="connsiteX37" fmla="*/ 186294 w 1177691"/>
              <a:gd name="connsiteY37" fmla="*/ 718313 h 1195202"/>
              <a:gd name="connsiteX38" fmla="*/ 103744 w 1177691"/>
              <a:gd name="connsiteY38" fmla="*/ 483363 h 1195202"/>
              <a:gd name="connsiteX39" fmla="*/ 65644 w 1177691"/>
              <a:gd name="connsiteY39" fmla="*/ 432563 h 1195202"/>
              <a:gd name="connsiteX0" fmla="*/ 65644 w 1177691"/>
              <a:gd name="connsiteY0" fmla="*/ 432563 h 1195202"/>
              <a:gd name="connsiteX1" fmla="*/ 319644 w 1177691"/>
              <a:gd name="connsiteY1" fmla="*/ 330963 h 1195202"/>
              <a:gd name="connsiteX2" fmla="*/ 408544 w 1177691"/>
              <a:gd name="connsiteY2" fmla="*/ 96013 h 1195202"/>
              <a:gd name="connsiteX3" fmla="*/ 402194 w 1177691"/>
              <a:gd name="connsiteY3" fmla="*/ 51563 h 1195202"/>
              <a:gd name="connsiteX4" fmla="*/ 332344 w 1177691"/>
              <a:gd name="connsiteY4" fmla="*/ 356363 h 1195202"/>
              <a:gd name="connsiteX5" fmla="*/ 357744 w 1177691"/>
              <a:gd name="connsiteY5" fmla="*/ 369063 h 1195202"/>
              <a:gd name="connsiteX6" fmla="*/ 421244 w 1177691"/>
              <a:gd name="connsiteY6" fmla="*/ 375413 h 1195202"/>
              <a:gd name="connsiteX7" fmla="*/ 624444 w 1177691"/>
              <a:gd name="connsiteY7" fmla="*/ 318263 h 1195202"/>
              <a:gd name="connsiteX8" fmla="*/ 878444 w 1177691"/>
              <a:gd name="connsiteY8" fmla="*/ 26163 h 1195202"/>
              <a:gd name="connsiteX9" fmla="*/ 1087994 w 1177691"/>
              <a:gd name="connsiteY9" fmla="*/ 19813 h 1195202"/>
              <a:gd name="connsiteX10" fmla="*/ 859394 w 1177691"/>
              <a:gd name="connsiteY10" fmla="*/ 76963 h 1195202"/>
              <a:gd name="connsiteX11" fmla="*/ 738744 w 1177691"/>
              <a:gd name="connsiteY11" fmla="*/ 305563 h 1195202"/>
              <a:gd name="connsiteX12" fmla="*/ 484744 w 1177691"/>
              <a:gd name="connsiteY12" fmla="*/ 394463 h 1195202"/>
              <a:gd name="connsiteX13" fmla="*/ 300594 w 1177691"/>
              <a:gd name="connsiteY13" fmla="*/ 438913 h 1195202"/>
              <a:gd name="connsiteX14" fmla="*/ 529194 w 1177691"/>
              <a:gd name="connsiteY14" fmla="*/ 521463 h 1195202"/>
              <a:gd name="connsiteX15" fmla="*/ 751444 w 1177691"/>
              <a:gd name="connsiteY15" fmla="*/ 654813 h 1195202"/>
              <a:gd name="connsiteX16" fmla="*/ 999094 w 1177691"/>
              <a:gd name="connsiteY16" fmla="*/ 591313 h 1195202"/>
              <a:gd name="connsiteX17" fmla="*/ 1176894 w 1177691"/>
              <a:gd name="connsiteY17" fmla="*/ 731013 h 1195202"/>
              <a:gd name="connsiteX18" fmla="*/ 929244 w 1177691"/>
              <a:gd name="connsiteY18" fmla="*/ 642113 h 1195202"/>
              <a:gd name="connsiteX19" fmla="*/ 802244 w 1177691"/>
              <a:gd name="connsiteY19" fmla="*/ 705613 h 1195202"/>
              <a:gd name="connsiteX20" fmla="*/ 452994 w 1177691"/>
              <a:gd name="connsiteY20" fmla="*/ 591313 h 1195202"/>
              <a:gd name="connsiteX21" fmla="*/ 503794 w 1177691"/>
              <a:gd name="connsiteY21" fmla="*/ 737363 h 1195202"/>
              <a:gd name="connsiteX22" fmla="*/ 732394 w 1177691"/>
              <a:gd name="connsiteY22" fmla="*/ 1054863 h 1195202"/>
              <a:gd name="connsiteX23" fmla="*/ 579994 w 1177691"/>
              <a:gd name="connsiteY23" fmla="*/ 908813 h 1195202"/>
              <a:gd name="connsiteX24" fmla="*/ 389494 w 1177691"/>
              <a:gd name="connsiteY24" fmla="*/ 610363 h 1195202"/>
              <a:gd name="connsiteX25" fmla="*/ 243444 w 1177691"/>
              <a:gd name="connsiteY25" fmla="*/ 496063 h 1195202"/>
              <a:gd name="connsiteX26" fmla="*/ 230744 w 1177691"/>
              <a:gd name="connsiteY26" fmla="*/ 705613 h 1195202"/>
              <a:gd name="connsiteX27" fmla="*/ 319644 w 1177691"/>
              <a:gd name="connsiteY27" fmla="*/ 915163 h 1195202"/>
              <a:gd name="connsiteX28" fmla="*/ 224394 w 1177691"/>
              <a:gd name="connsiteY28" fmla="*/ 1143763 h 1195202"/>
              <a:gd name="connsiteX29" fmla="*/ 122794 w 1177691"/>
              <a:gd name="connsiteY29" fmla="*/ 1194563 h 1195202"/>
              <a:gd name="connsiteX30" fmla="*/ 192644 w 1177691"/>
              <a:gd name="connsiteY30" fmla="*/ 1124713 h 1195202"/>
              <a:gd name="connsiteX31" fmla="*/ 268844 w 1177691"/>
              <a:gd name="connsiteY31" fmla="*/ 940563 h 1195202"/>
              <a:gd name="connsiteX32" fmla="*/ 206931 w 1177691"/>
              <a:gd name="connsiteY32" fmla="*/ 807213 h 1195202"/>
              <a:gd name="connsiteX33" fmla="*/ 157719 w 1177691"/>
              <a:gd name="connsiteY33" fmla="*/ 888176 h 1195202"/>
              <a:gd name="connsiteX34" fmla="*/ 49769 w 1177691"/>
              <a:gd name="connsiteY34" fmla="*/ 1091375 h 1195202"/>
              <a:gd name="connsiteX35" fmla="*/ 2144 w 1177691"/>
              <a:gd name="connsiteY35" fmla="*/ 1169163 h 1195202"/>
              <a:gd name="connsiteX36" fmla="*/ 114857 w 1177691"/>
              <a:gd name="connsiteY36" fmla="*/ 897700 h 1195202"/>
              <a:gd name="connsiteX37" fmla="*/ 186294 w 1177691"/>
              <a:gd name="connsiteY37" fmla="*/ 718313 h 1195202"/>
              <a:gd name="connsiteX38" fmla="*/ 103744 w 1177691"/>
              <a:gd name="connsiteY38" fmla="*/ 483363 h 1195202"/>
              <a:gd name="connsiteX39" fmla="*/ 65644 w 1177691"/>
              <a:gd name="connsiteY39" fmla="*/ 432563 h 1195202"/>
              <a:gd name="connsiteX0" fmla="*/ 65644 w 1177691"/>
              <a:gd name="connsiteY0" fmla="*/ 432563 h 1195202"/>
              <a:gd name="connsiteX1" fmla="*/ 319644 w 1177691"/>
              <a:gd name="connsiteY1" fmla="*/ 330963 h 1195202"/>
              <a:gd name="connsiteX2" fmla="*/ 408544 w 1177691"/>
              <a:gd name="connsiteY2" fmla="*/ 96013 h 1195202"/>
              <a:gd name="connsiteX3" fmla="*/ 402194 w 1177691"/>
              <a:gd name="connsiteY3" fmla="*/ 51563 h 1195202"/>
              <a:gd name="connsiteX4" fmla="*/ 332344 w 1177691"/>
              <a:gd name="connsiteY4" fmla="*/ 356363 h 1195202"/>
              <a:gd name="connsiteX5" fmla="*/ 357744 w 1177691"/>
              <a:gd name="connsiteY5" fmla="*/ 369063 h 1195202"/>
              <a:gd name="connsiteX6" fmla="*/ 421244 w 1177691"/>
              <a:gd name="connsiteY6" fmla="*/ 375413 h 1195202"/>
              <a:gd name="connsiteX7" fmla="*/ 624444 w 1177691"/>
              <a:gd name="connsiteY7" fmla="*/ 318263 h 1195202"/>
              <a:gd name="connsiteX8" fmla="*/ 878444 w 1177691"/>
              <a:gd name="connsiteY8" fmla="*/ 26163 h 1195202"/>
              <a:gd name="connsiteX9" fmla="*/ 1087994 w 1177691"/>
              <a:gd name="connsiteY9" fmla="*/ 19813 h 1195202"/>
              <a:gd name="connsiteX10" fmla="*/ 859394 w 1177691"/>
              <a:gd name="connsiteY10" fmla="*/ 76963 h 1195202"/>
              <a:gd name="connsiteX11" fmla="*/ 738744 w 1177691"/>
              <a:gd name="connsiteY11" fmla="*/ 305563 h 1195202"/>
              <a:gd name="connsiteX12" fmla="*/ 484744 w 1177691"/>
              <a:gd name="connsiteY12" fmla="*/ 394463 h 1195202"/>
              <a:gd name="connsiteX13" fmla="*/ 300594 w 1177691"/>
              <a:gd name="connsiteY13" fmla="*/ 438913 h 1195202"/>
              <a:gd name="connsiteX14" fmla="*/ 529194 w 1177691"/>
              <a:gd name="connsiteY14" fmla="*/ 521463 h 1195202"/>
              <a:gd name="connsiteX15" fmla="*/ 751444 w 1177691"/>
              <a:gd name="connsiteY15" fmla="*/ 654813 h 1195202"/>
              <a:gd name="connsiteX16" fmla="*/ 999094 w 1177691"/>
              <a:gd name="connsiteY16" fmla="*/ 591313 h 1195202"/>
              <a:gd name="connsiteX17" fmla="*/ 1176894 w 1177691"/>
              <a:gd name="connsiteY17" fmla="*/ 731013 h 1195202"/>
              <a:gd name="connsiteX18" fmla="*/ 929244 w 1177691"/>
              <a:gd name="connsiteY18" fmla="*/ 642113 h 1195202"/>
              <a:gd name="connsiteX19" fmla="*/ 802244 w 1177691"/>
              <a:gd name="connsiteY19" fmla="*/ 705613 h 1195202"/>
              <a:gd name="connsiteX20" fmla="*/ 452994 w 1177691"/>
              <a:gd name="connsiteY20" fmla="*/ 591313 h 1195202"/>
              <a:gd name="connsiteX21" fmla="*/ 503794 w 1177691"/>
              <a:gd name="connsiteY21" fmla="*/ 737363 h 1195202"/>
              <a:gd name="connsiteX22" fmla="*/ 732394 w 1177691"/>
              <a:gd name="connsiteY22" fmla="*/ 1054863 h 1195202"/>
              <a:gd name="connsiteX23" fmla="*/ 579994 w 1177691"/>
              <a:gd name="connsiteY23" fmla="*/ 908813 h 1195202"/>
              <a:gd name="connsiteX24" fmla="*/ 389494 w 1177691"/>
              <a:gd name="connsiteY24" fmla="*/ 610363 h 1195202"/>
              <a:gd name="connsiteX25" fmla="*/ 243444 w 1177691"/>
              <a:gd name="connsiteY25" fmla="*/ 496063 h 1195202"/>
              <a:gd name="connsiteX26" fmla="*/ 230744 w 1177691"/>
              <a:gd name="connsiteY26" fmla="*/ 705613 h 1195202"/>
              <a:gd name="connsiteX27" fmla="*/ 319644 w 1177691"/>
              <a:gd name="connsiteY27" fmla="*/ 915163 h 1195202"/>
              <a:gd name="connsiteX28" fmla="*/ 224394 w 1177691"/>
              <a:gd name="connsiteY28" fmla="*/ 1143763 h 1195202"/>
              <a:gd name="connsiteX29" fmla="*/ 122794 w 1177691"/>
              <a:gd name="connsiteY29" fmla="*/ 1194563 h 1195202"/>
              <a:gd name="connsiteX30" fmla="*/ 192644 w 1177691"/>
              <a:gd name="connsiteY30" fmla="*/ 1124713 h 1195202"/>
              <a:gd name="connsiteX31" fmla="*/ 268844 w 1177691"/>
              <a:gd name="connsiteY31" fmla="*/ 940563 h 1195202"/>
              <a:gd name="connsiteX32" fmla="*/ 206931 w 1177691"/>
              <a:gd name="connsiteY32" fmla="*/ 807213 h 1195202"/>
              <a:gd name="connsiteX33" fmla="*/ 157719 w 1177691"/>
              <a:gd name="connsiteY33" fmla="*/ 888176 h 1195202"/>
              <a:gd name="connsiteX34" fmla="*/ 49769 w 1177691"/>
              <a:gd name="connsiteY34" fmla="*/ 1091375 h 1195202"/>
              <a:gd name="connsiteX35" fmla="*/ 2144 w 1177691"/>
              <a:gd name="connsiteY35" fmla="*/ 1169163 h 1195202"/>
              <a:gd name="connsiteX36" fmla="*/ 114857 w 1177691"/>
              <a:gd name="connsiteY36" fmla="*/ 897700 h 1195202"/>
              <a:gd name="connsiteX37" fmla="*/ 172006 w 1177691"/>
              <a:gd name="connsiteY37" fmla="*/ 694500 h 1195202"/>
              <a:gd name="connsiteX38" fmla="*/ 103744 w 1177691"/>
              <a:gd name="connsiteY38" fmla="*/ 483363 h 1195202"/>
              <a:gd name="connsiteX39" fmla="*/ 65644 w 1177691"/>
              <a:gd name="connsiteY39" fmla="*/ 432563 h 1195202"/>
              <a:gd name="connsiteX0" fmla="*/ 65644 w 1177645"/>
              <a:gd name="connsiteY0" fmla="*/ 432563 h 1195202"/>
              <a:gd name="connsiteX1" fmla="*/ 319644 w 1177645"/>
              <a:gd name="connsiteY1" fmla="*/ 330963 h 1195202"/>
              <a:gd name="connsiteX2" fmla="*/ 408544 w 1177645"/>
              <a:gd name="connsiteY2" fmla="*/ 96013 h 1195202"/>
              <a:gd name="connsiteX3" fmla="*/ 402194 w 1177645"/>
              <a:gd name="connsiteY3" fmla="*/ 51563 h 1195202"/>
              <a:gd name="connsiteX4" fmla="*/ 332344 w 1177645"/>
              <a:gd name="connsiteY4" fmla="*/ 356363 h 1195202"/>
              <a:gd name="connsiteX5" fmla="*/ 357744 w 1177645"/>
              <a:gd name="connsiteY5" fmla="*/ 369063 h 1195202"/>
              <a:gd name="connsiteX6" fmla="*/ 421244 w 1177645"/>
              <a:gd name="connsiteY6" fmla="*/ 375413 h 1195202"/>
              <a:gd name="connsiteX7" fmla="*/ 624444 w 1177645"/>
              <a:gd name="connsiteY7" fmla="*/ 318263 h 1195202"/>
              <a:gd name="connsiteX8" fmla="*/ 878444 w 1177645"/>
              <a:gd name="connsiteY8" fmla="*/ 26163 h 1195202"/>
              <a:gd name="connsiteX9" fmla="*/ 1087994 w 1177645"/>
              <a:gd name="connsiteY9" fmla="*/ 19813 h 1195202"/>
              <a:gd name="connsiteX10" fmla="*/ 859394 w 1177645"/>
              <a:gd name="connsiteY10" fmla="*/ 76963 h 1195202"/>
              <a:gd name="connsiteX11" fmla="*/ 738744 w 1177645"/>
              <a:gd name="connsiteY11" fmla="*/ 305563 h 1195202"/>
              <a:gd name="connsiteX12" fmla="*/ 484744 w 1177645"/>
              <a:gd name="connsiteY12" fmla="*/ 394463 h 1195202"/>
              <a:gd name="connsiteX13" fmla="*/ 300594 w 1177645"/>
              <a:gd name="connsiteY13" fmla="*/ 438913 h 1195202"/>
              <a:gd name="connsiteX14" fmla="*/ 529194 w 1177645"/>
              <a:gd name="connsiteY14" fmla="*/ 521463 h 1195202"/>
              <a:gd name="connsiteX15" fmla="*/ 799069 w 1177645"/>
              <a:gd name="connsiteY15" fmla="*/ 654813 h 1195202"/>
              <a:gd name="connsiteX16" fmla="*/ 999094 w 1177645"/>
              <a:gd name="connsiteY16" fmla="*/ 591313 h 1195202"/>
              <a:gd name="connsiteX17" fmla="*/ 1176894 w 1177645"/>
              <a:gd name="connsiteY17" fmla="*/ 731013 h 1195202"/>
              <a:gd name="connsiteX18" fmla="*/ 929244 w 1177645"/>
              <a:gd name="connsiteY18" fmla="*/ 642113 h 1195202"/>
              <a:gd name="connsiteX19" fmla="*/ 802244 w 1177645"/>
              <a:gd name="connsiteY19" fmla="*/ 705613 h 1195202"/>
              <a:gd name="connsiteX20" fmla="*/ 452994 w 1177645"/>
              <a:gd name="connsiteY20" fmla="*/ 591313 h 1195202"/>
              <a:gd name="connsiteX21" fmla="*/ 503794 w 1177645"/>
              <a:gd name="connsiteY21" fmla="*/ 737363 h 1195202"/>
              <a:gd name="connsiteX22" fmla="*/ 732394 w 1177645"/>
              <a:gd name="connsiteY22" fmla="*/ 1054863 h 1195202"/>
              <a:gd name="connsiteX23" fmla="*/ 579994 w 1177645"/>
              <a:gd name="connsiteY23" fmla="*/ 908813 h 1195202"/>
              <a:gd name="connsiteX24" fmla="*/ 389494 w 1177645"/>
              <a:gd name="connsiteY24" fmla="*/ 610363 h 1195202"/>
              <a:gd name="connsiteX25" fmla="*/ 243444 w 1177645"/>
              <a:gd name="connsiteY25" fmla="*/ 496063 h 1195202"/>
              <a:gd name="connsiteX26" fmla="*/ 230744 w 1177645"/>
              <a:gd name="connsiteY26" fmla="*/ 705613 h 1195202"/>
              <a:gd name="connsiteX27" fmla="*/ 319644 w 1177645"/>
              <a:gd name="connsiteY27" fmla="*/ 915163 h 1195202"/>
              <a:gd name="connsiteX28" fmla="*/ 224394 w 1177645"/>
              <a:gd name="connsiteY28" fmla="*/ 1143763 h 1195202"/>
              <a:gd name="connsiteX29" fmla="*/ 122794 w 1177645"/>
              <a:gd name="connsiteY29" fmla="*/ 1194563 h 1195202"/>
              <a:gd name="connsiteX30" fmla="*/ 192644 w 1177645"/>
              <a:gd name="connsiteY30" fmla="*/ 1124713 h 1195202"/>
              <a:gd name="connsiteX31" fmla="*/ 268844 w 1177645"/>
              <a:gd name="connsiteY31" fmla="*/ 940563 h 1195202"/>
              <a:gd name="connsiteX32" fmla="*/ 206931 w 1177645"/>
              <a:gd name="connsiteY32" fmla="*/ 807213 h 1195202"/>
              <a:gd name="connsiteX33" fmla="*/ 157719 w 1177645"/>
              <a:gd name="connsiteY33" fmla="*/ 888176 h 1195202"/>
              <a:gd name="connsiteX34" fmla="*/ 49769 w 1177645"/>
              <a:gd name="connsiteY34" fmla="*/ 1091375 h 1195202"/>
              <a:gd name="connsiteX35" fmla="*/ 2144 w 1177645"/>
              <a:gd name="connsiteY35" fmla="*/ 1169163 h 1195202"/>
              <a:gd name="connsiteX36" fmla="*/ 114857 w 1177645"/>
              <a:gd name="connsiteY36" fmla="*/ 897700 h 1195202"/>
              <a:gd name="connsiteX37" fmla="*/ 172006 w 1177645"/>
              <a:gd name="connsiteY37" fmla="*/ 694500 h 1195202"/>
              <a:gd name="connsiteX38" fmla="*/ 103744 w 1177645"/>
              <a:gd name="connsiteY38" fmla="*/ 483363 h 1195202"/>
              <a:gd name="connsiteX39" fmla="*/ 65644 w 1177645"/>
              <a:gd name="connsiteY39" fmla="*/ 432563 h 1195202"/>
              <a:gd name="connsiteX0" fmla="*/ 65644 w 1176905"/>
              <a:gd name="connsiteY0" fmla="*/ 432563 h 1195202"/>
              <a:gd name="connsiteX1" fmla="*/ 319644 w 1176905"/>
              <a:gd name="connsiteY1" fmla="*/ 330963 h 1195202"/>
              <a:gd name="connsiteX2" fmla="*/ 408544 w 1176905"/>
              <a:gd name="connsiteY2" fmla="*/ 96013 h 1195202"/>
              <a:gd name="connsiteX3" fmla="*/ 402194 w 1176905"/>
              <a:gd name="connsiteY3" fmla="*/ 51563 h 1195202"/>
              <a:gd name="connsiteX4" fmla="*/ 332344 w 1176905"/>
              <a:gd name="connsiteY4" fmla="*/ 356363 h 1195202"/>
              <a:gd name="connsiteX5" fmla="*/ 357744 w 1176905"/>
              <a:gd name="connsiteY5" fmla="*/ 369063 h 1195202"/>
              <a:gd name="connsiteX6" fmla="*/ 421244 w 1176905"/>
              <a:gd name="connsiteY6" fmla="*/ 375413 h 1195202"/>
              <a:gd name="connsiteX7" fmla="*/ 624444 w 1176905"/>
              <a:gd name="connsiteY7" fmla="*/ 318263 h 1195202"/>
              <a:gd name="connsiteX8" fmla="*/ 878444 w 1176905"/>
              <a:gd name="connsiteY8" fmla="*/ 26163 h 1195202"/>
              <a:gd name="connsiteX9" fmla="*/ 1087994 w 1176905"/>
              <a:gd name="connsiteY9" fmla="*/ 19813 h 1195202"/>
              <a:gd name="connsiteX10" fmla="*/ 859394 w 1176905"/>
              <a:gd name="connsiteY10" fmla="*/ 76963 h 1195202"/>
              <a:gd name="connsiteX11" fmla="*/ 738744 w 1176905"/>
              <a:gd name="connsiteY11" fmla="*/ 305563 h 1195202"/>
              <a:gd name="connsiteX12" fmla="*/ 484744 w 1176905"/>
              <a:gd name="connsiteY12" fmla="*/ 394463 h 1195202"/>
              <a:gd name="connsiteX13" fmla="*/ 300594 w 1176905"/>
              <a:gd name="connsiteY13" fmla="*/ 438913 h 1195202"/>
              <a:gd name="connsiteX14" fmla="*/ 529194 w 1176905"/>
              <a:gd name="connsiteY14" fmla="*/ 521463 h 1195202"/>
              <a:gd name="connsiteX15" fmla="*/ 799069 w 1176905"/>
              <a:gd name="connsiteY15" fmla="*/ 654813 h 1195202"/>
              <a:gd name="connsiteX16" fmla="*/ 999094 w 1176905"/>
              <a:gd name="connsiteY16" fmla="*/ 591313 h 1195202"/>
              <a:gd name="connsiteX17" fmla="*/ 1176894 w 1176905"/>
              <a:gd name="connsiteY17" fmla="*/ 731013 h 1195202"/>
              <a:gd name="connsiteX18" fmla="*/ 991157 w 1176905"/>
              <a:gd name="connsiteY18" fmla="*/ 642113 h 1195202"/>
              <a:gd name="connsiteX19" fmla="*/ 802244 w 1176905"/>
              <a:gd name="connsiteY19" fmla="*/ 705613 h 1195202"/>
              <a:gd name="connsiteX20" fmla="*/ 452994 w 1176905"/>
              <a:gd name="connsiteY20" fmla="*/ 591313 h 1195202"/>
              <a:gd name="connsiteX21" fmla="*/ 503794 w 1176905"/>
              <a:gd name="connsiteY21" fmla="*/ 737363 h 1195202"/>
              <a:gd name="connsiteX22" fmla="*/ 732394 w 1176905"/>
              <a:gd name="connsiteY22" fmla="*/ 1054863 h 1195202"/>
              <a:gd name="connsiteX23" fmla="*/ 579994 w 1176905"/>
              <a:gd name="connsiteY23" fmla="*/ 908813 h 1195202"/>
              <a:gd name="connsiteX24" fmla="*/ 389494 w 1176905"/>
              <a:gd name="connsiteY24" fmla="*/ 610363 h 1195202"/>
              <a:gd name="connsiteX25" fmla="*/ 243444 w 1176905"/>
              <a:gd name="connsiteY25" fmla="*/ 496063 h 1195202"/>
              <a:gd name="connsiteX26" fmla="*/ 230744 w 1176905"/>
              <a:gd name="connsiteY26" fmla="*/ 705613 h 1195202"/>
              <a:gd name="connsiteX27" fmla="*/ 319644 w 1176905"/>
              <a:gd name="connsiteY27" fmla="*/ 915163 h 1195202"/>
              <a:gd name="connsiteX28" fmla="*/ 224394 w 1176905"/>
              <a:gd name="connsiteY28" fmla="*/ 1143763 h 1195202"/>
              <a:gd name="connsiteX29" fmla="*/ 122794 w 1176905"/>
              <a:gd name="connsiteY29" fmla="*/ 1194563 h 1195202"/>
              <a:gd name="connsiteX30" fmla="*/ 192644 w 1176905"/>
              <a:gd name="connsiteY30" fmla="*/ 1124713 h 1195202"/>
              <a:gd name="connsiteX31" fmla="*/ 268844 w 1176905"/>
              <a:gd name="connsiteY31" fmla="*/ 940563 h 1195202"/>
              <a:gd name="connsiteX32" fmla="*/ 206931 w 1176905"/>
              <a:gd name="connsiteY32" fmla="*/ 807213 h 1195202"/>
              <a:gd name="connsiteX33" fmla="*/ 157719 w 1176905"/>
              <a:gd name="connsiteY33" fmla="*/ 888176 h 1195202"/>
              <a:gd name="connsiteX34" fmla="*/ 49769 w 1176905"/>
              <a:gd name="connsiteY34" fmla="*/ 1091375 h 1195202"/>
              <a:gd name="connsiteX35" fmla="*/ 2144 w 1176905"/>
              <a:gd name="connsiteY35" fmla="*/ 1169163 h 1195202"/>
              <a:gd name="connsiteX36" fmla="*/ 114857 w 1176905"/>
              <a:gd name="connsiteY36" fmla="*/ 897700 h 1195202"/>
              <a:gd name="connsiteX37" fmla="*/ 172006 w 1176905"/>
              <a:gd name="connsiteY37" fmla="*/ 694500 h 1195202"/>
              <a:gd name="connsiteX38" fmla="*/ 103744 w 1176905"/>
              <a:gd name="connsiteY38" fmla="*/ 483363 h 1195202"/>
              <a:gd name="connsiteX39" fmla="*/ 65644 w 1176905"/>
              <a:gd name="connsiteY39" fmla="*/ 432563 h 1195202"/>
              <a:gd name="connsiteX0" fmla="*/ 65644 w 1176905"/>
              <a:gd name="connsiteY0" fmla="*/ 432563 h 1195202"/>
              <a:gd name="connsiteX1" fmla="*/ 319644 w 1176905"/>
              <a:gd name="connsiteY1" fmla="*/ 330963 h 1195202"/>
              <a:gd name="connsiteX2" fmla="*/ 408544 w 1176905"/>
              <a:gd name="connsiteY2" fmla="*/ 96013 h 1195202"/>
              <a:gd name="connsiteX3" fmla="*/ 402194 w 1176905"/>
              <a:gd name="connsiteY3" fmla="*/ 51563 h 1195202"/>
              <a:gd name="connsiteX4" fmla="*/ 332344 w 1176905"/>
              <a:gd name="connsiteY4" fmla="*/ 356363 h 1195202"/>
              <a:gd name="connsiteX5" fmla="*/ 357744 w 1176905"/>
              <a:gd name="connsiteY5" fmla="*/ 369063 h 1195202"/>
              <a:gd name="connsiteX6" fmla="*/ 421244 w 1176905"/>
              <a:gd name="connsiteY6" fmla="*/ 375413 h 1195202"/>
              <a:gd name="connsiteX7" fmla="*/ 624444 w 1176905"/>
              <a:gd name="connsiteY7" fmla="*/ 318263 h 1195202"/>
              <a:gd name="connsiteX8" fmla="*/ 878444 w 1176905"/>
              <a:gd name="connsiteY8" fmla="*/ 26163 h 1195202"/>
              <a:gd name="connsiteX9" fmla="*/ 1087994 w 1176905"/>
              <a:gd name="connsiteY9" fmla="*/ 19813 h 1195202"/>
              <a:gd name="connsiteX10" fmla="*/ 859394 w 1176905"/>
              <a:gd name="connsiteY10" fmla="*/ 76963 h 1195202"/>
              <a:gd name="connsiteX11" fmla="*/ 738744 w 1176905"/>
              <a:gd name="connsiteY11" fmla="*/ 305563 h 1195202"/>
              <a:gd name="connsiteX12" fmla="*/ 484744 w 1176905"/>
              <a:gd name="connsiteY12" fmla="*/ 394463 h 1195202"/>
              <a:gd name="connsiteX13" fmla="*/ 300594 w 1176905"/>
              <a:gd name="connsiteY13" fmla="*/ 438913 h 1195202"/>
              <a:gd name="connsiteX14" fmla="*/ 529194 w 1176905"/>
              <a:gd name="connsiteY14" fmla="*/ 521463 h 1195202"/>
              <a:gd name="connsiteX15" fmla="*/ 799069 w 1176905"/>
              <a:gd name="connsiteY15" fmla="*/ 654813 h 1195202"/>
              <a:gd name="connsiteX16" fmla="*/ 999094 w 1176905"/>
              <a:gd name="connsiteY16" fmla="*/ 591313 h 1195202"/>
              <a:gd name="connsiteX17" fmla="*/ 1176894 w 1176905"/>
              <a:gd name="connsiteY17" fmla="*/ 731013 h 1195202"/>
              <a:gd name="connsiteX18" fmla="*/ 991157 w 1176905"/>
              <a:gd name="connsiteY18" fmla="*/ 642113 h 1195202"/>
              <a:gd name="connsiteX19" fmla="*/ 745094 w 1176905"/>
              <a:gd name="connsiteY19" fmla="*/ 686563 h 1195202"/>
              <a:gd name="connsiteX20" fmla="*/ 452994 w 1176905"/>
              <a:gd name="connsiteY20" fmla="*/ 591313 h 1195202"/>
              <a:gd name="connsiteX21" fmla="*/ 503794 w 1176905"/>
              <a:gd name="connsiteY21" fmla="*/ 737363 h 1195202"/>
              <a:gd name="connsiteX22" fmla="*/ 732394 w 1176905"/>
              <a:gd name="connsiteY22" fmla="*/ 1054863 h 1195202"/>
              <a:gd name="connsiteX23" fmla="*/ 579994 w 1176905"/>
              <a:gd name="connsiteY23" fmla="*/ 908813 h 1195202"/>
              <a:gd name="connsiteX24" fmla="*/ 389494 w 1176905"/>
              <a:gd name="connsiteY24" fmla="*/ 610363 h 1195202"/>
              <a:gd name="connsiteX25" fmla="*/ 243444 w 1176905"/>
              <a:gd name="connsiteY25" fmla="*/ 496063 h 1195202"/>
              <a:gd name="connsiteX26" fmla="*/ 230744 w 1176905"/>
              <a:gd name="connsiteY26" fmla="*/ 705613 h 1195202"/>
              <a:gd name="connsiteX27" fmla="*/ 319644 w 1176905"/>
              <a:gd name="connsiteY27" fmla="*/ 915163 h 1195202"/>
              <a:gd name="connsiteX28" fmla="*/ 224394 w 1176905"/>
              <a:gd name="connsiteY28" fmla="*/ 1143763 h 1195202"/>
              <a:gd name="connsiteX29" fmla="*/ 122794 w 1176905"/>
              <a:gd name="connsiteY29" fmla="*/ 1194563 h 1195202"/>
              <a:gd name="connsiteX30" fmla="*/ 192644 w 1176905"/>
              <a:gd name="connsiteY30" fmla="*/ 1124713 h 1195202"/>
              <a:gd name="connsiteX31" fmla="*/ 268844 w 1176905"/>
              <a:gd name="connsiteY31" fmla="*/ 940563 h 1195202"/>
              <a:gd name="connsiteX32" fmla="*/ 206931 w 1176905"/>
              <a:gd name="connsiteY32" fmla="*/ 807213 h 1195202"/>
              <a:gd name="connsiteX33" fmla="*/ 157719 w 1176905"/>
              <a:gd name="connsiteY33" fmla="*/ 888176 h 1195202"/>
              <a:gd name="connsiteX34" fmla="*/ 49769 w 1176905"/>
              <a:gd name="connsiteY34" fmla="*/ 1091375 h 1195202"/>
              <a:gd name="connsiteX35" fmla="*/ 2144 w 1176905"/>
              <a:gd name="connsiteY35" fmla="*/ 1169163 h 1195202"/>
              <a:gd name="connsiteX36" fmla="*/ 114857 w 1176905"/>
              <a:gd name="connsiteY36" fmla="*/ 897700 h 1195202"/>
              <a:gd name="connsiteX37" fmla="*/ 172006 w 1176905"/>
              <a:gd name="connsiteY37" fmla="*/ 694500 h 1195202"/>
              <a:gd name="connsiteX38" fmla="*/ 103744 w 1176905"/>
              <a:gd name="connsiteY38" fmla="*/ 483363 h 1195202"/>
              <a:gd name="connsiteX39" fmla="*/ 65644 w 1176905"/>
              <a:gd name="connsiteY39" fmla="*/ 432563 h 1195202"/>
              <a:gd name="connsiteX0" fmla="*/ 65644 w 1177180"/>
              <a:gd name="connsiteY0" fmla="*/ 432563 h 1195202"/>
              <a:gd name="connsiteX1" fmla="*/ 319644 w 1177180"/>
              <a:gd name="connsiteY1" fmla="*/ 330963 h 1195202"/>
              <a:gd name="connsiteX2" fmla="*/ 408544 w 1177180"/>
              <a:gd name="connsiteY2" fmla="*/ 96013 h 1195202"/>
              <a:gd name="connsiteX3" fmla="*/ 402194 w 1177180"/>
              <a:gd name="connsiteY3" fmla="*/ 51563 h 1195202"/>
              <a:gd name="connsiteX4" fmla="*/ 332344 w 1177180"/>
              <a:gd name="connsiteY4" fmla="*/ 356363 h 1195202"/>
              <a:gd name="connsiteX5" fmla="*/ 357744 w 1177180"/>
              <a:gd name="connsiteY5" fmla="*/ 369063 h 1195202"/>
              <a:gd name="connsiteX6" fmla="*/ 421244 w 1177180"/>
              <a:gd name="connsiteY6" fmla="*/ 375413 h 1195202"/>
              <a:gd name="connsiteX7" fmla="*/ 624444 w 1177180"/>
              <a:gd name="connsiteY7" fmla="*/ 318263 h 1195202"/>
              <a:gd name="connsiteX8" fmla="*/ 878444 w 1177180"/>
              <a:gd name="connsiteY8" fmla="*/ 26163 h 1195202"/>
              <a:gd name="connsiteX9" fmla="*/ 1087994 w 1177180"/>
              <a:gd name="connsiteY9" fmla="*/ 19813 h 1195202"/>
              <a:gd name="connsiteX10" fmla="*/ 859394 w 1177180"/>
              <a:gd name="connsiteY10" fmla="*/ 76963 h 1195202"/>
              <a:gd name="connsiteX11" fmla="*/ 738744 w 1177180"/>
              <a:gd name="connsiteY11" fmla="*/ 305563 h 1195202"/>
              <a:gd name="connsiteX12" fmla="*/ 484744 w 1177180"/>
              <a:gd name="connsiteY12" fmla="*/ 394463 h 1195202"/>
              <a:gd name="connsiteX13" fmla="*/ 300594 w 1177180"/>
              <a:gd name="connsiteY13" fmla="*/ 438913 h 1195202"/>
              <a:gd name="connsiteX14" fmla="*/ 529194 w 1177180"/>
              <a:gd name="connsiteY14" fmla="*/ 521463 h 1195202"/>
              <a:gd name="connsiteX15" fmla="*/ 799069 w 1177180"/>
              <a:gd name="connsiteY15" fmla="*/ 654813 h 1195202"/>
              <a:gd name="connsiteX16" fmla="*/ 1027669 w 1177180"/>
              <a:gd name="connsiteY16" fmla="*/ 610363 h 1195202"/>
              <a:gd name="connsiteX17" fmla="*/ 1176894 w 1177180"/>
              <a:gd name="connsiteY17" fmla="*/ 731013 h 1195202"/>
              <a:gd name="connsiteX18" fmla="*/ 991157 w 1177180"/>
              <a:gd name="connsiteY18" fmla="*/ 642113 h 1195202"/>
              <a:gd name="connsiteX19" fmla="*/ 745094 w 1177180"/>
              <a:gd name="connsiteY19" fmla="*/ 686563 h 1195202"/>
              <a:gd name="connsiteX20" fmla="*/ 452994 w 1177180"/>
              <a:gd name="connsiteY20" fmla="*/ 591313 h 1195202"/>
              <a:gd name="connsiteX21" fmla="*/ 503794 w 1177180"/>
              <a:gd name="connsiteY21" fmla="*/ 737363 h 1195202"/>
              <a:gd name="connsiteX22" fmla="*/ 732394 w 1177180"/>
              <a:gd name="connsiteY22" fmla="*/ 1054863 h 1195202"/>
              <a:gd name="connsiteX23" fmla="*/ 579994 w 1177180"/>
              <a:gd name="connsiteY23" fmla="*/ 908813 h 1195202"/>
              <a:gd name="connsiteX24" fmla="*/ 389494 w 1177180"/>
              <a:gd name="connsiteY24" fmla="*/ 610363 h 1195202"/>
              <a:gd name="connsiteX25" fmla="*/ 243444 w 1177180"/>
              <a:gd name="connsiteY25" fmla="*/ 496063 h 1195202"/>
              <a:gd name="connsiteX26" fmla="*/ 230744 w 1177180"/>
              <a:gd name="connsiteY26" fmla="*/ 705613 h 1195202"/>
              <a:gd name="connsiteX27" fmla="*/ 319644 w 1177180"/>
              <a:gd name="connsiteY27" fmla="*/ 915163 h 1195202"/>
              <a:gd name="connsiteX28" fmla="*/ 224394 w 1177180"/>
              <a:gd name="connsiteY28" fmla="*/ 1143763 h 1195202"/>
              <a:gd name="connsiteX29" fmla="*/ 122794 w 1177180"/>
              <a:gd name="connsiteY29" fmla="*/ 1194563 h 1195202"/>
              <a:gd name="connsiteX30" fmla="*/ 192644 w 1177180"/>
              <a:gd name="connsiteY30" fmla="*/ 1124713 h 1195202"/>
              <a:gd name="connsiteX31" fmla="*/ 268844 w 1177180"/>
              <a:gd name="connsiteY31" fmla="*/ 940563 h 1195202"/>
              <a:gd name="connsiteX32" fmla="*/ 206931 w 1177180"/>
              <a:gd name="connsiteY32" fmla="*/ 807213 h 1195202"/>
              <a:gd name="connsiteX33" fmla="*/ 157719 w 1177180"/>
              <a:gd name="connsiteY33" fmla="*/ 888176 h 1195202"/>
              <a:gd name="connsiteX34" fmla="*/ 49769 w 1177180"/>
              <a:gd name="connsiteY34" fmla="*/ 1091375 h 1195202"/>
              <a:gd name="connsiteX35" fmla="*/ 2144 w 1177180"/>
              <a:gd name="connsiteY35" fmla="*/ 1169163 h 1195202"/>
              <a:gd name="connsiteX36" fmla="*/ 114857 w 1177180"/>
              <a:gd name="connsiteY36" fmla="*/ 897700 h 1195202"/>
              <a:gd name="connsiteX37" fmla="*/ 172006 w 1177180"/>
              <a:gd name="connsiteY37" fmla="*/ 694500 h 1195202"/>
              <a:gd name="connsiteX38" fmla="*/ 103744 w 1177180"/>
              <a:gd name="connsiteY38" fmla="*/ 483363 h 1195202"/>
              <a:gd name="connsiteX39" fmla="*/ 65644 w 1177180"/>
              <a:gd name="connsiteY39" fmla="*/ 432563 h 1195202"/>
              <a:gd name="connsiteX0" fmla="*/ 65644 w 1177180"/>
              <a:gd name="connsiteY0" fmla="*/ 432563 h 1195202"/>
              <a:gd name="connsiteX1" fmla="*/ 319644 w 1177180"/>
              <a:gd name="connsiteY1" fmla="*/ 330963 h 1195202"/>
              <a:gd name="connsiteX2" fmla="*/ 408544 w 1177180"/>
              <a:gd name="connsiteY2" fmla="*/ 96013 h 1195202"/>
              <a:gd name="connsiteX3" fmla="*/ 402194 w 1177180"/>
              <a:gd name="connsiteY3" fmla="*/ 51563 h 1195202"/>
              <a:gd name="connsiteX4" fmla="*/ 332344 w 1177180"/>
              <a:gd name="connsiteY4" fmla="*/ 356363 h 1195202"/>
              <a:gd name="connsiteX5" fmla="*/ 357744 w 1177180"/>
              <a:gd name="connsiteY5" fmla="*/ 369063 h 1195202"/>
              <a:gd name="connsiteX6" fmla="*/ 421244 w 1177180"/>
              <a:gd name="connsiteY6" fmla="*/ 375413 h 1195202"/>
              <a:gd name="connsiteX7" fmla="*/ 624444 w 1177180"/>
              <a:gd name="connsiteY7" fmla="*/ 318263 h 1195202"/>
              <a:gd name="connsiteX8" fmla="*/ 878444 w 1177180"/>
              <a:gd name="connsiteY8" fmla="*/ 26163 h 1195202"/>
              <a:gd name="connsiteX9" fmla="*/ 1087994 w 1177180"/>
              <a:gd name="connsiteY9" fmla="*/ 19813 h 1195202"/>
              <a:gd name="connsiteX10" fmla="*/ 859394 w 1177180"/>
              <a:gd name="connsiteY10" fmla="*/ 76963 h 1195202"/>
              <a:gd name="connsiteX11" fmla="*/ 738744 w 1177180"/>
              <a:gd name="connsiteY11" fmla="*/ 248413 h 1195202"/>
              <a:gd name="connsiteX12" fmla="*/ 484744 w 1177180"/>
              <a:gd name="connsiteY12" fmla="*/ 394463 h 1195202"/>
              <a:gd name="connsiteX13" fmla="*/ 300594 w 1177180"/>
              <a:gd name="connsiteY13" fmla="*/ 438913 h 1195202"/>
              <a:gd name="connsiteX14" fmla="*/ 529194 w 1177180"/>
              <a:gd name="connsiteY14" fmla="*/ 521463 h 1195202"/>
              <a:gd name="connsiteX15" fmla="*/ 799069 w 1177180"/>
              <a:gd name="connsiteY15" fmla="*/ 654813 h 1195202"/>
              <a:gd name="connsiteX16" fmla="*/ 1027669 w 1177180"/>
              <a:gd name="connsiteY16" fmla="*/ 610363 h 1195202"/>
              <a:gd name="connsiteX17" fmla="*/ 1176894 w 1177180"/>
              <a:gd name="connsiteY17" fmla="*/ 731013 h 1195202"/>
              <a:gd name="connsiteX18" fmla="*/ 991157 w 1177180"/>
              <a:gd name="connsiteY18" fmla="*/ 642113 h 1195202"/>
              <a:gd name="connsiteX19" fmla="*/ 745094 w 1177180"/>
              <a:gd name="connsiteY19" fmla="*/ 686563 h 1195202"/>
              <a:gd name="connsiteX20" fmla="*/ 452994 w 1177180"/>
              <a:gd name="connsiteY20" fmla="*/ 591313 h 1195202"/>
              <a:gd name="connsiteX21" fmla="*/ 503794 w 1177180"/>
              <a:gd name="connsiteY21" fmla="*/ 737363 h 1195202"/>
              <a:gd name="connsiteX22" fmla="*/ 732394 w 1177180"/>
              <a:gd name="connsiteY22" fmla="*/ 1054863 h 1195202"/>
              <a:gd name="connsiteX23" fmla="*/ 579994 w 1177180"/>
              <a:gd name="connsiteY23" fmla="*/ 908813 h 1195202"/>
              <a:gd name="connsiteX24" fmla="*/ 389494 w 1177180"/>
              <a:gd name="connsiteY24" fmla="*/ 610363 h 1195202"/>
              <a:gd name="connsiteX25" fmla="*/ 243444 w 1177180"/>
              <a:gd name="connsiteY25" fmla="*/ 496063 h 1195202"/>
              <a:gd name="connsiteX26" fmla="*/ 230744 w 1177180"/>
              <a:gd name="connsiteY26" fmla="*/ 705613 h 1195202"/>
              <a:gd name="connsiteX27" fmla="*/ 319644 w 1177180"/>
              <a:gd name="connsiteY27" fmla="*/ 915163 h 1195202"/>
              <a:gd name="connsiteX28" fmla="*/ 224394 w 1177180"/>
              <a:gd name="connsiteY28" fmla="*/ 1143763 h 1195202"/>
              <a:gd name="connsiteX29" fmla="*/ 122794 w 1177180"/>
              <a:gd name="connsiteY29" fmla="*/ 1194563 h 1195202"/>
              <a:gd name="connsiteX30" fmla="*/ 192644 w 1177180"/>
              <a:gd name="connsiteY30" fmla="*/ 1124713 h 1195202"/>
              <a:gd name="connsiteX31" fmla="*/ 268844 w 1177180"/>
              <a:gd name="connsiteY31" fmla="*/ 940563 h 1195202"/>
              <a:gd name="connsiteX32" fmla="*/ 206931 w 1177180"/>
              <a:gd name="connsiteY32" fmla="*/ 807213 h 1195202"/>
              <a:gd name="connsiteX33" fmla="*/ 157719 w 1177180"/>
              <a:gd name="connsiteY33" fmla="*/ 888176 h 1195202"/>
              <a:gd name="connsiteX34" fmla="*/ 49769 w 1177180"/>
              <a:gd name="connsiteY34" fmla="*/ 1091375 h 1195202"/>
              <a:gd name="connsiteX35" fmla="*/ 2144 w 1177180"/>
              <a:gd name="connsiteY35" fmla="*/ 1169163 h 1195202"/>
              <a:gd name="connsiteX36" fmla="*/ 114857 w 1177180"/>
              <a:gd name="connsiteY36" fmla="*/ 897700 h 1195202"/>
              <a:gd name="connsiteX37" fmla="*/ 172006 w 1177180"/>
              <a:gd name="connsiteY37" fmla="*/ 694500 h 1195202"/>
              <a:gd name="connsiteX38" fmla="*/ 103744 w 1177180"/>
              <a:gd name="connsiteY38" fmla="*/ 483363 h 1195202"/>
              <a:gd name="connsiteX39" fmla="*/ 65644 w 1177180"/>
              <a:gd name="connsiteY39" fmla="*/ 432563 h 1195202"/>
              <a:gd name="connsiteX0" fmla="*/ 65644 w 1177180"/>
              <a:gd name="connsiteY0" fmla="*/ 432563 h 1195202"/>
              <a:gd name="connsiteX1" fmla="*/ 319644 w 1177180"/>
              <a:gd name="connsiteY1" fmla="*/ 330963 h 1195202"/>
              <a:gd name="connsiteX2" fmla="*/ 408544 w 1177180"/>
              <a:gd name="connsiteY2" fmla="*/ 96013 h 1195202"/>
              <a:gd name="connsiteX3" fmla="*/ 402194 w 1177180"/>
              <a:gd name="connsiteY3" fmla="*/ 51563 h 1195202"/>
              <a:gd name="connsiteX4" fmla="*/ 332344 w 1177180"/>
              <a:gd name="connsiteY4" fmla="*/ 356363 h 1195202"/>
              <a:gd name="connsiteX5" fmla="*/ 357744 w 1177180"/>
              <a:gd name="connsiteY5" fmla="*/ 369063 h 1195202"/>
              <a:gd name="connsiteX6" fmla="*/ 421244 w 1177180"/>
              <a:gd name="connsiteY6" fmla="*/ 375413 h 1195202"/>
              <a:gd name="connsiteX7" fmla="*/ 624444 w 1177180"/>
              <a:gd name="connsiteY7" fmla="*/ 318263 h 1195202"/>
              <a:gd name="connsiteX8" fmla="*/ 878444 w 1177180"/>
              <a:gd name="connsiteY8" fmla="*/ 26163 h 1195202"/>
              <a:gd name="connsiteX9" fmla="*/ 1087994 w 1177180"/>
              <a:gd name="connsiteY9" fmla="*/ 19813 h 1195202"/>
              <a:gd name="connsiteX10" fmla="*/ 859394 w 1177180"/>
              <a:gd name="connsiteY10" fmla="*/ 76963 h 1195202"/>
              <a:gd name="connsiteX11" fmla="*/ 738744 w 1177180"/>
              <a:gd name="connsiteY11" fmla="*/ 248413 h 1195202"/>
              <a:gd name="connsiteX12" fmla="*/ 484744 w 1177180"/>
              <a:gd name="connsiteY12" fmla="*/ 394463 h 1195202"/>
              <a:gd name="connsiteX13" fmla="*/ 300594 w 1177180"/>
              <a:gd name="connsiteY13" fmla="*/ 438913 h 1195202"/>
              <a:gd name="connsiteX14" fmla="*/ 529194 w 1177180"/>
              <a:gd name="connsiteY14" fmla="*/ 569088 h 1195202"/>
              <a:gd name="connsiteX15" fmla="*/ 799069 w 1177180"/>
              <a:gd name="connsiteY15" fmla="*/ 654813 h 1195202"/>
              <a:gd name="connsiteX16" fmla="*/ 1027669 w 1177180"/>
              <a:gd name="connsiteY16" fmla="*/ 610363 h 1195202"/>
              <a:gd name="connsiteX17" fmla="*/ 1176894 w 1177180"/>
              <a:gd name="connsiteY17" fmla="*/ 731013 h 1195202"/>
              <a:gd name="connsiteX18" fmla="*/ 991157 w 1177180"/>
              <a:gd name="connsiteY18" fmla="*/ 642113 h 1195202"/>
              <a:gd name="connsiteX19" fmla="*/ 745094 w 1177180"/>
              <a:gd name="connsiteY19" fmla="*/ 686563 h 1195202"/>
              <a:gd name="connsiteX20" fmla="*/ 452994 w 1177180"/>
              <a:gd name="connsiteY20" fmla="*/ 591313 h 1195202"/>
              <a:gd name="connsiteX21" fmla="*/ 503794 w 1177180"/>
              <a:gd name="connsiteY21" fmla="*/ 737363 h 1195202"/>
              <a:gd name="connsiteX22" fmla="*/ 732394 w 1177180"/>
              <a:gd name="connsiteY22" fmla="*/ 1054863 h 1195202"/>
              <a:gd name="connsiteX23" fmla="*/ 579994 w 1177180"/>
              <a:gd name="connsiteY23" fmla="*/ 908813 h 1195202"/>
              <a:gd name="connsiteX24" fmla="*/ 389494 w 1177180"/>
              <a:gd name="connsiteY24" fmla="*/ 610363 h 1195202"/>
              <a:gd name="connsiteX25" fmla="*/ 243444 w 1177180"/>
              <a:gd name="connsiteY25" fmla="*/ 496063 h 1195202"/>
              <a:gd name="connsiteX26" fmla="*/ 230744 w 1177180"/>
              <a:gd name="connsiteY26" fmla="*/ 705613 h 1195202"/>
              <a:gd name="connsiteX27" fmla="*/ 319644 w 1177180"/>
              <a:gd name="connsiteY27" fmla="*/ 915163 h 1195202"/>
              <a:gd name="connsiteX28" fmla="*/ 224394 w 1177180"/>
              <a:gd name="connsiteY28" fmla="*/ 1143763 h 1195202"/>
              <a:gd name="connsiteX29" fmla="*/ 122794 w 1177180"/>
              <a:gd name="connsiteY29" fmla="*/ 1194563 h 1195202"/>
              <a:gd name="connsiteX30" fmla="*/ 192644 w 1177180"/>
              <a:gd name="connsiteY30" fmla="*/ 1124713 h 1195202"/>
              <a:gd name="connsiteX31" fmla="*/ 268844 w 1177180"/>
              <a:gd name="connsiteY31" fmla="*/ 940563 h 1195202"/>
              <a:gd name="connsiteX32" fmla="*/ 206931 w 1177180"/>
              <a:gd name="connsiteY32" fmla="*/ 807213 h 1195202"/>
              <a:gd name="connsiteX33" fmla="*/ 157719 w 1177180"/>
              <a:gd name="connsiteY33" fmla="*/ 888176 h 1195202"/>
              <a:gd name="connsiteX34" fmla="*/ 49769 w 1177180"/>
              <a:gd name="connsiteY34" fmla="*/ 1091375 h 1195202"/>
              <a:gd name="connsiteX35" fmla="*/ 2144 w 1177180"/>
              <a:gd name="connsiteY35" fmla="*/ 1169163 h 1195202"/>
              <a:gd name="connsiteX36" fmla="*/ 114857 w 1177180"/>
              <a:gd name="connsiteY36" fmla="*/ 897700 h 1195202"/>
              <a:gd name="connsiteX37" fmla="*/ 172006 w 1177180"/>
              <a:gd name="connsiteY37" fmla="*/ 694500 h 1195202"/>
              <a:gd name="connsiteX38" fmla="*/ 103744 w 1177180"/>
              <a:gd name="connsiteY38" fmla="*/ 483363 h 1195202"/>
              <a:gd name="connsiteX39" fmla="*/ 65644 w 1177180"/>
              <a:gd name="connsiteY39" fmla="*/ 432563 h 1195202"/>
              <a:gd name="connsiteX0" fmla="*/ 65644 w 1177180"/>
              <a:gd name="connsiteY0" fmla="*/ 432563 h 1195467"/>
              <a:gd name="connsiteX1" fmla="*/ 319644 w 1177180"/>
              <a:gd name="connsiteY1" fmla="*/ 330963 h 1195467"/>
              <a:gd name="connsiteX2" fmla="*/ 408544 w 1177180"/>
              <a:gd name="connsiteY2" fmla="*/ 96013 h 1195467"/>
              <a:gd name="connsiteX3" fmla="*/ 402194 w 1177180"/>
              <a:gd name="connsiteY3" fmla="*/ 51563 h 1195467"/>
              <a:gd name="connsiteX4" fmla="*/ 332344 w 1177180"/>
              <a:gd name="connsiteY4" fmla="*/ 356363 h 1195467"/>
              <a:gd name="connsiteX5" fmla="*/ 357744 w 1177180"/>
              <a:gd name="connsiteY5" fmla="*/ 369063 h 1195467"/>
              <a:gd name="connsiteX6" fmla="*/ 421244 w 1177180"/>
              <a:gd name="connsiteY6" fmla="*/ 375413 h 1195467"/>
              <a:gd name="connsiteX7" fmla="*/ 624444 w 1177180"/>
              <a:gd name="connsiteY7" fmla="*/ 318263 h 1195467"/>
              <a:gd name="connsiteX8" fmla="*/ 878444 w 1177180"/>
              <a:gd name="connsiteY8" fmla="*/ 26163 h 1195467"/>
              <a:gd name="connsiteX9" fmla="*/ 1087994 w 1177180"/>
              <a:gd name="connsiteY9" fmla="*/ 19813 h 1195467"/>
              <a:gd name="connsiteX10" fmla="*/ 859394 w 1177180"/>
              <a:gd name="connsiteY10" fmla="*/ 76963 h 1195467"/>
              <a:gd name="connsiteX11" fmla="*/ 738744 w 1177180"/>
              <a:gd name="connsiteY11" fmla="*/ 248413 h 1195467"/>
              <a:gd name="connsiteX12" fmla="*/ 484744 w 1177180"/>
              <a:gd name="connsiteY12" fmla="*/ 394463 h 1195467"/>
              <a:gd name="connsiteX13" fmla="*/ 300594 w 1177180"/>
              <a:gd name="connsiteY13" fmla="*/ 438913 h 1195467"/>
              <a:gd name="connsiteX14" fmla="*/ 529194 w 1177180"/>
              <a:gd name="connsiteY14" fmla="*/ 569088 h 1195467"/>
              <a:gd name="connsiteX15" fmla="*/ 799069 w 1177180"/>
              <a:gd name="connsiteY15" fmla="*/ 654813 h 1195467"/>
              <a:gd name="connsiteX16" fmla="*/ 1027669 w 1177180"/>
              <a:gd name="connsiteY16" fmla="*/ 610363 h 1195467"/>
              <a:gd name="connsiteX17" fmla="*/ 1176894 w 1177180"/>
              <a:gd name="connsiteY17" fmla="*/ 731013 h 1195467"/>
              <a:gd name="connsiteX18" fmla="*/ 991157 w 1177180"/>
              <a:gd name="connsiteY18" fmla="*/ 642113 h 1195467"/>
              <a:gd name="connsiteX19" fmla="*/ 745094 w 1177180"/>
              <a:gd name="connsiteY19" fmla="*/ 686563 h 1195467"/>
              <a:gd name="connsiteX20" fmla="*/ 452994 w 1177180"/>
              <a:gd name="connsiteY20" fmla="*/ 591313 h 1195467"/>
              <a:gd name="connsiteX21" fmla="*/ 503794 w 1177180"/>
              <a:gd name="connsiteY21" fmla="*/ 737363 h 1195467"/>
              <a:gd name="connsiteX22" fmla="*/ 732394 w 1177180"/>
              <a:gd name="connsiteY22" fmla="*/ 1054863 h 1195467"/>
              <a:gd name="connsiteX23" fmla="*/ 579994 w 1177180"/>
              <a:gd name="connsiteY23" fmla="*/ 908813 h 1195467"/>
              <a:gd name="connsiteX24" fmla="*/ 389494 w 1177180"/>
              <a:gd name="connsiteY24" fmla="*/ 610363 h 1195467"/>
              <a:gd name="connsiteX25" fmla="*/ 243444 w 1177180"/>
              <a:gd name="connsiteY25" fmla="*/ 496063 h 1195467"/>
              <a:gd name="connsiteX26" fmla="*/ 230744 w 1177180"/>
              <a:gd name="connsiteY26" fmla="*/ 705613 h 1195467"/>
              <a:gd name="connsiteX27" fmla="*/ 288688 w 1177180"/>
              <a:gd name="connsiteY27" fmla="*/ 886588 h 1195467"/>
              <a:gd name="connsiteX28" fmla="*/ 224394 w 1177180"/>
              <a:gd name="connsiteY28" fmla="*/ 1143763 h 1195467"/>
              <a:gd name="connsiteX29" fmla="*/ 122794 w 1177180"/>
              <a:gd name="connsiteY29" fmla="*/ 1194563 h 1195467"/>
              <a:gd name="connsiteX30" fmla="*/ 192644 w 1177180"/>
              <a:gd name="connsiteY30" fmla="*/ 1124713 h 1195467"/>
              <a:gd name="connsiteX31" fmla="*/ 268844 w 1177180"/>
              <a:gd name="connsiteY31" fmla="*/ 940563 h 1195467"/>
              <a:gd name="connsiteX32" fmla="*/ 206931 w 1177180"/>
              <a:gd name="connsiteY32" fmla="*/ 807213 h 1195467"/>
              <a:gd name="connsiteX33" fmla="*/ 157719 w 1177180"/>
              <a:gd name="connsiteY33" fmla="*/ 888176 h 1195467"/>
              <a:gd name="connsiteX34" fmla="*/ 49769 w 1177180"/>
              <a:gd name="connsiteY34" fmla="*/ 1091375 h 1195467"/>
              <a:gd name="connsiteX35" fmla="*/ 2144 w 1177180"/>
              <a:gd name="connsiteY35" fmla="*/ 1169163 h 1195467"/>
              <a:gd name="connsiteX36" fmla="*/ 114857 w 1177180"/>
              <a:gd name="connsiteY36" fmla="*/ 897700 h 1195467"/>
              <a:gd name="connsiteX37" fmla="*/ 172006 w 1177180"/>
              <a:gd name="connsiteY37" fmla="*/ 694500 h 1195467"/>
              <a:gd name="connsiteX38" fmla="*/ 103744 w 1177180"/>
              <a:gd name="connsiteY38" fmla="*/ 483363 h 1195467"/>
              <a:gd name="connsiteX39" fmla="*/ 65644 w 1177180"/>
              <a:gd name="connsiteY39" fmla="*/ 432563 h 11954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408544 w 1177180"/>
              <a:gd name="connsiteY2" fmla="*/ 96013 h 1194567"/>
              <a:gd name="connsiteX3" fmla="*/ 402194 w 1177180"/>
              <a:gd name="connsiteY3" fmla="*/ 51563 h 1194567"/>
              <a:gd name="connsiteX4" fmla="*/ 332344 w 1177180"/>
              <a:gd name="connsiteY4" fmla="*/ 356363 h 1194567"/>
              <a:gd name="connsiteX5" fmla="*/ 357744 w 1177180"/>
              <a:gd name="connsiteY5" fmla="*/ 369063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88688 w 1177180"/>
              <a:gd name="connsiteY27" fmla="*/ 886588 h 1194567"/>
              <a:gd name="connsiteX28" fmla="*/ 212487 w 1177180"/>
              <a:gd name="connsiteY28" fmla="*/ 1122331 h 1194567"/>
              <a:gd name="connsiteX29" fmla="*/ 122794 w 1177180"/>
              <a:gd name="connsiteY29" fmla="*/ 1194563 h 1194567"/>
              <a:gd name="connsiteX30" fmla="*/ 192644 w 1177180"/>
              <a:gd name="connsiteY30" fmla="*/ 1124713 h 1194567"/>
              <a:gd name="connsiteX31" fmla="*/ 268844 w 1177180"/>
              <a:gd name="connsiteY31" fmla="*/ 940563 h 1194567"/>
              <a:gd name="connsiteX32" fmla="*/ 206931 w 1177180"/>
              <a:gd name="connsiteY32" fmla="*/ 807213 h 1194567"/>
              <a:gd name="connsiteX33" fmla="*/ 157719 w 1177180"/>
              <a:gd name="connsiteY33" fmla="*/ 888176 h 1194567"/>
              <a:gd name="connsiteX34" fmla="*/ 49769 w 1177180"/>
              <a:gd name="connsiteY34" fmla="*/ 1091375 h 1194567"/>
              <a:gd name="connsiteX35" fmla="*/ 2144 w 1177180"/>
              <a:gd name="connsiteY35" fmla="*/ 1169163 h 1194567"/>
              <a:gd name="connsiteX36" fmla="*/ 114857 w 1177180"/>
              <a:gd name="connsiteY36" fmla="*/ 897700 h 1194567"/>
              <a:gd name="connsiteX37" fmla="*/ 172006 w 1177180"/>
              <a:gd name="connsiteY37" fmla="*/ 694500 h 1194567"/>
              <a:gd name="connsiteX38" fmla="*/ 103744 w 1177180"/>
              <a:gd name="connsiteY38" fmla="*/ 483363 h 1194567"/>
              <a:gd name="connsiteX39" fmla="*/ 65644 w 1177180"/>
              <a:gd name="connsiteY39" fmla="*/ 432563 h 11945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408544 w 1177180"/>
              <a:gd name="connsiteY2" fmla="*/ 96013 h 1194567"/>
              <a:gd name="connsiteX3" fmla="*/ 402194 w 1177180"/>
              <a:gd name="connsiteY3" fmla="*/ 51563 h 1194567"/>
              <a:gd name="connsiteX4" fmla="*/ 332344 w 1177180"/>
              <a:gd name="connsiteY4" fmla="*/ 356363 h 1194567"/>
              <a:gd name="connsiteX5" fmla="*/ 357744 w 1177180"/>
              <a:gd name="connsiteY5" fmla="*/ 369063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72718 w 1177180"/>
              <a:gd name="connsiteY27" fmla="*/ 844682 h 1194567"/>
              <a:gd name="connsiteX28" fmla="*/ 288688 w 1177180"/>
              <a:gd name="connsiteY28" fmla="*/ 886588 h 1194567"/>
              <a:gd name="connsiteX29" fmla="*/ 212487 w 1177180"/>
              <a:gd name="connsiteY29" fmla="*/ 1122331 h 1194567"/>
              <a:gd name="connsiteX30" fmla="*/ 122794 w 1177180"/>
              <a:gd name="connsiteY30" fmla="*/ 1194563 h 1194567"/>
              <a:gd name="connsiteX31" fmla="*/ 192644 w 1177180"/>
              <a:gd name="connsiteY31" fmla="*/ 1124713 h 1194567"/>
              <a:gd name="connsiteX32" fmla="*/ 268844 w 1177180"/>
              <a:gd name="connsiteY32" fmla="*/ 940563 h 1194567"/>
              <a:gd name="connsiteX33" fmla="*/ 206931 w 1177180"/>
              <a:gd name="connsiteY33" fmla="*/ 807213 h 1194567"/>
              <a:gd name="connsiteX34" fmla="*/ 157719 w 1177180"/>
              <a:gd name="connsiteY34" fmla="*/ 888176 h 1194567"/>
              <a:gd name="connsiteX35" fmla="*/ 49769 w 1177180"/>
              <a:gd name="connsiteY35" fmla="*/ 1091375 h 1194567"/>
              <a:gd name="connsiteX36" fmla="*/ 2144 w 1177180"/>
              <a:gd name="connsiteY36" fmla="*/ 1169163 h 1194567"/>
              <a:gd name="connsiteX37" fmla="*/ 114857 w 1177180"/>
              <a:gd name="connsiteY37" fmla="*/ 897700 h 1194567"/>
              <a:gd name="connsiteX38" fmla="*/ 172006 w 1177180"/>
              <a:gd name="connsiteY38" fmla="*/ 694500 h 1194567"/>
              <a:gd name="connsiteX39" fmla="*/ 103744 w 1177180"/>
              <a:gd name="connsiteY39" fmla="*/ 483363 h 1194567"/>
              <a:gd name="connsiteX40" fmla="*/ 65644 w 1177180"/>
              <a:gd name="connsiteY40" fmla="*/ 432563 h 11945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408544 w 1177180"/>
              <a:gd name="connsiteY2" fmla="*/ 96013 h 1194567"/>
              <a:gd name="connsiteX3" fmla="*/ 402194 w 1177180"/>
              <a:gd name="connsiteY3" fmla="*/ 51563 h 1194567"/>
              <a:gd name="connsiteX4" fmla="*/ 332344 w 1177180"/>
              <a:gd name="connsiteY4" fmla="*/ 356363 h 1194567"/>
              <a:gd name="connsiteX5" fmla="*/ 357744 w 1177180"/>
              <a:gd name="connsiteY5" fmla="*/ 369063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72718 w 1177180"/>
              <a:gd name="connsiteY27" fmla="*/ 844682 h 1194567"/>
              <a:gd name="connsiteX28" fmla="*/ 300595 w 1177180"/>
              <a:gd name="connsiteY28" fmla="*/ 922307 h 1194567"/>
              <a:gd name="connsiteX29" fmla="*/ 212487 w 1177180"/>
              <a:gd name="connsiteY29" fmla="*/ 1122331 h 1194567"/>
              <a:gd name="connsiteX30" fmla="*/ 122794 w 1177180"/>
              <a:gd name="connsiteY30" fmla="*/ 1194563 h 1194567"/>
              <a:gd name="connsiteX31" fmla="*/ 192644 w 1177180"/>
              <a:gd name="connsiteY31" fmla="*/ 1124713 h 1194567"/>
              <a:gd name="connsiteX32" fmla="*/ 268844 w 1177180"/>
              <a:gd name="connsiteY32" fmla="*/ 940563 h 1194567"/>
              <a:gd name="connsiteX33" fmla="*/ 206931 w 1177180"/>
              <a:gd name="connsiteY33" fmla="*/ 807213 h 1194567"/>
              <a:gd name="connsiteX34" fmla="*/ 157719 w 1177180"/>
              <a:gd name="connsiteY34" fmla="*/ 888176 h 1194567"/>
              <a:gd name="connsiteX35" fmla="*/ 49769 w 1177180"/>
              <a:gd name="connsiteY35" fmla="*/ 1091375 h 1194567"/>
              <a:gd name="connsiteX36" fmla="*/ 2144 w 1177180"/>
              <a:gd name="connsiteY36" fmla="*/ 1169163 h 1194567"/>
              <a:gd name="connsiteX37" fmla="*/ 114857 w 1177180"/>
              <a:gd name="connsiteY37" fmla="*/ 897700 h 1194567"/>
              <a:gd name="connsiteX38" fmla="*/ 172006 w 1177180"/>
              <a:gd name="connsiteY38" fmla="*/ 694500 h 1194567"/>
              <a:gd name="connsiteX39" fmla="*/ 103744 w 1177180"/>
              <a:gd name="connsiteY39" fmla="*/ 483363 h 1194567"/>
              <a:gd name="connsiteX40" fmla="*/ 65644 w 1177180"/>
              <a:gd name="connsiteY40" fmla="*/ 432563 h 11945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408544 w 1177180"/>
              <a:gd name="connsiteY2" fmla="*/ 96013 h 1194567"/>
              <a:gd name="connsiteX3" fmla="*/ 402194 w 1177180"/>
              <a:gd name="connsiteY3" fmla="*/ 51563 h 1194567"/>
              <a:gd name="connsiteX4" fmla="*/ 332344 w 1177180"/>
              <a:gd name="connsiteY4" fmla="*/ 356363 h 1194567"/>
              <a:gd name="connsiteX5" fmla="*/ 357744 w 1177180"/>
              <a:gd name="connsiteY5" fmla="*/ 369063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72718 w 1177180"/>
              <a:gd name="connsiteY27" fmla="*/ 844682 h 1194567"/>
              <a:gd name="connsiteX28" fmla="*/ 289387 w 1177180"/>
              <a:gd name="connsiteY28" fmla="*/ 901832 h 1194567"/>
              <a:gd name="connsiteX29" fmla="*/ 300595 w 1177180"/>
              <a:gd name="connsiteY29" fmla="*/ 922307 h 1194567"/>
              <a:gd name="connsiteX30" fmla="*/ 212487 w 1177180"/>
              <a:gd name="connsiteY30" fmla="*/ 1122331 h 1194567"/>
              <a:gd name="connsiteX31" fmla="*/ 122794 w 1177180"/>
              <a:gd name="connsiteY31" fmla="*/ 1194563 h 1194567"/>
              <a:gd name="connsiteX32" fmla="*/ 192644 w 1177180"/>
              <a:gd name="connsiteY32" fmla="*/ 1124713 h 1194567"/>
              <a:gd name="connsiteX33" fmla="*/ 268844 w 1177180"/>
              <a:gd name="connsiteY33" fmla="*/ 940563 h 1194567"/>
              <a:gd name="connsiteX34" fmla="*/ 206931 w 1177180"/>
              <a:gd name="connsiteY34" fmla="*/ 807213 h 1194567"/>
              <a:gd name="connsiteX35" fmla="*/ 157719 w 1177180"/>
              <a:gd name="connsiteY35" fmla="*/ 888176 h 1194567"/>
              <a:gd name="connsiteX36" fmla="*/ 49769 w 1177180"/>
              <a:gd name="connsiteY36" fmla="*/ 1091375 h 1194567"/>
              <a:gd name="connsiteX37" fmla="*/ 2144 w 1177180"/>
              <a:gd name="connsiteY37" fmla="*/ 1169163 h 1194567"/>
              <a:gd name="connsiteX38" fmla="*/ 114857 w 1177180"/>
              <a:gd name="connsiteY38" fmla="*/ 897700 h 1194567"/>
              <a:gd name="connsiteX39" fmla="*/ 172006 w 1177180"/>
              <a:gd name="connsiteY39" fmla="*/ 694500 h 1194567"/>
              <a:gd name="connsiteX40" fmla="*/ 103744 w 1177180"/>
              <a:gd name="connsiteY40" fmla="*/ 483363 h 1194567"/>
              <a:gd name="connsiteX41" fmla="*/ 65644 w 1177180"/>
              <a:gd name="connsiteY41" fmla="*/ 432563 h 11945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408544 w 1177180"/>
              <a:gd name="connsiteY2" fmla="*/ 96013 h 1194567"/>
              <a:gd name="connsiteX3" fmla="*/ 402194 w 1177180"/>
              <a:gd name="connsiteY3" fmla="*/ 51563 h 1194567"/>
              <a:gd name="connsiteX4" fmla="*/ 332344 w 1177180"/>
              <a:gd name="connsiteY4" fmla="*/ 356363 h 1194567"/>
              <a:gd name="connsiteX5" fmla="*/ 357744 w 1177180"/>
              <a:gd name="connsiteY5" fmla="*/ 369063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72718 w 1177180"/>
              <a:gd name="connsiteY27" fmla="*/ 844682 h 1194567"/>
              <a:gd name="connsiteX28" fmla="*/ 289387 w 1177180"/>
              <a:gd name="connsiteY28" fmla="*/ 901832 h 1194567"/>
              <a:gd name="connsiteX29" fmla="*/ 293451 w 1177180"/>
              <a:gd name="connsiteY29" fmla="*/ 955645 h 1194567"/>
              <a:gd name="connsiteX30" fmla="*/ 212487 w 1177180"/>
              <a:gd name="connsiteY30" fmla="*/ 1122331 h 1194567"/>
              <a:gd name="connsiteX31" fmla="*/ 122794 w 1177180"/>
              <a:gd name="connsiteY31" fmla="*/ 1194563 h 1194567"/>
              <a:gd name="connsiteX32" fmla="*/ 192644 w 1177180"/>
              <a:gd name="connsiteY32" fmla="*/ 1124713 h 1194567"/>
              <a:gd name="connsiteX33" fmla="*/ 268844 w 1177180"/>
              <a:gd name="connsiteY33" fmla="*/ 940563 h 1194567"/>
              <a:gd name="connsiteX34" fmla="*/ 206931 w 1177180"/>
              <a:gd name="connsiteY34" fmla="*/ 807213 h 1194567"/>
              <a:gd name="connsiteX35" fmla="*/ 157719 w 1177180"/>
              <a:gd name="connsiteY35" fmla="*/ 888176 h 1194567"/>
              <a:gd name="connsiteX36" fmla="*/ 49769 w 1177180"/>
              <a:gd name="connsiteY36" fmla="*/ 1091375 h 1194567"/>
              <a:gd name="connsiteX37" fmla="*/ 2144 w 1177180"/>
              <a:gd name="connsiteY37" fmla="*/ 1169163 h 1194567"/>
              <a:gd name="connsiteX38" fmla="*/ 114857 w 1177180"/>
              <a:gd name="connsiteY38" fmla="*/ 897700 h 1194567"/>
              <a:gd name="connsiteX39" fmla="*/ 172006 w 1177180"/>
              <a:gd name="connsiteY39" fmla="*/ 694500 h 1194567"/>
              <a:gd name="connsiteX40" fmla="*/ 103744 w 1177180"/>
              <a:gd name="connsiteY40" fmla="*/ 483363 h 1194567"/>
              <a:gd name="connsiteX41" fmla="*/ 65644 w 1177180"/>
              <a:gd name="connsiteY41" fmla="*/ 432563 h 11945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408544 w 1177180"/>
              <a:gd name="connsiteY2" fmla="*/ 96013 h 1194567"/>
              <a:gd name="connsiteX3" fmla="*/ 402194 w 1177180"/>
              <a:gd name="connsiteY3" fmla="*/ 51563 h 1194567"/>
              <a:gd name="connsiteX4" fmla="*/ 346632 w 1177180"/>
              <a:gd name="connsiteY4" fmla="*/ 346838 h 1194567"/>
              <a:gd name="connsiteX5" fmla="*/ 357744 w 1177180"/>
              <a:gd name="connsiteY5" fmla="*/ 369063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72718 w 1177180"/>
              <a:gd name="connsiteY27" fmla="*/ 844682 h 1194567"/>
              <a:gd name="connsiteX28" fmla="*/ 289387 w 1177180"/>
              <a:gd name="connsiteY28" fmla="*/ 901832 h 1194567"/>
              <a:gd name="connsiteX29" fmla="*/ 293451 w 1177180"/>
              <a:gd name="connsiteY29" fmla="*/ 955645 h 1194567"/>
              <a:gd name="connsiteX30" fmla="*/ 212487 w 1177180"/>
              <a:gd name="connsiteY30" fmla="*/ 1122331 h 1194567"/>
              <a:gd name="connsiteX31" fmla="*/ 122794 w 1177180"/>
              <a:gd name="connsiteY31" fmla="*/ 1194563 h 1194567"/>
              <a:gd name="connsiteX32" fmla="*/ 192644 w 1177180"/>
              <a:gd name="connsiteY32" fmla="*/ 1124713 h 1194567"/>
              <a:gd name="connsiteX33" fmla="*/ 268844 w 1177180"/>
              <a:gd name="connsiteY33" fmla="*/ 940563 h 1194567"/>
              <a:gd name="connsiteX34" fmla="*/ 206931 w 1177180"/>
              <a:gd name="connsiteY34" fmla="*/ 807213 h 1194567"/>
              <a:gd name="connsiteX35" fmla="*/ 157719 w 1177180"/>
              <a:gd name="connsiteY35" fmla="*/ 888176 h 1194567"/>
              <a:gd name="connsiteX36" fmla="*/ 49769 w 1177180"/>
              <a:gd name="connsiteY36" fmla="*/ 1091375 h 1194567"/>
              <a:gd name="connsiteX37" fmla="*/ 2144 w 1177180"/>
              <a:gd name="connsiteY37" fmla="*/ 1169163 h 1194567"/>
              <a:gd name="connsiteX38" fmla="*/ 114857 w 1177180"/>
              <a:gd name="connsiteY38" fmla="*/ 897700 h 1194567"/>
              <a:gd name="connsiteX39" fmla="*/ 172006 w 1177180"/>
              <a:gd name="connsiteY39" fmla="*/ 694500 h 1194567"/>
              <a:gd name="connsiteX40" fmla="*/ 103744 w 1177180"/>
              <a:gd name="connsiteY40" fmla="*/ 483363 h 1194567"/>
              <a:gd name="connsiteX41" fmla="*/ 65644 w 1177180"/>
              <a:gd name="connsiteY41" fmla="*/ 432563 h 11945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368063 w 1177180"/>
              <a:gd name="connsiteY2" fmla="*/ 96013 h 1194567"/>
              <a:gd name="connsiteX3" fmla="*/ 402194 w 1177180"/>
              <a:gd name="connsiteY3" fmla="*/ 51563 h 1194567"/>
              <a:gd name="connsiteX4" fmla="*/ 346632 w 1177180"/>
              <a:gd name="connsiteY4" fmla="*/ 346838 h 1194567"/>
              <a:gd name="connsiteX5" fmla="*/ 357744 w 1177180"/>
              <a:gd name="connsiteY5" fmla="*/ 369063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72718 w 1177180"/>
              <a:gd name="connsiteY27" fmla="*/ 844682 h 1194567"/>
              <a:gd name="connsiteX28" fmla="*/ 289387 w 1177180"/>
              <a:gd name="connsiteY28" fmla="*/ 901832 h 1194567"/>
              <a:gd name="connsiteX29" fmla="*/ 293451 w 1177180"/>
              <a:gd name="connsiteY29" fmla="*/ 955645 h 1194567"/>
              <a:gd name="connsiteX30" fmla="*/ 212487 w 1177180"/>
              <a:gd name="connsiteY30" fmla="*/ 1122331 h 1194567"/>
              <a:gd name="connsiteX31" fmla="*/ 122794 w 1177180"/>
              <a:gd name="connsiteY31" fmla="*/ 1194563 h 1194567"/>
              <a:gd name="connsiteX32" fmla="*/ 192644 w 1177180"/>
              <a:gd name="connsiteY32" fmla="*/ 1124713 h 1194567"/>
              <a:gd name="connsiteX33" fmla="*/ 268844 w 1177180"/>
              <a:gd name="connsiteY33" fmla="*/ 940563 h 1194567"/>
              <a:gd name="connsiteX34" fmla="*/ 206931 w 1177180"/>
              <a:gd name="connsiteY34" fmla="*/ 807213 h 1194567"/>
              <a:gd name="connsiteX35" fmla="*/ 157719 w 1177180"/>
              <a:gd name="connsiteY35" fmla="*/ 888176 h 1194567"/>
              <a:gd name="connsiteX36" fmla="*/ 49769 w 1177180"/>
              <a:gd name="connsiteY36" fmla="*/ 1091375 h 1194567"/>
              <a:gd name="connsiteX37" fmla="*/ 2144 w 1177180"/>
              <a:gd name="connsiteY37" fmla="*/ 1169163 h 1194567"/>
              <a:gd name="connsiteX38" fmla="*/ 114857 w 1177180"/>
              <a:gd name="connsiteY38" fmla="*/ 897700 h 1194567"/>
              <a:gd name="connsiteX39" fmla="*/ 172006 w 1177180"/>
              <a:gd name="connsiteY39" fmla="*/ 694500 h 1194567"/>
              <a:gd name="connsiteX40" fmla="*/ 103744 w 1177180"/>
              <a:gd name="connsiteY40" fmla="*/ 483363 h 1194567"/>
              <a:gd name="connsiteX41" fmla="*/ 65644 w 1177180"/>
              <a:gd name="connsiteY41" fmla="*/ 432563 h 11945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387113 w 1177180"/>
              <a:gd name="connsiteY2" fmla="*/ 86488 h 1194567"/>
              <a:gd name="connsiteX3" fmla="*/ 402194 w 1177180"/>
              <a:gd name="connsiteY3" fmla="*/ 51563 h 1194567"/>
              <a:gd name="connsiteX4" fmla="*/ 346632 w 1177180"/>
              <a:gd name="connsiteY4" fmla="*/ 346838 h 1194567"/>
              <a:gd name="connsiteX5" fmla="*/ 357744 w 1177180"/>
              <a:gd name="connsiteY5" fmla="*/ 369063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72718 w 1177180"/>
              <a:gd name="connsiteY27" fmla="*/ 844682 h 1194567"/>
              <a:gd name="connsiteX28" fmla="*/ 289387 w 1177180"/>
              <a:gd name="connsiteY28" fmla="*/ 901832 h 1194567"/>
              <a:gd name="connsiteX29" fmla="*/ 293451 w 1177180"/>
              <a:gd name="connsiteY29" fmla="*/ 955645 h 1194567"/>
              <a:gd name="connsiteX30" fmla="*/ 212487 w 1177180"/>
              <a:gd name="connsiteY30" fmla="*/ 1122331 h 1194567"/>
              <a:gd name="connsiteX31" fmla="*/ 122794 w 1177180"/>
              <a:gd name="connsiteY31" fmla="*/ 1194563 h 1194567"/>
              <a:gd name="connsiteX32" fmla="*/ 192644 w 1177180"/>
              <a:gd name="connsiteY32" fmla="*/ 1124713 h 1194567"/>
              <a:gd name="connsiteX33" fmla="*/ 268844 w 1177180"/>
              <a:gd name="connsiteY33" fmla="*/ 940563 h 1194567"/>
              <a:gd name="connsiteX34" fmla="*/ 206931 w 1177180"/>
              <a:gd name="connsiteY34" fmla="*/ 807213 h 1194567"/>
              <a:gd name="connsiteX35" fmla="*/ 157719 w 1177180"/>
              <a:gd name="connsiteY35" fmla="*/ 888176 h 1194567"/>
              <a:gd name="connsiteX36" fmla="*/ 49769 w 1177180"/>
              <a:gd name="connsiteY36" fmla="*/ 1091375 h 1194567"/>
              <a:gd name="connsiteX37" fmla="*/ 2144 w 1177180"/>
              <a:gd name="connsiteY37" fmla="*/ 1169163 h 1194567"/>
              <a:gd name="connsiteX38" fmla="*/ 114857 w 1177180"/>
              <a:gd name="connsiteY38" fmla="*/ 897700 h 1194567"/>
              <a:gd name="connsiteX39" fmla="*/ 172006 w 1177180"/>
              <a:gd name="connsiteY39" fmla="*/ 694500 h 1194567"/>
              <a:gd name="connsiteX40" fmla="*/ 103744 w 1177180"/>
              <a:gd name="connsiteY40" fmla="*/ 483363 h 1194567"/>
              <a:gd name="connsiteX41" fmla="*/ 65644 w 1177180"/>
              <a:gd name="connsiteY41" fmla="*/ 432563 h 11945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387113 w 1177180"/>
              <a:gd name="connsiteY2" fmla="*/ 86488 h 1194567"/>
              <a:gd name="connsiteX3" fmla="*/ 402194 w 1177180"/>
              <a:gd name="connsiteY3" fmla="*/ 51563 h 1194567"/>
              <a:gd name="connsiteX4" fmla="*/ 360919 w 1177180"/>
              <a:gd name="connsiteY4" fmla="*/ 308738 h 1194567"/>
              <a:gd name="connsiteX5" fmla="*/ 357744 w 1177180"/>
              <a:gd name="connsiteY5" fmla="*/ 369063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72718 w 1177180"/>
              <a:gd name="connsiteY27" fmla="*/ 844682 h 1194567"/>
              <a:gd name="connsiteX28" fmla="*/ 289387 w 1177180"/>
              <a:gd name="connsiteY28" fmla="*/ 901832 h 1194567"/>
              <a:gd name="connsiteX29" fmla="*/ 293451 w 1177180"/>
              <a:gd name="connsiteY29" fmla="*/ 955645 h 1194567"/>
              <a:gd name="connsiteX30" fmla="*/ 212487 w 1177180"/>
              <a:gd name="connsiteY30" fmla="*/ 1122331 h 1194567"/>
              <a:gd name="connsiteX31" fmla="*/ 122794 w 1177180"/>
              <a:gd name="connsiteY31" fmla="*/ 1194563 h 1194567"/>
              <a:gd name="connsiteX32" fmla="*/ 192644 w 1177180"/>
              <a:gd name="connsiteY32" fmla="*/ 1124713 h 1194567"/>
              <a:gd name="connsiteX33" fmla="*/ 268844 w 1177180"/>
              <a:gd name="connsiteY33" fmla="*/ 940563 h 1194567"/>
              <a:gd name="connsiteX34" fmla="*/ 206931 w 1177180"/>
              <a:gd name="connsiteY34" fmla="*/ 807213 h 1194567"/>
              <a:gd name="connsiteX35" fmla="*/ 157719 w 1177180"/>
              <a:gd name="connsiteY35" fmla="*/ 888176 h 1194567"/>
              <a:gd name="connsiteX36" fmla="*/ 49769 w 1177180"/>
              <a:gd name="connsiteY36" fmla="*/ 1091375 h 1194567"/>
              <a:gd name="connsiteX37" fmla="*/ 2144 w 1177180"/>
              <a:gd name="connsiteY37" fmla="*/ 1169163 h 1194567"/>
              <a:gd name="connsiteX38" fmla="*/ 114857 w 1177180"/>
              <a:gd name="connsiteY38" fmla="*/ 897700 h 1194567"/>
              <a:gd name="connsiteX39" fmla="*/ 172006 w 1177180"/>
              <a:gd name="connsiteY39" fmla="*/ 694500 h 1194567"/>
              <a:gd name="connsiteX40" fmla="*/ 103744 w 1177180"/>
              <a:gd name="connsiteY40" fmla="*/ 483363 h 1194567"/>
              <a:gd name="connsiteX41" fmla="*/ 65644 w 1177180"/>
              <a:gd name="connsiteY41" fmla="*/ 432563 h 1194567"/>
              <a:gd name="connsiteX0" fmla="*/ 65644 w 1177180"/>
              <a:gd name="connsiteY0" fmla="*/ 432563 h 1194567"/>
              <a:gd name="connsiteX1" fmla="*/ 319644 w 1177180"/>
              <a:gd name="connsiteY1" fmla="*/ 330963 h 1194567"/>
              <a:gd name="connsiteX2" fmla="*/ 387113 w 1177180"/>
              <a:gd name="connsiteY2" fmla="*/ 86488 h 1194567"/>
              <a:gd name="connsiteX3" fmla="*/ 402194 w 1177180"/>
              <a:gd name="connsiteY3" fmla="*/ 51563 h 1194567"/>
              <a:gd name="connsiteX4" fmla="*/ 360919 w 1177180"/>
              <a:gd name="connsiteY4" fmla="*/ 308738 h 1194567"/>
              <a:gd name="connsiteX5" fmla="*/ 374412 w 1177180"/>
              <a:gd name="connsiteY5" fmla="*/ 347632 h 1194567"/>
              <a:gd name="connsiteX6" fmla="*/ 421244 w 1177180"/>
              <a:gd name="connsiteY6" fmla="*/ 375413 h 1194567"/>
              <a:gd name="connsiteX7" fmla="*/ 624444 w 1177180"/>
              <a:gd name="connsiteY7" fmla="*/ 318263 h 1194567"/>
              <a:gd name="connsiteX8" fmla="*/ 878444 w 1177180"/>
              <a:gd name="connsiteY8" fmla="*/ 26163 h 1194567"/>
              <a:gd name="connsiteX9" fmla="*/ 1087994 w 1177180"/>
              <a:gd name="connsiteY9" fmla="*/ 19813 h 1194567"/>
              <a:gd name="connsiteX10" fmla="*/ 859394 w 1177180"/>
              <a:gd name="connsiteY10" fmla="*/ 76963 h 1194567"/>
              <a:gd name="connsiteX11" fmla="*/ 738744 w 1177180"/>
              <a:gd name="connsiteY11" fmla="*/ 248413 h 1194567"/>
              <a:gd name="connsiteX12" fmla="*/ 484744 w 1177180"/>
              <a:gd name="connsiteY12" fmla="*/ 394463 h 1194567"/>
              <a:gd name="connsiteX13" fmla="*/ 300594 w 1177180"/>
              <a:gd name="connsiteY13" fmla="*/ 438913 h 1194567"/>
              <a:gd name="connsiteX14" fmla="*/ 529194 w 1177180"/>
              <a:gd name="connsiteY14" fmla="*/ 569088 h 1194567"/>
              <a:gd name="connsiteX15" fmla="*/ 799069 w 1177180"/>
              <a:gd name="connsiteY15" fmla="*/ 654813 h 1194567"/>
              <a:gd name="connsiteX16" fmla="*/ 1027669 w 1177180"/>
              <a:gd name="connsiteY16" fmla="*/ 610363 h 1194567"/>
              <a:gd name="connsiteX17" fmla="*/ 1176894 w 1177180"/>
              <a:gd name="connsiteY17" fmla="*/ 731013 h 1194567"/>
              <a:gd name="connsiteX18" fmla="*/ 991157 w 1177180"/>
              <a:gd name="connsiteY18" fmla="*/ 642113 h 1194567"/>
              <a:gd name="connsiteX19" fmla="*/ 745094 w 1177180"/>
              <a:gd name="connsiteY19" fmla="*/ 686563 h 1194567"/>
              <a:gd name="connsiteX20" fmla="*/ 452994 w 1177180"/>
              <a:gd name="connsiteY20" fmla="*/ 591313 h 1194567"/>
              <a:gd name="connsiteX21" fmla="*/ 503794 w 1177180"/>
              <a:gd name="connsiteY21" fmla="*/ 737363 h 1194567"/>
              <a:gd name="connsiteX22" fmla="*/ 732394 w 1177180"/>
              <a:gd name="connsiteY22" fmla="*/ 1054863 h 1194567"/>
              <a:gd name="connsiteX23" fmla="*/ 579994 w 1177180"/>
              <a:gd name="connsiteY23" fmla="*/ 908813 h 1194567"/>
              <a:gd name="connsiteX24" fmla="*/ 389494 w 1177180"/>
              <a:gd name="connsiteY24" fmla="*/ 610363 h 1194567"/>
              <a:gd name="connsiteX25" fmla="*/ 243444 w 1177180"/>
              <a:gd name="connsiteY25" fmla="*/ 496063 h 1194567"/>
              <a:gd name="connsiteX26" fmla="*/ 230744 w 1177180"/>
              <a:gd name="connsiteY26" fmla="*/ 705613 h 1194567"/>
              <a:gd name="connsiteX27" fmla="*/ 272718 w 1177180"/>
              <a:gd name="connsiteY27" fmla="*/ 844682 h 1194567"/>
              <a:gd name="connsiteX28" fmla="*/ 289387 w 1177180"/>
              <a:gd name="connsiteY28" fmla="*/ 901832 h 1194567"/>
              <a:gd name="connsiteX29" fmla="*/ 293451 w 1177180"/>
              <a:gd name="connsiteY29" fmla="*/ 955645 h 1194567"/>
              <a:gd name="connsiteX30" fmla="*/ 212487 w 1177180"/>
              <a:gd name="connsiteY30" fmla="*/ 1122331 h 1194567"/>
              <a:gd name="connsiteX31" fmla="*/ 122794 w 1177180"/>
              <a:gd name="connsiteY31" fmla="*/ 1194563 h 1194567"/>
              <a:gd name="connsiteX32" fmla="*/ 192644 w 1177180"/>
              <a:gd name="connsiteY32" fmla="*/ 1124713 h 1194567"/>
              <a:gd name="connsiteX33" fmla="*/ 268844 w 1177180"/>
              <a:gd name="connsiteY33" fmla="*/ 940563 h 1194567"/>
              <a:gd name="connsiteX34" fmla="*/ 206931 w 1177180"/>
              <a:gd name="connsiteY34" fmla="*/ 807213 h 1194567"/>
              <a:gd name="connsiteX35" fmla="*/ 157719 w 1177180"/>
              <a:gd name="connsiteY35" fmla="*/ 888176 h 1194567"/>
              <a:gd name="connsiteX36" fmla="*/ 49769 w 1177180"/>
              <a:gd name="connsiteY36" fmla="*/ 1091375 h 1194567"/>
              <a:gd name="connsiteX37" fmla="*/ 2144 w 1177180"/>
              <a:gd name="connsiteY37" fmla="*/ 1169163 h 1194567"/>
              <a:gd name="connsiteX38" fmla="*/ 114857 w 1177180"/>
              <a:gd name="connsiteY38" fmla="*/ 897700 h 1194567"/>
              <a:gd name="connsiteX39" fmla="*/ 172006 w 1177180"/>
              <a:gd name="connsiteY39" fmla="*/ 694500 h 1194567"/>
              <a:gd name="connsiteX40" fmla="*/ 103744 w 1177180"/>
              <a:gd name="connsiteY40" fmla="*/ 483363 h 1194567"/>
              <a:gd name="connsiteX41" fmla="*/ 65644 w 1177180"/>
              <a:gd name="connsiteY41" fmla="*/ 432563 h 11945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</a:cxnLst>
            <a:rect l="l" t="t" r="r" b="b"/>
            <a:pathLst>
              <a:path w="1177180" h="1194567">
                <a:moveTo>
                  <a:pt x="65644" y="432563"/>
                </a:moveTo>
                <a:cubicBezTo>
                  <a:pt x="101627" y="407163"/>
                  <a:pt x="266066" y="388642"/>
                  <a:pt x="319644" y="330963"/>
                </a:cubicBezTo>
                <a:cubicBezTo>
                  <a:pt x="373222" y="273284"/>
                  <a:pt x="373355" y="133055"/>
                  <a:pt x="387113" y="86488"/>
                </a:cubicBezTo>
                <a:cubicBezTo>
                  <a:pt x="400871" y="39921"/>
                  <a:pt x="406560" y="14521"/>
                  <a:pt x="402194" y="51563"/>
                </a:cubicBezTo>
                <a:cubicBezTo>
                  <a:pt x="397828" y="88605"/>
                  <a:pt x="365549" y="259393"/>
                  <a:pt x="360919" y="308738"/>
                </a:cubicBezTo>
                <a:cubicBezTo>
                  <a:pt x="356289" y="358083"/>
                  <a:pt x="364358" y="336520"/>
                  <a:pt x="374412" y="347632"/>
                </a:cubicBezTo>
                <a:cubicBezTo>
                  <a:pt x="384466" y="358744"/>
                  <a:pt x="379572" y="380308"/>
                  <a:pt x="421244" y="375413"/>
                </a:cubicBezTo>
                <a:cubicBezTo>
                  <a:pt x="462916" y="370518"/>
                  <a:pt x="548244" y="376471"/>
                  <a:pt x="624444" y="318263"/>
                </a:cubicBezTo>
                <a:cubicBezTo>
                  <a:pt x="700644" y="260055"/>
                  <a:pt x="801186" y="75905"/>
                  <a:pt x="878444" y="26163"/>
                </a:cubicBezTo>
                <a:cubicBezTo>
                  <a:pt x="955702" y="-23579"/>
                  <a:pt x="1091169" y="11346"/>
                  <a:pt x="1087994" y="19813"/>
                </a:cubicBezTo>
                <a:cubicBezTo>
                  <a:pt x="1084819" y="28280"/>
                  <a:pt x="917602" y="38863"/>
                  <a:pt x="859394" y="76963"/>
                </a:cubicBezTo>
                <a:cubicBezTo>
                  <a:pt x="801186" y="115063"/>
                  <a:pt x="801186" y="195496"/>
                  <a:pt x="738744" y="248413"/>
                </a:cubicBezTo>
                <a:cubicBezTo>
                  <a:pt x="676302" y="301330"/>
                  <a:pt x="557769" y="362713"/>
                  <a:pt x="484744" y="394463"/>
                </a:cubicBezTo>
                <a:cubicBezTo>
                  <a:pt x="411719" y="426213"/>
                  <a:pt x="293186" y="409809"/>
                  <a:pt x="300594" y="438913"/>
                </a:cubicBezTo>
                <a:cubicBezTo>
                  <a:pt x="308002" y="468017"/>
                  <a:pt x="446115" y="533105"/>
                  <a:pt x="529194" y="569088"/>
                </a:cubicBezTo>
                <a:cubicBezTo>
                  <a:pt x="612273" y="605071"/>
                  <a:pt x="715990" y="647934"/>
                  <a:pt x="799069" y="654813"/>
                </a:cubicBezTo>
                <a:cubicBezTo>
                  <a:pt x="882148" y="661692"/>
                  <a:pt x="964698" y="597663"/>
                  <a:pt x="1027669" y="610363"/>
                </a:cubicBezTo>
                <a:cubicBezTo>
                  <a:pt x="1090640" y="623063"/>
                  <a:pt x="1182979" y="725721"/>
                  <a:pt x="1176894" y="731013"/>
                </a:cubicBezTo>
                <a:cubicBezTo>
                  <a:pt x="1170809" y="736305"/>
                  <a:pt x="1063124" y="649521"/>
                  <a:pt x="991157" y="642113"/>
                </a:cubicBezTo>
                <a:cubicBezTo>
                  <a:pt x="919190" y="634705"/>
                  <a:pt x="834788" y="695030"/>
                  <a:pt x="745094" y="686563"/>
                </a:cubicBezTo>
                <a:cubicBezTo>
                  <a:pt x="655400" y="678096"/>
                  <a:pt x="493210" y="582846"/>
                  <a:pt x="452994" y="591313"/>
                </a:cubicBezTo>
                <a:cubicBezTo>
                  <a:pt x="412778" y="599780"/>
                  <a:pt x="457227" y="660105"/>
                  <a:pt x="503794" y="737363"/>
                </a:cubicBezTo>
                <a:cubicBezTo>
                  <a:pt x="550361" y="814621"/>
                  <a:pt x="719694" y="1026288"/>
                  <a:pt x="732394" y="1054863"/>
                </a:cubicBezTo>
                <a:cubicBezTo>
                  <a:pt x="745094" y="1083438"/>
                  <a:pt x="637144" y="982896"/>
                  <a:pt x="579994" y="908813"/>
                </a:cubicBezTo>
                <a:cubicBezTo>
                  <a:pt x="522844" y="834730"/>
                  <a:pt x="445586" y="679155"/>
                  <a:pt x="389494" y="610363"/>
                </a:cubicBezTo>
                <a:cubicBezTo>
                  <a:pt x="333402" y="541571"/>
                  <a:pt x="269902" y="480188"/>
                  <a:pt x="243444" y="496063"/>
                </a:cubicBezTo>
                <a:cubicBezTo>
                  <a:pt x="216986" y="511938"/>
                  <a:pt x="225865" y="647510"/>
                  <a:pt x="230744" y="705613"/>
                </a:cubicBezTo>
                <a:cubicBezTo>
                  <a:pt x="235623" y="763716"/>
                  <a:pt x="260960" y="811979"/>
                  <a:pt x="272718" y="844682"/>
                </a:cubicBezTo>
                <a:cubicBezTo>
                  <a:pt x="284476" y="877385"/>
                  <a:pt x="284741" y="888895"/>
                  <a:pt x="289387" y="901832"/>
                </a:cubicBezTo>
                <a:cubicBezTo>
                  <a:pt x="294033" y="914769"/>
                  <a:pt x="306268" y="918895"/>
                  <a:pt x="293451" y="955645"/>
                </a:cubicBezTo>
                <a:cubicBezTo>
                  <a:pt x="280634" y="992395"/>
                  <a:pt x="240930" y="1082511"/>
                  <a:pt x="212487" y="1122331"/>
                </a:cubicBezTo>
                <a:cubicBezTo>
                  <a:pt x="184044" y="1162151"/>
                  <a:pt x="126101" y="1194166"/>
                  <a:pt x="122794" y="1194563"/>
                </a:cubicBezTo>
                <a:cubicBezTo>
                  <a:pt x="119487" y="1194960"/>
                  <a:pt x="168302" y="1167046"/>
                  <a:pt x="192644" y="1124713"/>
                </a:cubicBezTo>
                <a:cubicBezTo>
                  <a:pt x="216986" y="1082380"/>
                  <a:pt x="266463" y="993480"/>
                  <a:pt x="268844" y="940563"/>
                </a:cubicBezTo>
                <a:cubicBezTo>
                  <a:pt x="271225" y="887646"/>
                  <a:pt x="225452" y="815944"/>
                  <a:pt x="206931" y="807213"/>
                </a:cubicBezTo>
                <a:cubicBezTo>
                  <a:pt x="188410" y="798482"/>
                  <a:pt x="183913" y="840816"/>
                  <a:pt x="157719" y="888176"/>
                </a:cubicBezTo>
                <a:cubicBezTo>
                  <a:pt x="131525" y="935536"/>
                  <a:pt x="75698" y="1044544"/>
                  <a:pt x="49769" y="1091375"/>
                </a:cubicBezTo>
                <a:cubicBezTo>
                  <a:pt x="23840" y="1138206"/>
                  <a:pt x="-8704" y="1201442"/>
                  <a:pt x="2144" y="1169163"/>
                </a:cubicBezTo>
                <a:cubicBezTo>
                  <a:pt x="12992" y="1136884"/>
                  <a:pt x="86547" y="976810"/>
                  <a:pt x="114857" y="897700"/>
                </a:cubicBezTo>
                <a:cubicBezTo>
                  <a:pt x="143167" y="818590"/>
                  <a:pt x="166714" y="764350"/>
                  <a:pt x="172006" y="694500"/>
                </a:cubicBezTo>
                <a:cubicBezTo>
                  <a:pt x="177298" y="624650"/>
                  <a:pt x="121471" y="527019"/>
                  <a:pt x="103744" y="483363"/>
                </a:cubicBezTo>
                <a:cubicBezTo>
                  <a:pt x="86017" y="439707"/>
                  <a:pt x="29661" y="457963"/>
                  <a:pt x="65644" y="432563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5492FA8-797F-409A-AD3F-D93A4BDC3CBF}"/>
              </a:ext>
            </a:extLst>
          </p:cNvPr>
          <p:cNvSpPr txBox="1"/>
          <p:nvPr/>
        </p:nvSpPr>
        <p:spPr>
          <a:xfrm>
            <a:off x="2455109" y="8654031"/>
            <a:ext cx="1120820" cy="369332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rons</a:t>
            </a:r>
            <a:endParaRPr lang="zh-CN" altLang="en-US" b="1" dirty="0">
              <a:solidFill>
                <a:schemeClr val="accent2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文本框 292">
            <a:extLst>
              <a:ext uri="{FF2B5EF4-FFF2-40B4-BE49-F238E27FC236}">
                <a16:creationId xmlns:a16="http://schemas.microsoft.com/office/drawing/2014/main" id="{22D6D113-B4F8-4422-8AC9-D14D35E9B8DC}"/>
              </a:ext>
            </a:extLst>
          </p:cNvPr>
          <p:cNvSpPr txBox="1"/>
          <p:nvPr/>
        </p:nvSpPr>
        <p:spPr>
          <a:xfrm>
            <a:off x="4804090" y="7772590"/>
            <a:ext cx="641522" cy="307777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endParaRPr lang="zh-CN" altLang="en-US" sz="1400" b="1" dirty="0">
              <a:solidFill>
                <a:schemeClr val="accent5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文本框 293">
            <a:extLst>
              <a:ext uri="{FF2B5EF4-FFF2-40B4-BE49-F238E27FC236}">
                <a16:creationId xmlns:a16="http://schemas.microsoft.com/office/drawing/2014/main" id="{79F60C00-5B0B-453E-BED1-8F029C906E21}"/>
              </a:ext>
            </a:extLst>
          </p:cNvPr>
          <p:cNvSpPr txBox="1"/>
          <p:nvPr/>
        </p:nvSpPr>
        <p:spPr>
          <a:xfrm>
            <a:off x="840233" y="7772590"/>
            <a:ext cx="511679" cy="307777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solidFill>
                  <a:srgbClr val="EB29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endParaRPr lang="zh-CN" altLang="en-US" sz="1400" b="1" dirty="0">
              <a:solidFill>
                <a:srgbClr val="EB292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1" name="直接箭头连接符 540">
            <a:extLst>
              <a:ext uri="{FF2B5EF4-FFF2-40B4-BE49-F238E27FC236}">
                <a16:creationId xmlns:a16="http://schemas.microsoft.com/office/drawing/2014/main" id="{AB0995E5-0053-447D-8572-FC331880B7C3}"/>
              </a:ext>
            </a:extLst>
          </p:cNvPr>
          <p:cNvCxnSpPr>
            <a:cxnSpLocks/>
            <a:endCxn id="186" idx="4"/>
          </p:cNvCxnSpPr>
          <p:nvPr/>
        </p:nvCxnSpPr>
        <p:spPr>
          <a:xfrm flipH="1">
            <a:off x="4851744" y="7273477"/>
            <a:ext cx="146475" cy="67421"/>
          </a:xfrm>
          <a:prstGeom prst="straightConnector1">
            <a:avLst/>
          </a:prstGeom>
          <a:ln w="9525">
            <a:noFill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5781CE64-0A2D-40F6-A685-0F2528BE16A5}"/>
              </a:ext>
            </a:extLst>
          </p:cNvPr>
          <p:cNvGrpSpPr/>
          <p:nvPr/>
        </p:nvGrpSpPr>
        <p:grpSpPr>
          <a:xfrm flipH="1">
            <a:off x="3651430" y="7017248"/>
            <a:ext cx="891043" cy="958107"/>
            <a:chOff x="4958582" y="1025021"/>
            <a:chExt cx="1436637" cy="1544762"/>
          </a:xfrm>
        </p:grpSpPr>
        <p:sp>
          <p:nvSpPr>
            <p:cNvPr id="5" name="任意多边形: 形状 4">
              <a:extLst>
                <a:ext uri="{FF2B5EF4-FFF2-40B4-BE49-F238E27FC236}">
                  <a16:creationId xmlns:a16="http://schemas.microsoft.com/office/drawing/2014/main" id="{03A3263E-607E-41A8-94BE-F556E8976F1F}"/>
                </a:ext>
              </a:extLst>
            </p:cNvPr>
            <p:cNvSpPr/>
            <p:nvPr/>
          </p:nvSpPr>
          <p:spPr>
            <a:xfrm>
              <a:off x="5245100" y="1025021"/>
              <a:ext cx="863600" cy="1544762"/>
            </a:xfrm>
            <a:custGeom>
              <a:avLst/>
              <a:gdLst>
                <a:gd name="connsiteX0" fmla="*/ 0 w 863600"/>
                <a:gd name="connsiteY0" fmla="*/ 1018641 h 1543725"/>
                <a:gd name="connsiteX1" fmla="*/ 101600 w 863600"/>
                <a:gd name="connsiteY1" fmla="*/ 383641 h 1543725"/>
                <a:gd name="connsiteX2" fmla="*/ 139700 w 863600"/>
                <a:gd name="connsiteY2" fmla="*/ 53441 h 1543725"/>
                <a:gd name="connsiteX3" fmla="*/ 190500 w 863600"/>
                <a:gd name="connsiteY3" fmla="*/ 1513941 h 1543725"/>
                <a:gd name="connsiteX4" fmla="*/ 266700 w 863600"/>
                <a:gd name="connsiteY4" fmla="*/ 993241 h 1543725"/>
                <a:gd name="connsiteX5" fmla="*/ 317500 w 863600"/>
                <a:gd name="connsiteY5" fmla="*/ 472541 h 1543725"/>
                <a:gd name="connsiteX6" fmla="*/ 355600 w 863600"/>
                <a:gd name="connsiteY6" fmla="*/ 701141 h 1543725"/>
                <a:gd name="connsiteX7" fmla="*/ 342900 w 863600"/>
                <a:gd name="connsiteY7" fmla="*/ 1285341 h 1543725"/>
                <a:gd name="connsiteX8" fmla="*/ 342900 w 863600"/>
                <a:gd name="connsiteY8" fmla="*/ 1374241 h 1543725"/>
                <a:gd name="connsiteX9" fmla="*/ 419100 w 863600"/>
                <a:gd name="connsiteY9" fmla="*/ 802741 h 1543725"/>
                <a:gd name="connsiteX10" fmla="*/ 419100 w 863600"/>
                <a:gd name="connsiteY10" fmla="*/ 536041 h 1543725"/>
                <a:gd name="connsiteX11" fmla="*/ 469900 w 863600"/>
                <a:gd name="connsiteY11" fmla="*/ 320141 h 1543725"/>
                <a:gd name="connsiteX12" fmla="*/ 469900 w 863600"/>
                <a:gd name="connsiteY12" fmla="*/ 1196441 h 1543725"/>
                <a:gd name="connsiteX13" fmla="*/ 622300 w 863600"/>
                <a:gd name="connsiteY13" fmla="*/ 650341 h 1543725"/>
                <a:gd name="connsiteX14" fmla="*/ 711200 w 863600"/>
                <a:gd name="connsiteY14" fmla="*/ 1221841 h 1543725"/>
                <a:gd name="connsiteX15" fmla="*/ 787400 w 863600"/>
                <a:gd name="connsiteY15" fmla="*/ 878941 h 1543725"/>
                <a:gd name="connsiteX16" fmla="*/ 863600 w 863600"/>
                <a:gd name="connsiteY16" fmla="*/ 1069441 h 1543725"/>
                <a:gd name="connsiteX0" fmla="*/ 0 w 863600"/>
                <a:gd name="connsiteY0" fmla="*/ 1018641 h 1543725"/>
                <a:gd name="connsiteX1" fmla="*/ 101600 w 863600"/>
                <a:gd name="connsiteY1" fmla="*/ 383641 h 1543725"/>
                <a:gd name="connsiteX2" fmla="*/ 139700 w 863600"/>
                <a:gd name="connsiteY2" fmla="*/ 53441 h 1543725"/>
                <a:gd name="connsiteX3" fmla="*/ 190500 w 863600"/>
                <a:gd name="connsiteY3" fmla="*/ 1513941 h 1543725"/>
                <a:gd name="connsiteX4" fmla="*/ 266700 w 863600"/>
                <a:gd name="connsiteY4" fmla="*/ 993241 h 1543725"/>
                <a:gd name="connsiteX5" fmla="*/ 317500 w 863600"/>
                <a:gd name="connsiteY5" fmla="*/ 472541 h 1543725"/>
                <a:gd name="connsiteX6" fmla="*/ 355600 w 863600"/>
                <a:gd name="connsiteY6" fmla="*/ 701141 h 1543725"/>
                <a:gd name="connsiteX7" fmla="*/ 342900 w 863600"/>
                <a:gd name="connsiteY7" fmla="*/ 1285341 h 1543725"/>
                <a:gd name="connsiteX8" fmla="*/ 342900 w 863600"/>
                <a:gd name="connsiteY8" fmla="*/ 1374241 h 1543725"/>
                <a:gd name="connsiteX9" fmla="*/ 419100 w 863600"/>
                <a:gd name="connsiteY9" fmla="*/ 802741 h 1543725"/>
                <a:gd name="connsiteX10" fmla="*/ 442913 w 863600"/>
                <a:gd name="connsiteY10" fmla="*/ 536041 h 1543725"/>
                <a:gd name="connsiteX11" fmla="*/ 469900 w 863600"/>
                <a:gd name="connsiteY11" fmla="*/ 320141 h 1543725"/>
                <a:gd name="connsiteX12" fmla="*/ 469900 w 863600"/>
                <a:gd name="connsiteY12" fmla="*/ 1196441 h 1543725"/>
                <a:gd name="connsiteX13" fmla="*/ 622300 w 863600"/>
                <a:gd name="connsiteY13" fmla="*/ 650341 h 1543725"/>
                <a:gd name="connsiteX14" fmla="*/ 711200 w 863600"/>
                <a:gd name="connsiteY14" fmla="*/ 1221841 h 1543725"/>
                <a:gd name="connsiteX15" fmla="*/ 787400 w 863600"/>
                <a:gd name="connsiteY15" fmla="*/ 878941 h 1543725"/>
                <a:gd name="connsiteX16" fmla="*/ 863600 w 863600"/>
                <a:gd name="connsiteY16" fmla="*/ 1069441 h 1543725"/>
                <a:gd name="connsiteX0" fmla="*/ 0 w 863600"/>
                <a:gd name="connsiteY0" fmla="*/ 1019042 h 1544126"/>
                <a:gd name="connsiteX1" fmla="*/ 89694 w 863600"/>
                <a:gd name="connsiteY1" fmla="*/ 381661 h 1544126"/>
                <a:gd name="connsiteX2" fmla="*/ 139700 w 863600"/>
                <a:gd name="connsiteY2" fmla="*/ 53842 h 1544126"/>
                <a:gd name="connsiteX3" fmla="*/ 190500 w 863600"/>
                <a:gd name="connsiteY3" fmla="*/ 1514342 h 1544126"/>
                <a:gd name="connsiteX4" fmla="*/ 266700 w 863600"/>
                <a:gd name="connsiteY4" fmla="*/ 993642 h 1544126"/>
                <a:gd name="connsiteX5" fmla="*/ 317500 w 863600"/>
                <a:gd name="connsiteY5" fmla="*/ 472942 h 1544126"/>
                <a:gd name="connsiteX6" fmla="*/ 355600 w 863600"/>
                <a:gd name="connsiteY6" fmla="*/ 701542 h 1544126"/>
                <a:gd name="connsiteX7" fmla="*/ 342900 w 863600"/>
                <a:gd name="connsiteY7" fmla="*/ 1285742 h 1544126"/>
                <a:gd name="connsiteX8" fmla="*/ 342900 w 863600"/>
                <a:gd name="connsiteY8" fmla="*/ 1374642 h 1544126"/>
                <a:gd name="connsiteX9" fmla="*/ 419100 w 863600"/>
                <a:gd name="connsiteY9" fmla="*/ 803142 h 1544126"/>
                <a:gd name="connsiteX10" fmla="*/ 442913 w 863600"/>
                <a:gd name="connsiteY10" fmla="*/ 536442 h 1544126"/>
                <a:gd name="connsiteX11" fmla="*/ 469900 w 863600"/>
                <a:gd name="connsiteY11" fmla="*/ 320542 h 1544126"/>
                <a:gd name="connsiteX12" fmla="*/ 469900 w 863600"/>
                <a:gd name="connsiteY12" fmla="*/ 1196842 h 1544126"/>
                <a:gd name="connsiteX13" fmla="*/ 622300 w 863600"/>
                <a:gd name="connsiteY13" fmla="*/ 650742 h 1544126"/>
                <a:gd name="connsiteX14" fmla="*/ 711200 w 863600"/>
                <a:gd name="connsiteY14" fmla="*/ 1222242 h 1544126"/>
                <a:gd name="connsiteX15" fmla="*/ 787400 w 863600"/>
                <a:gd name="connsiteY15" fmla="*/ 879342 h 1544126"/>
                <a:gd name="connsiteX16" fmla="*/ 863600 w 863600"/>
                <a:gd name="connsiteY16" fmla="*/ 1069842 h 1544126"/>
                <a:gd name="connsiteX0" fmla="*/ 0 w 863600"/>
                <a:gd name="connsiteY0" fmla="*/ 1019445 h 1544529"/>
                <a:gd name="connsiteX1" fmla="*/ 70644 w 863600"/>
                <a:gd name="connsiteY1" fmla="*/ 379683 h 1544529"/>
                <a:gd name="connsiteX2" fmla="*/ 139700 w 863600"/>
                <a:gd name="connsiteY2" fmla="*/ 54245 h 1544529"/>
                <a:gd name="connsiteX3" fmla="*/ 190500 w 863600"/>
                <a:gd name="connsiteY3" fmla="*/ 1514745 h 1544529"/>
                <a:gd name="connsiteX4" fmla="*/ 266700 w 863600"/>
                <a:gd name="connsiteY4" fmla="*/ 994045 h 1544529"/>
                <a:gd name="connsiteX5" fmla="*/ 317500 w 863600"/>
                <a:gd name="connsiteY5" fmla="*/ 473345 h 1544529"/>
                <a:gd name="connsiteX6" fmla="*/ 355600 w 863600"/>
                <a:gd name="connsiteY6" fmla="*/ 701945 h 1544529"/>
                <a:gd name="connsiteX7" fmla="*/ 342900 w 863600"/>
                <a:gd name="connsiteY7" fmla="*/ 1286145 h 1544529"/>
                <a:gd name="connsiteX8" fmla="*/ 342900 w 863600"/>
                <a:gd name="connsiteY8" fmla="*/ 1375045 h 1544529"/>
                <a:gd name="connsiteX9" fmla="*/ 419100 w 863600"/>
                <a:gd name="connsiteY9" fmla="*/ 803545 h 1544529"/>
                <a:gd name="connsiteX10" fmla="*/ 442913 w 863600"/>
                <a:gd name="connsiteY10" fmla="*/ 536845 h 1544529"/>
                <a:gd name="connsiteX11" fmla="*/ 469900 w 863600"/>
                <a:gd name="connsiteY11" fmla="*/ 320945 h 1544529"/>
                <a:gd name="connsiteX12" fmla="*/ 469900 w 863600"/>
                <a:gd name="connsiteY12" fmla="*/ 1197245 h 1544529"/>
                <a:gd name="connsiteX13" fmla="*/ 622300 w 863600"/>
                <a:gd name="connsiteY13" fmla="*/ 651145 h 1544529"/>
                <a:gd name="connsiteX14" fmla="*/ 711200 w 863600"/>
                <a:gd name="connsiteY14" fmla="*/ 1222645 h 1544529"/>
                <a:gd name="connsiteX15" fmla="*/ 787400 w 863600"/>
                <a:gd name="connsiteY15" fmla="*/ 879745 h 1544529"/>
                <a:gd name="connsiteX16" fmla="*/ 863600 w 863600"/>
                <a:gd name="connsiteY16" fmla="*/ 1070245 h 1544529"/>
                <a:gd name="connsiteX0" fmla="*/ 0 w 863600"/>
                <a:gd name="connsiteY0" fmla="*/ 1019445 h 1544529"/>
                <a:gd name="connsiteX1" fmla="*/ 84932 w 863600"/>
                <a:gd name="connsiteY1" fmla="*/ 379683 h 1544529"/>
                <a:gd name="connsiteX2" fmla="*/ 139700 w 863600"/>
                <a:gd name="connsiteY2" fmla="*/ 54245 h 1544529"/>
                <a:gd name="connsiteX3" fmla="*/ 190500 w 863600"/>
                <a:gd name="connsiteY3" fmla="*/ 1514745 h 1544529"/>
                <a:gd name="connsiteX4" fmla="*/ 266700 w 863600"/>
                <a:gd name="connsiteY4" fmla="*/ 994045 h 1544529"/>
                <a:gd name="connsiteX5" fmla="*/ 317500 w 863600"/>
                <a:gd name="connsiteY5" fmla="*/ 473345 h 1544529"/>
                <a:gd name="connsiteX6" fmla="*/ 355600 w 863600"/>
                <a:gd name="connsiteY6" fmla="*/ 701945 h 1544529"/>
                <a:gd name="connsiteX7" fmla="*/ 342900 w 863600"/>
                <a:gd name="connsiteY7" fmla="*/ 1286145 h 1544529"/>
                <a:gd name="connsiteX8" fmla="*/ 342900 w 863600"/>
                <a:gd name="connsiteY8" fmla="*/ 1375045 h 1544529"/>
                <a:gd name="connsiteX9" fmla="*/ 419100 w 863600"/>
                <a:gd name="connsiteY9" fmla="*/ 803545 h 1544529"/>
                <a:gd name="connsiteX10" fmla="*/ 442913 w 863600"/>
                <a:gd name="connsiteY10" fmla="*/ 536845 h 1544529"/>
                <a:gd name="connsiteX11" fmla="*/ 469900 w 863600"/>
                <a:gd name="connsiteY11" fmla="*/ 320945 h 1544529"/>
                <a:gd name="connsiteX12" fmla="*/ 469900 w 863600"/>
                <a:gd name="connsiteY12" fmla="*/ 1197245 h 1544529"/>
                <a:gd name="connsiteX13" fmla="*/ 622300 w 863600"/>
                <a:gd name="connsiteY13" fmla="*/ 651145 h 1544529"/>
                <a:gd name="connsiteX14" fmla="*/ 711200 w 863600"/>
                <a:gd name="connsiteY14" fmla="*/ 1222645 h 1544529"/>
                <a:gd name="connsiteX15" fmla="*/ 787400 w 863600"/>
                <a:gd name="connsiteY15" fmla="*/ 879745 h 1544529"/>
                <a:gd name="connsiteX16" fmla="*/ 863600 w 863600"/>
                <a:gd name="connsiteY16" fmla="*/ 1070245 h 1544529"/>
                <a:gd name="connsiteX0" fmla="*/ 0 w 863600"/>
                <a:gd name="connsiteY0" fmla="*/ 1019678 h 1544762"/>
                <a:gd name="connsiteX1" fmla="*/ 84932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42913 w 863600"/>
                <a:gd name="connsiteY10" fmla="*/ 537078 h 1544762"/>
                <a:gd name="connsiteX11" fmla="*/ 469900 w 863600"/>
                <a:gd name="connsiteY11" fmla="*/ 321178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42913 w 863600"/>
                <a:gd name="connsiteY10" fmla="*/ 537078 h 1544762"/>
                <a:gd name="connsiteX11" fmla="*/ 469900 w 863600"/>
                <a:gd name="connsiteY11" fmla="*/ 321178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42913 w 863600"/>
                <a:gd name="connsiteY10" fmla="*/ 537078 h 1544762"/>
                <a:gd name="connsiteX11" fmla="*/ 457994 w 863600"/>
                <a:gd name="connsiteY11" fmla="*/ 483103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23863 w 863600"/>
                <a:gd name="connsiteY10" fmla="*/ 537078 h 1544762"/>
                <a:gd name="connsiteX11" fmla="*/ 457994 w 863600"/>
                <a:gd name="connsiteY11" fmla="*/ 483103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57994 w 863600"/>
                <a:gd name="connsiteY11" fmla="*/ 483103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53231 w 863600"/>
                <a:gd name="connsiteY12" fmla="*/ 470404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31800 w 863600"/>
                <a:gd name="connsiteY12" fmla="*/ 453735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65137 w 863600"/>
                <a:gd name="connsiteY12" fmla="*/ 491835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31800 w 863600"/>
                <a:gd name="connsiteY11" fmla="*/ 40214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31800 w 863600"/>
                <a:gd name="connsiteY11" fmla="*/ 40214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24656 w 863600"/>
                <a:gd name="connsiteY11" fmla="*/ 36404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19893 w 863600"/>
                <a:gd name="connsiteY11" fmla="*/ 42119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17512 w 863600"/>
                <a:gd name="connsiteY11" fmla="*/ 464053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22275 w 863600"/>
                <a:gd name="connsiteY11" fmla="*/ 283078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36563 w 863600"/>
                <a:gd name="connsiteY11" fmla="*/ 278315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863600" h="1544762">
                  <a:moveTo>
                    <a:pt x="0" y="1019678"/>
                  </a:moveTo>
                  <a:cubicBezTo>
                    <a:pt x="38100" y="781553"/>
                    <a:pt x="59268" y="543164"/>
                    <a:pt x="73026" y="379916"/>
                  </a:cubicBezTo>
                  <a:cubicBezTo>
                    <a:pt x="86784" y="216668"/>
                    <a:pt x="120121" y="-134699"/>
                    <a:pt x="139700" y="54478"/>
                  </a:cubicBezTo>
                  <a:cubicBezTo>
                    <a:pt x="159279" y="243655"/>
                    <a:pt x="169333" y="1358345"/>
                    <a:pt x="190500" y="1514978"/>
                  </a:cubicBezTo>
                  <a:cubicBezTo>
                    <a:pt x="211667" y="1671611"/>
                    <a:pt x="245533" y="1167845"/>
                    <a:pt x="266700" y="994278"/>
                  </a:cubicBezTo>
                  <a:cubicBezTo>
                    <a:pt x="287867" y="820711"/>
                    <a:pt x="302683" y="522261"/>
                    <a:pt x="317500" y="473578"/>
                  </a:cubicBezTo>
                  <a:cubicBezTo>
                    <a:pt x="332317" y="424895"/>
                    <a:pt x="351367" y="566712"/>
                    <a:pt x="355600" y="702178"/>
                  </a:cubicBezTo>
                  <a:cubicBezTo>
                    <a:pt x="359833" y="837644"/>
                    <a:pt x="345017" y="1174195"/>
                    <a:pt x="342900" y="1286378"/>
                  </a:cubicBezTo>
                  <a:cubicBezTo>
                    <a:pt x="340783" y="1398561"/>
                    <a:pt x="334566" y="1454521"/>
                    <a:pt x="342900" y="1375278"/>
                  </a:cubicBezTo>
                  <a:cubicBezTo>
                    <a:pt x="351234" y="1296035"/>
                    <a:pt x="380603" y="951019"/>
                    <a:pt x="392906" y="810922"/>
                  </a:cubicBezTo>
                  <a:cubicBezTo>
                    <a:pt x="405209" y="670825"/>
                    <a:pt x="409443" y="623465"/>
                    <a:pt x="416719" y="534697"/>
                  </a:cubicBezTo>
                  <a:cubicBezTo>
                    <a:pt x="423995" y="445929"/>
                    <a:pt x="431272" y="296968"/>
                    <a:pt x="436563" y="278315"/>
                  </a:cubicBezTo>
                  <a:cubicBezTo>
                    <a:pt x="441854" y="259662"/>
                    <a:pt x="444896" y="301335"/>
                    <a:pt x="448468" y="422779"/>
                  </a:cubicBezTo>
                  <a:cubicBezTo>
                    <a:pt x="452040" y="544223"/>
                    <a:pt x="440928" y="1159378"/>
                    <a:pt x="469900" y="1197478"/>
                  </a:cubicBezTo>
                  <a:cubicBezTo>
                    <a:pt x="498872" y="1235578"/>
                    <a:pt x="582083" y="647145"/>
                    <a:pt x="622300" y="651378"/>
                  </a:cubicBezTo>
                  <a:cubicBezTo>
                    <a:pt x="662517" y="655611"/>
                    <a:pt x="683683" y="1184778"/>
                    <a:pt x="711200" y="1222878"/>
                  </a:cubicBezTo>
                  <a:cubicBezTo>
                    <a:pt x="738717" y="1260978"/>
                    <a:pt x="762000" y="905378"/>
                    <a:pt x="787400" y="879978"/>
                  </a:cubicBezTo>
                  <a:cubicBezTo>
                    <a:pt x="812800" y="854578"/>
                    <a:pt x="838200" y="962528"/>
                    <a:pt x="863600" y="1070478"/>
                  </a:cubicBezTo>
                </a:path>
              </a:pathLst>
            </a:custGeom>
            <a:noFill/>
            <a:ln w="9525"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C073AA90-A73E-4557-A192-C4F436EF0097}"/>
                </a:ext>
              </a:extLst>
            </p:cNvPr>
            <p:cNvCxnSpPr>
              <a:cxnSpLocks/>
              <a:stCxn id="5" idx="0"/>
            </p:cNvCxnSpPr>
            <p:nvPr/>
          </p:nvCxnSpPr>
          <p:spPr>
            <a:xfrm flipH="1">
              <a:off x="4958582" y="2044699"/>
              <a:ext cx="286518" cy="7939"/>
            </a:xfrm>
            <a:prstGeom prst="line">
              <a:avLst/>
            </a:prstGeom>
            <a:ln w="9525">
              <a:solidFill>
                <a:schemeClr val="accent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直接连接符 229">
              <a:extLst>
                <a:ext uri="{FF2B5EF4-FFF2-40B4-BE49-F238E27FC236}">
                  <a16:creationId xmlns:a16="http://schemas.microsoft.com/office/drawing/2014/main" id="{85CDCA56-9FFC-4340-86B0-84B2453E0B22}"/>
                </a:ext>
              </a:extLst>
            </p:cNvPr>
            <p:cNvCxnSpPr/>
            <p:nvPr/>
          </p:nvCxnSpPr>
          <p:spPr>
            <a:xfrm flipH="1">
              <a:off x="6108700" y="2087911"/>
              <a:ext cx="286519" cy="7939"/>
            </a:xfrm>
            <a:prstGeom prst="line">
              <a:avLst/>
            </a:prstGeom>
            <a:ln w="9525">
              <a:solidFill>
                <a:schemeClr val="accent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7" name="任意多边形: 形状 206">
            <a:extLst>
              <a:ext uri="{FF2B5EF4-FFF2-40B4-BE49-F238E27FC236}">
                <a16:creationId xmlns:a16="http://schemas.microsoft.com/office/drawing/2014/main" id="{415FB071-CBB1-4704-A7F7-400D1F074CE6}"/>
              </a:ext>
            </a:extLst>
          </p:cNvPr>
          <p:cNvSpPr/>
          <p:nvPr/>
        </p:nvSpPr>
        <p:spPr>
          <a:xfrm>
            <a:off x="1882206" y="5822787"/>
            <a:ext cx="1295037" cy="1583192"/>
          </a:xfrm>
          <a:custGeom>
            <a:avLst/>
            <a:gdLst>
              <a:gd name="connsiteX0" fmla="*/ 48162 w 1734087"/>
              <a:gd name="connsiteY0" fmla="*/ 1745904 h 1745904"/>
              <a:gd name="connsiteX1" fmla="*/ 19587 w 1734087"/>
              <a:gd name="connsiteY1" fmla="*/ 1079154 h 1745904"/>
              <a:gd name="connsiteX2" fmla="*/ 305337 w 1734087"/>
              <a:gd name="connsiteY2" fmla="*/ 469554 h 1745904"/>
              <a:gd name="connsiteX3" fmla="*/ 867312 w 1734087"/>
              <a:gd name="connsiteY3" fmla="*/ 107604 h 1745904"/>
              <a:gd name="connsiteX4" fmla="*/ 1410237 w 1734087"/>
              <a:gd name="connsiteY4" fmla="*/ 21879 h 1745904"/>
              <a:gd name="connsiteX5" fmla="*/ 1734087 w 1734087"/>
              <a:gd name="connsiteY5" fmla="*/ 2829 h 1745904"/>
              <a:gd name="connsiteX0" fmla="*/ 48162 w 1543587"/>
              <a:gd name="connsiteY0" fmla="*/ 1725866 h 1725866"/>
              <a:gd name="connsiteX1" fmla="*/ 19587 w 1543587"/>
              <a:gd name="connsiteY1" fmla="*/ 1059116 h 1725866"/>
              <a:gd name="connsiteX2" fmla="*/ 305337 w 1543587"/>
              <a:gd name="connsiteY2" fmla="*/ 449516 h 1725866"/>
              <a:gd name="connsiteX3" fmla="*/ 867312 w 1543587"/>
              <a:gd name="connsiteY3" fmla="*/ 87566 h 1725866"/>
              <a:gd name="connsiteX4" fmla="*/ 1410237 w 1543587"/>
              <a:gd name="connsiteY4" fmla="*/ 1841 h 1725866"/>
              <a:gd name="connsiteX5" fmla="*/ 1543587 w 1543587"/>
              <a:gd name="connsiteY5" fmla="*/ 30416 h 1725866"/>
              <a:gd name="connsiteX0" fmla="*/ 48162 w 1410237"/>
              <a:gd name="connsiteY0" fmla="*/ 1724025 h 1724025"/>
              <a:gd name="connsiteX1" fmla="*/ 19587 w 1410237"/>
              <a:gd name="connsiteY1" fmla="*/ 1057275 h 1724025"/>
              <a:gd name="connsiteX2" fmla="*/ 305337 w 1410237"/>
              <a:gd name="connsiteY2" fmla="*/ 447675 h 1724025"/>
              <a:gd name="connsiteX3" fmla="*/ 867312 w 1410237"/>
              <a:gd name="connsiteY3" fmla="*/ 85725 h 1724025"/>
              <a:gd name="connsiteX4" fmla="*/ 1410237 w 1410237"/>
              <a:gd name="connsiteY4" fmla="*/ 0 h 1724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410237" h="1724025">
                <a:moveTo>
                  <a:pt x="48162" y="1724025"/>
                </a:moveTo>
                <a:cubicBezTo>
                  <a:pt x="12443" y="1497012"/>
                  <a:pt x="-23275" y="1270000"/>
                  <a:pt x="19587" y="1057275"/>
                </a:cubicBezTo>
                <a:cubicBezTo>
                  <a:pt x="62449" y="844550"/>
                  <a:pt x="164050" y="609600"/>
                  <a:pt x="305337" y="447675"/>
                </a:cubicBezTo>
                <a:cubicBezTo>
                  <a:pt x="446624" y="285750"/>
                  <a:pt x="683162" y="160337"/>
                  <a:pt x="867312" y="85725"/>
                </a:cubicBezTo>
                <a:cubicBezTo>
                  <a:pt x="1051462" y="11113"/>
                  <a:pt x="1297525" y="9525"/>
                  <a:pt x="1410237" y="0"/>
                </a:cubicBezTo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8" name="任意多边形: 形状 207">
            <a:extLst>
              <a:ext uri="{FF2B5EF4-FFF2-40B4-BE49-F238E27FC236}">
                <a16:creationId xmlns:a16="http://schemas.microsoft.com/office/drawing/2014/main" id="{5FA93144-B97A-436B-8FC3-0F75272465D5}"/>
              </a:ext>
            </a:extLst>
          </p:cNvPr>
          <p:cNvSpPr/>
          <p:nvPr/>
        </p:nvSpPr>
        <p:spPr>
          <a:xfrm flipH="1">
            <a:off x="3157429" y="5822787"/>
            <a:ext cx="1295037" cy="1583192"/>
          </a:xfrm>
          <a:custGeom>
            <a:avLst/>
            <a:gdLst>
              <a:gd name="connsiteX0" fmla="*/ 48162 w 1734087"/>
              <a:gd name="connsiteY0" fmla="*/ 1745904 h 1745904"/>
              <a:gd name="connsiteX1" fmla="*/ 19587 w 1734087"/>
              <a:gd name="connsiteY1" fmla="*/ 1079154 h 1745904"/>
              <a:gd name="connsiteX2" fmla="*/ 305337 w 1734087"/>
              <a:gd name="connsiteY2" fmla="*/ 469554 h 1745904"/>
              <a:gd name="connsiteX3" fmla="*/ 867312 w 1734087"/>
              <a:gd name="connsiteY3" fmla="*/ 107604 h 1745904"/>
              <a:gd name="connsiteX4" fmla="*/ 1410237 w 1734087"/>
              <a:gd name="connsiteY4" fmla="*/ 21879 h 1745904"/>
              <a:gd name="connsiteX5" fmla="*/ 1734087 w 1734087"/>
              <a:gd name="connsiteY5" fmla="*/ 2829 h 1745904"/>
              <a:gd name="connsiteX0" fmla="*/ 48162 w 1543587"/>
              <a:gd name="connsiteY0" fmla="*/ 1725866 h 1725866"/>
              <a:gd name="connsiteX1" fmla="*/ 19587 w 1543587"/>
              <a:gd name="connsiteY1" fmla="*/ 1059116 h 1725866"/>
              <a:gd name="connsiteX2" fmla="*/ 305337 w 1543587"/>
              <a:gd name="connsiteY2" fmla="*/ 449516 h 1725866"/>
              <a:gd name="connsiteX3" fmla="*/ 867312 w 1543587"/>
              <a:gd name="connsiteY3" fmla="*/ 87566 h 1725866"/>
              <a:gd name="connsiteX4" fmla="*/ 1410237 w 1543587"/>
              <a:gd name="connsiteY4" fmla="*/ 1841 h 1725866"/>
              <a:gd name="connsiteX5" fmla="*/ 1543587 w 1543587"/>
              <a:gd name="connsiteY5" fmla="*/ 30416 h 1725866"/>
              <a:gd name="connsiteX0" fmla="*/ 48162 w 1410237"/>
              <a:gd name="connsiteY0" fmla="*/ 1724025 h 1724025"/>
              <a:gd name="connsiteX1" fmla="*/ 19587 w 1410237"/>
              <a:gd name="connsiteY1" fmla="*/ 1057275 h 1724025"/>
              <a:gd name="connsiteX2" fmla="*/ 305337 w 1410237"/>
              <a:gd name="connsiteY2" fmla="*/ 447675 h 1724025"/>
              <a:gd name="connsiteX3" fmla="*/ 867312 w 1410237"/>
              <a:gd name="connsiteY3" fmla="*/ 85725 h 1724025"/>
              <a:gd name="connsiteX4" fmla="*/ 1410237 w 1410237"/>
              <a:gd name="connsiteY4" fmla="*/ 0 h 1724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410237" h="1724025">
                <a:moveTo>
                  <a:pt x="48162" y="1724025"/>
                </a:moveTo>
                <a:cubicBezTo>
                  <a:pt x="12443" y="1497012"/>
                  <a:pt x="-23275" y="1270000"/>
                  <a:pt x="19587" y="1057275"/>
                </a:cubicBezTo>
                <a:cubicBezTo>
                  <a:pt x="62449" y="844550"/>
                  <a:pt x="164050" y="609600"/>
                  <a:pt x="305337" y="447675"/>
                </a:cubicBezTo>
                <a:cubicBezTo>
                  <a:pt x="446624" y="285750"/>
                  <a:pt x="683162" y="160337"/>
                  <a:pt x="867312" y="85725"/>
                </a:cubicBezTo>
                <a:cubicBezTo>
                  <a:pt x="1051462" y="11113"/>
                  <a:pt x="1297525" y="9525"/>
                  <a:pt x="1410237" y="0"/>
                </a:cubicBezTo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44" name="组合 243">
            <a:extLst>
              <a:ext uri="{FF2B5EF4-FFF2-40B4-BE49-F238E27FC236}">
                <a16:creationId xmlns:a16="http://schemas.microsoft.com/office/drawing/2014/main" id="{46337921-11F5-4955-9BB8-5EF5EA63F39F}"/>
              </a:ext>
            </a:extLst>
          </p:cNvPr>
          <p:cNvGrpSpPr/>
          <p:nvPr/>
        </p:nvGrpSpPr>
        <p:grpSpPr>
          <a:xfrm>
            <a:off x="1865569" y="7217506"/>
            <a:ext cx="909522" cy="675621"/>
            <a:chOff x="7541968" y="1495174"/>
            <a:chExt cx="1707589" cy="1268450"/>
          </a:xfrm>
        </p:grpSpPr>
        <p:sp>
          <p:nvSpPr>
            <p:cNvPr id="245" name="任意多边形: 形状 244">
              <a:extLst>
                <a:ext uri="{FF2B5EF4-FFF2-40B4-BE49-F238E27FC236}">
                  <a16:creationId xmlns:a16="http://schemas.microsoft.com/office/drawing/2014/main" id="{C36F336E-A943-466A-813D-9C9160D6F124}"/>
                </a:ext>
              </a:extLst>
            </p:cNvPr>
            <p:cNvSpPr/>
            <p:nvPr/>
          </p:nvSpPr>
          <p:spPr>
            <a:xfrm>
              <a:off x="8099438" y="1495174"/>
              <a:ext cx="863600" cy="1268450"/>
            </a:xfrm>
            <a:custGeom>
              <a:avLst/>
              <a:gdLst>
                <a:gd name="connsiteX0" fmla="*/ 0 w 863600"/>
                <a:gd name="connsiteY0" fmla="*/ 1018641 h 1543725"/>
                <a:gd name="connsiteX1" fmla="*/ 101600 w 863600"/>
                <a:gd name="connsiteY1" fmla="*/ 383641 h 1543725"/>
                <a:gd name="connsiteX2" fmla="*/ 139700 w 863600"/>
                <a:gd name="connsiteY2" fmla="*/ 53441 h 1543725"/>
                <a:gd name="connsiteX3" fmla="*/ 190500 w 863600"/>
                <a:gd name="connsiteY3" fmla="*/ 1513941 h 1543725"/>
                <a:gd name="connsiteX4" fmla="*/ 266700 w 863600"/>
                <a:gd name="connsiteY4" fmla="*/ 993241 h 1543725"/>
                <a:gd name="connsiteX5" fmla="*/ 317500 w 863600"/>
                <a:gd name="connsiteY5" fmla="*/ 472541 h 1543725"/>
                <a:gd name="connsiteX6" fmla="*/ 355600 w 863600"/>
                <a:gd name="connsiteY6" fmla="*/ 701141 h 1543725"/>
                <a:gd name="connsiteX7" fmla="*/ 342900 w 863600"/>
                <a:gd name="connsiteY7" fmla="*/ 1285341 h 1543725"/>
                <a:gd name="connsiteX8" fmla="*/ 342900 w 863600"/>
                <a:gd name="connsiteY8" fmla="*/ 1374241 h 1543725"/>
                <a:gd name="connsiteX9" fmla="*/ 419100 w 863600"/>
                <a:gd name="connsiteY9" fmla="*/ 802741 h 1543725"/>
                <a:gd name="connsiteX10" fmla="*/ 419100 w 863600"/>
                <a:gd name="connsiteY10" fmla="*/ 536041 h 1543725"/>
                <a:gd name="connsiteX11" fmla="*/ 469900 w 863600"/>
                <a:gd name="connsiteY11" fmla="*/ 320141 h 1543725"/>
                <a:gd name="connsiteX12" fmla="*/ 469900 w 863600"/>
                <a:gd name="connsiteY12" fmla="*/ 1196441 h 1543725"/>
                <a:gd name="connsiteX13" fmla="*/ 622300 w 863600"/>
                <a:gd name="connsiteY13" fmla="*/ 650341 h 1543725"/>
                <a:gd name="connsiteX14" fmla="*/ 711200 w 863600"/>
                <a:gd name="connsiteY14" fmla="*/ 1221841 h 1543725"/>
                <a:gd name="connsiteX15" fmla="*/ 787400 w 863600"/>
                <a:gd name="connsiteY15" fmla="*/ 878941 h 1543725"/>
                <a:gd name="connsiteX16" fmla="*/ 863600 w 863600"/>
                <a:gd name="connsiteY16" fmla="*/ 1069441 h 1543725"/>
                <a:gd name="connsiteX0" fmla="*/ 0 w 863600"/>
                <a:gd name="connsiteY0" fmla="*/ 1018641 h 1543725"/>
                <a:gd name="connsiteX1" fmla="*/ 101600 w 863600"/>
                <a:gd name="connsiteY1" fmla="*/ 383641 h 1543725"/>
                <a:gd name="connsiteX2" fmla="*/ 139700 w 863600"/>
                <a:gd name="connsiteY2" fmla="*/ 53441 h 1543725"/>
                <a:gd name="connsiteX3" fmla="*/ 190500 w 863600"/>
                <a:gd name="connsiteY3" fmla="*/ 1513941 h 1543725"/>
                <a:gd name="connsiteX4" fmla="*/ 266700 w 863600"/>
                <a:gd name="connsiteY4" fmla="*/ 993241 h 1543725"/>
                <a:gd name="connsiteX5" fmla="*/ 317500 w 863600"/>
                <a:gd name="connsiteY5" fmla="*/ 472541 h 1543725"/>
                <a:gd name="connsiteX6" fmla="*/ 355600 w 863600"/>
                <a:gd name="connsiteY6" fmla="*/ 701141 h 1543725"/>
                <a:gd name="connsiteX7" fmla="*/ 342900 w 863600"/>
                <a:gd name="connsiteY7" fmla="*/ 1285341 h 1543725"/>
                <a:gd name="connsiteX8" fmla="*/ 342900 w 863600"/>
                <a:gd name="connsiteY8" fmla="*/ 1374241 h 1543725"/>
                <a:gd name="connsiteX9" fmla="*/ 419100 w 863600"/>
                <a:gd name="connsiteY9" fmla="*/ 802741 h 1543725"/>
                <a:gd name="connsiteX10" fmla="*/ 442913 w 863600"/>
                <a:gd name="connsiteY10" fmla="*/ 536041 h 1543725"/>
                <a:gd name="connsiteX11" fmla="*/ 469900 w 863600"/>
                <a:gd name="connsiteY11" fmla="*/ 320141 h 1543725"/>
                <a:gd name="connsiteX12" fmla="*/ 469900 w 863600"/>
                <a:gd name="connsiteY12" fmla="*/ 1196441 h 1543725"/>
                <a:gd name="connsiteX13" fmla="*/ 622300 w 863600"/>
                <a:gd name="connsiteY13" fmla="*/ 650341 h 1543725"/>
                <a:gd name="connsiteX14" fmla="*/ 711200 w 863600"/>
                <a:gd name="connsiteY14" fmla="*/ 1221841 h 1543725"/>
                <a:gd name="connsiteX15" fmla="*/ 787400 w 863600"/>
                <a:gd name="connsiteY15" fmla="*/ 878941 h 1543725"/>
                <a:gd name="connsiteX16" fmla="*/ 863600 w 863600"/>
                <a:gd name="connsiteY16" fmla="*/ 1069441 h 1543725"/>
                <a:gd name="connsiteX0" fmla="*/ 0 w 863600"/>
                <a:gd name="connsiteY0" fmla="*/ 1019042 h 1544126"/>
                <a:gd name="connsiteX1" fmla="*/ 89694 w 863600"/>
                <a:gd name="connsiteY1" fmla="*/ 381661 h 1544126"/>
                <a:gd name="connsiteX2" fmla="*/ 139700 w 863600"/>
                <a:gd name="connsiteY2" fmla="*/ 53842 h 1544126"/>
                <a:gd name="connsiteX3" fmla="*/ 190500 w 863600"/>
                <a:gd name="connsiteY3" fmla="*/ 1514342 h 1544126"/>
                <a:gd name="connsiteX4" fmla="*/ 266700 w 863600"/>
                <a:gd name="connsiteY4" fmla="*/ 993642 h 1544126"/>
                <a:gd name="connsiteX5" fmla="*/ 317500 w 863600"/>
                <a:gd name="connsiteY5" fmla="*/ 472942 h 1544126"/>
                <a:gd name="connsiteX6" fmla="*/ 355600 w 863600"/>
                <a:gd name="connsiteY6" fmla="*/ 701542 h 1544126"/>
                <a:gd name="connsiteX7" fmla="*/ 342900 w 863600"/>
                <a:gd name="connsiteY7" fmla="*/ 1285742 h 1544126"/>
                <a:gd name="connsiteX8" fmla="*/ 342900 w 863600"/>
                <a:gd name="connsiteY8" fmla="*/ 1374642 h 1544126"/>
                <a:gd name="connsiteX9" fmla="*/ 419100 w 863600"/>
                <a:gd name="connsiteY9" fmla="*/ 803142 h 1544126"/>
                <a:gd name="connsiteX10" fmla="*/ 442913 w 863600"/>
                <a:gd name="connsiteY10" fmla="*/ 536442 h 1544126"/>
                <a:gd name="connsiteX11" fmla="*/ 469900 w 863600"/>
                <a:gd name="connsiteY11" fmla="*/ 320542 h 1544126"/>
                <a:gd name="connsiteX12" fmla="*/ 469900 w 863600"/>
                <a:gd name="connsiteY12" fmla="*/ 1196842 h 1544126"/>
                <a:gd name="connsiteX13" fmla="*/ 622300 w 863600"/>
                <a:gd name="connsiteY13" fmla="*/ 650742 h 1544126"/>
                <a:gd name="connsiteX14" fmla="*/ 711200 w 863600"/>
                <a:gd name="connsiteY14" fmla="*/ 1222242 h 1544126"/>
                <a:gd name="connsiteX15" fmla="*/ 787400 w 863600"/>
                <a:gd name="connsiteY15" fmla="*/ 879342 h 1544126"/>
                <a:gd name="connsiteX16" fmla="*/ 863600 w 863600"/>
                <a:gd name="connsiteY16" fmla="*/ 1069842 h 1544126"/>
                <a:gd name="connsiteX0" fmla="*/ 0 w 863600"/>
                <a:gd name="connsiteY0" fmla="*/ 1019445 h 1544529"/>
                <a:gd name="connsiteX1" fmla="*/ 70644 w 863600"/>
                <a:gd name="connsiteY1" fmla="*/ 379683 h 1544529"/>
                <a:gd name="connsiteX2" fmla="*/ 139700 w 863600"/>
                <a:gd name="connsiteY2" fmla="*/ 54245 h 1544529"/>
                <a:gd name="connsiteX3" fmla="*/ 190500 w 863600"/>
                <a:gd name="connsiteY3" fmla="*/ 1514745 h 1544529"/>
                <a:gd name="connsiteX4" fmla="*/ 266700 w 863600"/>
                <a:gd name="connsiteY4" fmla="*/ 994045 h 1544529"/>
                <a:gd name="connsiteX5" fmla="*/ 317500 w 863600"/>
                <a:gd name="connsiteY5" fmla="*/ 473345 h 1544529"/>
                <a:gd name="connsiteX6" fmla="*/ 355600 w 863600"/>
                <a:gd name="connsiteY6" fmla="*/ 701945 h 1544529"/>
                <a:gd name="connsiteX7" fmla="*/ 342900 w 863600"/>
                <a:gd name="connsiteY7" fmla="*/ 1286145 h 1544529"/>
                <a:gd name="connsiteX8" fmla="*/ 342900 w 863600"/>
                <a:gd name="connsiteY8" fmla="*/ 1375045 h 1544529"/>
                <a:gd name="connsiteX9" fmla="*/ 419100 w 863600"/>
                <a:gd name="connsiteY9" fmla="*/ 803545 h 1544529"/>
                <a:gd name="connsiteX10" fmla="*/ 442913 w 863600"/>
                <a:gd name="connsiteY10" fmla="*/ 536845 h 1544529"/>
                <a:gd name="connsiteX11" fmla="*/ 469900 w 863600"/>
                <a:gd name="connsiteY11" fmla="*/ 320945 h 1544529"/>
                <a:gd name="connsiteX12" fmla="*/ 469900 w 863600"/>
                <a:gd name="connsiteY12" fmla="*/ 1197245 h 1544529"/>
                <a:gd name="connsiteX13" fmla="*/ 622300 w 863600"/>
                <a:gd name="connsiteY13" fmla="*/ 651145 h 1544529"/>
                <a:gd name="connsiteX14" fmla="*/ 711200 w 863600"/>
                <a:gd name="connsiteY14" fmla="*/ 1222645 h 1544529"/>
                <a:gd name="connsiteX15" fmla="*/ 787400 w 863600"/>
                <a:gd name="connsiteY15" fmla="*/ 879745 h 1544529"/>
                <a:gd name="connsiteX16" fmla="*/ 863600 w 863600"/>
                <a:gd name="connsiteY16" fmla="*/ 1070245 h 1544529"/>
                <a:gd name="connsiteX0" fmla="*/ 0 w 863600"/>
                <a:gd name="connsiteY0" fmla="*/ 1019445 h 1544529"/>
                <a:gd name="connsiteX1" fmla="*/ 84932 w 863600"/>
                <a:gd name="connsiteY1" fmla="*/ 379683 h 1544529"/>
                <a:gd name="connsiteX2" fmla="*/ 139700 w 863600"/>
                <a:gd name="connsiteY2" fmla="*/ 54245 h 1544529"/>
                <a:gd name="connsiteX3" fmla="*/ 190500 w 863600"/>
                <a:gd name="connsiteY3" fmla="*/ 1514745 h 1544529"/>
                <a:gd name="connsiteX4" fmla="*/ 266700 w 863600"/>
                <a:gd name="connsiteY4" fmla="*/ 994045 h 1544529"/>
                <a:gd name="connsiteX5" fmla="*/ 317500 w 863600"/>
                <a:gd name="connsiteY5" fmla="*/ 473345 h 1544529"/>
                <a:gd name="connsiteX6" fmla="*/ 355600 w 863600"/>
                <a:gd name="connsiteY6" fmla="*/ 701945 h 1544529"/>
                <a:gd name="connsiteX7" fmla="*/ 342900 w 863600"/>
                <a:gd name="connsiteY7" fmla="*/ 1286145 h 1544529"/>
                <a:gd name="connsiteX8" fmla="*/ 342900 w 863600"/>
                <a:gd name="connsiteY8" fmla="*/ 1375045 h 1544529"/>
                <a:gd name="connsiteX9" fmla="*/ 419100 w 863600"/>
                <a:gd name="connsiteY9" fmla="*/ 803545 h 1544529"/>
                <a:gd name="connsiteX10" fmla="*/ 442913 w 863600"/>
                <a:gd name="connsiteY10" fmla="*/ 536845 h 1544529"/>
                <a:gd name="connsiteX11" fmla="*/ 469900 w 863600"/>
                <a:gd name="connsiteY11" fmla="*/ 320945 h 1544529"/>
                <a:gd name="connsiteX12" fmla="*/ 469900 w 863600"/>
                <a:gd name="connsiteY12" fmla="*/ 1197245 h 1544529"/>
                <a:gd name="connsiteX13" fmla="*/ 622300 w 863600"/>
                <a:gd name="connsiteY13" fmla="*/ 651145 h 1544529"/>
                <a:gd name="connsiteX14" fmla="*/ 711200 w 863600"/>
                <a:gd name="connsiteY14" fmla="*/ 1222645 h 1544529"/>
                <a:gd name="connsiteX15" fmla="*/ 787400 w 863600"/>
                <a:gd name="connsiteY15" fmla="*/ 879745 h 1544529"/>
                <a:gd name="connsiteX16" fmla="*/ 863600 w 863600"/>
                <a:gd name="connsiteY16" fmla="*/ 1070245 h 1544529"/>
                <a:gd name="connsiteX0" fmla="*/ 0 w 863600"/>
                <a:gd name="connsiteY0" fmla="*/ 1019678 h 1544762"/>
                <a:gd name="connsiteX1" fmla="*/ 84932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42913 w 863600"/>
                <a:gd name="connsiteY10" fmla="*/ 537078 h 1544762"/>
                <a:gd name="connsiteX11" fmla="*/ 469900 w 863600"/>
                <a:gd name="connsiteY11" fmla="*/ 321178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42913 w 863600"/>
                <a:gd name="connsiteY10" fmla="*/ 537078 h 1544762"/>
                <a:gd name="connsiteX11" fmla="*/ 469900 w 863600"/>
                <a:gd name="connsiteY11" fmla="*/ 321178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42913 w 863600"/>
                <a:gd name="connsiteY10" fmla="*/ 537078 h 1544762"/>
                <a:gd name="connsiteX11" fmla="*/ 457994 w 863600"/>
                <a:gd name="connsiteY11" fmla="*/ 483103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419100 w 863600"/>
                <a:gd name="connsiteY9" fmla="*/ 803778 h 1544762"/>
                <a:gd name="connsiteX10" fmla="*/ 423863 w 863600"/>
                <a:gd name="connsiteY10" fmla="*/ 537078 h 1544762"/>
                <a:gd name="connsiteX11" fmla="*/ 457994 w 863600"/>
                <a:gd name="connsiteY11" fmla="*/ 483103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57994 w 863600"/>
                <a:gd name="connsiteY11" fmla="*/ 483103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69900 w 863600"/>
                <a:gd name="connsiteY12" fmla="*/ 1197478 h 1544762"/>
                <a:gd name="connsiteX13" fmla="*/ 622300 w 863600"/>
                <a:gd name="connsiteY13" fmla="*/ 651378 h 1544762"/>
                <a:gd name="connsiteX14" fmla="*/ 711200 w 863600"/>
                <a:gd name="connsiteY14" fmla="*/ 1222878 h 1544762"/>
                <a:gd name="connsiteX15" fmla="*/ 787400 w 863600"/>
                <a:gd name="connsiteY15" fmla="*/ 879978 h 1544762"/>
                <a:gd name="connsiteX16" fmla="*/ 863600 w 863600"/>
                <a:gd name="connsiteY16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53231 w 863600"/>
                <a:gd name="connsiteY12" fmla="*/ 470404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31800 w 863600"/>
                <a:gd name="connsiteY12" fmla="*/ 453735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65137 w 863600"/>
                <a:gd name="connsiteY12" fmla="*/ 491835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48469 w 863600"/>
                <a:gd name="connsiteY11" fmla="*/ 468815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23863 w 863600"/>
                <a:gd name="connsiteY10" fmla="*/ 537078 h 1544762"/>
                <a:gd name="connsiteX11" fmla="*/ 431800 w 863600"/>
                <a:gd name="connsiteY11" fmla="*/ 40214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31800 w 863600"/>
                <a:gd name="connsiteY11" fmla="*/ 40214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24656 w 863600"/>
                <a:gd name="connsiteY11" fmla="*/ 36404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19893 w 863600"/>
                <a:gd name="connsiteY11" fmla="*/ 421190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17512 w 863600"/>
                <a:gd name="connsiteY11" fmla="*/ 464053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22275 w 863600"/>
                <a:gd name="connsiteY11" fmla="*/ 283078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  <a:gd name="connsiteX0" fmla="*/ 0 w 863600"/>
                <a:gd name="connsiteY0" fmla="*/ 1019678 h 1544762"/>
                <a:gd name="connsiteX1" fmla="*/ 73026 w 863600"/>
                <a:gd name="connsiteY1" fmla="*/ 379916 h 1544762"/>
                <a:gd name="connsiteX2" fmla="*/ 139700 w 863600"/>
                <a:gd name="connsiteY2" fmla="*/ 54478 h 1544762"/>
                <a:gd name="connsiteX3" fmla="*/ 190500 w 863600"/>
                <a:gd name="connsiteY3" fmla="*/ 1514978 h 1544762"/>
                <a:gd name="connsiteX4" fmla="*/ 266700 w 863600"/>
                <a:gd name="connsiteY4" fmla="*/ 994278 h 1544762"/>
                <a:gd name="connsiteX5" fmla="*/ 317500 w 863600"/>
                <a:gd name="connsiteY5" fmla="*/ 473578 h 1544762"/>
                <a:gd name="connsiteX6" fmla="*/ 355600 w 863600"/>
                <a:gd name="connsiteY6" fmla="*/ 702178 h 1544762"/>
                <a:gd name="connsiteX7" fmla="*/ 342900 w 863600"/>
                <a:gd name="connsiteY7" fmla="*/ 1286378 h 1544762"/>
                <a:gd name="connsiteX8" fmla="*/ 342900 w 863600"/>
                <a:gd name="connsiteY8" fmla="*/ 1375278 h 1544762"/>
                <a:gd name="connsiteX9" fmla="*/ 392906 w 863600"/>
                <a:gd name="connsiteY9" fmla="*/ 810922 h 1544762"/>
                <a:gd name="connsiteX10" fmla="*/ 416719 w 863600"/>
                <a:gd name="connsiteY10" fmla="*/ 534697 h 1544762"/>
                <a:gd name="connsiteX11" fmla="*/ 436563 w 863600"/>
                <a:gd name="connsiteY11" fmla="*/ 278315 h 1544762"/>
                <a:gd name="connsiteX12" fmla="*/ 448468 w 863600"/>
                <a:gd name="connsiteY12" fmla="*/ 422779 h 1544762"/>
                <a:gd name="connsiteX13" fmla="*/ 469900 w 863600"/>
                <a:gd name="connsiteY13" fmla="*/ 1197478 h 1544762"/>
                <a:gd name="connsiteX14" fmla="*/ 622300 w 863600"/>
                <a:gd name="connsiteY14" fmla="*/ 651378 h 1544762"/>
                <a:gd name="connsiteX15" fmla="*/ 711200 w 863600"/>
                <a:gd name="connsiteY15" fmla="*/ 1222878 h 1544762"/>
                <a:gd name="connsiteX16" fmla="*/ 787400 w 863600"/>
                <a:gd name="connsiteY16" fmla="*/ 879978 h 1544762"/>
                <a:gd name="connsiteX17" fmla="*/ 863600 w 863600"/>
                <a:gd name="connsiteY17" fmla="*/ 1070478 h 15447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863600" h="1544762">
                  <a:moveTo>
                    <a:pt x="0" y="1019678"/>
                  </a:moveTo>
                  <a:cubicBezTo>
                    <a:pt x="38100" y="781553"/>
                    <a:pt x="59268" y="543164"/>
                    <a:pt x="73026" y="379916"/>
                  </a:cubicBezTo>
                  <a:cubicBezTo>
                    <a:pt x="86784" y="216668"/>
                    <a:pt x="120121" y="-134699"/>
                    <a:pt x="139700" y="54478"/>
                  </a:cubicBezTo>
                  <a:cubicBezTo>
                    <a:pt x="159279" y="243655"/>
                    <a:pt x="169333" y="1358345"/>
                    <a:pt x="190500" y="1514978"/>
                  </a:cubicBezTo>
                  <a:cubicBezTo>
                    <a:pt x="211667" y="1671611"/>
                    <a:pt x="245533" y="1167845"/>
                    <a:pt x="266700" y="994278"/>
                  </a:cubicBezTo>
                  <a:cubicBezTo>
                    <a:pt x="287867" y="820711"/>
                    <a:pt x="302683" y="522261"/>
                    <a:pt x="317500" y="473578"/>
                  </a:cubicBezTo>
                  <a:cubicBezTo>
                    <a:pt x="332317" y="424895"/>
                    <a:pt x="351367" y="566712"/>
                    <a:pt x="355600" y="702178"/>
                  </a:cubicBezTo>
                  <a:cubicBezTo>
                    <a:pt x="359833" y="837644"/>
                    <a:pt x="345017" y="1174195"/>
                    <a:pt x="342900" y="1286378"/>
                  </a:cubicBezTo>
                  <a:cubicBezTo>
                    <a:pt x="340783" y="1398561"/>
                    <a:pt x="334566" y="1454521"/>
                    <a:pt x="342900" y="1375278"/>
                  </a:cubicBezTo>
                  <a:cubicBezTo>
                    <a:pt x="351234" y="1296035"/>
                    <a:pt x="380603" y="951019"/>
                    <a:pt x="392906" y="810922"/>
                  </a:cubicBezTo>
                  <a:cubicBezTo>
                    <a:pt x="405209" y="670825"/>
                    <a:pt x="409443" y="623465"/>
                    <a:pt x="416719" y="534697"/>
                  </a:cubicBezTo>
                  <a:cubicBezTo>
                    <a:pt x="423995" y="445929"/>
                    <a:pt x="431272" y="296968"/>
                    <a:pt x="436563" y="278315"/>
                  </a:cubicBezTo>
                  <a:cubicBezTo>
                    <a:pt x="441854" y="259662"/>
                    <a:pt x="444896" y="301335"/>
                    <a:pt x="448468" y="422779"/>
                  </a:cubicBezTo>
                  <a:cubicBezTo>
                    <a:pt x="452040" y="544223"/>
                    <a:pt x="440928" y="1159378"/>
                    <a:pt x="469900" y="1197478"/>
                  </a:cubicBezTo>
                  <a:cubicBezTo>
                    <a:pt x="498872" y="1235578"/>
                    <a:pt x="582083" y="647145"/>
                    <a:pt x="622300" y="651378"/>
                  </a:cubicBezTo>
                  <a:cubicBezTo>
                    <a:pt x="662517" y="655611"/>
                    <a:pt x="683683" y="1184778"/>
                    <a:pt x="711200" y="1222878"/>
                  </a:cubicBezTo>
                  <a:cubicBezTo>
                    <a:pt x="738717" y="1260978"/>
                    <a:pt x="762000" y="905378"/>
                    <a:pt x="787400" y="879978"/>
                  </a:cubicBezTo>
                  <a:cubicBezTo>
                    <a:pt x="812800" y="854578"/>
                    <a:pt x="838200" y="962528"/>
                    <a:pt x="863600" y="1070478"/>
                  </a:cubicBezTo>
                </a:path>
              </a:pathLst>
            </a:custGeom>
            <a:noFill/>
            <a:ln w="9525">
              <a:solidFill>
                <a:srgbClr val="EB292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246" name="直接连接符 245">
              <a:extLst>
                <a:ext uri="{FF2B5EF4-FFF2-40B4-BE49-F238E27FC236}">
                  <a16:creationId xmlns:a16="http://schemas.microsoft.com/office/drawing/2014/main" id="{6E879588-6D3A-4AA5-B735-CC5487ED50B4}"/>
                </a:ext>
              </a:extLst>
            </p:cNvPr>
            <p:cNvCxnSpPr>
              <a:cxnSpLocks/>
              <a:stCxn id="245" idx="0"/>
            </p:cNvCxnSpPr>
            <p:nvPr/>
          </p:nvCxnSpPr>
          <p:spPr>
            <a:xfrm flipH="1">
              <a:off x="7541968" y="2332462"/>
              <a:ext cx="557470" cy="5745"/>
            </a:xfrm>
            <a:prstGeom prst="line">
              <a:avLst/>
            </a:prstGeom>
            <a:ln w="9525">
              <a:solidFill>
                <a:srgbClr val="EB292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直接连接符 246">
              <a:extLst>
                <a:ext uri="{FF2B5EF4-FFF2-40B4-BE49-F238E27FC236}">
                  <a16:creationId xmlns:a16="http://schemas.microsoft.com/office/drawing/2014/main" id="{836FCEB7-E4DE-4B07-B3D3-434307116136}"/>
                </a:ext>
              </a:extLst>
            </p:cNvPr>
            <p:cNvCxnSpPr/>
            <p:nvPr/>
          </p:nvCxnSpPr>
          <p:spPr>
            <a:xfrm flipH="1">
              <a:off x="8963038" y="2350948"/>
              <a:ext cx="286519" cy="7939"/>
            </a:xfrm>
            <a:prstGeom prst="line">
              <a:avLst/>
            </a:prstGeom>
            <a:ln w="9525">
              <a:solidFill>
                <a:srgbClr val="EB292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03" name="直接箭头连接符 402">
            <a:extLst>
              <a:ext uri="{FF2B5EF4-FFF2-40B4-BE49-F238E27FC236}">
                <a16:creationId xmlns:a16="http://schemas.microsoft.com/office/drawing/2014/main" id="{93AC325F-EF93-40C7-BE0D-A2B7B20F8E9F}"/>
              </a:ext>
            </a:extLst>
          </p:cNvPr>
          <p:cNvCxnSpPr>
            <a:cxnSpLocks/>
          </p:cNvCxnSpPr>
          <p:nvPr/>
        </p:nvCxnSpPr>
        <p:spPr>
          <a:xfrm>
            <a:off x="2480979" y="9822735"/>
            <a:ext cx="718756" cy="43886"/>
          </a:xfrm>
          <a:prstGeom prst="straightConnector1">
            <a:avLst/>
          </a:prstGeom>
          <a:ln w="9525">
            <a:solidFill>
              <a:srgbClr val="EB292F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4" name="直接箭头连接符 403">
            <a:extLst>
              <a:ext uri="{FF2B5EF4-FFF2-40B4-BE49-F238E27FC236}">
                <a16:creationId xmlns:a16="http://schemas.microsoft.com/office/drawing/2014/main" id="{DF67E49D-F0FC-4DDE-BD5F-5FD70DC9CAC7}"/>
              </a:ext>
            </a:extLst>
          </p:cNvPr>
          <p:cNvCxnSpPr>
            <a:cxnSpLocks/>
          </p:cNvCxnSpPr>
          <p:nvPr/>
        </p:nvCxnSpPr>
        <p:spPr>
          <a:xfrm flipV="1">
            <a:off x="2560328" y="10578978"/>
            <a:ext cx="720662" cy="350682"/>
          </a:xfrm>
          <a:prstGeom prst="straightConnector1">
            <a:avLst/>
          </a:prstGeom>
          <a:ln w="9525">
            <a:solidFill>
              <a:schemeClr val="accent5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6" name="箭头: 下 405">
            <a:extLst>
              <a:ext uri="{FF2B5EF4-FFF2-40B4-BE49-F238E27FC236}">
                <a16:creationId xmlns:a16="http://schemas.microsoft.com/office/drawing/2014/main" id="{CA6FB45B-849F-42CD-8B44-DD4366F14609}"/>
              </a:ext>
            </a:extLst>
          </p:cNvPr>
          <p:cNvSpPr/>
          <p:nvPr/>
        </p:nvSpPr>
        <p:spPr>
          <a:xfrm rot="20705361">
            <a:off x="6748882" y="8754350"/>
            <a:ext cx="334374" cy="1123661"/>
          </a:xfrm>
          <a:prstGeom prst="downArrow">
            <a:avLst/>
          </a:prstGeom>
          <a:solidFill>
            <a:srgbClr val="EB292F">
              <a:alpha val="69804"/>
            </a:srgbClr>
          </a:solidFill>
          <a:ln w="9525">
            <a:noFill/>
          </a:ln>
          <a:scene3d>
            <a:camera prst="isometricBottomDown"/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8" name="矩形 407">
            <a:extLst>
              <a:ext uri="{FF2B5EF4-FFF2-40B4-BE49-F238E27FC236}">
                <a16:creationId xmlns:a16="http://schemas.microsoft.com/office/drawing/2014/main" id="{FEB7BE35-F9DA-451F-B6AA-251D10CE09E6}"/>
              </a:ext>
            </a:extLst>
          </p:cNvPr>
          <p:cNvSpPr/>
          <p:nvPr/>
        </p:nvSpPr>
        <p:spPr>
          <a:xfrm>
            <a:off x="7154484" y="8078743"/>
            <a:ext cx="134460" cy="940562"/>
          </a:xfrm>
          <a:prstGeom prst="rect">
            <a:avLst/>
          </a:prstGeom>
          <a:solidFill>
            <a:srgbClr val="F26E72"/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409" name="箭头: 下 408">
            <a:extLst>
              <a:ext uri="{FF2B5EF4-FFF2-40B4-BE49-F238E27FC236}">
                <a16:creationId xmlns:a16="http://schemas.microsoft.com/office/drawing/2014/main" id="{3FA8E206-0F59-4BE5-9F50-4E3107262C25}"/>
              </a:ext>
            </a:extLst>
          </p:cNvPr>
          <p:cNvSpPr/>
          <p:nvPr/>
        </p:nvSpPr>
        <p:spPr>
          <a:xfrm rot="20705361">
            <a:off x="7519086" y="8754350"/>
            <a:ext cx="334374" cy="1123661"/>
          </a:xfrm>
          <a:prstGeom prst="downArrow">
            <a:avLst/>
          </a:prstGeom>
          <a:solidFill>
            <a:srgbClr val="EB292F">
              <a:alpha val="69804"/>
            </a:srgbClr>
          </a:solidFill>
          <a:ln w="9525">
            <a:noFill/>
          </a:ln>
          <a:scene3d>
            <a:camera prst="isometricBottomDown"/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0" name="矩形 409">
            <a:extLst>
              <a:ext uri="{FF2B5EF4-FFF2-40B4-BE49-F238E27FC236}">
                <a16:creationId xmlns:a16="http://schemas.microsoft.com/office/drawing/2014/main" id="{3847FB5C-5CA6-47A9-AE21-1004AA31CB98}"/>
              </a:ext>
            </a:extLst>
          </p:cNvPr>
          <p:cNvSpPr/>
          <p:nvPr/>
        </p:nvSpPr>
        <p:spPr>
          <a:xfrm>
            <a:off x="7936295" y="8078743"/>
            <a:ext cx="133989" cy="940562"/>
          </a:xfrm>
          <a:prstGeom prst="rect">
            <a:avLst/>
          </a:prstGeom>
          <a:solidFill>
            <a:srgbClr val="F26E72"/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412" name="矩形 411">
            <a:extLst>
              <a:ext uri="{FF2B5EF4-FFF2-40B4-BE49-F238E27FC236}">
                <a16:creationId xmlns:a16="http://schemas.microsoft.com/office/drawing/2014/main" id="{709DA38D-6AE9-49EA-A69D-745D769BEE84}"/>
              </a:ext>
            </a:extLst>
          </p:cNvPr>
          <p:cNvSpPr/>
          <p:nvPr/>
        </p:nvSpPr>
        <p:spPr>
          <a:xfrm>
            <a:off x="9501433" y="8078745"/>
            <a:ext cx="126846" cy="958847"/>
          </a:xfrm>
          <a:prstGeom prst="rect">
            <a:avLst/>
          </a:prstGeom>
          <a:solidFill>
            <a:schemeClr val="accent5"/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413" name="箭头: 下 412">
            <a:extLst>
              <a:ext uri="{FF2B5EF4-FFF2-40B4-BE49-F238E27FC236}">
                <a16:creationId xmlns:a16="http://schemas.microsoft.com/office/drawing/2014/main" id="{58BFA52B-C0D9-4F64-9B6A-09EB4DD97F58}"/>
              </a:ext>
            </a:extLst>
          </p:cNvPr>
          <p:cNvSpPr/>
          <p:nvPr/>
        </p:nvSpPr>
        <p:spPr>
          <a:xfrm rot="20705361">
            <a:off x="9093404" y="8762878"/>
            <a:ext cx="334374" cy="1123661"/>
          </a:xfrm>
          <a:prstGeom prst="downArrow">
            <a:avLst/>
          </a:prstGeom>
          <a:solidFill>
            <a:schemeClr val="accent5">
              <a:lumMod val="75000"/>
              <a:alpha val="69804"/>
            </a:schemeClr>
          </a:solidFill>
          <a:ln w="9525">
            <a:noFill/>
          </a:ln>
          <a:scene3d>
            <a:camera prst="isometricBottomDown"/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4" name="箭头: 下 413">
            <a:extLst>
              <a:ext uri="{FF2B5EF4-FFF2-40B4-BE49-F238E27FC236}">
                <a16:creationId xmlns:a16="http://schemas.microsoft.com/office/drawing/2014/main" id="{A2958A5F-54E0-4652-97F6-74B54CECFE30}"/>
              </a:ext>
            </a:extLst>
          </p:cNvPr>
          <p:cNvSpPr/>
          <p:nvPr/>
        </p:nvSpPr>
        <p:spPr>
          <a:xfrm rot="16200000">
            <a:off x="8849044" y="10181778"/>
            <a:ext cx="334374" cy="1123661"/>
          </a:xfrm>
          <a:prstGeom prst="downArrow">
            <a:avLst/>
          </a:prstGeom>
          <a:solidFill>
            <a:schemeClr val="accent6">
              <a:lumMod val="75000"/>
              <a:alpha val="50000"/>
            </a:schemeClr>
          </a:solidFill>
          <a:ln w="9525">
            <a:noFill/>
          </a:ln>
          <a:scene3d>
            <a:camera prst="isometricLeftDown"/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6" name="箭头: 下 415">
            <a:extLst>
              <a:ext uri="{FF2B5EF4-FFF2-40B4-BE49-F238E27FC236}">
                <a16:creationId xmlns:a16="http://schemas.microsoft.com/office/drawing/2014/main" id="{0884DA9D-9D7E-4762-80FB-0F48D074D502}"/>
              </a:ext>
            </a:extLst>
          </p:cNvPr>
          <p:cNvSpPr/>
          <p:nvPr/>
        </p:nvSpPr>
        <p:spPr>
          <a:xfrm rot="16200000">
            <a:off x="9803280" y="9190364"/>
            <a:ext cx="334374" cy="1123661"/>
          </a:xfrm>
          <a:prstGeom prst="downArrow">
            <a:avLst/>
          </a:prstGeom>
          <a:solidFill>
            <a:schemeClr val="accent6">
              <a:lumMod val="75000"/>
              <a:alpha val="50000"/>
            </a:schemeClr>
          </a:solidFill>
          <a:ln w="9525">
            <a:noFill/>
          </a:ln>
          <a:scene3d>
            <a:camera prst="isometricLeftDown"/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458" name="组合 457">
            <a:extLst>
              <a:ext uri="{FF2B5EF4-FFF2-40B4-BE49-F238E27FC236}">
                <a16:creationId xmlns:a16="http://schemas.microsoft.com/office/drawing/2014/main" id="{1BFB5BE6-2F2A-43D5-89D2-9CA61A00EE85}"/>
              </a:ext>
            </a:extLst>
          </p:cNvPr>
          <p:cNvGrpSpPr/>
          <p:nvPr/>
        </p:nvGrpSpPr>
        <p:grpSpPr>
          <a:xfrm>
            <a:off x="6644274" y="6919830"/>
            <a:ext cx="651269" cy="1085072"/>
            <a:chOff x="7296674" y="2008519"/>
            <a:chExt cx="529871" cy="882812"/>
          </a:xfrm>
        </p:grpSpPr>
        <p:sp>
          <p:nvSpPr>
            <p:cNvPr id="430" name="任意多边形: 形状 429">
              <a:extLst>
                <a:ext uri="{FF2B5EF4-FFF2-40B4-BE49-F238E27FC236}">
                  <a16:creationId xmlns:a16="http://schemas.microsoft.com/office/drawing/2014/main" id="{47B67EC2-0658-4B93-94C1-46E68B770880}"/>
                </a:ext>
              </a:extLst>
            </p:cNvPr>
            <p:cNvSpPr/>
            <p:nvPr/>
          </p:nvSpPr>
          <p:spPr>
            <a:xfrm flipH="1">
              <a:off x="7306190" y="2008519"/>
              <a:ext cx="520355" cy="882812"/>
            </a:xfrm>
            <a:custGeom>
              <a:avLst/>
              <a:gdLst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197857 w 2783758"/>
                <a:gd name="connsiteY22" fmla="*/ 1544904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289297 w 2783758"/>
                <a:gd name="connsiteY22" fmla="*/ 1636344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2783758" h="4722803">
                  <a:moveTo>
                    <a:pt x="197857" y="1544904"/>
                  </a:moveTo>
                  <a:cubicBezTo>
                    <a:pt x="212605" y="1330233"/>
                    <a:pt x="240463" y="982826"/>
                    <a:pt x="335508" y="768155"/>
                  </a:cubicBezTo>
                  <a:cubicBezTo>
                    <a:pt x="430553" y="553484"/>
                    <a:pt x="623920" y="379781"/>
                    <a:pt x="768127" y="256878"/>
                  </a:cubicBezTo>
                  <a:cubicBezTo>
                    <a:pt x="912334" y="133975"/>
                    <a:pt x="1036876" y="66788"/>
                    <a:pt x="1200747" y="30736"/>
                  </a:cubicBezTo>
                  <a:cubicBezTo>
                    <a:pt x="1364618" y="-5316"/>
                    <a:pt x="1569456" y="-18425"/>
                    <a:pt x="1751353" y="40568"/>
                  </a:cubicBezTo>
                  <a:cubicBezTo>
                    <a:pt x="1933250" y="99561"/>
                    <a:pt x="2151198" y="224103"/>
                    <a:pt x="2292127" y="384697"/>
                  </a:cubicBezTo>
                  <a:cubicBezTo>
                    <a:pt x="2433056" y="545291"/>
                    <a:pt x="2514992" y="773072"/>
                    <a:pt x="2596927" y="1004130"/>
                  </a:cubicBezTo>
                  <a:cubicBezTo>
                    <a:pt x="2678862" y="1235188"/>
                    <a:pt x="2782101" y="1503936"/>
                    <a:pt x="2783740" y="1771046"/>
                  </a:cubicBezTo>
                  <a:cubicBezTo>
                    <a:pt x="2785379" y="2038156"/>
                    <a:pt x="2678863" y="2380646"/>
                    <a:pt x="2606760" y="2606788"/>
                  </a:cubicBezTo>
                  <a:cubicBezTo>
                    <a:pt x="2534657" y="2832930"/>
                    <a:pt x="2446166" y="2954194"/>
                    <a:pt x="2351121" y="3127897"/>
                  </a:cubicBezTo>
                  <a:cubicBezTo>
                    <a:pt x="2256076" y="3301600"/>
                    <a:pt x="2146282" y="3512994"/>
                    <a:pt x="2036489" y="3649007"/>
                  </a:cubicBezTo>
                  <a:cubicBezTo>
                    <a:pt x="1926696" y="3785020"/>
                    <a:pt x="1816902" y="3840736"/>
                    <a:pt x="1692360" y="3943975"/>
                  </a:cubicBezTo>
                  <a:cubicBezTo>
                    <a:pt x="1567818" y="4047214"/>
                    <a:pt x="1431805" y="4142258"/>
                    <a:pt x="1289237" y="4268439"/>
                  </a:cubicBezTo>
                  <a:cubicBezTo>
                    <a:pt x="1146669" y="4394620"/>
                    <a:pt x="982798" y="4640427"/>
                    <a:pt x="836953" y="4701059"/>
                  </a:cubicBezTo>
                  <a:cubicBezTo>
                    <a:pt x="691108" y="4761691"/>
                    <a:pt x="522321" y="4681394"/>
                    <a:pt x="414166" y="4632233"/>
                  </a:cubicBezTo>
                  <a:cubicBezTo>
                    <a:pt x="306011" y="4583072"/>
                    <a:pt x="230630" y="4517523"/>
                    <a:pt x="188024" y="4406091"/>
                  </a:cubicBezTo>
                  <a:cubicBezTo>
                    <a:pt x="145418" y="4294659"/>
                    <a:pt x="178192" y="4084904"/>
                    <a:pt x="158527" y="3963639"/>
                  </a:cubicBezTo>
                  <a:cubicBezTo>
                    <a:pt x="138862" y="3842374"/>
                    <a:pt x="96256" y="3770272"/>
                    <a:pt x="70037" y="3678504"/>
                  </a:cubicBezTo>
                  <a:cubicBezTo>
                    <a:pt x="43818" y="3586736"/>
                    <a:pt x="-8621" y="3491691"/>
                    <a:pt x="1211" y="3413033"/>
                  </a:cubicBezTo>
                  <a:cubicBezTo>
                    <a:pt x="11043" y="3334375"/>
                    <a:pt x="89702" y="3306516"/>
                    <a:pt x="129031" y="3206555"/>
                  </a:cubicBezTo>
                  <a:cubicBezTo>
                    <a:pt x="168360" y="3106594"/>
                    <a:pt x="217521" y="3004994"/>
                    <a:pt x="237186" y="2813265"/>
                  </a:cubicBezTo>
                </a:path>
              </a:pathLst>
            </a:custGeom>
            <a:solidFill>
              <a:schemeClr val="bg1">
                <a:lumMod val="95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431" name="任意多边形: 形状 430">
              <a:extLst>
                <a:ext uri="{FF2B5EF4-FFF2-40B4-BE49-F238E27FC236}">
                  <a16:creationId xmlns:a16="http://schemas.microsoft.com/office/drawing/2014/main" id="{CF0B87D8-BC25-4CA3-85FF-A5560562DDEC}"/>
                </a:ext>
              </a:extLst>
            </p:cNvPr>
            <p:cNvSpPr/>
            <p:nvPr/>
          </p:nvSpPr>
          <p:spPr>
            <a:xfrm flipH="1">
              <a:off x="7296674" y="2008519"/>
              <a:ext cx="507263" cy="882812"/>
            </a:xfrm>
            <a:custGeom>
              <a:avLst/>
              <a:gdLst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197857 w 2783758"/>
                <a:gd name="connsiteY22" fmla="*/ 1544904 h 4722803"/>
                <a:gd name="connsiteX0" fmla="*/ 247018 w 2783758"/>
                <a:gd name="connsiteY0" fmla="*/ 2056181 h 4722803"/>
                <a:gd name="connsiteX1" fmla="*/ 197857 w 2783758"/>
                <a:gd name="connsiteY1" fmla="*/ 1544904 h 4722803"/>
                <a:gd name="connsiteX2" fmla="*/ 335508 w 2783758"/>
                <a:gd name="connsiteY2" fmla="*/ 768155 h 4722803"/>
                <a:gd name="connsiteX3" fmla="*/ 768127 w 2783758"/>
                <a:gd name="connsiteY3" fmla="*/ 256878 h 4722803"/>
                <a:gd name="connsiteX4" fmla="*/ 1200747 w 2783758"/>
                <a:gd name="connsiteY4" fmla="*/ 30736 h 4722803"/>
                <a:gd name="connsiteX5" fmla="*/ 1751353 w 2783758"/>
                <a:gd name="connsiteY5" fmla="*/ 40568 h 4722803"/>
                <a:gd name="connsiteX6" fmla="*/ 2292127 w 2783758"/>
                <a:gd name="connsiteY6" fmla="*/ 384697 h 4722803"/>
                <a:gd name="connsiteX7" fmla="*/ 2596927 w 2783758"/>
                <a:gd name="connsiteY7" fmla="*/ 1004130 h 4722803"/>
                <a:gd name="connsiteX8" fmla="*/ 2783740 w 2783758"/>
                <a:gd name="connsiteY8" fmla="*/ 1771046 h 4722803"/>
                <a:gd name="connsiteX9" fmla="*/ 2606760 w 2783758"/>
                <a:gd name="connsiteY9" fmla="*/ 2606788 h 4722803"/>
                <a:gd name="connsiteX10" fmla="*/ 2351121 w 2783758"/>
                <a:gd name="connsiteY10" fmla="*/ 3127897 h 4722803"/>
                <a:gd name="connsiteX11" fmla="*/ 2036489 w 2783758"/>
                <a:gd name="connsiteY11" fmla="*/ 3649007 h 4722803"/>
                <a:gd name="connsiteX12" fmla="*/ 1692360 w 2783758"/>
                <a:gd name="connsiteY12" fmla="*/ 3943975 h 4722803"/>
                <a:gd name="connsiteX13" fmla="*/ 1289237 w 2783758"/>
                <a:gd name="connsiteY13" fmla="*/ 4268439 h 4722803"/>
                <a:gd name="connsiteX14" fmla="*/ 836953 w 2783758"/>
                <a:gd name="connsiteY14" fmla="*/ 4701059 h 4722803"/>
                <a:gd name="connsiteX15" fmla="*/ 414166 w 2783758"/>
                <a:gd name="connsiteY15" fmla="*/ 4632233 h 4722803"/>
                <a:gd name="connsiteX16" fmla="*/ 188024 w 2783758"/>
                <a:gd name="connsiteY16" fmla="*/ 4406091 h 4722803"/>
                <a:gd name="connsiteX17" fmla="*/ 158527 w 2783758"/>
                <a:gd name="connsiteY17" fmla="*/ 3963639 h 4722803"/>
                <a:gd name="connsiteX18" fmla="*/ 70037 w 2783758"/>
                <a:gd name="connsiteY18" fmla="*/ 3678504 h 4722803"/>
                <a:gd name="connsiteX19" fmla="*/ 1211 w 2783758"/>
                <a:gd name="connsiteY19" fmla="*/ 3413033 h 4722803"/>
                <a:gd name="connsiteX20" fmla="*/ 129031 w 2783758"/>
                <a:gd name="connsiteY20" fmla="*/ 3206555 h 4722803"/>
                <a:gd name="connsiteX21" fmla="*/ 237186 w 2783758"/>
                <a:gd name="connsiteY21" fmla="*/ 2813265 h 4722803"/>
                <a:gd name="connsiteX22" fmla="*/ 338458 w 2783758"/>
                <a:gd name="connsiteY22" fmla="*/ 2147621 h 4722803"/>
                <a:gd name="connsiteX0" fmla="*/ 247018 w 2783758"/>
                <a:gd name="connsiteY0" fmla="*/ 2056181 h 4722803"/>
                <a:gd name="connsiteX1" fmla="*/ 197857 w 2783758"/>
                <a:gd name="connsiteY1" fmla="*/ 1544904 h 4722803"/>
                <a:gd name="connsiteX2" fmla="*/ 335508 w 2783758"/>
                <a:gd name="connsiteY2" fmla="*/ 768155 h 4722803"/>
                <a:gd name="connsiteX3" fmla="*/ 768127 w 2783758"/>
                <a:gd name="connsiteY3" fmla="*/ 256878 h 4722803"/>
                <a:gd name="connsiteX4" fmla="*/ 1200747 w 2783758"/>
                <a:gd name="connsiteY4" fmla="*/ 30736 h 4722803"/>
                <a:gd name="connsiteX5" fmla="*/ 1751353 w 2783758"/>
                <a:gd name="connsiteY5" fmla="*/ 40568 h 4722803"/>
                <a:gd name="connsiteX6" fmla="*/ 2292127 w 2783758"/>
                <a:gd name="connsiteY6" fmla="*/ 384697 h 4722803"/>
                <a:gd name="connsiteX7" fmla="*/ 2596927 w 2783758"/>
                <a:gd name="connsiteY7" fmla="*/ 1004130 h 4722803"/>
                <a:gd name="connsiteX8" fmla="*/ 2783740 w 2783758"/>
                <a:gd name="connsiteY8" fmla="*/ 1771046 h 4722803"/>
                <a:gd name="connsiteX9" fmla="*/ 2606760 w 2783758"/>
                <a:gd name="connsiteY9" fmla="*/ 2606788 h 4722803"/>
                <a:gd name="connsiteX10" fmla="*/ 2351121 w 2783758"/>
                <a:gd name="connsiteY10" fmla="*/ 3127897 h 4722803"/>
                <a:gd name="connsiteX11" fmla="*/ 2036489 w 2783758"/>
                <a:gd name="connsiteY11" fmla="*/ 3649007 h 4722803"/>
                <a:gd name="connsiteX12" fmla="*/ 1692360 w 2783758"/>
                <a:gd name="connsiteY12" fmla="*/ 3943975 h 4722803"/>
                <a:gd name="connsiteX13" fmla="*/ 1289237 w 2783758"/>
                <a:gd name="connsiteY13" fmla="*/ 4268439 h 4722803"/>
                <a:gd name="connsiteX14" fmla="*/ 836953 w 2783758"/>
                <a:gd name="connsiteY14" fmla="*/ 4701059 h 4722803"/>
                <a:gd name="connsiteX15" fmla="*/ 414166 w 2783758"/>
                <a:gd name="connsiteY15" fmla="*/ 4632233 h 4722803"/>
                <a:gd name="connsiteX16" fmla="*/ 188024 w 2783758"/>
                <a:gd name="connsiteY16" fmla="*/ 4406091 h 4722803"/>
                <a:gd name="connsiteX17" fmla="*/ 158527 w 2783758"/>
                <a:gd name="connsiteY17" fmla="*/ 3963639 h 4722803"/>
                <a:gd name="connsiteX18" fmla="*/ 70037 w 2783758"/>
                <a:gd name="connsiteY18" fmla="*/ 3678504 h 4722803"/>
                <a:gd name="connsiteX19" fmla="*/ 1211 w 2783758"/>
                <a:gd name="connsiteY19" fmla="*/ 3413033 h 4722803"/>
                <a:gd name="connsiteX20" fmla="*/ 129031 w 2783758"/>
                <a:gd name="connsiteY20" fmla="*/ 3206555 h 4722803"/>
                <a:gd name="connsiteX21" fmla="*/ 237186 w 2783758"/>
                <a:gd name="connsiteY21" fmla="*/ 281326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0" fmla="*/ 127820 w 2713721"/>
                <a:gd name="connsiteY0" fmla="*/ 1544904 h 4722803"/>
                <a:gd name="connsiteX1" fmla="*/ 265471 w 2713721"/>
                <a:gd name="connsiteY1" fmla="*/ 768155 h 4722803"/>
                <a:gd name="connsiteX2" fmla="*/ 698090 w 2713721"/>
                <a:gd name="connsiteY2" fmla="*/ 256878 h 4722803"/>
                <a:gd name="connsiteX3" fmla="*/ 1130710 w 2713721"/>
                <a:gd name="connsiteY3" fmla="*/ 30736 h 4722803"/>
                <a:gd name="connsiteX4" fmla="*/ 1681316 w 2713721"/>
                <a:gd name="connsiteY4" fmla="*/ 40568 h 4722803"/>
                <a:gd name="connsiteX5" fmla="*/ 2222090 w 2713721"/>
                <a:gd name="connsiteY5" fmla="*/ 384697 h 4722803"/>
                <a:gd name="connsiteX6" fmla="*/ 2526890 w 2713721"/>
                <a:gd name="connsiteY6" fmla="*/ 1004130 h 4722803"/>
                <a:gd name="connsiteX7" fmla="*/ 2713703 w 2713721"/>
                <a:gd name="connsiteY7" fmla="*/ 1771046 h 4722803"/>
                <a:gd name="connsiteX8" fmla="*/ 2536723 w 2713721"/>
                <a:gd name="connsiteY8" fmla="*/ 2606788 h 4722803"/>
                <a:gd name="connsiteX9" fmla="*/ 2281084 w 2713721"/>
                <a:gd name="connsiteY9" fmla="*/ 3127897 h 4722803"/>
                <a:gd name="connsiteX10" fmla="*/ 1966452 w 2713721"/>
                <a:gd name="connsiteY10" fmla="*/ 3649007 h 4722803"/>
                <a:gd name="connsiteX11" fmla="*/ 1622323 w 2713721"/>
                <a:gd name="connsiteY11" fmla="*/ 3943975 h 4722803"/>
                <a:gd name="connsiteX12" fmla="*/ 1219200 w 2713721"/>
                <a:gd name="connsiteY12" fmla="*/ 4268439 h 4722803"/>
                <a:gd name="connsiteX13" fmla="*/ 766916 w 2713721"/>
                <a:gd name="connsiteY13" fmla="*/ 4701059 h 4722803"/>
                <a:gd name="connsiteX14" fmla="*/ 344129 w 2713721"/>
                <a:gd name="connsiteY14" fmla="*/ 4632233 h 4722803"/>
                <a:gd name="connsiteX15" fmla="*/ 117987 w 2713721"/>
                <a:gd name="connsiteY15" fmla="*/ 4406091 h 4722803"/>
                <a:gd name="connsiteX16" fmla="*/ 88490 w 2713721"/>
                <a:gd name="connsiteY16" fmla="*/ 3963639 h 4722803"/>
                <a:gd name="connsiteX17" fmla="*/ 0 w 2713721"/>
                <a:gd name="connsiteY17" fmla="*/ 3678504 h 47228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2713721" h="4722803">
                  <a:moveTo>
                    <a:pt x="127820" y="1544904"/>
                  </a:moveTo>
                  <a:cubicBezTo>
                    <a:pt x="142568" y="1330233"/>
                    <a:pt x="170426" y="982826"/>
                    <a:pt x="265471" y="768155"/>
                  </a:cubicBezTo>
                  <a:cubicBezTo>
                    <a:pt x="360516" y="553484"/>
                    <a:pt x="553883" y="379781"/>
                    <a:pt x="698090" y="256878"/>
                  </a:cubicBezTo>
                  <a:cubicBezTo>
                    <a:pt x="842297" y="133975"/>
                    <a:pt x="966839" y="66788"/>
                    <a:pt x="1130710" y="30736"/>
                  </a:cubicBezTo>
                  <a:cubicBezTo>
                    <a:pt x="1294581" y="-5316"/>
                    <a:pt x="1499419" y="-18425"/>
                    <a:pt x="1681316" y="40568"/>
                  </a:cubicBezTo>
                  <a:cubicBezTo>
                    <a:pt x="1863213" y="99561"/>
                    <a:pt x="2081161" y="224103"/>
                    <a:pt x="2222090" y="384697"/>
                  </a:cubicBezTo>
                  <a:cubicBezTo>
                    <a:pt x="2363019" y="545291"/>
                    <a:pt x="2444955" y="773072"/>
                    <a:pt x="2526890" y="1004130"/>
                  </a:cubicBezTo>
                  <a:cubicBezTo>
                    <a:pt x="2608825" y="1235188"/>
                    <a:pt x="2712064" y="1503936"/>
                    <a:pt x="2713703" y="1771046"/>
                  </a:cubicBezTo>
                  <a:cubicBezTo>
                    <a:pt x="2715342" y="2038156"/>
                    <a:pt x="2608826" y="2380646"/>
                    <a:pt x="2536723" y="2606788"/>
                  </a:cubicBezTo>
                  <a:cubicBezTo>
                    <a:pt x="2464620" y="2832930"/>
                    <a:pt x="2376129" y="2954194"/>
                    <a:pt x="2281084" y="3127897"/>
                  </a:cubicBezTo>
                  <a:cubicBezTo>
                    <a:pt x="2186039" y="3301600"/>
                    <a:pt x="2076245" y="3512994"/>
                    <a:pt x="1966452" y="3649007"/>
                  </a:cubicBezTo>
                  <a:cubicBezTo>
                    <a:pt x="1856659" y="3785020"/>
                    <a:pt x="1746865" y="3840736"/>
                    <a:pt x="1622323" y="3943975"/>
                  </a:cubicBezTo>
                  <a:cubicBezTo>
                    <a:pt x="1497781" y="4047214"/>
                    <a:pt x="1361768" y="4142258"/>
                    <a:pt x="1219200" y="4268439"/>
                  </a:cubicBezTo>
                  <a:cubicBezTo>
                    <a:pt x="1076632" y="4394620"/>
                    <a:pt x="912761" y="4640427"/>
                    <a:pt x="766916" y="4701059"/>
                  </a:cubicBezTo>
                  <a:cubicBezTo>
                    <a:pt x="621071" y="4761691"/>
                    <a:pt x="452284" y="4681394"/>
                    <a:pt x="344129" y="4632233"/>
                  </a:cubicBezTo>
                  <a:cubicBezTo>
                    <a:pt x="235974" y="4583072"/>
                    <a:pt x="160593" y="4517523"/>
                    <a:pt x="117987" y="4406091"/>
                  </a:cubicBezTo>
                  <a:cubicBezTo>
                    <a:pt x="75381" y="4294659"/>
                    <a:pt x="108155" y="4084904"/>
                    <a:pt x="88490" y="3963639"/>
                  </a:cubicBezTo>
                  <a:cubicBezTo>
                    <a:pt x="68825" y="3842374"/>
                    <a:pt x="26219" y="3770272"/>
                    <a:pt x="0" y="3678504"/>
                  </a:cubicBezTo>
                </a:path>
              </a:pathLst>
            </a:custGeom>
            <a:solidFill>
              <a:schemeClr val="bg1">
                <a:lumMod val="95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2" name="任意多边形: 形状 431">
              <a:extLst>
                <a:ext uri="{FF2B5EF4-FFF2-40B4-BE49-F238E27FC236}">
                  <a16:creationId xmlns:a16="http://schemas.microsoft.com/office/drawing/2014/main" id="{49DAB492-8AD4-4782-8E4C-A369F34850B7}"/>
                </a:ext>
              </a:extLst>
            </p:cNvPr>
            <p:cNvSpPr/>
            <p:nvPr/>
          </p:nvSpPr>
          <p:spPr>
            <a:xfrm flipH="1">
              <a:off x="7628004" y="2398200"/>
              <a:ext cx="80868" cy="80868"/>
            </a:xfrm>
            <a:custGeom>
              <a:avLst/>
              <a:gdLst>
                <a:gd name="connsiteX0" fmla="*/ 0 w 1101213"/>
                <a:gd name="connsiteY0" fmla="*/ 0 h 865238"/>
                <a:gd name="connsiteX1" fmla="*/ 98323 w 1101213"/>
                <a:gd name="connsiteY1" fmla="*/ 206477 h 865238"/>
                <a:gd name="connsiteX2" fmla="*/ 265471 w 1101213"/>
                <a:gd name="connsiteY2" fmla="*/ 373625 h 865238"/>
                <a:gd name="connsiteX3" fmla="*/ 432619 w 1101213"/>
                <a:gd name="connsiteY3" fmla="*/ 432619 h 865238"/>
                <a:gd name="connsiteX4" fmla="*/ 786581 w 1101213"/>
                <a:gd name="connsiteY4" fmla="*/ 550606 h 865238"/>
                <a:gd name="connsiteX5" fmla="*/ 1002890 w 1101213"/>
                <a:gd name="connsiteY5" fmla="*/ 639096 h 865238"/>
                <a:gd name="connsiteX6" fmla="*/ 1081548 w 1101213"/>
                <a:gd name="connsiteY6" fmla="*/ 786580 h 865238"/>
                <a:gd name="connsiteX7" fmla="*/ 1101213 w 1101213"/>
                <a:gd name="connsiteY7" fmla="*/ 865238 h 865238"/>
                <a:gd name="connsiteX0" fmla="*/ 0 w 1082429"/>
                <a:gd name="connsiteY0" fmla="*/ 0 h 941438"/>
                <a:gd name="connsiteX1" fmla="*/ 98323 w 1082429"/>
                <a:gd name="connsiteY1" fmla="*/ 206477 h 941438"/>
                <a:gd name="connsiteX2" fmla="*/ 265471 w 1082429"/>
                <a:gd name="connsiteY2" fmla="*/ 373625 h 941438"/>
                <a:gd name="connsiteX3" fmla="*/ 432619 w 1082429"/>
                <a:gd name="connsiteY3" fmla="*/ 432619 h 941438"/>
                <a:gd name="connsiteX4" fmla="*/ 786581 w 1082429"/>
                <a:gd name="connsiteY4" fmla="*/ 550606 h 941438"/>
                <a:gd name="connsiteX5" fmla="*/ 1002890 w 1082429"/>
                <a:gd name="connsiteY5" fmla="*/ 639096 h 941438"/>
                <a:gd name="connsiteX6" fmla="*/ 1081548 w 1082429"/>
                <a:gd name="connsiteY6" fmla="*/ 786580 h 941438"/>
                <a:gd name="connsiteX7" fmla="*/ 1047873 w 1082429"/>
                <a:gd name="connsiteY7" fmla="*/ 941438 h 941438"/>
                <a:gd name="connsiteX0" fmla="*/ 0 w 1081550"/>
                <a:gd name="connsiteY0" fmla="*/ 0 h 786579"/>
                <a:gd name="connsiteX1" fmla="*/ 98323 w 1081550"/>
                <a:gd name="connsiteY1" fmla="*/ 206477 h 786579"/>
                <a:gd name="connsiteX2" fmla="*/ 265471 w 1081550"/>
                <a:gd name="connsiteY2" fmla="*/ 373625 h 786579"/>
                <a:gd name="connsiteX3" fmla="*/ 432619 w 1081550"/>
                <a:gd name="connsiteY3" fmla="*/ 432619 h 786579"/>
                <a:gd name="connsiteX4" fmla="*/ 786581 w 1081550"/>
                <a:gd name="connsiteY4" fmla="*/ 550606 h 786579"/>
                <a:gd name="connsiteX5" fmla="*/ 1002890 w 1081550"/>
                <a:gd name="connsiteY5" fmla="*/ 639096 h 786579"/>
                <a:gd name="connsiteX6" fmla="*/ 1081548 w 1081550"/>
                <a:gd name="connsiteY6" fmla="*/ 786580 h 786579"/>
                <a:gd name="connsiteX0" fmla="*/ 0 w 1002889"/>
                <a:gd name="connsiteY0" fmla="*/ 0 h 639095"/>
                <a:gd name="connsiteX1" fmla="*/ 98323 w 1002889"/>
                <a:gd name="connsiteY1" fmla="*/ 206477 h 639095"/>
                <a:gd name="connsiteX2" fmla="*/ 265471 w 1002889"/>
                <a:gd name="connsiteY2" fmla="*/ 373625 h 639095"/>
                <a:gd name="connsiteX3" fmla="*/ 432619 w 1002889"/>
                <a:gd name="connsiteY3" fmla="*/ 432619 h 639095"/>
                <a:gd name="connsiteX4" fmla="*/ 786581 w 1002889"/>
                <a:gd name="connsiteY4" fmla="*/ 550606 h 639095"/>
                <a:gd name="connsiteX5" fmla="*/ 1002890 w 1002889"/>
                <a:gd name="connsiteY5" fmla="*/ 639096 h 639095"/>
                <a:gd name="connsiteX0" fmla="*/ 0 w 786581"/>
                <a:gd name="connsiteY0" fmla="*/ 0 h 550606"/>
                <a:gd name="connsiteX1" fmla="*/ 98323 w 786581"/>
                <a:gd name="connsiteY1" fmla="*/ 206477 h 550606"/>
                <a:gd name="connsiteX2" fmla="*/ 265471 w 786581"/>
                <a:gd name="connsiteY2" fmla="*/ 373625 h 550606"/>
                <a:gd name="connsiteX3" fmla="*/ 432619 w 786581"/>
                <a:gd name="connsiteY3" fmla="*/ 432619 h 550606"/>
                <a:gd name="connsiteX4" fmla="*/ 786581 w 786581"/>
                <a:gd name="connsiteY4" fmla="*/ 550606 h 550606"/>
                <a:gd name="connsiteX0" fmla="*/ 0 w 432621"/>
                <a:gd name="connsiteY0" fmla="*/ 0 h 432620"/>
                <a:gd name="connsiteX1" fmla="*/ 98323 w 432621"/>
                <a:gd name="connsiteY1" fmla="*/ 206477 h 432620"/>
                <a:gd name="connsiteX2" fmla="*/ 265471 w 432621"/>
                <a:gd name="connsiteY2" fmla="*/ 373625 h 432620"/>
                <a:gd name="connsiteX3" fmla="*/ 432619 w 432621"/>
                <a:gd name="connsiteY3" fmla="*/ 432619 h 4326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2621" h="432620">
                  <a:moveTo>
                    <a:pt x="0" y="0"/>
                  </a:moveTo>
                  <a:cubicBezTo>
                    <a:pt x="27039" y="72103"/>
                    <a:pt x="54078" y="144206"/>
                    <a:pt x="98323" y="206477"/>
                  </a:cubicBezTo>
                  <a:cubicBezTo>
                    <a:pt x="142568" y="268748"/>
                    <a:pt x="209755" y="335935"/>
                    <a:pt x="265471" y="373625"/>
                  </a:cubicBezTo>
                  <a:cubicBezTo>
                    <a:pt x="321187" y="411315"/>
                    <a:pt x="432619" y="432619"/>
                    <a:pt x="432619" y="43261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3" name="任意多边形: 形状 432">
              <a:extLst>
                <a:ext uri="{FF2B5EF4-FFF2-40B4-BE49-F238E27FC236}">
                  <a16:creationId xmlns:a16="http://schemas.microsoft.com/office/drawing/2014/main" id="{1E14BE69-3455-4B60-A915-BDA2DB17A05D}"/>
                </a:ext>
              </a:extLst>
            </p:cNvPr>
            <p:cNvSpPr/>
            <p:nvPr/>
          </p:nvSpPr>
          <p:spPr>
            <a:xfrm flipH="1">
              <a:off x="7509150" y="2473453"/>
              <a:ext cx="247301" cy="221798"/>
            </a:xfrm>
            <a:custGeom>
              <a:avLst/>
              <a:gdLst>
                <a:gd name="connsiteX0" fmla="*/ 506751 w 1322993"/>
                <a:gd name="connsiteY0" fmla="*/ 1530 h 1186562"/>
                <a:gd name="connsiteX1" fmla="*/ 880376 w 1322993"/>
                <a:gd name="connsiteY1" fmla="*/ 149013 h 1186562"/>
                <a:gd name="connsiteX2" fmla="*/ 1214673 w 1322993"/>
                <a:gd name="connsiteY2" fmla="*/ 267001 h 1186562"/>
                <a:gd name="connsiteX3" fmla="*/ 1322828 w 1322993"/>
                <a:gd name="connsiteY3" fmla="*/ 384988 h 1186562"/>
                <a:gd name="connsiteX4" fmla="*/ 1234338 w 1322993"/>
                <a:gd name="connsiteY4" fmla="*/ 670123 h 1186562"/>
                <a:gd name="connsiteX5" fmla="*/ 1047525 w 1322993"/>
                <a:gd name="connsiteY5" fmla="*/ 738949 h 1186562"/>
                <a:gd name="connsiteX6" fmla="*/ 801718 w 1322993"/>
                <a:gd name="connsiteY6" fmla="*/ 738949 h 1186562"/>
                <a:gd name="connsiteX7" fmla="*/ 644402 w 1322993"/>
                <a:gd name="connsiteY7" fmla="*/ 817607 h 1186562"/>
                <a:gd name="connsiteX8" fmla="*/ 457589 w 1322993"/>
                <a:gd name="connsiteY8" fmla="*/ 955259 h 1186562"/>
                <a:gd name="connsiteX9" fmla="*/ 310105 w 1322993"/>
                <a:gd name="connsiteY9" fmla="*/ 1132239 h 1186562"/>
                <a:gd name="connsiteX10" fmla="*/ 74131 w 1322993"/>
                <a:gd name="connsiteY10" fmla="*/ 1171568 h 1186562"/>
                <a:gd name="connsiteX11" fmla="*/ 5305 w 1322993"/>
                <a:gd name="connsiteY11" fmla="*/ 906097 h 1186562"/>
                <a:gd name="connsiteX12" fmla="*/ 192118 w 1322993"/>
                <a:gd name="connsiteY12" fmla="*/ 689788 h 1186562"/>
                <a:gd name="connsiteX13" fmla="*/ 359267 w 1322993"/>
                <a:gd name="connsiteY13" fmla="*/ 424317 h 1186562"/>
                <a:gd name="connsiteX14" fmla="*/ 369099 w 1322993"/>
                <a:gd name="connsiteY14" fmla="*/ 247336 h 1186562"/>
                <a:gd name="connsiteX15" fmla="*/ 506751 w 1322993"/>
                <a:gd name="connsiteY15" fmla="*/ 1530 h 11865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1322993" h="1186562">
                  <a:moveTo>
                    <a:pt x="506751" y="1530"/>
                  </a:moveTo>
                  <a:cubicBezTo>
                    <a:pt x="591964" y="-14857"/>
                    <a:pt x="762389" y="104768"/>
                    <a:pt x="880376" y="149013"/>
                  </a:cubicBezTo>
                  <a:cubicBezTo>
                    <a:pt x="998363" y="193258"/>
                    <a:pt x="1140931" y="227672"/>
                    <a:pt x="1214673" y="267001"/>
                  </a:cubicBezTo>
                  <a:cubicBezTo>
                    <a:pt x="1288415" y="306330"/>
                    <a:pt x="1319551" y="317801"/>
                    <a:pt x="1322828" y="384988"/>
                  </a:cubicBezTo>
                  <a:cubicBezTo>
                    <a:pt x="1326106" y="452175"/>
                    <a:pt x="1280222" y="611130"/>
                    <a:pt x="1234338" y="670123"/>
                  </a:cubicBezTo>
                  <a:cubicBezTo>
                    <a:pt x="1188454" y="729116"/>
                    <a:pt x="1119628" y="727478"/>
                    <a:pt x="1047525" y="738949"/>
                  </a:cubicBezTo>
                  <a:cubicBezTo>
                    <a:pt x="975422" y="750420"/>
                    <a:pt x="868905" y="725839"/>
                    <a:pt x="801718" y="738949"/>
                  </a:cubicBezTo>
                  <a:cubicBezTo>
                    <a:pt x="734531" y="752059"/>
                    <a:pt x="701757" y="781555"/>
                    <a:pt x="644402" y="817607"/>
                  </a:cubicBezTo>
                  <a:cubicBezTo>
                    <a:pt x="587047" y="853659"/>
                    <a:pt x="513305" y="902820"/>
                    <a:pt x="457589" y="955259"/>
                  </a:cubicBezTo>
                  <a:cubicBezTo>
                    <a:pt x="401873" y="1007698"/>
                    <a:pt x="374015" y="1096188"/>
                    <a:pt x="310105" y="1132239"/>
                  </a:cubicBezTo>
                  <a:cubicBezTo>
                    <a:pt x="246195" y="1168290"/>
                    <a:pt x="124931" y="1209258"/>
                    <a:pt x="74131" y="1171568"/>
                  </a:cubicBezTo>
                  <a:cubicBezTo>
                    <a:pt x="23331" y="1133878"/>
                    <a:pt x="-14360" y="986394"/>
                    <a:pt x="5305" y="906097"/>
                  </a:cubicBezTo>
                  <a:cubicBezTo>
                    <a:pt x="24970" y="825800"/>
                    <a:pt x="133124" y="770085"/>
                    <a:pt x="192118" y="689788"/>
                  </a:cubicBezTo>
                  <a:cubicBezTo>
                    <a:pt x="251112" y="609491"/>
                    <a:pt x="329770" y="498059"/>
                    <a:pt x="359267" y="424317"/>
                  </a:cubicBezTo>
                  <a:cubicBezTo>
                    <a:pt x="388764" y="350575"/>
                    <a:pt x="344518" y="312884"/>
                    <a:pt x="369099" y="247336"/>
                  </a:cubicBezTo>
                  <a:cubicBezTo>
                    <a:pt x="393680" y="181788"/>
                    <a:pt x="421538" y="17917"/>
                    <a:pt x="506751" y="1530"/>
                  </a:cubicBezTo>
                  <a:close/>
                </a:path>
              </a:pathLst>
            </a:custGeom>
            <a:solidFill>
              <a:schemeClr val="accent3"/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4" name="任意多边形: 形状 433">
              <a:extLst>
                <a:ext uri="{FF2B5EF4-FFF2-40B4-BE49-F238E27FC236}">
                  <a16:creationId xmlns:a16="http://schemas.microsoft.com/office/drawing/2014/main" id="{618FBC23-6687-4E0D-9B54-00D552D5E71A}"/>
                </a:ext>
              </a:extLst>
            </p:cNvPr>
            <p:cNvSpPr/>
            <p:nvPr/>
          </p:nvSpPr>
          <p:spPr>
            <a:xfrm flipH="1">
              <a:off x="7507799" y="2279320"/>
              <a:ext cx="153472" cy="152913"/>
            </a:xfrm>
            <a:custGeom>
              <a:avLst/>
              <a:gdLst>
                <a:gd name="connsiteX0" fmla="*/ 3396 w 205414"/>
                <a:gd name="connsiteY0" fmla="*/ 257 h 204666"/>
                <a:gd name="connsiteX1" fmla="*/ 22446 w 205414"/>
                <a:gd name="connsiteY1" fmla="*/ 81220 h 204666"/>
                <a:gd name="connsiteX2" fmla="*/ 12921 w 205414"/>
                <a:gd name="connsiteY2" fmla="*/ 138370 h 204666"/>
                <a:gd name="connsiteX3" fmla="*/ 112933 w 205414"/>
                <a:gd name="connsiteY3" fmla="*/ 195520 h 204666"/>
                <a:gd name="connsiteX4" fmla="*/ 198658 w 205414"/>
                <a:gd name="connsiteY4" fmla="*/ 200282 h 204666"/>
                <a:gd name="connsiteX5" fmla="*/ 189133 w 205414"/>
                <a:gd name="connsiteY5" fmla="*/ 152657 h 204666"/>
                <a:gd name="connsiteX6" fmla="*/ 103408 w 205414"/>
                <a:gd name="connsiteY6" fmla="*/ 109795 h 204666"/>
                <a:gd name="connsiteX7" fmla="*/ 3396 w 205414"/>
                <a:gd name="connsiteY7" fmla="*/ 257 h 2046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05414" h="204666">
                  <a:moveTo>
                    <a:pt x="3396" y="257"/>
                  </a:moveTo>
                  <a:cubicBezTo>
                    <a:pt x="-10098" y="-4506"/>
                    <a:pt x="20859" y="58201"/>
                    <a:pt x="22446" y="81220"/>
                  </a:cubicBezTo>
                  <a:cubicBezTo>
                    <a:pt x="24033" y="104239"/>
                    <a:pt x="-2160" y="119320"/>
                    <a:pt x="12921" y="138370"/>
                  </a:cubicBezTo>
                  <a:cubicBezTo>
                    <a:pt x="28002" y="157420"/>
                    <a:pt x="81977" y="185201"/>
                    <a:pt x="112933" y="195520"/>
                  </a:cubicBezTo>
                  <a:cubicBezTo>
                    <a:pt x="143889" y="205839"/>
                    <a:pt x="185958" y="207426"/>
                    <a:pt x="198658" y="200282"/>
                  </a:cubicBezTo>
                  <a:cubicBezTo>
                    <a:pt x="211358" y="193138"/>
                    <a:pt x="205008" y="167738"/>
                    <a:pt x="189133" y="152657"/>
                  </a:cubicBezTo>
                  <a:cubicBezTo>
                    <a:pt x="173258" y="137576"/>
                    <a:pt x="129602" y="131226"/>
                    <a:pt x="103408" y="109795"/>
                  </a:cubicBezTo>
                  <a:cubicBezTo>
                    <a:pt x="77214" y="88364"/>
                    <a:pt x="16890" y="5020"/>
                    <a:pt x="3396" y="257"/>
                  </a:cubicBez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5" name="任意多边形: 形状 434">
              <a:extLst>
                <a:ext uri="{FF2B5EF4-FFF2-40B4-BE49-F238E27FC236}">
                  <a16:creationId xmlns:a16="http://schemas.microsoft.com/office/drawing/2014/main" id="{E523BF9D-270B-483B-9357-51BE65A46570}"/>
                </a:ext>
              </a:extLst>
            </p:cNvPr>
            <p:cNvSpPr/>
            <p:nvPr/>
          </p:nvSpPr>
          <p:spPr>
            <a:xfrm flipH="1">
              <a:off x="7463813" y="2115552"/>
              <a:ext cx="225154" cy="319674"/>
            </a:xfrm>
            <a:custGeom>
              <a:avLst/>
              <a:gdLst>
                <a:gd name="connsiteX0" fmla="*/ 301344 w 301394"/>
                <a:gd name="connsiteY0" fmla="*/ 48032 h 410775"/>
                <a:gd name="connsiteX1" fmla="*/ 199744 w 301394"/>
                <a:gd name="connsiteY1" fmla="*/ 28982 h 410775"/>
                <a:gd name="connsiteX2" fmla="*/ 98144 w 301394"/>
                <a:gd name="connsiteY2" fmla="*/ 28982 h 410775"/>
                <a:gd name="connsiteX3" fmla="*/ 98144 w 301394"/>
                <a:gd name="connsiteY3" fmla="*/ 73432 h 410775"/>
                <a:gd name="connsiteX4" fmla="*/ 98144 w 301394"/>
                <a:gd name="connsiteY4" fmla="*/ 162332 h 410775"/>
                <a:gd name="connsiteX5" fmla="*/ 79094 w 301394"/>
                <a:gd name="connsiteY5" fmla="*/ 200432 h 410775"/>
                <a:gd name="connsiteX6" fmla="*/ 91794 w 301394"/>
                <a:gd name="connsiteY6" fmla="*/ 270282 h 410775"/>
                <a:gd name="connsiteX7" fmla="*/ 155294 w 301394"/>
                <a:gd name="connsiteY7" fmla="*/ 289332 h 410775"/>
                <a:gd name="connsiteX8" fmla="*/ 212444 w 301394"/>
                <a:gd name="connsiteY8" fmla="*/ 346482 h 410775"/>
                <a:gd name="connsiteX9" fmla="*/ 237844 w 301394"/>
                <a:gd name="connsiteY9" fmla="*/ 403632 h 410775"/>
                <a:gd name="connsiteX10" fmla="*/ 161644 w 301394"/>
                <a:gd name="connsiteY10" fmla="*/ 403632 h 410775"/>
                <a:gd name="connsiteX11" fmla="*/ 40994 w 301394"/>
                <a:gd name="connsiteY11" fmla="*/ 346482 h 410775"/>
                <a:gd name="connsiteX12" fmla="*/ 40994 w 301394"/>
                <a:gd name="connsiteY12" fmla="*/ 276632 h 410775"/>
                <a:gd name="connsiteX13" fmla="*/ 40994 w 301394"/>
                <a:gd name="connsiteY13" fmla="*/ 143282 h 410775"/>
                <a:gd name="connsiteX14" fmla="*/ 2894 w 301394"/>
                <a:gd name="connsiteY14" fmla="*/ 35332 h 410775"/>
                <a:gd name="connsiteX15" fmla="*/ 129894 w 301394"/>
                <a:gd name="connsiteY15" fmla="*/ 3582 h 410775"/>
                <a:gd name="connsiteX16" fmla="*/ 212444 w 301394"/>
                <a:gd name="connsiteY16" fmla="*/ 3582 h 410775"/>
                <a:gd name="connsiteX17" fmla="*/ 301344 w 301394"/>
                <a:gd name="connsiteY17" fmla="*/ 48032 h 410775"/>
                <a:gd name="connsiteX0" fmla="*/ 301225 w 301277"/>
                <a:gd name="connsiteY0" fmla="*/ 64670 h 427413"/>
                <a:gd name="connsiteX1" fmla="*/ 199625 w 301277"/>
                <a:gd name="connsiteY1" fmla="*/ 45620 h 427413"/>
                <a:gd name="connsiteX2" fmla="*/ 98025 w 301277"/>
                <a:gd name="connsiteY2" fmla="*/ 45620 h 427413"/>
                <a:gd name="connsiteX3" fmla="*/ 98025 w 301277"/>
                <a:gd name="connsiteY3" fmla="*/ 90070 h 427413"/>
                <a:gd name="connsiteX4" fmla="*/ 98025 w 301277"/>
                <a:gd name="connsiteY4" fmla="*/ 178970 h 427413"/>
                <a:gd name="connsiteX5" fmla="*/ 78975 w 301277"/>
                <a:gd name="connsiteY5" fmla="*/ 217070 h 427413"/>
                <a:gd name="connsiteX6" fmla="*/ 91675 w 301277"/>
                <a:gd name="connsiteY6" fmla="*/ 286920 h 427413"/>
                <a:gd name="connsiteX7" fmla="*/ 155175 w 301277"/>
                <a:gd name="connsiteY7" fmla="*/ 305970 h 427413"/>
                <a:gd name="connsiteX8" fmla="*/ 212325 w 301277"/>
                <a:gd name="connsiteY8" fmla="*/ 363120 h 427413"/>
                <a:gd name="connsiteX9" fmla="*/ 237725 w 301277"/>
                <a:gd name="connsiteY9" fmla="*/ 420270 h 427413"/>
                <a:gd name="connsiteX10" fmla="*/ 161525 w 301277"/>
                <a:gd name="connsiteY10" fmla="*/ 420270 h 427413"/>
                <a:gd name="connsiteX11" fmla="*/ 40875 w 301277"/>
                <a:gd name="connsiteY11" fmla="*/ 363120 h 427413"/>
                <a:gd name="connsiteX12" fmla="*/ 40875 w 301277"/>
                <a:gd name="connsiteY12" fmla="*/ 293270 h 427413"/>
                <a:gd name="connsiteX13" fmla="*/ 40875 w 301277"/>
                <a:gd name="connsiteY13" fmla="*/ 159920 h 427413"/>
                <a:gd name="connsiteX14" fmla="*/ 2775 w 301277"/>
                <a:gd name="connsiteY14" fmla="*/ 51970 h 427413"/>
                <a:gd name="connsiteX15" fmla="*/ 127394 w 301277"/>
                <a:gd name="connsiteY15" fmla="*/ 1170 h 427413"/>
                <a:gd name="connsiteX16" fmla="*/ 212325 w 301277"/>
                <a:gd name="connsiteY16" fmla="*/ 20220 h 427413"/>
                <a:gd name="connsiteX17" fmla="*/ 301225 w 301277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98025 w 301571"/>
                <a:gd name="connsiteY2" fmla="*/ 45620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126600 w 301571"/>
                <a:gd name="connsiteY2" fmla="*/ 59907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150413 w 301571"/>
                <a:gd name="connsiteY2" fmla="*/ 74195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98025 w 301392"/>
                <a:gd name="connsiteY3" fmla="*/ 90070 h 427413"/>
                <a:gd name="connsiteX4" fmla="*/ 98025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121838 w 301392"/>
                <a:gd name="connsiteY3" fmla="*/ 106739 h 427413"/>
                <a:gd name="connsiteX4" fmla="*/ 98025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121838 w 301392"/>
                <a:gd name="connsiteY3" fmla="*/ 106739 h 427413"/>
                <a:gd name="connsiteX4" fmla="*/ 102787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866"/>
                <a:gd name="connsiteX1" fmla="*/ 209150 w 301392"/>
                <a:gd name="connsiteY1" fmla="*/ 69432 h 427866"/>
                <a:gd name="connsiteX2" fmla="*/ 150413 w 301392"/>
                <a:gd name="connsiteY2" fmla="*/ 74195 h 427866"/>
                <a:gd name="connsiteX3" fmla="*/ 121838 w 301392"/>
                <a:gd name="connsiteY3" fmla="*/ 106739 h 427866"/>
                <a:gd name="connsiteX4" fmla="*/ 102787 w 301392"/>
                <a:gd name="connsiteY4" fmla="*/ 178970 h 427866"/>
                <a:gd name="connsiteX5" fmla="*/ 78975 w 301392"/>
                <a:gd name="connsiteY5" fmla="*/ 217070 h 427866"/>
                <a:gd name="connsiteX6" fmla="*/ 91675 w 301392"/>
                <a:gd name="connsiteY6" fmla="*/ 286920 h 427866"/>
                <a:gd name="connsiteX7" fmla="*/ 155175 w 301392"/>
                <a:gd name="connsiteY7" fmla="*/ 305970 h 427866"/>
                <a:gd name="connsiteX8" fmla="*/ 212325 w 301392"/>
                <a:gd name="connsiteY8" fmla="*/ 363120 h 427866"/>
                <a:gd name="connsiteX9" fmla="*/ 237725 w 301392"/>
                <a:gd name="connsiteY9" fmla="*/ 420270 h 427866"/>
                <a:gd name="connsiteX10" fmla="*/ 161525 w 301392"/>
                <a:gd name="connsiteY10" fmla="*/ 420270 h 427866"/>
                <a:gd name="connsiteX11" fmla="*/ 55163 w 301392"/>
                <a:gd name="connsiteY11" fmla="*/ 355976 h 427866"/>
                <a:gd name="connsiteX12" fmla="*/ 40875 w 301392"/>
                <a:gd name="connsiteY12" fmla="*/ 293270 h 427866"/>
                <a:gd name="connsiteX13" fmla="*/ 40875 w 301392"/>
                <a:gd name="connsiteY13" fmla="*/ 159920 h 427866"/>
                <a:gd name="connsiteX14" fmla="*/ 2775 w 301392"/>
                <a:gd name="connsiteY14" fmla="*/ 51970 h 427866"/>
                <a:gd name="connsiteX15" fmla="*/ 127394 w 301392"/>
                <a:gd name="connsiteY15" fmla="*/ 1170 h 427866"/>
                <a:gd name="connsiteX16" fmla="*/ 228994 w 301392"/>
                <a:gd name="connsiteY16" fmla="*/ 20220 h 427866"/>
                <a:gd name="connsiteX17" fmla="*/ 301225 w 301392"/>
                <a:gd name="connsiteY17" fmla="*/ 64670 h 427866"/>
                <a:gd name="connsiteX0" fmla="*/ 301225 w 301392"/>
                <a:gd name="connsiteY0" fmla="*/ 64670 h 427866"/>
                <a:gd name="connsiteX1" fmla="*/ 209150 w 301392"/>
                <a:gd name="connsiteY1" fmla="*/ 69432 h 427866"/>
                <a:gd name="connsiteX2" fmla="*/ 124219 w 301392"/>
                <a:gd name="connsiteY2" fmla="*/ 52764 h 427866"/>
                <a:gd name="connsiteX3" fmla="*/ 121838 w 301392"/>
                <a:gd name="connsiteY3" fmla="*/ 106739 h 427866"/>
                <a:gd name="connsiteX4" fmla="*/ 102787 w 301392"/>
                <a:gd name="connsiteY4" fmla="*/ 178970 h 427866"/>
                <a:gd name="connsiteX5" fmla="*/ 78975 w 301392"/>
                <a:gd name="connsiteY5" fmla="*/ 217070 h 427866"/>
                <a:gd name="connsiteX6" fmla="*/ 91675 w 301392"/>
                <a:gd name="connsiteY6" fmla="*/ 286920 h 427866"/>
                <a:gd name="connsiteX7" fmla="*/ 155175 w 301392"/>
                <a:gd name="connsiteY7" fmla="*/ 305970 h 427866"/>
                <a:gd name="connsiteX8" fmla="*/ 212325 w 301392"/>
                <a:gd name="connsiteY8" fmla="*/ 363120 h 427866"/>
                <a:gd name="connsiteX9" fmla="*/ 237725 w 301392"/>
                <a:gd name="connsiteY9" fmla="*/ 420270 h 427866"/>
                <a:gd name="connsiteX10" fmla="*/ 161525 w 301392"/>
                <a:gd name="connsiteY10" fmla="*/ 420270 h 427866"/>
                <a:gd name="connsiteX11" fmla="*/ 55163 w 301392"/>
                <a:gd name="connsiteY11" fmla="*/ 355976 h 427866"/>
                <a:gd name="connsiteX12" fmla="*/ 40875 w 301392"/>
                <a:gd name="connsiteY12" fmla="*/ 293270 h 427866"/>
                <a:gd name="connsiteX13" fmla="*/ 40875 w 301392"/>
                <a:gd name="connsiteY13" fmla="*/ 159920 h 427866"/>
                <a:gd name="connsiteX14" fmla="*/ 2775 w 301392"/>
                <a:gd name="connsiteY14" fmla="*/ 51970 h 427866"/>
                <a:gd name="connsiteX15" fmla="*/ 127394 w 301392"/>
                <a:gd name="connsiteY15" fmla="*/ 1170 h 427866"/>
                <a:gd name="connsiteX16" fmla="*/ 228994 w 301392"/>
                <a:gd name="connsiteY16" fmla="*/ 20220 h 427866"/>
                <a:gd name="connsiteX17" fmla="*/ 301225 w 301392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121838 w 301356"/>
                <a:gd name="connsiteY3" fmla="*/ 106739 h 427866"/>
                <a:gd name="connsiteX4" fmla="*/ 102787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83738 w 301356"/>
                <a:gd name="connsiteY3" fmla="*/ 101976 h 427866"/>
                <a:gd name="connsiteX4" fmla="*/ 102787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83738 w 301356"/>
                <a:gd name="connsiteY3" fmla="*/ 101976 h 427866"/>
                <a:gd name="connsiteX4" fmla="*/ 78975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301356" h="427866">
                  <a:moveTo>
                    <a:pt x="301225" y="64670"/>
                  </a:moveTo>
                  <a:cubicBezTo>
                    <a:pt x="298315" y="70491"/>
                    <a:pt x="241032" y="57129"/>
                    <a:pt x="211531" y="55145"/>
                  </a:cubicBezTo>
                  <a:cubicBezTo>
                    <a:pt x="182030" y="53161"/>
                    <a:pt x="145518" y="44959"/>
                    <a:pt x="124219" y="52764"/>
                  </a:cubicBezTo>
                  <a:cubicBezTo>
                    <a:pt x="102920" y="60569"/>
                    <a:pt x="91279" y="80942"/>
                    <a:pt x="83738" y="101976"/>
                  </a:cubicBezTo>
                  <a:cubicBezTo>
                    <a:pt x="76197" y="123010"/>
                    <a:pt x="79769" y="159788"/>
                    <a:pt x="78975" y="178970"/>
                  </a:cubicBezTo>
                  <a:cubicBezTo>
                    <a:pt x="78181" y="198152"/>
                    <a:pt x="76858" y="199078"/>
                    <a:pt x="78975" y="217070"/>
                  </a:cubicBezTo>
                  <a:cubicBezTo>
                    <a:pt x="81092" y="235062"/>
                    <a:pt x="78975" y="272103"/>
                    <a:pt x="91675" y="286920"/>
                  </a:cubicBezTo>
                  <a:cubicBezTo>
                    <a:pt x="104375" y="301737"/>
                    <a:pt x="135067" y="293270"/>
                    <a:pt x="155175" y="305970"/>
                  </a:cubicBezTo>
                  <a:cubicBezTo>
                    <a:pt x="175283" y="318670"/>
                    <a:pt x="198567" y="344070"/>
                    <a:pt x="212325" y="363120"/>
                  </a:cubicBezTo>
                  <a:cubicBezTo>
                    <a:pt x="226083" y="382170"/>
                    <a:pt x="246192" y="410745"/>
                    <a:pt x="237725" y="420270"/>
                  </a:cubicBezTo>
                  <a:cubicBezTo>
                    <a:pt x="229258" y="429795"/>
                    <a:pt x="191952" y="430986"/>
                    <a:pt x="161525" y="420270"/>
                  </a:cubicBezTo>
                  <a:cubicBezTo>
                    <a:pt x="131098" y="409554"/>
                    <a:pt x="75271" y="377143"/>
                    <a:pt x="55163" y="355976"/>
                  </a:cubicBezTo>
                  <a:cubicBezTo>
                    <a:pt x="35055" y="334809"/>
                    <a:pt x="43256" y="325946"/>
                    <a:pt x="40875" y="293270"/>
                  </a:cubicBezTo>
                  <a:cubicBezTo>
                    <a:pt x="38494" y="260594"/>
                    <a:pt x="47225" y="200137"/>
                    <a:pt x="40875" y="159920"/>
                  </a:cubicBezTo>
                  <a:cubicBezTo>
                    <a:pt x="34525" y="119703"/>
                    <a:pt x="-11645" y="78428"/>
                    <a:pt x="2775" y="51970"/>
                  </a:cubicBezTo>
                  <a:cubicBezTo>
                    <a:pt x="17195" y="25512"/>
                    <a:pt x="92469" y="6462"/>
                    <a:pt x="127394" y="1170"/>
                  </a:cubicBezTo>
                  <a:cubicBezTo>
                    <a:pt x="162319" y="-4122"/>
                    <a:pt x="200022" y="9637"/>
                    <a:pt x="228994" y="20220"/>
                  </a:cubicBezTo>
                  <a:cubicBezTo>
                    <a:pt x="257966" y="30803"/>
                    <a:pt x="304136" y="58849"/>
                    <a:pt x="301225" y="64670"/>
                  </a:cubicBezTo>
                  <a:close/>
                </a:path>
              </a:pathLst>
            </a:custGeom>
            <a:solidFill>
              <a:schemeClr val="accent3"/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6" name="任意多边形: 形状 435">
              <a:extLst>
                <a:ext uri="{FF2B5EF4-FFF2-40B4-BE49-F238E27FC236}">
                  <a16:creationId xmlns:a16="http://schemas.microsoft.com/office/drawing/2014/main" id="{2457B09B-7CA7-4AAE-8ECF-BB197B6C09F9}"/>
                </a:ext>
              </a:extLst>
            </p:cNvPr>
            <p:cNvSpPr/>
            <p:nvPr/>
          </p:nvSpPr>
          <p:spPr>
            <a:xfrm flipH="1">
              <a:off x="7390258" y="2117031"/>
              <a:ext cx="289684" cy="578220"/>
            </a:xfrm>
            <a:custGeom>
              <a:avLst/>
              <a:gdLst>
                <a:gd name="connsiteX0" fmla="*/ 791928 w 1549729"/>
                <a:gd name="connsiteY0" fmla="*/ 3093321 h 3093321"/>
                <a:gd name="connsiteX1" fmla="*/ 1165554 w 1549729"/>
                <a:gd name="connsiteY1" fmla="*/ 2532882 h 3093321"/>
                <a:gd name="connsiteX2" fmla="*/ 1401528 w 1549729"/>
                <a:gd name="connsiteY2" fmla="*/ 1942947 h 3093321"/>
                <a:gd name="connsiteX3" fmla="*/ 1549012 w 1549729"/>
                <a:gd name="connsiteY3" fmla="*/ 1166199 h 3093321"/>
                <a:gd name="connsiteX4" fmla="*/ 1342535 w 1549729"/>
                <a:gd name="connsiteY4" fmla="*/ 586095 h 3093321"/>
                <a:gd name="connsiteX5" fmla="*/ 1027902 w 1549729"/>
                <a:gd name="connsiteY5" fmla="*/ 94482 h 3093321"/>
                <a:gd name="connsiteX6" fmla="*/ 408470 w 1549729"/>
                <a:gd name="connsiteY6" fmla="*/ 5992 h 3093321"/>
                <a:gd name="connsiteX7" fmla="*/ 15180 w 1549729"/>
                <a:gd name="connsiteY7" fmla="*/ 182973 h 3093321"/>
                <a:gd name="connsiteX8" fmla="*/ 84006 w 1549729"/>
                <a:gd name="connsiteY8" fmla="*/ 586095 h 3093321"/>
                <a:gd name="connsiteX9" fmla="*/ 113502 w 1549729"/>
                <a:gd name="connsiteY9" fmla="*/ 979386 h 3093321"/>
                <a:gd name="connsiteX10" fmla="*/ 201993 w 1549729"/>
                <a:gd name="connsiteY10" fmla="*/ 1441502 h 3093321"/>
                <a:gd name="connsiteX11" fmla="*/ 536289 w 1549729"/>
                <a:gd name="connsiteY11" fmla="*/ 1647979 h 3093321"/>
                <a:gd name="connsiteX12" fmla="*/ 870586 w 1549729"/>
                <a:gd name="connsiteY12" fmla="*/ 1657811 h 3093321"/>
                <a:gd name="connsiteX13" fmla="*/ 949244 w 1549729"/>
                <a:gd name="connsiteY13" fmla="*/ 1647979 h 30933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1549729" h="3093321">
                  <a:moveTo>
                    <a:pt x="791928" y="3093321"/>
                  </a:moveTo>
                  <a:cubicBezTo>
                    <a:pt x="927941" y="2908966"/>
                    <a:pt x="1063954" y="2724611"/>
                    <a:pt x="1165554" y="2532882"/>
                  </a:cubicBezTo>
                  <a:cubicBezTo>
                    <a:pt x="1267154" y="2341153"/>
                    <a:pt x="1337618" y="2170727"/>
                    <a:pt x="1401528" y="1942947"/>
                  </a:cubicBezTo>
                  <a:cubicBezTo>
                    <a:pt x="1465438" y="1715166"/>
                    <a:pt x="1558844" y="1392341"/>
                    <a:pt x="1549012" y="1166199"/>
                  </a:cubicBezTo>
                  <a:cubicBezTo>
                    <a:pt x="1539180" y="940057"/>
                    <a:pt x="1429387" y="764714"/>
                    <a:pt x="1342535" y="586095"/>
                  </a:cubicBezTo>
                  <a:cubicBezTo>
                    <a:pt x="1255683" y="407476"/>
                    <a:pt x="1183580" y="191166"/>
                    <a:pt x="1027902" y="94482"/>
                  </a:cubicBezTo>
                  <a:cubicBezTo>
                    <a:pt x="872225" y="-2202"/>
                    <a:pt x="577257" y="-8756"/>
                    <a:pt x="408470" y="5992"/>
                  </a:cubicBezTo>
                  <a:cubicBezTo>
                    <a:pt x="239683" y="20740"/>
                    <a:pt x="69257" y="86289"/>
                    <a:pt x="15180" y="182973"/>
                  </a:cubicBezTo>
                  <a:cubicBezTo>
                    <a:pt x="-38897" y="279657"/>
                    <a:pt x="67619" y="453360"/>
                    <a:pt x="84006" y="586095"/>
                  </a:cubicBezTo>
                  <a:cubicBezTo>
                    <a:pt x="100393" y="718830"/>
                    <a:pt x="93837" y="836818"/>
                    <a:pt x="113502" y="979386"/>
                  </a:cubicBezTo>
                  <a:cubicBezTo>
                    <a:pt x="133166" y="1121954"/>
                    <a:pt x="131529" y="1330070"/>
                    <a:pt x="201993" y="1441502"/>
                  </a:cubicBezTo>
                  <a:cubicBezTo>
                    <a:pt x="272457" y="1552934"/>
                    <a:pt x="424857" y="1611928"/>
                    <a:pt x="536289" y="1647979"/>
                  </a:cubicBezTo>
                  <a:cubicBezTo>
                    <a:pt x="647721" y="1684030"/>
                    <a:pt x="801760" y="1657811"/>
                    <a:pt x="870586" y="1657811"/>
                  </a:cubicBezTo>
                  <a:cubicBezTo>
                    <a:pt x="939412" y="1657811"/>
                    <a:pt x="944328" y="1652895"/>
                    <a:pt x="949244" y="164797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7" name="任意多边形: 形状 436">
              <a:extLst>
                <a:ext uri="{FF2B5EF4-FFF2-40B4-BE49-F238E27FC236}">
                  <a16:creationId xmlns:a16="http://schemas.microsoft.com/office/drawing/2014/main" id="{25702138-00D2-4F1A-AC76-8668FBB3B7E9}"/>
                </a:ext>
              </a:extLst>
            </p:cNvPr>
            <p:cNvSpPr/>
            <p:nvPr/>
          </p:nvSpPr>
          <p:spPr>
            <a:xfrm flipH="1">
              <a:off x="7492813" y="2285041"/>
              <a:ext cx="147110" cy="276505"/>
            </a:xfrm>
            <a:custGeom>
              <a:avLst/>
              <a:gdLst>
                <a:gd name="connsiteX0" fmla="*/ 0 w 786995"/>
                <a:gd name="connsiteY0" fmla="*/ 0 h 1479227"/>
                <a:gd name="connsiteX1" fmla="*/ 98322 w 786995"/>
                <a:gd name="connsiteY1" fmla="*/ 226142 h 1479227"/>
                <a:gd name="connsiteX2" fmla="*/ 373626 w 786995"/>
                <a:gd name="connsiteY2" fmla="*/ 373626 h 1479227"/>
                <a:gd name="connsiteX3" fmla="*/ 629264 w 786995"/>
                <a:gd name="connsiteY3" fmla="*/ 570271 h 1479227"/>
                <a:gd name="connsiteX4" fmla="*/ 747251 w 786995"/>
                <a:gd name="connsiteY4" fmla="*/ 884903 h 1479227"/>
                <a:gd name="connsiteX5" fmla="*/ 786580 w 786995"/>
                <a:gd name="connsiteY5" fmla="*/ 1179871 h 1479227"/>
                <a:gd name="connsiteX6" fmla="*/ 727587 w 786995"/>
                <a:gd name="connsiteY6" fmla="*/ 1376516 h 1479227"/>
                <a:gd name="connsiteX7" fmla="*/ 678426 w 786995"/>
                <a:gd name="connsiteY7" fmla="*/ 1474839 h 14792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786995" h="1479227">
                  <a:moveTo>
                    <a:pt x="0" y="0"/>
                  </a:moveTo>
                  <a:cubicBezTo>
                    <a:pt x="18025" y="81935"/>
                    <a:pt x="36051" y="163871"/>
                    <a:pt x="98322" y="226142"/>
                  </a:cubicBezTo>
                  <a:cubicBezTo>
                    <a:pt x="160593" y="288413"/>
                    <a:pt x="285136" y="316271"/>
                    <a:pt x="373626" y="373626"/>
                  </a:cubicBezTo>
                  <a:cubicBezTo>
                    <a:pt x="462116" y="430981"/>
                    <a:pt x="566993" y="485058"/>
                    <a:pt x="629264" y="570271"/>
                  </a:cubicBezTo>
                  <a:cubicBezTo>
                    <a:pt x="691535" y="655484"/>
                    <a:pt x="721032" y="783303"/>
                    <a:pt x="747251" y="884903"/>
                  </a:cubicBezTo>
                  <a:cubicBezTo>
                    <a:pt x="773470" y="986503"/>
                    <a:pt x="789857" y="1097936"/>
                    <a:pt x="786580" y="1179871"/>
                  </a:cubicBezTo>
                  <a:cubicBezTo>
                    <a:pt x="783303" y="1261806"/>
                    <a:pt x="745613" y="1327355"/>
                    <a:pt x="727587" y="1376516"/>
                  </a:cubicBezTo>
                  <a:cubicBezTo>
                    <a:pt x="709561" y="1425677"/>
                    <a:pt x="683342" y="1497781"/>
                    <a:pt x="678426" y="147483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46" name="组合 445">
            <a:extLst>
              <a:ext uri="{FF2B5EF4-FFF2-40B4-BE49-F238E27FC236}">
                <a16:creationId xmlns:a16="http://schemas.microsoft.com/office/drawing/2014/main" id="{B5CB3331-3C26-4F02-88E9-B6588AF99162}"/>
              </a:ext>
            </a:extLst>
          </p:cNvPr>
          <p:cNvGrpSpPr/>
          <p:nvPr/>
        </p:nvGrpSpPr>
        <p:grpSpPr>
          <a:xfrm flipH="1">
            <a:off x="10078716" y="7175855"/>
            <a:ext cx="540727" cy="535687"/>
            <a:chOff x="6035483" y="2426275"/>
            <a:chExt cx="923001" cy="914400"/>
          </a:xfrm>
        </p:grpSpPr>
        <p:sp>
          <p:nvSpPr>
            <p:cNvPr id="447" name="弧形 446">
              <a:extLst>
                <a:ext uri="{FF2B5EF4-FFF2-40B4-BE49-F238E27FC236}">
                  <a16:creationId xmlns:a16="http://schemas.microsoft.com/office/drawing/2014/main" id="{834D179F-3672-4772-A503-9BFB17A4D8A1}"/>
                </a:ext>
              </a:extLst>
            </p:cNvPr>
            <p:cNvSpPr/>
            <p:nvPr/>
          </p:nvSpPr>
          <p:spPr>
            <a:xfrm rot="2563549">
              <a:off x="6044084" y="2426275"/>
              <a:ext cx="914400" cy="914400"/>
            </a:xfrm>
            <a:prstGeom prst="arc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2" name="弧形 451">
              <a:extLst>
                <a:ext uri="{FF2B5EF4-FFF2-40B4-BE49-F238E27FC236}">
                  <a16:creationId xmlns:a16="http://schemas.microsoft.com/office/drawing/2014/main" id="{673F80BE-8655-409E-BF55-DC3777FA02FB}"/>
                </a:ext>
              </a:extLst>
            </p:cNvPr>
            <p:cNvSpPr/>
            <p:nvPr/>
          </p:nvSpPr>
          <p:spPr>
            <a:xfrm rot="2563549">
              <a:off x="6035483" y="2530211"/>
              <a:ext cx="724355" cy="724355"/>
            </a:xfrm>
            <a:prstGeom prst="arc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3" name="弧形 452">
              <a:extLst>
                <a:ext uri="{FF2B5EF4-FFF2-40B4-BE49-F238E27FC236}">
                  <a16:creationId xmlns:a16="http://schemas.microsoft.com/office/drawing/2014/main" id="{D3818247-AF56-404E-9C12-EFA3206379B6}"/>
                </a:ext>
              </a:extLst>
            </p:cNvPr>
            <p:cNvSpPr/>
            <p:nvPr/>
          </p:nvSpPr>
          <p:spPr>
            <a:xfrm rot="2563549">
              <a:off x="6076435" y="2651188"/>
              <a:ext cx="482399" cy="482399"/>
            </a:xfrm>
            <a:prstGeom prst="arc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54" name="组合 453">
            <a:extLst>
              <a:ext uri="{FF2B5EF4-FFF2-40B4-BE49-F238E27FC236}">
                <a16:creationId xmlns:a16="http://schemas.microsoft.com/office/drawing/2014/main" id="{956338E0-7829-4740-B78E-91FDBD099E74}"/>
              </a:ext>
            </a:extLst>
          </p:cNvPr>
          <p:cNvGrpSpPr/>
          <p:nvPr/>
        </p:nvGrpSpPr>
        <p:grpSpPr>
          <a:xfrm>
            <a:off x="5967669" y="7174217"/>
            <a:ext cx="540727" cy="535687"/>
            <a:chOff x="6035483" y="2426275"/>
            <a:chExt cx="923001" cy="914400"/>
          </a:xfrm>
        </p:grpSpPr>
        <p:sp>
          <p:nvSpPr>
            <p:cNvPr id="455" name="弧形 454">
              <a:extLst>
                <a:ext uri="{FF2B5EF4-FFF2-40B4-BE49-F238E27FC236}">
                  <a16:creationId xmlns:a16="http://schemas.microsoft.com/office/drawing/2014/main" id="{26D0AF11-210F-4888-9CC8-12A1F266E995}"/>
                </a:ext>
              </a:extLst>
            </p:cNvPr>
            <p:cNvSpPr/>
            <p:nvPr/>
          </p:nvSpPr>
          <p:spPr>
            <a:xfrm rot="2563549">
              <a:off x="6044084" y="2426275"/>
              <a:ext cx="914400" cy="914400"/>
            </a:xfrm>
            <a:prstGeom prst="arc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6" name="弧形 455">
              <a:extLst>
                <a:ext uri="{FF2B5EF4-FFF2-40B4-BE49-F238E27FC236}">
                  <a16:creationId xmlns:a16="http://schemas.microsoft.com/office/drawing/2014/main" id="{02004774-DA4C-44D7-A787-E2E07570A220}"/>
                </a:ext>
              </a:extLst>
            </p:cNvPr>
            <p:cNvSpPr/>
            <p:nvPr/>
          </p:nvSpPr>
          <p:spPr>
            <a:xfrm rot="2563549">
              <a:off x="6035483" y="2530211"/>
              <a:ext cx="724355" cy="724355"/>
            </a:xfrm>
            <a:prstGeom prst="arc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7" name="弧形 456">
              <a:extLst>
                <a:ext uri="{FF2B5EF4-FFF2-40B4-BE49-F238E27FC236}">
                  <a16:creationId xmlns:a16="http://schemas.microsoft.com/office/drawing/2014/main" id="{B4E74270-DF61-4F17-95CC-32D246B13E22}"/>
                </a:ext>
              </a:extLst>
            </p:cNvPr>
            <p:cNvSpPr/>
            <p:nvPr/>
          </p:nvSpPr>
          <p:spPr>
            <a:xfrm rot="2563549">
              <a:off x="6076435" y="2651188"/>
              <a:ext cx="482399" cy="482399"/>
            </a:xfrm>
            <a:prstGeom prst="arc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59" name="组合 458">
            <a:extLst>
              <a:ext uri="{FF2B5EF4-FFF2-40B4-BE49-F238E27FC236}">
                <a16:creationId xmlns:a16="http://schemas.microsoft.com/office/drawing/2014/main" id="{24734A0B-DFD0-4D8B-B535-F006635D3B86}"/>
              </a:ext>
            </a:extLst>
          </p:cNvPr>
          <p:cNvGrpSpPr/>
          <p:nvPr/>
        </p:nvGrpSpPr>
        <p:grpSpPr>
          <a:xfrm flipH="1">
            <a:off x="9306816" y="6855726"/>
            <a:ext cx="651269" cy="1085072"/>
            <a:chOff x="7296674" y="2008519"/>
            <a:chExt cx="529871" cy="882812"/>
          </a:xfrm>
        </p:grpSpPr>
        <p:sp>
          <p:nvSpPr>
            <p:cNvPr id="460" name="任意多边形: 形状 459">
              <a:extLst>
                <a:ext uri="{FF2B5EF4-FFF2-40B4-BE49-F238E27FC236}">
                  <a16:creationId xmlns:a16="http://schemas.microsoft.com/office/drawing/2014/main" id="{CAAED6BD-C8C0-4D39-BBA9-85A398C88116}"/>
                </a:ext>
              </a:extLst>
            </p:cNvPr>
            <p:cNvSpPr/>
            <p:nvPr/>
          </p:nvSpPr>
          <p:spPr>
            <a:xfrm flipH="1">
              <a:off x="7306190" y="2008519"/>
              <a:ext cx="520355" cy="882812"/>
            </a:xfrm>
            <a:custGeom>
              <a:avLst/>
              <a:gdLst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197857 w 2783758"/>
                <a:gd name="connsiteY22" fmla="*/ 1544904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289297 w 2783758"/>
                <a:gd name="connsiteY22" fmla="*/ 1636344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2783758" h="4722803">
                  <a:moveTo>
                    <a:pt x="197857" y="1544904"/>
                  </a:moveTo>
                  <a:cubicBezTo>
                    <a:pt x="212605" y="1330233"/>
                    <a:pt x="240463" y="982826"/>
                    <a:pt x="335508" y="768155"/>
                  </a:cubicBezTo>
                  <a:cubicBezTo>
                    <a:pt x="430553" y="553484"/>
                    <a:pt x="623920" y="379781"/>
                    <a:pt x="768127" y="256878"/>
                  </a:cubicBezTo>
                  <a:cubicBezTo>
                    <a:pt x="912334" y="133975"/>
                    <a:pt x="1036876" y="66788"/>
                    <a:pt x="1200747" y="30736"/>
                  </a:cubicBezTo>
                  <a:cubicBezTo>
                    <a:pt x="1364618" y="-5316"/>
                    <a:pt x="1569456" y="-18425"/>
                    <a:pt x="1751353" y="40568"/>
                  </a:cubicBezTo>
                  <a:cubicBezTo>
                    <a:pt x="1933250" y="99561"/>
                    <a:pt x="2151198" y="224103"/>
                    <a:pt x="2292127" y="384697"/>
                  </a:cubicBezTo>
                  <a:cubicBezTo>
                    <a:pt x="2433056" y="545291"/>
                    <a:pt x="2514992" y="773072"/>
                    <a:pt x="2596927" y="1004130"/>
                  </a:cubicBezTo>
                  <a:cubicBezTo>
                    <a:pt x="2678862" y="1235188"/>
                    <a:pt x="2782101" y="1503936"/>
                    <a:pt x="2783740" y="1771046"/>
                  </a:cubicBezTo>
                  <a:cubicBezTo>
                    <a:pt x="2785379" y="2038156"/>
                    <a:pt x="2678863" y="2380646"/>
                    <a:pt x="2606760" y="2606788"/>
                  </a:cubicBezTo>
                  <a:cubicBezTo>
                    <a:pt x="2534657" y="2832930"/>
                    <a:pt x="2446166" y="2954194"/>
                    <a:pt x="2351121" y="3127897"/>
                  </a:cubicBezTo>
                  <a:cubicBezTo>
                    <a:pt x="2256076" y="3301600"/>
                    <a:pt x="2146282" y="3512994"/>
                    <a:pt x="2036489" y="3649007"/>
                  </a:cubicBezTo>
                  <a:cubicBezTo>
                    <a:pt x="1926696" y="3785020"/>
                    <a:pt x="1816902" y="3840736"/>
                    <a:pt x="1692360" y="3943975"/>
                  </a:cubicBezTo>
                  <a:cubicBezTo>
                    <a:pt x="1567818" y="4047214"/>
                    <a:pt x="1431805" y="4142258"/>
                    <a:pt x="1289237" y="4268439"/>
                  </a:cubicBezTo>
                  <a:cubicBezTo>
                    <a:pt x="1146669" y="4394620"/>
                    <a:pt x="982798" y="4640427"/>
                    <a:pt x="836953" y="4701059"/>
                  </a:cubicBezTo>
                  <a:cubicBezTo>
                    <a:pt x="691108" y="4761691"/>
                    <a:pt x="522321" y="4681394"/>
                    <a:pt x="414166" y="4632233"/>
                  </a:cubicBezTo>
                  <a:cubicBezTo>
                    <a:pt x="306011" y="4583072"/>
                    <a:pt x="230630" y="4517523"/>
                    <a:pt x="188024" y="4406091"/>
                  </a:cubicBezTo>
                  <a:cubicBezTo>
                    <a:pt x="145418" y="4294659"/>
                    <a:pt x="178192" y="4084904"/>
                    <a:pt x="158527" y="3963639"/>
                  </a:cubicBezTo>
                  <a:cubicBezTo>
                    <a:pt x="138862" y="3842374"/>
                    <a:pt x="96256" y="3770272"/>
                    <a:pt x="70037" y="3678504"/>
                  </a:cubicBezTo>
                  <a:cubicBezTo>
                    <a:pt x="43818" y="3586736"/>
                    <a:pt x="-8621" y="3491691"/>
                    <a:pt x="1211" y="3413033"/>
                  </a:cubicBezTo>
                  <a:cubicBezTo>
                    <a:pt x="11043" y="3334375"/>
                    <a:pt x="89702" y="3306516"/>
                    <a:pt x="129031" y="3206555"/>
                  </a:cubicBezTo>
                  <a:cubicBezTo>
                    <a:pt x="168360" y="3106594"/>
                    <a:pt x="217521" y="3004994"/>
                    <a:pt x="237186" y="2813265"/>
                  </a:cubicBezTo>
                </a:path>
              </a:pathLst>
            </a:custGeom>
            <a:solidFill>
              <a:schemeClr val="bg1">
                <a:lumMod val="95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461" name="任意多边形: 形状 460">
              <a:extLst>
                <a:ext uri="{FF2B5EF4-FFF2-40B4-BE49-F238E27FC236}">
                  <a16:creationId xmlns:a16="http://schemas.microsoft.com/office/drawing/2014/main" id="{3CDBBC6D-220D-4303-A97B-B22E798B8D72}"/>
                </a:ext>
              </a:extLst>
            </p:cNvPr>
            <p:cNvSpPr/>
            <p:nvPr/>
          </p:nvSpPr>
          <p:spPr>
            <a:xfrm flipH="1">
              <a:off x="7296674" y="2008519"/>
              <a:ext cx="507263" cy="882812"/>
            </a:xfrm>
            <a:custGeom>
              <a:avLst/>
              <a:gdLst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21" fmla="*/ 247018 w 2783758"/>
                <a:gd name="connsiteY21" fmla="*/ 2056181 h 4722803"/>
                <a:gd name="connsiteX22" fmla="*/ 197857 w 2783758"/>
                <a:gd name="connsiteY22" fmla="*/ 1544904 h 4722803"/>
                <a:gd name="connsiteX0" fmla="*/ 247018 w 2783758"/>
                <a:gd name="connsiteY0" fmla="*/ 2056181 h 4722803"/>
                <a:gd name="connsiteX1" fmla="*/ 197857 w 2783758"/>
                <a:gd name="connsiteY1" fmla="*/ 1544904 h 4722803"/>
                <a:gd name="connsiteX2" fmla="*/ 335508 w 2783758"/>
                <a:gd name="connsiteY2" fmla="*/ 768155 h 4722803"/>
                <a:gd name="connsiteX3" fmla="*/ 768127 w 2783758"/>
                <a:gd name="connsiteY3" fmla="*/ 256878 h 4722803"/>
                <a:gd name="connsiteX4" fmla="*/ 1200747 w 2783758"/>
                <a:gd name="connsiteY4" fmla="*/ 30736 h 4722803"/>
                <a:gd name="connsiteX5" fmla="*/ 1751353 w 2783758"/>
                <a:gd name="connsiteY5" fmla="*/ 40568 h 4722803"/>
                <a:gd name="connsiteX6" fmla="*/ 2292127 w 2783758"/>
                <a:gd name="connsiteY6" fmla="*/ 384697 h 4722803"/>
                <a:gd name="connsiteX7" fmla="*/ 2596927 w 2783758"/>
                <a:gd name="connsiteY7" fmla="*/ 1004130 h 4722803"/>
                <a:gd name="connsiteX8" fmla="*/ 2783740 w 2783758"/>
                <a:gd name="connsiteY8" fmla="*/ 1771046 h 4722803"/>
                <a:gd name="connsiteX9" fmla="*/ 2606760 w 2783758"/>
                <a:gd name="connsiteY9" fmla="*/ 2606788 h 4722803"/>
                <a:gd name="connsiteX10" fmla="*/ 2351121 w 2783758"/>
                <a:gd name="connsiteY10" fmla="*/ 3127897 h 4722803"/>
                <a:gd name="connsiteX11" fmla="*/ 2036489 w 2783758"/>
                <a:gd name="connsiteY11" fmla="*/ 3649007 h 4722803"/>
                <a:gd name="connsiteX12" fmla="*/ 1692360 w 2783758"/>
                <a:gd name="connsiteY12" fmla="*/ 3943975 h 4722803"/>
                <a:gd name="connsiteX13" fmla="*/ 1289237 w 2783758"/>
                <a:gd name="connsiteY13" fmla="*/ 4268439 h 4722803"/>
                <a:gd name="connsiteX14" fmla="*/ 836953 w 2783758"/>
                <a:gd name="connsiteY14" fmla="*/ 4701059 h 4722803"/>
                <a:gd name="connsiteX15" fmla="*/ 414166 w 2783758"/>
                <a:gd name="connsiteY15" fmla="*/ 4632233 h 4722803"/>
                <a:gd name="connsiteX16" fmla="*/ 188024 w 2783758"/>
                <a:gd name="connsiteY16" fmla="*/ 4406091 h 4722803"/>
                <a:gd name="connsiteX17" fmla="*/ 158527 w 2783758"/>
                <a:gd name="connsiteY17" fmla="*/ 3963639 h 4722803"/>
                <a:gd name="connsiteX18" fmla="*/ 70037 w 2783758"/>
                <a:gd name="connsiteY18" fmla="*/ 3678504 h 4722803"/>
                <a:gd name="connsiteX19" fmla="*/ 1211 w 2783758"/>
                <a:gd name="connsiteY19" fmla="*/ 3413033 h 4722803"/>
                <a:gd name="connsiteX20" fmla="*/ 129031 w 2783758"/>
                <a:gd name="connsiteY20" fmla="*/ 3206555 h 4722803"/>
                <a:gd name="connsiteX21" fmla="*/ 237186 w 2783758"/>
                <a:gd name="connsiteY21" fmla="*/ 2813265 h 4722803"/>
                <a:gd name="connsiteX22" fmla="*/ 338458 w 2783758"/>
                <a:gd name="connsiteY22" fmla="*/ 2147621 h 4722803"/>
                <a:gd name="connsiteX0" fmla="*/ 247018 w 2783758"/>
                <a:gd name="connsiteY0" fmla="*/ 2056181 h 4722803"/>
                <a:gd name="connsiteX1" fmla="*/ 197857 w 2783758"/>
                <a:gd name="connsiteY1" fmla="*/ 1544904 h 4722803"/>
                <a:gd name="connsiteX2" fmla="*/ 335508 w 2783758"/>
                <a:gd name="connsiteY2" fmla="*/ 768155 h 4722803"/>
                <a:gd name="connsiteX3" fmla="*/ 768127 w 2783758"/>
                <a:gd name="connsiteY3" fmla="*/ 256878 h 4722803"/>
                <a:gd name="connsiteX4" fmla="*/ 1200747 w 2783758"/>
                <a:gd name="connsiteY4" fmla="*/ 30736 h 4722803"/>
                <a:gd name="connsiteX5" fmla="*/ 1751353 w 2783758"/>
                <a:gd name="connsiteY5" fmla="*/ 40568 h 4722803"/>
                <a:gd name="connsiteX6" fmla="*/ 2292127 w 2783758"/>
                <a:gd name="connsiteY6" fmla="*/ 384697 h 4722803"/>
                <a:gd name="connsiteX7" fmla="*/ 2596927 w 2783758"/>
                <a:gd name="connsiteY7" fmla="*/ 1004130 h 4722803"/>
                <a:gd name="connsiteX8" fmla="*/ 2783740 w 2783758"/>
                <a:gd name="connsiteY8" fmla="*/ 1771046 h 4722803"/>
                <a:gd name="connsiteX9" fmla="*/ 2606760 w 2783758"/>
                <a:gd name="connsiteY9" fmla="*/ 2606788 h 4722803"/>
                <a:gd name="connsiteX10" fmla="*/ 2351121 w 2783758"/>
                <a:gd name="connsiteY10" fmla="*/ 3127897 h 4722803"/>
                <a:gd name="connsiteX11" fmla="*/ 2036489 w 2783758"/>
                <a:gd name="connsiteY11" fmla="*/ 3649007 h 4722803"/>
                <a:gd name="connsiteX12" fmla="*/ 1692360 w 2783758"/>
                <a:gd name="connsiteY12" fmla="*/ 3943975 h 4722803"/>
                <a:gd name="connsiteX13" fmla="*/ 1289237 w 2783758"/>
                <a:gd name="connsiteY13" fmla="*/ 4268439 h 4722803"/>
                <a:gd name="connsiteX14" fmla="*/ 836953 w 2783758"/>
                <a:gd name="connsiteY14" fmla="*/ 4701059 h 4722803"/>
                <a:gd name="connsiteX15" fmla="*/ 414166 w 2783758"/>
                <a:gd name="connsiteY15" fmla="*/ 4632233 h 4722803"/>
                <a:gd name="connsiteX16" fmla="*/ 188024 w 2783758"/>
                <a:gd name="connsiteY16" fmla="*/ 4406091 h 4722803"/>
                <a:gd name="connsiteX17" fmla="*/ 158527 w 2783758"/>
                <a:gd name="connsiteY17" fmla="*/ 3963639 h 4722803"/>
                <a:gd name="connsiteX18" fmla="*/ 70037 w 2783758"/>
                <a:gd name="connsiteY18" fmla="*/ 3678504 h 4722803"/>
                <a:gd name="connsiteX19" fmla="*/ 1211 w 2783758"/>
                <a:gd name="connsiteY19" fmla="*/ 3413033 h 4722803"/>
                <a:gd name="connsiteX20" fmla="*/ 129031 w 2783758"/>
                <a:gd name="connsiteY20" fmla="*/ 3206555 h 4722803"/>
                <a:gd name="connsiteX21" fmla="*/ 237186 w 2783758"/>
                <a:gd name="connsiteY21" fmla="*/ 281326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20" fmla="*/ 237186 w 2783758"/>
                <a:gd name="connsiteY20" fmla="*/ 281326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19" fmla="*/ 129031 w 2783758"/>
                <a:gd name="connsiteY19" fmla="*/ 3206555 h 4722803"/>
                <a:gd name="connsiteX0" fmla="*/ 197857 w 2783758"/>
                <a:gd name="connsiteY0" fmla="*/ 1544904 h 4722803"/>
                <a:gd name="connsiteX1" fmla="*/ 335508 w 2783758"/>
                <a:gd name="connsiteY1" fmla="*/ 768155 h 4722803"/>
                <a:gd name="connsiteX2" fmla="*/ 768127 w 2783758"/>
                <a:gd name="connsiteY2" fmla="*/ 256878 h 4722803"/>
                <a:gd name="connsiteX3" fmla="*/ 1200747 w 2783758"/>
                <a:gd name="connsiteY3" fmla="*/ 30736 h 4722803"/>
                <a:gd name="connsiteX4" fmla="*/ 1751353 w 2783758"/>
                <a:gd name="connsiteY4" fmla="*/ 40568 h 4722803"/>
                <a:gd name="connsiteX5" fmla="*/ 2292127 w 2783758"/>
                <a:gd name="connsiteY5" fmla="*/ 384697 h 4722803"/>
                <a:gd name="connsiteX6" fmla="*/ 2596927 w 2783758"/>
                <a:gd name="connsiteY6" fmla="*/ 1004130 h 4722803"/>
                <a:gd name="connsiteX7" fmla="*/ 2783740 w 2783758"/>
                <a:gd name="connsiteY7" fmla="*/ 1771046 h 4722803"/>
                <a:gd name="connsiteX8" fmla="*/ 2606760 w 2783758"/>
                <a:gd name="connsiteY8" fmla="*/ 2606788 h 4722803"/>
                <a:gd name="connsiteX9" fmla="*/ 2351121 w 2783758"/>
                <a:gd name="connsiteY9" fmla="*/ 3127897 h 4722803"/>
                <a:gd name="connsiteX10" fmla="*/ 2036489 w 2783758"/>
                <a:gd name="connsiteY10" fmla="*/ 3649007 h 4722803"/>
                <a:gd name="connsiteX11" fmla="*/ 1692360 w 2783758"/>
                <a:gd name="connsiteY11" fmla="*/ 3943975 h 4722803"/>
                <a:gd name="connsiteX12" fmla="*/ 1289237 w 2783758"/>
                <a:gd name="connsiteY12" fmla="*/ 4268439 h 4722803"/>
                <a:gd name="connsiteX13" fmla="*/ 836953 w 2783758"/>
                <a:gd name="connsiteY13" fmla="*/ 4701059 h 4722803"/>
                <a:gd name="connsiteX14" fmla="*/ 414166 w 2783758"/>
                <a:gd name="connsiteY14" fmla="*/ 4632233 h 4722803"/>
                <a:gd name="connsiteX15" fmla="*/ 188024 w 2783758"/>
                <a:gd name="connsiteY15" fmla="*/ 4406091 h 4722803"/>
                <a:gd name="connsiteX16" fmla="*/ 158527 w 2783758"/>
                <a:gd name="connsiteY16" fmla="*/ 3963639 h 4722803"/>
                <a:gd name="connsiteX17" fmla="*/ 70037 w 2783758"/>
                <a:gd name="connsiteY17" fmla="*/ 3678504 h 4722803"/>
                <a:gd name="connsiteX18" fmla="*/ 1211 w 2783758"/>
                <a:gd name="connsiteY18" fmla="*/ 3413033 h 4722803"/>
                <a:gd name="connsiteX0" fmla="*/ 127820 w 2713721"/>
                <a:gd name="connsiteY0" fmla="*/ 1544904 h 4722803"/>
                <a:gd name="connsiteX1" fmla="*/ 265471 w 2713721"/>
                <a:gd name="connsiteY1" fmla="*/ 768155 h 4722803"/>
                <a:gd name="connsiteX2" fmla="*/ 698090 w 2713721"/>
                <a:gd name="connsiteY2" fmla="*/ 256878 h 4722803"/>
                <a:gd name="connsiteX3" fmla="*/ 1130710 w 2713721"/>
                <a:gd name="connsiteY3" fmla="*/ 30736 h 4722803"/>
                <a:gd name="connsiteX4" fmla="*/ 1681316 w 2713721"/>
                <a:gd name="connsiteY4" fmla="*/ 40568 h 4722803"/>
                <a:gd name="connsiteX5" fmla="*/ 2222090 w 2713721"/>
                <a:gd name="connsiteY5" fmla="*/ 384697 h 4722803"/>
                <a:gd name="connsiteX6" fmla="*/ 2526890 w 2713721"/>
                <a:gd name="connsiteY6" fmla="*/ 1004130 h 4722803"/>
                <a:gd name="connsiteX7" fmla="*/ 2713703 w 2713721"/>
                <a:gd name="connsiteY7" fmla="*/ 1771046 h 4722803"/>
                <a:gd name="connsiteX8" fmla="*/ 2536723 w 2713721"/>
                <a:gd name="connsiteY8" fmla="*/ 2606788 h 4722803"/>
                <a:gd name="connsiteX9" fmla="*/ 2281084 w 2713721"/>
                <a:gd name="connsiteY9" fmla="*/ 3127897 h 4722803"/>
                <a:gd name="connsiteX10" fmla="*/ 1966452 w 2713721"/>
                <a:gd name="connsiteY10" fmla="*/ 3649007 h 4722803"/>
                <a:gd name="connsiteX11" fmla="*/ 1622323 w 2713721"/>
                <a:gd name="connsiteY11" fmla="*/ 3943975 h 4722803"/>
                <a:gd name="connsiteX12" fmla="*/ 1219200 w 2713721"/>
                <a:gd name="connsiteY12" fmla="*/ 4268439 h 4722803"/>
                <a:gd name="connsiteX13" fmla="*/ 766916 w 2713721"/>
                <a:gd name="connsiteY13" fmla="*/ 4701059 h 4722803"/>
                <a:gd name="connsiteX14" fmla="*/ 344129 w 2713721"/>
                <a:gd name="connsiteY14" fmla="*/ 4632233 h 4722803"/>
                <a:gd name="connsiteX15" fmla="*/ 117987 w 2713721"/>
                <a:gd name="connsiteY15" fmla="*/ 4406091 h 4722803"/>
                <a:gd name="connsiteX16" fmla="*/ 88490 w 2713721"/>
                <a:gd name="connsiteY16" fmla="*/ 3963639 h 4722803"/>
                <a:gd name="connsiteX17" fmla="*/ 0 w 2713721"/>
                <a:gd name="connsiteY17" fmla="*/ 3678504 h 47228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2713721" h="4722803">
                  <a:moveTo>
                    <a:pt x="127820" y="1544904"/>
                  </a:moveTo>
                  <a:cubicBezTo>
                    <a:pt x="142568" y="1330233"/>
                    <a:pt x="170426" y="982826"/>
                    <a:pt x="265471" y="768155"/>
                  </a:cubicBezTo>
                  <a:cubicBezTo>
                    <a:pt x="360516" y="553484"/>
                    <a:pt x="553883" y="379781"/>
                    <a:pt x="698090" y="256878"/>
                  </a:cubicBezTo>
                  <a:cubicBezTo>
                    <a:pt x="842297" y="133975"/>
                    <a:pt x="966839" y="66788"/>
                    <a:pt x="1130710" y="30736"/>
                  </a:cubicBezTo>
                  <a:cubicBezTo>
                    <a:pt x="1294581" y="-5316"/>
                    <a:pt x="1499419" y="-18425"/>
                    <a:pt x="1681316" y="40568"/>
                  </a:cubicBezTo>
                  <a:cubicBezTo>
                    <a:pt x="1863213" y="99561"/>
                    <a:pt x="2081161" y="224103"/>
                    <a:pt x="2222090" y="384697"/>
                  </a:cubicBezTo>
                  <a:cubicBezTo>
                    <a:pt x="2363019" y="545291"/>
                    <a:pt x="2444955" y="773072"/>
                    <a:pt x="2526890" y="1004130"/>
                  </a:cubicBezTo>
                  <a:cubicBezTo>
                    <a:pt x="2608825" y="1235188"/>
                    <a:pt x="2712064" y="1503936"/>
                    <a:pt x="2713703" y="1771046"/>
                  </a:cubicBezTo>
                  <a:cubicBezTo>
                    <a:pt x="2715342" y="2038156"/>
                    <a:pt x="2608826" y="2380646"/>
                    <a:pt x="2536723" y="2606788"/>
                  </a:cubicBezTo>
                  <a:cubicBezTo>
                    <a:pt x="2464620" y="2832930"/>
                    <a:pt x="2376129" y="2954194"/>
                    <a:pt x="2281084" y="3127897"/>
                  </a:cubicBezTo>
                  <a:cubicBezTo>
                    <a:pt x="2186039" y="3301600"/>
                    <a:pt x="2076245" y="3512994"/>
                    <a:pt x="1966452" y="3649007"/>
                  </a:cubicBezTo>
                  <a:cubicBezTo>
                    <a:pt x="1856659" y="3785020"/>
                    <a:pt x="1746865" y="3840736"/>
                    <a:pt x="1622323" y="3943975"/>
                  </a:cubicBezTo>
                  <a:cubicBezTo>
                    <a:pt x="1497781" y="4047214"/>
                    <a:pt x="1361768" y="4142258"/>
                    <a:pt x="1219200" y="4268439"/>
                  </a:cubicBezTo>
                  <a:cubicBezTo>
                    <a:pt x="1076632" y="4394620"/>
                    <a:pt x="912761" y="4640427"/>
                    <a:pt x="766916" y="4701059"/>
                  </a:cubicBezTo>
                  <a:cubicBezTo>
                    <a:pt x="621071" y="4761691"/>
                    <a:pt x="452284" y="4681394"/>
                    <a:pt x="344129" y="4632233"/>
                  </a:cubicBezTo>
                  <a:cubicBezTo>
                    <a:pt x="235974" y="4583072"/>
                    <a:pt x="160593" y="4517523"/>
                    <a:pt x="117987" y="4406091"/>
                  </a:cubicBezTo>
                  <a:cubicBezTo>
                    <a:pt x="75381" y="4294659"/>
                    <a:pt x="108155" y="4084904"/>
                    <a:pt x="88490" y="3963639"/>
                  </a:cubicBezTo>
                  <a:cubicBezTo>
                    <a:pt x="68825" y="3842374"/>
                    <a:pt x="26219" y="3770272"/>
                    <a:pt x="0" y="3678504"/>
                  </a:cubicBezTo>
                </a:path>
              </a:pathLst>
            </a:custGeom>
            <a:solidFill>
              <a:schemeClr val="bg1">
                <a:lumMod val="95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2" name="任意多边形: 形状 461">
              <a:extLst>
                <a:ext uri="{FF2B5EF4-FFF2-40B4-BE49-F238E27FC236}">
                  <a16:creationId xmlns:a16="http://schemas.microsoft.com/office/drawing/2014/main" id="{198CA21C-40F4-4181-943B-8F32FB6EF7A0}"/>
                </a:ext>
              </a:extLst>
            </p:cNvPr>
            <p:cNvSpPr/>
            <p:nvPr/>
          </p:nvSpPr>
          <p:spPr>
            <a:xfrm flipH="1">
              <a:off x="7628004" y="2398200"/>
              <a:ext cx="80868" cy="80868"/>
            </a:xfrm>
            <a:custGeom>
              <a:avLst/>
              <a:gdLst>
                <a:gd name="connsiteX0" fmla="*/ 0 w 1101213"/>
                <a:gd name="connsiteY0" fmla="*/ 0 h 865238"/>
                <a:gd name="connsiteX1" fmla="*/ 98323 w 1101213"/>
                <a:gd name="connsiteY1" fmla="*/ 206477 h 865238"/>
                <a:gd name="connsiteX2" fmla="*/ 265471 w 1101213"/>
                <a:gd name="connsiteY2" fmla="*/ 373625 h 865238"/>
                <a:gd name="connsiteX3" fmla="*/ 432619 w 1101213"/>
                <a:gd name="connsiteY3" fmla="*/ 432619 h 865238"/>
                <a:gd name="connsiteX4" fmla="*/ 786581 w 1101213"/>
                <a:gd name="connsiteY4" fmla="*/ 550606 h 865238"/>
                <a:gd name="connsiteX5" fmla="*/ 1002890 w 1101213"/>
                <a:gd name="connsiteY5" fmla="*/ 639096 h 865238"/>
                <a:gd name="connsiteX6" fmla="*/ 1081548 w 1101213"/>
                <a:gd name="connsiteY6" fmla="*/ 786580 h 865238"/>
                <a:gd name="connsiteX7" fmla="*/ 1101213 w 1101213"/>
                <a:gd name="connsiteY7" fmla="*/ 865238 h 865238"/>
                <a:gd name="connsiteX0" fmla="*/ 0 w 1082429"/>
                <a:gd name="connsiteY0" fmla="*/ 0 h 941438"/>
                <a:gd name="connsiteX1" fmla="*/ 98323 w 1082429"/>
                <a:gd name="connsiteY1" fmla="*/ 206477 h 941438"/>
                <a:gd name="connsiteX2" fmla="*/ 265471 w 1082429"/>
                <a:gd name="connsiteY2" fmla="*/ 373625 h 941438"/>
                <a:gd name="connsiteX3" fmla="*/ 432619 w 1082429"/>
                <a:gd name="connsiteY3" fmla="*/ 432619 h 941438"/>
                <a:gd name="connsiteX4" fmla="*/ 786581 w 1082429"/>
                <a:gd name="connsiteY4" fmla="*/ 550606 h 941438"/>
                <a:gd name="connsiteX5" fmla="*/ 1002890 w 1082429"/>
                <a:gd name="connsiteY5" fmla="*/ 639096 h 941438"/>
                <a:gd name="connsiteX6" fmla="*/ 1081548 w 1082429"/>
                <a:gd name="connsiteY6" fmla="*/ 786580 h 941438"/>
                <a:gd name="connsiteX7" fmla="*/ 1047873 w 1082429"/>
                <a:gd name="connsiteY7" fmla="*/ 941438 h 941438"/>
                <a:gd name="connsiteX0" fmla="*/ 0 w 1081550"/>
                <a:gd name="connsiteY0" fmla="*/ 0 h 786579"/>
                <a:gd name="connsiteX1" fmla="*/ 98323 w 1081550"/>
                <a:gd name="connsiteY1" fmla="*/ 206477 h 786579"/>
                <a:gd name="connsiteX2" fmla="*/ 265471 w 1081550"/>
                <a:gd name="connsiteY2" fmla="*/ 373625 h 786579"/>
                <a:gd name="connsiteX3" fmla="*/ 432619 w 1081550"/>
                <a:gd name="connsiteY3" fmla="*/ 432619 h 786579"/>
                <a:gd name="connsiteX4" fmla="*/ 786581 w 1081550"/>
                <a:gd name="connsiteY4" fmla="*/ 550606 h 786579"/>
                <a:gd name="connsiteX5" fmla="*/ 1002890 w 1081550"/>
                <a:gd name="connsiteY5" fmla="*/ 639096 h 786579"/>
                <a:gd name="connsiteX6" fmla="*/ 1081548 w 1081550"/>
                <a:gd name="connsiteY6" fmla="*/ 786580 h 786579"/>
                <a:gd name="connsiteX0" fmla="*/ 0 w 1002889"/>
                <a:gd name="connsiteY0" fmla="*/ 0 h 639095"/>
                <a:gd name="connsiteX1" fmla="*/ 98323 w 1002889"/>
                <a:gd name="connsiteY1" fmla="*/ 206477 h 639095"/>
                <a:gd name="connsiteX2" fmla="*/ 265471 w 1002889"/>
                <a:gd name="connsiteY2" fmla="*/ 373625 h 639095"/>
                <a:gd name="connsiteX3" fmla="*/ 432619 w 1002889"/>
                <a:gd name="connsiteY3" fmla="*/ 432619 h 639095"/>
                <a:gd name="connsiteX4" fmla="*/ 786581 w 1002889"/>
                <a:gd name="connsiteY4" fmla="*/ 550606 h 639095"/>
                <a:gd name="connsiteX5" fmla="*/ 1002890 w 1002889"/>
                <a:gd name="connsiteY5" fmla="*/ 639096 h 639095"/>
                <a:gd name="connsiteX0" fmla="*/ 0 w 786581"/>
                <a:gd name="connsiteY0" fmla="*/ 0 h 550606"/>
                <a:gd name="connsiteX1" fmla="*/ 98323 w 786581"/>
                <a:gd name="connsiteY1" fmla="*/ 206477 h 550606"/>
                <a:gd name="connsiteX2" fmla="*/ 265471 w 786581"/>
                <a:gd name="connsiteY2" fmla="*/ 373625 h 550606"/>
                <a:gd name="connsiteX3" fmla="*/ 432619 w 786581"/>
                <a:gd name="connsiteY3" fmla="*/ 432619 h 550606"/>
                <a:gd name="connsiteX4" fmla="*/ 786581 w 786581"/>
                <a:gd name="connsiteY4" fmla="*/ 550606 h 550606"/>
                <a:gd name="connsiteX0" fmla="*/ 0 w 432621"/>
                <a:gd name="connsiteY0" fmla="*/ 0 h 432620"/>
                <a:gd name="connsiteX1" fmla="*/ 98323 w 432621"/>
                <a:gd name="connsiteY1" fmla="*/ 206477 h 432620"/>
                <a:gd name="connsiteX2" fmla="*/ 265471 w 432621"/>
                <a:gd name="connsiteY2" fmla="*/ 373625 h 432620"/>
                <a:gd name="connsiteX3" fmla="*/ 432619 w 432621"/>
                <a:gd name="connsiteY3" fmla="*/ 432619 h 4326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2621" h="432620">
                  <a:moveTo>
                    <a:pt x="0" y="0"/>
                  </a:moveTo>
                  <a:cubicBezTo>
                    <a:pt x="27039" y="72103"/>
                    <a:pt x="54078" y="144206"/>
                    <a:pt x="98323" y="206477"/>
                  </a:cubicBezTo>
                  <a:cubicBezTo>
                    <a:pt x="142568" y="268748"/>
                    <a:pt x="209755" y="335935"/>
                    <a:pt x="265471" y="373625"/>
                  </a:cubicBezTo>
                  <a:cubicBezTo>
                    <a:pt x="321187" y="411315"/>
                    <a:pt x="432619" y="432619"/>
                    <a:pt x="432619" y="43261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3" name="任意多边形: 形状 462">
              <a:extLst>
                <a:ext uri="{FF2B5EF4-FFF2-40B4-BE49-F238E27FC236}">
                  <a16:creationId xmlns:a16="http://schemas.microsoft.com/office/drawing/2014/main" id="{D168E84C-6822-45E8-8833-7DC0FC7EC9DA}"/>
                </a:ext>
              </a:extLst>
            </p:cNvPr>
            <p:cNvSpPr/>
            <p:nvPr/>
          </p:nvSpPr>
          <p:spPr>
            <a:xfrm flipH="1">
              <a:off x="7509150" y="2473453"/>
              <a:ext cx="247301" cy="221798"/>
            </a:xfrm>
            <a:custGeom>
              <a:avLst/>
              <a:gdLst>
                <a:gd name="connsiteX0" fmla="*/ 506751 w 1322993"/>
                <a:gd name="connsiteY0" fmla="*/ 1530 h 1186562"/>
                <a:gd name="connsiteX1" fmla="*/ 880376 w 1322993"/>
                <a:gd name="connsiteY1" fmla="*/ 149013 h 1186562"/>
                <a:gd name="connsiteX2" fmla="*/ 1214673 w 1322993"/>
                <a:gd name="connsiteY2" fmla="*/ 267001 h 1186562"/>
                <a:gd name="connsiteX3" fmla="*/ 1322828 w 1322993"/>
                <a:gd name="connsiteY3" fmla="*/ 384988 h 1186562"/>
                <a:gd name="connsiteX4" fmla="*/ 1234338 w 1322993"/>
                <a:gd name="connsiteY4" fmla="*/ 670123 h 1186562"/>
                <a:gd name="connsiteX5" fmla="*/ 1047525 w 1322993"/>
                <a:gd name="connsiteY5" fmla="*/ 738949 h 1186562"/>
                <a:gd name="connsiteX6" fmla="*/ 801718 w 1322993"/>
                <a:gd name="connsiteY6" fmla="*/ 738949 h 1186562"/>
                <a:gd name="connsiteX7" fmla="*/ 644402 w 1322993"/>
                <a:gd name="connsiteY7" fmla="*/ 817607 h 1186562"/>
                <a:gd name="connsiteX8" fmla="*/ 457589 w 1322993"/>
                <a:gd name="connsiteY8" fmla="*/ 955259 h 1186562"/>
                <a:gd name="connsiteX9" fmla="*/ 310105 w 1322993"/>
                <a:gd name="connsiteY9" fmla="*/ 1132239 h 1186562"/>
                <a:gd name="connsiteX10" fmla="*/ 74131 w 1322993"/>
                <a:gd name="connsiteY10" fmla="*/ 1171568 h 1186562"/>
                <a:gd name="connsiteX11" fmla="*/ 5305 w 1322993"/>
                <a:gd name="connsiteY11" fmla="*/ 906097 h 1186562"/>
                <a:gd name="connsiteX12" fmla="*/ 192118 w 1322993"/>
                <a:gd name="connsiteY12" fmla="*/ 689788 h 1186562"/>
                <a:gd name="connsiteX13" fmla="*/ 359267 w 1322993"/>
                <a:gd name="connsiteY13" fmla="*/ 424317 h 1186562"/>
                <a:gd name="connsiteX14" fmla="*/ 369099 w 1322993"/>
                <a:gd name="connsiteY14" fmla="*/ 247336 h 1186562"/>
                <a:gd name="connsiteX15" fmla="*/ 506751 w 1322993"/>
                <a:gd name="connsiteY15" fmla="*/ 1530 h 11865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1322993" h="1186562">
                  <a:moveTo>
                    <a:pt x="506751" y="1530"/>
                  </a:moveTo>
                  <a:cubicBezTo>
                    <a:pt x="591964" y="-14857"/>
                    <a:pt x="762389" y="104768"/>
                    <a:pt x="880376" y="149013"/>
                  </a:cubicBezTo>
                  <a:cubicBezTo>
                    <a:pt x="998363" y="193258"/>
                    <a:pt x="1140931" y="227672"/>
                    <a:pt x="1214673" y="267001"/>
                  </a:cubicBezTo>
                  <a:cubicBezTo>
                    <a:pt x="1288415" y="306330"/>
                    <a:pt x="1319551" y="317801"/>
                    <a:pt x="1322828" y="384988"/>
                  </a:cubicBezTo>
                  <a:cubicBezTo>
                    <a:pt x="1326106" y="452175"/>
                    <a:pt x="1280222" y="611130"/>
                    <a:pt x="1234338" y="670123"/>
                  </a:cubicBezTo>
                  <a:cubicBezTo>
                    <a:pt x="1188454" y="729116"/>
                    <a:pt x="1119628" y="727478"/>
                    <a:pt x="1047525" y="738949"/>
                  </a:cubicBezTo>
                  <a:cubicBezTo>
                    <a:pt x="975422" y="750420"/>
                    <a:pt x="868905" y="725839"/>
                    <a:pt x="801718" y="738949"/>
                  </a:cubicBezTo>
                  <a:cubicBezTo>
                    <a:pt x="734531" y="752059"/>
                    <a:pt x="701757" y="781555"/>
                    <a:pt x="644402" y="817607"/>
                  </a:cubicBezTo>
                  <a:cubicBezTo>
                    <a:pt x="587047" y="853659"/>
                    <a:pt x="513305" y="902820"/>
                    <a:pt x="457589" y="955259"/>
                  </a:cubicBezTo>
                  <a:cubicBezTo>
                    <a:pt x="401873" y="1007698"/>
                    <a:pt x="374015" y="1096188"/>
                    <a:pt x="310105" y="1132239"/>
                  </a:cubicBezTo>
                  <a:cubicBezTo>
                    <a:pt x="246195" y="1168290"/>
                    <a:pt x="124931" y="1209258"/>
                    <a:pt x="74131" y="1171568"/>
                  </a:cubicBezTo>
                  <a:cubicBezTo>
                    <a:pt x="23331" y="1133878"/>
                    <a:pt x="-14360" y="986394"/>
                    <a:pt x="5305" y="906097"/>
                  </a:cubicBezTo>
                  <a:cubicBezTo>
                    <a:pt x="24970" y="825800"/>
                    <a:pt x="133124" y="770085"/>
                    <a:pt x="192118" y="689788"/>
                  </a:cubicBezTo>
                  <a:cubicBezTo>
                    <a:pt x="251112" y="609491"/>
                    <a:pt x="329770" y="498059"/>
                    <a:pt x="359267" y="424317"/>
                  </a:cubicBezTo>
                  <a:cubicBezTo>
                    <a:pt x="388764" y="350575"/>
                    <a:pt x="344518" y="312884"/>
                    <a:pt x="369099" y="247336"/>
                  </a:cubicBezTo>
                  <a:cubicBezTo>
                    <a:pt x="393680" y="181788"/>
                    <a:pt x="421538" y="17917"/>
                    <a:pt x="506751" y="1530"/>
                  </a:cubicBezTo>
                  <a:close/>
                </a:path>
              </a:pathLst>
            </a:custGeom>
            <a:solidFill>
              <a:schemeClr val="accent3"/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4" name="任意多边形: 形状 463">
              <a:extLst>
                <a:ext uri="{FF2B5EF4-FFF2-40B4-BE49-F238E27FC236}">
                  <a16:creationId xmlns:a16="http://schemas.microsoft.com/office/drawing/2014/main" id="{2CC5C847-D021-4193-BB8F-6EEA60A69D9C}"/>
                </a:ext>
              </a:extLst>
            </p:cNvPr>
            <p:cNvSpPr/>
            <p:nvPr/>
          </p:nvSpPr>
          <p:spPr>
            <a:xfrm flipH="1">
              <a:off x="7507799" y="2279320"/>
              <a:ext cx="153472" cy="152913"/>
            </a:xfrm>
            <a:custGeom>
              <a:avLst/>
              <a:gdLst>
                <a:gd name="connsiteX0" fmla="*/ 3396 w 205414"/>
                <a:gd name="connsiteY0" fmla="*/ 257 h 204666"/>
                <a:gd name="connsiteX1" fmla="*/ 22446 w 205414"/>
                <a:gd name="connsiteY1" fmla="*/ 81220 h 204666"/>
                <a:gd name="connsiteX2" fmla="*/ 12921 w 205414"/>
                <a:gd name="connsiteY2" fmla="*/ 138370 h 204666"/>
                <a:gd name="connsiteX3" fmla="*/ 112933 w 205414"/>
                <a:gd name="connsiteY3" fmla="*/ 195520 h 204666"/>
                <a:gd name="connsiteX4" fmla="*/ 198658 w 205414"/>
                <a:gd name="connsiteY4" fmla="*/ 200282 h 204666"/>
                <a:gd name="connsiteX5" fmla="*/ 189133 w 205414"/>
                <a:gd name="connsiteY5" fmla="*/ 152657 h 204666"/>
                <a:gd name="connsiteX6" fmla="*/ 103408 w 205414"/>
                <a:gd name="connsiteY6" fmla="*/ 109795 h 204666"/>
                <a:gd name="connsiteX7" fmla="*/ 3396 w 205414"/>
                <a:gd name="connsiteY7" fmla="*/ 257 h 2046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05414" h="204666">
                  <a:moveTo>
                    <a:pt x="3396" y="257"/>
                  </a:moveTo>
                  <a:cubicBezTo>
                    <a:pt x="-10098" y="-4506"/>
                    <a:pt x="20859" y="58201"/>
                    <a:pt x="22446" y="81220"/>
                  </a:cubicBezTo>
                  <a:cubicBezTo>
                    <a:pt x="24033" y="104239"/>
                    <a:pt x="-2160" y="119320"/>
                    <a:pt x="12921" y="138370"/>
                  </a:cubicBezTo>
                  <a:cubicBezTo>
                    <a:pt x="28002" y="157420"/>
                    <a:pt x="81977" y="185201"/>
                    <a:pt x="112933" y="195520"/>
                  </a:cubicBezTo>
                  <a:cubicBezTo>
                    <a:pt x="143889" y="205839"/>
                    <a:pt x="185958" y="207426"/>
                    <a:pt x="198658" y="200282"/>
                  </a:cubicBezTo>
                  <a:cubicBezTo>
                    <a:pt x="211358" y="193138"/>
                    <a:pt x="205008" y="167738"/>
                    <a:pt x="189133" y="152657"/>
                  </a:cubicBezTo>
                  <a:cubicBezTo>
                    <a:pt x="173258" y="137576"/>
                    <a:pt x="129602" y="131226"/>
                    <a:pt x="103408" y="109795"/>
                  </a:cubicBezTo>
                  <a:cubicBezTo>
                    <a:pt x="77214" y="88364"/>
                    <a:pt x="16890" y="5020"/>
                    <a:pt x="3396" y="257"/>
                  </a:cubicBez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5" name="任意多边形: 形状 464">
              <a:extLst>
                <a:ext uri="{FF2B5EF4-FFF2-40B4-BE49-F238E27FC236}">
                  <a16:creationId xmlns:a16="http://schemas.microsoft.com/office/drawing/2014/main" id="{AC01D985-0E8C-44FC-A8BB-375FB2EFD7FD}"/>
                </a:ext>
              </a:extLst>
            </p:cNvPr>
            <p:cNvSpPr/>
            <p:nvPr/>
          </p:nvSpPr>
          <p:spPr>
            <a:xfrm flipH="1">
              <a:off x="7463813" y="2115552"/>
              <a:ext cx="225154" cy="319674"/>
            </a:xfrm>
            <a:custGeom>
              <a:avLst/>
              <a:gdLst>
                <a:gd name="connsiteX0" fmla="*/ 301344 w 301394"/>
                <a:gd name="connsiteY0" fmla="*/ 48032 h 410775"/>
                <a:gd name="connsiteX1" fmla="*/ 199744 w 301394"/>
                <a:gd name="connsiteY1" fmla="*/ 28982 h 410775"/>
                <a:gd name="connsiteX2" fmla="*/ 98144 w 301394"/>
                <a:gd name="connsiteY2" fmla="*/ 28982 h 410775"/>
                <a:gd name="connsiteX3" fmla="*/ 98144 w 301394"/>
                <a:gd name="connsiteY3" fmla="*/ 73432 h 410775"/>
                <a:gd name="connsiteX4" fmla="*/ 98144 w 301394"/>
                <a:gd name="connsiteY4" fmla="*/ 162332 h 410775"/>
                <a:gd name="connsiteX5" fmla="*/ 79094 w 301394"/>
                <a:gd name="connsiteY5" fmla="*/ 200432 h 410775"/>
                <a:gd name="connsiteX6" fmla="*/ 91794 w 301394"/>
                <a:gd name="connsiteY6" fmla="*/ 270282 h 410775"/>
                <a:gd name="connsiteX7" fmla="*/ 155294 w 301394"/>
                <a:gd name="connsiteY7" fmla="*/ 289332 h 410775"/>
                <a:gd name="connsiteX8" fmla="*/ 212444 w 301394"/>
                <a:gd name="connsiteY8" fmla="*/ 346482 h 410775"/>
                <a:gd name="connsiteX9" fmla="*/ 237844 w 301394"/>
                <a:gd name="connsiteY9" fmla="*/ 403632 h 410775"/>
                <a:gd name="connsiteX10" fmla="*/ 161644 w 301394"/>
                <a:gd name="connsiteY10" fmla="*/ 403632 h 410775"/>
                <a:gd name="connsiteX11" fmla="*/ 40994 w 301394"/>
                <a:gd name="connsiteY11" fmla="*/ 346482 h 410775"/>
                <a:gd name="connsiteX12" fmla="*/ 40994 w 301394"/>
                <a:gd name="connsiteY12" fmla="*/ 276632 h 410775"/>
                <a:gd name="connsiteX13" fmla="*/ 40994 w 301394"/>
                <a:gd name="connsiteY13" fmla="*/ 143282 h 410775"/>
                <a:gd name="connsiteX14" fmla="*/ 2894 w 301394"/>
                <a:gd name="connsiteY14" fmla="*/ 35332 h 410775"/>
                <a:gd name="connsiteX15" fmla="*/ 129894 w 301394"/>
                <a:gd name="connsiteY15" fmla="*/ 3582 h 410775"/>
                <a:gd name="connsiteX16" fmla="*/ 212444 w 301394"/>
                <a:gd name="connsiteY16" fmla="*/ 3582 h 410775"/>
                <a:gd name="connsiteX17" fmla="*/ 301344 w 301394"/>
                <a:gd name="connsiteY17" fmla="*/ 48032 h 410775"/>
                <a:gd name="connsiteX0" fmla="*/ 301225 w 301277"/>
                <a:gd name="connsiteY0" fmla="*/ 64670 h 427413"/>
                <a:gd name="connsiteX1" fmla="*/ 199625 w 301277"/>
                <a:gd name="connsiteY1" fmla="*/ 45620 h 427413"/>
                <a:gd name="connsiteX2" fmla="*/ 98025 w 301277"/>
                <a:gd name="connsiteY2" fmla="*/ 45620 h 427413"/>
                <a:gd name="connsiteX3" fmla="*/ 98025 w 301277"/>
                <a:gd name="connsiteY3" fmla="*/ 90070 h 427413"/>
                <a:gd name="connsiteX4" fmla="*/ 98025 w 301277"/>
                <a:gd name="connsiteY4" fmla="*/ 178970 h 427413"/>
                <a:gd name="connsiteX5" fmla="*/ 78975 w 301277"/>
                <a:gd name="connsiteY5" fmla="*/ 217070 h 427413"/>
                <a:gd name="connsiteX6" fmla="*/ 91675 w 301277"/>
                <a:gd name="connsiteY6" fmla="*/ 286920 h 427413"/>
                <a:gd name="connsiteX7" fmla="*/ 155175 w 301277"/>
                <a:gd name="connsiteY7" fmla="*/ 305970 h 427413"/>
                <a:gd name="connsiteX8" fmla="*/ 212325 w 301277"/>
                <a:gd name="connsiteY8" fmla="*/ 363120 h 427413"/>
                <a:gd name="connsiteX9" fmla="*/ 237725 w 301277"/>
                <a:gd name="connsiteY9" fmla="*/ 420270 h 427413"/>
                <a:gd name="connsiteX10" fmla="*/ 161525 w 301277"/>
                <a:gd name="connsiteY10" fmla="*/ 420270 h 427413"/>
                <a:gd name="connsiteX11" fmla="*/ 40875 w 301277"/>
                <a:gd name="connsiteY11" fmla="*/ 363120 h 427413"/>
                <a:gd name="connsiteX12" fmla="*/ 40875 w 301277"/>
                <a:gd name="connsiteY12" fmla="*/ 293270 h 427413"/>
                <a:gd name="connsiteX13" fmla="*/ 40875 w 301277"/>
                <a:gd name="connsiteY13" fmla="*/ 159920 h 427413"/>
                <a:gd name="connsiteX14" fmla="*/ 2775 w 301277"/>
                <a:gd name="connsiteY14" fmla="*/ 51970 h 427413"/>
                <a:gd name="connsiteX15" fmla="*/ 127394 w 301277"/>
                <a:gd name="connsiteY15" fmla="*/ 1170 h 427413"/>
                <a:gd name="connsiteX16" fmla="*/ 212325 w 301277"/>
                <a:gd name="connsiteY16" fmla="*/ 20220 h 427413"/>
                <a:gd name="connsiteX17" fmla="*/ 301225 w 301277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98025 w 301571"/>
                <a:gd name="connsiteY2" fmla="*/ 45620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126600 w 301571"/>
                <a:gd name="connsiteY2" fmla="*/ 59907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571"/>
                <a:gd name="connsiteY0" fmla="*/ 64670 h 427413"/>
                <a:gd name="connsiteX1" fmla="*/ 199625 w 301571"/>
                <a:gd name="connsiteY1" fmla="*/ 45620 h 427413"/>
                <a:gd name="connsiteX2" fmla="*/ 150413 w 301571"/>
                <a:gd name="connsiteY2" fmla="*/ 74195 h 427413"/>
                <a:gd name="connsiteX3" fmla="*/ 98025 w 301571"/>
                <a:gd name="connsiteY3" fmla="*/ 90070 h 427413"/>
                <a:gd name="connsiteX4" fmla="*/ 98025 w 301571"/>
                <a:gd name="connsiteY4" fmla="*/ 178970 h 427413"/>
                <a:gd name="connsiteX5" fmla="*/ 78975 w 301571"/>
                <a:gd name="connsiteY5" fmla="*/ 217070 h 427413"/>
                <a:gd name="connsiteX6" fmla="*/ 91675 w 301571"/>
                <a:gd name="connsiteY6" fmla="*/ 286920 h 427413"/>
                <a:gd name="connsiteX7" fmla="*/ 155175 w 301571"/>
                <a:gd name="connsiteY7" fmla="*/ 305970 h 427413"/>
                <a:gd name="connsiteX8" fmla="*/ 212325 w 301571"/>
                <a:gd name="connsiteY8" fmla="*/ 363120 h 427413"/>
                <a:gd name="connsiteX9" fmla="*/ 237725 w 301571"/>
                <a:gd name="connsiteY9" fmla="*/ 420270 h 427413"/>
                <a:gd name="connsiteX10" fmla="*/ 161525 w 301571"/>
                <a:gd name="connsiteY10" fmla="*/ 420270 h 427413"/>
                <a:gd name="connsiteX11" fmla="*/ 40875 w 301571"/>
                <a:gd name="connsiteY11" fmla="*/ 363120 h 427413"/>
                <a:gd name="connsiteX12" fmla="*/ 40875 w 301571"/>
                <a:gd name="connsiteY12" fmla="*/ 293270 h 427413"/>
                <a:gd name="connsiteX13" fmla="*/ 40875 w 301571"/>
                <a:gd name="connsiteY13" fmla="*/ 159920 h 427413"/>
                <a:gd name="connsiteX14" fmla="*/ 2775 w 301571"/>
                <a:gd name="connsiteY14" fmla="*/ 51970 h 427413"/>
                <a:gd name="connsiteX15" fmla="*/ 127394 w 301571"/>
                <a:gd name="connsiteY15" fmla="*/ 1170 h 427413"/>
                <a:gd name="connsiteX16" fmla="*/ 228994 w 301571"/>
                <a:gd name="connsiteY16" fmla="*/ 20220 h 427413"/>
                <a:gd name="connsiteX17" fmla="*/ 301225 w 301571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98025 w 301392"/>
                <a:gd name="connsiteY3" fmla="*/ 90070 h 427413"/>
                <a:gd name="connsiteX4" fmla="*/ 98025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121838 w 301392"/>
                <a:gd name="connsiteY3" fmla="*/ 106739 h 427413"/>
                <a:gd name="connsiteX4" fmla="*/ 98025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413"/>
                <a:gd name="connsiteX1" fmla="*/ 209150 w 301392"/>
                <a:gd name="connsiteY1" fmla="*/ 69432 h 427413"/>
                <a:gd name="connsiteX2" fmla="*/ 150413 w 301392"/>
                <a:gd name="connsiteY2" fmla="*/ 74195 h 427413"/>
                <a:gd name="connsiteX3" fmla="*/ 121838 w 301392"/>
                <a:gd name="connsiteY3" fmla="*/ 106739 h 427413"/>
                <a:gd name="connsiteX4" fmla="*/ 102787 w 301392"/>
                <a:gd name="connsiteY4" fmla="*/ 178970 h 427413"/>
                <a:gd name="connsiteX5" fmla="*/ 78975 w 301392"/>
                <a:gd name="connsiteY5" fmla="*/ 217070 h 427413"/>
                <a:gd name="connsiteX6" fmla="*/ 91675 w 301392"/>
                <a:gd name="connsiteY6" fmla="*/ 286920 h 427413"/>
                <a:gd name="connsiteX7" fmla="*/ 155175 w 301392"/>
                <a:gd name="connsiteY7" fmla="*/ 305970 h 427413"/>
                <a:gd name="connsiteX8" fmla="*/ 212325 w 301392"/>
                <a:gd name="connsiteY8" fmla="*/ 363120 h 427413"/>
                <a:gd name="connsiteX9" fmla="*/ 237725 w 301392"/>
                <a:gd name="connsiteY9" fmla="*/ 420270 h 427413"/>
                <a:gd name="connsiteX10" fmla="*/ 161525 w 301392"/>
                <a:gd name="connsiteY10" fmla="*/ 420270 h 427413"/>
                <a:gd name="connsiteX11" fmla="*/ 40875 w 301392"/>
                <a:gd name="connsiteY11" fmla="*/ 363120 h 427413"/>
                <a:gd name="connsiteX12" fmla="*/ 40875 w 301392"/>
                <a:gd name="connsiteY12" fmla="*/ 293270 h 427413"/>
                <a:gd name="connsiteX13" fmla="*/ 40875 w 301392"/>
                <a:gd name="connsiteY13" fmla="*/ 159920 h 427413"/>
                <a:gd name="connsiteX14" fmla="*/ 2775 w 301392"/>
                <a:gd name="connsiteY14" fmla="*/ 51970 h 427413"/>
                <a:gd name="connsiteX15" fmla="*/ 127394 w 301392"/>
                <a:gd name="connsiteY15" fmla="*/ 1170 h 427413"/>
                <a:gd name="connsiteX16" fmla="*/ 228994 w 301392"/>
                <a:gd name="connsiteY16" fmla="*/ 20220 h 427413"/>
                <a:gd name="connsiteX17" fmla="*/ 301225 w 301392"/>
                <a:gd name="connsiteY17" fmla="*/ 64670 h 427413"/>
                <a:gd name="connsiteX0" fmla="*/ 301225 w 301392"/>
                <a:gd name="connsiteY0" fmla="*/ 64670 h 427866"/>
                <a:gd name="connsiteX1" fmla="*/ 209150 w 301392"/>
                <a:gd name="connsiteY1" fmla="*/ 69432 h 427866"/>
                <a:gd name="connsiteX2" fmla="*/ 150413 w 301392"/>
                <a:gd name="connsiteY2" fmla="*/ 74195 h 427866"/>
                <a:gd name="connsiteX3" fmla="*/ 121838 w 301392"/>
                <a:gd name="connsiteY3" fmla="*/ 106739 h 427866"/>
                <a:gd name="connsiteX4" fmla="*/ 102787 w 301392"/>
                <a:gd name="connsiteY4" fmla="*/ 178970 h 427866"/>
                <a:gd name="connsiteX5" fmla="*/ 78975 w 301392"/>
                <a:gd name="connsiteY5" fmla="*/ 217070 h 427866"/>
                <a:gd name="connsiteX6" fmla="*/ 91675 w 301392"/>
                <a:gd name="connsiteY6" fmla="*/ 286920 h 427866"/>
                <a:gd name="connsiteX7" fmla="*/ 155175 w 301392"/>
                <a:gd name="connsiteY7" fmla="*/ 305970 h 427866"/>
                <a:gd name="connsiteX8" fmla="*/ 212325 w 301392"/>
                <a:gd name="connsiteY8" fmla="*/ 363120 h 427866"/>
                <a:gd name="connsiteX9" fmla="*/ 237725 w 301392"/>
                <a:gd name="connsiteY9" fmla="*/ 420270 h 427866"/>
                <a:gd name="connsiteX10" fmla="*/ 161525 w 301392"/>
                <a:gd name="connsiteY10" fmla="*/ 420270 h 427866"/>
                <a:gd name="connsiteX11" fmla="*/ 55163 w 301392"/>
                <a:gd name="connsiteY11" fmla="*/ 355976 h 427866"/>
                <a:gd name="connsiteX12" fmla="*/ 40875 w 301392"/>
                <a:gd name="connsiteY12" fmla="*/ 293270 h 427866"/>
                <a:gd name="connsiteX13" fmla="*/ 40875 w 301392"/>
                <a:gd name="connsiteY13" fmla="*/ 159920 h 427866"/>
                <a:gd name="connsiteX14" fmla="*/ 2775 w 301392"/>
                <a:gd name="connsiteY14" fmla="*/ 51970 h 427866"/>
                <a:gd name="connsiteX15" fmla="*/ 127394 w 301392"/>
                <a:gd name="connsiteY15" fmla="*/ 1170 h 427866"/>
                <a:gd name="connsiteX16" fmla="*/ 228994 w 301392"/>
                <a:gd name="connsiteY16" fmla="*/ 20220 h 427866"/>
                <a:gd name="connsiteX17" fmla="*/ 301225 w 301392"/>
                <a:gd name="connsiteY17" fmla="*/ 64670 h 427866"/>
                <a:gd name="connsiteX0" fmla="*/ 301225 w 301392"/>
                <a:gd name="connsiteY0" fmla="*/ 64670 h 427866"/>
                <a:gd name="connsiteX1" fmla="*/ 209150 w 301392"/>
                <a:gd name="connsiteY1" fmla="*/ 69432 h 427866"/>
                <a:gd name="connsiteX2" fmla="*/ 124219 w 301392"/>
                <a:gd name="connsiteY2" fmla="*/ 52764 h 427866"/>
                <a:gd name="connsiteX3" fmla="*/ 121838 w 301392"/>
                <a:gd name="connsiteY3" fmla="*/ 106739 h 427866"/>
                <a:gd name="connsiteX4" fmla="*/ 102787 w 301392"/>
                <a:gd name="connsiteY4" fmla="*/ 178970 h 427866"/>
                <a:gd name="connsiteX5" fmla="*/ 78975 w 301392"/>
                <a:gd name="connsiteY5" fmla="*/ 217070 h 427866"/>
                <a:gd name="connsiteX6" fmla="*/ 91675 w 301392"/>
                <a:gd name="connsiteY6" fmla="*/ 286920 h 427866"/>
                <a:gd name="connsiteX7" fmla="*/ 155175 w 301392"/>
                <a:gd name="connsiteY7" fmla="*/ 305970 h 427866"/>
                <a:gd name="connsiteX8" fmla="*/ 212325 w 301392"/>
                <a:gd name="connsiteY8" fmla="*/ 363120 h 427866"/>
                <a:gd name="connsiteX9" fmla="*/ 237725 w 301392"/>
                <a:gd name="connsiteY9" fmla="*/ 420270 h 427866"/>
                <a:gd name="connsiteX10" fmla="*/ 161525 w 301392"/>
                <a:gd name="connsiteY10" fmla="*/ 420270 h 427866"/>
                <a:gd name="connsiteX11" fmla="*/ 55163 w 301392"/>
                <a:gd name="connsiteY11" fmla="*/ 355976 h 427866"/>
                <a:gd name="connsiteX12" fmla="*/ 40875 w 301392"/>
                <a:gd name="connsiteY12" fmla="*/ 293270 h 427866"/>
                <a:gd name="connsiteX13" fmla="*/ 40875 w 301392"/>
                <a:gd name="connsiteY13" fmla="*/ 159920 h 427866"/>
                <a:gd name="connsiteX14" fmla="*/ 2775 w 301392"/>
                <a:gd name="connsiteY14" fmla="*/ 51970 h 427866"/>
                <a:gd name="connsiteX15" fmla="*/ 127394 w 301392"/>
                <a:gd name="connsiteY15" fmla="*/ 1170 h 427866"/>
                <a:gd name="connsiteX16" fmla="*/ 228994 w 301392"/>
                <a:gd name="connsiteY16" fmla="*/ 20220 h 427866"/>
                <a:gd name="connsiteX17" fmla="*/ 301225 w 301392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121838 w 301356"/>
                <a:gd name="connsiteY3" fmla="*/ 106739 h 427866"/>
                <a:gd name="connsiteX4" fmla="*/ 102787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83738 w 301356"/>
                <a:gd name="connsiteY3" fmla="*/ 101976 h 427866"/>
                <a:gd name="connsiteX4" fmla="*/ 102787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  <a:gd name="connsiteX0" fmla="*/ 301225 w 301356"/>
                <a:gd name="connsiteY0" fmla="*/ 64670 h 427866"/>
                <a:gd name="connsiteX1" fmla="*/ 211531 w 301356"/>
                <a:gd name="connsiteY1" fmla="*/ 55145 h 427866"/>
                <a:gd name="connsiteX2" fmla="*/ 124219 w 301356"/>
                <a:gd name="connsiteY2" fmla="*/ 52764 h 427866"/>
                <a:gd name="connsiteX3" fmla="*/ 83738 w 301356"/>
                <a:gd name="connsiteY3" fmla="*/ 101976 h 427866"/>
                <a:gd name="connsiteX4" fmla="*/ 78975 w 301356"/>
                <a:gd name="connsiteY4" fmla="*/ 178970 h 427866"/>
                <a:gd name="connsiteX5" fmla="*/ 78975 w 301356"/>
                <a:gd name="connsiteY5" fmla="*/ 217070 h 427866"/>
                <a:gd name="connsiteX6" fmla="*/ 91675 w 301356"/>
                <a:gd name="connsiteY6" fmla="*/ 286920 h 427866"/>
                <a:gd name="connsiteX7" fmla="*/ 155175 w 301356"/>
                <a:gd name="connsiteY7" fmla="*/ 305970 h 427866"/>
                <a:gd name="connsiteX8" fmla="*/ 212325 w 301356"/>
                <a:gd name="connsiteY8" fmla="*/ 363120 h 427866"/>
                <a:gd name="connsiteX9" fmla="*/ 237725 w 301356"/>
                <a:gd name="connsiteY9" fmla="*/ 420270 h 427866"/>
                <a:gd name="connsiteX10" fmla="*/ 161525 w 301356"/>
                <a:gd name="connsiteY10" fmla="*/ 420270 h 427866"/>
                <a:gd name="connsiteX11" fmla="*/ 55163 w 301356"/>
                <a:gd name="connsiteY11" fmla="*/ 355976 h 427866"/>
                <a:gd name="connsiteX12" fmla="*/ 40875 w 301356"/>
                <a:gd name="connsiteY12" fmla="*/ 293270 h 427866"/>
                <a:gd name="connsiteX13" fmla="*/ 40875 w 301356"/>
                <a:gd name="connsiteY13" fmla="*/ 159920 h 427866"/>
                <a:gd name="connsiteX14" fmla="*/ 2775 w 301356"/>
                <a:gd name="connsiteY14" fmla="*/ 51970 h 427866"/>
                <a:gd name="connsiteX15" fmla="*/ 127394 w 301356"/>
                <a:gd name="connsiteY15" fmla="*/ 1170 h 427866"/>
                <a:gd name="connsiteX16" fmla="*/ 228994 w 301356"/>
                <a:gd name="connsiteY16" fmla="*/ 20220 h 427866"/>
                <a:gd name="connsiteX17" fmla="*/ 301225 w 301356"/>
                <a:gd name="connsiteY17" fmla="*/ 64670 h 4278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301356" h="427866">
                  <a:moveTo>
                    <a:pt x="301225" y="64670"/>
                  </a:moveTo>
                  <a:cubicBezTo>
                    <a:pt x="298315" y="70491"/>
                    <a:pt x="241032" y="57129"/>
                    <a:pt x="211531" y="55145"/>
                  </a:cubicBezTo>
                  <a:cubicBezTo>
                    <a:pt x="182030" y="53161"/>
                    <a:pt x="145518" y="44959"/>
                    <a:pt x="124219" y="52764"/>
                  </a:cubicBezTo>
                  <a:cubicBezTo>
                    <a:pt x="102920" y="60569"/>
                    <a:pt x="91279" y="80942"/>
                    <a:pt x="83738" y="101976"/>
                  </a:cubicBezTo>
                  <a:cubicBezTo>
                    <a:pt x="76197" y="123010"/>
                    <a:pt x="79769" y="159788"/>
                    <a:pt x="78975" y="178970"/>
                  </a:cubicBezTo>
                  <a:cubicBezTo>
                    <a:pt x="78181" y="198152"/>
                    <a:pt x="76858" y="199078"/>
                    <a:pt x="78975" y="217070"/>
                  </a:cubicBezTo>
                  <a:cubicBezTo>
                    <a:pt x="81092" y="235062"/>
                    <a:pt x="78975" y="272103"/>
                    <a:pt x="91675" y="286920"/>
                  </a:cubicBezTo>
                  <a:cubicBezTo>
                    <a:pt x="104375" y="301737"/>
                    <a:pt x="135067" y="293270"/>
                    <a:pt x="155175" y="305970"/>
                  </a:cubicBezTo>
                  <a:cubicBezTo>
                    <a:pt x="175283" y="318670"/>
                    <a:pt x="198567" y="344070"/>
                    <a:pt x="212325" y="363120"/>
                  </a:cubicBezTo>
                  <a:cubicBezTo>
                    <a:pt x="226083" y="382170"/>
                    <a:pt x="246192" y="410745"/>
                    <a:pt x="237725" y="420270"/>
                  </a:cubicBezTo>
                  <a:cubicBezTo>
                    <a:pt x="229258" y="429795"/>
                    <a:pt x="191952" y="430986"/>
                    <a:pt x="161525" y="420270"/>
                  </a:cubicBezTo>
                  <a:cubicBezTo>
                    <a:pt x="131098" y="409554"/>
                    <a:pt x="75271" y="377143"/>
                    <a:pt x="55163" y="355976"/>
                  </a:cubicBezTo>
                  <a:cubicBezTo>
                    <a:pt x="35055" y="334809"/>
                    <a:pt x="43256" y="325946"/>
                    <a:pt x="40875" y="293270"/>
                  </a:cubicBezTo>
                  <a:cubicBezTo>
                    <a:pt x="38494" y="260594"/>
                    <a:pt x="47225" y="200137"/>
                    <a:pt x="40875" y="159920"/>
                  </a:cubicBezTo>
                  <a:cubicBezTo>
                    <a:pt x="34525" y="119703"/>
                    <a:pt x="-11645" y="78428"/>
                    <a:pt x="2775" y="51970"/>
                  </a:cubicBezTo>
                  <a:cubicBezTo>
                    <a:pt x="17195" y="25512"/>
                    <a:pt x="92469" y="6462"/>
                    <a:pt x="127394" y="1170"/>
                  </a:cubicBezTo>
                  <a:cubicBezTo>
                    <a:pt x="162319" y="-4122"/>
                    <a:pt x="200022" y="9637"/>
                    <a:pt x="228994" y="20220"/>
                  </a:cubicBezTo>
                  <a:cubicBezTo>
                    <a:pt x="257966" y="30803"/>
                    <a:pt x="304136" y="58849"/>
                    <a:pt x="301225" y="64670"/>
                  </a:cubicBezTo>
                  <a:close/>
                </a:path>
              </a:pathLst>
            </a:custGeom>
            <a:solidFill>
              <a:schemeClr val="accent3"/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6" name="任意多边形: 形状 465">
              <a:extLst>
                <a:ext uri="{FF2B5EF4-FFF2-40B4-BE49-F238E27FC236}">
                  <a16:creationId xmlns:a16="http://schemas.microsoft.com/office/drawing/2014/main" id="{E8E38C2D-0D8D-4E58-A04E-3A8F3B2C5B74}"/>
                </a:ext>
              </a:extLst>
            </p:cNvPr>
            <p:cNvSpPr/>
            <p:nvPr/>
          </p:nvSpPr>
          <p:spPr>
            <a:xfrm flipH="1">
              <a:off x="7390258" y="2117031"/>
              <a:ext cx="289684" cy="578220"/>
            </a:xfrm>
            <a:custGeom>
              <a:avLst/>
              <a:gdLst>
                <a:gd name="connsiteX0" fmla="*/ 791928 w 1549729"/>
                <a:gd name="connsiteY0" fmla="*/ 3093321 h 3093321"/>
                <a:gd name="connsiteX1" fmla="*/ 1165554 w 1549729"/>
                <a:gd name="connsiteY1" fmla="*/ 2532882 h 3093321"/>
                <a:gd name="connsiteX2" fmla="*/ 1401528 w 1549729"/>
                <a:gd name="connsiteY2" fmla="*/ 1942947 h 3093321"/>
                <a:gd name="connsiteX3" fmla="*/ 1549012 w 1549729"/>
                <a:gd name="connsiteY3" fmla="*/ 1166199 h 3093321"/>
                <a:gd name="connsiteX4" fmla="*/ 1342535 w 1549729"/>
                <a:gd name="connsiteY4" fmla="*/ 586095 h 3093321"/>
                <a:gd name="connsiteX5" fmla="*/ 1027902 w 1549729"/>
                <a:gd name="connsiteY5" fmla="*/ 94482 h 3093321"/>
                <a:gd name="connsiteX6" fmla="*/ 408470 w 1549729"/>
                <a:gd name="connsiteY6" fmla="*/ 5992 h 3093321"/>
                <a:gd name="connsiteX7" fmla="*/ 15180 w 1549729"/>
                <a:gd name="connsiteY7" fmla="*/ 182973 h 3093321"/>
                <a:gd name="connsiteX8" fmla="*/ 84006 w 1549729"/>
                <a:gd name="connsiteY8" fmla="*/ 586095 h 3093321"/>
                <a:gd name="connsiteX9" fmla="*/ 113502 w 1549729"/>
                <a:gd name="connsiteY9" fmla="*/ 979386 h 3093321"/>
                <a:gd name="connsiteX10" fmla="*/ 201993 w 1549729"/>
                <a:gd name="connsiteY10" fmla="*/ 1441502 h 3093321"/>
                <a:gd name="connsiteX11" fmla="*/ 536289 w 1549729"/>
                <a:gd name="connsiteY11" fmla="*/ 1647979 h 3093321"/>
                <a:gd name="connsiteX12" fmla="*/ 870586 w 1549729"/>
                <a:gd name="connsiteY12" fmla="*/ 1657811 h 3093321"/>
                <a:gd name="connsiteX13" fmla="*/ 949244 w 1549729"/>
                <a:gd name="connsiteY13" fmla="*/ 1647979 h 30933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1549729" h="3093321">
                  <a:moveTo>
                    <a:pt x="791928" y="3093321"/>
                  </a:moveTo>
                  <a:cubicBezTo>
                    <a:pt x="927941" y="2908966"/>
                    <a:pt x="1063954" y="2724611"/>
                    <a:pt x="1165554" y="2532882"/>
                  </a:cubicBezTo>
                  <a:cubicBezTo>
                    <a:pt x="1267154" y="2341153"/>
                    <a:pt x="1337618" y="2170727"/>
                    <a:pt x="1401528" y="1942947"/>
                  </a:cubicBezTo>
                  <a:cubicBezTo>
                    <a:pt x="1465438" y="1715166"/>
                    <a:pt x="1558844" y="1392341"/>
                    <a:pt x="1549012" y="1166199"/>
                  </a:cubicBezTo>
                  <a:cubicBezTo>
                    <a:pt x="1539180" y="940057"/>
                    <a:pt x="1429387" y="764714"/>
                    <a:pt x="1342535" y="586095"/>
                  </a:cubicBezTo>
                  <a:cubicBezTo>
                    <a:pt x="1255683" y="407476"/>
                    <a:pt x="1183580" y="191166"/>
                    <a:pt x="1027902" y="94482"/>
                  </a:cubicBezTo>
                  <a:cubicBezTo>
                    <a:pt x="872225" y="-2202"/>
                    <a:pt x="577257" y="-8756"/>
                    <a:pt x="408470" y="5992"/>
                  </a:cubicBezTo>
                  <a:cubicBezTo>
                    <a:pt x="239683" y="20740"/>
                    <a:pt x="69257" y="86289"/>
                    <a:pt x="15180" y="182973"/>
                  </a:cubicBezTo>
                  <a:cubicBezTo>
                    <a:pt x="-38897" y="279657"/>
                    <a:pt x="67619" y="453360"/>
                    <a:pt x="84006" y="586095"/>
                  </a:cubicBezTo>
                  <a:cubicBezTo>
                    <a:pt x="100393" y="718830"/>
                    <a:pt x="93837" y="836818"/>
                    <a:pt x="113502" y="979386"/>
                  </a:cubicBezTo>
                  <a:cubicBezTo>
                    <a:pt x="133166" y="1121954"/>
                    <a:pt x="131529" y="1330070"/>
                    <a:pt x="201993" y="1441502"/>
                  </a:cubicBezTo>
                  <a:cubicBezTo>
                    <a:pt x="272457" y="1552934"/>
                    <a:pt x="424857" y="1611928"/>
                    <a:pt x="536289" y="1647979"/>
                  </a:cubicBezTo>
                  <a:cubicBezTo>
                    <a:pt x="647721" y="1684030"/>
                    <a:pt x="801760" y="1657811"/>
                    <a:pt x="870586" y="1657811"/>
                  </a:cubicBezTo>
                  <a:cubicBezTo>
                    <a:pt x="939412" y="1657811"/>
                    <a:pt x="944328" y="1652895"/>
                    <a:pt x="949244" y="164797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7" name="任意多边形: 形状 466">
              <a:extLst>
                <a:ext uri="{FF2B5EF4-FFF2-40B4-BE49-F238E27FC236}">
                  <a16:creationId xmlns:a16="http://schemas.microsoft.com/office/drawing/2014/main" id="{EDD61D1C-FB6C-46E0-B018-DAF5A70F886E}"/>
                </a:ext>
              </a:extLst>
            </p:cNvPr>
            <p:cNvSpPr/>
            <p:nvPr/>
          </p:nvSpPr>
          <p:spPr>
            <a:xfrm flipH="1">
              <a:off x="7492813" y="2285041"/>
              <a:ext cx="147110" cy="276505"/>
            </a:xfrm>
            <a:custGeom>
              <a:avLst/>
              <a:gdLst>
                <a:gd name="connsiteX0" fmla="*/ 0 w 786995"/>
                <a:gd name="connsiteY0" fmla="*/ 0 h 1479227"/>
                <a:gd name="connsiteX1" fmla="*/ 98322 w 786995"/>
                <a:gd name="connsiteY1" fmla="*/ 226142 h 1479227"/>
                <a:gd name="connsiteX2" fmla="*/ 373626 w 786995"/>
                <a:gd name="connsiteY2" fmla="*/ 373626 h 1479227"/>
                <a:gd name="connsiteX3" fmla="*/ 629264 w 786995"/>
                <a:gd name="connsiteY3" fmla="*/ 570271 h 1479227"/>
                <a:gd name="connsiteX4" fmla="*/ 747251 w 786995"/>
                <a:gd name="connsiteY4" fmla="*/ 884903 h 1479227"/>
                <a:gd name="connsiteX5" fmla="*/ 786580 w 786995"/>
                <a:gd name="connsiteY5" fmla="*/ 1179871 h 1479227"/>
                <a:gd name="connsiteX6" fmla="*/ 727587 w 786995"/>
                <a:gd name="connsiteY6" fmla="*/ 1376516 h 1479227"/>
                <a:gd name="connsiteX7" fmla="*/ 678426 w 786995"/>
                <a:gd name="connsiteY7" fmla="*/ 1474839 h 14792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786995" h="1479227">
                  <a:moveTo>
                    <a:pt x="0" y="0"/>
                  </a:moveTo>
                  <a:cubicBezTo>
                    <a:pt x="18025" y="81935"/>
                    <a:pt x="36051" y="163871"/>
                    <a:pt x="98322" y="226142"/>
                  </a:cubicBezTo>
                  <a:cubicBezTo>
                    <a:pt x="160593" y="288413"/>
                    <a:pt x="285136" y="316271"/>
                    <a:pt x="373626" y="373626"/>
                  </a:cubicBezTo>
                  <a:cubicBezTo>
                    <a:pt x="462116" y="430981"/>
                    <a:pt x="566993" y="485058"/>
                    <a:pt x="629264" y="570271"/>
                  </a:cubicBezTo>
                  <a:cubicBezTo>
                    <a:pt x="691535" y="655484"/>
                    <a:pt x="721032" y="783303"/>
                    <a:pt x="747251" y="884903"/>
                  </a:cubicBezTo>
                  <a:cubicBezTo>
                    <a:pt x="773470" y="986503"/>
                    <a:pt x="789857" y="1097936"/>
                    <a:pt x="786580" y="1179871"/>
                  </a:cubicBezTo>
                  <a:cubicBezTo>
                    <a:pt x="783303" y="1261806"/>
                    <a:pt x="745613" y="1327355"/>
                    <a:pt x="727587" y="1376516"/>
                  </a:cubicBezTo>
                  <a:cubicBezTo>
                    <a:pt x="709561" y="1425677"/>
                    <a:pt x="683342" y="1497781"/>
                    <a:pt x="678426" y="1474839"/>
                  </a:cubicBezTo>
                </a:path>
              </a:pathLst>
            </a:cu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7" name="椭圆 6">
            <a:extLst>
              <a:ext uri="{FF2B5EF4-FFF2-40B4-BE49-F238E27FC236}">
                <a16:creationId xmlns:a16="http://schemas.microsoft.com/office/drawing/2014/main" id="{C35AA9CD-EFDC-415A-AB2C-4264161A376B}"/>
              </a:ext>
            </a:extLst>
          </p:cNvPr>
          <p:cNvSpPr/>
          <p:nvPr/>
        </p:nvSpPr>
        <p:spPr>
          <a:xfrm>
            <a:off x="7992398" y="10174577"/>
            <a:ext cx="756257" cy="402744"/>
          </a:xfrm>
          <a:prstGeom prst="ellipse">
            <a:avLst/>
          </a:prstGeom>
          <a:noFill/>
          <a:ln w="9525">
            <a:solidFill>
              <a:schemeClr val="accent3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5" name="椭圆 334">
            <a:extLst>
              <a:ext uri="{FF2B5EF4-FFF2-40B4-BE49-F238E27FC236}">
                <a16:creationId xmlns:a16="http://schemas.microsoft.com/office/drawing/2014/main" id="{4246D622-BE7A-4B1C-B1B3-A8F86204116E}"/>
              </a:ext>
            </a:extLst>
          </p:cNvPr>
          <p:cNvSpPr/>
          <p:nvPr/>
        </p:nvSpPr>
        <p:spPr>
          <a:xfrm>
            <a:off x="4038290" y="9722712"/>
            <a:ext cx="230783" cy="167483"/>
          </a:xfrm>
          <a:prstGeom prst="ellipse">
            <a:avLst/>
          </a:prstGeom>
          <a:noFill/>
          <a:ln w="19050">
            <a:solidFill>
              <a:schemeClr val="accent3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50" name="直接箭头连接符 349">
            <a:extLst>
              <a:ext uri="{FF2B5EF4-FFF2-40B4-BE49-F238E27FC236}">
                <a16:creationId xmlns:a16="http://schemas.microsoft.com/office/drawing/2014/main" id="{22910F7C-00F0-4D6C-BEBB-DA27792D1CD1}"/>
              </a:ext>
            </a:extLst>
          </p:cNvPr>
          <p:cNvCxnSpPr>
            <a:cxnSpLocks/>
          </p:cNvCxnSpPr>
          <p:nvPr/>
        </p:nvCxnSpPr>
        <p:spPr>
          <a:xfrm>
            <a:off x="4289343" y="10696695"/>
            <a:ext cx="724223" cy="59772"/>
          </a:xfrm>
          <a:prstGeom prst="straightConnector1">
            <a:avLst/>
          </a:prstGeom>
          <a:ln w="9525">
            <a:noFill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39" name="组合 438">
            <a:extLst>
              <a:ext uri="{FF2B5EF4-FFF2-40B4-BE49-F238E27FC236}">
                <a16:creationId xmlns:a16="http://schemas.microsoft.com/office/drawing/2014/main" id="{FD051ED4-FC2C-44CD-84D7-C34CD460B029}"/>
              </a:ext>
            </a:extLst>
          </p:cNvPr>
          <p:cNvGrpSpPr/>
          <p:nvPr/>
        </p:nvGrpSpPr>
        <p:grpSpPr>
          <a:xfrm rot="1773924">
            <a:off x="10139364" y="5429904"/>
            <a:ext cx="535687" cy="620352"/>
            <a:chOff x="5258633" y="775855"/>
            <a:chExt cx="583340" cy="675535"/>
          </a:xfrm>
        </p:grpSpPr>
        <p:sp>
          <p:nvSpPr>
            <p:cNvPr id="440" name="矩形 439">
              <a:extLst>
                <a:ext uri="{FF2B5EF4-FFF2-40B4-BE49-F238E27FC236}">
                  <a16:creationId xmlns:a16="http://schemas.microsoft.com/office/drawing/2014/main" id="{9FAADFC7-1410-4CFD-A78F-BD568A2CDF31}"/>
                </a:ext>
              </a:extLst>
            </p:cNvPr>
            <p:cNvSpPr/>
            <p:nvPr/>
          </p:nvSpPr>
          <p:spPr>
            <a:xfrm>
              <a:off x="5393823" y="775855"/>
              <a:ext cx="313989" cy="857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1" name="梯形 440">
              <a:extLst>
                <a:ext uri="{FF2B5EF4-FFF2-40B4-BE49-F238E27FC236}">
                  <a16:creationId xmlns:a16="http://schemas.microsoft.com/office/drawing/2014/main" id="{28B86E1A-7FC6-4775-B5D2-1FF44993C516}"/>
                </a:ext>
              </a:extLst>
            </p:cNvPr>
            <p:cNvSpPr/>
            <p:nvPr/>
          </p:nvSpPr>
          <p:spPr>
            <a:xfrm>
              <a:off x="5290988" y="861580"/>
              <a:ext cx="519112" cy="205813"/>
            </a:xfrm>
            <a:prstGeom prst="trapezoid">
              <a:avLst>
                <a:gd name="adj" fmla="val 50000"/>
              </a:avLst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42" name="组合 441">
              <a:extLst>
                <a:ext uri="{FF2B5EF4-FFF2-40B4-BE49-F238E27FC236}">
                  <a16:creationId xmlns:a16="http://schemas.microsoft.com/office/drawing/2014/main" id="{09DA51E9-7C23-490C-8196-D1BA3A9C9FF4}"/>
                </a:ext>
              </a:extLst>
            </p:cNvPr>
            <p:cNvGrpSpPr/>
            <p:nvPr/>
          </p:nvGrpSpPr>
          <p:grpSpPr>
            <a:xfrm rot="5610853">
              <a:off x="5255889" y="865307"/>
              <a:ext cx="588827" cy="583340"/>
              <a:chOff x="6035483" y="2426275"/>
              <a:chExt cx="923001" cy="914400"/>
            </a:xfrm>
          </p:grpSpPr>
          <p:sp>
            <p:nvSpPr>
              <p:cNvPr id="443" name="弧形 442">
                <a:extLst>
                  <a:ext uri="{FF2B5EF4-FFF2-40B4-BE49-F238E27FC236}">
                    <a16:creationId xmlns:a16="http://schemas.microsoft.com/office/drawing/2014/main" id="{FD813176-E5B9-41A4-B967-C9188E73B30F}"/>
                  </a:ext>
                </a:extLst>
              </p:cNvPr>
              <p:cNvSpPr/>
              <p:nvPr/>
            </p:nvSpPr>
            <p:spPr>
              <a:xfrm rot="2563549">
                <a:off x="6044084" y="2426275"/>
                <a:ext cx="914400" cy="914400"/>
              </a:xfrm>
              <a:prstGeom prst="arc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44" name="弧形 443">
                <a:extLst>
                  <a:ext uri="{FF2B5EF4-FFF2-40B4-BE49-F238E27FC236}">
                    <a16:creationId xmlns:a16="http://schemas.microsoft.com/office/drawing/2014/main" id="{7FC06254-9F45-4432-80CF-6E19DF91B5B8}"/>
                  </a:ext>
                </a:extLst>
              </p:cNvPr>
              <p:cNvSpPr/>
              <p:nvPr/>
            </p:nvSpPr>
            <p:spPr>
              <a:xfrm rot="2563549">
                <a:off x="6035483" y="2530211"/>
                <a:ext cx="724355" cy="724355"/>
              </a:xfrm>
              <a:prstGeom prst="arc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45" name="弧形 444">
                <a:extLst>
                  <a:ext uri="{FF2B5EF4-FFF2-40B4-BE49-F238E27FC236}">
                    <a16:creationId xmlns:a16="http://schemas.microsoft.com/office/drawing/2014/main" id="{407EC946-6468-495B-84AD-B95F8A6F76E3}"/>
                  </a:ext>
                </a:extLst>
              </p:cNvPr>
              <p:cNvSpPr/>
              <p:nvPr/>
            </p:nvSpPr>
            <p:spPr>
              <a:xfrm rot="2563549">
                <a:off x="6076435" y="2651188"/>
                <a:ext cx="482399" cy="482399"/>
              </a:xfrm>
              <a:prstGeom prst="arc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sp>
        <p:nvSpPr>
          <p:cNvPr id="376" name="立方体 375">
            <a:extLst>
              <a:ext uri="{FF2B5EF4-FFF2-40B4-BE49-F238E27FC236}">
                <a16:creationId xmlns:a16="http://schemas.microsoft.com/office/drawing/2014/main" id="{0AD12C6D-2BC4-4DB8-ADAA-5CAEEEBE4A9F}"/>
              </a:ext>
            </a:extLst>
          </p:cNvPr>
          <p:cNvSpPr/>
          <p:nvPr/>
        </p:nvSpPr>
        <p:spPr>
          <a:xfrm flipH="1">
            <a:off x="7680158" y="6313267"/>
            <a:ext cx="1242516" cy="423675"/>
          </a:xfrm>
          <a:prstGeom prst="cube">
            <a:avLst>
              <a:gd name="adj" fmla="val 7096"/>
            </a:avLst>
          </a:prstGeom>
          <a:solidFill>
            <a:schemeClr val="accent3">
              <a:lumMod val="7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romorphic Chip</a:t>
            </a:r>
          </a:p>
        </p:txBody>
      </p:sp>
      <p:cxnSp>
        <p:nvCxnSpPr>
          <p:cNvPr id="450" name="连接符: 曲线 449">
            <a:extLst>
              <a:ext uri="{FF2B5EF4-FFF2-40B4-BE49-F238E27FC236}">
                <a16:creationId xmlns:a16="http://schemas.microsoft.com/office/drawing/2014/main" id="{A1CB1C15-85D5-42C9-94C9-7B4CA015F13A}"/>
              </a:ext>
            </a:extLst>
          </p:cNvPr>
          <p:cNvCxnSpPr>
            <a:cxnSpLocks/>
            <a:endCxn id="376" idx="2"/>
          </p:cNvCxnSpPr>
          <p:nvPr/>
        </p:nvCxnSpPr>
        <p:spPr>
          <a:xfrm rot="16200000" flipV="1">
            <a:off x="8731854" y="6730960"/>
            <a:ext cx="729975" cy="348329"/>
          </a:xfrm>
          <a:prstGeom prst="curvedConnector2">
            <a:avLst/>
          </a:prstGeom>
          <a:ln w="76200">
            <a:solidFill>
              <a:schemeClr val="accent3">
                <a:lumMod val="40000"/>
                <a:lumOff val="6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2" name="连接符: 曲线 381">
            <a:extLst>
              <a:ext uri="{FF2B5EF4-FFF2-40B4-BE49-F238E27FC236}">
                <a16:creationId xmlns:a16="http://schemas.microsoft.com/office/drawing/2014/main" id="{D44FDA4C-AA2D-4D45-9332-689BDA034615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7056495" y="6779843"/>
            <a:ext cx="845512" cy="440032"/>
          </a:xfrm>
          <a:prstGeom prst="curvedConnector3">
            <a:avLst>
              <a:gd name="adj1" fmla="val 92371"/>
            </a:avLst>
          </a:prstGeom>
          <a:ln w="76200">
            <a:solidFill>
              <a:schemeClr val="accent3">
                <a:lumMod val="40000"/>
                <a:lumOff val="6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0" name="直接连接符 379">
            <a:extLst>
              <a:ext uri="{FF2B5EF4-FFF2-40B4-BE49-F238E27FC236}">
                <a16:creationId xmlns:a16="http://schemas.microsoft.com/office/drawing/2014/main" id="{0AD14D5F-ADA6-40DA-A2E4-03C65EAD1731}"/>
              </a:ext>
            </a:extLst>
          </p:cNvPr>
          <p:cNvCxnSpPr>
            <a:cxnSpLocks/>
          </p:cNvCxnSpPr>
          <p:nvPr/>
        </p:nvCxnSpPr>
        <p:spPr>
          <a:xfrm>
            <a:off x="2973662" y="7064590"/>
            <a:ext cx="2214903" cy="1642465"/>
          </a:xfrm>
          <a:prstGeom prst="line">
            <a:avLst/>
          </a:prstGeom>
          <a:ln w="9525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1" name="直接连接符 380">
            <a:extLst>
              <a:ext uri="{FF2B5EF4-FFF2-40B4-BE49-F238E27FC236}">
                <a16:creationId xmlns:a16="http://schemas.microsoft.com/office/drawing/2014/main" id="{7B31E50F-985C-44B5-AE9D-83093351A519}"/>
              </a:ext>
            </a:extLst>
          </p:cNvPr>
          <p:cNvCxnSpPr>
            <a:cxnSpLocks/>
          </p:cNvCxnSpPr>
          <p:nvPr/>
        </p:nvCxnSpPr>
        <p:spPr>
          <a:xfrm flipH="1">
            <a:off x="1078862" y="7079927"/>
            <a:ext cx="1890622" cy="1711289"/>
          </a:xfrm>
          <a:prstGeom prst="line">
            <a:avLst/>
          </a:prstGeom>
          <a:ln w="9525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8" name="文本框 437">
            <a:extLst>
              <a:ext uri="{FF2B5EF4-FFF2-40B4-BE49-F238E27FC236}">
                <a16:creationId xmlns:a16="http://schemas.microsoft.com/office/drawing/2014/main" id="{1EAF6068-995F-4044-974D-BDAB687059D7}"/>
              </a:ext>
            </a:extLst>
          </p:cNvPr>
          <p:cNvSpPr txBox="1"/>
          <p:nvPr/>
        </p:nvSpPr>
        <p:spPr>
          <a:xfrm>
            <a:off x="9080714" y="7765674"/>
            <a:ext cx="1648211" cy="307777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tificial ear</a:t>
            </a:r>
            <a:endParaRPr lang="zh-CN" altLang="en-US" sz="1400" dirty="0">
              <a:solidFill>
                <a:schemeClr val="accent3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文本框 228">
            <a:extLst>
              <a:ext uri="{FF2B5EF4-FFF2-40B4-BE49-F238E27FC236}">
                <a16:creationId xmlns:a16="http://schemas.microsoft.com/office/drawing/2014/main" id="{35623975-DF94-44D0-8B09-6CE52B15C426}"/>
              </a:ext>
            </a:extLst>
          </p:cNvPr>
          <p:cNvSpPr txBox="1"/>
          <p:nvPr/>
        </p:nvSpPr>
        <p:spPr>
          <a:xfrm rot="10800000" flipV="1">
            <a:off x="2156205" y="7968990"/>
            <a:ext cx="2508635" cy="276999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D</a:t>
            </a:r>
            <a:r>
              <a:rPr lang="zh-CN" altLang="en-US" sz="12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sz="12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ectral cue etc.</a:t>
            </a:r>
            <a:endParaRPr lang="zh-CN" altLang="en-US" sz="1200" b="1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1" name="组合 230">
            <a:extLst>
              <a:ext uri="{FF2B5EF4-FFF2-40B4-BE49-F238E27FC236}">
                <a16:creationId xmlns:a16="http://schemas.microsoft.com/office/drawing/2014/main" id="{34705CA3-6FA1-43BC-A9E6-EA70F8DC7359}"/>
              </a:ext>
            </a:extLst>
          </p:cNvPr>
          <p:cNvGrpSpPr/>
          <p:nvPr/>
        </p:nvGrpSpPr>
        <p:grpSpPr>
          <a:xfrm flipH="1">
            <a:off x="5111833" y="7267574"/>
            <a:ext cx="540727" cy="535687"/>
            <a:chOff x="6035483" y="2426275"/>
            <a:chExt cx="923001" cy="914400"/>
          </a:xfrm>
        </p:grpSpPr>
        <p:sp>
          <p:nvSpPr>
            <p:cNvPr id="232" name="弧形 231">
              <a:extLst>
                <a:ext uri="{FF2B5EF4-FFF2-40B4-BE49-F238E27FC236}">
                  <a16:creationId xmlns:a16="http://schemas.microsoft.com/office/drawing/2014/main" id="{D8EA0AC6-DB07-4821-B150-7A2D2FDD54D7}"/>
                </a:ext>
              </a:extLst>
            </p:cNvPr>
            <p:cNvSpPr/>
            <p:nvPr/>
          </p:nvSpPr>
          <p:spPr>
            <a:xfrm rot="2563549">
              <a:off x="6044084" y="2426275"/>
              <a:ext cx="914400" cy="914400"/>
            </a:xfrm>
            <a:prstGeom prst="arc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6" name="弧形 235">
              <a:extLst>
                <a:ext uri="{FF2B5EF4-FFF2-40B4-BE49-F238E27FC236}">
                  <a16:creationId xmlns:a16="http://schemas.microsoft.com/office/drawing/2014/main" id="{886C0E36-9FAF-4F4F-881B-6027B36A9781}"/>
                </a:ext>
              </a:extLst>
            </p:cNvPr>
            <p:cNvSpPr/>
            <p:nvPr/>
          </p:nvSpPr>
          <p:spPr>
            <a:xfrm rot="2563549">
              <a:off x="6035483" y="2530211"/>
              <a:ext cx="724355" cy="724355"/>
            </a:xfrm>
            <a:prstGeom prst="arc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7" name="弧形 236">
              <a:extLst>
                <a:ext uri="{FF2B5EF4-FFF2-40B4-BE49-F238E27FC236}">
                  <a16:creationId xmlns:a16="http://schemas.microsoft.com/office/drawing/2014/main" id="{C4FFC9EB-130A-4337-9726-B42C3C4E25A9}"/>
                </a:ext>
              </a:extLst>
            </p:cNvPr>
            <p:cNvSpPr/>
            <p:nvPr/>
          </p:nvSpPr>
          <p:spPr>
            <a:xfrm rot="2563549">
              <a:off x="6076435" y="2651188"/>
              <a:ext cx="482399" cy="482399"/>
            </a:xfrm>
            <a:prstGeom prst="arc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38" name="组合 237">
            <a:extLst>
              <a:ext uri="{FF2B5EF4-FFF2-40B4-BE49-F238E27FC236}">
                <a16:creationId xmlns:a16="http://schemas.microsoft.com/office/drawing/2014/main" id="{36A58ABA-D613-4ACD-9CFA-40ABD1B3DC9D}"/>
              </a:ext>
            </a:extLst>
          </p:cNvPr>
          <p:cNvGrpSpPr/>
          <p:nvPr/>
        </p:nvGrpSpPr>
        <p:grpSpPr>
          <a:xfrm>
            <a:off x="673055" y="7265936"/>
            <a:ext cx="540727" cy="535687"/>
            <a:chOff x="6035483" y="2426275"/>
            <a:chExt cx="923001" cy="914400"/>
          </a:xfrm>
        </p:grpSpPr>
        <p:sp>
          <p:nvSpPr>
            <p:cNvPr id="239" name="弧形 238">
              <a:extLst>
                <a:ext uri="{FF2B5EF4-FFF2-40B4-BE49-F238E27FC236}">
                  <a16:creationId xmlns:a16="http://schemas.microsoft.com/office/drawing/2014/main" id="{6531A757-AE05-4677-9426-30CD67F9FC2E}"/>
                </a:ext>
              </a:extLst>
            </p:cNvPr>
            <p:cNvSpPr/>
            <p:nvPr/>
          </p:nvSpPr>
          <p:spPr>
            <a:xfrm rot="2563549">
              <a:off x="6044084" y="2426275"/>
              <a:ext cx="914400" cy="914400"/>
            </a:xfrm>
            <a:prstGeom prst="arc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8" name="弧形 247">
              <a:extLst>
                <a:ext uri="{FF2B5EF4-FFF2-40B4-BE49-F238E27FC236}">
                  <a16:creationId xmlns:a16="http://schemas.microsoft.com/office/drawing/2014/main" id="{D8E66113-11F3-4C6E-8E54-0B15284A980B}"/>
                </a:ext>
              </a:extLst>
            </p:cNvPr>
            <p:cNvSpPr/>
            <p:nvPr/>
          </p:nvSpPr>
          <p:spPr>
            <a:xfrm rot="2563549">
              <a:off x="6035483" y="2530211"/>
              <a:ext cx="724355" cy="724355"/>
            </a:xfrm>
            <a:prstGeom prst="arc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3" name="弧形 262">
              <a:extLst>
                <a:ext uri="{FF2B5EF4-FFF2-40B4-BE49-F238E27FC236}">
                  <a16:creationId xmlns:a16="http://schemas.microsoft.com/office/drawing/2014/main" id="{B1B93979-ACD5-476B-890F-25DA15A51945}"/>
                </a:ext>
              </a:extLst>
            </p:cNvPr>
            <p:cNvSpPr/>
            <p:nvPr/>
          </p:nvSpPr>
          <p:spPr>
            <a:xfrm rot="2563549">
              <a:off x="6076435" y="2651188"/>
              <a:ext cx="482399" cy="482399"/>
            </a:xfrm>
            <a:prstGeom prst="arc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8" name="图片 17">
            <a:extLst>
              <a:ext uri="{FF2B5EF4-FFF2-40B4-BE49-F238E27FC236}">
                <a16:creationId xmlns:a16="http://schemas.microsoft.com/office/drawing/2014/main" id="{8BA05EA6-DE51-41E8-BBC6-2E17CC60A0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80074" y="10463436"/>
            <a:ext cx="254210" cy="327410"/>
          </a:xfrm>
          <a:prstGeom prst="rect">
            <a:avLst/>
          </a:prstGeom>
        </p:spPr>
      </p:pic>
      <p:pic>
        <p:nvPicPr>
          <p:cNvPr id="264" name="图片 263">
            <a:extLst>
              <a:ext uri="{FF2B5EF4-FFF2-40B4-BE49-F238E27FC236}">
                <a16:creationId xmlns:a16="http://schemas.microsoft.com/office/drawing/2014/main" id="{93331FA4-4386-4739-94A3-D25B6F7453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37655" y="10471679"/>
            <a:ext cx="254210" cy="327410"/>
          </a:xfrm>
          <a:prstGeom prst="rect">
            <a:avLst/>
          </a:prstGeom>
        </p:spPr>
      </p:pic>
      <p:pic>
        <p:nvPicPr>
          <p:cNvPr id="267" name="图片 266">
            <a:extLst>
              <a:ext uri="{FF2B5EF4-FFF2-40B4-BE49-F238E27FC236}">
                <a16:creationId xmlns:a16="http://schemas.microsoft.com/office/drawing/2014/main" id="{4B532175-2D72-41C8-8352-7C30A9E4E0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5439" y="10476314"/>
            <a:ext cx="254210" cy="327410"/>
          </a:xfrm>
          <a:prstGeom prst="rect">
            <a:avLst/>
          </a:prstGeom>
        </p:spPr>
      </p:pic>
      <p:pic>
        <p:nvPicPr>
          <p:cNvPr id="273" name="图片 272">
            <a:extLst>
              <a:ext uri="{FF2B5EF4-FFF2-40B4-BE49-F238E27FC236}">
                <a16:creationId xmlns:a16="http://schemas.microsoft.com/office/drawing/2014/main" id="{84C45E3A-3239-4524-B9CB-AB4C746652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38722" y="9452982"/>
            <a:ext cx="254210" cy="327410"/>
          </a:xfrm>
          <a:prstGeom prst="rect">
            <a:avLst/>
          </a:prstGeom>
        </p:spPr>
      </p:pic>
      <p:pic>
        <p:nvPicPr>
          <p:cNvPr id="274" name="图片 273">
            <a:extLst>
              <a:ext uri="{FF2B5EF4-FFF2-40B4-BE49-F238E27FC236}">
                <a16:creationId xmlns:a16="http://schemas.microsoft.com/office/drawing/2014/main" id="{B2C3F0E7-5CAC-4D8E-A225-805F7FCAF9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98738" y="9481940"/>
            <a:ext cx="254210" cy="327410"/>
          </a:xfrm>
          <a:prstGeom prst="rect">
            <a:avLst/>
          </a:prstGeom>
        </p:spPr>
      </p:pic>
      <p:pic>
        <p:nvPicPr>
          <p:cNvPr id="275" name="图片 274">
            <a:extLst>
              <a:ext uri="{FF2B5EF4-FFF2-40B4-BE49-F238E27FC236}">
                <a16:creationId xmlns:a16="http://schemas.microsoft.com/office/drawing/2014/main" id="{0F0C641C-1B43-415D-9462-9712364883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99132" y="9503439"/>
            <a:ext cx="254210" cy="3197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4795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04</TotalTime>
  <Words>44</Words>
  <Application>Microsoft Office PowerPoint</Application>
  <PresentationFormat>自定义</PresentationFormat>
  <Paragraphs>2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Cambria Math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 zhou</dc:creator>
  <cp:lastModifiedBy>ying zhou</cp:lastModifiedBy>
  <cp:revision>2903</cp:revision>
  <dcterms:created xsi:type="dcterms:W3CDTF">2020-11-20T11:28:31Z</dcterms:created>
  <dcterms:modified xsi:type="dcterms:W3CDTF">2022-03-21T06:11:13Z</dcterms:modified>
</cp:coreProperties>
</file>